
<file path=[Content_Types].xml><?xml version="1.0" encoding="utf-8"?>
<Types xmlns="http://schemas.openxmlformats.org/package/2006/content-types">
  <Default Extension="png" ContentType="image/png"/>
  <Default Extension="jpeg" ContentType="image/jpeg"/>
  <Default Extension="rels" ContentType="application/vnd.openxmlformats-package.relationships+xml"/>
  <Default Extension="xml" ContentType="application/xml"/>
  <Default Extension="wdp" ContentType="image/vnd.ms-photo"/>
  <Default Extension="tiff" ContentType="image/tiff"/>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charts/chart1.xml" ContentType="application/vnd.openxmlformats-officedocument.drawingml.chart+xml"/>
  <Override PartName="/ppt/charts/chart2.xml" ContentType="application/vnd.openxmlformats-officedocument.drawingml.chart+xml"/>
  <Override PartName="/ppt/charts/chart3.xml" ContentType="application/vnd.openxmlformats-officedocument.drawingml.chart+xml"/>
  <Override PartName="/ppt/charts/chart4.xml" ContentType="application/vnd.openxmlformats-officedocument.drawingml.chart+xml"/>
  <Override PartName="/ppt/charts/chart5.xml" ContentType="application/vnd.openxmlformats-officedocument.drawingml.chart+xml"/>
  <Override PartName="/ppt/charts/chart6.xml" ContentType="application/vnd.openxmlformats-officedocument.drawingml.chart+xml"/>
  <Override PartName="/ppt/charts/chart7.xml" ContentType="application/vnd.openxmlformats-officedocument.drawingml.chart+xml"/>
  <Override PartName="/ppt/charts/chart8.xml" ContentType="application/vnd.openxmlformats-officedocument.drawingml.chart+xml"/>
  <Override PartName="/ppt/charts/chart9.xml" ContentType="application/vnd.openxmlformats-officedocument.drawingml.chart+xml"/>
  <Override PartName="/ppt/charts/chart10.xml" ContentType="application/vnd.openxmlformats-officedocument.drawingml.chart+xml"/>
  <Override PartName="/ppt/charts/chart11.xml" ContentType="application/vnd.openxmlformats-officedocument.drawingml.chart+xml"/>
  <Override PartName="/ppt/charts/chart12.xml" ContentType="application/vnd.openxmlformats-officedocument.drawingml.chart+xml"/>
  <Override PartName="/ppt/charts/chart13.xml" ContentType="application/vnd.openxmlformats-officedocument.drawingml.chart+xml"/>
  <Override PartName="/ppt/charts/chart14.xml" ContentType="application/vnd.openxmlformats-officedocument.drawingml.char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notesMasterIdLst>
    <p:notesMasterId r:id="rId9"/>
  </p:notesMasterIdLst>
  <p:sldIdLst>
    <p:sldId id="411" r:id="rId2"/>
    <p:sldId id="258" r:id="rId3"/>
    <p:sldId id="260" r:id="rId4"/>
    <p:sldId id="270" r:id="rId5"/>
    <p:sldId id="410" r:id="rId6"/>
    <p:sldId id="265" r:id="rId7"/>
    <p:sldId id="268" r:id="rId8"/>
  </p:sldIdLst>
  <p:sldSz cx="9144000" cy="6858000" type="screen4x3"/>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4319">
          <p15:clr>
            <a:srgbClr val="A4A3A4"/>
          </p15:clr>
        </p15:guide>
        <p15:guide id="2" pos="521"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6A91D0"/>
    <a:srgbClr val="9CB6E0"/>
    <a:srgbClr val="4472C4"/>
    <a:srgbClr val="D0DCF0"/>
    <a:srgbClr val="5B9BD5"/>
    <a:srgbClr val="9287FF"/>
    <a:srgbClr val="1DDCDB"/>
    <a:srgbClr val="6087CC"/>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073A0DAA-6AF3-43AB-8588-CEC1D06C72B9}" styleName="Medium Style 2">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dk1">
              <a:tint val="20000"/>
            </a:schemeClr>
          </a:solidFill>
        </a:fill>
      </a:tcStyle>
    </a:wholeTbl>
    <a:band1H>
      <a:tcStyle>
        <a:tcBdr/>
        <a:fill>
          <a:solidFill>
            <a:schemeClr val="dk1">
              <a:tint val="40000"/>
            </a:schemeClr>
          </a:solidFill>
        </a:fill>
      </a:tcStyle>
    </a:band1H>
    <a:band2H>
      <a:tcStyle>
        <a:tcBdr/>
      </a:tcStyle>
    </a:band2H>
    <a:band1V>
      <a:tcStyle>
        <a:tcBdr/>
        <a:fill>
          <a:solidFill>
            <a:schemeClr val="dk1">
              <a:tint val="40000"/>
            </a:schemeClr>
          </a:solidFill>
        </a:fill>
      </a:tcStyle>
    </a:band1V>
    <a:band2V>
      <a:tcStyle>
        <a:tcBdr/>
      </a:tcStyle>
    </a:band2V>
    <a:lastCol>
      <a:tcTxStyle b="on">
        <a:fontRef idx="minor">
          <a:prstClr val="black"/>
        </a:fontRef>
        <a:schemeClr val="lt1"/>
      </a:tcTxStyle>
      <a:tcStyle>
        <a:tcBdr/>
        <a:fill>
          <a:solidFill>
            <a:schemeClr val="dk1"/>
          </a:solidFill>
        </a:fill>
      </a:tcStyle>
    </a:lastCol>
    <a:firstCol>
      <a:tcTxStyle b="on">
        <a:fontRef idx="minor">
          <a:prstClr val="black"/>
        </a:fontRef>
        <a:schemeClr val="lt1"/>
      </a:tcTxStyle>
      <a:tcStyle>
        <a:tcBdr/>
        <a:fill>
          <a:solidFill>
            <a:schemeClr val="dk1"/>
          </a:solidFill>
        </a:fill>
      </a:tcStyle>
    </a:firstCol>
    <a:lastRow>
      <a:tcTxStyle b="on">
        <a:fontRef idx="minor">
          <a:prstClr val="black"/>
        </a:fontRef>
        <a:schemeClr val="lt1"/>
      </a:tcTxStyle>
      <a:tcStyle>
        <a:tcBdr>
          <a:top>
            <a:ln w="38100" cmpd="sng">
              <a:solidFill>
                <a:schemeClr val="lt1"/>
              </a:solidFill>
            </a:ln>
          </a:top>
        </a:tcBdr>
        <a:fill>
          <a:solidFill>
            <a:schemeClr val="dk1"/>
          </a:solidFill>
        </a:fill>
      </a:tcStyle>
    </a:lastRow>
    <a:firstRow>
      <a:tcTxStyle b="on">
        <a:fontRef idx="minor">
          <a:prstClr val="black"/>
        </a:fontRef>
        <a:schemeClr val="lt1"/>
      </a:tcTxStyle>
      <a:tcStyle>
        <a:tcBdr>
          <a:bottom>
            <a:ln w="38100" cmpd="sng">
              <a:solidFill>
                <a:schemeClr val="lt1"/>
              </a:solidFill>
            </a:ln>
          </a:bottom>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920" autoAdjust="0"/>
    <p:restoredTop sz="94660"/>
  </p:normalViewPr>
  <p:slideViewPr>
    <p:cSldViewPr snapToGrid="0">
      <p:cViewPr varScale="1">
        <p:scale>
          <a:sx n="130" d="100"/>
          <a:sy n="130" d="100"/>
        </p:scale>
        <p:origin x="1458" y="96"/>
      </p:cViewPr>
      <p:guideLst>
        <p:guide orient="horz" pos="4319"/>
        <p:guide pos="521"/>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viewProps" Target="viewProps.xml"/><Relationship Id="rId5" Type="http://schemas.openxmlformats.org/officeDocument/2006/relationships/slide" Target="slides/slide4.xml"/><Relationship Id="rId10" Type="http://schemas.openxmlformats.org/officeDocument/2006/relationships/presProps" Target="presProps.xml"/><Relationship Id="rId4" Type="http://schemas.openxmlformats.org/officeDocument/2006/relationships/slide" Target="slides/slide3.xml"/><Relationship Id="rId9" Type="http://schemas.openxmlformats.org/officeDocument/2006/relationships/notesMaster" Target="notesMasters/notesMaster1.xml"/></Relationships>
</file>

<file path=ppt/charts/_rels/chart1.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_rels/chart10.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_rels/chart11.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_rels/chart12.xml.rels><?xml version="1.0" encoding="UTF-8" standalone="yes"?>
<Relationships xmlns="http://schemas.openxmlformats.org/package/2006/relationships"><Relationship Id="rId1" Type="http://schemas.openxmlformats.org/officeDocument/2006/relationships/oleObject" Target="Book1" TargetMode="External"/></Relationships>
</file>

<file path=ppt/charts/_rels/chart13.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_rels/chart14.xml.rels><?xml version="1.0" encoding="UTF-8" standalone="yes"?>
<Relationships xmlns="http://schemas.openxmlformats.org/package/2006/relationships"><Relationship Id="rId1" Type="http://schemas.openxmlformats.org/officeDocument/2006/relationships/oleObject" Target="Book1" TargetMode="External"/></Relationships>
</file>

<file path=ppt/charts/_rels/chart2.xml.rels><?xml version="1.0" encoding="UTF-8" standalone="yes"?>
<Relationships xmlns="http://schemas.openxmlformats.org/package/2006/relationships"><Relationship Id="rId1" Type="http://schemas.openxmlformats.org/officeDocument/2006/relationships/oleObject" Target="file:///C:\Users\vwq83165\Desktop\new%20QY.xlsx" TargetMode="External"/></Relationships>
</file>

<file path=ppt/charts/_rels/chart3.xml.rels><?xml version="1.0" encoding="UTF-8" standalone="yes"?>
<Relationships xmlns="http://schemas.openxmlformats.org/package/2006/relationships"><Relationship Id="rId1" Type="http://schemas.openxmlformats.org/officeDocument/2006/relationships/oleObject" Target="file:///E:\AZD_MP_spectra.txt" TargetMode="External"/></Relationships>
</file>

<file path=ppt/charts/_rels/chart4.xml.rels><?xml version="1.0" encoding="UTF-8" standalone="yes"?>
<Relationships xmlns="http://schemas.openxmlformats.org/package/2006/relationships"><Relationship Id="rId1" Type="http://schemas.openxmlformats.org/officeDocument/2006/relationships/oleObject" Target="file:///F:\colocalisation%20distribution.xlsx" TargetMode="External"/></Relationships>
</file>

<file path=ppt/charts/_rels/chart5.xml.rels><?xml version="1.0" encoding="UTF-8" standalone="yes"?>
<Relationships xmlns="http://schemas.openxmlformats.org/package/2006/relationships"><Relationship Id="rId1" Type="http://schemas.openxmlformats.org/officeDocument/2006/relationships/oleObject" Target="file:///E:\Spectral%20overlap.xlsx" TargetMode="External"/></Relationships>
</file>

<file path=ppt/charts/_rels/chart6.xml.rels><?xml version="1.0" encoding="UTF-8" standalone="yes"?>
<Relationships xmlns="http://schemas.openxmlformats.org/package/2006/relationships"><Relationship Id="rId1" Type="http://schemas.openxmlformats.org/officeDocument/2006/relationships/oleObject" Target="file:///E:\AZD_GFP%20lifetimes.xlsx" TargetMode="External"/></Relationships>
</file>

<file path=ppt/charts/_rels/chart7.xml.rels><?xml version="1.0" encoding="UTF-8" standalone="yes"?>
<Relationships xmlns="http://schemas.openxmlformats.org/package/2006/relationships"><Relationship Id="rId1" Type="http://schemas.openxmlformats.org/officeDocument/2006/relationships/oleObject" Target="file:///C:\Users\vwq83165\Desktop\new%20QY.xlsx" TargetMode="External"/></Relationships>
</file>

<file path=ppt/charts/_rels/chart8.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_rels/chart9.xml.rels><?xml version="1.0" encoding="UTF-8" standalone="yes"?>
<Relationships xmlns="http://schemas.openxmlformats.org/package/2006/relationships"><Relationship Id="rId1" Type="http://schemas.openxmlformats.org/officeDocument/2006/relationships/oleObject" Target="file:///C:\Users\vwq83165\Desktop\uv-vis%20mtor%20inhibitors.xlsx" TargetMode="External"/></Relationships>
</file>

<file path=ppt/charts/chart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Sheet1!$D$1</c:f>
              <c:strCache>
                <c:ptCount val="1"/>
                <c:pt idx="0">
                  <c:v>DMSO only</c:v>
                </c:pt>
              </c:strCache>
            </c:strRef>
          </c:tx>
          <c:spPr>
            <a:ln>
              <a:solidFill>
                <a:schemeClr val="tx1"/>
              </a:solidFill>
            </a:ln>
          </c:spPr>
          <c:marker>
            <c:symbol val="none"/>
          </c:marker>
          <c:xVal>
            <c:numRef>
              <c:f>Sheet1!$D$3:$D$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H$3:$H$513</c:f>
              <c:numCache>
                <c:formatCode>General</c:formatCode>
                <c:ptCount val="511"/>
                <c:pt idx="0">
                  <c:v>83157.636363636339</c:v>
                </c:pt>
                <c:pt idx="1">
                  <c:v>13104.545454545434</c:v>
                </c:pt>
                <c:pt idx="2">
                  <c:v>51075.27272727275</c:v>
                </c:pt>
                <c:pt idx="3">
                  <c:v>7766.7272727272939</c:v>
                </c:pt>
                <c:pt idx="4">
                  <c:v>-3694.0000000000255</c:v>
                </c:pt>
                <c:pt idx="5">
                  <c:v>-4902.1818181818053</c:v>
                </c:pt>
                <c:pt idx="6">
                  <c:v>-16412.909090909088</c:v>
                </c:pt>
                <c:pt idx="7">
                  <c:v>-3318.0909090909145</c:v>
                </c:pt>
                <c:pt idx="8">
                  <c:v>-7471.2727272727507</c:v>
                </c:pt>
                <c:pt idx="9">
                  <c:v>-6455.8181818181738</c:v>
                </c:pt>
                <c:pt idx="10">
                  <c:v>4773.1818181818207</c:v>
                </c:pt>
                <c:pt idx="11">
                  <c:v>1421.8181818181706</c:v>
                </c:pt>
                <c:pt idx="12">
                  <c:v>-621.45454545457153</c:v>
                </c:pt>
                <c:pt idx="13">
                  <c:v>7880.4545454545168</c:v>
                </c:pt>
                <c:pt idx="14">
                  <c:v>0</c:v>
                </c:pt>
                <c:pt idx="15">
                  <c:v>-1656.2727272727461</c:v>
                </c:pt>
                <c:pt idx="16">
                  <c:v>-6486.3636363636188</c:v>
                </c:pt>
                <c:pt idx="17">
                  <c:v>-1070.9090909090819</c:v>
                </c:pt>
                <c:pt idx="18">
                  <c:v>12.45454545455034</c:v>
                </c:pt>
                <c:pt idx="19">
                  <c:v>-5759.4545454545378</c:v>
                </c:pt>
                <c:pt idx="20">
                  <c:v>1527.2727272727207</c:v>
                </c:pt>
                <c:pt idx="21">
                  <c:v>4264.1818181818089</c:v>
                </c:pt>
                <c:pt idx="22">
                  <c:v>-1449.5454545454434</c:v>
                </c:pt>
                <c:pt idx="23">
                  <c:v>2390.0909090909149</c:v>
                </c:pt>
                <c:pt idx="24">
                  <c:v>18067.818181818169</c:v>
                </c:pt>
                <c:pt idx="25">
                  <c:v>-131.81818181819759</c:v>
                </c:pt>
                <c:pt idx="26">
                  <c:v>1469.0000000000032</c:v>
                </c:pt>
                <c:pt idx="27">
                  <c:v>0</c:v>
                </c:pt>
                <c:pt idx="28">
                  <c:v>-1126.3636363636274</c:v>
                </c:pt>
                <c:pt idx="29">
                  <c:v>-6.9090909090877259</c:v>
                </c:pt>
                <c:pt idx="30">
                  <c:v>721.27272727269667</c:v>
                </c:pt>
                <c:pt idx="31">
                  <c:v>-1862.9090909090869</c:v>
                </c:pt>
                <c:pt idx="32">
                  <c:v>6113.2727272727197</c:v>
                </c:pt>
                <c:pt idx="33">
                  <c:v>-3602.4545454545728</c:v>
                </c:pt>
                <c:pt idx="34">
                  <c:v>880.81818181816698</c:v>
                </c:pt>
                <c:pt idx="35">
                  <c:v>6253.3636363636306</c:v>
                </c:pt>
                <c:pt idx="36">
                  <c:v>3436.000000000015</c:v>
                </c:pt>
                <c:pt idx="37">
                  <c:v>4744.0909090909227</c:v>
                </c:pt>
                <c:pt idx="38">
                  <c:v>-973.81818181816664</c:v>
                </c:pt>
                <c:pt idx="39">
                  <c:v>253.81818181817326</c:v>
                </c:pt>
                <c:pt idx="40">
                  <c:v>-2804.8181818181838</c:v>
                </c:pt>
                <c:pt idx="41">
                  <c:v>-151.18181818183564</c:v>
                </c:pt>
                <c:pt idx="42">
                  <c:v>3230.6363636363776</c:v>
                </c:pt>
                <c:pt idx="43">
                  <c:v>1438.4545454545585</c:v>
                </c:pt>
                <c:pt idx="44">
                  <c:v>2136.1818181818198</c:v>
                </c:pt>
                <c:pt idx="45">
                  <c:v>1310.9090909090799</c:v>
                </c:pt>
                <c:pt idx="46">
                  <c:v>-1926.7272727272668</c:v>
                </c:pt>
                <c:pt idx="47">
                  <c:v>198.36363636366821</c:v>
                </c:pt>
                <c:pt idx="48">
                  <c:v>585.36363636362375</c:v>
                </c:pt>
                <c:pt idx="49">
                  <c:v>5880.1818181818098</c:v>
                </c:pt>
                <c:pt idx="50">
                  <c:v>1946.1818181818267</c:v>
                </c:pt>
                <c:pt idx="51">
                  <c:v>2811.8181818181934</c:v>
                </c:pt>
                <c:pt idx="52">
                  <c:v>1869.9090909090964</c:v>
                </c:pt>
                <c:pt idx="53">
                  <c:v>212.27272727272509</c:v>
                </c:pt>
                <c:pt idx="54">
                  <c:v>-1779.7272727272687</c:v>
                </c:pt>
                <c:pt idx="55">
                  <c:v>-4221.1818181818135</c:v>
                </c:pt>
                <c:pt idx="56">
                  <c:v>255.27272727272015</c:v>
                </c:pt>
                <c:pt idx="57">
                  <c:v>6994.0909090909272</c:v>
                </c:pt>
                <c:pt idx="58">
                  <c:v>-1154.0909090909001</c:v>
                </c:pt>
                <c:pt idx="59">
                  <c:v>2986.5454545454641</c:v>
                </c:pt>
                <c:pt idx="60">
                  <c:v>492.45454545454595</c:v>
                </c:pt>
                <c:pt idx="61">
                  <c:v>4307.0909090909217</c:v>
                </c:pt>
                <c:pt idx="62">
                  <c:v>13377.818181818167</c:v>
                </c:pt>
                <c:pt idx="63">
                  <c:v>1283.0909090908854</c:v>
                </c:pt>
                <c:pt idx="64">
                  <c:v>-18895.909090909081</c:v>
                </c:pt>
                <c:pt idx="65">
                  <c:v>205.36363636363737</c:v>
                </c:pt>
                <c:pt idx="66">
                  <c:v>21023.818181818191</c:v>
                </c:pt>
                <c:pt idx="67">
                  <c:v>27841.727272727258</c:v>
                </c:pt>
                <c:pt idx="68">
                  <c:v>27149.54545454546</c:v>
                </c:pt>
                <c:pt idx="69">
                  <c:v>26772.272727272724</c:v>
                </c:pt>
                <c:pt idx="70">
                  <c:v>26927.545454545456</c:v>
                </c:pt>
                <c:pt idx="71">
                  <c:v>27227.272727272717</c:v>
                </c:pt>
                <c:pt idx="72">
                  <c:v>26805.54545454546</c:v>
                </c:pt>
                <c:pt idx="73">
                  <c:v>26522.545454545456</c:v>
                </c:pt>
                <c:pt idx="74">
                  <c:v>26480.909090909085</c:v>
                </c:pt>
                <c:pt idx="75">
                  <c:v>26636.272727272728</c:v>
                </c:pt>
                <c:pt idx="76">
                  <c:v>26929</c:v>
                </c:pt>
                <c:pt idx="77">
                  <c:v>27433.909090909099</c:v>
                </c:pt>
                <c:pt idx="78">
                  <c:v>27919.363636363636</c:v>
                </c:pt>
                <c:pt idx="79">
                  <c:v>28443.81818181818</c:v>
                </c:pt>
                <c:pt idx="80">
                  <c:v>29066.636363636364</c:v>
                </c:pt>
                <c:pt idx="81">
                  <c:v>29750.454545454548</c:v>
                </c:pt>
                <c:pt idx="82">
                  <c:v>30466.181818181816</c:v>
                </c:pt>
                <c:pt idx="83">
                  <c:v>31251.454545454544</c:v>
                </c:pt>
                <c:pt idx="84">
                  <c:v>32101.727272727276</c:v>
                </c:pt>
                <c:pt idx="85">
                  <c:v>32898</c:v>
                </c:pt>
                <c:pt idx="86">
                  <c:v>33648.454545454551</c:v>
                </c:pt>
                <c:pt idx="87">
                  <c:v>34362.818181818184</c:v>
                </c:pt>
                <c:pt idx="88">
                  <c:v>35010.545454545456</c:v>
                </c:pt>
                <c:pt idx="89">
                  <c:v>35622.272727272728</c:v>
                </c:pt>
                <c:pt idx="90">
                  <c:v>36080.090909090912</c:v>
                </c:pt>
                <c:pt idx="91">
                  <c:v>36482.454545454544</c:v>
                </c:pt>
                <c:pt idx="92">
                  <c:v>36701.545454545456</c:v>
                </c:pt>
                <c:pt idx="93">
                  <c:v>36790.36363636364</c:v>
                </c:pt>
                <c:pt idx="94">
                  <c:v>36747.272727272728</c:v>
                </c:pt>
                <c:pt idx="95">
                  <c:v>36496.272727272728</c:v>
                </c:pt>
                <c:pt idx="96">
                  <c:v>36103.727272727279</c:v>
                </c:pt>
                <c:pt idx="97">
                  <c:v>35494.727272727272</c:v>
                </c:pt>
                <c:pt idx="98">
                  <c:v>34713.727272727272</c:v>
                </c:pt>
                <c:pt idx="99">
                  <c:v>33820.454545454544</c:v>
                </c:pt>
                <c:pt idx="100">
                  <c:v>32773.090909090912</c:v>
                </c:pt>
                <c:pt idx="101">
                  <c:v>31609.272727272728</c:v>
                </c:pt>
                <c:pt idx="102">
                  <c:v>30342.727272727276</c:v>
                </c:pt>
                <c:pt idx="103">
                  <c:v>28962.636363636364</c:v>
                </c:pt>
                <c:pt idx="104">
                  <c:v>27554.63636363636</c:v>
                </c:pt>
                <c:pt idx="105">
                  <c:v>25073.000000000004</c:v>
                </c:pt>
                <c:pt idx="106">
                  <c:v>22417.909090909088</c:v>
                </c:pt>
                <c:pt idx="107">
                  <c:v>21238.81818181818</c:v>
                </c:pt>
                <c:pt idx="108">
                  <c:v>20235.909090909092</c:v>
                </c:pt>
                <c:pt idx="109">
                  <c:v>19177.545454545456</c:v>
                </c:pt>
                <c:pt idx="110">
                  <c:v>17838.909090909088</c:v>
                </c:pt>
                <c:pt idx="111">
                  <c:v>16586.272727272724</c:v>
                </c:pt>
                <c:pt idx="112">
                  <c:v>15493.181818181818</c:v>
                </c:pt>
                <c:pt idx="113">
                  <c:v>14285</c:v>
                </c:pt>
                <c:pt idx="114">
                  <c:v>13175.272727272728</c:v>
                </c:pt>
                <c:pt idx="115">
                  <c:v>12177.90909090909</c:v>
                </c:pt>
                <c:pt idx="116">
                  <c:v>11444.09090909091</c:v>
                </c:pt>
                <c:pt idx="117">
                  <c:v>10763</c:v>
                </c:pt>
                <c:pt idx="118">
                  <c:v>9850.2727272727261</c:v>
                </c:pt>
                <c:pt idx="119">
                  <c:v>9019.363636363636</c:v>
                </c:pt>
                <c:pt idx="120">
                  <c:v>8195.363636363636</c:v>
                </c:pt>
                <c:pt idx="121">
                  <c:v>7583.6363636363631</c:v>
                </c:pt>
                <c:pt idx="122">
                  <c:v>7170.272727272727</c:v>
                </c:pt>
                <c:pt idx="123">
                  <c:v>6551.6363636363631</c:v>
                </c:pt>
                <c:pt idx="124">
                  <c:v>6218.7272727272739</c:v>
                </c:pt>
                <c:pt idx="125">
                  <c:v>5844.0909090909099</c:v>
                </c:pt>
                <c:pt idx="126">
                  <c:v>5644.363636363636</c:v>
                </c:pt>
                <c:pt idx="127">
                  <c:v>5339.1818181818189</c:v>
                </c:pt>
                <c:pt idx="128">
                  <c:v>5186.545454545454</c:v>
                </c:pt>
                <c:pt idx="129">
                  <c:v>4993.8181818181811</c:v>
                </c:pt>
                <c:pt idx="130">
                  <c:v>4803.818181818182</c:v>
                </c:pt>
                <c:pt idx="131">
                  <c:v>4662.272727272727</c:v>
                </c:pt>
                <c:pt idx="132">
                  <c:v>4551.272727272727</c:v>
                </c:pt>
                <c:pt idx="133">
                  <c:v>4455.636363636364</c:v>
                </c:pt>
                <c:pt idx="134">
                  <c:v>4429.2727272727279</c:v>
                </c:pt>
                <c:pt idx="135">
                  <c:v>4254.454545454546</c:v>
                </c:pt>
                <c:pt idx="136">
                  <c:v>4093.5454545454545</c:v>
                </c:pt>
                <c:pt idx="137">
                  <c:v>4165.636363636364</c:v>
                </c:pt>
                <c:pt idx="138">
                  <c:v>4074.1818181818185</c:v>
                </c:pt>
                <c:pt idx="139">
                  <c:v>3979.8181818181824</c:v>
                </c:pt>
                <c:pt idx="140">
                  <c:v>3892.3636363636365</c:v>
                </c:pt>
                <c:pt idx="141">
                  <c:v>3843.818181818182</c:v>
                </c:pt>
                <c:pt idx="142">
                  <c:v>3824.454545454545</c:v>
                </c:pt>
                <c:pt idx="143">
                  <c:v>3778.6363636363635</c:v>
                </c:pt>
                <c:pt idx="144">
                  <c:v>3675.909090909091</c:v>
                </c:pt>
                <c:pt idx="145">
                  <c:v>3662.090909090909</c:v>
                </c:pt>
                <c:pt idx="146">
                  <c:v>3666.272727272727</c:v>
                </c:pt>
                <c:pt idx="147">
                  <c:v>3666.2727272727279</c:v>
                </c:pt>
                <c:pt idx="148">
                  <c:v>3633</c:v>
                </c:pt>
                <c:pt idx="149">
                  <c:v>3609.3636363636365</c:v>
                </c:pt>
                <c:pt idx="150">
                  <c:v>3631.5454545454545</c:v>
                </c:pt>
                <c:pt idx="151">
                  <c:v>3610.727272727273</c:v>
                </c:pt>
                <c:pt idx="152">
                  <c:v>3674.5454545454545</c:v>
                </c:pt>
                <c:pt idx="153">
                  <c:v>3628.818181818182</c:v>
                </c:pt>
                <c:pt idx="154">
                  <c:v>3723.181818181818</c:v>
                </c:pt>
                <c:pt idx="155">
                  <c:v>3732.818181818182</c:v>
                </c:pt>
                <c:pt idx="156">
                  <c:v>3809.1818181818185</c:v>
                </c:pt>
                <c:pt idx="157">
                  <c:v>3895.181818181818</c:v>
                </c:pt>
                <c:pt idx="158">
                  <c:v>3988.090909090909</c:v>
                </c:pt>
                <c:pt idx="159">
                  <c:v>4042.1818181818185</c:v>
                </c:pt>
                <c:pt idx="160">
                  <c:v>4165.636363636364</c:v>
                </c:pt>
                <c:pt idx="161">
                  <c:v>4315.454545454545</c:v>
                </c:pt>
                <c:pt idx="162">
                  <c:v>4400.090909090909</c:v>
                </c:pt>
                <c:pt idx="163">
                  <c:v>4567.909090909091</c:v>
                </c:pt>
                <c:pt idx="164">
                  <c:v>4717.727272727273</c:v>
                </c:pt>
                <c:pt idx="165">
                  <c:v>4877.2727272727279</c:v>
                </c:pt>
                <c:pt idx="166">
                  <c:v>5065.909090909091</c:v>
                </c:pt>
                <c:pt idx="167">
                  <c:v>5213.0000000000009</c:v>
                </c:pt>
                <c:pt idx="168">
                  <c:v>5418.2727272727279</c:v>
                </c:pt>
                <c:pt idx="169">
                  <c:v>5616.545454545455</c:v>
                </c:pt>
                <c:pt idx="170">
                  <c:v>5831.6363636363649</c:v>
                </c:pt>
                <c:pt idx="171">
                  <c:v>6031.3636363636369</c:v>
                </c:pt>
                <c:pt idx="172">
                  <c:v>6246.3636363636369</c:v>
                </c:pt>
                <c:pt idx="173">
                  <c:v>6460</c:v>
                </c:pt>
                <c:pt idx="174">
                  <c:v>6680.545454545454</c:v>
                </c:pt>
                <c:pt idx="175">
                  <c:v>6924.7272727272721</c:v>
                </c:pt>
                <c:pt idx="176">
                  <c:v>7141.090909090909</c:v>
                </c:pt>
                <c:pt idx="177">
                  <c:v>7396.3636363636369</c:v>
                </c:pt>
                <c:pt idx="178">
                  <c:v>7668.272727272727</c:v>
                </c:pt>
                <c:pt idx="179">
                  <c:v>7872.1818181818189</c:v>
                </c:pt>
                <c:pt idx="180">
                  <c:v>8153.7272727272721</c:v>
                </c:pt>
                <c:pt idx="181">
                  <c:v>8361.818181818182</c:v>
                </c:pt>
                <c:pt idx="182">
                  <c:v>8576.818181818182</c:v>
                </c:pt>
                <c:pt idx="183">
                  <c:v>8836.2727272727261</c:v>
                </c:pt>
                <c:pt idx="184">
                  <c:v>9041.545454545454</c:v>
                </c:pt>
                <c:pt idx="185">
                  <c:v>9256.545454545454</c:v>
                </c:pt>
                <c:pt idx="186">
                  <c:v>9479.9090909090901</c:v>
                </c:pt>
                <c:pt idx="187">
                  <c:v>9690.7272727272721</c:v>
                </c:pt>
                <c:pt idx="188">
                  <c:v>9893.181818181818</c:v>
                </c:pt>
                <c:pt idx="189">
                  <c:v>10054.181818181818</c:v>
                </c:pt>
                <c:pt idx="190">
                  <c:v>10252.545454545454</c:v>
                </c:pt>
                <c:pt idx="191">
                  <c:v>10413.363636363636</c:v>
                </c:pt>
                <c:pt idx="192">
                  <c:v>10571.545454545454</c:v>
                </c:pt>
                <c:pt idx="193">
                  <c:v>10738.09090909091</c:v>
                </c:pt>
                <c:pt idx="194">
                  <c:v>10878.09090909091</c:v>
                </c:pt>
                <c:pt idx="195">
                  <c:v>11032.090909090908</c:v>
                </c:pt>
                <c:pt idx="196">
                  <c:v>11168.09090909091</c:v>
                </c:pt>
                <c:pt idx="197">
                  <c:v>11288.727272727272</c:v>
                </c:pt>
                <c:pt idx="198">
                  <c:v>11394.09090909091</c:v>
                </c:pt>
                <c:pt idx="199">
                  <c:v>11460.81818181818</c:v>
                </c:pt>
                <c:pt idx="200">
                  <c:v>11541.18181818182</c:v>
                </c:pt>
                <c:pt idx="201">
                  <c:v>11588.363636363636</c:v>
                </c:pt>
                <c:pt idx="202">
                  <c:v>11616.09090909091</c:v>
                </c:pt>
                <c:pt idx="203">
                  <c:v>11616.09090909091</c:v>
                </c:pt>
                <c:pt idx="204">
                  <c:v>11591.18181818182</c:v>
                </c:pt>
                <c:pt idx="205">
                  <c:v>11542.545454545454</c:v>
                </c:pt>
                <c:pt idx="206">
                  <c:v>11481.545454545454</c:v>
                </c:pt>
                <c:pt idx="207">
                  <c:v>11412.18181818182</c:v>
                </c:pt>
                <c:pt idx="208">
                  <c:v>11341.454545454546</c:v>
                </c:pt>
                <c:pt idx="209">
                  <c:v>11218.000000000002</c:v>
                </c:pt>
                <c:pt idx="210">
                  <c:v>11097.272727272728</c:v>
                </c:pt>
                <c:pt idx="211">
                  <c:v>10962.818181818182</c:v>
                </c:pt>
                <c:pt idx="212">
                  <c:v>10826.727272727274</c:v>
                </c:pt>
                <c:pt idx="213">
                  <c:v>10663.181818181818</c:v>
                </c:pt>
                <c:pt idx="214">
                  <c:v>10499.454545454546</c:v>
                </c:pt>
                <c:pt idx="215">
                  <c:v>10330.18181818182</c:v>
                </c:pt>
                <c:pt idx="216">
                  <c:v>10158.181818181818</c:v>
                </c:pt>
                <c:pt idx="217">
                  <c:v>9975.0909090909099</c:v>
                </c:pt>
                <c:pt idx="218">
                  <c:v>9785.0909090909099</c:v>
                </c:pt>
                <c:pt idx="219">
                  <c:v>9570</c:v>
                </c:pt>
                <c:pt idx="220">
                  <c:v>9360.636363636364</c:v>
                </c:pt>
                <c:pt idx="221">
                  <c:v>9142.7272727272721</c:v>
                </c:pt>
                <c:pt idx="222">
                  <c:v>8897.2727272727279</c:v>
                </c:pt>
                <c:pt idx="223">
                  <c:v>8653.0909090909099</c:v>
                </c:pt>
                <c:pt idx="224">
                  <c:v>8379.818181818182</c:v>
                </c:pt>
                <c:pt idx="225">
                  <c:v>8070.454545454545</c:v>
                </c:pt>
                <c:pt idx="226">
                  <c:v>7777.8181818181829</c:v>
                </c:pt>
                <c:pt idx="227">
                  <c:v>7433.818181818182</c:v>
                </c:pt>
                <c:pt idx="228">
                  <c:v>7099.545454545455</c:v>
                </c:pt>
                <c:pt idx="229">
                  <c:v>6743</c:v>
                </c:pt>
                <c:pt idx="230">
                  <c:v>6365.636363636364</c:v>
                </c:pt>
                <c:pt idx="231">
                  <c:v>6005</c:v>
                </c:pt>
                <c:pt idx="232">
                  <c:v>5606.909090909091</c:v>
                </c:pt>
                <c:pt idx="233">
                  <c:v>5219.909090909091</c:v>
                </c:pt>
                <c:pt idx="234">
                  <c:v>4846.727272727273</c:v>
                </c:pt>
                <c:pt idx="235">
                  <c:v>4481.909090909091</c:v>
                </c:pt>
                <c:pt idx="236">
                  <c:v>4121.272727272727</c:v>
                </c:pt>
                <c:pt idx="237">
                  <c:v>3746.727272727273</c:v>
                </c:pt>
                <c:pt idx="238">
                  <c:v>3394.4545454545455</c:v>
                </c:pt>
                <c:pt idx="239">
                  <c:v>3068.3636363636369</c:v>
                </c:pt>
                <c:pt idx="240">
                  <c:v>2742.4545454545455</c:v>
                </c:pt>
                <c:pt idx="241">
                  <c:v>2438.6363636363635</c:v>
                </c:pt>
                <c:pt idx="242">
                  <c:v>2175.090909090909</c:v>
                </c:pt>
                <c:pt idx="243">
                  <c:v>1935.090909090909</c:v>
                </c:pt>
                <c:pt idx="244">
                  <c:v>1702.0909090909088</c:v>
                </c:pt>
                <c:pt idx="245">
                  <c:v>1496.7272727272727</c:v>
                </c:pt>
                <c:pt idx="246">
                  <c:v>1309.5454545454545</c:v>
                </c:pt>
                <c:pt idx="247">
                  <c:v>1129.0909090909092</c:v>
                </c:pt>
                <c:pt idx="248">
                  <c:v>983.5454545454545</c:v>
                </c:pt>
                <c:pt idx="249">
                  <c:v>851.72727272727263</c:v>
                </c:pt>
                <c:pt idx="250">
                  <c:v>729.63636363636385</c:v>
                </c:pt>
                <c:pt idx="251">
                  <c:v>621.45454545454561</c:v>
                </c:pt>
                <c:pt idx="252">
                  <c:v>535.45454545454538</c:v>
                </c:pt>
                <c:pt idx="253">
                  <c:v>453.6363636363638</c:v>
                </c:pt>
                <c:pt idx="254">
                  <c:v>375.90909090909088</c:v>
                </c:pt>
                <c:pt idx="255">
                  <c:v>321.81818181818164</c:v>
                </c:pt>
                <c:pt idx="256">
                  <c:v>278.81818181818187</c:v>
                </c:pt>
                <c:pt idx="257">
                  <c:v>234.45454545454527</c:v>
                </c:pt>
                <c:pt idx="258">
                  <c:v>187.27272727272722</c:v>
                </c:pt>
                <c:pt idx="259">
                  <c:v>158.18181818181804</c:v>
                </c:pt>
                <c:pt idx="260">
                  <c:v>127.63636363636355</c:v>
                </c:pt>
                <c:pt idx="261">
                  <c:v>113.72727272727292</c:v>
                </c:pt>
                <c:pt idx="262">
                  <c:v>94.363636363636431</c:v>
                </c:pt>
                <c:pt idx="263">
                  <c:v>67.909090909090693</c:v>
                </c:pt>
                <c:pt idx="264">
                  <c:v>72.090909090908966</c:v>
                </c:pt>
                <c:pt idx="265">
                  <c:v>62.363636363636282</c:v>
                </c:pt>
                <c:pt idx="266">
                  <c:v>48.545454545454525</c:v>
                </c:pt>
                <c:pt idx="267">
                  <c:v>41.636363636363328</c:v>
                </c:pt>
                <c:pt idx="268">
                  <c:v>37.454545454545382</c:v>
                </c:pt>
                <c:pt idx="269">
                  <c:v>31.909090909090967</c:v>
                </c:pt>
                <c:pt idx="270">
                  <c:v>26.363636363636235</c:v>
                </c:pt>
                <c:pt idx="271">
                  <c:v>26.363636363636235</c:v>
                </c:pt>
                <c:pt idx="272">
                  <c:v>23.545454545454437</c:v>
                </c:pt>
                <c:pt idx="273">
                  <c:v>22.181818181817974</c:v>
                </c:pt>
                <c:pt idx="274">
                  <c:v>20.818181818181824</c:v>
                </c:pt>
                <c:pt idx="275">
                  <c:v>11.090909090909143</c:v>
                </c:pt>
                <c:pt idx="276">
                  <c:v>2.727272727272616</c:v>
                </c:pt>
                <c:pt idx="277">
                  <c:v>11.181818181818326</c:v>
                </c:pt>
                <c:pt idx="278">
                  <c:v>15.272727272727092</c:v>
                </c:pt>
                <c:pt idx="279">
                  <c:v>12.454545454545295</c:v>
                </c:pt>
                <c:pt idx="280">
                  <c:v>13.81818181818176</c:v>
                </c:pt>
                <c:pt idx="281">
                  <c:v>8.2727272727273462</c:v>
                </c:pt>
                <c:pt idx="282">
                  <c:v>11.090909090909143</c:v>
                </c:pt>
                <c:pt idx="283">
                  <c:v>9.6363636363638125</c:v>
                </c:pt>
                <c:pt idx="284">
                  <c:v>4.1818181818182643</c:v>
                </c:pt>
                <c:pt idx="285">
                  <c:v>2.8181818181817979</c:v>
                </c:pt>
                <c:pt idx="286">
                  <c:v>1.3636363636364659</c:v>
                </c:pt>
                <c:pt idx="287">
                  <c:v>2.8181818181817979</c:v>
                </c:pt>
                <c:pt idx="288">
                  <c:v>-1.3636363636361504</c:v>
                </c:pt>
                <c:pt idx="289">
                  <c:v>-1.3636363636364659</c:v>
                </c:pt>
                <c:pt idx="290">
                  <c:v>5.6363636363635958</c:v>
                </c:pt>
                <c:pt idx="291">
                  <c:v>4.1818181818182643</c:v>
                </c:pt>
                <c:pt idx="292">
                  <c:v>4.1818181818182643</c:v>
                </c:pt>
                <c:pt idx="293">
                  <c:v>8.2727272727273462</c:v>
                </c:pt>
                <c:pt idx="294">
                  <c:v>5.5454545454544144</c:v>
                </c:pt>
                <c:pt idx="295">
                  <c:v>6.9090909090908799</c:v>
                </c:pt>
                <c:pt idx="296">
                  <c:v>11.090909090909143</c:v>
                </c:pt>
                <c:pt idx="297">
                  <c:v>6.9090909090908799</c:v>
                </c:pt>
                <c:pt idx="298">
                  <c:v>4.1818181818182643</c:v>
                </c:pt>
                <c:pt idx="299">
                  <c:v>1.3636363636364659</c:v>
                </c:pt>
                <c:pt idx="300">
                  <c:v>0</c:v>
                </c:pt>
                <c:pt idx="301">
                  <c:v>0</c:v>
                </c:pt>
                <c:pt idx="302">
                  <c:v>-7.0000000000000622</c:v>
                </c:pt>
                <c:pt idx="303">
                  <c:v>-2.727272727272616</c:v>
                </c:pt>
                <c:pt idx="304">
                  <c:v>4.1818181818182643</c:v>
                </c:pt>
                <c:pt idx="305">
                  <c:v>1.3636363636361504</c:v>
                </c:pt>
                <c:pt idx="306">
                  <c:v>-1.3636363636364659</c:v>
                </c:pt>
                <c:pt idx="307">
                  <c:v>-1.3636363636361504</c:v>
                </c:pt>
                <c:pt idx="308">
                  <c:v>0</c:v>
                </c:pt>
                <c:pt idx="309">
                  <c:v>-1.3636363636364659</c:v>
                </c:pt>
                <c:pt idx="310">
                  <c:v>2.8181818181817979</c:v>
                </c:pt>
                <c:pt idx="311">
                  <c:v>2.8181818181817979</c:v>
                </c:pt>
                <c:pt idx="312">
                  <c:v>0</c:v>
                </c:pt>
                <c:pt idx="313">
                  <c:v>-2.7272727272729318</c:v>
                </c:pt>
                <c:pt idx="314">
                  <c:v>-7.0000000000000622</c:v>
                </c:pt>
                <c:pt idx="315">
                  <c:v>1.3636363636364659</c:v>
                </c:pt>
                <c:pt idx="316">
                  <c:v>-1.3636363636364659</c:v>
                </c:pt>
                <c:pt idx="317">
                  <c:v>-7.0000000000000622</c:v>
                </c:pt>
                <c:pt idx="318">
                  <c:v>-4.1818181818179481</c:v>
                </c:pt>
                <c:pt idx="319">
                  <c:v>-8.27272727272703</c:v>
                </c:pt>
                <c:pt idx="320">
                  <c:v>-2.8181818181821137</c:v>
                </c:pt>
                <c:pt idx="321">
                  <c:v>-5.6363636363635958</c:v>
                </c:pt>
                <c:pt idx="322">
                  <c:v>-5.5454545454544144</c:v>
                </c:pt>
                <c:pt idx="323">
                  <c:v>1.3636363636361504</c:v>
                </c:pt>
                <c:pt idx="324">
                  <c:v>0</c:v>
                </c:pt>
                <c:pt idx="325">
                  <c:v>-1.3636363636364659</c:v>
                </c:pt>
                <c:pt idx="326">
                  <c:v>-4.1818181818182643</c:v>
                </c:pt>
                <c:pt idx="327">
                  <c:v>0</c:v>
                </c:pt>
                <c:pt idx="328">
                  <c:v>-2.727272727272616</c:v>
                </c:pt>
                <c:pt idx="329">
                  <c:v>-6.9090909090908799</c:v>
                </c:pt>
                <c:pt idx="330">
                  <c:v>-11.090909090909143</c:v>
                </c:pt>
                <c:pt idx="331">
                  <c:v>-1.3636363636364659</c:v>
                </c:pt>
                <c:pt idx="332">
                  <c:v>-5.5454545454547297</c:v>
                </c:pt>
                <c:pt idx="333">
                  <c:v>-13.81818181818176</c:v>
                </c:pt>
                <c:pt idx="334">
                  <c:v>-9.6363636363634964</c:v>
                </c:pt>
                <c:pt idx="335">
                  <c:v>-2.727272727272616</c:v>
                </c:pt>
                <c:pt idx="336">
                  <c:v>-2.727272727272616</c:v>
                </c:pt>
                <c:pt idx="337">
                  <c:v>0</c:v>
                </c:pt>
                <c:pt idx="338">
                  <c:v>1.3636363636361504</c:v>
                </c:pt>
                <c:pt idx="339">
                  <c:v>1.3636363636361504</c:v>
                </c:pt>
                <c:pt idx="340">
                  <c:v>-4.0909090909090819</c:v>
                </c:pt>
                <c:pt idx="341">
                  <c:v>-1.3636363636364659</c:v>
                </c:pt>
                <c:pt idx="342">
                  <c:v>1.4545454545453322</c:v>
                </c:pt>
                <c:pt idx="343">
                  <c:v>-1.3636363636364659</c:v>
                </c:pt>
                <c:pt idx="344">
                  <c:v>-1.3636363636364659</c:v>
                </c:pt>
                <c:pt idx="345">
                  <c:v>-7.0000000000000622</c:v>
                </c:pt>
                <c:pt idx="346">
                  <c:v>-5.5454545454547297</c:v>
                </c:pt>
                <c:pt idx="347">
                  <c:v>0</c:v>
                </c:pt>
                <c:pt idx="348">
                  <c:v>0</c:v>
                </c:pt>
                <c:pt idx="349">
                  <c:v>-5.5454545454547297</c:v>
                </c:pt>
                <c:pt idx="350">
                  <c:v>-16.636363636363559</c:v>
                </c:pt>
                <c:pt idx="351">
                  <c:v>-15.181818181818226</c:v>
                </c:pt>
                <c:pt idx="352">
                  <c:v>-8.2727272727273462</c:v>
                </c:pt>
                <c:pt idx="353">
                  <c:v>-9.7272727272726787</c:v>
                </c:pt>
                <c:pt idx="354">
                  <c:v>-11.090909090909143</c:v>
                </c:pt>
                <c:pt idx="355">
                  <c:v>-12.454545454545295</c:v>
                </c:pt>
                <c:pt idx="356">
                  <c:v>-12.454545454545295</c:v>
                </c:pt>
                <c:pt idx="357">
                  <c:v>-8.3636363636365285</c:v>
                </c:pt>
                <c:pt idx="358">
                  <c:v>-1.3636363636364659</c:v>
                </c:pt>
                <c:pt idx="359">
                  <c:v>-7.0000000000000622</c:v>
                </c:pt>
                <c:pt idx="360">
                  <c:v>-8.2727272727273462</c:v>
                </c:pt>
                <c:pt idx="361">
                  <c:v>-2.727272727272616</c:v>
                </c:pt>
                <c:pt idx="362">
                  <c:v>-6.9090909090908799</c:v>
                </c:pt>
                <c:pt idx="363">
                  <c:v>-11.090909090909143</c:v>
                </c:pt>
                <c:pt idx="364">
                  <c:v>-11.090909090908829</c:v>
                </c:pt>
                <c:pt idx="365">
                  <c:v>-11.090909090909143</c:v>
                </c:pt>
                <c:pt idx="366">
                  <c:v>-6.9090909090908799</c:v>
                </c:pt>
                <c:pt idx="367">
                  <c:v>-1.3636363636364659</c:v>
                </c:pt>
                <c:pt idx="368">
                  <c:v>-9.6363636363634964</c:v>
                </c:pt>
                <c:pt idx="369">
                  <c:v>-15.181818181818226</c:v>
                </c:pt>
                <c:pt idx="370">
                  <c:v>-22.181818181818286</c:v>
                </c:pt>
                <c:pt idx="371">
                  <c:v>-20.727272727272954</c:v>
                </c:pt>
                <c:pt idx="372">
                  <c:v>-12.454545454545295</c:v>
                </c:pt>
                <c:pt idx="373">
                  <c:v>-16.636363636363559</c:v>
                </c:pt>
                <c:pt idx="374">
                  <c:v>-11.090909090908829</c:v>
                </c:pt>
                <c:pt idx="375">
                  <c:v>-11.090909090908829</c:v>
                </c:pt>
                <c:pt idx="376">
                  <c:v>-8.3636363636362123</c:v>
                </c:pt>
                <c:pt idx="377">
                  <c:v>-16.636363636363559</c:v>
                </c:pt>
                <c:pt idx="378">
                  <c:v>-12.545454545454792</c:v>
                </c:pt>
                <c:pt idx="379">
                  <c:v>-11.090909090909143</c:v>
                </c:pt>
                <c:pt idx="380">
                  <c:v>-18.000000000000025</c:v>
                </c:pt>
                <c:pt idx="381">
                  <c:v>-18.090909090909207</c:v>
                </c:pt>
                <c:pt idx="382">
                  <c:v>-13.909090909090942</c:v>
                </c:pt>
                <c:pt idx="383">
                  <c:v>-9.7272727272726787</c:v>
                </c:pt>
                <c:pt idx="384">
                  <c:v>-13.909090909090942</c:v>
                </c:pt>
                <c:pt idx="385">
                  <c:v>-18.000000000000025</c:v>
                </c:pt>
                <c:pt idx="386">
                  <c:v>-5.5454545454547297</c:v>
                </c:pt>
                <c:pt idx="387">
                  <c:v>-5.5454545454544144</c:v>
                </c:pt>
                <c:pt idx="388">
                  <c:v>-11.090909090908829</c:v>
                </c:pt>
                <c:pt idx="389">
                  <c:v>-11.090909090909143</c:v>
                </c:pt>
                <c:pt idx="390">
                  <c:v>-9.6363636363638125</c:v>
                </c:pt>
                <c:pt idx="391">
                  <c:v>-12.454545454545295</c:v>
                </c:pt>
                <c:pt idx="392">
                  <c:v>-15.181818181818226</c:v>
                </c:pt>
                <c:pt idx="393">
                  <c:v>-13.81818181818176</c:v>
                </c:pt>
                <c:pt idx="394">
                  <c:v>-16.636363636363559</c:v>
                </c:pt>
                <c:pt idx="395">
                  <c:v>-13.81818181818176</c:v>
                </c:pt>
                <c:pt idx="396">
                  <c:v>-12.545454545454476</c:v>
                </c:pt>
                <c:pt idx="397">
                  <c:v>-12.454545454545295</c:v>
                </c:pt>
                <c:pt idx="398">
                  <c:v>-13.909090909090942</c:v>
                </c:pt>
                <c:pt idx="399">
                  <c:v>-19.363636363636491</c:v>
                </c:pt>
                <c:pt idx="400">
                  <c:v>-17.999999999999709</c:v>
                </c:pt>
                <c:pt idx="401">
                  <c:v>-12.545454545454476</c:v>
                </c:pt>
                <c:pt idx="402">
                  <c:v>-12.45454545454561</c:v>
                </c:pt>
                <c:pt idx="403">
                  <c:v>-12.545454545454476</c:v>
                </c:pt>
                <c:pt idx="404">
                  <c:v>-15.272727272727408</c:v>
                </c:pt>
                <c:pt idx="405">
                  <c:v>-15.272727272727408</c:v>
                </c:pt>
                <c:pt idx="406">
                  <c:v>-12.545454545454476</c:v>
                </c:pt>
                <c:pt idx="407">
                  <c:v>-11.090909090909143</c:v>
                </c:pt>
                <c:pt idx="408">
                  <c:v>-13.909090909090942</c:v>
                </c:pt>
                <c:pt idx="409">
                  <c:v>-9.7272727272726787</c:v>
                </c:pt>
                <c:pt idx="410">
                  <c:v>-9.7272727272729931</c:v>
                </c:pt>
                <c:pt idx="411">
                  <c:v>-15.272727272727092</c:v>
                </c:pt>
                <c:pt idx="412">
                  <c:v>-20.818181818181824</c:v>
                </c:pt>
                <c:pt idx="413">
                  <c:v>-15.272727272727408</c:v>
                </c:pt>
                <c:pt idx="414">
                  <c:v>-16.636363636363875</c:v>
                </c:pt>
                <c:pt idx="415">
                  <c:v>-13.81818181818176</c:v>
                </c:pt>
                <c:pt idx="416">
                  <c:v>-11.090909090909143</c:v>
                </c:pt>
                <c:pt idx="417">
                  <c:v>-16.636363636363559</c:v>
                </c:pt>
                <c:pt idx="418">
                  <c:v>-23.545454545454753</c:v>
                </c:pt>
                <c:pt idx="419">
                  <c:v>-19.454545454545357</c:v>
                </c:pt>
                <c:pt idx="420">
                  <c:v>-11.090909090909143</c:v>
                </c:pt>
                <c:pt idx="421">
                  <c:v>-8.2727272727273462</c:v>
                </c:pt>
                <c:pt idx="422">
                  <c:v>-2.8181818181817979</c:v>
                </c:pt>
                <c:pt idx="423">
                  <c:v>-2.8181818181817979</c:v>
                </c:pt>
                <c:pt idx="424">
                  <c:v>-5.5454545454544144</c:v>
                </c:pt>
                <c:pt idx="425">
                  <c:v>-9.7272727272726787</c:v>
                </c:pt>
                <c:pt idx="426">
                  <c:v>-12.454545454545295</c:v>
                </c:pt>
                <c:pt idx="427">
                  <c:v>-16.636363636363559</c:v>
                </c:pt>
                <c:pt idx="428">
                  <c:v>-13.909090909090942</c:v>
                </c:pt>
                <c:pt idx="429">
                  <c:v>-12.545454545454792</c:v>
                </c:pt>
                <c:pt idx="430">
                  <c:v>-11.181818181818326</c:v>
                </c:pt>
                <c:pt idx="431">
                  <c:v>-13.81818181818176</c:v>
                </c:pt>
                <c:pt idx="432">
                  <c:v>-9.7272727272726787</c:v>
                </c:pt>
                <c:pt idx="433">
                  <c:v>-16.636363636363559</c:v>
                </c:pt>
                <c:pt idx="434">
                  <c:v>-19.363636363636175</c:v>
                </c:pt>
                <c:pt idx="435">
                  <c:v>-13.909090909090942</c:v>
                </c:pt>
                <c:pt idx="436">
                  <c:v>-16.636363636363559</c:v>
                </c:pt>
                <c:pt idx="437">
                  <c:v>-26.363636363636552</c:v>
                </c:pt>
                <c:pt idx="438">
                  <c:v>-20.727272727272641</c:v>
                </c:pt>
                <c:pt idx="439">
                  <c:v>-13.909090909090626</c:v>
                </c:pt>
                <c:pt idx="440">
                  <c:v>-18.000000000000025</c:v>
                </c:pt>
                <c:pt idx="441">
                  <c:v>-15.272727272727408</c:v>
                </c:pt>
                <c:pt idx="442">
                  <c:v>-19.454545454545357</c:v>
                </c:pt>
                <c:pt idx="443">
                  <c:v>-19.45454545454567</c:v>
                </c:pt>
                <c:pt idx="444">
                  <c:v>-18.090909090908891</c:v>
                </c:pt>
                <c:pt idx="445">
                  <c:v>-20.818181818181824</c:v>
                </c:pt>
                <c:pt idx="446">
                  <c:v>-19.363636363636175</c:v>
                </c:pt>
                <c:pt idx="447">
                  <c:v>-15.272727272727408</c:v>
                </c:pt>
                <c:pt idx="448">
                  <c:v>-18.000000000000025</c:v>
                </c:pt>
                <c:pt idx="449">
                  <c:v>-25.000000000000085</c:v>
                </c:pt>
                <c:pt idx="450">
                  <c:v>-22.181818181817974</c:v>
                </c:pt>
                <c:pt idx="451">
                  <c:v>-20.818181818181824</c:v>
                </c:pt>
                <c:pt idx="452">
                  <c:v>-19.45454545454567</c:v>
                </c:pt>
                <c:pt idx="453">
                  <c:v>-19.363636363636175</c:v>
                </c:pt>
                <c:pt idx="454">
                  <c:v>-20.818181818181824</c:v>
                </c:pt>
                <c:pt idx="455">
                  <c:v>-20.818181818181824</c:v>
                </c:pt>
                <c:pt idx="456">
                  <c:v>-20.818181818181824</c:v>
                </c:pt>
                <c:pt idx="457">
                  <c:v>-18.000000000000025</c:v>
                </c:pt>
                <c:pt idx="458">
                  <c:v>-24.909090909090903</c:v>
                </c:pt>
                <c:pt idx="459">
                  <c:v>-29.181818181818034</c:v>
                </c:pt>
                <c:pt idx="460">
                  <c:v>-23.636363636363619</c:v>
                </c:pt>
                <c:pt idx="461">
                  <c:v>-22.181818181818286</c:v>
                </c:pt>
                <c:pt idx="462">
                  <c:v>-22.181818181818286</c:v>
                </c:pt>
                <c:pt idx="463">
                  <c:v>-24.909090909090903</c:v>
                </c:pt>
                <c:pt idx="464">
                  <c:v>-23.545454545454437</c:v>
                </c:pt>
                <c:pt idx="465">
                  <c:v>-25.000000000000085</c:v>
                </c:pt>
                <c:pt idx="466">
                  <c:v>-19.454545454545357</c:v>
                </c:pt>
                <c:pt idx="467">
                  <c:v>-16.636363636363559</c:v>
                </c:pt>
                <c:pt idx="468">
                  <c:v>-26.363636363636235</c:v>
                </c:pt>
                <c:pt idx="469">
                  <c:v>-22.181818181818286</c:v>
                </c:pt>
                <c:pt idx="470">
                  <c:v>-22.181818181818286</c:v>
                </c:pt>
                <c:pt idx="471">
                  <c:v>-16.636363636363559</c:v>
                </c:pt>
                <c:pt idx="472">
                  <c:v>-11.090909090909143</c:v>
                </c:pt>
                <c:pt idx="473">
                  <c:v>-13.909090909090942</c:v>
                </c:pt>
                <c:pt idx="474">
                  <c:v>-22.181818181818286</c:v>
                </c:pt>
                <c:pt idx="475">
                  <c:v>-26.363636363636235</c:v>
                </c:pt>
                <c:pt idx="476">
                  <c:v>-27.727272727272702</c:v>
                </c:pt>
                <c:pt idx="477">
                  <c:v>-18.000000000000025</c:v>
                </c:pt>
                <c:pt idx="478">
                  <c:v>-15.272727272727408</c:v>
                </c:pt>
                <c:pt idx="479">
                  <c:v>-18.000000000000025</c:v>
                </c:pt>
                <c:pt idx="480">
                  <c:v>-22.181818181817974</c:v>
                </c:pt>
                <c:pt idx="481">
                  <c:v>-19.454545454545357</c:v>
                </c:pt>
                <c:pt idx="482">
                  <c:v>-19.454545454545357</c:v>
                </c:pt>
                <c:pt idx="483">
                  <c:v>-18.000000000000025</c:v>
                </c:pt>
                <c:pt idx="484">
                  <c:v>-26.363636363636235</c:v>
                </c:pt>
                <c:pt idx="485">
                  <c:v>-24.909090909090903</c:v>
                </c:pt>
                <c:pt idx="486">
                  <c:v>-22.181818181817974</c:v>
                </c:pt>
                <c:pt idx="487">
                  <c:v>-24.909090909090903</c:v>
                </c:pt>
                <c:pt idx="488">
                  <c:v>-25.000000000000085</c:v>
                </c:pt>
                <c:pt idx="489">
                  <c:v>-18.090909090909207</c:v>
                </c:pt>
                <c:pt idx="490">
                  <c:v>-15.272727272727408</c:v>
                </c:pt>
                <c:pt idx="491">
                  <c:v>-19.363636363636175</c:v>
                </c:pt>
                <c:pt idx="492">
                  <c:v>-22.181818181818286</c:v>
                </c:pt>
                <c:pt idx="493">
                  <c:v>-19.454545454545357</c:v>
                </c:pt>
                <c:pt idx="494">
                  <c:v>-20.818181818181824</c:v>
                </c:pt>
                <c:pt idx="495">
                  <c:v>-23.545454545454437</c:v>
                </c:pt>
                <c:pt idx="496">
                  <c:v>-20.818181818181824</c:v>
                </c:pt>
                <c:pt idx="497">
                  <c:v>-20.818181818181824</c:v>
                </c:pt>
                <c:pt idx="498">
                  <c:v>-22.181818181818286</c:v>
                </c:pt>
                <c:pt idx="499">
                  <c:v>-16.636363636363559</c:v>
                </c:pt>
                <c:pt idx="500">
                  <c:v>-12.545454545454476</c:v>
                </c:pt>
                <c:pt idx="501">
                  <c:v>-8.27272727272703</c:v>
                </c:pt>
                <c:pt idx="502">
                  <c:v>-16.636363636363559</c:v>
                </c:pt>
                <c:pt idx="503">
                  <c:v>-19.454545454545357</c:v>
                </c:pt>
                <c:pt idx="504">
                  <c:v>-18.000000000000025</c:v>
                </c:pt>
                <c:pt idx="505">
                  <c:v>-19.454545454545357</c:v>
                </c:pt>
                <c:pt idx="506">
                  <c:v>-22.181818181818286</c:v>
                </c:pt>
                <c:pt idx="507">
                  <c:v>-25.000000000000085</c:v>
                </c:pt>
                <c:pt idx="508">
                  <c:v>-26.363636363636235</c:v>
                </c:pt>
                <c:pt idx="509">
                  <c:v>-23.545454545454437</c:v>
                </c:pt>
                <c:pt idx="510">
                  <c:v>-22.181818181818286</c:v>
                </c:pt>
              </c:numCache>
            </c:numRef>
          </c:yVal>
          <c:smooth val="1"/>
          <c:extLst>
            <c:ext xmlns:c16="http://schemas.microsoft.com/office/drawing/2014/chart" uri="{C3380CC4-5D6E-409C-BE32-E72D297353CC}">
              <c16:uniqueId val="{00000000-68A7-4DE5-8936-8121E83ED32B}"/>
            </c:ext>
          </c:extLst>
        </c:ser>
        <c:dLbls>
          <c:showLegendKey val="0"/>
          <c:showVal val="0"/>
          <c:showCatName val="0"/>
          <c:showSerName val="0"/>
          <c:showPercent val="0"/>
          <c:showBubbleSize val="0"/>
        </c:dLbls>
        <c:axId val="95521664"/>
        <c:axId val="95523344"/>
      </c:scatterChart>
      <c:valAx>
        <c:axId val="95521664"/>
        <c:scaling>
          <c:orientation val="minMax"/>
          <c:max val="700"/>
          <c:min val="265"/>
        </c:scaling>
        <c:delete val="0"/>
        <c:axPos val="b"/>
        <c:title>
          <c:tx>
            <c:rich>
              <a:bodyPr/>
              <a:lstStyle/>
              <a:p>
                <a:pPr>
                  <a:defRPr/>
                </a:pPr>
                <a:r>
                  <a:rPr lang="en-GB"/>
                  <a:t>Wavelength (nm)</a:t>
                </a:r>
              </a:p>
            </c:rich>
          </c:tx>
          <c:layout/>
          <c:overlay val="0"/>
        </c:title>
        <c:numFmt formatCode="General" sourceLinked="1"/>
        <c:majorTickMark val="out"/>
        <c:minorTickMark val="none"/>
        <c:tickLblPos val="nextTo"/>
        <c:crossAx val="95523344"/>
        <c:crosses val="autoZero"/>
        <c:crossBetween val="midCat"/>
      </c:valAx>
      <c:valAx>
        <c:axId val="95523344"/>
        <c:scaling>
          <c:orientation val="minMax"/>
          <c:max val="37000"/>
          <c:min val="0"/>
        </c:scaling>
        <c:delete val="0"/>
        <c:axPos val="l"/>
        <c:title>
          <c:tx>
            <c:rich>
              <a:bodyPr rot="-5400000" vert="horz"/>
              <a:lstStyle/>
              <a:p>
                <a:pPr>
                  <a:defRPr/>
                </a:pPr>
                <a:r>
                  <a:rPr lang="el-GR" sz="1000" b="1" i="0" u="none" strike="noStrike" baseline="0">
                    <a:effectLst/>
                  </a:rPr>
                  <a:t>ε</a:t>
                </a:r>
                <a:r>
                  <a:rPr lang="en-GB" sz="1000" b="1" i="0" u="none" strike="noStrike" baseline="0">
                    <a:effectLst/>
                  </a:rPr>
                  <a:t> (M</a:t>
                </a:r>
                <a:r>
                  <a:rPr lang="en-GB" sz="1000" b="1" i="0" u="none" strike="noStrike" baseline="30000">
                    <a:effectLst/>
                  </a:rPr>
                  <a:t>−1</a:t>
                </a:r>
                <a:r>
                  <a:rPr lang="en-GB" sz="1000" b="1" i="0" u="none" strike="noStrike" baseline="0">
                    <a:effectLst/>
                  </a:rPr>
                  <a:t>⋅cm</a:t>
                </a:r>
                <a:r>
                  <a:rPr lang="en-GB" sz="1000" b="1" i="0" u="none" strike="noStrike" baseline="30000">
                    <a:effectLst/>
                  </a:rPr>
                  <a:t>−1</a:t>
                </a:r>
                <a:r>
                  <a:rPr lang="en-GB" sz="1000" b="1" i="0" u="none" strike="noStrike" baseline="0">
                    <a:effectLst/>
                  </a:rPr>
                  <a:t>) </a:t>
                </a:r>
                <a:endParaRPr lang="en-GB" b="1"/>
              </a:p>
            </c:rich>
          </c:tx>
          <c:layout/>
          <c:overlay val="0"/>
        </c:title>
        <c:numFmt formatCode="General" sourceLinked="1"/>
        <c:majorTickMark val="out"/>
        <c:minorTickMark val="none"/>
        <c:tickLblPos val="nextTo"/>
        <c:crossAx val="95521664"/>
        <c:crosses val="autoZero"/>
        <c:crossBetween val="midCat"/>
      </c:valAx>
    </c:plotArea>
    <c:plotVisOnly val="1"/>
    <c:dispBlanksAs val="gap"/>
    <c:showDLblsOverMax val="0"/>
  </c:chart>
  <c:spPr>
    <a:noFill/>
    <a:ln>
      <a:noFill/>
    </a:ln>
  </c:spPr>
  <c:externalData r:id="rId1">
    <c:autoUpdate val="0"/>
  </c:externalData>
</c:chartSpace>
</file>

<file path=ppt/charts/chart10.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Sheet1!$J$1</c:f>
              <c:strCache>
                <c:ptCount val="1"/>
                <c:pt idx="0">
                  <c:v>INK128 with DMSO</c:v>
                </c:pt>
              </c:strCache>
            </c:strRef>
          </c:tx>
          <c:spPr>
            <a:ln>
              <a:solidFill>
                <a:schemeClr val="tx1"/>
              </a:solidFill>
            </a:ln>
          </c:spPr>
          <c:marker>
            <c:symbol val="none"/>
          </c:marker>
          <c:xVal>
            <c:numRef>
              <c:f>Sheet1!$I$3:$I$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N$3:$N$513</c:f>
              <c:numCache>
                <c:formatCode>General</c:formatCode>
                <c:ptCount val="511"/>
                <c:pt idx="0">
                  <c:v>-0.10556000000000035</c:v>
                </c:pt>
                <c:pt idx="1">
                  <c:v>-4.0435000000000255E-2</c:v>
                </c:pt>
                <c:pt idx="2">
                  <c:v>0.31459099999999979</c:v>
                </c:pt>
                <c:pt idx="3">
                  <c:v>6.2607000000000051E-2</c:v>
                </c:pt>
                <c:pt idx="4">
                  <c:v>5.8090999999999858E-2</c:v>
                </c:pt>
                <c:pt idx="5">
                  <c:v>-0.10047899999999979</c:v>
                </c:pt>
                <c:pt idx="6">
                  <c:v>-0.1878650000000002</c:v>
                </c:pt>
                <c:pt idx="7">
                  <c:v>-0.15695100000000009</c:v>
                </c:pt>
                <c:pt idx="8">
                  <c:v>-2.2414999999999886E-2</c:v>
                </c:pt>
                <c:pt idx="9">
                  <c:v>-4.4234999999999837E-2</c:v>
                </c:pt>
                <c:pt idx="10">
                  <c:v>1.6327000000000168E-2</c:v>
                </c:pt>
                <c:pt idx="11">
                  <c:v>-2.8396000000000123E-2</c:v>
                </c:pt>
                <c:pt idx="12">
                  <c:v>-8.3952999999999972E-2</c:v>
                </c:pt>
                <c:pt idx="13">
                  <c:v>-4.3015000000000282E-2</c:v>
                </c:pt>
                <c:pt idx="14">
                  <c:v>-0.125335</c:v>
                </c:pt>
                <c:pt idx="15">
                  <c:v>-5.7448999999999896E-2</c:v>
                </c:pt>
                <c:pt idx="16">
                  <c:v>-2.5893999999999896E-2</c:v>
                </c:pt>
                <c:pt idx="17">
                  <c:v>-4.4005999999999802E-2</c:v>
                </c:pt>
                <c:pt idx="18">
                  <c:v>-2.0507999999999783E-2</c:v>
                </c:pt>
                <c:pt idx="19">
                  <c:v>-1.9835999999999999E-2</c:v>
                </c:pt>
                <c:pt idx="20">
                  <c:v>-6.2133000000000028E-2</c:v>
                </c:pt>
                <c:pt idx="21">
                  <c:v>-1.072600000000027E-2</c:v>
                </c:pt>
                <c:pt idx="22">
                  <c:v>-0.14976500000000018</c:v>
                </c:pt>
                <c:pt idx="23">
                  <c:v>-3.9153999999999724E-2</c:v>
                </c:pt>
                <c:pt idx="24">
                  <c:v>0.17399699999999971</c:v>
                </c:pt>
                <c:pt idx="25">
                  <c:v>3.1234999999999867E-2</c:v>
                </c:pt>
                <c:pt idx="26">
                  <c:v>-0.13952600000000029</c:v>
                </c:pt>
                <c:pt idx="27">
                  <c:v>-4.699699999999999E-2</c:v>
                </c:pt>
                <c:pt idx="28">
                  <c:v>-8.4808000000000022E-2</c:v>
                </c:pt>
                <c:pt idx="29">
                  <c:v>-3.8528000000000152E-2</c:v>
                </c:pt>
                <c:pt idx="30">
                  <c:v>-9.8556000000000116E-2</c:v>
                </c:pt>
                <c:pt idx="31">
                  <c:v>-4.2259999999998757E-3</c:v>
                </c:pt>
                <c:pt idx="32">
                  <c:v>3.6987999999999764E-2</c:v>
                </c:pt>
                <c:pt idx="33">
                  <c:v>-4.8080000000000379E-2</c:v>
                </c:pt>
                <c:pt idx="34">
                  <c:v>-3.0014000000000242E-2</c:v>
                </c:pt>
                <c:pt idx="35">
                  <c:v>4.7821999999999774E-2</c:v>
                </c:pt>
                <c:pt idx="36">
                  <c:v>2.3758999999999829E-2</c:v>
                </c:pt>
                <c:pt idx="37">
                  <c:v>3.5476999999999946E-2</c:v>
                </c:pt>
                <c:pt idx="38">
                  <c:v>-1.2343999999999945E-2</c:v>
                </c:pt>
                <c:pt idx="39">
                  <c:v>-3.4439000000000143E-2</c:v>
                </c:pt>
                <c:pt idx="40">
                  <c:v>-1.2939000000000069E-2</c:v>
                </c:pt>
                <c:pt idx="41">
                  <c:v>-6.2860000000000485E-3</c:v>
                </c:pt>
                <c:pt idx="42">
                  <c:v>1.6266000000000079E-2</c:v>
                </c:pt>
                <c:pt idx="43">
                  <c:v>3.7963999999999852E-2</c:v>
                </c:pt>
                <c:pt idx="44">
                  <c:v>3.0411000000000153E-2</c:v>
                </c:pt>
                <c:pt idx="45">
                  <c:v>-5.4160000000001221E-3</c:v>
                </c:pt>
                <c:pt idx="46">
                  <c:v>-3.2286999999999989E-2</c:v>
                </c:pt>
                <c:pt idx="47">
                  <c:v>-2.1895999999999728E-2</c:v>
                </c:pt>
                <c:pt idx="48">
                  <c:v>-5.0598000000000178E-2</c:v>
                </c:pt>
                <c:pt idx="49">
                  <c:v>4.9362999999999789E-2</c:v>
                </c:pt>
                <c:pt idx="50">
                  <c:v>-9.2769999999997924E-3</c:v>
                </c:pt>
                <c:pt idx="51">
                  <c:v>-4.8292999999999954E-2</c:v>
                </c:pt>
                <c:pt idx="52">
                  <c:v>7.3300000000005999E-4</c:v>
                </c:pt>
                <c:pt idx="53">
                  <c:v>-6.7153000000000046E-2</c:v>
                </c:pt>
                <c:pt idx="54">
                  <c:v>-2.8854000000000192E-2</c:v>
                </c:pt>
                <c:pt idx="55">
                  <c:v>-1.7273000000000129E-2</c:v>
                </c:pt>
                <c:pt idx="56">
                  <c:v>-1.5609000000000241E-2</c:v>
                </c:pt>
                <c:pt idx="57">
                  <c:v>4.6158000000000331E-2</c:v>
                </c:pt>
                <c:pt idx="58">
                  <c:v>8.6830000000001836E-3</c:v>
                </c:pt>
                <c:pt idx="59">
                  <c:v>1.3016000000000104E-2</c:v>
                </c:pt>
                <c:pt idx="60">
                  <c:v>-0.16210900000000031</c:v>
                </c:pt>
                <c:pt idx="61">
                  <c:v>8.2250000000001142E-3</c:v>
                </c:pt>
                <c:pt idx="62">
                  <c:v>7.7927000000000052E-2</c:v>
                </c:pt>
                <c:pt idx="63">
                  <c:v>-3.5309000000000069E-2</c:v>
                </c:pt>
                <c:pt idx="64">
                  <c:v>1.2670000000000944E-3</c:v>
                </c:pt>
                <c:pt idx="65">
                  <c:v>0.33378700000000022</c:v>
                </c:pt>
                <c:pt idx="66">
                  <c:v>0.3923799999999999</c:v>
                </c:pt>
                <c:pt idx="67">
                  <c:v>0.42266899999999968</c:v>
                </c:pt>
                <c:pt idx="68">
                  <c:v>0.39964299999999991</c:v>
                </c:pt>
                <c:pt idx="69">
                  <c:v>0.39343300000000009</c:v>
                </c:pt>
                <c:pt idx="70">
                  <c:v>0.38905299999999982</c:v>
                </c:pt>
                <c:pt idx="71">
                  <c:v>0.37793000000000004</c:v>
                </c:pt>
                <c:pt idx="72">
                  <c:v>0.36845500000000014</c:v>
                </c:pt>
                <c:pt idx="73">
                  <c:v>0.35806300000000008</c:v>
                </c:pt>
                <c:pt idx="74">
                  <c:v>0.34901499999999991</c:v>
                </c:pt>
                <c:pt idx="75">
                  <c:v>0.340057</c:v>
                </c:pt>
                <c:pt idx="76">
                  <c:v>0.32937600000000006</c:v>
                </c:pt>
                <c:pt idx="77">
                  <c:v>0.31909199999999999</c:v>
                </c:pt>
                <c:pt idx="78">
                  <c:v>0.30880800000000003</c:v>
                </c:pt>
                <c:pt idx="79">
                  <c:v>0.298097</c:v>
                </c:pt>
                <c:pt idx="80">
                  <c:v>0.28874299999999997</c:v>
                </c:pt>
                <c:pt idx="81">
                  <c:v>0.27922100000000005</c:v>
                </c:pt>
                <c:pt idx="82">
                  <c:v>0.270874</c:v>
                </c:pt>
                <c:pt idx="83">
                  <c:v>0.26362699999999994</c:v>
                </c:pt>
                <c:pt idx="84">
                  <c:v>0.25666800000000001</c:v>
                </c:pt>
                <c:pt idx="85">
                  <c:v>0.25097700000000001</c:v>
                </c:pt>
                <c:pt idx="86">
                  <c:v>0.24627700000000005</c:v>
                </c:pt>
                <c:pt idx="87">
                  <c:v>0.24238600000000002</c:v>
                </c:pt>
                <c:pt idx="88">
                  <c:v>0.24009699999999998</c:v>
                </c:pt>
                <c:pt idx="89">
                  <c:v>0.23924300000000001</c:v>
                </c:pt>
                <c:pt idx="90">
                  <c:v>0.24031100000000002</c:v>
                </c:pt>
                <c:pt idx="91">
                  <c:v>0.24220400000000006</c:v>
                </c:pt>
                <c:pt idx="92">
                  <c:v>0.24566700000000005</c:v>
                </c:pt>
                <c:pt idx="93">
                  <c:v>0.24987800000000002</c:v>
                </c:pt>
                <c:pt idx="94">
                  <c:v>0.25549300000000003</c:v>
                </c:pt>
                <c:pt idx="95">
                  <c:v>0.26133800000000001</c:v>
                </c:pt>
                <c:pt idx="96">
                  <c:v>0.26783799999999996</c:v>
                </c:pt>
                <c:pt idx="97">
                  <c:v>0.273789</c:v>
                </c:pt>
                <c:pt idx="98">
                  <c:v>0.27957199999999999</c:v>
                </c:pt>
                <c:pt idx="99">
                  <c:v>0.28424199999999999</c:v>
                </c:pt>
                <c:pt idx="100">
                  <c:v>0.28820799999999996</c:v>
                </c:pt>
                <c:pt idx="101">
                  <c:v>0.29168699999999997</c:v>
                </c:pt>
                <c:pt idx="102">
                  <c:v>0.29542499999999999</c:v>
                </c:pt>
                <c:pt idx="103">
                  <c:v>0.29943900000000001</c:v>
                </c:pt>
                <c:pt idx="104">
                  <c:v>0.30255199999999999</c:v>
                </c:pt>
                <c:pt idx="105">
                  <c:v>0.29103099999999998</c:v>
                </c:pt>
                <c:pt idx="106">
                  <c:v>0.27525399999999994</c:v>
                </c:pt>
                <c:pt idx="107">
                  <c:v>0.27062999999999998</c:v>
                </c:pt>
                <c:pt idx="108">
                  <c:v>0.26570199999999994</c:v>
                </c:pt>
                <c:pt idx="109">
                  <c:v>0.25660699999999997</c:v>
                </c:pt>
                <c:pt idx="110">
                  <c:v>0.24696399999999999</c:v>
                </c:pt>
                <c:pt idx="111">
                  <c:v>0.23812900000000001</c:v>
                </c:pt>
                <c:pt idx="112">
                  <c:v>0.23350500000000005</c:v>
                </c:pt>
                <c:pt idx="113">
                  <c:v>0.22424400000000003</c:v>
                </c:pt>
                <c:pt idx="114">
                  <c:v>0.216309</c:v>
                </c:pt>
                <c:pt idx="115">
                  <c:v>0.20846599999999998</c:v>
                </c:pt>
                <c:pt idx="116">
                  <c:v>0.20692500000000003</c:v>
                </c:pt>
                <c:pt idx="117">
                  <c:v>0.19825800000000002</c:v>
                </c:pt>
                <c:pt idx="118">
                  <c:v>0.18634100000000001</c:v>
                </c:pt>
                <c:pt idx="119">
                  <c:v>0.176423</c:v>
                </c:pt>
                <c:pt idx="120">
                  <c:v>0.16699300000000003</c:v>
                </c:pt>
                <c:pt idx="121">
                  <c:v>0.15525900000000001</c:v>
                </c:pt>
                <c:pt idx="122">
                  <c:v>0.14575199999999999</c:v>
                </c:pt>
                <c:pt idx="123">
                  <c:v>0.13395799999999999</c:v>
                </c:pt>
                <c:pt idx="124">
                  <c:v>0.12345999999999999</c:v>
                </c:pt>
                <c:pt idx="125">
                  <c:v>0.11190800000000001</c:v>
                </c:pt>
                <c:pt idx="126">
                  <c:v>0.10119700000000001</c:v>
                </c:pt>
                <c:pt idx="127">
                  <c:v>8.9904999999999985E-2</c:v>
                </c:pt>
                <c:pt idx="128">
                  <c:v>8.1252999999999992E-2</c:v>
                </c:pt>
                <c:pt idx="129">
                  <c:v>7.142699999999999E-2</c:v>
                </c:pt>
                <c:pt idx="130">
                  <c:v>6.2730000000000008E-2</c:v>
                </c:pt>
                <c:pt idx="131">
                  <c:v>5.4658000000000005E-2</c:v>
                </c:pt>
                <c:pt idx="132">
                  <c:v>4.7393999999999999E-2</c:v>
                </c:pt>
                <c:pt idx="133">
                  <c:v>4.0818E-2</c:v>
                </c:pt>
                <c:pt idx="134">
                  <c:v>3.5371000000000007E-2</c:v>
                </c:pt>
                <c:pt idx="135">
                  <c:v>2.9922999999999998E-2</c:v>
                </c:pt>
                <c:pt idx="136">
                  <c:v>2.4323000000000004E-2</c:v>
                </c:pt>
                <c:pt idx="137">
                  <c:v>2.1775000000000003E-2</c:v>
                </c:pt>
                <c:pt idx="138">
                  <c:v>1.8464000000000001E-2</c:v>
                </c:pt>
                <c:pt idx="139">
                  <c:v>1.5931000000000001E-2</c:v>
                </c:pt>
                <c:pt idx="140">
                  <c:v>1.3749000000000004E-2</c:v>
                </c:pt>
                <c:pt idx="141">
                  <c:v>1.2161999999999999E-2</c:v>
                </c:pt>
                <c:pt idx="142">
                  <c:v>1.0529E-2</c:v>
                </c:pt>
                <c:pt idx="143">
                  <c:v>9.11E-3</c:v>
                </c:pt>
                <c:pt idx="144">
                  <c:v>8.4229999999999999E-3</c:v>
                </c:pt>
                <c:pt idx="145">
                  <c:v>7.9959999999999996E-3</c:v>
                </c:pt>
                <c:pt idx="146">
                  <c:v>7.4779999999999985E-3</c:v>
                </c:pt>
                <c:pt idx="147">
                  <c:v>7.2030000000000011E-3</c:v>
                </c:pt>
                <c:pt idx="148">
                  <c:v>6.8970000000000004E-3</c:v>
                </c:pt>
                <c:pt idx="149">
                  <c:v>6.241E-3</c:v>
                </c:pt>
                <c:pt idx="150">
                  <c:v>5.7829999999999999E-3</c:v>
                </c:pt>
                <c:pt idx="151">
                  <c:v>4.8520000000000021E-3</c:v>
                </c:pt>
                <c:pt idx="152">
                  <c:v>4.4709999999999993E-3</c:v>
                </c:pt>
                <c:pt idx="153">
                  <c:v>3.3430000000000022E-3</c:v>
                </c:pt>
                <c:pt idx="154">
                  <c:v>3.311999999999999E-3</c:v>
                </c:pt>
                <c:pt idx="155">
                  <c:v>2.578999999999998E-3</c:v>
                </c:pt>
                <c:pt idx="156">
                  <c:v>2.1979999999999986E-3</c:v>
                </c:pt>
                <c:pt idx="157">
                  <c:v>1.8619999999999991E-3</c:v>
                </c:pt>
                <c:pt idx="158">
                  <c:v>1.5419999999999982E-3</c:v>
                </c:pt>
                <c:pt idx="159">
                  <c:v>8.6999999999999925E-4</c:v>
                </c:pt>
                <c:pt idx="160">
                  <c:v>1.3129999999999982E-3</c:v>
                </c:pt>
                <c:pt idx="161">
                  <c:v>1.236000000000001E-3</c:v>
                </c:pt>
                <c:pt idx="162">
                  <c:v>7.4800000000000214E-4</c:v>
                </c:pt>
                <c:pt idx="163">
                  <c:v>1.0830000000000006E-3</c:v>
                </c:pt>
                <c:pt idx="164">
                  <c:v>7.7900000000000191E-4</c:v>
                </c:pt>
                <c:pt idx="165">
                  <c:v>5.3399999999999975E-4</c:v>
                </c:pt>
                <c:pt idx="166">
                  <c:v>5.65000000000003E-4</c:v>
                </c:pt>
                <c:pt idx="167">
                  <c:v>2.5999999999999981E-4</c:v>
                </c:pt>
                <c:pt idx="168">
                  <c:v>3.5100000000000409E-4</c:v>
                </c:pt>
                <c:pt idx="169">
                  <c:v>1.9800000000000026E-4</c:v>
                </c:pt>
                <c:pt idx="170">
                  <c:v>1.2300000000000158E-4</c:v>
                </c:pt>
                <c:pt idx="171">
                  <c:v>1.9899999999999779E-4</c:v>
                </c:pt>
                <c:pt idx="172">
                  <c:v>1.6000000000002124E-5</c:v>
                </c:pt>
                <c:pt idx="173">
                  <c:v>1.2200000000000058E-4</c:v>
                </c:pt>
                <c:pt idx="174">
                  <c:v>-1.9800000000000026E-4</c:v>
                </c:pt>
                <c:pt idx="175">
                  <c:v>3.8200000000000039E-4</c:v>
                </c:pt>
                <c:pt idx="176">
                  <c:v>8.2400000000000181E-4</c:v>
                </c:pt>
                <c:pt idx="177">
                  <c:v>7.7899999999999844E-4</c:v>
                </c:pt>
                <c:pt idx="178">
                  <c:v>7.0300000000000223E-4</c:v>
                </c:pt>
                <c:pt idx="179">
                  <c:v>2.9099999999999959E-4</c:v>
                </c:pt>
                <c:pt idx="180">
                  <c:v>5.5000000000000188E-4</c:v>
                </c:pt>
                <c:pt idx="181">
                  <c:v>3.8200000000000039E-4</c:v>
                </c:pt>
                <c:pt idx="182">
                  <c:v>4.5900000000000107E-4</c:v>
                </c:pt>
                <c:pt idx="183">
                  <c:v>3.6699999999999927E-4</c:v>
                </c:pt>
                <c:pt idx="184">
                  <c:v>1.8399999999999667E-4</c:v>
                </c:pt>
                <c:pt idx="185">
                  <c:v>-1.3699999999999823E-4</c:v>
                </c:pt>
                <c:pt idx="186">
                  <c:v>-2.5900000000000228E-4</c:v>
                </c:pt>
                <c:pt idx="187">
                  <c:v>-2.1299999999999791E-4</c:v>
                </c:pt>
                <c:pt idx="188">
                  <c:v>-2.2900000000000004E-4</c:v>
                </c:pt>
                <c:pt idx="189">
                  <c:v>-4.720000000000002E-4</c:v>
                </c:pt>
                <c:pt idx="190">
                  <c:v>-1.9799999999999679E-4</c:v>
                </c:pt>
                <c:pt idx="191">
                  <c:v>-3.2000000000000084E-4</c:v>
                </c:pt>
                <c:pt idx="192">
                  <c:v>-6.4100000000000268E-4</c:v>
                </c:pt>
                <c:pt idx="193">
                  <c:v>-6.0899999999999843E-4</c:v>
                </c:pt>
                <c:pt idx="194">
                  <c:v>-5.9499999999999831E-4</c:v>
                </c:pt>
                <c:pt idx="195">
                  <c:v>-7.6199999999999879E-4</c:v>
                </c:pt>
                <c:pt idx="196">
                  <c:v>-8.0799999999999969E-4</c:v>
                </c:pt>
                <c:pt idx="197">
                  <c:v>-8.0799999999999969E-4</c:v>
                </c:pt>
                <c:pt idx="198">
                  <c:v>-6.0999999999999943E-4</c:v>
                </c:pt>
                <c:pt idx="199">
                  <c:v>-8.2299999999999734E-4</c:v>
                </c:pt>
                <c:pt idx="200">
                  <c:v>-6.8700000000000011E-4</c:v>
                </c:pt>
                <c:pt idx="201">
                  <c:v>-6.5600000000000033E-4</c:v>
                </c:pt>
                <c:pt idx="202">
                  <c:v>-7.1699999999999889E-4</c:v>
                </c:pt>
                <c:pt idx="203">
                  <c:v>-8.2300000000000081E-4</c:v>
                </c:pt>
                <c:pt idx="204">
                  <c:v>-9.4500000000000139E-4</c:v>
                </c:pt>
                <c:pt idx="205">
                  <c:v>-9.6100000000000005E-4</c:v>
                </c:pt>
                <c:pt idx="206">
                  <c:v>-9.9099999999999883E-4</c:v>
                </c:pt>
                <c:pt idx="207">
                  <c:v>-9.3100000000000127E-4</c:v>
                </c:pt>
                <c:pt idx="208">
                  <c:v>-7.9300000000000204E-4</c:v>
                </c:pt>
                <c:pt idx="209">
                  <c:v>-8.6899999999999825E-4</c:v>
                </c:pt>
                <c:pt idx="210">
                  <c:v>-7.6299999999999979E-4</c:v>
                </c:pt>
                <c:pt idx="211">
                  <c:v>-7.6199999999999879E-4</c:v>
                </c:pt>
                <c:pt idx="212">
                  <c:v>-7.4799999999999867E-4</c:v>
                </c:pt>
                <c:pt idx="213">
                  <c:v>-6.7099999999999799E-4</c:v>
                </c:pt>
                <c:pt idx="214">
                  <c:v>-6.0999999999999943E-4</c:v>
                </c:pt>
                <c:pt idx="215">
                  <c:v>-6.7099999999999799E-4</c:v>
                </c:pt>
                <c:pt idx="216">
                  <c:v>-6.7099999999999799E-4</c:v>
                </c:pt>
                <c:pt idx="217">
                  <c:v>-5.9499999999999831E-4</c:v>
                </c:pt>
                <c:pt idx="218">
                  <c:v>-3.4999999999999615E-4</c:v>
                </c:pt>
                <c:pt idx="219">
                  <c:v>-4.8800000000000232E-4</c:v>
                </c:pt>
                <c:pt idx="220">
                  <c:v>-5.0299999999999997E-4</c:v>
                </c:pt>
                <c:pt idx="221">
                  <c:v>-3.9700000000000152E-4</c:v>
                </c:pt>
                <c:pt idx="222">
                  <c:v>-4.119999999999957E-4</c:v>
                </c:pt>
                <c:pt idx="223">
                  <c:v>-3.6599999999999827E-4</c:v>
                </c:pt>
                <c:pt idx="224">
                  <c:v>-3.3500000000000196E-4</c:v>
                </c:pt>
                <c:pt idx="225">
                  <c:v>-4.5800000000000007E-4</c:v>
                </c:pt>
                <c:pt idx="226">
                  <c:v>-4.4199999999999795E-4</c:v>
                </c:pt>
                <c:pt idx="227">
                  <c:v>-4.720000000000002E-4</c:v>
                </c:pt>
                <c:pt idx="228">
                  <c:v>-3.8099999999999939E-4</c:v>
                </c:pt>
                <c:pt idx="229">
                  <c:v>-3.0499999999999972E-4</c:v>
                </c:pt>
                <c:pt idx="230">
                  <c:v>-3.6599999999999827E-4</c:v>
                </c:pt>
                <c:pt idx="231">
                  <c:v>-2.7399999999999994E-4</c:v>
                </c:pt>
                <c:pt idx="232">
                  <c:v>-2.7399999999999647E-4</c:v>
                </c:pt>
                <c:pt idx="233">
                  <c:v>-2.7399999999999647E-4</c:v>
                </c:pt>
                <c:pt idx="234">
                  <c:v>-2.4400000000000116E-4</c:v>
                </c:pt>
                <c:pt idx="235">
                  <c:v>-2.1399999999999891E-4</c:v>
                </c:pt>
                <c:pt idx="236">
                  <c:v>-9.1000000000000802E-5</c:v>
                </c:pt>
                <c:pt idx="237">
                  <c:v>-9.1000000000000802E-5</c:v>
                </c:pt>
                <c:pt idx="238">
                  <c:v>-9.1000000000000802E-5</c:v>
                </c:pt>
                <c:pt idx="239">
                  <c:v>-1.3699999999999823E-4</c:v>
                </c:pt>
                <c:pt idx="240">
                  <c:v>-1.5199999999999936E-4</c:v>
                </c:pt>
                <c:pt idx="241">
                  <c:v>-4.4999999999999901E-5</c:v>
                </c:pt>
                <c:pt idx="242">
                  <c:v>-9.1000000000000802E-5</c:v>
                </c:pt>
                <c:pt idx="243">
                  <c:v>-1.0600000000000193E-4</c:v>
                </c:pt>
                <c:pt idx="244">
                  <c:v>-1.0600000000000193E-4</c:v>
                </c:pt>
                <c:pt idx="245">
                  <c:v>-9.1000000000000802E-5</c:v>
                </c:pt>
                <c:pt idx="246">
                  <c:v>1.0000000000010001E-6</c:v>
                </c:pt>
                <c:pt idx="247">
                  <c:v>3.1000000000003247E-5</c:v>
                </c:pt>
                <c:pt idx="248">
                  <c:v>6.1999999999999555E-5</c:v>
                </c:pt>
                <c:pt idx="249">
                  <c:v>1.5999999999998654E-5</c:v>
                </c:pt>
                <c:pt idx="250">
                  <c:v>3.1000000000003247E-5</c:v>
                </c:pt>
                <c:pt idx="251">
                  <c:v>1.0700000000000293E-4</c:v>
                </c:pt>
                <c:pt idx="252">
                  <c:v>1.8300000000000261E-4</c:v>
                </c:pt>
                <c:pt idx="253">
                  <c:v>1.8400000000000361E-4</c:v>
                </c:pt>
                <c:pt idx="254">
                  <c:v>1.5300000000000036E-4</c:v>
                </c:pt>
                <c:pt idx="255">
                  <c:v>1.8400000000000014E-4</c:v>
                </c:pt>
                <c:pt idx="256">
                  <c:v>3.6600000000000174E-4</c:v>
                </c:pt>
                <c:pt idx="257">
                  <c:v>4.4299999999999895E-4</c:v>
                </c:pt>
                <c:pt idx="258">
                  <c:v>3.5199999999999815E-4</c:v>
                </c:pt>
                <c:pt idx="259">
                  <c:v>4.740000000000022E-4</c:v>
                </c:pt>
                <c:pt idx="260">
                  <c:v>5.3500000000000075E-4</c:v>
                </c:pt>
                <c:pt idx="261">
                  <c:v>6.2600000000000156E-4</c:v>
                </c:pt>
                <c:pt idx="262">
                  <c:v>7.1800000000000336E-4</c:v>
                </c:pt>
                <c:pt idx="263">
                  <c:v>6.5599999999999686E-4</c:v>
                </c:pt>
                <c:pt idx="264">
                  <c:v>7.1799999999999989E-4</c:v>
                </c:pt>
                <c:pt idx="265">
                  <c:v>9.1600000000000015E-4</c:v>
                </c:pt>
                <c:pt idx="266">
                  <c:v>9.9199999999999983E-4</c:v>
                </c:pt>
                <c:pt idx="267">
                  <c:v>9.6199999999999758E-4</c:v>
                </c:pt>
                <c:pt idx="268">
                  <c:v>1.0379999999999973E-3</c:v>
                </c:pt>
                <c:pt idx="269">
                  <c:v>1.0530000000000019E-3</c:v>
                </c:pt>
                <c:pt idx="270">
                  <c:v>9.9199999999999983E-4</c:v>
                </c:pt>
                <c:pt idx="271">
                  <c:v>1.0219999999999986E-3</c:v>
                </c:pt>
                <c:pt idx="272">
                  <c:v>1.0380000000000007E-3</c:v>
                </c:pt>
                <c:pt idx="273">
                  <c:v>1.0379999999999973E-3</c:v>
                </c:pt>
                <c:pt idx="274">
                  <c:v>1.0530000000000019E-3</c:v>
                </c:pt>
                <c:pt idx="275">
                  <c:v>1.0220000000000021E-3</c:v>
                </c:pt>
                <c:pt idx="276">
                  <c:v>1.0070000000000009E-3</c:v>
                </c:pt>
                <c:pt idx="277">
                  <c:v>1.1000000000000038E-3</c:v>
                </c:pt>
                <c:pt idx="278">
                  <c:v>1.1909999999999976E-3</c:v>
                </c:pt>
                <c:pt idx="279">
                  <c:v>1.2059999999999987E-3</c:v>
                </c:pt>
                <c:pt idx="280">
                  <c:v>1.2659999999999998E-3</c:v>
                </c:pt>
                <c:pt idx="281">
                  <c:v>1.2969999999999995E-3</c:v>
                </c:pt>
                <c:pt idx="282">
                  <c:v>1.297000000000003E-3</c:v>
                </c:pt>
                <c:pt idx="283">
                  <c:v>1.3430000000000039E-3</c:v>
                </c:pt>
                <c:pt idx="284">
                  <c:v>1.405E-3</c:v>
                </c:pt>
                <c:pt idx="285">
                  <c:v>1.5109999999999985E-3</c:v>
                </c:pt>
                <c:pt idx="286">
                  <c:v>1.6330000000000025E-3</c:v>
                </c:pt>
                <c:pt idx="287">
                  <c:v>1.8159999999999982E-3</c:v>
                </c:pt>
                <c:pt idx="288">
                  <c:v>1.969000000000002E-3</c:v>
                </c:pt>
                <c:pt idx="289">
                  <c:v>2.1060000000000002E-3</c:v>
                </c:pt>
                <c:pt idx="290">
                  <c:v>2.2290000000000018E-3</c:v>
                </c:pt>
                <c:pt idx="291">
                  <c:v>2.3500000000000014E-3</c:v>
                </c:pt>
                <c:pt idx="292">
                  <c:v>2.5179999999999994E-3</c:v>
                </c:pt>
                <c:pt idx="293">
                  <c:v>2.6709999999999998E-3</c:v>
                </c:pt>
                <c:pt idx="294">
                  <c:v>2.869E-3</c:v>
                </c:pt>
                <c:pt idx="295">
                  <c:v>2.9760000000000029E-3</c:v>
                </c:pt>
                <c:pt idx="296">
                  <c:v>3.0670000000000003E-3</c:v>
                </c:pt>
                <c:pt idx="297">
                  <c:v>3.1130000000000012E-3</c:v>
                </c:pt>
                <c:pt idx="298">
                  <c:v>3.2500000000000029E-3</c:v>
                </c:pt>
                <c:pt idx="299">
                  <c:v>3.2510000000000004E-3</c:v>
                </c:pt>
                <c:pt idx="300">
                  <c:v>3.2360000000000028E-3</c:v>
                </c:pt>
                <c:pt idx="301">
                  <c:v>3.1899999999999984E-3</c:v>
                </c:pt>
                <c:pt idx="302">
                  <c:v>3.0670000000000003E-3</c:v>
                </c:pt>
                <c:pt idx="303">
                  <c:v>3.0530000000000002E-3</c:v>
                </c:pt>
                <c:pt idx="304">
                  <c:v>3.0830000000000024E-3</c:v>
                </c:pt>
                <c:pt idx="305">
                  <c:v>2.9759999999999995E-3</c:v>
                </c:pt>
                <c:pt idx="306">
                  <c:v>2.7930000000000003E-3</c:v>
                </c:pt>
                <c:pt idx="307">
                  <c:v>2.7170000000000007E-3</c:v>
                </c:pt>
                <c:pt idx="308">
                  <c:v>2.6709999999999998E-3</c:v>
                </c:pt>
                <c:pt idx="309">
                  <c:v>2.5939999999999991E-3</c:v>
                </c:pt>
                <c:pt idx="310">
                  <c:v>2.5179999999999994E-3</c:v>
                </c:pt>
                <c:pt idx="311">
                  <c:v>2.4729999999999995E-3</c:v>
                </c:pt>
                <c:pt idx="312">
                  <c:v>2.4270000000000021E-3</c:v>
                </c:pt>
                <c:pt idx="313">
                  <c:v>2.4109999999999999E-3</c:v>
                </c:pt>
                <c:pt idx="314">
                  <c:v>2.3960000000000023E-3</c:v>
                </c:pt>
                <c:pt idx="315">
                  <c:v>2.3960000000000023E-3</c:v>
                </c:pt>
                <c:pt idx="316">
                  <c:v>2.4419999999999997E-3</c:v>
                </c:pt>
                <c:pt idx="317">
                  <c:v>2.4869999999999996E-3</c:v>
                </c:pt>
                <c:pt idx="318">
                  <c:v>2.6100000000000012E-3</c:v>
                </c:pt>
                <c:pt idx="319">
                  <c:v>2.7620000000000006E-3</c:v>
                </c:pt>
                <c:pt idx="320">
                  <c:v>2.9150000000000009E-3</c:v>
                </c:pt>
                <c:pt idx="321">
                  <c:v>3.0360000000000005E-3</c:v>
                </c:pt>
                <c:pt idx="322">
                  <c:v>3.2660000000000015E-3</c:v>
                </c:pt>
                <c:pt idx="323">
                  <c:v>3.4789999999999995E-3</c:v>
                </c:pt>
                <c:pt idx="324">
                  <c:v>3.6160000000000012E-3</c:v>
                </c:pt>
                <c:pt idx="325">
                  <c:v>3.8159999999999999E-3</c:v>
                </c:pt>
                <c:pt idx="326">
                  <c:v>4.0740000000000012E-3</c:v>
                </c:pt>
                <c:pt idx="327">
                  <c:v>4.3040000000000023E-3</c:v>
                </c:pt>
                <c:pt idx="328">
                  <c:v>4.4710000000000027E-3</c:v>
                </c:pt>
                <c:pt idx="329">
                  <c:v>4.608000000000001E-3</c:v>
                </c:pt>
                <c:pt idx="330">
                  <c:v>4.7299999999999981E-3</c:v>
                </c:pt>
                <c:pt idx="331">
                  <c:v>4.8990000000000006E-3</c:v>
                </c:pt>
                <c:pt idx="332">
                  <c:v>4.9750000000000003E-3</c:v>
                </c:pt>
                <c:pt idx="333">
                  <c:v>4.9440000000000005E-3</c:v>
                </c:pt>
                <c:pt idx="334">
                  <c:v>4.9900000000000014E-3</c:v>
                </c:pt>
                <c:pt idx="335">
                  <c:v>4.9289999999999994E-3</c:v>
                </c:pt>
                <c:pt idx="336">
                  <c:v>4.7620000000000023E-3</c:v>
                </c:pt>
                <c:pt idx="337">
                  <c:v>4.6229999999999986E-3</c:v>
                </c:pt>
                <c:pt idx="338">
                  <c:v>4.4869999999999979E-3</c:v>
                </c:pt>
                <c:pt idx="339">
                  <c:v>4.1659999999999996E-3</c:v>
                </c:pt>
                <c:pt idx="340">
                  <c:v>3.8459999999999987E-3</c:v>
                </c:pt>
                <c:pt idx="341">
                  <c:v>3.601E-3</c:v>
                </c:pt>
                <c:pt idx="342">
                  <c:v>3.311999999999999E-3</c:v>
                </c:pt>
                <c:pt idx="343">
                  <c:v>2.9460000000000007E-3</c:v>
                </c:pt>
                <c:pt idx="344">
                  <c:v>2.6549999999999976E-3</c:v>
                </c:pt>
                <c:pt idx="345">
                  <c:v>2.3350000000000003E-3</c:v>
                </c:pt>
                <c:pt idx="346">
                  <c:v>1.9389999999999998E-3</c:v>
                </c:pt>
                <c:pt idx="347">
                  <c:v>1.5879999999999991E-3</c:v>
                </c:pt>
                <c:pt idx="348">
                  <c:v>1.3279999999999993E-3</c:v>
                </c:pt>
                <c:pt idx="349">
                  <c:v>1.0529999999999984E-3</c:v>
                </c:pt>
                <c:pt idx="350">
                  <c:v>7.6299999999999979E-4</c:v>
                </c:pt>
                <c:pt idx="351">
                  <c:v>5.3500000000000075E-4</c:v>
                </c:pt>
                <c:pt idx="352">
                  <c:v>5.0399999999999751E-4</c:v>
                </c:pt>
                <c:pt idx="353">
                  <c:v>3.6699999999999927E-4</c:v>
                </c:pt>
                <c:pt idx="354">
                  <c:v>1.9800000000000026E-4</c:v>
                </c:pt>
                <c:pt idx="355">
                  <c:v>7.7000000000000679E-5</c:v>
                </c:pt>
                <c:pt idx="356">
                  <c:v>0</c:v>
                </c:pt>
                <c:pt idx="357">
                  <c:v>-3.0000000000002247E-5</c:v>
                </c:pt>
                <c:pt idx="358">
                  <c:v>-5.9999999999997555E-5</c:v>
                </c:pt>
                <c:pt idx="359">
                  <c:v>-1.0699999999999946E-4</c:v>
                </c:pt>
                <c:pt idx="360">
                  <c:v>-1.3699999999999823E-4</c:v>
                </c:pt>
                <c:pt idx="361">
                  <c:v>-1.3699999999999823E-4</c:v>
                </c:pt>
                <c:pt idx="362">
                  <c:v>-1.8299999999999914E-4</c:v>
                </c:pt>
                <c:pt idx="363">
                  <c:v>-2.1299999999999791E-4</c:v>
                </c:pt>
                <c:pt idx="364">
                  <c:v>-2.2900000000000004E-4</c:v>
                </c:pt>
                <c:pt idx="365">
                  <c:v>-3.2000000000000084E-4</c:v>
                </c:pt>
                <c:pt idx="366">
                  <c:v>-3.2000000000000084E-4</c:v>
                </c:pt>
                <c:pt idx="367">
                  <c:v>-2.8900000000000106E-4</c:v>
                </c:pt>
                <c:pt idx="368">
                  <c:v>-2.8899999999999759E-4</c:v>
                </c:pt>
                <c:pt idx="369">
                  <c:v>-3.4999999999999962E-4</c:v>
                </c:pt>
                <c:pt idx="370">
                  <c:v>-4.259999999999993E-4</c:v>
                </c:pt>
                <c:pt idx="371">
                  <c:v>-3.8099999999999939E-4</c:v>
                </c:pt>
                <c:pt idx="372">
                  <c:v>-3.6599999999999827E-4</c:v>
                </c:pt>
                <c:pt idx="373">
                  <c:v>-3.3499999999999849E-4</c:v>
                </c:pt>
                <c:pt idx="374">
                  <c:v>-2.5899999999999881E-4</c:v>
                </c:pt>
                <c:pt idx="375">
                  <c:v>-2.4399999999999769E-4</c:v>
                </c:pt>
                <c:pt idx="376">
                  <c:v>-2.5899999999999881E-4</c:v>
                </c:pt>
                <c:pt idx="377">
                  <c:v>-3.8099999999999939E-4</c:v>
                </c:pt>
                <c:pt idx="378">
                  <c:v>-3.8099999999999939E-4</c:v>
                </c:pt>
                <c:pt idx="379">
                  <c:v>-3.2000000000000084E-4</c:v>
                </c:pt>
                <c:pt idx="380">
                  <c:v>-3.8099999999999939E-4</c:v>
                </c:pt>
                <c:pt idx="381">
                  <c:v>-3.5100000000000062E-4</c:v>
                </c:pt>
                <c:pt idx="382">
                  <c:v>-2.8999999999999859E-4</c:v>
                </c:pt>
                <c:pt idx="383">
                  <c:v>-2.7399999999999994E-4</c:v>
                </c:pt>
                <c:pt idx="384">
                  <c:v>-2.9000000000000206E-4</c:v>
                </c:pt>
                <c:pt idx="385">
                  <c:v>-3.9600000000000052E-4</c:v>
                </c:pt>
                <c:pt idx="386">
                  <c:v>-3.5100000000000062E-4</c:v>
                </c:pt>
                <c:pt idx="387">
                  <c:v>-3.4999999999999962E-4</c:v>
                </c:pt>
                <c:pt idx="388">
                  <c:v>-3.0499999999999972E-4</c:v>
                </c:pt>
                <c:pt idx="389">
                  <c:v>-3.2000000000000084E-4</c:v>
                </c:pt>
                <c:pt idx="390">
                  <c:v>-3.0400000000000219E-4</c:v>
                </c:pt>
                <c:pt idx="391">
                  <c:v>-3.8099999999999939E-4</c:v>
                </c:pt>
                <c:pt idx="392">
                  <c:v>-3.6500000000000074E-4</c:v>
                </c:pt>
                <c:pt idx="393">
                  <c:v>-3.3499999999999849E-4</c:v>
                </c:pt>
                <c:pt idx="394">
                  <c:v>-4.2699999999999683E-4</c:v>
                </c:pt>
                <c:pt idx="395">
                  <c:v>-3.9600000000000052E-4</c:v>
                </c:pt>
                <c:pt idx="396">
                  <c:v>-3.9700000000000152E-4</c:v>
                </c:pt>
                <c:pt idx="397">
                  <c:v>-4.2699999999999683E-4</c:v>
                </c:pt>
                <c:pt idx="398">
                  <c:v>-3.8099999999999939E-4</c:v>
                </c:pt>
                <c:pt idx="399">
                  <c:v>-3.0399999999999872E-4</c:v>
                </c:pt>
                <c:pt idx="400">
                  <c:v>-3.6599999999999827E-4</c:v>
                </c:pt>
                <c:pt idx="401">
                  <c:v>-3.9700000000000152E-4</c:v>
                </c:pt>
                <c:pt idx="402">
                  <c:v>-3.0399999999999872E-4</c:v>
                </c:pt>
                <c:pt idx="403">
                  <c:v>-2.8999999999999859E-4</c:v>
                </c:pt>
                <c:pt idx="404">
                  <c:v>-2.9000000000000206E-4</c:v>
                </c:pt>
                <c:pt idx="405">
                  <c:v>-2.7500000000000094E-4</c:v>
                </c:pt>
                <c:pt idx="406">
                  <c:v>-2.2900000000000004E-4</c:v>
                </c:pt>
                <c:pt idx="407">
                  <c:v>-1.820000000000016E-4</c:v>
                </c:pt>
                <c:pt idx="408">
                  <c:v>-1.9799999999999679E-4</c:v>
                </c:pt>
                <c:pt idx="409">
                  <c:v>-2.1299999999999791E-4</c:v>
                </c:pt>
                <c:pt idx="410">
                  <c:v>-2.5900000000000228E-4</c:v>
                </c:pt>
                <c:pt idx="411">
                  <c:v>-2.4300000000000016E-4</c:v>
                </c:pt>
                <c:pt idx="412">
                  <c:v>-1.6800000000000148E-4</c:v>
                </c:pt>
                <c:pt idx="413">
                  <c:v>-2.2799999999999904E-4</c:v>
                </c:pt>
                <c:pt idx="414">
                  <c:v>-2.7399999999999994E-4</c:v>
                </c:pt>
                <c:pt idx="415">
                  <c:v>-2.1299999999999791E-4</c:v>
                </c:pt>
                <c:pt idx="416">
                  <c:v>-1.6700000000000048E-4</c:v>
                </c:pt>
                <c:pt idx="417">
                  <c:v>-1.820000000000016E-4</c:v>
                </c:pt>
                <c:pt idx="418">
                  <c:v>-2.5900000000000228E-4</c:v>
                </c:pt>
                <c:pt idx="419">
                  <c:v>-2.2799999999999904E-4</c:v>
                </c:pt>
                <c:pt idx="420">
                  <c:v>-1.8299999999999914E-4</c:v>
                </c:pt>
                <c:pt idx="421">
                  <c:v>-2.9999999999998778E-5</c:v>
                </c:pt>
                <c:pt idx="422">
                  <c:v>-2.9999999999998778E-5</c:v>
                </c:pt>
                <c:pt idx="423">
                  <c:v>-1.0700000000000293E-4</c:v>
                </c:pt>
                <c:pt idx="424">
                  <c:v>-1.0599999999999846E-4</c:v>
                </c:pt>
                <c:pt idx="425">
                  <c:v>-1.2099999999999958E-4</c:v>
                </c:pt>
                <c:pt idx="426">
                  <c:v>-9.1000000000000802E-5</c:v>
                </c:pt>
                <c:pt idx="427">
                  <c:v>-1.3699999999999823E-4</c:v>
                </c:pt>
                <c:pt idx="428">
                  <c:v>-1.2200000000000058E-4</c:v>
                </c:pt>
                <c:pt idx="429">
                  <c:v>-9.1000000000000802E-5</c:v>
                </c:pt>
                <c:pt idx="430">
                  <c:v>-1.6800000000000148E-4</c:v>
                </c:pt>
                <c:pt idx="431">
                  <c:v>-2.2799999999999904E-4</c:v>
                </c:pt>
                <c:pt idx="432">
                  <c:v>-1.2199999999999711E-4</c:v>
                </c:pt>
                <c:pt idx="433">
                  <c:v>-2.1399999999999891E-4</c:v>
                </c:pt>
                <c:pt idx="434">
                  <c:v>-2.5899999999999881E-4</c:v>
                </c:pt>
                <c:pt idx="435">
                  <c:v>-2.1300000000000138E-4</c:v>
                </c:pt>
                <c:pt idx="436">
                  <c:v>-2.7399999999999994E-4</c:v>
                </c:pt>
                <c:pt idx="437">
                  <c:v>-2.8900000000000106E-4</c:v>
                </c:pt>
                <c:pt idx="438">
                  <c:v>-2.4300000000000016E-4</c:v>
                </c:pt>
                <c:pt idx="439">
                  <c:v>-1.8299999999999914E-4</c:v>
                </c:pt>
                <c:pt idx="440">
                  <c:v>-1.6700000000000048E-4</c:v>
                </c:pt>
                <c:pt idx="441">
                  <c:v>-1.8299999999999914E-4</c:v>
                </c:pt>
                <c:pt idx="442">
                  <c:v>-1.9800000000000026E-4</c:v>
                </c:pt>
                <c:pt idx="443">
                  <c:v>-1.8299999999999914E-4</c:v>
                </c:pt>
                <c:pt idx="444">
                  <c:v>-1.5300000000000036E-4</c:v>
                </c:pt>
                <c:pt idx="445">
                  <c:v>-1.2199999999999711E-4</c:v>
                </c:pt>
                <c:pt idx="446">
                  <c:v>-1.3599999999999723E-4</c:v>
                </c:pt>
                <c:pt idx="447">
                  <c:v>-9.1000000000000802E-5</c:v>
                </c:pt>
                <c:pt idx="448">
                  <c:v>-7.5999999999999679E-5</c:v>
                </c:pt>
                <c:pt idx="449">
                  <c:v>-1.8300000000000261E-4</c:v>
                </c:pt>
                <c:pt idx="450">
                  <c:v>-1.8299999999999914E-4</c:v>
                </c:pt>
                <c:pt idx="451">
                  <c:v>-2.1299999999999791E-4</c:v>
                </c:pt>
                <c:pt idx="452">
                  <c:v>-1.9800000000000026E-4</c:v>
                </c:pt>
                <c:pt idx="453">
                  <c:v>-1.5199999999999936E-4</c:v>
                </c:pt>
                <c:pt idx="454">
                  <c:v>-1.9800000000000026E-4</c:v>
                </c:pt>
                <c:pt idx="455">
                  <c:v>-1.6700000000000048E-4</c:v>
                </c:pt>
                <c:pt idx="456">
                  <c:v>-1.0699999999999946E-4</c:v>
                </c:pt>
                <c:pt idx="457">
                  <c:v>-9.0999999999997333E-5</c:v>
                </c:pt>
                <c:pt idx="458">
                  <c:v>-1.5199999999999936E-4</c:v>
                </c:pt>
                <c:pt idx="459">
                  <c:v>-1.9800000000000026E-4</c:v>
                </c:pt>
                <c:pt idx="460">
                  <c:v>-1.3699999999999823E-4</c:v>
                </c:pt>
                <c:pt idx="461">
                  <c:v>-1.0600000000000193E-4</c:v>
                </c:pt>
                <c:pt idx="462">
                  <c:v>-1.3699999999999823E-4</c:v>
                </c:pt>
                <c:pt idx="463">
                  <c:v>-1.2099999999999958E-4</c:v>
                </c:pt>
                <c:pt idx="464">
                  <c:v>-1.0599999999999846E-4</c:v>
                </c:pt>
                <c:pt idx="465">
                  <c:v>-9.1000000000000802E-5</c:v>
                </c:pt>
                <c:pt idx="466">
                  <c:v>-4.4999999999999901E-5</c:v>
                </c:pt>
                <c:pt idx="467">
                  <c:v>-2.9999999999998778E-5</c:v>
                </c:pt>
                <c:pt idx="468">
                  <c:v>-1.0599999999999846E-4</c:v>
                </c:pt>
                <c:pt idx="469">
                  <c:v>-3.0000000000002247E-5</c:v>
                </c:pt>
                <c:pt idx="470">
                  <c:v>-9.1000000000000802E-5</c:v>
                </c:pt>
                <c:pt idx="471">
                  <c:v>-7.5999999999999679E-5</c:v>
                </c:pt>
                <c:pt idx="472">
                  <c:v>0</c:v>
                </c:pt>
                <c:pt idx="473">
                  <c:v>-2.9999999999998778E-5</c:v>
                </c:pt>
                <c:pt idx="474">
                  <c:v>-4.4999999999999901E-5</c:v>
                </c:pt>
                <c:pt idx="475">
                  <c:v>-1.5300000000000036E-4</c:v>
                </c:pt>
                <c:pt idx="476">
                  <c:v>-1.6700000000000048E-4</c:v>
                </c:pt>
                <c:pt idx="477">
                  <c:v>-5.9999999999997555E-5</c:v>
                </c:pt>
                <c:pt idx="478">
                  <c:v>-4.4999999999999901E-5</c:v>
                </c:pt>
                <c:pt idx="479">
                  <c:v>-1.0599999999999846E-4</c:v>
                </c:pt>
                <c:pt idx="480">
                  <c:v>-7.4999999999998679E-5</c:v>
                </c:pt>
                <c:pt idx="481">
                  <c:v>-4.4999999999999901E-5</c:v>
                </c:pt>
                <c:pt idx="482">
                  <c:v>-6.0999999999998555E-5</c:v>
                </c:pt>
                <c:pt idx="483">
                  <c:v>-5.9999999999997555E-5</c:v>
                </c:pt>
                <c:pt idx="484">
                  <c:v>-7.5999999999999679E-5</c:v>
                </c:pt>
                <c:pt idx="485">
                  <c:v>-7.4999999999998679E-5</c:v>
                </c:pt>
                <c:pt idx="486">
                  <c:v>-2.9999999999998778E-5</c:v>
                </c:pt>
                <c:pt idx="487">
                  <c:v>-1.0599999999999846E-4</c:v>
                </c:pt>
                <c:pt idx="488">
                  <c:v>-6.0000000000001025E-5</c:v>
                </c:pt>
                <c:pt idx="489">
                  <c:v>4.5999999999997432E-5</c:v>
                </c:pt>
                <c:pt idx="490">
                  <c:v>3.0999999999999778E-5</c:v>
                </c:pt>
                <c:pt idx="491">
                  <c:v>4.7000000000001901E-5</c:v>
                </c:pt>
                <c:pt idx="492">
                  <c:v>1.0800000000000046E-4</c:v>
                </c:pt>
                <c:pt idx="493">
                  <c:v>0</c:v>
                </c:pt>
                <c:pt idx="494">
                  <c:v>0</c:v>
                </c:pt>
                <c:pt idx="495">
                  <c:v>0</c:v>
                </c:pt>
                <c:pt idx="496">
                  <c:v>0</c:v>
                </c:pt>
                <c:pt idx="497">
                  <c:v>-1.4999999999997654E-5</c:v>
                </c:pt>
                <c:pt idx="498">
                  <c:v>0</c:v>
                </c:pt>
                <c:pt idx="499">
                  <c:v>7.7000000000000679E-5</c:v>
                </c:pt>
                <c:pt idx="500">
                  <c:v>7.5999999999999679E-5</c:v>
                </c:pt>
                <c:pt idx="501">
                  <c:v>1.0800000000000393E-4</c:v>
                </c:pt>
                <c:pt idx="502">
                  <c:v>1.0800000000000046E-4</c:v>
                </c:pt>
                <c:pt idx="503">
                  <c:v>9.2000000000001803E-5</c:v>
                </c:pt>
                <c:pt idx="504">
                  <c:v>3.1000000000003247E-5</c:v>
                </c:pt>
                <c:pt idx="505">
                  <c:v>4.6000000000000901E-5</c:v>
                </c:pt>
                <c:pt idx="506">
                  <c:v>3.0999999999999778E-5</c:v>
                </c:pt>
                <c:pt idx="507">
                  <c:v>-1.4999999999997654E-5</c:v>
                </c:pt>
                <c:pt idx="508">
                  <c:v>-4.4999999999999901E-5</c:v>
                </c:pt>
                <c:pt idx="509">
                  <c:v>1.0000000000010001E-6</c:v>
                </c:pt>
                <c:pt idx="510">
                  <c:v>-2.9999999999998778E-5</c:v>
                </c:pt>
              </c:numCache>
            </c:numRef>
          </c:yVal>
          <c:smooth val="1"/>
          <c:extLst>
            <c:ext xmlns:c16="http://schemas.microsoft.com/office/drawing/2014/chart" uri="{C3380CC4-5D6E-409C-BE32-E72D297353CC}">
              <c16:uniqueId val="{00000000-0CD2-4B89-8010-DC295B82EE3D}"/>
            </c:ext>
          </c:extLst>
        </c:ser>
        <c:dLbls>
          <c:showLegendKey val="0"/>
          <c:showVal val="0"/>
          <c:showCatName val="0"/>
          <c:showSerName val="0"/>
          <c:showPercent val="0"/>
          <c:showBubbleSize val="0"/>
        </c:dLbls>
        <c:axId val="150027328"/>
        <c:axId val="150027888"/>
      </c:scatterChart>
      <c:valAx>
        <c:axId val="150027328"/>
        <c:scaling>
          <c:orientation val="minMax"/>
          <c:max val="338"/>
          <c:min val="278"/>
        </c:scaling>
        <c:delete val="0"/>
        <c:axPos val="b"/>
        <c:numFmt formatCode="General" sourceLinked="1"/>
        <c:majorTickMark val="out"/>
        <c:minorTickMark val="none"/>
        <c:tickLblPos val="nextTo"/>
        <c:txPr>
          <a:bodyPr/>
          <a:lstStyle/>
          <a:p>
            <a:pPr>
              <a:defRPr sz="800"/>
            </a:pPr>
            <a:endParaRPr lang="en-US"/>
          </a:p>
        </c:txPr>
        <c:crossAx val="150027888"/>
        <c:crosses val="autoZero"/>
        <c:crossBetween val="midCat"/>
        <c:majorUnit val="20"/>
        <c:minorUnit val="10"/>
      </c:valAx>
      <c:valAx>
        <c:axId val="150027888"/>
        <c:scaling>
          <c:orientation val="minMax"/>
          <c:max val="0.35000000000000003"/>
          <c:min val="0"/>
        </c:scaling>
        <c:delete val="0"/>
        <c:axPos val="l"/>
        <c:numFmt formatCode="General" sourceLinked="1"/>
        <c:majorTickMark val="out"/>
        <c:minorTickMark val="none"/>
        <c:tickLblPos val="nextTo"/>
        <c:txPr>
          <a:bodyPr/>
          <a:lstStyle/>
          <a:p>
            <a:pPr>
              <a:defRPr sz="800"/>
            </a:pPr>
            <a:endParaRPr lang="en-US"/>
          </a:p>
        </c:txPr>
        <c:crossAx val="150027328"/>
        <c:crosses val="autoZero"/>
        <c:crossBetween val="midCat"/>
      </c:valAx>
    </c:plotArea>
    <c:plotVisOnly val="1"/>
    <c:dispBlanksAs val="gap"/>
    <c:showDLblsOverMax val="0"/>
  </c:chart>
  <c:externalData r:id="rId1">
    <c:autoUpdate val="0"/>
  </c:externalData>
</c:chartSpace>
</file>

<file path=ppt/charts/chart11.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spPr>
            <a:ln>
              <a:solidFill>
                <a:schemeClr val="tx1"/>
              </a:solidFill>
            </a:ln>
          </c:spPr>
          <c:marker>
            <c:symbol val="none"/>
          </c:marker>
          <c:xVal>
            <c:numRef>
              <c:f>Sheet1!$R$3:$R$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U$3:$U$513</c:f>
              <c:numCache>
                <c:formatCode>General</c:formatCode>
                <c:ptCount val="511"/>
                <c:pt idx="0">
                  <c:v>0.99404899999999985</c:v>
                </c:pt>
                <c:pt idx="1">
                  <c:v>0.10769699999999978</c:v>
                </c:pt>
                <c:pt idx="2">
                  <c:v>0.64430200000000004</c:v>
                </c:pt>
                <c:pt idx="3">
                  <c:v>0.31039399999999989</c:v>
                </c:pt>
                <c:pt idx="4">
                  <c:v>-0.12136800000000007</c:v>
                </c:pt>
                <c:pt idx="5">
                  <c:v>-0.42724599999999996</c:v>
                </c:pt>
                <c:pt idx="6">
                  <c:v>2.3039999999999311E-3</c:v>
                </c:pt>
                <c:pt idx="7">
                  <c:v>-0.14526400000000023</c:v>
                </c:pt>
                <c:pt idx="8">
                  <c:v>-0.29602100000000026</c:v>
                </c:pt>
                <c:pt idx="9">
                  <c:v>-0.18765299999999979</c:v>
                </c:pt>
                <c:pt idx="10">
                  <c:v>0.17587199999999986</c:v>
                </c:pt>
                <c:pt idx="11">
                  <c:v>4.1960000000001579E-3</c:v>
                </c:pt>
                <c:pt idx="12">
                  <c:v>6.5902999999999892E-2</c:v>
                </c:pt>
                <c:pt idx="13">
                  <c:v>0.11254799999999972</c:v>
                </c:pt>
                <c:pt idx="14">
                  <c:v>5.3496999999999975E-2</c:v>
                </c:pt>
                <c:pt idx="15">
                  <c:v>-2.9754999999999907E-2</c:v>
                </c:pt>
                <c:pt idx="16">
                  <c:v>3.7308000000000188E-2</c:v>
                </c:pt>
                <c:pt idx="17">
                  <c:v>-0.10765099999999987</c:v>
                </c:pt>
                <c:pt idx="18">
                  <c:v>-9.4833999999999793E-2</c:v>
                </c:pt>
                <c:pt idx="19">
                  <c:v>4.5104999999999798E-2</c:v>
                </c:pt>
                <c:pt idx="20">
                  <c:v>3.4789999999999946E-2</c:v>
                </c:pt>
                <c:pt idx="21">
                  <c:v>4.8217999999999719E-2</c:v>
                </c:pt>
                <c:pt idx="22">
                  <c:v>-0.10275300000000002</c:v>
                </c:pt>
                <c:pt idx="23">
                  <c:v>8.4198000000000064E-2</c:v>
                </c:pt>
                <c:pt idx="24">
                  <c:v>0.22827199999999986</c:v>
                </c:pt>
                <c:pt idx="25">
                  <c:v>-3.1000000000044881E-5</c:v>
                </c:pt>
                <c:pt idx="26">
                  <c:v>-2.7542000000000108E-2</c:v>
                </c:pt>
                <c:pt idx="27">
                  <c:v>3.0318999999999832E-2</c:v>
                </c:pt>
                <c:pt idx="28">
                  <c:v>6.8206999999999976E-2</c:v>
                </c:pt>
                <c:pt idx="29">
                  <c:v>-1.3397000000000034E-2</c:v>
                </c:pt>
                <c:pt idx="30">
                  <c:v>9.0178999999999856E-2</c:v>
                </c:pt>
                <c:pt idx="31">
                  <c:v>3.8208000000000311E-2</c:v>
                </c:pt>
                <c:pt idx="32">
                  <c:v>0.11904899999999981</c:v>
                </c:pt>
                <c:pt idx="33">
                  <c:v>7.0083999999999883E-2</c:v>
                </c:pt>
                <c:pt idx="34">
                  <c:v>5.9477999999999767E-2</c:v>
                </c:pt>
                <c:pt idx="35">
                  <c:v>5.5252000000000148E-2</c:v>
                </c:pt>
                <c:pt idx="36">
                  <c:v>2.5191999999999951E-2</c:v>
                </c:pt>
                <c:pt idx="37">
                  <c:v>5.1468000000000139E-2</c:v>
                </c:pt>
                <c:pt idx="38">
                  <c:v>-8.8485999999999773E-2</c:v>
                </c:pt>
                <c:pt idx="39">
                  <c:v>5.6656000000000109E-2</c:v>
                </c:pt>
                <c:pt idx="40">
                  <c:v>5.4931999999999828E-2</c:v>
                </c:pt>
                <c:pt idx="41">
                  <c:v>6.7138999999999907E-2</c:v>
                </c:pt>
                <c:pt idx="42">
                  <c:v>7.0098000000000063E-2</c:v>
                </c:pt>
                <c:pt idx="43">
                  <c:v>0.12977599999999995</c:v>
                </c:pt>
                <c:pt idx="44">
                  <c:v>0.10815400000000015</c:v>
                </c:pt>
                <c:pt idx="45">
                  <c:v>-7.8120000000000828E-3</c:v>
                </c:pt>
                <c:pt idx="46">
                  <c:v>-5.7980000000001225E-3</c:v>
                </c:pt>
                <c:pt idx="47">
                  <c:v>-5.7979999999996784E-3</c:v>
                </c:pt>
                <c:pt idx="48">
                  <c:v>6.7595999999999837E-2</c:v>
                </c:pt>
                <c:pt idx="49">
                  <c:v>0.11384599999999996</c:v>
                </c:pt>
                <c:pt idx="50">
                  <c:v>7.9315000000000094E-2</c:v>
                </c:pt>
                <c:pt idx="51">
                  <c:v>5.6625999999999913E-2</c:v>
                </c:pt>
                <c:pt idx="52">
                  <c:v>2.650500000000007E-2</c:v>
                </c:pt>
                <c:pt idx="53">
                  <c:v>5.8991000000000085E-2</c:v>
                </c:pt>
                <c:pt idx="54">
                  <c:v>2.262900000000008E-2</c:v>
                </c:pt>
                <c:pt idx="55">
                  <c:v>4.9148000000000039E-2</c:v>
                </c:pt>
                <c:pt idx="56">
                  <c:v>6.8313999999999833E-2</c:v>
                </c:pt>
                <c:pt idx="57">
                  <c:v>7.1532999999999916E-2</c:v>
                </c:pt>
                <c:pt idx="58">
                  <c:v>2.6916999999999927E-2</c:v>
                </c:pt>
                <c:pt idx="59">
                  <c:v>5.7520000000000487E-3</c:v>
                </c:pt>
                <c:pt idx="60">
                  <c:v>1.4500000000000207E-3</c:v>
                </c:pt>
                <c:pt idx="61">
                  <c:v>0.10815400000000015</c:v>
                </c:pt>
                <c:pt idx="62">
                  <c:v>0.19901999999999981</c:v>
                </c:pt>
                <c:pt idx="63">
                  <c:v>1.7485999999999738E-2</c:v>
                </c:pt>
                <c:pt idx="64">
                  <c:v>7.8505999999999812E-2</c:v>
                </c:pt>
                <c:pt idx="65">
                  <c:v>-7.8963999999999743E-2</c:v>
                </c:pt>
                <c:pt idx="66">
                  <c:v>-1.9958000000000073E-2</c:v>
                </c:pt>
                <c:pt idx="67">
                  <c:v>6.6970999999999961E-2</c:v>
                </c:pt>
                <c:pt idx="68">
                  <c:v>9.3002000000000098E-2</c:v>
                </c:pt>
                <c:pt idx="69">
                  <c:v>0.11772200000000017</c:v>
                </c:pt>
                <c:pt idx="70">
                  <c:v>0.13517699999999994</c:v>
                </c:pt>
                <c:pt idx="71">
                  <c:v>0.15385499999999991</c:v>
                </c:pt>
                <c:pt idx="72">
                  <c:v>0.17118900000000009</c:v>
                </c:pt>
                <c:pt idx="73">
                  <c:v>0.18820199999999992</c:v>
                </c:pt>
                <c:pt idx="74">
                  <c:v>0.20770299999999992</c:v>
                </c:pt>
                <c:pt idx="75">
                  <c:v>0.22958300000000004</c:v>
                </c:pt>
                <c:pt idx="76">
                  <c:v>0.25254799999999994</c:v>
                </c:pt>
                <c:pt idx="77">
                  <c:v>0.27529900000000002</c:v>
                </c:pt>
                <c:pt idx="78">
                  <c:v>0.29531800000000002</c:v>
                </c:pt>
                <c:pt idx="79">
                  <c:v>0.30888399999999999</c:v>
                </c:pt>
                <c:pt idx="80">
                  <c:v>0.31582699999999997</c:v>
                </c:pt>
                <c:pt idx="81">
                  <c:v>0.31785600000000003</c:v>
                </c:pt>
                <c:pt idx="82">
                  <c:v>0.31761099999999992</c:v>
                </c:pt>
                <c:pt idx="83">
                  <c:v>0.31889400000000001</c:v>
                </c:pt>
                <c:pt idx="84">
                  <c:v>0.32345599999999997</c:v>
                </c:pt>
                <c:pt idx="85">
                  <c:v>0.33416799999999991</c:v>
                </c:pt>
                <c:pt idx="86">
                  <c:v>0.35166899999999995</c:v>
                </c:pt>
                <c:pt idx="87">
                  <c:v>0.37356599999999995</c:v>
                </c:pt>
                <c:pt idx="88">
                  <c:v>0.39558399999999999</c:v>
                </c:pt>
                <c:pt idx="89">
                  <c:v>0.41424500000000003</c:v>
                </c:pt>
                <c:pt idx="90">
                  <c:v>0.42478899999999997</c:v>
                </c:pt>
                <c:pt idx="91">
                  <c:v>0.42503399999999997</c:v>
                </c:pt>
                <c:pt idx="92">
                  <c:v>0.41505500000000001</c:v>
                </c:pt>
                <c:pt idx="93">
                  <c:v>0.39740000000000003</c:v>
                </c:pt>
                <c:pt idx="94">
                  <c:v>0.37570100000000001</c:v>
                </c:pt>
                <c:pt idx="95">
                  <c:v>0.35427799999999998</c:v>
                </c:pt>
                <c:pt idx="96">
                  <c:v>0.33700599999999997</c:v>
                </c:pt>
                <c:pt idx="97">
                  <c:v>0.32464599999999999</c:v>
                </c:pt>
                <c:pt idx="98">
                  <c:v>0.31839000000000001</c:v>
                </c:pt>
                <c:pt idx="99">
                  <c:v>0.31828299999999998</c:v>
                </c:pt>
                <c:pt idx="100">
                  <c:v>0.32331799999999999</c:v>
                </c:pt>
                <c:pt idx="101">
                  <c:v>0.32949800000000001</c:v>
                </c:pt>
                <c:pt idx="102">
                  <c:v>0.33404499999999998</c:v>
                </c:pt>
                <c:pt idx="103">
                  <c:v>0.33262700000000001</c:v>
                </c:pt>
                <c:pt idx="104">
                  <c:v>0.32276899999999997</c:v>
                </c:pt>
                <c:pt idx="105">
                  <c:v>0.29145799999999999</c:v>
                </c:pt>
                <c:pt idx="106">
                  <c:v>0.25674400000000003</c:v>
                </c:pt>
                <c:pt idx="107">
                  <c:v>0.231964</c:v>
                </c:pt>
                <c:pt idx="108">
                  <c:v>0.20223999999999998</c:v>
                </c:pt>
                <c:pt idx="109">
                  <c:v>0.172623</c:v>
                </c:pt>
                <c:pt idx="110">
                  <c:v>0.14504999999999998</c:v>
                </c:pt>
                <c:pt idx="111">
                  <c:v>0.12149000000000001</c:v>
                </c:pt>
                <c:pt idx="112">
                  <c:v>0.10165299999999999</c:v>
                </c:pt>
                <c:pt idx="113">
                  <c:v>8.5953000000000002E-2</c:v>
                </c:pt>
                <c:pt idx="114">
                  <c:v>7.4508000000000005E-2</c:v>
                </c:pt>
                <c:pt idx="115">
                  <c:v>6.5155000000000005E-2</c:v>
                </c:pt>
                <c:pt idx="116">
                  <c:v>5.6014999999999995E-2</c:v>
                </c:pt>
                <c:pt idx="117">
                  <c:v>4.9850000000000005E-2</c:v>
                </c:pt>
                <c:pt idx="118">
                  <c:v>4.5593000000000002E-2</c:v>
                </c:pt>
                <c:pt idx="119">
                  <c:v>4.3457000000000003E-2</c:v>
                </c:pt>
                <c:pt idx="120">
                  <c:v>4.1870000000000004E-2</c:v>
                </c:pt>
                <c:pt idx="121">
                  <c:v>4.1015999999999997E-2</c:v>
                </c:pt>
                <c:pt idx="122">
                  <c:v>3.9108000000000004E-2</c:v>
                </c:pt>
                <c:pt idx="123">
                  <c:v>3.9673E-2</c:v>
                </c:pt>
                <c:pt idx="124">
                  <c:v>3.8894999999999999E-2</c:v>
                </c:pt>
                <c:pt idx="125">
                  <c:v>3.9230000000000001E-2</c:v>
                </c:pt>
                <c:pt idx="126">
                  <c:v>3.8315000000000002E-2</c:v>
                </c:pt>
                <c:pt idx="127">
                  <c:v>3.7277000000000005E-2</c:v>
                </c:pt>
                <c:pt idx="128">
                  <c:v>3.7109000000000003E-2</c:v>
                </c:pt>
                <c:pt idx="129">
                  <c:v>3.6544999999999994E-2</c:v>
                </c:pt>
                <c:pt idx="130">
                  <c:v>3.6208999999999998E-2</c:v>
                </c:pt>
                <c:pt idx="131">
                  <c:v>3.4591999999999998E-2</c:v>
                </c:pt>
                <c:pt idx="132">
                  <c:v>3.3951000000000002E-2</c:v>
                </c:pt>
                <c:pt idx="133">
                  <c:v>3.3890000000000003E-2</c:v>
                </c:pt>
                <c:pt idx="134">
                  <c:v>3.3843999999999999E-2</c:v>
                </c:pt>
                <c:pt idx="135">
                  <c:v>3.3767999999999999E-2</c:v>
                </c:pt>
                <c:pt idx="136">
                  <c:v>3.3049999999999996E-2</c:v>
                </c:pt>
                <c:pt idx="137">
                  <c:v>3.4195000000000003E-2</c:v>
                </c:pt>
                <c:pt idx="138">
                  <c:v>3.4317E-2</c:v>
                </c:pt>
                <c:pt idx="139">
                  <c:v>3.3570000000000003E-2</c:v>
                </c:pt>
                <c:pt idx="140">
                  <c:v>3.3554E-2</c:v>
                </c:pt>
                <c:pt idx="141">
                  <c:v>3.3615000000000006E-2</c:v>
                </c:pt>
                <c:pt idx="142">
                  <c:v>3.3538999999999999E-2</c:v>
                </c:pt>
                <c:pt idx="143">
                  <c:v>3.1585999999999996E-2</c:v>
                </c:pt>
                <c:pt idx="144">
                  <c:v>3.1310999999999999E-2</c:v>
                </c:pt>
                <c:pt idx="145">
                  <c:v>3.0365000000000003E-2</c:v>
                </c:pt>
                <c:pt idx="146">
                  <c:v>2.9526000000000004E-2</c:v>
                </c:pt>
                <c:pt idx="147">
                  <c:v>2.9052999999999999E-2</c:v>
                </c:pt>
                <c:pt idx="148">
                  <c:v>2.8045E-2</c:v>
                </c:pt>
                <c:pt idx="149">
                  <c:v>2.7434999999999998E-2</c:v>
                </c:pt>
                <c:pt idx="150">
                  <c:v>2.6488999999999999E-2</c:v>
                </c:pt>
                <c:pt idx="151">
                  <c:v>2.6015999999999997E-2</c:v>
                </c:pt>
                <c:pt idx="152">
                  <c:v>2.5328999999999997E-2</c:v>
                </c:pt>
                <c:pt idx="153">
                  <c:v>2.4642999999999998E-2</c:v>
                </c:pt>
                <c:pt idx="154">
                  <c:v>2.4474999999999997E-2</c:v>
                </c:pt>
                <c:pt idx="155">
                  <c:v>2.3605000000000001E-2</c:v>
                </c:pt>
                <c:pt idx="156">
                  <c:v>2.3254999999999998E-2</c:v>
                </c:pt>
                <c:pt idx="157">
                  <c:v>2.2614000000000002E-2</c:v>
                </c:pt>
                <c:pt idx="158">
                  <c:v>2.2415000000000004E-2</c:v>
                </c:pt>
                <c:pt idx="159">
                  <c:v>2.0843E-2</c:v>
                </c:pt>
                <c:pt idx="160">
                  <c:v>2.0492999999999997E-2</c:v>
                </c:pt>
                <c:pt idx="161">
                  <c:v>2.0415999999999997E-2</c:v>
                </c:pt>
                <c:pt idx="162">
                  <c:v>1.9333000000000003E-2</c:v>
                </c:pt>
                <c:pt idx="163">
                  <c:v>1.9470000000000001E-2</c:v>
                </c:pt>
                <c:pt idx="164">
                  <c:v>1.9118999999999997E-2</c:v>
                </c:pt>
                <c:pt idx="165">
                  <c:v>1.8508999999999998E-2</c:v>
                </c:pt>
                <c:pt idx="166">
                  <c:v>1.7975000000000005E-2</c:v>
                </c:pt>
                <c:pt idx="167">
                  <c:v>1.7684999999999992E-2</c:v>
                </c:pt>
                <c:pt idx="168">
                  <c:v>1.7471E-2</c:v>
                </c:pt>
                <c:pt idx="169">
                  <c:v>1.7149999999999999E-2</c:v>
                </c:pt>
                <c:pt idx="170">
                  <c:v>1.6998000000000006E-2</c:v>
                </c:pt>
                <c:pt idx="171">
                  <c:v>1.6785000000000008E-2</c:v>
                </c:pt>
                <c:pt idx="172">
                  <c:v>1.6205000000000011E-2</c:v>
                </c:pt>
                <c:pt idx="173">
                  <c:v>1.6081999999999999E-2</c:v>
                </c:pt>
                <c:pt idx="174">
                  <c:v>1.5167E-2</c:v>
                </c:pt>
                <c:pt idx="175">
                  <c:v>1.3794000000000001E-2</c:v>
                </c:pt>
                <c:pt idx="176">
                  <c:v>1.3366000000000003E-2</c:v>
                </c:pt>
                <c:pt idx="177">
                  <c:v>1.3504000000000002E-2</c:v>
                </c:pt>
                <c:pt idx="178">
                  <c:v>1.3489000000000001E-2</c:v>
                </c:pt>
                <c:pt idx="179">
                  <c:v>1.2786999999999993E-2</c:v>
                </c:pt>
                <c:pt idx="180">
                  <c:v>1.3016E-2</c:v>
                </c:pt>
                <c:pt idx="181">
                  <c:v>1.2603000000000003E-2</c:v>
                </c:pt>
                <c:pt idx="182">
                  <c:v>1.2116000000000002E-2</c:v>
                </c:pt>
                <c:pt idx="183">
                  <c:v>1.1963000000000001E-2</c:v>
                </c:pt>
                <c:pt idx="184">
                  <c:v>1.1612000000000004E-2</c:v>
                </c:pt>
                <c:pt idx="185">
                  <c:v>1.1444000000000003E-2</c:v>
                </c:pt>
                <c:pt idx="186">
                  <c:v>1.1261000000000007E-2</c:v>
                </c:pt>
                <c:pt idx="187">
                  <c:v>1.0864000000000006E-2</c:v>
                </c:pt>
                <c:pt idx="188">
                  <c:v>1.0696000000000004E-2</c:v>
                </c:pt>
                <c:pt idx="189">
                  <c:v>1.0483000000000006E-2</c:v>
                </c:pt>
                <c:pt idx="190">
                  <c:v>1.0329999999999999E-2</c:v>
                </c:pt>
                <c:pt idx="191">
                  <c:v>9.9640000000000006E-3</c:v>
                </c:pt>
                <c:pt idx="192">
                  <c:v>9.5819999999999933E-3</c:v>
                </c:pt>
                <c:pt idx="193">
                  <c:v>9.5980000000000093E-3</c:v>
                </c:pt>
                <c:pt idx="194">
                  <c:v>9.4140000000000057E-3</c:v>
                </c:pt>
                <c:pt idx="195">
                  <c:v>9.1860000000000067E-3</c:v>
                </c:pt>
                <c:pt idx="196">
                  <c:v>8.9110000000000023E-3</c:v>
                </c:pt>
                <c:pt idx="197">
                  <c:v>8.7129999999999985E-3</c:v>
                </c:pt>
                <c:pt idx="198">
                  <c:v>8.7119999999999975E-3</c:v>
                </c:pt>
                <c:pt idx="199">
                  <c:v>8.5299999999999959E-3</c:v>
                </c:pt>
                <c:pt idx="200">
                  <c:v>8.4070000000000047E-3</c:v>
                </c:pt>
                <c:pt idx="201">
                  <c:v>8.3309999999999912E-3</c:v>
                </c:pt>
                <c:pt idx="202">
                  <c:v>8.2389999999999963E-3</c:v>
                </c:pt>
                <c:pt idx="203">
                  <c:v>8.1940000000000068E-3</c:v>
                </c:pt>
                <c:pt idx="204">
                  <c:v>7.979999999999994E-3</c:v>
                </c:pt>
                <c:pt idx="205">
                  <c:v>7.8580000000000039E-3</c:v>
                </c:pt>
                <c:pt idx="206">
                  <c:v>7.7360000000000068E-3</c:v>
                </c:pt>
                <c:pt idx="207">
                  <c:v>7.7659999999999951E-3</c:v>
                </c:pt>
                <c:pt idx="208">
                  <c:v>7.9039999999999944E-3</c:v>
                </c:pt>
                <c:pt idx="209">
                  <c:v>7.6749999999999943E-3</c:v>
                </c:pt>
                <c:pt idx="210">
                  <c:v>7.6139999999999958E-3</c:v>
                </c:pt>
                <c:pt idx="211">
                  <c:v>7.6300000000000048E-3</c:v>
                </c:pt>
                <c:pt idx="212">
                  <c:v>7.5220000000000009E-3</c:v>
                </c:pt>
                <c:pt idx="213">
                  <c:v>7.538000000000003E-3</c:v>
                </c:pt>
                <c:pt idx="214">
                  <c:v>7.431000000000007E-3</c:v>
                </c:pt>
                <c:pt idx="215">
                  <c:v>7.4000000000000038E-3</c:v>
                </c:pt>
                <c:pt idx="216">
                  <c:v>7.2629999999999917E-3</c:v>
                </c:pt>
                <c:pt idx="217">
                  <c:v>7.2020000000000001E-3</c:v>
                </c:pt>
                <c:pt idx="218">
                  <c:v>7.079999999999996E-3</c:v>
                </c:pt>
                <c:pt idx="219">
                  <c:v>6.957999999999992E-3</c:v>
                </c:pt>
                <c:pt idx="220">
                  <c:v>6.9280000000000036E-3</c:v>
                </c:pt>
                <c:pt idx="221">
                  <c:v>6.8199999999999997E-3</c:v>
                </c:pt>
                <c:pt idx="222">
                  <c:v>6.8200000000000066E-3</c:v>
                </c:pt>
                <c:pt idx="223">
                  <c:v>6.7900000000000044E-3</c:v>
                </c:pt>
                <c:pt idx="224">
                  <c:v>6.9120000000000015E-3</c:v>
                </c:pt>
                <c:pt idx="225">
                  <c:v>6.744E-3</c:v>
                </c:pt>
                <c:pt idx="226">
                  <c:v>6.6680000000000073E-3</c:v>
                </c:pt>
                <c:pt idx="227">
                  <c:v>6.8360000000000087E-3</c:v>
                </c:pt>
                <c:pt idx="228">
                  <c:v>6.8819999999999992E-3</c:v>
                </c:pt>
                <c:pt idx="229">
                  <c:v>6.8510000000000099E-3</c:v>
                </c:pt>
                <c:pt idx="230">
                  <c:v>6.7289999999999989E-3</c:v>
                </c:pt>
                <c:pt idx="231">
                  <c:v>6.7139999999999977E-3</c:v>
                </c:pt>
                <c:pt idx="232">
                  <c:v>6.7140000000000047E-3</c:v>
                </c:pt>
                <c:pt idx="233">
                  <c:v>6.6230000000000039E-3</c:v>
                </c:pt>
                <c:pt idx="234">
                  <c:v>6.6829999999999945E-3</c:v>
                </c:pt>
                <c:pt idx="235">
                  <c:v>6.5909999999999996E-3</c:v>
                </c:pt>
                <c:pt idx="236">
                  <c:v>6.6229999999999969E-3</c:v>
                </c:pt>
                <c:pt idx="237">
                  <c:v>6.5609999999999974E-3</c:v>
                </c:pt>
                <c:pt idx="238">
                  <c:v>6.5769999999999995E-3</c:v>
                </c:pt>
                <c:pt idx="239">
                  <c:v>6.4699999999999966E-3</c:v>
                </c:pt>
                <c:pt idx="240">
                  <c:v>6.3939999999999969E-3</c:v>
                </c:pt>
                <c:pt idx="241">
                  <c:v>6.4239999999999992E-3</c:v>
                </c:pt>
                <c:pt idx="242">
                  <c:v>6.4400000000000013E-3</c:v>
                </c:pt>
                <c:pt idx="243">
                  <c:v>6.302000000000002E-3</c:v>
                </c:pt>
                <c:pt idx="244">
                  <c:v>6.2870000000000009E-3</c:v>
                </c:pt>
                <c:pt idx="245">
                  <c:v>6.2259999999999954E-3</c:v>
                </c:pt>
                <c:pt idx="246">
                  <c:v>6.1799999999999911E-3</c:v>
                </c:pt>
                <c:pt idx="247">
                  <c:v>6.1340000000000006E-3</c:v>
                </c:pt>
                <c:pt idx="248">
                  <c:v>6.1649999999999899E-3</c:v>
                </c:pt>
                <c:pt idx="249">
                  <c:v>6.1039999999999983E-3</c:v>
                </c:pt>
                <c:pt idx="250">
                  <c:v>6.0730000000000089E-3</c:v>
                </c:pt>
                <c:pt idx="251">
                  <c:v>5.9659999999999991E-3</c:v>
                </c:pt>
                <c:pt idx="252">
                  <c:v>5.9659999999999991E-3</c:v>
                </c:pt>
                <c:pt idx="253">
                  <c:v>5.8749999999999983E-3</c:v>
                </c:pt>
                <c:pt idx="254">
                  <c:v>5.844000000000002E-3</c:v>
                </c:pt>
                <c:pt idx="255">
                  <c:v>5.8139999999999997E-3</c:v>
                </c:pt>
                <c:pt idx="256">
                  <c:v>5.9050000000000075E-3</c:v>
                </c:pt>
                <c:pt idx="257">
                  <c:v>5.844000000000002E-3</c:v>
                </c:pt>
                <c:pt idx="258">
                  <c:v>5.6759999999999936E-3</c:v>
                </c:pt>
                <c:pt idx="259">
                  <c:v>5.7069999999999899E-3</c:v>
                </c:pt>
                <c:pt idx="260">
                  <c:v>5.6459999999999982E-3</c:v>
                </c:pt>
                <c:pt idx="261">
                  <c:v>5.5839999999999917E-3</c:v>
                </c:pt>
                <c:pt idx="262">
                  <c:v>5.5390000000000023E-3</c:v>
                </c:pt>
                <c:pt idx="263">
                  <c:v>5.4619999999999946E-3</c:v>
                </c:pt>
                <c:pt idx="264">
                  <c:v>5.5849999999999927E-3</c:v>
                </c:pt>
                <c:pt idx="265">
                  <c:v>5.614999999999995E-3</c:v>
                </c:pt>
                <c:pt idx="266">
                  <c:v>5.4929999999999979E-3</c:v>
                </c:pt>
                <c:pt idx="267">
                  <c:v>5.4629999999999956E-3</c:v>
                </c:pt>
                <c:pt idx="268">
                  <c:v>5.4469999999999935E-3</c:v>
                </c:pt>
                <c:pt idx="269">
                  <c:v>5.4769999999999958E-3</c:v>
                </c:pt>
                <c:pt idx="270">
                  <c:v>5.4170000000000051E-3</c:v>
                </c:pt>
                <c:pt idx="271">
                  <c:v>5.3249999999999964E-3</c:v>
                </c:pt>
                <c:pt idx="272">
                  <c:v>5.3399999999999975E-3</c:v>
                </c:pt>
                <c:pt idx="273">
                  <c:v>5.3710000000000008E-3</c:v>
                </c:pt>
                <c:pt idx="274">
                  <c:v>5.3249999999999964E-3</c:v>
                </c:pt>
                <c:pt idx="275">
                  <c:v>5.278999999999999E-3</c:v>
                </c:pt>
                <c:pt idx="276">
                  <c:v>5.2179999999999935E-3</c:v>
                </c:pt>
                <c:pt idx="277">
                  <c:v>5.2489999999999967E-3</c:v>
                </c:pt>
                <c:pt idx="278">
                  <c:v>5.2639999999999909E-3</c:v>
                </c:pt>
                <c:pt idx="279">
                  <c:v>5.1569999999999949E-3</c:v>
                </c:pt>
                <c:pt idx="280">
                  <c:v>5.1569999999999949E-3</c:v>
                </c:pt>
                <c:pt idx="281">
                  <c:v>5.1569999999999949E-3</c:v>
                </c:pt>
                <c:pt idx="282">
                  <c:v>5.0350000000000117E-3</c:v>
                </c:pt>
                <c:pt idx="283">
                  <c:v>5.0200000000000106E-3</c:v>
                </c:pt>
                <c:pt idx="284">
                  <c:v>4.9439999999999901E-3</c:v>
                </c:pt>
                <c:pt idx="285">
                  <c:v>4.8830000000000054E-3</c:v>
                </c:pt>
                <c:pt idx="286">
                  <c:v>5.0040000000000015E-3</c:v>
                </c:pt>
                <c:pt idx="287">
                  <c:v>4.9739999999999993E-3</c:v>
                </c:pt>
                <c:pt idx="288">
                  <c:v>4.7910000000000036E-3</c:v>
                </c:pt>
                <c:pt idx="289">
                  <c:v>4.7299999999999981E-3</c:v>
                </c:pt>
                <c:pt idx="290">
                  <c:v>4.7460000000000072E-3</c:v>
                </c:pt>
                <c:pt idx="291">
                  <c:v>4.6839999999999937E-3</c:v>
                </c:pt>
                <c:pt idx="292">
                  <c:v>4.6839999999999937E-3</c:v>
                </c:pt>
                <c:pt idx="293">
                  <c:v>4.7450000000000062E-3</c:v>
                </c:pt>
                <c:pt idx="294">
                  <c:v>4.8669999999999963E-3</c:v>
                </c:pt>
                <c:pt idx="295">
                  <c:v>4.6690000000000065E-3</c:v>
                </c:pt>
                <c:pt idx="296">
                  <c:v>4.837000000000008E-3</c:v>
                </c:pt>
                <c:pt idx="297">
                  <c:v>4.7599999999999934E-3</c:v>
                </c:pt>
                <c:pt idx="298">
                  <c:v>4.8059999999999908E-3</c:v>
                </c:pt>
                <c:pt idx="299">
                  <c:v>4.714999999999997E-3</c:v>
                </c:pt>
                <c:pt idx="300">
                  <c:v>4.6390000000000042E-3</c:v>
                </c:pt>
                <c:pt idx="301">
                  <c:v>4.5929999999999999E-3</c:v>
                </c:pt>
                <c:pt idx="302">
                  <c:v>4.4700000000000017E-3</c:v>
                </c:pt>
                <c:pt idx="303">
                  <c:v>4.3800000000000089E-3</c:v>
                </c:pt>
                <c:pt idx="304">
                  <c:v>4.4099999999999973E-3</c:v>
                </c:pt>
                <c:pt idx="305">
                  <c:v>4.2569999999999969E-3</c:v>
                </c:pt>
                <c:pt idx="306">
                  <c:v>4.2269999999999947E-3</c:v>
                </c:pt>
                <c:pt idx="307">
                  <c:v>4.1500000000000009E-3</c:v>
                </c:pt>
                <c:pt idx="308">
                  <c:v>4.1809999999999972E-3</c:v>
                </c:pt>
                <c:pt idx="309">
                  <c:v>4.0890000000000024E-3</c:v>
                </c:pt>
                <c:pt idx="310">
                  <c:v>4.1199999999999987E-3</c:v>
                </c:pt>
                <c:pt idx="311">
                  <c:v>4.043999999999992E-3</c:v>
                </c:pt>
                <c:pt idx="312">
                  <c:v>4.0280000000000038E-3</c:v>
                </c:pt>
                <c:pt idx="313">
                  <c:v>4.0280000000000038E-3</c:v>
                </c:pt>
                <c:pt idx="314">
                  <c:v>3.9670000000000052E-3</c:v>
                </c:pt>
                <c:pt idx="315">
                  <c:v>3.9670000000000052E-3</c:v>
                </c:pt>
                <c:pt idx="316">
                  <c:v>3.9980000000000016E-3</c:v>
                </c:pt>
                <c:pt idx="317">
                  <c:v>3.9819999999999994E-3</c:v>
                </c:pt>
                <c:pt idx="318">
                  <c:v>3.9980000000000085E-3</c:v>
                </c:pt>
                <c:pt idx="319">
                  <c:v>4.0279999999999969E-3</c:v>
                </c:pt>
                <c:pt idx="320">
                  <c:v>4.042999999999998E-3</c:v>
                </c:pt>
                <c:pt idx="321">
                  <c:v>3.9669999999999983E-3</c:v>
                </c:pt>
                <c:pt idx="322">
                  <c:v>3.9219999999999949E-3</c:v>
                </c:pt>
                <c:pt idx="323">
                  <c:v>3.9819999999999994E-3</c:v>
                </c:pt>
                <c:pt idx="324">
                  <c:v>3.9670000000000052E-3</c:v>
                </c:pt>
                <c:pt idx="325">
                  <c:v>4.0440000000000059E-3</c:v>
                </c:pt>
                <c:pt idx="326">
                  <c:v>3.9970000000000006E-3</c:v>
                </c:pt>
                <c:pt idx="327">
                  <c:v>3.9830000000000004E-3</c:v>
                </c:pt>
                <c:pt idx="328">
                  <c:v>3.8910000000000056E-3</c:v>
                </c:pt>
                <c:pt idx="329">
                  <c:v>3.8749999999999896E-3</c:v>
                </c:pt>
                <c:pt idx="330">
                  <c:v>3.9210000000000009E-3</c:v>
                </c:pt>
                <c:pt idx="331">
                  <c:v>3.8760000000000044E-3</c:v>
                </c:pt>
                <c:pt idx="332">
                  <c:v>3.8460000000000022E-3</c:v>
                </c:pt>
                <c:pt idx="333">
                  <c:v>3.7389999999999993E-3</c:v>
                </c:pt>
                <c:pt idx="334">
                  <c:v>3.8149999999999989E-3</c:v>
                </c:pt>
                <c:pt idx="335">
                  <c:v>3.7849999999999967E-3</c:v>
                </c:pt>
                <c:pt idx="336">
                  <c:v>3.708000000000003E-3</c:v>
                </c:pt>
                <c:pt idx="337">
                  <c:v>3.7379999999999983E-3</c:v>
                </c:pt>
                <c:pt idx="338">
                  <c:v>3.6930000000000018E-3</c:v>
                </c:pt>
                <c:pt idx="339">
                  <c:v>3.7079999999999891E-3</c:v>
                </c:pt>
                <c:pt idx="340">
                  <c:v>3.5099999999999992E-3</c:v>
                </c:pt>
                <c:pt idx="341">
                  <c:v>3.601E-3</c:v>
                </c:pt>
                <c:pt idx="342">
                  <c:v>3.5249999999999934E-3</c:v>
                </c:pt>
                <c:pt idx="343">
                  <c:v>3.494000000000004E-3</c:v>
                </c:pt>
                <c:pt idx="344">
                  <c:v>3.4640000000000018E-3</c:v>
                </c:pt>
                <c:pt idx="345">
                  <c:v>3.4019999999999953E-3</c:v>
                </c:pt>
                <c:pt idx="346">
                  <c:v>3.5099999999999923E-3</c:v>
                </c:pt>
                <c:pt idx="347">
                  <c:v>4.2579999999999979E-3</c:v>
                </c:pt>
                <c:pt idx="348">
                  <c:v>4.501000000000005E-3</c:v>
                </c:pt>
                <c:pt idx="349">
                  <c:v>4.3490000000000056E-3</c:v>
                </c:pt>
                <c:pt idx="350">
                  <c:v>4.1959999999999983E-3</c:v>
                </c:pt>
                <c:pt idx="351">
                  <c:v>4.1970000000000063E-3</c:v>
                </c:pt>
                <c:pt idx="352">
                  <c:v>4.2419999999999958E-3</c:v>
                </c:pt>
                <c:pt idx="353">
                  <c:v>4.271999999999998E-3</c:v>
                </c:pt>
                <c:pt idx="354">
                  <c:v>4.1800000000000032E-3</c:v>
                </c:pt>
                <c:pt idx="355">
                  <c:v>4.1659999999999961E-3</c:v>
                </c:pt>
                <c:pt idx="356">
                  <c:v>4.0130000000000027E-3</c:v>
                </c:pt>
                <c:pt idx="357">
                  <c:v>4.0279999999999969E-3</c:v>
                </c:pt>
                <c:pt idx="358">
                  <c:v>4.1049999999999975E-3</c:v>
                </c:pt>
                <c:pt idx="359">
                  <c:v>3.9970000000000006E-3</c:v>
                </c:pt>
                <c:pt idx="360">
                  <c:v>4.0130000000000027E-3</c:v>
                </c:pt>
                <c:pt idx="361">
                  <c:v>4.0290000000000048E-3</c:v>
                </c:pt>
                <c:pt idx="362">
                  <c:v>3.9219999999999949E-3</c:v>
                </c:pt>
                <c:pt idx="363">
                  <c:v>3.9370000000000099E-3</c:v>
                </c:pt>
                <c:pt idx="364">
                  <c:v>3.8300000000000001E-3</c:v>
                </c:pt>
                <c:pt idx="365">
                  <c:v>3.8600000000000023E-3</c:v>
                </c:pt>
                <c:pt idx="366">
                  <c:v>3.8610000000000033E-3</c:v>
                </c:pt>
                <c:pt idx="367">
                  <c:v>3.8449999999999943E-3</c:v>
                </c:pt>
                <c:pt idx="368">
                  <c:v>3.8149999999999989E-3</c:v>
                </c:pt>
                <c:pt idx="369">
                  <c:v>3.7230000000000041E-3</c:v>
                </c:pt>
                <c:pt idx="370">
                  <c:v>3.6929999999999949E-3</c:v>
                </c:pt>
                <c:pt idx="371">
                  <c:v>3.6930000000000018E-3</c:v>
                </c:pt>
                <c:pt idx="372">
                  <c:v>3.6620000000000055E-3</c:v>
                </c:pt>
                <c:pt idx="373">
                  <c:v>3.6469999999999975E-3</c:v>
                </c:pt>
                <c:pt idx="374">
                  <c:v>3.7230000000000041E-3</c:v>
                </c:pt>
                <c:pt idx="375">
                  <c:v>3.6160000000000012E-3</c:v>
                </c:pt>
                <c:pt idx="376">
                  <c:v>3.707000000000002E-3</c:v>
                </c:pt>
                <c:pt idx="377">
                  <c:v>3.5559999999999967E-3</c:v>
                </c:pt>
                <c:pt idx="378">
                  <c:v>3.5849999999999979E-3</c:v>
                </c:pt>
                <c:pt idx="379">
                  <c:v>3.5860000000000058E-3</c:v>
                </c:pt>
                <c:pt idx="380">
                  <c:v>3.4640000000000087E-3</c:v>
                </c:pt>
                <c:pt idx="381">
                  <c:v>3.4790000000000029E-3</c:v>
                </c:pt>
                <c:pt idx="382">
                  <c:v>3.5250000000000004E-3</c:v>
                </c:pt>
                <c:pt idx="383">
                  <c:v>3.4639999999999949E-3</c:v>
                </c:pt>
                <c:pt idx="384">
                  <c:v>3.5090000000000052E-3</c:v>
                </c:pt>
                <c:pt idx="385">
                  <c:v>3.3109999999999945E-3</c:v>
                </c:pt>
                <c:pt idx="386">
                  <c:v>3.4179999999999974E-3</c:v>
                </c:pt>
                <c:pt idx="387">
                  <c:v>3.3570000000000058E-3</c:v>
                </c:pt>
                <c:pt idx="388">
                  <c:v>3.3110000000000014E-3</c:v>
                </c:pt>
                <c:pt idx="389">
                  <c:v>3.3110000000000084E-3</c:v>
                </c:pt>
                <c:pt idx="390">
                  <c:v>3.3569999999999989E-3</c:v>
                </c:pt>
                <c:pt idx="391">
                  <c:v>3.1589999999999951E-3</c:v>
                </c:pt>
                <c:pt idx="392">
                  <c:v>3.143999999999994E-3</c:v>
                </c:pt>
                <c:pt idx="393">
                  <c:v>3.142999999999993E-3</c:v>
                </c:pt>
                <c:pt idx="394">
                  <c:v>3.0060000000000087E-3</c:v>
                </c:pt>
                <c:pt idx="395">
                  <c:v>3.036999999999998E-3</c:v>
                </c:pt>
                <c:pt idx="396">
                  <c:v>3.0059999999999948E-3</c:v>
                </c:pt>
                <c:pt idx="397">
                  <c:v>2.9450000000000032E-3</c:v>
                </c:pt>
                <c:pt idx="398">
                  <c:v>2.9449999999999962E-3</c:v>
                </c:pt>
                <c:pt idx="399">
                  <c:v>2.8999999999999998E-3</c:v>
                </c:pt>
                <c:pt idx="400">
                  <c:v>2.7920000000000028E-3</c:v>
                </c:pt>
                <c:pt idx="401">
                  <c:v>2.7620000000000006E-3</c:v>
                </c:pt>
                <c:pt idx="402">
                  <c:v>2.7310000000000043E-3</c:v>
                </c:pt>
                <c:pt idx="403">
                  <c:v>2.6850000000000068E-3</c:v>
                </c:pt>
                <c:pt idx="404">
                  <c:v>2.6090000000000002E-3</c:v>
                </c:pt>
                <c:pt idx="405">
                  <c:v>2.5629999999999958E-3</c:v>
                </c:pt>
                <c:pt idx="406">
                  <c:v>2.577999999999997E-3</c:v>
                </c:pt>
                <c:pt idx="407">
                  <c:v>2.5480000000000017E-3</c:v>
                </c:pt>
                <c:pt idx="408">
                  <c:v>2.5329999999999936E-3</c:v>
                </c:pt>
                <c:pt idx="409">
                  <c:v>2.5180000000000063E-3</c:v>
                </c:pt>
                <c:pt idx="410">
                  <c:v>2.4409999999999987E-3</c:v>
                </c:pt>
                <c:pt idx="411">
                  <c:v>2.3959999999999954E-3</c:v>
                </c:pt>
                <c:pt idx="412">
                  <c:v>2.3490000000000039E-3</c:v>
                </c:pt>
                <c:pt idx="413">
                  <c:v>2.3959999999999954E-3</c:v>
                </c:pt>
                <c:pt idx="414">
                  <c:v>2.364999999999999E-3</c:v>
                </c:pt>
                <c:pt idx="415">
                  <c:v>2.3350000000000037E-3</c:v>
                </c:pt>
                <c:pt idx="416">
                  <c:v>2.3350000000000037E-3</c:v>
                </c:pt>
                <c:pt idx="417">
                  <c:v>2.2130000000000066E-3</c:v>
                </c:pt>
                <c:pt idx="418">
                  <c:v>2.0909999999999956E-3</c:v>
                </c:pt>
                <c:pt idx="419">
                  <c:v>2.1209999999999979E-3</c:v>
                </c:pt>
                <c:pt idx="420">
                  <c:v>2.135999999999999E-3</c:v>
                </c:pt>
                <c:pt idx="421">
                  <c:v>2.1510000000000001E-3</c:v>
                </c:pt>
                <c:pt idx="422">
                  <c:v>2.1659999999999943E-3</c:v>
                </c:pt>
                <c:pt idx="423">
                  <c:v>2.1210000000000048E-3</c:v>
                </c:pt>
                <c:pt idx="424">
                  <c:v>2.029000000000003E-3</c:v>
                </c:pt>
                <c:pt idx="425">
                  <c:v>2.029000000000003E-3</c:v>
                </c:pt>
                <c:pt idx="426">
                  <c:v>2.0599999999999993E-3</c:v>
                </c:pt>
                <c:pt idx="427">
                  <c:v>1.9990000000000008E-3</c:v>
                </c:pt>
                <c:pt idx="428">
                  <c:v>1.9839999999999997E-3</c:v>
                </c:pt>
                <c:pt idx="429">
                  <c:v>2.0440000000000041E-3</c:v>
                </c:pt>
                <c:pt idx="430">
                  <c:v>1.9529999999999964E-3</c:v>
                </c:pt>
                <c:pt idx="431">
                  <c:v>1.907999999999993E-3</c:v>
                </c:pt>
                <c:pt idx="432">
                  <c:v>2.029000000000003E-3</c:v>
                </c:pt>
                <c:pt idx="433">
                  <c:v>1.9070000000000059E-3</c:v>
                </c:pt>
                <c:pt idx="434">
                  <c:v>1.7860000000000098E-3</c:v>
                </c:pt>
                <c:pt idx="435">
                  <c:v>1.799999999999996E-3</c:v>
                </c:pt>
                <c:pt idx="436">
                  <c:v>1.7399999999999985E-3</c:v>
                </c:pt>
                <c:pt idx="437">
                  <c:v>1.6480000000000036E-3</c:v>
                </c:pt>
                <c:pt idx="438">
                  <c:v>1.7399999999999916E-3</c:v>
                </c:pt>
                <c:pt idx="439">
                  <c:v>1.7700000000000007E-3</c:v>
                </c:pt>
                <c:pt idx="440">
                  <c:v>1.7090000000000022E-3</c:v>
                </c:pt>
                <c:pt idx="441">
                  <c:v>1.6479999999999967E-3</c:v>
                </c:pt>
                <c:pt idx="442">
                  <c:v>1.5870000000000051E-3</c:v>
                </c:pt>
                <c:pt idx="443">
                  <c:v>1.5560000000000018E-3</c:v>
                </c:pt>
                <c:pt idx="444">
                  <c:v>1.4800000000000021E-3</c:v>
                </c:pt>
                <c:pt idx="445">
                  <c:v>1.4339999999999908E-3</c:v>
                </c:pt>
                <c:pt idx="446">
                  <c:v>1.449999999999993E-3</c:v>
                </c:pt>
                <c:pt idx="447">
                  <c:v>1.4649999999999941E-3</c:v>
                </c:pt>
                <c:pt idx="448">
                  <c:v>1.3890000000000013E-3</c:v>
                </c:pt>
                <c:pt idx="449">
                  <c:v>1.3120000000000007E-3</c:v>
                </c:pt>
                <c:pt idx="450">
                  <c:v>1.3269999999999949E-3</c:v>
                </c:pt>
                <c:pt idx="451">
                  <c:v>1.2819999999999915E-3</c:v>
                </c:pt>
                <c:pt idx="452">
                  <c:v>1.4340000000000047E-3</c:v>
                </c:pt>
                <c:pt idx="453">
                  <c:v>1.5109999999999985E-3</c:v>
                </c:pt>
                <c:pt idx="454">
                  <c:v>1.3730000000000062E-3</c:v>
                </c:pt>
                <c:pt idx="455">
                  <c:v>1.3579999999999981E-3</c:v>
                </c:pt>
                <c:pt idx="456">
                  <c:v>1.3120000000000007E-3</c:v>
                </c:pt>
                <c:pt idx="457">
                  <c:v>1.2209999999999999E-3</c:v>
                </c:pt>
                <c:pt idx="458">
                  <c:v>1.0529999999999984E-3</c:v>
                </c:pt>
                <c:pt idx="459">
                  <c:v>8.6900000000000172E-4</c:v>
                </c:pt>
                <c:pt idx="460">
                  <c:v>7.470000000000046E-4</c:v>
                </c:pt>
                <c:pt idx="461">
                  <c:v>7.0200000000000123E-4</c:v>
                </c:pt>
                <c:pt idx="462">
                  <c:v>6.0999999999999943E-4</c:v>
                </c:pt>
                <c:pt idx="463">
                  <c:v>6.1099999999999349E-4</c:v>
                </c:pt>
                <c:pt idx="464">
                  <c:v>6.1000000000000637E-4</c:v>
                </c:pt>
                <c:pt idx="465">
                  <c:v>5.7900000000001006E-4</c:v>
                </c:pt>
                <c:pt idx="466">
                  <c:v>5.7999999999999718E-4</c:v>
                </c:pt>
                <c:pt idx="467">
                  <c:v>5.8000000000001106E-4</c:v>
                </c:pt>
                <c:pt idx="468">
                  <c:v>3.6599999999999827E-4</c:v>
                </c:pt>
                <c:pt idx="469">
                  <c:v>4.2699999999999683E-4</c:v>
                </c:pt>
                <c:pt idx="470">
                  <c:v>4.5800000000000007E-4</c:v>
                </c:pt>
                <c:pt idx="471">
                  <c:v>4.5800000000000007E-4</c:v>
                </c:pt>
                <c:pt idx="472">
                  <c:v>4.5800000000000007E-4</c:v>
                </c:pt>
                <c:pt idx="473">
                  <c:v>4.5699999999999907E-4</c:v>
                </c:pt>
                <c:pt idx="474">
                  <c:v>4.2800000000000477E-4</c:v>
                </c:pt>
                <c:pt idx="475">
                  <c:v>2.5900000000000228E-4</c:v>
                </c:pt>
                <c:pt idx="476">
                  <c:v>2.2900000000000698E-4</c:v>
                </c:pt>
                <c:pt idx="477">
                  <c:v>3.9700000000000152E-4</c:v>
                </c:pt>
                <c:pt idx="478">
                  <c:v>4.4299999999999895E-4</c:v>
                </c:pt>
                <c:pt idx="479">
                  <c:v>2.8999999999999859E-4</c:v>
                </c:pt>
                <c:pt idx="480">
                  <c:v>3.2100000000000184E-4</c:v>
                </c:pt>
                <c:pt idx="481">
                  <c:v>3.6600000000000521E-4</c:v>
                </c:pt>
                <c:pt idx="482">
                  <c:v>3.9699999999999458E-4</c:v>
                </c:pt>
                <c:pt idx="483">
                  <c:v>3.5100000000000409E-4</c:v>
                </c:pt>
                <c:pt idx="484">
                  <c:v>2.440000000000081E-4</c:v>
                </c:pt>
                <c:pt idx="485">
                  <c:v>2.6000000000000328E-4</c:v>
                </c:pt>
                <c:pt idx="486">
                  <c:v>2.8999999999999859E-4</c:v>
                </c:pt>
                <c:pt idx="487">
                  <c:v>1.8300000000000261E-4</c:v>
                </c:pt>
                <c:pt idx="488">
                  <c:v>1.8300000000000261E-4</c:v>
                </c:pt>
                <c:pt idx="489">
                  <c:v>2.4400000000000116E-4</c:v>
                </c:pt>
                <c:pt idx="490">
                  <c:v>2.5899999999999535E-4</c:v>
                </c:pt>
                <c:pt idx="491">
                  <c:v>1.8300000000000261E-4</c:v>
                </c:pt>
                <c:pt idx="492">
                  <c:v>1.5300000000000036E-4</c:v>
                </c:pt>
                <c:pt idx="493">
                  <c:v>1.5199999999999936E-4</c:v>
                </c:pt>
                <c:pt idx="494">
                  <c:v>9.0999999999993864E-5</c:v>
                </c:pt>
                <c:pt idx="495">
                  <c:v>-3.1000000000003247E-5</c:v>
                </c:pt>
                <c:pt idx="496">
                  <c:v>-4.5999999999990493E-5</c:v>
                </c:pt>
                <c:pt idx="497">
                  <c:v>0</c:v>
                </c:pt>
                <c:pt idx="498">
                  <c:v>1.5000000000001124E-5</c:v>
                </c:pt>
                <c:pt idx="499">
                  <c:v>-4.4999999999996432E-5</c:v>
                </c:pt>
                <c:pt idx="500">
                  <c:v>0</c:v>
                </c:pt>
                <c:pt idx="501">
                  <c:v>4.6000000000004371E-5</c:v>
                </c:pt>
                <c:pt idx="502">
                  <c:v>1.6000000000002124E-5</c:v>
                </c:pt>
                <c:pt idx="503">
                  <c:v>-1.379999999999923E-4</c:v>
                </c:pt>
                <c:pt idx="504">
                  <c:v>-1.9800000000000373E-4</c:v>
                </c:pt>
                <c:pt idx="505">
                  <c:v>-9.1999999999994864E-5</c:v>
                </c:pt>
                <c:pt idx="506">
                  <c:v>-1.8400000000000361E-4</c:v>
                </c:pt>
                <c:pt idx="507">
                  <c:v>-2.8999999999999859E-4</c:v>
                </c:pt>
                <c:pt idx="508">
                  <c:v>-3.199999999999939E-4</c:v>
                </c:pt>
                <c:pt idx="509">
                  <c:v>-2.7399999999999647E-4</c:v>
                </c:pt>
                <c:pt idx="510">
                  <c:v>-2.9000000000000553E-4</c:v>
                </c:pt>
              </c:numCache>
            </c:numRef>
          </c:yVal>
          <c:smooth val="1"/>
          <c:extLst>
            <c:ext xmlns:c16="http://schemas.microsoft.com/office/drawing/2014/chart" uri="{C3380CC4-5D6E-409C-BE32-E72D297353CC}">
              <c16:uniqueId val="{00000000-88C3-40AF-8C20-400DE9C9AA78}"/>
            </c:ext>
          </c:extLst>
        </c:ser>
        <c:dLbls>
          <c:showLegendKey val="0"/>
          <c:showVal val="0"/>
          <c:showCatName val="0"/>
          <c:showSerName val="0"/>
          <c:showPercent val="0"/>
          <c:showBubbleSize val="0"/>
        </c:dLbls>
        <c:axId val="150248240"/>
        <c:axId val="150248800"/>
      </c:scatterChart>
      <c:valAx>
        <c:axId val="150248240"/>
        <c:scaling>
          <c:orientation val="minMax"/>
          <c:max val="307"/>
          <c:min val="265"/>
        </c:scaling>
        <c:delete val="0"/>
        <c:axPos val="b"/>
        <c:numFmt formatCode="General" sourceLinked="1"/>
        <c:majorTickMark val="out"/>
        <c:minorTickMark val="none"/>
        <c:tickLblPos val="nextTo"/>
        <c:txPr>
          <a:bodyPr/>
          <a:lstStyle/>
          <a:p>
            <a:pPr>
              <a:defRPr sz="800"/>
            </a:pPr>
            <a:endParaRPr lang="en-US"/>
          </a:p>
        </c:txPr>
        <c:crossAx val="150248800"/>
        <c:crosses val="autoZero"/>
        <c:crossBetween val="midCat"/>
        <c:majorUnit val="20"/>
        <c:minorUnit val="10"/>
      </c:valAx>
      <c:valAx>
        <c:axId val="150248800"/>
        <c:scaling>
          <c:orientation val="minMax"/>
          <c:max val="0.45"/>
          <c:min val="0"/>
        </c:scaling>
        <c:delete val="0"/>
        <c:axPos val="l"/>
        <c:numFmt formatCode="General" sourceLinked="1"/>
        <c:majorTickMark val="out"/>
        <c:minorTickMark val="none"/>
        <c:tickLblPos val="nextTo"/>
        <c:txPr>
          <a:bodyPr/>
          <a:lstStyle/>
          <a:p>
            <a:pPr>
              <a:defRPr sz="800"/>
            </a:pPr>
            <a:endParaRPr lang="en-US"/>
          </a:p>
        </c:txPr>
        <c:crossAx val="150248240"/>
        <c:crosses val="autoZero"/>
        <c:crossBetween val="midCat"/>
      </c:valAx>
    </c:plotArea>
    <c:plotVisOnly val="1"/>
    <c:dispBlanksAs val="gap"/>
    <c:showDLblsOverMax val="0"/>
  </c:chart>
  <c:externalData r:id="rId1">
    <c:autoUpdate val="0"/>
  </c:externalData>
</c:chartSpace>
</file>

<file path=ppt/charts/chart1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spPr>
            <a:ln>
              <a:solidFill>
                <a:schemeClr val="tx1"/>
              </a:solidFill>
            </a:ln>
          </c:spPr>
          <c:marker>
            <c:symbol val="none"/>
          </c:marker>
          <c:xVal>
            <c:numRef>
              <c:f>Sheet1!$A$3:$A$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J$3:$J$513</c:f>
              <c:numCache>
                <c:formatCode>General</c:formatCode>
                <c:ptCount val="511"/>
                <c:pt idx="0">
                  <c:v>12601.875000000013</c:v>
                </c:pt>
                <c:pt idx="1">
                  <c:v>773.43750000000159</c:v>
                </c:pt>
                <c:pt idx="2">
                  <c:v>-4617.6874999999955</c:v>
                </c:pt>
                <c:pt idx="3">
                  <c:v>-5162.24999999998</c:v>
                </c:pt>
                <c:pt idx="4">
                  <c:v>-839.25000000001364</c:v>
                </c:pt>
                <c:pt idx="5">
                  <c:v>5125.0625</c:v>
                </c:pt>
                <c:pt idx="6">
                  <c:v>1819.6250000000193</c:v>
                </c:pt>
                <c:pt idx="7">
                  <c:v>5801.1874999999991</c:v>
                </c:pt>
                <c:pt idx="8">
                  <c:v>4173.2500000000173</c:v>
                </c:pt>
                <c:pt idx="9">
                  <c:v>6103.5624999999927</c:v>
                </c:pt>
                <c:pt idx="10">
                  <c:v>0</c:v>
                </c:pt>
                <c:pt idx="11">
                  <c:v>98.249999999994174</c:v>
                </c:pt>
                <c:pt idx="12">
                  <c:v>1065.2499999999898</c:v>
                </c:pt>
                <c:pt idx="13">
                  <c:v>-122.06249999999197</c:v>
                </c:pt>
                <c:pt idx="14">
                  <c:v>41.999999999986493</c:v>
                </c:pt>
                <c:pt idx="15">
                  <c:v>3676.4374999999905</c:v>
                </c:pt>
                <c:pt idx="16">
                  <c:v>2957.3125000000036</c:v>
                </c:pt>
                <c:pt idx="17">
                  <c:v>-1252.1250000000207</c:v>
                </c:pt>
                <c:pt idx="18">
                  <c:v>-843.06249999999147</c:v>
                </c:pt>
                <c:pt idx="19">
                  <c:v>-3975.87499999999</c:v>
                </c:pt>
                <c:pt idx="20">
                  <c:v>5.7499999999988116</c:v>
                </c:pt>
                <c:pt idx="21">
                  <c:v>-2561.5625000000032</c:v>
                </c:pt>
                <c:pt idx="22">
                  <c:v>418.68749999998681</c:v>
                </c:pt>
                <c:pt idx="23">
                  <c:v>517.87500000000102</c:v>
                </c:pt>
                <c:pt idx="24">
                  <c:v>2099.9999999999909</c:v>
                </c:pt>
                <c:pt idx="25">
                  <c:v>-309.93749999999602</c:v>
                </c:pt>
                <c:pt idx="26">
                  <c:v>-613.18750000000091</c:v>
                </c:pt>
                <c:pt idx="27">
                  <c:v>372.87499999999477</c:v>
                </c:pt>
                <c:pt idx="28">
                  <c:v>-1130.0625000000009</c:v>
                </c:pt>
                <c:pt idx="29">
                  <c:v>-895.49999999999352</c:v>
                </c:pt>
                <c:pt idx="30">
                  <c:v>-522.62499999999886</c:v>
                </c:pt>
                <c:pt idx="31">
                  <c:v>0</c:v>
                </c:pt>
                <c:pt idx="32">
                  <c:v>1988.3749999999868</c:v>
                </c:pt>
                <c:pt idx="33">
                  <c:v>1164.4375000000041</c:v>
                </c:pt>
                <c:pt idx="34">
                  <c:v>695.18749999999966</c:v>
                </c:pt>
                <c:pt idx="35">
                  <c:v>363.37499999999915</c:v>
                </c:pt>
                <c:pt idx="36">
                  <c:v>333.8125000000025</c:v>
                </c:pt>
                <c:pt idx="37">
                  <c:v>0</c:v>
                </c:pt>
                <c:pt idx="38">
                  <c:v>-79.124999999985462</c:v>
                </c:pt>
                <c:pt idx="39">
                  <c:v>0</c:v>
                </c:pt>
                <c:pt idx="40">
                  <c:v>580.81249999999977</c:v>
                </c:pt>
                <c:pt idx="41">
                  <c:v>452.99999999998124</c:v>
                </c:pt>
                <c:pt idx="42">
                  <c:v>-206.00000000001174</c:v>
                </c:pt>
                <c:pt idx="43">
                  <c:v>45.750000000011063</c:v>
                </c:pt>
                <c:pt idx="44">
                  <c:v>184.06249999999847</c:v>
                </c:pt>
                <c:pt idx="45">
                  <c:v>1723.3124999999905</c:v>
                </c:pt>
                <c:pt idx="46">
                  <c:v>-1079.562499999992</c:v>
                </c:pt>
                <c:pt idx="47">
                  <c:v>-123.99999999998523</c:v>
                </c:pt>
                <c:pt idx="48">
                  <c:v>911.68750000000807</c:v>
                </c:pt>
                <c:pt idx="49">
                  <c:v>722.87500000001171</c:v>
                </c:pt>
                <c:pt idx="50">
                  <c:v>0</c:v>
                </c:pt>
                <c:pt idx="51">
                  <c:v>-263.18750000001171</c:v>
                </c:pt>
                <c:pt idx="52">
                  <c:v>-149.75000000000406</c:v>
                </c:pt>
                <c:pt idx="53">
                  <c:v>-158.31250000000742</c:v>
                </c:pt>
                <c:pt idx="54">
                  <c:v>-22.875000000005532</c:v>
                </c:pt>
                <c:pt idx="55">
                  <c:v>-40.062499999993229</c:v>
                </c:pt>
                <c:pt idx="56">
                  <c:v>484.49999999999886</c:v>
                </c:pt>
                <c:pt idx="57">
                  <c:v>1155.8750000000007</c:v>
                </c:pt>
                <c:pt idx="58">
                  <c:v>808.68749999998829</c:v>
                </c:pt>
                <c:pt idx="59">
                  <c:v>1409.5624999999891</c:v>
                </c:pt>
                <c:pt idx="60">
                  <c:v>4495.6249999999754</c:v>
                </c:pt>
                <c:pt idx="61">
                  <c:v>2158.1874999999918</c:v>
                </c:pt>
                <c:pt idx="62">
                  <c:v>-535.9375</c:v>
                </c:pt>
                <c:pt idx="63">
                  <c:v>1510.6249999999877</c:v>
                </c:pt>
                <c:pt idx="64">
                  <c:v>-6126.4374999999982</c:v>
                </c:pt>
                <c:pt idx="65">
                  <c:v>-4925.7500000000064</c:v>
                </c:pt>
                <c:pt idx="66">
                  <c:v>23995.437499999996</c:v>
                </c:pt>
                <c:pt idx="67">
                  <c:v>27172.062500000011</c:v>
                </c:pt>
                <c:pt idx="68">
                  <c:v>25342.937500000025</c:v>
                </c:pt>
                <c:pt idx="69">
                  <c:v>25261.875000000004</c:v>
                </c:pt>
                <c:pt idx="70">
                  <c:v>24040.187499999993</c:v>
                </c:pt>
                <c:pt idx="71">
                  <c:v>23245.812499999993</c:v>
                </c:pt>
                <c:pt idx="72">
                  <c:v>22742.3125</c:v>
                </c:pt>
                <c:pt idx="73">
                  <c:v>22131</c:v>
                </c:pt>
                <c:pt idx="74">
                  <c:v>21491.062500000007</c:v>
                </c:pt>
                <c:pt idx="75">
                  <c:v>20777.687499999996</c:v>
                </c:pt>
                <c:pt idx="76">
                  <c:v>20048.125</c:v>
                </c:pt>
                <c:pt idx="77">
                  <c:v>19306.187500000004</c:v>
                </c:pt>
                <c:pt idx="78">
                  <c:v>18570.875</c:v>
                </c:pt>
                <c:pt idx="79">
                  <c:v>17926.250000000007</c:v>
                </c:pt>
                <c:pt idx="80">
                  <c:v>17318.75</c:v>
                </c:pt>
                <c:pt idx="81">
                  <c:v>16721.75</c:v>
                </c:pt>
                <c:pt idx="82">
                  <c:v>16116.187499999998</c:v>
                </c:pt>
                <c:pt idx="83">
                  <c:v>15620.25</c:v>
                </c:pt>
                <c:pt idx="84">
                  <c:v>15064.250000000002</c:v>
                </c:pt>
                <c:pt idx="85">
                  <c:v>14620.812500000004</c:v>
                </c:pt>
                <c:pt idx="86">
                  <c:v>14267.937500000005</c:v>
                </c:pt>
                <c:pt idx="87">
                  <c:v>13969.437499999998</c:v>
                </c:pt>
                <c:pt idx="88">
                  <c:v>13812.062500000004</c:v>
                </c:pt>
                <c:pt idx="89">
                  <c:v>13700.499999999998</c:v>
                </c:pt>
                <c:pt idx="90">
                  <c:v>13687.125000000002</c:v>
                </c:pt>
                <c:pt idx="91">
                  <c:v>13766.312500000004</c:v>
                </c:pt>
                <c:pt idx="92">
                  <c:v>13876.9375</c:v>
                </c:pt>
                <c:pt idx="93">
                  <c:v>14091.500000000004</c:v>
                </c:pt>
                <c:pt idx="94">
                  <c:v>14329.875</c:v>
                </c:pt>
                <c:pt idx="95">
                  <c:v>14594.062499999998</c:v>
                </c:pt>
                <c:pt idx="96">
                  <c:v>14869.6875</c:v>
                </c:pt>
                <c:pt idx="97">
                  <c:v>15162.500000000002</c:v>
                </c:pt>
                <c:pt idx="98">
                  <c:v>15407.5625</c:v>
                </c:pt>
                <c:pt idx="99">
                  <c:v>15658.375000000004</c:v>
                </c:pt>
                <c:pt idx="100">
                  <c:v>15874.875</c:v>
                </c:pt>
                <c:pt idx="101">
                  <c:v>16037</c:v>
                </c:pt>
                <c:pt idx="102">
                  <c:v>16141.937499999998</c:v>
                </c:pt>
                <c:pt idx="103">
                  <c:v>16215.312500000004</c:v>
                </c:pt>
                <c:pt idx="104">
                  <c:v>16228.625</c:v>
                </c:pt>
                <c:pt idx="105">
                  <c:v>15459.0625</c:v>
                </c:pt>
                <c:pt idx="106">
                  <c:v>14687.562500000002</c:v>
                </c:pt>
                <c:pt idx="107">
                  <c:v>14739</c:v>
                </c:pt>
                <c:pt idx="108">
                  <c:v>14638</c:v>
                </c:pt>
                <c:pt idx="109">
                  <c:v>14541.625000000002</c:v>
                </c:pt>
                <c:pt idx="110">
                  <c:v>14558.812500000002</c:v>
                </c:pt>
                <c:pt idx="111">
                  <c:v>14293.687500000002</c:v>
                </c:pt>
                <c:pt idx="112">
                  <c:v>13856.937500000002</c:v>
                </c:pt>
                <c:pt idx="113">
                  <c:v>13537.437500000002</c:v>
                </c:pt>
                <c:pt idx="114">
                  <c:v>13155.9375</c:v>
                </c:pt>
                <c:pt idx="115">
                  <c:v>12750.625000000002</c:v>
                </c:pt>
                <c:pt idx="116">
                  <c:v>12951.8125</c:v>
                </c:pt>
                <c:pt idx="117">
                  <c:v>12336.750000000002</c:v>
                </c:pt>
                <c:pt idx="118">
                  <c:v>11724.5</c:v>
                </c:pt>
                <c:pt idx="119">
                  <c:v>11050.1875</c:v>
                </c:pt>
                <c:pt idx="120">
                  <c:v>10396</c:v>
                </c:pt>
                <c:pt idx="121">
                  <c:v>9679.7500000000018</c:v>
                </c:pt>
                <c:pt idx="122">
                  <c:v>9057.0625000000018</c:v>
                </c:pt>
                <c:pt idx="123">
                  <c:v>8355.1875</c:v>
                </c:pt>
                <c:pt idx="124">
                  <c:v>7625.5625</c:v>
                </c:pt>
                <c:pt idx="125">
                  <c:v>7000.9375000000009</c:v>
                </c:pt>
                <c:pt idx="126">
                  <c:v>6309.5</c:v>
                </c:pt>
                <c:pt idx="127">
                  <c:v>5630.5000000000009</c:v>
                </c:pt>
                <c:pt idx="128">
                  <c:v>5021.1250000000009</c:v>
                </c:pt>
                <c:pt idx="129">
                  <c:v>4407.8750000000009</c:v>
                </c:pt>
                <c:pt idx="130">
                  <c:v>3821.3750000000005</c:v>
                </c:pt>
                <c:pt idx="131">
                  <c:v>3322.6249999999995</c:v>
                </c:pt>
                <c:pt idx="132">
                  <c:v>2847.6874999999995</c:v>
                </c:pt>
                <c:pt idx="133">
                  <c:v>2463.3125000000005</c:v>
                </c:pt>
                <c:pt idx="134">
                  <c:v>2113.375</c:v>
                </c:pt>
                <c:pt idx="135">
                  <c:v>1766.1874999999995</c:v>
                </c:pt>
                <c:pt idx="136">
                  <c:v>1544.0000000000002</c:v>
                </c:pt>
                <c:pt idx="137">
                  <c:v>1276.0624999999995</c:v>
                </c:pt>
                <c:pt idx="138">
                  <c:v>1083.3125000000002</c:v>
                </c:pt>
                <c:pt idx="139">
                  <c:v>917.4375000000008</c:v>
                </c:pt>
                <c:pt idx="140">
                  <c:v>743.81249999999977</c:v>
                </c:pt>
                <c:pt idx="141">
                  <c:v>564.5625</c:v>
                </c:pt>
                <c:pt idx="142">
                  <c:v>512.12499999999955</c:v>
                </c:pt>
                <c:pt idx="143">
                  <c:v>483.56250000000051</c:v>
                </c:pt>
                <c:pt idx="144">
                  <c:v>416.81249999999966</c:v>
                </c:pt>
                <c:pt idx="145">
                  <c:v>328.99999999999943</c:v>
                </c:pt>
                <c:pt idx="146">
                  <c:v>279.43750000000017</c:v>
                </c:pt>
                <c:pt idx="147">
                  <c:v>246.06249999999977</c:v>
                </c:pt>
                <c:pt idx="148">
                  <c:v>202.12500000000006</c:v>
                </c:pt>
                <c:pt idx="149">
                  <c:v>171.62499999999991</c:v>
                </c:pt>
                <c:pt idx="150">
                  <c:v>165.93749999999986</c:v>
                </c:pt>
                <c:pt idx="151">
                  <c:v>154.49999999999969</c:v>
                </c:pt>
                <c:pt idx="152">
                  <c:v>151.62499999999986</c:v>
                </c:pt>
                <c:pt idx="153">
                  <c:v>131.6249999999998</c:v>
                </c:pt>
                <c:pt idx="154">
                  <c:v>115.37500000000003</c:v>
                </c:pt>
                <c:pt idx="155">
                  <c:v>119.25</c:v>
                </c:pt>
                <c:pt idx="156">
                  <c:v>115.43749999999966</c:v>
                </c:pt>
                <c:pt idx="157">
                  <c:v>139.25000000000006</c:v>
                </c:pt>
                <c:pt idx="158">
                  <c:v>107.75000000000021</c:v>
                </c:pt>
                <c:pt idx="159">
                  <c:v>112.56250000000026</c:v>
                </c:pt>
                <c:pt idx="160">
                  <c:v>96.312500000000043</c:v>
                </c:pt>
                <c:pt idx="161">
                  <c:v>98.250000000000256</c:v>
                </c:pt>
                <c:pt idx="162">
                  <c:v>98.187500000000185</c:v>
                </c:pt>
                <c:pt idx="163">
                  <c:v>105.87500000000007</c:v>
                </c:pt>
                <c:pt idx="164">
                  <c:v>85.812499999999957</c:v>
                </c:pt>
                <c:pt idx="165">
                  <c:v>82.999999999999744</c:v>
                </c:pt>
                <c:pt idx="166">
                  <c:v>86.812500000000085</c:v>
                </c:pt>
                <c:pt idx="167">
                  <c:v>83.937499999999815</c:v>
                </c:pt>
                <c:pt idx="168">
                  <c:v>82.937500000000114</c:v>
                </c:pt>
                <c:pt idx="169">
                  <c:v>78.187500000000142</c:v>
                </c:pt>
                <c:pt idx="170">
                  <c:v>71.499999999999957</c:v>
                </c:pt>
                <c:pt idx="171">
                  <c:v>64.812499999999773</c:v>
                </c:pt>
                <c:pt idx="172">
                  <c:v>86.812500000000085</c:v>
                </c:pt>
                <c:pt idx="173">
                  <c:v>76.3125</c:v>
                </c:pt>
                <c:pt idx="174">
                  <c:v>75.312499999999858</c:v>
                </c:pt>
                <c:pt idx="175">
                  <c:v>58.187500000000085</c:v>
                </c:pt>
                <c:pt idx="176">
                  <c:v>54.374999999999737</c:v>
                </c:pt>
                <c:pt idx="177">
                  <c:v>52.437499999999972</c:v>
                </c:pt>
                <c:pt idx="178">
                  <c:v>55.312500000000242</c:v>
                </c:pt>
                <c:pt idx="179">
                  <c:v>53.375000000000043</c:v>
                </c:pt>
                <c:pt idx="180">
                  <c:v>63.875000000000135</c:v>
                </c:pt>
                <c:pt idx="181">
                  <c:v>54.374999999999737</c:v>
                </c:pt>
                <c:pt idx="182">
                  <c:v>40.062499999999737</c:v>
                </c:pt>
                <c:pt idx="183">
                  <c:v>62.937500000000064</c:v>
                </c:pt>
                <c:pt idx="184">
                  <c:v>58.187500000000085</c:v>
                </c:pt>
                <c:pt idx="185">
                  <c:v>64.874999999999829</c:v>
                </c:pt>
                <c:pt idx="186">
                  <c:v>58.187500000000085</c:v>
                </c:pt>
                <c:pt idx="187">
                  <c:v>54.374999999999737</c:v>
                </c:pt>
                <c:pt idx="188">
                  <c:v>57.250000000000014</c:v>
                </c:pt>
                <c:pt idx="189">
                  <c:v>61.062499999999922</c:v>
                </c:pt>
                <c:pt idx="190">
                  <c:v>61.999999999999993</c:v>
                </c:pt>
                <c:pt idx="191">
                  <c:v>61.999999999999993</c:v>
                </c:pt>
                <c:pt idx="192">
                  <c:v>64.874999999999829</c:v>
                </c:pt>
                <c:pt idx="193">
                  <c:v>61.000000000000291</c:v>
                </c:pt>
                <c:pt idx="194">
                  <c:v>80.124999999999901</c:v>
                </c:pt>
                <c:pt idx="195">
                  <c:v>60.062499999999787</c:v>
                </c:pt>
                <c:pt idx="196">
                  <c:v>54.312500000000107</c:v>
                </c:pt>
                <c:pt idx="197">
                  <c:v>62.937500000000064</c:v>
                </c:pt>
                <c:pt idx="198">
                  <c:v>65.812499999999901</c:v>
                </c:pt>
                <c:pt idx="199">
                  <c:v>52.437499999999972</c:v>
                </c:pt>
                <c:pt idx="200">
                  <c:v>58.187500000000085</c:v>
                </c:pt>
                <c:pt idx="201">
                  <c:v>51.499999999999901</c:v>
                </c:pt>
                <c:pt idx="202">
                  <c:v>62.937500000000064</c:v>
                </c:pt>
                <c:pt idx="203">
                  <c:v>61.062499999999922</c:v>
                </c:pt>
                <c:pt idx="204">
                  <c:v>58.187500000000085</c:v>
                </c:pt>
                <c:pt idx="205">
                  <c:v>48.687500000000121</c:v>
                </c:pt>
                <c:pt idx="206">
                  <c:v>57.187500000000384</c:v>
                </c:pt>
                <c:pt idx="207">
                  <c:v>54.374999999999737</c:v>
                </c:pt>
                <c:pt idx="208">
                  <c:v>61.937499999999929</c:v>
                </c:pt>
                <c:pt idx="209">
                  <c:v>58.187500000000085</c:v>
                </c:pt>
                <c:pt idx="210">
                  <c:v>60.06250000000022</c:v>
                </c:pt>
                <c:pt idx="211">
                  <c:v>61.062500000000355</c:v>
                </c:pt>
                <c:pt idx="212">
                  <c:v>58.187500000000085</c:v>
                </c:pt>
                <c:pt idx="213">
                  <c:v>50.499999999999766</c:v>
                </c:pt>
                <c:pt idx="214">
                  <c:v>61.999999999999993</c:v>
                </c:pt>
                <c:pt idx="215">
                  <c:v>60.06250000000022</c:v>
                </c:pt>
                <c:pt idx="216">
                  <c:v>53.375000000000043</c:v>
                </c:pt>
                <c:pt idx="217">
                  <c:v>47.687499999999986</c:v>
                </c:pt>
                <c:pt idx="218">
                  <c:v>56.312499999999943</c:v>
                </c:pt>
                <c:pt idx="219">
                  <c:v>57.18749999999995</c:v>
                </c:pt>
                <c:pt idx="220">
                  <c:v>59.124999999999716</c:v>
                </c:pt>
                <c:pt idx="221">
                  <c:v>53.375000000000043</c:v>
                </c:pt>
                <c:pt idx="222">
                  <c:v>54.374999999999737</c:v>
                </c:pt>
                <c:pt idx="223">
                  <c:v>51.499999999999901</c:v>
                </c:pt>
                <c:pt idx="224">
                  <c:v>55.312500000000242</c:v>
                </c:pt>
                <c:pt idx="225">
                  <c:v>59.125000000000149</c:v>
                </c:pt>
                <c:pt idx="226">
                  <c:v>51.499999999999901</c:v>
                </c:pt>
                <c:pt idx="227">
                  <c:v>54.375000000000171</c:v>
                </c:pt>
                <c:pt idx="228">
                  <c:v>52.437499999999972</c:v>
                </c:pt>
                <c:pt idx="229">
                  <c:v>46.750000000000355</c:v>
                </c:pt>
                <c:pt idx="230">
                  <c:v>47.687499999999986</c:v>
                </c:pt>
                <c:pt idx="231">
                  <c:v>53.375000000000043</c:v>
                </c:pt>
                <c:pt idx="232">
                  <c:v>54.375000000000171</c:v>
                </c:pt>
                <c:pt idx="233">
                  <c:v>52.437499999999972</c:v>
                </c:pt>
                <c:pt idx="234">
                  <c:v>55.312500000000242</c:v>
                </c:pt>
                <c:pt idx="235">
                  <c:v>55.312500000000242</c:v>
                </c:pt>
                <c:pt idx="236">
                  <c:v>53.375000000000043</c:v>
                </c:pt>
                <c:pt idx="237">
                  <c:v>49.562500000000128</c:v>
                </c:pt>
                <c:pt idx="238">
                  <c:v>52.500000000000028</c:v>
                </c:pt>
                <c:pt idx="239">
                  <c:v>50.562499999999829</c:v>
                </c:pt>
                <c:pt idx="240">
                  <c:v>49.562499999999694</c:v>
                </c:pt>
                <c:pt idx="241">
                  <c:v>49.562499999999694</c:v>
                </c:pt>
                <c:pt idx="242">
                  <c:v>51.499999999999901</c:v>
                </c:pt>
                <c:pt idx="243">
                  <c:v>52.437499999999972</c:v>
                </c:pt>
                <c:pt idx="244">
                  <c:v>53.375000000000043</c:v>
                </c:pt>
                <c:pt idx="245">
                  <c:v>54.374999999999737</c:v>
                </c:pt>
                <c:pt idx="246">
                  <c:v>54.312500000000107</c:v>
                </c:pt>
                <c:pt idx="247">
                  <c:v>55.312499999999808</c:v>
                </c:pt>
                <c:pt idx="248">
                  <c:v>48.625000000000057</c:v>
                </c:pt>
                <c:pt idx="249">
                  <c:v>49.624999999999758</c:v>
                </c:pt>
                <c:pt idx="250">
                  <c:v>52.500000000000028</c:v>
                </c:pt>
                <c:pt idx="251">
                  <c:v>47.687499999999986</c:v>
                </c:pt>
                <c:pt idx="252">
                  <c:v>47.687499999999986</c:v>
                </c:pt>
                <c:pt idx="253">
                  <c:v>53.437500000000099</c:v>
                </c:pt>
                <c:pt idx="254">
                  <c:v>50.562500000000263</c:v>
                </c:pt>
                <c:pt idx="255">
                  <c:v>51.500000000000334</c:v>
                </c:pt>
                <c:pt idx="256">
                  <c:v>52.437499999999972</c:v>
                </c:pt>
                <c:pt idx="257">
                  <c:v>49.562499999999694</c:v>
                </c:pt>
                <c:pt idx="258">
                  <c:v>49.625000000000192</c:v>
                </c:pt>
                <c:pt idx="259">
                  <c:v>47.687499999999986</c:v>
                </c:pt>
                <c:pt idx="260">
                  <c:v>50.562499999999829</c:v>
                </c:pt>
                <c:pt idx="261">
                  <c:v>50.499999999999766</c:v>
                </c:pt>
                <c:pt idx="262">
                  <c:v>48.625000000000057</c:v>
                </c:pt>
                <c:pt idx="263">
                  <c:v>51.499999999999901</c:v>
                </c:pt>
                <c:pt idx="264">
                  <c:v>48.687500000000121</c:v>
                </c:pt>
                <c:pt idx="265">
                  <c:v>51.499999999999901</c:v>
                </c:pt>
                <c:pt idx="266">
                  <c:v>52.437499999999972</c:v>
                </c:pt>
                <c:pt idx="267">
                  <c:v>51.500000000000334</c:v>
                </c:pt>
                <c:pt idx="268">
                  <c:v>51.499999999999901</c:v>
                </c:pt>
                <c:pt idx="269">
                  <c:v>50.562499999999829</c:v>
                </c:pt>
                <c:pt idx="270">
                  <c:v>47.687499999999986</c:v>
                </c:pt>
                <c:pt idx="271">
                  <c:v>51.499999999999901</c:v>
                </c:pt>
                <c:pt idx="272">
                  <c:v>48.625000000000057</c:v>
                </c:pt>
                <c:pt idx="273">
                  <c:v>44.875000000000213</c:v>
                </c:pt>
                <c:pt idx="274">
                  <c:v>49.624999999999758</c:v>
                </c:pt>
                <c:pt idx="275">
                  <c:v>47.687499999999986</c:v>
                </c:pt>
                <c:pt idx="276">
                  <c:v>50.499999999999766</c:v>
                </c:pt>
                <c:pt idx="277">
                  <c:v>50.562499999999829</c:v>
                </c:pt>
                <c:pt idx="278">
                  <c:v>47.687499999999986</c:v>
                </c:pt>
                <c:pt idx="279">
                  <c:v>47.687499999999986</c:v>
                </c:pt>
                <c:pt idx="280">
                  <c:v>49.562499999999694</c:v>
                </c:pt>
                <c:pt idx="281">
                  <c:v>50.562500000000263</c:v>
                </c:pt>
                <c:pt idx="282">
                  <c:v>47.687499999999986</c:v>
                </c:pt>
                <c:pt idx="283">
                  <c:v>48.625000000000057</c:v>
                </c:pt>
                <c:pt idx="284">
                  <c:v>46.749999999999922</c:v>
                </c:pt>
                <c:pt idx="285">
                  <c:v>48.687499999999687</c:v>
                </c:pt>
                <c:pt idx="286">
                  <c:v>42.937500000000007</c:v>
                </c:pt>
                <c:pt idx="287">
                  <c:v>44.87499999999978</c:v>
                </c:pt>
                <c:pt idx="288">
                  <c:v>47.687499999999986</c:v>
                </c:pt>
                <c:pt idx="289">
                  <c:v>47.687499999999986</c:v>
                </c:pt>
                <c:pt idx="290">
                  <c:v>47.687499999999986</c:v>
                </c:pt>
                <c:pt idx="291">
                  <c:v>46.749999999999922</c:v>
                </c:pt>
                <c:pt idx="292">
                  <c:v>42.875000000000377</c:v>
                </c:pt>
                <c:pt idx="293">
                  <c:v>45.749999999999787</c:v>
                </c:pt>
                <c:pt idx="294">
                  <c:v>50.500000000000199</c:v>
                </c:pt>
                <c:pt idx="295">
                  <c:v>50.500000000000199</c:v>
                </c:pt>
                <c:pt idx="296">
                  <c:v>49.562500000000128</c:v>
                </c:pt>
                <c:pt idx="297">
                  <c:v>49.562500000000128</c:v>
                </c:pt>
                <c:pt idx="298">
                  <c:v>51.499999999999901</c:v>
                </c:pt>
                <c:pt idx="299">
                  <c:v>50.562499999999829</c:v>
                </c:pt>
                <c:pt idx="300">
                  <c:v>45.75000000000022</c:v>
                </c:pt>
                <c:pt idx="301">
                  <c:v>46.687500000000291</c:v>
                </c:pt>
                <c:pt idx="302">
                  <c:v>46.749999999999922</c:v>
                </c:pt>
                <c:pt idx="303">
                  <c:v>45.749999999999787</c:v>
                </c:pt>
                <c:pt idx="304">
                  <c:v>43.875000000000078</c:v>
                </c:pt>
                <c:pt idx="305">
                  <c:v>46.750000000000355</c:v>
                </c:pt>
                <c:pt idx="306">
                  <c:v>46.687500000000291</c:v>
                </c:pt>
                <c:pt idx="307">
                  <c:v>44.812499999999716</c:v>
                </c:pt>
                <c:pt idx="308">
                  <c:v>49.562499999999694</c:v>
                </c:pt>
                <c:pt idx="309">
                  <c:v>49.624999999999758</c:v>
                </c:pt>
                <c:pt idx="310">
                  <c:v>44.812500000000149</c:v>
                </c:pt>
                <c:pt idx="311">
                  <c:v>43.875000000000078</c:v>
                </c:pt>
                <c:pt idx="312">
                  <c:v>46.687499999999858</c:v>
                </c:pt>
                <c:pt idx="313">
                  <c:v>45.75000000000022</c:v>
                </c:pt>
                <c:pt idx="314">
                  <c:v>44.87499999999978</c:v>
                </c:pt>
                <c:pt idx="315">
                  <c:v>44.87499999999978</c:v>
                </c:pt>
                <c:pt idx="316">
                  <c:v>48.625000000000057</c:v>
                </c:pt>
                <c:pt idx="317">
                  <c:v>43.875000000000078</c:v>
                </c:pt>
                <c:pt idx="318">
                  <c:v>41.937499999999879</c:v>
                </c:pt>
                <c:pt idx="319">
                  <c:v>42.875000000000377</c:v>
                </c:pt>
                <c:pt idx="320">
                  <c:v>39.124999999999666</c:v>
                </c:pt>
                <c:pt idx="321">
                  <c:v>40.062499999999737</c:v>
                </c:pt>
                <c:pt idx="322">
                  <c:v>42.937500000000007</c:v>
                </c:pt>
                <c:pt idx="323">
                  <c:v>44.812499999999716</c:v>
                </c:pt>
                <c:pt idx="324">
                  <c:v>44.812500000000149</c:v>
                </c:pt>
                <c:pt idx="325">
                  <c:v>44.812499999999716</c:v>
                </c:pt>
                <c:pt idx="326">
                  <c:v>42.874999999999943</c:v>
                </c:pt>
                <c:pt idx="327">
                  <c:v>42.875000000000377</c:v>
                </c:pt>
                <c:pt idx="328">
                  <c:v>39.062500000000036</c:v>
                </c:pt>
                <c:pt idx="329">
                  <c:v>41.999999999999936</c:v>
                </c:pt>
                <c:pt idx="330">
                  <c:v>40.999999999999808</c:v>
                </c:pt>
                <c:pt idx="331">
                  <c:v>41.999999999999936</c:v>
                </c:pt>
                <c:pt idx="332">
                  <c:v>41.937499999999879</c:v>
                </c:pt>
                <c:pt idx="333">
                  <c:v>40.999999999999808</c:v>
                </c:pt>
                <c:pt idx="334">
                  <c:v>39.062500000000036</c:v>
                </c:pt>
                <c:pt idx="335">
                  <c:v>42.937500000000007</c:v>
                </c:pt>
                <c:pt idx="336">
                  <c:v>34.312500000000057</c:v>
                </c:pt>
                <c:pt idx="337">
                  <c:v>32.437499999999915</c:v>
                </c:pt>
                <c:pt idx="338">
                  <c:v>37.187499999999893</c:v>
                </c:pt>
                <c:pt idx="339">
                  <c:v>36.249999999999822</c:v>
                </c:pt>
                <c:pt idx="340">
                  <c:v>42.874999999999943</c:v>
                </c:pt>
                <c:pt idx="341">
                  <c:v>47.687499999999986</c:v>
                </c:pt>
                <c:pt idx="342">
                  <c:v>40.062500000000171</c:v>
                </c:pt>
                <c:pt idx="343">
                  <c:v>37.187499999999893</c:v>
                </c:pt>
                <c:pt idx="344">
                  <c:v>37.249999999999957</c:v>
                </c:pt>
                <c:pt idx="345">
                  <c:v>34.375000000000121</c:v>
                </c:pt>
                <c:pt idx="346">
                  <c:v>36.187500000000199</c:v>
                </c:pt>
                <c:pt idx="347">
                  <c:v>34.312500000000057</c:v>
                </c:pt>
                <c:pt idx="348">
                  <c:v>33.374999999999986</c:v>
                </c:pt>
                <c:pt idx="349">
                  <c:v>38.124999999999964</c:v>
                </c:pt>
                <c:pt idx="350">
                  <c:v>38.124999999999964</c:v>
                </c:pt>
                <c:pt idx="351">
                  <c:v>38.187500000000028</c:v>
                </c:pt>
                <c:pt idx="352">
                  <c:v>35.250000000000128</c:v>
                </c:pt>
                <c:pt idx="353">
                  <c:v>35.312499999999758</c:v>
                </c:pt>
                <c:pt idx="354">
                  <c:v>34.312500000000057</c:v>
                </c:pt>
                <c:pt idx="355">
                  <c:v>34.312500000000057</c:v>
                </c:pt>
                <c:pt idx="356">
                  <c:v>34.374999999999687</c:v>
                </c:pt>
                <c:pt idx="357">
                  <c:v>35.312500000000192</c:v>
                </c:pt>
                <c:pt idx="358">
                  <c:v>36.250000000000263</c:v>
                </c:pt>
                <c:pt idx="359">
                  <c:v>37.187499999999893</c:v>
                </c:pt>
                <c:pt idx="360">
                  <c:v>35.250000000000128</c:v>
                </c:pt>
                <c:pt idx="361">
                  <c:v>35.312500000000192</c:v>
                </c:pt>
                <c:pt idx="362">
                  <c:v>37.249999999999957</c:v>
                </c:pt>
                <c:pt idx="363">
                  <c:v>39.062500000000036</c:v>
                </c:pt>
                <c:pt idx="364">
                  <c:v>40.062500000000171</c:v>
                </c:pt>
                <c:pt idx="365">
                  <c:v>40.999999999999808</c:v>
                </c:pt>
                <c:pt idx="366">
                  <c:v>33.374999999999986</c:v>
                </c:pt>
                <c:pt idx="367">
                  <c:v>34.312500000000057</c:v>
                </c:pt>
                <c:pt idx="368">
                  <c:v>31.437499999999783</c:v>
                </c:pt>
                <c:pt idx="369">
                  <c:v>30.500000000000146</c:v>
                </c:pt>
                <c:pt idx="370">
                  <c:v>35.312499999999758</c:v>
                </c:pt>
                <c:pt idx="371">
                  <c:v>38.187500000000028</c:v>
                </c:pt>
                <c:pt idx="372">
                  <c:v>38.187500000000028</c:v>
                </c:pt>
                <c:pt idx="373">
                  <c:v>37.249999999999957</c:v>
                </c:pt>
                <c:pt idx="374">
                  <c:v>33.374999999999986</c:v>
                </c:pt>
                <c:pt idx="375">
                  <c:v>33.374999999999986</c:v>
                </c:pt>
                <c:pt idx="376">
                  <c:v>38.187500000000028</c:v>
                </c:pt>
                <c:pt idx="377">
                  <c:v>37.187499999999893</c:v>
                </c:pt>
                <c:pt idx="378">
                  <c:v>39.124999999999666</c:v>
                </c:pt>
                <c:pt idx="379">
                  <c:v>37.187499999999893</c:v>
                </c:pt>
                <c:pt idx="380">
                  <c:v>39.125000000000099</c:v>
                </c:pt>
                <c:pt idx="381">
                  <c:v>38.187500000000028</c:v>
                </c:pt>
                <c:pt idx="382">
                  <c:v>40.062499999999737</c:v>
                </c:pt>
                <c:pt idx="383">
                  <c:v>41.999999999999936</c:v>
                </c:pt>
                <c:pt idx="384">
                  <c:v>45.749999999999787</c:v>
                </c:pt>
                <c:pt idx="385">
                  <c:v>47.687499999999986</c:v>
                </c:pt>
                <c:pt idx="386">
                  <c:v>47.687499999999986</c:v>
                </c:pt>
                <c:pt idx="387">
                  <c:v>44.812500000000149</c:v>
                </c:pt>
                <c:pt idx="388">
                  <c:v>44.87499999999978</c:v>
                </c:pt>
                <c:pt idx="389">
                  <c:v>51.499999999999901</c:v>
                </c:pt>
                <c:pt idx="390">
                  <c:v>54.375000000000171</c:v>
                </c:pt>
                <c:pt idx="391">
                  <c:v>54.312500000000107</c:v>
                </c:pt>
                <c:pt idx="392">
                  <c:v>56.312499999999943</c:v>
                </c:pt>
                <c:pt idx="393">
                  <c:v>58.187499999999652</c:v>
                </c:pt>
                <c:pt idx="394">
                  <c:v>61.999999999999993</c:v>
                </c:pt>
                <c:pt idx="395">
                  <c:v>66.750000000000412</c:v>
                </c:pt>
                <c:pt idx="396">
                  <c:v>68.687500000000171</c:v>
                </c:pt>
                <c:pt idx="397">
                  <c:v>69.562500000000185</c:v>
                </c:pt>
                <c:pt idx="398">
                  <c:v>71.499999999999957</c:v>
                </c:pt>
                <c:pt idx="399">
                  <c:v>70.562500000000313</c:v>
                </c:pt>
                <c:pt idx="400">
                  <c:v>71.499999999999957</c:v>
                </c:pt>
                <c:pt idx="401">
                  <c:v>72.437500000000028</c:v>
                </c:pt>
                <c:pt idx="402">
                  <c:v>82.000000000000043</c:v>
                </c:pt>
                <c:pt idx="403">
                  <c:v>83.937500000000242</c:v>
                </c:pt>
                <c:pt idx="404">
                  <c:v>85.812499999999957</c:v>
                </c:pt>
                <c:pt idx="405">
                  <c:v>88.687499999999801</c:v>
                </c:pt>
                <c:pt idx="406">
                  <c:v>89.624999999999872</c:v>
                </c:pt>
                <c:pt idx="407">
                  <c:v>92.500000000000142</c:v>
                </c:pt>
                <c:pt idx="408">
                  <c:v>97.250000000000114</c:v>
                </c:pt>
                <c:pt idx="409">
                  <c:v>100.18750000000001</c:v>
                </c:pt>
                <c:pt idx="410">
                  <c:v>101.06250000000003</c:v>
                </c:pt>
                <c:pt idx="411">
                  <c:v>101.12500000000009</c:v>
                </c:pt>
                <c:pt idx="412">
                  <c:v>102.0000000000001</c:v>
                </c:pt>
                <c:pt idx="413">
                  <c:v>102.0000000000001</c:v>
                </c:pt>
                <c:pt idx="414">
                  <c:v>107.74999999999977</c:v>
                </c:pt>
                <c:pt idx="415">
                  <c:v>109.68749999999999</c:v>
                </c:pt>
                <c:pt idx="416">
                  <c:v>107.74999999999977</c:v>
                </c:pt>
                <c:pt idx="417">
                  <c:v>108.74999999999991</c:v>
                </c:pt>
                <c:pt idx="418">
                  <c:v>112.56250000000026</c:v>
                </c:pt>
                <c:pt idx="419">
                  <c:v>111.56250000000013</c:v>
                </c:pt>
                <c:pt idx="420">
                  <c:v>112.56249999999982</c:v>
                </c:pt>
                <c:pt idx="421">
                  <c:v>107.75000000000021</c:v>
                </c:pt>
                <c:pt idx="422">
                  <c:v>105.87500000000007</c:v>
                </c:pt>
                <c:pt idx="423">
                  <c:v>107.81249999999984</c:v>
                </c:pt>
                <c:pt idx="424">
                  <c:v>108.68750000000028</c:v>
                </c:pt>
                <c:pt idx="425">
                  <c:v>110.62500000000006</c:v>
                </c:pt>
                <c:pt idx="426">
                  <c:v>106.81250000000014</c:v>
                </c:pt>
                <c:pt idx="427">
                  <c:v>106.81250000000014</c:v>
                </c:pt>
                <c:pt idx="428">
                  <c:v>109.68749999999999</c:v>
                </c:pt>
                <c:pt idx="429">
                  <c:v>104.87500000000037</c:v>
                </c:pt>
                <c:pt idx="430">
                  <c:v>100.12499999999996</c:v>
                </c:pt>
                <c:pt idx="431">
                  <c:v>106.8124999999997</c:v>
                </c:pt>
                <c:pt idx="432">
                  <c:v>105.87499999999963</c:v>
                </c:pt>
                <c:pt idx="433">
                  <c:v>102.9999999999998</c:v>
                </c:pt>
                <c:pt idx="434">
                  <c:v>105.81250000000001</c:v>
                </c:pt>
                <c:pt idx="435">
                  <c:v>107.74999999999977</c:v>
                </c:pt>
                <c:pt idx="436">
                  <c:v>106.81250000000014</c:v>
                </c:pt>
                <c:pt idx="437">
                  <c:v>105.81250000000001</c:v>
                </c:pt>
                <c:pt idx="438">
                  <c:v>106.81250000000014</c:v>
                </c:pt>
                <c:pt idx="439">
                  <c:v>102.9999999999998</c:v>
                </c:pt>
                <c:pt idx="440">
                  <c:v>102.93750000000017</c:v>
                </c:pt>
                <c:pt idx="441">
                  <c:v>99.124999999999829</c:v>
                </c:pt>
                <c:pt idx="442">
                  <c:v>101.12500000000009</c:v>
                </c:pt>
                <c:pt idx="443">
                  <c:v>109.68749999999999</c:v>
                </c:pt>
                <c:pt idx="444">
                  <c:v>109.68749999999999</c:v>
                </c:pt>
                <c:pt idx="445">
                  <c:v>107.75000000000021</c:v>
                </c:pt>
                <c:pt idx="446">
                  <c:v>107.75000000000021</c:v>
                </c:pt>
                <c:pt idx="447">
                  <c:v>111.56250000000013</c:v>
                </c:pt>
                <c:pt idx="448">
                  <c:v>104.87499999999994</c:v>
                </c:pt>
                <c:pt idx="449">
                  <c:v>104.9375</c:v>
                </c:pt>
                <c:pt idx="450">
                  <c:v>104.9375</c:v>
                </c:pt>
                <c:pt idx="451">
                  <c:v>104.87499999999994</c:v>
                </c:pt>
                <c:pt idx="452">
                  <c:v>101.12500000000009</c:v>
                </c:pt>
                <c:pt idx="453">
                  <c:v>98.250000000000256</c:v>
                </c:pt>
                <c:pt idx="454">
                  <c:v>98.249999999999815</c:v>
                </c:pt>
                <c:pt idx="455">
                  <c:v>96.312500000000043</c:v>
                </c:pt>
                <c:pt idx="456">
                  <c:v>92.500000000000142</c:v>
                </c:pt>
                <c:pt idx="457">
                  <c:v>90.625</c:v>
                </c:pt>
                <c:pt idx="458">
                  <c:v>85.875000000000014</c:v>
                </c:pt>
                <c:pt idx="459">
                  <c:v>82.999999999999744</c:v>
                </c:pt>
                <c:pt idx="460">
                  <c:v>81.062499999999972</c:v>
                </c:pt>
                <c:pt idx="461">
                  <c:v>79.187499999999829</c:v>
                </c:pt>
                <c:pt idx="462">
                  <c:v>78.249999999999758</c:v>
                </c:pt>
                <c:pt idx="463">
                  <c:v>72.500000000000085</c:v>
                </c:pt>
                <c:pt idx="464">
                  <c:v>65.812500000000341</c:v>
                </c:pt>
                <c:pt idx="465">
                  <c:v>62.937500000000064</c:v>
                </c:pt>
                <c:pt idx="466">
                  <c:v>61.999999999999993</c:v>
                </c:pt>
                <c:pt idx="467">
                  <c:v>61.062499999999922</c:v>
                </c:pt>
                <c:pt idx="468">
                  <c:v>58.187500000000085</c:v>
                </c:pt>
                <c:pt idx="469">
                  <c:v>54.312500000000107</c:v>
                </c:pt>
                <c:pt idx="470">
                  <c:v>51.499999999999901</c:v>
                </c:pt>
                <c:pt idx="471">
                  <c:v>48.625000000000057</c:v>
                </c:pt>
                <c:pt idx="472">
                  <c:v>47.687499999999986</c:v>
                </c:pt>
                <c:pt idx="473">
                  <c:v>42.937500000000007</c:v>
                </c:pt>
                <c:pt idx="474">
                  <c:v>39.062500000000036</c:v>
                </c:pt>
                <c:pt idx="475">
                  <c:v>38.187500000000028</c:v>
                </c:pt>
                <c:pt idx="476">
                  <c:v>37.187499999999893</c:v>
                </c:pt>
                <c:pt idx="477">
                  <c:v>35.312500000000192</c:v>
                </c:pt>
                <c:pt idx="478">
                  <c:v>32.437500000000348</c:v>
                </c:pt>
                <c:pt idx="479">
                  <c:v>29.562500000000075</c:v>
                </c:pt>
                <c:pt idx="480">
                  <c:v>29.562500000000075</c:v>
                </c:pt>
                <c:pt idx="481">
                  <c:v>28.625000000000007</c:v>
                </c:pt>
                <c:pt idx="482">
                  <c:v>28.625000000000007</c:v>
                </c:pt>
                <c:pt idx="483">
                  <c:v>24.812500000000096</c:v>
                </c:pt>
                <c:pt idx="484">
                  <c:v>20.000000000000053</c:v>
                </c:pt>
                <c:pt idx="485">
                  <c:v>22.874999999999893</c:v>
                </c:pt>
                <c:pt idx="486">
                  <c:v>23.812499999999964</c:v>
                </c:pt>
                <c:pt idx="487">
                  <c:v>25.750000000000167</c:v>
                </c:pt>
                <c:pt idx="488">
                  <c:v>27.687499999999936</c:v>
                </c:pt>
                <c:pt idx="489">
                  <c:v>26.687500000000238</c:v>
                </c:pt>
                <c:pt idx="490">
                  <c:v>20.937499999999691</c:v>
                </c:pt>
                <c:pt idx="491">
                  <c:v>22.874999999999893</c:v>
                </c:pt>
                <c:pt idx="492">
                  <c:v>21.937499999999822</c:v>
                </c:pt>
                <c:pt idx="493">
                  <c:v>22.874999999999893</c:v>
                </c:pt>
                <c:pt idx="494">
                  <c:v>21.937500000000256</c:v>
                </c:pt>
                <c:pt idx="495">
                  <c:v>25.750000000000167</c:v>
                </c:pt>
                <c:pt idx="496">
                  <c:v>28.625000000000007</c:v>
                </c:pt>
                <c:pt idx="497">
                  <c:v>23.875000000000025</c:v>
                </c:pt>
                <c:pt idx="498">
                  <c:v>20.999999999999751</c:v>
                </c:pt>
                <c:pt idx="499">
                  <c:v>24.812500000000096</c:v>
                </c:pt>
                <c:pt idx="500">
                  <c:v>26.687499999999805</c:v>
                </c:pt>
                <c:pt idx="501">
                  <c:v>27.624999999999872</c:v>
                </c:pt>
                <c:pt idx="502">
                  <c:v>27.624999999999872</c:v>
                </c:pt>
                <c:pt idx="503">
                  <c:v>24.750000000000032</c:v>
                </c:pt>
                <c:pt idx="504">
                  <c:v>24.750000000000032</c:v>
                </c:pt>
                <c:pt idx="505">
                  <c:v>28.562499999999943</c:v>
                </c:pt>
                <c:pt idx="506">
                  <c:v>29.562500000000075</c:v>
                </c:pt>
                <c:pt idx="507">
                  <c:v>30.500000000000146</c:v>
                </c:pt>
                <c:pt idx="508">
                  <c:v>37.249999999999957</c:v>
                </c:pt>
                <c:pt idx="509">
                  <c:v>32.437500000000348</c:v>
                </c:pt>
                <c:pt idx="510">
                  <c:v>25.750000000000167</c:v>
                </c:pt>
              </c:numCache>
            </c:numRef>
          </c:yVal>
          <c:smooth val="1"/>
          <c:extLst>
            <c:ext xmlns:c16="http://schemas.microsoft.com/office/drawing/2014/chart" uri="{C3380CC4-5D6E-409C-BE32-E72D297353CC}">
              <c16:uniqueId val="{00000000-74C9-421C-8FBE-1DD3C3672122}"/>
            </c:ext>
          </c:extLst>
        </c:ser>
        <c:dLbls>
          <c:showLegendKey val="0"/>
          <c:showVal val="0"/>
          <c:showCatName val="0"/>
          <c:showSerName val="0"/>
          <c:showPercent val="0"/>
          <c:showBubbleSize val="0"/>
        </c:dLbls>
        <c:axId val="150251040"/>
        <c:axId val="150251600"/>
      </c:scatterChart>
      <c:valAx>
        <c:axId val="150251040"/>
        <c:scaling>
          <c:orientation val="minMax"/>
          <c:max val="700"/>
          <c:min val="265"/>
        </c:scaling>
        <c:delete val="0"/>
        <c:axPos val="b"/>
        <c:title>
          <c:tx>
            <c:rich>
              <a:bodyPr/>
              <a:lstStyle/>
              <a:p>
                <a:pPr>
                  <a:defRPr/>
                </a:pPr>
                <a:r>
                  <a:rPr lang="en-GB" dirty="0"/>
                  <a:t>Wavelength (nm)</a:t>
                </a:r>
              </a:p>
            </c:rich>
          </c:tx>
          <c:layout/>
          <c:overlay val="0"/>
        </c:title>
        <c:numFmt formatCode="General" sourceLinked="1"/>
        <c:majorTickMark val="out"/>
        <c:minorTickMark val="none"/>
        <c:tickLblPos val="nextTo"/>
        <c:crossAx val="150251600"/>
        <c:crosses val="autoZero"/>
        <c:crossBetween val="midCat"/>
      </c:valAx>
      <c:valAx>
        <c:axId val="150251600"/>
        <c:scaling>
          <c:orientation val="minMax"/>
          <c:max val="21000"/>
          <c:min val="0"/>
        </c:scaling>
        <c:delete val="0"/>
        <c:axPos val="l"/>
        <c:title>
          <c:tx>
            <c:rich>
              <a:bodyPr rot="-5400000" vert="horz"/>
              <a:lstStyle/>
              <a:p>
                <a:pPr>
                  <a:defRPr/>
                </a:pPr>
                <a:r>
                  <a:rPr lang="el-GR"/>
                  <a:t>ε</a:t>
                </a:r>
                <a:r>
                  <a:rPr lang="en-GB"/>
                  <a:t> (M</a:t>
                </a:r>
                <a:r>
                  <a:rPr lang="en-GB" baseline="30000"/>
                  <a:t>-1</a:t>
                </a:r>
                <a:r>
                  <a:rPr lang="en-GB"/>
                  <a:t>. cm</a:t>
                </a:r>
                <a:r>
                  <a:rPr lang="en-GB" baseline="30000"/>
                  <a:t>-1</a:t>
                </a:r>
                <a:r>
                  <a:rPr lang="en-GB"/>
                  <a:t>)</a:t>
                </a:r>
              </a:p>
            </c:rich>
          </c:tx>
          <c:layout/>
          <c:overlay val="0"/>
        </c:title>
        <c:numFmt formatCode="General" sourceLinked="1"/>
        <c:majorTickMark val="out"/>
        <c:minorTickMark val="none"/>
        <c:tickLblPos val="nextTo"/>
        <c:crossAx val="150251040"/>
        <c:crosses val="autoZero"/>
        <c:crossBetween val="midCat"/>
      </c:valAx>
    </c:plotArea>
    <c:plotVisOnly val="1"/>
    <c:dispBlanksAs val="gap"/>
    <c:showDLblsOverMax val="0"/>
  </c:chart>
  <c:spPr>
    <a:ln>
      <a:noFill/>
    </a:ln>
  </c:spPr>
  <c:externalData r:id="rId1">
    <c:autoUpdate val="0"/>
  </c:externalData>
</c:chartSpace>
</file>

<file path=ppt/charts/chart1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Sheet1!$D$1</c:f>
              <c:strCache>
                <c:ptCount val="1"/>
                <c:pt idx="0">
                  <c:v>DMSO only</c:v>
                </c:pt>
              </c:strCache>
            </c:strRef>
          </c:tx>
          <c:spPr>
            <a:ln>
              <a:solidFill>
                <a:schemeClr val="tx1"/>
              </a:solidFill>
            </a:ln>
          </c:spPr>
          <c:marker>
            <c:symbol val="none"/>
          </c:marker>
          <c:xVal>
            <c:numRef>
              <c:f>Sheet1!$D$3:$D$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V$3:$V$513</c:f>
              <c:numCache>
                <c:formatCode>General</c:formatCode>
                <c:ptCount val="511"/>
                <c:pt idx="0">
                  <c:v>99404.89999999998</c:v>
                </c:pt>
                <c:pt idx="1">
                  <c:v>10769.699999999977</c:v>
                </c:pt>
                <c:pt idx="2">
                  <c:v>64430.2</c:v>
                </c:pt>
                <c:pt idx="3">
                  <c:v>31039.399999999987</c:v>
                </c:pt>
                <c:pt idx="4">
                  <c:v>-12136.800000000007</c:v>
                </c:pt>
                <c:pt idx="5">
                  <c:v>-42724.599999999991</c:v>
                </c:pt>
                <c:pt idx="6">
                  <c:v>230.3999999999931</c:v>
                </c:pt>
                <c:pt idx="7">
                  <c:v>-14526.400000000021</c:v>
                </c:pt>
                <c:pt idx="8">
                  <c:v>-29602.100000000024</c:v>
                </c:pt>
                <c:pt idx="9">
                  <c:v>-18765.299999999977</c:v>
                </c:pt>
                <c:pt idx="10">
                  <c:v>17587.199999999986</c:v>
                </c:pt>
                <c:pt idx="11">
                  <c:v>419.60000000001577</c:v>
                </c:pt>
                <c:pt idx="12">
                  <c:v>6590.2999999999884</c:v>
                </c:pt>
                <c:pt idx="13">
                  <c:v>11254.79999999997</c:v>
                </c:pt>
                <c:pt idx="14">
                  <c:v>5349.6999999999971</c:v>
                </c:pt>
                <c:pt idx="15">
                  <c:v>-2975.4999999999905</c:v>
                </c:pt>
                <c:pt idx="16">
                  <c:v>3730.8000000000184</c:v>
                </c:pt>
                <c:pt idx="17">
                  <c:v>-10765.099999999986</c:v>
                </c:pt>
                <c:pt idx="18">
                  <c:v>-9483.3999999999778</c:v>
                </c:pt>
                <c:pt idx="19">
                  <c:v>4510.4999999999791</c:v>
                </c:pt>
                <c:pt idx="20">
                  <c:v>3478.9999999999941</c:v>
                </c:pt>
                <c:pt idx="21">
                  <c:v>4821.799999999972</c:v>
                </c:pt>
                <c:pt idx="22">
                  <c:v>-10275.300000000001</c:v>
                </c:pt>
                <c:pt idx="23">
                  <c:v>8419.8000000000065</c:v>
                </c:pt>
                <c:pt idx="24">
                  <c:v>22827.199999999986</c:v>
                </c:pt>
                <c:pt idx="25">
                  <c:v>-3.1000000000044876</c:v>
                </c:pt>
                <c:pt idx="26">
                  <c:v>-2754.2000000000107</c:v>
                </c:pt>
                <c:pt idx="27">
                  <c:v>3031.8999999999828</c:v>
                </c:pt>
                <c:pt idx="28">
                  <c:v>6820.6999999999971</c:v>
                </c:pt>
                <c:pt idx="29">
                  <c:v>-1339.7000000000032</c:v>
                </c:pt>
                <c:pt idx="30">
                  <c:v>9017.8999999999851</c:v>
                </c:pt>
                <c:pt idx="31">
                  <c:v>3820.8000000000306</c:v>
                </c:pt>
                <c:pt idx="32">
                  <c:v>11904.89999999998</c:v>
                </c:pt>
                <c:pt idx="33">
                  <c:v>7008.3999999999878</c:v>
                </c:pt>
                <c:pt idx="34">
                  <c:v>5947.7999999999765</c:v>
                </c:pt>
                <c:pt idx="35">
                  <c:v>5525.2000000000144</c:v>
                </c:pt>
                <c:pt idx="36">
                  <c:v>2519.1999999999948</c:v>
                </c:pt>
                <c:pt idx="37">
                  <c:v>5146.8000000000138</c:v>
                </c:pt>
                <c:pt idx="38">
                  <c:v>-8848.5999999999767</c:v>
                </c:pt>
                <c:pt idx="39">
                  <c:v>5665.6000000000104</c:v>
                </c:pt>
                <c:pt idx="40">
                  <c:v>5493.1999999999825</c:v>
                </c:pt>
                <c:pt idx="41">
                  <c:v>6713.8999999999905</c:v>
                </c:pt>
                <c:pt idx="42">
                  <c:v>7009.8000000000056</c:v>
                </c:pt>
                <c:pt idx="43">
                  <c:v>12977.599999999993</c:v>
                </c:pt>
                <c:pt idx="44">
                  <c:v>10815.400000000014</c:v>
                </c:pt>
                <c:pt idx="45">
                  <c:v>-781.20000000000823</c:v>
                </c:pt>
                <c:pt idx="46">
                  <c:v>-579.80000000001223</c:v>
                </c:pt>
                <c:pt idx="47">
                  <c:v>-579.79999999996778</c:v>
                </c:pt>
                <c:pt idx="48">
                  <c:v>6759.5999999999831</c:v>
                </c:pt>
                <c:pt idx="49">
                  <c:v>11384.599999999995</c:v>
                </c:pt>
                <c:pt idx="50">
                  <c:v>7931.5000000000091</c:v>
                </c:pt>
                <c:pt idx="51">
                  <c:v>5662.5999999999904</c:v>
                </c:pt>
                <c:pt idx="52">
                  <c:v>2650.5000000000068</c:v>
                </c:pt>
                <c:pt idx="53">
                  <c:v>5899.1000000000076</c:v>
                </c:pt>
                <c:pt idx="54">
                  <c:v>2262.9000000000078</c:v>
                </c:pt>
                <c:pt idx="55">
                  <c:v>4914.8000000000038</c:v>
                </c:pt>
                <c:pt idx="56">
                  <c:v>6831.3999999999824</c:v>
                </c:pt>
                <c:pt idx="57">
                  <c:v>7153.2999999999911</c:v>
                </c:pt>
                <c:pt idx="58">
                  <c:v>2691.6999999999925</c:v>
                </c:pt>
                <c:pt idx="59">
                  <c:v>575.20000000000482</c:v>
                </c:pt>
                <c:pt idx="60">
                  <c:v>145.00000000000205</c:v>
                </c:pt>
                <c:pt idx="61">
                  <c:v>10815.400000000014</c:v>
                </c:pt>
                <c:pt idx="62">
                  <c:v>19901.999999999978</c:v>
                </c:pt>
                <c:pt idx="63">
                  <c:v>1748.5999999999735</c:v>
                </c:pt>
                <c:pt idx="64">
                  <c:v>7850.5999999999804</c:v>
                </c:pt>
                <c:pt idx="65">
                  <c:v>-7896.3999999999733</c:v>
                </c:pt>
                <c:pt idx="66">
                  <c:v>-1995.8000000000072</c:v>
                </c:pt>
                <c:pt idx="67">
                  <c:v>6697.0999999999958</c:v>
                </c:pt>
                <c:pt idx="68">
                  <c:v>9300.2000000000098</c:v>
                </c:pt>
                <c:pt idx="69">
                  <c:v>11772.200000000017</c:v>
                </c:pt>
                <c:pt idx="70">
                  <c:v>13517.699999999992</c:v>
                </c:pt>
                <c:pt idx="71">
                  <c:v>15385.499999999989</c:v>
                </c:pt>
                <c:pt idx="72">
                  <c:v>17118.900000000009</c:v>
                </c:pt>
                <c:pt idx="73">
                  <c:v>18820.19999999999</c:v>
                </c:pt>
                <c:pt idx="74">
                  <c:v>20770.299999999988</c:v>
                </c:pt>
                <c:pt idx="75">
                  <c:v>22958.300000000003</c:v>
                </c:pt>
                <c:pt idx="76">
                  <c:v>25254.799999999992</c:v>
                </c:pt>
                <c:pt idx="77">
                  <c:v>27529.899999999998</c:v>
                </c:pt>
                <c:pt idx="78">
                  <c:v>29531.8</c:v>
                </c:pt>
                <c:pt idx="79">
                  <c:v>30888.399999999998</c:v>
                </c:pt>
                <c:pt idx="80">
                  <c:v>31582.699999999993</c:v>
                </c:pt>
                <c:pt idx="81">
                  <c:v>31785.599999999999</c:v>
                </c:pt>
                <c:pt idx="82">
                  <c:v>31761.099999999991</c:v>
                </c:pt>
                <c:pt idx="83">
                  <c:v>31889.399999999998</c:v>
                </c:pt>
                <c:pt idx="84">
                  <c:v>32345.599999999995</c:v>
                </c:pt>
                <c:pt idx="85">
                  <c:v>33416.799999999988</c:v>
                </c:pt>
                <c:pt idx="86">
                  <c:v>35166.899999999994</c:v>
                </c:pt>
                <c:pt idx="87">
                  <c:v>37356.599999999991</c:v>
                </c:pt>
                <c:pt idx="88">
                  <c:v>39558.399999999994</c:v>
                </c:pt>
                <c:pt idx="89">
                  <c:v>41424.5</c:v>
                </c:pt>
                <c:pt idx="90">
                  <c:v>42478.899999999994</c:v>
                </c:pt>
                <c:pt idx="91">
                  <c:v>42503.399999999994</c:v>
                </c:pt>
                <c:pt idx="92">
                  <c:v>41505.5</c:v>
                </c:pt>
                <c:pt idx="93">
                  <c:v>39740</c:v>
                </c:pt>
                <c:pt idx="94">
                  <c:v>37570.1</c:v>
                </c:pt>
                <c:pt idx="95">
                  <c:v>35427.799999999996</c:v>
                </c:pt>
                <c:pt idx="96">
                  <c:v>33700.599999999991</c:v>
                </c:pt>
                <c:pt idx="97">
                  <c:v>32464.599999999995</c:v>
                </c:pt>
                <c:pt idx="98">
                  <c:v>31838.999999999996</c:v>
                </c:pt>
                <c:pt idx="99">
                  <c:v>31828.299999999996</c:v>
                </c:pt>
                <c:pt idx="100">
                  <c:v>32331.799999999996</c:v>
                </c:pt>
                <c:pt idx="101">
                  <c:v>32949.799999999996</c:v>
                </c:pt>
                <c:pt idx="102">
                  <c:v>33404.499999999993</c:v>
                </c:pt>
                <c:pt idx="103">
                  <c:v>33262.699999999997</c:v>
                </c:pt>
                <c:pt idx="104">
                  <c:v>32276.899999999994</c:v>
                </c:pt>
                <c:pt idx="105">
                  <c:v>29145.799999999996</c:v>
                </c:pt>
                <c:pt idx="106">
                  <c:v>25674.400000000001</c:v>
                </c:pt>
                <c:pt idx="107">
                  <c:v>23196.399999999998</c:v>
                </c:pt>
                <c:pt idx="108">
                  <c:v>20223.999999999996</c:v>
                </c:pt>
                <c:pt idx="109">
                  <c:v>17262.3</c:v>
                </c:pt>
                <c:pt idx="110">
                  <c:v>14504.999999999996</c:v>
                </c:pt>
                <c:pt idx="111">
                  <c:v>12149</c:v>
                </c:pt>
                <c:pt idx="112">
                  <c:v>10165.299999999999</c:v>
                </c:pt>
                <c:pt idx="113">
                  <c:v>8595.2999999999993</c:v>
                </c:pt>
                <c:pt idx="114">
                  <c:v>7450.8</c:v>
                </c:pt>
                <c:pt idx="115">
                  <c:v>6515.5</c:v>
                </c:pt>
                <c:pt idx="116">
                  <c:v>5601.4999999999991</c:v>
                </c:pt>
                <c:pt idx="117">
                  <c:v>4985</c:v>
                </c:pt>
                <c:pt idx="118">
                  <c:v>4559.3</c:v>
                </c:pt>
                <c:pt idx="119">
                  <c:v>4345.7</c:v>
                </c:pt>
                <c:pt idx="120">
                  <c:v>4187</c:v>
                </c:pt>
                <c:pt idx="121">
                  <c:v>4101.5999999999995</c:v>
                </c:pt>
                <c:pt idx="122">
                  <c:v>3910.8</c:v>
                </c:pt>
                <c:pt idx="123">
                  <c:v>3967.2999999999997</c:v>
                </c:pt>
                <c:pt idx="124">
                  <c:v>3889.4999999999995</c:v>
                </c:pt>
                <c:pt idx="125">
                  <c:v>3923</c:v>
                </c:pt>
                <c:pt idx="126">
                  <c:v>3831.5</c:v>
                </c:pt>
                <c:pt idx="127">
                  <c:v>3727.7000000000003</c:v>
                </c:pt>
                <c:pt idx="128">
                  <c:v>3710.9</c:v>
                </c:pt>
                <c:pt idx="129">
                  <c:v>3654.4999999999991</c:v>
                </c:pt>
                <c:pt idx="130">
                  <c:v>3620.8999999999996</c:v>
                </c:pt>
                <c:pt idx="131">
                  <c:v>3459.1999999999994</c:v>
                </c:pt>
                <c:pt idx="132">
                  <c:v>3395.1</c:v>
                </c:pt>
                <c:pt idx="133">
                  <c:v>3389</c:v>
                </c:pt>
                <c:pt idx="134">
                  <c:v>3384.3999999999996</c:v>
                </c:pt>
                <c:pt idx="135">
                  <c:v>3376.7999999999997</c:v>
                </c:pt>
                <c:pt idx="136">
                  <c:v>3304.9999999999995</c:v>
                </c:pt>
                <c:pt idx="137">
                  <c:v>3419.5</c:v>
                </c:pt>
                <c:pt idx="138">
                  <c:v>3431.7</c:v>
                </c:pt>
                <c:pt idx="139">
                  <c:v>3357</c:v>
                </c:pt>
                <c:pt idx="140">
                  <c:v>3355.3999999999996</c:v>
                </c:pt>
                <c:pt idx="141">
                  <c:v>3361.5000000000005</c:v>
                </c:pt>
                <c:pt idx="142">
                  <c:v>3353.8999999999996</c:v>
                </c:pt>
                <c:pt idx="143">
                  <c:v>3158.5999999999995</c:v>
                </c:pt>
                <c:pt idx="144">
                  <c:v>3131.0999999999995</c:v>
                </c:pt>
                <c:pt idx="145">
                  <c:v>3036.5</c:v>
                </c:pt>
                <c:pt idx="146">
                  <c:v>2952.6</c:v>
                </c:pt>
                <c:pt idx="147">
                  <c:v>2905.2999999999997</c:v>
                </c:pt>
                <c:pt idx="148">
                  <c:v>2804.5</c:v>
                </c:pt>
                <c:pt idx="149">
                  <c:v>2743.4999999999995</c:v>
                </c:pt>
                <c:pt idx="150">
                  <c:v>2648.8999999999996</c:v>
                </c:pt>
                <c:pt idx="151">
                  <c:v>2601.5999999999995</c:v>
                </c:pt>
                <c:pt idx="152">
                  <c:v>2532.8999999999996</c:v>
                </c:pt>
                <c:pt idx="153">
                  <c:v>2464.2999999999997</c:v>
                </c:pt>
                <c:pt idx="154">
                  <c:v>2447.4999999999995</c:v>
                </c:pt>
                <c:pt idx="155">
                  <c:v>2360.5</c:v>
                </c:pt>
                <c:pt idx="156">
                  <c:v>2325.4999999999995</c:v>
                </c:pt>
                <c:pt idx="157">
                  <c:v>2261.4</c:v>
                </c:pt>
                <c:pt idx="158">
                  <c:v>2241.5000000000005</c:v>
                </c:pt>
                <c:pt idx="159">
                  <c:v>2084.2999999999997</c:v>
                </c:pt>
                <c:pt idx="160">
                  <c:v>2049.2999999999997</c:v>
                </c:pt>
                <c:pt idx="161">
                  <c:v>2041.5999999999995</c:v>
                </c:pt>
                <c:pt idx="162">
                  <c:v>1933.3000000000002</c:v>
                </c:pt>
                <c:pt idx="163">
                  <c:v>1947</c:v>
                </c:pt>
                <c:pt idx="164">
                  <c:v>1911.8999999999996</c:v>
                </c:pt>
                <c:pt idx="165">
                  <c:v>1850.8999999999996</c:v>
                </c:pt>
                <c:pt idx="166">
                  <c:v>1797.5000000000002</c:v>
                </c:pt>
                <c:pt idx="167">
                  <c:v>1768.4999999999991</c:v>
                </c:pt>
                <c:pt idx="168">
                  <c:v>1747.1</c:v>
                </c:pt>
                <c:pt idx="169">
                  <c:v>1714.9999999999998</c:v>
                </c:pt>
                <c:pt idx="170">
                  <c:v>1699.8000000000004</c:v>
                </c:pt>
                <c:pt idx="171">
                  <c:v>1678.5000000000007</c:v>
                </c:pt>
                <c:pt idx="172">
                  <c:v>1620.5000000000009</c:v>
                </c:pt>
                <c:pt idx="173">
                  <c:v>1608.1999999999998</c:v>
                </c:pt>
                <c:pt idx="174">
                  <c:v>1516.6999999999998</c:v>
                </c:pt>
                <c:pt idx="175">
                  <c:v>1379.3999999999999</c:v>
                </c:pt>
                <c:pt idx="176">
                  <c:v>1336.6000000000001</c:v>
                </c:pt>
                <c:pt idx="177">
                  <c:v>1350.4</c:v>
                </c:pt>
                <c:pt idx="178">
                  <c:v>1348.9</c:v>
                </c:pt>
                <c:pt idx="179">
                  <c:v>1278.6999999999991</c:v>
                </c:pt>
                <c:pt idx="180">
                  <c:v>1301.5999999999999</c:v>
                </c:pt>
                <c:pt idx="181">
                  <c:v>1260.3000000000002</c:v>
                </c:pt>
                <c:pt idx="182">
                  <c:v>1211.6000000000001</c:v>
                </c:pt>
                <c:pt idx="183">
                  <c:v>1196.3</c:v>
                </c:pt>
                <c:pt idx="184">
                  <c:v>1161.2000000000003</c:v>
                </c:pt>
                <c:pt idx="185">
                  <c:v>1144.4000000000001</c:v>
                </c:pt>
                <c:pt idx="186">
                  <c:v>1126.1000000000006</c:v>
                </c:pt>
                <c:pt idx="187">
                  <c:v>1086.4000000000005</c:v>
                </c:pt>
                <c:pt idx="188">
                  <c:v>1069.6000000000004</c:v>
                </c:pt>
                <c:pt idx="189">
                  <c:v>1048.3000000000006</c:v>
                </c:pt>
                <c:pt idx="190">
                  <c:v>1032.9999999999998</c:v>
                </c:pt>
                <c:pt idx="191">
                  <c:v>996.4</c:v>
                </c:pt>
                <c:pt idx="192">
                  <c:v>958.19999999999925</c:v>
                </c:pt>
                <c:pt idx="193">
                  <c:v>959.80000000000086</c:v>
                </c:pt>
                <c:pt idx="194">
                  <c:v>941.40000000000055</c:v>
                </c:pt>
                <c:pt idx="195">
                  <c:v>918.60000000000059</c:v>
                </c:pt>
                <c:pt idx="196">
                  <c:v>891.10000000000014</c:v>
                </c:pt>
                <c:pt idx="197">
                  <c:v>871.29999999999973</c:v>
                </c:pt>
                <c:pt idx="198">
                  <c:v>871.1999999999997</c:v>
                </c:pt>
                <c:pt idx="199">
                  <c:v>852.99999999999955</c:v>
                </c:pt>
                <c:pt idx="200">
                  <c:v>840.70000000000039</c:v>
                </c:pt>
                <c:pt idx="201">
                  <c:v>833.099999999999</c:v>
                </c:pt>
                <c:pt idx="202">
                  <c:v>823.89999999999952</c:v>
                </c:pt>
                <c:pt idx="203">
                  <c:v>819.40000000000066</c:v>
                </c:pt>
                <c:pt idx="204">
                  <c:v>797.99999999999932</c:v>
                </c:pt>
                <c:pt idx="205">
                  <c:v>785.8000000000003</c:v>
                </c:pt>
                <c:pt idx="206">
                  <c:v>773.60000000000059</c:v>
                </c:pt>
                <c:pt idx="207">
                  <c:v>776.59999999999945</c:v>
                </c:pt>
                <c:pt idx="208">
                  <c:v>790.39999999999941</c:v>
                </c:pt>
                <c:pt idx="209">
                  <c:v>767.49999999999932</c:v>
                </c:pt>
                <c:pt idx="210">
                  <c:v>761.39999999999952</c:v>
                </c:pt>
                <c:pt idx="211">
                  <c:v>763.00000000000045</c:v>
                </c:pt>
                <c:pt idx="212">
                  <c:v>752.2</c:v>
                </c:pt>
                <c:pt idx="213">
                  <c:v>753.8000000000003</c:v>
                </c:pt>
                <c:pt idx="214">
                  <c:v>743.10000000000059</c:v>
                </c:pt>
                <c:pt idx="215">
                  <c:v>740.00000000000034</c:v>
                </c:pt>
                <c:pt idx="216">
                  <c:v>726.29999999999916</c:v>
                </c:pt>
                <c:pt idx="217">
                  <c:v>720.19999999999993</c:v>
                </c:pt>
                <c:pt idx="218">
                  <c:v>707.99999999999955</c:v>
                </c:pt>
                <c:pt idx="219">
                  <c:v>695.79999999999916</c:v>
                </c:pt>
                <c:pt idx="220">
                  <c:v>692.8000000000003</c:v>
                </c:pt>
                <c:pt idx="221">
                  <c:v>681.99999999999989</c:v>
                </c:pt>
                <c:pt idx="222">
                  <c:v>682.00000000000057</c:v>
                </c:pt>
                <c:pt idx="223">
                  <c:v>679.00000000000034</c:v>
                </c:pt>
                <c:pt idx="224">
                  <c:v>691.2</c:v>
                </c:pt>
                <c:pt idx="225">
                  <c:v>674.4</c:v>
                </c:pt>
                <c:pt idx="226">
                  <c:v>666.80000000000064</c:v>
                </c:pt>
                <c:pt idx="227">
                  <c:v>683.60000000000082</c:v>
                </c:pt>
                <c:pt idx="228">
                  <c:v>688.19999999999982</c:v>
                </c:pt>
                <c:pt idx="229">
                  <c:v>685.10000000000093</c:v>
                </c:pt>
                <c:pt idx="230">
                  <c:v>672.89999999999986</c:v>
                </c:pt>
                <c:pt idx="231">
                  <c:v>671.39999999999975</c:v>
                </c:pt>
                <c:pt idx="232">
                  <c:v>671.40000000000043</c:v>
                </c:pt>
                <c:pt idx="233">
                  <c:v>662.3000000000003</c:v>
                </c:pt>
                <c:pt idx="234">
                  <c:v>668.29999999999939</c:v>
                </c:pt>
                <c:pt idx="235">
                  <c:v>659.09999999999991</c:v>
                </c:pt>
                <c:pt idx="236">
                  <c:v>662.29999999999961</c:v>
                </c:pt>
                <c:pt idx="237">
                  <c:v>656.09999999999968</c:v>
                </c:pt>
                <c:pt idx="238">
                  <c:v>657.69999999999993</c:v>
                </c:pt>
                <c:pt idx="239">
                  <c:v>646.99999999999966</c:v>
                </c:pt>
                <c:pt idx="240">
                  <c:v>639.39999999999964</c:v>
                </c:pt>
                <c:pt idx="241">
                  <c:v>642.39999999999986</c:v>
                </c:pt>
                <c:pt idx="242">
                  <c:v>644.00000000000011</c:v>
                </c:pt>
                <c:pt idx="243">
                  <c:v>630.20000000000016</c:v>
                </c:pt>
                <c:pt idx="244">
                  <c:v>628.70000000000005</c:v>
                </c:pt>
                <c:pt idx="245">
                  <c:v>622.59999999999945</c:v>
                </c:pt>
                <c:pt idx="246">
                  <c:v>617.99999999999909</c:v>
                </c:pt>
                <c:pt idx="247">
                  <c:v>613.4</c:v>
                </c:pt>
                <c:pt idx="248">
                  <c:v>616.49999999999898</c:v>
                </c:pt>
                <c:pt idx="249">
                  <c:v>610.39999999999975</c:v>
                </c:pt>
                <c:pt idx="250">
                  <c:v>607.30000000000086</c:v>
                </c:pt>
                <c:pt idx="251">
                  <c:v>596.59999999999991</c:v>
                </c:pt>
                <c:pt idx="252">
                  <c:v>596.59999999999991</c:v>
                </c:pt>
                <c:pt idx="253">
                  <c:v>587.49999999999977</c:v>
                </c:pt>
                <c:pt idx="254">
                  <c:v>584.4000000000002</c:v>
                </c:pt>
                <c:pt idx="255">
                  <c:v>581.4</c:v>
                </c:pt>
                <c:pt idx="256">
                  <c:v>590.50000000000068</c:v>
                </c:pt>
                <c:pt idx="257">
                  <c:v>584.4000000000002</c:v>
                </c:pt>
                <c:pt idx="258">
                  <c:v>567.59999999999934</c:v>
                </c:pt>
                <c:pt idx="259">
                  <c:v>570.69999999999891</c:v>
                </c:pt>
                <c:pt idx="260">
                  <c:v>564.5999999999998</c:v>
                </c:pt>
                <c:pt idx="261">
                  <c:v>558.39999999999918</c:v>
                </c:pt>
                <c:pt idx="262">
                  <c:v>553.9000000000002</c:v>
                </c:pt>
                <c:pt idx="263">
                  <c:v>546.19999999999936</c:v>
                </c:pt>
                <c:pt idx="264">
                  <c:v>558.4999999999992</c:v>
                </c:pt>
                <c:pt idx="265">
                  <c:v>561.49999999999943</c:v>
                </c:pt>
                <c:pt idx="266">
                  <c:v>549.29999999999973</c:v>
                </c:pt>
                <c:pt idx="267">
                  <c:v>546.2999999999995</c:v>
                </c:pt>
                <c:pt idx="268">
                  <c:v>544.69999999999936</c:v>
                </c:pt>
                <c:pt idx="269">
                  <c:v>547.69999999999948</c:v>
                </c:pt>
                <c:pt idx="270">
                  <c:v>541.7000000000005</c:v>
                </c:pt>
                <c:pt idx="271">
                  <c:v>532.49999999999955</c:v>
                </c:pt>
                <c:pt idx="272">
                  <c:v>533.99999999999966</c:v>
                </c:pt>
                <c:pt idx="273">
                  <c:v>537.1</c:v>
                </c:pt>
                <c:pt idx="274">
                  <c:v>532.49999999999955</c:v>
                </c:pt>
                <c:pt idx="275">
                  <c:v>527.89999999999986</c:v>
                </c:pt>
                <c:pt idx="276">
                  <c:v>521.79999999999927</c:v>
                </c:pt>
                <c:pt idx="277">
                  <c:v>524.89999999999964</c:v>
                </c:pt>
                <c:pt idx="278">
                  <c:v>526.39999999999907</c:v>
                </c:pt>
                <c:pt idx="279">
                  <c:v>515.69999999999948</c:v>
                </c:pt>
                <c:pt idx="280">
                  <c:v>515.69999999999948</c:v>
                </c:pt>
                <c:pt idx="281">
                  <c:v>515.69999999999948</c:v>
                </c:pt>
                <c:pt idx="282">
                  <c:v>503.50000000000114</c:v>
                </c:pt>
                <c:pt idx="283">
                  <c:v>502.00000000000102</c:v>
                </c:pt>
                <c:pt idx="284">
                  <c:v>494.39999999999895</c:v>
                </c:pt>
                <c:pt idx="285">
                  <c:v>488.30000000000052</c:v>
                </c:pt>
                <c:pt idx="286">
                  <c:v>500.40000000000009</c:v>
                </c:pt>
                <c:pt idx="287">
                  <c:v>497.39999999999986</c:v>
                </c:pt>
                <c:pt idx="288">
                  <c:v>479.10000000000031</c:v>
                </c:pt>
                <c:pt idx="289">
                  <c:v>472.99999999999977</c:v>
                </c:pt>
                <c:pt idx="290">
                  <c:v>474.6000000000007</c:v>
                </c:pt>
                <c:pt idx="291">
                  <c:v>468.39999999999935</c:v>
                </c:pt>
                <c:pt idx="292">
                  <c:v>468.39999999999935</c:v>
                </c:pt>
                <c:pt idx="293">
                  <c:v>474.50000000000057</c:v>
                </c:pt>
                <c:pt idx="294">
                  <c:v>486.69999999999959</c:v>
                </c:pt>
                <c:pt idx="295">
                  <c:v>466.9000000000006</c:v>
                </c:pt>
                <c:pt idx="296">
                  <c:v>483.70000000000078</c:v>
                </c:pt>
                <c:pt idx="297">
                  <c:v>475.99999999999932</c:v>
                </c:pt>
                <c:pt idx="298">
                  <c:v>480.59999999999906</c:v>
                </c:pt>
                <c:pt idx="299">
                  <c:v>471.49999999999966</c:v>
                </c:pt>
                <c:pt idx="300">
                  <c:v>463.90000000000038</c:v>
                </c:pt>
                <c:pt idx="301">
                  <c:v>459.29999999999995</c:v>
                </c:pt>
                <c:pt idx="302">
                  <c:v>447.00000000000011</c:v>
                </c:pt>
                <c:pt idx="303">
                  <c:v>438.00000000000085</c:v>
                </c:pt>
                <c:pt idx="304">
                  <c:v>440.99999999999972</c:v>
                </c:pt>
                <c:pt idx="305">
                  <c:v>425.69999999999965</c:v>
                </c:pt>
                <c:pt idx="306">
                  <c:v>422.69999999999942</c:v>
                </c:pt>
                <c:pt idx="307">
                  <c:v>415.00000000000006</c:v>
                </c:pt>
                <c:pt idx="308">
                  <c:v>418.09999999999968</c:v>
                </c:pt>
                <c:pt idx="309">
                  <c:v>408.9000000000002</c:v>
                </c:pt>
                <c:pt idx="310">
                  <c:v>411.99999999999983</c:v>
                </c:pt>
                <c:pt idx="311">
                  <c:v>404.39999999999918</c:v>
                </c:pt>
                <c:pt idx="312">
                  <c:v>402.80000000000035</c:v>
                </c:pt>
                <c:pt idx="313">
                  <c:v>402.80000000000035</c:v>
                </c:pt>
                <c:pt idx="314">
                  <c:v>396.7000000000005</c:v>
                </c:pt>
                <c:pt idx="315">
                  <c:v>396.7000000000005</c:v>
                </c:pt>
                <c:pt idx="316">
                  <c:v>399.80000000000013</c:v>
                </c:pt>
                <c:pt idx="317">
                  <c:v>398.19999999999993</c:v>
                </c:pt>
                <c:pt idx="318">
                  <c:v>399.80000000000081</c:v>
                </c:pt>
                <c:pt idx="319">
                  <c:v>402.79999999999967</c:v>
                </c:pt>
                <c:pt idx="320">
                  <c:v>404.29999999999978</c:v>
                </c:pt>
                <c:pt idx="321">
                  <c:v>396.69999999999982</c:v>
                </c:pt>
                <c:pt idx="322">
                  <c:v>392.19999999999948</c:v>
                </c:pt>
                <c:pt idx="323">
                  <c:v>398.19999999999993</c:v>
                </c:pt>
                <c:pt idx="324">
                  <c:v>396.7000000000005</c:v>
                </c:pt>
                <c:pt idx="325">
                  <c:v>404.40000000000055</c:v>
                </c:pt>
                <c:pt idx="326">
                  <c:v>399.70000000000005</c:v>
                </c:pt>
                <c:pt idx="327">
                  <c:v>398.3</c:v>
                </c:pt>
                <c:pt idx="328">
                  <c:v>389.10000000000053</c:v>
                </c:pt>
                <c:pt idx="329">
                  <c:v>387.49999999999892</c:v>
                </c:pt>
                <c:pt idx="330">
                  <c:v>392.10000000000008</c:v>
                </c:pt>
                <c:pt idx="331">
                  <c:v>387.60000000000042</c:v>
                </c:pt>
                <c:pt idx="332">
                  <c:v>384.60000000000019</c:v>
                </c:pt>
                <c:pt idx="333">
                  <c:v>373.89999999999992</c:v>
                </c:pt>
                <c:pt idx="334">
                  <c:v>381.49999999999989</c:v>
                </c:pt>
                <c:pt idx="335">
                  <c:v>378.49999999999966</c:v>
                </c:pt>
                <c:pt idx="336">
                  <c:v>370.80000000000024</c:v>
                </c:pt>
                <c:pt idx="337">
                  <c:v>373.79999999999978</c:v>
                </c:pt>
                <c:pt idx="338">
                  <c:v>369.30000000000018</c:v>
                </c:pt>
                <c:pt idx="339">
                  <c:v>370.79999999999887</c:v>
                </c:pt>
                <c:pt idx="340">
                  <c:v>350.99999999999989</c:v>
                </c:pt>
                <c:pt idx="341">
                  <c:v>360.09999999999997</c:v>
                </c:pt>
                <c:pt idx="342">
                  <c:v>352.49999999999932</c:v>
                </c:pt>
                <c:pt idx="343">
                  <c:v>349.40000000000038</c:v>
                </c:pt>
                <c:pt idx="344">
                  <c:v>346.40000000000015</c:v>
                </c:pt>
                <c:pt idx="345">
                  <c:v>340.19999999999948</c:v>
                </c:pt>
                <c:pt idx="346">
                  <c:v>350.9999999999992</c:v>
                </c:pt>
                <c:pt idx="347">
                  <c:v>425.79999999999973</c:v>
                </c:pt>
                <c:pt idx="348">
                  <c:v>450.10000000000048</c:v>
                </c:pt>
                <c:pt idx="349">
                  <c:v>434.90000000000055</c:v>
                </c:pt>
                <c:pt idx="350">
                  <c:v>419.5999999999998</c:v>
                </c:pt>
                <c:pt idx="351">
                  <c:v>419.70000000000061</c:v>
                </c:pt>
                <c:pt idx="352">
                  <c:v>424.19999999999953</c:v>
                </c:pt>
                <c:pt idx="353">
                  <c:v>427.19999999999976</c:v>
                </c:pt>
                <c:pt idx="354">
                  <c:v>418.00000000000028</c:v>
                </c:pt>
                <c:pt idx="355">
                  <c:v>416.59999999999957</c:v>
                </c:pt>
                <c:pt idx="356">
                  <c:v>401.30000000000024</c:v>
                </c:pt>
                <c:pt idx="357">
                  <c:v>402.79999999999967</c:v>
                </c:pt>
                <c:pt idx="358">
                  <c:v>410.49999999999972</c:v>
                </c:pt>
                <c:pt idx="359">
                  <c:v>399.70000000000005</c:v>
                </c:pt>
                <c:pt idx="360">
                  <c:v>401.30000000000024</c:v>
                </c:pt>
                <c:pt idx="361">
                  <c:v>402.90000000000043</c:v>
                </c:pt>
                <c:pt idx="362">
                  <c:v>392.19999999999948</c:v>
                </c:pt>
                <c:pt idx="363">
                  <c:v>393.70000000000095</c:v>
                </c:pt>
                <c:pt idx="364">
                  <c:v>383</c:v>
                </c:pt>
                <c:pt idx="365">
                  <c:v>386.00000000000023</c:v>
                </c:pt>
                <c:pt idx="366">
                  <c:v>386.10000000000031</c:v>
                </c:pt>
                <c:pt idx="367">
                  <c:v>384.49999999999937</c:v>
                </c:pt>
                <c:pt idx="368">
                  <c:v>381.49999999999989</c:v>
                </c:pt>
                <c:pt idx="369">
                  <c:v>372.30000000000035</c:v>
                </c:pt>
                <c:pt idx="370">
                  <c:v>369.29999999999944</c:v>
                </c:pt>
                <c:pt idx="371">
                  <c:v>369.30000000000018</c:v>
                </c:pt>
                <c:pt idx="372">
                  <c:v>366.2000000000005</c:v>
                </c:pt>
                <c:pt idx="373">
                  <c:v>364.6999999999997</c:v>
                </c:pt>
                <c:pt idx="374">
                  <c:v>372.30000000000035</c:v>
                </c:pt>
                <c:pt idx="375">
                  <c:v>361.60000000000008</c:v>
                </c:pt>
                <c:pt idx="376">
                  <c:v>370.70000000000016</c:v>
                </c:pt>
                <c:pt idx="377">
                  <c:v>355.59999999999962</c:v>
                </c:pt>
                <c:pt idx="378">
                  <c:v>358.49999999999977</c:v>
                </c:pt>
                <c:pt idx="379">
                  <c:v>358.60000000000053</c:v>
                </c:pt>
                <c:pt idx="380">
                  <c:v>346.40000000000083</c:v>
                </c:pt>
                <c:pt idx="381">
                  <c:v>347.90000000000026</c:v>
                </c:pt>
                <c:pt idx="382">
                  <c:v>352.5</c:v>
                </c:pt>
                <c:pt idx="383">
                  <c:v>346.39999999999947</c:v>
                </c:pt>
                <c:pt idx="384">
                  <c:v>350.90000000000049</c:v>
                </c:pt>
                <c:pt idx="385">
                  <c:v>331.0999999999994</c:v>
                </c:pt>
                <c:pt idx="386">
                  <c:v>341.79999999999973</c:v>
                </c:pt>
                <c:pt idx="387">
                  <c:v>335.70000000000056</c:v>
                </c:pt>
                <c:pt idx="388">
                  <c:v>331.10000000000014</c:v>
                </c:pt>
                <c:pt idx="389">
                  <c:v>331.10000000000082</c:v>
                </c:pt>
                <c:pt idx="390">
                  <c:v>335.69999999999987</c:v>
                </c:pt>
                <c:pt idx="391">
                  <c:v>315.89999999999947</c:v>
                </c:pt>
                <c:pt idx="392">
                  <c:v>314.39999999999935</c:v>
                </c:pt>
                <c:pt idx="393">
                  <c:v>314.29999999999927</c:v>
                </c:pt>
                <c:pt idx="394">
                  <c:v>300.60000000000082</c:v>
                </c:pt>
                <c:pt idx="395">
                  <c:v>303.69999999999976</c:v>
                </c:pt>
                <c:pt idx="396">
                  <c:v>300.59999999999945</c:v>
                </c:pt>
                <c:pt idx="397">
                  <c:v>294.50000000000028</c:v>
                </c:pt>
                <c:pt idx="398">
                  <c:v>294.4999999999996</c:v>
                </c:pt>
                <c:pt idx="399">
                  <c:v>289.99999999999994</c:v>
                </c:pt>
                <c:pt idx="400">
                  <c:v>279.20000000000027</c:v>
                </c:pt>
                <c:pt idx="401">
                  <c:v>276.20000000000005</c:v>
                </c:pt>
                <c:pt idx="402">
                  <c:v>273.10000000000042</c:v>
                </c:pt>
                <c:pt idx="403">
                  <c:v>268.50000000000068</c:v>
                </c:pt>
                <c:pt idx="404">
                  <c:v>260.89999999999998</c:v>
                </c:pt>
                <c:pt idx="405">
                  <c:v>256.29999999999956</c:v>
                </c:pt>
                <c:pt idx="406">
                  <c:v>257.79999999999967</c:v>
                </c:pt>
                <c:pt idx="407">
                  <c:v>254.80000000000015</c:v>
                </c:pt>
                <c:pt idx="408">
                  <c:v>253.29999999999933</c:v>
                </c:pt>
                <c:pt idx="409">
                  <c:v>251.80000000000061</c:v>
                </c:pt>
                <c:pt idx="410">
                  <c:v>244.09999999999985</c:v>
                </c:pt>
                <c:pt idx="411">
                  <c:v>239.59999999999951</c:v>
                </c:pt>
                <c:pt idx="412">
                  <c:v>234.90000000000038</c:v>
                </c:pt>
                <c:pt idx="413">
                  <c:v>239.59999999999951</c:v>
                </c:pt>
                <c:pt idx="414">
                  <c:v>236.49999999999989</c:v>
                </c:pt>
                <c:pt idx="415">
                  <c:v>233.50000000000034</c:v>
                </c:pt>
                <c:pt idx="416">
                  <c:v>233.50000000000034</c:v>
                </c:pt>
                <c:pt idx="417">
                  <c:v>221.30000000000064</c:v>
                </c:pt>
                <c:pt idx="418">
                  <c:v>209.09999999999954</c:v>
                </c:pt>
                <c:pt idx="419">
                  <c:v>212.09999999999977</c:v>
                </c:pt>
                <c:pt idx="420">
                  <c:v>213.59999999999988</c:v>
                </c:pt>
                <c:pt idx="421">
                  <c:v>215.1</c:v>
                </c:pt>
                <c:pt idx="422">
                  <c:v>216.59999999999943</c:v>
                </c:pt>
                <c:pt idx="423">
                  <c:v>212.10000000000048</c:v>
                </c:pt>
                <c:pt idx="424">
                  <c:v>202.90000000000029</c:v>
                </c:pt>
                <c:pt idx="425">
                  <c:v>202.90000000000029</c:v>
                </c:pt>
                <c:pt idx="426">
                  <c:v>205.99999999999991</c:v>
                </c:pt>
                <c:pt idx="427">
                  <c:v>199.90000000000006</c:v>
                </c:pt>
                <c:pt idx="428">
                  <c:v>198.39999999999995</c:v>
                </c:pt>
                <c:pt idx="429">
                  <c:v>204.4000000000004</c:v>
                </c:pt>
                <c:pt idx="430">
                  <c:v>195.29999999999961</c:v>
                </c:pt>
                <c:pt idx="431">
                  <c:v>190.7999999999993</c:v>
                </c:pt>
                <c:pt idx="432">
                  <c:v>202.90000000000029</c:v>
                </c:pt>
                <c:pt idx="433">
                  <c:v>190.70000000000059</c:v>
                </c:pt>
                <c:pt idx="434">
                  <c:v>178.60000000000096</c:v>
                </c:pt>
                <c:pt idx="435">
                  <c:v>179.9999999999996</c:v>
                </c:pt>
                <c:pt idx="436">
                  <c:v>173.99999999999983</c:v>
                </c:pt>
                <c:pt idx="437">
                  <c:v>164.80000000000035</c:v>
                </c:pt>
                <c:pt idx="438">
                  <c:v>173.99999999999915</c:v>
                </c:pt>
                <c:pt idx="439">
                  <c:v>177.00000000000006</c:v>
                </c:pt>
                <c:pt idx="440">
                  <c:v>170.9000000000002</c:v>
                </c:pt>
                <c:pt idx="441">
                  <c:v>164.79999999999964</c:v>
                </c:pt>
                <c:pt idx="442">
                  <c:v>158.7000000000005</c:v>
                </c:pt>
                <c:pt idx="443">
                  <c:v>155.60000000000016</c:v>
                </c:pt>
                <c:pt idx="444">
                  <c:v>148.0000000000002</c:v>
                </c:pt>
                <c:pt idx="445">
                  <c:v>143.39999999999907</c:v>
                </c:pt>
                <c:pt idx="446">
                  <c:v>144.99999999999929</c:v>
                </c:pt>
                <c:pt idx="447">
                  <c:v>146.4999999999994</c:v>
                </c:pt>
                <c:pt idx="448">
                  <c:v>138.90000000000012</c:v>
                </c:pt>
                <c:pt idx="449">
                  <c:v>131.20000000000005</c:v>
                </c:pt>
                <c:pt idx="450">
                  <c:v>132.69999999999948</c:v>
                </c:pt>
                <c:pt idx="451">
                  <c:v>128.19999999999914</c:v>
                </c:pt>
                <c:pt idx="452">
                  <c:v>143.40000000000046</c:v>
                </c:pt>
                <c:pt idx="453">
                  <c:v>151.09999999999982</c:v>
                </c:pt>
                <c:pt idx="454">
                  <c:v>137.30000000000061</c:v>
                </c:pt>
                <c:pt idx="455">
                  <c:v>135.79999999999981</c:v>
                </c:pt>
                <c:pt idx="456">
                  <c:v>131.20000000000005</c:v>
                </c:pt>
                <c:pt idx="457">
                  <c:v>122.09999999999998</c:v>
                </c:pt>
                <c:pt idx="458">
                  <c:v>105.29999999999983</c:v>
                </c:pt>
                <c:pt idx="459">
                  <c:v>86.900000000000162</c:v>
                </c:pt>
                <c:pt idx="460">
                  <c:v>74.700000000000458</c:v>
                </c:pt>
                <c:pt idx="461">
                  <c:v>70.200000000000117</c:v>
                </c:pt>
                <c:pt idx="462">
                  <c:v>60.999999999999936</c:v>
                </c:pt>
                <c:pt idx="463">
                  <c:v>61.099999999999348</c:v>
                </c:pt>
                <c:pt idx="464">
                  <c:v>61.000000000000632</c:v>
                </c:pt>
                <c:pt idx="465">
                  <c:v>57.900000000001</c:v>
                </c:pt>
                <c:pt idx="466">
                  <c:v>57.999999999999716</c:v>
                </c:pt>
                <c:pt idx="467">
                  <c:v>58.000000000001101</c:v>
                </c:pt>
                <c:pt idx="468">
                  <c:v>36.599999999999824</c:v>
                </c:pt>
                <c:pt idx="469">
                  <c:v>42.699999999999676</c:v>
                </c:pt>
                <c:pt idx="470">
                  <c:v>45.800000000000004</c:v>
                </c:pt>
                <c:pt idx="471">
                  <c:v>45.800000000000004</c:v>
                </c:pt>
                <c:pt idx="472">
                  <c:v>45.800000000000004</c:v>
                </c:pt>
                <c:pt idx="473">
                  <c:v>45.699999999999903</c:v>
                </c:pt>
                <c:pt idx="474">
                  <c:v>42.800000000000473</c:v>
                </c:pt>
                <c:pt idx="475">
                  <c:v>25.900000000000226</c:v>
                </c:pt>
                <c:pt idx="476">
                  <c:v>22.900000000000695</c:v>
                </c:pt>
                <c:pt idx="477">
                  <c:v>39.700000000000152</c:v>
                </c:pt>
                <c:pt idx="478">
                  <c:v>44.299999999999891</c:v>
                </c:pt>
                <c:pt idx="479">
                  <c:v>28.999999999999858</c:v>
                </c:pt>
                <c:pt idx="480">
                  <c:v>32.100000000000179</c:v>
                </c:pt>
                <c:pt idx="481">
                  <c:v>36.60000000000052</c:v>
                </c:pt>
                <c:pt idx="482">
                  <c:v>39.699999999999456</c:v>
                </c:pt>
                <c:pt idx="483">
                  <c:v>35.100000000000406</c:v>
                </c:pt>
                <c:pt idx="484">
                  <c:v>24.400000000000809</c:v>
                </c:pt>
                <c:pt idx="485">
                  <c:v>26.000000000000327</c:v>
                </c:pt>
                <c:pt idx="486">
                  <c:v>28.999999999999858</c:v>
                </c:pt>
                <c:pt idx="487">
                  <c:v>18.30000000000026</c:v>
                </c:pt>
                <c:pt idx="488">
                  <c:v>18.30000000000026</c:v>
                </c:pt>
                <c:pt idx="489">
                  <c:v>24.400000000000116</c:v>
                </c:pt>
                <c:pt idx="490">
                  <c:v>25.899999999999533</c:v>
                </c:pt>
                <c:pt idx="491">
                  <c:v>18.30000000000026</c:v>
                </c:pt>
                <c:pt idx="492">
                  <c:v>15.300000000000034</c:v>
                </c:pt>
                <c:pt idx="493">
                  <c:v>15.199999999999935</c:v>
                </c:pt>
                <c:pt idx="494">
                  <c:v>9.099999999999385</c:v>
                </c:pt>
                <c:pt idx="495">
                  <c:v>-3.1000000000003243</c:v>
                </c:pt>
                <c:pt idx="496">
                  <c:v>-4.5999999999990493</c:v>
                </c:pt>
                <c:pt idx="497">
                  <c:v>0</c:v>
                </c:pt>
                <c:pt idx="498">
                  <c:v>1.5000000000001121</c:v>
                </c:pt>
                <c:pt idx="499">
                  <c:v>-4.499999999999643</c:v>
                </c:pt>
                <c:pt idx="500">
                  <c:v>0</c:v>
                </c:pt>
                <c:pt idx="501">
                  <c:v>4.6000000000004366</c:v>
                </c:pt>
                <c:pt idx="502">
                  <c:v>1.6000000000002121</c:v>
                </c:pt>
                <c:pt idx="503">
                  <c:v>-13.799999999999228</c:v>
                </c:pt>
                <c:pt idx="504">
                  <c:v>-19.80000000000037</c:v>
                </c:pt>
                <c:pt idx="505">
                  <c:v>-9.1999999999994859</c:v>
                </c:pt>
                <c:pt idx="506">
                  <c:v>-18.400000000000357</c:v>
                </c:pt>
                <c:pt idx="507">
                  <c:v>-28.999999999999858</c:v>
                </c:pt>
                <c:pt idx="508">
                  <c:v>-31.999999999999389</c:v>
                </c:pt>
                <c:pt idx="509">
                  <c:v>-27.399999999999643</c:v>
                </c:pt>
                <c:pt idx="510">
                  <c:v>-29.000000000000551</c:v>
                </c:pt>
              </c:numCache>
            </c:numRef>
          </c:yVal>
          <c:smooth val="1"/>
          <c:extLst>
            <c:ext xmlns:c16="http://schemas.microsoft.com/office/drawing/2014/chart" uri="{C3380CC4-5D6E-409C-BE32-E72D297353CC}">
              <c16:uniqueId val="{00000000-C04D-4E3A-B81B-911277EA3C69}"/>
            </c:ext>
          </c:extLst>
        </c:ser>
        <c:dLbls>
          <c:showLegendKey val="0"/>
          <c:showVal val="0"/>
          <c:showCatName val="0"/>
          <c:showSerName val="0"/>
          <c:showPercent val="0"/>
          <c:showBubbleSize val="0"/>
        </c:dLbls>
        <c:axId val="150253840"/>
        <c:axId val="150254400"/>
      </c:scatterChart>
      <c:valAx>
        <c:axId val="150253840"/>
        <c:scaling>
          <c:orientation val="minMax"/>
          <c:max val="700"/>
          <c:min val="265"/>
        </c:scaling>
        <c:delete val="0"/>
        <c:axPos val="b"/>
        <c:title>
          <c:tx>
            <c:rich>
              <a:bodyPr/>
              <a:lstStyle/>
              <a:p>
                <a:pPr>
                  <a:defRPr/>
                </a:pPr>
                <a:r>
                  <a:rPr lang="en-GB" dirty="0"/>
                  <a:t>Wavelength (nm)</a:t>
                </a:r>
              </a:p>
            </c:rich>
          </c:tx>
          <c:layout/>
          <c:overlay val="0"/>
        </c:title>
        <c:numFmt formatCode="General" sourceLinked="1"/>
        <c:majorTickMark val="out"/>
        <c:minorTickMark val="none"/>
        <c:tickLblPos val="nextTo"/>
        <c:crossAx val="150254400"/>
        <c:crosses val="autoZero"/>
        <c:crossBetween val="midCat"/>
      </c:valAx>
      <c:valAx>
        <c:axId val="150254400"/>
        <c:scaling>
          <c:orientation val="minMax"/>
          <c:max val="43000"/>
          <c:min val="0"/>
        </c:scaling>
        <c:delete val="0"/>
        <c:axPos val="l"/>
        <c:title>
          <c:tx>
            <c:rich>
              <a:bodyPr rot="-5400000" vert="horz"/>
              <a:lstStyle/>
              <a:p>
                <a:pPr>
                  <a:defRPr/>
                </a:pPr>
                <a:r>
                  <a:rPr lang="el-GR" sz="1000" b="1" i="0" u="none" strike="noStrike" baseline="0">
                    <a:effectLst/>
                  </a:rPr>
                  <a:t>ε</a:t>
                </a:r>
                <a:r>
                  <a:rPr lang="en-GB" sz="1000" b="1" i="0" u="none" strike="noStrike" baseline="0">
                    <a:effectLst/>
                  </a:rPr>
                  <a:t> (M</a:t>
                </a:r>
                <a:r>
                  <a:rPr lang="en-GB" sz="1000" b="1" i="0" u="none" strike="noStrike" baseline="30000">
                    <a:effectLst/>
                  </a:rPr>
                  <a:t>−1</a:t>
                </a:r>
                <a:r>
                  <a:rPr lang="en-GB" sz="1000" b="1" i="0" u="none" strike="noStrike" baseline="0">
                    <a:effectLst/>
                  </a:rPr>
                  <a:t>⋅cm</a:t>
                </a:r>
                <a:r>
                  <a:rPr lang="en-GB" sz="1000" b="1" i="0" u="none" strike="noStrike" baseline="30000">
                    <a:effectLst/>
                  </a:rPr>
                  <a:t>−1</a:t>
                </a:r>
                <a:r>
                  <a:rPr lang="en-GB" sz="1000" b="1" i="0" u="none" strike="noStrike" baseline="0">
                    <a:effectLst/>
                  </a:rPr>
                  <a:t>) </a:t>
                </a:r>
                <a:endParaRPr lang="en-GB" b="1"/>
              </a:p>
            </c:rich>
          </c:tx>
          <c:layout/>
          <c:overlay val="0"/>
        </c:title>
        <c:numFmt formatCode="General" sourceLinked="1"/>
        <c:majorTickMark val="out"/>
        <c:minorTickMark val="none"/>
        <c:tickLblPos val="nextTo"/>
        <c:crossAx val="150253840"/>
        <c:crosses val="autoZero"/>
        <c:crossBetween val="midCat"/>
      </c:valAx>
    </c:plotArea>
    <c:plotVisOnly val="1"/>
    <c:dispBlanksAs val="gap"/>
    <c:showDLblsOverMax val="0"/>
  </c:chart>
  <c:spPr>
    <a:noFill/>
    <a:ln>
      <a:noFill/>
    </a:ln>
  </c:spPr>
  <c:externalData r:id="rId1">
    <c:autoUpdate val="0"/>
  </c:externalData>
</c:chartSpace>
</file>

<file path=ppt/charts/chart1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16832683389277378"/>
          <c:y val="6.6633807056750871E-2"/>
          <c:w val="0.69294047825951144"/>
          <c:h val="0.52371113850987183"/>
        </c:manualLayout>
      </c:layout>
      <c:scatterChart>
        <c:scatterStyle val="smoothMarker"/>
        <c:varyColors val="0"/>
        <c:ser>
          <c:idx val="0"/>
          <c:order val="0"/>
          <c:tx>
            <c:strRef>
              <c:f>Sheet1!$A$3</c:f>
              <c:strCache>
                <c:ptCount val="1"/>
                <c:pt idx="0">
                  <c:v>INK128 Emission</c:v>
                </c:pt>
              </c:strCache>
            </c:strRef>
          </c:tx>
          <c:spPr>
            <a:ln>
              <a:solidFill>
                <a:srgbClr val="0070C0"/>
              </a:solidFill>
            </a:ln>
          </c:spPr>
          <c:marker>
            <c:symbol val="none"/>
          </c:marker>
          <c:xVal>
            <c:numRef>
              <c:f>Sheet1!$A$6:$A$456</c:f>
              <c:numCache>
                <c:formatCode>General</c:formatCode>
                <c:ptCount val="451"/>
                <c:pt idx="0">
                  <c:v>250</c:v>
                </c:pt>
                <c:pt idx="1">
                  <c:v>251.07000729999999</c:v>
                </c:pt>
                <c:pt idx="2">
                  <c:v>252</c:v>
                </c:pt>
                <c:pt idx="3">
                  <c:v>253.07000729999999</c:v>
                </c:pt>
                <c:pt idx="4">
                  <c:v>254</c:v>
                </c:pt>
                <c:pt idx="5">
                  <c:v>255.07000729999999</c:v>
                </c:pt>
                <c:pt idx="6">
                  <c:v>256</c:v>
                </c:pt>
                <c:pt idx="7">
                  <c:v>257.07000729999999</c:v>
                </c:pt>
                <c:pt idx="8">
                  <c:v>258</c:v>
                </c:pt>
                <c:pt idx="9">
                  <c:v>259.07000729999999</c:v>
                </c:pt>
                <c:pt idx="10">
                  <c:v>260</c:v>
                </c:pt>
                <c:pt idx="11">
                  <c:v>260.92999270000001</c:v>
                </c:pt>
                <c:pt idx="12">
                  <c:v>262.02999879999999</c:v>
                </c:pt>
                <c:pt idx="13">
                  <c:v>262.9599915</c:v>
                </c:pt>
                <c:pt idx="14">
                  <c:v>264.05999759999997</c:v>
                </c:pt>
                <c:pt idx="15">
                  <c:v>265</c:v>
                </c:pt>
                <c:pt idx="16">
                  <c:v>265.92999270000001</c:v>
                </c:pt>
                <c:pt idx="17">
                  <c:v>267.02999879999999</c:v>
                </c:pt>
                <c:pt idx="18">
                  <c:v>267.9599915</c:v>
                </c:pt>
                <c:pt idx="19">
                  <c:v>269.05999759999997</c:v>
                </c:pt>
                <c:pt idx="20">
                  <c:v>270</c:v>
                </c:pt>
                <c:pt idx="21">
                  <c:v>271.07000729999999</c:v>
                </c:pt>
                <c:pt idx="22">
                  <c:v>272</c:v>
                </c:pt>
                <c:pt idx="23">
                  <c:v>273.07000729999999</c:v>
                </c:pt>
                <c:pt idx="24">
                  <c:v>274</c:v>
                </c:pt>
                <c:pt idx="25">
                  <c:v>275.07000729999999</c:v>
                </c:pt>
                <c:pt idx="26">
                  <c:v>276</c:v>
                </c:pt>
                <c:pt idx="27">
                  <c:v>277.07000729999999</c:v>
                </c:pt>
                <c:pt idx="28">
                  <c:v>278</c:v>
                </c:pt>
                <c:pt idx="29">
                  <c:v>279.07000729999999</c:v>
                </c:pt>
                <c:pt idx="30">
                  <c:v>280</c:v>
                </c:pt>
                <c:pt idx="31">
                  <c:v>281.07000729999999</c:v>
                </c:pt>
                <c:pt idx="32">
                  <c:v>282</c:v>
                </c:pt>
                <c:pt idx="33">
                  <c:v>283.07000729999999</c:v>
                </c:pt>
                <c:pt idx="34">
                  <c:v>284</c:v>
                </c:pt>
                <c:pt idx="35">
                  <c:v>285.07000729999999</c:v>
                </c:pt>
                <c:pt idx="36">
                  <c:v>286</c:v>
                </c:pt>
                <c:pt idx="37">
                  <c:v>287.07000729999999</c:v>
                </c:pt>
                <c:pt idx="38">
                  <c:v>288</c:v>
                </c:pt>
                <c:pt idx="39">
                  <c:v>289.07000729999999</c:v>
                </c:pt>
                <c:pt idx="40">
                  <c:v>290</c:v>
                </c:pt>
                <c:pt idx="41">
                  <c:v>290.92999270000001</c:v>
                </c:pt>
                <c:pt idx="42">
                  <c:v>292.02999879999999</c:v>
                </c:pt>
                <c:pt idx="43">
                  <c:v>292.9599915</c:v>
                </c:pt>
                <c:pt idx="44">
                  <c:v>294.05999759999997</c:v>
                </c:pt>
                <c:pt idx="45">
                  <c:v>295</c:v>
                </c:pt>
                <c:pt idx="46">
                  <c:v>295.92999270000001</c:v>
                </c:pt>
                <c:pt idx="47">
                  <c:v>297.02999879999999</c:v>
                </c:pt>
                <c:pt idx="48">
                  <c:v>297.9599915</c:v>
                </c:pt>
                <c:pt idx="49">
                  <c:v>299.05999759999997</c:v>
                </c:pt>
                <c:pt idx="50">
                  <c:v>300</c:v>
                </c:pt>
                <c:pt idx="51">
                  <c:v>301.07000729999999</c:v>
                </c:pt>
                <c:pt idx="52">
                  <c:v>302</c:v>
                </c:pt>
                <c:pt idx="53">
                  <c:v>303.07000729999999</c:v>
                </c:pt>
                <c:pt idx="54">
                  <c:v>304</c:v>
                </c:pt>
                <c:pt idx="55">
                  <c:v>305.07000729999999</c:v>
                </c:pt>
                <c:pt idx="56">
                  <c:v>306</c:v>
                </c:pt>
                <c:pt idx="57">
                  <c:v>307.07000729999999</c:v>
                </c:pt>
                <c:pt idx="58">
                  <c:v>308</c:v>
                </c:pt>
                <c:pt idx="59">
                  <c:v>309.07000729999999</c:v>
                </c:pt>
                <c:pt idx="60">
                  <c:v>310</c:v>
                </c:pt>
                <c:pt idx="61">
                  <c:v>311.07000729999999</c:v>
                </c:pt>
                <c:pt idx="62">
                  <c:v>312</c:v>
                </c:pt>
                <c:pt idx="63">
                  <c:v>313.07000729999999</c:v>
                </c:pt>
                <c:pt idx="64">
                  <c:v>314</c:v>
                </c:pt>
                <c:pt idx="65">
                  <c:v>315.07000729999999</c:v>
                </c:pt>
                <c:pt idx="66">
                  <c:v>316</c:v>
                </c:pt>
                <c:pt idx="67">
                  <c:v>317.07000729999999</c:v>
                </c:pt>
                <c:pt idx="68">
                  <c:v>318</c:v>
                </c:pt>
                <c:pt idx="69">
                  <c:v>319.07000729999999</c:v>
                </c:pt>
                <c:pt idx="70">
                  <c:v>320</c:v>
                </c:pt>
                <c:pt idx="71">
                  <c:v>321.07000729999999</c:v>
                </c:pt>
                <c:pt idx="72">
                  <c:v>322</c:v>
                </c:pt>
                <c:pt idx="73">
                  <c:v>323.07000729999999</c:v>
                </c:pt>
                <c:pt idx="74">
                  <c:v>324</c:v>
                </c:pt>
                <c:pt idx="75">
                  <c:v>325.07000729999999</c:v>
                </c:pt>
                <c:pt idx="76">
                  <c:v>326</c:v>
                </c:pt>
                <c:pt idx="77">
                  <c:v>327.07000729999999</c:v>
                </c:pt>
                <c:pt idx="78">
                  <c:v>328</c:v>
                </c:pt>
                <c:pt idx="79">
                  <c:v>329.07000729999999</c:v>
                </c:pt>
                <c:pt idx="80">
                  <c:v>330</c:v>
                </c:pt>
                <c:pt idx="81">
                  <c:v>331.07000729999999</c:v>
                </c:pt>
                <c:pt idx="82">
                  <c:v>332</c:v>
                </c:pt>
                <c:pt idx="83">
                  <c:v>333.07000729999999</c:v>
                </c:pt>
                <c:pt idx="84">
                  <c:v>334</c:v>
                </c:pt>
                <c:pt idx="85">
                  <c:v>335.07000729999999</c:v>
                </c:pt>
                <c:pt idx="86">
                  <c:v>336</c:v>
                </c:pt>
                <c:pt idx="87">
                  <c:v>337.07000729999999</c:v>
                </c:pt>
                <c:pt idx="88">
                  <c:v>338</c:v>
                </c:pt>
                <c:pt idx="89">
                  <c:v>339.07000729999999</c:v>
                </c:pt>
                <c:pt idx="90">
                  <c:v>340</c:v>
                </c:pt>
                <c:pt idx="91">
                  <c:v>341.05999759999997</c:v>
                </c:pt>
                <c:pt idx="92">
                  <c:v>341.9599915</c:v>
                </c:pt>
                <c:pt idx="93">
                  <c:v>343.02999879999999</c:v>
                </c:pt>
                <c:pt idx="94">
                  <c:v>343.92999270000001</c:v>
                </c:pt>
                <c:pt idx="95">
                  <c:v>345</c:v>
                </c:pt>
                <c:pt idx="96">
                  <c:v>346.05999759999997</c:v>
                </c:pt>
                <c:pt idx="97">
                  <c:v>346.9599915</c:v>
                </c:pt>
                <c:pt idx="98">
                  <c:v>348.02999879999999</c:v>
                </c:pt>
                <c:pt idx="99">
                  <c:v>348.92999270000001</c:v>
                </c:pt>
                <c:pt idx="100">
                  <c:v>350</c:v>
                </c:pt>
                <c:pt idx="101">
                  <c:v>351.07000729999999</c:v>
                </c:pt>
                <c:pt idx="102">
                  <c:v>352</c:v>
                </c:pt>
                <c:pt idx="103">
                  <c:v>353.07000729999999</c:v>
                </c:pt>
                <c:pt idx="104">
                  <c:v>354</c:v>
                </c:pt>
                <c:pt idx="105">
                  <c:v>355.07000729999999</c:v>
                </c:pt>
                <c:pt idx="106">
                  <c:v>356</c:v>
                </c:pt>
                <c:pt idx="107">
                  <c:v>357.07000729999999</c:v>
                </c:pt>
                <c:pt idx="108">
                  <c:v>358</c:v>
                </c:pt>
                <c:pt idx="109">
                  <c:v>359.07000729999999</c:v>
                </c:pt>
                <c:pt idx="110">
                  <c:v>360</c:v>
                </c:pt>
                <c:pt idx="111">
                  <c:v>361.07000729999999</c:v>
                </c:pt>
                <c:pt idx="112">
                  <c:v>362</c:v>
                </c:pt>
                <c:pt idx="113">
                  <c:v>363.07000729999999</c:v>
                </c:pt>
                <c:pt idx="114">
                  <c:v>364</c:v>
                </c:pt>
                <c:pt idx="115">
                  <c:v>365.07000729999999</c:v>
                </c:pt>
                <c:pt idx="116">
                  <c:v>366</c:v>
                </c:pt>
                <c:pt idx="117">
                  <c:v>367.07000729999999</c:v>
                </c:pt>
                <c:pt idx="118">
                  <c:v>368</c:v>
                </c:pt>
                <c:pt idx="119">
                  <c:v>369.07000729999999</c:v>
                </c:pt>
                <c:pt idx="120">
                  <c:v>370</c:v>
                </c:pt>
                <c:pt idx="121">
                  <c:v>371.05999759999997</c:v>
                </c:pt>
                <c:pt idx="122">
                  <c:v>371.9599915</c:v>
                </c:pt>
                <c:pt idx="123">
                  <c:v>373.02999879999999</c:v>
                </c:pt>
                <c:pt idx="124">
                  <c:v>373.92999270000001</c:v>
                </c:pt>
                <c:pt idx="125">
                  <c:v>375</c:v>
                </c:pt>
                <c:pt idx="126">
                  <c:v>376.05999759999997</c:v>
                </c:pt>
                <c:pt idx="127">
                  <c:v>376.9599915</c:v>
                </c:pt>
                <c:pt idx="128">
                  <c:v>378.02999879999999</c:v>
                </c:pt>
                <c:pt idx="129">
                  <c:v>378.92999270000001</c:v>
                </c:pt>
                <c:pt idx="130">
                  <c:v>380</c:v>
                </c:pt>
                <c:pt idx="131">
                  <c:v>381.07000729999999</c:v>
                </c:pt>
                <c:pt idx="132">
                  <c:v>382</c:v>
                </c:pt>
                <c:pt idx="133">
                  <c:v>383.07000729999999</c:v>
                </c:pt>
                <c:pt idx="134">
                  <c:v>384</c:v>
                </c:pt>
                <c:pt idx="135">
                  <c:v>385.07000729999999</c:v>
                </c:pt>
                <c:pt idx="136">
                  <c:v>386</c:v>
                </c:pt>
                <c:pt idx="137">
                  <c:v>387.07000729999999</c:v>
                </c:pt>
                <c:pt idx="138">
                  <c:v>388</c:v>
                </c:pt>
                <c:pt idx="139">
                  <c:v>389.07000729999999</c:v>
                </c:pt>
                <c:pt idx="140">
                  <c:v>390</c:v>
                </c:pt>
                <c:pt idx="141">
                  <c:v>391.05999759999997</c:v>
                </c:pt>
                <c:pt idx="142">
                  <c:v>391.9599915</c:v>
                </c:pt>
                <c:pt idx="143">
                  <c:v>393.02999879999999</c:v>
                </c:pt>
                <c:pt idx="144">
                  <c:v>393.92999270000001</c:v>
                </c:pt>
                <c:pt idx="145">
                  <c:v>395</c:v>
                </c:pt>
                <c:pt idx="146">
                  <c:v>396.05999759999997</c:v>
                </c:pt>
                <c:pt idx="147">
                  <c:v>396.9599915</c:v>
                </c:pt>
                <c:pt idx="148">
                  <c:v>398.02999879999999</c:v>
                </c:pt>
                <c:pt idx="149">
                  <c:v>398.92999270000001</c:v>
                </c:pt>
                <c:pt idx="150">
                  <c:v>400</c:v>
                </c:pt>
                <c:pt idx="151">
                  <c:v>401.05999759999997</c:v>
                </c:pt>
                <c:pt idx="152">
                  <c:v>401.9599915</c:v>
                </c:pt>
                <c:pt idx="153">
                  <c:v>403.02999879999999</c:v>
                </c:pt>
                <c:pt idx="154">
                  <c:v>403.92999270000001</c:v>
                </c:pt>
                <c:pt idx="155">
                  <c:v>405</c:v>
                </c:pt>
                <c:pt idx="156">
                  <c:v>406.05999759999997</c:v>
                </c:pt>
                <c:pt idx="157">
                  <c:v>406.9599915</c:v>
                </c:pt>
                <c:pt idx="158">
                  <c:v>408.02999879999999</c:v>
                </c:pt>
                <c:pt idx="159">
                  <c:v>408.92999270000001</c:v>
                </c:pt>
                <c:pt idx="160">
                  <c:v>410</c:v>
                </c:pt>
                <c:pt idx="161">
                  <c:v>411.05999759999997</c:v>
                </c:pt>
                <c:pt idx="162">
                  <c:v>411.9599915</c:v>
                </c:pt>
                <c:pt idx="163">
                  <c:v>413.02999879999999</c:v>
                </c:pt>
                <c:pt idx="164">
                  <c:v>413.92999270000001</c:v>
                </c:pt>
                <c:pt idx="165">
                  <c:v>415</c:v>
                </c:pt>
                <c:pt idx="166">
                  <c:v>416.05999759999997</c:v>
                </c:pt>
                <c:pt idx="167">
                  <c:v>416.9599915</c:v>
                </c:pt>
                <c:pt idx="168">
                  <c:v>418.02999879999999</c:v>
                </c:pt>
                <c:pt idx="169">
                  <c:v>418.92999270000001</c:v>
                </c:pt>
                <c:pt idx="170">
                  <c:v>420</c:v>
                </c:pt>
                <c:pt idx="171">
                  <c:v>421.05999759999997</c:v>
                </c:pt>
                <c:pt idx="172">
                  <c:v>421.9599915</c:v>
                </c:pt>
                <c:pt idx="173">
                  <c:v>423.02999879999999</c:v>
                </c:pt>
                <c:pt idx="174">
                  <c:v>423.92999270000001</c:v>
                </c:pt>
                <c:pt idx="175">
                  <c:v>425</c:v>
                </c:pt>
                <c:pt idx="176">
                  <c:v>426.05999759999997</c:v>
                </c:pt>
                <c:pt idx="177">
                  <c:v>426.9599915</c:v>
                </c:pt>
                <c:pt idx="178">
                  <c:v>428.02999879999999</c:v>
                </c:pt>
                <c:pt idx="179">
                  <c:v>428.92999270000001</c:v>
                </c:pt>
                <c:pt idx="180">
                  <c:v>430</c:v>
                </c:pt>
                <c:pt idx="181">
                  <c:v>431.05999759999997</c:v>
                </c:pt>
                <c:pt idx="182">
                  <c:v>431.9599915</c:v>
                </c:pt>
                <c:pt idx="183">
                  <c:v>433.02999879999999</c:v>
                </c:pt>
                <c:pt idx="184">
                  <c:v>433.92999270000001</c:v>
                </c:pt>
                <c:pt idx="185">
                  <c:v>435</c:v>
                </c:pt>
                <c:pt idx="186">
                  <c:v>436.05999759999997</c:v>
                </c:pt>
                <c:pt idx="187">
                  <c:v>436.9599915</c:v>
                </c:pt>
                <c:pt idx="188">
                  <c:v>438.02999879999999</c:v>
                </c:pt>
                <c:pt idx="189">
                  <c:v>438.92999270000001</c:v>
                </c:pt>
                <c:pt idx="190">
                  <c:v>440</c:v>
                </c:pt>
                <c:pt idx="191">
                  <c:v>441.05999759999997</c:v>
                </c:pt>
                <c:pt idx="192">
                  <c:v>441.9599915</c:v>
                </c:pt>
                <c:pt idx="193">
                  <c:v>443.02999879999999</c:v>
                </c:pt>
                <c:pt idx="194">
                  <c:v>443.92999270000001</c:v>
                </c:pt>
                <c:pt idx="195">
                  <c:v>445</c:v>
                </c:pt>
                <c:pt idx="196">
                  <c:v>446.05999759999997</c:v>
                </c:pt>
                <c:pt idx="197">
                  <c:v>446.9599915</c:v>
                </c:pt>
                <c:pt idx="198">
                  <c:v>448.02999879999999</c:v>
                </c:pt>
                <c:pt idx="199">
                  <c:v>448.92999270000001</c:v>
                </c:pt>
                <c:pt idx="200">
                  <c:v>450</c:v>
                </c:pt>
                <c:pt idx="201">
                  <c:v>451.0400085</c:v>
                </c:pt>
                <c:pt idx="202">
                  <c:v>451.94000240000003</c:v>
                </c:pt>
                <c:pt idx="203">
                  <c:v>452.98001099999999</c:v>
                </c:pt>
                <c:pt idx="204">
                  <c:v>454.01998900000001</c:v>
                </c:pt>
                <c:pt idx="205">
                  <c:v>455.07000729999999</c:v>
                </c:pt>
                <c:pt idx="206">
                  <c:v>455.97000120000001</c:v>
                </c:pt>
                <c:pt idx="207">
                  <c:v>457.01000979999998</c:v>
                </c:pt>
                <c:pt idx="208">
                  <c:v>458.0499878</c:v>
                </c:pt>
                <c:pt idx="209">
                  <c:v>458.9500122</c:v>
                </c:pt>
                <c:pt idx="210">
                  <c:v>460</c:v>
                </c:pt>
                <c:pt idx="211">
                  <c:v>461.05999759999997</c:v>
                </c:pt>
                <c:pt idx="212">
                  <c:v>461.9599915</c:v>
                </c:pt>
                <c:pt idx="213">
                  <c:v>463.02999879999999</c:v>
                </c:pt>
                <c:pt idx="214">
                  <c:v>463.92999270000001</c:v>
                </c:pt>
                <c:pt idx="215">
                  <c:v>465</c:v>
                </c:pt>
                <c:pt idx="216">
                  <c:v>466.05999759999997</c:v>
                </c:pt>
                <c:pt idx="217">
                  <c:v>466.9599915</c:v>
                </c:pt>
                <c:pt idx="218">
                  <c:v>468.02999879999999</c:v>
                </c:pt>
                <c:pt idx="219">
                  <c:v>468.92999270000001</c:v>
                </c:pt>
                <c:pt idx="220">
                  <c:v>470</c:v>
                </c:pt>
                <c:pt idx="221">
                  <c:v>471.0400085</c:v>
                </c:pt>
                <c:pt idx="222">
                  <c:v>471.94000240000003</c:v>
                </c:pt>
                <c:pt idx="223">
                  <c:v>472.98001099999999</c:v>
                </c:pt>
                <c:pt idx="224">
                  <c:v>474.01998900000001</c:v>
                </c:pt>
                <c:pt idx="225">
                  <c:v>475.07000729999999</c:v>
                </c:pt>
                <c:pt idx="226">
                  <c:v>475.97000120000001</c:v>
                </c:pt>
                <c:pt idx="227">
                  <c:v>477.01000979999998</c:v>
                </c:pt>
                <c:pt idx="228">
                  <c:v>478.0499878</c:v>
                </c:pt>
                <c:pt idx="229">
                  <c:v>478.9500122</c:v>
                </c:pt>
                <c:pt idx="230">
                  <c:v>480</c:v>
                </c:pt>
                <c:pt idx="231">
                  <c:v>481.0400085</c:v>
                </c:pt>
                <c:pt idx="232">
                  <c:v>481.94000240000003</c:v>
                </c:pt>
                <c:pt idx="233">
                  <c:v>482.98001099999999</c:v>
                </c:pt>
                <c:pt idx="234">
                  <c:v>484.01998900000001</c:v>
                </c:pt>
                <c:pt idx="235">
                  <c:v>485.07000729999999</c:v>
                </c:pt>
                <c:pt idx="236">
                  <c:v>485.97000120000001</c:v>
                </c:pt>
                <c:pt idx="237">
                  <c:v>487.01000979999998</c:v>
                </c:pt>
                <c:pt idx="238">
                  <c:v>488.0499878</c:v>
                </c:pt>
                <c:pt idx="239">
                  <c:v>488.9500122</c:v>
                </c:pt>
                <c:pt idx="240">
                  <c:v>490</c:v>
                </c:pt>
                <c:pt idx="241">
                  <c:v>491.0400085</c:v>
                </c:pt>
                <c:pt idx="242">
                  <c:v>491.94000240000003</c:v>
                </c:pt>
                <c:pt idx="243">
                  <c:v>492.98001099999999</c:v>
                </c:pt>
                <c:pt idx="244">
                  <c:v>494.01998900000001</c:v>
                </c:pt>
                <c:pt idx="245">
                  <c:v>495.07000729999999</c:v>
                </c:pt>
                <c:pt idx="246">
                  <c:v>495.97000120000001</c:v>
                </c:pt>
                <c:pt idx="247">
                  <c:v>497.01000979999998</c:v>
                </c:pt>
                <c:pt idx="248">
                  <c:v>498.0499878</c:v>
                </c:pt>
                <c:pt idx="249">
                  <c:v>498.9500122</c:v>
                </c:pt>
                <c:pt idx="250">
                  <c:v>500</c:v>
                </c:pt>
              </c:numCache>
            </c:numRef>
          </c:xVal>
          <c:yVal>
            <c:numRef>
              <c:f>Sheet1!$C$6:$C$256</c:f>
              <c:numCache>
                <c:formatCode>General</c:formatCode>
                <c:ptCount val="251"/>
                <c:pt idx="0">
                  <c:v>1.3453767956315612E-3</c:v>
                </c:pt>
                <c:pt idx="1">
                  <c:v>1.2043055054182187E-4</c:v>
                </c:pt>
                <c:pt idx="2">
                  <c:v>1.162579715543515E-3</c:v>
                </c:pt>
                <c:pt idx="3">
                  <c:v>4.3384386420589234E-4</c:v>
                </c:pt>
                <c:pt idx="4">
                  <c:v>4.2053481357941073E-4</c:v>
                </c:pt>
                <c:pt idx="5">
                  <c:v>1.2176077912292584E-3</c:v>
                </c:pt>
                <c:pt idx="6">
                  <c:v>1.0293751041313918E-3</c:v>
                </c:pt>
                <c:pt idx="7">
                  <c:v>4.5453111522180832E-4</c:v>
                </c:pt>
                <c:pt idx="8">
                  <c:v>8.9259734337961399E-4</c:v>
                </c:pt>
                <c:pt idx="9">
                  <c:v>5.0407662470369112E-4</c:v>
                </c:pt>
                <c:pt idx="10">
                  <c:v>9.2911439722316276E-4</c:v>
                </c:pt>
                <c:pt idx="11">
                  <c:v>9.5882380799187255E-4</c:v>
                </c:pt>
                <c:pt idx="12">
                  <c:v>1.1895943142566879E-3</c:v>
                </c:pt>
                <c:pt idx="13">
                  <c:v>1.2826666491703351E-3</c:v>
                </c:pt>
                <c:pt idx="14">
                  <c:v>4.2293884321029465E-4</c:v>
                </c:pt>
                <c:pt idx="15">
                  <c:v>7.2763977294276999E-4</c:v>
                </c:pt>
                <c:pt idx="16">
                  <c:v>1.1248566407043685E-3</c:v>
                </c:pt>
                <c:pt idx="17">
                  <c:v>9.9582768540467303E-4</c:v>
                </c:pt>
                <c:pt idx="18">
                  <c:v>4.9128621952251948E-4</c:v>
                </c:pt>
                <c:pt idx="19">
                  <c:v>9.1791897223162885E-4</c:v>
                </c:pt>
                <c:pt idx="20">
                  <c:v>9.1731564679986457E-4</c:v>
                </c:pt>
                <c:pt idx="21">
                  <c:v>9.7534180579072127E-4</c:v>
                </c:pt>
                <c:pt idx="22">
                  <c:v>1.1181165526583136E-3</c:v>
                </c:pt>
                <c:pt idx="23">
                  <c:v>1.1190309075516424E-3</c:v>
                </c:pt>
                <c:pt idx="24">
                  <c:v>7.3963336589908573E-4</c:v>
                </c:pt>
                <c:pt idx="25">
                  <c:v>1.13375230104978E-3</c:v>
                </c:pt>
                <c:pt idx="26">
                  <c:v>1.3876755562140196E-3</c:v>
                </c:pt>
                <c:pt idx="27">
                  <c:v>2.9936870589231292E-4</c:v>
                </c:pt>
                <c:pt idx="28">
                  <c:v>1.4427024966136132E-3</c:v>
                </c:pt>
                <c:pt idx="29">
                  <c:v>7.3201235294615644E-4</c:v>
                </c:pt>
                <c:pt idx="30">
                  <c:v>4.8799416923467657E-4</c:v>
                </c:pt>
                <c:pt idx="31">
                  <c:v>1.3173060463934981E-3</c:v>
                </c:pt>
                <c:pt idx="32">
                  <c:v>8.1198725846596675E-4</c:v>
                </c:pt>
                <c:pt idx="33">
                  <c:v>9.8668785641720276E-4</c:v>
                </c:pt>
                <c:pt idx="34">
                  <c:v>5.0057456163223838E-4</c:v>
                </c:pt>
                <c:pt idx="35">
                  <c:v>1.324105047409414E-3</c:v>
                </c:pt>
                <c:pt idx="36">
                  <c:v>1.6260207145275989E-3</c:v>
                </c:pt>
                <c:pt idx="37">
                  <c:v>7.4926695648493049E-4</c:v>
                </c:pt>
                <c:pt idx="38">
                  <c:v>1.1051775711141212E-3</c:v>
                </c:pt>
                <c:pt idx="39">
                  <c:v>1.2054630672197766E-3</c:v>
                </c:pt>
                <c:pt idx="40">
                  <c:v>1.8484644463257701E-3</c:v>
                </c:pt>
                <c:pt idx="41">
                  <c:v>2.0164337868269554E-3</c:v>
                </c:pt>
                <c:pt idx="42">
                  <c:v>1.943825318320352E-3</c:v>
                </c:pt>
                <c:pt idx="43">
                  <c:v>2.624405831357941E-3</c:v>
                </c:pt>
                <c:pt idx="44">
                  <c:v>2.9379973120555363E-3</c:v>
                </c:pt>
                <c:pt idx="45">
                  <c:v>4.6161561953945145E-3</c:v>
                </c:pt>
                <c:pt idx="46">
                  <c:v>5.0773822045377583E-3</c:v>
                </c:pt>
                <c:pt idx="47">
                  <c:v>6.3872967092786998E-3</c:v>
                </c:pt>
                <c:pt idx="48">
                  <c:v>7.2937934346427365E-3</c:v>
                </c:pt>
                <c:pt idx="49">
                  <c:v>7.3107478581103964E-3</c:v>
                </c:pt>
                <c:pt idx="50">
                  <c:v>7.1212306214019638E-3</c:v>
                </c:pt>
                <c:pt idx="51">
                  <c:v>7.8333613029122912E-3</c:v>
                </c:pt>
                <c:pt idx="52">
                  <c:v>9.7247087199458185E-3</c:v>
                </c:pt>
                <c:pt idx="53">
                  <c:v>1.1806011886217405E-2</c:v>
                </c:pt>
                <c:pt idx="54">
                  <c:v>1.4369957255333557E-2</c:v>
                </c:pt>
                <c:pt idx="55">
                  <c:v>1.8762801405350488E-2</c:v>
                </c:pt>
                <c:pt idx="56">
                  <c:v>2.3382966737216387E-2</c:v>
                </c:pt>
                <c:pt idx="57">
                  <c:v>2.7491973289874704E-2</c:v>
                </c:pt>
                <c:pt idx="58">
                  <c:v>3.2439209261767694E-2</c:v>
                </c:pt>
                <c:pt idx="59">
                  <c:v>3.7256423154419238E-2</c:v>
                </c:pt>
                <c:pt idx="60">
                  <c:v>4.2113525524889943E-2</c:v>
                </c:pt>
                <c:pt idx="61">
                  <c:v>4.8238775745005076E-2</c:v>
                </c:pt>
                <c:pt idx="62">
                  <c:v>5.3182210997290882E-2</c:v>
                </c:pt>
                <c:pt idx="63">
                  <c:v>6.0231888291567892E-2</c:v>
                </c:pt>
                <c:pt idx="64">
                  <c:v>6.2788901312224851E-2</c:v>
                </c:pt>
                <c:pt idx="65">
                  <c:v>7.0839706535726382E-2</c:v>
                </c:pt>
                <c:pt idx="66">
                  <c:v>7.5194385954961057E-2</c:v>
                </c:pt>
                <c:pt idx="67">
                  <c:v>8.1592311784625796E-2</c:v>
                </c:pt>
                <c:pt idx="68">
                  <c:v>8.6895183457500844E-2</c:v>
                </c:pt>
                <c:pt idx="69">
                  <c:v>9.2016823061293593E-2</c:v>
                </c:pt>
                <c:pt idx="70">
                  <c:v>9.7625779546224187E-2</c:v>
                </c:pt>
                <c:pt idx="71">
                  <c:v>0.10025777370470708</c:v>
                </c:pt>
                <c:pt idx="72">
                  <c:v>0.10653461716898069</c:v>
                </c:pt>
                <c:pt idx="73">
                  <c:v>0.11087600719607178</c:v>
                </c:pt>
                <c:pt idx="74">
                  <c:v>0.11976521740602776</c:v>
                </c:pt>
                <c:pt idx="75">
                  <c:v>0.12617803936674568</c:v>
                </c:pt>
                <c:pt idx="76">
                  <c:v>0.13098904850998985</c:v>
                </c:pt>
                <c:pt idx="77">
                  <c:v>0.13878943752116493</c:v>
                </c:pt>
                <c:pt idx="78">
                  <c:v>0.14568281061632238</c:v>
                </c:pt>
                <c:pt idx="79">
                  <c:v>0.15223170792414492</c:v>
                </c:pt>
                <c:pt idx="80">
                  <c:v>0.15993123129021333</c:v>
                </c:pt>
                <c:pt idx="81">
                  <c:v>0.16578546105655265</c:v>
                </c:pt>
                <c:pt idx="82">
                  <c:v>0.17135903022350152</c:v>
                </c:pt>
                <c:pt idx="83">
                  <c:v>0.17339969302404332</c:v>
                </c:pt>
                <c:pt idx="84">
                  <c:v>0.17650477006434134</c:v>
                </c:pt>
                <c:pt idx="85">
                  <c:v>0.17973604021334236</c:v>
                </c:pt>
                <c:pt idx="86">
                  <c:v>0.19096761403657297</c:v>
                </c:pt>
                <c:pt idx="87">
                  <c:v>0.19583414663054521</c:v>
                </c:pt>
                <c:pt idx="88">
                  <c:v>0.19705541813410088</c:v>
                </c:pt>
                <c:pt idx="89">
                  <c:v>0.20414819725702676</c:v>
                </c:pt>
                <c:pt idx="90">
                  <c:v>0.20804513401625466</c:v>
                </c:pt>
                <c:pt idx="91">
                  <c:v>0.22132030960040636</c:v>
                </c:pt>
                <c:pt idx="92">
                  <c:v>0.23151697079241448</c:v>
                </c:pt>
                <c:pt idx="93">
                  <c:v>0.24206514806975957</c:v>
                </c:pt>
                <c:pt idx="94">
                  <c:v>0.24947012394175416</c:v>
                </c:pt>
                <c:pt idx="95">
                  <c:v>0.25971484033186587</c:v>
                </c:pt>
                <c:pt idx="96">
                  <c:v>0.27527403843548931</c:v>
                </c:pt>
                <c:pt idx="97">
                  <c:v>0.28637531772773445</c:v>
                </c:pt>
                <c:pt idx="98">
                  <c:v>0.30712039840839822</c:v>
                </c:pt>
                <c:pt idx="99">
                  <c:v>0.31516869268540471</c:v>
                </c:pt>
                <c:pt idx="100">
                  <c:v>0.3310430910091432</c:v>
                </c:pt>
                <c:pt idx="101">
                  <c:v>0.34587267812394173</c:v>
                </c:pt>
                <c:pt idx="102">
                  <c:v>0.36553419370132068</c:v>
                </c:pt>
                <c:pt idx="103">
                  <c:v>0.3806243700474094</c:v>
                </c:pt>
                <c:pt idx="104">
                  <c:v>0.39083830917710799</c:v>
                </c:pt>
                <c:pt idx="105">
                  <c:v>0.40919639442939382</c:v>
                </c:pt>
                <c:pt idx="106">
                  <c:v>0.42238351735523194</c:v>
                </c:pt>
                <c:pt idx="107">
                  <c:v>0.44920905502878428</c:v>
                </c:pt>
                <c:pt idx="108">
                  <c:v>0.47249963554012864</c:v>
                </c:pt>
                <c:pt idx="109">
                  <c:v>0.49007456459532678</c:v>
                </c:pt>
                <c:pt idx="110">
                  <c:v>0.51022725634947508</c:v>
                </c:pt>
                <c:pt idx="111">
                  <c:v>0.52779869751100572</c:v>
                </c:pt>
                <c:pt idx="112">
                  <c:v>0.54740621562817471</c:v>
                </c:pt>
                <c:pt idx="113">
                  <c:v>0.57598615230274297</c:v>
                </c:pt>
                <c:pt idx="114">
                  <c:v>0.5902974677446664</c:v>
                </c:pt>
                <c:pt idx="115">
                  <c:v>0.60825354359972905</c:v>
                </c:pt>
                <c:pt idx="116">
                  <c:v>0.62232690873687768</c:v>
                </c:pt>
                <c:pt idx="117">
                  <c:v>0.65260324246528945</c:v>
                </c:pt>
                <c:pt idx="118">
                  <c:v>0.66991619361666099</c:v>
                </c:pt>
                <c:pt idx="119">
                  <c:v>0.69337425660345409</c:v>
                </c:pt>
                <c:pt idx="120">
                  <c:v>0.70410947096173371</c:v>
                </c:pt>
                <c:pt idx="121">
                  <c:v>0.72434545165932951</c:v>
                </c:pt>
                <c:pt idx="122">
                  <c:v>0.73411433203521836</c:v>
                </c:pt>
                <c:pt idx="123">
                  <c:v>0.76176022985099889</c:v>
                </c:pt>
                <c:pt idx="124">
                  <c:v>0.77729242922451736</c:v>
                </c:pt>
                <c:pt idx="125">
                  <c:v>0.78970356552658316</c:v>
                </c:pt>
                <c:pt idx="126">
                  <c:v>0.82014169768032508</c:v>
                </c:pt>
                <c:pt idx="127">
                  <c:v>0.83292125643413484</c:v>
                </c:pt>
                <c:pt idx="128">
                  <c:v>0.8460634246528953</c:v>
                </c:pt>
                <c:pt idx="129">
                  <c:v>0.85944328479512355</c:v>
                </c:pt>
                <c:pt idx="130">
                  <c:v>0.87208978750423294</c:v>
                </c:pt>
                <c:pt idx="131">
                  <c:v>0.89257392397561797</c:v>
                </c:pt>
                <c:pt idx="132">
                  <c:v>0.9014891804944124</c:v>
                </c:pt>
                <c:pt idx="133">
                  <c:v>0.91967939552996958</c:v>
                </c:pt>
                <c:pt idx="134">
                  <c:v>0.91998568235692513</c:v>
                </c:pt>
                <c:pt idx="135">
                  <c:v>0.93113569505587535</c:v>
                </c:pt>
                <c:pt idx="136">
                  <c:v>0.94251054605485951</c:v>
                </c:pt>
                <c:pt idx="137">
                  <c:v>0.95555615221808321</c:v>
                </c:pt>
                <c:pt idx="138">
                  <c:v>0.95521014222824241</c:v>
                </c:pt>
                <c:pt idx="139">
                  <c:v>0.96895312817473744</c:v>
                </c:pt>
                <c:pt idx="140">
                  <c:v>0.97120939299017939</c:v>
                </c:pt>
                <c:pt idx="141">
                  <c:v>0.97941112174060274</c:v>
                </c:pt>
                <c:pt idx="142">
                  <c:v>0.97760459871317307</c:v>
                </c:pt>
                <c:pt idx="143">
                  <c:v>0.99768614375211639</c:v>
                </c:pt>
                <c:pt idx="144">
                  <c:v>0.99447226464612259</c:v>
                </c:pt>
                <c:pt idx="145">
                  <c:v>0.99425517693870635</c:v>
                </c:pt>
                <c:pt idx="146">
                  <c:v>0.99321669573315274</c:v>
                </c:pt>
                <c:pt idx="147">
                  <c:v>1.0000031239417542</c:v>
                </c:pt>
                <c:pt idx="148">
                  <c:v>0.99572085760243823</c:v>
                </c:pt>
                <c:pt idx="149">
                  <c:v>0.99840283694547916</c:v>
                </c:pt>
                <c:pt idx="150">
                  <c:v>0.99510737978327124</c:v>
                </c:pt>
                <c:pt idx="151">
                  <c:v>0.99412483406705043</c:v>
                </c:pt>
                <c:pt idx="152">
                  <c:v>0.99783114883169655</c:v>
                </c:pt>
                <c:pt idx="153">
                  <c:v>0.99198257111412125</c:v>
                </c:pt>
                <c:pt idx="154">
                  <c:v>0.99507159752793761</c:v>
                </c:pt>
                <c:pt idx="155">
                  <c:v>0.99733632323061294</c:v>
                </c:pt>
                <c:pt idx="156">
                  <c:v>0.9763339155096511</c:v>
                </c:pt>
                <c:pt idx="157">
                  <c:v>0.97120048002031822</c:v>
                </c:pt>
                <c:pt idx="158">
                  <c:v>0.97177171520487637</c:v>
                </c:pt>
                <c:pt idx="159">
                  <c:v>0.96049930494412461</c:v>
                </c:pt>
                <c:pt idx="160">
                  <c:v>0.95489952759905183</c:v>
                </c:pt>
                <c:pt idx="161">
                  <c:v>0.95074618438875713</c:v>
                </c:pt>
                <c:pt idx="162">
                  <c:v>0.92998831442600738</c:v>
                </c:pt>
                <c:pt idx="163">
                  <c:v>0.92474862851337614</c:v>
                </c:pt>
                <c:pt idx="164">
                  <c:v>0.91282747375550277</c:v>
                </c:pt>
                <c:pt idx="165">
                  <c:v>0.90799786996274978</c:v>
                </c:pt>
                <c:pt idx="166">
                  <c:v>0.90453725618015579</c:v>
                </c:pt>
                <c:pt idx="167">
                  <c:v>0.88639096258042671</c:v>
                </c:pt>
                <c:pt idx="168">
                  <c:v>0.87070413393159496</c:v>
                </c:pt>
                <c:pt idx="169">
                  <c:v>0.86971971469691833</c:v>
                </c:pt>
                <c:pt idx="170">
                  <c:v>0.86242205553674223</c:v>
                </c:pt>
                <c:pt idx="171">
                  <c:v>0.84234755037250253</c:v>
                </c:pt>
                <c:pt idx="172">
                  <c:v>0.82966474771418897</c:v>
                </c:pt>
                <c:pt idx="173">
                  <c:v>0.82576911894683369</c:v>
                </c:pt>
                <c:pt idx="174">
                  <c:v>0.80258808338977305</c:v>
                </c:pt>
                <c:pt idx="175">
                  <c:v>0.78935768498137482</c:v>
                </c:pt>
                <c:pt idx="176">
                  <c:v>0.7739706197934304</c:v>
                </c:pt>
                <c:pt idx="177">
                  <c:v>0.76222560218421942</c:v>
                </c:pt>
                <c:pt idx="178">
                  <c:v>0.75033067084321026</c:v>
                </c:pt>
                <c:pt idx="179">
                  <c:v>0.74009790365729755</c:v>
                </c:pt>
                <c:pt idx="180">
                  <c:v>0.73255415577378935</c:v>
                </c:pt>
                <c:pt idx="181">
                  <c:v>0.71147908364375201</c:v>
                </c:pt>
                <c:pt idx="182">
                  <c:v>0.69649454461564508</c:v>
                </c:pt>
                <c:pt idx="183">
                  <c:v>0.68590381857433125</c:v>
                </c:pt>
                <c:pt idx="184">
                  <c:v>0.66737146892990185</c:v>
                </c:pt>
                <c:pt idx="185">
                  <c:v>0.65964809566542493</c:v>
                </c:pt>
                <c:pt idx="186">
                  <c:v>0.6406386827802234</c:v>
                </c:pt>
                <c:pt idx="187">
                  <c:v>0.62557799187267182</c:v>
                </c:pt>
                <c:pt idx="188">
                  <c:v>0.61962051473078217</c:v>
                </c:pt>
                <c:pt idx="189">
                  <c:v>0.5998417679478496</c:v>
                </c:pt>
                <c:pt idx="190">
                  <c:v>0.59316191398577722</c:v>
                </c:pt>
                <c:pt idx="191">
                  <c:v>0.57115971418896039</c:v>
                </c:pt>
                <c:pt idx="192">
                  <c:v>0.56474048162885204</c:v>
                </c:pt>
                <c:pt idx="193">
                  <c:v>0.55416474051811715</c:v>
                </c:pt>
                <c:pt idx="194">
                  <c:v>0.54829904597019974</c:v>
                </c:pt>
                <c:pt idx="195">
                  <c:v>0.53237614045038939</c:v>
                </c:pt>
                <c:pt idx="196">
                  <c:v>0.52187122248560791</c:v>
                </c:pt>
                <c:pt idx="197">
                  <c:v>0.50330877387402639</c:v>
                </c:pt>
                <c:pt idx="198">
                  <c:v>0.49669370386048084</c:v>
                </c:pt>
                <c:pt idx="199">
                  <c:v>0.48850240687436508</c:v>
                </c:pt>
                <c:pt idx="200">
                  <c:v>0.47868204808669146</c:v>
                </c:pt>
                <c:pt idx="201">
                  <c:v>0.46650999246528951</c:v>
                </c:pt>
                <c:pt idx="202">
                  <c:v>0.46023915594310866</c:v>
                </c:pt>
                <c:pt idx="203">
                  <c:v>0.45143767533017271</c:v>
                </c:pt>
                <c:pt idx="204">
                  <c:v>0.44162157949542835</c:v>
                </c:pt>
                <c:pt idx="205">
                  <c:v>0.43460892448357596</c:v>
                </c:pt>
                <c:pt idx="206">
                  <c:v>0.42402181552658313</c:v>
                </c:pt>
                <c:pt idx="207">
                  <c:v>0.41452360040636638</c:v>
                </c:pt>
                <c:pt idx="208">
                  <c:v>0.40696932424652893</c:v>
                </c:pt>
                <c:pt idx="209">
                  <c:v>0.39648210404673212</c:v>
                </c:pt>
                <c:pt idx="210">
                  <c:v>0.39076677548256006</c:v>
                </c:pt>
                <c:pt idx="211">
                  <c:v>0.3825369181341009</c:v>
                </c:pt>
                <c:pt idx="212">
                  <c:v>0.37081951295292925</c:v>
                </c:pt>
                <c:pt idx="213">
                  <c:v>0.36038609625804263</c:v>
                </c:pt>
                <c:pt idx="214">
                  <c:v>0.35518758626820185</c:v>
                </c:pt>
                <c:pt idx="215">
                  <c:v>0.34528032145275989</c:v>
                </c:pt>
                <c:pt idx="216">
                  <c:v>0.34103015704368439</c:v>
                </c:pt>
                <c:pt idx="217">
                  <c:v>0.33538300347104638</c:v>
                </c:pt>
                <c:pt idx="218">
                  <c:v>0.325539133931595</c:v>
                </c:pt>
                <c:pt idx="219">
                  <c:v>0.31896401295292925</c:v>
                </c:pt>
                <c:pt idx="220">
                  <c:v>0.3084706888757196</c:v>
                </c:pt>
                <c:pt idx="221">
                  <c:v>0.30095813799525906</c:v>
                </c:pt>
                <c:pt idx="222">
                  <c:v>0.294823134693532</c:v>
                </c:pt>
                <c:pt idx="223">
                  <c:v>0.28629574254994922</c:v>
                </c:pt>
                <c:pt idx="224">
                  <c:v>0.28085718303420248</c:v>
                </c:pt>
                <c:pt idx="225">
                  <c:v>0.27309967389095829</c:v>
                </c:pt>
                <c:pt idx="226">
                  <c:v>0.26772244277006435</c:v>
                </c:pt>
                <c:pt idx="227">
                  <c:v>0.25806871063325432</c:v>
                </c:pt>
                <c:pt idx="228">
                  <c:v>0.25422247714188961</c:v>
                </c:pt>
                <c:pt idx="229">
                  <c:v>0.24695953513376226</c:v>
                </c:pt>
                <c:pt idx="230">
                  <c:v>0.23765639857771756</c:v>
                </c:pt>
                <c:pt idx="231">
                  <c:v>0.23401971190314932</c:v>
                </c:pt>
                <c:pt idx="232">
                  <c:v>0.2285424951743989</c:v>
                </c:pt>
                <c:pt idx="233">
                  <c:v>0.21582069615645105</c:v>
                </c:pt>
                <c:pt idx="234">
                  <c:v>0.21336907822553333</c:v>
                </c:pt>
                <c:pt idx="235">
                  <c:v>0.20850469327802235</c:v>
                </c:pt>
                <c:pt idx="236">
                  <c:v>0.20161693955299695</c:v>
                </c:pt>
                <c:pt idx="237">
                  <c:v>0.19415352573653913</c:v>
                </c:pt>
                <c:pt idx="238">
                  <c:v>0.19085152929224516</c:v>
                </c:pt>
                <c:pt idx="239">
                  <c:v>0.18338516043007108</c:v>
                </c:pt>
                <c:pt idx="240">
                  <c:v>0.17730457433118862</c:v>
                </c:pt>
                <c:pt idx="241">
                  <c:v>0.17283745149001017</c:v>
                </c:pt>
                <c:pt idx="242">
                  <c:v>0.17327269251608535</c:v>
                </c:pt>
                <c:pt idx="243">
                  <c:v>0.16446239536065019</c:v>
                </c:pt>
                <c:pt idx="244">
                  <c:v>0.15947612876735523</c:v>
                </c:pt>
                <c:pt idx="245">
                  <c:v>0.15465098239078903</c:v>
                </c:pt>
                <c:pt idx="246">
                  <c:v>0.15268487284117846</c:v>
                </c:pt>
                <c:pt idx="247">
                  <c:v>0.14579648933288181</c:v>
                </c:pt>
                <c:pt idx="248">
                  <c:v>0.14538546960717913</c:v>
                </c:pt>
                <c:pt idx="249">
                  <c:v>0.14294815839823907</c:v>
                </c:pt>
                <c:pt idx="250">
                  <c:v>0.13756832754825601</c:v>
                </c:pt>
              </c:numCache>
            </c:numRef>
          </c:yVal>
          <c:smooth val="1"/>
          <c:extLst>
            <c:ext xmlns:c16="http://schemas.microsoft.com/office/drawing/2014/chart" uri="{C3380CC4-5D6E-409C-BE32-E72D297353CC}">
              <c16:uniqueId val="{00000000-72FF-479C-936F-9968A7358709}"/>
            </c:ext>
          </c:extLst>
        </c:ser>
        <c:ser>
          <c:idx val="1"/>
          <c:order val="1"/>
          <c:tx>
            <c:strRef>
              <c:f>Sheet1!$D$3</c:f>
              <c:strCache>
                <c:ptCount val="1"/>
                <c:pt idx="0">
                  <c:v>INK128 Excitation</c:v>
                </c:pt>
              </c:strCache>
            </c:strRef>
          </c:tx>
          <c:spPr>
            <a:ln>
              <a:solidFill>
                <a:srgbClr val="002060"/>
              </a:solidFill>
            </a:ln>
          </c:spPr>
          <c:marker>
            <c:symbol val="none"/>
          </c:marker>
          <c:xVal>
            <c:numRef>
              <c:f>Sheet1!$D$6:$D$456</c:f>
              <c:numCache>
                <c:formatCode>General</c:formatCode>
                <c:ptCount val="451"/>
                <c:pt idx="0">
                  <c:v>250</c:v>
                </c:pt>
                <c:pt idx="1">
                  <c:v>250.92999270000001</c:v>
                </c:pt>
                <c:pt idx="2">
                  <c:v>252.02999879999999</c:v>
                </c:pt>
                <c:pt idx="3">
                  <c:v>252.96000670000001</c:v>
                </c:pt>
                <c:pt idx="4">
                  <c:v>254.0599976</c:v>
                </c:pt>
                <c:pt idx="5">
                  <c:v>255</c:v>
                </c:pt>
                <c:pt idx="6">
                  <c:v>255.92999270000001</c:v>
                </c:pt>
                <c:pt idx="7">
                  <c:v>257.02999879999999</c:v>
                </c:pt>
                <c:pt idx="8">
                  <c:v>257.9599915</c:v>
                </c:pt>
                <c:pt idx="9">
                  <c:v>259.05999759999997</c:v>
                </c:pt>
                <c:pt idx="10">
                  <c:v>260</c:v>
                </c:pt>
                <c:pt idx="11">
                  <c:v>260.92999270000001</c:v>
                </c:pt>
                <c:pt idx="12">
                  <c:v>262.02999879999999</c:v>
                </c:pt>
                <c:pt idx="13">
                  <c:v>262.9599915</c:v>
                </c:pt>
                <c:pt idx="14">
                  <c:v>264.05999759999997</c:v>
                </c:pt>
                <c:pt idx="15">
                  <c:v>265</c:v>
                </c:pt>
                <c:pt idx="16">
                  <c:v>265.92999270000001</c:v>
                </c:pt>
                <c:pt idx="17">
                  <c:v>267.02999879999999</c:v>
                </c:pt>
                <c:pt idx="18">
                  <c:v>267.9599915</c:v>
                </c:pt>
                <c:pt idx="19">
                  <c:v>269.05999759999997</c:v>
                </c:pt>
                <c:pt idx="20">
                  <c:v>270</c:v>
                </c:pt>
                <c:pt idx="21">
                  <c:v>271.07000729999999</c:v>
                </c:pt>
                <c:pt idx="22">
                  <c:v>272</c:v>
                </c:pt>
                <c:pt idx="23">
                  <c:v>273.07000729999999</c:v>
                </c:pt>
                <c:pt idx="24">
                  <c:v>274</c:v>
                </c:pt>
                <c:pt idx="25">
                  <c:v>275.07000729999999</c:v>
                </c:pt>
                <c:pt idx="26">
                  <c:v>276</c:v>
                </c:pt>
                <c:pt idx="27">
                  <c:v>277.07000729999999</c:v>
                </c:pt>
                <c:pt idx="28">
                  <c:v>278</c:v>
                </c:pt>
                <c:pt idx="29">
                  <c:v>279.07000729999999</c:v>
                </c:pt>
                <c:pt idx="30">
                  <c:v>280</c:v>
                </c:pt>
                <c:pt idx="31">
                  <c:v>280.92999270000001</c:v>
                </c:pt>
                <c:pt idx="32">
                  <c:v>282.02999879999999</c:v>
                </c:pt>
                <c:pt idx="33">
                  <c:v>282.9599915</c:v>
                </c:pt>
                <c:pt idx="34">
                  <c:v>284.05999759999997</c:v>
                </c:pt>
                <c:pt idx="35">
                  <c:v>285</c:v>
                </c:pt>
                <c:pt idx="36">
                  <c:v>285.92999270000001</c:v>
                </c:pt>
                <c:pt idx="37">
                  <c:v>287.02999879999999</c:v>
                </c:pt>
                <c:pt idx="38">
                  <c:v>287.9599915</c:v>
                </c:pt>
                <c:pt idx="39">
                  <c:v>289.05999759999997</c:v>
                </c:pt>
                <c:pt idx="40">
                  <c:v>290</c:v>
                </c:pt>
                <c:pt idx="41">
                  <c:v>290.92999270000001</c:v>
                </c:pt>
                <c:pt idx="42">
                  <c:v>292.02999879999999</c:v>
                </c:pt>
                <c:pt idx="43">
                  <c:v>292.9599915</c:v>
                </c:pt>
                <c:pt idx="44">
                  <c:v>294.05999759999997</c:v>
                </c:pt>
                <c:pt idx="45">
                  <c:v>295</c:v>
                </c:pt>
                <c:pt idx="46">
                  <c:v>295.92999270000001</c:v>
                </c:pt>
                <c:pt idx="47">
                  <c:v>297.02999879999999</c:v>
                </c:pt>
                <c:pt idx="48">
                  <c:v>297.9599915</c:v>
                </c:pt>
                <c:pt idx="49">
                  <c:v>299.05999759999997</c:v>
                </c:pt>
                <c:pt idx="50">
                  <c:v>300</c:v>
                </c:pt>
                <c:pt idx="51">
                  <c:v>301.07000729999999</c:v>
                </c:pt>
                <c:pt idx="52">
                  <c:v>302</c:v>
                </c:pt>
                <c:pt idx="53">
                  <c:v>303.07000729999999</c:v>
                </c:pt>
                <c:pt idx="54">
                  <c:v>304</c:v>
                </c:pt>
                <c:pt idx="55">
                  <c:v>305.07000729999999</c:v>
                </c:pt>
                <c:pt idx="56">
                  <c:v>306</c:v>
                </c:pt>
                <c:pt idx="57">
                  <c:v>307.07000729999999</c:v>
                </c:pt>
                <c:pt idx="58">
                  <c:v>308</c:v>
                </c:pt>
                <c:pt idx="59">
                  <c:v>309.07000729999999</c:v>
                </c:pt>
                <c:pt idx="60">
                  <c:v>310</c:v>
                </c:pt>
                <c:pt idx="61">
                  <c:v>310.92999270000001</c:v>
                </c:pt>
                <c:pt idx="62">
                  <c:v>312.02999879999999</c:v>
                </c:pt>
                <c:pt idx="63">
                  <c:v>312.9599915</c:v>
                </c:pt>
                <c:pt idx="64">
                  <c:v>314.05999759999997</c:v>
                </c:pt>
                <c:pt idx="65">
                  <c:v>315</c:v>
                </c:pt>
                <c:pt idx="66">
                  <c:v>315.92999270000001</c:v>
                </c:pt>
                <c:pt idx="67">
                  <c:v>317.02999879999999</c:v>
                </c:pt>
                <c:pt idx="68">
                  <c:v>317.9599915</c:v>
                </c:pt>
                <c:pt idx="69">
                  <c:v>319.05999759999997</c:v>
                </c:pt>
                <c:pt idx="70">
                  <c:v>320</c:v>
                </c:pt>
                <c:pt idx="71">
                  <c:v>321.07000729999999</c:v>
                </c:pt>
                <c:pt idx="72">
                  <c:v>322</c:v>
                </c:pt>
                <c:pt idx="73">
                  <c:v>323.07000729999999</c:v>
                </c:pt>
                <c:pt idx="74">
                  <c:v>324</c:v>
                </c:pt>
                <c:pt idx="75">
                  <c:v>325.07000729999999</c:v>
                </c:pt>
                <c:pt idx="76">
                  <c:v>326</c:v>
                </c:pt>
                <c:pt idx="77">
                  <c:v>327.07000729999999</c:v>
                </c:pt>
                <c:pt idx="78">
                  <c:v>328</c:v>
                </c:pt>
                <c:pt idx="79">
                  <c:v>329.07000729999999</c:v>
                </c:pt>
                <c:pt idx="80">
                  <c:v>330</c:v>
                </c:pt>
                <c:pt idx="81">
                  <c:v>331.07000729999999</c:v>
                </c:pt>
                <c:pt idx="82">
                  <c:v>332</c:v>
                </c:pt>
                <c:pt idx="83">
                  <c:v>333.07000729999999</c:v>
                </c:pt>
                <c:pt idx="84">
                  <c:v>334</c:v>
                </c:pt>
                <c:pt idx="85">
                  <c:v>335.07000729999999</c:v>
                </c:pt>
                <c:pt idx="86">
                  <c:v>336</c:v>
                </c:pt>
                <c:pt idx="87">
                  <c:v>337.07000729999999</c:v>
                </c:pt>
                <c:pt idx="88">
                  <c:v>338</c:v>
                </c:pt>
                <c:pt idx="89">
                  <c:v>339.07000729999999</c:v>
                </c:pt>
                <c:pt idx="90">
                  <c:v>340</c:v>
                </c:pt>
                <c:pt idx="91">
                  <c:v>341.07000729999999</c:v>
                </c:pt>
                <c:pt idx="92">
                  <c:v>342</c:v>
                </c:pt>
                <c:pt idx="93">
                  <c:v>343.07000729999999</c:v>
                </c:pt>
                <c:pt idx="94">
                  <c:v>344</c:v>
                </c:pt>
                <c:pt idx="95">
                  <c:v>345.07000729999999</c:v>
                </c:pt>
                <c:pt idx="96">
                  <c:v>346</c:v>
                </c:pt>
                <c:pt idx="97">
                  <c:v>347.07000729999999</c:v>
                </c:pt>
                <c:pt idx="98">
                  <c:v>348</c:v>
                </c:pt>
                <c:pt idx="99">
                  <c:v>349.07000729999999</c:v>
                </c:pt>
                <c:pt idx="100">
                  <c:v>350</c:v>
                </c:pt>
                <c:pt idx="101">
                  <c:v>350.92999270000001</c:v>
                </c:pt>
                <c:pt idx="102">
                  <c:v>352.02999879999999</c:v>
                </c:pt>
                <c:pt idx="103">
                  <c:v>352.9599915</c:v>
                </c:pt>
                <c:pt idx="104">
                  <c:v>354.05999759999997</c:v>
                </c:pt>
                <c:pt idx="105">
                  <c:v>355</c:v>
                </c:pt>
                <c:pt idx="106">
                  <c:v>355.92999270000001</c:v>
                </c:pt>
                <c:pt idx="107">
                  <c:v>357.02999879999999</c:v>
                </c:pt>
                <c:pt idx="108">
                  <c:v>357.9599915</c:v>
                </c:pt>
                <c:pt idx="109">
                  <c:v>359.05999759999997</c:v>
                </c:pt>
                <c:pt idx="110">
                  <c:v>360</c:v>
                </c:pt>
                <c:pt idx="111">
                  <c:v>361.07000729999999</c:v>
                </c:pt>
                <c:pt idx="112">
                  <c:v>362</c:v>
                </c:pt>
                <c:pt idx="113">
                  <c:v>363.07000729999999</c:v>
                </c:pt>
                <c:pt idx="114">
                  <c:v>364</c:v>
                </c:pt>
                <c:pt idx="115">
                  <c:v>365.07000729999999</c:v>
                </c:pt>
                <c:pt idx="116">
                  <c:v>366</c:v>
                </c:pt>
                <c:pt idx="117">
                  <c:v>367.07000729999999</c:v>
                </c:pt>
                <c:pt idx="118">
                  <c:v>368</c:v>
                </c:pt>
                <c:pt idx="119">
                  <c:v>369.07000729999999</c:v>
                </c:pt>
                <c:pt idx="120">
                  <c:v>370</c:v>
                </c:pt>
                <c:pt idx="121">
                  <c:v>371.05999759999997</c:v>
                </c:pt>
                <c:pt idx="122">
                  <c:v>371.9599915</c:v>
                </c:pt>
                <c:pt idx="123">
                  <c:v>373.02999879999999</c:v>
                </c:pt>
                <c:pt idx="124">
                  <c:v>373.92999270000001</c:v>
                </c:pt>
                <c:pt idx="125">
                  <c:v>375</c:v>
                </c:pt>
                <c:pt idx="126">
                  <c:v>376.05999759999997</c:v>
                </c:pt>
                <c:pt idx="127">
                  <c:v>376.9599915</c:v>
                </c:pt>
                <c:pt idx="128">
                  <c:v>378.02999879999999</c:v>
                </c:pt>
                <c:pt idx="129">
                  <c:v>378.92999270000001</c:v>
                </c:pt>
                <c:pt idx="130">
                  <c:v>380</c:v>
                </c:pt>
                <c:pt idx="131">
                  <c:v>381.07000729999999</c:v>
                </c:pt>
                <c:pt idx="132">
                  <c:v>382</c:v>
                </c:pt>
                <c:pt idx="133">
                  <c:v>383.07000729999999</c:v>
                </c:pt>
                <c:pt idx="134">
                  <c:v>384</c:v>
                </c:pt>
                <c:pt idx="135">
                  <c:v>385.07000729999999</c:v>
                </c:pt>
                <c:pt idx="136">
                  <c:v>386</c:v>
                </c:pt>
                <c:pt idx="137">
                  <c:v>387.07000729999999</c:v>
                </c:pt>
                <c:pt idx="138">
                  <c:v>388</c:v>
                </c:pt>
                <c:pt idx="139">
                  <c:v>389.07000729999999</c:v>
                </c:pt>
                <c:pt idx="140">
                  <c:v>390</c:v>
                </c:pt>
                <c:pt idx="141">
                  <c:v>391.07000729999999</c:v>
                </c:pt>
                <c:pt idx="142">
                  <c:v>392</c:v>
                </c:pt>
                <c:pt idx="143">
                  <c:v>393.07000729999999</c:v>
                </c:pt>
                <c:pt idx="144">
                  <c:v>394</c:v>
                </c:pt>
                <c:pt idx="145">
                  <c:v>395.07000729999999</c:v>
                </c:pt>
                <c:pt idx="146">
                  <c:v>396</c:v>
                </c:pt>
                <c:pt idx="147">
                  <c:v>397.07000729999999</c:v>
                </c:pt>
                <c:pt idx="148">
                  <c:v>398</c:v>
                </c:pt>
                <c:pt idx="149">
                  <c:v>399.07000729999999</c:v>
                </c:pt>
                <c:pt idx="150">
                  <c:v>400</c:v>
                </c:pt>
                <c:pt idx="151">
                  <c:v>401.07000729999999</c:v>
                </c:pt>
                <c:pt idx="152">
                  <c:v>402</c:v>
                </c:pt>
                <c:pt idx="153">
                  <c:v>403.07000729999999</c:v>
                </c:pt>
                <c:pt idx="154">
                  <c:v>404</c:v>
                </c:pt>
                <c:pt idx="155">
                  <c:v>405.07000729999999</c:v>
                </c:pt>
                <c:pt idx="156">
                  <c:v>406</c:v>
                </c:pt>
                <c:pt idx="157">
                  <c:v>407.07000729999999</c:v>
                </c:pt>
                <c:pt idx="158">
                  <c:v>408</c:v>
                </c:pt>
                <c:pt idx="159">
                  <c:v>409.07000729999999</c:v>
                </c:pt>
                <c:pt idx="160">
                  <c:v>410</c:v>
                </c:pt>
                <c:pt idx="161">
                  <c:v>411.05999759999997</c:v>
                </c:pt>
                <c:pt idx="162">
                  <c:v>411.9599915</c:v>
                </c:pt>
                <c:pt idx="163">
                  <c:v>413.02999879999999</c:v>
                </c:pt>
                <c:pt idx="164">
                  <c:v>413.92999270000001</c:v>
                </c:pt>
                <c:pt idx="165">
                  <c:v>415</c:v>
                </c:pt>
                <c:pt idx="166">
                  <c:v>416.05999759999997</c:v>
                </c:pt>
                <c:pt idx="167">
                  <c:v>416.9599915</c:v>
                </c:pt>
                <c:pt idx="168">
                  <c:v>418.02999879999999</c:v>
                </c:pt>
                <c:pt idx="169">
                  <c:v>418.92999270000001</c:v>
                </c:pt>
                <c:pt idx="170">
                  <c:v>420</c:v>
                </c:pt>
                <c:pt idx="171">
                  <c:v>421.05999759999997</c:v>
                </c:pt>
                <c:pt idx="172">
                  <c:v>421.9599915</c:v>
                </c:pt>
                <c:pt idx="173">
                  <c:v>423.02999879999999</c:v>
                </c:pt>
                <c:pt idx="174">
                  <c:v>423.92999270000001</c:v>
                </c:pt>
                <c:pt idx="175">
                  <c:v>425</c:v>
                </c:pt>
                <c:pt idx="176">
                  <c:v>426.05999759999997</c:v>
                </c:pt>
                <c:pt idx="177">
                  <c:v>426.9599915</c:v>
                </c:pt>
                <c:pt idx="178">
                  <c:v>428.02999879999999</c:v>
                </c:pt>
                <c:pt idx="179">
                  <c:v>428.92999270000001</c:v>
                </c:pt>
                <c:pt idx="180">
                  <c:v>430</c:v>
                </c:pt>
                <c:pt idx="181">
                  <c:v>431.07000729999999</c:v>
                </c:pt>
                <c:pt idx="182">
                  <c:v>432</c:v>
                </c:pt>
                <c:pt idx="183">
                  <c:v>433.07000729999999</c:v>
                </c:pt>
                <c:pt idx="184">
                  <c:v>434</c:v>
                </c:pt>
                <c:pt idx="185">
                  <c:v>435.07000729999999</c:v>
                </c:pt>
                <c:pt idx="186">
                  <c:v>436</c:v>
                </c:pt>
                <c:pt idx="187">
                  <c:v>437.07000729999999</c:v>
                </c:pt>
                <c:pt idx="188">
                  <c:v>438</c:v>
                </c:pt>
                <c:pt idx="189">
                  <c:v>439.07000729999999</c:v>
                </c:pt>
                <c:pt idx="190">
                  <c:v>440</c:v>
                </c:pt>
                <c:pt idx="191">
                  <c:v>441.05999759999997</c:v>
                </c:pt>
                <c:pt idx="192">
                  <c:v>441.9599915</c:v>
                </c:pt>
                <c:pt idx="193">
                  <c:v>443.02999879999999</c:v>
                </c:pt>
                <c:pt idx="194">
                  <c:v>443.92999270000001</c:v>
                </c:pt>
                <c:pt idx="195">
                  <c:v>445</c:v>
                </c:pt>
                <c:pt idx="196">
                  <c:v>446.05999759999997</c:v>
                </c:pt>
                <c:pt idx="197">
                  <c:v>446.9599915</c:v>
                </c:pt>
                <c:pt idx="198">
                  <c:v>448.02999879999999</c:v>
                </c:pt>
                <c:pt idx="199">
                  <c:v>448.92999270000001</c:v>
                </c:pt>
                <c:pt idx="200">
                  <c:v>450</c:v>
                </c:pt>
                <c:pt idx="201">
                  <c:v>451.05999759999997</c:v>
                </c:pt>
                <c:pt idx="202">
                  <c:v>451.9599915</c:v>
                </c:pt>
                <c:pt idx="203">
                  <c:v>453.02999879999999</c:v>
                </c:pt>
                <c:pt idx="204">
                  <c:v>453.92999270000001</c:v>
                </c:pt>
                <c:pt idx="205">
                  <c:v>455</c:v>
                </c:pt>
                <c:pt idx="206">
                  <c:v>456.05999759999997</c:v>
                </c:pt>
                <c:pt idx="207">
                  <c:v>456.9599915</c:v>
                </c:pt>
                <c:pt idx="208">
                  <c:v>458.02999879999999</c:v>
                </c:pt>
                <c:pt idx="209">
                  <c:v>458.92999270000001</c:v>
                </c:pt>
                <c:pt idx="210">
                  <c:v>460</c:v>
                </c:pt>
                <c:pt idx="211">
                  <c:v>461.05999759999997</c:v>
                </c:pt>
                <c:pt idx="212">
                  <c:v>461.9599915</c:v>
                </c:pt>
                <c:pt idx="213">
                  <c:v>463.02999879999999</c:v>
                </c:pt>
                <c:pt idx="214">
                  <c:v>463.92999270000001</c:v>
                </c:pt>
                <c:pt idx="215">
                  <c:v>465</c:v>
                </c:pt>
                <c:pt idx="216">
                  <c:v>466.05999759999997</c:v>
                </c:pt>
                <c:pt idx="217">
                  <c:v>466.9599915</c:v>
                </c:pt>
                <c:pt idx="218">
                  <c:v>468.02999879999999</c:v>
                </c:pt>
                <c:pt idx="219">
                  <c:v>468.92999270000001</c:v>
                </c:pt>
                <c:pt idx="220">
                  <c:v>470</c:v>
                </c:pt>
                <c:pt idx="221">
                  <c:v>471.0400085</c:v>
                </c:pt>
                <c:pt idx="222">
                  <c:v>471.94000240000003</c:v>
                </c:pt>
                <c:pt idx="223">
                  <c:v>472.98001099999999</c:v>
                </c:pt>
                <c:pt idx="224">
                  <c:v>474.01998900000001</c:v>
                </c:pt>
                <c:pt idx="225">
                  <c:v>475.07000729999999</c:v>
                </c:pt>
                <c:pt idx="226">
                  <c:v>475.97000120000001</c:v>
                </c:pt>
                <c:pt idx="227">
                  <c:v>477.01000979999998</c:v>
                </c:pt>
                <c:pt idx="228">
                  <c:v>478.0499878</c:v>
                </c:pt>
                <c:pt idx="229">
                  <c:v>478.9500122</c:v>
                </c:pt>
                <c:pt idx="230">
                  <c:v>480</c:v>
                </c:pt>
                <c:pt idx="231">
                  <c:v>481.05999759999997</c:v>
                </c:pt>
                <c:pt idx="232">
                  <c:v>481.9599915</c:v>
                </c:pt>
                <c:pt idx="233">
                  <c:v>483.02999879999999</c:v>
                </c:pt>
                <c:pt idx="234">
                  <c:v>483.92999270000001</c:v>
                </c:pt>
                <c:pt idx="235">
                  <c:v>485</c:v>
                </c:pt>
                <c:pt idx="236">
                  <c:v>486.05999759999997</c:v>
                </c:pt>
                <c:pt idx="237">
                  <c:v>486.9599915</c:v>
                </c:pt>
                <c:pt idx="238">
                  <c:v>488.02999879999999</c:v>
                </c:pt>
                <c:pt idx="239">
                  <c:v>488.92999270000001</c:v>
                </c:pt>
                <c:pt idx="240">
                  <c:v>490</c:v>
                </c:pt>
                <c:pt idx="241">
                  <c:v>491.0400085</c:v>
                </c:pt>
                <c:pt idx="242">
                  <c:v>491.94000240000003</c:v>
                </c:pt>
                <c:pt idx="243">
                  <c:v>492.98001099999999</c:v>
                </c:pt>
                <c:pt idx="244">
                  <c:v>494.01998900000001</c:v>
                </c:pt>
                <c:pt idx="245">
                  <c:v>495.07000729999999</c:v>
                </c:pt>
                <c:pt idx="246">
                  <c:v>495.97000120000001</c:v>
                </c:pt>
                <c:pt idx="247">
                  <c:v>497.01000979999998</c:v>
                </c:pt>
                <c:pt idx="248">
                  <c:v>498.0499878</c:v>
                </c:pt>
                <c:pt idx="249">
                  <c:v>498.9500122</c:v>
                </c:pt>
                <c:pt idx="250">
                  <c:v>500</c:v>
                </c:pt>
                <c:pt idx="251">
                  <c:v>501.05999759999997</c:v>
                </c:pt>
                <c:pt idx="252">
                  <c:v>501.9599915</c:v>
                </c:pt>
                <c:pt idx="253">
                  <c:v>503.02999879999999</c:v>
                </c:pt>
                <c:pt idx="254">
                  <c:v>503.92999270000001</c:v>
                </c:pt>
                <c:pt idx="255">
                  <c:v>505</c:v>
                </c:pt>
                <c:pt idx="256">
                  <c:v>506.05999759999997</c:v>
                </c:pt>
                <c:pt idx="257">
                  <c:v>506.9599915</c:v>
                </c:pt>
                <c:pt idx="258">
                  <c:v>508.02999879999999</c:v>
                </c:pt>
                <c:pt idx="259">
                  <c:v>508.92999270000001</c:v>
                </c:pt>
                <c:pt idx="260">
                  <c:v>510</c:v>
                </c:pt>
                <c:pt idx="261">
                  <c:v>511.0400085</c:v>
                </c:pt>
                <c:pt idx="262">
                  <c:v>511.94000240000003</c:v>
                </c:pt>
                <c:pt idx="263">
                  <c:v>512.97998050000001</c:v>
                </c:pt>
                <c:pt idx="264">
                  <c:v>514.02001949999999</c:v>
                </c:pt>
                <c:pt idx="265">
                  <c:v>515.07000730000004</c:v>
                </c:pt>
                <c:pt idx="266">
                  <c:v>515.96997069999998</c:v>
                </c:pt>
                <c:pt idx="267">
                  <c:v>517.01000980000003</c:v>
                </c:pt>
                <c:pt idx="268">
                  <c:v>518.04998780000005</c:v>
                </c:pt>
                <c:pt idx="269">
                  <c:v>518.95001219999995</c:v>
                </c:pt>
                <c:pt idx="270">
                  <c:v>520</c:v>
                </c:pt>
                <c:pt idx="271">
                  <c:v>521.03997800000002</c:v>
                </c:pt>
                <c:pt idx="272">
                  <c:v>521.94000240000003</c:v>
                </c:pt>
                <c:pt idx="273">
                  <c:v>522.97998050000001</c:v>
                </c:pt>
                <c:pt idx="274">
                  <c:v>524.02001949999999</c:v>
                </c:pt>
                <c:pt idx="275">
                  <c:v>525.07000730000004</c:v>
                </c:pt>
                <c:pt idx="276">
                  <c:v>525.96997069999998</c:v>
                </c:pt>
                <c:pt idx="277">
                  <c:v>527.01000980000003</c:v>
                </c:pt>
                <c:pt idx="278">
                  <c:v>528.04998780000005</c:v>
                </c:pt>
                <c:pt idx="279">
                  <c:v>528.95001219999995</c:v>
                </c:pt>
                <c:pt idx="280">
                  <c:v>530</c:v>
                </c:pt>
                <c:pt idx="281">
                  <c:v>531.03997800000002</c:v>
                </c:pt>
                <c:pt idx="282">
                  <c:v>531.94000240000003</c:v>
                </c:pt>
                <c:pt idx="283">
                  <c:v>532.97998050000001</c:v>
                </c:pt>
                <c:pt idx="284">
                  <c:v>534.02001949999999</c:v>
                </c:pt>
                <c:pt idx="285">
                  <c:v>535.07000730000004</c:v>
                </c:pt>
                <c:pt idx="286">
                  <c:v>535.96997069999998</c:v>
                </c:pt>
                <c:pt idx="287">
                  <c:v>537.01000980000003</c:v>
                </c:pt>
                <c:pt idx="288">
                  <c:v>538.04998780000005</c:v>
                </c:pt>
                <c:pt idx="289">
                  <c:v>538.95001219999995</c:v>
                </c:pt>
                <c:pt idx="290">
                  <c:v>540</c:v>
                </c:pt>
                <c:pt idx="291">
                  <c:v>541.03997800000002</c:v>
                </c:pt>
                <c:pt idx="292">
                  <c:v>541.94000240000003</c:v>
                </c:pt>
                <c:pt idx="293">
                  <c:v>542.97998050000001</c:v>
                </c:pt>
                <c:pt idx="294">
                  <c:v>544.02001949999999</c:v>
                </c:pt>
                <c:pt idx="295">
                  <c:v>545.07000730000004</c:v>
                </c:pt>
                <c:pt idx="296">
                  <c:v>545.96997069999998</c:v>
                </c:pt>
                <c:pt idx="297">
                  <c:v>547.01000980000003</c:v>
                </c:pt>
                <c:pt idx="298">
                  <c:v>548.04998780000005</c:v>
                </c:pt>
                <c:pt idx="299">
                  <c:v>548.95001219999995</c:v>
                </c:pt>
                <c:pt idx="300">
                  <c:v>550</c:v>
                </c:pt>
                <c:pt idx="301">
                  <c:v>551.02001949999999</c:v>
                </c:pt>
                <c:pt idx="302">
                  <c:v>552.04998780000005</c:v>
                </c:pt>
                <c:pt idx="303">
                  <c:v>552.94000240000003</c:v>
                </c:pt>
                <c:pt idx="304">
                  <c:v>553.96997069999998</c:v>
                </c:pt>
                <c:pt idx="305">
                  <c:v>555</c:v>
                </c:pt>
                <c:pt idx="306">
                  <c:v>556.02001949999999</c:v>
                </c:pt>
                <c:pt idx="307">
                  <c:v>557.04998780000005</c:v>
                </c:pt>
                <c:pt idx="308">
                  <c:v>557.94000240000003</c:v>
                </c:pt>
                <c:pt idx="309">
                  <c:v>558.96997069999998</c:v>
                </c:pt>
                <c:pt idx="310">
                  <c:v>560</c:v>
                </c:pt>
                <c:pt idx="311">
                  <c:v>561.02001949999999</c:v>
                </c:pt>
                <c:pt idx="312">
                  <c:v>562.04998780000005</c:v>
                </c:pt>
                <c:pt idx="313">
                  <c:v>562.94000240000003</c:v>
                </c:pt>
                <c:pt idx="314">
                  <c:v>563.96997069999998</c:v>
                </c:pt>
                <c:pt idx="315">
                  <c:v>565</c:v>
                </c:pt>
                <c:pt idx="316">
                  <c:v>566.02001949999999</c:v>
                </c:pt>
                <c:pt idx="317">
                  <c:v>567.04998780000005</c:v>
                </c:pt>
                <c:pt idx="318">
                  <c:v>567.94000240000003</c:v>
                </c:pt>
                <c:pt idx="319">
                  <c:v>568.96997069999998</c:v>
                </c:pt>
                <c:pt idx="320">
                  <c:v>570</c:v>
                </c:pt>
                <c:pt idx="321">
                  <c:v>571.03997800000002</c:v>
                </c:pt>
                <c:pt idx="322">
                  <c:v>571.94000240000003</c:v>
                </c:pt>
                <c:pt idx="323">
                  <c:v>572.97998050000001</c:v>
                </c:pt>
                <c:pt idx="324">
                  <c:v>574.02001949999999</c:v>
                </c:pt>
                <c:pt idx="325">
                  <c:v>575.07000730000004</c:v>
                </c:pt>
                <c:pt idx="326">
                  <c:v>575.96997069999998</c:v>
                </c:pt>
                <c:pt idx="327">
                  <c:v>577.01000980000003</c:v>
                </c:pt>
                <c:pt idx="328">
                  <c:v>578.04998780000005</c:v>
                </c:pt>
                <c:pt idx="329">
                  <c:v>578.95001219999995</c:v>
                </c:pt>
                <c:pt idx="330">
                  <c:v>580</c:v>
                </c:pt>
                <c:pt idx="331">
                  <c:v>581.02001949999999</c:v>
                </c:pt>
                <c:pt idx="332">
                  <c:v>582.04998780000005</c:v>
                </c:pt>
                <c:pt idx="333">
                  <c:v>582.94000240000003</c:v>
                </c:pt>
                <c:pt idx="334">
                  <c:v>583.96997069999998</c:v>
                </c:pt>
                <c:pt idx="335">
                  <c:v>585</c:v>
                </c:pt>
                <c:pt idx="336">
                  <c:v>586.02001949999999</c:v>
                </c:pt>
                <c:pt idx="337">
                  <c:v>587.04998780000005</c:v>
                </c:pt>
                <c:pt idx="338">
                  <c:v>587.94000240000003</c:v>
                </c:pt>
                <c:pt idx="339">
                  <c:v>588.96997069999998</c:v>
                </c:pt>
                <c:pt idx="340">
                  <c:v>590</c:v>
                </c:pt>
                <c:pt idx="341">
                  <c:v>591.02001949999999</c:v>
                </c:pt>
                <c:pt idx="342">
                  <c:v>592.04998780000005</c:v>
                </c:pt>
                <c:pt idx="343">
                  <c:v>592.94000240000003</c:v>
                </c:pt>
                <c:pt idx="344">
                  <c:v>593.96997069999998</c:v>
                </c:pt>
                <c:pt idx="345">
                  <c:v>595</c:v>
                </c:pt>
                <c:pt idx="346">
                  <c:v>596.02001949999999</c:v>
                </c:pt>
                <c:pt idx="347">
                  <c:v>597.04998780000005</c:v>
                </c:pt>
                <c:pt idx="348">
                  <c:v>597.94000240000003</c:v>
                </c:pt>
                <c:pt idx="349">
                  <c:v>598.96997069999998</c:v>
                </c:pt>
                <c:pt idx="350">
                  <c:v>600</c:v>
                </c:pt>
                <c:pt idx="351">
                  <c:v>601.01000980000003</c:v>
                </c:pt>
                <c:pt idx="352">
                  <c:v>602.02001949999999</c:v>
                </c:pt>
                <c:pt idx="353">
                  <c:v>603.03997800000002</c:v>
                </c:pt>
                <c:pt idx="354">
                  <c:v>604.04998780000005</c:v>
                </c:pt>
                <c:pt idx="355">
                  <c:v>605.07000730000004</c:v>
                </c:pt>
                <c:pt idx="356">
                  <c:v>605.94000240000003</c:v>
                </c:pt>
                <c:pt idx="357">
                  <c:v>606.95001219999995</c:v>
                </c:pt>
                <c:pt idx="358">
                  <c:v>607.96997069999998</c:v>
                </c:pt>
                <c:pt idx="359">
                  <c:v>608.97998050000001</c:v>
                </c:pt>
                <c:pt idx="360">
                  <c:v>610</c:v>
                </c:pt>
                <c:pt idx="361">
                  <c:v>611.02001949999999</c:v>
                </c:pt>
                <c:pt idx="362">
                  <c:v>612.04998780000005</c:v>
                </c:pt>
                <c:pt idx="363">
                  <c:v>612.94000240000003</c:v>
                </c:pt>
                <c:pt idx="364">
                  <c:v>613.96997069999998</c:v>
                </c:pt>
                <c:pt idx="365">
                  <c:v>615</c:v>
                </c:pt>
                <c:pt idx="366">
                  <c:v>616.02001949999999</c:v>
                </c:pt>
                <c:pt idx="367">
                  <c:v>617.04998780000005</c:v>
                </c:pt>
                <c:pt idx="368">
                  <c:v>617.94000240000003</c:v>
                </c:pt>
                <c:pt idx="369">
                  <c:v>618.96997069999998</c:v>
                </c:pt>
                <c:pt idx="370">
                  <c:v>620</c:v>
                </c:pt>
                <c:pt idx="371">
                  <c:v>621.01000980000003</c:v>
                </c:pt>
                <c:pt idx="372">
                  <c:v>622.02001949999999</c:v>
                </c:pt>
                <c:pt idx="373">
                  <c:v>623.03997800000002</c:v>
                </c:pt>
                <c:pt idx="374">
                  <c:v>624.04998780000005</c:v>
                </c:pt>
                <c:pt idx="375">
                  <c:v>625.07000730000004</c:v>
                </c:pt>
                <c:pt idx="376">
                  <c:v>625.94000240000003</c:v>
                </c:pt>
                <c:pt idx="377">
                  <c:v>626.95001219999995</c:v>
                </c:pt>
                <c:pt idx="378">
                  <c:v>627.96997069999998</c:v>
                </c:pt>
                <c:pt idx="379">
                  <c:v>628.97998050000001</c:v>
                </c:pt>
                <c:pt idx="380">
                  <c:v>630</c:v>
                </c:pt>
                <c:pt idx="381">
                  <c:v>631.01000980000003</c:v>
                </c:pt>
                <c:pt idx="382">
                  <c:v>632.02001949999999</c:v>
                </c:pt>
                <c:pt idx="383">
                  <c:v>633.03997800000002</c:v>
                </c:pt>
                <c:pt idx="384">
                  <c:v>634.04998780000005</c:v>
                </c:pt>
                <c:pt idx="385">
                  <c:v>635.07000730000004</c:v>
                </c:pt>
                <c:pt idx="386">
                  <c:v>635.94000240000003</c:v>
                </c:pt>
                <c:pt idx="387">
                  <c:v>636.95001219999995</c:v>
                </c:pt>
                <c:pt idx="388">
                  <c:v>637.96997069999998</c:v>
                </c:pt>
                <c:pt idx="389">
                  <c:v>638.97998050000001</c:v>
                </c:pt>
                <c:pt idx="390">
                  <c:v>640</c:v>
                </c:pt>
                <c:pt idx="391">
                  <c:v>641.01000980000003</c:v>
                </c:pt>
                <c:pt idx="392">
                  <c:v>642.02001949999999</c:v>
                </c:pt>
                <c:pt idx="393">
                  <c:v>643.03997800000002</c:v>
                </c:pt>
                <c:pt idx="394">
                  <c:v>644.04998780000005</c:v>
                </c:pt>
                <c:pt idx="395">
                  <c:v>645.07000730000004</c:v>
                </c:pt>
                <c:pt idx="396">
                  <c:v>645.94000240000003</c:v>
                </c:pt>
                <c:pt idx="397">
                  <c:v>646.95001219999995</c:v>
                </c:pt>
                <c:pt idx="398">
                  <c:v>647.96997069999998</c:v>
                </c:pt>
                <c:pt idx="399">
                  <c:v>648.97998050000001</c:v>
                </c:pt>
                <c:pt idx="400">
                  <c:v>650</c:v>
                </c:pt>
                <c:pt idx="401">
                  <c:v>651.01000980000003</c:v>
                </c:pt>
                <c:pt idx="402">
                  <c:v>652.02001949999999</c:v>
                </c:pt>
                <c:pt idx="403">
                  <c:v>653.03997800000002</c:v>
                </c:pt>
                <c:pt idx="404">
                  <c:v>654.04998780000005</c:v>
                </c:pt>
                <c:pt idx="405">
                  <c:v>655.07000730000004</c:v>
                </c:pt>
                <c:pt idx="406">
                  <c:v>655.94000240000003</c:v>
                </c:pt>
                <c:pt idx="407">
                  <c:v>656.95001219999995</c:v>
                </c:pt>
                <c:pt idx="408">
                  <c:v>657.96997069999998</c:v>
                </c:pt>
                <c:pt idx="409">
                  <c:v>658.97998050000001</c:v>
                </c:pt>
                <c:pt idx="410">
                  <c:v>660</c:v>
                </c:pt>
                <c:pt idx="411">
                  <c:v>661</c:v>
                </c:pt>
                <c:pt idx="412">
                  <c:v>662</c:v>
                </c:pt>
                <c:pt idx="413">
                  <c:v>663</c:v>
                </c:pt>
                <c:pt idx="414">
                  <c:v>664</c:v>
                </c:pt>
                <c:pt idx="415">
                  <c:v>665</c:v>
                </c:pt>
                <c:pt idx="416">
                  <c:v>666</c:v>
                </c:pt>
                <c:pt idx="417">
                  <c:v>667</c:v>
                </c:pt>
                <c:pt idx="418">
                  <c:v>668</c:v>
                </c:pt>
                <c:pt idx="419">
                  <c:v>669</c:v>
                </c:pt>
                <c:pt idx="420">
                  <c:v>670</c:v>
                </c:pt>
                <c:pt idx="421">
                  <c:v>671</c:v>
                </c:pt>
                <c:pt idx="422">
                  <c:v>672</c:v>
                </c:pt>
                <c:pt idx="423">
                  <c:v>673</c:v>
                </c:pt>
                <c:pt idx="424">
                  <c:v>674</c:v>
                </c:pt>
                <c:pt idx="425">
                  <c:v>675</c:v>
                </c:pt>
                <c:pt idx="426">
                  <c:v>676</c:v>
                </c:pt>
                <c:pt idx="427">
                  <c:v>677</c:v>
                </c:pt>
                <c:pt idx="428">
                  <c:v>678</c:v>
                </c:pt>
                <c:pt idx="429">
                  <c:v>679</c:v>
                </c:pt>
                <c:pt idx="430">
                  <c:v>680</c:v>
                </c:pt>
                <c:pt idx="431">
                  <c:v>681.01000980000003</c:v>
                </c:pt>
                <c:pt idx="432">
                  <c:v>682.02001949999999</c:v>
                </c:pt>
                <c:pt idx="433">
                  <c:v>683.03997800000002</c:v>
                </c:pt>
                <c:pt idx="434">
                  <c:v>684.04998780000005</c:v>
                </c:pt>
                <c:pt idx="435">
                  <c:v>685.07000730000004</c:v>
                </c:pt>
                <c:pt idx="436">
                  <c:v>685.94000240000003</c:v>
                </c:pt>
                <c:pt idx="437">
                  <c:v>686.95001219999995</c:v>
                </c:pt>
                <c:pt idx="438">
                  <c:v>687.96997069999998</c:v>
                </c:pt>
                <c:pt idx="439">
                  <c:v>688.97998050000001</c:v>
                </c:pt>
                <c:pt idx="440">
                  <c:v>690</c:v>
                </c:pt>
                <c:pt idx="441">
                  <c:v>690.97998050000001</c:v>
                </c:pt>
                <c:pt idx="442">
                  <c:v>691.96997069999998</c:v>
                </c:pt>
                <c:pt idx="443">
                  <c:v>692.95001219999995</c:v>
                </c:pt>
                <c:pt idx="444">
                  <c:v>693.94000240000003</c:v>
                </c:pt>
                <c:pt idx="445">
                  <c:v>695.07000730000004</c:v>
                </c:pt>
                <c:pt idx="446">
                  <c:v>696.04998780000005</c:v>
                </c:pt>
                <c:pt idx="447">
                  <c:v>697.03997800000002</c:v>
                </c:pt>
                <c:pt idx="448">
                  <c:v>698.02001949999999</c:v>
                </c:pt>
                <c:pt idx="449">
                  <c:v>699.01000980000003</c:v>
                </c:pt>
                <c:pt idx="450">
                  <c:v>700</c:v>
                </c:pt>
              </c:numCache>
            </c:numRef>
          </c:xVal>
          <c:yVal>
            <c:numRef>
              <c:f>Sheet1!$F$6:$F$456</c:f>
              <c:numCache>
                <c:formatCode>General</c:formatCode>
                <c:ptCount val="451"/>
                <c:pt idx="0">
                  <c:v>2.5880904489458713E-3</c:v>
                </c:pt>
                <c:pt idx="1">
                  <c:v>3.1297452810452749E-3</c:v>
                </c:pt>
                <c:pt idx="2">
                  <c:v>3.4325754306392588E-3</c:v>
                </c:pt>
                <c:pt idx="3">
                  <c:v>4.1864877920744226E-3</c:v>
                </c:pt>
                <c:pt idx="4">
                  <c:v>5.2100740644818117E-3</c:v>
                </c:pt>
                <c:pt idx="5">
                  <c:v>7.5899145145033979E-3</c:v>
                </c:pt>
                <c:pt idx="6">
                  <c:v>9.0909889402203924E-3</c:v>
                </c:pt>
                <c:pt idx="7">
                  <c:v>1.177241700145293E-2</c:v>
                </c:pt>
                <c:pt idx="8">
                  <c:v>1.43147814793513E-2</c:v>
                </c:pt>
                <c:pt idx="9">
                  <c:v>1.6658180671684345E-2</c:v>
                </c:pt>
                <c:pt idx="10">
                  <c:v>1.9176142852430203E-2</c:v>
                </c:pt>
                <c:pt idx="11">
                  <c:v>2.2685473735456596E-2</c:v>
                </c:pt>
                <c:pt idx="12">
                  <c:v>2.8383038789036398E-2</c:v>
                </c:pt>
                <c:pt idx="13">
                  <c:v>3.5930388996813216E-2</c:v>
                </c:pt>
                <c:pt idx="14">
                  <c:v>4.4870364310701599E-2</c:v>
                </c:pt>
                <c:pt idx="15">
                  <c:v>5.2588946818108141E-2</c:v>
                </c:pt>
                <c:pt idx="16">
                  <c:v>5.9508139142956724E-2</c:v>
                </c:pt>
                <c:pt idx="17">
                  <c:v>6.6990487569145399E-2</c:v>
                </c:pt>
                <c:pt idx="18">
                  <c:v>7.4335180290778957E-2</c:v>
                </c:pt>
                <c:pt idx="19">
                  <c:v>7.9527257458645945E-2</c:v>
                </c:pt>
                <c:pt idx="20">
                  <c:v>8.4961895978610286E-2</c:v>
                </c:pt>
                <c:pt idx="21">
                  <c:v>8.6654416463800565E-2</c:v>
                </c:pt>
                <c:pt idx="22">
                  <c:v>8.9624759075803459E-2</c:v>
                </c:pt>
                <c:pt idx="23">
                  <c:v>9.241471073421717E-2</c:v>
                </c:pt>
                <c:pt idx="24">
                  <c:v>9.3454528399580614E-2</c:v>
                </c:pt>
                <c:pt idx="25">
                  <c:v>9.5940021928184488E-2</c:v>
                </c:pt>
                <c:pt idx="26">
                  <c:v>9.8938518632502512E-2</c:v>
                </c:pt>
                <c:pt idx="27">
                  <c:v>0.10082323260615714</c:v>
                </c:pt>
                <c:pt idx="28">
                  <c:v>0.10175347442473348</c:v>
                </c:pt>
                <c:pt idx="29">
                  <c:v>0.10336329912014748</c:v>
                </c:pt>
                <c:pt idx="30">
                  <c:v>0.10325462214041783</c:v>
                </c:pt>
                <c:pt idx="31">
                  <c:v>0.10301293621504619</c:v>
                </c:pt>
                <c:pt idx="32">
                  <c:v>0.10615339146153131</c:v>
                </c:pt>
                <c:pt idx="33">
                  <c:v>0.10833912441345384</c:v>
                </c:pt>
                <c:pt idx="34">
                  <c:v>0.11331946750286909</c:v>
                </c:pt>
                <c:pt idx="35">
                  <c:v>0.11688876066827074</c:v>
                </c:pt>
                <c:pt idx="36">
                  <c:v>0.12481620870255099</c:v>
                </c:pt>
                <c:pt idx="37">
                  <c:v>0.13236781290025545</c:v>
                </c:pt>
                <c:pt idx="38">
                  <c:v>0.14453727430740887</c:v>
                </c:pt>
                <c:pt idx="39">
                  <c:v>0.15576239338900683</c:v>
                </c:pt>
                <c:pt idx="40">
                  <c:v>0.16433735425861035</c:v>
                </c:pt>
                <c:pt idx="41">
                  <c:v>0.17549281504656206</c:v>
                </c:pt>
                <c:pt idx="42">
                  <c:v>0.18636138858968088</c:v>
                </c:pt>
                <c:pt idx="43">
                  <c:v>0.19902543030117753</c:v>
                </c:pt>
                <c:pt idx="44">
                  <c:v>0.21386441858039695</c:v>
                </c:pt>
                <c:pt idx="45">
                  <c:v>0.22599356374387172</c:v>
                </c:pt>
                <c:pt idx="46">
                  <c:v>0.24342233761167195</c:v>
                </c:pt>
                <c:pt idx="47">
                  <c:v>0.27570487249504505</c:v>
                </c:pt>
                <c:pt idx="48">
                  <c:v>0.32305273828767145</c:v>
                </c:pt>
                <c:pt idx="49">
                  <c:v>0.38904946135387991</c:v>
                </c:pt>
                <c:pt idx="50">
                  <c:v>0.45965288802713339</c:v>
                </c:pt>
                <c:pt idx="51">
                  <c:v>0.56132273648661801</c:v>
                </c:pt>
                <c:pt idx="52">
                  <c:v>0.64270047272018704</c:v>
                </c:pt>
                <c:pt idx="53">
                  <c:v>0.76293435703108525</c:v>
                </c:pt>
                <c:pt idx="54">
                  <c:v>0.8452646114303991</c:v>
                </c:pt>
                <c:pt idx="55">
                  <c:v>0.92707036484343641</c:v>
                </c:pt>
                <c:pt idx="56">
                  <c:v>0.97011914306736824</c:v>
                </c:pt>
                <c:pt idx="57">
                  <c:v>0.9999999354571284</c:v>
                </c:pt>
                <c:pt idx="58">
                  <c:v>0.9946016657797998</c:v>
                </c:pt>
                <c:pt idx="59">
                  <c:v>0.96885566369844589</c:v>
                </c:pt>
                <c:pt idx="60">
                  <c:v>0.95405095751911129</c:v>
                </c:pt>
                <c:pt idx="61">
                  <c:v>0.90477701421397949</c:v>
                </c:pt>
                <c:pt idx="62">
                  <c:v>0.85901281227224302</c:v>
                </c:pt>
                <c:pt idx="63">
                  <c:v>0.79359033246135569</c:v>
                </c:pt>
                <c:pt idx="64">
                  <c:v>0.73278055915436136</c:v>
                </c:pt>
                <c:pt idx="65">
                  <c:v>0.67708135495772226</c:v>
                </c:pt>
                <c:pt idx="66">
                  <c:v>0.62916112175100913</c:v>
                </c:pt>
                <c:pt idx="67">
                  <c:v>0.5622181647408645</c:v>
                </c:pt>
                <c:pt idx="68">
                  <c:v>0.50246652243213108</c:v>
                </c:pt>
                <c:pt idx="69">
                  <c:v>0.43654561675016601</c:v>
                </c:pt>
                <c:pt idx="70">
                  <c:v>0.38787577505231552</c:v>
                </c:pt>
                <c:pt idx="71">
                  <c:v>0.34006012301666416</c:v>
                </c:pt>
                <c:pt idx="72">
                  <c:v>0.30147948202603964</c:v>
                </c:pt>
                <c:pt idx="73">
                  <c:v>0.25565790884784417</c:v>
                </c:pt>
                <c:pt idx="74">
                  <c:v>0.22561363202818085</c:v>
                </c:pt>
                <c:pt idx="75">
                  <c:v>0.19178332570771256</c:v>
                </c:pt>
                <c:pt idx="76">
                  <c:v>0.17142396261676882</c:v>
                </c:pt>
                <c:pt idx="77">
                  <c:v>0.14643871502724015</c:v>
                </c:pt>
                <c:pt idx="78">
                  <c:v>0.12836959582024463</c:v>
                </c:pt>
                <c:pt idx="79">
                  <c:v>0.11102566722474053</c:v>
                </c:pt>
                <c:pt idx="80">
                  <c:v>9.6191908024563996E-2</c:v>
                </c:pt>
                <c:pt idx="81">
                  <c:v>8.6437484573741452E-2</c:v>
                </c:pt>
                <c:pt idx="82">
                  <c:v>7.8107969221041296E-2</c:v>
                </c:pt>
                <c:pt idx="83">
                  <c:v>7.0886202475700641E-2</c:v>
                </c:pt>
                <c:pt idx="84">
                  <c:v>6.4634638069188732E-2</c:v>
                </c:pt>
                <c:pt idx="85">
                  <c:v>5.934041438982296E-2</c:v>
                </c:pt>
                <c:pt idx="86">
                  <c:v>5.5820863759833313E-2</c:v>
                </c:pt>
                <c:pt idx="87">
                  <c:v>5.2644789925247057E-2</c:v>
                </c:pt>
                <c:pt idx="88">
                  <c:v>4.9160033291827825E-2</c:v>
                </c:pt>
                <c:pt idx="89">
                  <c:v>4.633029697711924E-2</c:v>
                </c:pt>
                <c:pt idx="90">
                  <c:v>4.3354041377512892E-2</c:v>
                </c:pt>
                <c:pt idx="91">
                  <c:v>4.2232868385610668E-2</c:v>
                </c:pt>
                <c:pt idx="92">
                  <c:v>4.0551435238809649E-2</c:v>
                </c:pt>
                <c:pt idx="93">
                  <c:v>4.0037947438334408E-2</c:v>
                </c:pt>
                <c:pt idx="94">
                  <c:v>3.8234553610231127E-2</c:v>
                </c:pt>
                <c:pt idx="95">
                  <c:v>3.7432724772599069E-2</c:v>
                </c:pt>
                <c:pt idx="96">
                  <c:v>3.720880907747337E-2</c:v>
                </c:pt>
                <c:pt idx="97">
                  <c:v>3.5811257813529285E-2</c:v>
                </c:pt>
                <c:pt idx="98">
                  <c:v>3.6111647570514112E-2</c:v>
                </c:pt>
                <c:pt idx="99">
                  <c:v>3.6901087680568927E-2</c:v>
                </c:pt>
                <c:pt idx="100">
                  <c:v>3.6461189756656978E-2</c:v>
                </c:pt>
                <c:pt idx="101">
                  <c:v>3.607718577507895E-2</c:v>
                </c:pt>
                <c:pt idx="102">
                  <c:v>3.5634235629017408E-2</c:v>
                </c:pt>
                <c:pt idx="103">
                  <c:v>3.5102129566433778E-2</c:v>
                </c:pt>
                <c:pt idx="104">
                  <c:v>3.2755604851738875E-2</c:v>
                </c:pt>
                <c:pt idx="105">
                  <c:v>2.9796355417718391E-2</c:v>
                </c:pt>
                <c:pt idx="106">
                  <c:v>2.7738027143658292E-2</c:v>
                </c:pt>
                <c:pt idx="107">
                  <c:v>2.537982498432018E-2</c:v>
                </c:pt>
                <c:pt idx="108">
                  <c:v>2.2857571688177199E-2</c:v>
                </c:pt>
                <c:pt idx="109">
                  <c:v>2.0804322016065233E-2</c:v>
                </c:pt>
                <c:pt idx="110">
                  <c:v>1.9057468901093069E-2</c:v>
                </c:pt>
                <c:pt idx="111">
                  <c:v>1.7243712690378419E-2</c:v>
                </c:pt>
                <c:pt idx="112">
                  <c:v>1.6337156027986608E-2</c:v>
                </c:pt>
                <c:pt idx="113">
                  <c:v>1.4935955546968051E-2</c:v>
                </c:pt>
                <c:pt idx="114">
                  <c:v>1.4016786406328726E-2</c:v>
                </c:pt>
                <c:pt idx="115">
                  <c:v>1.3373497268812044E-2</c:v>
                </c:pt>
                <c:pt idx="116">
                  <c:v>1.2676735288374475E-2</c:v>
                </c:pt>
                <c:pt idx="117">
                  <c:v>1.0687875793698034E-2</c:v>
                </c:pt>
                <c:pt idx="118">
                  <c:v>1.0226597543641738E-2</c:v>
                </c:pt>
                <c:pt idx="119">
                  <c:v>9.7731111036892492E-3</c:v>
                </c:pt>
                <c:pt idx="120">
                  <c:v>8.9612628273834701E-3</c:v>
                </c:pt>
                <c:pt idx="121">
                  <c:v>8.4621979470449298E-3</c:v>
                </c:pt>
                <c:pt idx="122">
                  <c:v>7.871489624887075E-3</c:v>
                </c:pt>
                <c:pt idx="123">
                  <c:v>7.6145219883220431E-3</c:v>
                </c:pt>
                <c:pt idx="124">
                  <c:v>7.1880797348291975E-3</c:v>
                </c:pt>
                <c:pt idx="125">
                  <c:v>7.1586677183398256E-3</c:v>
                </c:pt>
                <c:pt idx="126">
                  <c:v>6.8064093858038873E-3</c:v>
                </c:pt>
                <c:pt idx="127">
                  <c:v>6.177683853443014E-3</c:v>
                </c:pt>
                <c:pt idx="128">
                  <c:v>6.2187977568586017E-3</c:v>
                </c:pt>
                <c:pt idx="129">
                  <c:v>5.9821186330762336E-3</c:v>
                </c:pt>
                <c:pt idx="130">
                  <c:v>5.9011253039405777E-3</c:v>
                </c:pt>
                <c:pt idx="131">
                  <c:v>6.2336339562710777E-3</c:v>
                </c:pt>
                <c:pt idx="132">
                  <c:v>5.993765806088216E-3</c:v>
                </c:pt>
                <c:pt idx="133">
                  <c:v>6.3803638066525052E-3</c:v>
                </c:pt>
                <c:pt idx="134">
                  <c:v>6.3750961494132641E-3</c:v>
                </c:pt>
                <c:pt idx="135">
                  <c:v>5.7997276823556383E-3</c:v>
                </c:pt>
                <c:pt idx="136">
                  <c:v>5.4468328157268233E-3</c:v>
                </c:pt>
                <c:pt idx="137">
                  <c:v>5.4468328157268233E-3</c:v>
                </c:pt>
                <c:pt idx="138">
                  <c:v>5.4468328157268233E-3</c:v>
                </c:pt>
                <c:pt idx="139">
                  <c:v>5.4468328157268233E-3</c:v>
                </c:pt>
                <c:pt idx="140">
                  <c:v>5.4468328157268233E-3</c:v>
                </c:pt>
                <c:pt idx="141">
                  <c:v>5.4468328157268233E-3</c:v>
                </c:pt>
                <c:pt idx="142">
                  <c:v>5.4468328157268233E-3</c:v>
                </c:pt>
                <c:pt idx="143">
                  <c:v>5.4468328157268233E-3</c:v>
                </c:pt>
                <c:pt idx="144">
                  <c:v>5.4468328157268233E-3</c:v>
                </c:pt>
                <c:pt idx="145">
                  <c:v>5.4468328157268233E-3</c:v>
                </c:pt>
                <c:pt idx="146">
                  <c:v>5.4468328157268233E-3</c:v>
                </c:pt>
                <c:pt idx="147">
                  <c:v>5.4468328157268233E-3</c:v>
                </c:pt>
                <c:pt idx="148">
                  <c:v>5.4468328157268233E-3</c:v>
                </c:pt>
                <c:pt idx="149">
                  <c:v>5.4468328157268233E-3</c:v>
                </c:pt>
                <c:pt idx="150">
                  <c:v>5.4468328157268233E-3</c:v>
                </c:pt>
                <c:pt idx="151">
                  <c:v>9.5330959125511702E-3</c:v>
                </c:pt>
                <c:pt idx="152">
                  <c:v>4.6944944479812107E-3</c:v>
                </c:pt>
                <c:pt idx="153">
                  <c:v>2.3642758771325015E-3</c:v>
                </c:pt>
                <c:pt idx="154">
                  <c:v>1.2251419064161146E-3</c:v>
                </c:pt>
                <c:pt idx="155">
                  <c:v>1.0443459571677111E-3</c:v>
                </c:pt>
                <c:pt idx="156">
                  <c:v>8.3297978271386179E-4</c:v>
                </c:pt>
                <c:pt idx="157">
                  <c:v>6.1539969884091242E-4</c:v>
                </c:pt>
                <c:pt idx="158">
                  <c:v>5.5260226715544395E-4</c:v>
                </c:pt>
                <c:pt idx="159">
                  <c:v>4.0352604899070318E-4</c:v>
                </c:pt>
                <c:pt idx="160">
                  <c:v>3.3955441076763599E-4</c:v>
                </c:pt>
                <c:pt idx="161">
                  <c:v>3.4617671879203605E-4</c:v>
                </c:pt>
                <c:pt idx="162">
                  <c:v>1.1955150646135612E-4</c:v>
                </c:pt>
                <c:pt idx="163">
                  <c:v>2.8361725503470256E-4</c:v>
                </c:pt>
                <c:pt idx="164">
                  <c:v>8.340326545950323E-5</c:v>
                </c:pt>
                <c:pt idx="165">
                  <c:v>2.205575977512034E-4</c:v>
                </c:pt>
                <c:pt idx="166">
                  <c:v>1.3790681308404896E-4</c:v>
                </c:pt>
                <c:pt idx="167">
                  <c:v>7.2517435775232628E-5</c:v>
                </c:pt>
                <c:pt idx="168">
                  <c:v>1.0008206523665617E-4</c:v>
                </c:pt>
                <c:pt idx="169">
                  <c:v>1.5545364090436241E-5</c:v>
                </c:pt>
                <c:pt idx="170">
                  <c:v>5.1192691267677316E-5</c:v>
                </c:pt>
                <c:pt idx="171">
                  <c:v>7.0491869770106496E-5</c:v>
                </c:pt>
                <c:pt idx="172">
                  <c:v>1.2664702526003093E-4</c:v>
                </c:pt>
                <c:pt idx="173">
                  <c:v>4.9330899869008705E-5</c:v>
                </c:pt>
                <c:pt idx="174">
                  <c:v>5.8951792683379099E-5</c:v>
                </c:pt>
                <c:pt idx="175">
                  <c:v>7.8563975672869685E-5</c:v>
                </c:pt>
                <c:pt idx="176">
                  <c:v>4.2023464817066036E-5</c:v>
                </c:pt>
                <c:pt idx="177">
                  <c:v>7.9965746319468368E-5</c:v>
                </c:pt>
                <c:pt idx="178">
                  <c:v>6.6940129725024823E-5</c:v>
                </c:pt>
                <c:pt idx="179">
                  <c:v>1.0798831269976274E-4</c:v>
                </c:pt>
                <c:pt idx="180">
                  <c:v>4.9123254304855857E-5</c:v>
                </c:pt>
                <c:pt idx="181">
                  <c:v>3.9452399386371449E-5</c:v>
                </c:pt>
                <c:pt idx="182">
                  <c:v>-4.9737351902283316E-5</c:v>
                </c:pt>
                <c:pt idx="183">
                  <c:v>-7.9485604849689894E-5</c:v>
                </c:pt>
                <c:pt idx="184">
                  <c:v>-4.8326142997907784E-5</c:v>
                </c:pt>
                <c:pt idx="185">
                  <c:v>4.7833803929410999E-5</c:v>
                </c:pt>
                <c:pt idx="186">
                  <c:v>-8.6627051679579679E-5</c:v>
                </c:pt>
                <c:pt idx="187">
                  <c:v>1.9294029255746928E-4</c:v>
                </c:pt>
                <c:pt idx="188">
                  <c:v>8.9111661421619238E-5</c:v>
                </c:pt>
                <c:pt idx="189">
                  <c:v>8.7854598064902265E-5</c:v>
                </c:pt>
                <c:pt idx="190">
                  <c:v>3.4059690907261728E-5</c:v>
                </c:pt>
                <c:pt idx="191">
                  <c:v>4.2638585244843894E-5</c:v>
                </c:pt>
                <c:pt idx="192">
                  <c:v>-4.3495188503090981E-5</c:v>
                </c:pt>
                <c:pt idx="193">
                  <c:v>5.1558558395009339E-5</c:v>
                </c:pt>
                <c:pt idx="194">
                  <c:v>3.4255718979927579E-5</c:v>
                </c:pt>
                <c:pt idx="195">
                  <c:v>4.1653723908544182E-5</c:v>
                </c:pt>
                <c:pt idx="196">
                  <c:v>2.548842008680709E-5</c:v>
                </c:pt>
                <c:pt idx="197">
                  <c:v>-8.4921256836165812E-6</c:v>
                </c:pt>
                <c:pt idx="198">
                  <c:v>6.2857935013319386E-5</c:v>
                </c:pt>
                <c:pt idx="199">
                  <c:v>7.5253722289849939E-5</c:v>
                </c:pt>
                <c:pt idx="200">
                  <c:v>3.8597189168189905E-5</c:v>
                </c:pt>
                <c:pt idx="201">
                  <c:v>-1.04089456112589E-5</c:v>
                </c:pt>
                <c:pt idx="202">
                  <c:v>2.1000534742813047E-5</c:v>
                </c:pt>
                <c:pt idx="203">
                  <c:v>1.6677989157617176E-4</c:v>
                </c:pt>
                <c:pt idx="204">
                  <c:v>6.6630968489350529E-5</c:v>
                </c:pt>
                <c:pt idx="205">
                  <c:v>1.8045235533330041E-4</c:v>
                </c:pt>
                <c:pt idx="206">
                  <c:v>1.0964617964596493E-4</c:v>
                </c:pt>
                <c:pt idx="207">
                  <c:v>5.3121745046641957E-5</c:v>
                </c:pt>
                <c:pt idx="208">
                  <c:v>6.0798188230371742E-5</c:v>
                </c:pt>
                <c:pt idx="209">
                  <c:v>1.9876221479990584E-4</c:v>
                </c:pt>
                <c:pt idx="210">
                  <c:v>1.4019089509078721E-4</c:v>
                </c:pt>
                <c:pt idx="211">
                  <c:v>6.2911969342340914E-5</c:v>
                </c:pt>
                <c:pt idx="212">
                  <c:v>3.3904984348865899E-5</c:v>
                </c:pt>
                <c:pt idx="213">
                  <c:v>7.4776198965797807E-5</c:v>
                </c:pt>
                <c:pt idx="214">
                  <c:v>1.267149059405464E-4</c:v>
                </c:pt>
                <c:pt idx="215">
                  <c:v>2.7344526774739437E-5</c:v>
                </c:pt>
                <c:pt idx="216">
                  <c:v>1.1421770982631409E-4</c:v>
                </c:pt>
                <c:pt idx="217">
                  <c:v>9.9186480010048198E-5</c:v>
                </c:pt>
                <c:pt idx="218">
                  <c:v>1.1799227372652305E-4</c:v>
                </c:pt>
                <c:pt idx="219">
                  <c:v>1.5481527022870921E-5</c:v>
                </c:pt>
                <c:pt idx="220">
                  <c:v>1.5703643113162914E-4</c:v>
                </c:pt>
                <c:pt idx="221">
                  <c:v>1.6019671042400161E-5</c:v>
                </c:pt>
                <c:pt idx="222">
                  <c:v>9.9659370077965738E-5</c:v>
                </c:pt>
                <c:pt idx="223">
                  <c:v>8.4724614315363021E-5</c:v>
                </c:pt>
                <c:pt idx="224">
                  <c:v>1.7222083708211311E-5</c:v>
                </c:pt>
                <c:pt idx="225">
                  <c:v>-1.3733799853989681E-4</c:v>
                </c:pt>
                <c:pt idx="226">
                  <c:v>1.122236911883818E-4</c:v>
                </c:pt>
                <c:pt idx="227">
                  <c:v>3.2694753545606301E-5</c:v>
                </c:pt>
                <c:pt idx="228">
                  <c:v>6.1752070832420686E-5</c:v>
                </c:pt>
                <c:pt idx="229">
                  <c:v>1.4130410226295503E-5</c:v>
                </c:pt>
                <c:pt idx="230">
                  <c:v>0</c:v>
                </c:pt>
                <c:pt idx="231">
                  <c:v>8.6933999340638212E-5</c:v>
                </c:pt>
                <c:pt idx="232">
                  <c:v>1.2792225526316384E-4</c:v>
                </c:pt>
                <c:pt idx="233">
                  <c:v>7.0182861183445803E-5</c:v>
                </c:pt>
                <c:pt idx="234">
                  <c:v>-6.6192213404550425E-5</c:v>
                </c:pt>
                <c:pt idx="235">
                  <c:v>1.1017570692372897E-4</c:v>
                </c:pt>
                <c:pt idx="236">
                  <c:v>-5.2268122480650969E-5</c:v>
                </c:pt>
                <c:pt idx="237">
                  <c:v>1.1974851536028138E-4</c:v>
                </c:pt>
                <c:pt idx="238">
                  <c:v>-2.8218201335648135E-5</c:v>
                </c:pt>
                <c:pt idx="239">
                  <c:v>1.9958603032039696E-5</c:v>
                </c:pt>
                <c:pt idx="240">
                  <c:v>1.079245538704516E-4</c:v>
                </c:pt>
                <c:pt idx="241">
                  <c:v>2.1888106019145258E-4</c:v>
                </c:pt>
                <c:pt idx="242">
                  <c:v>2.1631968494063183E-4</c:v>
                </c:pt>
                <c:pt idx="243">
                  <c:v>1.1152657277147295E-4</c:v>
                </c:pt>
                <c:pt idx="244">
                  <c:v>1.7235174000410205E-4</c:v>
                </c:pt>
                <c:pt idx="245">
                  <c:v>1.0276585930022823E-4</c:v>
                </c:pt>
                <c:pt idx="246">
                  <c:v>1.4536669532506761E-4</c:v>
                </c:pt>
                <c:pt idx="247">
                  <c:v>2.0843958838449601E-4</c:v>
                </c:pt>
                <c:pt idx="248">
                  <c:v>1.9214713133572806E-5</c:v>
                </c:pt>
                <c:pt idx="249">
                  <c:v>1.4325812755597455E-4</c:v>
                </c:pt>
                <c:pt idx="250">
                  <c:v>-2.1186409320236526E-4</c:v>
                </c:pt>
                <c:pt idx="251">
                  <c:v>4.2443222783346789E-4</c:v>
                </c:pt>
                <c:pt idx="252">
                  <c:v>6.7894229887775317E-5</c:v>
                </c:pt>
                <c:pt idx="253">
                  <c:v>-1.3668372441874024E-4</c:v>
                </c:pt>
                <c:pt idx="254">
                  <c:v>9.3033962909772956E-5</c:v>
                </c:pt>
                <c:pt idx="255">
                  <c:v>1.4028185046256747E-4</c:v>
                </c:pt>
                <c:pt idx="256">
                  <c:v>6.9054330673005938E-5</c:v>
                </c:pt>
                <c:pt idx="257">
                  <c:v>2.4897852504990802E-4</c:v>
                </c:pt>
                <c:pt idx="258">
                  <c:v>2.2157841825706787E-5</c:v>
                </c:pt>
                <c:pt idx="259">
                  <c:v>6.5632466908459972E-5</c:v>
                </c:pt>
                <c:pt idx="260">
                  <c:v>-2.1187723720447817E-5</c:v>
                </c:pt>
                <c:pt idx="261">
                  <c:v>4.2286678945521103E-5</c:v>
                </c:pt>
                <c:pt idx="262">
                  <c:v>8.3665132342596835E-5</c:v>
                </c:pt>
                <c:pt idx="263">
                  <c:v>4.3075210722230636E-5</c:v>
                </c:pt>
                <c:pt idx="264">
                  <c:v>2.2407673307342702E-5</c:v>
                </c:pt>
                <c:pt idx="265">
                  <c:v>6.6759417388915059E-5</c:v>
                </c:pt>
                <c:pt idx="266">
                  <c:v>-2.0904333551822903E-5</c:v>
                </c:pt>
                <c:pt idx="267">
                  <c:v>1.434314740341979E-4</c:v>
                </c:pt>
                <c:pt idx="268">
                  <c:v>-3.9718922433196587E-5</c:v>
                </c:pt>
                <c:pt idx="269">
                  <c:v>7.7701174372914783E-5</c:v>
                </c:pt>
                <c:pt idx="270">
                  <c:v>4.1186768547418619E-5</c:v>
                </c:pt>
                <c:pt idx="271">
                  <c:v>1.4755421929045048E-4</c:v>
                </c:pt>
                <c:pt idx="272">
                  <c:v>1.487123660248783E-4</c:v>
                </c:pt>
                <c:pt idx="273">
                  <c:v>1.6194750207817801E-4</c:v>
                </c:pt>
                <c:pt idx="274">
                  <c:v>2.7445372286356439E-4</c:v>
                </c:pt>
                <c:pt idx="275">
                  <c:v>1.1280267295594262E-4</c:v>
                </c:pt>
                <c:pt idx="276">
                  <c:v>1.7476552271427568E-4</c:v>
                </c:pt>
                <c:pt idx="277">
                  <c:v>1.0825485101148925E-4</c:v>
                </c:pt>
                <c:pt idx="278">
                  <c:v>6.5973969368158064E-5</c:v>
                </c:pt>
                <c:pt idx="279">
                  <c:v>-1.3269650767742579E-5</c:v>
                </c:pt>
                <c:pt idx="280">
                  <c:v>1.3464629664272569E-4</c:v>
                </c:pt>
                <c:pt idx="281">
                  <c:v>7.0686168933897247E-5</c:v>
                </c:pt>
                <c:pt idx="282">
                  <c:v>1.3297965170207748E-4</c:v>
                </c:pt>
                <c:pt idx="283">
                  <c:v>-3.1104297817610863E-5</c:v>
                </c:pt>
                <c:pt idx="284">
                  <c:v>2.6414379885408742E-4</c:v>
                </c:pt>
                <c:pt idx="285">
                  <c:v>1.7237294459127662E-5</c:v>
                </c:pt>
                <c:pt idx="286">
                  <c:v>3.5309892168326985E-5</c:v>
                </c:pt>
                <c:pt idx="287">
                  <c:v>9.2672935124988806E-5</c:v>
                </c:pt>
                <c:pt idx="288">
                  <c:v>9.3743080481682422E-5</c:v>
                </c:pt>
                <c:pt idx="289">
                  <c:v>2.2396283662437093E-4</c:v>
                </c:pt>
                <c:pt idx="290">
                  <c:v>-1.0418543019463056E-4</c:v>
                </c:pt>
                <c:pt idx="291">
                  <c:v>6.7396776688016355E-5</c:v>
                </c:pt>
                <c:pt idx="292">
                  <c:v>1.7082948556053023E-5</c:v>
                </c:pt>
                <c:pt idx="293">
                  <c:v>8.8634443416084116E-5</c:v>
                </c:pt>
                <c:pt idx="294">
                  <c:v>-5.8267043631186042E-5</c:v>
                </c:pt>
                <c:pt idx="295">
                  <c:v>1.4979957123043504E-4</c:v>
                </c:pt>
                <c:pt idx="296">
                  <c:v>4.5443011963789604E-5</c:v>
                </c:pt>
                <c:pt idx="297">
                  <c:v>9.9741036029879851E-5</c:v>
                </c:pt>
                <c:pt idx="298">
                  <c:v>2.1976215808413809E-4</c:v>
                </c:pt>
                <c:pt idx="299">
                  <c:v>2.9731557939930868E-4</c:v>
                </c:pt>
                <c:pt idx="300">
                  <c:v>1.2677762667460577E-4</c:v>
                </c:pt>
                <c:pt idx="301">
                  <c:v>1.0021749072887752E-4</c:v>
                </c:pt>
                <c:pt idx="302">
                  <c:v>-6.8674754578292239E-5</c:v>
                </c:pt>
                <c:pt idx="303">
                  <c:v>1.0493061391335314E-4</c:v>
                </c:pt>
                <c:pt idx="304">
                  <c:v>2.8821323387037782E-4</c:v>
                </c:pt>
                <c:pt idx="305">
                  <c:v>-1.1225033051072672E-4</c:v>
                </c:pt>
                <c:pt idx="306">
                  <c:v>1.9686966224817778E-4</c:v>
                </c:pt>
                <c:pt idx="307">
                  <c:v>8.1622911018738528E-5</c:v>
                </c:pt>
                <c:pt idx="308">
                  <c:v>5.0052437907196362E-4</c:v>
                </c:pt>
                <c:pt idx="309">
                  <c:v>3.0395144388550545E-4</c:v>
                </c:pt>
                <c:pt idx="310">
                  <c:v>4.6507193600133753E-4</c:v>
                </c:pt>
                <c:pt idx="311">
                  <c:v>-1.7106552603362335E-4</c:v>
                </c:pt>
                <c:pt idx="312">
                  <c:v>-8.4509705936530369E-5</c:v>
                </c:pt>
                <c:pt idx="313">
                  <c:v>-2.0944721140986835E-4</c:v>
                </c:pt>
                <c:pt idx="314">
                  <c:v>-4.0063741453960335E-5</c:v>
                </c:pt>
                <c:pt idx="315">
                  <c:v>3.1702620973318794E-4</c:v>
                </c:pt>
                <c:pt idx="316">
                  <c:v>-1.9574496351483677E-4</c:v>
                </c:pt>
                <c:pt idx="317">
                  <c:v>-7.8203856221430802E-5</c:v>
                </c:pt>
                <c:pt idx="318">
                  <c:v>3.905422920751394E-5</c:v>
                </c:pt>
                <c:pt idx="319">
                  <c:v>1.1723641902215705E-4</c:v>
                </c:pt>
                <c:pt idx="320">
                  <c:v>-2.8292524316782968E-4</c:v>
                </c:pt>
                <c:pt idx="321">
                  <c:v>1.0457715047115271E-4</c:v>
                </c:pt>
                <c:pt idx="322">
                  <c:v>1.025618203712465E-4</c:v>
                </c:pt>
                <c:pt idx="323">
                  <c:v>2.3838416326928699E-4</c:v>
                </c:pt>
                <c:pt idx="324">
                  <c:v>-1.3689526663070024E-4</c:v>
                </c:pt>
                <c:pt idx="325">
                  <c:v>3.5972261133491662E-5</c:v>
                </c:pt>
                <c:pt idx="326">
                  <c:v>-7.4614179945935608E-5</c:v>
                </c:pt>
                <c:pt idx="327">
                  <c:v>-4.0532927969950472E-4</c:v>
                </c:pt>
                <c:pt idx="328">
                  <c:v>-1.2980825868045276E-4</c:v>
                </c:pt>
                <c:pt idx="329">
                  <c:v>-4.6574076632263609E-5</c:v>
                </c:pt>
                <c:pt idx="330">
                  <c:v>4.3076970119928847E-4</c:v>
                </c:pt>
                <c:pt idx="331">
                  <c:v>4.4976511517214399E-4</c:v>
                </c:pt>
                <c:pt idx="332">
                  <c:v>-2.5517834404301055E-4</c:v>
                </c:pt>
                <c:pt idx="333">
                  <c:v>-1.5712636367305898E-4</c:v>
                </c:pt>
                <c:pt idx="334">
                  <c:v>0</c:v>
                </c:pt>
                <c:pt idx="335">
                  <c:v>-5.337831459916725E-5</c:v>
                </c:pt>
                <c:pt idx="336">
                  <c:v>-2.1377501072128809E-4</c:v>
                </c:pt>
                <c:pt idx="337">
                  <c:v>2.6007566022747362E-4</c:v>
                </c:pt>
                <c:pt idx="338">
                  <c:v>-4.6696261082676956E-4</c:v>
                </c:pt>
                <c:pt idx="339">
                  <c:v>-1.0101460203582559E-4</c:v>
                </c:pt>
                <c:pt idx="340">
                  <c:v>-5.0157402217037394E-5</c:v>
                </c:pt>
                <c:pt idx="341">
                  <c:v>1.994044134620448E-4</c:v>
                </c:pt>
                <c:pt idx="342">
                  <c:v>9.956897192630965E-5</c:v>
                </c:pt>
                <c:pt idx="343">
                  <c:v>-6.3835745706823329E-4</c:v>
                </c:pt>
                <c:pt idx="344">
                  <c:v>-4.1910955261135335E-4</c:v>
                </c:pt>
                <c:pt idx="345">
                  <c:v>-8.8811926989923313E-5</c:v>
                </c:pt>
                <c:pt idx="346">
                  <c:v>-1.7552781969877124E-4</c:v>
                </c:pt>
                <c:pt idx="347">
                  <c:v>-8.7425010260267595E-5</c:v>
                </c:pt>
                <c:pt idx="348">
                  <c:v>-4.5296339169306608E-5</c:v>
                </c:pt>
                <c:pt idx="349">
                  <c:v>-4.7046749159969401E-5</c:v>
                </c:pt>
                <c:pt idx="350">
                  <c:v>-3.412041865989738E-4</c:v>
                </c:pt>
                <c:pt idx="351">
                  <c:v>3.8669121460873599E-4</c:v>
                </c:pt>
                <c:pt idx="352">
                  <c:v>9.2080717663457889E-5</c:v>
                </c:pt>
                <c:pt idx="353">
                  <c:v>-1.7333025062919055E-4</c:v>
                </c:pt>
                <c:pt idx="354">
                  <c:v>1.6633694593786631E-4</c:v>
                </c:pt>
                <c:pt idx="355">
                  <c:v>1.2624645830725152E-4</c:v>
                </c:pt>
                <c:pt idx="356">
                  <c:v>8.5907515023633959E-5</c:v>
                </c:pt>
                <c:pt idx="357">
                  <c:v>4.4232456745518929E-5</c:v>
                </c:pt>
                <c:pt idx="358">
                  <c:v>2.6973277571024307E-4</c:v>
                </c:pt>
                <c:pt idx="359">
                  <c:v>-4.6222113104928058E-5</c:v>
                </c:pt>
                <c:pt idx="360">
                  <c:v>4.7886788729872093E-5</c:v>
                </c:pt>
                <c:pt idx="361">
                  <c:v>-1.5135027020924389E-4</c:v>
                </c:pt>
                <c:pt idx="362">
                  <c:v>-2.7184899180961202E-4</c:v>
                </c:pt>
                <c:pt idx="363">
                  <c:v>4.6324260046712648E-4</c:v>
                </c:pt>
                <c:pt idx="364">
                  <c:v>3.724176942130861E-4</c:v>
                </c:pt>
                <c:pt idx="365">
                  <c:v>1.9619981669824485E-4</c:v>
                </c:pt>
                <c:pt idx="366">
                  <c:v>3.3599750311291292E-4</c:v>
                </c:pt>
                <c:pt idx="367">
                  <c:v>-2.0425800756770289E-4</c:v>
                </c:pt>
                <c:pt idx="368">
                  <c:v>1.3764014501041596E-4</c:v>
                </c:pt>
                <c:pt idx="369">
                  <c:v>4.1335081673369217E-4</c:v>
                </c:pt>
                <c:pt idx="370">
                  <c:v>-6.320760712528713E-4</c:v>
                </c:pt>
                <c:pt idx="371">
                  <c:v>0</c:v>
                </c:pt>
                <c:pt idx="372">
                  <c:v>3.5037278712715989E-4</c:v>
                </c:pt>
                <c:pt idx="373">
                  <c:v>6.8411071028508073E-5</c:v>
                </c:pt>
                <c:pt idx="374">
                  <c:v>3.2624992085814562E-4</c:v>
                </c:pt>
                <c:pt idx="375">
                  <c:v>-1.8953902274306382E-4</c:v>
                </c:pt>
                <c:pt idx="376">
                  <c:v>0</c:v>
                </c:pt>
                <c:pt idx="377">
                  <c:v>-3.0783028277768754E-4</c:v>
                </c:pt>
                <c:pt idx="378">
                  <c:v>0</c:v>
                </c:pt>
                <c:pt idx="379">
                  <c:v>1.9719429566003485E-4</c:v>
                </c:pt>
                <c:pt idx="380">
                  <c:v>3.4979856845959934E-4</c:v>
                </c:pt>
                <c:pt idx="381">
                  <c:v>-2.868113182379509E-4</c:v>
                </c:pt>
                <c:pt idx="382">
                  <c:v>1.4679083841599908E-4</c:v>
                </c:pt>
                <c:pt idx="383">
                  <c:v>7.3951707937564308E-5</c:v>
                </c:pt>
                <c:pt idx="384">
                  <c:v>2.9592431948762384E-4</c:v>
                </c:pt>
                <c:pt idx="385">
                  <c:v>3.0488505693193515E-4</c:v>
                </c:pt>
                <c:pt idx="386">
                  <c:v>-2.3414238833622205E-4</c:v>
                </c:pt>
                <c:pt idx="387">
                  <c:v>1.6077998195668168E-4</c:v>
                </c:pt>
                <c:pt idx="388">
                  <c:v>8.4250826609776053E-4</c:v>
                </c:pt>
                <c:pt idx="389">
                  <c:v>4.3116454354769009E-4</c:v>
                </c:pt>
                <c:pt idx="390">
                  <c:v>-8.9315199641346532E-4</c:v>
                </c:pt>
                <c:pt idx="391">
                  <c:v>2.753758556796805E-4</c:v>
                </c:pt>
                <c:pt idx="392">
                  <c:v>2.8022155723713072E-4</c:v>
                </c:pt>
                <c:pt idx="393">
                  <c:v>5.8176605770296627E-4</c:v>
                </c:pt>
                <c:pt idx="394">
                  <c:v>7.8429860011634107E-4</c:v>
                </c:pt>
                <c:pt idx="395">
                  <c:v>7.8787984186791567E-4</c:v>
                </c:pt>
                <c:pt idx="396">
                  <c:v>2.961952620614747E-4</c:v>
                </c:pt>
                <c:pt idx="397">
                  <c:v>-4.934685140407382E-4</c:v>
                </c:pt>
                <c:pt idx="398">
                  <c:v>1.9678079833180241E-4</c:v>
                </c:pt>
                <c:pt idx="399">
                  <c:v>0</c:v>
                </c:pt>
                <c:pt idx="400">
                  <c:v>-2.8601061166767095E-4</c:v>
                </c:pt>
                <c:pt idx="401">
                  <c:v>-8.551669697449654E-4</c:v>
                </c:pt>
                <c:pt idx="402">
                  <c:v>1.1612789624866585E-3</c:v>
                </c:pt>
                <c:pt idx="403">
                  <c:v>5.8729659600895569E-4</c:v>
                </c:pt>
                <c:pt idx="404">
                  <c:v>1.9764446214990869E-4</c:v>
                </c:pt>
                <c:pt idx="405">
                  <c:v>1.8965014462725673E-4</c:v>
                </c:pt>
                <c:pt idx="406">
                  <c:v>1.8283036959297215E-4</c:v>
                </c:pt>
                <c:pt idx="407">
                  <c:v>8.6835907084491942E-5</c:v>
                </c:pt>
                <c:pt idx="408">
                  <c:v>-8.4424399008539537E-5</c:v>
                </c:pt>
                <c:pt idx="409">
                  <c:v>2.4690473349223857E-4</c:v>
                </c:pt>
                <c:pt idx="410">
                  <c:v>-2.5582405387834014E-4</c:v>
                </c:pt>
                <c:pt idx="411">
                  <c:v>2.6599768239866716E-4</c:v>
                </c:pt>
                <c:pt idx="412">
                  <c:v>-9.4297025864480054E-5</c:v>
                </c:pt>
                <c:pt idx="413">
                  <c:v>4.1197949421747096E-4</c:v>
                </c:pt>
                <c:pt idx="414">
                  <c:v>-2.2160718716633638E-4</c:v>
                </c:pt>
                <c:pt idx="415">
                  <c:v>5.5374844528516373E-4</c:v>
                </c:pt>
                <c:pt idx="416">
                  <c:v>0</c:v>
                </c:pt>
                <c:pt idx="417">
                  <c:v>1.1114016511091026E-4</c:v>
                </c:pt>
                <c:pt idx="418">
                  <c:v>3.3162172242590224E-4</c:v>
                </c:pt>
                <c:pt idx="419">
                  <c:v>-1.1066595453682088E-4</c:v>
                </c:pt>
                <c:pt idx="420">
                  <c:v>-6.9020207901809589E-4</c:v>
                </c:pt>
                <c:pt idx="421">
                  <c:v>-7.136816323486412E-4</c:v>
                </c:pt>
                <c:pt idx="422">
                  <c:v>-3.731071413716323E-4</c:v>
                </c:pt>
                <c:pt idx="423">
                  <c:v>2.4979945915122641E-4</c:v>
                </c:pt>
                <c:pt idx="424">
                  <c:v>5.0414714463360851E-4</c:v>
                </c:pt>
                <c:pt idx="425">
                  <c:v>1.2181807825341662E-4</c:v>
                </c:pt>
                <c:pt idx="426">
                  <c:v>-5.9799788155952781E-4</c:v>
                </c:pt>
                <c:pt idx="427">
                  <c:v>-9.1625710294301139E-4</c:v>
                </c:pt>
                <c:pt idx="428">
                  <c:v>-7.8064878310050425E-4</c:v>
                </c:pt>
                <c:pt idx="429">
                  <c:v>-2.1633110411133994E-4</c:v>
                </c:pt>
                <c:pt idx="430">
                  <c:v>-4.2894854826690091E-4</c:v>
                </c:pt>
                <c:pt idx="431">
                  <c:v>1.0166952803998461E-3</c:v>
                </c:pt>
                <c:pt idx="432">
                  <c:v>3.4765792667397055E-4</c:v>
                </c:pt>
                <c:pt idx="433">
                  <c:v>-6.2150570774127201E-4</c:v>
                </c:pt>
                <c:pt idx="434">
                  <c:v>7.7617777237757701E-4</c:v>
                </c:pt>
                <c:pt idx="435">
                  <c:v>5.4781903428701741E-4</c:v>
                </c:pt>
                <c:pt idx="436">
                  <c:v>-9.3701318559640792E-4</c:v>
                </c:pt>
                <c:pt idx="437">
                  <c:v>1.6419206016133258E-3</c:v>
                </c:pt>
                <c:pt idx="438">
                  <c:v>0</c:v>
                </c:pt>
                <c:pt idx="439">
                  <c:v>-8.1556856163854472E-4</c:v>
                </c:pt>
                <c:pt idx="440">
                  <c:v>1.8637984565852887E-3</c:v>
                </c:pt>
                <c:pt idx="441">
                  <c:v>9.5797896332674038E-4</c:v>
                </c:pt>
                <c:pt idx="442">
                  <c:v>1.2085209191642539E-3</c:v>
                </c:pt>
                <c:pt idx="443">
                  <c:v>1.3544289654474347E-4</c:v>
                </c:pt>
                <c:pt idx="444">
                  <c:v>-1.0443988388839861E-3</c:v>
                </c:pt>
                <c:pt idx="445">
                  <c:v>4.810094603457818E-4</c:v>
                </c:pt>
                <c:pt idx="446">
                  <c:v>4.3544362876825359E-4</c:v>
                </c:pt>
                <c:pt idx="447">
                  <c:v>1.0230067097949647E-4</c:v>
                </c:pt>
                <c:pt idx="448">
                  <c:v>5.0587102223819509E-4</c:v>
                </c:pt>
                <c:pt idx="449">
                  <c:v>-9.2952370249875158E-4</c:v>
                </c:pt>
                <c:pt idx="450">
                  <c:v>-4.5273821677676174E-4</c:v>
                </c:pt>
              </c:numCache>
            </c:numRef>
          </c:yVal>
          <c:smooth val="1"/>
          <c:extLst>
            <c:ext xmlns:c16="http://schemas.microsoft.com/office/drawing/2014/chart" uri="{C3380CC4-5D6E-409C-BE32-E72D297353CC}">
              <c16:uniqueId val="{00000001-72FF-479C-936F-9968A7358709}"/>
            </c:ext>
          </c:extLst>
        </c:ser>
        <c:dLbls>
          <c:showLegendKey val="0"/>
          <c:showVal val="0"/>
          <c:showCatName val="0"/>
          <c:showSerName val="0"/>
          <c:showPercent val="0"/>
          <c:showBubbleSize val="0"/>
        </c:dLbls>
        <c:axId val="150663936"/>
        <c:axId val="150664496"/>
      </c:scatterChart>
      <c:valAx>
        <c:axId val="150663936"/>
        <c:scaling>
          <c:orientation val="minMax"/>
          <c:max val="500"/>
          <c:min val="250"/>
        </c:scaling>
        <c:delete val="0"/>
        <c:axPos val="b"/>
        <c:title>
          <c:tx>
            <c:rich>
              <a:bodyPr/>
              <a:lstStyle/>
              <a:p>
                <a:pPr>
                  <a:defRPr/>
                </a:pPr>
                <a:r>
                  <a:rPr lang="en-GB" dirty="0"/>
                  <a:t>Wavelength</a:t>
                </a:r>
                <a:r>
                  <a:rPr lang="en-GB" baseline="0" dirty="0"/>
                  <a:t> (nm)</a:t>
                </a:r>
                <a:endParaRPr lang="en-GB" dirty="0"/>
              </a:p>
            </c:rich>
          </c:tx>
          <c:layout/>
          <c:overlay val="0"/>
        </c:title>
        <c:numFmt formatCode="General" sourceLinked="1"/>
        <c:majorTickMark val="out"/>
        <c:minorTickMark val="none"/>
        <c:tickLblPos val="nextTo"/>
        <c:crossAx val="150664496"/>
        <c:crosses val="autoZero"/>
        <c:crossBetween val="midCat"/>
      </c:valAx>
      <c:valAx>
        <c:axId val="150664496"/>
        <c:scaling>
          <c:orientation val="minMax"/>
          <c:max val="1"/>
          <c:min val="0"/>
        </c:scaling>
        <c:delete val="0"/>
        <c:axPos val="l"/>
        <c:title>
          <c:tx>
            <c:rich>
              <a:bodyPr/>
              <a:lstStyle/>
              <a:p>
                <a:pPr>
                  <a:defRPr/>
                </a:pPr>
                <a:r>
                  <a:rPr lang="en-GB"/>
                  <a:t>Normalised Intensity (a.u.)</a:t>
                </a:r>
              </a:p>
            </c:rich>
          </c:tx>
          <c:layout/>
          <c:overlay val="0"/>
        </c:title>
        <c:numFmt formatCode="General" sourceLinked="1"/>
        <c:majorTickMark val="out"/>
        <c:minorTickMark val="none"/>
        <c:tickLblPos val="nextTo"/>
        <c:crossAx val="150663936"/>
        <c:crosses val="autoZero"/>
        <c:crossBetween val="midCat"/>
      </c:valAx>
    </c:plotArea>
    <c:legend>
      <c:legendPos val="b"/>
      <c:layout/>
      <c:overlay val="0"/>
    </c:legend>
    <c:plotVisOnly val="1"/>
    <c:dispBlanksAs val="gap"/>
    <c:showDLblsOverMax val="0"/>
  </c:chart>
  <c:spPr>
    <a:ln>
      <a:noFill/>
    </a:ln>
  </c:spPr>
  <c:externalData r:id="rId1">
    <c:autoUpdate val="0"/>
  </c:externalData>
</c:chartSpace>
</file>

<file path=ppt/charts/chart2.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8.7542486862957708E-2"/>
          <c:y val="1.6822422267288219E-2"/>
          <c:w val="0.41754824735173912"/>
          <c:h val="0.44941167623433553"/>
        </c:manualLayout>
      </c:layout>
      <c:scatterChart>
        <c:scatterStyle val="smoothMarker"/>
        <c:varyColors val="0"/>
        <c:ser>
          <c:idx val="0"/>
          <c:order val="0"/>
          <c:tx>
            <c:strRef>
              <c:f>Absorbance!$A$1</c:f>
              <c:strCache>
                <c:ptCount val="1"/>
                <c:pt idx="0">
                  <c:v>Quinine Sulphate (200 μM) H2SO4 Abs</c:v>
                </c:pt>
              </c:strCache>
            </c:strRef>
          </c:tx>
          <c:spPr>
            <a:ln>
              <a:solidFill>
                <a:srgbClr val="0070C0"/>
              </a:solidFill>
            </a:ln>
          </c:spPr>
          <c:marker>
            <c:symbol val="none"/>
          </c:marker>
          <c:xVal>
            <c:numRef>
              <c:f>Absorbance!$A$3:$A$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Absorbance!$B$3:$B$513</c:f>
              <c:numCache>
                <c:formatCode>General</c:formatCode>
                <c:ptCount val="511"/>
                <c:pt idx="0">
                  <c:v>3.898819</c:v>
                </c:pt>
                <c:pt idx="1">
                  <c:v>3.6758120000000001</c:v>
                </c:pt>
                <c:pt idx="2">
                  <c:v>3.8031619999999999</c:v>
                </c:pt>
                <c:pt idx="3">
                  <c:v>3.740173</c:v>
                </c:pt>
                <c:pt idx="4">
                  <c:v>3.4617460000000002</c:v>
                </c:pt>
                <c:pt idx="5">
                  <c:v>3.7010190000000001</c:v>
                </c:pt>
                <c:pt idx="6">
                  <c:v>3.5787200000000001</c:v>
                </c:pt>
                <c:pt idx="7">
                  <c:v>3.3218540000000001</c:v>
                </c:pt>
                <c:pt idx="8">
                  <c:v>3.5612180000000002</c:v>
                </c:pt>
                <c:pt idx="9">
                  <c:v>3.3953700000000002</c:v>
                </c:pt>
                <c:pt idx="10">
                  <c:v>3.2121580000000001</c:v>
                </c:pt>
                <c:pt idx="11">
                  <c:v>3.3102719999999999</c:v>
                </c:pt>
                <c:pt idx="12">
                  <c:v>3.1941069999999998</c:v>
                </c:pt>
                <c:pt idx="13">
                  <c:v>3.1676329999999999</c:v>
                </c:pt>
                <c:pt idx="14">
                  <c:v>3.2417910000000001</c:v>
                </c:pt>
                <c:pt idx="15">
                  <c:v>3.179306</c:v>
                </c:pt>
                <c:pt idx="16">
                  <c:v>3.1060180000000002</c:v>
                </c:pt>
                <c:pt idx="17">
                  <c:v>3.1911160000000001</c:v>
                </c:pt>
                <c:pt idx="18">
                  <c:v>3.1215820000000001</c:v>
                </c:pt>
                <c:pt idx="19">
                  <c:v>3.1864170000000001</c:v>
                </c:pt>
                <c:pt idx="20">
                  <c:v>3.1365810000000001</c:v>
                </c:pt>
                <c:pt idx="21">
                  <c:v>3.1989589999999999</c:v>
                </c:pt>
                <c:pt idx="22">
                  <c:v>3.0324710000000001</c:v>
                </c:pt>
                <c:pt idx="23">
                  <c:v>3.0473479999999999</c:v>
                </c:pt>
                <c:pt idx="24">
                  <c:v>3.0635680000000001</c:v>
                </c:pt>
                <c:pt idx="25">
                  <c:v>3.083221</c:v>
                </c:pt>
                <c:pt idx="26">
                  <c:v>3.1181950000000001</c:v>
                </c:pt>
                <c:pt idx="27">
                  <c:v>3.085464</c:v>
                </c:pt>
                <c:pt idx="28">
                  <c:v>3.0884860000000001</c:v>
                </c:pt>
                <c:pt idx="29">
                  <c:v>2.9754640000000001</c:v>
                </c:pt>
                <c:pt idx="30">
                  <c:v>2.9487459999999999</c:v>
                </c:pt>
                <c:pt idx="31">
                  <c:v>2.896118</c:v>
                </c:pt>
                <c:pt idx="32">
                  <c:v>2.8485719999999999</c:v>
                </c:pt>
                <c:pt idx="33">
                  <c:v>2.771347</c:v>
                </c:pt>
                <c:pt idx="34">
                  <c:v>2.6994929999999999</c:v>
                </c:pt>
                <c:pt idx="35">
                  <c:v>2.6073300000000001</c:v>
                </c:pt>
                <c:pt idx="36">
                  <c:v>2.5155940000000001</c:v>
                </c:pt>
                <c:pt idx="37">
                  <c:v>2.4067690000000002</c:v>
                </c:pt>
                <c:pt idx="38">
                  <c:v>2.306854</c:v>
                </c:pt>
                <c:pt idx="39">
                  <c:v>2.2399290000000001</c:v>
                </c:pt>
                <c:pt idx="40">
                  <c:v>2.1988219999999998</c:v>
                </c:pt>
                <c:pt idx="41">
                  <c:v>2.1893009999999999</c:v>
                </c:pt>
                <c:pt idx="42">
                  <c:v>2.2091219999999998</c:v>
                </c:pt>
                <c:pt idx="43">
                  <c:v>2.2642519999999999</c:v>
                </c:pt>
                <c:pt idx="44">
                  <c:v>2.3406370000000001</c:v>
                </c:pt>
                <c:pt idx="45">
                  <c:v>2.4337460000000002</c:v>
                </c:pt>
                <c:pt idx="46">
                  <c:v>2.5433650000000001</c:v>
                </c:pt>
                <c:pt idx="47">
                  <c:v>2.6689910000000001</c:v>
                </c:pt>
                <c:pt idx="48">
                  <c:v>2.7842250000000002</c:v>
                </c:pt>
                <c:pt idx="49">
                  <c:v>2.8604579999999999</c:v>
                </c:pt>
                <c:pt idx="50">
                  <c:v>2.9394840000000002</c:v>
                </c:pt>
                <c:pt idx="51">
                  <c:v>2.965195</c:v>
                </c:pt>
                <c:pt idx="52">
                  <c:v>2.9821469999999999</c:v>
                </c:pt>
                <c:pt idx="53">
                  <c:v>2.9923709999999999</c:v>
                </c:pt>
                <c:pt idx="54">
                  <c:v>2.9602659999999998</c:v>
                </c:pt>
                <c:pt idx="55">
                  <c:v>2.9859010000000001</c:v>
                </c:pt>
                <c:pt idx="56">
                  <c:v>2.9754640000000001</c:v>
                </c:pt>
                <c:pt idx="57">
                  <c:v>2.9560240000000002</c:v>
                </c:pt>
                <c:pt idx="58">
                  <c:v>2.9528349999999999</c:v>
                </c:pt>
                <c:pt idx="59">
                  <c:v>2.9488979999999998</c:v>
                </c:pt>
                <c:pt idx="60">
                  <c:v>2.9431150000000001</c:v>
                </c:pt>
                <c:pt idx="61">
                  <c:v>2.9177089999999999</c:v>
                </c:pt>
                <c:pt idx="62">
                  <c:v>2.9345249999999998</c:v>
                </c:pt>
                <c:pt idx="63">
                  <c:v>2.9159999999999999</c:v>
                </c:pt>
                <c:pt idx="64">
                  <c:v>2.889389</c:v>
                </c:pt>
                <c:pt idx="65">
                  <c:v>2.852112</c:v>
                </c:pt>
                <c:pt idx="66">
                  <c:v>2.836716</c:v>
                </c:pt>
                <c:pt idx="67">
                  <c:v>2.733673</c:v>
                </c:pt>
                <c:pt idx="68">
                  <c:v>2.4795530000000001</c:v>
                </c:pt>
                <c:pt idx="69">
                  <c:v>2.0781399999999999</c:v>
                </c:pt>
                <c:pt idx="70">
                  <c:v>1.6298520000000001</c:v>
                </c:pt>
                <c:pt idx="71">
                  <c:v>1.2372890000000001</c:v>
                </c:pt>
                <c:pt idx="72">
                  <c:v>0.91589399999999999</c:v>
                </c:pt>
                <c:pt idx="73">
                  <c:v>0.66799900000000001</c:v>
                </c:pt>
                <c:pt idx="74">
                  <c:v>0.48638900000000002</c:v>
                </c:pt>
                <c:pt idx="75">
                  <c:v>0.36376999999999998</c:v>
                </c:pt>
                <c:pt idx="76">
                  <c:v>0.28529399999999999</c:v>
                </c:pt>
                <c:pt idx="77">
                  <c:v>0.236679</c:v>
                </c:pt>
                <c:pt idx="78">
                  <c:v>0.209259</c:v>
                </c:pt>
                <c:pt idx="79">
                  <c:v>0.19581599999999999</c:v>
                </c:pt>
                <c:pt idx="80">
                  <c:v>0.190582</c:v>
                </c:pt>
                <c:pt idx="81">
                  <c:v>0.190247</c:v>
                </c:pt>
                <c:pt idx="82">
                  <c:v>0.192963</c:v>
                </c:pt>
                <c:pt idx="83">
                  <c:v>0.19783000000000001</c:v>
                </c:pt>
                <c:pt idx="84">
                  <c:v>0.204147</c:v>
                </c:pt>
                <c:pt idx="85">
                  <c:v>0.211227</c:v>
                </c:pt>
                <c:pt idx="86">
                  <c:v>0.219467</c:v>
                </c:pt>
                <c:pt idx="87">
                  <c:v>0.228409</c:v>
                </c:pt>
                <c:pt idx="88">
                  <c:v>0.237625</c:v>
                </c:pt>
                <c:pt idx="89">
                  <c:v>0.24793999999999999</c:v>
                </c:pt>
                <c:pt idx="90">
                  <c:v>0.25915500000000002</c:v>
                </c:pt>
                <c:pt idx="91">
                  <c:v>0.27098100000000003</c:v>
                </c:pt>
                <c:pt idx="92">
                  <c:v>0.28372199999999997</c:v>
                </c:pt>
                <c:pt idx="93">
                  <c:v>0.29705799999999999</c:v>
                </c:pt>
                <c:pt idx="94">
                  <c:v>0.31123400000000001</c:v>
                </c:pt>
                <c:pt idx="95">
                  <c:v>0.32536300000000001</c:v>
                </c:pt>
                <c:pt idx="96">
                  <c:v>0.34014899999999998</c:v>
                </c:pt>
                <c:pt idx="97">
                  <c:v>0.35534700000000002</c:v>
                </c:pt>
                <c:pt idx="98">
                  <c:v>0.37107800000000002</c:v>
                </c:pt>
                <c:pt idx="99">
                  <c:v>0.38803100000000001</c:v>
                </c:pt>
                <c:pt idx="100">
                  <c:v>0.40565499999999999</c:v>
                </c:pt>
                <c:pt idx="101">
                  <c:v>0.42425499999999999</c:v>
                </c:pt>
                <c:pt idx="102">
                  <c:v>0.44325300000000001</c:v>
                </c:pt>
                <c:pt idx="103">
                  <c:v>0.46360800000000002</c:v>
                </c:pt>
                <c:pt idx="104">
                  <c:v>0.48519899999999999</c:v>
                </c:pt>
                <c:pt idx="105">
                  <c:v>0.49076799999999998</c:v>
                </c:pt>
                <c:pt idx="106">
                  <c:v>0.49545299999999998</c:v>
                </c:pt>
                <c:pt idx="107">
                  <c:v>0.51591500000000001</c:v>
                </c:pt>
                <c:pt idx="108">
                  <c:v>0.54196200000000005</c:v>
                </c:pt>
                <c:pt idx="109">
                  <c:v>0.56622300000000003</c:v>
                </c:pt>
                <c:pt idx="110">
                  <c:v>0.58946200000000004</c:v>
                </c:pt>
                <c:pt idx="111">
                  <c:v>0.61351</c:v>
                </c:pt>
                <c:pt idx="112">
                  <c:v>0.63417100000000004</c:v>
                </c:pt>
                <c:pt idx="113">
                  <c:v>0.656281</c:v>
                </c:pt>
                <c:pt idx="114">
                  <c:v>0.67575099999999999</c:v>
                </c:pt>
                <c:pt idx="115">
                  <c:v>0.69943200000000005</c:v>
                </c:pt>
                <c:pt idx="116">
                  <c:v>0.75665300000000002</c:v>
                </c:pt>
                <c:pt idx="117">
                  <c:v>0.78614799999999996</c:v>
                </c:pt>
                <c:pt idx="118">
                  <c:v>0.80934099999999998</c:v>
                </c:pt>
                <c:pt idx="119">
                  <c:v>0.826233</c:v>
                </c:pt>
                <c:pt idx="120">
                  <c:v>0.84986899999999999</c:v>
                </c:pt>
                <c:pt idx="121">
                  <c:v>0.86531100000000005</c:v>
                </c:pt>
                <c:pt idx="122">
                  <c:v>0.88382000000000005</c:v>
                </c:pt>
                <c:pt idx="123">
                  <c:v>0.89880400000000005</c:v>
                </c:pt>
                <c:pt idx="124">
                  <c:v>0.91223100000000001</c:v>
                </c:pt>
                <c:pt idx="125">
                  <c:v>0.91654999999999998</c:v>
                </c:pt>
                <c:pt idx="126">
                  <c:v>0.920624</c:v>
                </c:pt>
                <c:pt idx="127">
                  <c:v>0.92266800000000004</c:v>
                </c:pt>
                <c:pt idx="128">
                  <c:v>0.92033399999999999</c:v>
                </c:pt>
                <c:pt idx="129">
                  <c:v>0.91375700000000004</c:v>
                </c:pt>
                <c:pt idx="130">
                  <c:v>0.90695199999999998</c:v>
                </c:pt>
                <c:pt idx="131">
                  <c:v>0.89511099999999999</c:v>
                </c:pt>
                <c:pt idx="132">
                  <c:v>0.88787799999999995</c:v>
                </c:pt>
                <c:pt idx="133">
                  <c:v>0.88185100000000005</c:v>
                </c:pt>
                <c:pt idx="134">
                  <c:v>0.87326000000000004</c:v>
                </c:pt>
                <c:pt idx="135">
                  <c:v>0.87170400000000003</c:v>
                </c:pt>
                <c:pt idx="136">
                  <c:v>0.87365700000000002</c:v>
                </c:pt>
                <c:pt idx="137">
                  <c:v>0.87759399999999999</c:v>
                </c:pt>
                <c:pt idx="138">
                  <c:v>0.88439900000000005</c:v>
                </c:pt>
                <c:pt idx="139">
                  <c:v>0.89566000000000001</c:v>
                </c:pt>
                <c:pt idx="140">
                  <c:v>0.90910299999999999</c:v>
                </c:pt>
                <c:pt idx="141">
                  <c:v>0.92471300000000001</c:v>
                </c:pt>
                <c:pt idx="142">
                  <c:v>0.94213899999999995</c:v>
                </c:pt>
                <c:pt idx="143">
                  <c:v>0.95927399999999996</c:v>
                </c:pt>
                <c:pt idx="144">
                  <c:v>0.97895799999999999</c:v>
                </c:pt>
                <c:pt idx="145">
                  <c:v>0.99868800000000002</c:v>
                </c:pt>
                <c:pt idx="146">
                  <c:v>1.017334</c:v>
                </c:pt>
                <c:pt idx="147">
                  <c:v>1.034241</c:v>
                </c:pt>
                <c:pt idx="148">
                  <c:v>1.0508729999999999</c:v>
                </c:pt>
                <c:pt idx="149">
                  <c:v>1.066406</c:v>
                </c:pt>
                <c:pt idx="150">
                  <c:v>1.0798490000000001</c:v>
                </c:pt>
                <c:pt idx="151">
                  <c:v>1.0939639999999999</c:v>
                </c:pt>
                <c:pt idx="152">
                  <c:v>1.106033</c:v>
                </c:pt>
                <c:pt idx="153">
                  <c:v>1.1134189999999999</c:v>
                </c:pt>
                <c:pt idx="154">
                  <c:v>1.1201319999999999</c:v>
                </c:pt>
                <c:pt idx="155">
                  <c:v>1.123901</c:v>
                </c:pt>
                <c:pt idx="156">
                  <c:v>1.126312</c:v>
                </c:pt>
                <c:pt idx="157">
                  <c:v>1.1265719999999999</c:v>
                </c:pt>
                <c:pt idx="158">
                  <c:v>1.1233519999999999</c:v>
                </c:pt>
                <c:pt idx="159">
                  <c:v>1.1209560000000001</c:v>
                </c:pt>
                <c:pt idx="160">
                  <c:v>1.113434</c:v>
                </c:pt>
                <c:pt idx="161">
                  <c:v>1.1029359999999999</c:v>
                </c:pt>
                <c:pt idx="162">
                  <c:v>1.0902559999999999</c:v>
                </c:pt>
                <c:pt idx="163">
                  <c:v>1.0764009999999999</c:v>
                </c:pt>
                <c:pt idx="164">
                  <c:v>1.061218</c:v>
                </c:pt>
                <c:pt idx="165">
                  <c:v>1.0406340000000001</c:v>
                </c:pt>
                <c:pt idx="166">
                  <c:v>1.0193939999999999</c:v>
                </c:pt>
                <c:pt idx="167">
                  <c:v>0.99324000000000001</c:v>
                </c:pt>
                <c:pt idx="168">
                  <c:v>0.96823099999999995</c:v>
                </c:pt>
                <c:pt idx="169">
                  <c:v>0.93937700000000002</c:v>
                </c:pt>
                <c:pt idx="170">
                  <c:v>0.90701299999999996</c:v>
                </c:pt>
                <c:pt idx="171">
                  <c:v>0.87730399999999997</c:v>
                </c:pt>
                <c:pt idx="172">
                  <c:v>0.84312399999999998</c:v>
                </c:pt>
                <c:pt idx="173">
                  <c:v>0.80754099999999995</c:v>
                </c:pt>
                <c:pt idx="174">
                  <c:v>0.771698</c:v>
                </c:pt>
                <c:pt idx="175">
                  <c:v>0.73335300000000003</c:v>
                </c:pt>
                <c:pt idx="176">
                  <c:v>0.69412200000000002</c:v>
                </c:pt>
                <c:pt idx="177">
                  <c:v>0.65588400000000002</c:v>
                </c:pt>
                <c:pt idx="178">
                  <c:v>0.61674499999999999</c:v>
                </c:pt>
                <c:pt idx="179">
                  <c:v>0.57910200000000001</c:v>
                </c:pt>
                <c:pt idx="180">
                  <c:v>0.54136700000000004</c:v>
                </c:pt>
                <c:pt idx="181">
                  <c:v>0.50428799999999996</c:v>
                </c:pt>
                <c:pt idx="182">
                  <c:v>0.46940599999999999</c:v>
                </c:pt>
                <c:pt idx="183">
                  <c:v>0.43609599999999998</c:v>
                </c:pt>
                <c:pt idx="184">
                  <c:v>0.40443400000000002</c:v>
                </c:pt>
                <c:pt idx="185">
                  <c:v>0.373199</c:v>
                </c:pt>
                <c:pt idx="186">
                  <c:v>0.34379599999999999</c:v>
                </c:pt>
                <c:pt idx="187">
                  <c:v>0.31550600000000001</c:v>
                </c:pt>
                <c:pt idx="188">
                  <c:v>0.28918500000000003</c:v>
                </c:pt>
                <c:pt idx="189">
                  <c:v>0.265656</c:v>
                </c:pt>
                <c:pt idx="190">
                  <c:v>0.24385100000000001</c:v>
                </c:pt>
                <c:pt idx="191">
                  <c:v>0.223633</c:v>
                </c:pt>
                <c:pt idx="192">
                  <c:v>0.20503199999999999</c:v>
                </c:pt>
                <c:pt idx="193">
                  <c:v>0.187775</c:v>
                </c:pt>
                <c:pt idx="194">
                  <c:v>0.171982</c:v>
                </c:pt>
                <c:pt idx="195">
                  <c:v>0.15734899999999999</c:v>
                </c:pt>
                <c:pt idx="196">
                  <c:v>0.14407300000000001</c:v>
                </c:pt>
                <c:pt idx="197">
                  <c:v>0.13229399999999999</c:v>
                </c:pt>
                <c:pt idx="198">
                  <c:v>0.12185699999999999</c:v>
                </c:pt>
                <c:pt idx="199">
                  <c:v>0.11221299999999999</c:v>
                </c:pt>
                <c:pt idx="200">
                  <c:v>0.103271</c:v>
                </c:pt>
                <c:pt idx="201">
                  <c:v>9.5490000000000005E-2</c:v>
                </c:pt>
                <c:pt idx="202">
                  <c:v>8.8332999999999995E-2</c:v>
                </c:pt>
                <c:pt idx="203">
                  <c:v>8.1848000000000004E-2</c:v>
                </c:pt>
                <c:pt idx="204">
                  <c:v>7.6247999999999996E-2</c:v>
                </c:pt>
                <c:pt idx="205">
                  <c:v>7.1381E-2</c:v>
                </c:pt>
                <c:pt idx="206">
                  <c:v>6.6818000000000002E-2</c:v>
                </c:pt>
                <c:pt idx="207">
                  <c:v>6.2958E-2</c:v>
                </c:pt>
                <c:pt idx="208">
                  <c:v>5.9616000000000002E-2</c:v>
                </c:pt>
                <c:pt idx="209">
                  <c:v>5.6411999999999997E-2</c:v>
                </c:pt>
                <c:pt idx="210">
                  <c:v>5.3619E-2</c:v>
                </c:pt>
                <c:pt idx="211">
                  <c:v>5.1270000000000003E-2</c:v>
                </c:pt>
                <c:pt idx="212">
                  <c:v>4.9300999999999998E-2</c:v>
                </c:pt>
                <c:pt idx="213">
                  <c:v>4.7516000000000003E-2</c:v>
                </c:pt>
                <c:pt idx="214">
                  <c:v>4.5990000000000003E-2</c:v>
                </c:pt>
                <c:pt idx="215">
                  <c:v>4.4631999999999998E-2</c:v>
                </c:pt>
                <c:pt idx="216">
                  <c:v>4.3442000000000001E-2</c:v>
                </c:pt>
                <c:pt idx="217">
                  <c:v>4.2403999999999997E-2</c:v>
                </c:pt>
                <c:pt idx="218">
                  <c:v>4.1473000000000003E-2</c:v>
                </c:pt>
                <c:pt idx="219">
                  <c:v>4.0771000000000002E-2</c:v>
                </c:pt>
                <c:pt idx="220">
                  <c:v>4.0023999999999997E-2</c:v>
                </c:pt>
                <c:pt idx="221">
                  <c:v>3.9474000000000002E-2</c:v>
                </c:pt>
                <c:pt idx="222">
                  <c:v>3.9017000000000003E-2</c:v>
                </c:pt>
                <c:pt idx="223">
                  <c:v>3.8712000000000003E-2</c:v>
                </c:pt>
                <c:pt idx="224">
                  <c:v>3.8300000000000001E-2</c:v>
                </c:pt>
                <c:pt idx="225">
                  <c:v>3.7842000000000001E-2</c:v>
                </c:pt>
                <c:pt idx="226">
                  <c:v>3.7597999999999999E-2</c:v>
                </c:pt>
                <c:pt idx="227">
                  <c:v>3.746E-2</c:v>
                </c:pt>
                <c:pt idx="228">
                  <c:v>3.7215999999999999E-2</c:v>
                </c:pt>
                <c:pt idx="229">
                  <c:v>3.7109000000000003E-2</c:v>
                </c:pt>
                <c:pt idx="230">
                  <c:v>3.6942000000000003E-2</c:v>
                </c:pt>
                <c:pt idx="231">
                  <c:v>3.6697E-2</c:v>
                </c:pt>
                <c:pt idx="232">
                  <c:v>3.6513999999999998E-2</c:v>
                </c:pt>
                <c:pt idx="233">
                  <c:v>3.6575000000000003E-2</c:v>
                </c:pt>
                <c:pt idx="234">
                  <c:v>3.6452999999999999E-2</c:v>
                </c:pt>
                <c:pt idx="235">
                  <c:v>3.6377E-2</c:v>
                </c:pt>
                <c:pt idx="236">
                  <c:v>3.6301E-2</c:v>
                </c:pt>
                <c:pt idx="237">
                  <c:v>3.6301E-2</c:v>
                </c:pt>
                <c:pt idx="238">
                  <c:v>3.6223999999999999E-2</c:v>
                </c:pt>
                <c:pt idx="239">
                  <c:v>3.6179000000000003E-2</c:v>
                </c:pt>
                <c:pt idx="240">
                  <c:v>3.6087000000000001E-2</c:v>
                </c:pt>
                <c:pt idx="241">
                  <c:v>3.6011000000000001E-2</c:v>
                </c:pt>
                <c:pt idx="242">
                  <c:v>3.6011000000000001E-2</c:v>
                </c:pt>
                <c:pt idx="243">
                  <c:v>3.5964999999999997E-2</c:v>
                </c:pt>
                <c:pt idx="244">
                  <c:v>3.6011000000000001E-2</c:v>
                </c:pt>
                <c:pt idx="245">
                  <c:v>3.5919E-2</c:v>
                </c:pt>
                <c:pt idx="246">
                  <c:v>3.5950000000000003E-2</c:v>
                </c:pt>
                <c:pt idx="247">
                  <c:v>3.5903999999999998E-2</c:v>
                </c:pt>
                <c:pt idx="248">
                  <c:v>3.5873000000000002E-2</c:v>
                </c:pt>
                <c:pt idx="249">
                  <c:v>3.5888999999999997E-2</c:v>
                </c:pt>
                <c:pt idx="250">
                  <c:v>3.5858000000000001E-2</c:v>
                </c:pt>
                <c:pt idx="251">
                  <c:v>3.5750999999999998E-2</c:v>
                </c:pt>
                <c:pt idx="252">
                  <c:v>3.5797000000000002E-2</c:v>
                </c:pt>
                <c:pt idx="253">
                  <c:v>3.5674999999999998E-2</c:v>
                </c:pt>
                <c:pt idx="254">
                  <c:v>3.5674999999999998E-2</c:v>
                </c:pt>
                <c:pt idx="255">
                  <c:v>3.5750999999999998E-2</c:v>
                </c:pt>
                <c:pt idx="256">
                  <c:v>3.5674999999999998E-2</c:v>
                </c:pt>
                <c:pt idx="257">
                  <c:v>3.5659999999999997E-2</c:v>
                </c:pt>
                <c:pt idx="258">
                  <c:v>3.5645000000000003E-2</c:v>
                </c:pt>
                <c:pt idx="259">
                  <c:v>3.5538E-2</c:v>
                </c:pt>
                <c:pt idx="260">
                  <c:v>3.5460999999999999E-2</c:v>
                </c:pt>
                <c:pt idx="261">
                  <c:v>3.5598999999999999E-2</c:v>
                </c:pt>
                <c:pt idx="262">
                  <c:v>3.5674999999999998E-2</c:v>
                </c:pt>
                <c:pt idx="263">
                  <c:v>3.5629000000000001E-2</c:v>
                </c:pt>
                <c:pt idx="264">
                  <c:v>3.5506999999999997E-2</c:v>
                </c:pt>
                <c:pt idx="265">
                  <c:v>3.5598999999999999E-2</c:v>
                </c:pt>
                <c:pt idx="266">
                  <c:v>3.5553000000000001E-2</c:v>
                </c:pt>
                <c:pt idx="267">
                  <c:v>3.5538E-2</c:v>
                </c:pt>
                <c:pt idx="268">
                  <c:v>3.5445999999999998E-2</c:v>
                </c:pt>
                <c:pt idx="269">
                  <c:v>3.5400000000000001E-2</c:v>
                </c:pt>
                <c:pt idx="270">
                  <c:v>3.5339000000000002E-2</c:v>
                </c:pt>
                <c:pt idx="271">
                  <c:v>3.5385E-2</c:v>
                </c:pt>
                <c:pt idx="272">
                  <c:v>3.5385E-2</c:v>
                </c:pt>
                <c:pt idx="273">
                  <c:v>3.5400000000000001E-2</c:v>
                </c:pt>
                <c:pt idx="274">
                  <c:v>3.5430999999999997E-2</c:v>
                </c:pt>
                <c:pt idx="275">
                  <c:v>3.5339000000000002E-2</c:v>
                </c:pt>
                <c:pt idx="276">
                  <c:v>3.5277999999999997E-2</c:v>
                </c:pt>
                <c:pt idx="277">
                  <c:v>3.5324000000000001E-2</c:v>
                </c:pt>
                <c:pt idx="278">
                  <c:v>3.5277999999999997E-2</c:v>
                </c:pt>
                <c:pt idx="279">
                  <c:v>3.5354999999999998E-2</c:v>
                </c:pt>
                <c:pt idx="280">
                  <c:v>3.5324000000000001E-2</c:v>
                </c:pt>
                <c:pt idx="281">
                  <c:v>3.5277999999999997E-2</c:v>
                </c:pt>
                <c:pt idx="282">
                  <c:v>3.5201999999999997E-2</c:v>
                </c:pt>
                <c:pt idx="283">
                  <c:v>3.5125999999999998E-2</c:v>
                </c:pt>
                <c:pt idx="284">
                  <c:v>3.508E-2</c:v>
                </c:pt>
                <c:pt idx="285">
                  <c:v>3.5125999999999998E-2</c:v>
                </c:pt>
                <c:pt idx="286">
                  <c:v>3.5110000000000002E-2</c:v>
                </c:pt>
                <c:pt idx="287">
                  <c:v>3.5019000000000002E-2</c:v>
                </c:pt>
                <c:pt idx="288">
                  <c:v>3.4958000000000003E-2</c:v>
                </c:pt>
                <c:pt idx="289">
                  <c:v>3.4972999999999997E-2</c:v>
                </c:pt>
                <c:pt idx="290">
                  <c:v>3.4882000000000003E-2</c:v>
                </c:pt>
                <c:pt idx="291">
                  <c:v>3.4805000000000003E-2</c:v>
                </c:pt>
                <c:pt idx="292">
                  <c:v>3.4820999999999998E-2</c:v>
                </c:pt>
                <c:pt idx="293">
                  <c:v>3.4851E-2</c:v>
                </c:pt>
                <c:pt idx="294">
                  <c:v>3.4729000000000003E-2</c:v>
                </c:pt>
                <c:pt idx="295">
                  <c:v>3.4698E-2</c:v>
                </c:pt>
                <c:pt idx="296">
                  <c:v>3.4637000000000001E-2</c:v>
                </c:pt>
                <c:pt idx="297">
                  <c:v>3.4591999999999998E-2</c:v>
                </c:pt>
                <c:pt idx="298">
                  <c:v>3.4561000000000001E-2</c:v>
                </c:pt>
                <c:pt idx="299">
                  <c:v>3.4546E-2</c:v>
                </c:pt>
                <c:pt idx="300">
                  <c:v>3.4637000000000001E-2</c:v>
                </c:pt>
                <c:pt idx="301">
                  <c:v>3.4667999999999997E-2</c:v>
                </c:pt>
                <c:pt idx="302">
                  <c:v>3.4667999999999997E-2</c:v>
                </c:pt>
                <c:pt idx="303">
                  <c:v>3.4653000000000003E-2</c:v>
                </c:pt>
                <c:pt idx="304">
                  <c:v>3.4653000000000003E-2</c:v>
                </c:pt>
                <c:pt idx="305">
                  <c:v>3.4622E-2</c:v>
                </c:pt>
                <c:pt idx="306">
                  <c:v>3.4591999999999998E-2</c:v>
                </c:pt>
                <c:pt idx="307">
                  <c:v>3.4637000000000001E-2</c:v>
                </c:pt>
                <c:pt idx="308">
                  <c:v>3.4682999999999999E-2</c:v>
                </c:pt>
                <c:pt idx="309">
                  <c:v>3.4637000000000001E-2</c:v>
                </c:pt>
                <c:pt idx="310">
                  <c:v>3.4561000000000001E-2</c:v>
                </c:pt>
                <c:pt idx="311">
                  <c:v>3.4591999999999998E-2</c:v>
                </c:pt>
                <c:pt idx="312">
                  <c:v>3.4576000000000003E-2</c:v>
                </c:pt>
                <c:pt idx="313">
                  <c:v>3.4514999999999997E-2</c:v>
                </c:pt>
                <c:pt idx="314">
                  <c:v>3.4530999999999999E-2</c:v>
                </c:pt>
                <c:pt idx="315">
                  <c:v>3.4576000000000003E-2</c:v>
                </c:pt>
                <c:pt idx="316">
                  <c:v>3.4424000000000003E-2</c:v>
                </c:pt>
                <c:pt idx="317">
                  <c:v>3.4377999999999999E-2</c:v>
                </c:pt>
                <c:pt idx="318">
                  <c:v>3.4438999999999997E-2</c:v>
                </c:pt>
                <c:pt idx="319">
                  <c:v>3.4424000000000003E-2</c:v>
                </c:pt>
                <c:pt idx="320">
                  <c:v>3.4393E-2</c:v>
                </c:pt>
                <c:pt idx="321">
                  <c:v>3.4393E-2</c:v>
                </c:pt>
                <c:pt idx="322">
                  <c:v>3.4424000000000003E-2</c:v>
                </c:pt>
                <c:pt idx="323">
                  <c:v>3.4347999999999997E-2</c:v>
                </c:pt>
                <c:pt idx="324">
                  <c:v>3.4332000000000001E-2</c:v>
                </c:pt>
                <c:pt idx="325">
                  <c:v>3.4332000000000001E-2</c:v>
                </c:pt>
                <c:pt idx="326">
                  <c:v>3.4347999999999997E-2</c:v>
                </c:pt>
                <c:pt idx="327">
                  <c:v>3.4332000000000001E-2</c:v>
                </c:pt>
                <c:pt idx="328">
                  <c:v>3.4301999999999999E-2</c:v>
                </c:pt>
                <c:pt idx="329">
                  <c:v>3.4347999999999997E-2</c:v>
                </c:pt>
                <c:pt idx="330">
                  <c:v>3.4317E-2</c:v>
                </c:pt>
                <c:pt idx="331">
                  <c:v>3.4271000000000003E-2</c:v>
                </c:pt>
                <c:pt idx="332">
                  <c:v>3.4224999999999998E-2</c:v>
                </c:pt>
                <c:pt idx="333">
                  <c:v>3.4241000000000001E-2</c:v>
                </c:pt>
                <c:pt idx="334">
                  <c:v>3.4195000000000003E-2</c:v>
                </c:pt>
                <c:pt idx="335">
                  <c:v>3.4224999999999998E-2</c:v>
                </c:pt>
                <c:pt idx="336">
                  <c:v>3.4180000000000002E-2</c:v>
                </c:pt>
                <c:pt idx="337">
                  <c:v>3.4133999999999998E-2</c:v>
                </c:pt>
                <c:pt idx="338">
                  <c:v>3.4118999999999997E-2</c:v>
                </c:pt>
                <c:pt idx="339">
                  <c:v>3.4148999999999999E-2</c:v>
                </c:pt>
                <c:pt idx="340">
                  <c:v>3.4148999999999999E-2</c:v>
                </c:pt>
                <c:pt idx="341">
                  <c:v>3.4180000000000002E-2</c:v>
                </c:pt>
                <c:pt idx="342">
                  <c:v>3.4027000000000002E-2</c:v>
                </c:pt>
                <c:pt idx="343">
                  <c:v>3.4088E-2</c:v>
                </c:pt>
                <c:pt idx="344">
                  <c:v>3.4088E-2</c:v>
                </c:pt>
                <c:pt idx="345">
                  <c:v>3.4088E-2</c:v>
                </c:pt>
                <c:pt idx="346">
                  <c:v>3.3996999999999999E-2</c:v>
                </c:pt>
                <c:pt idx="347">
                  <c:v>3.3875000000000002E-2</c:v>
                </c:pt>
                <c:pt idx="348">
                  <c:v>3.3904999999999998E-2</c:v>
                </c:pt>
                <c:pt idx="349">
                  <c:v>3.3936000000000001E-2</c:v>
                </c:pt>
                <c:pt idx="350">
                  <c:v>3.3904999999999998E-2</c:v>
                </c:pt>
                <c:pt idx="351">
                  <c:v>3.3919999999999999E-2</c:v>
                </c:pt>
                <c:pt idx="352">
                  <c:v>3.3904999999999998E-2</c:v>
                </c:pt>
                <c:pt idx="353">
                  <c:v>3.3843999999999999E-2</c:v>
                </c:pt>
                <c:pt idx="354">
                  <c:v>3.3859E-2</c:v>
                </c:pt>
                <c:pt idx="355">
                  <c:v>3.3904999999999998E-2</c:v>
                </c:pt>
                <c:pt idx="356">
                  <c:v>3.3828999999999998E-2</c:v>
                </c:pt>
                <c:pt idx="357">
                  <c:v>3.3890000000000003E-2</c:v>
                </c:pt>
                <c:pt idx="358">
                  <c:v>3.3813000000000003E-2</c:v>
                </c:pt>
                <c:pt idx="359">
                  <c:v>3.3813000000000003E-2</c:v>
                </c:pt>
                <c:pt idx="360">
                  <c:v>3.3813000000000003E-2</c:v>
                </c:pt>
                <c:pt idx="361">
                  <c:v>3.3813000000000003E-2</c:v>
                </c:pt>
                <c:pt idx="362">
                  <c:v>3.3843999999999999E-2</c:v>
                </c:pt>
                <c:pt idx="363">
                  <c:v>3.3722000000000002E-2</c:v>
                </c:pt>
                <c:pt idx="364">
                  <c:v>3.3722000000000002E-2</c:v>
                </c:pt>
                <c:pt idx="365">
                  <c:v>3.3707000000000001E-2</c:v>
                </c:pt>
                <c:pt idx="366">
                  <c:v>3.3722000000000002E-2</c:v>
                </c:pt>
                <c:pt idx="367">
                  <c:v>3.3828999999999998E-2</c:v>
                </c:pt>
                <c:pt idx="368">
                  <c:v>3.3751999999999997E-2</c:v>
                </c:pt>
                <c:pt idx="369">
                  <c:v>3.3751999999999997E-2</c:v>
                </c:pt>
                <c:pt idx="370">
                  <c:v>3.3767999999999999E-2</c:v>
                </c:pt>
                <c:pt idx="371">
                  <c:v>3.3737000000000003E-2</c:v>
                </c:pt>
                <c:pt idx="372">
                  <c:v>3.3707000000000001E-2</c:v>
                </c:pt>
                <c:pt idx="373">
                  <c:v>3.3599999999999998E-2</c:v>
                </c:pt>
                <c:pt idx="374">
                  <c:v>3.3675999999999998E-2</c:v>
                </c:pt>
                <c:pt idx="375">
                  <c:v>3.3675999999999998E-2</c:v>
                </c:pt>
                <c:pt idx="376">
                  <c:v>3.363E-2</c:v>
                </c:pt>
                <c:pt idx="377">
                  <c:v>3.3646000000000002E-2</c:v>
                </c:pt>
                <c:pt idx="378">
                  <c:v>3.3675999999999998E-2</c:v>
                </c:pt>
                <c:pt idx="379">
                  <c:v>3.3707000000000001E-2</c:v>
                </c:pt>
                <c:pt idx="380">
                  <c:v>3.363E-2</c:v>
                </c:pt>
                <c:pt idx="381">
                  <c:v>3.3614999999999999E-2</c:v>
                </c:pt>
                <c:pt idx="382">
                  <c:v>3.3661000000000003E-2</c:v>
                </c:pt>
                <c:pt idx="383">
                  <c:v>3.3646000000000002E-2</c:v>
                </c:pt>
                <c:pt idx="384">
                  <c:v>3.3646000000000002E-2</c:v>
                </c:pt>
                <c:pt idx="385">
                  <c:v>3.3569000000000002E-2</c:v>
                </c:pt>
                <c:pt idx="386">
                  <c:v>3.3614999999999999E-2</c:v>
                </c:pt>
                <c:pt idx="387">
                  <c:v>3.3599999999999998E-2</c:v>
                </c:pt>
                <c:pt idx="388">
                  <c:v>3.3599999999999998E-2</c:v>
                </c:pt>
                <c:pt idx="389">
                  <c:v>3.3569000000000002E-2</c:v>
                </c:pt>
                <c:pt idx="390">
                  <c:v>3.3569000000000002E-2</c:v>
                </c:pt>
                <c:pt idx="391">
                  <c:v>3.3599999999999998E-2</c:v>
                </c:pt>
                <c:pt idx="392">
                  <c:v>3.363E-2</c:v>
                </c:pt>
                <c:pt idx="393">
                  <c:v>3.363E-2</c:v>
                </c:pt>
                <c:pt idx="394">
                  <c:v>3.3675999999999998E-2</c:v>
                </c:pt>
                <c:pt idx="395">
                  <c:v>3.3675999999999998E-2</c:v>
                </c:pt>
                <c:pt idx="396">
                  <c:v>3.3584999999999997E-2</c:v>
                </c:pt>
                <c:pt idx="397">
                  <c:v>3.3675999999999998E-2</c:v>
                </c:pt>
                <c:pt idx="398">
                  <c:v>3.3737000000000003E-2</c:v>
                </c:pt>
                <c:pt idx="399">
                  <c:v>3.3722000000000002E-2</c:v>
                </c:pt>
                <c:pt idx="400">
                  <c:v>3.3751999999999997E-2</c:v>
                </c:pt>
                <c:pt idx="401">
                  <c:v>3.3690999999999999E-2</c:v>
                </c:pt>
                <c:pt idx="402">
                  <c:v>3.3675999999999998E-2</c:v>
                </c:pt>
                <c:pt idx="403">
                  <c:v>3.3722000000000002E-2</c:v>
                </c:pt>
                <c:pt idx="404">
                  <c:v>3.3751999999999997E-2</c:v>
                </c:pt>
                <c:pt idx="405">
                  <c:v>3.3767999999999999E-2</c:v>
                </c:pt>
                <c:pt idx="406">
                  <c:v>3.3798000000000002E-2</c:v>
                </c:pt>
                <c:pt idx="407">
                  <c:v>3.3828999999999998E-2</c:v>
                </c:pt>
                <c:pt idx="408">
                  <c:v>3.3996999999999999E-2</c:v>
                </c:pt>
                <c:pt idx="409">
                  <c:v>3.4012000000000001E-2</c:v>
                </c:pt>
                <c:pt idx="410">
                  <c:v>3.4012000000000001E-2</c:v>
                </c:pt>
                <c:pt idx="411">
                  <c:v>3.4042000000000003E-2</c:v>
                </c:pt>
                <c:pt idx="412">
                  <c:v>3.4118999999999997E-2</c:v>
                </c:pt>
                <c:pt idx="413">
                  <c:v>3.4088E-2</c:v>
                </c:pt>
                <c:pt idx="414">
                  <c:v>3.4118999999999997E-2</c:v>
                </c:pt>
                <c:pt idx="415">
                  <c:v>3.4103000000000001E-2</c:v>
                </c:pt>
                <c:pt idx="416">
                  <c:v>3.4118999999999997E-2</c:v>
                </c:pt>
                <c:pt idx="417">
                  <c:v>3.4133999999999998E-2</c:v>
                </c:pt>
                <c:pt idx="418">
                  <c:v>3.4148999999999999E-2</c:v>
                </c:pt>
                <c:pt idx="419">
                  <c:v>3.4088E-2</c:v>
                </c:pt>
                <c:pt idx="420">
                  <c:v>3.4103000000000001E-2</c:v>
                </c:pt>
                <c:pt idx="421">
                  <c:v>3.4057999999999998E-2</c:v>
                </c:pt>
                <c:pt idx="422">
                  <c:v>3.4072999999999999E-2</c:v>
                </c:pt>
                <c:pt idx="423">
                  <c:v>3.4088E-2</c:v>
                </c:pt>
                <c:pt idx="424">
                  <c:v>3.4057999999999998E-2</c:v>
                </c:pt>
                <c:pt idx="425">
                  <c:v>3.4057999999999998E-2</c:v>
                </c:pt>
                <c:pt idx="426">
                  <c:v>3.4072999999999999E-2</c:v>
                </c:pt>
                <c:pt idx="427">
                  <c:v>3.4088E-2</c:v>
                </c:pt>
                <c:pt idx="428">
                  <c:v>3.4088E-2</c:v>
                </c:pt>
                <c:pt idx="429">
                  <c:v>3.4072999999999999E-2</c:v>
                </c:pt>
                <c:pt idx="430">
                  <c:v>3.4057999999999998E-2</c:v>
                </c:pt>
                <c:pt idx="431">
                  <c:v>3.4042000000000003E-2</c:v>
                </c:pt>
                <c:pt idx="432">
                  <c:v>3.4012000000000001E-2</c:v>
                </c:pt>
                <c:pt idx="433">
                  <c:v>3.4027000000000002E-2</c:v>
                </c:pt>
                <c:pt idx="434">
                  <c:v>3.4042000000000003E-2</c:v>
                </c:pt>
                <c:pt idx="435">
                  <c:v>3.3966000000000003E-2</c:v>
                </c:pt>
                <c:pt idx="436">
                  <c:v>3.3980999999999997E-2</c:v>
                </c:pt>
                <c:pt idx="437">
                  <c:v>3.3996999999999999E-2</c:v>
                </c:pt>
                <c:pt idx="438">
                  <c:v>3.4042000000000003E-2</c:v>
                </c:pt>
                <c:pt idx="439">
                  <c:v>3.4103000000000001E-2</c:v>
                </c:pt>
                <c:pt idx="440">
                  <c:v>3.3966000000000003E-2</c:v>
                </c:pt>
                <c:pt idx="441">
                  <c:v>3.4042000000000003E-2</c:v>
                </c:pt>
                <c:pt idx="442">
                  <c:v>3.4042000000000003E-2</c:v>
                </c:pt>
                <c:pt idx="443">
                  <c:v>3.4088E-2</c:v>
                </c:pt>
                <c:pt idx="444">
                  <c:v>3.4103000000000001E-2</c:v>
                </c:pt>
                <c:pt idx="445">
                  <c:v>3.4118999999999997E-2</c:v>
                </c:pt>
                <c:pt idx="446">
                  <c:v>3.3951000000000002E-2</c:v>
                </c:pt>
                <c:pt idx="447">
                  <c:v>3.3859E-2</c:v>
                </c:pt>
                <c:pt idx="448">
                  <c:v>3.3828999999999998E-2</c:v>
                </c:pt>
                <c:pt idx="449">
                  <c:v>3.3828999999999998E-2</c:v>
                </c:pt>
                <c:pt idx="450">
                  <c:v>3.3767999999999999E-2</c:v>
                </c:pt>
                <c:pt idx="451">
                  <c:v>3.3859E-2</c:v>
                </c:pt>
                <c:pt idx="452">
                  <c:v>3.3859E-2</c:v>
                </c:pt>
                <c:pt idx="453">
                  <c:v>3.3828999999999998E-2</c:v>
                </c:pt>
                <c:pt idx="454">
                  <c:v>3.3783000000000001E-2</c:v>
                </c:pt>
                <c:pt idx="455">
                  <c:v>3.3919999999999999E-2</c:v>
                </c:pt>
                <c:pt idx="456">
                  <c:v>3.3890000000000003E-2</c:v>
                </c:pt>
                <c:pt idx="457">
                  <c:v>3.3936000000000001E-2</c:v>
                </c:pt>
                <c:pt idx="458">
                  <c:v>3.4057999999999998E-2</c:v>
                </c:pt>
                <c:pt idx="459">
                  <c:v>3.4088E-2</c:v>
                </c:pt>
                <c:pt idx="460">
                  <c:v>3.4072999999999999E-2</c:v>
                </c:pt>
                <c:pt idx="461">
                  <c:v>3.4088E-2</c:v>
                </c:pt>
                <c:pt idx="462">
                  <c:v>3.4042000000000003E-2</c:v>
                </c:pt>
                <c:pt idx="463">
                  <c:v>3.4042000000000003E-2</c:v>
                </c:pt>
                <c:pt idx="464">
                  <c:v>3.4088E-2</c:v>
                </c:pt>
                <c:pt idx="465">
                  <c:v>3.4180000000000002E-2</c:v>
                </c:pt>
                <c:pt idx="466">
                  <c:v>3.4118999999999997E-2</c:v>
                </c:pt>
                <c:pt idx="467">
                  <c:v>3.4133999999999998E-2</c:v>
                </c:pt>
                <c:pt idx="468">
                  <c:v>3.4195000000000003E-2</c:v>
                </c:pt>
                <c:pt idx="469">
                  <c:v>3.4241000000000001E-2</c:v>
                </c:pt>
                <c:pt idx="470">
                  <c:v>3.4195000000000003E-2</c:v>
                </c:pt>
                <c:pt idx="471">
                  <c:v>3.4195000000000003E-2</c:v>
                </c:pt>
                <c:pt idx="472">
                  <c:v>3.4209999999999997E-2</c:v>
                </c:pt>
                <c:pt idx="473">
                  <c:v>3.4271000000000003E-2</c:v>
                </c:pt>
                <c:pt idx="474">
                  <c:v>3.4301999999999999E-2</c:v>
                </c:pt>
                <c:pt idx="475">
                  <c:v>3.4285999999999997E-2</c:v>
                </c:pt>
                <c:pt idx="476">
                  <c:v>3.4241000000000001E-2</c:v>
                </c:pt>
                <c:pt idx="477">
                  <c:v>3.4224999999999998E-2</c:v>
                </c:pt>
                <c:pt idx="478">
                  <c:v>3.4133999999999998E-2</c:v>
                </c:pt>
                <c:pt idx="479">
                  <c:v>3.4148999999999999E-2</c:v>
                </c:pt>
                <c:pt idx="480">
                  <c:v>3.4164E-2</c:v>
                </c:pt>
                <c:pt idx="481">
                  <c:v>3.4180000000000002E-2</c:v>
                </c:pt>
                <c:pt idx="482">
                  <c:v>3.4180000000000002E-2</c:v>
                </c:pt>
                <c:pt idx="483">
                  <c:v>3.4164E-2</c:v>
                </c:pt>
                <c:pt idx="484">
                  <c:v>3.4209999999999997E-2</c:v>
                </c:pt>
                <c:pt idx="485">
                  <c:v>3.4256000000000002E-2</c:v>
                </c:pt>
                <c:pt idx="486">
                  <c:v>3.4241000000000001E-2</c:v>
                </c:pt>
                <c:pt idx="487">
                  <c:v>3.4195000000000003E-2</c:v>
                </c:pt>
                <c:pt idx="488">
                  <c:v>3.4164E-2</c:v>
                </c:pt>
                <c:pt idx="489">
                  <c:v>3.4224999999999998E-2</c:v>
                </c:pt>
                <c:pt idx="490">
                  <c:v>3.4285999999999997E-2</c:v>
                </c:pt>
                <c:pt idx="491">
                  <c:v>3.4301999999999999E-2</c:v>
                </c:pt>
                <c:pt idx="492">
                  <c:v>3.4224999999999998E-2</c:v>
                </c:pt>
                <c:pt idx="493">
                  <c:v>3.4271000000000003E-2</c:v>
                </c:pt>
                <c:pt idx="494">
                  <c:v>3.4271000000000003E-2</c:v>
                </c:pt>
                <c:pt idx="495">
                  <c:v>3.4317E-2</c:v>
                </c:pt>
                <c:pt idx="496">
                  <c:v>3.4301999999999999E-2</c:v>
                </c:pt>
                <c:pt idx="497">
                  <c:v>3.4285999999999997E-2</c:v>
                </c:pt>
                <c:pt idx="498">
                  <c:v>3.4377999999999999E-2</c:v>
                </c:pt>
                <c:pt idx="499">
                  <c:v>3.4393E-2</c:v>
                </c:pt>
                <c:pt idx="500">
                  <c:v>3.4409000000000002E-2</c:v>
                </c:pt>
                <c:pt idx="501">
                  <c:v>3.4470000000000001E-2</c:v>
                </c:pt>
                <c:pt idx="502">
                  <c:v>3.4424000000000003E-2</c:v>
                </c:pt>
                <c:pt idx="503">
                  <c:v>3.4514999999999997E-2</c:v>
                </c:pt>
                <c:pt idx="504">
                  <c:v>3.4485000000000002E-2</c:v>
                </c:pt>
                <c:pt idx="505">
                  <c:v>3.4500000000000003E-2</c:v>
                </c:pt>
                <c:pt idx="506">
                  <c:v>3.4606999999999999E-2</c:v>
                </c:pt>
                <c:pt idx="507">
                  <c:v>3.4637000000000001E-2</c:v>
                </c:pt>
                <c:pt idx="508">
                  <c:v>3.4667999999999997E-2</c:v>
                </c:pt>
                <c:pt idx="509">
                  <c:v>3.4714000000000002E-2</c:v>
                </c:pt>
                <c:pt idx="510">
                  <c:v>3.4743999999999997E-2</c:v>
                </c:pt>
              </c:numCache>
            </c:numRef>
          </c:yVal>
          <c:smooth val="1"/>
          <c:extLst>
            <c:ext xmlns:c16="http://schemas.microsoft.com/office/drawing/2014/chart" uri="{C3380CC4-5D6E-409C-BE32-E72D297353CC}">
              <c16:uniqueId val="{00000000-3FAF-4CBF-82DD-E60AB52489B3}"/>
            </c:ext>
          </c:extLst>
        </c:ser>
        <c:ser>
          <c:idx val="1"/>
          <c:order val="1"/>
          <c:tx>
            <c:strRef>
              <c:f>Absorbance!$G$1</c:f>
              <c:strCache>
                <c:ptCount val="1"/>
                <c:pt idx="0">
                  <c:v>Coumarin1 (5 μM) Ethanol Abs</c:v>
                </c:pt>
              </c:strCache>
            </c:strRef>
          </c:tx>
          <c:marker>
            <c:symbol val="none"/>
          </c:marker>
          <c:xVal>
            <c:numRef>
              <c:f>Absorbance!$G$3:$G$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Absorbance!$H$3:$H$513</c:f>
              <c:numCache>
                <c:formatCode>General</c:formatCode>
                <c:ptCount val="511"/>
                <c:pt idx="0">
                  <c:v>3.398285</c:v>
                </c:pt>
                <c:pt idx="1">
                  <c:v>3.0665439999999999</c:v>
                </c:pt>
                <c:pt idx="2">
                  <c:v>3.2260589999999998</c:v>
                </c:pt>
                <c:pt idx="3">
                  <c:v>3.1527250000000002</c:v>
                </c:pt>
                <c:pt idx="4">
                  <c:v>3.4627530000000002</c:v>
                </c:pt>
                <c:pt idx="5">
                  <c:v>3.5932010000000001</c:v>
                </c:pt>
                <c:pt idx="6">
                  <c:v>3.3665470000000002</c:v>
                </c:pt>
                <c:pt idx="7">
                  <c:v>3.2214049999999999</c:v>
                </c:pt>
                <c:pt idx="8">
                  <c:v>3.349777</c:v>
                </c:pt>
                <c:pt idx="9">
                  <c:v>3.2416230000000001</c:v>
                </c:pt>
                <c:pt idx="10">
                  <c:v>2.8831479999999998</c:v>
                </c:pt>
                <c:pt idx="11">
                  <c:v>2.5231780000000001</c:v>
                </c:pt>
                <c:pt idx="12">
                  <c:v>2.2311709999999998</c:v>
                </c:pt>
                <c:pt idx="13">
                  <c:v>1.9736629999999999</c:v>
                </c:pt>
                <c:pt idx="14">
                  <c:v>1.764999</c:v>
                </c:pt>
                <c:pt idx="15">
                  <c:v>1.5948329999999999</c:v>
                </c:pt>
                <c:pt idx="16">
                  <c:v>1.4605410000000001</c:v>
                </c:pt>
                <c:pt idx="17">
                  <c:v>1.3504940000000001</c:v>
                </c:pt>
                <c:pt idx="18">
                  <c:v>1.262192</c:v>
                </c:pt>
                <c:pt idx="19">
                  <c:v>1.1894070000000001</c:v>
                </c:pt>
                <c:pt idx="20">
                  <c:v>1.130295</c:v>
                </c:pt>
                <c:pt idx="21">
                  <c:v>1.078705</c:v>
                </c:pt>
                <c:pt idx="22">
                  <c:v>1.0303040000000001</c:v>
                </c:pt>
                <c:pt idx="23">
                  <c:v>0.98400900000000002</c:v>
                </c:pt>
                <c:pt idx="24">
                  <c:v>0.93873600000000001</c:v>
                </c:pt>
                <c:pt idx="25">
                  <c:v>0.89392099999999997</c:v>
                </c:pt>
                <c:pt idx="26">
                  <c:v>0.84854099999999999</c:v>
                </c:pt>
                <c:pt idx="27">
                  <c:v>0.80380200000000002</c:v>
                </c:pt>
                <c:pt idx="28">
                  <c:v>0.75984200000000002</c:v>
                </c:pt>
                <c:pt idx="29">
                  <c:v>0.71697999999999995</c:v>
                </c:pt>
                <c:pt idx="30">
                  <c:v>0.67839099999999997</c:v>
                </c:pt>
                <c:pt idx="31">
                  <c:v>0.64415</c:v>
                </c:pt>
                <c:pt idx="32">
                  <c:v>0.61459399999999997</c:v>
                </c:pt>
                <c:pt idx="33">
                  <c:v>0.58779899999999996</c:v>
                </c:pt>
                <c:pt idx="34">
                  <c:v>0.56549099999999997</c:v>
                </c:pt>
                <c:pt idx="35">
                  <c:v>0.54478499999999996</c:v>
                </c:pt>
                <c:pt idx="36">
                  <c:v>0.52613799999999999</c:v>
                </c:pt>
                <c:pt idx="37">
                  <c:v>0.50807199999999997</c:v>
                </c:pt>
                <c:pt idx="38">
                  <c:v>0.49174499999999999</c:v>
                </c:pt>
                <c:pt idx="39">
                  <c:v>0.47648600000000002</c:v>
                </c:pt>
                <c:pt idx="40">
                  <c:v>0.462341</c:v>
                </c:pt>
                <c:pt idx="41">
                  <c:v>0.44789099999999998</c:v>
                </c:pt>
                <c:pt idx="42">
                  <c:v>0.43270900000000001</c:v>
                </c:pt>
                <c:pt idx="43">
                  <c:v>0.41738900000000001</c:v>
                </c:pt>
                <c:pt idx="44">
                  <c:v>0.40295399999999998</c:v>
                </c:pt>
                <c:pt idx="45">
                  <c:v>0.39041100000000001</c:v>
                </c:pt>
                <c:pt idx="46">
                  <c:v>0.37914999999999999</c:v>
                </c:pt>
                <c:pt idx="47">
                  <c:v>0.36874400000000002</c:v>
                </c:pt>
                <c:pt idx="48">
                  <c:v>0.35911599999999999</c:v>
                </c:pt>
                <c:pt idx="49">
                  <c:v>0.35069299999999998</c:v>
                </c:pt>
                <c:pt idx="50">
                  <c:v>0.34217799999999998</c:v>
                </c:pt>
                <c:pt idx="51">
                  <c:v>0.33404499999999998</c:v>
                </c:pt>
                <c:pt idx="52">
                  <c:v>0.32603500000000002</c:v>
                </c:pt>
                <c:pt idx="53">
                  <c:v>0.31790200000000002</c:v>
                </c:pt>
                <c:pt idx="54">
                  <c:v>0.30972300000000003</c:v>
                </c:pt>
                <c:pt idx="55">
                  <c:v>0.30177300000000001</c:v>
                </c:pt>
                <c:pt idx="56">
                  <c:v>0.29421999999999998</c:v>
                </c:pt>
                <c:pt idx="57">
                  <c:v>0.287018</c:v>
                </c:pt>
                <c:pt idx="58">
                  <c:v>0.27993800000000002</c:v>
                </c:pt>
                <c:pt idx="59">
                  <c:v>0.27323900000000001</c:v>
                </c:pt>
                <c:pt idx="60">
                  <c:v>0.26683000000000001</c:v>
                </c:pt>
                <c:pt idx="61">
                  <c:v>0.26034499999999999</c:v>
                </c:pt>
                <c:pt idx="62">
                  <c:v>0.25431799999999999</c:v>
                </c:pt>
                <c:pt idx="63">
                  <c:v>0.247864</c:v>
                </c:pt>
                <c:pt idx="64">
                  <c:v>0.24176</c:v>
                </c:pt>
                <c:pt idx="65">
                  <c:v>0.235321</c:v>
                </c:pt>
                <c:pt idx="66">
                  <c:v>0.22880600000000001</c:v>
                </c:pt>
                <c:pt idx="67">
                  <c:v>0.22209200000000001</c:v>
                </c:pt>
                <c:pt idx="68">
                  <c:v>0.21540799999999999</c:v>
                </c:pt>
                <c:pt idx="69">
                  <c:v>0.20855699999999999</c:v>
                </c:pt>
                <c:pt idx="70">
                  <c:v>0.201431</c:v>
                </c:pt>
                <c:pt idx="71">
                  <c:v>0.19455</c:v>
                </c:pt>
                <c:pt idx="72">
                  <c:v>0.187943</c:v>
                </c:pt>
                <c:pt idx="73">
                  <c:v>0.18129000000000001</c:v>
                </c:pt>
                <c:pt idx="74">
                  <c:v>0.17521700000000001</c:v>
                </c:pt>
                <c:pt idx="75">
                  <c:v>0.170242</c:v>
                </c:pt>
                <c:pt idx="76">
                  <c:v>0.166245</c:v>
                </c:pt>
                <c:pt idx="77">
                  <c:v>0.16294900000000001</c:v>
                </c:pt>
                <c:pt idx="78">
                  <c:v>0.16030900000000001</c:v>
                </c:pt>
                <c:pt idx="79">
                  <c:v>0.158112</c:v>
                </c:pt>
                <c:pt idx="80">
                  <c:v>0.15646399999999999</c:v>
                </c:pt>
                <c:pt idx="81">
                  <c:v>0.155029</c:v>
                </c:pt>
                <c:pt idx="82">
                  <c:v>0.15420500000000001</c:v>
                </c:pt>
                <c:pt idx="83">
                  <c:v>0.15365599999999999</c:v>
                </c:pt>
                <c:pt idx="84">
                  <c:v>0.15281700000000001</c:v>
                </c:pt>
                <c:pt idx="85">
                  <c:v>0.15242</c:v>
                </c:pt>
                <c:pt idx="86">
                  <c:v>0.15193200000000001</c:v>
                </c:pt>
                <c:pt idx="87">
                  <c:v>0.15142800000000001</c:v>
                </c:pt>
                <c:pt idx="88">
                  <c:v>0.150726</c:v>
                </c:pt>
                <c:pt idx="89">
                  <c:v>0.14990200000000001</c:v>
                </c:pt>
                <c:pt idx="90">
                  <c:v>0.14894099999999999</c:v>
                </c:pt>
                <c:pt idx="91">
                  <c:v>0.14771999999999999</c:v>
                </c:pt>
                <c:pt idx="92">
                  <c:v>0.146088</c:v>
                </c:pt>
                <c:pt idx="93">
                  <c:v>0.144485</c:v>
                </c:pt>
                <c:pt idx="94">
                  <c:v>0.142593</c:v>
                </c:pt>
                <c:pt idx="95">
                  <c:v>0.140488</c:v>
                </c:pt>
                <c:pt idx="96">
                  <c:v>0.13870199999999999</c:v>
                </c:pt>
                <c:pt idx="97">
                  <c:v>0.136658</c:v>
                </c:pt>
                <c:pt idx="98">
                  <c:v>0.13439899999999999</c:v>
                </c:pt>
                <c:pt idx="99">
                  <c:v>0.132523</c:v>
                </c:pt>
                <c:pt idx="100">
                  <c:v>0.13070699999999999</c:v>
                </c:pt>
                <c:pt idx="101">
                  <c:v>0.12905900000000001</c:v>
                </c:pt>
                <c:pt idx="102">
                  <c:v>0.12764</c:v>
                </c:pt>
                <c:pt idx="103">
                  <c:v>0.12609899999999999</c:v>
                </c:pt>
                <c:pt idx="104">
                  <c:v>0.12501499999999999</c:v>
                </c:pt>
                <c:pt idx="105">
                  <c:v>0.122421</c:v>
                </c:pt>
                <c:pt idx="106">
                  <c:v>0.120911</c:v>
                </c:pt>
                <c:pt idx="107">
                  <c:v>0.120529</c:v>
                </c:pt>
                <c:pt idx="108">
                  <c:v>0.121201</c:v>
                </c:pt>
                <c:pt idx="109">
                  <c:v>0.119431</c:v>
                </c:pt>
                <c:pt idx="110">
                  <c:v>0.11969</c:v>
                </c:pt>
                <c:pt idx="111">
                  <c:v>0.119614</c:v>
                </c:pt>
                <c:pt idx="112">
                  <c:v>0.118149</c:v>
                </c:pt>
                <c:pt idx="113">
                  <c:v>0.119049</c:v>
                </c:pt>
                <c:pt idx="114">
                  <c:v>0.11770600000000001</c:v>
                </c:pt>
                <c:pt idx="115">
                  <c:v>0.117081</c:v>
                </c:pt>
                <c:pt idx="116">
                  <c:v>0.116837</c:v>
                </c:pt>
                <c:pt idx="117">
                  <c:v>0.117386</c:v>
                </c:pt>
                <c:pt idx="118">
                  <c:v>0.11663800000000001</c:v>
                </c:pt>
                <c:pt idx="119">
                  <c:v>0.116302</c:v>
                </c:pt>
                <c:pt idx="120">
                  <c:v>0.116714</c:v>
                </c:pt>
                <c:pt idx="121">
                  <c:v>0.11682099999999999</c:v>
                </c:pt>
                <c:pt idx="122">
                  <c:v>0.116364</c:v>
                </c:pt>
                <c:pt idx="123">
                  <c:v>0.116318</c:v>
                </c:pt>
                <c:pt idx="124">
                  <c:v>0.11589099999999999</c:v>
                </c:pt>
                <c:pt idx="125">
                  <c:v>0.115692</c:v>
                </c:pt>
                <c:pt idx="126">
                  <c:v>0.11573799999999999</c:v>
                </c:pt>
                <c:pt idx="127">
                  <c:v>0.114838</c:v>
                </c:pt>
                <c:pt idx="128">
                  <c:v>0.11390699999999999</c:v>
                </c:pt>
                <c:pt idx="129">
                  <c:v>0.112946</c:v>
                </c:pt>
                <c:pt idx="130">
                  <c:v>0.112793</c:v>
                </c:pt>
                <c:pt idx="131">
                  <c:v>0.112091</c:v>
                </c:pt>
                <c:pt idx="132">
                  <c:v>0.111954</c:v>
                </c:pt>
                <c:pt idx="133">
                  <c:v>0.11261</c:v>
                </c:pt>
                <c:pt idx="134">
                  <c:v>0.113556</c:v>
                </c:pt>
                <c:pt idx="135">
                  <c:v>0.11466999999999999</c:v>
                </c:pt>
                <c:pt idx="136">
                  <c:v>0.116074</c:v>
                </c:pt>
                <c:pt idx="137">
                  <c:v>0.116928</c:v>
                </c:pt>
                <c:pt idx="138">
                  <c:v>0.118729</c:v>
                </c:pt>
                <c:pt idx="139">
                  <c:v>0.120728</c:v>
                </c:pt>
                <c:pt idx="140">
                  <c:v>0.122253</c:v>
                </c:pt>
                <c:pt idx="141">
                  <c:v>0.124817</c:v>
                </c:pt>
                <c:pt idx="142">
                  <c:v>0.12707499999999999</c:v>
                </c:pt>
                <c:pt idx="143">
                  <c:v>0.12890599999999999</c:v>
                </c:pt>
                <c:pt idx="144">
                  <c:v>0.13125600000000001</c:v>
                </c:pt>
                <c:pt idx="145">
                  <c:v>0.134216</c:v>
                </c:pt>
                <c:pt idx="146">
                  <c:v>0.13619999999999999</c:v>
                </c:pt>
                <c:pt idx="147">
                  <c:v>0.138733</c:v>
                </c:pt>
                <c:pt idx="148">
                  <c:v>0.14138800000000001</c:v>
                </c:pt>
                <c:pt idx="149">
                  <c:v>0.144119</c:v>
                </c:pt>
                <c:pt idx="150">
                  <c:v>0.146255</c:v>
                </c:pt>
                <c:pt idx="151">
                  <c:v>0.14993300000000001</c:v>
                </c:pt>
                <c:pt idx="152">
                  <c:v>0.15342700000000001</c:v>
                </c:pt>
                <c:pt idx="153">
                  <c:v>0.15679899999999999</c:v>
                </c:pt>
                <c:pt idx="154">
                  <c:v>0.16006500000000001</c:v>
                </c:pt>
                <c:pt idx="155">
                  <c:v>0.162827</c:v>
                </c:pt>
                <c:pt idx="156">
                  <c:v>0.16653399999999999</c:v>
                </c:pt>
                <c:pt idx="157">
                  <c:v>0.16986100000000001</c:v>
                </c:pt>
                <c:pt idx="158">
                  <c:v>0.173203</c:v>
                </c:pt>
                <c:pt idx="159">
                  <c:v>0.17659</c:v>
                </c:pt>
                <c:pt idx="160">
                  <c:v>0.18042</c:v>
                </c:pt>
                <c:pt idx="161">
                  <c:v>0.184006</c:v>
                </c:pt>
                <c:pt idx="162">
                  <c:v>0.187302</c:v>
                </c:pt>
                <c:pt idx="163">
                  <c:v>0.19076499999999999</c:v>
                </c:pt>
                <c:pt idx="164">
                  <c:v>0.194244</c:v>
                </c:pt>
                <c:pt idx="165">
                  <c:v>0.19764699999999999</c:v>
                </c:pt>
                <c:pt idx="166">
                  <c:v>0.20060700000000001</c:v>
                </c:pt>
                <c:pt idx="167">
                  <c:v>0.20369000000000001</c:v>
                </c:pt>
                <c:pt idx="168">
                  <c:v>0.20686299999999999</c:v>
                </c:pt>
                <c:pt idx="169">
                  <c:v>0.20968600000000001</c:v>
                </c:pt>
                <c:pt idx="170">
                  <c:v>0.21269199999999999</c:v>
                </c:pt>
                <c:pt idx="171">
                  <c:v>0.21568300000000001</c:v>
                </c:pt>
                <c:pt idx="172">
                  <c:v>0.21756</c:v>
                </c:pt>
                <c:pt idx="173">
                  <c:v>0.22003200000000001</c:v>
                </c:pt>
                <c:pt idx="174">
                  <c:v>0.22201499999999999</c:v>
                </c:pt>
                <c:pt idx="175">
                  <c:v>0.22404499999999999</c:v>
                </c:pt>
                <c:pt idx="176">
                  <c:v>0.226074</c:v>
                </c:pt>
                <c:pt idx="177">
                  <c:v>0.22714200000000001</c:v>
                </c:pt>
                <c:pt idx="178">
                  <c:v>0.22817999999999999</c:v>
                </c:pt>
                <c:pt idx="179">
                  <c:v>0.22909499999999999</c:v>
                </c:pt>
                <c:pt idx="180">
                  <c:v>0.22966</c:v>
                </c:pt>
                <c:pt idx="181">
                  <c:v>0.23019400000000001</c:v>
                </c:pt>
                <c:pt idx="182">
                  <c:v>0.23063700000000001</c:v>
                </c:pt>
                <c:pt idx="183">
                  <c:v>0.23092699999999999</c:v>
                </c:pt>
                <c:pt idx="184">
                  <c:v>0.23077400000000001</c:v>
                </c:pt>
                <c:pt idx="185">
                  <c:v>0.23039200000000001</c:v>
                </c:pt>
                <c:pt idx="186">
                  <c:v>0.22978199999999999</c:v>
                </c:pt>
                <c:pt idx="187">
                  <c:v>0.229126</c:v>
                </c:pt>
                <c:pt idx="188">
                  <c:v>0.227798</c:v>
                </c:pt>
                <c:pt idx="189">
                  <c:v>0.226242</c:v>
                </c:pt>
                <c:pt idx="190">
                  <c:v>0.22425800000000001</c:v>
                </c:pt>
                <c:pt idx="191">
                  <c:v>0.22206100000000001</c:v>
                </c:pt>
                <c:pt idx="192">
                  <c:v>0.21920799999999999</c:v>
                </c:pt>
                <c:pt idx="193">
                  <c:v>0.215836</c:v>
                </c:pt>
                <c:pt idx="194">
                  <c:v>0.212418</c:v>
                </c:pt>
                <c:pt idx="195">
                  <c:v>0.20819099999999999</c:v>
                </c:pt>
                <c:pt idx="196">
                  <c:v>0.203842</c:v>
                </c:pt>
                <c:pt idx="197">
                  <c:v>0.19889799999999999</c:v>
                </c:pt>
                <c:pt idx="198">
                  <c:v>0.193741</c:v>
                </c:pt>
                <c:pt idx="199">
                  <c:v>0.188217</c:v>
                </c:pt>
                <c:pt idx="200">
                  <c:v>0.18215899999999999</c:v>
                </c:pt>
                <c:pt idx="201">
                  <c:v>0.176208</c:v>
                </c:pt>
                <c:pt idx="202">
                  <c:v>0.170013</c:v>
                </c:pt>
                <c:pt idx="203">
                  <c:v>0.163605</c:v>
                </c:pt>
                <c:pt idx="204">
                  <c:v>0.157471</c:v>
                </c:pt>
                <c:pt idx="205">
                  <c:v>0.151535</c:v>
                </c:pt>
                <c:pt idx="206">
                  <c:v>0.14543200000000001</c:v>
                </c:pt>
                <c:pt idx="207">
                  <c:v>0.13948099999999999</c:v>
                </c:pt>
                <c:pt idx="208">
                  <c:v>0.13398699999999999</c:v>
                </c:pt>
                <c:pt idx="209">
                  <c:v>0.128357</c:v>
                </c:pt>
                <c:pt idx="210">
                  <c:v>0.123154</c:v>
                </c:pt>
                <c:pt idx="211">
                  <c:v>0.118286</c:v>
                </c:pt>
                <c:pt idx="212">
                  <c:v>0.113785</c:v>
                </c:pt>
                <c:pt idx="213">
                  <c:v>0.109787</c:v>
                </c:pt>
                <c:pt idx="214">
                  <c:v>0.10609399999999999</c:v>
                </c:pt>
                <c:pt idx="215">
                  <c:v>0.10256999999999999</c:v>
                </c:pt>
                <c:pt idx="216">
                  <c:v>9.9364999999999995E-2</c:v>
                </c:pt>
                <c:pt idx="217">
                  <c:v>9.6435999999999994E-2</c:v>
                </c:pt>
                <c:pt idx="218">
                  <c:v>9.3613000000000002E-2</c:v>
                </c:pt>
                <c:pt idx="219">
                  <c:v>9.1247999999999996E-2</c:v>
                </c:pt>
                <c:pt idx="220">
                  <c:v>8.8988999999999999E-2</c:v>
                </c:pt>
                <c:pt idx="221">
                  <c:v>8.7082000000000007E-2</c:v>
                </c:pt>
                <c:pt idx="222">
                  <c:v>8.5433999999999996E-2</c:v>
                </c:pt>
                <c:pt idx="223">
                  <c:v>8.3817000000000003E-2</c:v>
                </c:pt>
                <c:pt idx="224">
                  <c:v>8.2366999999999996E-2</c:v>
                </c:pt>
                <c:pt idx="225">
                  <c:v>8.0962999999999993E-2</c:v>
                </c:pt>
                <c:pt idx="226">
                  <c:v>7.9987000000000003E-2</c:v>
                </c:pt>
                <c:pt idx="227">
                  <c:v>7.8949000000000005E-2</c:v>
                </c:pt>
                <c:pt idx="228">
                  <c:v>7.8109999999999999E-2</c:v>
                </c:pt>
                <c:pt idx="229">
                  <c:v>7.7408000000000005E-2</c:v>
                </c:pt>
                <c:pt idx="230">
                  <c:v>7.6674999999999993E-2</c:v>
                </c:pt>
                <c:pt idx="231">
                  <c:v>7.6035000000000005E-2</c:v>
                </c:pt>
                <c:pt idx="232">
                  <c:v>7.5454999999999994E-2</c:v>
                </c:pt>
                <c:pt idx="233">
                  <c:v>7.5149999999999995E-2</c:v>
                </c:pt>
                <c:pt idx="234">
                  <c:v>7.4814000000000005E-2</c:v>
                </c:pt>
                <c:pt idx="235">
                  <c:v>7.4448E-2</c:v>
                </c:pt>
                <c:pt idx="236">
                  <c:v>7.4080999999999994E-2</c:v>
                </c:pt>
                <c:pt idx="237">
                  <c:v>7.3837E-2</c:v>
                </c:pt>
                <c:pt idx="238">
                  <c:v>7.3623999999999995E-2</c:v>
                </c:pt>
                <c:pt idx="239">
                  <c:v>7.3380000000000001E-2</c:v>
                </c:pt>
                <c:pt idx="240">
                  <c:v>7.3211999999999999E-2</c:v>
                </c:pt>
                <c:pt idx="241">
                  <c:v>7.2968000000000005E-2</c:v>
                </c:pt>
                <c:pt idx="242">
                  <c:v>7.2753999999999999E-2</c:v>
                </c:pt>
                <c:pt idx="243">
                  <c:v>7.2753999999999999E-2</c:v>
                </c:pt>
                <c:pt idx="244">
                  <c:v>7.2707999999999995E-2</c:v>
                </c:pt>
                <c:pt idx="245">
                  <c:v>7.2495000000000004E-2</c:v>
                </c:pt>
                <c:pt idx="246">
                  <c:v>7.2342000000000004E-2</c:v>
                </c:pt>
                <c:pt idx="247">
                  <c:v>7.2159000000000001E-2</c:v>
                </c:pt>
                <c:pt idx="248">
                  <c:v>7.2097999999999995E-2</c:v>
                </c:pt>
                <c:pt idx="249">
                  <c:v>7.2021000000000002E-2</c:v>
                </c:pt>
                <c:pt idx="250">
                  <c:v>7.1854000000000001E-2</c:v>
                </c:pt>
                <c:pt idx="251">
                  <c:v>7.1762000000000006E-2</c:v>
                </c:pt>
                <c:pt idx="252">
                  <c:v>7.1716000000000002E-2</c:v>
                </c:pt>
                <c:pt idx="253">
                  <c:v>7.1579000000000004E-2</c:v>
                </c:pt>
                <c:pt idx="254">
                  <c:v>7.1426000000000003E-2</c:v>
                </c:pt>
                <c:pt idx="255">
                  <c:v>7.1411000000000002E-2</c:v>
                </c:pt>
                <c:pt idx="256">
                  <c:v>7.1319999999999995E-2</c:v>
                </c:pt>
                <c:pt idx="257">
                  <c:v>7.1274000000000004E-2</c:v>
                </c:pt>
                <c:pt idx="258">
                  <c:v>7.1106000000000003E-2</c:v>
                </c:pt>
                <c:pt idx="259">
                  <c:v>7.0999000000000007E-2</c:v>
                </c:pt>
                <c:pt idx="260">
                  <c:v>7.0816000000000004E-2</c:v>
                </c:pt>
                <c:pt idx="261">
                  <c:v>7.0861999999999994E-2</c:v>
                </c:pt>
                <c:pt idx="262">
                  <c:v>7.0786000000000002E-2</c:v>
                </c:pt>
                <c:pt idx="263">
                  <c:v>7.0723999999999995E-2</c:v>
                </c:pt>
                <c:pt idx="264">
                  <c:v>7.0571999999999996E-2</c:v>
                </c:pt>
                <c:pt idx="265">
                  <c:v>7.0556999999999995E-2</c:v>
                </c:pt>
                <c:pt idx="266">
                  <c:v>7.0465E-2</c:v>
                </c:pt>
                <c:pt idx="267">
                  <c:v>7.0343000000000003E-2</c:v>
                </c:pt>
                <c:pt idx="268">
                  <c:v>7.0221000000000006E-2</c:v>
                </c:pt>
                <c:pt idx="269">
                  <c:v>7.0098999999999995E-2</c:v>
                </c:pt>
                <c:pt idx="270">
                  <c:v>7.0007E-2</c:v>
                </c:pt>
                <c:pt idx="271">
                  <c:v>6.9916000000000006E-2</c:v>
                </c:pt>
                <c:pt idx="272">
                  <c:v>6.9916000000000006E-2</c:v>
                </c:pt>
                <c:pt idx="273">
                  <c:v>6.9808999999999996E-2</c:v>
                </c:pt>
                <c:pt idx="274">
                  <c:v>6.9778000000000007E-2</c:v>
                </c:pt>
                <c:pt idx="275">
                  <c:v>6.9611000000000006E-2</c:v>
                </c:pt>
                <c:pt idx="276">
                  <c:v>6.9518999999999997E-2</c:v>
                </c:pt>
                <c:pt idx="277">
                  <c:v>6.9503999999999996E-2</c:v>
                </c:pt>
                <c:pt idx="278">
                  <c:v>6.9320999999999994E-2</c:v>
                </c:pt>
                <c:pt idx="279">
                  <c:v>6.9397E-2</c:v>
                </c:pt>
                <c:pt idx="280">
                  <c:v>6.9350999999999996E-2</c:v>
                </c:pt>
                <c:pt idx="281">
                  <c:v>6.9182999999999995E-2</c:v>
                </c:pt>
                <c:pt idx="282">
                  <c:v>6.9077E-2</c:v>
                </c:pt>
                <c:pt idx="283">
                  <c:v>6.8970000000000004E-2</c:v>
                </c:pt>
                <c:pt idx="284">
                  <c:v>6.8832000000000004E-2</c:v>
                </c:pt>
                <c:pt idx="285">
                  <c:v>6.8802000000000002E-2</c:v>
                </c:pt>
                <c:pt idx="286">
                  <c:v>6.8787000000000001E-2</c:v>
                </c:pt>
                <c:pt idx="287">
                  <c:v>6.8557999999999994E-2</c:v>
                </c:pt>
                <c:pt idx="288">
                  <c:v>6.8450999999999998E-2</c:v>
                </c:pt>
                <c:pt idx="289">
                  <c:v>6.8450999999999998E-2</c:v>
                </c:pt>
                <c:pt idx="290">
                  <c:v>6.8297999999999998E-2</c:v>
                </c:pt>
                <c:pt idx="291">
                  <c:v>6.8192000000000003E-2</c:v>
                </c:pt>
                <c:pt idx="292">
                  <c:v>6.8192000000000003E-2</c:v>
                </c:pt>
                <c:pt idx="293">
                  <c:v>6.8129999999999996E-2</c:v>
                </c:pt>
                <c:pt idx="294">
                  <c:v>6.7977999999999997E-2</c:v>
                </c:pt>
                <c:pt idx="295">
                  <c:v>6.7932000000000006E-2</c:v>
                </c:pt>
                <c:pt idx="296">
                  <c:v>6.7824999999999996E-2</c:v>
                </c:pt>
                <c:pt idx="297">
                  <c:v>6.7734000000000003E-2</c:v>
                </c:pt>
                <c:pt idx="298">
                  <c:v>6.7687999999999998E-2</c:v>
                </c:pt>
                <c:pt idx="299">
                  <c:v>6.7672999999999997E-2</c:v>
                </c:pt>
                <c:pt idx="300">
                  <c:v>6.7672999999999997E-2</c:v>
                </c:pt>
                <c:pt idx="301">
                  <c:v>6.7687999999999998E-2</c:v>
                </c:pt>
                <c:pt idx="302">
                  <c:v>6.7596000000000003E-2</c:v>
                </c:pt>
                <c:pt idx="303">
                  <c:v>6.7534999999999998E-2</c:v>
                </c:pt>
                <c:pt idx="304">
                  <c:v>6.7459000000000005E-2</c:v>
                </c:pt>
                <c:pt idx="305">
                  <c:v>6.7336999999999994E-2</c:v>
                </c:pt>
                <c:pt idx="306">
                  <c:v>6.7322000000000007E-2</c:v>
                </c:pt>
                <c:pt idx="307">
                  <c:v>6.7291000000000004E-2</c:v>
                </c:pt>
                <c:pt idx="308">
                  <c:v>6.7307000000000006E-2</c:v>
                </c:pt>
                <c:pt idx="309">
                  <c:v>6.7183999999999994E-2</c:v>
                </c:pt>
                <c:pt idx="310">
                  <c:v>6.7108000000000001E-2</c:v>
                </c:pt>
                <c:pt idx="311">
                  <c:v>6.7001000000000005E-2</c:v>
                </c:pt>
                <c:pt idx="312">
                  <c:v>6.6909999999999997E-2</c:v>
                </c:pt>
                <c:pt idx="313">
                  <c:v>6.6803000000000001E-2</c:v>
                </c:pt>
                <c:pt idx="314">
                  <c:v>6.6818000000000002E-2</c:v>
                </c:pt>
                <c:pt idx="315">
                  <c:v>6.6788E-2</c:v>
                </c:pt>
                <c:pt idx="316">
                  <c:v>6.6635E-2</c:v>
                </c:pt>
                <c:pt idx="317">
                  <c:v>6.6558999999999993E-2</c:v>
                </c:pt>
                <c:pt idx="318">
                  <c:v>6.6558999999999993E-2</c:v>
                </c:pt>
                <c:pt idx="319">
                  <c:v>6.6483E-2</c:v>
                </c:pt>
                <c:pt idx="320">
                  <c:v>6.6483E-2</c:v>
                </c:pt>
                <c:pt idx="321">
                  <c:v>6.6406000000000007E-2</c:v>
                </c:pt>
                <c:pt idx="322">
                  <c:v>6.6314999999999999E-2</c:v>
                </c:pt>
                <c:pt idx="323">
                  <c:v>6.6253999999999993E-2</c:v>
                </c:pt>
                <c:pt idx="324">
                  <c:v>6.6161999999999999E-2</c:v>
                </c:pt>
                <c:pt idx="325">
                  <c:v>6.6131999999999996E-2</c:v>
                </c:pt>
                <c:pt idx="326">
                  <c:v>6.6100999999999993E-2</c:v>
                </c:pt>
                <c:pt idx="327">
                  <c:v>6.6115999999999994E-2</c:v>
                </c:pt>
                <c:pt idx="328">
                  <c:v>6.5963999999999995E-2</c:v>
                </c:pt>
                <c:pt idx="329">
                  <c:v>6.5856999999999999E-2</c:v>
                </c:pt>
                <c:pt idx="330">
                  <c:v>6.5795999999999993E-2</c:v>
                </c:pt>
                <c:pt idx="331">
                  <c:v>6.5720000000000001E-2</c:v>
                </c:pt>
                <c:pt idx="332">
                  <c:v>6.5598000000000004E-2</c:v>
                </c:pt>
                <c:pt idx="333">
                  <c:v>6.5520999999999996E-2</c:v>
                </c:pt>
                <c:pt idx="334">
                  <c:v>6.5460000000000004E-2</c:v>
                </c:pt>
                <c:pt idx="335">
                  <c:v>6.5368999999999997E-2</c:v>
                </c:pt>
                <c:pt idx="336">
                  <c:v>6.5308000000000005E-2</c:v>
                </c:pt>
                <c:pt idx="337">
                  <c:v>6.5230999999999997E-2</c:v>
                </c:pt>
                <c:pt idx="338">
                  <c:v>6.5170000000000006E-2</c:v>
                </c:pt>
                <c:pt idx="339">
                  <c:v>6.5140000000000003E-2</c:v>
                </c:pt>
                <c:pt idx="340">
                  <c:v>6.5109E-2</c:v>
                </c:pt>
                <c:pt idx="341">
                  <c:v>6.5062999999999996E-2</c:v>
                </c:pt>
                <c:pt idx="342">
                  <c:v>6.4972000000000002E-2</c:v>
                </c:pt>
                <c:pt idx="343">
                  <c:v>6.5002000000000004E-2</c:v>
                </c:pt>
                <c:pt idx="344">
                  <c:v>6.4865000000000006E-2</c:v>
                </c:pt>
                <c:pt idx="345">
                  <c:v>6.4788999999999999E-2</c:v>
                </c:pt>
                <c:pt idx="346">
                  <c:v>6.4667000000000002E-2</c:v>
                </c:pt>
                <c:pt idx="347">
                  <c:v>6.4529000000000003E-2</c:v>
                </c:pt>
                <c:pt idx="348">
                  <c:v>6.4484E-2</c:v>
                </c:pt>
                <c:pt idx="349">
                  <c:v>6.4452999999999996E-2</c:v>
                </c:pt>
                <c:pt idx="350">
                  <c:v>6.4422999999999994E-2</c:v>
                </c:pt>
                <c:pt idx="351">
                  <c:v>6.4377000000000004E-2</c:v>
                </c:pt>
                <c:pt idx="352">
                  <c:v>6.4330999999999999E-2</c:v>
                </c:pt>
                <c:pt idx="353">
                  <c:v>6.4300999999999997E-2</c:v>
                </c:pt>
                <c:pt idx="354">
                  <c:v>6.4240000000000005E-2</c:v>
                </c:pt>
                <c:pt idx="355">
                  <c:v>6.4240000000000005E-2</c:v>
                </c:pt>
                <c:pt idx="356">
                  <c:v>6.4102000000000006E-2</c:v>
                </c:pt>
                <c:pt idx="357">
                  <c:v>6.4087000000000005E-2</c:v>
                </c:pt>
                <c:pt idx="358">
                  <c:v>6.3994999999999996E-2</c:v>
                </c:pt>
                <c:pt idx="359">
                  <c:v>6.3872999999999999E-2</c:v>
                </c:pt>
                <c:pt idx="360">
                  <c:v>6.3811999999999994E-2</c:v>
                </c:pt>
                <c:pt idx="361">
                  <c:v>6.3751000000000002E-2</c:v>
                </c:pt>
                <c:pt idx="362">
                  <c:v>6.3721E-2</c:v>
                </c:pt>
                <c:pt idx="363">
                  <c:v>6.3568E-2</c:v>
                </c:pt>
                <c:pt idx="364">
                  <c:v>6.3537999999999997E-2</c:v>
                </c:pt>
                <c:pt idx="365">
                  <c:v>6.3416E-2</c:v>
                </c:pt>
                <c:pt idx="366">
                  <c:v>6.3309000000000004E-2</c:v>
                </c:pt>
                <c:pt idx="367">
                  <c:v>6.3231999999999997E-2</c:v>
                </c:pt>
                <c:pt idx="368">
                  <c:v>6.3126000000000002E-2</c:v>
                </c:pt>
                <c:pt idx="369">
                  <c:v>6.3064999999999996E-2</c:v>
                </c:pt>
                <c:pt idx="370">
                  <c:v>6.3034000000000007E-2</c:v>
                </c:pt>
                <c:pt idx="371">
                  <c:v>6.3034000000000007E-2</c:v>
                </c:pt>
                <c:pt idx="372">
                  <c:v>6.2942999999999999E-2</c:v>
                </c:pt>
                <c:pt idx="373">
                  <c:v>6.2789999999999999E-2</c:v>
                </c:pt>
                <c:pt idx="374">
                  <c:v>6.2851000000000004E-2</c:v>
                </c:pt>
                <c:pt idx="375">
                  <c:v>6.2758999999999995E-2</c:v>
                </c:pt>
                <c:pt idx="376">
                  <c:v>6.2698000000000004E-2</c:v>
                </c:pt>
                <c:pt idx="377">
                  <c:v>6.2591999999999995E-2</c:v>
                </c:pt>
                <c:pt idx="378">
                  <c:v>6.2531000000000003E-2</c:v>
                </c:pt>
                <c:pt idx="379">
                  <c:v>6.2576000000000007E-2</c:v>
                </c:pt>
                <c:pt idx="380">
                  <c:v>6.2454000000000003E-2</c:v>
                </c:pt>
                <c:pt idx="381">
                  <c:v>6.2378000000000003E-2</c:v>
                </c:pt>
                <c:pt idx="382">
                  <c:v>6.2331999999999999E-2</c:v>
                </c:pt>
                <c:pt idx="383">
                  <c:v>6.2286000000000001E-2</c:v>
                </c:pt>
                <c:pt idx="384">
                  <c:v>6.2271E-2</c:v>
                </c:pt>
                <c:pt idx="385">
                  <c:v>6.2240999999999998E-2</c:v>
                </c:pt>
                <c:pt idx="386">
                  <c:v>6.2179999999999999E-2</c:v>
                </c:pt>
                <c:pt idx="387">
                  <c:v>6.2073000000000003E-2</c:v>
                </c:pt>
                <c:pt idx="388">
                  <c:v>6.2011999999999998E-2</c:v>
                </c:pt>
                <c:pt idx="389">
                  <c:v>6.1981000000000001E-2</c:v>
                </c:pt>
                <c:pt idx="390">
                  <c:v>6.1890000000000001E-2</c:v>
                </c:pt>
                <c:pt idx="391">
                  <c:v>6.1829000000000002E-2</c:v>
                </c:pt>
                <c:pt idx="392">
                  <c:v>6.1737E-2</c:v>
                </c:pt>
                <c:pt idx="393">
                  <c:v>6.1691000000000003E-2</c:v>
                </c:pt>
                <c:pt idx="394">
                  <c:v>6.1721999999999999E-2</c:v>
                </c:pt>
                <c:pt idx="395">
                  <c:v>6.1676000000000002E-2</c:v>
                </c:pt>
                <c:pt idx="396">
                  <c:v>6.1462000000000003E-2</c:v>
                </c:pt>
                <c:pt idx="397">
                  <c:v>6.1447000000000002E-2</c:v>
                </c:pt>
                <c:pt idx="398">
                  <c:v>6.1447000000000002E-2</c:v>
                </c:pt>
                <c:pt idx="399">
                  <c:v>6.1324999999999998E-2</c:v>
                </c:pt>
                <c:pt idx="400">
                  <c:v>6.1295000000000002E-2</c:v>
                </c:pt>
                <c:pt idx="401">
                  <c:v>6.1171999999999997E-2</c:v>
                </c:pt>
                <c:pt idx="402">
                  <c:v>6.1095999999999998E-2</c:v>
                </c:pt>
                <c:pt idx="403">
                  <c:v>6.1034999999999999E-2</c:v>
                </c:pt>
                <c:pt idx="404">
                  <c:v>6.1004999999999997E-2</c:v>
                </c:pt>
                <c:pt idx="405">
                  <c:v>6.0928000000000003E-2</c:v>
                </c:pt>
                <c:pt idx="406">
                  <c:v>6.0928000000000003E-2</c:v>
                </c:pt>
                <c:pt idx="407">
                  <c:v>6.0866999999999997E-2</c:v>
                </c:pt>
                <c:pt idx="408">
                  <c:v>6.0928000000000003E-2</c:v>
                </c:pt>
                <c:pt idx="409">
                  <c:v>6.0790999999999998E-2</c:v>
                </c:pt>
                <c:pt idx="410">
                  <c:v>6.0729999999999999E-2</c:v>
                </c:pt>
                <c:pt idx="411">
                  <c:v>6.0684000000000002E-2</c:v>
                </c:pt>
                <c:pt idx="412">
                  <c:v>6.0684000000000002E-2</c:v>
                </c:pt>
                <c:pt idx="413">
                  <c:v>6.0623000000000003E-2</c:v>
                </c:pt>
                <c:pt idx="414">
                  <c:v>6.0623000000000003E-2</c:v>
                </c:pt>
                <c:pt idx="415">
                  <c:v>6.0576999999999999E-2</c:v>
                </c:pt>
                <c:pt idx="416">
                  <c:v>6.0576999999999999E-2</c:v>
                </c:pt>
                <c:pt idx="417">
                  <c:v>6.0576999999999999E-2</c:v>
                </c:pt>
                <c:pt idx="418">
                  <c:v>6.0516E-2</c:v>
                </c:pt>
                <c:pt idx="419">
                  <c:v>6.0394000000000003E-2</c:v>
                </c:pt>
                <c:pt idx="420">
                  <c:v>6.0379000000000002E-2</c:v>
                </c:pt>
                <c:pt idx="421">
                  <c:v>6.0287E-2</c:v>
                </c:pt>
                <c:pt idx="422">
                  <c:v>6.0271999999999999E-2</c:v>
                </c:pt>
                <c:pt idx="423">
                  <c:v>6.0303000000000002E-2</c:v>
                </c:pt>
                <c:pt idx="424">
                  <c:v>6.0180999999999998E-2</c:v>
                </c:pt>
                <c:pt idx="425">
                  <c:v>6.0135000000000001E-2</c:v>
                </c:pt>
                <c:pt idx="426">
                  <c:v>6.0135000000000001E-2</c:v>
                </c:pt>
                <c:pt idx="427">
                  <c:v>6.0150000000000002E-2</c:v>
                </c:pt>
                <c:pt idx="428">
                  <c:v>6.0135000000000001E-2</c:v>
                </c:pt>
                <c:pt idx="429">
                  <c:v>6.0074000000000002E-2</c:v>
                </c:pt>
                <c:pt idx="430">
                  <c:v>6.0088999999999997E-2</c:v>
                </c:pt>
                <c:pt idx="431">
                  <c:v>6.0074000000000002E-2</c:v>
                </c:pt>
                <c:pt idx="432">
                  <c:v>5.9982000000000001E-2</c:v>
                </c:pt>
                <c:pt idx="433">
                  <c:v>6.0042999999999999E-2</c:v>
                </c:pt>
                <c:pt idx="434">
                  <c:v>6.0059000000000001E-2</c:v>
                </c:pt>
                <c:pt idx="435">
                  <c:v>6.0135000000000001E-2</c:v>
                </c:pt>
                <c:pt idx="436">
                  <c:v>6.0303000000000002E-2</c:v>
                </c:pt>
                <c:pt idx="437">
                  <c:v>6.0332999999999998E-2</c:v>
                </c:pt>
                <c:pt idx="438">
                  <c:v>6.0409999999999998E-2</c:v>
                </c:pt>
                <c:pt idx="439">
                  <c:v>6.0576999999999999E-2</c:v>
                </c:pt>
                <c:pt idx="440">
                  <c:v>6.0516E-2</c:v>
                </c:pt>
                <c:pt idx="441">
                  <c:v>6.0485999999999998E-2</c:v>
                </c:pt>
                <c:pt idx="442">
                  <c:v>6.0470999999999997E-2</c:v>
                </c:pt>
                <c:pt idx="443">
                  <c:v>6.0500999999999999E-2</c:v>
                </c:pt>
                <c:pt idx="444">
                  <c:v>6.0332999999999998E-2</c:v>
                </c:pt>
                <c:pt idx="445">
                  <c:v>6.0180999999999998E-2</c:v>
                </c:pt>
                <c:pt idx="446">
                  <c:v>5.9874999999999998E-2</c:v>
                </c:pt>
                <c:pt idx="447">
                  <c:v>5.9631000000000003E-2</c:v>
                </c:pt>
                <c:pt idx="448">
                  <c:v>5.9433E-2</c:v>
                </c:pt>
                <c:pt idx="449">
                  <c:v>5.9296000000000001E-2</c:v>
                </c:pt>
                <c:pt idx="450">
                  <c:v>5.9173999999999997E-2</c:v>
                </c:pt>
                <c:pt idx="451">
                  <c:v>5.9128E-2</c:v>
                </c:pt>
                <c:pt idx="452">
                  <c:v>5.9067000000000001E-2</c:v>
                </c:pt>
                <c:pt idx="453">
                  <c:v>5.8990000000000001E-2</c:v>
                </c:pt>
                <c:pt idx="454">
                  <c:v>5.8883999999999999E-2</c:v>
                </c:pt>
                <c:pt idx="455">
                  <c:v>5.8975E-2</c:v>
                </c:pt>
                <c:pt idx="456">
                  <c:v>5.8975E-2</c:v>
                </c:pt>
                <c:pt idx="457">
                  <c:v>5.8944999999999997E-2</c:v>
                </c:pt>
                <c:pt idx="458">
                  <c:v>5.9052E-2</c:v>
                </c:pt>
                <c:pt idx="459">
                  <c:v>5.9035999999999998E-2</c:v>
                </c:pt>
                <c:pt idx="460">
                  <c:v>5.8975E-2</c:v>
                </c:pt>
                <c:pt idx="461">
                  <c:v>5.8929000000000002E-2</c:v>
                </c:pt>
                <c:pt idx="462">
                  <c:v>5.8853000000000003E-2</c:v>
                </c:pt>
                <c:pt idx="463">
                  <c:v>5.8806999999999998E-2</c:v>
                </c:pt>
                <c:pt idx="464">
                  <c:v>5.8791999999999997E-2</c:v>
                </c:pt>
                <c:pt idx="465">
                  <c:v>5.8806999999999998E-2</c:v>
                </c:pt>
                <c:pt idx="466">
                  <c:v>5.8685000000000001E-2</c:v>
                </c:pt>
                <c:pt idx="467">
                  <c:v>5.8624000000000002E-2</c:v>
                </c:pt>
                <c:pt idx="468">
                  <c:v>5.8562999999999997E-2</c:v>
                </c:pt>
                <c:pt idx="469">
                  <c:v>5.8548000000000003E-2</c:v>
                </c:pt>
                <c:pt idx="470">
                  <c:v>5.8441E-2</c:v>
                </c:pt>
                <c:pt idx="471">
                  <c:v>5.8410999999999998E-2</c:v>
                </c:pt>
                <c:pt idx="472">
                  <c:v>5.8365E-2</c:v>
                </c:pt>
                <c:pt idx="473">
                  <c:v>5.8333999999999997E-2</c:v>
                </c:pt>
                <c:pt idx="474">
                  <c:v>5.8243000000000003E-2</c:v>
                </c:pt>
                <c:pt idx="475">
                  <c:v>5.8181999999999998E-2</c:v>
                </c:pt>
                <c:pt idx="476">
                  <c:v>5.8104999999999997E-2</c:v>
                </c:pt>
                <c:pt idx="477">
                  <c:v>5.8028999999999997E-2</c:v>
                </c:pt>
                <c:pt idx="478">
                  <c:v>5.7952999999999998E-2</c:v>
                </c:pt>
                <c:pt idx="479">
                  <c:v>5.7861000000000003E-2</c:v>
                </c:pt>
                <c:pt idx="480">
                  <c:v>5.7846000000000002E-2</c:v>
                </c:pt>
                <c:pt idx="481">
                  <c:v>5.7815999999999999E-2</c:v>
                </c:pt>
                <c:pt idx="482">
                  <c:v>5.7723999999999998E-2</c:v>
                </c:pt>
                <c:pt idx="483">
                  <c:v>5.7678E-2</c:v>
                </c:pt>
                <c:pt idx="484">
                  <c:v>5.7709000000000003E-2</c:v>
                </c:pt>
                <c:pt idx="485">
                  <c:v>5.7693000000000001E-2</c:v>
                </c:pt>
                <c:pt idx="486">
                  <c:v>5.7662999999999999E-2</c:v>
                </c:pt>
                <c:pt idx="487">
                  <c:v>5.7541000000000002E-2</c:v>
                </c:pt>
                <c:pt idx="488">
                  <c:v>5.7494999999999997E-2</c:v>
                </c:pt>
                <c:pt idx="489">
                  <c:v>5.7494999999999997E-2</c:v>
                </c:pt>
                <c:pt idx="490">
                  <c:v>5.7526000000000001E-2</c:v>
                </c:pt>
                <c:pt idx="491">
                  <c:v>5.7465000000000002E-2</c:v>
                </c:pt>
                <c:pt idx="492">
                  <c:v>5.7357999999999999E-2</c:v>
                </c:pt>
                <c:pt idx="493">
                  <c:v>5.7297000000000001E-2</c:v>
                </c:pt>
                <c:pt idx="494">
                  <c:v>5.7251000000000003E-2</c:v>
                </c:pt>
                <c:pt idx="495">
                  <c:v>5.7280999999999999E-2</c:v>
                </c:pt>
                <c:pt idx="496">
                  <c:v>5.7236000000000002E-2</c:v>
                </c:pt>
                <c:pt idx="497">
                  <c:v>5.7159000000000001E-2</c:v>
                </c:pt>
                <c:pt idx="498">
                  <c:v>5.7174999999999997E-2</c:v>
                </c:pt>
                <c:pt idx="499">
                  <c:v>5.7113999999999998E-2</c:v>
                </c:pt>
                <c:pt idx="500">
                  <c:v>5.7098000000000003E-2</c:v>
                </c:pt>
                <c:pt idx="501">
                  <c:v>5.7068000000000001E-2</c:v>
                </c:pt>
                <c:pt idx="502">
                  <c:v>5.7007000000000002E-2</c:v>
                </c:pt>
                <c:pt idx="503">
                  <c:v>5.6992000000000001E-2</c:v>
                </c:pt>
                <c:pt idx="504">
                  <c:v>5.6931000000000002E-2</c:v>
                </c:pt>
                <c:pt idx="505">
                  <c:v>5.6899999999999999E-2</c:v>
                </c:pt>
                <c:pt idx="506">
                  <c:v>5.6884999999999998E-2</c:v>
                </c:pt>
                <c:pt idx="507">
                  <c:v>5.6899999999999999E-2</c:v>
                </c:pt>
                <c:pt idx="508">
                  <c:v>5.6869999999999997E-2</c:v>
                </c:pt>
                <c:pt idx="509">
                  <c:v>5.6854000000000002E-2</c:v>
                </c:pt>
                <c:pt idx="510">
                  <c:v>5.6824E-2</c:v>
                </c:pt>
              </c:numCache>
            </c:numRef>
          </c:yVal>
          <c:smooth val="1"/>
          <c:extLst>
            <c:ext xmlns:c16="http://schemas.microsoft.com/office/drawing/2014/chart" uri="{C3380CC4-5D6E-409C-BE32-E72D297353CC}">
              <c16:uniqueId val="{00000001-3FAF-4CBF-82DD-E60AB52489B3}"/>
            </c:ext>
          </c:extLst>
        </c:ser>
        <c:ser>
          <c:idx val="3"/>
          <c:order val="2"/>
          <c:tx>
            <c:strRef>
              <c:f>AZD!$A$1</c:f>
              <c:strCache>
                <c:ptCount val="1"/>
                <c:pt idx="0">
                  <c:v>AZD2014 (11 μM) DMSO Abs</c:v>
                </c:pt>
              </c:strCache>
            </c:strRef>
          </c:tx>
          <c:marker>
            <c:symbol val="none"/>
          </c:marker>
          <c:xVal>
            <c:numRef>
              <c:f>AZD!$A$3:$A$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AZD!$B$3:$B$513</c:f>
              <c:numCache>
                <c:formatCode>General</c:formatCode>
                <c:ptCount val="511"/>
                <c:pt idx="0">
                  <c:v>3.9528810000000001</c:v>
                </c:pt>
                <c:pt idx="1">
                  <c:v>3.8833920000000002</c:v>
                </c:pt>
                <c:pt idx="2">
                  <c:v>3.873138</c:v>
                </c:pt>
                <c:pt idx="3">
                  <c:v>3.6944430000000001</c:v>
                </c:pt>
                <c:pt idx="4">
                  <c:v>3.8993229999999999</c:v>
                </c:pt>
                <c:pt idx="5">
                  <c:v>3.8498839999999999</c:v>
                </c:pt>
                <c:pt idx="6">
                  <c:v>3.9609070000000002</c:v>
                </c:pt>
                <c:pt idx="7">
                  <c:v>3.89357</c:v>
                </c:pt>
                <c:pt idx="8">
                  <c:v>3.937103</c:v>
                </c:pt>
                <c:pt idx="9">
                  <c:v>3.9412229999999999</c:v>
                </c:pt>
                <c:pt idx="10">
                  <c:v>3.8478850000000002</c:v>
                </c:pt>
                <c:pt idx="11">
                  <c:v>3.945068</c:v>
                </c:pt>
                <c:pt idx="12">
                  <c:v>3.9948269999999999</c:v>
                </c:pt>
                <c:pt idx="13">
                  <c:v>3.9953609999999999</c:v>
                </c:pt>
                <c:pt idx="14">
                  <c:v>3.9667819999999998</c:v>
                </c:pt>
                <c:pt idx="15">
                  <c:v>3.9974980000000002</c:v>
                </c:pt>
                <c:pt idx="16">
                  <c:v>3.9945369999999998</c:v>
                </c:pt>
                <c:pt idx="17">
                  <c:v>3.985916</c:v>
                </c:pt>
                <c:pt idx="18">
                  <c:v>4</c:v>
                </c:pt>
                <c:pt idx="19">
                  <c:v>3.9588619999999999</c:v>
                </c:pt>
                <c:pt idx="20">
                  <c:v>3.9895170000000002</c:v>
                </c:pt>
                <c:pt idx="21">
                  <c:v>3.9994049999999999</c:v>
                </c:pt>
                <c:pt idx="22">
                  <c:v>3.96109</c:v>
                </c:pt>
                <c:pt idx="23">
                  <c:v>3.9041600000000001</c:v>
                </c:pt>
                <c:pt idx="24">
                  <c:v>4</c:v>
                </c:pt>
                <c:pt idx="25">
                  <c:v>4</c:v>
                </c:pt>
                <c:pt idx="26">
                  <c:v>3.9821010000000001</c:v>
                </c:pt>
                <c:pt idx="27">
                  <c:v>4</c:v>
                </c:pt>
                <c:pt idx="28">
                  <c:v>3.9880979999999999</c:v>
                </c:pt>
                <c:pt idx="29">
                  <c:v>4</c:v>
                </c:pt>
                <c:pt idx="30">
                  <c:v>4</c:v>
                </c:pt>
                <c:pt idx="31">
                  <c:v>3.9961549999999999</c:v>
                </c:pt>
                <c:pt idx="32">
                  <c:v>3.9971619999999999</c:v>
                </c:pt>
                <c:pt idx="33">
                  <c:v>4</c:v>
                </c:pt>
                <c:pt idx="34">
                  <c:v>3.9983520000000001</c:v>
                </c:pt>
                <c:pt idx="35">
                  <c:v>3.9826969999999999</c:v>
                </c:pt>
                <c:pt idx="36">
                  <c:v>4</c:v>
                </c:pt>
                <c:pt idx="37">
                  <c:v>3.9994049999999999</c:v>
                </c:pt>
                <c:pt idx="38">
                  <c:v>3.9923860000000002</c:v>
                </c:pt>
                <c:pt idx="39">
                  <c:v>4</c:v>
                </c:pt>
                <c:pt idx="40">
                  <c:v>4</c:v>
                </c:pt>
                <c:pt idx="41">
                  <c:v>4</c:v>
                </c:pt>
                <c:pt idx="42">
                  <c:v>4</c:v>
                </c:pt>
                <c:pt idx="43">
                  <c:v>3.9928279999999998</c:v>
                </c:pt>
                <c:pt idx="44">
                  <c:v>4</c:v>
                </c:pt>
                <c:pt idx="45">
                  <c:v>3.9999389999999999</c:v>
                </c:pt>
                <c:pt idx="46">
                  <c:v>3.9958499999999999</c:v>
                </c:pt>
                <c:pt idx="47">
                  <c:v>3.994186</c:v>
                </c:pt>
                <c:pt idx="48">
                  <c:v>4</c:v>
                </c:pt>
                <c:pt idx="49">
                  <c:v>3.9909819999999998</c:v>
                </c:pt>
                <c:pt idx="50">
                  <c:v>4</c:v>
                </c:pt>
                <c:pt idx="51">
                  <c:v>4</c:v>
                </c:pt>
                <c:pt idx="52">
                  <c:v>3.999908</c:v>
                </c:pt>
                <c:pt idx="53">
                  <c:v>3.9955750000000001</c:v>
                </c:pt>
                <c:pt idx="54">
                  <c:v>3.9974370000000001</c:v>
                </c:pt>
                <c:pt idx="55">
                  <c:v>4</c:v>
                </c:pt>
                <c:pt idx="56">
                  <c:v>3.9564210000000002</c:v>
                </c:pt>
                <c:pt idx="57">
                  <c:v>4</c:v>
                </c:pt>
                <c:pt idx="58">
                  <c:v>3.9988100000000002</c:v>
                </c:pt>
                <c:pt idx="59">
                  <c:v>4</c:v>
                </c:pt>
                <c:pt idx="60">
                  <c:v>4</c:v>
                </c:pt>
                <c:pt idx="61">
                  <c:v>3.9957280000000002</c:v>
                </c:pt>
                <c:pt idx="62">
                  <c:v>3.9577789999999999</c:v>
                </c:pt>
                <c:pt idx="63">
                  <c:v>3.999161</c:v>
                </c:pt>
                <c:pt idx="64">
                  <c:v>3.9831699999999999</c:v>
                </c:pt>
                <c:pt idx="65">
                  <c:v>3.897491</c:v>
                </c:pt>
                <c:pt idx="66">
                  <c:v>3.4658509999999998</c:v>
                </c:pt>
                <c:pt idx="67">
                  <c:v>2.9047999999999998</c:v>
                </c:pt>
                <c:pt idx="68">
                  <c:v>2.5304720000000001</c:v>
                </c:pt>
                <c:pt idx="69">
                  <c:v>2.209946</c:v>
                </c:pt>
                <c:pt idx="70">
                  <c:v>1.936844</c:v>
                </c:pt>
                <c:pt idx="71">
                  <c:v>1.7222440000000001</c:v>
                </c:pt>
                <c:pt idx="72">
                  <c:v>1.541809</c:v>
                </c:pt>
                <c:pt idx="73">
                  <c:v>1.3888240000000001</c:v>
                </c:pt>
                <c:pt idx="74">
                  <c:v>1.2581329999999999</c:v>
                </c:pt>
                <c:pt idx="75">
                  <c:v>1.1499630000000001</c:v>
                </c:pt>
                <c:pt idx="76">
                  <c:v>1.060684</c:v>
                </c:pt>
                <c:pt idx="77">
                  <c:v>0.98623700000000003</c:v>
                </c:pt>
                <c:pt idx="78">
                  <c:v>0.92517099999999997</c:v>
                </c:pt>
                <c:pt idx="79">
                  <c:v>0.87559500000000001</c:v>
                </c:pt>
                <c:pt idx="80">
                  <c:v>0.83688399999999996</c:v>
                </c:pt>
                <c:pt idx="81">
                  <c:v>0.80549599999999999</c:v>
                </c:pt>
                <c:pt idx="82">
                  <c:v>0.78167699999999996</c:v>
                </c:pt>
                <c:pt idx="83">
                  <c:v>0.76362600000000003</c:v>
                </c:pt>
                <c:pt idx="84">
                  <c:v>0.74888600000000005</c:v>
                </c:pt>
                <c:pt idx="85">
                  <c:v>0.73799099999999995</c:v>
                </c:pt>
                <c:pt idx="86">
                  <c:v>0.72871399999999997</c:v>
                </c:pt>
                <c:pt idx="87">
                  <c:v>0.72111499999999995</c:v>
                </c:pt>
                <c:pt idx="88">
                  <c:v>0.71447799999999995</c:v>
                </c:pt>
                <c:pt idx="89">
                  <c:v>0.70852700000000002</c:v>
                </c:pt>
                <c:pt idx="90">
                  <c:v>0.70347599999999999</c:v>
                </c:pt>
                <c:pt idx="91">
                  <c:v>0.69825700000000002</c:v>
                </c:pt>
                <c:pt idx="92">
                  <c:v>0.69238299999999997</c:v>
                </c:pt>
                <c:pt idx="93">
                  <c:v>0.68646200000000002</c:v>
                </c:pt>
                <c:pt idx="94">
                  <c:v>0.67903100000000005</c:v>
                </c:pt>
                <c:pt idx="95">
                  <c:v>0.67056300000000002</c:v>
                </c:pt>
                <c:pt idx="96">
                  <c:v>0.66062900000000002</c:v>
                </c:pt>
                <c:pt idx="97">
                  <c:v>0.64874299999999996</c:v>
                </c:pt>
                <c:pt idx="98">
                  <c:v>0.63456699999999999</c:v>
                </c:pt>
                <c:pt idx="99">
                  <c:v>0.619919</c:v>
                </c:pt>
                <c:pt idx="100">
                  <c:v>0.60264600000000002</c:v>
                </c:pt>
                <c:pt idx="101">
                  <c:v>0.58399999999999996</c:v>
                </c:pt>
                <c:pt idx="102">
                  <c:v>0.56552100000000005</c:v>
                </c:pt>
                <c:pt idx="103">
                  <c:v>0.54698199999999997</c:v>
                </c:pt>
                <c:pt idx="104">
                  <c:v>0.52827500000000005</c:v>
                </c:pt>
                <c:pt idx="105">
                  <c:v>0.49163800000000002</c:v>
                </c:pt>
                <c:pt idx="106">
                  <c:v>0.45419300000000001</c:v>
                </c:pt>
                <c:pt idx="107">
                  <c:v>0.43284600000000001</c:v>
                </c:pt>
                <c:pt idx="108">
                  <c:v>0.41288799999999998</c:v>
                </c:pt>
                <c:pt idx="109">
                  <c:v>0.39343299999999998</c:v>
                </c:pt>
                <c:pt idx="110">
                  <c:v>0.37323000000000001</c:v>
                </c:pt>
                <c:pt idx="111">
                  <c:v>0.35359200000000002</c:v>
                </c:pt>
                <c:pt idx="112">
                  <c:v>0.33456399999999997</c:v>
                </c:pt>
                <c:pt idx="113">
                  <c:v>0.31718400000000002</c:v>
                </c:pt>
                <c:pt idx="114">
                  <c:v>0.301819</c:v>
                </c:pt>
                <c:pt idx="115">
                  <c:v>0.288773</c:v>
                </c:pt>
                <c:pt idx="116">
                  <c:v>0.28131099999999998</c:v>
                </c:pt>
                <c:pt idx="117">
                  <c:v>0.269287</c:v>
                </c:pt>
                <c:pt idx="118">
                  <c:v>0.25535600000000003</c:v>
                </c:pt>
                <c:pt idx="119">
                  <c:v>0.24382000000000001</c:v>
                </c:pt>
                <c:pt idx="120">
                  <c:v>0.23172000000000001</c:v>
                </c:pt>
                <c:pt idx="121">
                  <c:v>0.22170999999999999</c:v>
                </c:pt>
                <c:pt idx="122">
                  <c:v>0.212204</c:v>
                </c:pt>
                <c:pt idx="123">
                  <c:v>0.20369000000000001</c:v>
                </c:pt>
                <c:pt idx="124">
                  <c:v>0.19575500000000001</c:v>
                </c:pt>
                <c:pt idx="125">
                  <c:v>0.18873599999999999</c:v>
                </c:pt>
                <c:pt idx="126">
                  <c:v>0.18379200000000001</c:v>
                </c:pt>
                <c:pt idx="127">
                  <c:v>0.178452</c:v>
                </c:pt>
                <c:pt idx="128">
                  <c:v>0.17346200000000001</c:v>
                </c:pt>
                <c:pt idx="129">
                  <c:v>0.167877</c:v>
                </c:pt>
                <c:pt idx="130">
                  <c:v>0.16497800000000001</c:v>
                </c:pt>
                <c:pt idx="131">
                  <c:v>0.160385</c:v>
                </c:pt>
                <c:pt idx="132">
                  <c:v>0.15623500000000001</c:v>
                </c:pt>
                <c:pt idx="133">
                  <c:v>0.15205399999999999</c:v>
                </c:pt>
                <c:pt idx="134">
                  <c:v>0.14949000000000001</c:v>
                </c:pt>
                <c:pt idx="135">
                  <c:v>0.14530899999999999</c:v>
                </c:pt>
                <c:pt idx="136">
                  <c:v>0.142288</c:v>
                </c:pt>
                <c:pt idx="137">
                  <c:v>0.13903799999999999</c:v>
                </c:pt>
                <c:pt idx="138">
                  <c:v>0.13636799999999999</c:v>
                </c:pt>
                <c:pt idx="139">
                  <c:v>0.13398699999999999</c:v>
                </c:pt>
                <c:pt idx="140">
                  <c:v>0.130997</c:v>
                </c:pt>
                <c:pt idx="141">
                  <c:v>0.12875400000000001</c:v>
                </c:pt>
                <c:pt idx="142">
                  <c:v>0.12619</c:v>
                </c:pt>
                <c:pt idx="143">
                  <c:v>0.123947</c:v>
                </c:pt>
                <c:pt idx="144">
                  <c:v>0.12207</c:v>
                </c:pt>
                <c:pt idx="145">
                  <c:v>0.12034599999999999</c:v>
                </c:pt>
                <c:pt idx="146">
                  <c:v>0.11831700000000001</c:v>
                </c:pt>
                <c:pt idx="147">
                  <c:v>0.116852</c:v>
                </c:pt>
                <c:pt idx="148">
                  <c:v>0.116074</c:v>
                </c:pt>
                <c:pt idx="149">
                  <c:v>0.114578</c:v>
                </c:pt>
                <c:pt idx="150">
                  <c:v>0.112579</c:v>
                </c:pt>
                <c:pt idx="151">
                  <c:v>0.111862</c:v>
                </c:pt>
                <c:pt idx="152">
                  <c:v>0.111359</c:v>
                </c:pt>
                <c:pt idx="153">
                  <c:v>0.110245</c:v>
                </c:pt>
                <c:pt idx="154">
                  <c:v>0.109421</c:v>
                </c:pt>
                <c:pt idx="155">
                  <c:v>0.108612</c:v>
                </c:pt>
                <c:pt idx="156">
                  <c:v>0.10849</c:v>
                </c:pt>
                <c:pt idx="157">
                  <c:v>0.108246</c:v>
                </c:pt>
                <c:pt idx="158">
                  <c:v>0.109116</c:v>
                </c:pt>
                <c:pt idx="159">
                  <c:v>0.109268</c:v>
                </c:pt>
                <c:pt idx="160">
                  <c:v>0.109879</c:v>
                </c:pt>
                <c:pt idx="161">
                  <c:v>0.110306</c:v>
                </c:pt>
                <c:pt idx="162">
                  <c:v>0.11082500000000001</c:v>
                </c:pt>
                <c:pt idx="163">
                  <c:v>0.112106</c:v>
                </c:pt>
                <c:pt idx="164">
                  <c:v>0.11299099999999999</c:v>
                </c:pt>
                <c:pt idx="165">
                  <c:v>0.113953</c:v>
                </c:pt>
                <c:pt idx="166">
                  <c:v>0.115372</c:v>
                </c:pt>
                <c:pt idx="167">
                  <c:v>0.116882</c:v>
                </c:pt>
                <c:pt idx="168">
                  <c:v>0.118149</c:v>
                </c:pt>
                <c:pt idx="169">
                  <c:v>0.12004099999999999</c:v>
                </c:pt>
                <c:pt idx="170">
                  <c:v>0.12178</c:v>
                </c:pt>
                <c:pt idx="171">
                  <c:v>0.123322</c:v>
                </c:pt>
                <c:pt idx="172">
                  <c:v>0.125275</c:v>
                </c:pt>
                <c:pt idx="173">
                  <c:v>0.12724299999999999</c:v>
                </c:pt>
                <c:pt idx="174">
                  <c:v>0.12921099999999999</c:v>
                </c:pt>
                <c:pt idx="175">
                  <c:v>0.13139300000000001</c:v>
                </c:pt>
                <c:pt idx="176">
                  <c:v>0.13372800000000001</c:v>
                </c:pt>
                <c:pt idx="177">
                  <c:v>0.13588</c:v>
                </c:pt>
                <c:pt idx="178">
                  <c:v>0.13789399999999999</c:v>
                </c:pt>
                <c:pt idx="179">
                  <c:v>0.140488</c:v>
                </c:pt>
                <c:pt idx="180">
                  <c:v>0.14274600000000001</c:v>
                </c:pt>
                <c:pt idx="181">
                  <c:v>0.144867</c:v>
                </c:pt>
                <c:pt idx="182">
                  <c:v>0.14718600000000001</c:v>
                </c:pt>
                <c:pt idx="183">
                  <c:v>0.14929200000000001</c:v>
                </c:pt>
                <c:pt idx="184">
                  <c:v>0.15141299999999999</c:v>
                </c:pt>
                <c:pt idx="185">
                  <c:v>0.15361</c:v>
                </c:pt>
                <c:pt idx="186">
                  <c:v>0.15567</c:v>
                </c:pt>
                <c:pt idx="187">
                  <c:v>0.15801999999999999</c:v>
                </c:pt>
                <c:pt idx="188">
                  <c:v>0.15995799999999999</c:v>
                </c:pt>
                <c:pt idx="189">
                  <c:v>0.16162099999999999</c:v>
                </c:pt>
                <c:pt idx="190">
                  <c:v>0.16354399999999999</c:v>
                </c:pt>
                <c:pt idx="191">
                  <c:v>0.165405</c:v>
                </c:pt>
                <c:pt idx="192">
                  <c:v>0.16711400000000001</c:v>
                </c:pt>
                <c:pt idx="193">
                  <c:v>0.168793</c:v>
                </c:pt>
                <c:pt idx="194">
                  <c:v>0.170456</c:v>
                </c:pt>
                <c:pt idx="195">
                  <c:v>0.17186000000000001</c:v>
                </c:pt>
                <c:pt idx="196">
                  <c:v>0.17314099999999999</c:v>
                </c:pt>
                <c:pt idx="197">
                  <c:v>0.17443800000000001</c:v>
                </c:pt>
                <c:pt idx="198">
                  <c:v>0.1754</c:v>
                </c:pt>
                <c:pt idx="199">
                  <c:v>0.176285</c:v>
                </c:pt>
                <c:pt idx="200">
                  <c:v>0.176956</c:v>
                </c:pt>
                <c:pt idx="201">
                  <c:v>0.177597</c:v>
                </c:pt>
                <c:pt idx="202">
                  <c:v>0.177841</c:v>
                </c:pt>
                <c:pt idx="203">
                  <c:v>0.17762800000000001</c:v>
                </c:pt>
                <c:pt idx="204">
                  <c:v>0.17744399999999999</c:v>
                </c:pt>
                <c:pt idx="205">
                  <c:v>0.177094</c:v>
                </c:pt>
                <c:pt idx="206">
                  <c:v>0.176422</c:v>
                </c:pt>
                <c:pt idx="207">
                  <c:v>0.175568</c:v>
                </c:pt>
                <c:pt idx="208">
                  <c:v>0.17443800000000001</c:v>
                </c:pt>
                <c:pt idx="209">
                  <c:v>0.17315700000000001</c:v>
                </c:pt>
                <c:pt idx="210">
                  <c:v>0.171768</c:v>
                </c:pt>
                <c:pt idx="211">
                  <c:v>0.17036399999999999</c:v>
                </c:pt>
                <c:pt idx="212">
                  <c:v>0.16880800000000001</c:v>
                </c:pt>
                <c:pt idx="213">
                  <c:v>0.167023</c:v>
                </c:pt>
                <c:pt idx="214">
                  <c:v>0.16528300000000001</c:v>
                </c:pt>
                <c:pt idx="215">
                  <c:v>0.163269</c:v>
                </c:pt>
                <c:pt idx="216">
                  <c:v>0.16148399999999999</c:v>
                </c:pt>
                <c:pt idx="217">
                  <c:v>0.1595</c:v>
                </c:pt>
                <c:pt idx="218">
                  <c:v>0.15731800000000001</c:v>
                </c:pt>
                <c:pt idx="219">
                  <c:v>0.155167</c:v>
                </c:pt>
                <c:pt idx="220">
                  <c:v>0.15264900000000001</c:v>
                </c:pt>
                <c:pt idx="221">
                  <c:v>0.150116</c:v>
                </c:pt>
                <c:pt idx="222">
                  <c:v>0.147476</c:v>
                </c:pt>
                <c:pt idx="223">
                  <c:v>0.14485200000000001</c:v>
                </c:pt>
                <c:pt idx="224">
                  <c:v>0.14176900000000001</c:v>
                </c:pt>
                <c:pt idx="225">
                  <c:v>0.138428</c:v>
                </c:pt>
                <c:pt idx="226">
                  <c:v>0.1353</c:v>
                </c:pt>
                <c:pt idx="227">
                  <c:v>0.131577</c:v>
                </c:pt>
                <c:pt idx="228">
                  <c:v>0.12789900000000001</c:v>
                </c:pt>
                <c:pt idx="229">
                  <c:v>0.124069</c:v>
                </c:pt>
                <c:pt idx="230">
                  <c:v>0.119934</c:v>
                </c:pt>
                <c:pt idx="231">
                  <c:v>0.11572300000000001</c:v>
                </c:pt>
                <c:pt idx="232">
                  <c:v>0.11146499999999999</c:v>
                </c:pt>
                <c:pt idx="233">
                  <c:v>0.107269</c:v>
                </c:pt>
                <c:pt idx="234">
                  <c:v>0.103119</c:v>
                </c:pt>
                <c:pt idx="235">
                  <c:v>9.8969000000000001E-2</c:v>
                </c:pt>
                <c:pt idx="236">
                  <c:v>9.4771999999999995E-2</c:v>
                </c:pt>
                <c:pt idx="237">
                  <c:v>9.0851000000000001E-2</c:v>
                </c:pt>
                <c:pt idx="238">
                  <c:v>8.7096999999999994E-2</c:v>
                </c:pt>
                <c:pt idx="239">
                  <c:v>8.3557000000000006E-2</c:v>
                </c:pt>
                <c:pt idx="240">
                  <c:v>7.9940999999999998E-2</c:v>
                </c:pt>
                <c:pt idx="241">
                  <c:v>7.6645000000000005E-2</c:v>
                </c:pt>
                <c:pt idx="242">
                  <c:v>7.3638999999999996E-2</c:v>
                </c:pt>
                <c:pt idx="243">
                  <c:v>7.0953000000000002E-2</c:v>
                </c:pt>
                <c:pt idx="244">
                  <c:v>6.8267999999999995E-2</c:v>
                </c:pt>
                <c:pt idx="245">
                  <c:v>6.5948000000000007E-2</c:v>
                </c:pt>
                <c:pt idx="246">
                  <c:v>6.3934000000000005E-2</c:v>
                </c:pt>
                <c:pt idx="247">
                  <c:v>6.2102999999999998E-2</c:v>
                </c:pt>
                <c:pt idx="248">
                  <c:v>6.0332999999999998E-2</c:v>
                </c:pt>
                <c:pt idx="249">
                  <c:v>5.8777000000000003E-2</c:v>
                </c:pt>
                <c:pt idx="250">
                  <c:v>5.7388000000000002E-2</c:v>
                </c:pt>
                <c:pt idx="251">
                  <c:v>5.6168000000000003E-2</c:v>
                </c:pt>
                <c:pt idx="252">
                  <c:v>5.5145E-2</c:v>
                </c:pt>
                <c:pt idx="253">
                  <c:v>5.4427999999999997E-2</c:v>
                </c:pt>
                <c:pt idx="254">
                  <c:v>5.3497000000000003E-2</c:v>
                </c:pt>
                <c:pt idx="255">
                  <c:v>5.2901999999999998E-2</c:v>
                </c:pt>
                <c:pt idx="256">
                  <c:v>5.2322E-2</c:v>
                </c:pt>
                <c:pt idx="257">
                  <c:v>5.1804000000000003E-2</c:v>
                </c:pt>
                <c:pt idx="258">
                  <c:v>5.1331000000000002E-2</c:v>
                </c:pt>
                <c:pt idx="259">
                  <c:v>5.0949000000000001E-2</c:v>
                </c:pt>
                <c:pt idx="260">
                  <c:v>5.0629E-2</c:v>
                </c:pt>
                <c:pt idx="261">
                  <c:v>5.0384999999999999E-2</c:v>
                </c:pt>
                <c:pt idx="262">
                  <c:v>5.0216999999999998E-2</c:v>
                </c:pt>
                <c:pt idx="263">
                  <c:v>5.0002999999999999E-2</c:v>
                </c:pt>
                <c:pt idx="264">
                  <c:v>4.9697999999999999E-2</c:v>
                </c:pt>
                <c:pt idx="265">
                  <c:v>4.9561000000000001E-2</c:v>
                </c:pt>
                <c:pt idx="266">
                  <c:v>4.9591000000000003E-2</c:v>
                </c:pt>
                <c:pt idx="267">
                  <c:v>4.9515000000000003E-2</c:v>
                </c:pt>
                <c:pt idx="268">
                  <c:v>4.9453999999999998E-2</c:v>
                </c:pt>
                <c:pt idx="269">
                  <c:v>4.9224999999999998E-2</c:v>
                </c:pt>
                <c:pt idx="270">
                  <c:v>4.9118000000000002E-2</c:v>
                </c:pt>
                <c:pt idx="271">
                  <c:v>4.9057000000000003E-2</c:v>
                </c:pt>
                <c:pt idx="272">
                  <c:v>4.8965000000000002E-2</c:v>
                </c:pt>
                <c:pt idx="273">
                  <c:v>4.8934999999999999E-2</c:v>
                </c:pt>
                <c:pt idx="274">
                  <c:v>4.8904000000000003E-2</c:v>
                </c:pt>
                <c:pt idx="275">
                  <c:v>4.8842999999999998E-2</c:v>
                </c:pt>
                <c:pt idx="276">
                  <c:v>4.8690999999999998E-2</c:v>
                </c:pt>
                <c:pt idx="277">
                  <c:v>4.8569000000000001E-2</c:v>
                </c:pt>
                <c:pt idx="278">
                  <c:v>4.8522999999999997E-2</c:v>
                </c:pt>
                <c:pt idx="279">
                  <c:v>4.863E-2</c:v>
                </c:pt>
                <c:pt idx="280">
                  <c:v>4.8461999999999998E-2</c:v>
                </c:pt>
                <c:pt idx="281">
                  <c:v>4.8431000000000002E-2</c:v>
                </c:pt>
                <c:pt idx="282">
                  <c:v>4.8401E-2</c:v>
                </c:pt>
                <c:pt idx="283">
                  <c:v>4.8355000000000002E-2</c:v>
                </c:pt>
                <c:pt idx="284">
                  <c:v>4.8217999999999997E-2</c:v>
                </c:pt>
                <c:pt idx="285">
                  <c:v>4.8217999999999997E-2</c:v>
                </c:pt>
                <c:pt idx="286">
                  <c:v>4.8385999999999998E-2</c:v>
                </c:pt>
                <c:pt idx="287">
                  <c:v>4.8340000000000001E-2</c:v>
                </c:pt>
                <c:pt idx="288">
                  <c:v>4.8308999999999998E-2</c:v>
                </c:pt>
                <c:pt idx="289">
                  <c:v>4.8232999999999998E-2</c:v>
                </c:pt>
                <c:pt idx="290">
                  <c:v>4.8247999999999999E-2</c:v>
                </c:pt>
                <c:pt idx="291">
                  <c:v>4.8325E-2</c:v>
                </c:pt>
                <c:pt idx="292">
                  <c:v>4.8340000000000001E-2</c:v>
                </c:pt>
                <c:pt idx="293">
                  <c:v>4.8416000000000001E-2</c:v>
                </c:pt>
                <c:pt idx="294">
                  <c:v>4.8340000000000001E-2</c:v>
                </c:pt>
                <c:pt idx="295">
                  <c:v>4.8325E-2</c:v>
                </c:pt>
                <c:pt idx="296">
                  <c:v>4.8308999999999998E-2</c:v>
                </c:pt>
                <c:pt idx="297">
                  <c:v>4.8355000000000002E-2</c:v>
                </c:pt>
                <c:pt idx="298">
                  <c:v>4.8279000000000002E-2</c:v>
                </c:pt>
                <c:pt idx="299">
                  <c:v>4.8293999999999997E-2</c:v>
                </c:pt>
                <c:pt idx="300">
                  <c:v>4.8370000000000003E-2</c:v>
                </c:pt>
                <c:pt idx="301">
                  <c:v>4.8308999999999998E-2</c:v>
                </c:pt>
                <c:pt idx="302">
                  <c:v>4.8232999999999998E-2</c:v>
                </c:pt>
                <c:pt idx="303">
                  <c:v>4.8187000000000001E-2</c:v>
                </c:pt>
                <c:pt idx="304">
                  <c:v>4.8050000000000002E-2</c:v>
                </c:pt>
                <c:pt idx="305">
                  <c:v>4.7988999999999997E-2</c:v>
                </c:pt>
                <c:pt idx="306">
                  <c:v>4.7897000000000002E-2</c:v>
                </c:pt>
                <c:pt idx="307">
                  <c:v>4.7867E-2</c:v>
                </c:pt>
                <c:pt idx="308">
                  <c:v>4.7821000000000002E-2</c:v>
                </c:pt>
                <c:pt idx="309">
                  <c:v>4.7683999999999997E-2</c:v>
                </c:pt>
                <c:pt idx="310">
                  <c:v>4.7577000000000001E-2</c:v>
                </c:pt>
                <c:pt idx="311">
                  <c:v>4.7378999999999998E-2</c:v>
                </c:pt>
                <c:pt idx="312">
                  <c:v>4.7363000000000002E-2</c:v>
                </c:pt>
                <c:pt idx="313">
                  <c:v>4.7333E-2</c:v>
                </c:pt>
                <c:pt idx="314">
                  <c:v>4.7348000000000001E-2</c:v>
                </c:pt>
                <c:pt idx="315">
                  <c:v>4.7287000000000003E-2</c:v>
                </c:pt>
                <c:pt idx="316">
                  <c:v>4.718E-2</c:v>
                </c:pt>
                <c:pt idx="317">
                  <c:v>4.718E-2</c:v>
                </c:pt>
                <c:pt idx="318">
                  <c:v>4.7287000000000003E-2</c:v>
                </c:pt>
                <c:pt idx="319">
                  <c:v>4.7301999999999997E-2</c:v>
                </c:pt>
                <c:pt idx="320">
                  <c:v>4.7378999999999998E-2</c:v>
                </c:pt>
                <c:pt idx="321">
                  <c:v>4.7440000000000003E-2</c:v>
                </c:pt>
                <c:pt idx="322">
                  <c:v>4.7409E-2</c:v>
                </c:pt>
                <c:pt idx="323">
                  <c:v>4.7501000000000002E-2</c:v>
                </c:pt>
                <c:pt idx="324">
                  <c:v>4.7545999999999998E-2</c:v>
                </c:pt>
                <c:pt idx="325">
                  <c:v>4.7653000000000001E-2</c:v>
                </c:pt>
                <c:pt idx="326">
                  <c:v>4.7729000000000001E-2</c:v>
                </c:pt>
                <c:pt idx="327">
                  <c:v>4.7821000000000002E-2</c:v>
                </c:pt>
                <c:pt idx="328">
                  <c:v>4.7927999999999998E-2</c:v>
                </c:pt>
                <c:pt idx="329">
                  <c:v>4.7974000000000003E-2</c:v>
                </c:pt>
                <c:pt idx="330">
                  <c:v>4.8003999999999998E-2</c:v>
                </c:pt>
                <c:pt idx="331">
                  <c:v>4.8035000000000001E-2</c:v>
                </c:pt>
                <c:pt idx="332">
                  <c:v>4.8050000000000002E-2</c:v>
                </c:pt>
                <c:pt idx="333">
                  <c:v>4.7974000000000003E-2</c:v>
                </c:pt>
                <c:pt idx="334">
                  <c:v>4.7927999999999998E-2</c:v>
                </c:pt>
                <c:pt idx="335">
                  <c:v>4.7927999999999998E-2</c:v>
                </c:pt>
                <c:pt idx="336">
                  <c:v>4.7713999999999999E-2</c:v>
                </c:pt>
                <c:pt idx="337">
                  <c:v>4.7577000000000001E-2</c:v>
                </c:pt>
                <c:pt idx="338">
                  <c:v>4.7484999999999999E-2</c:v>
                </c:pt>
                <c:pt idx="339">
                  <c:v>4.7301999999999997E-2</c:v>
                </c:pt>
                <c:pt idx="340">
                  <c:v>4.7028E-2</c:v>
                </c:pt>
                <c:pt idx="341">
                  <c:v>4.6906000000000003E-2</c:v>
                </c:pt>
                <c:pt idx="342">
                  <c:v>4.6646E-2</c:v>
                </c:pt>
                <c:pt idx="343">
                  <c:v>4.6386999999999998E-2</c:v>
                </c:pt>
                <c:pt idx="344">
                  <c:v>4.6127000000000001E-2</c:v>
                </c:pt>
                <c:pt idx="345">
                  <c:v>4.5975000000000002E-2</c:v>
                </c:pt>
                <c:pt idx="346">
                  <c:v>4.5761000000000003E-2</c:v>
                </c:pt>
                <c:pt idx="347">
                  <c:v>4.5562999999999999E-2</c:v>
                </c:pt>
                <c:pt idx="348">
                  <c:v>4.5425E-2</c:v>
                </c:pt>
                <c:pt idx="349">
                  <c:v>4.5212000000000002E-2</c:v>
                </c:pt>
                <c:pt idx="350">
                  <c:v>4.512E-2</c:v>
                </c:pt>
                <c:pt idx="351">
                  <c:v>4.4968000000000001E-2</c:v>
                </c:pt>
                <c:pt idx="352">
                  <c:v>4.4739000000000001E-2</c:v>
                </c:pt>
                <c:pt idx="353">
                  <c:v>4.4784999999999998E-2</c:v>
                </c:pt>
                <c:pt idx="354">
                  <c:v>4.4646999999999999E-2</c:v>
                </c:pt>
                <c:pt idx="355">
                  <c:v>4.4571E-2</c:v>
                </c:pt>
                <c:pt idx="356">
                  <c:v>4.4525000000000002E-2</c:v>
                </c:pt>
                <c:pt idx="357">
                  <c:v>4.4449000000000002E-2</c:v>
                </c:pt>
                <c:pt idx="358">
                  <c:v>4.4449000000000002E-2</c:v>
                </c:pt>
                <c:pt idx="359">
                  <c:v>4.4341999999999999E-2</c:v>
                </c:pt>
                <c:pt idx="360">
                  <c:v>4.4188999999999999E-2</c:v>
                </c:pt>
                <c:pt idx="361">
                  <c:v>4.4188999999999999E-2</c:v>
                </c:pt>
                <c:pt idx="362">
                  <c:v>4.4112999999999999E-2</c:v>
                </c:pt>
                <c:pt idx="363">
                  <c:v>4.4021999999999999E-2</c:v>
                </c:pt>
                <c:pt idx="364">
                  <c:v>4.3976000000000001E-2</c:v>
                </c:pt>
                <c:pt idx="365">
                  <c:v>4.3976000000000001E-2</c:v>
                </c:pt>
                <c:pt idx="366">
                  <c:v>4.3944999999999998E-2</c:v>
                </c:pt>
                <c:pt idx="367">
                  <c:v>4.3839000000000003E-2</c:v>
                </c:pt>
                <c:pt idx="368">
                  <c:v>4.3777000000000003E-2</c:v>
                </c:pt>
                <c:pt idx="369">
                  <c:v>4.3792999999999999E-2</c:v>
                </c:pt>
                <c:pt idx="370">
                  <c:v>4.3715999999999998E-2</c:v>
                </c:pt>
                <c:pt idx="371">
                  <c:v>4.3671000000000001E-2</c:v>
                </c:pt>
                <c:pt idx="372">
                  <c:v>4.3671000000000001E-2</c:v>
                </c:pt>
                <c:pt idx="373">
                  <c:v>4.3487999999999999E-2</c:v>
                </c:pt>
                <c:pt idx="374">
                  <c:v>4.3503E-2</c:v>
                </c:pt>
                <c:pt idx="375">
                  <c:v>4.3518000000000001E-2</c:v>
                </c:pt>
                <c:pt idx="376">
                  <c:v>4.3487999999999999E-2</c:v>
                </c:pt>
                <c:pt idx="377">
                  <c:v>4.3442000000000001E-2</c:v>
                </c:pt>
                <c:pt idx="378">
                  <c:v>4.3410999999999998E-2</c:v>
                </c:pt>
                <c:pt idx="379">
                  <c:v>4.3471999999999997E-2</c:v>
                </c:pt>
                <c:pt idx="380">
                  <c:v>4.335E-2</c:v>
                </c:pt>
                <c:pt idx="381">
                  <c:v>4.3381000000000003E-2</c:v>
                </c:pt>
                <c:pt idx="382">
                  <c:v>4.335E-2</c:v>
                </c:pt>
                <c:pt idx="383">
                  <c:v>4.3274E-2</c:v>
                </c:pt>
                <c:pt idx="384">
                  <c:v>4.3228000000000003E-2</c:v>
                </c:pt>
                <c:pt idx="385">
                  <c:v>4.3181999999999998E-2</c:v>
                </c:pt>
                <c:pt idx="386">
                  <c:v>4.3198E-2</c:v>
                </c:pt>
                <c:pt idx="387">
                  <c:v>4.3152000000000003E-2</c:v>
                </c:pt>
                <c:pt idx="388">
                  <c:v>4.3105999999999998E-2</c:v>
                </c:pt>
                <c:pt idx="389">
                  <c:v>4.3076000000000003E-2</c:v>
                </c:pt>
                <c:pt idx="390">
                  <c:v>4.3152000000000003E-2</c:v>
                </c:pt>
                <c:pt idx="391">
                  <c:v>4.3076000000000003E-2</c:v>
                </c:pt>
                <c:pt idx="392">
                  <c:v>4.2984000000000001E-2</c:v>
                </c:pt>
                <c:pt idx="393">
                  <c:v>4.3014999999999998E-2</c:v>
                </c:pt>
                <c:pt idx="394">
                  <c:v>4.2969E-2</c:v>
                </c:pt>
                <c:pt idx="395">
                  <c:v>4.2876999999999998E-2</c:v>
                </c:pt>
                <c:pt idx="396">
                  <c:v>4.2800999999999999E-2</c:v>
                </c:pt>
                <c:pt idx="397">
                  <c:v>4.2770000000000002E-2</c:v>
                </c:pt>
                <c:pt idx="398">
                  <c:v>4.2770000000000002E-2</c:v>
                </c:pt>
                <c:pt idx="399">
                  <c:v>4.2724999999999999E-2</c:v>
                </c:pt>
                <c:pt idx="400">
                  <c:v>4.2785999999999998E-2</c:v>
                </c:pt>
                <c:pt idx="401">
                  <c:v>4.2724999999999999E-2</c:v>
                </c:pt>
                <c:pt idx="402">
                  <c:v>4.2694000000000003E-2</c:v>
                </c:pt>
                <c:pt idx="403">
                  <c:v>4.2664000000000001E-2</c:v>
                </c:pt>
                <c:pt idx="404">
                  <c:v>4.2603000000000002E-2</c:v>
                </c:pt>
                <c:pt idx="405">
                  <c:v>4.2556999999999998E-2</c:v>
                </c:pt>
                <c:pt idx="406">
                  <c:v>4.2571999999999999E-2</c:v>
                </c:pt>
                <c:pt idx="407">
                  <c:v>4.2526000000000001E-2</c:v>
                </c:pt>
                <c:pt idx="408">
                  <c:v>4.2587E-2</c:v>
                </c:pt>
                <c:pt idx="409">
                  <c:v>4.2526000000000001E-2</c:v>
                </c:pt>
                <c:pt idx="410">
                  <c:v>4.2450000000000002E-2</c:v>
                </c:pt>
                <c:pt idx="411">
                  <c:v>4.2342999999999999E-2</c:v>
                </c:pt>
                <c:pt idx="412">
                  <c:v>4.2358E-2</c:v>
                </c:pt>
                <c:pt idx="413">
                  <c:v>4.2403999999999997E-2</c:v>
                </c:pt>
                <c:pt idx="414">
                  <c:v>4.2418999999999998E-2</c:v>
                </c:pt>
                <c:pt idx="415">
                  <c:v>4.2297000000000001E-2</c:v>
                </c:pt>
                <c:pt idx="416">
                  <c:v>4.2358E-2</c:v>
                </c:pt>
                <c:pt idx="417">
                  <c:v>4.2297000000000001E-2</c:v>
                </c:pt>
                <c:pt idx="418">
                  <c:v>4.2206E-2</c:v>
                </c:pt>
                <c:pt idx="419">
                  <c:v>4.2174999999999997E-2</c:v>
                </c:pt>
                <c:pt idx="420">
                  <c:v>4.2221000000000002E-2</c:v>
                </c:pt>
                <c:pt idx="421">
                  <c:v>4.2174999999999997E-2</c:v>
                </c:pt>
                <c:pt idx="422">
                  <c:v>4.2206E-2</c:v>
                </c:pt>
                <c:pt idx="423">
                  <c:v>4.2174999999999997E-2</c:v>
                </c:pt>
                <c:pt idx="424">
                  <c:v>4.2190999999999999E-2</c:v>
                </c:pt>
                <c:pt idx="425">
                  <c:v>4.2130000000000001E-2</c:v>
                </c:pt>
                <c:pt idx="426">
                  <c:v>4.2130000000000001E-2</c:v>
                </c:pt>
                <c:pt idx="427">
                  <c:v>4.2174999999999997E-2</c:v>
                </c:pt>
                <c:pt idx="428">
                  <c:v>4.2174999999999997E-2</c:v>
                </c:pt>
                <c:pt idx="429">
                  <c:v>4.2160000000000003E-2</c:v>
                </c:pt>
                <c:pt idx="430">
                  <c:v>4.2297000000000001E-2</c:v>
                </c:pt>
                <c:pt idx="431">
                  <c:v>4.2297000000000001E-2</c:v>
                </c:pt>
                <c:pt idx="432">
                  <c:v>4.2297000000000001E-2</c:v>
                </c:pt>
                <c:pt idx="433">
                  <c:v>4.2313000000000003E-2</c:v>
                </c:pt>
                <c:pt idx="434">
                  <c:v>4.2297000000000001E-2</c:v>
                </c:pt>
                <c:pt idx="435">
                  <c:v>4.2206E-2</c:v>
                </c:pt>
                <c:pt idx="436">
                  <c:v>4.2221000000000002E-2</c:v>
                </c:pt>
                <c:pt idx="437">
                  <c:v>4.2190999999999999E-2</c:v>
                </c:pt>
                <c:pt idx="438">
                  <c:v>4.2174999999999997E-2</c:v>
                </c:pt>
                <c:pt idx="439">
                  <c:v>4.2098999999999998E-2</c:v>
                </c:pt>
                <c:pt idx="440">
                  <c:v>4.1961999999999999E-2</c:v>
                </c:pt>
                <c:pt idx="441">
                  <c:v>4.1869999999999997E-2</c:v>
                </c:pt>
                <c:pt idx="442">
                  <c:v>4.1840000000000002E-2</c:v>
                </c:pt>
                <c:pt idx="443">
                  <c:v>4.1748E-2</c:v>
                </c:pt>
                <c:pt idx="444">
                  <c:v>4.1702000000000003E-2</c:v>
                </c:pt>
                <c:pt idx="445">
                  <c:v>4.1640999999999997E-2</c:v>
                </c:pt>
                <c:pt idx="446">
                  <c:v>4.1503999999999999E-2</c:v>
                </c:pt>
                <c:pt idx="447">
                  <c:v>4.1382000000000002E-2</c:v>
                </c:pt>
                <c:pt idx="448">
                  <c:v>4.1274999999999999E-2</c:v>
                </c:pt>
                <c:pt idx="449">
                  <c:v>4.1168000000000003E-2</c:v>
                </c:pt>
                <c:pt idx="450">
                  <c:v>4.1061E-2</c:v>
                </c:pt>
                <c:pt idx="451">
                  <c:v>4.1061E-2</c:v>
                </c:pt>
                <c:pt idx="452">
                  <c:v>4.1030999999999998E-2</c:v>
                </c:pt>
                <c:pt idx="453">
                  <c:v>4.1045999999999999E-2</c:v>
                </c:pt>
                <c:pt idx="454">
                  <c:v>4.1061E-2</c:v>
                </c:pt>
                <c:pt idx="455">
                  <c:v>4.1091999999999997E-2</c:v>
                </c:pt>
                <c:pt idx="456">
                  <c:v>4.1106999999999998E-2</c:v>
                </c:pt>
                <c:pt idx="457">
                  <c:v>4.1168000000000003E-2</c:v>
                </c:pt>
                <c:pt idx="458">
                  <c:v>4.1214000000000001E-2</c:v>
                </c:pt>
                <c:pt idx="459">
                  <c:v>4.1229000000000002E-2</c:v>
                </c:pt>
                <c:pt idx="460">
                  <c:v>4.1229000000000002E-2</c:v>
                </c:pt>
                <c:pt idx="461">
                  <c:v>4.1121999999999999E-2</c:v>
                </c:pt>
                <c:pt idx="462">
                  <c:v>4.1091999999999997E-2</c:v>
                </c:pt>
                <c:pt idx="463">
                  <c:v>4.1045999999999999E-2</c:v>
                </c:pt>
                <c:pt idx="464">
                  <c:v>4.1030999999999998E-2</c:v>
                </c:pt>
                <c:pt idx="465">
                  <c:v>4.1061E-2</c:v>
                </c:pt>
                <c:pt idx="466">
                  <c:v>4.0939000000000003E-2</c:v>
                </c:pt>
                <c:pt idx="467">
                  <c:v>4.0833000000000001E-2</c:v>
                </c:pt>
                <c:pt idx="468">
                  <c:v>4.0833000000000001E-2</c:v>
                </c:pt>
                <c:pt idx="469">
                  <c:v>4.0862999999999997E-2</c:v>
                </c:pt>
                <c:pt idx="470">
                  <c:v>4.0786999999999997E-2</c:v>
                </c:pt>
                <c:pt idx="471">
                  <c:v>4.0725999999999998E-2</c:v>
                </c:pt>
                <c:pt idx="472">
                  <c:v>4.0786999999999997E-2</c:v>
                </c:pt>
                <c:pt idx="473">
                  <c:v>4.0786999999999997E-2</c:v>
                </c:pt>
                <c:pt idx="474">
                  <c:v>4.0740999999999999E-2</c:v>
                </c:pt>
                <c:pt idx="475">
                  <c:v>4.0740999999999999E-2</c:v>
                </c:pt>
                <c:pt idx="476">
                  <c:v>4.0680000000000001E-2</c:v>
                </c:pt>
                <c:pt idx="477">
                  <c:v>4.0695000000000002E-2</c:v>
                </c:pt>
                <c:pt idx="478">
                  <c:v>4.0619000000000002E-2</c:v>
                </c:pt>
                <c:pt idx="479">
                  <c:v>4.0572999999999998E-2</c:v>
                </c:pt>
                <c:pt idx="480">
                  <c:v>4.0557999999999997E-2</c:v>
                </c:pt>
                <c:pt idx="481">
                  <c:v>4.0543000000000003E-2</c:v>
                </c:pt>
                <c:pt idx="482">
                  <c:v>4.0527000000000001E-2</c:v>
                </c:pt>
                <c:pt idx="483">
                  <c:v>4.0511999999999999E-2</c:v>
                </c:pt>
                <c:pt idx="484">
                  <c:v>4.0481999999999997E-2</c:v>
                </c:pt>
                <c:pt idx="485">
                  <c:v>4.0481999999999997E-2</c:v>
                </c:pt>
                <c:pt idx="486">
                  <c:v>4.0511999999999999E-2</c:v>
                </c:pt>
                <c:pt idx="487">
                  <c:v>4.0390000000000002E-2</c:v>
                </c:pt>
                <c:pt idx="488">
                  <c:v>4.0343999999999998E-2</c:v>
                </c:pt>
                <c:pt idx="489">
                  <c:v>4.0375000000000001E-2</c:v>
                </c:pt>
                <c:pt idx="490">
                  <c:v>4.0405000000000003E-2</c:v>
                </c:pt>
                <c:pt idx="491">
                  <c:v>4.0390000000000002E-2</c:v>
                </c:pt>
                <c:pt idx="492">
                  <c:v>4.0298E-2</c:v>
                </c:pt>
                <c:pt idx="493">
                  <c:v>4.0237000000000002E-2</c:v>
                </c:pt>
                <c:pt idx="494">
                  <c:v>4.0267999999999998E-2</c:v>
                </c:pt>
                <c:pt idx="495">
                  <c:v>4.0222000000000001E-2</c:v>
                </c:pt>
                <c:pt idx="496">
                  <c:v>4.0222000000000001E-2</c:v>
                </c:pt>
                <c:pt idx="497">
                  <c:v>4.0298E-2</c:v>
                </c:pt>
                <c:pt idx="498">
                  <c:v>4.0343999999999998E-2</c:v>
                </c:pt>
                <c:pt idx="499">
                  <c:v>4.0237000000000002E-2</c:v>
                </c:pt>
                <c:pt idx="500">
                  <c:v>4.0314000000000003E-2</c:v>
                </c:pt>
                <c:pt idx="501">
                  <c:v>4.0314000000000003E-2</c:v>
                </c:pt>
                <c:pt idx="502">
                  <c:v>4.0237000000000002E-2</c:v>
                </c:pt>
                <c:pt idx="503">
                  <c:v>4.0267999999999998E-2</c:v>
                </c:pt>
                <c:pt idx="504">
                  <c:v>4.0114999999999998E-2</c:v>
                </c:pt>
                <c:pt idx="505">
                  <c:v>4.0038999999999998E-2</c:v>
                </c:pt>
                <c:pt idx="506">
                  <c:v>4.0038999999999998E-2</c:v>
                </c:pt>
                <c:pt idx="507">
                  <c:v>4.0085000000000003E-2</c:v>
                </c:pt>
                <c:pt idx="508">
                  <c:v>4.0085000000000003E-2</c:v>
                </c:pt>
                <c:pt idx="509">
                  <c:v>4.0053999999999999E-2</c:v>
                </c:pt>
                <c:pt idx="510">
                  <c:v>3.9993000000000001E-2</c:v>
                </c:pt>
              </c:numCache>
            </c:numRef>
          </c:yVal>
          <c:smooth val="1"/>
          <c:extLst>
            <c:ext xmlns:c16="http://schemas.microsoft.com/office/drawing/2014/chart" uri="{C3380CC4-5D6E-409C-BE32-E72D297353CC}">
              <c16:uniqueId val="{00000002-3FAF-4CBF-82DD-E60AB52489B3}"/>
            </c:ext>
          </c:extLst>
        </c:ser>
        <c:ser>
          <c:idx val="4"/>
          <c:order val="3"/>
          <c:tx>
            <c:strRef>
              <c:f>AZD!$D$1</c:f>
              <c:strCache>
                <c:ptCount val="1"/>
                <c:pt idx="0">
                  <c:v>AZD2014 (11 μM) PBS Abs</c:v>
                </c:pt>
              </c:strCache>
            </c:strRef>
          </c:tx>
          <c:spPr>
            <a:ln>
              <a:solidFill>
                <a:schemeClr val="accent6">
                  <a:lumMod val="50000"/>
                </a:schemeClr>
              </a:solidFill>
            </a:ln>
          </c:spPr>
          <c:marker>
            <c:symbol val="none"/>
          </c:marker>
          <c:xVal>
            <c:numRef>
              <c:f>AZD!$D$3:$D$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AZD!$E$3:$E$513</c:f>
              <c:numCache>
                <c:formatCode>General</c:formatCode>
                <c:ptCount val="511"/>
                <c:pt idx="0">
                  <c:v>3.7231749999999999</c:v>
                </c:pt>
                <c:pt idx="1">
                  <c:v>3.6840060000000001</c:v>
                </c:pt>
                <c:pt idx="2">
                  <c:v>3.4389949999999998</c:v>
                </c:pt>
                <c:pt idx="3">
                  <c:v>3.9038240000000002</c:v>
                </c:pt>
                <c:pt idx="4">
                  <c:v>3.9732820000000002</c:v>
                </c:pt>
                <c:pt idx="5">
                  <c:v>3.8614809999999999</c:v>
                </c:pt>
                <c:pt idx="6">
                  <c:v>3.8948670000000001</c:v>
                </c:pt>
                <c:pt idx="7">
                  <c:v>3.825256</c:v>
                </c:pt>
                <c:pt idx="8">
                  <c:v>3.8121489999999998</c:v>
                </c:pt>
                <c:pt idx="9">
                  <c:v>3.7855989999999999</c:v>
                </c:pt>
                <c:pt idx="10">
                  <c:v>3.7540439999999999</c:v>
                </c:pt>
                <c:pt idx="11">
                  <c:v>3.83107</c:v>
                </c:pt>
                <c:pt idx="12">
                  <c:v>3.7710720000000002</c:v>
                </c:pt>
                <c:pt idx="13">
                  <c:v>3.823013</c:v>
                </c:pt>
                <c:pt idx="14">
                  <c:v>3.8776860000000002</c:v>
                </c:pt>
                <c:pt idx="15">
                  <c:v>3.8718409999999999</c:v>
                </c:pt>
                <c:pt idx="16">
                  <c:v>3.8895719999999998</c:v>
                </c:pt>
                <c:pt idx="17">
                  <c:v>3.7582239999999998</c:v>
                </c:pt>
                <c:pt idx="18">
                  <c:v>3.9086150000000002</c:v>
                </c:pt>
                <c:pt idx="19">
                  <c:v>3.8892519999999999</c:v>
                </c:pt>
                <c:pt idx="20">
                  <c:v>3.7504580000000001</c:v>
                </c:pt>
                <c:pt idx="21">
                  <c:v>3.9046780000000001</c:v>
                </c:pt>
                <c:pt idx="22">
                  <c:v>3.8203130000000001</c:v>
                </c:pt>
                <c:pt idx="23">
                  <c:v>3.8141479999999999</c:v>
                </c:pt>
                <c:pt idx="24">
                  <c:v>3.654175</c:v>
                </c:pt>
                <c:pt idx="25">
                  <c:v>3.658798</c:v>
                </c:pt>
                <c:pt idx="26">
                  <c:v>3.7146150000000002</c:v>
                </c:pt>
                <c:pt idx="27">
                  <c:v>3.8081969999999998</c:v>
                </c:pt>
                <c:pt idx="28">
                  <c:v>3.8127749999999998</c:v>
                </c:pt>
                <c:pt idx="29">
                  <c:v>3.4042050000000001</c:v>
                </c:pt>
                <c:pt idx="30">
                  <c:v>3.0839080000000001</c:v>
                </c:pt>
                <c:pt idx="31">
                  <c:v>2.7948909999999998</c:v>
                </c:pt>
                <c:pt idx="32">
                  <c:v>2.452591</c:v>
                </c:pt>
                <c:pt idx="33">
                  <c:v>2.0696870000000001</c:v>
                </c:pt>
                <c:pt idx="34">
                  <c:v>1.7316130000000001</c:v>
                </c:pt>
                <c:pt idx="35">
                  <c:v>1.436615</c:v>
                </c:pt>
                <c:pt idx="36">
                  <c:v>1.2088620000000001</c:v>
                </c:pt>
                <c:pt idx="37">
                  <c:v>1.026276</c:v>
                </c:pt>
                <c:pt idx="38">
                  <c:v>0.89175400000000005</c:v>
                </c:pt>
                <c:pt idx="39">
                  <c:v>0.78675799999999996</c:v>
                </c:pt>
                <c:pt idx="40">
                  <c:v>0.70742799999999995</c:v>
                </c:pt>
                <c:pt idx="41">
                  <c:v>0.64993299999999998</c:v>
                </c:pt>
                <c:pt idx="42">
                  <c:v>0.60723899999999997</c:v>
                </c:pt>
                <c:pt idx="43">
                  <c:v>0.57550000000000001</c:v>
                </c:pt>
                <c:pt idx="44">
                  <c:v>0.55177299999999996</c:v>
                </c:pt>
                <c:pt idx="45">
                  <c:v>0.53414899999999998</c:v>
                </c:pt>
                <c:pt idx="46">
                  <c:v>0.52128600000000003</c:v>
                </c:pt>
                <c:pt idx="47">
                  <c:v>0.51110800000000001</c:v>
                </c:pt>
                <c:pt idx="48">
                  <c:v>0.50302100000000005</c:v>
                </c:pt>
                <c:pt idx="49">
                  <c:v>0.49648999999999999</c:v>
                </c:pt>
                <c:pt idx="50">
                  <c:v>0.49037199999999997</c:v>
                </c:pt>
                <c:pt idx="51">
                  <c:v>0.48426799999999998</c:v>
                </c:pt>
                <c:pt idx="52">
                  <c:v>0.47778300000000001</c:v>
                </c:pt>
                <c:pt idx="53">
                  <c:v>0.47097800000000001</c:v>
                </c:pt>
                <c:pt idx="54">
                  <c:v>0.46334799999999998</c:v>
                </c:pt>
                <c:pt idx="55">
                  <c:v>0.45542899999999997</c:v>
                </c:pt>
                <c:pt idx="56">
                  <c:v>0.447357</c:v>
                </c:pt>
                <c:pt idx="57">
                  <c:v>0.439224</c:v>
                </c:pt>
                <c:pt idx="58">
                  <c:v>0.430954</c:v>
                </c:pt>
                <c:pt idx="59">
                  <c:v>0.42230200000000001</c:v>
                </c:pt>
                <c:pt idx="60">
                  <c:v>0.41401700000000002</c:v>
                </c:pt>
                <c:pt idx="61">
                  <c:v>0.40554800000000002</c:v>
                </c:pt>
                <c:pt idx="62">
                  <c:v>0.397781</c:v>
                </c:pt>
                <c:pt idx="63">
                  <c:v>0.38969399999999998</c:v>
                </c:pt>
                <c:pt idx="64">
                  <c:v>0.382187</c:v>
                </c:pt>
                <c:pt idx="65">
                  <c:v>0.37515300000000001</c:v>
                </c:pt>
                <c:pt idx="66">
                  <c:v>0.368591</c:v>
                </c:pt>
                <c:pt idx="67">
                  <c:v>0.36299100000000001</c:v>
                </c:pt>
                <c:pt idx="68">
                  <c:v>0.35870400000000002</c:v>
                </c:pt>
                <c:pt idx="69">
                  <c:v>0.35614000000000001</c:v>
                </c:pt>
                <c:pt idx="70">
                  <c:v>0.35491899999999998</c:v>
                </c:pt>
                <c:pt idx="71">
                  <c:v>0.35508699999999999</c:v>
                </c:pt>
                <c:pt idx="72">
                  <c:v>0.35705599999999998</c:v>
                </c:pt>
                <c:pt idx="73">
                  <c:v>0.359985</c:v>
                </c:pt>
                <c:pt idx="74">
                  <c:v>0.364014</c:v>
                </c:pt>
                <c:pt idx="75">
                  <c:v>0.36863699999999999</c:v>
                </c:pt>
                <c:pt idx="76">
                  <c:v>0.37380999999999998</c:v>
                </c:pt>
                <c:pt idx="77">
                  <c:v>0.37939499999999998</c:v>
                </c:pt>
                <c:pt idx="78">
                  <c:v>0.38555899999999999</c:v>
                </c:pt>
                <c:pt idx="79">
                  <c:v>0.39114399999999999</c:v>
                </c:pt>
                <c:pt idx="80">
                  <c:v>0.39637800000000001</c:v>
                </c:pt>
                <c:pt idx="81">
                  <c:v>0.40109299999999998</c:v>
                </c:pt>
                <c:pt idx="82">
                  <c:v>0.40524300000000002</c:v>
                </c:pt>
                <c:pt idx="83">
                  <c:v>0.40849299999999999</c:v>
                </c:pt>
                <c:pt idx="84">
                  <c:v>0.41061399999999998</c:v>
                </c:pt>
                <c:pt idx="85">
                  <c:v>0.41165200000000002</c:v>
                </c:pt>
                <c:pt idx="86">
                  <c:v>0.41169699999999998</c:v>
                </c:pt>
                <c:pt idx="87">
                  <c:v>0.41039999999999999</c:v>
                </c:pt>
                <c:pt idx="88">
                  <c:v>0.40783700000000001</c:v>
                </c:pt>
                <c:pt idx="89">
                  <c:v>0.40342699999999998</c:v>
                </c:pt>
                <c:pt idx="90">
                  <c:v>0.39759800000000001</c:v>
                </c:pt>
                <c:pt idx="91">
                  <c:v>0.39051799999999998</c:v>
                </c:pt>
                <c:pt idx="92">
                  <c:v>0.38151600000000002</c:v>
                </c:pt>
                <c:pt idx="93">
                  <c:v>0.37117</c:v>
                </c:pt>
                <c:pt idx="94">
                  <c:v>0.35917700000000002</c:v>
                </c:pt>
                <c:pt idx="95">
                  <c:v>0.34591699999999997</c:v>
                </c:pt>
                <c:pt idx="96">
                  <c:v>0.33236700000000002</c:v>
                </c:pt>
                <c:pt idx="97">
                  <c:v>0.31765700000000002</c:v>
                </c:pt>
                <c:pt idx="98">
                  <c:v>0.30256699999999997</c:v>
                </c:pt>
                <c:pt idx="99">
                  <c:v>0.28716999999999998</c:v>
                </c:pt>
                <c:pt idx="100">
                  <c:v>0.27162199999999997</c:v>
                </c:pt>
                <c:pt idx="101">
                  <c:v>0.25675999999999999</c:v>
                </c:pt>
                <c:pt idx="102">
                  <c:v>0.24221799999999999</c:v>
                </c:pt>
                <c:pt idx="103">
                  <c:v>0.228348</c:v>
                </c:pt>
                <c:pt idx="104">
                  <c:v>0.215363</c:v>
                </c:pt>
                <c:pt idx="105">
                  <c:v>0.20089699999999999</c:v>
                </c:pt>
                <c:pt idx="106">
                  <c:v>0.18623400000000001</c:v>
                </c:pt>
                <c:pt idx="107">
                  <c:v>0.176514</c:v>
                </c:pt>
                <c:pt idx="108">
                  <c:v>0.168625</c:v>
                </c:pt>
                <c:pt idx="109">
                  <c:v>0.15948499999999999</c:v>
                </c:pt>
                <c:pt idx="110">
                  <c:v>0.153091</c:v>
                </c:pt>
                <c:pt idx="111">
                  <c:v>0.14701800000000001</c:v>
                </c:pt>
                <c:pt idx="112">
                  <c:v>0.14186099999999999</c:v>
                </c:pt>
                <c:pt idx="113">
                  <c:v>0.13694799999999999</c:v>
                </c:pt>
                <c:pt idx="114">
                  <c:v>0.13259899999999999</c:v>
                </c:pt>
                <c:pt idx="115">
                  <c:v>0.12797500000000001</c:v>
                </c:pt>
                <c:pt idx="116">
                  <c:v>0.12579299999999999</c:v>
                </c:pt>
                <c:pt idx="117">
                  <c:v>0.123169</c:v>
                </c:pt>
                <c:pt idx="118">
                  <c:v>0.11938500000000001</c:v>
                </c:pt>
                <c:pt idx="119">
                  <c:v>0.11816400000000001</c:v>
                </c:pt>
                <c:pt idx="120">
                  <c:v>0.115982</c:v>
                </c:pt>
                <c:pt idx="121">
                  <c:v>0.113785</c:v>
                </c:pt>
                <c:pt idx="122">
                  <c:v>0.1129</c:v>
                </c:pt>
                <c:pt idx="123">
                  <c:v>0.112076</c:v>
                </c:pt>
                <c:pt idx="124">
                  <c:v>0.11035200000000001</c:v>
                </c:pt>
                <c:pt idx="125">
                  <c:v>0.108795</c:v>
                </c:pt>
                <c:pt idx="126">
                  <c:v>0.109116</c:v>
                </c:pt>
                <c:pt idx="127">
                  <c:v>0.108765</c:v>
                </c:pt>
                <c:pt idx="128">
                  <c:v>0.107681</c:v>
                </c:pt>
                <c:pt idx="129">
                  <c:v>0.106979</c:v>
                </c:pt>
                <c:pt idx="130">
                  <c:v>0.10636900000000001</c:v>
                </c:pt>
                <c:pt idx="131">
                  <c:v>0.10639999999999999</c:v>
                </c:pt>
                <c:pt idx="132">
                  <c:v>0.105957</c:v>
                </c:pt>
                <c:pt idx="133">
                  <c:v>0.105255</c:v>
                </c:pt>
                <c:pt idx="134">
                  <c:v>0.104599</c:v>
                </c:pt>
                <c:pt idx="135">
                  <c:v>0.104492</c:v>
                </c:pt>
                <c:pt idx="136">
                  <c:v>0.10421800000000001</c:v>
                </c:pt>
                <c:pt idx="137">
                  <c:v>0.103577</c:v>
                </c:pt>
                <c:pt idx="138">
                  <c:v>0.103882</c:v>
                </c:pt>
                <c:pt idx="139">
                  <c:v>0.103104</c:v>
                </c:pt>
                <c:pt idx="140">
                  <c:v>0.102982</c:v>
                </c:pt>
                <c:pt idx="141">
                  <c:v>0.102936</c:v>
                </c:pt>
                <c:pt idx="142">
                  <c:v>0.102753</c:v>
                </c:pt>
                <c:pt idx="143">
                  <c:v>0.10302699999999999</c:v>
                </c:pt>
                <c:pt idx="144">
                  <c:v>0.102829</c:v>
                </c:pt>
                <c:pt idx="145">
                  <c:v>0.103302</c:v>
                </c:pt>
                <c:pt idx="146">
                  <c:v>0.103241</c:v>
                </c:pt>
                <c:pt idx="147">
                  <c:v>0.103882</c:v>
                </c:pt>
                <c:pt idx="148">
                  <c:v>0.10455299999999999</c:v>
                </c:pt>
                <c:pt idx="149">
                  <c:v>0.10498</c:v>
                </c:pt>
                <c:pt idx="150">
                  <c:v>0.104584</c:v>
                </c:pt>
                <c:pt idx="151">
                  <c:v>0.10609399999999999</c:v>
                </c:pt>
                <c:pt idx="152">
                  <c:v>0.10788</c:v>
                </c:pt>
                <c:pt idx="153">
                  <c:v>0.108643</c:v>
                </c:pt>
                <c:pt idx="154">
                  <c:v>0.109802</c:v>
                </c:pt>
                <c:pt idx="155">
                  <c:v>0.11161799999999999</c:v>
                </c:pt>
                <c:pt idx="156">
                  <c:v>0.112869</c:v>
                </c:pt>
                <c:pt idx="157">
                  <c:v>0.114883</c:v>
                </c:pt>
                <c:pt idx="158">
                  <c:v>0.116562</c:v>
                </c:pt>
                <c:pt idx="159">
                  <c:v>0.118393</c:v>
                </c:pt>
                <c:pt idx="160">
                  <c:v>0.120392</c:v>
                </c:pt>
                <c:pt idx="161">
                  <c:v>0.122543</c:v>
                </c:pt>
                <c:pt idx="162">
                  <c:v>0.124664</c:v>
                </c:pt>
                <c:pt idx="163">
                  <c:v>0.127029</c:v>
                </c:pt>
                <c:pt idx="164">
                  <c:v>0.12956200000000001</c:v>
                </c:pt>
                <c:pt idx="165">
                  <c:v>0.13122600000000001</c:v>
                </c:pt>
                <c:pt idx="166">
                  <c:v>0.13369800000000001</c:v>
                </c:pt>
                <c:pt idx="167">
                  <c:v>0.13626099999999999</c:v>
                </c:pt>
                <c:pt idx="168">
                  <c:v>0.138626</c:v>
                </c:pt>
                <c:pt idx="169">
                  <c:v>0.141296</c:v>
                </c:pt>
                <c:pt idx="170">
                  <c:v>0.143738</c:v>
                </c:pt>
                <c:pt idx="171">
                  <c:v>0.14654500000000001</c:v>
                </c:pt>
                <c:pt idx="172">
                  <c:v>0.14857500000000001</c:v>
                </c:pt>
                <c:pt idx="173">
                  <c:v>0.15126000000000001</c:v>
                </c:pt>
                <c:pt idx="174">
                  <c:v>0.153671</c:v>
                </c:pt>
                <c:pt idx="175">
                  <c:v>0.15567</c:v>
                </c:pt>
                <c:pt idx="176">
                  <c:v>0.158279</c:v>
                </c:pt>
                <c:pt idx="177">
                  <c:v>0.160583</c:v>
                </c:pt>
                <c:pt idx="178">
                  <c:v>0.162994</c:v>
                </c:pt>
                <c:pt idx="179">
                  <c:v>0.16484099999999999</c:v>
                </c:pt>
                <c:pt idx="180">
                  <c:v>0.16686999999999999</c:v>
                </c:pt>
                <c:pt idx="181">
                  <c:v>0.168823</c:v>
                </c:pt>
                <c:pt idx="182">
                  <c:v>0.170319</c:v>
                </c:pt>
                <c:pt idx="183">
                  <c:v>0.17161599999999999</c:v>
                </c:pt>
                <c:pt idx="184">
                  <c:v>0.17308000000000001</c:v>
                </c:pt>
                <c:pt idx="185">
                  <c:v>0.17446900000000001</c:v>
                </c:pt>
                <c:pt idx="186">
                  <c:v>0.175507</c:v>
                </c:pt>
                <c:pt idx="187">
                  <c:v>0.17666599999999999</c:v>
                </c:pt>
                <c:pt idx="188">
                  <c:v>0.17762800000000001</c:v>
                </c:pt>
                <c:pt idx="189">
                  <c:v>0.178116</c:v>
                </c:pt>
                <c:pt idx="190">
                  <c:v>0.17857400000000001</c:v>
                </c:pt>
                <c:pt idx="191">
                  <c:v>0.17907699999999999</c:v>
                </c:pt>
                <c:pt idx="192">
                  <c:v>0.179092</c:v>
                </c:pt>
                <c:pt idx="193">
                  <c:v>0.17904700000000001</c:v>
                </c:pt>
                <c:pt idx="194">
                  <c:v>0.17907699999999999</c:v>
                </c:pt>
                <c:pt idx="195">
                  <c:v>0.17849699999999999</c:v>
                </c:pt>
                <c:pt idx="196">
                  <c:v>0.17807000000000001</c:v>
                </c:pt>
                <c:pt idx="197">
                  <c:v>0.17749000000000001</c:v>
                </c:pt>
                <c:pt idx="198">
                  <c:v>0.17671200000000001</c:v>
                </c:pt>
                <c:pt idx="199">
                  <c:v>0.17543</c:v>
                </c:pt>
                <c:pt idx="200">
                  <c:v>0.17422499999999999</c:v>
                </c:pt>
                <c:pt idx="201">
                  <c:v>0.17286699999999999</c:v>
                </c:pt>
                <c:pt idx="202">
                  <c:v>0.17132600000000001</c:v>
                </c:pt>
                <c:pt idx="203">
                  <c:v>0.169434</c:v>
                </c:pt>
                <c:pt idx="204">
                  <c:v>0.167465</c:v>
                </c:pt>
                <c:pt idx="205">
                  <c:v>0.16537499999999999</c:v>
                </c:pt>
                <c:pt idx="206">
                  <c:v>0.163101</c:v>
                </c:pt>
                <c:pt idx="207">
                  <c:v>0.16056799999999999</c:v>
                </c:pt>
                <c:pt idx="208">
                  <c:v>0.158051</c:v>
                </c:pt>
                <c:pt idx="209">
                  <c:v>0.15504499999999999</c:v>
                </c:pt>
                <c:pt idx="210">
                  <c:v>0.15206900000000001</c:v>
                </c:pt>
                <c:pt idx="211">
                  <c:v>0.14901700000000001</c:v>
                </c:pt>
                <c:pt idx="212">
                  <c:v>0.14566000000000001</c:v>
                </c:pt>
                <c:pt idx="213">
                  <c:v>0.14230300000000001</c:v>
                </c:pt>
                <c:pt idx="214">
                  <c:v>0.138794</c:v>
                </c:pt>
                <c:pt idx="215">
                  <c:v>0.13503999999999999</c:v>
                </c:pt>
                <c:pt idx="216">
                  <c:v>0.13139300000000001</c:v>
                </c:pt>
                <c:pt idx="217">
                  <c:v>0.12742600000000001</c:v>
                </c:pt>
                <c:pt idx="218">
                  <c:v>0.123352</c:v>
                </c:pt>
                <c:pt idx="219">
                  <c:v>0.119431</c:v>
                </c:pt>
                <c:pt idx="220">
                  <c:v>0.11526500000000001</c:v>
                </c:pt>
                <c:pt idx="221">
                  <c:v>0.111176</c:v>
                </c:pt>
                <c:pt idx="222">
                  <c:v>0.107071</c:v>
                </c:pt>
                <c:pt idx="223">
                  <c:v>0.102921</c:v>
                </c:pt>
                <c:pt idx="224">
                  <c:v>9.8663000000000001E-2</c:v>
                </c:pt>
                <c:pt idx="225">
                  <c:v>9.4344999999999998E-2</c:v>
                </c:pt>
                <c:pt idx="226">
                  <c:v>9.0621999999999994E-2</c:v>
                </c:pt>
                <c:pt idx="227">
                  <c:v>8.6594000000000004E-2</c:v>
                </c:pt>
                <c:pt idx="228">
                  <c:v>8.2733000000000001E-2</c:v>
                </c:pt>
                <c:pt idx="229">
                  <c:v>7.9131999999999994E-2</c:v>
                </c:pt>
                <c:pt idx="230">
                  <c:v>7.5546000000000002E-2</c:v>
                </c:pt>
                <c:pt idx="231">
                  <c:v>7.2127999999999998E-2</c:v>
                </c:pt>
                <c:pt idx="232">
                  <c:v>6.8954000000000001E-2</c:v>
                </c:pt>
                <c:pt idx="233">
                  <c:v>6.6009999999999999E-2</c:v>
                </c:pt>
                <c:pt idx="234">
                  <c:v>6.3353999999999994E-2</c:v>
                </c:pt>
                <c:pt idx="235">
                  <c:v>6.0745E-2</c:v>
                </c:pt>
                <c:pt idx="236">
                  <c:v>5.8257999999999997E-2</c:v>
                </c:pt>
                <c:pt idx="237">
                  <c:v>5.6015000000000002E-2</c:v>
                </c:pt>
                <c:pt idx="238">
                  <c:v>5.4092000000000001E-2</c:v>
                </c:pt>
                <c:pt idx="239">
                  <c:v>5.2322E-2</c:v>
                </c:pt>
                <c:pt idx="240">
                  <c:v>5.0597999999999997E-2</c:v>
                </c:pt>
                <c:pt idx="241">
                  <c:v>4.9224999999999998E-2</c:v>
                </c:pt>
                <c:pt idx="242">
                  <c:v>4.7806000000000001E-2</c:v>
                </c:pt>
                <c:pt idx="243">
                  <c:v>4.6630999999999999E-2</c:v>
                </c:pt>
                <c:pt idx="244">
                  <c:v>4.5502000000000001E-2</c:v>
                </c:pt>
                <c:pt idx="245">
                  <c:v>4.4525000000000002E-2</c:v>
                </c:pt>
                <c:pt idx="246">
                  <c:v>4.3747000000000001E-2</c:v>
                </c:pt>
                <c:pt idx="247">
                  <c:v>4.3076000000000003E-2</c:v>
                </c:pt>
                <c:pt idx="248">
                  <c:v>4.2297000000000001E-2</c:v>
                </c:pt>
                <c:pt idx="249">
                  <c:v>4.1717999999999998E-2</c:v>
                </c:pt>
                <c:pt idx="250">
                  <c:v>4.1214000000000001E-2</c:v>
                </c:pt>
                <c:pt idx="251">
                  <c:v>4.0786999999999997E-2</c:v>
                </c:pt>
                <c:pt idx="252">
                  <c:v>4.0481999999999997E-2</c:v>
                </c:pt>
                <c:pt idx="253">
                  <c:v>4.0038999999999998E-2</c:v>
                </c:pt>
                <c:pt idx="254">
                  <c:v>3.9749E-2</c:v>
                </c:pt>
                <c:pt idx="255">
                  <c:v>3.952E-2</c:v>
                </c:pt>
                <c:pt idx="256">
                  <c:v>3.9246000000000003E-2</c:v>
                </c:pt>
                <c:pt idx="257">
                  <c:v>3.9046999999999998E-2</c:v>
                </c:pt>
                <c:pt idx="258">
                  <c:v>3.8970999999999999E-2</c:v>
                </c:pt>
                <c:pt idx="259">
                  <c:v>3.8773000000000002E-2</c:v>
                </c:pt>
                <c:pt idx="260">
                  <c:v>3.8650999999999998E-2</c:v>
                </c:pt>
                <c:pt idx="261">
                  <c:v>3.8528E-2</c:v>
                </c:pt>
                <c:pt idx="262">
                  <c:v>3.8483000000000003E-2</c:v>
                </c:pt>
                <c:pt idx="263">
                  <c:v>3.8360999999999999E-2</c:v>
                </c:pt>
                <c:pt idx="264">
                  <c:v>3.8239000000000002E-2</c:v>
                </c:pt>
                <c:pt idx="265">
                  <c:v>3.8115999999999997E-2</c:v>
                </c:pt>
                <c:pt idx="266">
                  <c:v>3.8086000000000002E-2</c:v>
                </c:pt>
                <c:pt idx="267">
                  <c:v>3.7994E-2</c:v>
                </c:pt>
                <c:pt idx="268">
                  <c:v>3.8010000000000002E-2</c:v>
                </c:pt>
                <c:pt idx="269">
                  <c:v>3.7810999999999997E-2</c:v>
                </c:pt>
                <c:pt idx="270">
                  <c:v>3.7734999999999998E-2</c:v>
                </c:pt>
                <c:pt idx="271">
                  <c:v>3.7781000000000002E-2</c:v>
                </c:pt>
                <c:pt idx="272">
                  <c:v>3.7749999999999999E-2</c:v>
                </c:pt>
                <c:pt idx="273">
                  <c:v>3.7673999999999999E-2</c:v>
                </c:pt>
                <c:pt idx="274">
                  <c:v>3.7613000000000001E-2</c:v>
                </c:pt>
                <c:pt idx="275">
                  <c:v>3.7581999999999997E-2</c:v>
                </c:pt>
                <c:pt idx="276">
                  <c:v>3.7537000000000001E-2</c:v>
                </c:pt>
                <c:pt idx="277">
                  <c:v>3.7520999999999999E-2</c:v>
                </c:pt>
                <c:pt idx="278">
                  <c:v>3.7368999999999999E-2</c:v>
                </c:pt>
                <c:pt idx="279">
                  <c:v>3.7476000000000002E-2</c:v>
                </c:pt>
                <c:pt idx="280">
                  <c:v>3.7414999999999997E-2</c:v>
                </c:pt>
                <c:pt idx="281">
                  <c:v>3.7399000000000002E-2</c:v>
                </c:pt>
                <c:pt idx="282">
                  <c:v>3.7384000000000001E-2</c:v>
                </c:pt>
                <c:pt idx="283">
                  <c:v>3.7353999999999998E-2</c:v>
                </c:pt>
                <c:pt idx="284">
                  <c:v>3.7215999999999999E-2</c:v>
                </c:pt>
                <c:pt idx="285">
                  <c:v>3.7155000000000001E-2</c:v>
                </c:pt>
                <c:pt idx="286">
                  <c:v>3.7124999999999998E-2</c:v>
                </c:pt>
                <c:pt idx="287">
                  <c:v>3.7033000000000003E-2</c:v>
                </c:pt>
                <c:pt idx="288">
                  <c:v>3.6986999999999999E-2</c:v>
                </c:pt>
                <c:pt idx="289">
                  <c:v>3.7003000000000001E-2</c:v>
                </c:pt>
                <c:pt idx="290">
                  <c:v>3.6986999999999999E-2</c:v>
                </c:pt>
                <c:pt idx="291">
                  <c:v>3.7003000000000001E-2</c:v>
                </c:pt>
                <c:pt idx="292">
                  <c:v>3.6910999999999999E-2</c:v>
                </c:pt>
                <c:pt idx="293">
                  <c:v>3.6880000000000003E-2</c:v>
                </c:pt>
                <c:pt idx="294">
                  <c:v>3.6865000000000002E-2</c:v>
                </c:pt>
                <c:pt idx="295">
                  <c:v>3.6774000000000001E-2</c:v>
                </c:pt>
                <c:pt idx="296">
                  <c:v>3.6713000000000003E-2</c:v>
                </c:pt>
                <c:pt idx="297">
                  <c:v>3.6742999999999998E-2</c:v>
                </c:pt>
                <c:pt idx="298">
                  <c:v>3.6606E-2</c:v>
                </c:pt>
                <c:pt idx="299">
                  <c:v>3.6575000000000003E-2</c:v>
                </c:pt>
                <c:pt idx="300">
                  <c:v>3.6606E-2</c:v>
                </c:pt>
                <c:pt idx="301">
                  <c:v>3.6606E-2</c:v>
                </c:pt>
                <c:pt idx="302">
                  <c:v>3.6590999999999999E-2</c:v>
                </c:pt>
                <c:pt idx="303">
                  <c:v>3.6636000000000002E-2</c:v>
                </c:pt>
                <c:pt idx="304">
                  <c:v>3.6681999999999999E-2</c:v>
                </c:pt>
                <c:pt idx="305">
                  <c:v>3.6621000000000001E-2</c:v>
                </c:pt>
                <c:pt idx="306">
                  <c:v>3.6590999999999999E-2</c:v>
                </c:pt>
                <c:pt idx="307">
                  <c:v>3.6590999999999999E-2</c:v>
                </c:pt>
                <c:pt idx="308">
                  <c:v>3.6590999999999999E-2</c:v>
                </c:pt>
                <c:pt idx="309">
                  <c:v>3.6498999999999997E-2</c:v>
                </c:pt>
                <c:pt idx="310">
                  <c:v>3.6498999999999997E-2</c:v>
                </c:pt>
                <c:pt idx="311">
                  <c:v>3.6498999999999997E-2</c:v>
                </c:pt>
                <c:pt idx="312">
                  <c:v>3.6437999999999998E-2</c:v>
                </c:pt>
                <c:pt idx="313">
                  <c:v>3.6422999999999997E-2</c:v>
                </c:pt>
                <c:pt idx="314">
                  <c:v>3.6437999999999998E-2</c:v>
                </c:pt>
                <c:pt idx="315">
                  <c:v>3.6422999999999997E-2</c:v>
                </c:pt>
                <c:pt idx="316">
                  <c:v>3.6346000000000003E-2</c:v>
                </c:pt>
                <c:pt idx="317">
                  <c:v>3.6316000000000001E-2</c:v>
                </c:pt>
                <c:pt idx="318">
                  <c:v>3.6377E-2</c:v>
                </c:pt>
                <c:pt idx="319">
                  <c:v>3.6361999999999998E-2</c:v>
                </c:pt>
                <c:pt idx="320">
                  <c:v>3.6392000000000001E-2</c:v>
                </c:pt>
                <c:pt idx="321">
                  <c:v>3.6392000000000001E-2</c:v>
                </c:pt>
                <c:pt idx="322">
                  <c:v>3.6284999999999998E-2</c:v>
                </c:pt>
                <c:pt idx="323">
                  <c:v>3.6255000000000003E-2</c:v>
                </c:pt>
                <c:pt idx="324">
                  <c:v>3.6269999999999997E-2</c:v>
                </c:pt>
                <c:pt idx="325">
                  <c:v>3.6208999999999998E-2</c:v>
                </c:pt>
                <c:pt idx="326">
                  <c:v>3.6193999999999997E-2</c:v>
                </c:pt>
                <c:pt idx="327">
                  <c:v>3.6255000000000003E-2</c:v>
                </c:pt>
                <c:pt idx="328">
                  <c:v>3.6223999999999999E-2</c:v>
                </c:pt>
                <c:pt idx="329">
                  <c:v>3.6132999999999998E-2</c:v>
                </c:pt>
                <c:pt idx="330">
                  <c:v>3.6087000000000001E-2</c:v>
                </c:pt>
                <c:pt idx="331">
                  <c:v>3.6132999999999998E-2</c:v>
                </c:pt>
                <c:pt idx="332">
                  <c:v>3.6056999999999999E-2</c:v>
                </c:pt>
                <c:pt idx="333">
                  <c:v>3.6072E-2</c:v>
                </c:pt>
                <c:pt idx="334">
                  <c:v>3.6026000000000002E-2</c:v>
                </c:pt>
                <c:pt idx="335">
                  <c:v>3.6056999999999999E-2</c:v>
                </c:pt>
                <c:pt idx="336">
                  <c:v>3.5994999999999999E-2</c:v>
                </c:pt>
                <c:pt idx="337">
                  <c:v>3.5994999999999999E-2</c:v>
                </c:pt>
                <c:pt idx="338">
                  <c:v>3.5979999999999998E-2</c:v>
                </c:pt>
                <c:pt idx="339">
                  <c:v>3.5979999999999998E-2</c:v>
                </c:pt>
                <c:pt idx="340">
                  <c:v>3.5979999999999998E-2</c:v>
                </c:pt>
                <c:pt idx="341">
                  <c:v>3.5919E-2</c:v>
                </c:pt>
                <c:pt idx="342">
                  <c:v>3.5843E-2</c:v>
                </c:pt>
                <c:pt idx="343">
                  <c:v>3.5873000000000002E-2</c:v>
                </c:pt>
                <c:pt idx="344">
                  <c:v>3.5858000000000001E-2</c:v>
                </c:pt>
                <c:pt idx="345">
                  <c:v>3.5858000000000001E-2</c:v>
                </c:pt>
                <c:pt idx="346">
                  <c:v>3.5811999999999997E-2</c:v>
                </c:pt>
                <c:pt idx="347">
                  <c:v>3.5674999999999998E-2</c:v>
                </c:pt>
                <c:pt idx="348">
                  <c:v>3.5659999999999997E-2</c:v>
                </c:pt>
                <c:pt idx="349">
                  <c:v>3.5674999999999998E-2</c:v>
                </c:pt>
                <c:pt idx="350">
                  <c:v>3.5645000000000003E-2</c:v>
                </c:pt>
                <c:pt idx="351">
                  <c:v>3.5538E-2</c:v>
                </c:pt>
                <c:pt idx="352">
                  <c:v>3.5538E-2</c:v>
                </c:pt>
                <c:pt idx="353">
                  <c:v>3.5538E-2</c:v>
                </c:pt>
                <c:pt idx="354">
                  <c:v>3.5521999999999998E-2</c:v>
                </c:pt>
                <c:pt idx="355">
                  <c:v>3.5598999999999999E-2</c:v>
                </c:pt>
                <c:pt idx="356">
                  <c:v>3.5538E-2</c:v>
                </c:pt>
                <c:pt idx="357">
                  <c:v>3.5568000000000002E-2</c:v>
                </c:pt>
                <c:pt idx="358">
                  <c:v>3.5553000000000001E-2</c:v>
                </c:pt>
                <c:pt idx="359">
                  <c:v>3.5492000000000003E-2</c:v>
                </c:pt>
                <c:pt idx="360">
                  <c:v>3.5521999999999998E-2</c:v>
                </c:pt>
                <c:pt idx="361">
                  <c:v>3.5538E-2</c:v>
                </c:pt>
                <c:pt idx="362">
                  <c:v>3.5521999999999998E-2</c:v>
                </c:pt>
                <c:pt idx="363">
                  <c:v>3.5430999999999997E-2</c:v>
                </c:pt>
                <c:pt idx="364">
                  <c:v>3.5430999999999997E-2</c:v>
                </c:pt>
                <c:pt idx="365">
                  <c:v>3.5400000000000001E-2</c:v>
                </c:pt>
                <c:pt idx="366">
                  <c:v>3.5400000000000001E-2</c:v>
                </c:pt>
                <c:pt idx="367">
                  <c:v>3.5416000000000003E-2</c:v>
                </c:pt>
                <c:pt idx="368">
                  <c:v>3.5339000000000002E-2</c:v>
                </c:pt>
                <c:pt idx="369">
                  <c:v>3.5416000000000003E-2</c:v>
                </c:pt>
                <c:pt idx="370">
                  <c:v>3.5385E-2</c:v>
                </c:pt>
                <c:pt idx="371">
                  <c:v>3.5309E-2</c:v>
                </c:pt>
                <c:pt idx="372">
                  <c:v>3.5263000000000003E-2</c:v>
                </c:pt>
                <c:pt idx="373">
                  <c:v>3.5233E-2</c:v>
                </c:pt>
                <c:pt idx="374">
                  <c:v>3.5277999999999997E-2</c:v>
                </c:pt>
                <c:pt idx="375">
                  <c:v>3.5277999999999997E-2</c:v>
                </c:pt>
                <c:pt idx="376">
                  <c:v>3.5293999999999999E-2</c:v>
                </c:pt>
                <c:pt idx="377">
                  <c:v>3.5201999999999997E-2</c:v>
                </c:pt>
                <c:pt idx="378">
                  <c:v>3.5216999999999998E-2</c:v>
                </c:pt>
                <c:pt idx="379">
                  <c:v>3.5233E-2</c:v>
                </c:pt>
                <c:pt idx="380">
                  <c:v>3.5140999999999999E-2</c:v>
                </c:pt>
                <c:pt idx="381">
                  <c:v>3.5201999999999997E-2</c:v>
                </c:pt>
                <c:pt idx="382">
                  <c:v>3.5216999999999998E-2</c:v>
                </c:pt>
                <c:pt idx="383">
                  <c:v>3.5187000000000003E-2</c:v>
                </c:pt>
                <c:pt idx="384">
                  <c:v>3.5140999999999999E-2</c:v>
                </c:pt>
                <c:pt idx="385">
                  <c:v>3.5095000000000001E-2</c:v>
                </c:pt>
                <c:pt idx="386">
                  <c:v>3.5140999999999999E-2</c:v>
                </c:pt>
                <c:pt idx="387">
                  <c:v>3.5125999999999998E-2</c:v>
                </c:pt>
                <c:pt idx="388">
                  <c:v>3.5110000000000002E-2</c:v>
                </c:pt>
                <c:pt idx="389">
                  <c:v>3.5125999999999998E-2</c:v>
                </c:pt>
                <c:pt idx="390">
                  <c:v>3.5172000000000002E-2</c:v>
                </c:pt>
                <c:pt idx="391">
                  <c:v>3.5172000000000002E-2</c:v>
                </c:pt>
                <c:pt idx="392">
                  <c:v>3.5156E-2</c:v>
                </c:pt>
                <c:pt idx="393">
                  <c:v>3.5187000000000003E-2</c:v>
                </c:pt>
                <c:pt idx="394">
                  <c:v>3.5233E-2</c:v>
                </c:pt>
                <c:pt idx="395">
                  <c:v>3.5156E-2</c:v>
                </c:pt>
                <c:pt idx="396">
                  <c:v>3.5125999999999998E-2</c:v>
                </c:pt>
                <c:pt idx="397">
                  <c:v>3.5187000000000003E-2</c:v>
                </c:pt>
                <c:pt idx="398">
                  <c:v>3.5156E-2</c:v>
                </c:pt>
                <c:pt idx="399">
                  <c:v>3.5140999999999999E-2</c:v>
                </c:pt>
                <c:pt idx="400">
                  <c:v>3.5233E-2</c:v>
                </c:pt>
                <c:pt idx="401">
                  <c:v>3.5172000000000002E-2</c:v>
                </c:pt>
                <c:pt idx="402">
                  <c:v>3.5201999999999997E-2</c:v>
                </c:pt>
                <c:pt idx="403">
                  <c:v>3.5248000000000002E-2</c:v>
                </c:pt>
                <c:pt idx="404">
                  <c:v>3.5248000000000002E-2</c:v>
                </c:pt>
                <c:pt idx="405">
                  <c:v>3.5277999999999997E-2</c:v>
                </c:pt>
                <c:pt idx="406">
                  <c:v>3.5324000000000001E-2</c:v>
                </c:pt>
                <c:pt idx="407">
                  <c:v>3.5339000000000002E-2</c:v>
                </c:pt>
                <c:pt idx="408">
                  <c:v>3.5477000000000002E-2</c:v>
                </c:pt>
                <c:pt idx="409">
                  <c:v>3.5445999999999998E-2</c:v>
                </c:pt>
                <c:pt idx="410">
                  <c:v>3.5492000000000003E-2</c:v>
                </c:pt>
                <c:pt idx="411">
                  <c:v>3.5477000000000002E-2</c:v>
                </c:pt>
                <c:pt idx="412">
                  <c:v>3.5568000000000002E-2</c:v>
                </c:pt>
                <c:pt idx="413">
                  <c:v>3.5598999999999999E-2</c:v>
                </c:pt>
                <c:pt idx="414">
                  <c:v>3.5582999999999997E-2</c:v>
                </c:pt>
                <c:pt idx="415">
                  <c:v>3.5506999999999997E-2</c:v>
                </c:pt>
                <c:pt idx="416">
                  <c:v>3.5521999999999998E-2</c:v>
                </c:pt>
                <c:pt idx="417">
                  <c:v>3.5568000000000002E-2</c:v>
                </c:pt>
                <c:pt idx="418">
                  <c:v>3.5553000000000001E-2</c:v>
                </c:pt>
                <c:pt idx="419">
                  <c:v>3.5521999999999998E-2</c:v>
                </c:pt>
                <c:pt idx="420">
                  <c:v>3.5582999999999997E-2</c:v>
                </c:pt>
                <c:pt idx="421">
                  <c:v>3.5477000000000002E-2</c:v>
                </c:pt>
                <c:pt idx="422">
                  <c:v>3.5477000000000002E-2</c:v>
                </c:pt>
                <c:pt idx="423">
                  <c:v>3.5492000000000003E-2</c:v>
                </c:pt>
                <c:pt idx="424">
                  <c:v>3.5568000000000002E-2</c:v>
                </c:pt>
                <c:pt idx="425">
                  <c:v>3.5430999999999997E-2</c:v>
                </c:pt>
                <c:pt idx="426">
                  <c:v>3.5445999999999998E-2</c:v>
                </c:pt>
                <c:pt idx="427">
                  <c:v>3.5538E-2</c:v>
                </c:pt>
                <c:pt idx="428">
                  <c:v>3.5445999999999998E-2</c:v>
                </c:pt>
                <c:pt idx="429">
                  <c:v>3.5477000000000002E-2</c:v>
                </c:pt>
                <c:pt idx="430">
                  <c:v>3.5506999999999997E-2</c:v>
                </c:pt>
                <c:pt idx="431">
                  <c:v>3.5521999999999998E-2</c:v>
                </c:pt>
                <c:pt idx="432">
                  <c:v>3.5477000000000002E-2</c:v>
                </c:pt>
                <c:pt idx="433">
                  <c:v>3.5477000000000002E-2</c:v>
                </c:pt>
                <c:pt idx="434">
                  <c:v>3.5492000000000003E-2</c:v>
                </c:pt>
                <c:pt idx="435">
                  <c:v>3.5385E-2</c:v>
                </c:pt>
                <c:pt idx="436">
                  <c:v>3.5506999999999997E-2</c:v>
                </c:pt>
                <c:pt idx="437">
                  <c:v>3.5492000000000003E-2</c:v>
                </c:pt>
                <c:pt idx="438">
                  <c:v>3.5460999999999999E-2</c:v>
                </c:pt>
                <c:pt idx="439">
                  <c:v>3.5568000000000002E-2</c:v>
                </c:pt>
                <c:pt idx="440">
                  <c:v>3.5477000000000002E-2</c:v>
                </c:pt>
                <c:pt idx="441">
                  <c:v>3.5460999999999999E-2</c:v>
                </c:pt>
                <c:pt idx="442">
                  <c:v>3.5506999999999997E-2</c:v>
                </c:pt>
                <c:pt idx="443">
                  <c:v>3.5598999999999999E-2</c:v>
                </c:pt>
                <c:pt idx="444">
                  <c:v>3.5629000000000001E-2</c:v>
                </c:pt>
                <c:pt idx="445">
                  <c:v>3.5538E-2</c:v>
                </c:pt>
                <c:pt idx="446">
                  <c:v>3.5492000000000003E-2</c:v>
                </c:pt>
                <c:pt idx="447">
                  <c:v>3.5477000000000002E-2</c:v>
                </c:pt>
                <c:pt idx="448">
                  <c:v>3.5400000000000001E-2</c:v>
                </c:pt>
                <c:pt idx="449">
                  <c:v>3.5339000000000002E-2</c:v>
                </c:pt>
                <c:pt idx="450">
                  <c:v>3.5369999999999999E-2</c:v>
                </c:pt>
                <c:pt idx="451">
                  <c:v>3.5339000000000002E-2</c:v>
                </c:pt>
                <c:pt idx="452">
                  <c:v>3.5248000000000002E-2</c:v>
                </c:pt>
                <c:pt idx="453">
                  <c:v>3.5233E-2</c:v>
                </c:pt>
                <c:pt idx="454">
                  <c:v>3.5339000000000002E-2</c:v>
                </c:pt>
                <c:pt idx="455">
                  <c:v>3.5460999999999999E-2</c:v>
                </c:pt>
                <c:pt idx="456">
                  <c:v>3.5385E-2</c:v>
                </c:pt>
                <c:pt idx="457">
                  <c:v>3.5477000000000002E-2</c:v>
                </c:pt>
                <c:pt idx="458">
                  <c:v>3.5582999999999997E-2</c:v>
                </c:pt>
                <c:pt idx="459">
                  <c:v>3.5614E-2</c:v>
                </c:pt>
                <c:pt idx="460">
                  <c:v>3.5582999999999997E-2</c:v>
                </c:pt>
                <c:pt idx="461">
                  <c:v>3.5568000000000002E-2</c:v>
                </c:pt>
                <c:pt idx="462">
                  <c:v>3.5614E-2</c:v>
                </c:pt>
                <c:pt idx="463">
                  <c:v>3.5645000000000003E-2</c:v>
                </c:pt>
                <c:pt idx="464">
                  <c:v>3.5645000000000003E-2</c:v>
                </c:pt>
                <c:pt idx="465">
                  <c:v>3.5674999999999998E-2</c:v>
                </c:pt>
                <c:pt idx="466">
                  <c:v>3.5674999999999998E-2</c:v>
                </c:pt>
                <c:pt idx="467">
                  <c:v>3.5645000000000003E-2</c:v>
                </c:pt>
                <c:pt idx="468">
                  <c:v>3.5598999999999999E-2</c:v>
                </c:pt>
                <c:pt idx="469">
                  <c:v>3.569E-2</c:v>
                </c:pt>
                <c:pt idx="470">
                  <c:v>3.5629000000000001E-2</c:v>
                </c:pt>
                <c:pt idx="471">
                  <c:v>3.5674999999999998E-2</c:v>
                </c:pt>
                <c:pt idx="472">
                  <c:v>3.5706000000000002E-2</c:v>
                </c:pt>
                <c:pt idx="473">
                  <c:v>3.5674999999999998E-2</c:v>
                </c:pt>
                <c:pt idx="474">
                  <c:v>3.5706000000000002E-2</c:v>
                </c:pt>
                <c:pt idx="475">
                  <c:v>3.5721000000000003E-2</c:v>
                </c:pt>
                <c:pt idx="476">
                  <c:v>3.5674999999999998E-2</c:v>
                </c:pt>
                <c:pt idx="477">
                  <c:v>3.5659999999999997E-2</c:v>
                </c:pt>
                <c:pt idx="478">
                  <c:v>3.5568000000000002E-2</c:v>
                </c:pt>
                <c:pt idx="479">
                  <c:v>3.5506999999999997E-2</c:v>
                </c:pt>
                <c:pt idx="480">
                  <c:v>3.5553000000000001E-2</c:v>
                </c:pt>
                <c:pt idx="481">
                  <c:v>3.5614E-2</c:v>
                </c:pt>
                <c:pt idx="482">
                  <c:v>3.5645000000000003E-2</c:v>
                </c:pt>
                <c:pt idx="483">
                  <c:v>3.569E-2</c:v>
                </c:pt>
                <c:pt idx="484">
                  <c:v>3.5735999999999997E-2</c:v>
                </c:pt>
                <c:pt idx="485">
                  <c:v>3.5674999999999998E-2</c:v>
                </c:pt>
                <c:pt idx="486">
                  <c:v>3.5629000000000001E-2</c:v>
                </c:pt>
                <c:pt idx="487">
                  <c:v>3.5629000000000001E-2</c:v>
                </c:pt>
                <c:pt idx="488">
                  <c:v>3.5614E-2</c:v>
                </c:pt>
                <c:pt idx="489">
                  <c:v>3.5568000000000002E-2</c:v>
                </c:pt>
                <c:pt idx="490">
                  <c:v>3.5614E-2</c:v>
                </c:pt>
                <c:pt idx="491">
                  <c:v>3.5645000000000003E-2</c:v>
                </c:pt>
                <c:pt idx="492">
                  <c:v>3.5614E-2</c:v>
                </c:pt>
                <c:pt idx="493">
                  <c:v>3.569E-2</c:v>
                </c:pt>
                <c:pt idx="494">
                  <c:v>3.5735999999999997E-2</c:v>
                </c:pt>
                <c:pt idx="495">
                  <c:v>3.5721000000000003E-2</c:v>
                </c:pt>
                <c:pt idx="496">
                  <c:v>3.5674999999999998E-2</c:v>
                </c:pt>
                <c:pt idx="497">
                  <c:v>3.5645000000000003E-2</c:v>
                </c:pt>
                <c:pt idx="498">
                  <c:v>3.5782000000000001E-2</c:v>
                </c:pt>
                <c:pt idx="499">
                  <c:v>3.5706000000000002E-2</c:v>
                </c:pt>
                <c:pt idx="500">
                  <c:v>3.5721000000000003E-2</c:v>
                </c:pt>
                <c:pt idx="501">
                  <c:v>3.5827999999999999E-2</c:v>
                </c:pt>
                <c:pt idx="502">
                  <c:v>3.5797000000000002E-2</c:v>
                </c:pt>
                <c:pt idx="503">
                  <c:v>3.5827999999999999E-2</c:v>
                </c:pt>
                <c:pt idx="504">
                  <c:v>3.5903999999999998E-2</c:v>
                </c:pt>
                <c:pt idx="505">
                  <c:v>3.5919E-2</c:v>
                </c:pt>
                <c:pt idx="506">
                  <c:v>3.5979999999999998E-2</c:v>
                </c:pt>
                <c:pt idx="507">
                  <c:v>3.6040999999999997E-2</c:v>
                </c:pt>
                <c:pt idx="508">
                  <c:v>3.6026000000000002E-2</c:v>
                </c:pt>
                <c:pt idx="509">
                  <c:v>3.6193999999999997E-2</c:v>
                </c:pt>
                <c:pt idx="510">
                  <c:v>3.6223999999999999E-2</c:v>
                </c:pt>
              </c:numCache>
            </c:numRef>
          </c:yVal>
          <c:smooth val="1"/>
          <c:extLst>
            <c:ext xmlns:c16="http://schemas.microsoft.com/office/drawing/2014/chart" uri="{C3380CC4-5D6E-409C-BE32-E72D297353CC}">
              <c16:uniqueId val="{00000003-3FAF-4CBF-82DD-E60AB52489B3}"/>
            </c:ext>
          </c:extLst>
        </c:ser>
        <c:dLbls>
          <c:showLegendKey val="0"/>
          <c:showVal val="0"/>
          <c:showCatName val="0"/>
          <c:showSerName val="0"/>
          <c:showPercent val="0"/>
          <c:showBubbleSize val="0"/>
        </c:dLbls>
        <c:axId val="148437696"/>
        <c:axId val="148438256"/>
      </c:scatterChart>
      <c:scatterChart>
        <c:scatterStyle val="smoothMarker"/>
        <c:varyColors val="0"/>
        <c:ser>
          <c:idx val="6"/>
          <c:order val="4"/>
          <c:tx>
            <c:strRef>
              <c:f>Emission!$A$1</c:f>
              <c:strCache>
                <c:ptCount val="1"/>
                <c:pt idx="0">
                  <c:v>Quinine Sulphate (200 μM) H2SO4 Emission</c:v>
                </c:pt>
              </c:strCache>
            </c:strRef>
          </c:tx>
          <c:spPr>
            <a:ln>
              <a:solidFill>
                <a:schemeClr val="accent5">
                  <a:lumMod val="60000"/>
                  <a:lumOff val="40000"/>
                </a:schemeClr>
              </a:solidFill>
            </a:ln>
          </c:spPr>
          <c:marker>
            <c:symbol val="none"/>
          </c:marker>
          <c:xVal>
            <c:numRef>
              <c:f>Emission!$A$14:$A$613</c:f>
              <c:numCache>
                <c:formatCode>General</c:formatCode>
                <c:ptCount val="600"/>
                <c:pt idx="0">
                  <c:v>400.4500122</c:v>
                </c:pt>
                <c:pt idx="1">
                  <c:v>401.05999759999997</c:v>
                </c:pt>
                <c:pt idx="2">
                  <c:v>401.51000979999998</c:v>
                </c:pt>
                <c:pt idx="3">
                  <c:v>401.9599915</c:v>
                </c:pt>
                <c:pt idx="4">
                  <c:v>402.57000729999999</c:v>
                </c:pt>
                <c:pt idx="5">
                  <c:v>403.02999879999999</c:v>
                </c:pt>
                <c:pt idx="6">
                  <c:v>403.48001099999999</c:v>
                </c:pt>
                <c:pt idx="7">
                  <c:v>403.92999270000001</c:v>
                </c:pt>
                <c:pt idx="8">
                  <c:v>404.5400085</c:v>
                </c:pt>
                <c:pt idx="9">
                  <c:v>405</c:v>
                </c:pt>
                <c:pt idx="10">
                  <c:v>405.4500122</c:v>
                </c:pt>
                <c:pt idx="11">
                  <c:v>406.05999759999997</c:v>
                </c:pt>
                <c:pt idx="12">
                  <c:v>406.51000979999998</c:v>
                </c:pt>
                <c:pt idx="13">
                  <c:v>406.9599915</c:v>
                </c:pt>
                <c:pt idx="14">
                  <c:v>407.57000729999999</c:v>
                </c:pt>
                <c:pt idx="15">
                  <c:v>408.02999879999999</c:v>
                </c:pt>
                <c:pt idx="16">
                  <c:v>408.48001099999999</c:v>
                </c:pt>
                <c:pt idx="17">
                  <c:v>408.92999270000001</c:v>
                </c:pt>
                <c:pt idx="18">
                  <c:v>409.5400085</c:v>
                </c:pt>
                <c:pt idx="19">
                  <c:v>410</c:v>
                </c:pt>
                <c:pt idx="20">
                  <c:v>410.4500122</c:v>
                </c:pt>
                <c:pt idx="21">
                  <c:v>411.05999759999997</c:v>
                </c:pt>
                <c:pt idx="22">
                  <c:v>411.51000979999998</c:v>
                </c:pt>
                <c:pt idx="23">
                  <c:v>411.9599915</c:v>
                </c:pt>
                <c:pt idx="24">
                  <c:v>412.57000729999999</c:v>
                </c:pt>
                <c:pt idx="25">
                  <c:v>413.02999879999999</c:v>
                </c:pt>
                <c:pt idx="26">
                  <c:v>413.48001099999999</c:v>
                </c:pt>
                <c:pt idx="27">
                  <c:v>413.92999270000001</c:v>
                </c:pt>
                <c:pt idx="28">
                  <c:v>414.5400085</c:v>
                </c:pt>
                <c:pt idx="29">
                  <c:v>415</c:v>
                </c:pt>
                <c:pt idx="30">
                  <c:v>415.4500122</c:v>
                </c:pt>
                <c:pt idx="31">
                  <c:v>416.05999759999997</c:v>
                </c:pt>
                <c:pt idx="32">
                  <c:v>416.51000979999998</c:v>
                </c:pt>
                <c:pt idx="33">
                  <c:v>416.9599915</c:v>
                </c:pt>
                <c:pt idx="34">
                  <c:v>417.57000729999999</c:v>
                </c:pt>
                <c:pt idx="35">
                  <c:v>418.02999879999999</c:v>
                </c:pt>
                <c:pt idx="36">
                  <c:v>418.48001099999999</c:v>
                </c:pt>
                <c:pt idx="37">
                  <c:v>418.92999270000001</c:v>
                </c:pt>
                <c:pt idx="38">
                  <c:v>419.5400085</c:v>
                </c:pt>
                <c:pt idx="39">
                  <c:v>420</c:v>
                </c:pt>
                <c:pt idx="40">
                  <c:v>420.4500122</c:v>
                </c:pt>
                <c:pt idx="41">
                  <c:v>421.05999759999997</c:v>
                </c:pt>
                <c:pt idx="42">
                  <c:v>421.51000979999998</c:v>
                </c:pt>
                <c:pt idx="43">
                  <c:v>421.9599915</c:v>
                </c:pt>
                <c:pt idx="44">
                  <c:v>422.57000729999999</c:v>
                </c:pt>
                <c:pt idx="45">
                  <c:v>423.02999879999999</c:v>
                </c:pt>
                <c:pt idx="46">
                  <c:v>423.48001099999999</c:v>
                </c:pt>
                <c:pt idx="47">
                  <c:v>423.92999270000001</c:v>
                </c:pt>
                <c:pt idx="48">
                  <c:v>424.5400085</c:v>
                </c:pt>
                <c:pt idx="49">
                  <c:v>425</c:v>
                </c:pt>
                <c:pt idx="50">
                  <c:v>425.4500122</c:v>
                </c:pt>
                <c:pt idx="51">
                  <c:v>426.05999759999997</c:v>
                </c:pt>
                <c:pt idx="52">
                  <c:v>426.51000979999998</c:v>
                </c:pt>
                <c:pt idx="53">
                  <c:v>426.9599915</c:v>
                </c:pt>
                <c:pt idx="54">
                  <c:v>427.57000729999999</c:v>
                </c:pt>
                <c:pt idx="55">
                  <c:v>428.02999879999999</c:v>
                </c:pt>
                <c:pt idx="56">
                  <c:v>428.48001099999999</c:v>
                </c:pt>
                <c:pt idx="57">
                  <c:v>428.92999270000001</c:v>
                </c:pt>
                <c:pt idx="58">
                  <c:v>429.5400085</c:v>
                </c:pt>
                <c:pt idx="59">
                  <c:v>430</c:v>
                </c:pt>
                <c:pt idx="60">
                  <c:v>430.4500122</c:v>
                </c:pt>
                <c:pt idx="61">
                  <c:v>431.05999759999997</c:v>
                </c:pt>
                <c:pt idx="62">
                  <c:v>431.51000979999998</c:v>
                </c:pt>
                <c:pt idx="63">
                  <c:v>431.9599915</c:v>
                </c:pt>
                <c:pt idx="64">
                  <c:v>432.57000729999999</c:v>
                </c:pt>
                <c:pt idx="65">
                  <c:v>433.02999879999999</c:v>
                </c:pt>
                <c:pt idx="66">
                  <c:v>433.48001099999999</c:v>
                </c:pt>
                <c:pt idx="67">
                  <c:v>433.92999270000001</c:v>
                </c:pt>
                <c:pt idx="68">
                  <c:v>434.5400085</c:v>
                </c:pt>
                <c:pt idx="69">
                  <c:v>435</c:v>
                </c:pt>
                <c:pt idx="70">
                  <c:v>435.4500122</c:v>
                </c:pt>
                <c:pt idx="71">
                  <c:v>436.05999759999997</c:v>
                </c:pt>
                <c:pt idx="72">
                  <c:v>436.51000979999998</c:v>
                </c:pt>
                <c:pt idx="73">
                  <c:v>436.9599915</c:v>
                </c:pt>
                <c:pt idx="74">
                  <c:v>437.57000729999999</c:v>
                </c:pt>
                <c:pt idx="75">
                  <c:v>438.02999879999999</c:v>
                </c:pt>
                <c:pt idx="76">
                  <c:v>438.48001099999999</c:v>
                </c:pt>
                <c:pt idx="77">
                  <c:v>438.92999270000001</c:v>
                </c:pt>
                <c:pt idx="78">
                  <c:v>439.5400085</c:v>
                </c:pt>
                <c:pt idx="79">
                  <c:v>440</c:v>
                </c:pt>
                <c:pt idx="80">
                  <c:v>440.4500122</c:v>
                </c:pt>
                <c:pt idx="81">
                  <c:v>441.05999759999997</c:v>
                </c:pt>
                <c:pt idx="82">
                  <c:v>441.51000979999998</c:v>
                </c:pt>
                <c:pt idx="83">
                  <c:v>441.9599915</c:v>
                </c:pt>
                <c:pt idx="84">
                  <c:v>442.57000729999999</c:v>
                </c:pt>
                <c:pt idx="85">
                  <c:v>443.02999879999999</c:v>
                </c:pt>
                <c:pt idx="86">
                  <c:v>443.48001099999999</c:v>
                </c:pt>
                <c:pt idx="87">
                  <c:v>443.92999270000001</c:v>
                </c:pt>
                <c:pt idx="88">
                  <c:v>444.5400085</c:v>
                </c:pt>
                <c:pt idx="89">
                  <c:v>445</c:v>
                </c:pt>
                <c:pt idx="90">
                  <c:v>445.4500122</c:v>
                </c:pt>
                <c:pt idx="91">
                  <c:v>446.05999759999997</c:v>
                </c:pt>
                <c:pt idx="92">
                  <c:v>446.51000979999998</c:v>
                </c:pt>
                <c:pt idx="93">
                  <c:v>446.9599915</c:v>
                </c:pt>
                <c:pt idx="94">
                  <c:v>447.57000729999999</c:v>
                </c:pt>
                <c:pt idx="95">
                  <c:v>448.02999879999999</c:v>
                </c:pt>
                <c:pt idx="96">
                  <c:v>448.48001099999999</c:v>
                </c:pt>
                <c:pt idx="97">
                  <c:v>448.92999270000001</c:v>
                </c:pt>
                <c:pt idx="98">
                  <c:v>449.5400085</c:v>
                </c:pt>
                <c:pt idx="99">
                  <c:v>450</c:v>
                </c:pt>
                <c:pt idx="100">
                  <c:v>450.44000240000003</c:v>
                </c:pt>
                <c:pt idx="101">
                  <c:v>451.0400085</c:v>
                </c:pt>
                <c:pt idx="102">
                  <c:v>451.48999020000002</c:v>
                </c:pt>
                <c:pt idx="103">
                  <c:v>451.94000240000003</c:v>
                </c:pt>
                <c:pt idx="104">
                  <c:v>452.52999879999999</c:v>
                </c:pt>
                <c:pt idx="105">
                  <c:v>452.98001099999999</c:v>
                </c:pt>
                <c:pt idx="106">
                  <c:v>453.42999270000001</c:v>
                </c:pt>
                <c:pt idx="107">
                  <c:v>454.01998900000001</c:v>
                </c:pt>
                <c:pt idx="108">
                  <c:v>454.47000120000001</c:v>
                </c:pt>
                <c:pt idx="109">
                  <c:v>455.07000729999999</c:v>
                </c:pt>
                <c:pt idx="110">
                  <c:v>455.51998900000001</c:v>
                </c:pt>
                <c:pt idx="111">
                  <c:v>455.97000120000001</c:v>
                </c:pt>
                <c:pt idx="112">
                  <c:v>456.55999759999997</c:v>
                </c:pt>
                <c:pt idx="113">
                  <c:v>457.01000979999998</c:v>
                </c:pt>
                <c:pt idx="114">
                  <c:v>457.4599915</c:v>
                </c:pt>
                <c:pt idx="115">
                  <c:v>458.0499878</c:v>
                </c:pt>
                <c:pt idx="116">
                  <c:v>458.5</c:v>
                </c:pt>
                <c:pt idx="117">
                  <c:v>458.9500122</c:v>
                </c:pt>
                <c:pt idx="118">
                  <c:v>459.5499878</c:v>
                </c:pt>
                <c:pt idx="119">
                  <c:v>460</c:v>
                </c:pt>
                <c:pt idx="120">
                  <c:v>460.4500122</c:v>
                </c:pt>
                <c:pt idx="121">
                  <c:v>461.05999759999997</c:v>
                </c:pt>
                <c:pt idx="122">
                  <c:v>461.51000979999998</c:v>
                </c:pt>
                <c:pt idx="123">
                  <c:v>461.9599915</c:v>
                </c:pt>
                <c:pt idx="124">
                  <c:v>462.57000729999999</c:v>
                </c:pt>
                <c:pt idx="125">
                  <c:v>463.02999879999999</c:v>
                </c:pt>
                <c:pt idx="126">
                  <c:v>463.48001099999999</c:v>
                </c:pt>
                <c:pt idx="127">
                  <c:v>463.92999270000001</c:v>
                </c:pt>
                <c:pt idx="128">
                  <c:v>464.5400085</c:v>
                </c:pt>
                <c:pt idx="129">
                  <c:v>465</c:v>
                </c:pt>
                <c:pt idx="130">
                  <c:v>465.4500122</c:v>
                </c:pt>
                <c:pt idx="131">
                  <c:v>466.05999759999997</c:v>
                </c:pt>
                <c:pt idx="132">
                  <c:v>466.51000979999998</c:v>
                </c:pt>
                <c:pt idx="133">
                  <c:v>466.9599915</c:v>
                </c:pt>
                <c:pt idx="134">
                  <c:v>467.57000729999999</c:v>
                </c:pt>
                <c:pt idx="135">
                  <c:v>468.02999879999999</c:v>
                </c:pt>
                <c:pt idx="136">
                  <c:v>468.48001099999999</c:v>
                </c:pt>
                <c:pt idx="137">
                  <c:v>468.92999270000001</c:v>
                </c:pt>
                <c:pt idx="138">
                  <c:v>469.5400085</c:v>
                </c:pt>
                <c:pt idx="139">
                  <c:v>470</c:v>
                </c:pt>
                <c:pt idx="140">
                  <c:v>470.44000240000003</c:v>
                </c:pt>
                <c:pt idx="141">
                  <c:v>471.0400085</c:v>
                </c:pt>
                <c:pt idx="142">
                  <c:v>471.48999020000002</c:v>
                </c:pt>
                <c:pt idx="143">
                  <c:v>471.94000240000003</c:v>
                </c:pt>
                <c:pt idx="144">
                  <c:v>472.52999879999999</c:v>
                </c:pt>
                <c:pt idx="145">
                  <c:v>472.98001099999999</c:v>
                </c:pt>
                <c:pt idx="146">
                  <c:v>473.42999270000001</c:v>
                </c:pt>
                <c:pt idx="147">
                  <c:v>474.01998900000001</c:v>
                </c:pt>
                <c:pt idx="148">
                  <c:v>474.47000120000001</c:v>
                </c:pt>
                <c:pt idx="149">
                  <c:v>475.07000729999999</c:v>
                </c:pt>
                <c:pt idx="150">
                  <c:v>475.51998900000001</c:v>
                </c:pt>
                <c:pt idx="151">
                  <c:v>475.97000120000001</c:v>
                </c:pt>
                <c:pt idx="152">
                  <c:v>476.55999759999997</c:v>
                </c:pt>
                <c:pt idx="153">
                  <c:v>477.01000979999998</c:v>
                </c:pt>
                <c:pt idx="154">
                  <c:v>477.4599915</c:v>
                </c:pt>
                <c:pt idx="155">
                  <c:v>478.0499878</c:v>
                </c:pt>
                <c:pt idx="156">
                  <c:v>478.5</c:v>
                </c:pt>
                <c:pt idx="157">
                  <c:v>478.9500122</c:v>
                </c:pt>
                <c:pt idx="158">
                  <c:v>479.5499878</c:v>
                </c:pt>
                <c:pt idx="159">
                  <c:v>480</c:v>
                </c:pt>
                <c:pt idx="160">
                  <c:v>480.44000240000003</c:v>
                </c:pt>
                <c:pt idx="161">
                  <c:v>481.0400085</c:v>
                </c:pt>
                <c:pt idx="162">
                  <c:v>481.48999020000002</c:v>
                </c:pt>
                <c:pt idx="163">
                  <c:v>481.94000240000003</c:v>
                </c:pt>
                <c:pt idx="164">
                  <c:v>482.52999879999999</c:v>
                </c:pt>
                <c:pt idx="165">
                  <c:v>482.98001099999999</c:v>
                </c:pt>
                <c:pt idx="166">
                  <c:v>483.42999270000001</c:v>
                </c:pt>
                <c:pt idx="167">
                  <c:v>484.01998900000001</c:v>
                </c:pt>
                <c:pt idx="168">
                  <c:v>484.47000120000001</c:v>
                </c:pt>
                <c:pt idx="169">
                  <c:v>485.07000729999999</c:v>
                </c:pt>
                <c:pt idx="170">
                  <c:v>485.51998900000001</c:v>
                </c:pt>
                <c:pt idx="171">
                  <c:v>485.97000120000001</c:v>
                </c:pt>
                <c:pt idx="172">
                  <c:v>486.55999759999997</c:v>
                </c:pt>
                <c:pt idx="173">
                  <c:v>487.01000979999998</c:v>
                </c:pt>
                <c:pt idx="174">
                  <c:v>487.4599915</c:v>
                </c:pt>
                <c:pt idx="175">
                  <c:v>488.0499878</c:v>
                </c:pt>
                <c:pt idx="176">
                  <c:v>488.5</c:v>
                </c:pt>
                <c:pt idx="177">
                  <c:v>488.9500122</c:v>
                </c:pt>
                <c:pt idx="178">
                  <c:v>489.5499878</c:v>
                </c:pt>
                <c:pt idx="179">
                  <c:v>490</c:v>
                </c:pt>
                <c:pt idx="180">
                  <c:v>490.44000240000003</c:v>
                </c:pt>
                <c:pt idx="181">
                  <c:v>491.0400085</c:v>
                </c:pt>
                <c:pt idx="182">
                  <c:v>491.48999020000002</c:v>
                </c:pt>
                <c:pt idx="183">
                  <c:v>491.94000240000003</c:v>
                </c:pt>
                <c:pt idx="184">
                  <c:v>492.52999879999999</c:v>
                </c:pt>
                <c:pt idx="185">
                  <c:v>492.98001099999999</c:v>
                </c:pt>
                <c:pt idx="186">
                  <c:v>493.42999270000001</c:v>
                </c:pt>
                <c:pt idx="187">
                  <c:v>494.01998900000001</c:v>
                </c:pt>
                <c:pt idx="188">
                  <c:v>494.47000120000001</c:v>
                </c:pt>
                <c:pt idx="189">
                  <c:v>495.07000729999999</c:v>
                </c:pt>
                <c:pt idx="190">
                  <c:v>495.51998900000001</c:v>
                </c:pt>
                <c:pt idx="191">
                  <c:v>495.97000120000001</c:v>
                </c:pt>
                <c:pt idx="192">
                  <c:v>496.55999759999997</c:v>
                </c:pt>
                <c:pt idx="193">
                  <c:v>497.01000979999998</c:v>
                </c:pt>
                <c:pt idx="194">
                  <c:v>497.4599915</c:v>
                </c:pt>
                <c:pt idx="195">
                  <c:v>498.0499878</c:v>
                </c:pt>
                <c:pt idx="196">
                  <c:v>498.5</c:v>
                </c:pt>
                <c:pt idx="197">
                  <c:v>498.9500122</c:v>
                </c:pt>
                <c:pt idx="198">
                  <c:v>499.5499878</c:v>
                </c:pt>
                <c:pt idx="199">
                  <c:v>500</c:v>
                </c:pt>
                <c:pt idx="200">
                  <c:v>500.44000240000003</c:v>
                </c:pt>
                <c:pt idx="201">
                  <c:v>501.0400085</c:v>
                </c:pt>
                <c:pt idx="202">
                  <c:v>501.48999020000002</c:v>
                </c:pt>
                <c:pt idx="203">
                  <c:v>501.94000240000003</c:v>
                </c:pt>
                <c:pt idx="204">
                  <c:v>502.52999879999999</c:v>
                </c:pt>
                <c:pt idx="205">
                  <c:v>502.98001099999999</c:v>
                </c:pt>
                <c:pt idx="206">
                  <c:v>503.42999270000001</c:v>
                </c:pt>
                <c:pt idx="207">
                  <c:v>504.01998900000001</c:v>
                </c:pt>
                <c:pt idx="208">
                  <c:v>504.47000120000001</c:v>
                </c:pt>
                <c:pt idx="209">
                  <c:v>505.07000729999999</c:v>
                </c:pt>
                <c:pt idx="210">
                  <c:v>505.51998900000001</c:v>
                </c:pt>
                <c:pt idx="211">
                  <c:v>505.97000120000001</c:v>
                </c:pt>
                <c:pt idx="212">
                  <c:v>506.55999759999997</c:v>
                </c:pt>
                <c:pt idx="213">
                  <c:v>507.01000979999998</c:v>
                </c:pt>
                <c:pt idx="214">
                  <c:v>507.4599915</c:v>
                </c:pt>
                <c:pt idx="215">
                  <c:v>508.0499878</c:v>
                </c:pt>
                <c:pt idx="216">
                  <c:v>508.5</c:v>
                </c:pt>
                <c:pt idx="217">
                  <c:v>508.9500122</c:v>
                </c:pt>
                <c:pt idx="218">
                  <c:v>509.5499878</c:v>
                </c:pt>
                <c:pt idx="219">
                  <c:v>510</c:v>
                </c:pt>
                <c:pt idx="220">
                  <c:v>510.44000240000003</c:v>
                </c:pt>
                <c:pt idx="221">
                  <c:v>511.0400085</c:v>
                </c:pt>
                <c:pt idx="222">
                  <c:v>511.48999020000002</c:v>
                </c:pt>
                <c:pt idx="223">
                  <c:v>511.94000240000003</c:v>
                </c:pt>
                <c:pt idx="224">
                  <c:v>512.53002930000002</c:v>
                </c:pt>
                <c:pt idx="225">
                  <c:v>512.97998050000001</c:v>
                </c:pt>
                <c:pt idx="226">
                  <c:v>513.42999269999996</c:v>
                </c:pt>
                <c:pt idx="227">
                  <c:v>514.02001949999999</c:v>
                </c:pt>
                <c:pt idx="228">
                  <c:v>514.46997069999998</c:v>
                </c:pt>
                <c:pt idx="229">
                  <c:v>515.07000730000004</c:v>
                </c:pt>
                <c:pt idx="230">
                  <c:v>515.52001949999999</c:v>
                </c:pt>
                <c:pt idx="231">
                  <c:v>515.96997069999998</c:v>
                </c:pt>
                <c:pt idx="232">
                  <c:v>516.55999759999997</c:v>
                </c:pt>
                <c:pt idx="233">
                  <c:v>517.01000980000003</c:v>
                </c:pt>
                <c:pt idx="234">
                  <c:v>517.46002199999998</c:v>
                </c:pt>
                <c:pt idx="235">
                  <c:v>518.04998780000005</c:v>
                </c:pt>
                <c:pt idx="236">
                  <c:v>518.5</c:v>
                </c:pt>
                <c:pt idx="237">
                  <c:v>518.95001219999995</c:v>
                </c:pt>
                <c:pt idx="238">
                  <c:v>519.54998780000005</c:v>
                </c:pt>
                <c:pt idx="239">
                  <c:v>520</c:v>
                </c:pt>
                <c:pt idx="240">
                  <c:v>520.44000240000003</c:v>
                </c:pt>
                <c:pt idx="241">
                  <c:v>521.03997800000002</c:v>
                </c:pt>
                <c:pt idx="242">
                  <c:v>521.48999019999997</c:v>
                </c:pt>
                <c:pt idx="243">
                  <c:v>521.94000240000003</c:v>
                </c:pt>
                <c:pt idx="244">
                  <c:v>522.53002930000002</c:v>
                </c:pt>
                <c:pt idx="245">
                  <c:v>522.97998050000001</c:v>
                </c:pt>
                <c:pt idx="246">
                  <c:v>523.42999269999996</c:v>
                </c:pt>
                <c:pt idx="247">
                  <c:v>524.02001949999999</c:v>
                </c:pt>
                <c:pt idx="248">
                  <c:v>524.46997069999998</c:v>
                </c:pt>
                <c:pt idx="249">
                  <c:v>525.07000730000004</c:v>
                </c:pt>
                <c:pt idx="250">
                  <c:v>525.52001949999999</c:v>
                </c:pt>
                <c:pt idx="251">
                  <c:v>525.96997069999998</c:v>
                </c:pt>
                <c:pt idx="252">
                  <c:v>526.55999759999997</c:v>
                </c:pt>
                <c:pt idx="253">
                  <c:v>527.01000980000003</c:v>
                </c:pt>
                <c:pt idx="254">
                  <c:v>527.46002199999998</c:v>
                </c:pt>
                <c:pt idx="255">
                  <c:v>528.04998780000005</c:v>
                </c:pt>
                <c:pt idx="256">
                  <c:v>528.5</c:v>
                </c:pt>
                <c:pt idx="257">
                  <c:v>528.95001219999995</c:v>
                </c:pt>
                <c:pt idx="258">
                  <c:v>529.54998780000005</c:v>
                </c:pt>
                <c:pt idx="259">
                  <c:v>530</c:v>
                </c:pt>
                <c:pt idx="260">
                  <c:v>530.44000240000003</c:v>
                </c:pt>
                <c:pt idx="261">
                  <c:v>531.02001949999999</c:v>
                </c:pt>
                <c:pt idx="262">
                  <c:v>531.46997069999998</c:v>
                </c:pt>
                <c:pt idx="263">
                  <c:v>532.04998780000005</c:v>
                </c:pt>
                <c:pt idx="264">
                  <c:v>532.5</c:v>
                </c:pt>
                <c:pt idx="265">
                  <c:v>532.94000240000003</c:v>
                </c:pt>
                <c:pt idx="266">
                  <c:v>533.52001949999999</c:v>
                </c:pt>
                <c:pt idx="267">
                  <c:v>533.96997069999998</c:v>
                </c:pt>
                <c:pt idx="268">
                  <c:v>534.54998780000005</c:v>
                </c:pt>
                <c:pt idx="269">
                  <c:v>535</c:v>
                </c:pt>
                <c:pt idx="270">
                  <c:v>535.44000240000003</c:v>
                </c:pt>
                <c:pt idx="271">
                  <c:v>536.02001949999999</c:v>
                </c:pt>
                <c:pt idx="272">
                  <c:v>536.46997069999998</c:v>
                </c:pt>
                <c:pt idx="273">
                  <c:v>537.04998780000005</c:v>
                </c:pt>
                <c:pt idx="274">
                  <c:v>537.5</c:v>
                </c:pt>
                <c:pt idx="275">
                  <c:v>537.94000240000003</c:v>
                </c:pt>
                <c:pt idx="276">
                  <c:v>538.52001949999999</c:v>
                </c:pt>
                <c:pt idx="277">
                  <c:v>538.96997069999998</c:v>
                </c:pt>
                <c:pt idx="278">
                  <c:v>539.54998780000005</c:v>
                </c:pt>
                <c:pt idx="279">
                  <c:v>540</c:v>
                </c:pt>
                <c:pt idx="280">
                  <c:v>540.44000240000003</c:v>
                </c:pt>
                <c:pt idx="281">
                  <c:v>541.02001949999999</c:v>
                </c:pt>
                <c:pt idx="282">
                  <c:v>541.46997069999998</c:v>
                </c:pt>
                <c:pt idx="283">
                  <c:v>542.04998780000005</c:v>
                </c:pt>
                <c:pt idx="284">
                  <c:v>542.5</c:v>
                </c:pt>
                <c:pt idx="285">
                  <c:v>542.94000240000003</c:v>
                </c:pt>
                <c:pt idx="286">
                  <c:v>543.52001949999999</c:v>
                </c:pt>
                <c:pt idx="287">
                  <c:v>543.96997069999998</c:v>
                </c:pt>
                <c:pt idx="288">
                  <c:v>544.54998780000005</c:v>
                </c:pt>
                <c:pt idx="289">
                  <c:v>545</c:v>
                </c:pt>
                <c:pt idx="290">
                  <c:v>545.44000240000003</c:v>
                </c:pt>
                <c:pt idx="291">
                  <c:v>546.02001949999999</c:v>
                </c:pt>
                <c:pt idx="292">
                  <c:v>546.46997069999998</c:v>
                </c:pt>
                <c:pt idx="293">
                  <c:v>547.04998780000005</c:v>
                </c:pt>
                <c:pt idx="294">
                  <c:v>547.5</c:v>
                </c:pt>
                <c:pt idx="295">
                  <c:v>547.94000240000003</c:v>
                </c:pt>
                <c:pt idx="296">
                  <c:v>548.52001949999999</c:v>
                </c:pt>
                <c:pt idx="297">
                  <c:v>548.96997069999998</c:v>
                </c:pt>
                <c:pt idx="298">
                  <c:v>549.54998780000005</c:v>
                </c:pt>
                <c:pt idx="299">
                  <c:v>550</c:v>
                </c:pt>
                <c:pt idx="300">
                  <c:v>550.44000240000003</c:v>
                </c:pt>
                <c:pt idx="301">
                  <c:v>551.02001949999999</c:v>
                </c:pt>
                <c:pt idx="302">
                  <c:v>551.46997069999998</c:v>
                </c:pt>
                <c:pt idx="303">
                  <c:v>552.04998780000005</c:v>
                </c:pt>
                <c:pt idx="304">
                  <c:v>552.5</c:v>
                </c:pt>
                <c:pt idx="305">
                  <c:v>552.94000240000003</c:v>
                </c:pt>
                <c:pt idx="306">
                  <c:v>553.52001949999999</c:v>
                </c:pt>
                <c:pt idx="307">
                  <c:v>553.96997069999998</c:v>
                </c:pt>
                <c:pt idx="308">
                  <c:v>554.54998780000005</c:v>
                </c:pt>
                <c:pt idx="309">
                  <c:v>555</c:v>
                </c:pt>
                <c:pt idx="310">
                  <c:v>555.44000240000003</c:v>
                </c:pt>
                <c:pt idx="311">
                  <c:v>556.02001949999999</c:v>
                </c:pt>
                <c:pt idx="312">
                  <c:v>556.46997069999998</c:v>
                </c:pt>
                <c:pt idx="313">
                  <c:v>557.04998780000005</c:v>
                </c:pt>
                <c:pt idx="314">
                  <c:v>557.5</c:v>
                </c:pt>
                <c:pt idx="315">
                  <c:v>557.94000240000003</c:v>
                </c:pt>
                <c:pt idx="316">
                  <c:v>558.52001949999999</c:v>
                </c:pt>
                <c:pt idx="317">
                  <c:v>558.96997069999998</c:v>
                </c:pt>
                <c:pt idx="318">
                  <c:v>559.54998780000005</c:v>
                </c:pt>
                <c:pt idx="319">
                  <c:v>560</c:v>
                </c:pt>
                <c:pt idx="320">
                  <c:v>560.44000240000003</c:v>
                </c:pt>
                <c:pt idx="321">
                  <c:v>561.02001949999999</c:v>
                </c:pt>
                <c:pt idx="322">
                  <c:v>561.46997069999998</c:v>
                </c:pt>
                <c:pt idx="323">
                  <c:v>562.04998780000005</c:v>
                </c:pt>
                <c:pt idx="324">
                  <c:v>562.5</c:v>
                </c:pt>
                <c:pt idx="325">
                  <c:v>562.94000240000003</c:v>
                </c:pt>
                <c:pt idx="326">
                  <c:v>563.52001949999999</c:v>
                </c:pt>
                <c:pt idx="327">
                  <c:v>563.96997069999998</c:v>
                </c:pt>
                <c:pt idx="328">
                  <c:v>564.54998780000005</c:v>
                </c:pt>
                <c:pt idx="329">
                  <c:v>565</c:v>
                </c:pt>
                <c:pt idx="330">
                  <c:v>565.44000240000003</c:v>
                </c:pt>
                <c:pt idx="331">
                  <c:v>566.02001949999999</c:v>
                </c:pt>
                <c:pt idx="332">
                  <c:v>566.46997069999998</c:v>
                </c:pt>
                <c:pt idx="333">
                  <c:v>567.04998780000005</c:v>
                </c:pt>
                <c:pt idx="334">
                  <c:v>567.5</c:v>
                </c:pt>
                <c:pt idx="335">
                  <c:v>567.94000240000003</c:v>
                </c:pt>
                <c:pt idx="336">
                  <c:v>568.52001949999999</c:v>
                </c:pt>
                <c:pt idx="337">
                  <c:v>568.96997069999998</c:v>
                </c:pt>
                <c:pt idx="338">
                  <c:v>569.54998780000005</c:v>
                </c:pt>
                <c:pt idx="339">
                  <c:v>570</c:v>
                </c:pt>
                <c:pt idx="340">
                  <c:v>570.44000240000003</c:v>
                </c:pt>
                <c:pt idx="341">
                  <c:v>571.02001949999999</c:v>
                </c:pt>
                <c:pt idx="342">
                  <c:v>571.46997069999998</c:v>
                </c:pt>
                <c:pt idx="343">
                  <c:v>572.04998780000005</c:v>
                </c:pt>
                <c:pt idx="344">
                  <c:v>572.5</c:v>
                </c:pt>
                <c:pt idx="345">
                  <c:v>572.94000240000003</c:v>
                </c:pt>
                <c:pt idx="346">
                  <c:v>573.52001949999999</c:v>
                </c:pt>
                <c:pt idx="347">
                  <c:v>573.96997069999998</c:v>
                </c:pt>
                <c:pt idx="348">
                  <c:v>574.54998780000005</c:v>
                </c:pt>
                <c:pt idx="349">
                  <c:v>575</c:v>
                </c:pt>
                <c:pt idx="350">
                  <c:v>575.44000240000003</c:v>
                </c:pt>
                <c:pt idx="351">
                  <c:v>576.02001949999999</c:v>
                </c:pt>
                <c:pt idx="352">
                  <c:v>576.46997069999998</c:v>
                </c:pt>
                <c:pt idx="353">
                  <c:v>577.04998780000005</c:v>
                </c:pt>
                <c:pt idx="354">
                  <c:v>577.5</c:v>
                </c:pt>
                <c:pt idx="355">
                  <c:v>577.94000240000003</c:v>
                </c:pt>
                <c:pt idx="356">
                  <c:v>578.52001949999999</c:v>
                </c:pt>
                <c:pt idx="357">
                  <c:v>578.96997069999998</c:v>
                </c:pt>
                <c:pt idx="358">
                  <c:v>579.54998780000005</c:v>
                </c:pt>
                <c:pt idx="359">
                  <c:v>580</c:v>
                </c:pt>
                <c:pt idx="360">
                  <c:v>580.44000240000003</c:v>
                </c:pt>
                <c:pt idx="361">
                  <c:v>581.02001949999999</c:v>
                </c:pt>
                <c:pt idx="362">
                  <c:v>581.46997069999998</c:v>
                </c:pt>
                <c:pt idx="363">
                  <c:v>582.04998780000005</c:v>
                </c:pt>
                <c:pt idx="364">
                  <c:v>582.5</c:v>
                </c:pt>
                <c:pt idx="365">
                  <c:v>582.94000240000003</c:v>
                </c:pt>
                <c:pt idx="366">
                  <c:v>583.52001949999999</c:v>
                </c:pt>
                <c:pt idx="367">
                  <c:v>583.96997069999998</c:v>
                </c:pt>
                <c:pt idx="368">
                  <c:v>584.54998780000005</c:v>
                </c:pt>
                <c:pt idx="369">
                  <c:v>585</c:v>
                </c:pt>
                <c:pt idx="370">
                  <c:v>585.44000240000003</c:v>
                </c:pt>
                <c:pt idx="371">
                  <c:v>586.02001949999999</c:v>
                </c:pt>
                <c:pt idx="372">
                  <c:v>586.46997069999998</c:v>
                </c:pt>
                <c:pt idx="373">
                  <c:v>587.04998780000005</c:v>
                </c:pt>
                <c:pt idx="374">
                  <c:v>587.5</c:v>
                </c:pt>
                <c:pt idx="375">
                  <c:v>587.94000240000003</c:v>
                </c:pt>
                <c:pt idx="376">
                  <c:v>588.52001949999999</c:v>
                </c:pt>
                <c:pt idx="377">
                  <c:v>588.96997069999998</c:v>
                </c:pt>
                <c:pt idx="378">
                  <c:v>589.54998780000005</c:v>
                </c:pt>
                <c:pt idx="379">
                  <c:v>590</c:v>
                </c:pt>
                <c:pt idx="380">
                  <c:v>590.42999269999996</c:v>
                </c:pt>
                <c:pt idx="381">
                  <c:v>591.01000980000003</c:v>
                </c:pt>
                <c:pt idx="382">
                  <c:v>591.44000240000003</c:v>
                </c:pt>
                <c:pt idx="383">
                  <c:v>592.02001949999999</c:v>
                </c:pt>
                <c:pt idx="384">
                  <c:v>592.46002199999998</c:v>
                </c:pt>
                <c:pt idx="385">
                  <c:v>593.03997800000002</c:v>
                </c:pt>
                <c:pt idx="386">
                  <c:v>593.46997069999998</c:v>
                </c:pt>
                <c:pt idx="387">
                  <c:v>594.04998780000005</c:v>
                </c:pt>
                <c:pt idx="388">
                  <c:v>594.48999019999997</c:v>
                </c:pt>
                <c:pt idx="389">
                  <c:v>595.07000730000004</c:v>
                </c:pt>
                <c:pt idx="390">
                  <c:v>595.5</c:v>
                </c:pt>
                <c:pt idx="391">
                  <c:v>595.94000240000003</c:v>
                </c:pt>
                <c:pt idx="392">
                  <c:v>596.52001949999999</c:v>
                </c:pt>
                <c:pt idx="393">
                  <c:v>596.95001219999995</c:v>
                </c:pt>
                <c:pt idx="394">
                  <c:v>597.53002930000002</c:v>
                </c:pt>
                <c:pt idx="395">
                  <c:v>597.96997069999998</c:v>
                </c:pt>
                <c:pt idx="396">
                  <c:v>598.54998780000005</c:v>
                </c:pt>
                <c:pt idx="397">
                  <c:v>598.97998050000001</c:v>
                </c:pt>
                <c:pt idx="398">
                  <c:v>599.55999759999997</c:v>
                </c:pt>
                <c:pt idx="399">
                  <c:v>600</c:v>
                </c:pt>
                <c:pt idx="400">
                  <c:v>600.42999269999996</c:v>
                </c:pt>
                <c:pt idx="401">
                  <c:v>601.01000980000003</c:v>
                </c:pt>
                <c:pt idx="402">
                  <c:v>601.44000240000003</c:v>
                </c:pt>
                <c:pt idx="403">
                  <c:v>602.02001949999999</c:v>
                </c:pt>
                <c:pt idx="404">
                  <c:v>602.46002199999998</c:v>
                </c:pt>
                <c:pt idx="405">
                  <c:v>603.03997800000002</c:v>
                </c:pt>
                <c:pt idx="406">
                  <c:v>603.46997069999998</c:v>
                </c:pt>
                <c:pt idx="407">
                  <c:v>604.04998780000005</c:v>
                </c:pt>
                <c:pt idx="408">
                  <c:v>604.48999019999997</c:v>
                </c:pt>
                <c:pt idx="409">
                  <c:v>605.07000730000004</c:v>
                </c:pt>
                <c:pt idx="410">
                  <c:v>605.5</c:v>
                </c:pt>
                <c:pt idx="411">
                  <c:v>605.94000240000003</c:v>
                </c:pt>
                <c:pt idx="412">
                  <c:v>606.52001949999999</c:v>
                </c:pt>
                <c:pt idx="413">
                  <c:v>606.95001219999995</c:v>
                </c:pt>
                <c:pt idx="414">
                  <c:v>607.53002930000002</c:v>
                </c:pt>
                <c:pt idx="415">
                  <c:v>607.96997069999998</c:v>
                </c:pt>
                <c:pt idx="416">
                  <c:v>608.54998780000005</c:v>
                </c:pt>
                <c:pt idx="417">
                  <c:v>608.97998050000001</c:v>
                </c:pt>
                <c:pt idx="418">
                  <c:v>609.55999759999997</c:v>
                </c:pt>
                <c:pt idx="419">
                  <c:v>610</c:v>
                </c:pt>
                <c:pt idx="420">
                  <c:v>610.42999269999996</c:v>
                </c:pt>
                <c:pt idx="421">
                  <c:v>611.01000980000003</c:v>
                </c:pt>
                <c:pt idx="422">
                  <c:v>611.44000240000003</c:v>
                </c:pt>
                <c:pt idx="423">
                  <c:v>612.02001949999999</c:v>
                </c:pt>
                <c:pt idx="424">
                  <c:v>612.46002199999998</c:v>
                </c:pt>
                <c:pt idx="425">
                  <c:v>613.03997800000002</c:v>
                </c:pt>
                <c:pt idx="426">
                  <c:v>613.46997069999998</c:v>
                </c:pt>
                <c:pt idx="427">
                  <c:v>614.04998780000005</c:v>
                </c:pt>
                <c:pt idx="428">
                  <c:v>614.48999019999997</c:v>
                </c:pt>
                <c:pt idx="429">
                  <c:v>615.07000730000004</c:v>
                </c:pt>
                <c:pt idx="430">
                  <c:v>615.5</c:v>
                </c:pt>
                <c:pt idx="431">
                  <c:v>615.94000240000003</c:v>
                </c:pt>
                <c:pt idx="432">
                  <c:v>616.52001949999999</c:v>
                </c:pt>
                <c:pt idx="433">
                  <c:v>616.95001219999995</c:v>
                </c:pt>
                <c:pt idx="434">
                  <c:v>617.53002930000002</c:v>
                </c:pt>
                <c:pt idx="435">
                  <c:v>617.96997069999998</c:v>
                </c:pt>
                <c:pt idx="436">
                  <c:v>618.54998780000005</c:v>
                </c:pt>
                <c:pt idx="437">
                  <c:v>618.97998050000001</c:v>
                </c:pt>
                <c:pt idx="438">
                  <c:v>619.55999759999997</c:v>
                </c:pt>
                <c:pt idx="439">
                  <c:v>620</c:v>
                </c:pt>
                <c:pt idx="440">
                  <c:v>620.42999269999996</c:v>
                </c:pt>
                <c:pt idx="441">
                  <c:v>621.01000980000003</c:v>
                </c:pt>
                <c:pt idx="442">
                  <c:v>621.44000240000003</c:v>
                </c:pt>
                <c:pt idx="443">
                  <c:v>622.02001949999999</c:v>
                </c:pt>
                <c:pt idx="444">
                  <c:v>622.46002199999998</c:v>
                </c:pt>
                <c:pt idx="445">
                  <c:v>623.03997800000002</c:v>
                </c:pt>
                <c:pt idx="446">
                  <c:v>623.46997069999998</c:v>
                </c:pt>
                <c:pt idx="447">
                  <c:v>624.04998780000005</c:v>
                </c:pt>
                <c:pt idx="448">
                  <c:v>624.48999019999997</c:v>
                </c:pt>
                <c:pt idx="449">
                  <c:v>625.07000730000004</c:v>
                </c:pt>
                <c:pt idx="450">
                  <c:v>625.5</c:v>
                </c:pt>
                <c:pt idx="451">
                  <c:v>625.94000240000003</c:v>
                </c:pt>
                <c:pt idx="452">
                  <c:v>626.52001949999999</c:v>
                </c:pt>
                <c:pt idx="453">
                  <c:v>626.95001219999995</c:v>
                </c:pt>
                <c:pt idx="454">
                  <c:v>627.53002930000002</c:v>
                </c:pt>
                <c:pt idx="455">
                  <c:v>627.96997069999998</c:v>
                </c:pt>
                <c:pt idx="456">
                  <c:v>628.54998780000005</c:v>
                </c:pt>
                <c:pt idx="457">
                  <c:v>628.97998050000001</c:v>
                </c:pt>
                <c:pt idx="458">
                  <c:v>629.55999759999997</c:v>
                </c:pt>
                <c:pt idx="459">
                  <c:v>630</c:v>
                </c:pt>
                <c:pt idx="460">
                  <c:v>630.42999269999996</c:v>
                </c:pt>
                <c:pt idx="461">
                  <c:v>631.01000980000003</c:v>
                </c:pt>
                <c:pt idx="462">
                  <c:v>631.44000240000003</c:v>
                </c:pt>
                <c:pt idx="463">
                  <c:v>632.02001949999999</c:v>
                </c:pt>
                <c:pt idx="464">
                  <c:v>632.46002199999998</c:v>
                </c:pt>
                <c:pt idx="465">
                  <c:v>633.03997800000002</c:v>
                </c:pt>
                <c:pt idx="466">
                  <c:v>633.46997069999998</c:v>
                </c:pt>
                <c:pt idx="467">
                  <c:v>634.04998780000005</c:v>
                </c:pt>
                <c:pt idx="468">
                  <c:v>634.48999019999997</c:v>
                </c:pt>
                <c:pt idx="469">
                  <c:v>635.07000730000004</c:v>
                </c:pt>
                <c:pt idx="470">
                  <c:v>635.5</c:v>
                </c:pt>
                <c:pt idx="471">
                  <c:v>635.94000240000003</c:v>
                </c:pt>
                <c:pt idx="472">
                  <c:v>636.52001949999999</c:v>
                </c:pt>
                <c:pt idx="473">
                  <c:v>636.95001219999995</c:v>
                </c:pt>
                <c:pt idx="474">
                  <c:v>637.53002930000002</c:v>
                </c:pt>
                <c:pt idx="475">
                  <c:v>637.96997069999998</c:v>
                </c:pt>
                <c:pt idx="476">
                  <c:v>638.54998780000005</c:v>
                </c:pt>
                <c:pt idx="477">
                  <c:v>638.97998050000001</c:v>
                </c:pt>
                <c:pt idx="478">
                  <c:v>639.55999759999997</c:v>
                </c:pt>
                <c:pt idx="479">
                  <c:v>640</c:v>
                </c:pt>
                <c:pt idx="480">
                  <c:v>640.57000730000004</c:v>
                </c:pt>
                <c:pt idx="481">
                  <c:v>641</c:v>
                </c:pt>
                <c:pt idx="482">
                  <c:v>641.57000730000004</c:v>
                </c:pt>
                <c:pt idx="483">
                  <c:v>642</c:v>
                </c:pt>
                <c:pt idx="484">
                  <c:v>642.57000730000004</c:v>
                </c:pt>
                <c:pt idx="485">
                  <c:v>643</c:v>
                </c:pt>
                <c:pt idx="486">
                  <c:v>643.57000730000004</c:v>
                </c:pt>
                <c:pt idx="487">
                  <c:v>644</c:v>
                </c:pt>
                <c:pt idx="488">
                  <c:v>644.57000730000004</c:v>
                </c:pt>
                <c:pt idx="489">
                  <c:v>645</c:v>
                </c:pt>
                <c:pt idx="490">
                  <c:v>645.57000730000004</c:v>
                </c:pt>
                <c:pt idx="491">
                  <c:v>646</c:v>
                </c:pt>
                <c:pt idx="492">
                  <c:v>646.57000730000004</c:v>
                </c:pt>
                <c:pt idx="493">
                  <c:v>647</c:v>
                </c:pt>
                <c:pt idx="494">
                  <c:v>647.57000730000004</c:v>
                </c:pt>
                <c:pt idx="495">
                  <c:v>648</c:v>
                </c:pt>
                <c:pt idx="496">
                  <c:v>648.57000730000004</c:v>
                </c:pt>
                <c:pt idx="497">
                  <c:v>649</c:v>
                </c:pt>
                <c:pt idx="498">
                  <c:v>649.57000730000004</c:v>
                </c:pt>
                <c:pt idx="499">
                  <c:v>650</c:v>
                </c:pt>
                <c:pt idx="500">
                  <c:v>650.42999269999996</c:v>
                </c:pt>
                <c:pt idx="501">
                  <c:v>651.01000980000003</c:v>
                </c:pt>
                <c:pt idx="502">
                  <c:v>651.44000240000003</c:v>
                </c:pt>
                <c:pt idx="503">
                  <c:v>652.02001949999999</c:v>
                </c:pt>
                <c:pt idx="504">
                  <c:v>652.46002199999998</c:v>
                </c:pt>
                <c:pt idx="505">
                  <c:v>653.03997800000002</c:v>
                </c:pt>
                <c:pt idx="506">
                  <c:v>653.46997069999998</c:v>
                </c:pt>
                <c:pt idx="507">
                  <c:v>654.04998780000005</c:v>
                </c:pt>
                <c:pt idx="508">
                  <c:v>654.48999019999997</c:v>
                </c:pt>
                <c:pt idx="509">
                  <c:v>655.07000730000004</c:v>
                </c:pt>
                <c:pt idx="510">
                  <c:v>655.5</c:v>
                </c:pt>
                <c:pt idx="511">
                  <c:v>655.94000240000003</c:v>
                </c:pt>
                <c:pt idx="512">
                  <c:v>656.52001949999999</c:v>
                </c:pt>
                <c:pt idx="513">
                  <c:v>656.95001219999995</c:v>
                </c:pt>
                <c:pt idx="514">
                  <c:v>657.53002930000002</c:v>
                </c:pt>
                <c:pt idx="515">
                  <c:v>657.96997069999998</c:v>
                </c:pt>
                <c:pt idx="516">
                  <c:v>658.54998780000005</c:v>
                </c:pt>
                <c:pt idx="517">
                  <c:v>658.97998050000001</c:v>
                </c:pt>
                <c:pt idx="518">
                  <c:v>659.55999759999997</c:v>
                </c:pt>
                <c:pt idx="519">
                  <c:v>660</c:v>
                </c:pt>
                <c:pt idx="520">
                  <c:v>660.57000730000004</c:v>
                </c:pt>
                <c:pt idx="521">
                  <c:v>661</c:v>
                </c:pt>
                <c:pt idx="522">
                  <c:v>661.57000730000004</c:v>
                </c:pt>
                <c:pt idx="523">
                  <c:v>662</c:v>
                </c:pt>
                <c:pt idx="524">
                  <c:v>662.57000730000004</c:v>
                </c:pt>
                <c:pt idx="525">
                  <c:v>663</c:v>
                </c:pt>
                <c:pt idx="526">
                  <c:v>663.57000730000004</c:v>
                </c:pt>
                <c:pt idx="527">
                  <c:v>664</c:v>
                </c:pt>
                <c:pt idx="528">
                  <c:v>664.57000730000004</c:v>
                </c:pt>
                <c:pt idx="529">
                  <c:v>665</c:v>
                </c:pt>
                <c:pt idx="530">
                  <c:v>665.57000730000004</c:v>
                </c:pt>
                <c:pt idx="531">
                  <c:v>666</c:v>
                </c:pt>
                <c:pt idx="532">
                  <c:v>666.57000730000004</c:v>
                </c:pt>
                <c:pt idx="533">
                  <c:v>667</c:v>
                </c:pt>
                <c:pt idx="534">
                  <c:v>667.57000730000004</c:v>
                </c:pt>
                <c:pt idx="535">
                  <c:v>668</c:v>
                </c:pt>
                <c:pt idx="536">
                  <c:v>668.57000730000004</c:v>
                </c:pt>
                <c:pt idx="537">
                  <c:v>669</c:v>
                </c:pt>
                <c:pt idx="538">
                  <c:v>669.57000730000004</c:v>
                </c:pt>
                <c:pt idx="539">
                  <c:v>670</c:v>
                </c:pt>
                <c:pt idx="540">
                  <c:v>670.55999759999997</c:v>
                </c:pt>
                <c:pt idx="541">
                  <c:v>670.97998050000001</c:v>
                </c:pt>
                <c:pt idx="542">
                  <c:v>671.53997800000002</c:v>
                </c:pt>
                <c:pt idx="543">
                  <c:v>671.96997069999998</c:v>
                </c:pt>
                <c:pt idx="544">
                  <c:v>672.53002930000002</c:v>
                </c:pt>
                <c:pt idx="545">
                  <c:v>672.95001219999995</c:v>
                </c:pt>
                <c:pt idx="546">
                  <c:v>673.52001949999999</c:v>
                </c:pt>
                <c:pt idx="547">
                  <c:v>673.94000240000003</c:v>
                </c:pt>
                <c:pt idx="548">
                  <c:v>674.5</c:v>
                </c:pt>
                <c:pt idx="549">
                  <c:v>675.07000730000004</c:v>
                </c:pt>
                <c:pt idx="550">
                  <c:v>675.48999019999997</c:v>
                </c:pt>
                <c:pt idx="551">
                  <c:v>676.04998780000005</c:v>
                </c:pt>
                <c:pt idx="552">
                  <c:v>676.46997069999998</c:v>
                </c:pt>
                <c:pt idx="553">
                  <c:v>677.03997800000002</c:v>
                </c:pt>
                <c:pt idx="554">
                  <c:v>677.46002199999998</c:v>
                </c:pt>
                <c:pt idx="555">
                  <c:v>678.02001949999999</c:v>
                </c:pt>
                <c:pt idx="556">
                  <c:v>678.45001219999995</c:v>
                </c:pt>
                <c:pt idx="557">
                  <c:v>679.01000980000003</c:v>
                </c:pt>
                <c:pt idx="558">
                  <c:v>679.42999269999996</c:v>
                </c:pt>
                <c:pt idx="559">
                  <c:v>680</c:v>
                </c:pt>
                <c:pt idx="560">
                  <c:v>680.57000730000004</c:v>
                </c:pt>
                <c:pt idx="561">
                  <c:v>681</c:v>
                </c:pt>
                <c:pt idx="562">
                  <c:v>681.57000730000004</c:v>
                </c:pt>
                <c:pt idx="563">
                  <c:v>682</c:v>
                </c:pt>
                <c:pt idx="564">
                  <c:v>682.57000730000004</c:v>
                </c:pt>
                <c:pt idx="565">
                  <c:v>683</c:v>
                </c:pt>
                <c:pt idx="566">
                  <c:v>683.57000730000004</c:v>
                </c:pt>
                <c:pt idx="567">
                  <c:v>684</c:v>
                </c:pt>
                <c:pt idx="568">
                  <c:v>684.57000730000004</c:v>
                </c:pt>
                <c:pt idx="569">
                  <c:v>685</c:v>
                </c:pt>
                <c:pt idx="570">
                  <c:v>685.57000730000004</c:v>
                </c:pt>
                <c:pt idx="571">
                  <c:v>686</c:v>
                </c:pt>
                <c:pt idx="572">
                  <c:v>686.57000730000004</c:v>
                </c:pt>
                <c:pt idx="573">
                  <c:v>687</c:v>
                </c:pt>
                <c:pt idx="574">
                  <c:v>687.57000730000004</c:v>
                </c:pt>
                <c:pt idx="575">
                  <c:v>688</c:v>
                </c:pt>
                <c:pt idx="576">
                  <c:v>688.57000730000004</c:v>
                </c:pt>
                <c:pt idx="577">
                  <c:v>689</c:v>
                </c:pt>
                <c:pt idx="578">
                  <c:v>689.57000730000004</c:v>
                </c:pt>
                <c:pt idx="579">
                  <c:v>690</c:v>
                </c:pt>
                <c:pt idx="580">
                  <c:v>690.55999759999997</c:v>
                </c:pt>
                <c:pt idx="581">
                  <c:v>690.97998050000001</c:v>
                </c:pt>
                <c:pt idx="582">
                  <c:v>691.53997800000002</c:v>
                </c:pt>
                <c:pt idx="583">
                  <c:v>691.96997069999998</c:v>
                </c:pt>
                <c:pt idx="584">
                  <c:v>692.53002930000002</c:v>
                </c:pt>
                <c:pt idx="585">
                  <c:v>692.95001219999995</c:v>
                </c:pt>
                <c:pt idx="586">
                  <c:v>693.52001949999999</c:v>
                </c:pt>
                <c:pt idx="587">
                  <c:v>693.94000240000003</c:v>
                </c:pt>
                <c:pt idx="588">
                  <c:v>694.5</c:v>
                </c:pt>
                <c:pt idx="589">
                  <c:v>695.07000730000004</c:v>
                </c:pt>
                <c:pt idx="590">
                  <c:v>695.48999019999997</c:v>
                </c:pt>
                <c:pt idx="591">
                  <c:v>696.04998780000005</c:v>
                </c:pt>
                <c:pt idx="592">
                  <c:v>696.46997069999998</c:v>
                </c:pt>
                <c:pt idx="593">
                  <c:v>697.03997800000002</c:v>
                </c:pt>
                <c:pt idx="594">
                  <c:v>697.46002199999998</c:v>
                </c:pt>
                <c:pt idx="595">
                  <c:v>698.02001949999999</c:v>
                </c:pt>
                <c:pt idx="596">
                  <c:v>698.45001219999995</c:v>
                </c:pt>
                <c:pt idx="597">
                  <c:v>699.01000980000003</c:v>
                </c:pt>
                <c:pt idx="598">
                  <c:v>699.42999269999996</c:v>
                </c:pt>
                <c:pt idx="599">
                  <c:v>700</c:v>
                </c:pt>
              </c:numCache>
            </c:numRef>
          </c:xVal>
          <c:yVal>
            <c:numRef>
              <c:f>Emission!$B$14:$B$613</c:f>
              <c:numCache>
                <c:formatCode>General</c:formatCode>
                <c:ptCount val="600"/>
                <c:pt idx="0">
                  <c:v>12.03901482</c:v>
                </c:pt>
                <c:pt idx="1">
                  <c:v>12.92965412</c:v>
                </c:pt>
                <c:pt idx="2">
                  <c:v>13.83634853</c:v>
                </c:pt>
                <c:pt idx="3">
                  <c:v>14.67968655</c:v>
                </c:pt>
                <c:pt idx="4">
                  <c:v>16.0272541</c:v>
                </c:pt>
                <c:pt idx="5">
                  <c:v>16.839292530000002</c:v>
                </c:pt>
                <c:pt idx="6">
                  <c:v>17.623205179999999</c:v>
                </c:pt>
                <c:pt idx="7">
                  <c:v>18.56450272</c:v>
                </c:pt>
                <c:pt idx="8">
                  <c:v>19.194643020000001</c:v>
                </c:pt>
                <c:pt idx="9">
                  <c:v>19.926893230000001</c:v>
                </c:pt>
                <c:pt idx="10">
                  <c:v>20.612985609999999</c:v>
                </c:pt>
                <c:pt idx="11">
                  <c:v>20.901643750000002</c:v>
                </c:pt>
                <c:pt idx="12">
                  <c:v>21.658679960000001</c:v>
                </c:pt>
                <c:pt idx="13">
                  <c:v>22.413877490000001</c:v>
                </c:pt>
                <c:pt idx="14">
                  <c:v>23.235427860000001</c:v>
                </c:pt>
                <c:pt idx="15">
                  <c:v>23.413106920000001</c:v>
                </c:pt>
                <c:pt idx="16">
                  <c:v>23.856494900000001</c:v>
                </c:pt>
                <c:pt idx="17">
                  <c:v>24.276565550000001</c:v>
                </c:pt>
                <c:pt idx="18">
                  <c:v>25.215824130000001</c:v>
                </c:pt>
                <c:pt idx="19">
                  <c:v>25.451259610000001</c:v>
                </c:pt>
                <c:pt idx="20">
                  <c:v>26.66420746</c:v>
                </c:pt>
                <c:pt idx="21">
                  <c:v>27.00870514</c:v>
                </c:pt>
                <c:pt idx="22">
                  <c:v>28.923032760000002</c:v>
                </c:pt>
                <c:pt idx="23">
                  <c:v>29.248634339999999</c:v>
                </c:pt>
                <c:pt idx="24">
                  <c:v>30.5294323</c:v>
                </c:pt>
                <c:pt idx="25">
                  <c:v>31.290016170000001</c:v>
                </c:pt>
                <c:pt idx="26">
                  <c:v>32.105125430000001</c:v>
                </c:pt>
                <c:pt idx="27">
                  <c:v>33.396064760000002</c:v>
                </c:pt>
                <c:pt idx="28">
                  <c:v>34.357448580000003</c:v>
                </c:pt>
                <c:pt idx="29">
                  <c:v>35.767623899999997</c:v>
                </c:pt>
                <c:pt idx="30">
                  <c:v>36.568359379999997</c:v>
                </c:pt>
                <c:pt idx="31">
                  <c:v>38.182041169999998</c:v>
                </c:pt>
                <c:pt idx="32">
                  <c:v>39.702232359999996</c:v>
                </c:pt>
                <c:pt idx="33">
                  <c:v>40.292083740000002</c:v>
                </c:pt>
                <c:pt idx="34">
                  <c:v>41.65755463</c:v>
                </c:pt>
                <c:pt idx="35">
                  <c:v>42.767467500000002</c:v>
                </c:pt>
                <c:pt idx="36">
                  <c:v>44.402851099999999</c:v>
                </c:pt>
                <c:pt idx="37">
                  <c:v>44.98890686</c:v>
                </c:pt>
                <c:pt idx="38">
                  <c:v>46.9908638</c:v>
                </c:pt>
                <c:pt idx="39">
                  <c:v>48.042709350000003</c:v>
                </c:pt>
                <c:pt idx="40">
                  <c:v>49.002479549999997</c:v>
                </c:pt>
                <c:pt idx="41">
                  <c:v>50.969043730000003</c:v>
                </c:pt>
                <c:pt idx="42">
                  <c:v>51.370063780000002</c:v>
                </c:pt>
                <c:pt idx="43">
                  <c:v>53.534381869999997</c:v>
                </c:pt>
                <c:pt idx="44">
                  <c:v>53.78522873</c:v>
                </c:pt>
                <c:pt idx="45">
                  <c:v>54.876998899999997</c:v>
                </c:pt>
                <c:pt idx="46">
                  <c:v>56.430553439999997</c:v>
                </c:pt>
                <c:pt idx="47">
                  <c:v>57.293750760000002</c:v>
                </c:pt>
                <c:pt idx="48">
                  <c:v>59.237853999999999</c:v>
                </c:pt>
                <c:pt idx="49">
                  <c:v>60.485816960000001</c:v>
                </c:pt>
                <c:pt idx="50">
                  <c:v>61.71749878</c:v>
                </c:pt>
                <c:pt idx="51">
                  <c:v>63.48986816</c:v>
                </c:pt>
                <c:pt idx="52">
                  <c:v>64.123489379999995</c:v>
                </c:pt>
                <c:pt idx="53">
                  <c:v>65.576660160000003</c:v>
                </c:pt>
                <c:pt idx="54">
                  <c:v>66.98919678</c:v>
                </c:pt>
                <c:pt idx="55">
                  <c:v>68.092430109999995</c:v>
                </c:pt>
                <c:pt idx="56">
                  <c:v>70.045013429999997</c:v>
                </c:pt>
                <c:pt idx="57">
                  <c:v>69.965431210000006</c:v>
                </c:pt>
                <c:pt idx="58">
                  <c:v>71.884712219999997</c:v>
                </c:pt>
                <c:pt idx="59">
                  <c:v>72.460639950000001</c:v>
                </c:pt>
                <c:pt idx="60">
                  <c:v>74.626594539999999</c:v>
                </c:pt>
                <c:pt idx="61">
                  <c:v>75.830932619999999</c:v>
                </c:pt>
                <c:pt idx="62">
                  <c:v>77.542076109999996</c:v>
                </c:pt>
                <c:pt idx="63">
                  <c:v>78.184112549999995</c:v>
                </c:pt>
                <c:pt idx="64">
                  <c:v>79.63015747</c:v>
                </c:pt>
                <c:pt idx="65">
                  <c:v>80.174354550000004</c:v>
                </c:pt>
                <c:pt idx="66">
                  <c:v>82.492141720000006</c:v>
                </c:pt>
                <c:pt idx="67">
                  <c:v>83.073135379999997</c:v>
                </c:pt>
                <c:pt idx="68">
                  <c:v>84.26953125</c:v>
                </c:pt>
                <c:pt idx="69">
                  <c:v>84.898056030000006</c:v>
                </c:pt>
                <c:pt idx="70">
                  <c:v>85.926284789999997</c:v>
                </c:pt>
                <c:pt idx="71">
                  <c:v>87.1318512</c:v>
                </c:pt>
                <c:pt idx="72">
                  <c:v>88.60329437</c:v>
                </c:pt>
                <c:pt idx="73">
                  <c:v>88.601264950000001</c:v>
                </c:pt>
                <c:pt idx="74">
                  <c:v>90.207534789999997</c:v>
                </c:pt>
                <c:pt idx="75">
                  <c:v>92.127761840000005</c:v>
                </c:pt>
                <c:pt idx="76">
                  <c:v>92.191009519999994</c:v>
                </c:pt>
                <c:pt idx="77">
                  <c:v>93.603935239999998</c:v>
                </c:pt>
                <c:pt idx="78">
                  <c:v>94.042648319999998</c:v>
                </c:pt>
                <c:pt idx="79">
                  <c:v>95.394462590000003</c:v>
                </c:pt>
                <c:pt idx="80">
                  <c:v>95.890625</c:v>
                </c:pt>
                <c:pt idx="81">
                  <c:v>96.086067200000002</c:v>
                </c:pt>
                <c:pt idx="82">
                  <c:v>98.849922179999993</c:v>
                </c:pt>
                <c:pt idx="83">
                  <c:v>99.451370240000003</c:v>
                </c:pt>
                <c:pt idx="84">
                  <c:v>99.053077700000003</c:v>
                </c:pt>
                <c:pt idx="85">
                  <c:v>99.810295100000005</c:v>
                </c:pt>
                <c:pt idx="86">
                  <c:v>100.6973038</c:v>
                </c:pt>
                <c:pt idx="87">
                  <c:v>101.2021561</c:v>
                </c:pt>
                <c:pt idx="88">
                  <c:v>103.1013184</c:v>
                </c:pt>
                <c:pt idx="89">
                  <c:v>102.9305344</c:v>
                </c:pt>
                <c:pt idx="90">
                  <c:v>103.4324417</c:v>
                </c:pt>
                <c:pt idx="91">
                  <c:v>105.4955597</c:v>
                </c:pt>
                <c:pt idx="92">
                  <c:v>105.0997696</c:v>
                </c:pt>
                <c:pt idx="93">
                  <c:v>106.3759003</c:v>
                </c:pt>
                <c:pt idx="94">
                  <c:v>107.56445309999999</c:v>
                </c:pt>
                <c:pt idx="95">
                  <c:v>108.1247711</c:v>
                </c:pt>
                <c:pt idx="96">
                  <c:v>108.0601578</c:v>
                </c:pt>
                <c:pt idx="97">
                  <c:v>108.9707489</c:v>
                </c:pt>
                <c:pt idx="98">
                  <c:v>108.950943</c:v>
                </c:pt>
                <c:pt idx="99">
                  <c:v>109.9548111</c:v>
                </c:pt>
                <c:pt idx="100">
                  <c:v>110.9642029</c:v>
                </c:pt>
                <c:pt idx="101">
                  <c:v>110.8965912</c:v>
                </c:pt>
                <c:pt idx="102">
                  <c:v>111.52114109999999</c:v>
                </c:pt>
                <c:pt idx="103">
                  <c:v>112.5809479</c:v>
                </c:pt>
                <c:pt idx="104">
                  <c:v>112.9859924</c:v>
                </c:pt>
                <c:pt idx="105">
                  <c:v>113.8634186</c:v>
                </c:pt>
                <c:pt idx="106">
                  <c:v>112.93776699999999</c:v>
                </c:pt>
                <c:pt idx="107">
                  <c:v>114.2679291</c:v>
                </c:pt>
                <c:pt idx="108">
                  <c:v>114.42803960000001</c:v>
                </c:pt>
                <c:pt idx="109">
                  <c:v>115.5829315</c:v>
                </c:pt>
                <c:pt idx="110">
                  <c:v>116.2659225</c:v>
                </c:pt>
                <c:pt idx="111">
                  <c:v>115.49962619999999</c:v>
                </c:pt>
                <c:pt idx="112">
                  <c:v>117.03801730000001</c:v>
                </c:pt>
                <c:pt idx="113">
                  <c:v>116.374588</c:v>
                </c:pt>
                <c:pt idx="114">
                  <c:v>116.0426178</c:v>
                </c:pt>
                <c:pt idx="115">
                  <c:v>117.8331757</c:v>
                </c:pt>
                <c:pt idx="116">
                  <c:v>117.67707059999999</c:v>
                </c:pt>
                <c:pt idx="117">
                  <c:v>117.0917358</c:v>
                </c:pt>
                <c:pt idx="118">
                  <c:v>117.3751755</c:v>
                </c:pt>
                <c:pt idx="119">
                  <c:v>117.86246490000001</c:v>
                </c:pt>
                <c:pt idx="120">
                  <c:v>118.5043793</c:v>
                </c:pt>
                <c:pt idx="121">
                  <c:v>117.554863</c:v>
                </c:pt>
                <c:pt idx="122">
                  <c:v>118.6819687</c:v>
                </c:pt>
                <c:pt idx="123">
                  <c:v>117.0801239</c:v>
                </c:pt>
                <c:pt idx="124">
                  <c:v>118.2434616</c:v>
                </c:pt>
                <c:pt idx="125">
                  <c:v>118.16577909999999</c:v>
                </c:pt>
                <c:pt idx="126">
                  <c:v>117.6758423</c:v>
                </c:pt>
                <c:pt idx="127">
                  <c:v>118.25057219999999</c:v>
                </c:pt>
                <c:pt idx="128">
                  <c:v>117.7648087</c:v>
                </c:pt>
                <c:pt idx="129">
                  <c:v>118.7367249</c:v>
                </c:pt>
                <c:pt idx="130">
                  <c:v>117.8304596</c:v>
                </c:pt>
                <c:pt idx="131">
                  <c:v>117.992981</c:v>
                </c:pt>
                <c:pt idx="132">
                  <c:v>118.29559329999999</c:v>
                </c:pt>
                <c:pt idx="133">
                  <c:v>117.2729111</c:v>
                </c:pt>
                <c:pt idx="134">
                  <c:v>117.4570923</c:v>
                </c:pt>
                <c:pt idx="135">
                  <c:v>117.5797501</c:v>
                </c:pt>
                <c:pt idx="136">
                  <c:v>116.4531708</c:v>
                </c:pt>
                <c:pt idx="137">
                  <c:v>117.07958979999999</c:v>
                </c:pt>
                <c:pt idx="138">
                  <c:v>115.79161070000001</c:v>
                </c:pt>
                <c:pt idx="139">
                  <c:v>116.04316710000001</c:v>
                </c:pt>
                <c:pt idx="140">
                  <c:v>115.2071991</c:v>
                </c:pt>
                <c:pt idx="141">
                  <c:v>115.20467379999999</c:v>
                </c:pt>
                <c:pt idx="142">
                  <c:v>114.1168289</c:v>
                </c:pt>
                <c:pt idx="143">
                  <c:v>113.2391739</c:v>
                </c:pt>
                <c:pt idx="144">
                  <c:v>113.6716461</c:v>
                </c:pt>
                <c:pt idx="145">
                  <c:v>112.896286</c:v>
                </c:pt>
                <c:pt idx="146">
                  <c:v>112.7362823</c:v>
                </c:pt>
                <c:pt idx="147">
                  <c:v>111.9329376</c:v>
                </c:pt>
                <c:pt idx="148">
                  <c:v>111.26289370000001</c:v>
                </c:pt>
                <c:pt idx="149">
                  <c:v>111.4350128</c:v>
                </c:pt>
                <c:pt idx="150">
                  <c:v>109.8737869</c:v>
                </c:pt>
                <c:pt idx="151">
                  <c:v>109.8891373</c:v>
                </c:pt>
                <c:pt idx="152">
                  <c:v>108.56931299999999</c:v>
                </c:pt>
                <c:pt idx="153">
                  <c:v>108.16954800000001</c:v>
                </c:pt>
                <c:pt idx="154">
                  <c:v>108.02220149999999</c:v>
                </c:pt>
                <c:pt idx="155">
                  <c:v>106.50141139999999</c:v>
                </c:pt>
                <c:pt idx="156">
                  <c:v>106.98873140000001</c:v>
                </c:pt>
                <c:pt idx="157">
                  <c:v>105.95676419999999</c:v>
                </c:pt>
                <c:pt idx="158">
                  <c:v>104.55184939999999</c:v>
                </c:pt>
                <c:pt idx="159">
                  <c:v>104.1285019</c:v>
                </c:pt>
                <c:pt idx="160">
                  <c:v>103.142189</c:v>
                </c:pt>
                <c:pt idx="161">
                  <c:v>102.24780269999999</c:v>
                </c:pt>
                <c:pt idx="162">
                  <c:v>102.2022552</c:v>
                </c:pt>
                <c:pt idx="163">
                  <c:v>100.98982239999999</c:v>
                </c:pt>
                <c:pt idx="164">
                  <c:v>100.3130264</c:v>
                </c:pt>
                <c:pt idx="165">
                  <c:v>99.278358460000007</c:v>
                </c:pt>
                <c:pt idx="166">
                  <c:v>98.672691349999994</c:v>
                </c:pt>
                <c:pt idx="167">
                  <c:v>97.792922970000006</c:v>
                </c:pt>
                <c:pt idx="168">
                  <c:v>96.977424619999994</c:v>
                </c:pt>
                <c:pt idx="169">
                  <c:v>97.363647459999996</c:v>
                </c:pt>
                <c:pt idx="170">
                  <c:v>94.792221069999997</c:v>
                </c:pt>
                <c:pt idx="171">
                  <c:v>94.872673030000001</c:v>
                </c:pt>
                <c:pt idx="172">
                  <c:v>93.926132199999998</c:v>
                </c:pt>
                <c:pt idx="173">
                  <c:v>93.443626399999999</c:v>
                </c:pt>
                <c:pt idx="174">
                  <c:v>92.733383180000004</c:v>
                </c:pt>
                <c:pt idx="175">
                  <c:v>91.895744320000006</c:v>
                </c:pt>
                <c:pt idx="176">
                  <c:v>91.053253170000005</c:v>
                </c:pt>
                <c:pt idx="177">
                  <c:v>90.302276610000007</c:v>
                </c:pt>
                <c:pt idx="178">
                  <c:v>89.186943049999996</c:v>
                </c:pt>
                <c:pt idx="179">
                  <c:v>87.984863279999999</c:v>
                </c:pt>
                <c:pt idx="180">
                  <c:v>87.829063419999997</c:v>
                </c:pt>
                <c:pt idx="181">
                  <c:v>86.132873540000006</c:v>
                </c:pt>
                <c:pt idx="182">
                  <c:v>85.329528809999999</c:v>
                </c:pt>
                <c:pt idx="183">
                  <c:v>84.792739870000005</c:v>
                </c:pt>
                <c:pt idx="184">
                  <c:v>83.787780760000004</c:v>
                </c:pt>
                <c:pt idx="185">
                  <c:v>82.812171939999999</c:v>
                </c:pt>
                <c:pt idx="186">
                  <c:v>82.307785030000005</c:v>
                </c:pt>
                <c:pt idx="187">
                  <c:v>81.872024539999998</c:v>
                </c:pt>
                <c:pt idx="188">
                  <c:v>80.013092040000004</c:v>
                </c:pt>
                <c:pt idx="189">
                  <c:v>79.566864010000003</c:v>
                </c:pt>
                <c:pt idx="190">
                  <c:v>78.46407318</c:v>
                </c:pt>
                <c:pt idx="191">
                  <c:v>78.237693789999994</c:v>
                </c:pt>
                <c:pt idx="192">
                  <c:v>77.248535160000003</c:v>
                </c:pt>
                <c:pt idx="193">
                  <c:v>77.476242069999998</c:v>
                </c:pt>
                <c:pt idx="194">
                  <c:v>76.07706451</c:v>
                </c:pt>
                <c:pt idx="195">
                  <c:v>74.697166440000004</c:v>
                </c:pt>
                <c:pt idx="196">
                  <c:v>73.730964659999998</c:v>
                </c:pt>
                <c:pt idx="197">
                  <c:v>72.926040650000004</c:v>
                </c:pt>
                <c:pt idx="198">
                  <c:v>71.956100460000002</c:v>
                </c:pt>
                <c:pt idx="199">
                  <c:v>72.205200199999993</c:v>
                </c:pt>
                <c:pt idx="200">
                  <c:v>70.921508790000004</c:v>
                </c:pt>
                <c:pt idx="201">
                  <c:v>70.687622070000003</c:v>
                </c:pt>
                <c:pt idx="202">
                  <c:v>69.210960389999997</c:v>
                </c:pt>
                <c:pt idx="203">
                  <c:v>69.406646730000006</c:v>
                </c:pt>
                <c:pt idx="204">
                  <c:v>67.651107789999998</c:v>
                </c:pt>
                <c:pt idx="205">
                  <c:v>66.749641420000003</c:v>
                </c:pt>
                <c:pt idx="206">
                  <c:v>66.348381040000007</c:v>
                </c:pt>
                <c:pt idx="207">
                  <c:v>65.404129030000007</c:v>
                </c:pt>
                <c:pt idx="208">
                  <c:v>64.837570189999994</c:v>
                </c:pt>
                <c:pt idx="209">
                  <c:v>64.218704220000006</c:v>
                </c:pt>
                <c:pt idx="210">
                  <c:v>63.263782499999998</c:v>
                </c:pt>
                <c:pt idx="211">
                  <c:v>62.262645720000002</c:v>
                </c:pt>
                <c:pt idx="212">
                  <c:v>61.402385709999997</c:v>
                </c:pt>
                <c:pt idx="213">
                  <c:v>61.29357529</c:v>
                </c:pt>
                <c:pt idx="214">
                  <c:v>60.022891999999999</c:v>
                </c:pt>
                <c:pt idx="215">
                  <c:v>59.271961210000001</c:v>
                </c:pt>
                <c:pt idx="216">
                  <c:v>58.768829349999997</c:v>
                </c:pt>
                <c:pt idx="217">
                  <c:v>57.51887894</c:v>
                </c:pt>
                <c:pt idx="218">
                  <c:v>57.548526760000001</c:v>
                </c:pt>
                <c:pt idx="219">
                  <c:v>56.030990600000003</c:v>
                </c:pt>
                <c:pt idx="220">
                  <c:v>55.792495729999999</c:v>
                </c:pt>
                <c:pt idx="221">
                  <c:v>55.40866089</c:v>
                </c:pt>
                <c:pt idx="222">
                  <c:v>53.875919340000003</c:v>
                </c:pt>
                <c:pt idx="223">
                  <c:v>53.870120999999997</c:v>
                </c:pt>
                <c:pt idx="224">
                  <c:v>52.24060059</c:v>
                </c:pt>
                <c:pt idx="225">
                  <c:v>51.860115049999997</c:v>
                </c:pt>
                <c:pt idx="226">
                  <c:v>51.37087631</c:v>
                </c:pt>
                <c:pt idx="227">
                  <c:v>50.812095640000003</c:v>
                </c:pt>
                <c:pt idx="228">
                  <c:v>50.202438350000001</c:v>
                </c:pt>
                <c:pt idx="229">
                  <c:v>49.290142060000001</c:v>
                </c:pt>
                <c:pt idx="230">
                  <c:v>48.787868500000002</c:v>
                </c:pt>
                <c:pt idx="231">
                  <c:v>49.006065370000002</c:v>
                </c:pt>
                <c:pt idx="232">
                  <c:v>47.445533750000003</c:v>
                </c:pt>
                <c:pt idx="233">
                  <c:v>46.957733150000003</c:v>
                </c:pt>
                <c:pt idx="234">
                  <c:v>46.440353389999999</c:v>
                </c:pt>
                <c:pt idx="235">
                  <c:v>45.88718033</c:v>
                </c:pt>
                <c:pt idx="236">
                  <c:v>45.633235929999998</c:v>
                </c:pt>
                <c:pt idx="237">
                  <c:v>45.215652470000002</c:v>
                </c:pt>
                <c:pt idx="238">
                  <c:v>44.077342989999998</c:v>
                </c:pt>
                <c:pt idx="239">
                  <c:v>43.386154169999998</c:v>
                </c:pt>
                <c:pt idx="240">
                  <c:v>42.684959409999998</c:v>
                </c:pt>
                <c:pt idx="241">
                  <c:v>41.940761569999999</c:v>
                </c:pt>
                <c:pt idx="242">
                  <c:v>42.2313118</c:v>
                </c:pt>
                <c:pt idx="243">
                  <c:v>41.236968990000001</c:v>
                </c:pt>
                <c:pt idx="244">
                  <c:v>40.667907710000001</c:v>
                </c:pt>
                <c:pt idx="245">
                  <c:v>40.347690579999998</c:v>
                </c:pt>
                <c:pt idx="246">
                  <c:v>39.950866699999999</c:v>
                </c:pt>
                <c:pt idx="247">
                  <c:v>39.438438419999997</c:v>
                </c:pt>
                <c:pt idx="248">
                  <c:v>38.304195399999998</c:v>
                </c:pt>
                <c:pt idx="249">
                  <c:v>38.260913850000001</c:v>
                </c:pt>
                <c:pt idx="250">
                  <c:v>37.580020900000001</c:v>
                </c:pt>
                <c:pt idx="251">
                  <c:v>37.633007050000003</c:v>
                </c:pt>
                <c:pt idx="252">
                  <c:v>36.630462649999998</c:v>
                </c:pt>
                <c:pt idx="253">
                  <c:v>36.004055020000003</c:v>
                </c:pt>
                <c:pt idx="254">
                  <c:v>35.511234279999996</c:v>
                </c:pt>
                <c:pt idx="255">
                  <c:v>34.605651860000002</c:v>
                </c:pt>
                <c:pt idx="256">
                  <c:v>35.094997409999998</c:v>
                </c:pt>
                <c:pt idx="257">
                  <c:v>34.071620940000003</c:v>
                </c:pt>
                <c:pt idx="258">
                  <c:v>33.267372129999998</c:v>
                </c:pt>
                <c:pt idx="259">
                  <c:v>33.104999540000001</c:v>
                </c:pt>
                <c:pt idx="260">
                  <c:v>32.141590119999996</c:v>
                </c:pt>
                <c:pt idx="261">
                  <c:v>31.94463348</c:v>
                </c:pt>
                <c:pt idx="262">
                  <c:v>31.377761840000002</c:v>
                </c:pt>
                <c:pt idx="263">
                  <c:v>31.116300580000001</c:v>
                </c:pt>
                <c:pt idx="264">
                  <c:v>30.97904205</c:v>
                </c:pt>
                <c:pt idx="265">
                  <c:v>30.337875369999999</c:v>
                </c:pt>
                <c:pt idx="266">
                  <c:v>29.804527279999999</c:v>
                </c:pt>
                <c:pt idx="267">
                  <c:v>29.76321411</c:v>
                </c:pt>
                <c:pt idx="268">
                  <c:v>29.01831245</c:v>
                </c:pt>
                <c:pt idx="269">
                  <c:v>28.503404620000001</c:v>
                </c:pt>
                <c:pt idx="270">
                  <c:v>28.37713814</c:v>
                </c:pt>
                <c:pt idx="271">
                  <c:v>27.983764650000001</c:v>
                </c:pt>
                <c:pt idx="272">
                  <c:v>27.771205899999998</c:v>
                </c:pt>
                <c:pt idx="273">
                  <c:v>27.49727631</c:v>
                </c:pt>
                <c:pt idx="274">
                  <c:v>26.902181630000001</c:v>
                </c:pt>
                <c:pt idx="275">
                  <c:v>25.879480359999999</c:v>
                </c:pt>
                <c:pt idx="276">
                  <c:v>25.894449229999999</c:v>
                </c:pt>
                <c:pt idx="277">
                  <c:v>25.654470440000001</c:v>
                </c:pt>
                <c:pt idx="278">
                  <c:v>25.216188429999999</c:v>
                </c:pt>
                <c:pt idx="279">
                  <c:v>24.743902210000002</c:v>
                </c:pt>
                <c:pt idx="280">
                  <c:v>24.53317642</c:v>
                </c:pt>
                <c:pt idx="281">
                  <c:v>24.537328720000001</c:v>
                </c:pt>
                <c:pt idx="282">
                  <c:v>23.739774700000002</c:v>
                </c:pt>
                <c:pt idx="283">
                  <c:v>23.21653748</c:v>
                </c:pt>
                <c:pt idx="284">
                  <c:v>22.906637190000001</c:v>
                </c:pt>
                <c:pt idx="285">
                  <c:v>22.32746315</c:v>
                </c:pt>
                <c:pt idx="286">
                  <c:v>22.327892299999998</c:v>
                </c:pt>
                <c:pt idx="287">
                  <c:v>22.034557339999999</c:v>
                </c:pt>
                <c:pt idx="288">
                  <c:v>21.366638179999999</c:v>
                </c:pt>
                <c:pt idx="289">
                  <c:v>21.134401319999998</c:v>
                </c:pt>
                <c:pt idx="290">
                  <c:v>21.13698578</c:v>
                </c:pt>
                <c:pt idx="291">
                  <c:v>20.651853559999999</c:v>
                </c:pt>
                <c:pt idx="292">
                  <c:v>20.32789803</c:v>
                </c:pt>
                <c:pt idx="293">
                  <c:v>19.80060005</c:v>
                </c:pt>
                <c:pt idx="294">
                  <c:v>19.84924698</c:v>
                </c:pt>
                <c:pt idx="295">
                  <c:v>19.336715699999999</c:v>
                </c:pt>
                <c:pt idx="296">
                  <c:v>18.92995071</c:v>
                </c:pt>
                <c:pt idx="297">
                  <c:v>18.786613460000002</c:v>
                </c:pt>
                <c:pt idx="298">
                  <c:v>18.558591839999998</c:v>
                </c:pt>
                <c:pt idx="299">
                  <c:v>17.952507019999999</c:v>
                </c:pt>
                <c:pt idx="300">
                  <c:v>18.04007339</c:v>
                </c:pt>
                <c:pt idx="301">
                  <c:v>17.221986770000001</c:v>
                </c:pt>
                <c:pt idx="302">
                  <c:v>17.710582729999999</c:v>
                </c:pt>
                <c:pt idx="303">
                  <c:v>17.289005280000001</c:v>
                </c:pt>
                <c:pt idx="304">
                  <c:v>16.727447510000001</c:v>
                </c:pt>
                <c:pt idx="305">
                  <c:v>16.32446289</c:v>
                </c:pt>
                <c:pt idx="306">
                  <c:v>16.368120189999999</c:v>
                </c:pt>
                <c:pt idx="307">
                  <c:v>15.80727482</c:v>
                </c:pt>
                <c:pt idx="308">
                  <c:v>15.889232639999999</c:v>
                </c:pt>
                <c:pt idx="309">
                  <c:v>15.70590591</c:v>
                </c:pt>
                <c:pt idx="310">
                  <c:v>15.112360000000001</c:v>
                </c:pt>
                <c:pt idx="311">
                  <c:v>15.28741932</c:v>
                </c:pt>
                <c:pt idx="312">
                  <c:v>14.551947589999999</c:v>
                </c:pt>
                <c:pt idx="313">
                  <c:v>14.782406809999999</c:v>
                </c:pt>
                <c:pt idx="314">
                  <c:v>14.30655479</c:v>
                </c:pt>
                <c:pt idx="315">
                  <c:v>14.139796260000001</c:v>
                </c:pt>
                <c:pt idx="316">
                  <c:v>13.89356422</c:v>
                </c:pt>
                <c:pt idx="317">
                  <c:v>13.994055749999999</c:v>
                </c:pt>
                <c:pt idx="318">
                  <c:v>13.34132767</c:v>
                </c:pt>
                <c:pt idx="319">
                  <c:v>13.27974796</c:v>
                </c:pt>
                <c:pt idx="320">
                  <c:v>13.144217490000001</c:v>
                </c:pt>
                <c:pt idx="321">
                  <c:v>12.666728969999999</c:v>
                </c:pt>
                <c:pt idx="322">
                  <c:v>12.87097073</c:v>
                </c:pt>
                <c:pt idx="323">
                  <c:v>12.427273749999999</c:v>
                </c:pt>
                <c:pt idx="324">
                  <c:v>12.71130943</c:v>
                </c:pt>
                <c:pt idx="325">
                  <c:v>12.31697559</c:v>
                </c:pt>
                <c:pt idx="326">
                  <c:v>11.83605766</c:v>
                </c:pt>
                <c:pt idx="327">
                  <c:v>11.809691430000001</c:v>
                </c:pt>
                <c:pt idx="328">
                  <c:v>11.484101300000001</c:v>
                </c:pt>
                <c:pt idx="329">
                  <c:v>11.36773968</c:v>
                </c:pt>
                <c:pt idx="330">
                  <c:v>11.288513180000001</c:v>
                </c:pt>
                <c:pt idx="331">
                  <c:v>11.0123558</c:v>
                </c:pt>
                <c:pt idx="332">
                  <c:v>10.665447240000001</c:v>
                </c:pt>
                <c:pt idx="333">
                  <c:v>10.636294360000001</c:v>
                </c:pt>
                <c:pt idx="334">
                  <c:v>10.339337349999999</c:v>
                </c:pt>
                <c:pt idx="335">
                  <c:v>10.3144598</c:v>
                </c:pt>
                <c:pt idx="336">
                  <c:v>10.246171</c:v>
                </c:pt>
                <c:pt idx="337">
                  <c:v>10.05028725</c:v>
                </c:pt>
                <c:pt idx="338">
                  <c:v>9.6570615770000003</c:v>
                </c:pt>
                <c:pt idx="339">
                  <c:v>9.9134511950000004</c:v>
                </c:pt>
                <c:pt idx="340">
                  <c:v>9.4108781809999993</c:v>
                </c:pt>
                <c:pt idx="341">
                  <c:v>9.3731765750000005</c:v>
                </c:pt>
                <c:pt idx="342">
                  <c:v>9.3080244059999995</c:v>
                </c:pt>
                <c:pt idx="343">
                  <c:v>9.149058342</c:v>
                </c:pt>
                <c:pt idx="344">
                  <c:v>8.8181076049999998</c:v>
                </c:pt>
                <c:pt idx="345">
                  <c:v>8.4898805619999997</c:v>
                </c:pt>
                <c:pt idx="346">
                  <c:v>8.7416057590000005</c:v>
                </c:pt>
                <c:pt idx="347">
                  <c:v>8.4511232379999992</c:v>
                </c:pt>
                <c:pt idx="348">
                  <c:v>8.4001894000000004</c:v>
                </c:pt>
                <c:pt idx="349">
                  <c:v>8.1932077410000002</c:v>
                </c:pt>
                <c:pt idx="350">
                  <c:v>8.2728929519999994</c:v>
                </c:pt>
                <c:pt idx="351">
                  <c:v>8.0446605679999994</c:v>
                </c:pt>
                <c:pt idx="352">
                  <c:v>7.6760082240000003</c:v>
                </c:pt>
                <c:pt idx="353">
                  <c:v>7.6884741779999999</c:v>
                </c:pt>
                <c:pt idx="354">
                  <c:v>7.4433917999999997</c:v>
                </c:pt>
                <c:pt idx="355">
                  <c:v>7.500539303</c:v>
                </c:pt>
                <c:pt idx="356">
                  <c:v>7.2319803240000002</c:v>
                </c:pt>
                <c:pt idx="357">
                  <c:v>7.1818780899999997</c:v>
                </c:pt>
                <c:pt idx="358">
                  <c:v>7.2680234910000001</c:v>
                </c:pt>
                <c:pt idx="359">
                  <c:v>7.187614441</c:v>
                </c:pt>
                <c:pt idx="360">
                  <c:v>6.8446836470000001</c:v>
                </c:pt>
                <c:pt idx="361">
                  <c:v>6.7681951519999997</c:v>
                </c:pt>
                <c:pt idx="362">
                  <c:v>6.7353415490000001</c:v>
                </c:pt>
                <c:pt idx="363">
                  <c:v>6.5495448109999996</c:v>
                </c:pt>
                <c:pt idx="364">
                  <c:v>6.5420155529999997</c:v>
                </c:pt>
                <c:pt idx="365">
                  <c:v>6.4208087919999999</c:v>
                </c:pt>
                <c:pt idx="366">
                  <c:v>6.1427040100000001</c:v>
                </c:pt>
                <c:pt idx="367">
                  <c:v>6.207920551</c:v>
                </c:pt>
                <c:pt idx="368">
                  <c:v>5.9361410140000004</c:v>
                </c:pt>
                <c:pt idx="369">
                  <c:v>6.0045528409999998</c:v>
                </c:pt>
                <c:pt idx="370">
                  <c:v>5.7940192220000002</c:v>
                </c:pt>
                <c:pt idx="371">
                  <c:v>5.7205290790000003</c:v>
                </c:pt>
                <c:pt idx="372">
                  <c:v>5.9148087499999997</c:v>
                </c:pt>
                <c:pt idx="373">
                  <c:v>5.4143314360000003</c:v>
                </c:pt>
                <c:pt idx="374">
                  <c:v>5.4459204669999997</c:v>
                </c:pt>
                <c:pt idx="375">
                  <c:v>5.5386753080000002</c:v>
                </c:pt>
                <c:pt idx="376">
                  <c:v>5.2730417249999997</c:v>
                </c:pt>
                <c:pt idx="377">
                  <c:v>5.298978806</c:v>
                </c:pt>
                <c:pt idx="378">
                  <c:v>5.143153667</c:v>
                </c:pt>
                <c:pt idx="379">
                  <c:v>5.0461897850000001</c:v>
                </c:pt>
                <c:pt idx="380">
                  <c:v>5.1027846339999998</c:v>
                </c:pt>
                <c:pt idx="381">
                  <c:v>5.0169024469999997</c:v>
                </c:pt>
                <c:pt idx="382">
                  <c:v>4.8281917569999999</c:v>
                </c:pt>
                <c:pt idx="383">
                  <c:v>4.865951538</c:v>
                </c:pt>
                <c:pt idx="384">
                  <c:v>4.4185614590000002</c:v>
                </c:pt>
                <c:pt idx="385">
                  <c:v>4.4300279619999996</c:v>
                </c:pt>
                <c:pt idx="386">
                  <c:v>4.4873523710000001</c:v>
                </c:pt>
                <c:pt idx="387">
                  <c:v>4.4714331630000004</c:v>
                </c:pt>
                <c:pt idx="388">
                  <c:v>4.4961361889999996</c:v>
                </c:pt>
                <c:pt idx="389">
                  <c:v>4.3073353770000002</c:v>
                </c:pt>
                <c:pt idx="390">
                  <c:v>4.2095756529999999</c:v>
                </c:pt>
                <c:pt idx="391">
                  <c:v>4.2180461879999998</c:v>
                </c:pt>
                <c:pt idx="392">
                  <c:v>4.1367211340000001</c:v>
                </c:pt>
                <c:pt idx="393">
                  <c:v>4.0343861580000002</c:v>
                </c:pt>
                <c:pt idx="394">
                  <c:v>4.0509061810000002</c:v>
                </c:pt>
                <c:pt idx="395">
                  <c:v>4.0041179659999999</c:v>
                </c:pt>
                <c:pt idx="396">
                  <c:v>3.858597279</c:v>
                </c:pt>
                <c:pt idx="397">
                  <c:v>3.8818831440000001</c:v>
                </c:pt>
                <c:pt idx="398">
                  <c:v>3.797359943</c:v>
                </c:pt>
                <c:pt idx="399">
                  <c:v>3.7424545290000002</c:v>
                </c:pt>
                <c:pt idx="400">
                  <c:v>3.520295382</c:v>
                </c:pt>
                <c:pt idx="401">
                  <c:v>3.6066963670000001</c:v>
                </c:pt>
                <c:pt idx="402">
                  <c:v>3.4845261569999999</c:v>
                </c:pt>
                <c:pt idx="403">
                  <c:v>3.2740924360000001</c:v>
                </c:pt>
                <c:pt idx="404">
                  <c:v>3.346982718</c:v>
                </c:pt>
                <c:pt idx="405">
                  <c:v>3.4793541430000001</c:v>
                </c:pt>
                <c:pt idx="406">
                  <c:v>3.2561786170000002</c:v>
                </c:pt>
                <c:pt idx="407">
                  <c:v>3.2924327849999999</c:v>
                </c:pt>
                <c:pt idx="408">
                  <c:v>3.2414464949999999</c:v>
                </c:pt>
                <c:pt idx="409">
                  <c:v>3.0592520240000001</c:v>
                </c:pt>
                <c:pt idx="410">
                  <c:v>2.9783041479999999</c:v>
                </c:pt>
                <c:pt idx="411">
                  <c:v>2.9387707710000002</c:v>
                </c:pt>
                <c:pt idx="412">
                  <c:v>3.0202515129999998</c:v>
                </c:pt>
                <c:pt idx="413">
                  <c:v>2.856517792</c:v>
                </c:pt>
                <c:pt idx="414">
                  <c:v>2.7788188460000001</c:v>
                </c:pt>
                <c:pt idx="415">
                  <c:v>2.8279259200000002</c:v>
                </c:pt>
                <c:pt idx="416">
                  <c:v>2.759432077</c:v>
                </c:pt>
                <c:pt idx="417">
                  <c:v>2.6413061619999998</c:v>
                </c:pt>
                <c:pt idx="418">
                  <c:v>2.6449484829999999</c:v>
                </c:pt>
                <c:pt idx="419">
                  <c:v>2.661702156</c:v>
                </c:pt>
                <c:pt idx="420">
                  <c:v>2.5668613910000002</c:v>
                </c:pt>
                <c:pt idx="421">
                  <c:v>2.5870807170000001</c:v>
                </c:pt>
                <c:pt idx="422">
                  <c:v>2.5309121609999998</c:v>
                </c:pt>
                <c:pt idx="423">
                  <c:v>2.349172115</c:v>
                </c:pt>
                <c:pt idx="424">
                  <c:v>2.3887519840000002</c:v>
                </c:pt>
                <c:pt idx="425">
                  <c:v>2.434280872</c:v>
                </c:pt>
                <c:pt idx="426">
                  <c:v>2.4551720619999999</c:v>
                </c:pt>
                <c:pt idx="427">
                  <c:v>2.4427094459999998</c:v>
                </c:pt>
                <c:pt idx="428">
                  <c:v>2.4041492940000002</c:v>
                </c:pt>
                <c:pt idx="429">
                  <c:v>2.2853116990000002</c:v>
                </c:pt>
                <c:pt idx="430">
                  <c:v>2.1227567199999999</c:v>
                </c:pt>
                <c:pt idx="431">
                  <c:v>2.137255192</c:v>
                </c:pt>
                <c:pt idx="432">
                  <c:v>2.0696959499999998</c:v>
                </c:pt>
                <c:pt idx="433">
                  <c:v>2.0208032130000002</c:v>
                </c:pt>
                <c:pt idx="434">
                  <c:v>2.089092731</c:v>
                </c:pt>
                <c:pt idx="435">
                  <c:v>2.0900132660000001</c:v>
                </c:pt>
                <c:pt idx="436">
                  <c:v>1.9853913780000001</c:v>
                </c:pt>
                <c:pt idx="437">
                  <c:v>1.9650342460000001</c:v>
                </c:pt>
                <c:pt idx="438">
                  <c:v>1.9852448700000001</c:v>
                </c:pt>
                <c:pt idx="439">
                  <c:v>1.825926661</c:v>
                </c:pt>
                <c:pt idx="440">
                  <c:v>1.9099634889999999</c:v>
                </c:pt>
                <c:pt idx="441">
                  <c:v>1.8778148889999999</c:v>
                </c:pt>
                <c:pt idx="442">
                  <c:v>1.76254344</c:v>
                </c:pt>
                <c:pt idx="443">
                  <c:v>1.816669345</c:v>
                </c:pt>
                <c:pt idx="444">
                  <c:v>1.766018629</c:v>
                </c:pt>
                <c:pt idx="445">
                  <c:v>1.634628296</c:v>
                </c:pt>
                <c:pt idx="446">
                  <c:v>1.6595888139999999</c:v>
                </c:pt>
                <c:pt idx="447">
                  <c:v>1.636400342</c:v>
                </c:pt>
                <c:pt idx="448">
                  <c:v>1.6682180170000001</c:v>
                </c:pt>
                <c:pt idx="449">
                  <c:v>1.6326177120000001</c:v>
                </c:pt>
                <c:pt idx="450">
                  <c:v>1.6436231139999999</c:v>
                </c:pt>
                <c:pt idx="451">
                  <c:v>1.54805243</c:v>
                </c:pt>
                <c:pt idx="452">
                  <c:v>1.6006605629999999</c:v>
                </c:pt>
                <c:pt idx="453">
                  <c:v>1.5106949810000001</c:v>
                </c:pt>
                <c:pt idx="454">
                  <c:v>1.4915494920000001</c:v>
                </c:pt>
                <c:pt idx="455">
                  <c:v>1.4597294329999999</c:v>
                </c:pt>
                <c:pt idx="456">
                  <c:v>1.3331429960000001</c:v>
                </c:pt>
                <c:pt idx="457">
                  <c:v>1.3534288409999999</c:v>
                </c:pt>
                <c:pt idx="458">
                  <c:v>1.47229743</c:v>
                </c:pt>
                <c:pt idx="459">
                  <c:v>1.2932753560000001</c:v>
                </c:pt>
                <c:pt idx="460">
                  <c:v>1.4003344769999999</c:v>
                </c:pt>
                <c:pt idx="461">
                  <c:v>1.3559113739999999</c:v>
                </c:pt>
                <c:pt idx="462">
                  <c:v>1.16511023</c:v>
                </c:pt>
                <c:pt idx="463">
                  <c:v>1.3977279659999999</c:v>
                </c:pt>
                <c:pt idx="464">
                  <c:v>1.218501925</c:v>
                </c:pt>
                <c:pt idx="465">
                  <c:v>1.2714369299999999</c:v>
                </c:pt>
                <c:pt idx="466">
                  <c:v>1.250594497</c:v>
                </c:pt>
                <c:pt idx="467">
                  <c:v>1.190987706</c:v>
                </c:pt>
                <c:pt idx="468">
                  <c:v>1.1707615849999999</c:v>
                </c:pt>
                <c:pt idx="469">
                  <c:v>1.137528181</c:v>
                </c:pt>
                <c:pt idx="470">
                  <c:v>1.171507597</c:v>
                </c:pt>
                <c:pt idx="471">
                  <c:v>1.048571825</c:v>
                </c:pt>
                <c:pt idx="472">
                  <c:v>1.0986762050000001</c:v>
                </c:pt>
                <c:pt idx="473">
                  <c:v>1.102697968</c:v>
                </c:pt>
                <c:pt idx="474">
                  <c:v>1.0646982190000001</c:v>
                </c:pt>
                <c:pt idx="475">
                  <c:v>1.089973211</c:v>
                </c:pt>
                <c:pt idx="476">
                  <c:v>1.0593663449999999</c:v>
                </c:pt>
                <c:pt idx="477">
                  <c:v>0.95101016760000001</c:v>
                </c:pt>
                <c:pt idx="478">
                  <c:v>0.98699086899999999</c:v>
                </c:pt>
                <c:pt idx="479">
                  <c:v>0.93127268549999997</c:v>
                </c:pt>
                <c:pt idx="480">
                  <c:v>0.90454816819999995</c:v>
                </c:pt>
                <c:pt idx="481">
                  <c:v>0.97034984830000004</c:v>
                </c:pt>
                <c:pt idx="482">
                  <c:v>0.89597558980000003</c:v>
                </c:pt>
                <c:pt idx="483">
                  <c:v>0.91800445320000001</c:v>
                </c:pt>
                <c:pt idx="484">
                  <c:v>0.82175391909999995</c:v>
                </c:pt>
                <c:pt idx="485">
                  <c:v>0.92004215720000004</c:v>
                </c:pt>
                <c:pt idx="486">
                  <c:v>0.94516432289999996</c:v>
                </c:pt>
                <c:pt idx="487">
                  <c:v>0.83563786750000002</c:v>
                </c:pt>
                <c:pt idx="488">
                  <c:v>0.83162438869999999</c:v>
                </c:pt>
                <c:pt idx="489">
                  <c:v>0.84500741960000003</c:v>
                </c:pt>
                <c:pt idx="490">
                  <c:v>0.8501443863</c:v>
                </c:pt>
                <c:pt idx="491">
                  <c:v>0.74142813679999997</c:v>
                </c:pt>
                <c:pt idx="492">
                  <c:v>0.81449377540000001</c:v>
                </c:pt>
                <c:pt idx="493">
                  <c:v>0.80668729539999995</c:v>
                </c:pt>
                <c:pt idx="494">
                  <c:v>0.79005771879999998</c:v>
                </c:pt>
                <c:pt idx="495">
                  <c:v>0.68114203210000002</c:v>
                </c:pt>
                <c:pt idx="496">
                  <c:v>0.69962364440000002</c:v>
                </c:pt>
                <c:pt idx="497">
                  <c:v>0.78132253890000003</c:v>
                </c:pt>
                <c:pt idx="498">
                  <c:v>0.63078737259999995</c:v>
                </c:pt>
                <c:pt idx="499">
                  <c:v>0.6950381994</c:v>
                </c:pt>
                <c:pt idx="500">
                  <c:v>0.7047005892</c:v>
                </c:pt>
                <c:pt idx="501">
                  <c:v>0.71019911769999999</c:v>
                </c:pt>
                <c:pt idx="502">
                  <c:v>0.6959666014</c:v>
                </c:pt>
                <c:pt idx="503">
                  <c:v>0.57484805579999998</c:v>
                </c:pt>
                <c:pt idx="504">
                  <c:v>0.60427004100000004</c:v>
                </c:pt>
                <c:pt idx="505">
                  <c:v>0.6620660424</c:v>
                </c:pt>
                <c:pt idx="506">
                  <c:v>0.71132451299999999</c:v>
                </c:pt>
                <c:pt idx="507">
                  <c:v>0.63369685409999998</c:v>
                </c:pt>
                <c:pt idx="508">
                  <c:v>0.61092573400000005</c:v>
                </c:pt>
                <c:pt idx="509">
                  <c:v>0.59776431320000001</c:v>
                </c:pt>
                <c:pt idx="510">
                  <c:v>0.5744858384</c:v>
                </c:pt>
                <c:pt idx="511">
                  <c:v>0.6075800657</c:v>
                </c:pt>
                <c:pt idx="512">
                  <c:v>0.58415794369999996</c:v>
                </c:pt>
                <c:pt idx="513">
                  <c:v>0.60024446249999996</c:v>
                </c:pt>
                <c:pt idx="514">
                  <c:v>0.54868179559999997</c:v>
                </c:pt>
                <c:pt idx="515">
                  <c:v>0.52894061800000003</c:v>
                </c:pt>
                <c:pt idx="516">
                  <c:v>0.59346657989999996</c:v>
                </c:pt>
                <c:pt idx="517">
                  <c:v>0.50099068879999997</c:v>
                </c:pt>
                <c:pt idx="518">
                  <c:v>0.557487607</c:v>
                </c:pt>
                <c:pt idx="519">
                  <c:v>0.51722061630000005</c:v>
                </c:pt>
                <c:pt idx="520">
                  <c:v>0.54215317959999998</c:v>
                </c:pt>
                <c:pt idx="521">
                  <c:v>0.54287946220000005</c:v>
                </c:pt>
                <c:pt idx="522">
                  <c:v>0.5229684711</c:v>
                </c:pt>
                <c:pt idx="523">
                  <c:v>0.51526600119999999</c:v>
                </c:pt>
                <c:pt idx="524">
                  <c:v>0.50229460000000004</c:v>
                </c:pt>
                <c:pt idx="525">
                  <c:v>0.49451175330000002</c:v>
                </c:pt>
                <c:pt idx="526">
                  <c:v>0.50788956880000002</c:v>
                </c:pt>
                <c:pt idx="527">
                  <c:v>0.48886665699999998</c:v>
                </c:pt>
                <c:pt idx="528">
                  <c:v>0.44460082049999999</c:v>
                </c:pt>
                <c:pt idx="529">
                  <c:v>0.4580304623</c:v>
                </c:pt>
                <c:pt idx="530">
                  <c:v>0.4329644144</c:v>
                </c:pt>
                <c:pt idx="531">
                  <c:v>0.47971823810000003</c:v>
                </c:pt>
                <c:pt idx="532">
                  <c:v>0.41524782780000002</c:v>
                </c:pt>
                <c:pt idx="533">
                  <c:v>0.42100465300000001</c:v>
                </c:pt>
                <c:pt idx="534">
                  <c:v>0.4368772507</c:v>
                </c:pt>
                <c:pt idx="535">
                  <c:v>0.42461857200000003</c:v>
                </c:pt>
                <c:pt idx="536">
                  <c:v>0.39231225850000001</c:v>
                </c:pt>
                <c:pt idx="537">
                  <c:v>0.3313097358</c:v>
                </c:pt>
                <c:pt idx="538">
                  <c:v>0.39601334929999998</c:v>
                </c:pt>
                <c:pt idx="539">
                  <c:v>0.39852443339999999</c:v>
                </c:pt>
                <c:pt idx="540">
                  <c:v>0.33647292849999999</c:v>
                </c:pt>
                <c:pt idx="541">
                  <c:v>0.35465934869999999</c:v>
                </c:pt>
                <c:pt idx="542">
                  <c:v>0.42823308710000002</c:v>
                </c:pt>
                <c:pt idx="543">
                  <c:v>0.34504386780000001</c:v>
                </c:pt>
                <c:pt idx="544">
                  <c:v>0.35914096239999999</c:v>
                </c:pt>
                <c:pt idx="545">
                  <c:v>0.3527617455</c:v>
                </c:pt>
                <c:pt idx="546">
                  <c:v>0.29325631260000001</c:v>
                </c:pt>
                <c:pt idx="547">
                  <c:v>0.3383103609</c:v>
                </c:pt>
                <c:pt idx="548">
                  <c:v>0.40190282459999999</c:v>
                </c:pt>
                <c:pt idx="549">
                  <c:v>0.35752132530000003</c:v>
                </c:pt>
                <c:pt idx="550">
                  <c:v>0.25127583739999998</c:v>
                </c:pt>
                <c:pt idx="551">
                  <c:v>0.3192703724</c:v>
                </c:pt>
                <c:pt idx="552">
                  <c:v>0.36707195640000001</c:v>
                </c:pt>
                <c:pt idx="553">
                  <c:v>0.31654083729999999</c:v>
                </c:pt>
                <c:pt idx="554">
                  <c:v>0.33449926969999999</c:v>
                </c:pt>
                <c:pt idx="555">
                  <c:v>0.33862832189999997</c:v>
                </c:pt>
                <c:pt idx="556">
                  <c:v>0.31142172219999997</c:v>
                </c:pt>
                <c:pt idx="557">
                  <c:v>0.2913315594</c:v>
                </c:pt>
                <c:pt idx="558">
                  <c:v>0.33286339040000001</c:v>
                </c:pt>
                <c:pt idx="559">
                  <c:v>0.26431098580000001</c:v>
                </c:pt>
                <c:pt idx="560">
                  <c:v>0.2762539685</c:v>
                </c:pt>
                <c:pt idx="561">
                  <c:v>0.28624841569999998</c:v>
                </c:pt>
                <c:pt idx="562">
                  <c:v>0.27824085949999999</c:v>
                </c:pt>
                <c:pt idx="563">
                  <c:v>0.24101634320000001</c:v>
                </c:pt>
                <c:pt idx="564">
                  <c:v>0.23127436639999999</c:v>
                </c:pt>
                <c:pt idx="565">
                  <c:v>0.30453833940000002</c:v>
                </c:pt>
                <c:pt idx="566">
                  <c:v>0.21471251550000001</c:v>
                </c:pt>
                <c:pt idx="567">
                  <c:v>0.26894232629999998</c:v>
                </c:pt>
                <c:pt idx="568">
                  <c:v>0.28238624330000001</c:v>
                </c:pt>
                <c:pt idx="569">
                  <c:v>0.28384900089999998</c:v>
                </c:pt>
                <c:pt idx="570">
                  <c:v>0.23923425379999999</c:v>
                </c:pt>
                <c:pt idx="571">
                  <c:v>0.26375743750000002</c:v>
                </c:pt>
                <c:pt idx="572">
                  <c:v>0.26097941400000002</c:v>
                </c:pt>
                <c:pt idx="573">
                  <c:v>0.240746513</c:v>
                </c:pt>
                <c:pt idx="574">
                  <c:v>0.24756123129999999</c:v>
                </c:pt>
                <c:pt idx="575">
                  <c:v>0.2131127864</c:v>
                </c:pt>
                <c:pt idx="576">
                  <c:v>0.24320198600000001</c:v>
                </c:pt>
                <c:pt idx="577">
                  <c:v>0.2665586472</c:v>
                </c:pt>
                <c:pt idx="578">
                  <c:v>0.22603595260000001</c:v>
                </c:pt>
                <c:pt idx="579">
                  <c:v>0.2136663496</c:v>
                </c:pt>
                <c:pt idx="580">
                  <c:v>0.19142620269999999</c:v>
                </c:pt>
                <c:pt idx="581">
                  <c:v>0.23529277740000001</c:v>
                </c:pt>
                <c:pt idx="582">
                  <c:v>0.2411631048</c:v>
                </c:pt>
                <c:pt idx="583">
                  <c:v>0.2238105386</c:v>
                </c:pt>
                <c:pt idx="584">
                  <c:v>0.2213395387</c:v>
                </c:pt>
                <c:pt idx="585">
                  <c:v>0.21428760890000001</c:v>
                </c:pt>
                <c:pt idx="586">
                  <c:v>0.18838852640000001</c:v>
                </c:pt>
                <c:pt idx="587">
                  <c:v>0.222461611</c:v>
                </c:pt>
                <c:pt idx="588">
                  <c:v>0.21600630879999999</c:v>
                </c:pt>
                <c:pt idx="589">
                  <c:v>0.1677561551</c:v>
                </c:pt>
                <c:pt idx="590">
                  <c:v>0.21446038780000001</c:v>
                </c:pt>
                <c:pt idx="591">
                  <c:v>0.1966457814</c:v>
                </c:pt>
                <c:pt idx="592">
                  <c:v>0.168060869</c:v>
                </c:pt>
                <c:pt idx="593">
                  <c:v>0.16275872290000001</c:v>
                </c:pt>
                <c:pt idx="594">
                  <c:v>0.19765476879999999</c:v>
                </c:pt>
                <c:pt idx="595">
                  <c:v>0.17645668980000001</c:v>
                </c:pt>
                <c:pt idx="596">
                  <c:v>0.23281037809999999</c:v>
                </c:pt>
                <c:pt idx="597">
                  <c:v>0.20074009900000001</c:v>
                </c:pt>
                <c:pt idx="598">
                  <c:v>0.23395417630000001</c:v>
                </c:pt>
                <c:pt idx="599">
                  <c:v>0.18668077890000001</c:v>
                </c:pt>
              </c:numCache>
            </c:numRef>
          </c:yVal>
          <c:smooth val="1"/>
          <c:extLst>
            <c:ext xmlns:c16="http://schemas.microsoft.com/office/drawing/2014/chart" uri="{C3380CC4-5D6E-409C-BE32-E72D297353CC}">
              <c16:uniqueId val="{00000004-3FAF-4CBF-82DD-E60AB52489B3}"/>
            </c:ext>
          </c:extLst>
        </c:ser>
        <c:ser>
          <c:idx val="8"/>
          <c:order val="5"/>
          <c:tx>
            <c:strRef>
              <c:f>Emission!$G$1</c:f>
              <c:strCache>
                <c:ptCount val="1"/>
                <c:pt idx="0">
                  <c:v>Coumarin1 (5 μM) Ethanol Emission</c:v>
                </c:pt>
              </c:strCache>
            </c:strRef>
          </c:tx>
          <c:spPr>
            <a:ln>
              <a:solidFill>
                <a:schemeClr val="accent2">
                  <a:lumMod val="60000"/>
                  <a:lumOff val="40000"/>
                </a:schemeClr>
              </a:solidFill>
            </a:ln>
          </c:spPr>
          <c:marker>
            <c:symbol val="none"/>
          </c:marker>
          <c:xVal>
            <c:numRef>
              <c:f>Emission!$G$14:$G$613</c:f>
              <c:numCache>
                <c:formatCode>General</c:formatCode>
                <c:ptCount val="600"/>
                <c:pt idx="0">
                  <c:v>400.4500122</c:v>
                </c:pt>
                <c:pt idx="1">
                  <c:v>401.05999759999997</c:v>
                </c:pt>
                <c:pt idx="2">
                  <c:v>401.51000979999998</c:v>
                </c:pt>
                <c:pt idx="3">
                  <c:v>401.9599915</c:v>
                </c:pt>
                <c:pt idx="4">
                  <c:v>402.57000729999999</c:v>
                </c:pt>
                <c:pt idx="5">
                  <c:v>403.02999879999999</c:v>
                </c:pt>
                <c:pt idx="6">
                  <c:v>403.48001099999999</c:v>
                </c:pt>
                <c:pt idx="7">
                  <c:v>403.92999270000001</c:v>
                </c:pt>
                <c:pt idx="8">
                  <c:v>404.5400085</c:v>
                </c:pt>
                <c:pt idx="9">
                  <c:v>405</c:v>
                </c:pt>
                <c:pt idx="10">
                  <c:v>405.4500122</c:v>
                </c:pt>
                <c:pt idx="11">
                  <c:v>406.05999759999997</c:v>
                </c:pt>
                <c:pt idx="12">
                  <c:v>406.51000979999998</c:v>
                </c:pt>
                <c:pt idx="13">
                  <c:v>406.9599915</c:v>
                </c:pt>
                <c:pt idx="14">
                  <c:v>407.57000729999999</c:v>
                </c:pt>
                <c:pt idx="15">
                  <c:v>408.02999879999999</c:v>
                </c:pt>
                <c:pt idx="16">
                  <c:v>408.48001099999999</c:v>
                </c:pt>
                <c:pt idx="17">
                  <c:v>408.92999270000001</c:v>
                </c:pt>
                <c:pt idx="18">
                  <c:v>409.5400085</c:v>
                </c:pt>
                <c:pt idx="19">
                  <c:v>410</c:v>
                </c:pt>
                <c:pt idx="20">
                  <c:v>410.4500122</c:v>
                </c:pt>
                <c:pt idx="21">
                  <c:v>411.05999759999997</c:v>
                </c:pt>
                <c:pt idx="22">
                  <c:v>411.51000979999998</c:v>
                </c:pt>
                <c:pt idx="23">
                  <c:v>411.9599915</c:v>
                </c:pt>
                <c:pt idx="24">
                  <c:v>412.57000729999999</c:v>
                </c:pt>
                <c:pt idx="25">
                  <c:v>413.02999879999999</c:v>
                </c:pt>
                <c:pt idx="26">
                  <c:v>413.48001099999999</c:v>
                </c:pt>
                <c:pt idx="27">
                  <c:v>413.92999270000001</c:v>
                </c:pt>
                <c:pt idx="28">
                  <c:v>414.5400085</c:v>
                </c:pt>
                <c:pt idx="29">
                  <c:v>415</c:v>
                </c:pt>
                <c:pt idx="30">
                  <c:v>415.4500122</c:v>
                </c:pt>
                <c:pt idx="31">
                  <c:v>416.05999759999997</c:v>
                </c:pt>
                <c:pt idx="32">
                  <c:v>416.51000979999998</c:v>
                </c:pt>
                <c:pt idx="33">
                  <c:v>416.9599915</c:v>
                </c:pt>
                <c:pt idx="34">
                  <c:v>417.57000729999999</c:v>
                </c:pt>
                <c:pt idx="35">
                  <c:v>418.02999879999999</c:v>
                </c:pt>
                <c:pt idx="36">
                  <c:v>418.48001099999999</c:v>
                </c:pt>
                <c:pt idx="37">
                  <c:v>418.92999270000001</c:v>
                </c:pt>
                <c:pt idx="38">
                  <c:v>419.5400085</c:v>
                </c:pt>
                <c:pt idx="39">
                  <c:v>420</c:v>
                </c:pt>
                <c:pt idx="40">
                  <c:v>420.4500122</c:v>
                </c:pt>
                <c:pt idx="41">
                  <c:v>421.05999759999997</c:v>
                </c:pt>
                <c:pt idx="42">
                  <c:v>421.51000979999998</c:v>
                </c:pt>
                <c:pt idx="43">
                  <c:v>421.9599915</c:v>
                </c:pt>
                <c:pt idx="44">
                  <c:v>422.57000729999999</c:v>
                </c:pt>
                <c:pt idx="45">
                  <c:v>423.02999879999999</c:v>
                </c:pt>
                <c:pt idx="46">
                  <c:v>423.48001099999999</c:v>
                </c:pt>
                <c:pt idx="47">
                  <c:v>423.92999270000001</c:v>
                </c:pt>
                <c:pt idx="48">
                  <c:v>424.5400085</c:v>
                </c:pt>
                <c:pt idx="49">
                  <c:v>425</c:v>
                </c:pt>
                <c:pt idx="50">
                  <c:v>425.4500122</c:v>
                </c:pt>
                <c:pt idx="51">
                  <c:v>426.05999759999997</c:v>
                </c:pt>
                <c:pt idx="52">
                  <c:v>426.51000979999998</c:v>
                </c:pt>
                <c:pt idx="53">
                  <c:v>426.9599915</c:v>
                </c:pt>
                <c:pt idx="54">
                  <c:v>427.57000729999999</c:v>
                </c:pt>
                <c:pt idx="55">
                  <c:v>428.02999879999999</c:v>
                </c:pt>
                <c:pt idx="56">
                  <c:v>428.48001099999999</c:v>
                </c:pt>
                <c:pt idx="57">
                  <c:v>428.92999270000001</c:v>
                </c:pt>
                <c:pt idx="58">
                  <c:v>429.5400085</c:v>
                </c:pt>
                <c:pt idx="59">
                  <c:v>430</c:v>
                </c:pt>
                <c:pt idx="60">
                  <c:v>430.4500122</c:v>
                </c:pt>
                <c:pt idx="61">
                  <c:v>431.05999759999997</c:v>
                </c:pt>
                <c:pt idx="62">
                  <c:v>431.51000979999998</c:v>
                </c:pt>
                <c:pt idx="63">
                  <c:v>431.9599915</c:v>
                </c:pt>
                <c:pt idx="64">
                  <c:v>432.57000729999999</c:v>
                </c:pt>
                <c:pt idx="65">
                  <c:v>433.02999879999999</c:v>
                </c:pt>
                <c:pt idx="66">
                  <c:v>433.48001099999999</c:v>
                </c:pt>
                <c:pt idx="67">
                  <c:v>433.92999270000001</c:v>
                </c:pt>
                <c:pt idx="68">
                  <c:v>434.5400085</c:v>
                </c:pt>
                <c:pt idx="69">
                  <c:v>435</c:v>
                </c:pt>
                <c:pt idx="70">
                  <c:v>435.4500122</c:v>
                </c:pt>
                <c:pt idx="71">
                  <c:v>436.05999759999997</c:v>
                </c:pt>
                <c:pt idx="72">
                  <c:v>436.51000979999998</c:v>
                </c:pt>
                <c:pt idx="73">
                  <c:v>436.9599915</c:v>
                </c:pt>
                <c:pt idx="74">
                  <c:v>437.57000729999999</c:v>
                </c:pt>
                <c:pt idx="75">
                  <c:v>438.02999879999999</c:v>
                </c:pt>
                <c:pt idx="76">
                  <c:v>438.48001099999999</c:v>
                </c:pt>
                <c:pt idx="77">
                  <c:v>438.92999270000001</c:v>
                </c:pt>
                <c:pt idx="78">
                  <c:v>439.5400085</c:v>
                </c:pt>
                <c:pt idx="79">
                  <c:v>440</c:v>
                </c:pt>
                <c:pt idx="80">
                  <c:v>440.4500122</c:v>
                </c:pt>
                <c:pt idx="81">
                  <c:v>441.05999759999997</c:v>
                </c:pt>
                <c:pt idx="82">
                  <c:v>441.51000979999998</c:v>
                </c:pt>
                <c:pt idx="83">
                  <c:v>441.9599915</c:v>
                </c:pt>
                <c:pt idx="84">
                  <c:v>442.57000729999999</c:v>
                </c:pt>
                <c:pt idx="85">
                  <c:v>443.02999879999999</c:v>
                </c:pt>
                <c:pt idx="86">
                  <c:v>443.48001099999999</c:v>
                </c:pt>
                <c:pt idx="87">
                  <c:v>443.92999270000001</c:v>
                </c:pt>
                <c:pt idx="88">
                  <c:v>444.5400085</c:v>
                </c:pt>
                <c:pt idx="89">
                  <c:v>445</c:v>
                </c:pt>
                <c:pt idx="90">
                  <c:v>445.4500122</c:v>
                </c:pt>
                <c:pt idx="91">
                  <c:v>446.05999759999997</c:v>
                </c:pt>
                <c:pt idx="92">
                  <c:v>446.51000979999998</c:v>
                </c:pt>
                <c:pt idx="93">
                  <c:v>446.9599915</c:v>
                </c:pt>
                <c:pt idx="94">
                  <c:v>447.57000729999999</c:v>
                </c:pt>
                <c:pt idx="95">
                  <c:v>448.02999879999999</c:v>
                </c:pt>
                <c:pt idx="96">
                  <c:v>448.48001099999999</c:v>
                </c:pt>
                <c:pt idx="97">
                  <c:v>448.92999270000001</c:v>
                </c:pt>
                <c:pt idx="98">
                  <c:v>449.5400085</c:v>
                </c:pt>
                <c:pt idx="99">
                  <c:v>450</c:v>
                </c:pt>
                <c:pt idx="100">
                  <c:v>450.44000240000003</c:v>
                </c:pt>
                <c:pt idx="101">
                  <c:v>451.0400085</c:v>
                </c:pt>
                <c:pt idx="102">
                  <c:v>451.48999020000002</c:v>
                </c:pt>
                <c:pt idx="103">
                  <c:v>451.94000240000003</c:v>
                </c:pt>
                <c:pt idx="104">
                  <c:v>452.52999879999999</c:v>
                </c:pt>
                <c:pt idx="105">
                  <c:v>452.98001099999999</c:v>
                </c:pt>
                <c:pt idx="106">
                  <c:v>453.42999270000001</c:v>
                </c:pt>
                <c:pt idx="107">
                  <c:v>454.01998900000001</c:v>
                </c:pt>
                <c:pt idx="108">
                  <c:v>454.47000120000001</c:v>
                </c:pt>
                <c:pt idx="109">
                  <c:v>455.07000729999999</c:v>
                </c:pt>
                <c:pt idx="110">
                  <c:v>455.51998900000001</c:v>
                </c:pt>
                <c:pt idx="111">
                  <c:v>455.97000120000001</c:v>
                </c:pt>
                <c:pt idx="112">
                  <c:v>456.55999759999997</c:v>
                </c:pt>
                <c:pt idx="113">
                  <c:v>457.01000979999998</c:v>
                </c:pt>
                <c:pt idx="114">
                  <c:v>457.4599915</c:v>
                </c:pt>
                <c:pt idx="115">
                  <c:v>458.0499878</c:v>
                </c:pt>
                <c:pt idx="116">
                  <c:v>458.5</c:v>
                </c:pt>
                <c:pt idx="117">
                  <c:v>458.9500122</c:v>
                </c:pt>
                <c:pt idx="118">
                  <c:v>459.5499878</c:v>
                </c:pt>
                <c:pt idx="119">
                  <c:v>460</c:v>
                </c:pt>
                <c:pt idx="120">
                  <c:v>460.4500122</c:v>
                </c:pt>
                <c:pt idx="121">
                  <c:v>461.05999759999997</c:v>
                </c:pt>
                <c:pt idx="122">
                  <c:v>461.51000979999998</c:v>
                </c:pt>
                <c:pt idx="123">
                  <c:v>461.9599915</c:v>
                </c:pt>
                <c:pt idx="124">
                  <c:v>462.57000729999999</c:v>
                </c:pt>
                <c:pt idx="125">
                  <c:v>463.02999879999999</c:v>
                </c:pt>
                <c:pt idx="126">
                  <c:v>463.48001099999999</c:v>
                </c:pt>
                <c:pt idx="127">
                  <c:v>463.92999270000001</c:v>
                </c:pt>
                <c:pt idx="128">
                  <c:v>464.5400085</c:v>
                </c:pt>
                <c:pt idx="129">
                  <c:v>465</c:v>
                </c:pt>
                <c:pt idx="130">
                  <c:v>465.4500122</c:v>
                </c:pt>
                <c:pt idx="131">
                  <c:v>466.05999759999997</c:v>
                </c:pt>
                <c:pt idx="132">
                  <c:v>466.51000979999998</c:v>
                </c:pt>
                <c:pt idx="133">
                  <c:v>466.9599915</c:v>
                </c:pt>
                <c:pt idx="134">
                  <c:v>467.57000729999999</c:v>
                </c:pt>
                <c:pt idx="135">
                  <c:v>468.02999879999999</c:v>
                </c:pt>
                <c:pt idx="136">
                  <c:v>468.48001099999999</c:v>
                </c:pt>
                <c:pt idx="137">
                  <c:v>468.92999270000001</c:v>
                </c:pt>
                <c:pt idx="138">
                  <c:v>469.5400085</c:v>
                </c:pt>
                <c:pt idx="139">
                  <c:v>470</c:v>
                </c:pt>
                <c:pt idx="140">
                  <c:v>470.44000240000003</c:v>
                </c:pt>
                <c:pt idx="141">
                  <c:v>471.0400085</c:v>
                </c:pt>
                <c:pt idx="142">
                  <c:v>471.48999020000002</c:v>
                </c:pt>
                <c:pt idx="143">
                  <c:v>471.94000240000003</c:v>
                </c:pt>
                <c:pt idx="144">
                  <c:v>472.52999879999999</c:v>
                </c:pt>
                <c:pt idx="145">
                  <c:v>472.98001099999999</c:v>
                </c:pt>
                <c:pt idx="146">
                  <c:v>473.42999270000001</c:v>
                </c:pt>
                <c:pt idx="147">
                  <c:v>474.01998900000001</c:v>
                </c:pt>
                <c:pt idx="148">
                  <c:v>474.47000120000001</c:v>
                </c:pt>
                <c:pt idx="149">
                  <c:v>475.07000729999999</c:v>
                </c:pt>
                <c:pt idx="150">
                  <c:v>475.51998900000001</c:v>
                </c:pt>
                <c:pt idx="151">
                  <c:v>475.97000120000001</c:v>
                </c:pt>
                <c:pt idx="152">
                  <c:v>476.55999759999997</c:v>
                </c:pt>
                <c:pt idx="153">
                  <c:v>477.01000979999998</c:v>
                </c:pt>
                <c:pt idx="154">
                  <c:v>477.4599915</c:v>
                </c:pt>
                <c:pt idx="155">
                  <c:v>478.0499878</c:v>
                </c:pt>
                <c:pt idx="156">
                  <c:v>478.5</c:v>
                </c:pt>
                <c:pt idx="157">
                  <c:v>478.9500122</c:v>
                </c:pt>
                <c:pt idx="158">
                  <c:v>479.5499878</c:v>
                </c:pt>
                <c:pt idx="159">
                  <c:v>480</c:v>
                </c:pt>
                <c:pt idx="160">
                  <c:v>480.44000240000003</c:v>
                </c:pt>
                <c:pt idx="161">
                  <c:v>481.0400085</c:v>
                </c:pt>
                <c:pt idx="162">
                  <c:v>481.48999020000002</c:v>
                </c:pt>
                <c:pt idx="163">
                  <c:v>481.94000240000003</c:v>
                </c:pt>
                <c:pt idx="164">
                  <c:v>482.52999879999999</c:v>
                </c:pt>
                <c:pt idx="165">
                  <c:v>482.98001099999999</c:v>
                </c:pt>
                <c:pt idx="166">
                  <c:v>483.42999270000001</c:v>
                </c:pt>
                <c:pt idx="167">
                  <c:v>484.01998900000001</c:v>
                </c:pt>
                <c:pt idx="168">
                  <c:v>484.47000120000001</c:v>
                </c:pt>
                <c:pt idx="169">
                  <c:v>485.07000729999999</c:v>
                </c:pt>
                <c:pt idx="170">
                  <c:v>485.51998900000001</c:v>
                </c:pt>
                <c:pt idx="171">
                  <c:v>485.97000120000001</c:v>
                </c:pt>
                <c:pt idx="172">
                  <c:v>486.55999759999997</c:v>
                </c:pt>
                <c:pt idx="173">
                  <c:v>487.01000979999998</c:v>
                </c:pt>
                <c:pt idx="174">
                  <c:v>487.4599915</c:v>
                </c:pt>
                <c:pt idx="175">
                  <c:v>488.0499878</c:v>
                </c:pt>
                <c:pt idx="176">
                  <c:v>488.5</c:v>
                </c:pt>
                <c:pt idx="177">
                  <c:v>488.9500122</c:v>
                </c:pt>
                <c:pt idx="178">
                  <c:v>489.5499878</c:v>
                </c:pt>
                <c:pt idx="179">
                  <c:v>490</c:v>
                </c:pt>
                <c:pt idx="180">
                  <c:v>490.44000240000003</c:v>
                </c:pt>
                <c:pt idx="181">
                  <c:v>491.0400085</c:v>
                </c:pt>
                <c:pt idx="182">
                  <c:v>491.48999020000002</c:v>
                </c:pt>
                <c:pt idx="183">
                  <c:v>491.94000240000003</c:v>
                </c:pt>
                <c:pt idx="184">
                  <c:v>492.52999879999999</c:v>
                </c:pt>
                <c:pt idx="185">
                  <c:v>492.98001099999999</c:v>
                </c:pt>
                <c:pt idx="186">
                  <c:v>493.42999270000001</c:v>
                </c:pt>
                <c:pt idx="187">
                  <c:v>494.01998900000001</c:v>
                </c:pt>
                <c:pt idx="188">
                  <c:v>494.47000120000001</c:v>
                </c:pt>
                <c:pt idx="189">
                  <c:v>495.07000729999999</c:v>
                </c:pt>
                <c:pt idx="190">
                  <c:v>495.51998900000001</c:v>
                </c:pt>
                <c:pt idx="191">
                  <c:v>495.97000120000001</c:v>
                </c:pt>
                <c:pt idx="192">
                  <c:v>496.55999759999997</c:v>
                </c:pt>
                <c:pt idx="193">
                  <c:v>497.01000979999998</c:v>
                </c:pt>
                <c:pt idx="194">
                  <c:v>497.4599915</c:v>
                </c:pt>
                <c:pt idx="195">
                  <c:v>498.0499878</c:v>
                </c:pt>
                <c:pt idx="196">
                  <c:v>498.5</c:v>
                </c:pt>
                <c:pt idx="197">
                  <c:v>498.9500122</c:v>
                </c:pt>
                <c:pt idx="198">
                  <c:v>499.5499878</c:v>
                </c:pt>
                <c:pt idx="199">
                  <c:v>500</c:v>
                </c:pt>
                <c:pt idx="200">
                  <c:v>500.44000240000003</c:v>
                </c:pt>
                <c:pt idx="201">
                  <c:v>501.0400085</c:v>
                </c:pt>
                <c:pt idx="202">
                  <c:v>501.48999020000002</c:v>
                </c:pt>
                <c:pt idx="203">
                  <c:v>501.94000240000003</c:v>
                </c:pt>
                <c:pt idx="204">
                  <c:v>502.52999879999999</c:v>
                </c:pt>
                <c:pt idx="205">
                  <c:v>502.98001099999999</c:v>
                </c:pt>
                <c:pt idx="206">
                  <c:v>503.42999270000001</c:v>
                </c:pt>
                <c:pt idx="207">
                  <c:v>504.01998900000001</c:v>
                </c:pt>
                <c:pt idx="208">
                  <c:v>504.47000120000001</c:v>
                </c:pt>
                <c:pt idx="209">
                  <c:v>505.07000729999999</c:v>
                </c:pt>
                <c:pt idx="210">
                  <c:v>505.51998900000001</c:v>
                </c:pt>
                <c:pt idx="211">
                  <c:v>505.97000120000001</c:v>
                </c:pt>
                <c:pt idx="212">
                  <c:v>506.55999759999997</c:v>
                </c:pt>
                <c:pt idx="213">
                  <c:v>507.01000979999998</c:v>
                </c:pt>
                <c:pt idx="214">
                  <c:v>507.4599915</c:v>
                </c:pt>
                <c:pt idx="215">
                  <c:v>508.0499878</c:v>
                </c:pt>
                <c:pt idx="216">
                  <c:v>508.5</c:v>
                </c:pt>
                <c:pt idx="217">
                  <c:v>508.9500122</c:v>
                </c:pt>
                <c:pt idx="218">
                  <c:v>509.5499878</c:v>
                </c:pt>
                <c:pt idx="219">
                  <c:v>510</c:v>
                </c:pt>
                <c:pt idx="220">
                  <c:v>510.44000240000003</c:v>
                </c:pt>
                <c:pt idx="221">
                  <c:v>511.0400085</c:v>
                </c:pt>
                <c:pt idx="222">
                  <c:v>511.48999020000002</c:v>
                </c:pt>
                <c:pt idx="223">
                  <c:v>511.94000240000003</c:v>
                </c:pt>
                <c:pt idx="224">
                  <c:v>512.53002930000002</c:v>
                </c:pt>
                <c:pt idx="225">
                  <c:v>512.97998050000001</c:v>
                </c:pt>
                <c:pt idx="226">
                  <c:v>513.42999269999996</c:v>
                </c:pt>
                <c:pt idx="227">
                  <c:v>514.02001949999999</c:v>
                </c:pt>
                <c:pt idx="228">
                  <c:v>514.46997069999998</c:v>
                </c:pt>
                <c:pt idx="229">
                  <c:v>515.07000730000004</c:v>
                </c:pt>
                <c:pt idx="230">
                  <c:v>515.52001949999999</c:v>
                </c:pt>
                <c:pt idx="231">
                  <c:v>515.96997069999998</c:v>
                </c:pt>
                <c:pt idx="232">
                  <c:v>516.55999759999997</c:v>
                </c:pt>
                <c:pt idx="233">
                  <c:v>517.01000980000003</c:v>
                </c:pt>
                <c:pt idx="234">
                  <c:v>517.46002199999998</c:v>
                </c:pt>
                <c:pt idx="235">
                  <c:v>518.04998780000005</c:v>
                </c:pt>
                <c:pt idx="236">
                  <c:v>518.5</c:v>
                </c:pt>
                <c:pt idx="237">
                  <c:v>518.95001219999995</c:v>
                </c:pt>
                <c:pt idx="238">
                  <c:v>519.54998780000005</c:v>
                </c:pt>
                <c:pt idx="239">
                  <c:v>520</c:v>
                </c:pt>
                <c:pt idx="240">
                  <c:v>520.44000240000003</c:v>
                </c:pt>
                <c:pt idx="241">
                  <c:v>521.03997800000002</c:v>
                </c:pt>
                <c:pt idx="242">
                  <c:v>521.48999019999997</c:v>
                </c:pt>
                <c:pt idx="243">
                  <c:v>521.94000240000003</c:v>
                </c:pt>
                <c:pt idx="244">
                  <c:v>522.53002930000002</c:v>
                </c:pt>
                <c:pt idx="245">
                  <c:v>522.97998050000001</c:v>
                </c:pt>
                <c:pt idx="246">
                  <c:v>523.42999269999996</c:v>
                </c:pt>
                <c:pt idx="247">
                  <c:v>524.02001949999999</c:v>
                </c:pt>
                <c:pt idx="248">
                  <c:v>524.46997069999998</c:v>
                </c:pt>
                <c:pt idx="249">
                  <c:v>525.07000730000004</c:v>
                </c:pt>
                <c:pt idx="250">
                  <c:v>525.52001949999999</c:v>
                </c:pt>
                <c:pt idx="251">
                  <c:v>525.96997069999998</c:v>
                </c:pt>
                <c:pt idx="252">
                  <c:v>526.55999759999997</c:v>
                </c:pt>
                <c:pt idx="253">
                  <c:v>527.01000980000003</c:v>
                </c:pt>
                <c:pt idx="254">
                  <c:v>527.46002199999998</c:v>
                </c:pt>
                <c:pt idx="255">
                  <c:v>528.04998780000005</c:v>
                </c:pt>
                <c:pt idx="256">
                  <c:v>528.5</c:v>
                </c:pt>
                <c:pt idx="257">
                  <c:v>528.95001219999995</c:v>
                </c:pt>
                <c:pt idx="258">
                  <c:v>529.54998780000005</c:v>
                </c:pt>
                <c:pt idx="259">
                  <c:v>530</c:v>
                </c:pt>
                <c:pt idx="260">
                  <c:v>530.44000240000003</c:v>
                </c:pt>
                <c:pt idx="261">
                  <c:v>531.02001949999999</c:v>
                </c:pt>
                <c:pt idx="262">
                  <c:v>531.46997069999998</c:v>
                </c:pt>
                <c:pt idx="263">
                  <c:v>532.04998780000005</c:v>
                </c:pt>
                <c:pt idx="264">
                  <c:v>532.5</c:v>
                </c:pt>
                <c:pt idx="265">
                  <c:v>532.94000240000003</c:v>
                </c:pt>
                <c:pt idx="266">
                  <c:v>533.52001949999999</c:v>
                </c:pt>
                <c:pt idx="267">
                  <c:v>533.96997069999998</c:v>
                </c:pt>
                <c:pt idx="268">
                  <c:v>534.54998780000005</c:v>
                </c:pt>
                <c:pt idx="269">
                  <c:v>535</c:v>
                </c:pt>
                <c:pt idx="270">
                  <c:v>535.44000240000003</c:v>
                </c:pt>
                <c:pt idx="271">
                  <c:v>536.02001949999999</c:v>
                </c:pt>
                <c:pt idx="272">
                  <c:v>536.46997069999998</c:v>
                </c:pt>
                <c:pt idx="273">
                  <c:v>537.04998780000005</c:v>
                </c:pt>
                <c:pt idx="274">
                  <c:v>537.5</c:v>
                </c:pt>
                <c:pt idx="275">
                  <c:v>537.94000240000003</c:v>
                </c:pt>
                <c:pt idx="276">
                  <c:v>538.52001949999999</c:v>
                </c:pt>
                <c:pt idx="277">
                  <c:v>538.96997069999998</c:v>
                </c:pt>
                <c:pt idx="278">
                  <c:v>539.54998780000005</c:v>
                </c:pt>
                <c:pt idx="279">
                  <c:v>540</c:v>
                </c:pt>
                <c:pt idx="280">
                  <c:v>540.44000240000003</c:v>
                </c:pt>
                <c:pt idx="281">
                  <c:v>541.02001949999999</c:v>
                </c:pt>
                <c:pt idx="282">
                  <c:v>541.46997069999998</c:v>
                </c:pt>
                <c:pt idx="283">
                  <c:v>542.04998780000005</c:v>
                </c:pt>
                <c:pt idx="284">
                  <c:v>542.5</c:v>
                </c:pt>
                <c:pt idx="285">
                  <c:v>542.94000240000003</c:v>
                </c:pt>
                <c:pt idx="286">
                  <c:v>543.52001949999999</c:v>
                </c:pt>
                <c:pt idx="287">
                  <c:v>543.96997069999998</c:v>
                </c:pt>
                <c:pt idx="288">
                  <c:v>544.54998780000005</c:v>
                </c:pt>
                <c:pt idx="289">
                  <c:v>545</c:v>
                </c:pt>
                <c:pt idx="290">
                  <c:v>545.44000240000003</c:v>
                </c:pt>
                <c:pt idx="291">
                  <c:v>546.02001949999999</c:v>
                </c:pt>
                <c:pt idx="292">
                  <c:v>546.46997069999998</c:v>
                </c:pt>
                <c:pt idx="293">
                  <c:v>547.04998780000005</c:v>
                </c:pt>
                <c:pt idx="294">
                  <c:v>547.5</c:v>
                </c:pt>
                <c:pt idx="295">
                  <c:v>547.94000240000003</c:v>
                </c:pt>
                <c:pt idx="296">
                  <c:v>548.52001949999999</c:v>
                </c:pt>
                <c:pt idx="297">
                  <c:v>548.96997069999998</c:v>
                </c:pt>
                <c:pt idx="298">
                  <c:v>549.54998780000005</c:v>
                </c:pt>
                <c:pt idx="299">
                  <c:v>550</c:v>
                </c:pt>
                <c:pt idx="300">
                  <c:v>550.44000240000003</c:v>
                </c:pt>
                <c:pt idx="301">
                  <c:v>551.02001949999999</c:v>
                </c:pt>
                <c:pt idx="302">
                  <c:v>551.46997069999998</c:v>
                </c:pt>
                <c:pt idx="303">
                  <c:v>552.04998780000005</c:v>
                </c:pt>
                <c:pt idx="304">
                  <c:v>552.5</c:v>
                </c:pt>
                <c:pt idx="305">
                  <c:v>552.94000240000003</c:v>
                </c:pt>
                <c:pt idx="306">
                  <c:v>553.52001949999999</c:v>
                </c:pt>
                <c:pt idx="307">
                  <c:v>553.96997069999998</c:v>
                </c:pt>
                <c:pt idx="308">
                  <c:v>554.54998780000005</c:v>
                </c:pt>
                <c:pt idx="309">
                  <c:v>555</c:v>
                </c:pt>
                <c:pt idx="310">
                  <c:v>555.44000240000003</c:v>
                </c:pt>
                <c:pt idx="311">
                  <c:v>556.02001949999999</c:v>
                </c:pt>
                <c:pt idx="312">
                  <c:v>556.46997069999998</c:v>
                </c:pt>
                <c:pt idx="313">
                  <c:v>557.04998780000005</c:v>
                </c:pt>
                <c:pt idx="314">
                  <c:v>557.5</c:v>
                </c:pt>
                <c:pt idx="315">
                  <c:v>557.94000240000003</c:v>
                </c:pt>
                <c:pt idx="316">
                  <c:v>558.52001949999999</c:v>
                </c:pt>
                <c:pt idx="317">
                  <c:v>558.96997069999998</c:v>
                </c:pt>
                <c:pt idx="318">
                  <c:v>559.54998780000005</c:v>
                </c:pt>
                <c:pt idx="319">
                  <c:v>560</c:v>
                </c:pt>
                <c:pt idx="320">
                  <c:v>560.44000240000003</c:v>
                </c:pt>
                <c:pt idx="321">
                  <c:v>561.02001949999999</c:v>
                </c:pt>
                <c:pt idx="322">
                  <c:v>561.46997069999998</c:v>
                </c:pt>
                <c:pt idx="323">
                  <c:v>562.04998780000005</c:v>
                </c:pt>
                <c:pt idx="324">
                  <c:v>562.5</c:v>
                </c:pt>
                <c:pt idx="325">
                  <c:v>562.94000240000003</c:v>
                </c:pt>
                <c:pt idx="326">
                  <c:v>563.52001949999999</c:v>
                </c:pt>
                <c:pt idx="327">
                  <c:v>563.96997069999998</c:v>
                </c:pt>
                <c:pt idx="328">
                  <c:v>564.54998780000005</c:v>
                </c:pt>
                <c:pt idx="329">
                  <c:v>565</c:v>
                </c:pt>
                <c:pt idx="330">
                  <c:v>565.44000240000003</c:v>
                </c:pt>
                <c:pt idx="331">
                  <c:v>566.02001949999999</c:v>
                </c:pt>
                <c:pt idx="332">
                  <c:v>566.46997069999998</c:v>
                </c:pt>
                <c:pt idx="333">
                  <c:v>567.04998780000005</c:v>
                </c:pt>
                <c:pt idx="334">
                  <c:v>567.5</c:v>
                </c:pt>
                <c:pt idx="335">
                  <c:v>567.94000240000003</c:v>
                </c:pt>
                <c:pt idx="336">
                  <c:v>568.52001949999999</c:v>
                </c:pt>
                <c:pt idx="337">
                  <c:v>568.96997069999998</c:v>
                </c:pt>
                <c:pt idx="338">
                  <c:v>569.54998780000005</c:v>
                </c:pt>
                <c:pt idx="339">
                  <c:v>570</c:v>
                </c:pt>
                <c:pt idx="340">
                  <c:v>570.44000240000003</c:v>
                </c:pt>
                <c:pt idx="341">
                  <c:v>571.02001949999999</c:v>
                </c:pt>
                <c:pt idx="342">
                  <c:v>571.46997069999998</c:v>
                </c:pt>
                <c:pt idx="343">
                  <c:v>572.04998780000005</c:v>
                </c:pt>
                <c:pt idx="344">
                  <c:v>572.5</c:v>
                </c:pt>
                <c:pt idx="345">
                  <c:v>572.94000240000003</c:v>
                </c:pt>
                <c:pt idx="346">
                  <c:v>573.52001949999999</c:v>
                </c:pt>
                <c:pt idx="347">
                  <c:v>573.96997069999998</c:v>
                </c:pt>
                <c:pt idx="348">
                  <c:v>574.54998780000005</c:v>
                </c:pt>
                <c:pt idx="349">
                  <c:v>575</c:v>
                </c:pt>
                <c:pt idx="350">
                  <c:v>575.44000240000003</c:v>
                </c:pt>
                <c:pt idx="351">
                  <c:v>576.02001949999999</c:v>
                </c:pt>
                <c:pt idx="352">
                  <c:v>576.46997069999998</c:v>
                </c:pt>
                <c:pt idx="353">
                  <c:v>577.04998780000005</c:v>
                </c:pt>
                <c:pt idx="354">
                  <c:v>577.5</c:v>
                </c:pt>
                <c:pt idx="355">
                  <c:v>577.94000240000003</c:v>
                </c:pt>
                <c:pt idx="356">
                  <c:v>578.52001949999999</c:v>
                </c:pt>
                <c:pt idx="357">
                  <c:v>578.96997069999998</c:v>
                </c:pt>
                <c:pt idx="358">
                  <c:v>579.54998780000005</c:v>
                </c:pt>
                <c:pt idx="359">
                  <c:v>580</c:v>
                </c:pt>
                <c:pt idx="360">
                  <c:v>580.44000240000003</c:v>
                </c:pt>
                <c:pt idx="361">
                  <c:v>581.02001949999999</c:v>
                </c:pt>
                <c:pt idx="362">
                  <c:v>581.46997069999998</c:v>
                </c:pt>
                <c:pt idx="363">
                  <c:v>582.04998780000005</c:v>
                </c:pt>
                <c:pt idx="364">
                  <c:v>582.5</c:v>
                </c:pt>
                <c:pt idx="365">
                  <c:v>582.94000240000003</c:v>
                </c:pt>
                <c:pt idx="366">
                  <c:v>583.52001949999999</c:v>
                </c:pt>
                <c:pt idx="367">
                  <c:v>583.96997069999998</c:v>
                </c:pt>
                <c:pt idx="368">
                  <c:v>584.54998780000005</c:v>
                </c:pt>
                <c:pt idx="369">
                  <c:v>585</c:v>
                </c:pt>
                <c:pt idx="370">
                  <c:v>585.44000240000003</c:v>
                </c:pt>
                <c:pt idx="371">
                  <c:v>586.02001949999999</c:v>
                </c:pt>
                <c:pt idx="372">
                  <c:v>586.46997069999998</c:v>
                </c:pt>
                <c:pt idx="373">
                  <c:v>587.04998780000005</c:v>
                </c:pt>
                <c:pt idx="374">
                  <c:v>587.5</c:v>
                </c:pt>
                <c:pt idx="375">
                  <c:v>587.94000240000003</c:v>
                </c:pt>
                <c:pt idx="376">
                  <c:v>588.52001949999999</c:v>
                </c:pt>
                <c:pt idx="377">
                  <c:v>588.96997069999998</c:v>
                </c:pt>
                <c:pt idx="378">
                  <c:v>589.54998780000005</c:v>
                </c:pt>
                <c:pt idx="379">
                  <c:v>590</c:v>
                </c:pt>
                <c:pt idx="380">
                  <c:v>590.42999269999996</c:v>
                </c:pt>
                <c:pt idx="381">
                  <c:v>591.01000980000003</c:v>
                </c:pt>
                <c:pt idx="382">
                  <c:v>591.44000240000003</c:v>
                </c:pt>
                <c:pt idx="383">
                  <c:v>592.02001949999999</c:v>
                </c:pt>
                <c:pt idx="384">
                  <c:v>592.46002199999998</c:v>
                </c:pt>
                <c:pt idx="385">
                  <c:v>593.03997800000002</c:v>
                </c:pt>
                <c:pt idx="386">
                  <c:v>593.46997069999998</c:v>
                </c:pt>
                <c:pt idx="387">
                  <c:v>594.04998780000005</c:v>
                </c:pt>
                <c:pt idx="388">
                  <c:v>594.48999019999997</c:v>
                </c:pt>
                <c:pt idx="389">
                  <c:v>595.07000730000004</c:v>
                </c:pt>
                <c:pt idx="390">
                  <c:v>595.5</c:v>
                </c:pt>
                <c:pt idx="391">
                  <c:v>595.94000240000003</c:v>
                </c:pt>
                <c:pt idx="392">
                  <c:v>596.52001949999999</c:v>
                </c:pt>
                <c:pt idx="393">
                  <c:v>596.95001219999995</c:v>
                </c:pt>
                <c:pt idx="394">
                  <c:v>597.53002930000002</c:v>
                </c:pt>
                <c:pt idx="395">
                  <c:v>597.96997069999998</c:v>
                </c:pt>
                <c:pt idx="396">
                  <c:v>598.54998780000005</c:v>
                </c:pt>
                <c:pt idx="397">
                  <c:v>598.97998050000001</c:v>
                </c:pt>
                <c:pt idx="398">
                  <c:v>599.55999759999997</c:v>
                </c:pt>
                <c:pt idx="399">
                  <c:v>600</c:v>
                </c:pt>
                <c:pt idx="400">
                  <c:v>600.42999269999996</c:v>
                </c:pt>
                <c:pt idx="401">
                  <c:v>601.01000980000003</c:v>
                </c:pt>
                <c:pt idx="402">
                  <c:v>601.44000240000003</c:v>
                </c:pt>
                <c:pt idx="403">
                  <c:v>602.02001949999999</c:v>
                </c:pt>
                <c:pt idx="404">
                  <c:v>602.46002199999998</c:v>
                </c:pt>
                <c:pt idx="405">
                  <c:v>603.03997800000002</c:v>
                </c:pt>
                <c:pt idx="406">
                  <c:v>603.46997069999998</c:v>
                </c:pt>
                <c:pt idx="407">
                  <c:v>604.04998780000005</c:v>
                </c:pt>
                <c:pt idx="408">
                  <c:v>604.48999019999997</c:v>
                </c:pt>
                <c:pt idx="409">
                  <c:v>605.07000730000004</c:v>
                </c:pt>
                <c:pt idx="410">
                  <c:v>605.5</c:v>
                </c:pt>
                <c:pt idx="411">
                  <c:v>605.94000240000003</c:v>
                </c:pt>
                <c:pt idx="412">
                  <c:v>606.52001949999999</c:v>
                </c:pt>
                <c:pt idx="413">
                  <c:v>606.95001219999995</c:v>
                </c:pt>
                <c:pt idx="414">
                  <c:v>607.53002930000002</c:v>
                </c:pt>
                <c:pt idx="415">
                  <c:v>607.96997069999998</c:v>
                </c:pt>
                <c:pt idx="416">
                  <c:v>608.54998780000005</c:v>
                </c:pt>
                <c:pt idx="417">
                  <c:v>608.97998050000001</c:v>
                </c:pt>
                <c:pt idx="418">
                  <c:v>609.55999759999997</c:v>
                </c:pt>
                <c:pt idx="419">
                  <c:v>610</c:v>
                </c:pt>
                <c:pt idx="420">
                  <c:v>610.42999269999996</c:v>
                </c:pt>
                <c:pt idx="421">
                  <c:v>611.01000980000003</c:v>
                </c:pt>
                <c:pt idx="422">
                  <c:v>611.44000240000003</c:v>
                </c:pt>
                <c:pt idx="423">
                  <c:v>612.02001949999999</c:v>
                </c:pt>
                <c:pt idx="424">
                  <c:v>612.46002199999998</c:v>
                </c:pt>
                <c:pt idx="425">
                  <c:v>613.03997800000002</c:v>
                </c:pt>
                <c:pt idx="426">
                  <c:v>613.46997069999998</c:v>
                </c:pt>
                <c:pt idx="427">
                  <c:v>614.04998780000005</c:v>
                </c:pt>
                <c:pt idx="428">
                  <c:v>614.48999019999997</c:v>
                </c:pt>
                <c:pt idx="429">
                  <c:v>615.07000730000004</c:v>
                </c:pt>
                <c:pt idx="430">
                  <c:v>615.5</c:v>
                </c:pt>
                <c:pt idx="431">
                  <c:v>615.94000240000003</c:v>
                </c:pt>
                <c:pt idx="432">
                  <c:v>616.52001949999999</c:v>
                </c:pt>
                <c:pt idx="433">
                  <c:v>616.95001219999995</c:v>
                </c:pt>
                <c:pt idx="434">
                  <c:v>617.53002930000002</c:v>
                </c:pt>
                <c:pt idx="435">
                  <c:v>617.96997069999998</c:v>
                </c:pt>
                <c:pt idx="436">
                  <c:v>618.54998780000005</c:v>
                </c:pt>
                <c:pt idx="437">
                  <c:v>618.97998050000001</c:v>
                </c:pt>
                <c:pt idx="438">
                  <c:v>619.55999759999997</c:v>
                </c:pt>
                <c:pt idx="439">
                  <c:v>620</c:v>
                </c:pt>
                <c:pt idx="440">
                  <c:v>620.42999269999996</c:v>
                </c:pt>
                <c:pt idx="441">
                  <c:v>621.01000980000003</c:v>
                </c:pt>
                <c:pt idx="442">
                  <c:v>621.44000240000003</c:v>
                </c:pt>
                <c:pt idx="443">
                  <c:v>622.02001949999999</c:v>
                </c:pt>
                <c:pt idx="444">
                  <c:v>622.46002199999998</c:v>
                </c:pt>
                <c:pt idx="445">
                  <c:v>623.03997800000002</c:v>
                </c:pt>
                <c:pt idx="446">
                  <c:v>623.46997069999998</c:v>
                </c:pt>
                <c:pt idx="447">
                  <c:v>624.04998780000005</c:v>
                </c:pt>
                <c:pt idx="448">
                  <c:v>624.48999019999997</c:v>
                </c:pt>
                <c:pt idx="449">
                  <c:v>625.07000730000004</c:v>
                </c:pt>
                <c:pt idx="450">
                  <c:v>625.5</c:v>
                </c:pt>
                <c:pt idx="451">
                  <c:v>625.94000240000003</c:v>
                </c:pt>
                <c:pt idx="452">
                  <c:v>626.52001949999999</c:v>
                </c:pt>
                <c:pt idx="453">
                  <c:v>626.95001219999995</c:v>
                </c:pt>
                <c:pt idx="454">
                  <c:v>627.53002930000002</c:v>
                </c:pt>
                <c:pt idx="455">
                  <c:v>627.96997069999998</c:v>
                </c:pt>
                <c:pt idx="456">
                  <c:v>628.54998780000005</c:v>
                </c:pt>
                <c:pt idx="457">
                  <c:v>628.97998050000001</c:v>
                </c:pt>
                <c:pt idx="458">
                  <c:v>629.55999759999997</c:v>
                </c:pt>
                <c:pt idx="459">
                  <c:v>630</c:v>
                </c:pt>
                <c:pt idx="460">
                  <c:v>630.42999269999996</c:v>
                </c:pt>
                <c:pt idx="461">
                  <c:v>631.01000980000003</c:v>
                </c:pt>
                <c:pt idx="462">
                  <c:v>631.44000240000003</c:v>
                </c:pt>
                <c:pt idx="463">
                  <c:v>632.02001949999999</c:v>
                </c:pt>
                <c:pt idx="464">
                  <c:v>632.46002199999998</c:v>
                </c:pt>
                <c:pt idx="465">
                  <c:v>633.03997800000002</c:v>
                </c:pt>
                <c:pt idx="466">
                  <c:v>633.46997069999998</c:v>
                </c:pt>
                <c:pt idx="467">
                  <c:v>634.04998780000005</c:v>
                </c:pt>
                <c:pt idx="468">
                  <c:v>634.48999019999997</c:v>
                </c:pt>
                <c:pt idx="469">
                  <c:v>635.07000730000004</c:v>
                </c:pt>
                <c:pt idx="470">
                  <c:v>635.5</c:v>
                </c:pt>
                <c:pt idx="471">
                  <c:v>635.94000240000003</c:v>
                </c:pt>
                <c:pt idx="472">
                  <c:v>636.52001949999999</c:v>
                </c:pt>
                <c:pt idx="473">
                  <c:v>636.95001219999995</c:v>
                </c:pt>
                <c:pt idx="474">
                  <c:v>637.53002930000002</c:v>
                </c:pt>
                <c:pt idx="475">
                  <c:v>637.96997069999998</c:v>
                </c:pt>
                <c:pt idx="476">
                  <c:v>638.54998780000005</c:v>
                </c:pt>
                <c:pt idx="477">
                  <c:v>638.97998050000001</c:v>
                </c:pt>
                <c:pt idx="478">
                  <c:v>639.55999759999997</c:v>
                </c:pt>
                <c:pt idx="479">
                  <c:v>640</c:v>
                </c:pt>
                <c:pt idx="480">
                  <c:v>640.57000730000004</c:v>
                </c:pt>
                <c:pt idx="481">
                  <c:v>641</c:v>
                </c:pt>
                <c:pt idx="482">
                  <c:v>641.57000730000004</c:v>
                </c:pt>
                <c:pt idx="483">
                  <c:v>642</c:v>
                </c:pt>
                <c:pt idx="484">
                  <c:v>642.57000730000004</c:v>
                </c:pt>
                <c:pt idx="485">
                  <c:v>643</c:v>
                </c:pt>
                <c:pt idx="486">
                  <c:v>643.57000730000004</c:v>
                </c:pt>
                <c:pt idx="487">
                  <c:v>644</c:v>
                </c:pt>
                <c:pt idx="488">
                  <c:v>644.57000730000004</c:v>
                </c:pt>
                <c:pt idx="489">
                  <c:v>645</c:v>
                </c:pt>
                <c:pt idx="490">
                  <c:v>645.57000730000004</c:v>
                </c:pt>
                <c:pt idx="491">
                  <c:v>646</c:v>
                </c:pt>
                <c:pt idx="492">
                  <c:v>646.57000730000004</c:v>
                </c:pt>
                <c:pt idx="493">
                  <c:v>647</c:v>
                </c:pt>
                <c:pt idx="494">
                  <c:v>647.57000730000004</c:v>
                </c:pt>
                <c:pt idx="495">
                  <c:v>648</c:v>
                </c:pt>
                <c:pt idx="496">
                  <c:v>648.57000730000004</c:v>
                </c:pt>
                <c:pt idx="497">
                  <c:v>649</c:v>
                </c:pt>
                <c:pt idx="498">
                  <c:v>649.57000730000004</c:v>
                </c:pt>
                <c:pt idx="499">
                  <c:v>650</c:v>
                </c:pt>
                <c:pt idx="500">
                  <c:v>650.42999269999996</c:v>
                </c:pt>
                <c:pt idx="501">
                  <c:v>651.01000980000003</c:v>
                </c:pt>
                <c:pt idx="502">
                  <c:v>651.44000240000003</c:v>
                </c:pt>
                <c:pt idx="503">
                  <c:v>652.02001949999999</c:v>
                </c:pt>
                <c:pt idx="504">
                  <c:v>652.46002199999998</c:v>
                </c:pt>
                <c:pt idx="505">
                  <c:v>653.03997800000002</c:v>
                </c:pt>
                <c:pt idx="506">
                  <c:v>653.46997069999998</c:v>
                </c:pt>
                <c:pt idx="507">
                  <c:v>654.04998780000005</c:v>
                </c:pt>
                <c:pt idx="508">
                  <c:v>654.48999019999997</c:v>
                </c:pt>
                <c:pt idx="509">
                  <c:v>655.07000730000004</c:v>
                </c:pt>
                <c:pt idx="510">
                  <c:v>655.5</c:v>
                </c:pt>
                <c:pt idx="511">
                  <c:v>655.94000240000003</c:v>
                </c:pt>
                <c:pt idx="512">
                  <c:v>656.52001949999999</c:v>
                </c:pt>
                <c:pt idx="513">
                  <c:v>656.95001219999995</c:v>
                </c:pt>
                <c:pt idx="514">
                  <c:v>657.53002930000002</c:v>
                </c:pt>
                <c:pt idx="515">
                  <c:v>657.96997069999998</c:v>
                </c:pt>
                <c:pt idx="516">
                  <c:v>658.54998780000005</c:v>
                </c:pt>
                <c:pt idx="517">
                  <c:v>658.97998050000001</c:v>
                </c:pt>
                <c:pt idx="518">
                  <c:v>659.55999759999997</c:v>
                </c:pt>
                <c:pt idx="519">
                  <c:v>660</c:v>
                </c:pt>
                <c:pt idx="520">
                  <c:v>660.57000730000004</c:v>
                </c:pt>
                <c:pt idx="521">
                  <c:v>661</c:v>
                </c:pt>
                <c:pt idx="522">
                  <c:v>661.57000730000004</c:v>
                </c:pt>
                <c:pt idx="523">
                  <c:v>662</c:v>
                </c:pt>
                <c:pt idx="524">
                  <c:v>662.57000730000004</c:v>
                </c:pt>
                <c:pt idx="525">
                  <c:v>663</c:v>
                </c:pt>
                <c:pt idx="526">
                  <c:v>663.57000730000004</c:v>
                </c:pt>
                <c:pt idx="527">
                  <c:v>664</c:v>
                </c:pt>
                <c:pt idx="528">
                  <c:v>664.57000730000004</c:v>
                </c:pt>
                <c:pt idx="529">
                  <c:v>665</c:v>
                </c:pt>
                <c:pt idx="530">
                  <c:v>665.57000730000004</c:v>
                </c:pt>
                <c:pt idx="531">
                  <c:v>666</c:v>
                </c:pt>
                <c:pt idx="532">
                  <c:v>666.57000730000004</c:v>
                </c:pt>
                <c:pt idx="533">
                  <c:v>667</c:v>
                </c:pt>
                <c:pt idx="534">
                  <c:v>667.57000730000004</c:v>
                </c:pt>
                <c:pt idx="535">
                  <c:v>668</c:v>
                </c:pt>
                <c:pt idx="536">
                  <c:v>668.57000730000004</c:v>
                </c:pt>
                <c:pt idx="537">
                  <c:v>669</c:v>
                </c:pt>
                <c:pt idx="538">
                  <c:v>669.57000730000004</c:v>
                </c:pt>
                <c:pt idx="539">
                  <c:v>670</c:v>
                </c:pt>
                <c:pt idx="540">
                  <c:v>670.55999759999997</c:v>
                </c:pt>
                <c:pt idx="541">
                  <c:v>670.97998050000001</c:v>
                </c:pt>
                <c:pt idx="542">
                  <c:v>671.53997800000002</c:v>
                </c:pt>
                <c:pt idx="543">
                  <c:v>671.96997069999998</c:v>
                </c:pt>
                <c:pt idx="544">
                  <c:v>672.53002930000002</c:v>
                </c:pt>
                <c:pt idx="545">
                  <c:v>672.95001219999995</c:v>
                </c:pt>
                <c:pt idx="546">
                  <c:v>673.52001949999999</c:v>
                </c:pt>
                <c:pt idx="547">
                  <c:v>673.94000240000003</c:v>
                </c:pt>
                <c:pt idx="548">
                  <c:v>674.5</c:v>
                </c:pt>
                <c:pt idx="549">
                  <c:v>675.07000730000004</c:v>
                </c:pt>
                <c:pt idx="550">
                  <c:v>675.48999019999997</c:v>
                </c:pt>
                <c:pt idx="551">
                  <c:v>676.04998780000005</c:v>
                </c:pt>
                <c:pt idx="552">
                  <c:v>676.46997069999998</c:v>
                </c:pt>
                <c:pt idx="553">
                  <c:v>677.03997800000002</c:v>
                </c:pt>
                <c:pt idx="554">
                  <c:v>677.46002199999998</c:v>
                </c:pt>
                <c:pt idx="555">
                  <c:v>678.02001949999999</c:v>
                </c:pt>
                <c:pt idx="556">
                  <c:v>678.45001219999995</c:v>
                </c:pt>
                <c:pt idx="557">
                  <c:v>679.01000980000003</c:v>
                </c:pt>
                <c:pt idx="558">
                  <c:v>679.42999269999996</c:v>
                </c:pt>
                <c:pt idx="559">
                  <c:v>680</c:v>
                </c:pt>
                <c:pt idx="560">
                  <c:v>680.57000730000004</c:v>
                </c:pt>
                <c:pt idx="561">
                  <c:v>681</c:v>
                </c:pt>
                <c:pt idx="562">
                  <c:v>681.57000730000004</c:v>
                </c:pt>
                <c:pt idx="563">
                  <c:v>682</c:v>
                </c:pt>
                <c:pt idx="564">
                  <c:v>682.57000730000004</c:v>
                </c:pt>
                <c:pt idx="565">
                  <c:v>683</c:v>
                </c:pt>
                <c:pt idx="566">
                  <c:v>683.57000730000004</c:v>
                </c:pt>
                <c:pt idx="567">
                  <c:v>684</c:v>
                </c:pt>
                <c:pt idx="568">
                  <c:v>684.57000730000004</c:v>
                </c:pt>
                <c:pt idx="569">
                  <c:v>685</c:v>
                </c:pt>
                <c:pt idx="570">
                  <c:v>685.57000730000004</c:v>
                </c:pt>
                <c:pt idx="571">
                  <c:v>686</c:v>
                </c:pt>
                <c:pt idx="572">
                  <c:v>686.57000730000004</c:v>
                </c:pt>
                <c:pt idx="573">
                  <c:v>687</c:v>
                </c:pt>
                <c:pt idx="574">
                  <c:v>687.57000730000004</c:v>
                </c:pt>
                <c:pt idx="575">
                  <c:v>688</c:v>
                </c:pt>
                <c:pt idx="576">
                  <c:v>688.57000730000004</c:v>
                </c:pt>
                <c:pt idx="577">
                  <c:v>689</c:v>
                </c:pt>
                <c:pt idx="578">
                  <c:v>689.57000730000004</c:v>
                </c:pt>
                <c:pt idx="579">
                  <c:v>690</c:v>
                </c:pt>
                <c:pt idx="580">
                  <c:v>690.55999759999997</c:v>
                </c:pt>
                <c:pt idx="581">
                  <c:v>690.97998050000001</c:v>
                </c:pt>
                <c:pt idx="582">
                  <c:v>691.53997800000002</c:v>
                </c:pt>
                <c:pt idx="583">
                  <c:v>691.96997069999998</c:v>
                </c:pt>
                <c:pt idx="584">
                  <c:v>692.53002930000002</c:v>
                </c:pt>
                <c:pt idx="585">
                  <c:v>692.95001219999995</c:v>
                </c:pt>
                <c:pt idx="586">
                  <c:v>693.52001949999999</c:v>
                </c:pt>
                <c:pt idx="587">
                  <c:v>693.94000240000003</c:v>
                </c:pt>
                <c:pt idx="588">
                  <c:v>694.5</c:v>
                </c:pt>
                <c:pt idx="589">
                  <c:v>695.07000730000004</c:v>
                </c:pt>
                <c:pt idx="590">
                  <c:v>695.48999019999997</c:v>
                </c:pt>
                <c:pt idx="591">
                  <c:v>696.04998780000005</c:v>
                </c:pt>
                <c:pt idx="592">
                  <c:v>696.46997069999998</c:v>
                </c:pt>
                <c:pt idx="593">
                  <c:v>697.03997800000002</c:v>
                </c:pt>
                <c:pt idx="594">
                  <c:v>697.46002199999998</c:v>
                </c:pt>
                <c:pt idx="595">
                  <c:v>698.02001949999999</c:v>
                </c:pt>
                <c:pt idx="596">
                  <c:v>698.45001219999995</c:v>
                </c:pt>
                <c:pt idx="597">
                  <c:v>699.01000980000003</c:v>
                </c:pt>
                <c:pt idx="598">
                  <c:v>699.42999269999996</c:v>
                </c:pt>
                <c:pt idx="599">
                  <c:v>700</c:v>
                </c:pt>
              </c:numCache>
            </c:numRef>
          </c:xVal>
          <c:yVal>
            <c:numRef>
              <c:f>Emission!$H$14:$H$613</c:f>
              <c:numCache>
                <c:formatCode>General</c:formatCode>
                <c:ptCount val="600"/>
                <c:pt idx="0">
                  <c:v>15.287325859999999</c:v>
                </c:pt>
                <c:pt idx="1">
                  <c:v>16.970428470000002</c:v>
                </c:pt>
                <c:pt idx="2">
                  <c:v>18.735166549999999</c:v>
                </c:pt>
                <c:pt idx="3">
                  <c:v>21.029050829999999</c:v>
                </c:pt>
                <c:pt idx="4">
                  <c:v>22.534692759999999</c:v>
                </c:pt>
                <c:pt idx="5">
                  <c:v>24.875995639999999</c:v>
                </c:pt>
                <c:pt idx="6">
                  <c:v>26.364881520000001</c:v>
                </c:pt>
                <c:pt idx="7">
                  <c:v>28.50959778</c:v>
                </c:pt>
                <c:pt idx="8">
                  <c:v>30.80827141</c:v>
                </c:pt>
                <c:pt idx="9">
                  <c:v>31.75683403</c:v>
                </c:pt>
                <c:pt idx="10">
                  <c:v>33.621227259999998</c:v>
                </c:pt>
                <c:pt idx="11">
                  <c:v>35.880668640000003</c:v>
                </c:pt>
                <c:pt idx="12">
                  <c:v>38.238147740000002</c:v>
                </c:pt>
                <c:pt idx="13">
                  <c:v>40.415142060000001</c:v>
                </c:pt>
                <c:pt idx="14">
                  <c:v>43.33297348</c:v>
                </c:pt>
                <c:pt idx="15">
                  <c:v>45.046726229999997</c:v>
                </c:pt>
                <c:pt idx="16">
                  <c:v>47.165840150000001</c:v>
                </c:pt>
                <c:pt idx="17">
                  <c:v>50.192134860000003</c:v>
                </c:pt>
                <c:pt idx="18">
                  <c:v>53.666992190000002</c:v>
                </c:pt>
                <c:pt idx="19">
                  <c:v>55.759590150000001</c:v>
                </c:pt>
                <c:pt idx="20">
                  <c:v>59.567535399999997</c:v>
                </c:pt>
                <c:pt idx="21">
                  <c:v>64.204025270000002</c:v>
                </c:pt>
                <c:pt idx="22">
                  <c:v>68.196136469999999</c:v>
                </c:pt>
                <c:pt idx="23">
                  <c:v>70.615974429999994</c:v>
                </c:pt>
                <c:pt idx="24">
                  <c:v>76.635139469999999</c:v>
                </c:pt>
                <c:pt idx="25">
                  <c:v>79.779335020000005</c:v>
                </c:pt>
                <c:pt idx="26">
                  <c:v>83.337715149999994</c:v>
                </c:pt>
                <c:pt idx="27">
                  <c:v>89.188285829999998</c:v>
                </c:pt>
                <c:pt idx="28">
                  <c:v>92.894897459999996</c:v>
                </c:pt>
                <c:pt idx="29">
                  <c:v>97.931327820000007</c:v>
                </c:pt>
                <c:pt idx="30">
                  <c:v>102.7007141</c:v>
                </c:pt>
                <c:pt idx="31">
                  <c:v>110.7185516</c:v>
                </c:pt>
                <c:pt idx="32">
                  <c:v>115.254097</c:v>
                </c:pt>
                <c:pt idx="33">
                  <c:v>120.16307070000001</c:v>
                </c:pt>
                <c:pt idx="34">
                  <c:v>126.71794130000001</c:v>
                </c:pt>
                <c:pt idx="35">
                  <c:v>130.5990448</c:v>
                </c:pt>
                <c:pt idx="36">
                  <c:v>135.70509340000001</c:v>
                </c:pt>
                <c:pt idx="37">
                  <c:v>140.12986760000001</c:v>
                </c:pt>
                <c:pt idx="38">
                  <c:v>149.493042</c:v>
                </c:pt>
                <c:pt idx="39">
                  <c:v>154.95886229999999</c:v>
                </c:pt>
                <c:pt idx="40">
                  <c:v>159.70327760000001</c:v>
                </c:pt>
                <c:pt idx="41">
                  <c:v>167.4254913</c:v>
                </c:pt>
                <c:pt idx="42">
                  <c:v>172.86999510000001</c:v>
                </c:pt>
                <c:pt idx="43">
                  <c:v>176.30810550000001</c:v>
                </c:pt>
                <c:pt idx="44">
                  <c:v>182.6152802</c:v>
                </c:pt>
                <c:pt idx="45">
                  <c:v>187.8021545</c:v>
                </c:pt>
                <c:pt idx="46">
                  <c:v>193.9088745</c:v>
                </c:pt>
                <c:pt idx="47">
                  <c:v>201.18826290000001</c:v>
                </c:pt>
                <c:pt idx="48">
                  <c:v>207.86993409999999</c:v>
                </c:pt>
                <c:pt idx="49">
                  <c:v>213.04132079999999</c:v>
                </c:pt>
                <c:pt idx="50">
                  <c:v>219.70141599999999</c:v>
                </c:pt>
                <c:pt idx="51">
                  <c:v>226.83050539999999</c:v>
                </c:pt>
                <c:pt idx="52">
                  <c:v>231.67250060000001</c:v>
                </c:pt>
                <c:pt idx="53">
                  <c:v>236.00077820000001</c:v>
                </c:pt>
                <c:pt idx="54">
                  <c:v>241.1794739</c:v>
                </c:pt>
                <c:pt idx="55">
                  <c:v>249.23423769999999</c:v>
                </c:pt>
                <c:pt idx="56">
                  <c:v>254.021637</c:v>
                </c:pt>
                <c:pt idx="57">
                  <c:v>258.42086790000002</c:v>
                </c:pt>
                <c:pt idx="58">
                  <c:v>264.2852173</c:v>
                </c:pt>
                <c:pt idx="59">
                  <c:v>269.39727779999998</c:v>
                </c:pt>
                <c:pt idx="60">
                  <c:v>274.0369263</c:v>
                </c:pt>
                <c:pt idx="61">
                  <c:v>279.2609253</c:v>
                </c:pt>
                <c:pt idx="62">
                  <c:v>283.59768680000002</c:v>
                </c:pt>
                <c:pt idx="63">
                  <c:v>287.8995056</c:v>
                </c:pt>
                <c:pt idx="64">
                  <c:v>290.56735229999998</c:v>
                </c:pt>
                <c:pt idx="65">
                  <c:v>297.62005620000002</c:v>
                </c:pt>
                <c:pt idx="66">
                  <c:v>302.14221190000001</c:v>
                </c:pt>
                <c:pt idx="67">
                  <c:v>303.20690919999998</c:v>
                </c:pt>
                <c:pt idx="68">
                  <c:v>308.61080930000003</c:v>
                </c:pt>
                <c:pt idx="69">
                  <c:v>312.26248170000002</c:v>
                </c:pt>
                <c:pt idx="70">
                  <c:v>315.55316160000001</c:v>
                </c:pt>
                <c:pt idx="71">
                  <c:v>319.0224609</c:v>
                </c:pt>
                <c:pt idx="72">
                  <c:v>319.7068481</c:v>
                </c:pt>
                <c:pt idx="73">
                  <c:v>322.72149660000002</c:v>
                </c:pt>
                <c:pt idx="74">
                  <c:v>324.78460689999997</c:v>
                </c:pt>
                <c:pt idx="75">
                  <c:v>328.37997439999998</c:v>
                </c:pt>
                <c:pt idx="76">
                  <c:v>329.31564329999998</c:v>
                </c:pt>
                <c:pt idx="77">
                  <c:v>334.78427119999998</c:v>
                </c:pt>
                <c:pt idx="78">
                  <c:v>336.23672490000001</c:v>
                </c:pt>
                <c:pt idx="79">
                  <c:v>334.41293330000002</c:v>
                </c:pt>
                <c:pt idx="80">
                  <c:v>338.3134766</c:v>
                </c:pt>
                <c:pt idx="81">
                  <c:v>339.7208862</c:v>
                </c:pt>
                <c:pt idx="82">
                  <c:v>341.243042</c:v>
                </c:pt>
                <c:pt idx="83">
                  <c:v>341.29470830000002</c:v>
                </c:pt>
                <c:pt idx="84">
                  <c:v>344.87341309999999</c:v>
                </c:pt>
                <c:pt idx="85">
                  <c:v>343.01049799999998</c:v>
                </c:pt>
                <c:pt idx="86">
                  <c:v>343.93945309999998</c:v>
                </c:pt>
                <c:pt idx="87">
                  <c:v>346.10516360000003</c:v>
                </c:pt>
                <c:pt idx="88">
                  <c:v>344.66091920000002</c:v>
                </c:pt>
                <c:pt idx="89">
                  <c:v>344.18841550000002</c:v>
                </c:pt>
                <c:pt idx="90">
                  <c:v>346.49600220000002</c:v>
                </c:pt>
                <c:pt idx="91">
                  <c:v>344.47708130000001</c:v>
                </c:pt>
                <c:pt idx="92">
                  <c:v>345.01007079999999</c:v>
                </c:pt>
                <c:pt idx="93">
                  <c:v>343.70483400000001</c:v>
                </c:pt>
                <c:pt idx="94">
                  <c:v>344.05847169999998</c:v>
                </c:pt>
                <c:pt idx="95">
                  <c:v>341.98770139999999</c:v>
                </c:pt>
                <c:pt idx="96">
                  <c:v>341.92858890000002</c:v>
                </c:pt>
                <c:pt idx="97">
                  <c:v>344.66235349999999</c:v>
                </c:pt>
                <c:pt idx="98">
                  <c:v>342.2616577</c:v>
                </c:pt>
                <c:pt idx="99">
                  <c:v>339.33816530000001</c:v>
                </c:pt>
                <c:pt idx="100">
                  <c:v>340.84860229999998</c:v>
                </c:pt>
                <c:pt idx="101">
                  <c:v>339.21249390000003</c:v>
                </c:pt>
                <c:pt idx="102">
                  <c:v>338.4395447</c:v>
                </c:pt>
                <c:pt idx="103">
                  <c:v>338.35546879999998</c:v>
                </c:pt>
                <c:pt idx="104">
                  <c:v>336.60696410000003</c:v>
                </c:pt>
                <c:pt idx="105">
                  <c:v>334.07269289999999</c:v>
                </c:pt>
                <c:pt idx="106">
                  <c:v>333.2127686</c:v>
                </c:pt>
                <c:pt idx="107">
                  <c:v>330.8544617</c:v>
                </c:pt>
                <c:pt idx="108">
                  <c:v>328.77868649999999</c:v>
                </c:pt>
                <c:pt idx="109">
                  <c:v>326.66854860000001</c:v>
                </c:pt>
                <c:pt idx="110">
                  <c:v>325.42507929999999</c:v>
                </c:pt>
                <c:pt idx="111">
                  <c:v>323.48446660000002</c:v>
                </c:pt>
                <c:pt idx="112">
                  <c:v>321.09054570000001</c:v>
                </c:pt>
                <c:pt idx="113">
                  <c:v>320.26834109999999</c:v>
                </c:pt>
                <c:pt idx="114">
                  <c:v>318.37747189999999</c:v>
                </c:pt>
                <c:pt idx="115">
                  <c:v>316.391571</c:v>
                </c:pt>
                <c:pt idx="116">
                  <c:v>315.07852170000001</c:v>
                </c:pt>
                <c:pt idx="117">
                  <c:v>311.53790279999998</c:v>
                </c:pt>
                <c:pt idx="118">
                  <c:v>309.23818970000002</c:v>
                </c:pt>
                <c:pt idx="119">
                  <c:v>305.5847473</c:v>
                </c:pt>
                <c:pt idx="120">
                  <c:v>304.47100829999999</c:v>
                </c:pt>
                <c:pt idx="121">
                  <c:v>301.78747559999999</c:v>
                </c:pt>
                <c:pt idx="122">
                  <c:v>299.64910889999999</c:v>
                </c:pt>
                <c:pt idx="123">
                  <c:v>298.6016846</c:v>
                </c:pt>
                <c:pt idx="124">
                  <c:v>294.23849489999998</c:v>
                </c:pt>
                <c:pt idx="125">
                  <c:v>292.61926269999998</c:v>
                </c:pt>
                <c:pt idx="126">
                  <c:v>288.93176269999998</c:v>
                </c:pt>
                <c:pt idx="127">
                  <c:v>288.20486449999999</c:v>
                </c:pt>
                <c:pt idx="128">
                  <c:v>282.12677000000002</c:v>
                </c:pt>
                <c:pt idx="129">
                  <c:v>280.38027949999997</c:v>
                </c:pt>
                <c:pt idx="130">
                  <c:v>278.24136349999998</c:v>
                </c:pt>
                <c:pt idx="131">
                  <c:v>275.09851070000002</c:v>
                </c:pt>
                <c:pt idx="132">
                  <c:v>271.28189090000001</c:v>
                </c:pt>
                <c:pt idx="133">
                  <c:v>268.0890503</c:v>
                </c:pt>
                <c:pt idx="134">
                  <c:v>264.0213928</c:v>
                </c:pt>
                <c:pt idx="135">
                  <c:v>262.14852910000002</c:v>
                </c:pt>
                <c:pt idx="136">
                  <c:v>259.21185300000002</c:v>
                </c:pt>
                <c:pt idx="137">
                  <c:v>256.92834470000003</c:v>
                </c:pt>
                <c:pt idx="138">
                  <c:v>251.3155975</c:v>
                </c:pt>
                <c:pt idx="139">
                  <c:v>249.7127533</c:v>
                </c:pt>
                <c:pt idx="140">
                  <c:v>246.64323429999999</c:v>
                </c:pt>
                <c:pt idx="141">
                  <c:v>242.1562653</c:v>
                </c:pt>
                <c:pt idx="142">
                  <c:v>239.5816193</c:v>
                </c:pt>
                <c:pt idx="143">
                  <c:v>236.4663544</c:v>
                </c:pt>
                <c:pt idx="144">
                  <c:v>233.30488589999999</c:v>
                </c:pt>
                <c:pt idx="145">
                  <c:v>228.90017700000001</c:v>
                </c:pt>
                <c:pt idx="146">
                  <c:v>228.1400146</c:v>
                </c:pt>
                <c:pt idx="147">
                  <c:v>222.14619450000001</c:v>
                </c:pt>
                <c:pt idx="148">
                  <c:v>218.9514618</c:v>
                </c:pt>
                <c:pt idx="149">
                  <c:v>216.25979609999999</c:v>
                </c:pt>
                <c:pt idx="150">
                  <c:v>213.2045593</c:v>
                </c:pt>
                <c:pt idx="151">
                  <c:v>211.0529938</c:v>
                </c:pt>
                <c:pt idx="152">
                  <c:v>207.65028380000001</c:v>
                </c:pt>
                <c:pt idx="153">
                  <c:v>202.50979609999999</c:v>
                </c:pt>
                <c:pt idx="154">
                  <c:v>199.09437560000001</c:v>
                </c:pt>
                <c:pt idx="155">
                  <c:v>195.70751949999999</c:v>
                </c:pt>
                <c:pt idx="156">
                  <c:v>192.8439941</c:v>
                </c:pt>
                <c:pt idx="157">
                  <c:v>190.07647710000001</c:v>
                </c:pt>
                <c:pt idx="158">
                  <c:v>185.85739140000001</c:v>
                </c:pt>
                <c:pt idx="159">
                  <c:v>183.00895689999999</c:v>
                </c:pt>
                <c:pt idx="160">
                  <c:v>179.07275390000001</c:v>
                </c:pt>
                <c:pt idx="161">
                  <c:v>177.3903809</c:v>
                </c:pt>
                <c:pt idx="162">
                  <c:v>173.78140260000001</c:v>
                </c:pt>
                <c:pt idx="163">
                  <c:v>172.15188599999999</c:v>
                </c:pt>
                <c:pt idx="164">
                  <c:v>166.71084590000001</c:v>
                </c:pt>
                <c:pt idx="165">
                  <c:v>165.510437</c:v>
                </c:pt>
                <c:pt idx="166">
                  <c:v>163.36930849999999</c:v>
                </c:pt>
                <c:pt idx="167">
                  <c:v>157.8041992</c:v>
                </c:pt>
                <c:pt idx="168">
                  <c:v>156.58049009999999</c:v>
                </c:pt>
                <c:pt idx="169">
                  <c:v>153.31558229999999</c:v>
                </c:pt>
                <c:pt idx="170">
                  <c:v>151.7437286</c:v>
                </c:pt>
                <c:pt idx="171">
                  <c:v>148.3799286</c:v>
                </c:pt>
                <c:pt idx="172">
                  <c:v>145.2632141</c:v>
                </c:pt>
                <c:pt idx="173">
                  <c:v>143.6226044</c:v>
                </c:pt>
                <c:pt idx="174">
                  <c:v>140.04444889999999</c:v>
                </c:pt>
                <c:pt idx="175">
                  <c:v>136.97450259999999</c:v>
                </c:pt>
                <c:pt idx="176">
                  <c:v>134.5138245</c:v>
                </c:pt>
                <c:pt idx="177">
                  <c:v>131.25184630000001</c:v>
                </c:pt>
                <c:pt idx="178">
                  <c:v>130.159729</c:v>
                </c:pt>
                <c:pt idx="179">
                  <c:v>127.3533554</c:v>
                </c:pt>
                <c:pt idx="180">
                  <c:v>125.25698850000001</c:v>
                </c:pt>
                <c:pt idx="181">
                  <c:v>122.4490814</c:v>
                </c:pt>
                <c:pt idx="182">
                  <c:v>120.3656082</c:v>
                </c:pt>
                <c:pt idx="183">
                  <c:v>117.4575195</c:v>
                </c:pt>
                <c:pt idx="184">
                  <c:v>115.3908844</c:v>
                </c:pt>
                <c:pt idx="185">
                  <c:v>112.6980743</c:v>
                </c:pt>
                <c:pt idx="186">
                  <c:v>110.9122086</c:v>
                </c:pt>
                <c:pt idx="187">
                  <c:v>108.8306427</c:v>
                </c:pt>
                <c:pt idx="188">
                  <c:v>106.3101959</c:v>
                </c:pt>
                <c:pt idx="189">
                  <c:v>104.4031906</c:v>
                </c:pt>
                <c:pt idx="190">
                  <c:v>102.4039078</c:v>
                </c:pt>
                <c:pt idx="191">
                  <c:v>100.6896515</c:v>
                </c:pt>
                <c:pt idx="192">
                  <c:v>98.194236759999995</c:v>
                </c:pt>
                <c:pt idx="193">
                  <c:v>96.454261779999996</c:v>
                </c:pt>
                <c:pt idx="194">
                  <c:v>94.568237300000007</c:v>
                </c:pt>
                <c:pt idx="195">
                  <c:v>92.471443179999994</c:v>
                </c:pt>
                <c:pt idx="196">
                  <c:v>90.591407779999997</c:v>
                </c:pt>
                <c:pt idx="197">
                  <c:v>90.162406919999995</c:v>
                </c:pt>
                <c:pt idx="198">
                  <c:v>86.424629210000006</c:v>
                </c:pt>
                <c:pt idx="199">
                  <c:v>86.065704350000004</c:v>
                </c:pt>
                <c:pt idx="200">
                  <c:v>84.020454409999999</c:v>
                </c:pt>
                <c:pt idx="201">
                  <c:v>82.318756100000002</c:v>
                </c:pt>
                <c:pt idx="202">
                  <c:v>80.248512270000006</c:v>
                </c:pt>
                <c:pt idx="203">
                  <c:v>79.290596010000002</c:v>
                </c:pt>
                <c:pt idx="204">
                  <c:v>77.606674190000007</c:v>
                </c:pt>
                <c:pt idx="205">
                  <c:v>75.330535889999993</c:v>
                </c:pt>
                <c:pt idx="206">
                  <c:v>74.748703000000006</c:v>
                </c:pt>
                <c:pt idx="207">
                  <c:v>73.27811432</c:v>
                </c:pt>
                <c:pt idx="208">
                  <c:v>70.804328920000003</c:v>
                </c:pt>
                <c:pt idx="209">
                  <c:v>69.70355988</c:v>
                </c:pt>
                <c:pt idx="210">
                  <c:v>68.164710999999997</c:v>
                </c:pt>
                <c:pt idx="211">
                  <c:v>67.004959110000001</c:v>
                </c:pt>
                <c:pt idx="212">
                  <c:v>65.336753849999994</c:v>
                </c:pt>
                <c:pt idx="213">
                  <c:v>63.880413060000002</c:v>
                </c:pt>
                <c:pt idx="214">
                  <c:v>61.736259459999999</c:v>
                </c:pt>
                <c:pt idx="215">
                  <c:v>60.738967899999999</c:v>
                </c:pt>
                <c:pt idx="216">
                  <c:v>60.478691099999999</c:v>
                </c:pt>
                <c:pt idx="217">
                  <c:v>59.260627749999998</c:v>
                </c:pt>
                <c:pt idx="218">
                  <c:v>57.929191590000002</c:v>
                </c:pt>
                <c:pt idx="219">
                  <c:v>56.922340390000002</c:v>
                </c:pt>
                <c:pt idx="220">
                  <c:v>54.801383970000003</c:v>
                </c:pt>
                <c:pt idx="221">
                  <c:v>54.032157900000001</c:v>
                </c:pt>
                <c:pt idx="222">
                  <c:v>52.90373993</c:v>
                </c:pt>
                <c:pt idx="223">
                  <c:v>51.926074980000003</c:v>
                </c:pt>
                <c:pt idx="224">
                  <c:v>50.564727779999998</c:v>
                </c:pt>
                <c:pt idx="225">
                  <c:v>50.156528469999998</c:v>
                </c:pt>
                <c:pt idx="226">
                  <c:v>49.057937619999997</c:v>
                </c:pt>
                <c:pt idx="227">
                  <c:v>47.720176700000003</c:v>
                </c:pt>
                <c:pt idx="228">
                  <c:v>47.001750950000002</c:v>
                </c:pt>
                <c:pt idx="229">
                  <c:v>45.908161159999999</c:v>
                </c:pt>
                <c:pt idx="230">
                  <c:v>44.809513090000003</c:v>
                </c:pt>
                <c:pt idx="231">
                  <c:v>44.081230159999997</c:v>
                </c:pt>
                <c:pt idx="232">
                  <c:v>43.121784210000001</c:v>
                </c:pt>
                <c:pt idx="233">
                  <c:v>41.941299440000002</c:v>
                </c:pt>
                <c:pt idx="234">
                  <c:v>41.006313319999997</c:v>
                </c:pt>
                <c:pt idx="235">
                  <c:v>40.23806381</c:v>
                </c:pt>
                <c:pt idx="236">
                  <c:v>39.452152249999997</c:v>
                </c:pt>
                <c:pt idx="237">
                  <c:v>39.193702700000003</c:v>
                </c:pt>
                <c:pt idx="238">
                  <c:v>37.637203220000004</c:v>
                </c:pt>
                <c:pt idx="239">
                  <c:v>36.765666959999997</c:v>
                </c:pt>
                <c:pt idx="240">
                  <c:v>36.446437840000002</c:v>
                </c:pt>
                <c:pt idx="241">
                  <c:v>35.14103317</c:v>
                </c:pt>
                <c:pt idx="242">
                  <c:v>34.408489230000001</c:v>
                </c:pt>
                <c:pt idx="243">
                  <c:v>34.038253779999998</c:v>
                </c:pt>
                <c:pt idx="244">
                  <c:v>33.169410710000001</c:v>
                </c:pt>
                <c:pt idx="245">
                  <c:v>32.695125580000003</c:v>
                </c:pt>
                <c:pt idx="246">
                  <c:v>32.041843409999998</c:v>
                </c:pt>
                <c:pt idx="247">
                  <c:v>31.729404450000001</c:v>
                </c:pt>
                <c:pt idx="248">
                  <c:v>30.353725430000001</c:v>
                </c:pt>
                <c:pt idx="249">
                  <c:v>29.77352715</c:v>
                </c:pt>
                <c:pt idx="250">
                  <c:v>29.793682100000002</c:v>
                </c:pt>
                <c:pt idx="251">
                  <c:v>28.98618317</c:v>
                </c:pt>
                <c:pt idx="252">
                  <c:v>27.924131389999999</c:v>
                </c:pt>
                <c:pt idx="253">
                  <c:v>27.61352158</c:v>
                </c:pt>
                <c:pt idx="254">
                  <c:v>26.755245209999998</c:v>
                </c:pt>
                <c:pt idx="255">
                  <c:v>26.517547610000001</c:v>
                </c:pt>
                <c:pt idx="256">
                  <c:v>26.197916029999998</c:v>
                </c:pt>
                <c:pt idx="257">
                  <c:v>25.60161591</c:v>
                </c:pt>
                <c:pt idx="258">
                  <c:v>24.645973210000001</c:v>
                </c:pt>
                <c:pt idx="259">
                  <c:v>24.034523010000001</c:v>
                </c:pt>
                <c:pt idx="260">
                  <c:v>23.93212128</c:v>
                </c:pt>
                <c:pt idx="261">
                  <c:v>23.170509339999999</c:v>
                </c:pt>
                <c:pt idx="262">
                  <c:v>22.73393059</c:v>
                </c:pt>
                <c:pt idx="263">
                  <c:v>21.99359703</c:v>
                </c:pt>
                <c:pt idx="264">
                  <c:v>21.527833940000001</c:v>
                </c:pt>
                <c:pt idx="265">
                  <c:v>21.125341420000002</c:v>
                </c:pt>
                <c:pt idx="266">
                  <c:v>21.097526550000001</c:v>
                </c:pt>
                <c:pt idx="267">
                  <c:v>20.45809174</c:v>
                </c:pt>
                <c:pt idx="268">
                  <c:v>19.678979869999999</c:v>
                </c:pt>
                <c:pt idx="269">
                  <c:v>19.750432969999999</c:v>
                </c:pt>
                <c:pt idx="270">
                  <c:v>19.11782646</c:v>
                </c:pt>
                <c:pt idx="271">
                  <c:v>18.912269590000001</c:v>
                </c:pt>
                <c:pt idx="272">
                  <c:v>18.459918980000001</c:v>
                </c:pt>
                <c:pt idx="273">
                  <c:v>17.783700939999999</c:v>
                </c:pt>
                <c:pt idx="274">
                  <c:v>17.963993070000001</c:v>
                </c:pt>
                <c:pt idx="275">
                  <c:v>17.66596603</c:v>
                </c:pt>
                <c:pt idx="276">
                  <c:v>16.756032940000001</c:v>
                </c:pt>
                <c:pt idx="277">
                  <c:v>16.56828308</c:v>
                </c:pt>
                <c:pt idx="278">
                  <c:v>16.244800569999999</c:v>
                </c:pt>
                <c:pt idx="279">
                  <c:v>16.119047160000001</c:v>
                </c:pt>
                <c:pt idx="280">
                  <c:v>15.45917225</c:v>
                </c:pt>
                <c:pt idx="281">
                  <c:v>15.199815750000001</c:v>
                </c:pt>
                <c:pt idx="282">
                  <c:v>15.128968240000001</c:v>
                </c:pt>
                <c:pt idx="283">
                  <c:v>14.30324268</c:v>
                </c:pt>
                <c:pt idx="284">
                  <c:v>14.298324579999999</c:v>
                </c:pt>
                <c:pt idx="285">
                  <c:v>14.08588505</c:v>
                </c:pt>
                <c:pt idx="286">
                  <c:v>13.453476909999999</c:v>
                </c:pt>
                <c:pt idx="287">
                  <c:v>13.058403970000001</c:v>
                </c:pt>
                <c:pt idx="288">
                  <c:v>13.03529644</c:v>
                </c:pt>
                <c:pt idx="289">
                  <c:v>12.71127796</c:v>
                </c:pt>
                <c:pt idx="290">
                  <c:v>12.35405636</c:v>
                </c:pt>
                <c:pt idx="291">
                  <c:v>11.98895645</c:v>
                </c:pt>
                <c:pt idx="292">
                  <c:v>11.904633520000001</c:v>
                </c:pt>
                <c:pt idx="293">
                  <c:v>11.660236360000001</c:v>
                </c:pt>
                <c:pt idx="294">
                  <c:v>11.228585239999999</c:v>
                </c:pt>
                <c:pt idx="295">
                  <c:v>11.253456119999999</c:v>
                </c:pt>
                <c:pt idx="296">
                  <c:v>11.080246929999999</c:v>
                </c:pt>
                <c:pt idx="297">
                  <c:v>10.491659159999999</c:v>
                </c:pt>
                <c:pt idx="298">
                  <c:v>10.386343</c:v>
                </c:pt>
                <c:pt idx="299">
                  <c:v>10.38168716</c:v>
                </c:pt>
                <c:pt idx="300">
                  <c:v>10.03956223</c:v>
                </c:pt>
                <c:pt idx="301">
                  <c:v>9.7280673980000003</c:v>
                </c:pt>
                <c:pt idx="302">
                  <c:v>9.6756448749999997</c:v>
                </c:pt>
                <c:pt idx="303">
                  <c:v>9.5261459350000006</c:v>
                </c:pt>
                <c:pt idx="304">
                  <c:v>9.0798521040000004</c:v>
                </c:pt>
                <c:pt idx="305">
                  <c:v>8.9889030460000008</c:v>
                </c:pt>
                <c:pt idx="306">
                  <c:v>8.6368513109999991</c:v>
                </c:pt>
                <c:pt idx="307">
                  <c:v>8.7486343380000005</c:v>
                </c:pt>
                <c:pt idx="308">
                  <c:v>8.4482107160000002</c:v>
                </c:pt>
                <c:pt idx="309">
                  <c:v>8.4647455219999994</c:v>
                </c:pt>
                <c:pt idx="310">
                  <c:v>7.9601492880000002</c:v>
                </c:pt>
                <c:pt idx="311">
                  <c:v>7.9016060829999999</c:v>
                </c:pt>
                <c:pt idx="312">
                  <c:v>7.7162842749999996</c:v>
                </c:pt>
                <c:pt idx="313">
                  <c:v>7.7980971339999998</c:v>
                </c:pt>
                <c:pt idx="314">
                  <c:v>7.2043800349999998</c:v>
                </c:pt>
                <c:pt idx="315">
                  <c:v>7.3805484769999996</c:v>
                </c:pt>
                <c:pt idx="316">
                  <c:v>7.04257679</c:v>
                </c:pt>
                <c:pt idx="317">
                  <c:v>6.9948372839999999</c:v>
                </c:pt>
                <c:pt idx="318">
                  <c:v>6.9590125079999998</c:v>
                </c:pt>
                <c:pt idx="319">
                  <c:v>6.7188382149999999</c:v>
                </c:pt>
                <c:pt idx="320">
                  <c:v>6.549379826</c:v>
                </c:pt>
                <c:pt idx="321">
                  <c:v>6.4048900599999996</c:v>
                </c:pt>
                <c:pt idx="322">
                  <c:v>6.3173460959999996</c:v>
                </c:pt>
                <c:pt idx="323">
                  <c:v>6.3198623659999997</c:v>
                </c:pt>
                <c:pt idx="324">
                  <c:v>6.1663784980000003</c:v>
                </c:pt>
                <c:pt idx="325">
                  <c:v>6.1160359379999996</c:v>
                </c:pt>
                <c:pt idx="326">
                  <c:v>5.8896923069999998</c:v>
                </c:pt>
                <c:pt idx="327">
                  <c:v>5.6874899860000001</c:v>
                </c:pt>
                <c:pt idx="328">
                  <c:v>5.560263634</c:v>
                </c:pt>
                <c:pt idx="329">
                  <c:v>5.5041131969999997</c:v>
                </c:pt>
                <c:pt idx="330">
                  <c:v>5.2491631510000003</c:v>
                </c:pt>
                <c:pt idx="331">
                  <c:v>5.1236939430000001</c:v>
                </c:pt>
                <c:pt idx="332">
                  <c:v>5.0599479680000004</c:v>
                </c:pt>
                <c:pt idx="333">
                  <c:v>5.067825794</c:v>
                </c:pt>
                <c:pt idx="334">
                  <c:v>4.8589668269999997</c:v>
                </c:pt>
                <c:pt idx="335">
                  <c:v>5.042733192</c:v>
                </c:pt>
                <c:pt idx="336">
                  <c:v>4.7817130089999997</c:v>
                </c:pt>
                <c:pt idx="337">
                  <c:v>4.5300040250000002</c:v>
                </c:pt>
                <c:pt idx="338">
                  <c:v>4.6125240329999997</c:v>
                </c:pt>
                <c:pt idx="339">
                  <c:v>4.2619915009999998</c:v>
                </c:pt>
                <c:pt idx="340">
                  <c:v>4.2481436730000004</c:v>
                </c:pt>
                <c:pt idx="341">
                  <c:v>4.0690422059999998</c:v>
                </c:pt>
                <c:pt idx="342">
                  <c:v>4.143786907</c:v>
                </c:pt>
                <c:pt idx="343">
                  <c:v>4.1386046409999997</c:v>
                </c:pt>
                <c:pt idx="344">
                  <c:v>4.075514793</c:v>
                </c:pt>
                <c:pt idx="345">
                  <c:v>3.9811012739999998</c:v>
                </c:pt>
                <c:pt idx="346">
                  <c:v>3.8700156209999999</c:v>
                </c:pt>
                <c:pt idx="347">
                  <c:v>3.763874054</c:v>
                </c:pt>
                <c:pt idx="348">
                  <c:v>3.6698899269999998</c:v>
                </c:pt>
                <c:pt idx="349">
                  <c:v>3.6094810960000001</c:v>
                </c:pt>
                <c:pt idx="350">
                  <c:v>3.6023285390000002</c:v>
                </c:pt>
                <c:pt idx="351">
                  <c:v>3.3098227979999999</c:v>
                </c:pt>
                <c:pt idx="352">
                  <c:v>3.3674190039999998</c:v>
                </c:pt>
                <c:pt idx="353">
                  <c:v>3.2974643709999998</c:v>
                </c:pt>
                <c:pt idx="354">
                  <c:v>3.113917351</c:v>
                </c:pt>
                <c:pt idx="355">
                  <c:v>3.293509722</c:v>
                </c:pt>
                <c:pt idx="356">
                  <c:v>3.1363220209999998</c:v>
                </c:pt>
                <c:pt idx="357">
                  <c:v>3.0210876459999998</c:v>
                </c:pt>
                <c:pt idx="358">
                  <c:v>2.9890201090000001</c:v>
                </c:pt>
                <c:pt idx="359">
                  <c:v>3.017488003</c:v>
                </c:pt>
                <c:pt idx="360">
                  <c:v>2.9038169379999998</c:v>
                </c:pt>
                <c:pt idx="361">
                  <c:v>2.7502119540000001</c:v>
                </c:pt>
                <c:pt idx="362">
                  <c:v>2.7354564670000001</c:v>
                </c:pt>
                <c:pt idx="363">
                  <c:v>2.7836327550000002</c:v>
                </c:pt>
                <c:pt idx="364">
                  <c:v>2.784815788</c:v>
                </c:pt>
                <c:pt idx="365">
                  <c:v>2.6352004999999998</c:v>
                </c:pt>
                <c:pt idx="366">
                  <c:v>2.629621744</c:v>
                </c:pt>
                <c:pt idx="367">
                  <c:v>2.2357168199999999</c:v>
                </c:pt>
                <c:pt idx="368">
                  <c:v>2.5017359259999998</c:v>
                </c:pt>
                <c:pt idx="369">
                  <c:v>2.5259470940000002</c:v>
                </c:pt>
                <c:pt idx="370">
                  <c:v>2.3944537640000001</c:v>
                </c:pt>
                <c:pt idx="371">
                  <c:v>2.381975889</c:v>
                </c:pt>
                <c:pt idx="372">
                  <c:v>2.2831454280000001</c:v>
                </c:pt>
                <c:pt idx="373">
                  <c:v>2.1747860910000001</c:v>
                </c:pt>
                <c:pt idx="374">
                  <c:v>2.1915843490000002</c:v>
                </c:pt>
                <c:pt idx="375">
                  <c:v>2.044188976</c:v>
                </c:pt>
                <c:pt idx="376">
                  <c:v>2.2680010799999999</c:v>
                </c:pt>
                <c:pt idx="377">
                  <c:v>2.1518430710000001</c:v>
                </c:pt>
                <c:pt idx="378">
                  <c:v>1.9153434039999999</c:v>
                </c:pt>
                <c:pt idx="379">
                  <c:v>2.0100982190000001</c:v>
                </c:pt>
                <c:pt idx="380">
                  <c:v>1.985062361</c:v>
                </c:pt>
                <c:pt idx="381">
                  <c:v>2.0067958830000001</c:v>
                </c:pt>
                <c:pt idx="382">
                  <c:v>1.9695197339999999</c:v>
                </c:pt>
                <c:pt idx="383">
                  <c:v>1.82867527</c:v>
                </c:pt>
                <c:pt idx="384">
                  <c:v>1.7848392719999999</c:v>
                </c:pt>
                <c:pt idx="385">
                  <c:v>1.805120587</c:v>
                </c:pt>
                <c:pt idx="386">
                  <c:v>1.84128201</c:v>
                </c:pt>
                <c:pt idx="387">
                  <c:v>1.687647581</c:v>
                </c:pt>
                <c:pt idx="388">
                  <c:v>1.6735852959999999</c:v>
                </c:pt>
                <c:pt idx="389">
                  <c:v>1.5865422490000001</c:v>
                </c:pt>
                <c:pt idx="390">
                  <c:v>1.6452836989999999</c:v>
                </c:pt>
                <c:pt idx="391">
                  <c:v>1.6223706010000001</c:v>
                </c:pt>
                <c:pt idx="392">
                  <c:v>1.54115808</c:v>
                </c:pt>
                <c:pt idx="393">
                  <c:v>1.4571491480000001</c:v>
                </c:pt>
                <c:pt idx="394">
                  <c:v>1.319626451</c:v>
                </c:pt>
                <c:pt idx="395">
                  <c:v>1.5039911269999999</c:v>
                </c:pt>
                <c:pt idx="396">
                  <c:v>1.42703867</c:v>
                </c:pt>
                <c:pt idx="397">
                  <c:v>1.335125804</c:v>
                </c:pt>
                <c:pt idx="398">
                  <c:v>1.3896139860000001</c:v>
                </c:pt>
                <c:pt idx="399">
                  <c:v>1.404054403</c:v>
                </c:pt>
                <c:pt idx="400">
                  <c:v>1.3798890109999999</c:v>
                </c:pt>
                <c:pt idx="401">
                  <c:v>1.355097175</c:v>
                </c:pt>
                <c:pt idx="402">
                  <c:v>1.4103790519999999</c:v>
                </c:pt>
                <c:pt idx="403">
                  <c:v>1.2496778959999999</c:v>
                </c:pt>
                <c:pt idx="404">
                  <c:v>1.2194868329999999</c:v>
                </c:pt>
                <c:pt idx="405">
                  <c:v>1.1660025119999999</c:v>
                </c:pt>
                <c:pt idx="406">
                  <c:v>1.26262629</c:v>
                </c:pt>
                <c:pt idx="407">
                  <c:v>1.2492207289999999</c:v>
                </c:pt>
                <c:pt idx="408">
                  <c:v>1.123725533</c:v>
                </c:pt>
                <c:pt idx="409">
                  <c:v>1.0775167940000001</c:v>
                </c:pt>
                <c:pt idx="410">
                  <c:v>1.0605511670000001</c:v>
                </c:pt>
                <c:pt idx="411">
                  <c:v>1.143799424</c:v>
                </c:pt>
                <c:pt idx="412">
                  <c:v>1.1114919190000001</c:v>
                </c:pt>
                <c:pt idx="413">
                  <c:v>1.119776726</c:v>
                </c:pt>
                <c:pt idx="414">
                  <c:v>0.99915999170000003</c:v>
                </c:pt>
                <c:pt idx="415">
                  <c:v>1.1402685640000001</c:v>
                </c:pt>
                <c:pt idx="416">
                  <c:v>1.010704517</c:v>
                </c:pt>
                <c:pt idx="417">
                  <c:v>1.0530917639999999</c:v>
                </c:pt>
                <c:pt idx="418">
                  <c:v>0.911565721</c:v>
                </c:pt>
                <c:pt idx="419">
                  <c:v>0.92719328400000001</c:v>
                </c:pt>
                <c:pt idx="420">
                  <c:v>0.97406810519999998</c:v>
                </c:pt>
                <c:pt idx="421">
                  <c:v>0.898619473</c:v>
                </c:pt>
                <c:pt idx="422">
                  <c:v>0.88900715109999995</c:v>
                </c:pt>
                <c:pt idx="423">
                  <c:v>0.85135704280000002</c:v>
                </c:pt>
                <c:pt idx="424">
                  <c:v>0.90388387439999995</c:v>
                </c:pt>
                <c:pt idx="425">
                  <c:v>0.81307393309999998</c:v>
                </c:pt>
                <c:pt idx="426">
                  <c:v>0.84186232090000002</c:v>
                </c:pt>
                <c:pt idx="427">
                  <c:v>0.87449139360000006</c:v>
                </c:pt>
                <c:pt idx="428">
                  <c:v>0.81358933450000004</c:v>
                </c:pt>
                <c:pt idx="429">
                  <c:v>0.79388350249999995</c:v>
                </c:pt>
                <c:pt idx="430">
                  <c:v>0.77871793509999998</c:v>
                </c:pt>
                <c:pt idx="431">
                  <c:v>0.79740005729999996</c:v>
                </c:pt>
                <c:pt idx="432">
                  <c:v>0.69903892280000002</c:v>
                </c:pt>
                <c:pt idx="433">
                  <c:v>0.78328305480000004</c:v>
                </c:pt>
                <c:pt idx="434">
                  <c:v>0.8080621362</c:v>
                </c:pt>
                <c:pt idx="435">
                  <c:v>0.70916998389999997</c:v>
                </c:pt>
                <c:pt idx="436">
                  <c:v>0.75431853530000004</c:v>
                </c:pt>
                <c:pt idx="437">
                  <c:v>0.74224662779999995</c:v>
                </c:pt>
                <c:pt idx="438">
                  <c:v>0.70239698890000002</c:v>
                </c:pt>
                <c:pt idx="439">
                  <c:v>0.61254411939999998</c:v>
                </c:pt>
                <c:pt idx="440">
                  <c:v>0.70253413919999996</c:v>
                </c:pt>
                <c:pt idx="441">
                  <c:v>0.67206847670000003</c:v>
                </c:pt>
                <c:pt idx="442">
                  <c:v>0.57835400100000001</c:v>
                </c:pt>
                <c:pt idx="443">
                  <c:v>0.62397426369999998</c:v>
                </c:pt>
                <c:pt idx="444">
                  <c:v>0.60899603369999999</c:v>
                </c:pt>
                <c:pt idx="445">
                  <c:v>0.65150612590000001</c:v>
                </c:pt>
                <c:pt idx="446">
                  <c:v>0.56994074579999998</c:v>
                </c:pt>
                <c:pt idx="447">
                  <c:v>0.6175521612</c:v>
                </c:pt>
                <c:pt idx="448">
                  <c:v>0.62844920159999995</c:v>
                </c:pt>
                <c:pt idx="449">
                  <c:v>0.51222771410000001</c:v>
                </c:pt>
                <c:pt idx="450">
                  <c:v>0.51844048499999995</c:v>
                </c:pt>
                <c:pt idx="451">
                  <c:v>0.60927701000000001</c:v>
                </c:pt>
                <c:pt idx="452">
                  <c:v>0.46486353870000002</c:v>
                </c:pt>
                <c:pt idx="453">
                  <c:v>0.5531657338</c:v>
                </c:pt>
                <c:pt idx="454">
                  <c:v>0.60075706240000004</c:v>
                </c:pt>
                <c:pt idx="455">
                  <c:v>0.54137217999999998</c:v>
                </c:pt>
                <c:pt idx="456">
                  <c:v>0.55521994829999999</c:v>
                </c:pt>
                <c:pt idx="457">
                  <c:v>0.53303968909999999</c:v>
                </c:pt>
                <c:pt idx="458">
                  <c:v>0.45514002440000001</c:v>
                </c:pt>
                <c:pt idx="459">
                  <c:v>0.52516233919999999</c:v>
                </c:pt>
                <c:pt idx="460">
                  <c:v>0.52884733679999996</c:v>
                </c:pt>
                <c:pt idx="461">
                  <c:v>0.45192700619999998</c:v>
                </c:pt>
                <c:pt idx="462">
                  <c:v>0.54435956480000003</c:v>
                </c:pt>
                <c:pt idx="463">
                  <c:v>0.49126216769999997</c:v>
                </c:pt>
                <c:pt idx="464">
                  <c:v>0.48450872299999997</c:v>
                </c:pt>
                <c:pt idx="465">
                  <c:v>0.47564738989999999</c:v>
                </c:pt>
                <c:pt idx="466">
                  <c:v>0.40985682610000002</c:v>
                </c:pt>
                <c:pt idx="467">
                  <c:v>0.4206333458</c:v>
                </c:pt>
                <c:pt idx="468">
                  <c:v>0.37924644349999997</c:v>
                </c:pt>
                <c:pt idx="469">
                  <c:v>0.44399651890000003</c:v>
                </c:pt>
                <c:pt idx="470">
                  <c:v>0.46862024070000002</c:v>
                </c:pt>
                <c:pt idx="471">
                  <c:v>0.45469838379999999</c:v>
                </c:pt>
                <c:pt idx="472">
                  <c:v>0.40568357710000003</c:v>
                </c:pt>
                <c:pt idx="473">
                  <c:v>0.39490216970000003</c:v>
                </c:pt>
                <c:pt idx="474">
                  <c:v>0.4567219615</c:v>
                </c:pt>
                <c:pt idx="475">
                  <c:v>0.37615984679999998</c:v>
                </c:pt>
                <c:pt idx="476">
                  <c:v>0.38647833469999998</c:v>
                </c:pt>
                <c:pt idx="477">
                  <c:v>0.41595959659999998</c:v>
                </c:pt>
                <c:pt idx="478">
                  <c:v>0.38347753880000002</c:v>
                </c:pt>
                <c:pt idx="479">
                  <c:v>0.3665916622</c:v>
                </c:pt>
                <c:pt idx="480">
                  <c:v>0.3647300899</c:v>
                </c:pt>
                <c:pt idx="481">
                  <c:v>0.38446664809999997</c:v>
                </c:pt>
                <c:pt idx="482">
                  <c:v>0.40767592190000002</c:v>
                </c:pt>
                <c:pt idx="483">
                  <c:v>0.37952595950000001</c:v>
                </c:pt>
                <c:pt idx="484">
                  <c:v>0.38318073749999998</c:v>
                </c:pt>
                <c:pt idx="485">
                  <c:v>0.34662815930000002</c:v>
                </c:pt>
                <c:pt idx="486">
                  <c:v>0.2888929844</c:v>
                </c:pt>
                <c:pt idx="487">
                  <c:v>0.369140476</c:v>
                </c:pt>
                <c:pt idx="488">
                  <c:v>0.35964387660000002</c:v>
                </c:pt>
                <c:pt idx="489">
                  <c:v>0.30468624830000002</c:v>
                </c:pt>
                <c:pt idx="490">
                  <c:v>0.29604279989999999</c:v>
                </c:pt>
                <c:pt idx="491">
                  <c:v>0.33396822209999999</c:v>
                </c:pt>
                <c:pt idx="492">
                  <c:v>0.33745166659999998</c:v>
                </c:pt>
                <c:pt idx="493">
                  <c:v>0.33559644220000001</c:v>
                </c:pt>
                <c:pt idx="494">
                  <c:v>0.30289703610000002</c:v>
                </c:pt>
                <c:pt idx="495">
                  <c:v>0.37613952160000003</c:v>
                </c:pt>
                <c:pt idx="496">
                  <c:v>0.28852364419999998</c:v>
                </c:pt>
                <c:pt idx="497">
                  <c:v>0.32322779299999999</c:v>
                </c:pt>
                <c:pt idx="498">
                  <c:v>0.32106667760000002</c:v>
                </c:pt>
                <c:pt idx="499">
                  <c:v>0.3317107856</c:v>
                </c:pt>
                <c:pt idx="500">
                  <c:v>0.3264524043</c:v>
                </c:pt>
                <c:pt idx="501">
                  <c:v>0.28232443330000001</c:v>
                </c:pt>
                <c:pt idx="502">
                  <c:v>0.28341570500000002</c:v>
                </c:pt>
                <c:pt idx="503">
                  <c:v>0.28713029620000002</c:v>
                </c:pt>
                <c:pt idx="504">
                  <c:v>0.2435291409</c:v>
                </c:pt>
                <c:pt idx="505">
                  <c:v>0.25892278549999997</c:v>
                </c:pt>
                <c:pt idx="506">
                  <c:v>0.243907243</c:v>
                </c:pt>
                <c:pt idx="507">
                  <c:v>0.29334181549999999</c:v>
                </c:pt>
                <c:pt idx="508">
                  <c:v>0.29707887770000002</c:v>
                </c:pt>
                <c:pt idx="509">
                  <c:v>0.2730025351</c:v>
                </c:pt>
                <c:pt idx="510">
                  <c:v>0.31062236430000001</c:v>
                </c:pt>
                <c:pt idx="511">
                  <c:v>0.2734183073</c:v>
                </c:pt>
                <c:pt idx="512">
                  <c:v>0.27132418749999998</c:v>
                </c:pt>
                <c:pt idx="513">
                  <c:v>0.24539314209999999</c:v>
                </c:pt>
                <c:pt idx="514">
                  <c:v>0.26572161909999997</c:v>
                </c:pt>
                <c:pt idx="515">
                  <c:v>0.26714363689999998</c:v>
                </c:pt>
                <c:pt idx="516">
                  <c:v>0.28919345140000002</c:v>
                </c:pt>
                <c:pt idx="517">
                  <c:v>0.32205846910000002</c:v>
                </c:pt>
                <c:pt idx="518">
                  <c:v>0.23614457250000001</c:v>
                </c:pt>
                <c:pt idx="519">
                  <c:v>0.2441726625</c:v>
                </c:pt>
                <c:pt idx="520">
                  <c:v>0.2758709788</c:v>
                </c:pt>
                <c:pt idx="521">
                  <c:v>0.18988913299999999</c:v>
                </c:pt>
                <c:pt idx="522">
                  <c:v>0.24546243249999999</c:v>
                </c:pt>
                <c:pt idx="523">
                  <c:v>0.22991353270000001</c:v>
                </c:pt>
                <c:pt idx="524">
                  <c:v>0.25964403149999998</c:v>
                </c:pt>
                <c:pt idx="525">
                  <c:v>0.2464544028</c:v>
                </c:pt>
                <c:pt idx="526">
                  <c:v>0.25162726639999999</c:v>
                </c:pt>
                <c:pt idx="527">
                  <c:v>0.25337693100000003</c:v>
                </c:pt>
                <c:pt idx="528">
                  <c:v>0.2173279226</c:v>
                </c:pt>
                <c:pt idx="529">
                  <c:v>0.2756793797</c:v>
                </c:pt>
                <c:pt idx="530">
                  <c:v>0.25508224959999998</c:v>
                </c:pt>
                <c:pt idx="531">
                  <c:v>0.19686134159999999</c:v>
                </c:pt>
                <c:pt idx="532">
                  <c:v>0.22622996570000001</c:v>
                </c:pt>
                <c:pt idx="533">
                  <c:v>0.2130247653</c:v>
                </c:pt>
                <c:pt idx="534">
                  <c:v>0.2301814556</c:v>
                </c:pt>
                <c:pt idx="535">
                  <c:v>0.22695323819999999</c:v>
                </c:pt>
                <c:pt idx="536">
                  <c:v>0.23516249659999999</c:v>
                </c:pt>
                <c:pt idx="537">
                  <c:v>0.2470542043</c:v>
                </c:pt>
                <c:pt idx="538">
                  <c:v>0.23517496879999999</c:v>
                </c:pt>
                <c:pt idx="539">
                  <c:v>0.2121232301</c:v>
                </c:pt>
                <c:pt idx="540">
                  <c:v>0.18463225659999999</c:v>
                </c:pt>
                <c:pt idx="541">
                  <c:v>0.1991419941</c:v>
                </c:pt>
                <c:pt idx="542">
                  <c:v>0.2144911736</c:v>
                </c:pt>
                <c:pt idx="543">
                  <c:v>0.1735279411</c:v>
                </c:pt>
                <c:pt idx="544">
                  <c:v>0.2190107405</c:v>
                </c:pt>
                <c:pt idx="545">
                  <c:v>0.15885223449999999</c:v>
                </c:pt>
                <c:pt idx="546">
                  <c:v>0.1735455394</c:v>
                </c:pt>
                <c:pt idx="547">
                  <c:v>0.19929209349999999</c:v>
                </c:pt>
                <c:pt idx="548">
                  <c:v>0.19990342859999999</c:v>
                </c:pt>
                <c:pt idx="549">
                  <c:v>0.20022431020000001</c:v>
                </c:pt>
                <c:pt idx="550">
                  <c:v>0.16883155699999999</c:v>
                </c:pt>
                <c:pt idx="551">
                  <c:v>0.17106236520000001</c:v>
                </c:pt>
                <c:pt idx="552">
                  <c:v>0.15904432539999999</c:v>
                </c:pt>
                <c:pt idx="553">
                  <c:v>0.16330535709999999</c:v>
                </c:pt>
                <c:pt idx="554">
                  <c:v>0.21079917249999999</c:v>
                </c:pt>
                <c:pt idx="555">
                  <c:v>0.19489885870000001</c:v>
                </c:pt>
                <c:pt idx="556">
                  <c:v>0.19467625020000001</c:v>
                </c:pt>
                <c:pt idx="557">
                  <c:v>0.12829124929999999</c:v>
                </c:pt>
                <c:pt idx="558">
                  <c:v>0.17299641669999999</c:v>
                </c:pt>
                <c:pt idx="559">
                  <c:v>0.1569261998</c:v>
                </c:pt>
                <c:pt idx="560">
                  <c:v>0.15650035440000001</c:v>
                </c:pt>
                <c:pt idx="561">
                  <c:v>0.1571542323</c:v>
                </c:pt>
                <c:pt idx="562">
                  <c:v>0.1452308893</c:v>
                </c:pt>
                <c:pt idx="563">
                  <c:v>0.15897355969999999</c:v>
                </c:pt>
                <c:pt idx="564">
                  <c:v>0.1502092928</c:v>
                </c:pt>
                <c:pt idx="565">
                  <c:v>0.15419383349999999</c:v>
                </c:pt>
                <c:pt idx="566">
                  <c:v>0.14423505959999999</c:v>
                </c:pt>
                <c:pt idx="567">
                  <c:v>0.18537940080000001</c:v>
                </c:pt>
                <c:pt idx="568">
                  <c:v>0.19104780260000001</c:v>
                </c:pt>
                <c:pt idx="569">
                  <c:v>0.21368283029999999</c:v>
                </c:pt>
                <c:pt idx="570">
                  <c:v>0.16448658699999999</c:v>
                </c:pt>
                <c:pt idx="571">
                  <c:v>0.1353355795</c:v>
                </c:pt>
                <c:pt idx="572">
                  <c:v>0.13429988919999999</c:v>
                </c:pt>
                <c:pt idx="573">
                  <c:v>0.1318353266</c:v>
                </c:pt>
                <c:pt idx="574">
                  <c:v>0.12876012919999999</c:v>
                </c:pt>
                <c:pt idx="575">
                  <c:v>0.1534663886</c:v>
                </c:pt>
                <c:pt idx="576">
                  <c:v>0.15699423849999999</c:v>
                </c:pt>
                <c:pt idx="577">
                  <c:v>0.15188473459999999</c:v>
                </c:pt>
                <c:pt idx="578">
                  <c:v>0.1593082398</c:v>
                </c:pt>
                <c:pt idx="579">
                  <c:v>0.1231600642</c:v>
                </c:pt>
                <c:pt idx="580">
                  <c:v>0.110792838</c:v>
                </c:pt>
                <c:pt idx="581">
                  <c:v>0.16439332070000001</c:v>
                </c:pt>
                <c:pt idx="582">
                  <c:v>0.11961390080000001</c:v>
                </c:pt>
                <c:pt idx="583">
                  <c:v>0.14309369029999999</c:v>
                </c:pt>
                <c:pt idx="584">
                  <c:v>0.13320623340000001</c:v>
                </c:pt>
                <c:pt idx="585">
                  <c:v>0.1673153043</c:v>
                </c:pt>
                <c:pt idx="586">
                  <c:v>0.13168722390000001</c:v>
                </c:pt>
                <c:pt idx="587">
                  <c:v>0.17261667550000001</c:v>
                </c:pt>
                <c:pt idx="588">
                  <c:v>0.17157021159999999</c:v>
                </c:pt>
                <c:pt idx="589">
                  <c:v>9.5183707770000001E-2</c:v>
                </c:pt>
                <c:pt idx="590">
                  <c:v>0.1907456964</c:v>
                </c:pt>
                <c:pt idx="591">
                  <c:v>0.1175382286</c:v>
                </c:pt>
                <c:pt idx="592">
                  <c:v>0.13684146110000001</c:v>
                </c:pt>
                <c:pt idx="593">
                  <c:v>0.14604836700000001</c:v>
                </c:pt>
                <c:pt idx="594">
                  <c:v>0.1363728642</c:v>
                </c:pt>
                <c:pt idx="595">
                  <c:v>0.14534419779999999</c:v>
                </c:pt>
                <c:pt idx="596">
                  <c:v>0.13530363140000001</c:v>
                </c:pt>
                <c:pt idx="597">
                  <c:v>0.14321656529999999</c:v>
                </c:pt>
                <c:pt idx="598">
                  <c:v>0.17658565940000001</c:v>
                </c:pt>
                <c:pt idx="599">
                  <c:v>0.1239125133</c:v>
                </c:pt>
              </c:numCache>
            </c:numRef>
          </c:yVal>
          <c:smooth val="1"/>
          <c:extLst>
            <c:ext xmlns:c16="http://schemas.microsoft.com/office/drawing/2014/chart" uri="{C3380CC4-5D6E-409C-BE32-E72D297353CC}">
              <c16:uniqueId val="{00000005-3FAF-4CBF-82DD-E60AB52489B3}"/>
            </c:ext>
          </c:extLst>
        </c:ser>
        <c:ser>
          <c:idx val="9"/>
          <c:order val="6"/>
          <c:tx>
            <c:strRef>
              <c:f>AZD!$G$1</c:f>
              <c:strCache>
                <c:ptCount val="1"/>
                <c:pt idx="0">
                  <c:v>AZD2014 (11 μM) DMSO Emission</c:v>
                </c:pt>
              </c:strCache>
            </c:strRef>
          </c:tx>
          <c:spPr>
            <a:ln>
              <a:solidFill>
                <a:schemeClr val="accent4">
                  <a:lumMod val="60000"/>
                  <a:lumOff val="40000"/>
                </a:schemeClr>
              </a:solidFill>
            </a:ln>
          </c:spPr>
          <c:marker>
            <c:symbol val="none"/>
          </c:marker>
          <c:xVal>
            <c:numRef>
              <c:f>AZD!$G$3:$G$613</c:f>
              <c:numCache>
                <c:formatCode>General</c:formatCode>
                <c:ptCount val="611"/>
                <c:pt idx="16">
                  <c:v>403.02999879999999</c:v>
                </c:pt>
                <c:pt idx="17">
                  <c:v>403.48001099999999</c:v>
                </c:pt>
                <c:pt idx="18">
                  <c:v>403.92999270000001</c:v>
                </c:pt>
                <c:pt idx="19">
                  <c:v>404.5400085</c:v>
                </c:pt>
                <c:pt idx="20">
                  <c:v>405</c:v>
                </c:pt>
                <c:pt idx="21">
                  <c:v>405.4500122</c:v>
                </c:pt>
                <c:pt idx="22">
                  <c:v>406.05999759999997</c:v>
                </c:pt>
                <c:pt idx="23">
                  <c:v>406.51000979999998</c:v>
                </c:pt>
                <c:pt idx="24">
                  <c:v>406.9599915</c:v>
                </c:pt>
                <c:pt idx="25">
                  <c:v>407.57000729999999</c:v>
                </c:pt>
                <c:pt idx="26">
                  <c:v>408.02999879999999</c:v>
                </c:pt>
                <c:pt idx="27">
                  <c:v>408.48001099999999</c:v>
                </c:pt>
                <c:pt idx="28">
                  <c:v>408.92999270000001</c:v>
                </c:pt>
                <c:pt idx="29">
                  <c:v>409.5400085</c:v>
                </c:pt>
                <c:pt idx="30">
                  <c:v>410</c:v>
                </c:pt>
                <c:pt idx="31">
                  <c:v>410.4500122</c:v>
                </c:pt>
                <c:pt idx="32">
                  <c:v>411.05999759999997</c:v>
                </c:pt>
                <c:pt idx="33">
                  <c:v>411.51000979999998</c:v>
                </c:pt>
                <c:pt idx="34">
                  <c:v>411.9599915</c:v>
                </c:pt>
                <c:pt idx="35">
                  <c:v>412.57000729999999</c:v>
                </c:pt>
                <c:pt idx="36">
                  <c:v>413.02999879999999</c:v>
                </c:pt>
                <c:pt idx="37">
                  <c:v>413.48001099999999</c:v>
                </c:pt>
                <c:pt idx="38">
                  <c:v>413.92999270000001</c:v>
                </c:pt>
                <c:pt idx="39">
                  <c:v>414.5400085</c:v>
                </c:pt>
                <c:pt idx="40">
                  <c:v>415</c:v>
                </c:pt>
                <c:pt idx="41">
                  <c:v>415.4500122</c:v>
                </c:pt>
                <c:pt idx="42">
                  <c:v>416.05999759999997</c:v>
                </c:pt>
                <c:pt idx="43">
                  <c:v>416.51000979999998</c:v>
                </c:pt>
                <c:pt idx="44">
                  <c:v>416.9599915</c:v>
                </c:pt>
                <c:pt idx="45">
                  <c:v>417.57000729999999</c:v>
                </c:pt>
                <c:pt idx="46">
                  <c:v>418.02999879999999</c:v>
                </c:pt>
                <c:pt idx="47">
                  <c:v>418.48001099999999</c:v>
                </c:pt>
                <c:pt idx="48">
                  <c:v>418.92999270000001</c:v>
                </c:pt>
                <c:pt idx="49">
                  <c:v>419.5400085</c:v>
                </c:pt>
                <c:pt idx="50">
                  <c:v>420</c:v>
                </c:pt>
                <c:pt idx="51">
                  <c:v>420.4500122</c:v>
                </c:pt>
                <c:pt idx="52">
                  <c:v>421.05999759999997</c:v>
                </c:pt>
                <c:pt idx="53">
                  <c:v>421.51000979999998</c:v>
                </c:pt>
                <c:pt idx="54">
                  <c:v>421.9599915</c:v>
                </c:pt>
                <c:pt idx="55">
                  <c:v>422.57000729999999</c:v>
                </c:pt>
                <c:pt idx="56">
                  <c:v>423.02999879999999</c:v>
                </c:pt>
                <c:pt idx="57">
                  <c:v>423.48001099999999</c:v>
                </c:pt>
                <c:pt idx="58">
                  <c:v>423.92999270000001</c:v>
                </c:pt>
                <c:pt idx="59">
                  <c:v>424.5400085</c:v>
                </c:pt>
                <c:pt idx="60">
                  <c:v>425</c:v>
                </c:pt>
                <c:pt idx="61">
                  <c:v>425.4500122</c:v>
                </c:pt>
                <c:pt idx="62">
                  <c:v>426.05999759999997</c:v>
                </c:pt>
                <c:pt idx="63">
                  <c:v>426.51000979999998</c:v>
                </c:pt>
                <c:pt idx="64">
                  <c:v>426.9599915</c:v>
                </c:pt>
                <c:pt idx="65">
                  <c:v>427.57000729999999</c:v>
                </c:pt>
                <c:pt idx="66">
                  <c:v>428.02999879999999</c:v>
                </c:pt>
                <c:pt idx="67">
                  <c:v>428.48001099999999</c:v>
                </c:pt>
                <c:pt idx="68">
                  <c:v>428.92999270000001</c:v>
                </c:pt>
                <c:pt idx="69">
                  <c:v>429.5400085</c:v>
                </c:pt>
                <c:pt idx="70">
                  <c:v>430</c:v>
                </c:pt>
                <c:pt idx="71">
                  <c:v>430.4500122</c:v>
                </c:pt>
                <c:pt idx="72">
                  <c:v>431.05999759999997</c:v>
                </c:pt>
                <c:pt idx="73">
                  <c:v>431.51000979999998</c:v>
                </c:pt>
                <c:pt idx="74">
                  <c:v>431.9599915</c:v>
                </c:pt>
                <c:pt idx="75">
                  <c:v>432.57000729999999</c:v>
                </c:pt>
                <c:pt idx="76">
                  <c:v>433.02999879999999</c:v>
                </c:pt>
                <c:pt idx="77">
                  <c:v>433.48001099999999</c:v>
                </c:pt>
                <c:pt idx="78">
                  <c:v>433.92999270000001</c:v>
                </c:pt>
                <c:pt idx="79">
                  <c:v>434.5400085</c:v>
                </c:pt>
                <c:pt idx="80">
                  <c:v>435</c:v>
                </c:pt>
                <c:pt idx="81">
                  <c:v>435.4500122</c:v>
                </c:pt>
                <c:pt idx="82">
                  <c:v>436.05999759999997</c:v>
                </c:pt>
                <c:pt idx="83">
                  <c:v>436.51000979999998</c:v>
                </c:pt>
                <c:pt idx="84">
                  <c:v>436.9599915</c:v>
                </c:pt>
                <c:pt idx="85">
                  <c:v>437.57000729999999</c:v>
                </c:pt>
                <c:pt idx="86">
                  <c:v>438.02999879999999</c:v>
                </c:pt>
                <c:pt idx="87">
                  <c:v>438.48001099999999</c:v>
                </c:pt>
                <c:pt idx="88">
                  <c:v>438.92999270000001</c:v>
                </c:pt>
                <c:pt idx="89">
                  <c:v>439.5400085</c:v>
                </c:pt>
                <c:pt idx="90">
                  <c:v>440</c:v>
                </c:pt>
                <c:pt idx="91">
                  <c:v>440.4500122</c:v>
                </c:pt>
                <c:pt idx="92">
                  <c:v>441.05999759999997</c:v>
                </c:pt>
                <c:pt idx="93">
                  <c:v>441.51000979999998</c:v>
                </c:pt>
                <c:pt idx="94">
                  <c:v>441.9599915</c:v>
                </c:pt>
                <c:pt idx="95">
                  <c:v>442.57000729999999</c:v>
                </c:pt>
                <c:pt idx="96">
                  <c:v>443.02999879999999</c:v>
                </c:pt>
                <c:pt idx="97">
                  <c:v>443.48001099999999</c:v>
                </c:pt>
                <c:pt idx="98">
                  <c:v>443.92999270000001</c:v>
                </c:pt>
                <c:pt idx="99">
                  <c:v>444.5400085</c:v>
                </c:pt>
                <c:pt idx="100">
                  <c:v>445</c:v>
                </c:pt>
                <c:pt idx="101">
                  <c:v>445.4500122</c:v>
                </c:pt>
                <c:pt idx="102">
                  <c:v>446.05999759999997</c:v>
                </c:pt>
                <c:pt idx="103">
                  <c:v>446.51000979999998</c:v>
                </c:pt>
                <c:pt idx="104">
                  <c:v>446.9599915</c:v>
                </c:pt>
                <c:pt idx="105">
                  <c:v>447.57000729999999</c:v>
                </c:pt>
                <c:pt idx="106">
                  <c:v>448.02999879999999</c:v>
                </c:pt>
                <c:pt idx="107">
                  <c:v>448.48001099999999</c:v>
                </c:pt>
                <c:pt idx="108">
                  <c:v>448.92999270000001</c:v>
                </c:pt>
                <c:pt idx="109">
                  <c:v>449.5400085</c:v>
                </c:pt>
                <c:pt idx="110">
                  <c:v>450</c:v>
                </c:pt>
                <c:pt idx="111">
                  <c:v>450.44000240000003</c:v>
                </c:pt>
                <c:pt idx="112">
                  <c:v>451.0400085</c:v>
                </c:pt>
                <c:pt idx="113">
                  <c:v>451.48999020000002</c:v>
                </c:pt>
                <c:pt idx="114">
                  <c:v>451.94000240000003</c:v>
                </c:pt>
                <c:pt idx="115">
                  <c:v>452.52999879999999</c:v>
                </c:pt>
                <c:pt idx="116">
                  <c:v>452.98001099999999</c:v>
                </c:pt>
                <c:pt idx="117">
                  <c:v>453.42999270000001</c:v>
                </c:pt>
                <c:pt idx="118">
                  <c:v>454.01998900000001</c:v>
                </c:pt>
                <c:pt idx="119">
                  <c:v>454.47000120000001</c:v>
                </c:pt>
                <c:pt idx="120">
                  <c:v>455.07000729999999</c:v>
                </c:pt>
                <c:pt idx="121">
                  <c:v>455.51998900000001</c:v>
                </c:pt>
                <c:pt idx="122">
                  <c:v>455.97000120000001</c:v>
                </c:pt>
                <c:pt idx="123">
                  <c:v>456.55999759999997</c:v>
                </c:pt>
                <c:pt idx="124">
                  <c:v>457.01000979999998</c:v>
                </c:pt>
                <c:pt idx="125">
                  <c:v>457.4599915</c:v>
                </c:pt>
                <c:pt idx="126">
                  <c:v>458.0499878</c:v>
                </c:pt>
                <c:pt idx="127">
                  <c:v>458.5</c:v>
                </c:pt>
                <c:pt idx="128">
                  <c:v>458.9500122</c:v>
                </c:pt>
                <c:pt idx="129">
                  <c:v>459.5499878</c:v>
                </c:pt>
                <c:pt idx="130">
                  <c:v>460</c:v>
                </c:pt>
                <c:pt idx="131">
                  <c:v>460.4500122</c:v>
                </c:pt>
                <c:pt idx="132">
                  <c:v>461.05999759999997</c:v>
                </c:pt>
                <c:pt idx="133">
                  <c:v>461.51000979999998</c:v>
                </c:pt>
                <c:pt idx="134">
                  <c:v>461.9599915</c:v>
                </c:pt>
                <c:pt idx="135">
                  <c:v>462.57000729999999</c:v>
                </c:pt>
                <c:pt idx="136">
                  <c:v>463.02999879999999</c:v>
                </c:pt>
                <c:pt idx="137">
                  <c:v>463.48001099999999</c:v>
                </c:pt>
                <c:pt idx="138">
                  <c:v>463.92999270000001</c:v>
                </c:pt>
                <c:pt idx="139">
                  <c:v>464.5400085</c:v>
                </c:pt>
                <c:pt idx="140">
                  <c:v>465</c:v>
                </c:pt>
                <c:pt idx="141">
                  <c:v>465.4500122</c:v>
                </c:pt>
                <c:pt idx="142">
                  <c:v>466.05999759999997</c:v>
                </c:pt>
                <c:pt idx="143">
                  <c:v>466.51000979999998</c:v>
                </c:pt>
                <c:pt idx="144">
                  <c:v>466.9599915</c:v>
                </c:pt>
                <c:pt idx="145">
                  <c:v>467.57000729999999</c:v>
                </c:pt>
                <c:pt idx="146">
                  <c:v>468.02999879999999</c:v>
                </c:pt>
                <c:pt idx="147">
                  <c:v>468.48001099999999</c:v>
                </c:pt>
                <c:pt idx="148">
                  <c:v>468.92999270000001</c:v>
                </c:pt>
                <c:pt idx="149">
                  <c:v>469.5400085</c:v>
                </c:pt>
                <c:pt idx="150">
                  <c:v>470</c:v>
                </c:pt>
                <c:pt idx="151">
                  <c:v>470.44000240000003</c:v>
                </c:pt>
                <c:pt idx="152">
                  <c:v>471.0400085</c:v>
                </c:pt>
                <c:pt idx="153">
                  <c:v>471.48999020000002</c:v>
                </c:pt>
                <c:pt idx="154">
                  <c:v>471.94000240000003</c:v>
                </c:pt>
                <c:pt idx="155">
                  <c:v>472.52999879999999</c:v>
                </c:pt>
                <c:pt idx="156">
                  <c:v>472.98001099999999</c:v>
                </c:pt>
                <c:pt idx="157">
                  <c:v>473.42999270000001</c:v>
                </c:pt>
                <c:pt idx="158">
                  <c:v>474.01998900000001</c:v>
                </c:pt>
                <c:pt idx="159">
                  <c:v>474.47000120000001</c:v>
                </c:pt>
                <c:pt idx="160">
                  <c:v>475.07000729999999</c:v>
                </c:pt>
                <c:pt idx="161">
                  <c:v>475.51998900000001</c:v>
                </c:pt>
                <c:pt idx="162">
                  <c:v>475.97000120000001</c:v>
                </c:pt>
                <c:pt idx="163">
                  <c:v>476.55999759999997</c:v>
                </c:pt>
                <c:pt idx="164">
                  <c:v>477.01000979999998</c:v>
                </c:pt>
                <c:pt idx="165">
                  <c:v>477.4599915</c:v>
                </c:pt>
                <c:pt idx="166">
                  <c:v>478.0499878</c:v>
                </c:pt>
                <c:pt idx="167">
                  <c:v>478.5</c:v>
                </c:pt>
                <c:pt idx="168">
                  <c:v>478.9500122</c:v>
                </c:pt>
                <c:pt idx="169">
                  <c:v>479.5499878</c:v>
                </c:pt>
                <c:pt idx="170">
                  <c:v>480</c:v>
                </c:pt>
                <c:pt idx="171">
                  <c:v>480.44000240000003</c:v>
                </c:pt>
                <c:pt idx="172">
                  <c:v>481.0400085</c:v>
                </c:pt>
                <c:pt idx="173">
                  <c:v>481.48999020000002</c:v>
                </c:pt>
                <c:pt idx="174">
                  <c:v>481.94000240000003</c:v>
                </c:pt>
                <c:pt idx="175">
                  <c:v>482.52999879999999</c:v>
                </c:pt>
                <c:pt idx="176">
                  <c:v>482.98001099999999</c:v>
                </c:pt>
                <c:pt idx="177">
                  <c:v>483.42999270000001</c:v>
                </c:pt>
                <c:pt idx="178">
                  <c:v>484.01998900000001</c:v>
                </c:pt>
                <c:pt idx="179">
                  <c:v>484.47000120000001</c:v>
                </c:pt>
                <c:pt idx="180">
                  <c:v>485.07000729999999</c:v>
                </c:pt>
                <c:pt idx="181">
                  <c:v>485.51998900000001</c:v>
                </c:pt>
                <c:pt idx="182">
                  <c:v>485.97000120000001</c:v>
                </c:pt>
                <c:pt idx="183">
                  <c:v>486.55999759999997</c:v>
                </c:pt>
                <c:pt idx="184">
                  <c:v>487.01000979999998</c:v>
                </c:pt>
                <c:pt idx="185">
                  <c:v>487.4599915</c:v>
                </c:pt>
                <c:pt idx="186">
                  <c:v>488.0499878</c:v>
                </c:pt>
                <c:pt idx="187">
                  <c:v>488.5</c:v>
                </c:pt>
                <c:pt idx="188">
                  <c:v>488.9500122</c:v>
                </c:pt>
                <c:pt idx="189">
                  <c:v>489.5499878</c:v>
                </c:pt>
                <c:pt idx="190">
                  <c:v>490</c:v>
                </c:pt>
                <c:pt idx="191">
                  <c:v>490.44000240000003</c:v>
                </c:pt>
                <c:pt idx="192">
                  <c:v>491.0400085</c:v>
                </c:pt>
                <c:pt idx="193">
                  <c:v>491.48999020000002</c:v>
                </c:pt>
                <c:pt idx="194">
                  <c:v>491.94000240000003</c:v>
                </c:pt>
                <c:pt idx="195">
                  <c:v>492.52999879999999</c:v>
                </c:pt>
                <c:pt idx="196">
                  <c:v>492.98001099999999</c:v>
                </c:pt>
                <c:pt idx="197">
                  <c:v>493.42999270000001</c:v>
                </c:pt>
                <c:pt idx="198">
                  <c:v>494.01998900000001</c:v>
                </c:pt>
                <c:pt idx="199">
                  <c:v>494.47000120000001</c:v>
                </c:pt>
                <c:pt idx="200">
                  <c:v>495.07000729999999</c:v>
                </c:pt>
                <c:pt idx="201">
                  <c:v>495.51998900000001</c:v>
                </c:pt>
                <c:pt idx="202">
                  <c:v>495.97000120000001</c:v>
                </c:pt>
                <c:pt idx="203">
                  <c:v>496.55999759999997</c:v>
                </c:pt>
                <c:pt idx="204">
                  <c:v>497.01000979999998</c:v>
                </c:pt>
                <c:pt idx="205">
                  <c:v>497.4599915</c:v>
                </c:pt>
                <c:pt idx="206">
                  <c:v>498.0499878</c:v>
                </c:pt>
                <c:pt idx="207">
                  <c:v>498.5</c:v>
                </c:pt>
                <c:pt idx="208">
                  <c:v>498.9500122</c:v>
                </c:pt>
                <c:pt idx="209">
                  <c:v>499.5499878</c:v>
                </c:pt>
                <c:pt idx="210">
                  <c:v>500</c:v>
                </c:pt>
                <c:pt idx="211">
                  <c:v>500.44000240000003</c:v>
                </c:pt>
                <c:pt idx="212">
                  <c:v>501.0400085</c:v>
                </c:pt>
                <c:pt idx="213">
                  <c:v>501.48999020000002</c:v>
                </c:pt>
                <c:pt idx="214">
                  <c:v>501.94000240000003</c:v>
                </c:pt>
                <c:pt idx="215">
                  <c:v>502.52999879999999</c:v>
                </c:pt>
                <c:pt idx="216">
                  <c:v>502.98001099999999</c:v>
                </c:pt>
                <c:pt idx="217">
                  <c:v>503.42999270000001</c:v>
                </c:pt>
                <c:pt idx="218">
                  <c:v>504.01998900000001</c:v>
                </c:pt>
                <c:pt idx="219">
                  <c:v>504.47000120000001</c:v>
                </c:pt>
                <c:pt idx="220">
                  <c:v>505.07000729999999</c:v>
                </c:pt>
                <c:pt idx="221">
                  <c:v>505.51998900000001</c:v>
                </c:pt>
                <c:pt idx="222">
                  <c:v>505.97000120000001</c:v>
                </c:pt>
                <c:pt idx="223">
                  <c:v>506.55999759999997</c:v>
                </c:pt>
                <c:pt idx="224">
                  <c:v>507.01000979999998</c:v>
                </c:pt>
                <c:pt idx="225">
                  <c:v>507.4599915</c:v>
                </c:pt>
                <c:pt idx="226">
                  <c:v>508.0499878</c:v>
                </c:pt>
                <c:pt idx="227">
                  <c:v>508.5</c:v>
                </c:pt>
                <c:pt idx="228">
                  <c:v>508.9500122</c:v>
                </c:pt>
                <c:pt idx="229">
                  <c:v>509.5499878</c:v>
                </c:pt>
                <c:pt idx="230">
                  <c:v>510</c:v>
                </c:pt>
                <c:pt idx="231">
                  <c:v>510.44000240000003</c:v>
                </c:pt>
                <c:pt idx="232">
                  <c:v>511.0400085</c:v>
                </c:pt>
                <c:pt idx="233">
                  <c:v>511.48999020000002</c:v>
                </c:pt>
                <c:pt idx="234">
                  <c:v>511.94000240000003</c:v>
                </c:pt>
                <c:pt idx="235">
                  <c:v>512.53002930000002</c:v>
                </c:pt>
                <c:pt idx="236">
                  <c:v>512.97998050000001</c:v>
                </c:pt>
                <c:pt idx="237">
                  <c:v>513.42999269999996</c:v>
                </c:pt>
                <c:pt idx="238">
                  <c:v>514.02001949999999</c:v>
                </c:pt>
                <c:pt idx="239">
                  <c:v>514.46997069999998</c:v>
                </c:pt>
                <c:pt idx="240">
                  <c:v>515.07000730000004</c:v>
                </c:pt>
                <c:pt idx="241">
                  <c:v>515.52001949999999</c:v>
                </c:pt>
                <c:pt idx="242">
                  <c:v>515.96997069999998</c:v>
                </c:pt>
                <c:pt idx="243">
                  <c:v>516.55999759999997</c:v>
                </c:pt>
                <c:pt idx="244">
                  <c:v>517.01000980000003</c:v>
                </c:pt>
                <c:pt idx="245">
                  <c:v>517.46002199999998</c:v>
                </c:pt>
                <c:pt idx="246">
                  <c:v>518.04998780000005</c:v>
                </c:pt>
                <c:pt idx="247">
                  <c:v>518.5</c:v>
                </c:pt>
                <c:pt idx="248">
                  <c:v>518.95001219999995</c:v>
                </c:pt>
                <c:pt idx="249">
                  <c:v>519.54998780000005</c:v>
                </c:pt>
                <c:pt idx="250">
                  <c:v>520</c:v>
                </c:pt>
                <c:pt idx="251">
                  <c:v>520.44000240000003</c:v>
                </c:pt>
                <c:pt idx="252">
                  <c:v>521.03997800000002</c:v>
                </c:pt>
                <c:pt idx="253">
                  <c:v>521.48999019999997</c:v>
                </c:pt>
                <c:pt idx="254">
                  <c:v>521.94000240000003</c:v>
                </c:pt>
                <c:pt idx="255">
                  <c:v>522.53002930000002</c:v>
                </c:pt>
                <c:pt idx="256">
                  <c:v>522.97998050000001</c:v>
                </c:pt>
                <c:pt idx="257">
                  <c:v>523.42999269999996</c:v>
                </c:pt>
                <c:pt idx="258">
                  <c:v>524.02001949999999</c:v>
                </c:pt>
                <c:pt idx="259">
                  <c:v>524.46997069999998</c:v>
                </c:pt>
                <c:pt idx="260">
                  <c:v>525.07000730000004</c:v>
                </c:pt>
                <c:pt idx="261">
                  <c:v>525.52001949999999</c:v>
                </c:pt>
                <c:pt idx="262">
                  <c:v>525.96997069999998</c:v>
                </c:pt>
                <c:pt idx="263">
                  <c:v>526.55999759999997</c:v>
                </c:pt>
                <c:pt idx="264">
                  <c:v>527.01000980000003</c:v>
                </c:pt>
                <c:pt idx="265">
                  <c:v>527.46002199999998</c:v>
                </c:pt>
                <c:pt idx="266">
                  <c:v>528.04998780000005</c:v>
                </c:pt>
                <c:pt idx="267">
                  <c:v>528.5</c:v>
                </c:pt>
                <c:pt idx="268">
                  <c:v>528.95001219999995</c:v>
                </c:pt>
                <c:pt idx="269">
                  <c:v>529.54998780000005</c:v>
                </c:pt>
                <c:pt idx="270">
                  <c:v>530</c:v>
                </c:pt>
                <c:pt idx="271">
                  <c:v>530.44000240000003</c:v>
                </c:pt>
                <c:pt idx="272">
                  <c:v>531.02001949999999</c:v>
                </c:pt>
                <c:pt idx="273">
                  <c:v>531.46997069999998</c:v>
                </c:pt>
                <c:pt idx="274">
                  <c:v>532.04998780000005</c:v>
                </c:pt>
                <c:pt idx="275">
                  <c:v>532.5</c:v>
                </c:pt>
                <c:pt idx="276">
                  <c:v>532.94000240000003</c:v>
                </c:pt>
                <c:pt idx="277">
                  <c:v>533.52001949999999</c:v>
                </c:pt>
                <c:pt idx="278">
                  <c:v>533.96997069999998</c:v>
                </c:pt>
                <c:pt idx="279">
                  <c:v>534.54998780000005</c:v>
                </c:pt>
                <c:pt idx="280">
                  <c:v>535</c:v>
                </c:pt>
                <c:pt idx="281">
                  <c:v>535.44000240000003</c:v>
                </c:pt>
                <c:pt idx="282">
                  <c:v>536.02001949999999</c:v>
                </c:pt>
                <c:pt idx="283">
                  <c:v>536.46997069999998</c:v>
                </c:pt>
                <c:pt idx="284">
                  <c:v>537.04998780000005</c:v>
                </c:pt>
                <c:pt idx="285">
                  <c:v>537.5</c:v>
                </c:pt>
                <c:pt idx="286">
                  <c:v>537.94000240000003</c:v>
                </c:pt>
                <c:pt idx="287">
                  <c:v>538.52001949999999</c:v>
                </c:pt>
                <c:pt idx="288">
                  <c:v>538.96997069999998</c:v>
                </c:pt>
                <c:pt idx="289">
                  <c:v>539.54998780000005</c:v>
                </c:pt>
                <c:pt idx="290">
                  <c:v>540</c:v>
                </c:pt>
                <c:pt idx="291">
                  <c:v>540.44000240000003</c:v>
                </c:pt>
                <c:pt idx="292">
                  <c:v>541.02001949999999</c:v>
                </c:pt>
                <c:pt idx="293">
                  <c:v>541.46997069999998</c:v>
                </c:pt>
                <c:pt idx="294">
                  <c:v>542.04998780000005</c:v>
                </c:pt>
                <c:pt idx="295">
                  <c:v>542.5</c:v>
                </c:pt>
                <c:pt idx="296">
                  <c:v>542.94000240000003</c:v>
                </c:pt>
                <c:pt idx="297">
                  <c:v>543.52001949999999</c:v>
                </c:pt>
                <c:pt idx="298">
                  <c:v>543.96997069999998</c:v>
                </c:pt>
                <c:pt idx="299">
                  <c:v>544.54998780000005</c:v>
                </c:pt>
                <c:pt idx="300">
                  <c:v>545</c:v>
                </c:pt>
                <c:pt idx="301">
                  <c:v>545.44000240000003</c:v>
                </c:pt>
                <c:pt idx="302">
                  <c:v>546.02001949999999</c:v>
                </c:pt>
                <c:pt idx="303">
                  <c:v>546.46997069999998</c:v>
                </c:pt>
                <c:pt idx="304">
                  <c:v>547.04998780000005</c:v>
                </c:pt>
                <c:pt idx="305">
                  <c:v>547.5</c:v>
                </c:pt>
                <c:pt idx="306">
                  <c:v>547.94000240000003</c:v>
                </c:pt>
                <c:pt idx="307">
                  <c:v>548.52001949999999</c:v>
                </c:pt>
                <c:pt idx="308">
                  <c:v>548.96997069999998</c:v>
                </c:pt>
                <c:pt idx="309">
                  <c:v>549.54998780000005</c:v>
                </c:pt>
                <c:pt idx="310">
                  <c:v>550</c:v>
                </c:pt>
                <c:pt idx="311">
                  <c:v>550.44000240000003</c:v>
                </c:pt>
                <c:pt idx="312">
                  <c:v>551.02001949999999</c:v>
                </c:pt>
                <c:pt idx="313">
                  <c:v>551.46997069999998</c:v>
                </c:pt>
                <c:pt idx="314">
                  <c:v>552.04998780000005</c:v>
                </c:pt>
                <c:pt idx="315">
                  <c:v>552.5</c:v>
                </c:pt>
                <c:pt idx="316">
                  <c:v>552.94000240000003</c:v>
                </c:pt>
                <c:pt idx="317">
                  <c:v>553.52001949999999</c:v>
                </c:pt>
                <c:pt idx="318">
                  <c:v>553.96997069999998</c:v>
                </c:pt>
                <c:pt idx="319">
                  <c:v>554.54998780000005</c:v>
                </c:pt>
                <c:pt idx="320">
                  <c:v>555</c:v>
                </c:pt>
                <c:pt idx="321">
                  <c:v>555.44000240000003</c:v>
                </c:pt>
                <c:pt idx="322">
                  <c:v>556.02001949999999</c:v>
                </c:pt>
                <c:pt idx="323">
                  <c:v>556.46997069999998</c:v>
                </c:pt>
                <c:pt idx="324">
                  <c:v>557.04998780000005</c:v>
                </c:pt>
                <c:pt idx="325">
                  <c:v>557.5</c:v>
                </c:pt>
                <c:pt idx="326">
                  <c:v>557.94000240000003</c:v>
                </c:pt>
                <c:pt idx="327">
                  <c:v>558.52001949999999</c:v>
                </c:pt>
                <c:pt idx="328">
                  <c:v>558.96997069999998</c:v>
                </c:pt>
                <c:pt idx="329">
                  <c:v>559.54998780000005</c:v>
                </c:pt>
                <c:pt idx="330">
                  <c:v>560</c:v>
                </c:pt>
                <c:pt idx="331">
                  <c:v>560.44000240000003</c:v>
                </c:pt>
                <c:pt idx="332">
                  <c:v>561.02001949999999</c:v>
                </c:pt>
                <c:pt idx="333">
                  <c:v>561.46997069999998</c:v>
                </c:pt>
                <c:pt idx="334">
                  <c:v>562.04998780000005</c:v>
                </c:pt>
                <c:pt idx="335">
                  <c:v>562.5</c:v>
                </c:pt>
                <c:pt idx="336">
                  <c:v>562.94000240000003</c:v>
                </c:pt>
                <c:pt idx="337">
                  <c:v>563.52001949999999</c:v>
                </c:pt>
                <c:pt idx="338">
                  <c:v>563.96997069999998</c:v>
                </c:pt>
                <c:pt idx="339">
                  <c:v>564.54998780000005</c:v>
                </c:pt>
                <c:pt idx="340">
                  <c:v>565</c:v>
                </c:pt>
                <c:pt idx="341">
                  <c:v>565.44000240000003</c:v>
                </c:pt>
                <c:pt idx="342">
                  <c:v>566.02001949999999</c:v>
                </c:pt>
                <c:pt idx="343">
                  <c:v>566.46997069999998</c:v>
                </c:pt>
                <c:pt idx="344">
                  <c:v>567.04998780000005</c:v>
                </c:pt>
                <c:pt idx="345">
                  <c:v>567.5</c:v>
                </c:pt>
                <c:pt idx="346">
                  <c:v>567.94000240000003</c:v>
                </c:pt>
                <c:pt idx="347">
                  <c:v>568.52001949999999</c:v>
                </c:pt>
                <c:pt idx="348">
                  <c:v>568.96997069999998</c:v>
                </c:pt>
                <c:pt idx="349">
                  <c:v>569.54998780000005</c:v>
                </c:pt>
                <c:pt idx="350">
                  <c:v>570</c:v>
                </c:pt>
                <c:pt idx="351">
                  <c:v>570.44000240000003</c:v>
                </c:pt>
                <c:pt idx="352">
                  <c:v>571.02001949999999</c:v>
                </c:pt>
                <c:pt idx="353">
                  <c:v>571.46997069999998</c:v>
                </c:pt>
                <c:pt idx="354">
                  <c:v>572.04998780000005</c:v>
                </c:pt>
                <c:pt idx="355">
                  <c:v>572.5</c:v>
                </c:pt>
                <c:pt idx="356">
                  <c:v>572.94000240000003</c:v>
                </c:pt>
                <c:pt idx="357">
                  <c:v>573.52001949999999</c:v>
                </c:pt>
                <c:pt idx="358">
                  <c:v>573.96997069999998</c:v>
                </c:pt>
                <c:pt idx="359">
                  <c:v>574.54998780000005</c:v>
                </c:pt>
                <c:pt idx="360">
                  <c:v>575</c:v>
                </c:pt>
                <c:pt idx="361">
                  <c:v>575.44000240000003</c:v>
                </c:pt>
                <c:pt idx="362">
                  <c:v>576.02001949999999</c:v>
                </c:pt>
                <c:pt idx="363">
                  <c:v>576.46997069999998</c:v>
                </c:pt>
                <c:pt idx="364">
                  <c:v>577.04998780000005</c:v>
                </c:pt>
                <c:pt idx="365">
                  <c:v>577.5</c:v>
                </c:pt>
                <c:pt idx="366">
                  <c:v>577.94000240000003</c:v>
                </c:pt>
                <c:pt idx="367">
                  <c:v>578.52001949999999</c:v>
                </c:pt>
                <c:pt idx="368">
                  <c:v>578.96997069999998</c:v>
                </c:pt>
                <c:pt idx="369">
                  <c:v>579.54998780000005</c:v>
                </c:pt>
                <c:pt idx="370">
                  <c:v>580</c:v>
                </c:pt>
                <c:pt idx="371">
                  <c:v>580.44000240000003</c:v>
                </c:pt>
                <c:pt idx="372">
                  <c:v>581.02001949999999</c:v>
                </c:pt>
                <c:pt idx="373">
                  <c:v>581.46997069999998</c:v>
                </c:pt>
                <c:pt idx="374">
                  <c:v>582.04998780000005</c:v>
                </c:pt>
                <c:pt idx="375">
                  <c:v>582.5</c:v>
                </c:pt>
                <c:pt idx="376">
                  <c:v>582.94000240000003</c:v>
                </c:pt>
                <c:pt idx="377">
                  <c:v>583.52001949999999</c:v>
                </c:pt>
                <c:pt idx="378">
                  <c:v>583.96997069999998</c:v>
                </c:pt>
                <c:pt idx="379">
                  <c:v>584.54998780000005</c:v>
                </c:pt>
                <c:pt idx="380">
                  <c:v>585</c:v>
                </c:pt>
                <c:pt idx="381">
                  <c:v>585.44000240000003</c:v>
                </c:pt>
                <c:pt idx="382">
                  <c:v>586.02001949999999</c:v>
                </c:pt>
                <c:pt idx="383">
                  <c:v>586.46997069999998</c:v>
                </c:pt>
                <c:pt idx="384">
                  <c:v>587.04998780000005</c:v>
                </c:pt>
                <c:pt idx="385">
                  <c:v>587.5</c:v>
                </c:pt>
                <c:pt idx="386">
                  <c:v>587.94000240000003</c:v>
                </c:pt>
                <c:pt idx="387">
                  <c:v>588.52001949999999</c:v>
                </c:pt>
                <c:pt idx="388">
                  <c:v>588.96997069999998</c:v>
                </c:pt>
                <c:pt idx="389">
                  <c:v>589.54998780000005</c:v>
                </c:pt>
                <c:pt idx="390">
                  <c:v>590</c:v>
                </c:pt>
                <c:pt idx="391">
                  <c:v>590.42999269999996</c:v>
                </c:pt>
                <c:pt idx="392">
                  <c:v>591.01000980000003</c:v>
                </c:pt>
                <c:pt idx="393">
                  <c:v>591.44000240000003</c:v>
                </c:pt>
                <c:pt idx="394">
                  <c:v>592.02001949999999</c:v>
                </c:pt>
                <c:pt idx="395">
                  <c:v>592.46002199999998</c:v>
                </c:pt>
                <c:pt idx="396">
                  <c:v>593.03997800000002</c:v>
                </c:pt>
                <c:pt idx="397">
                  <c:v>593.46997069999998</c:v>
                </c:pt>
                <c:pt idx="398">
                  <c:v>594.04998780000005</c:v>
                </c:pt>
                <c:pt idx="399">
                  <c:v>594.48999019999997</c:v>
                </c:pt>
                <c:pt idx="400">
                  <c:v>595.07000730000004</c:v>
                </c:pt>
                <c:pt idx="401">
                  <c:v>595.5</c:v>
                </c:pt>
                <c:pt idx="402">
                  <c:v>595.94000240000003</c:v>
                </c:pt>
                <c:pt idx="403">
                  <c:v>596.52001949999999</c:v>
                </c:pt>
                <c:pt idx="404">
                  <c:v>596.95001219999995</c:v>
                </c:pt>
                <c:pt idx="405">
                  <c:v>597.53002930000002</c:v>
                </c:pt>
                <c:pt idx="406">
                  <c:v>597.96997069999998</c:v>
                </c:pt>
                <c:pt idx="407">
                  <c:v>598.54998780000005</c:v>
                </c:pt>
                <c:pt idx="408">
                  <c:v>598.97998050000001</c:v>
                </c:pt>
                <c:pt idx="409">
                  <c:v>599.55999759999997</c:v>
                </c:pt>
                <c:pt idx="410">
                  <c:v>600</c:v>
                </c:pt>
                <c:pt idx="411">
                  <c:v>600.42999269999996</c:v>
                </c:pt>
                <c:pt idx="412">
                  <c:v>601.01000980000003</c:v>
                </c:pt>
                <c:pt idx="413">
                  <c:v>601.44000240000003</c:v>
                </c:pt>
                <c:pt idx="414">
                  <c:v>602.02001949999999</c:v>
                </c:pt>
                <c:pt idx="415">
                  <c:v>602.46002199999998</c:v>
                </c:pt>
                <c:pt idx="416">
                  <c:v>603.03997800000002</c:v>
                </c:pt>
                <c:pt idx="417">
                  <c:v>603.46997069999998</c:v>
                </c:pt>
                <c:pt idx="418">
                  <c:v>604.04998780000005</c:v>
                </c:pt>
                <c:pt idx="419">
                  <c:v>604.48999019999997</c:v>
                </c:pt>
                <c:pt idx="420">
                  <c:v>605.07000730000004</c:v>
                </c:pt>
                <c:pt idx="421">
                  <c:v>605.5</c:v>
                </c:pt>
                <c:pt idx="422">
                  <c:v>605.94000240000003</c:v>
                </c:pt>
                <c:pt idx="423">
                  <c:v>606.52001949999999</c:v>
                </c:pt>
                <c:pt idx="424">
                  <c:v>606.95001219999995</c:v>
                </c:pt>
                <c:pt idx="425">
                  <c:v>607.53002930000002</c:v>
                </c:pt>
                <c:pt idx="426">
                  <c:v>607.96997069999998</c:v>
                </c:pt>
                <c:pt idx="427">
                  <c:v>608.54998780000005</c:v>
                </c:pt>
                <c:pt idx="428">
                  <c:v>608.97998050000001</c:v>
                </c:pt>
                <c:pt idx="429">
                  <c:v>609.55999759999997</c:v>
                </c:pt>
                <c:pt idx="430">
                  <c:v>610</c:v>
                </c:pt>
                <c:pt idx="431">
                  <c:v>610.42999269999996</c:v>
                </c:pt>
                <c:pt idx="432">
                  <c:v>611.01000980000003</c:v>
                </c:pt>
                <c:pt idx="433">
                  <c:v>611.44000240000003</c:v>
                </c:pt>
                <c:pt idx="434">
                  <c:v>612.02001949999999</c:v>
                </c:pt>
                <c:pt idx="435">
                  <c:v>612.46002199999998</c:v>
                </c:pt>
                <c:pt idx="436">
                  <c:v>613.03997800000002</c:v>
                </c:pt>
                <c:pt idx="437">
                  <c:v>613.46997069999998</c:v>
                </c:pt>
                <c:pt idx="438">
                  <c:v>614.04998780000005</c:v>
                </c:pt>
                <c:pt idx="439">
                  <c:v>614.48999019999997</c:v>
                </c:pt>
                <c:pt idx="440">
                  <c:v>615.07000730000004</c:v>
                </c:pt>
                <c:pt idx="441">
                  <c:v>615.5</c:v>
                </c:pt>
                <c:pt idx="442">
                  <c:v>615.94000240000003</c:v>
                </c:pt>
                <c:pt idx="443">
                  <c:v>616.52001949999999</c:v>
                </c:pt>
                <c:pt idx="444">
                  <c:v>616.95001219999995</c:v>
                </c:pt>
                <c:pt idx="445">
                  <c:v>617.53002930000002</c:v>
                </c:pt>
                <c:pt idx="446">
                  <c:v>617.96997069999998</c:v>
                </c:pt>
                <c:pt idx="447">
                  <c:v>618.54998780000005</c:v>
                </c:pt>
                <c:pt idx="448">
                  <c:v>618.97998050000001</c:v>
                </c:pt>
                <c:pt idx="449">
                  <c:v>619.55999759999997</c:v>
                </c:pt>
                <c:pt idx="450">
                  <c:v>620</c:v>
                </c:pt>
                <c:pt idx="451">
                  <c:v>620.42999269999996</c:v>
                </c:pt>
                <c:pt idx="452">
                  <c:v>621.01000980000003</c:v>
                </c:pt>
                <c:pt idx="453">
                  <c:v>621.44000240000003</c:v>
                </c:pt>
                <c:pt idx="454">
                  <c:v>622.02001949999999</c:v>
                </c:pt>
                <c:pt idx="455">
                  <c:v>622.46002199999998</c:v>
                </c:pt>
                <c:pt idx="456">
                  <c:v>623.03997800000002</c:v>
                </c:pt>
                <c:pt idx="457">
                  <c:v>623.46997069999998</c:v>
                </c:pt>
                <c:pt idx="458">
                  <c:v>624.04998780000005</c:v>
                </c:pt>
                <c:pt idx="459">
                  <c:v>624.48999019999997</c:v>
                </c:pt>
                <c:pt idx="460">
                  <c:v>625.07000730000004</c:v>
                </c:pt>
                <c:pt idx="461">
                  <c:v>625.5</c:v>
                </c:pt>
                <c:pt idx="462">
                  <c:v>625.94000240000003</c:v>
                </c:pt>
                <c:pt idx="463">
                  <c:v>626.52001949999999</c:v>
                </c:pt>
                <c:pt idx="464">
                  <c:v>626.95001219999995</c:v>
                </c:pt>
                <c:pt idx="465">
                  <c:v>627.53002930000002</c:v>
                </c:pt>
                <c:pt idx="466">
                  <c:v>627.96997069999998</c:v>
                </c:pt>
                <c:pt idx="467">
                  <c:v>628.54998780000005</c:v>
                </c:pt>
                <c:pt idx="468">
                  <c:v>628.97998050000001</c:v>
                </c:pt>
                <c:pt idx="469">
                  <c:v>629.55999759999997</c:v>
                </c:pt>
                <c:pt idx="470">
                  <c:v>630</c:v>
                </c:pt>
                <c:pt idx="471">
                  <c:v>630.42999269999996</c:v>
                </c:pt>
                <c:pt idx="472">
                  <c:v>631.01000980000003</c:v>
                </c:pt>
                <c:pt idx="473">
                  <c:v>631.44000240000003</c:v>
                </c:pt>
                <c:pt idx="474">
                  <c:v>632.02001949999999</c:v>
                </c:pt>
                <c:pt idx="475">
                  <c:v>632.46002199999998</c:v>
                </c:pt>
                <c:pt idx="476">
                  <c:v>633.03997800000002</c:v>
                </c:pt>
                <c:pt idx="477">
                  <c:v>633.46997069999998</c:v>
                </c:pt>
                <c:pt idx="478">
                  <c:v>634.04998780000005</c:v>
                </c:pt>
                <c:pt idx="479">
                  <c:v>634.48999019999997</c:v>
                </c:pt>
                <c:pt idx="480">
                  <c:v>635.07000730000004</c:v>
                </c:pt>
                <c:pt idx="481">
                  <c:v>635.5</c:v>
                </c:pt>
                <c:pt idx="482">
                  <c:v>635.94000240000003</c:v>
                </c:pt>
                <c:pt idx="483">
                  <c:v>636.52001949999999</c:v>
                </c:pt>
                <c:pt idx="484">
                  <c:v>636.95001219999995</c:v>
                </c:pt>
                <c:pt idx="485">
                  <c:v>637.53002930000002</c:v>
                </c:pt>
                <c:pt idx="486">
                  <c:v>637.96997069999998</c:v>
                </c:pt>
                <c:pt idx="487">
                  <c:v>638.54998780000005</c:v>
                </c:pt>
                <c:pt idx="488">
                  <c:v>638.97998050000001</c:v>
                </c:pt>
                <c:pt idx="489">
                  <c:v>639.55999759999997</c:v>
                </c:pt>
                <c:pt idx="490">
                  <c:v>640</c:v>
                </c:pt>
                <c:pt idx="491">
                  <c:v>640.57000730000004</c:v>
                </c:pt>
                <c:pt idx="492">
                  <c:v>641</c:v>
                </c:pt>
                <c:pt idx="493">
                  <c:v>641.57000730000004</c:v>
                </c:pt>
                <c:pt idx="494">
                  <c:v>642</c:v>
                </c:pt>
                <c:pt idx="495">
                  <c:v>642.57000730000004</c:v>
                </c:pt>
                <c:pt idx="496">
                  <c:v>643</c:v>
                </c:pt>
                <c:pt idx="497">
                  <c:v>643.57000730000004</c:v>
                </c:pt>
                <c:pt idx="498">
                  <c:v>644</c:v>
                </c:pt>
                <c:pt idx="499">
                  <c:v>644.57000730000004</c:v>
                </c:pt>
                <c:pt idx="500">
                  <c:v>645</c:v>
                </c:pt>
                <c:pt idx="501">
                  <c:v>645.57000730000004</c:v>
                </c:pt>
                <c:pt idx="502">
                  <c:v>646</c:v>
                </c:pt>
                <c:pt idx="503">
                  <c:v>646.57000730000004</c:v>
                </c:pt>
                <c:pt idx="504">
                  <c:v>647</c:v>
                </c:pt>
                <c:pt idx="505">
                  <c:v>647.57000730000004</c:v>
                </c:pt>
                <c:pt idx="506">
                  <c:v>648</c:v>
                </c:pt>
                <c:pt idx="507">
                  <c:v>648.57000730000004</c:v>
                </c:pt>
                <c:pt idx="508">
                  <c:v>649</c:v>
                </c:pt>
                <c:pt idx="509">
                  <c:v>649.57000730000004</c:v>
                </c:pt>
                <c:pt idx="510">
                  <c:v>650</c:v>
                </c:pt>
                <c:pt idx="511">
                  <c:v>650.42999269999996</c:v>
                </c:pt>
                <c:pt idx="512">
                  <c:v>651.01000980000003</c:v>
                </c:pt>
                <c:pt idx="513">
                  <c:v>651.44000240000003</c:v>
                </c:pt>
                <c:pt idx="514">
                  <c:v>652.02001949999999</c:v>
                </c:pt>
                <c:pt idx="515">
                  <c:v>652.46002199999998</c:v>
                </c:pt>
                <c:pt idx="516">
                  <c:v>653.03997800000002</c:v>
                </c:pt>
                <c:pt idx="517">
                  <c:v>653.46997069999998</c:v>
                </c:pt>
                <c:pt idx="518">
                  <c:v>654.04998780000005</c:v>
                </c:pt>
                <c:pt idx="519">
                  <c:v>654.48999019999997</c:v>
                </c:pt>
                <c:pt idx="520">
                  <c:v>655.07000730000004</c:v>
                </c:pt>
                <c:pt idx="521">
                  <c:v>655.5</c:v>
                </c:pt>
                <c:pt idx="522">
                  <c:v>655.94000240000003</c:v>
                </c:pt>
                <c:pt idx="523">
                  <c:v>656.52001949999999</c:v>
                </c:pt>
                <c:pt idx="524">
                  <c:v>656.95001219999995</c:v>
                </c:pt>
                <c:pt idx="525">
                  <c:v>657.53002930000002</c:v>
                </c:pt>
                <c:pt idx="526">
                  <c:v>657.96997069999998</c:v>
                </c:pt>
                <c:pt idx="527">
                  <c:v>658.54998780000005</c:v>
                </c:pt>
                <c:pt idx="528">
                  <c:v>658.97998050000001</c:v>
                </c:pt>
                <c:pt idx="529">
                  <c:v>659.55999759999997</c:v>
                </c:pt>
                <c:pt idx="530">
                  <c:v>660</c:v>
                </c:pt>
                <c:pt idx="531">
                  <c:v>660.57000730000004</c:v>
                </c:pt>
                <c:pt idx="532">
                  <c:v>661</c:v>
                </c:pt>
                <c:pt idx="533">
                  <c:v>661.57000730000004</c:v>
                </c:pt>
                <c:pt idx="534">
                  <c:v>662</c:v>
                </c:pt>
                <c:pt idx="535">
                  <c:v>662.57000730000004</c:v>
                </c:pt>
                <c:pt idx="536">
                  <c:v>663</c:v>
                </c:pt>
                <c:pt idx="537">
                  <c:v>663.57000730000004</c:v>
                </c:pt>
                <c:pt idx="538">
                  <c:v>664</c:v>
                </c:pt>
                <c:pt idx="539">
                  <c:v>664.57000730000004</c:v>
                </c:pt>
                <c:pt idx="540">
                  <c:v>665</c:v>
                </c:pt>
                <c:pt idx="541">
                  <c:v>665.57000730000004</c:v>
                </c:pt>
                <c:pt idx="542">
                  <c:v>666</c:v>
                </c:pt>
                <c:pt idx="543">
                  <c:v>666.57000730000004</c:v>
                </c:pt>
                <c:pt idx="544">
                  <c:v>667</c:v>
                </c:pt>
                <c:pt idx="545">
                  <c:v>667.57000730000004</c:v>
                </c:pt>
                <c:pt idx="546">
                  <c:v>668</c:v>
                </c:pt>
                <c:pt idx="547">
                  <c:v>668.57000730000004</c:v>
                </c:pt>
                <c:pt idx="548">
                  <c:v>669</c:v>
                </c:pt>
                <c:pt idx="549">
                  <c:v>669.57000730000004</c:v>
                </c:pt>
                <c:pt idx="550">
                  <c:v>670</c:v>
                </c:pt>
                <c:pt idx="551">
                  <c:v>670.55999759999997</c:v>
                </c:pt>
                <c:pt idx="552">
                  <c:v>670.97998050000001</c:v>
                </c:pt>
                <c:pt idx="553">
                  <c:v>671.53997800000002</c:v>
                </c:pt>
                <c:pt idx="554">
                  <c:v>671.96997069999998</c:v>
                </c:pt>
                <c:pt idx="555">
                  <c:v>672.53002930000002</c:v>
                </c:pt>
                <c:pt idx="556">
                  <c:v>672.95001219999995</c:v>
                </c:pt>
                <c:pt idx="557">
                  <c:v>673.52001949999999</c:v>
                </c:pt>
                <c:pt idx="558">
                  <c:v>673.94000240000003</c:v>
                </c:pt>
                <c:pt idx="559">
                  <c:v>674.5</c:v>
                </c:pt>
                <c:pt idx="560">
                  <c:v>675.07000730000004</c:v>
                </c:pt>
                <c:pt idx="561">
                  <c:v>675.48999019999997</c:v>
                </c:pt>
                <c:pt idx="562">
                  <c:v>676.04998780000005</c:v>
                </c:pt>
                <c:pt idx="563">
                  <c:v>676.46997069999998</c:v>
                </c:pt>
                <c:pt idx="564">
                  <c:v>677.03997800000002</c:v>
                </c:pt>
                <c:pt idx="565">
                  <c:v>677.46002199999998</c:v>
                </c:pt>
                <c:pt idx="566">
                  <c:v>678.02001949999999</c:v>
                </c:pt>
                <c:pt idx="567">
                  <c:v>678.45001219999995</c:v>
                </c:pt>
                <c:pt idx="568">
                  <c:v>679.01000980000003</c:v>
                </c:pt>
                <c:pt idx="569">
                  <c:v>679.42999269999996</c:v>
                </c:pt>
                <c:pt idx="570">
                  <c:v>680</c:v>
                </c:pt>
                <c:pt idx="571">
                  <c:v>680.57000730000004</c:v>
                </c:pt>
                <c:pt idx="572">
                  <c:v>681</c:v>
                </c:pt>
                <c:pt idx="573">
                  <c:v>681.57000730000004</c:v>
                </c:pt>
                <c:pt idx="574">
                  <c:v>682</c:v>
                </c:pt>
                <c:pt idx="575">
                  <c:v>682.57000730000004</c:v>
                </c:pt>
                <c:pt idx="576">
                  <c:v>683</c:v>
                </c:pt>
                <c:pt idx="577">
                  <c:v>683.57000730000004</c:v>
                </c:pt>
                <c:pt idx="578">
                  <c:v>684</c:v>
                </c:pt>
                <c:pt idx="579">
                  <c:v>684.57000730000004</c:v>
                </c:pt>
                <c:pt idx="580">
                  <c:v>685</c:v>
                </c:pt>
                <c:pt idx="581">
                  <c:v>685.57000730000004</c:v>
                </c:pt>
                <c:pt idx="582">
                  <c:v>686</c:v>
                </c:pt>
                <c:pt idx="583">
                  <c:v>686.57000730000004</c:v>
                </c:pt>
                <c:pt idx="584">
                  <c:v>687</c:v>
                </c:pt>
                <c:pt idx="585">
                  <c:v>687.57000730000004</c:v>
                </c:pt>
                <c:pt idx="586">
                  <c:v>688</c:v>
                </c:pt>
                <c:pt idx="587">
                  <c:v>688.57000730000004</c:v>
                </c:pt>
                <c:pt idx="588">
                  <c:v>689</c:v>
                </c:pt>
                <c:pt idx="589">
                  <c:v>689.57000730000004</c:v>
                </c:pt>
                <c:pt idx="590">
                  <c:v>690</c:v>
                </c:pt>
                <c:pt idx="591">
                  <c:v>690.55999759999997</c:v>
                </c:pt>
                <c:pt idx="592">
                  <c:v>690.97998050000001</c:v>
                </c:pt>
                <c:pt idx="593">
                  <c:v>691.53997800000002</c:v>
                </c:pt>
                <c:pt idx="594">
                  <c:v>691.96997069999998</c:v>
                </c:pt>
                <c:pt idx="595">
                  <c:v>692.53002930000002</c:v>
                </c:pt>
                <c:pt idx="596">
                  <c:v>692.95001219999995</c:v>
                </c:pt>
                <c:pt idx="597">
                  <c:v>693.52001949999999</c:v>
                </c:pt>
                <c:pt idx="598">
                  <c:v>693.94000240000003</c:v>
                </c:pt>
                <c:pt idx="599">
                  <c:v>694.5</c:v>
                </c:pt>
                <c:pt idx="600">
                  <c:v>695.07000730000004</c:v>
                </c:pt>
                <c:pt idx="601">
                  <c:v>695.48999019999997</c:v>
                </c:pt>
                <c:pt idx="602">
                  <c:v>696.04998780000005</c:v>
                </c:pt>
                <c:pt idx="603">
                  <c:v>696.46997069999998</c:v>
                </c:pt>
                <c:pt idx="604">
                  <c:v>697.03997800000002</c:v>
                </c:pt>
                <c:pt idx="605">
                  <c:v>697.46002199999998</c:v>
                </c:pt>
                <c:pt idx="606">
                  <c:v>698.02001949999999</c:v>
                </c:pt>
                <c:pt idx="607">
                  <c:v>698.45001219999995</c:v>
                </c:pt>
                <c:pt idx="608">
                  <c:v>699.01000980000003</c:v>
                </c:pt>
                <c:pt idx="609">
                  <c:v>699.42999269999996</c:v>
                </c:pt>
                <c:pt idx="610">
                  <c:v>700</c:v>
                </c:pt>
              </c:numCache>
            </c:numRef>
          </c:xVal>
          <c:yVal>
            <c:numRef>
              <c:f>AZD!$H$3:$H$613</c:f>
              <c:numCache>
                <c:formatCode>General</c:formatCode>
                <c:ptCount val="611"/>
                <c:pt idx="16">
                  <c:v>6.3762078290000002</c:v>
                </c:pt>
                <c:pt idx="17">
                  <c:v>6.6582822799999999</c:v>
                </c:pt>
                <c:pt idx="18">
                  <c:v>6.5865054130000003</c:v>
                </c:pt>
                <c:pt idx="19">
                  <c:v>5.9617681500000002</c:v>
                </c:pt>
                <c:pt idx="20">
                  <c:v>5.5383863450000002</c:v>
                </c:pt>
                <c:pt idx="21">
                  <c:v>5.0699296</c:v>
                </c:pt>
                <c:pt idx="22">
                  <c:v>4.6438059809999999</c:v>
                </c:pt>
                <c:pt idx="23">
                  <c:v>4.6529235839999998</c:v>
                </c:pt>
                <c:pt idx="24">
                  <c:v>4.3249368669999999</c:v>
                </c:pt>
                <c:pt idx="25">
                  <c:v>4.2835907940000002</c:v>
                </c:pt>
                <c:pt idx="26">
                  <c:v>4.1399903299999998</c:v>
                </c:pt>
                <c:pt idx="27">
                  <c:v>3.9645302299999998</c:v>
                </c:pt>
                <c:pt idx="28">
                  <c:v>3.6228609089999999</c:v>
                </c:pt>
                <c:pt idx="29">
                  <c:v>3.498973608</c:v>
                </c:pt>
                <c:pt idx="30">
                  <c:v>3.3702557089999998</c:v>
                </c:pt>
                <c:pt idx="31">
                  <c:v>3.339192867</c:v>
                </c:pt>
                <c:pt idx="32">
                  <c:v>3.3295419220000002</c:v>
                </c:pt>
                <c:pt idx="33">
                  <c:v>3.51938796</c:v>
                </c:pt>
                <c:pt idx="34">
                  <c:v>3.8694505690000001</c:v>
                </c:pt>
                <c:pt idx="35">
                  <c:v>3.9010531899999998</c:v>
                </c:pt>
                <c:pt idx="36">
                  <c:v>3.9130551819999999</c:v>
                </c:pt>
                <c:pt idx="37">
                  <c:v>4.2789340019999997</c:v>
                </c:pt>
                <c:pt idx="38">
                  <c:v>4.5376234049999997</c:v>
                </c:pt>
                <c:pt idx="39">
                  <c:v>4.9405093190000002</c:v>
                </c:pt>
                <c:pt idx="40">
                  <c:v>5.3502817150000004</c:v>
                </c:pt>
                <c:pt idx="41">
                  <c:v>5.665765285</c:v>
                </c:pt>
                <c:pt idx="42">
                  <c:v>6.1230936050000002</c:v>
                </c:pt>
                <c:pt idx="43">
                  <c:v>6.6721506120000003</c:v>
                </c:pt>
                <c:pt idx="44">
                  <c:v>7.2239155769999996</c:v>
                </c:pt>
                <c:pt idx="45">
                  <c:v>7.723072052</c:v>
                </c:pt>
                <c:pt idx="46">
                  <c:v>8.091477394</c:v>
                </c:pt>
                <c:pt idx="47">
                  <c:v>8.9301662450000006</c:v>
                </c:pt>
                <c:pt idx="48">
                  <c:v>9.5552921299999998</c:v>
                </c:pt>
                <c:pt idx="49">
                  <c:v>10.28301907</c:v>
                </c:pt>
                <c:pt idx="50">
                  <c:v>11.08466625</c:v>
                </c:pt>
                <c:pt idx="51">
                  <c:v>11.69324398</c:v>
                </c:pt>
                <c:pt idx="52">
                  <c:v>13.1713419</c:v>
                </c:pt>
                <c:pt idx="53">
                  <c:v>13.749738689999999</c:v>
                </c:pt>
                <c:pt idx="54">
                  <c:v>14.585002899999999</c:v>
                </c:pt>
                <c:pt idx="55">
                  <c:v>16.219308850000001</c:v>
                </c:pt>
                <c:pt idx="56">
                  <c:v>16.722862240000001</c:v>
                </c:pt>
                <c:pt idx="57">
                  <c:v>18.006423949999999</c:v>
                </c:pt>
                <c:pt idx="58">
                  <c:v>19.74516869</c:v>
                </c:pt>
                <c:pt idx="59">
                  <c:v>21.74477959</c:v>
                </c:pt>
                <c:pt idx="60">
                  <c:v>22.882869719999999</c:v>
                </c:pt>
                <c:pt idx="61">
                  <c:v>24.464756009999999</c:v>
                </c:pt>
                <c:pt idx="62">
                  <c:v>27.1770134</c:v>
                </c:pt>
                <c:pt idx="63">
                  <c:v>28.34893799</c:v>
                </c:pt>
                <c:pt idx="64">
                  <c:v>30.27661896</c:v>
                </c:pt>
                <c:pt idx="65">
                  <c:v>32.175189969999998</c:v>
                </c:pt>
                <c:pt idx="66">
                  <c:v>34.241466520000003</c:v>
                </c:pt>
                <c:pt idx="67">
                  <c:v>37.026416779999998</c:v>
                </c:pt>
                <c:pt idx="68">
                  <c:v>38.873928069999998</c:v>
                </c:pt>
                <c:pt idx="69">
                  <c:v>42.469650270000002</c:v>
                </c:pt>
                <c:pt idx="70">
                  <c:v>45.051338200000004</c:v>
                </c:pt>
                <c:pt idx="71">
                  <c:v>47.927627559999998</c:v>
                </c:pt>
                <c:pt idx="72">
                  <c:v>51.620670320000002</c:v>
                </c:pt>
                <c:pt idx="73">
                  <c:v>54.172153469999998</c:v>
                </c:pt>
                <c:pt idx="74">
                  <c:v>57.073966980000002</c:v>
                </c:pt>
                <c:pt idx="75">
                  <c:v>60.644691469999998</c:v>
                </c:pt>
                <c:pt idx="76">
                  <c:v>63.078716280000002</c:v>
                </c:pt>
                <c:pt idx="77">
                  <c:v>67.73591614</c:v>
                </c:pt>
                <c:pt idx="78">
                  <c:v>70.536155699999995</c:v>
                </c:pt>
                <c:pt idx="79">
                  <c:v>75.070716860000005</c:v>
                </c:pt>
                <c:pt idx="80">
                  <c:v>78.106964110000007</c:v>
                </c:pt>
                <c:pt idx="81">
                  <c:v>82.614334110000001</c:v>
                </c:pt>
                <c:pt idx="82">
                  <c:v>87.134536740000001</c:v>
                </c:pt>
                <c:pt idx="83">
                  <c:v>90.390228269999994</c:v>
                </c:pt>
                <c:pt idx="84">
                  <c:v>92.977737430000005</c:v>
                </c:pt>
                <c:pt idx="85">
                  <c:v>97.566719059999997</c:v>
                </c:pt>
                <c:pt idx="86">
                  <c:v>102.10196689999999</c:v>
                </c:pt>
                <c:pt idx="87">
                  <c:v>105.6388931</c:v>
                </c:pt>
                <c:pt idx="88">
                  <c:v>109.9593201</c:v>
                </c:pt>
                <c:pt idx="89">
                  <c:v>114.43254090000001</c:v>
                </c:pt>
                <c:pt idx="90">
                  <c:v>117.6537781</c:v>
                </c:pt>
                <c:pt idx="91">
                  <c:v>121.7575226</c:v>
                </c:pt>
                <c:pt idx="92">
                  <c:v>126.5522385</c:v>
                </c:pt>
                <c:pt idx="93">
                  <c:v>131.07064819999999</c:v>
                </c:pt>
                <c:pt idx="94">
                  <c:v>134.3845062</c:v>
                </c:pt>
                <c:pt idx="95">
                  <c:v>137.32324220000001</c:v>
                </c:pt>
                <c:pt idx="96">
                  <c:v>142.31758120000001</c:v>
                </c:pt>
                <c:pt idx="97">
                  <c:v>145.8453217</c:v>
                </c:pt>
                <c:pt idx="98">
                  <c:v>148.5872498</c:v>
                </c:pt>
                <c:pt idx="99">
                  <c:v>153.4078064</c:v>
                </c:pt>
                <c:pt idx="100">
                  <c:v>157.61608889999999</c:v>
                </c:pt>
                <c:pt idx="101">
                  <c:v>161.8456726</c:v>
                </c:pt>
                <c:pt idx="102">
                  <c:v>166.59426880000001</c:v>
                </c:pt>
                <c:pt idx="103">
                  <c:v>169.11924740000001</c:v>
                </c:pt>
                <c:pt idx="104">
                  <c:v>171.70040890000001</c:v>
                </c:pt>
                <c:pt idx="105">
                  <c:v>175.18299870000001</c:v>
                </c:pt>
                <c:pt idx="106">
                  <c:v>178.2961731</c:v>
                </c:pt>
                <c:pt idx="107">
                  <c:v>180.30606080000001</c:v>
                </c:pt>
                <c:pt idx="108">
                  <c:v>183.6073303</c:v>
                </c:pt>
                <c:pt idx="109">
                  <c:v>188.1724701</c:v>
                </c:pt>
                <c:pt idx="110">
                  <c:v>191.2896423</c:v>
                </c:pt>
                <c:pt idx="111">
                  <c:v>193.96830750000001</c:v>
                </c:pt>
                <c:pt idx="112">
                  <c:v>197.06144710000001</c:v>
                </c:pt>
                <c:pt idx="113">
                  <c:v>200.25820920000001</c:v>
                </c:pt>
                <c:pt idx="114">
                  <c:v>201.4107971</c:v>
                </c:pt>
                <c:pt idx="115">
                  <c:v>205.78831479999999</c:v>
                </c:pt>
                <c:pt idx="116">
                  <c:v>206.10423280000001</c:v>
                </c:pt>
                <c:pt idx="117">
                  <c:v>209.38912959999999</c:v>
                </c:pt>
                <c:pt idx="118">
                  <c:v>211.95010379999999</c:v>
                </c:pt>
                <c:pt idx="119">
                  <c:v>214.5098572</c:v>
                </c:pt>
                <c:pt idx="120">
                  <c:v>217.27447509999999</c:v>
                </c:pt>
                <c:pt idx="121">
                  <c:v>217.4030151</c:v>
                </c:pt>
                <c:pt idx="122">
                  <c:v>218.7657318</c:v>
                </c:pt>
                <c:pt idx="123">
                  <c:v>219.26123050000001</c:v>
                </c:pt>
                <c:pt idx="124">
                  <c:v>222.20666499999999</c:v>
                </c:pt>
                <c:pt idx="125">
                  <c:v>224.23599239999999</c:v>
                </c:pt>
                <c:pt idx="126">
                  <c:v>225.6850891</c:v>
                </c:pt>
                <c:pt idx="127">
                  <c:v>227.6341248</c:v>
                </c:pt>
                <c:pt idx="128">
                  <c:v>228.67385859999999</c:v>
                </c:pt>
                <c:pt idx="129">
                  <c:v>231.2928162</c:v>
                </c:pt>
                <c:pt idx="130">
                  <c:v>233.25584409999999</c:v>
                </c:pt>
                <c:pt idx="131">
                  <c:v>233.7757111</c:v>
                </c:pt>
                <c:pt idx="132">
                  <c:v>234.81892400000001</c:v>
                </c:pt>
                <c:pt idx="133">
                  <c:v>235.81301880000001</c:v>
                </c:pt>
                <c:pt idx="134">
                  <c:v>236.40911869999999</c:v>
                </c:pt>
                <c:pt idx="135">
                  <c:v>236.89295960000001</c:v>
                </c:pt>
                <c:pt idx="136">
                  <c:v>237.1975861</c:v>
                </c:pt>
                <c:pt idx="137">
                  <c:v>238.3114319</c:v>
                </c:pt>
                <c:pt idx="138">
                  <c:v>239.39167789999999</c:v>
                </c:pt>
                <c:pt idx="139">
                  <c:v>240.14433289999999</c:v>
                </c:pt>
                <c:pt idx="140">
                  <c:v>239.2735596</c:v>
                </c:pt>
                <c:pt idx="141">
                  <c:v>240.4155121</c:v>
                </c:pt>
                <c:pt idx="142">
                  <c:v>241.7144165</c:v>
                </c:pt>
                <c:pt idx="143">
                  <c:v>239.86112979999999</c:v>
                </c:pt>
                <c:pt idx="144">
                  <c:v>241.43939209999999</c:v>
                </c:pt>
                <c:pt idx="145">
                  <c:v>241.5605927</c:v>
                </c:pt>
                <c:pt idx="146">
                  <c:v>241.17134089999999</c:v>
                </c:pt>
                <c:pt idx="147">
                  <c:v>240.14057919999999</c:v>
                </c:pt>
                <c:pt idx="148">
                  <c:v>240.03913879999999</c:v>
                </c:pt>
                <c:pt idx="149">
                  <c:v>241.1697388</c:v>
                </c:pt>
                <c:pt idx="150">
                  <c:v>240.98609920000001</c:v>
                </c:pt>
                <c:pt idx="151">
                  <c:v>239.9245148</c:v>
                </c:pt>
                <c:pt idx="152">
                  <c:v>240.15272519999999</c:v>
                </c:pt>
                <c:pt idx="153">
                  <c:v>239.7175751</c:v>
                </c:pt>
                <c:pt idx="154">
                  <c:v>239.44224550000001</c:v>
                </c:pt>
                <c:pt idx="155">
                  <c:v>237.08393860000001</c:v>
                </c:pt>
                <c:pt idx="156">
                  <c:v>237.32060240000001</c:v>
                </c:pt>
                <c:pt idx="157">
                  <c:v>237.53829959999999</c:v>
                </c:pt>
                <c:pt idx="158">
                  <c:v>236.06762699999999</c:v>
                </c:pt>
                <c:pt idx="159">
                  <c:v>235.0499725</c:v>
                </c:pt>
                <c:pt idx="160">
                  <c:v>234.78266909999999</c:v>
                </c:pt>
                <c:pt idx="161">
                  <c:v>233.94613649999999</c:v>
                </c:pt>
                <c:pt idx="162">
                  <c:v>231.93478390000001</c:v>
                </c:pt>
                <c:pt idx="163">
                  <c:v>230.84091190000001</c:v>
                </c:pt>
                <c:pt idx="164">
                  <c:v>228.95819090000001</c:v>
                </c:pt>
                <c:pt idx="165">
                  <c:v>227.6680145</c:v>
                </c:pt>
                <c:pt idx="166">
                  <c:v>226.34767149999999</c:v>
                </c:pt>
                <c:pt idx="167">
                  <c:v>224.6987762</c:v>
                </c:pt>
                <c:pt idx="168">
                  <c:v>223.97930909999999</c:v>
                </c:pt>
                <c:pt idx="169">
                  <c:v>223.58781429999999</c:v>
                </c:pt>
                <c:pt idx="170">
                  <c:v>220.07316589999999</c:v>
                </c:pt>
                <c:pt idx="171">
                  <c:v>220.3478088</c:v>
                </c:pt>
                <c:pt idx="172">
                  <c:v>218.5763092</c:v>
                </c:pt>
                <c:pt idx="173">
                  <c:v>217.13394170000001</c:v>
                </c:pt>
                <c:pt idx="174">
                  <c:v>216.6187286</c:v>
                </c:pt>
                <c:pt idx="175">
                  <c:v>214.52641299999999</c:v>
                </c:pt>
                <c:pt idx="176">
                  <c:v>213.1057739</c:v>
                </c:pt>
                <c:pt idx="177">
                  <c:v>213.2377319</c:v>
                </c:pt>
                <c:pt idx="178">
                  <c:v>209.99403380000001</c:v>
                </c:pt>
                <c:pt idx="179">
                  <c:v>209.70617680000001</c:v>
                </c:pt>
                <c:pt idx="180">
                  <c:v>206.22648620000001</c:v>
                </c:pt>
                <c:pt idx="181">
                  <c:v>205.9700928</c:v>
                </c:pt>
                <c:pt idx="182">
                  <c:v>203.30905150000001</c:v>
                </c:pt>
                <c:pt idx="183">
                  <c:v>202.8330383</c:v>
                </c:pt>
                <c:pt idx="184">
                  <c:v>199.9963989</c:v>
                </c:pt>
                <c:pt idx="185">
                  <c:v>198.81884769999999</c:v>
                </c:pt>
                <c:pt idx="186">
                  <c:v>197.03062439999999</c:v>
                </c:pt>
                <c:pt idx="187">
                  <c:v>194.4150391</c:v>
                </c:pt>
                <c:pt idx="188">
                  <c:v>193.83163450000001</c:v>
                </c:pt>
                <c:pt idx="189">
                  <c:v>192.28019710000001</c:v>
                </c:pt>
                <c:pt idx="190">
                  <c:v>188.49237059999999</c:v>
                </c:pt>
                <c:pt idx="191">
                  <c:v>188.5309906</c:v>
                </c:pt>
                <c:pt idx="192">
                  <c:v>186.9499817</c:v>
                </c:pt>
                <c:pt idx="193">
                  <c:v>184.90873719999999</c:v>
                </c:pt>
                <c:pt idx="194">
                  <c:v>181.74972529999999</c:v>
                </c:pt>
                <c:pt idx="195">
                  <c:v>180.28001399999999</c:v>
                </c:pt>
                <c:pt idx="196">
                  <c:v>179.89860530000001</c:v>
                </c:pt>
                <c:pt idx="197">
                  <c:v>176.4937439</c:v>
                </c:pt>
                <c:pt idx="198">
                  <c:v>175.6184998</c:v>
                </c:pt>
                <c:pt idx="199">
                  <c:v>172.87492370000001</c:v>
                </c:pt>
                <c:pt idx="200">
                  <c:v>171.30728149999999</c:v>
                </c:pt>
                <c:pt idx="201">
                  <c:v>168.97911070000001</c:v>
                </c:pt>
                <c:pt idx="202">
                  <c:v>167.22050479999999</c:v>
                </c:pt>
                <c:pt idx="203">
                  <c:v>166.2511902</c:v>
                </c:pt>
                <c:pt idx="204">
                  <c:v>164.08511350000001</c:v>
                </c:pt>
                <c:pt idx="205">
                  <c:v>161.86412050000001</c:v>
                </c:pt>
                <c:pt idx="206">
                  <c:v>160.3280182</c:v>
                </c:pt>
                <c:pt idx="207">
                  <c:v>159.41313170000001</c:v>
                </c:pt>
                <c:pt idx="208">
                  <c:v>156.46966549999999</c:v>
                </c:pt>
                <c:pt idx="209">
                  <c:v>154.11508180000001</c:v>
                </c:pt>
                <c:pt idx="210">
                  <c:v>154.20521550000001</c:v>
                </c:pt>
                <c:pt idx="211">
                  <c:v>152.17218020000001</c:v>
                </c:pt>
                <c:pt idx="212">
                  <c:v>151.16419980000001</c:v>
                </c:pt>
                <c:pt idx="213">
                  <c:v>148.81170650000001</c:v>
                </c:pt>
                <c:pt idx="214">
                  <c:v>146.5193634</c:v>
                </c:pt>
                <c:pt idx="215">
                  <c:v>144.54069519999999</c:v>
                </c:pt>
                <c:pt idx="216">
                  <c:v>141.97914119999999</c:v>
                </c:pt>
                <c:pt idx="217">
                  <c:v>140.32614140000001</c:v>
                </c:pt>
                <c:pt idx="218">
                  <c:v>137.89035029999999</c:v>
                </c:pt>
                <c:pt idx="219">
                  <c:v>137.22599790000001</c:v>
                </c:pt>
                <c:pt idx="220">
                  <c:v>135.55345149999999</c:v>
                </c:pt>
                <c:pt idx="221">
                  <c:v>133.74205019999999</c:v>
                </c:pt>
                <c:pt idx="222">
                  <c:v>132.5209045</c:v>
                </c:pt>
                <c:pt idx="223">
                  <c:v>130.4110718</c:v>
                </c:pt>
                <c:pt idx="224">
                  <c:v>130.4687653</c:v>
                </c:pt>
                <c:pt idx="225">
                  <c:v>126.9840775</c:v>
                </c:pt>
                <c:pt idx="226">
                  <c:v>124.5911102</c:v>
                </c:pt>
                <c:pt idx="227">
                  <c:v>124.8322067</c:v>
                </c:pt>
                <c:pt idx="228">
                  <c:v>122.4178314</c:v>
                </c:pt>
                <c:pt idx="229">
                  <c:v>121.00958249999999</c:v>
                </c:pt>
                <c:pt idx="230">
                  <c:v>119.1182404</c:v>
                </c:pt>
                <c:pt idx="231">
                  <c:v>118.7090302</c:v>
                </c:pt>
                <c:pt idx="232">
                  <c:v>115.44071959999999</c:v>
                </c:pt>
                <c:pt idx="233">
                  <c:v>113.9983063</c:v>
                </c:pt>
                <c:pt idx="234">
                  <c:v>112.61132809999999</c:v>
                </c:pt>
                <c:pt idx="235">
                  <c:v>111.33223719999999</c:v>
                </c:pt>
                <c:pt idx="236">
                  <c:v>111.01696010000001</c:v>
                </c:pt>
                <c:pt idx="237">
                  <c:v>108.9086685</c:v>
                </c:pt>
                <c:pt idx="238">
                  <c:v>107.33556369999999</c:v>
                </c:pt>
                <c:pt idx="239">
                  <c:v>105.9984055</c:v>
                </c:pt>
                <c:pt idx="240">
                  <c:v>104.0037155</c:v>
                </c:pt>
                <c:pt idx="241">
                  <c:v>103.0327377</c:v>
                </c:pt>
                <c:pt idx="242">
                  <c:v>101.3394241</c:v>
                </c:pt>
                <c:pt idx="243">
                  <c:v>100.52207180000001</c:v>
                </c:pt>
                <c:pt idx="244">
                  <c:v>97.933677669999994</c:v>
                </c:pt>
                <c:pt idx="245">
                  <c:v>96.607528689999995</c:v>
                </c:pt>
                <c:pt idx="246">
                  <c:v>95.430809019999998</c:v>
                </c:pt>
                <c:pt idx="247">
                  <c:v>94.586105349999997</c:v>
                </c:pt>
                <c:pt idx="248">
                  <c:v>93.882499690000003</c:v>
                </c:pt>
                <c:pt idx="249">
                  <c:v>91.961265560000001</c:v>
                </c:pt>
                <c:pt idx="250">
                  <c:v>90.375556950000004</c:v>
                </c:pt>
                <c:pt idx="251">
                  <c:v>89.076454159999997</c:v>
                </c:pt>
                <c:pt idx="252">
                  <c:v>88.115501399999999</c:v>
                </c:pt>
                <c:pt idx="253">
                  <c:v>87.403228760000005</c:v>
                </c:pt>
                <c:pt idx="254">
                  <c:v>85.649108889999994</c:v>
                </c:pt>
                <c:pt idx="255">
                  <c:v>84.787994380000001</c:v>
                </c:pt>
                <c:pt idx="256">
                  <c:v>83.304664610000003</c:v>
                </c:pt>
                <c:pt idx="257">
                  <c:v>82.208473209999994</c:v>
                </c:pt>
                <c:pt idx="258">
                  <c:v>81.287773130000005</c:v>
                </c:pt>
                <c:pt idx="259">
                  <c:v>79.755966189999995</c:v>
                </c:pt>
                <c:pt idx="260">
                  <c:v>78.18325806</c:v>
                </c:pt>
                <c:pt idx="261">
                  <c:v>78.118949889999996</c:v>
                </c:pt>
                <c:pt idx="262">
                  <c:v>77.119087219999997</c:v>
                </c:pt>
                <c:pt idx="263">
                  <c:v>75.460136410000004</c:v>
                </c:pt>
                <c:pt idx="264">
                  <c:v>74.660285950000002</c:v>
                </c:pt>
                <c:pt idx="265">
                  <c:v>74.076217650000004</c:v>
                </c:pt>
                <c:pt idx="266">
                  <c:v>73.198028559999997</c:v>
                </c:pt>
                <c:pt idx="267">
                  <c:v>72.471000669999995</c:v>
                </c:pt>
                <c:pt idx="268">
                  <c:v>71.04200745</c:v>
                </c:pt>
                <c:pt idx="269">
                  <c:v>68.898529049999993</c:v>
                </c:pt>
                <c:pt idx="270">
                  <c:v>68.174896239999995</c:v>
                </c:pt>
                <c:pt idx="271">
                  <c:v>67.056732179999997</c:v>
                </c:pt>
                <c:pt idx="272">
                  <c:v>66.695510859999999</c:v>
                </c:pt>
                <c:pt idx="273">
                  <c:v>65.586524960000006</c:v>
                </c:pt>
                <c:pt idx="274">
                  <c:v>64.073959349999996</c:v>
                </c:pt>
                <c:pt idx="275">
                  <c:v>63.789131159999997</c:v>
                </c:pt>
                <c:pt idx="276">
                  <c:v>62.208347320000001</c:v>
                </c:pt>
                <c:pt idx="277">
                  <c:v>61.133018489999998</c:v>
                </c:pt>
                <c:pt idx="278">
                  <c:v>61.231986999999997</c:v>
                </c:pt>
                <c:pt idx="279">
                  <c:v>58.775054930000003</c:v>
                </c:pt>
                <c:pt idx="280">
                  <c:v>58.345932009999999</c:v>
                </c:pt>
                <c:pt idx="281">
                  <c:v>57.708148960000003</c:v>
                </c:pt>
                <c:pt idx="282">
                  <c:v>56.955818180000001</c:v>
                </c:pt>
                <c:pt idx="283">
                  <c:v>56.376182559999997</c:v>
                </c:pt>
                <c:pt idx="284">
                  <c:v>55.35307693</c:v>
                </c:pt>
                <c:pt idx="285">
                  <c:v>54.418743130000003</c:v>
                </c:pt>
                <c:pt idx="286">
                  <c:v>54.028808589999997</c:v>
                </c:pt>
                <c:pt idx="287">
                  <c:v>52.908683779999997</c:v>
                </c:pt>
                <c:pt idx="288">
                  <c:v>52.462039949999998</c:v>
                </c:pt>
                <c:pt idx="289">
                  <c:v>51.531772609999997</c:v>
                </c:pt>
                <c:pt idx="290">
                  <c:v>50.935989380000002</c:v>
                </c:pt>
                <c:pt idx="291">
                  <c:v>50.348609920000001</c:v>
                </c:pt>
                <c:pt idx="292">
                  <c:v>48.925842289999999</c:v>
                </c:pt>
                <c:pt idx="293">
                  <c:v>48.671985630000002</c:v>
                </c:pt>
                <c:pt idx="294">
                  <c:v>47.357551569999998</c:v>
                </c:pt>
                <c:pt idx="295">
                  <c:v>46.630470279999997</c:v>
                </c:pt>
                <c:pt idx="296">
                  <c:v>46.38677216</c:v>
                </c:pt>
                <c:pt idx="297">
                  <c:v>45.480472560000003</c:v>
                </c:pt>
                <c:pt idx="298">
                  <c:v>44.741432189999998</c:v>
                </c:pt>
                <c:pt idx="299">
                  <c:v>43.977546689999997</c:v>
                </c:pt>
                <c:pt idx="300">
                  <c:v>42.779396060000003</c:v>
                </c:pt>
                <c:pt idx="301">
                  <c:v>42.391838069999999</c:v>
                </c:pt>
                <c:pt idx="302">
                  <c:v>41.290878300000003</c:v>
                </c:pt>
                <c:pt idx="303">
                  <c:v>40.889888759999998</c:v>
                </c:pt>
                <c:pt idx="304">
                  <c:v>40.205497739999998</c:v>
                </c:pt>
                <c:pt idx="305">
                  <c:v>39.635608670000003</c:v>
                </c:pt>
                <c:pt idx="306">
                  <c:v>39.46243286</c:v>
                </c:pt>
                <c:pt idx="307">
                  <c:v>38.404506679999997</c:v>
                </c:pt>
                <c:pt idx="308">
                  <c:v>37.800525669999999</c:v>
                </c:pt>
                <c:pt idx="309">
                  <c:v>37.363624569999999</c:v>
                </c:pt>
                <c:pt idx="310">
                  <c:v>36.529880519999999</c:v>
                </c:pt>
                <c:pt idx="311">
                  <c:v>36.25638962</c:v>
                </c:pt>
                <c:pt idx="312">
                  <c:v>35.461528780000002</c:v>
                </c:pt>
                <c:pt idx="313">
                  <c:v>34.905178069999998</c:v>
                </c:pt>
                <c:pt idx="314">
                  <c:v>34.97405243</c:v>
                </c:pt>
                <c:pt idx="315">
                  <c:v>33.420368189999998</c:v>
                </c:pt>
                <c:pt idx="316">
                  <c:v>33.971660610000001</c:v>
                </c:pt>
                <c:pt idx="317">
                  <c:v>33.150249479999999</c:v>
                </c:pt>
                <c:pt idx="318">
                  <c:v>32.564407350000003</c:v>
                </c:pt>
                <c:pt idx="319">
                  <c:v>31.563177110000002</c:v>
                </c:pt>
                <c:pt idx="320">
                  <c:v>31.041225430000001</c:v>
                </c:pt>
                <c:pt idx="321">
                  <c:v>30.326904299999999</c:v>
                </c:pt>
                <c:pt idx="322">
                  <c:v>29.851158139999999</c:v>
                </c:pt>
                <c:pt idx="323">
                  <c:v>29.606346129999999</c:v>
                </c:pt>
                <c:pt idx="324">
                  <c:v>29.534465789999999</c:v>
                </c:pt>
                <c:pt idx="325">
                  <c:v>28.558601379999999</c:v>
                </c:pt>
                <c:pt idx="326">
                  <c:v>28.986953740000001</c:v>
                </c:pt>
                <c:pt idx="327">
                  <c:v>27.73123932</c:v>
                </c:pt>
                <c:pt idx="328">
                  <c:v>27.82358932</c:v>
                </c:pt>
                <c:pt idx="329">
                  <c:v>26.92030716</c:v>
                </c:pt>
                <c:pt idx="330">
                  <c:v>26.663276669999998</c:v>
                </c:pt>
                <c:pt idx="331">
                  <c:v>26.13928795</c:v>
                </c:pt>
                <c:pt idx="332">
                  <c:v>25.702404019999999</c:v>
                </c:pt>
                <c:pt idx="333">
                  <c:v>25.459270480000001</c:v>
                </c:pt>
                <c:pt idx="334">
                  <c:v>25.051837920000001</c:v>
                </c:pt>
                <c:pt idx="335">
                  <c:v>24.478893280000001</c:v>
                </c:pt>
                <c:pt idx="336">
                  <c:v>23.973224640000002</c:v>
                </c:pt>
                <c:pt idx="337">
                  <c:v>23.603174209999999</c:v>
                </c:pt>
                <c:pt idx="338">
                  <c:v>23.22754097</c:v>
                </c:pt>
                <c:pt idx="339">
                  <c:v>23.159254069999999</c:v>
                </c:pt>
                <c:pt idx="340">
                  <c:v>22.42870903</c:v>
                </c:pt>
                <c:pt idx="341">
                  <c:v>21.88336945</c:v>
                </c:pt>
                <c:pt idx="342">
                  <c:v>21.899717330000001</c:v>
                </c:pt>
                <c:pt idx="343">
                  <c:v>21.73965836</c:v>
                </c:pt>
                <c:pt idx="344">
                  <c:v>21.368011469999999</c:v>
                </c:pt>
                <c:pt idx="345">
                  <c:v>20.687143330000001</c:v>
                </c:pt>
                <c:pt idx="346">
                  <c:v>20.755844119999999</c:v>
                </c:pt>
                <c:pt idx="347">
                  <c:v>20.1349926</c:v>
                </c:pt>
                <c:pt idx="348">
                  <c:v>19.731395719999998</c:v>
                </c:pt>
                <c:pt idx="349">
                  <c:v>19.44407082</c:v>
                </c:pt>
                <c:pt idx="350">
                  <c:v>19.29573822</c:v>
                </c:pt>
                <c:pt idx="351">
                  <c:v>18.95205498</c:v>
                </c:pt>
                <c:pt idx="352">
                  <c:v>18.59100342</c:v>
                </c:pt>
                <c:pt idx="353">
                  <c:v>18.037786480000001</c:v>
                </c:pt>
                <c:pt idx="354">
                  <c:v>17.68997383</c:v>
                </c:pt>
                <c:pt idx="355">
                  <c:v>17.73856163</c:v>
                </c:pt>
                <c:pt idx="356">
                  <c:v>17.275863650000002</c:v>
                </c:pt>
                <c:pt idx="357">
                  <c:v>17.152359010000001</c:v>
                </c:pt>
                <c:pt idx="358">
                  <c:v>16.76924515</c:v>
                </c:pt>
                <c:pt idx="359">
                  <c:v>16.42879868</c:v>
                </c:pt>
                <c:pt idx="360">
                  <c:v>16.328235630000002</c:v>
                </c:pt>
                <c:pt idx="361">
                  <c:v>16.388240809999999</c:v>
                </c:pt>
                <c:pt idx="362">
                  <c:v>15.76275349</c:v>
                </c:pt>
                <c:pt idx="363">
                  <c:v>15.131533620000001</c:v>
                </c:pt>
                <c:pt idx="364">
                  <c:v>15.247980119999999</c:v>
                </c:pt>
                <c:pt idx="365">
                  <c:v>15.124045369999999</c:v>
                </c:pt>
                <c:pt idx="366">
                  <c:v>14.73506355</c:v>
                </c:pt>
                <c:pt idx="367">
                  <c:v>14.601662640000001</c:v>
                </c:pt>
                <c:pt idx="368">
                  <c:v>14.286412240000001</c:v>
                </c:pt>
                <c:pt idx="369">
                  <c:v>14.013222689999999</c:v>
                </c:pt>
                <c:pt idx="370">
                  <c:v>13.896571160000001</c:v>
                </c:pt>
                <c:pt idx="371">
                  <c:v>14.03064442</c:v>
                </c:pt>
                <c:pt idx="372">
                  <c:v>13.563103679999999</c:v>
                </c:pt>
                <c:pt idx="373">
                  <c:v>13.035794259999999</c:v>
                </c:pt>
                <c:pt idx="374">
                  <c:v>12.93805122</c:v>
                </c:pt>
                <c:pt idx="375">
                  <c:v>12.64025784</c:v>
                </c:pt>
                <c:pt idx="376">
                  <c:v>12.61408806</c:v>
                </c:pt>
                <c:pt idx="377">
                  <c:v>12.324762339999999</c:v>
                </c:pt>
                <c:pt idx="378">
                  <c:v>12.13676167</c:v>
                </c:pt>
                <c:pt idx="379">
                  <c:v>12.138137820000001</c:v>
                </c:pt>
                <c:pt idx="380">
                  <c:v>11.72850513</c:v>
                </c:pt>
                <c:pt idx="381">
                  <c:v>11.621910099999999</c:v>
                </c:pt>
                <c:pt idx="382">
                  <c:v>11.36445236</c:v>
                </c:pt>
                <c:pt idx="383">
                  <c:v>11.36587048</c:v>
                </c:pt>
                <c:pt idx="384">
                  <c:v>11.10164928</c:v>
                </c:pt>
                <c:pt idx="385">
                  <c:v>10.82086277</c:v>
                </c:pt>
                <c:pt idx="386">
                  <c:v>10.55743217</c:v>
                </c:pt>
                <c:pt idx="387">
                  <c:v>10.54184914</c:v>
                </c:pt>
                <c:pt idx="388">
                  <c:v>10.237668040000001</c:v>
                </c:pt>
                <c:pt idx="389">
                  <c:v>10.180388450000001</c:v>
                </c:pt>
                <c:pt idx="390">
                  <c:v>10.133105280000001</c:v>
                </c:pt>
                <c:pt idx="391">
                  <c:v>9.7393178939999991</c:v>
                </c:pt>
                <c:pt idx="392">
                  <c:v>9.8394174579999998</c:v>
                </c:pt>
                <c:pt idx="393">
                  <c:v>9.4962654109999995</c:v>
                </c:pt>
                <c:pt idx="394">
                  <c:v>9.587661743</c:v>
                </c:pt>
                <c:pt idx="395">
                  <c:v>9.2154722210000006</c:v>
                </c:pt>
                <c:pt idx="396">
                  <c:v>9.1560926439999992</c:v>
                </c:pt>
                <c:pt idx="397">
                  <c:v>8.9993381499999998</c:v>
                </c:pt>
                <c:pt idx="398">
                  <c:v>8.6927490229999993</c:v>
                </c:pt>
                <c:pt idx="399">
                  <c:v>8.7101793290000007</c:v>
                </c:pt>
                <c:pt idx="400">
                  <c:v>8.6302757260000007</c:v>
                </c:pt>
                <c:pt idx="401">
                  <c:v>8.5837297439999993</c:v>
                </c:pt>
                <c:pt idx="402">
                  <c:v>8.2850637440000003</c:v>
                </c:pt>
                <c:pt idx="403">
                  <c:v>7.8714637759999997</c:v>
                </c:pt>
                <c:pt idx="404">
                  <c:v>7.6747779850000004</c:v>
                </c:pt>
                <c:pt idx="405">
                  <c:v>7.8228554729999997</c:v>
                </c:pt>
                <c:pt idx="406">
                  <c:v>7.552514553</c:v>
                </c:pt>
                <c:pt idx="407">
                  <c:v>7.3214087489999997</c:v>
                </c:pt>
                <c:pt idx="408">
                  <c:v>7.3977828030000001</c:v>
                </c:pt>
                <c:pt idx="409">
                  <c:v>7.326464176</c:v>
                </c:pt>
                <c:pt idx="410">
                  <c:v>7.1586213110000001</c:v>
                </c:pt>
                <c:pt idx="411">
                  <c:v>6.9890604019999998</c:v>
                </c:pt>
                <c:pt idx="412">
                  <c:v>6.7019209860000002</c:v>
                </c:pt>
                <c:pt idx="413">
                  <c:v>6.8327975270000003</c:v>
                </c:pt>
                <c:pt idx="414">
                  <c:v>6.6385931969999996</c:v>
                </c:pt>
                <c:pt idx="415">
                  <c:v>6.5870394709999998</c:v>
                </c:pt>
                <c:pt idx="416">
                  <c:v>6.4324154849999999</c:v>
                </c:pt>
                <c:pt idx="417">
                  <c:v>6.4651670460000004</c:v>
                </c:pt>
                <c:pt idx="418">
                  <c:v>6.1978392600000003</c:v>
                </c:pt>
                <c:pt idx="419">
                  <c:v>6.2604131699999996</c:v>
                </c:pt>
                <c:pt idx="420">
                  <c:v>6.1942286490000003</c:v>
                </c:pt>
                <c:pt idx="421">
                  <c:v>6.1451268199999998</c:v>
                </c:pt>
                <c:pt idx="422">
                  <c:v>6.0085735319999998</c:v>
                </c:pt>
                <c:pt idx="423">
                  <c:v>5.6954998970000004</c:v>
                </c:pt>
                <c:pt idx="424">
                  <c:v>5.7604284290000001</c:v>
                </c:pt>
                <c:pt idx="425">
                  <c:v>5.6161923409999996</c:v>
                </c:pt>
                <c:pt idx="426">
                  <c:v>5.5881247519999997</c:v>
                </c:pt>
                <c:pt idx="427">
                  <c:v>5.4543600080000001</c:v>
                </c:pt>
                <c:pt idx="428">
                  <c:v>5.2148208619999998</c:v>
                </c:pt>
                <c:pt idx="429">
                  <c:v>5.0010623929999998</c:v>
                </c:pt>
                <c:pt idx="430">
                  <c:v>5.1584820750000002</c:v>
                </c:pt>
                <c:pt idx="431">
                  <c:v>5.0052704810000002</c:v>
                </c:pt>
                <c:pt idx="432">
                  <c:v>5.0141639710000003</c:v>
                </c:pt>
                <c:pt idx="433">
                  <c:v>5.063458443</c:v>
                </c:pt>
                <c:pt idx="434">
                  <c:v>4.7741165160000003</c:v>
                </c:pt>
                <c:pt idx="435">
                  <c:v>4.7254366870000002</c:v>
                </c:pt>
                <c:pt idx="436">
                  <c:v>4.6415905950000003</c:v>
                </c:pt>
                <c:pt idx="437">
                  <c:v>4.5417079930000002</c:v>
                </c:pt>
                <c:pt idx="438">
                  <c:v>4.638563156</c:v>
                </c:pt>
                <c:pt idx="439">
                  <c:v>4.5012803080000001</c:v>
                </c:pt>
                <c:pt idx="440">
                  <c:v>4.4761052130000003</c:v>
                </c:pt>
                <c:pt idx="441">
                  <c:v>4.2683887479999996</c:v>
                </c:pt>
                <c:pt idx="442">
                  <c:v>4.197874069</c:v>
                </c:pt>
                <c:pt idx="443">
                  <c:v>4.1504154209999999</c:v>
                </c:pt>
                <c:pt idx="444">
                  <c:v>4.138183594</c:v>
                </c:pt>
                <c:pt idx="445">
                  <c:v>4.1335382459999996</c:v>
                </c:pt>
                <c:pt idx="446">
                  <c:v>4.0814075470000004</c:v>
                </c:pt>
                <c:pt idx="447">
                  <c:v>3.8956136699999999</c:v>
                </c:pt>
                <c:pt idx="448">
                  <c:v>3.86626482</c:v>
                </c:pt>
                <c:pt idx="449">
                  <c:v>3.6315705779999998</c:v>
                </c:pt>
                <c:pt idx="450">
                  <c:v>3.7612571720000001</c:v>
                </c:pt>
                <c:pt idx="451">
                  <c:v>3.6138138770000001</c:v>
                </c:pt>
                <c:pt idx="452">
                  <c:v>3.665977716</c:v>
                </c:pt>
                <c:pt idx="453">
                  <c:v>3.4795606139999999</c:v>
                </c:pt>
                <c:pt idx="454">
                  <c:v>3.5340743059999999</c:v>
                </c:pt>
                <c:pt idx="455">
                  <c:v>3.453061581</c:v>
                </c:pt>
                <c:pt idx="456">
                  <c:v>3.322242975</c:v>
                </c:pt>
                <c:pt idx="457">
                  <c:v>3.172719479</c:v>
                </c:pt>
                <c:pt idx="458">
                  <c:v>3.2434773450000001</c:v>
                </c:pt>
                <c:pt idx="459">
                  <c:v>3.0490062240000002</c:v>
                </c:pt>
                <c:pt idx="460">
                  <c:v>3.2774262429999999</c:v>
                </c:pt>
                <c:pt idx="461">
                  <c:v>3.0375471119999999</c:v>
                </c:pt>
                <c:pt idx="462">
                  <c:v>3.1055071349999999</c:v>
                </c:pt>
                <c:pt idx="463">
                  <c:v>2.822503567</c:v>
                </c:pt>
                <c:pt idx="464">
                  <c:v>2.8797976969999999</c:v>
                </c:pt>
                <c:pt idx="465">
                  <c:v>2.8941068649999999</c:v>
                </c:pt>
                <c:pt idx="466">
                  <c:v>2.7810459139999999</c:v>
                </c:pt>
                <c:pt idx="467">
                  <c:v>2.6613402370000001</c:v>
                </c:pt>
                <c:pt idx="468">
                  <c:v>2.7730503080000002</c:v>
                </c:pt>
                <c:pt idx="469">
                  <c:v>2.7546517850000001</c:v>
                </c:pt>
                <c:pt idx="470">
                  <c:v>2.7073726649999998</c:v>
                </c:pt>
                <c:pt idx="471">
                  <c:v>2.5891771320000001</c:v>
                </c:pt>
                <c:pt idx="472">
                  <c:v>2.4082427019999999</c:v>
                </c:pt>
                <c:pt idx="473">
                  <c:v>2.6356272700000001</c:v>
                </c:pt>
                <c:pt idx="474">
                  <c:v>2.4898900990000001</c:v>
                </c:pt>
                <c:pt idx="475">
                  <c:v>2.5242192750000001</c:v>
                </c:pt>
                <c:pt idx="476">
                  <c:v>2.4436395169999998</c:v>
                </c:pt>
                <c:pt idx="477">
                  <c:v>2.343231678</c:v>
                </c:pt>
                <c:pt idx="478">
                  <c:v>2.4387304780000001</c:v>
                </c:pt>
                <c:pt idx="479">
                  <c:v>2.325661421</c:v>
                </c:pt>
                <c:pt idx="480">
                  <c:v>2.2606782910000001</c:v>
                </c:pt>
                <c:pt idx="481">
                  <c:v>2.083514214</c:v>
                </c:pt>
                <c:pt idx="482">
                  <c:v>2.101577282</c:v>
                </c:pt>
                <c:pt idx="483">
                  <c:v>2.253922701</c:v>
                </c:pt>
                <c:pt idx="484">
                  <c:v>2.0853238109999999</c:v>
                </c:pt>
                <c:pt idx="485">
                  <c:v>2.0963599679999998</c:v>
                </c:pt>
                <c:pt idx="486">
                  <c:v>1.970852971</c:v>
                </c:pt>
                <c:pt idx="487">
                  <c:v>2.047162771</c:v>
                </c:pt>
                <c:pt idx="488">
                  <c:v>2.0918498040000002</c:v>
                </c:pt>
                <c:pt idx="489">
                  <c:v>1.983116627</c:v>
                </c:pt>
                <c:pt idx="490">
                  <c:v>2.104692698</c:v>
                </c:pt>
                <c:pt idx="491">
                  <c:v>1.955836535</c:v>
                </c:pt>
                <c:pt idx="492">
                  <c:v>1.8180052040000001</c:v>
                </c:pt>
                <c:pt idx="493">
                  <c:v>1.9109845160000001</c:v>
                </c:pt>
                <c:pt idx="494">
                  <c:v>1.8259687419999999</c:v>
                </c:pt>
                <c:pt idx="495">
                  <c:v>1.827242136</c:v>
                </c:pt>
                <c:pt idx="496">
                  <c:v>1.65809238</c:v>
                </c:pt>
                <c:pt idx="497">
                  <c:v>1.6648335460000001</c:v>
                </c:pt>
                <c:pt idx="498">
                  <c:v>1.7554267640000001</c:v>
                </c:pt>
                <c:pt idx="499">
                  <c:v>1.595929623</c:v>
                </c:pt>
                <c:pt idx="500">
                  <c:v>1.695915461</c:v>
                </c:pt>
                <c:pt idx="501">
                  <c:v>1.5482784510000001</c:v>
                </c:pt>
                <c:pt idx="502">
                  <c:v>1.512554288</c:v>
                </c:pt>
                <c:pt idx="503">
                  <c:v>1.568457961</c:v>
                </c:pt>
                <c:pt idx="504">
                  <c:v>1.54414165</c:v>
                </c:pt>
                <c:pt idx="505">
                  <c:v>1.471903682</c:v>
                </c:pt>
                <c:pt idx="506">
                  <c:v>1.5120975969999999</c:v>
                </c:pt>
                <c:pt idx="507">
                  <c:v>1.3816845419999999</c:v>
                </c:pt>
                <c:pt idx="508">
                  <c:v>1.4764974120000001</c:v>
                </c:pt>
                <c:pt idx="509">
                  <c:v>1.4206597809999999</c:v>
                </c:pt>
                <c:pt idx="510">
                  <c:v>1.4062514310000001</c:v>
                </c:pt>
                <c:pt idx="511">
                  <c:v>1.350890398</c:v>
                </c:pt>
                <c:pt idx="512">
                  <c:v>1.400097132</c:v>
                </c:pt>
                <c:pt idx="513">
                  <c:v>1.362137318</c:v>
                </c:pt>
                <c:pt idx="514">
                  <c:v>1.267544985</c:v>
                </c:pt>
                <c:pt idx="515">
                  <c:v>1.3118928670000001</c:v>
                </c:pt>
                <c:pt idx="516">
                  <c:v>1.2665853499999999</c:v>
                </c:pt>
                <c:pt idx="517">
                  <c:v>1.1730626820000001</c:v>
                </c:pt>
                <c:pt idx="518">
                  <c:v>1.1998207569999999</c:v>
                </c:pt>
                <c:pt idx="519">
                  <c:v>1.2139729260000001</c:v>
                </c:pt>
                <c:pt idx="520">
                  <c:v>1.1633146999999999</c:v>
                </c:pt>
                <c:pt idx="521">
                  <c:v>1.172143817</c:v>
                </c:pt>
                <c:pt idx="522">
                  <c:v>1.1985312699999999</c:v>
                </c:pt>
                <c:pt idx="523">
                  <c:v>1.0906170610000001</c:v>
                </c:pt>
                <c:pt idx="524">
                  <c:v>1.0777275559999999</c:v>
                </c:pt>
                <c:pt idx="525">
                  <c:v>1.1119885439999999</c:v>
                </c:pt>
                <c:pt idx="526">
                  <c:v>1.0957143309999999</c:v>
                </c:pt>
                <c:pt idx="527">
                  <c:v>1.0478454829999999</c:v>
                </c:pt>
                <c:pt idx="528">
                  <c:v>1.046356678</c:v>
                </c:pt>
                <c:pt idx="529">
                  <c:v>1.0661906000000001</c:v>
                </c:pt>
                <c:pt idx="530">
                  <c:v>1.0182212589999999</c:v>
                </c:pt>
                <c:pt idx="531">
                  <c:v>1.04301548</c:v>
                </c:pt>
                <c:pt idx="532">
                  <c:v>0.91879564520000001</c:v>
                </c:pt>
                <c:pt idx="533">
                  <c:v>0.94871884579999999</c:v>
                </c:pt>
                <c:pt idx="534">
                  <c:v>0.91169840099999999</c:v>
                </c:pt>
                <c:pt idx="535">
                  <c:v>0.92298018930000003</c:v>
                </c:pt>
                <c:pt idx="536">
                  <c:v>0.87500566239999999</c:v>
                </c:pt>
                <c:pt idx="537">
                  <c:v>0.95509898660000003</c:v>
                </c:pt>
                <c:pt idx="538">
                  <c:v>0.91128641369999996</c:v>
                </c:pt>
                <c:pt idx="539">
                  <c:v>0.93120086189999995</c:v>
                </c:pt>
                <c:pt idx="540">
                  <c:v>0.87559318539999997</c:v>
                </c:pt>
                <c:pt idx="541">
                  <c:v>0.7977027297</c:v>
                </c:pt>
                <c:pt idx="542">
                  <c:v>0.85356205699999999</c:v>
                </c:pt>
                <c:pt idx="543">
                  <c:v>0.80677396059999995</c:v>
                </c:pt>
                <c:pt idx="544">
                  <c:v>0.84182310100000002</c:v>
                </c:pt>
                <c:pt idx="545">
                  <c:v>0.78547090289999999</c:v>
                </c:pt>
                <c:pt idx="546">
                  <c:v>0.77113658190000001</c:v>
                </c:pt>
                <c:pt idx="547">
                  <c:v>0.73378354310000005</c:v>
                </c:pt>
                <c:pt idx="548">
                  <c:v>0.76534694430000005</c:v>
                </c:pt>
                <c:pt idx="549">
                  <c:v>0.82279002670000001</c:v>
                </c:pt>
                <c:pt idx="550">
                  <c:v>0.7927652597</c:v>
                </c:pt>
                <c:pt idx="551">
                  <c:v>0.70627552270000005</c:v>
                </c:pt>
                <c:pt idx="552">
                  <c:v>0.68770682809999995</c:v>
                </c:pt>
                <c:pt idx="553">
                  <c:v>0.72198182339999994</c:v>
                </c:pt>
                <c:pt idx="554">
                  <c:v>0.68716216090000004</c:v>
                </c:pt>
                <c:pt idx="555">
                  <c:v>0.66251653430000002</c:v>
                </c:pt>
                <c:pt idx="556">
                  <c:v>0.75412172079999995</c:v>
                </c:pt>
                <c:pt idx="557">
                  <c:v>0.6947255135</c:v>
                </c:pt>
                <c:pt idx="558">
                  <c:v>0.59730690720000001</c:v>
                </c:pt>
                <c:pt idx="559">
                  <c:v>0.62825930119999995</c:v>
                </c:pt>
                <c:pt idx="560">
                  <c:v>0.70017617939999999</c:v>
                </c:pt>
                <c:pt idx="561">
                  <c:v>0.65026348830000003</c:v>
                </c:pt>
                <c:pt idx="562">
                  <c:v>0.65013521910000005</c:v>
                </c:pt>
                <c:pt idx="563">
                  <c:v>0.63436746600000005</c:v>
                </c:pt>
                <c:pt idx="564">
                  <c:v>0.58988529440000004</c:v>
                </c:pt>
                <c:pt idx="565">
                  <c:v>0.64056444170000004</c:v>
                </c:pt>
                <c:pt idx="566">
                  <c:v>0.61977934840000004</c:v>
                </c:pt>
                <c:pt idx="567">
                  <c:v>0.58546835180000001</c:v>
                </c:pt>
                <c:pt idx="568">
                  <c:v>0.65573447939999996</c:v>
                </c:pt>
                <c:pt idx="569">
                  <c:v>0.59129595759999998</c:v>
                </c:pt>
                <c:pt idx="570">
                  <c:v>0.50533562899999995</c:v>
                </c:pt>
                <c:pt idx="571">
                  <c:v>0.49264851209999999</c:v>
                </c:pt>
                <c:pt idx="572">
                  <c:v>0.55643624069999997</c:v>
                </c:pt>
                <c:pt idx="573">
                  <c:v>0.51610881090000005</c:v>
                </c:pt>
                <c:pt idx="574">
                  <c:v>0.56398087740000002</c:v>
                </c:pt>
                <c:pt idx="575">
                  <c:v>0.48776155710000002</c:v>
                </c:pt>
                <c:pt idx="576">
                  <c:v>0.52259242530000005</c:v>
                </c:pt>
                <c:pt idx="577">
                  <c:v>0.50482481720000005</c:v>
                </c:pt>
                <c:pt idx="578">
                  <c:v>0.50744426249999997</c:v>
                </c:pt>
                <c:pt idx="579">
                  <c:v>0.48732241990000003</c:v>
                </c:pt>
                <c:pt idx="580">
                  <c:v>0.4861065745</c:v>
                </c:pt>
                <c:pt idx="581">
                  <c:v>0.45936140419999999</c:v>
                </c:pt>
                <c:pt idx="582">
                  <c:v>0.50799506900000002</c:v>
                </c:pt>
                <c:pt idx="583">
                  <c:v>0.405159086</c:v>
                </c:pt>
                <c:pt idx="584">
                  <c:v>0.48050203920000001</c:v>
                </c:pt>
                <c:pt idx="585">
                  <c:v>0.43126136059999998</c:v>
                </c:pt>
                <c:pt idx="586">
                  <c:v>0.43526700140000002</c:v>
                </c:pt>
                <c:pt idx="587">
                  <c:v>0.42490762469999999</c:v>
                </c:pt>
                <c:pt idx="588">
                  <c:v>0.43919667600000001</c:v>
                </c:pt>
                <c:pt idx="589">
                  <c:v>0.47111707930000002</c:v>
                </c:pt>
                <c:pt idx="590">
                  <c:v>0.4120319784</c:v>
                </c:pt>
                <c:pt idx="591">
                  <c:v>0.39884150029999998</c:v>
                </c:pt>
                <c:pt idx="592">
                  <c:v>0.40857541559999999</c:v>
                </c:pt>
                <c:pt idx="593">
                  <c:v>0.39180532099999998</c:v>
                </c:pt>
                <c:pt idx="594">
                  <c:v>0.37322875859999999</c:v>
                </c:pt>
                <c:pt idx="595">
                  <c:v>0.39155343170000001</c:v>
                </c:pt>
                <c:pt idx="596">
                  <c:v>0.36165484790000002</c:v>
                </c:pt>
                <c:pt idx="597">
                  <c:v>0.3674009144</c:v>
                </c:pt>
                <c:pt idx="598">
                  <c:v>0.41003611680000002</c:v>
                </c:pt>
                <c:pt idx="599">
                  <c:v>0.38068735599999998</c:v>
                </c:pt>
                <c:pt idx="600">
                  <c:v>0.32771506909999998</c:v>
                </c:pt>
                <c:pt idx="601">
                  <c:v>0.3781960607</c:v>
                </c:pt>
                <c:pt idx="602">
                  <c:v>0.35741752389999998</c:v>
                </c:pt>
                <c:pt idx="603">
                  <c:v>0.34019872550000002</c:v>
                </c:pt>
                <c:pt idx="604">
                  <c:v>0.31666553019999999</c:v>
                </c:pt>
                <c:pt idx="605">
                  <c:v>0.38009589910000002</c:v>
                </c:pt>
                <c:pt idx="606">
                  <c:v>0.3075991273</c:v>
                </c:pt>
                <c:pt idx="607">
                  <c:v>0.33079293370000001</c:v>
                </c:pt>
                <c:pt idx="608">
                  <c:v>0.39273315669999997</c:v>
                </c:pt>
                <c:pt idx="609">
                  <c:v>0.36717695</c:v>
                </c:pt>
                <c:pt idx="610">
                  <c:v>0.3020677269</c:v>
                </c:pt>
              </c:numCache>
            </c:numRef>
          </c:yVal>
          <c:smooth val="1"/>
          <c:extLst>
            <c:ext xmlns:c16="http://schemas.microsoft.com/office/drawing/2014/chart" uri="{C3380CC4-5D6E-409C-BE32-E72D297353CC}">
              <c16:uniqueId val="{00000006-3FAF-4CBF-82DD-E60AB52489B3}"/>
            </c:ext>
          </c:extLst>
        </c:ser>
        <c:ser>
          <c:idx val="5"/>
          <c:order val="7"/>
          <c:tx>
            <c:strRef>
              <c:f>AZD!$J$1</c:f>
              <c:strCache>
                <c:ptCount val="1"/>
                <c:pt idx="0">
                  <c:v>AZD2014 (11 μM) PBS Emission</c:v>
                </c:pt>
              </c:strCache>
            </c:strRef>
          </c:tx>
          <c:spPr>
            <a:ln>
              <a:solidFill>
                <a:schemeClr val="accent6">
                  <a:lumMod val="60000"/>
                  <a:lumOff val="40000"/>
                </a:schemeClr>
              </a:solidFill>
            </a:ln>
          </c:spPr>
          <c:marker>
            <c:symbol val="none"/>
          </c:marker>
          <c:xVal>
            <c:numRef>
              <c:f>AZD!$J$3:$J$613</c:f>
              <c:numCache>
                <c:formatCode>General</c:formatCode>
                <c:ptCount val="611"/>
                <c:pt idx="16">
                  <c:v>403.02999879999999</c:v>
                </c:pt>
                <c:pt idx="17">
                  <c:v>403.48001099999999</c:v>
                </c:pt>
                <c:pt idx="18">
                  <c:v>403.92999270000001</c:v>
                </c:pt>
                <c:pt idx="19">
                  <c:v>404.5400085</c:v>
                </c:pt>
                <c:pt idx="20">
                  <c:v>405</c:v>
                </c:pt>
                <c:pt idx="21">
                  <c:v>405.4500122</c:v>
                </c:pt>
                <c:pt idx="22">
                  <c:v>406.05999759999997</c:v>
                </c:pt>
                <c:pt idx="23">
                  <c:v>406.51000979999998</c:v>
                </c:pt>
                <c:pt idx="24">
                  <c:v>406.9599915</c:v>
                </c:pt>
                <c:pt idx="25">
                  <c:v>407.57000729999999</c:v>
                </c:pt>
                <c:pt idx="26">
                  <c:v>408.02999879999999</c:v>
                </c:pt>
                <c:pt idx="27">
                  <c:v>408.48001099999999</c:v>
                </c:pt>
                <c:pt idx="28">
                  <c:v>408.92999270000001</c:v>
                </c:pt>
                <c:pt idx="29">
                  <c:v>409.5400085</c:v>
                </c:pt>
                <c:pt idx="30">
                  <c:v>410</c:v>
                </c:pt>
                <c:pt idx="31">
                  <c:v>410.4500122</c:v>
                </c:pt>
                <c:pt idx="32">
                  <c:v>411.05999759999997</c:v>
                </c:pt>
                <c:pt idx="33">
                  <c:v>411.51000979999998</c:v>
                </c:pt>
                <c:pt idx="34">
                  <c:v>411.9599915</c:v>
                </c:pt>
                <c:pt idx="35">
                  <c:v>412.57000729999999</c:v>
                </c:pt>
                <c:pt idx="36">
                  <c:v>413.02999879999999</c:v>
                </c:pt>
                <c:pt idx="37">
                  <c:v>413.48001099999999</c:v>
                </c:pt>
                <c:pt idx="38">
                  <c:v>413.92999270000001</c:v>
                </c:pt>
                <c:pt idx="39">
                  <c:v>414.5400085</c:v>
                </c:pt>
                <c:pt idx="40">
                  <c:v>415</c:v>
                </c:pt>
                <c:pt idx="41">
                  <c:v>415.4500122</c:v>
                </c:pt>
                <c:pt idx="42">
                  <c:v>416.05999759999997</c:v>
                </c:pt>
                <c:pt idx="43">
                  <c:v>416.51000979999998</c:v>
                </c:pt>
                <c:pt idx="44">
                  <c:v>416.9599915</c:v>
                </c:pt>
                <c:pt idx="45">
                  <c:v>417.57000729999999</c:v>
                </c:pt>
                <c:pt idx="46">
                  <c:v>418.02999879999999</c:v>
                </c:pt>
                <c:pt idx="47">
                  <c:v>418.48001099999999</c:v>
                </c:pt>
                <c:pt idx="48">
                  <c:v>418.92999270000001</c:v>
                </c:pt>
                <c:pt idx="49">
                  <c:v>419.5400085</c:v>
                </c:pt>
                <c:pt idx="50">
                  <c:v>420</c:v>
                </c:pt>
                <c:pt idx="51">
                  <c:v>420.4500122</c:v>
                </c:pt>
                <c:pt idx="52">
                  <c:v>421.05999759999997</c:v>
                </c:pt>
                <c:pt idx="53">
                  <c:v>421.51000979999998</c:v>
                </c:pt>
                <c:pt idx="54">
                  <c:v>421.9599915</c:v>
                </c:pt>
                <c:pt idx="55">
                  <c:v>422.57000729999999</c:v>
                </c:pt>
                <c:pt idx="56">
                  <c:v>423.02999879999999</c:v>
                </c:pt>
                <c:pt idx="57">
                  <c:v>423.48001099999999</c:v>
                </c:pt>
                <c:pt idx="58">
                  <c:v>423.92999270000001</c:v>
                </c:pt>
                <c:pt idx="59">
                  <c:v>424.5400085</c:v>
                </c:pt>
                <c:pt idx="60">
                  <c:v>425</c:v>
                </c:pt>
                <c:pt idx="61">
                  <c:v>425.4500122</c:v>
                </c:pt>
                <c:pt idx="62">
                  <c:v>426.05999759999997</c:v>
                </c:pt>
                <c:pt idx="63">
                  <c:v>426.51000979999998</c:v>
                </c:pt>
                <c:pt idx="64">
                  <c:v>426.9599915</c:v>
                </c:pt>
                <c:pt idx="65">
                  <c:v>427.57000729999999</c:v>
                </c:pt>
                <c:pt idx="66">
                  <c:v>428.02999879999999</c:v>
                </c:pt>
                <c:pt idx="67">
                  <c:v>428.48001099999999</c:v>
                </c:pt>
                <c:pt idx="68">
                  <c:v>428.92999270000001</c:v>
                </c:pt>
                <c:pt idx="69">
                  <c:v>429.5400085</c:v>
                </c:pt>
                <c:pt idx="70">
                  <c:v>430</c:v>
                </c:pt>
                <c:pt idx="71">
                  <c:v>430.4500122</c:v>
                </c:pt>
                <c:pt idx="72">
                  <c:v>431.05999759999997</c:v>
                </c:pt>
                <c:pt idx="73">
                  <c:v>431.51000979999998</c:v>
                </c:pt>
                <c:pt idx="74">
                  <c:v>431.9599915</c:v>
                </c:pt>
                <c:pt idx="75">
                  <c:v>432.57000729999999</c:v>
                </c:pt>
                <c:pt idx="76">
                  <c:v>433.02999879999999</c:v>
                </c:pt>
                <c:pt idx="77">
                  <c:v>433.48001099999999</c:v>
                </c:pt>
                <c:pt idx="78">
                  <c:v>433.92999270000001</c:v>
                </c:pt>
                <c:pt idx="79">
                  <c:v>434.5400085</c:v>
                </c:pt>
                <c:pt idx="80">
                  <c:v>435</c:v>
                </c:pt>
                <c:pt idx="81">
                  <c:v>435.4500122</c:v>
                </c:pt>
                <c:pt idx="82">
                  <c:v>436.05999759999997</c:v>
                </c:pt>
                <c:pt idx="83">
                  <c:v>436.51000979999998</c:v>
                </c:pt>
                <c:pt idx="84">
                  <c:v>436.9599915</c:v>
                </c:pt>
                <c:pt idx="85">
                  <c:v>437.57000729999999</c:v>
                </c:pt>
                <c:pt idx="86">
                  <c:v>438.02999879999999</c:v>
                </c:pt>
                <c:pt idx="87">
                  <c:v>438.48001099999999</c:v>
                </c:pt>
                <c:pt idx="88">
                  <c:v>438.92999270000001</c:v>
                </c:pt>
                <c:pt idx="89">
                  <c:v>439.5400085</c:v>
                </c:pt>
                <c:pt idx="90">
                  <c:v>440</c:v>
                </c:pt>
                <c:pt idx="91">
                  <c:v>440.4500122</c:v>
                </c:pt>
                <c:pt idx="92">
                  <c:v>441.05999759999997</c:v>
                </c:pt>
                <c:pt idx="93">
                  <c:v>441.51000979999998</c:v>
                </c:pt>
                <c:pt idx="94">
                  <c:v>441.9599915</c:v>
                </c:pt>
                <c:pt idx="95">
                  <c:v>442.57000729999999</c:v>
                </c:pt>
                <c:pt idx="96">
                  <c:v>443.02999879999999</c:v>
                </c:pt>
                <c:pt idx="97">
                  <c:v>443.48001099999999</c:v>
                </c:pt>
                <c:pt idx="98">
                  <c:v>443.92999270000001</c:v>
                </c:pt>
                <c:pt idx="99">
                  <c:v>444.5400085</c:v>
                </c:pt>
                <c:pt idx="100">
                  <c:v>445</c:v>
                </c:pt>
                <c:pt idx="101">
                  <c:v>445.4500122</c:v>
                </c:pt>
                <c:pt idx="102">
                  <c:v>446.05999759999997</c:v>
                </c:pt>
                <c:pt idx="103">
                  <c:v>446.51000979999998</c:v>
                </c:pt>
                <c:pt idx="104">
                  <c:v>446.9599915</c:v>
                </c:pt>
                <c:pt idx="105">
                  <c:v>447.57000729999999</c:v>
                </c:pt>
                <c:pt idx="106">
                  <c:v>448.02999879999999</c:v>
                </c:pt>
                <c:pt idx="107">
                  <c:v>448.48001099999999</c:v>
                </c:pt>
                <c:pt idx="108">
                  <c:v>448.92999270000001</c:v>
                </c:pt>
                <c:pt idx="109">
                  <c:v>449.5400085</c:v>
                </c:pt>
                <c:pt idx="110">
                  <c:v>450</c:v>
                </c:pt>
                <c:pt idx="111">
                  <c:v>450.44000240000003</c:v>
                </c:pt>
                <c:pt idx="112">
                  <c:v>451.0400085</c:v>
                </c:pt>
                <c:pt idx="113">
                  <c:v>451.48999020000002</c:v>
                </c:pt>
                <c:pt idx="114">
                  <c:v>451.94000240000003</c:v>
                </c:pt>
                <c:pt idx="115">
                  <c:v>452.52999879999999</c:v>
                </c:pt>
                <c:pt idx="116">
                  <c:v>452.98001099999999</c:v>
                </c:pt>
                <c:pt idx="117">
                  <c:v>453.42999270000001</c:v>
                </c:pt>
                <c:pt idx="118">
                  <c:v>454.01998900000001</c:v>
                </c:pt>
                <c:pt idx="119">
                  <c:v>454.47000120000001</c:v>
                </c:pt>
                <c:pt idx="120">
                  <c:v>455.07000729999999</c:v>
                </c:pt>
                <c:pt idx="121">
                  <c:v>455.51998900000001</c:v>
                </c:pt>
                <c:pt idx="122">
                  <c:v>455.97000120000001</c:v>
                </c:pt>
                <c:pt idx="123">
                  <c:v>456.55999759999997</c:v>
                </c:pt>
                <c:pt idx="124">
                  <c:v>457.01000979999998</c:v>
                </c:pt>
                <c:pt idx="125">
                  <c:v>457.4599915</c:v>
                </c:pt>
                <c:pt idx="126">
                  <c:v>458.0499878</c:v>
                </c:pt>
                <c:pt idx="127">
                  <c:v>458.5</c:v>
                </c:pt>
                <c:pt idx="128">
                  <c:v>458.9500122</c:v>
                </c:pt>
                <c:pt idx="129">
                  <c:v>459.5499878</c:v>
                </c:pt>
                <c:pt idx="130">
                  <c:v>460</c:v>
                </c:pt>
                <c:pt idx="131">
                  <c:v>460.4500122</c:v>
                </c:pt>
                <c:pt idx="132">
                  <c:v>461.05999759999997</c:v>
                </c:pt>
                <c:pt idx="133">
                  <c:v>461.51000979999998</c:v>
                </c:pt>
                <c:pt idx="134">
                  <c:v>461.9599915</c:v>
                </c:pt>
                <c:pt idx="135">
                  <c:v>462.57000729999999</c:v>
                </c:pt>
                <c:pt idx="136">
                  <c:v>463.02999879999999</c:v>
                </c:pt>
                <c:pt idx="137">
                  <c:v>463.48001099999999</c:v>
                </c:pt>
                <c:pt idx="138">
                  <c:v>463.92999270000001</c:v>
                </c:pt>
                <c:pt idx="139">
                  <c:v>464.5400085</c:v>
                </c:pt>
                <c:pt idx="140">
                  <c:v>465</c:v>
                </c:pt>
                <c:pt idx="141">
                  <c:v>465.4500122</c:v>
                </c:pt>
                <c:pt idx="142">
                  <c:v>466.05999759999997</c:v>
                </c:pt>
                <c:pt idx="143">
                  <c:v>466.51000979999998</c:v>
                </c:pt>
                <c:pt idx="144">
                  <c:v>466.9599915</c:v>
                </c:pt>
                <c:pt idx="145">
                  <c:v>467.57000729999999</c:v>
                </c:pt>
                <c:pt idx="146">
                  <c:v>468.02999879999999</c:v>
                </c:pt>
                <c:pt idx="147">
                  <c:v>468.48001099999999</c:v>
                </c:pt>
                <c:pt idx="148">
                  <c:v>468.92999270000001</c:v>
                </c:pt>
                <c:pt idx="149">
                  <c:v>469.5400085</c:v>
                </c:pt>
                <c:pt idx="150">
                  <c:v>470</c:v>
                </c:pt>
                <c:pt idx="151">
                  <c:v>470.44000240000003</c:v>
                </c:pt>
                <c:pt idx="152">
                  <c:v>471.0400085</c:v>
                </c:pt>
                <c:pt idx="153">
                  <c:v>471.48999020000002</c:v>
                </c:pt>
                <c:pt idx="154">
                  <c:v>471.94000240000003</c:v>
                </c:pt>
                <c:pt idx="155">
                  <c:v>472.52999879999999</c:v>
                </c:pt>
                <c:pt idx="156">
                  <c:v>472.98001099999999</c:v>
                </c:pt>
                <c:pt idx="157">
                  <c:v>473.42999270000001</c:v>
                </c:pt>
                <c:pt idx="158">
                  <c:v>474.01998900000001</c:v>
                </c:pt>
                <c:pt idx="159">
                  <c:v>474.47000120000001</c:v>
                </c:pt>
                <c:pt idx="160">
                  <c:v>475.07000729999999</c:v>
                </c:pt>
                <c:pt idx="161">
                  <c:v>475.51998900000001</c:v>
                </c:pt>
                <c:pt idx="162">
                  <c:v>475.97000120000001</c:v>
                </c:pt>
                <c:pt idx="163">
                  <c:v>476.55999759999997</c:v>
                </c:pt>
                <c:pt idx="164">
                  <c:v>477.01000979999998</c:v>
                </c:pt>
                <c:pt idx="165">
                  <c:v>477.4599915</c:v>
                </c:pt>
                <c:pt idx="166">
                  <c:v>478.0499878</c:v>
                </c:pt>
                <c:pt idx="167">
                  <c:v>478.5</c:v>
                </c:pt>
                <c:pt idx="168">
                  <c:v>478.9500122</c:v>
                </c:pt>
                <c:pt idx="169">
                  <c:v>479.5499878</c:v>
                </c:pt>
                <c:pt idx="170">
                  <c:v>480</c:v>
                </c:pt>
                <c:pt idx="171">
                  <c:v>480.44000240000003</c:v>
                </c:pt>
                <c:pt idx="172">
                  <c:v>481.0400085</c:v>
                </c:pt>
                <c:pt idx="173">
                  <c:v>481.48999020000002</c:v>
                </c:pt>
                <c:pt idx="174">
                  <c:v>481.94000240000003</c:v>
                </c:pt>
                <c:pt idx="175">
                  <c:v>482.52999879999999</c:v>
                </c:pt>
                <c:pt idx="176">
                  <c:v>482.98001099999999</c:v>
                </c:pt>
                <c:pt idx="177">
                  <c:v>483.42999270000001</c:v>
                </c:pt>
                <c:pt idx="178">
                  <c:v>484.01998900000001</c:v>
                </c:pt>
                <c:pt idx="179">
                  <c:v>484.47000120000001</c:v>
                </c:pt>
                <c:pt idx="180">
                  <c:v>485.07000729999999</c:v>
                </c:pt>
                <c:pt idx="181">
                  <c:v>485.51998900000001</c:v>
                </c:pt>
                <c:pt idx="182">
                  <c:v>485.97000120000001</c:v>
                </c:pt>
                <c:pt idx="183">
                  <c:v>486.55999759999997</c:v>
                </c:pt>
                <c:pt idx="184">
                  <c:v>487.01000979999998</c:v>
                </c:pt>
                <c:pt idx="185">
                  <c:v>487.4599915</c:v>
                </c:pt>
                <c:pt idx="186">
                  <c:v>488.0499878</c:v>
                </c:pt>
                <c:pt idx="187">
                  <c:v>488.5</c:v>
                </c:pt>
                <c:pt idx="188">
                  <c:v>488.9500122</c:v>
                </c:pt>
                <c:pt idx="189">
                  <c:v>489.5499878</c:v>
                </c:pt>
                <c:pt idx="190">
                  <c:v>490</c:v>
                </c:pt>
                <c:pt idx="191">
                  <c:v>490.44000240000003</c:v>
                </c:pt>
                <c:pt idx="192">
                  <c:v>491.0400085</c:v>
                </c:pt>
                <c:pt idx="193">
                  <c:v>491.48999020000002</c:v>
                </c:pt>
                <c:pt idx="194">
                  <c:v>491.94000240000003</c:v>
                </c:pt>
                <c:pt idx="195">
                  <c:v>492.52999879999999</c:v>
                </c:pt>
                <c:pt idx="196">
                  <c:v>492.98001099999999</c:v>
                </c:pt>
                <c:pt idx="197">
                  <c:v>493.42999270000001</c:v>
                </c:pt>
                <c:pt idx="198">
                  <c:v>494.01998900000001</c:v>
                </c:pt>
                <c:pt idx="199">
                  <c:v>494.47000120000001</c:v>
                </c:pt>
                <c:pt idx="200">
                  <c:v>495.07000729999999</c:v>
                </c:pt>
                <c:pt idx="201">
                  <c:v>495.51998900000001</c:v>
                </c:pt>
                <c:pt idx="202">
                  <c:v>495.97000120000001</c:v>
                </c:pt>
                <c:pt idx="203">
                  <c:v>496.55999759999997</c:v>
                </c:pt>
                <c:pt idx="204">
                  <c:v>497.01000979999998</c:v>
                </c:pt>
                <c:pt idx="205">
                  <c:v>497.4599915</c:v>
                </c:pt>
                <c:pt idx="206">
                  <c:v>498.0499878</c:v>
                </c:pt>
                <c:pt idx="207">
                  <c:v>498.5</c:v>
                </c:pt>
                <c:pt idx="208">
                  <c:v>498.9500122</c:v>
                </c:pt>
                <c:pt idx="209">
                  <c:v>499.5499878</c:v>
                </c:pt>
                <c:pt idx="210">
                  <c:v>500</c:v>
                </c:pt>
                <c:pt idx="211">
                  <c:v>500.44000240000003</c:v>
                </c:pt>
                <c:pt idx="212">
                  <c:v>501.0400085</c:v>
                </c:pt>
                <c:pt idx="213">
                  <c:v>501.48999020000002</c:v>
                </c:pt>
                <c:pt idx="214">
                  <c:v>501.94000240000003</c:v>
                </c:pt>
                <c:pt idx="215">
                  <c:v>502.52999879999999</c:v>
                </c:pt>
                <c:pt idx="216">
                  <c:v>502.98001099999999</c:v>
                </c:pt>
                <c:pt idx="217">
                  <c:v>503.42999270000001</c:v>
                </c:pt>
                <c:pt idx="218">
                  <c:v>504.01998900000001</c:v>
                </c:pt>
                <c:pt idx="219">
                  <c:v>504.47000120000001</c:v>
                </c:pt>
                <c:pt idx="220">
                  <c:v>505.07000729999999</c:v>
                </c:pt>
                <c:pt idx="221">
                  <c:v>505.51998900000001</c:v>
                </c:pt>
                <c:pt idx="222">
                  <c:v>505.97000120000001</c:v>
                </c:pt>
                <c:pt idx="223">
                  <c:v>506.55999759999997</c:v>
                </c:pt>
                <c:pt idx="224">
                  <c:v>507.01000979999998</c:v>
                </c:pt>
                <c:pt idx="225">
                  <c:v>507.4599915</c:v>
                </c:pt>
                <c:pt idx="226">
                  <c:v>508.0499878</c:v>
                </c:pt>
                <c:pt idx="227">
                  <c:v>508.5</c:v>
                </c:pt>
                <c:pt idx="228">
                  <c:v>508.9500122</c:v>
                </c:pt>
                <c:pt idx="229">
                  <c:v>509.5499878</c:v>
                </c:pt>
                <c:pt idx="230">
                  <c:v>510</c:v>
                </c:pt>
                <c:pt idx="231">
                  <c:v>510.44000240000003</c:v>
                </c:pt>
                <c:pt idx="232">
                  <c:v>511.0400085</c:v>
                </c:pt>
                <c:pt idx="233">
                  <c:v>511.48999020000002</c:v>
                </c:pt>
                <c:pt idx="234">
                  <c:v>511.94000240000003</c:v>
                </c:pt>
                <c:pt idx="235">
                  <c:v>512.53002930000002</c:v>
                </c:pt>
                <c:pt idx="236">
                  <c:v>512.97998050000001</c:v>
                </c:pt>
                <c:pt idx="237">
                  <c:v>513.42999269999996</c:v>
                </c:pt>
                <c:pt idx="238">
                  <c:v>514.02001949999999</c:v>
                </c:pt>
                <c:pt idx="239">
                  <c:v>514.46997069999998</c:v>
                </c:pt>
                <c:pt idx="240">
                  <c:v>515.07000730000004</c:v>
                </c:pt>
                <c:pt idx="241">
                  <c:v>515.52001949999999</c:v>
                </c:pt>
                <c:pt idx="242">
                  <c:v>515.96997069999998</c:v>
                </c:pt>
                <c:pt idx="243">
                  <c:v>516.55999759999997</c:v>
                </c:pt>
                <c:pt idx="244">
                  <c:v>517.01000980000003</c:v>
                </c:pt>
                <c:pt idx="245">
                  <c:v>517.46002199999998</c:v>
                </c:pt>
                <c:pt idx="246">
                  <c:v>518.04998780000005</c:v>
                </c:pt>
                <c:pt idx="247">
                  <c:v>518.5</c:v>
                </c:pt>
                <c:pt idx="248">
                  <c:v>518.95001219999995</c:v>
                </c:pt>
                <c:pt idx="249">
                  <c:v>519.54998780000005</c:v>
                </c:pt>
                <c:pt idx="250">
                  <c:v>520</c:v>
                </c:pt>
                <c:pt idx="251">
                  <c:v>520.44000240000003</c:v>
                </c:pt>
                <c:pt idx="252">
                  <c:v>521.03997800000002</c:v>
                </c:pt>
                <c:pt idx="253">
                  <c:v>521.48999019999997</c:v>
                </c:pt>
                <c:pt idx="254">
                  <c:v>521.94000240000003</c:v>
                </c:pt>
                <c:pt idx="255">
                  <c:v>522.53002930000002</c:v>
                </c:pt>
                <c:pt idx="256">
                  <c:v>522.97998050000001</c:v>
                </c:pt>
                <c:pt idx="257">
                  <c:v>523.42999269999996</c:v>
                </c:pt>
                <c:pt idx="258">
                  <c:v>524.02001949999999</c:v>
                </c:pt>
                <c:pt idx="259">
                  <c:v>524.46997069999998</c:v>
                </c:pt>
                <c:pt idx="260">
                  <c:v>525.07000730000004</c:v>
                </c:pt>
                <c:pt idx="261">
                  <c:v>525.52001949999999</c:v>
                </c:pt>
                <c:pt idx="262">
                  <c:v>525.96997069999998</c:v>
                </c:pt>
                <c:pt idx="263">
                  <c:v>526.55999759999997</c:v>
                </c:pt>
                <c:pt idx="264">
                  <c:v>527.01000980000003</c:v>
                </c:pt>
                <c:pt idx="265">
                  <c:v>527.46002199999998</c:v>
                </c:pt>
                <c:pt idx="266">
                  <c:v>528.04998780000005</c:v>
                </c:pt>
                <c:pt idx="267">
                  <c:v>528.5</c:v>
                </c:pt>
                <c:pt idx="268">
                  <c:v>528.95001219999995</c:v>
                </c:pt>
                <c:pt idx="269">
                  <c:v>529.54998780000005</c:v>
                </c:pt>
                <c:pt idx="270">
                  <c:v>530</c:v>
                </c:pt>
                <c:pt idx="271">
                  <c:v>530.44000240000003</c:v>
                </c:pt>
                <c:pt idx="272">
                  <c:v>531.02001949999999</c:v>
                </c:pt>
                <c:pt idx="273">
                  <c:v>531.46997069999998</c:v>
                </c:pt>
                <c:pt idx="274">
                  <c:v>532.04998780000005</c:v>
                </c:pt>
                <c:pt idx="275">
                  <c:v>532.5</c:v>
                </c:pt>
                <c:pt idx="276">
                  <c:v>532.94000240000003</c:v>
                </c:pt>
                <c:pt idx="277">
                  <c:v>533.52001949999999</c:v>
                </c:pt>
                <c:pt idx="278">
                  <c:v>533.96997069999998</c:v>
                </c:pt>
                <c:pt idx="279">
                  <c:v>534.54998780000005</c:v>
                </c:pt>
                <c:pt idx="280">
                  <c:v>535</c:v>
                </c:pt>
                <c:pt idx="281">
                  <c:v>535.44000240000003</c:v>
                </c:pt>
                <c:pt idx="282">
                  <c:v>536.02001949999999</c:v>
                </c:pt>
                <c:pt idx="283">
                  <c:v>536.46997069999998</c:v>
                </c:pt>
                <c:pt idx="284">
                  <c:v>537.04998780000005</c:v>
                </c:pt>
                <c:pt idx="285">
                  <c:v>537.5</c:v>
                </c:pt>
                <c:pt idx="286">
                  <c:v>537.94000240000003</c:v>
                </c:pt>
                <c:pt idx="287">
                  <c:v>538.52001949999999</c:v>
                </c:pt>
                <c:pt idx="288">
                  <c:v>538.96997069999998</c:v>
                </c:pt>
                <c:pt idx="289">
                  <c:v>539.54998780000005</c:v>
                </c:pt>
                <c:pt idx="290">
                  <c:v>540</c:v>
                </c:pt>
                <c:pt idx="291">
                  <c:v>540.44000240000003</c:v>
                </c:pt>
                <c:pt idx="292">
                  <c:v>541.02001949999999</c:v>
                </c:pt>
                <c:pt idx="293">
                  <c:v>541.46997069999998</c:v>
                </c:pt>
                <c:pt idx="294">
                  <c:v>542.04998780000005</c:v>
                </c:pt>
                <c:pt idx="295">
                  <c:v>542.5</c:v>
                </c:pt>
                <c:pt idx="296">
                  <c:v>542.94000240000003</c:v>
                </c:pt>
                <c:pt idx="297">
                  <c:v>543.52001949999999</c:v>
                </c:pt>
                <c:pt idx="298">
                  <c:v>543.96997069999998</c:v>
                </c:pt>
                <c:pt idx="299">
                  <c:v>544.54998780000005</c:v>
                </c:pt>
                <c:pt idx="300">
                  <c:v>545</c:v>
                </c:pt>
                <c:pt idx="301">
                  <c:v>545.44000240000003</c:v>
                </c:pt>
                <c:pt idx="302">
                  <c:v>546.02001949999999</c:v>
                </c:pt>
                <c:pt idx="303">
                  <c:v>546.46997069999998</c:v>
                </c:pt>
                <c:pt idx="304">
                  <c:v>547.04998780000005</c:v>
                </c:pt>
                <c:pt idx="305">
                  <c:v>547.5</c:v>
                </c:pt>
                <c:pt idx="306">
                  <c:v>547.94000240000003</c:v>
                </c:pt>
                <c:pt idx="307">
                  <c:v>548.52001949999999</c:v>
                </c:pt>
                <c:pt idx="308">
                  <c:v>548.96997069999998</c:v>
                </c:pt>
                <c:pt idx="309">
                  <c:v>549.54998780000005</c:v>
                </c:pt>
                <c:pt idx="310">
                  <c:v>550</c:v>
                </c:pt>
                <c:pt idx="311">
                  <c:v>550.44000240000003</c:v>
                </c:pt>
                <c:pt idx="312">
                  <c:v>551.02001949999999</c:v>
                </c:pt>
                <c:pt idx="313">
                  <c:v>551.46997069999998</c:v>
                </c:pt>
                <c:pt idx="314">
                  <c:v>552.04998780000005</c:v>
                </c:pt>
                <c:pt idx="315">
                  <c:v>552.5</c:v>
                </c:pt>
                <c:pt idx="316">
                  <c:v>552.94000240000003</c:v>
                </c:pt>
                <c:pt idx="317">
                  <c:v>553.52001949999999</c:v>
                </c:pt>
                <c:pt idx="318">
                  <c:v>553.96997069999998</c:v>
                </c:pt>
                <c:pt idx="319">
                  <c:v>554.54998780000005</c:v>
                </c:pt>
                <c:pt idx="320">
                  <c:v>555</c:v>
                </c:pt>
                <c:pt idx="321">
                  <c:v>555.44000240000003</c:v>
                </c:pt>
                <c:pt idx="322">
                  <c:v>556.02001949999999</c:v>
                </c:pt>
                <c:pt idx="323">
                  <c:v>556.46997069999998</c:v>
                </c:pt>
                <c:pt idx="324">
                  <c:v>557.04998780000005</c:v>
                </c:pt>
                <c:pt idx="325">
                  <c:v>557.5</c:v>
                </c:pt>
                <c:pt idx="326">
                  <c:v>557.94000240000003</c:v>
                </c:pt>
                <c:pt idx="327">
                  <c:v>558.52001949999999</c:v>
                </c:pt>
                <c:pt idx="328">
                  <c:v>558.96997069999998</c:v>
                </c:pt>
                <c:pt idx="329">
                  <c:v>559.54998780000005</c:v>
                </c:pt>
                <c:pt idx="330">
                  <c:v>560</c:v>
                </c:pt>
                <c:pt idx="331">
                  <c:v>560.44000240000003</c:v>
                </c:pt>
                <c:pt idx="332">
                  <c:v>561.02001949999999</c:v>
                </c:pt>
                <c:pt idx="333">
                  <c:v>561.46997069999998</c:v>
                </c:pt>
                <c:pt idx="334">
                  <c:v>562.04998780000005</c:v>
                </c:pt>
                <c:pt idx="335">
                  <c:v>562.5</c:v>
                </c:pt>
                <c:pt idx="336">
                  <c:v>562.94000240000003</c:v>
                </c:pt>
                <c:pt idx="337">
                  <c:v>563.52001949999999</c:v>
                </c:pt>
                <c:pt idx="338">
                  <c:v>563.96997069999998</c:v>
                </c:pt>
                <c:pt idx="339">
                  <c:v>564.54998780000005</c:v>
                </c:pt>
                <c:pt idx="340">
                  <c:v>565</c:v>
                </c:pt>
                <c:pt idx="341">
                  <c:v>565.44000240000003</c:v>
                </c:pt>
                <c:pt idx="342">
                  <c:v>566.02001949999999</c:v>
                </c:pt>
                <c:pt idx="343">
                  <c:v>566.46997069999998</c:v>
                </c:pt>
                <c:pt idx="344">
                  <c:v>567.04998780000005</c:v>
                </c:pt>
                <c:pt idx="345">
                  <c:v>567.5</c:v>
                </c:pt>
                <c:pt idx="346">
                  <c:v>567.94000240000003</c:v>
                </c:pt>
                <c:pt idx="347">
                  <c:v>568.52001949999999</c:v>
                </c:pt>
                <c:pt idx="348">
                  <c:v>568.96997069999998</c:v>
                </c:pt>
                <c:pt idx="349">
                  <c:v>569.54998780000005</c:v>
                </c:pt>
                <c:pt idx="350">
                  <c:v>570</c:v>
                </c:pt>
                <c:pt idx="351">
                  <c:v>570.44000240000003</c:v>
                </c:pt>
                <c:pt idx="352">
                  <c:v>571.02001949999999</c:v>
                </c:pt>
                <c:pt idx="353">
                  <c:v>571.46997069999998</c:v>
                </c:pt>
                <c:pt idx="354">
                  <c:v>572.04998780000005</c:v>
                </c:pt>
                <c:pt idx="355">
                  <c:v>572.5</c:v>
                </c:pt>
                <c:pt idx="356">
                  <c:v>572.94000240000003</c:v>
                </c:pt>
                <c:pt idx="357">
                  <c:v>573.52001949999999</c:v>
                </c:pt>
                <c:pt idx="358">
                  <c:v>573.96997069999998</c:v>
                </c:pt>
                <c:pt idx="359">
                  <c:v>574.54998780000005</c:v>
                </c:pt>
                <c:pt idx="360">
                  <c:v>575</c:v>
                </c:pt>
                <c:pt idx="361">
                  <c:v>575.44000240000003</c:v>
                </c:pt>
                <c:pt idx="362">
                  <c:v>576.02001949999999</c:v>
                </c:pt>
                <c:pt idx="363">
                  <c:v>576.46997069999998</c:v>
                </c:pt>
                <c:pt idx="364">
                  <c:v>577.04998780000005</c:v>
                </c:pt>
                <c:pt idx="365">
                  <c:v>577.5</c:v>
                </c:pt>
                <c:pt idx="366">
                  <c:v>577.94000240000003</c:v>
                </c:pt>
                <c:pt idx="367">
                  <c:v>578.52001949999999</c:v>
                </c:pt>
                <c:pt idx="368">
                  <c:v>578.96997069999998</c:v>
                </c:pt>
                <c:pt idx="369">
                  <c:v>579.54998780000005</c:v>
                </c:pt>
                <c:pt idx="370">
                  <c:v>580</c:v>
                </c:pt>
                <c:pt idx="371">
                  <c:v>580.44000240000003</c:v>
                </c:pt>
                <c:pt idx="372">
                  <c:v>581.02001949999999</c:v>
                </c:pt>
                <c:pt idx="373">
                  <c:v>581.46997069999998</c:v>
                </c:pt>
                <c:pt idx="374">
                  <c:v>582.04998780000005</c:v>
                </c:pt>
                <c:pt idx="375">
                  <c:v>582.5</c:v>
                </c:pt>
                <c:pt idx="376">
                  <c:v>582.94000240000003</c:v>
                </c:pt>
                <c:pt idx="377">
                  <c:v>583.52001949999999</c:v>
                </c:pt>
                <c:pt idx="378">
                  <c:v>583.96997069999998</c:v>
                </c:pt>
                <c:pt idx="379">
                  <c:v>584.54998780000005</c:v>
                </c:pt>
                <c:pt idx="380">
                  <c:v>585</c:v>
                </c:pt>
                <c:pt idx="381">
                  <c:v>585.44000240000003</c:v>
                </c:pt>
                <c:pt idx="382">
                  <c:v>586.02001949999999</c:v>
                </c:pt>
                <c:pt idx="383">
                  <c:v>586.46997069999998</c:v>
                </c:pt>
                <c:pt idx="384">
                  <c:v>587.04998780000005</c:v>
                </c:pt>
                <c:pt idx="385">
                  <c:v>587.5</c:v>
                </c:pt>
                <c:pt idx="386">
                  <c:v>587.94000240000003</c:v>
                </c:pt>
                <c:pt idx="387">
                  <c:v>588.52001949999999</c:v>
                </c:pt>
                <c:pt idx="388">
                  <c:v>588.96997069999998</c:v>
                </c:pt>
                <c:pt idx="389">
                  <c:v>589.54998780000005</c:v>
                </c:pt>
                <c:pt idx="390">
                  <c:v>590</c:v>
                </c:pt>
                <c:pt idx="391">
                  <c:v>590.42999269999996</c:v>
                </c:pt>
                <c:pt idx="392">
                  <c:v>591.01000980000003</c:v>
                </c:pt>
                <c:pt idx="393">
                  <c:v>591.44000240000003</c:v>
                </c:pt>
                <c:pt idx="394">
                  <c:v>592.02001949999999</c:v>
                </c:pt>
                <c:pt idx="395">
                  <c:v>592.46002199999998</c:v>
                </c:pt>
                <c:pt idx="396">
                  <c:v>593.03997800000002</c:v>
                </c:pt>
                <c:pt idx="397">
                  <c:v>593.46997069999998</c:v>
                </c:pt>
                <c:pt idx="398">
                  <c:v>594.04998780000005</c:v>
                </c:pt>
                <c:pt idx="399">
                  <c:v>594.48999019999997</c:v>
                </c:pt>
                <c:pt idx="400">
                  <c:v>595.07000730000004</c:v>
                </c:pt>
                <c:pt idx="401">
                  <c:v>595.5</c:v>
                </c:pt>
                <c:pt idx="402">
                  <c:v>595.94000240000003</c:v>
                </c:pt>
                <c:pt idx="403">
                  <c:v>596.52001949999999</c:v>
                </c:pt>
                <c:pt idx="404">
                  <c:v>596.95001219999995</c:v>
                </c:pt>
                <c:pt idx="405">
                  <c:v>597.53002930000002</c:v>
                </c:pt>
                <c:pt idx="406">
                  <c:v>597.96997069999998</c:v>
                </c:pt>
                <c:pt idx="407">
                  <c:v>598.54998780000005</c:v>
                </c:pt>
                <c:pt idx="408">
                  <c:v>598.97998050000001</c:v>
                </c:pt>
                <c:pt idx="409">
                  <c:v>599.55999759999997</c:v>
                </c:pt>
                <c:pt idx="410">
                  <c:v>600</c:v>
                </c:pt>
                <c:pt idx="411">
                  <c:v>600.42999269999996</c:v>
                </c:pt>
                <c:pt idx="412">
                  <c:v>601.01000980000003</c:v>
                </c:pt>
                <c:pt idx="413">
                  <c:v>601.44000240000003</c:v>
                </c:pt>
                <c:pt idx="414">
                  <c:v>602.02001949999999</c:v>
                </c:pt>
                <c:pt idx="415">
                  <c:v>602.46002199999998</c:v>
                </c:pt>
                <c:pt idx="416">
                  <c:v>603.03997800000002</c:v>
                </c:pt>
                <c:pt idx="417">
                  <c:v>603.46997069999998</c:v>
                </c:pt>
                <c:pt idx="418">
                  <c:v>604.04998780000005</c:v>
                </c:pt>
                <c:pt idx="419">
                  <c:v>604.48999019999997</c:v>
                </c:pt>
                <c:pt idx="420">
                  <c:v>605.07000730000004</c:v>
                </c:pt>
                <c:pt idx="421">
                  <c:v>605.5</c:v>
                </c:pt>
                <c:pt idx="422">
                  <c:v>605.94000240000003</c:v>
                </c:pt>
                <c:pt idx="423">
                  <c:v>606.52001949999999</c:v>
                </c:pt>
                <c:pt idx="424">
                  <c:v>606.95001219999995</c:v>
                </c:pt>
                <c:pt idx="425">
                  <c:v>607.53002930000002</c:v>
                </c:pt>
                <c:pt idx="426">
                  <c:v>607.96997069999998</c:v>
                </c:pt>
                <c:pt idx="427">
                  <c:v>608.54998780000005</c:v>
                </c:pt>
                <c:pt idx="428">
                  <c:v>608.97998050000001</c:v>
                </c:pt>
                <c:pt idx="429">
                  <c:v>609.55999759999997</c:v>
                </c:pt>
                <c:pt idx="430">
                  <c:v>610</c:v>
                </c:pt>
                <c:pt idx="431">
                  <c:v>610.42999269999996</c:v>
                </c:pt>
                <c:pt idx="432">
                  <c:v>611.01000980000003</c:v>
                </c:pt>
                <c:pt idx="433">
                  <c:v>611.44000240000003</c:v>
                </c:pt>
                <c:pt idx="434">
                  <c:v>612.02001949999999</c:v>
                </c:pt>
                <c:pt idx="435">
                  <c:v>612.46002199999998</c:v>
                </c:pt>
                <c:pt idx="436">
                  <c:v>613.03997800000002</c:v>
                </c:pt>
                <c:pt idx="437">
                  <c:v>613.46997069999998</c:v>
                </c:pt>
                <c:pt idx="438">
                  <c:v>614.04998780000005</c:v>
                </c:pt>
                <c:pt idx="439">
                  <c:v>614.48999019999997</c:v>
                </c:pt>
                <c:pt idx="440">
                  <c:v>615.07000730000004</c:v>
                </c:pt>
                <c:pt idx="441">
                  <c:v>615.5</c:v>
                </c:pt>
                <c:pt idx="442">
                  <c:v>615.94000240000003</c:v>
                </c:pt>
                <c:pt idx="443">
                  <c:v>616.52001949999999</c:v>
                </c:pt>
                <c:pt idx="444">
                  <c:v>616.95001219999995</c:v>
                </c:pt>
                <c:pt idx="445">
                  <c:v>617.53002930000002</c:v>
                </c:pt>
                <c:pt idx="446">
                  <c:v>617.96997069999998</c:v>
                </c:pt>
                <c:pt idx="447">
                  <c:v>618.54998780000005</c:v>
                </c:pt>
                <c:pt idx="448">
                  <c:v>618.97998050000001</c:v>
                </c:pt>
                <c:pt idx="449">
                  <c:v>619.55999759999997</c:v>
                </c:pt>
                <c:pt idx="450">
                  <c:v>620</c:v>
                </c:pt>
                <c:pt idx="451">
                  <c:v>620.42999269999996</c:v>
                </c:pt>
                <c:pt idx="452">
                  <c:v>621.01000980000003</c:v>
                </c:pt>
                <c:pt idx="453">
                  <c:v>621.44000240000003</c:v>
                </c:pt>
                <c:pt idx="454">
                  <c:v>622.02001949999999</c:v>
                </c:pt>
                <c:pt idx="455">
                  <c:v>622.46002199999998</c:v>
                </c:pt>
                <c:pt idx="456">
                  <c:v>623.03997800000002</c:v>
                </c:pt>
                <c:pt idx="457">
                  <c:v>623.46997069999998</c:v>
                </c:pt>
                <c:pt idx="458">
                  <c:v>624.04998780000005</c:v>
                </c:pt>
                <c:pt idx="459">
                  <c:v>624.48999019999997</c:v>
                </c:pt>
                <c:pt idx="460">
                  <c:v>625.07000730000004</c:v>
                </c:pt>
                <c:pt idx="461">
                  <c:v>625.5</c:v>
                </c:pt>
                <c:pt idx="462">
                  <c:v>625.94000240000003</c:v>
                </c:pt>
                <c:pt idx="463">
                  <c:v>626.52001949999999</c:v>
                </c:pt>
                <c:pt idx="464">
                  <c:v>626.95001219999995</c:v>
                </c:pt>
                <c:pt idx="465">
                  <c:v>627.53002930000002</c:v>
                </c:pt>
                <c:pt idx="466">
                  <c:v>627.96997069999998</c:v>
                </c:pt>
                <c:pt idx="467">
                  <c:v>628.54998780000005</c:v>
                </c:pt>
                <c:pt idx="468">
                  <c:v>628.97998050000001</c:v>
                </c:pt>
                <c:pt idx="469">
                  <c:v>629.55999759999997</c:v>
                </c:pt>
                <c:pt idx="470">
                  <c:v>630</c:v>
                </c:pt>
                <c:pt idx="471">
                  <c:v>630.42999269999996</c:v>
                </c:pt>
                <c:pt idx="472">
                  <c:v>631.01000980000003</c:v>
                </c:pt>
                <c:pt idx="473">
                  <c:v>631.44000240000003</c:v>
                </c:pt>
                <c:pt idx="474">
                  <c:v>632.02001949999999</c:v>
                </c:pt>
                <c:pt idx="475">
                  <c:v>632.46002199999998</c:v>
                </c:pt>
                <c:pt idx="476">
                  <c:v>633.03997800000002</c:v>
                </c:pt>
                <c:pt idx="477">
                  <c:v>633.46997069999998</c:v>
                </c:pt>
                <c:pt idx="478">
                  <c:v>634.04998780000005</c:v>
                </c:pt>
                <c:pt idx="479">
                  <c:v>634.48999019999997</c:v>
                </c:pt>
                <c:pt idx="480">
                  <c:v>635.07000730000004</c:v>
                </c:pt>
                <c:pt idx="481">
                  <c:v>635.5</c:v>
                </c:pt>
                <c:pt idx="482">
                  <c:v>635.94000240000003</c:v>
                </c:pt>
                <c:pt idx="483">
                  <c:v>636.52001949999999</c:v>
                </c:pt>
                <c:pt idx="484">
                  <c:v>636.95001219999995</c:v>
                </c:pt>
                <c:pt idx="485">
                  <c:v>637.53002930000002</c:v>
                </c:pt>
                <c:pt idx="486">
                  <c:v>637.96997069999998</c:v>
                </c:pt>
                <c:pt idx="487">
                  <c:v>638.54998780000005</c:v>
                </c:pt>
                <c:pt idx="488">
                  <c:v>638.97998050000001</c:v>
                </c:pt>
                <c:pt idx="489">
                  <c:v>639.55999759999997</c:v>
                </c:pt>
                <c:pt idx="490">
                  <c:v>640</c:v>
                </c:pt>
                <c:pt idx="491">
                  <c:v>640.57000730000004</c:v>
                </c:pt>
                <c:pt idx="492">
                  <c:v>641</c:v>
                </c:pt>
                <c:pt idx="493">
                  <c:v>641.57000730000004</c:v>
                </c:pt>
                <c:pt idx="494">
                  <c:v>642</c:v>
                </c:pt>
                <c:pt idx="495">
                  <c:v>642.57000730000004</c:v>
                </c:pt>
                <c:pt idx="496">
                  <c:v>643</c:v>
                </c:pt>
                <c:pt idx="497">
                  <c:v>643.57000730000004</c:v>
                </c:pt>
                <c:pt idx="498">
                  <c:v>644</c:v>
                </c:pt>
                <c:pt idx="499">
                  <c:v>644.57000730000004</c:v>
                </c:pt>
                <c:pt idx="500">
                  <c:v>645</c:v>
                </c:pt>
                <c:pt idx="501">
                  <c:v>645.57000730000004</c:v>
                </c:pt>
                <c:pt idx="502">
                  <c:v>646</c:v>
                </c:pt>
                <c:pt idx="503">
                  <c:v>646.57000730000004</c:v>
                </c:pt>
                <c:pt idx="504">
                  <c:v>647</c:v>
                </c:pt>
                <c:pt idx="505">
                  <c:v>647.57000730000004</c:v>
                </c:pt>
                <c:pt idx="506">
                  <c:v>648</c:v>
                </c:pt>
                <c:pt idx="507">
                  <c:v>648.57000730000004</c:v>
                </c:pt>
                <c:pt idx="508">
                  <c:v>649</c:v>
                </c:pt>
                <c:pt idx="509">
                  <c:v>649.57000730000004</c:v>
                </c:pt>
                <c:pt idx="510">
                  <c:v>650</c:v>
                </c:pt>
                <c:pt idx="511">
                  <c:v>650.42999269999996</c:v>
                </c:pt>
                <c:pt idx="512">
                  <c:v>651.01000980000003</c:v>
                </c:pt>
                <c:pt idx="513">
                  <c:v>651.44000240000003</c:v>
                </c:pt>
                <c:pt idx="514">
                  <c:v>652.02001949999999</c:v>
                </c:pt>
                <c:pt idx="515">
                  <c:v>652.46002199999998</c:v>
                </c:pt>
                <c:pt idx="516">
                  <c:v>653.03997800000002</c:v>
                </c:pt>
                <c:pt idx="517">
                  <c:v>653.46997069999998</c:v>
                </c:pt>
                <c:pt idx="518">
                  <c:v>654.04998780000005</c:v>
                </c:pt>
                <c:pt idx="519">
                  <c:v>654.48999019999997</c:v>
                </c:pt>
                <c:pt idx="520">
                  <c:v>655.07000730000004</c:v>
                </c:pt>
                <c:pt idx="521">
                  <c:v>655.5</c:v>
                </c:pt>
                <c:pt idx="522">
                  <c:v>655.94000240000003</c:v>
                </c:pt>
                <c:pt idx="523">
                  <c:v>656.52001949999999</c:v>
                </c:pt>
                <c:pt idx="524">
                  <c:v>656.95001219999995</c:v>
                </c:pt>
                <c:pt idx="525">
                  <c:v>657.53002930000002</c:v>
                </c:pt>
                <c:pt idx="526">
                  <c:v>657.96997069999998</c:v>
                </c:pt>
                <c:pt idx="527">
                  <c:v>658.54998780000005</c:v>
                </c:pt>
                <c:pt idx="528">
                  <c:v>658.97998050000001</c:v>
                </c:pt>
                <c:pt idx="529">
                  <c:v>659.55999759999997</c:v>
                </c:pt>
                <c:pt idx="530">
                  <c:v>660</c:v>
                </c:pt>
                <c:pt idx="531">
                  <c:v>660.57000730000004</c:v>
                </c:pt>
                <c:pt idx="532">
                  <c:v>661</c:v>
                </c:pt>
                <c:pt idx="533">
                  <c:v>661.57000730000004</c:v>
                </c:pt>
                <c:pt idx="534">
                  <c:v>662</c:v>
                </c:pt>
                <c:pt idx="535">
                  <c:v>662.57000730000004</c:v>
                </c:pt>
                <c:pt idx="536">
                  <c:v>663</c:v>
                </c:pt>
                <c:pt idx="537">
                  <c:v>663.57000730000004</c:v>
                </c:pt>
                <c:pt idx="538">
                  <c:v>664</c:v>
                </c:pt>
                <c:pt idx="539">
                  <c:v>664.57000730000004</c:v>
                </c:pt>
                <c:pt idx="540">
                  <c:v>665</c:v>
                </c:pt>
                <c:pt idx="541">
                  <c:v>665.57000730000004</c:v>
                </c:pt>
                <c:pt idx="542">
                  <c:v>666</c:v>
                </c:pt>
                <c:pt idx="543">
                  <c:v>666.57000730000004</c:v>
                </c:pt>
                <c:pt idx="544">
                  <c:v>667</c:v>
                </c:pt>
                <c:pt idx="545">
                  <c:v>667.57000730000004</c:v>
                </c:pt>
                <c:pt idx="546">
                  <c:v>668</c:v>
                </c:pt>
                <c:pt idx="547">
                  <c:v>668.57000730000004</c:v>
                </c:pt>
                <c:pt idx="548">
                  <c:v>669</c:v>
                </c:pt>
                <c:pt idx="549">
                  <c:v>669.57000730000004</c:v>
                </c:pt>
                <c:pt idx="550">
                  <c:v>670</c:v>
                </c:pt>
                <c:pt idx="551">
                  <c:v>670.55999759999997</c:v>
                </c:pt>
                <c:pt idx="552">
                  <c:v>670.97998050000001</c:v>
                </c:pt>
                <c:pt idx="553">
                  <c:v>671.53997800000002</c:v>
                </c:pt>
                <c:pt idx="554">
                  <c:v>671.96997069999998</c:v>
                </c:pt>
                <c:pt idx="555">
                  <c:v>672.53002930000002</c:v>
                </c:pt>
                <c:pt idx="556">
                  <c:v>672.95001219999995</c:v>
                </c:pt>
                <c:pt idx="557">
                  <c:v>673.52001949999999</c:v>
                </c:pt>
                <c:pt idx="558">
                  <c:v>673.94000240000003</c:v>
                </c:pt>
                <c:pt idx="559">
                  <c:v>674.5</c:v>
                </c:pt>
                <c:pt idx="560">
                  <c:v>675.07000730000004</c:v>
                </c:pt>
                <c:pt idx="561">
                  <c:v>675.48999019999997</c:v>
                </c:pt>
                <c:pt idx="562">
                  <c:v>676.04998780000005</c:v>
                </c:pt>
                <c:pt idx="563">
                  <c:v>676.46997069999998</c:v>
                </c:pt>
                <c:pt idx="564">
                  <c:v>677.03997800000002</c:v>
                </c:pt>
                <c:pt idx="565">
                  <c:v>677.46002199999998</c:v>
                </c:pt>
                <c:pt idx="566">
                  <c:v>678.02001949999999</c:v>
                </c:pt>
                <c:pt idx="567">
                  <c:v>678.45001219999995</c:v>
                </c:pt>
                <c:pt idx="568">
                  <c:v>679.01000980000003</c:v>
                </c:pt>
                <c:pt idx="569">
                  <c:v>679.42999269999996</c:v>
                </c:pt>
                <c:pt idx="570">
                  <c:v>680</c:v>
                </c:pt>
                <c:pt idx="571">
                  <c:v>680.57000730000004</c:v>
                </c:pt>
                <c:pt idx="572">
                  <c:v>681</c:v>
                </c:pt>
                <c:pt idx="573">
                  <c:v>681.57000730000004</c:v>
                </c:pt>
                <c:pt idx="574">
                  <c:v>682</c:v>
                </c:pt>
                <c:pt idx="575">
                  <c:v>682.57000730000004</c:v>
                </c:pt>
                <c:pt idx="576">
                  <c:v>683</c:v>
                </c:pt>
                <c:pt idx="577">
                  <c:v>683.57000730000004</c:v>
                </c:pt>
                <c:pt idx="578">
                  <c:v>684</c:v>
                </c:pt>
                <c:pt idx="579">
                  <c:v>684.57000730000004</c:v>
                </c:pt>
                <c:pt idx="580">
                  <c:v>685</c:v>
                </c:pt>
                <c:pt idx="581">
                  <c:v>685.57000730000004</c:v>
                </c:pt>
                <c:pt idx="582">
                  <c:v>686</c:v>
                </c:pt>
                <c:pt idx="583">
                  <c:v>686.57000730000004</c:v>
                </c:pt>
                <c:pt idx="584">
                  <c:v>687</c:v>
                </c:pt>
                <c:pt idx="585">
                  <c:v>687.57000730000004</c:v>
                </c:pt>
                <c:pt idx="586">
                  <c:v>688</c:v>
                </c:pt>
                <c:pt idx="587">
                  <c:v>688.57000730000004</c:v>
                </c:pt>
                <c:pt idx="588">
                  <c:v>689</c:v>
                </c:pt>
                <c:pt idx="589">
                  <c:v>689.57000730000004</c:v>
                </c:pt>
                <c:pt idx="590">
                  <c:v>690</c:v>
                </c:pt>
                <c:pt idx="591">
                  <c:v>690.55999759999997</c:v>
                </c:pt>
                <c:pt idx="592">
                  <c:v>690.97998050000001</c:v>
                </c:pt>
                <c:pt idx="593">
                  <c:v>691.53997800000002</c:v>
                </c:pt>
                <c:pt idx="594">
                  <c:v>691.96997069999998</c:v>
                </c:pt>
                <c:pt idx="595">
                  <c:v>692.53002930000002</c:v>
                </c:pt>
                <c:pt idx="596">
                  <c:v>692.95001219999995</c:v>
                </c:pt>
                <c:pt idx="597">
                  <c:v>693.52001949999999</c:v>
                </c:pt>
                <c:pt idx="598">
                  <c:v>693.94000240000003</c:v>
                </c:pt>
                <c:pt idx="599">
                  <c:v>694.5</c:v>
                </c:pt>
                <c:pt idx="600">
                  <c:v>695.07000730000004</c:v>
                </c:pt>
                <c:pt idx="601">
                  <c:v>695.48999019999997</c:v>
                </c:pt>
                <c:pt idx="602">
                  <c:v>696.04998780000005</c:v>
                </c:pt>
                <c:pt idx="603">
                  <c:v>696.46997069999998</c:v>
                </c:pt>
                <c:pt idx="604">
                  <c:v>697.03997800000002</c:v>
                </c:pt>
                <c:pt idx="605">
                  <c:v>697.46002199999998</c:v>
                </c:pt>
                <c:pt idx="606">
                  <c:v>698.02001949999999</c:v>
                </c:pt>
                <c:pt idx="607">
                  <c:v>698.45001219999995</c:v>
                </c:pt>
                <c:pt idx="608">
                  <c:v>699.01000980000003</c:v>
                </c:pt>
                <c:pt idx="609">
                  <c:v>699.42999269999996</c:v>
                </c:pt>
                <c:pt idx="610">
                  <c:v>700</c:v>
                </c:pt>
              </c:numCache>
            </c:numRef>
          </c:xVal>
          <c:yVal>
            <c:numRef>
              <c:f>AZD!$K$3:$K$613</c:f>
              <c:numCache>
                <c:formatCode>General</c:formatCode>
                <c:ptCount val="611"/>
                <c:pt idx="16">
                  <c:v>3.4226343629999998</c:v>
                </c:pt>
                <c:pt idx="17">
                  <c:v>3.5581140520000001</c:v>
                </c:pt>
                <c:pt idx="18">
                  <c:v>3.8953154090000002</c:v>
                </c:pt>
                <c:pt idx="19">
                  <c:v>3.4921088220000001</c:v>
                </c:pt>
                <c:pt idx="20">
                  <c:v>3.3522753719999998</c:v>
                </c:pt>
                <c:pt idx="21">
                  <c:v>3.241967678</c:v>
                </c:pt>
                <c:pt idx="22">
                  <c:v>3.1042261120000001</c:v>
                </c:pt>
                <c:pt idx="23">
                  <c:v>3.0737471580000002</c:v>
                </c:pt>
                <c:pt idx="24">
                  <c:v>3.067424774</c:v>
                </c:pt>
                <c:pt idx="25">
                  <c:v>2.8467078209999999</c:v>
                </c:pt>
                <c:pt idx="26">
                  <c:v>2.78165555</c:v>
                </c:pt>
                <c:pt idx="27">
                  <c:v>2.3798768520000002</c:v>
                </c:pt>
                <c:pt idx="28">
                  <c:v>1.9631762500000001</c:v>
                </c:pt>
                <c:pt idx="29">
                  <c:v>1.676490426</c:v>
                </c:pt>
                <c:pt idx="30">
                  <c:v>1.50188458</c:v>
                </c:pt>
                <c:pt idx="31">
                  <c:v>1.53831327</c:v>
                </c:pt>
                <c:pt idx="32">
                  <c:v>1.3598614929999999</c:v>
                </c:pt>
                <c:pt idx="33">
                  <c:v>1.4352394340000001</c:v>
                </c:pt>
                <c:pt idx="34">
                  <c:v>1.362724423</c:v>
                </c:pt>
                <c:pt idx="35">
                  <c:v>1.5356746910000001</c:v>
                </c:pt>
                <c:pt idx="36">
                  <c:v>1.6229373220000001</c:v>
                </c:pt>
                <c:pt idx="37">
                  <c:v>1.7547030450000001</c:v>
                </c:pt>
                <c:pt idx="38">
                  <c:v>1.8106361630000001</c:v>
                </c:pt>
                <c:pt idx="39">
                  <c:v>1.8722865580000001</c:v>
                </c:pt>
                <c:pt idx="40">
                  <c:v>1.997837305</c:v>
                </c:pt>
                <c:pt idx="41">
                  <c:v>2.1775822640000002</c:v>
                </c:pt>
                <c:pt idx="42">
                  <c:v>2.346646786</c:v>
                </c:pt>
                <c:pt idx="43">
                  <c:v>2.4179413319999998</c:v>
                </c:pt>
                <c:pt idx="44">
                  <c:v>2.6052885059999999</c:v>
                </c:pt>
                <c:pt idx="45">
                  <c:v>2.9512965680000001</c:v>
                </c:pt>
                <c:pt idx="46">
                  <c:v>2.8871774669999999</c:v>
                </c:pt>
                <c:pt idx="47">
                  <c:v>3.1513738629999999</c:v>
                </c:pt>
                <c:pt idx="48">
                  <c:v>3.2706294059999999</c:v>
                </c:pt>
                <c:pt idx="49">
                  <c:v>3.6285762789999998</c:v>
                </c:pt>
                <c:pt idx="50">
                  <c:v>3.908299923</c:v>
                </c:pt>
                <c:pt idx="51">
                  <c:v>3.9104726310000002</c:v>
                </c:pt>
                <c:pt idx="52">
                  <c:v>4.3356008529999999</c:v>
                </c:pt>
                <c:pt idx="53">
                  <c:v>4.4832901950000004</c:v>
                </c:pt>
                <c:pt idx="54">
                  <c:v>4.7324409479999998</c:v>
                </c:pt>
                <c:pt idx="55">
                  <c:v>4.9414544109999996</c:v>
                </c:pt>
                <c:pt idx="56">
                  <c:v>5.251344681</c:v>
                </c:pt>
                <c:pt idx="57">
                  <c:v>5.6912722589999998</c:v>
                </c:pt>
                <c:pt idx="58">
                  <c:v>5.9291300769999999</c:v>
                </c:pt>
                <c:pt idx="59">
                  <c:v>6.4821128850000003</c:v>
                </c:pt>
                <c:pt idx="60">
                  <c:v>6.8931398389999998</c:v>
                </c:pt>
                <c:pt idx="61">
                  <c:v>7.12912941</c:v>
                </c:pt>
                <c:pt idx="62">
                  <c:v>7.7096385959999996</c:v>
                </c:pt>
                <c:pt idx="63">
                  <c:v>8.058509827</c:v>
                </c:pt>
                <c:pt idx="64">
                  <c:v>8.3696813579999993</c:v>
                </c:pt>
                <c:pt idx="65">
                  <c:v>8.9430456159999991</c:v>
                </c:pt>
                <c:pt idx="66">
                  <c:v>9.415888786</c:v>
                </c:pt>
                <c:pt idx="67">
                  <c:v>10.04999733</c:v>
                </c:pt>
                <c:pt idx="68">
                  <c:v>10.342275620000001</c:v>
                </c:pt>
                <c:pt idx="69">
                  <c:v>11.29509258</c:v>
                </c:pt>
                <c:pt idx="70">
                  <c:v>11.66659546</c:v>
                </c:pt>
                <c:pt idx="71">
                  <c:v>12.445822720000001</c:v>
                </c:pt>
                <c:pt idx="72">
                  <c:v>13.240971569999999</c:v>
                </c:pt>
                <c:pt idx="73">
                  <c:v>13.47931004</c:v>
                </c:pt>
                <c:pt idx="74">
                  <c:v>14.2320776</c:v>
                </c:pt>
                <c:pt idx="75">
                  <c:v>15.108351710000001</c:v>
                </c:pt>
                <c:pt idx="76">
                  <c:v>15.62300301</c:v>
                </c:pt>
                <c:pt idx="77">
                  <c:v>16.689872739999998</c:v>
                </c:pt>
                <c:pt idx="78">
                  <c:v>16.859354020000001</c:v>
                </c:pt>
                <c:pt idx="79">
                  <c:v>17.73625565</c:v>
                </c:pt>
                <c:pt idx="80">
                  <c:v>18.557100299999998</c:v>
                </c:pt>
                <c:pt idx="81">
                  <c:v>19.840814590000001</c:v>
                </c:pt>
                <c:pt idx="82">
                  <c:v>20.287370679999999</c:v>
                </c:pt>
                <c:pt idx="83">
                  <c:v>21.097997670000002</c:v>
                </c:pt>
                <c:pt idx="84">
                  <c:v>22.07334328</c:v>
                </c:pt>
                <c:pt idx="85">
                  <c:v>22.634010310000001</c:v>
                </c:pt>
                <c:pt idx="86">
                  <c:v>23.311586380000001</c:v>
                </c:pt>
                <c:pt idx="87">
                  <c:v>24.53666496</c:v>
                </c:pt>
                <c:pt idx="88">
                  <c:v>24.727306370000001</c:v>
                </c:pt>
                <c:pt idx="89">
                  <c:v>26.390504839999998</c:v>
                </c:pt>
                <c:pt idx="90">
                  <c:v>27.622053149999999</c:v>
                </c:pt>
                <c:pt idx="91">
                  <c:v>28.75121498</c:v>
                </c:pt>
                <c:pt idx="92">
                  <c:v>28.884990689999999</c:v>
                </c:pt>
                <c:pt idx="93">
                  <c:v>29.798339840000001</c:v>
                </c:pt>
                <c:pt idx="94">
                  <c:v>30.659835820000001</c:v>
                </c:pt>
                <c:pt idx="95">
                  <c:v>31.85083771</c:v>
                </c:pt>
                <c:pt idx="96">
                  <c:v>32.489574429999998</c:v>
                </c:pt>
                <c:pt idx="97">
                  <c:v>33.13640213</c:v>
                </c:pt>
                <c:pt idx="98">
                  <c:v>33.927742000000002</c:v>
                </c:pt>
                <c:pt idx="99">
                  <c:v>35.20462036</c:v>
                </c:pt>
                <c:pt idx="100">
                  <c:v>35.735206599999998</c:v>
                </c:pt>
                <c:pt idx="101">
                  <c:v>36.734504700000002</c:v>
                </c:pt>
                <c:pt idx="102">
                  <c:v>37.96887589</c:v>
                </c:pt>
                <c:pt idx="103">
                  <c:v>38.213169100000002</c:v>
                </c:pt>
                <c:pt idx="104">
                  <c:v>39.66772461</c:v>
                </c:pt>
                <c:pt idx="105">
                  <c:v>41.067531590000002</c:v>
                </c:pt>
                <c:pt idx="106">
                  <c:v>41.143711089999996</c:v>
                </c:pt>
                <c:pt idx="107">
                  <c:v>42.001888280000003</c:v>
                </c:pt>
                <c:pt idx="108">
                  <c:v>43.415039059999998</c:v>
                </c:pt>
                <c:pt idx="109">
                  <c:v>43.759925840000001</c:v>
                </c:pt>
                <c:pt idx="110">
                  <c:v>45.192417140000003</c:v>
                </c:pt>
                <c:pt idx="111">
                  <c:v>45.582996369999996</c:v>
                </c:pt>
                <c:pt idx="112">
                  <c:v>46.078472140000002</c:v>
                </c:pt>
                <c:pt idx="113">
                  <c:v>47.44256592</c:v>
                </c:pt>
                <c:pt idx="114">
                  <c:v>47.948509219999998</c:v>
                </c:pt>
                <c:pt idx="115">
                  <c:v>49.15077591</c:v>
                </c:pt>
                <c:pt idx="116">
                  <c:v>49.915714260000001</c:v>
                </c:pt>
                <c:pt idx="117">
                  <c:v>50.650058749999999</c:v>
                </c:pt>
                <c:pt idx="118">
                  <c:v>51.182975769999999</c:v>
                </c:pt>
                <c:pt idx="119">
                  <c:v>51.892631530000003</c:v>
                </c:pt>
                <c:pt idx="120">
                  <c:v>52.991786959999999</c:v>
                </c:pt>
                <c:pt idx="121">
                  <c:v>54.091056819999999</c:v>
                </c:pt>
                <c:pt idx="122">
                  <c:v>54.580356600000002</c:v>
                </c:pt>
                <c:pt idx="123">
                  <c:v>55.070125580000003</c:v>
                </c:pt>
                <c:pt idx="124">
                  <c:v>56.185966489999998</c:v>
                </c:pt>
                <c:pt idx="125">
                  <c:v>56.348976139999998</c:v>
                </c:pt>
                <c:pt idx="126">
                  <c:v>57.049739840000001</c:v>
                </c:pt>
                <c:pt idx="127">
                  <c:v>57.91876602</c:v>
                </c:pt>
                <c:pt idx="128">
                  <c:v>58.504428859999997</c:v>
                </c:pt>
                <c:pt idx="129">
                  <c:v>59.116867069999998</c:v>
                </c:pt>
                <c:pt idx="130">
                  <c:v>59.738651279999999</c:v>
                </c:pt>
                <c:pt idx="131">
                  <c:v>60.310440059999998</c:v>
                </c:pt>
                <c:pt idx="132">
                  <c:v>60.321571349999999</c:v>
                </c:pt>
                <c:pt idx="133">
                  <c:v>61.362644199999998</c:v>
                </c:pt>
                <c:pt idx="134">
                  <c:v>60.967521669999996</c:v>
                </c:pt>
                <c:pt idx="135">
                  <c:v>61.617191310000003</c:v>
                </c:pt>
                <c:pt idx="136">
                  <c:v>61.704498289999997</c:v>
                </c:pt>
                <c:pt idx="137">
                  <c:v>63.34517288</c:v>
                </c:pt>
                <c:pt idx="138">
                  <c:v>63.093788150000002</c:v>
                </c:pt>
                <c:pt idx="139">
                  <c:v>63.555561070000003</c:v>
                </c:pt>
                <c:pt idx="140">
                  <c:v>63.619388579999999</c:v>
                </c:pt>
                <c:pt idx="141">
                  <c:v>63.283271790000001</c:v>
                </c:pt>
                <c:pt idx="142">
                  <c:v>63.847644809999998</c:v>
                </c:pt>
                <c:pt idx="143">
                  <c:v>65.560821529999998</c:v>
                </c:pt>
                <c:pt idx="144">
                  <c:v>64.767250059999995</c:v>
                </c:pt>
                <c:pt idx="145">
                  <c:v>64.834770199999994</c:v>
                </c:pt>
                <c:pt idx="146">
                  <c:v>65.013343809999995</c:v>
                </c:pt>
                <c:pt idx="147">
                  <c:v>66.294898989999993</c:v>
                </c:pt>
                <c:pt idx="148">
                  <c:v>65.174995420000002</c:v>
                </c:pt>
                <c:pt idx="149">
                  <c:v>65.117286680000007</c:v>
                </c:pt>
                <c:pt idx="150">
                  <c:v>66.201065060000005</c:v>
                </c:pt>
                <c:pt idx="151">
                  <c:v>66.197875980000006</c:v>
                </c:pt>
                <c:pt idx="152">
                  <c:v>65.711669920000006</c:v>
                </c:pt>
                <c:pt idx="153">
                  <c:v>65.968330379999998</c:v>
                </c:pt>
                <c:pt idx="154">
                  <c:v>66.028678889999995</c:v>
                </c:pt>
                <c:pt idx="155">
                  <c:v>66.083793639999996</c:v>
                </c:pt>
                <c:pt idx="156">
                  <c:v>65.249320979999993</c:v>
                </c:pt>
                <c:pt idx="157">
                  <c:v>65.465797420000001</c:v>
                </c:pt>
                <c:pt idx="158">
                  <c:v>65.711349490000003</c:v>
                </c:pt>
                <c:pt idx="159">
                  <c:v>65.679756159999997</c:v>
                </c:pt>
                <c:pt idx="160">
                  <c:v>65.706176760000005</c:v>
                </c:pt>
                <c:pt idx="161">
                  <c:v>64.977394099999998</c:v>
                </c:pt>
                <c:pt idx="162">
                  <c:v>64.539810180000003</c:v>
                </c:pt>
                <c:pt idx="163">
                  <c:v>65.363349909999997</c:v>
                </c:pt>
                <c:pt idx="164">
                  <c:v>65.464591979999994</c:v>
                </c:pt>
                <c:pt idx="165">
                  <c:v>64.90644073</c:v>
                </c:pt>
                <c:pt idx="166">
                  <c:v>64.814605709999995</c:v>
                </c:pt>
                <c:pt idx="167">
                  <c:v>63.603542330000003</c:v>
                </c:pt>
                <c:pt idx="168">
                  <c:v>63.697463990000003</c:v>
                </c:pt>
                <c:pt idx="169">
                  <c:v>63.441486359999999</c:v>
                </c:pt>
                <c:pt idx="170">
                  <c:v>64.195533749999996</c:v>
                </c:pt>
                <c:pt idx="171">
                  <c:v>63.402236940000002</c:v>
                </c:pt>
                <c:pt idx="172">
                  <c:v>63.602993009999999</c:v>
                </c:pt>
                <c:pt idx="173">
                  <c:v>63.124187470000003</c:v>
                </c:pt>
                <c:pt idx="174">
                  <c:v>62.687740329999997</c:v>
                </c:pt>
                <c:pt idx="175">
                  <c:v>62.113029480000002</c:v>
                </c:pt>
                <c:pt idx="176">
                  <c:v>61.862827299999999</c:v>
                </c:pt>
                <c:pt idx="177">
                  <c:v>61.63889313</c:v>
                </c:pt>
                <c:pt idx="178">
                  <c:v>61.329887390000003</c:v>
                </c:pt>
                <c:pt idx="179">
                  <c:v>61.158191680000002</c:v>
                </c:pt>
                <c:pt idx="180">
                  <c:v>60.764339450000001</c:v>
                </c:pt>
                <c:pt idx="181">
                  <c:v>61.11692429</c:v>
                </c:pt>
                <c:pt idx="182">
                  <c:v>60.420867919999999</c:v>
                </c:pt>
                <c:pt idx="183">
                  <c:v>59.934123990000003</c:v>
                </c:pt>
                <c:pt idx="184">
                  <c:v>59.296627039999997</c:v>
                </c:pt>
                <c:pt idx="185">
                  <c:v>59.008689879999999</c:v>
                </c:pt>
                <c:pt idx="186">
                  <c:v>58.280635830000001</c:v>
                </c:pt>
                <c:pt idx="187">
                  <c:v>57.930511469999999</c:v>
                </c:pt>
                <c:pt idx="188">
                  <c:v>57.090465549999998</c:v>
                </c:pt>
                <c:pt idx="189">
                  <c:v>57.012767789999998</c:v>
                </c:pt>
                <c:pt idx="190">
                  <c:v>56.723037720000001</c:v>
                </c:pt>
                <c:pt idx="191">
                  <c:v>56.444866179999998</c:v>
                </c:pt>
                <c:pt idx="192">
                  <c:v>55.790081020000002</c:v>
                </c:pt>
                <c:pt idx="193">
                  <c:v>55.645759580000004</c:v>
                </c:pt>
                <c:pt idx="194">
                  <c:v>54.98394012</c:v>
                </c:pt>
                <c:pt idx="195">
                  <c:v>54.827121730000002</c:v>
                </c:pt>
                <c:pt idx="196">
                  <c:v>54.015521999999997</c:v>
                </c:pt>
                <c:pt idx="197">
                  <c:v>53.932346340000002</c:v>
                </c:pt>
                <c:pt idx="198">
                  <c:v>53.363910679999996</c:v>
                </c:pt>
                <c:pt idx="199">
                  <c:v>52.728137969999999</c:v>
                </c:pt>
                <c:pt idx="200">
                  <c:v>52.661834720000002</c:v>
                </c:pt>
                <c:pt idx="201">
                  <c:v>52.342899320000001</c:v>
                </c:pt>
                <c:pt idx="202">
                  <c:v>51.58873749</c:v>
                </c:pt>
                <c:pt idx="203">
                  <c:v>51.260318759999997</c:v>
                </c:pt>
                <c:pt idx="204">
                  <c:v>50.510860440000002</c:v>
                </c:pt>
                <c:pt idx="205">
                  <c:v>49.718631739999999</c:v>
                </c:pt>
                <c:pt idx="206">
                  <c:v>49.576782229999999</c:v>
                </c:pt>
                <c:pt idx="207">
                  <c:v>49.53453064</c:v>
                </c:pt>
                <c:pt idx="208">
                  <c:v>48.637207029999999</c:v>
                </c:pt>
                <c:pt idx="209">
                  <c:v>48.810279850000001</c:v>
                </c:pt>
                <c:pt idx="210">
                  <c:v>48.33280182</c:v>
                </c:pt>
                <c:pt idx="211">
                  <c:v>47.789745330000002</c:v>
                </c:pt>
                <c:pt idx="212">
                  <c:v>46.94338226</c:v>
                </c:pt>
                <c:pt idx="213">
                  <c:v>46.399841309999999</c:v>
                </c:pt>
                <c:pt idx="214">
                  <c:v>46.2439003</c:v>
                </c:pt>
                <c:pt idx="215">
                  <c:v>45.673736570000003</c:v>
                </c:pt>
                <c:pt idx="216">
                  <c:v>44.942939760000002</c:v>
                </c:pt>
                <c:pt idx="217">
                  <c:v>44.081253050000001</c:v>
                </c:pt>
                <c:pt idx="218">
                  <c:v>44.01806259</c:v>
                </c:pt>
                <c:pt idx="219">
                  <c:v>43.613845830000002</c:v>
                </c:pt>
                <c:pt idx="220">
                  <c:v>43.847415920000003</c:v>
                </c:pt>
                <c:pt idx="221">
                  <c:v>42.495399480000003</c:v>
                </c:pt>
                <c:pt idx="222">
                  <c:v>42.522769930000003</c:v>
                </c:pt>
                <c:pt idx="223">
                  <c:v>42.19367218</c:v>
                </c:pt>
                <c:pt idx="224">
                  <c:v>41.962425230000001</c:v>
                </c:pt>
                <c:pt idx="225">
                  <c:v>41.395523070000003</c:v>
                </c:pt>
                <c:pt idx="226">
                  <c:v>40.560131069999997</c:v>
                </c:pt>
                <c:pt idx="227">
                  <c:v>40.026058200000001</c:v>
                </c:pt>
                <c:pt idx="228">
                  <c:v>39.670341489999998</c:v>
                </c:pt>
                <c:pt idx="229">
                  <c:v>39.249858860000003</c:v>
                </c:pt>
                <c:pt idx="230">
                  <c:v>38.662136080000003</c:v>
                </c:pt>
                <c:pt idx="231">
                  <c:v>38.386672969999999</c:v>
                </c:pt>
                <c:pt idx="232">
                  <c:v>38.138275149999998</c:v>
                </c:pt>
                <c:pt idx="233">
                  <c:v>37.448745729999999</c:v>
                </c:pt>
                <c:pt idx="234">
                  <c:v>37.177555079999998</c:v>
                </c:pt>
                <c:pt idx="235">
                  <c:v>36.749385830000001</c:v>
                </c:pt>
                <c:pt idx="236">
                  <c:v>36.186286930000001</c:v>
                </c:pt>
                <c:pt idx="237">
                  <c:v>35.9453125</c:v>
                </c:pt>
                <c:pt idx="238">
                  <c:v>35.377441410000003</c:v>
                </c:pt>
                <c:pt idx="239">
                  <c:v>35.169975280000003</c:v>
                </c:pt>
                <c:pt idx="240">
                  <c:v>34.391887660000002</c:v>
                </c:pt>
                <c:pt idx="241">
                  <c:v>34.045711519999998</c:v>
                </c:pt>
                <c:pt idx="242">
                  <c:v>33.859367370000001</c:v>
                </c:pt>
                <c:pt idx="243">
                  <c:v>33.269226070000002</c:v>
                </c:pt>
                <c:pt idx="244">
                  <c:v>33.071548460000002</c:v>
                </c:pt>
                <c:pt idx="245">
                  <c:v>32.49069214</c:v>
                </c:pt>
                <c:pt idx="246">
                  <c:v>32.115364069999998</c:v>
                </c:pt>
                <c:pt idx="247">
                  <c:v>31.748670579999999</c:v>
                </c:pt>
                <c:pt idx="248">
                  <c:v>31.610816960000001</c:v>
                </c:pt>
                <c:pt idx="249">
                  <c:v>30.785522459999999</c:v>
                </c:pt>
                <c:pt idx="250">
                  <c:v>30.52306557</c:v>
                </c:pt>
                <c:pt idx="251">
                  <c:v>30.006391529999998</c:v>
                </c:pt>
                <c:pt idx="252">
                  <c:v>29.45371437</c:v>
                </c:pt>
                <c:pt idx="253">
                  <c:v>29.435337069999999</c:v>
                </c:pt>
                <c:pt idx="254">
                  <c:v>29.033409120000002</c:v>
                </c:pt>
                <c:pt idx="255">
                  <c:v>28.832250599999998</c:v>
                </c:pt>
                <c:pt idx="256">
                  <c:v>28.75462151</c:v>
                </c:pt>
                <c:pt idx="257">
                  <c:v>27.84765625</c:v>
                </c:pt>
                <c:pt idx="258">
                  <c:v>27.56075096</c:v>
                </c:pt>
                <c:pt idx="259">
                  <c:v>27.520969390000001</c:v>
                </c:pt>
                <c:pt idx="260">
                  <c:v>27.021459579999998</c:v>
                </c:pt>
                <c:pt idx="261">
                  <c:v>26.52811432</c:v>
                </c:pt>
                <c:pt idx="262">
                  <c:v>26.374343870000001</c:v>
                </c:pt>
                <c:pt idx="263">
                  <c:v>25.84440231</c:v>
                </c:pt>
                <c:pt idx="264">
                  <c:v>25.642938610000002</c:v>
                </c:pt>
                <c:pt idx="265">
                  <c:v>25.624740599999999</c:v>
                </c:pt>
                <c:pt idx="266">
                  <c:v>25.412927629999999</c:v>
                </c:pt>
                <c:pt idx="267">
                  <c:v>25.260013579999999</c:v>
                </c:pt>
                <c:pt idx="268">
                  <c:v>24.49163055</c:v>
                </c:pt>
                <c:pt idx="269">
                  <c:v>24.269588469999999</c:v>
                </c:pt>
                <c:pt idx="270">
                  <c:v>23.658069609999998</c:v>
                </c:pt>
                <c:pt idx="271">
                  <c:v>23.276601790000001</c:v>
                </c:pt>
                <c:pt idx="272">
                  <c:v>22.952701569999999</c:v>
                </c:pt>
                <c:pt idx="273">
                  <c:v>22.975156779999999</c:v>
                </c:pt>
                <c:pt idx="274">
                  <c:v>22.652444840000001</c:v>
                </c:pt>
                <c:pt idx="275">
                  <c:v>22.443466189999999</c:v>
                </c:pt>
                <c:pt idx="276">
                  <c:v>22.234840389999999</c:v>
                </c:pt>
                <c:pt idx="277">
                  <c:v>21.601955409999999</c:v>
                </c:pt>
                <c:pt idx="278">
                  <c:v>21.212842940000002</c:v>
                </c:pt>
                <c:pt idx="279">
                  <c:v>21.001447679999998</c:v>
                </c:pt>
                <c:pt idx="280">
                  <c:v>20.759805679999999</c:v>
                </c:pt>
                <c:pt idx="281">
                  <c:v>21.022134779999998</c:v>
                </c:pt>
                <c:pt idx="282">
                  <c:v>20.222568509999999</c:v>
                </c:pt>
                <c:pt idx="283">
                  <c:v>20.48601532</c:v>
                </c:pt>
                <c:pt idx="284">
                  <c:v>19.847822189999999</c:v>
                </c:pt>
                <c:pt idx="285">
                  <c:v>19.395912169999999</c:v>
                </c:pt>
                <c:pt idx="286">
                  <c:v>19.75273323</c:v>
                </c:pt>
                <c:pt idx="287">
                  <c:v>19.097290040000001</c:v>
                </c:pt>
                <c:pt idx="288">
                  <c:v>18.837503430000002</c:v>
                </c:pt>
                <c:pt idx="289">
                  <c:v>18.114288330000001</c:v>
                </c:pt>
                <c:pt idx="290">
                  <c:v>18.139503479999998</c:v>
                </c:pt>
                <c:pt idx="291">
                  <c:v>17.936384199999999</c:v>
                </c:pt>
                <c:pt idx="292">
                  <c:v>17.709306720000001</c:v>
                </c:pt>
                <c:pt idx="293">
                  <c:v>17.388904570000001</c:v>
                </c:pt>
                <c:pt idx="294">
                  <c:v>17.210092540000002</c:v>
                </c:pt>
                <c:pt idx="295">
                  <c:v>16.97006798</c:v>
                </c:pt>
                <c:pt idx="296">
                  <c:v>16.646286010000001</c:v>
                </c:pt>
                <c:pt idx="297">
                  <c:v>16.172830579999999</c:v>
                </c:pt>
                <c:pt idx="298">
                  <c:v>16.061605449999998</c:v>
                </c:pt>
                <c:pt idx="299">
                  <c:v>16.023969650000002</c:v>
                </c:pt>
                <c:pt idx="300">
                  <c:v>15.799221040000001</c:v>
                </c:pt>
                <c:pt idx="301">
                  <c:v>15.44304752</c:v>
                </c:pt>
                <c:pt idx="302">
                  <c:v>15.49990463</c:v>
                </c:pt>
                <c:pt idx="303">
                  <c:v>15.22927284</c:v>
                </c:pt>
                <c:pt idx="304">
                  <c:v>14.789675709999999</c:v>
                </c:pt>
                <c:pt idx="305">
                  <c:v>14.56818676</c:v>
                </c:pt>
                <c:pt idx="306">
                  <c:v>14.353675839999999</c:v>
                </c:pt>
                <c:pt idx="307">
                  <c:v>14.18978596</c:v>
                </c:pt>
                <c:pt idx="308">
                  <c:v>14.159683230000001</c:v>
                </c:pt>
                <c:pt idx="309">
                  <c:v>13.810597420000001</c:v>
                </c:pt>
                <c:pt idx="310">
                  <c:v>13.57527065</c:v>
                </c:pt>
                <c:pt idx="311">
                  <c:v>13.16864204</c:v>
                </c:pt>
                <c:pt idx="312">
                  <c:v>13.21548271</c:v>
                </c:pt>
                <c:pt idx="313">
                  <c:v>12.99473667</c:v>
                </c:pt>
                <c:pt idx="314">
                  <c:v>12.93971157</c:v>
                </c:pt>
                <c:pt idx="315">
                  <c:v>12.74494743</c:v>
                </c:pt>
                <c:pt idx="316">
                  <c:v>12.41918278</c:v>
                </c:pt>
                <c:pt idx="317">
                  <c:v>12.20504665</c:v>
                </c:pt>
                <c:pt idx="318">
                  <c:v>11.928211210000001</c:v>
                </c:pt>
                <c:pt idx="319">
                  <c:v>11.963049890000001</c:v>
                </c:pt>
                <c:pt idx="320">
                  <c:v>11.64629841</c:v>
                </c:pt>
                <c:pt idx="321">
                  <c:v>11.47842503</c:v>
                </c:pt>
                <c:pt idx="322">
                  <c:v>11.380239489999999</c:v>
                </c:pt>
                <c:pt idx="323">
                  <c:v>10.99769783</c:v>
                </c:pt>
                <c:pt idx="324">
                  <c:v>11.161824230000001</c:v>
                </c:pt>
                <c:pt idx="325">
                  <c:v>10.55667877</c:v>
                </c:pt>
                <c:pt idx="326">
                  <c:v>10.79867649</c:v>
                </c:pt>
                <c:pt idx="327">
                  <c:v>10.484940529999999</c:v>
                </c:pt>
                <c:pt idx="328">
                  <c:v>10.37332344</c:v>
                </c:pt>
                <c:pt idx="329">
                  <c:v>10.382247919999999</c:v>
                </c:pt>
                <c:pt idx="330">
                  <c:v>9.9686965940000007</c:v>
                </c:pt>
                <c:pt idx="331">
                  <c:v>10.22345829</c:v>
                </c:pt>
                <c:pt idx="332">
                  <c:v>9.8899402619999996</c:v>
                </c:pt>
                <c:pt idx="333">
                  <c:v>9.5972013470000004</c:v>
                </c:pt>
                <c:pt idx="334">
                  <c:v>9.5681400300000004</c:v>
                </c:pt>
                <c:pt idx="335">
                  <c:v>9.4601726530000008</c:v>
                </c:pt>
                <c:pt idx="336">
                  <c:v>9.3010244370000006</c:v>
                </c:pt>
                <c:pt idx="337">
                  <c:v>9.0753393169999992</c:v>
                </c:pt>
                <c:pt idx="338">
                  <c:v>8.8031158450000007</c:v>
                </c:pt>
                <c:pt idx="339">
                  <c:v>9.0135354999999997</c:v>
                </c:pt>
                <c:pt idx="340">
                  <c:v>8.6384019849999998</c:v>
                </c:pt>
                <c:pt idx="341">
                  <c:v>8.6153516769999996</c:v>
                </c:pt>
                <c:pt idx="342">
                  <c:v>8.4493160249999999</c:v>
                </c:pt>
                <c:pt idx="343">
                  <c:v>8.4031038280000008</c:v>
                </c:pt>
                <c:pt idx="344">
                  <c:v>8.3518495559999995</c:v>
                </c:pt>
                <c:pt idx="345">
                  <c:v>8.154990196</c:v>
                </c:pt>
                <c:pt idx="346">
                  <c:v>7.9478182789999998</c:v>
                </c:pt>
                <c:pt idx="347">
                  <c:v>7.828360558</c:v>
                </c:pt>
                <c:pt idx="348">
                  <c:v>7.8059167860000001</c:v>
                </c:pt>
                <c:pt idx="349">
                  <c:v>7.4315237999999999</c:v>
                </c:pt>
                <c:pt idx="350">
                  <c:v>7.3542642589999998</c:v>
                </c:pt>
                <c:pt idx="351">
                  <c:v>7.3351483350000004</c:v>
                </c:pt>
                <c:pt idx="352">
                  <c:v>7.4586749079999999</c:v>
                </c:pt>
                <c:pt idx="353">
                  <c:v>7.12912941</c:v>
                </c:pt>
                <c:pt idx="354">
                  <c:v>7.0332679750000002</c:v>
                </c:pt>
                <c:pt idx="355">
                  <c:v>6.8896169660000002</c:v>
                </c:pt>
                <c:pt idx="356">
                  <c:v>6.8138031960000003</c:v>
                </c:pt>
                <c:pt idx="357">
                  <c:v>6.6355257029999999</c:v>
                </c:pt>
                <c:pt idx="358">
                  <c:v>6.5232157710000003</c:v>
                </c:pt>
                <c:pt idx="359">
                  <c:v>6.566589832</c:v>
                </c:pt>
                <c:pt idx="360">
                  <c:v>6.2816820140000003</c:v>
                </c:pt>
                <c:pt idx="361">
                  <c:v>6.7696471210000002</c:v>
                </c:pt>
                <c:pt idx="362">
                  <c:v>6.4892292019999998</c:v>
                </c:pt>
                <c:pt idx="363">
                  <c:v>5.9206004139999999</c:v>
                </c:pt>
                <c:pt idx="364">
                  <c:v>6.102056503</c:v>
                </c:pt>
                <c:pt idx="365">
                  <c:v>6.0017519000000004</c:v>
                </c:pt>
                <c:pt idx="366">
                  <c:v>5.946074963</c:v>
                </c:pt>
                <c:pt idx="367">
                  <c:v>5.7700972559999997</c:v>
                </c:pt>
                <c:pt idx="368">
                  <c:v>5.8922820089999997</c:v>
                </c:pt>
                <c:pt idx="369">
                  <c:v>5.739010811</c:v>
                </c:pt>
                <c:pt idx="370">
                  <c:v>5.684525013</c:v>
                </c:pt>
                <c:pt idx="371">
                  <c:v>5.4909915920000003</c:v>
                </c:pt>
                <c:pt idx="372">
                  <c:v>5.3917679789999999</c:v>
                </c:pt>
                <c:pt idx="373">
                  <c:v>5.282407761</c:v>
                </c:pt>
                <c:pt idx="374">
                  <c:v>5.1649055480000001</c:v>
                </c:pt>
                <c:pt idx="375">
                  <c:v>5.1570091250000001</c:v>
                </c:pt>
                <c:pt idx="376">
                  <c:v>4.9883890150000001</c:v>
                </c:pt>
                <c:pt idx="377">
                  <c:v>4.9999923710000003</c:v>
                </c:pt>
                <c:pt idx="378">
                  <c:v>4.9534435270000001</c:v>
                </c:pt>
                <c:pt idx="379">
                  <c:v>4.7304739949999997</c:v>
                </c:pt>
                <c:pt idx="380">
                  <c:v>4.6945509909999998</c:v>
                </c:pt>
                <c:pt idx="381">
                  <c:v>4.6458234789999997</c:v>
                </c:pt>
                <c:pt idx="382">
                  <c:v>4.7236881259999999</c:v>
                </c:pt>
                <c:pt idx="383">
                  <c:v>4.7107119559999999</c:v>
                </c:pt>
                <c:pt idx="384">
                  <c:v>4.5988330839999998</c:v>
                </c:pt>
                <c:pt idx="385">
                  <c:v>4.4220609660000001</c:v>
                </c:pt>
                <c:pt idx="386">
                  <c:v>4.5094995500000001</c:v>
                </c:pt>
                <c:pt idx="387">
                  <c:v>4.2596993449999996</c:v>
                </c:pt>
                <c:pt idx="388">
                  <c:v>4.1697006229999998</c:v>
                </c:pt>
                <c:pt idx="389">
                  <c:v>4.2216114999999999</c:v>
                </c:pt>
                <c:pt idx="390">
                  <c:v>4.1379804609999997</c:v>
                </c:pt>
                <c:pt idx="391">
                  <c:v>4.0066556929999999</c:v>
                </c:pt>
                <c:pt idx="392">
                  <c:v>3.9885039330000001</c:v>
                </c:pt>
                <c:pt idx="393">
                  <c:v>3.98107481</c:v>
                </c:pt>
                <c:pt idx="394">
                  <c:v>3.7442557810000001</c:v>
                </c:pt>
                <c:pt idx="395">
                  <c:v>3.8489224910000002</c:v>
                </c:pt>
                <c:pt idx="396">
                  <c:v>3.8152430060000002</c:v>
                </c:pt>
                <c:pt idx="397">
                  <c:v>3.635715008</c:v>
                </c:pt>
                <c:pt idx="398">
                  <c:v>3.5576388840000002</c:v>
                </c:pt>
                <c:pt idx="399">
                  <c:v>3.8041508199999998</c:v>
                </c:pt>
                <c:pt idx="400">
                  <c:v>3.430361032</c:v>
                </c:pt>
                <c:pt idx="401">
                  <c:v>3.5100440979999998</c:v>
                </c:pt>
                <c:pt idx="402">
                  <c:v>3.495655298</c:v>
                </c:pt>
                <c:pt idx="403">
                  <c:v>3.4321537019999999</c:v>
                </c:pt>
                <c:pt idx="404">
                  <c:v>3.3547594549999999</c:v>
                </c:pt>
                <c:pt idx="405">
                  <c:v>3.1974680420000001</c:v>
                </c:pt>
                <c:pt idx="406">
                  <c:v>3.3139004710000002</c:v>
                </c:pt>
                <c:pt idx="407">
                  <c:v>3.2331550120000001</c:v>
                </c:pt>
                <c:pt idx="408">
                  <c:v>3.0528016089999999</c:v>
                </c:pt>
                <c:pt idx="409">
                  <c:v>3.1999440190000001</c:v>
                </c:pt>
                <c:pt idx="410">
                  <c:v>3.0838074679999998</c:v>
                </c:pt>
                <c:pt idx="411">
                  <c:v>3.0575513839999999</c:v>
                </c:pt>
                <c:pt idx="412">
                  <c:v>3.0325274470000001</c:v>
                </c:pt>
                <c:pt idx="413">
                  <c:v>2.9704670910000002</c:v>
                </c:pt>
                <c:pt idx="414">
                  <c:v>2.7885961529999999</c:v>
                </c:pt>
                <c:pt idx="415">
                  <c:v>2.843043089</c:v>
                </c:pt>
                <c:pt idx="416">
                  <c:v>2.6541290279999998</c:v>
                </c:pt>
                <c:pt idx="417">
                  <c:v>2.657590151</c:v>
                </c:pt>
                <c:pt idx="418">
                  <c:v>2.681948185</c:v>
                </c:pt>
                <c:pt idx="419">
                  <c:v>2.6175651549999999</c:v>
                </c:pt>
                <c:pt idx="420">
                  <c:v>2.6433539389999998</c:v>
                </c:pt>
                <c:pt idx="421">
                  <c:v>2.5736346239999999</c:v>
                </c:pt>
                <c:pt idx="422">
                  <c:v>2.5004680160000001</c:v>
                </c:pt>
                <c:pt idx="423">
                  <c:v>2.4514861109999999</c:v>
                </c:pt>
                <c:pt idx="424">
                  <c:v>2.2596879009999999</c:v>
                </c:pt>
                <c:pt idx="425">
                  <c:v>2.412371635</c:v>
                </c:pt>
                <c:pt idx="426">
                  <c:v>2.4628670220000002</c:v>
                </c:pt>
                <c:pt idx="427">
                  <c:v>2.3422541620000001</c:v>
                </c:pt>
                <c:pt idx="428">
                  <c:v>2.2628755570000001</c:v>
                </c:pt>
                <c:pt idx="429">
                  <c:v>2.3085896969999999</c:v>
                </c:pt>
                <c:pt idx="430">
                  <c:v>2.1939809320000001</c:v>
                </c:pt>
                <c:pt idx="431">
                  <c:v>2.3089847560000001</c:v>
                </c:pt>
                <c:pt idx="432">
                  <c:v>2.1447191239999999</c:v>
                </c:pt>
                <c:pt idx="433">
                  <c:v>2.2873520850000002</c:v>
                </c:pt>
                <c:pt idx="434">
                  <c:v>2.1197967530000001</c:v>
                </c:pt>
                <c:pt idx="435">
                  <c:v>2.1985340120000001</c:v>
                </c:pt>
                <c:pt idx="436">
                  <c:v>2.05148983</c:v>
                </c:pt>
                <c:pt idx="437">
                  <c:v>2.0170936579999998</c:v>
                </c:pt>
                <c:pt idx="438">
                  <c:v>2.007618189</c:v>
                </c:pt>
                <c:pt idx="439">
                  <c:v>1.931912541</c:v>
                </c:pt>
                <c:pt idx="440">
                  <c:v>1.899833798</c:v>
                </c:pt>
                <c:pt idx="441">
                  <c:v>1.865536571</c:v>
                </c:pt>
                <c:pt idx="442">
                  <c:v>1.990183711</c:v>
                </c:pt>
                <c:pt idx="443">
                  <c:v>1.8247071500000001</c:v>
                </c:pt>
                <c:pt idx="444">
                  <c:v>1.9003658290000001</c:v>
                </c:pt>
                <c:pt idx="445">
                  <c:v>1.7743989229999999</c:v>
                </c:pt>
                <c:pt idx="446">
                  <c:v>1.6420449020000001</c:v>
                </c:pt>
                <c:pt idx="447">
                  <c:v>1.6383477449999999</c:v>
                </c:pt>
                <c:pt idx="448">
                  <c:v>1.591234684</c:v>
                </c:pt>
                <c:pt idx="449">
                  <c:v>1.6472823619999999</c:v>
                </c:pt>
                <c:pt idx="450">
                  <c:v>1.619644761</c:v>
                </c:pt>
                <c:pt idx="451">
                  <c:v>1.6394401789999999</c:v>
                </c:pt>
                <c:pt idx="452">
                  <c:v>1.518930197</c:v>
                </c:pt>
                <c:pt idx="453">
                  <c:v>1.608943462</c:v>
                </c:pt>
                <c:pt idx="454">
                  <c:v>1.458758593</c:v>
                </c:pt>
                <c:pt idx="455">
                  <c:v>1.5015919209999999</c:v>
                </c:pt>
                <c:pt idx="456">
                  <c:v>1.5230220560000001</c:v>
                </c:pt>
                <c:pt idx="457">
                  <c:v>1.426278234</c:v>
                </c:pt>
                <c:pt idx="458">
                  <c:v>1.4125384089999999</c:v>
                </c:pt>
                <c:pt idx="459">
                  <c:v>1.478532314</c:v>
                </c:pt>
                <c:pt idx="460">
                  <c:v>1.401809335</c:v>
                </c:pt>
                <c:pt idx="461">
                  <c:v>1.3267860410000001</c:v>
                </c:pt>
                <c:pt idx="462">
                  <c:v>1.413950324</c:v>
                </c:pt>
                <c:pt idx="463">
                  <c:v>1.414335251</c:v>
                </c:pt>
                <c:pt idx="464">
                  <c:v>1.3634009359999999</c:v>
                </c:pt>
                <c:pt idx="465">
                  <c:v>1.2921781539999999</c:v>
                </c:pt>
                <c:pt idx="466">
                  <c:v>1.290932655</c:v>
                </c:pt>
                <c:pt idx="467">
                  <c:v>1.2122449870000001</c:v>
                </c:pt>
                <c:pt idx="468">
                  <c:v>1.286102772</c:v>
                </c:pt>
                <c:pt idx="469">
                  <c:v>1.2786787749999999</c:v>
                </c:pt>
                <c:pt idx="470">
                  <c:v>1.242251158</c:v>
                </c:pt>
                <c:pt idx="471">
                  <c:v>1.219100595</c:v>
                </c:pt>
                <c:pt idx="472">
                  <c:v>1.198775291</c:v>
                </c:pt>
                <c:pt idx="473">
                  <c:v>1.1863565439999999</c:v>
                </c:pt>
                <c:pt idx="474">
                  <c:v>1.2064748999999999</c:v>
                </c:pt>
                <c:pt idx="475">
                  <c:v>1.189958692</c:v>
                </c:pt>
                <c:pt idx="476">
                  <c:v>1.1993067260000001</c:v>
                </c:pt>
                <c:pt idx="477">
                  <c:v>1.089906931</c:v>
                </c:pt>
                <c:pt idx="478">
                  <c:v>1.06248498</c:v>
                </c:pt>
                <c:pt idx="479">
                  <c:v>1.0610525609999999</c:v>
                </c:pt>
                <c:pt idx="480">
                  <c:v>1.051308036</c:v>
                </c:pt>
                <c:pt idx="481">
                  <c:v>1.0733884570000001</c:v>
                </c:pt>
                <c:pt idx="482">
                  <c:v>0.96564519410000005</c:v>
                </c:pt>
                <c:pt idx="483">
                  <c:v>0.98812186719999995</c:v>
                </c:pt>
                <c:pt idx="484">
                  <c:v>0.9396441579</c:v>
                </c:pt>
                <c:pt idx="485">
                  <c:v>1.0305044649999999</c:v>
                </c:pt>
                <c:pt idx="486">
                  <c:v>0.94630956649999998</c:v>
                </c:pt>
                <c:pt idx="487">
                  <c:v>0.90867334600000005</c:v>
                </c:pt>
                <c:pt idx="488">
                  <c:v>1.0097975729999999</c:v>
                </c:pt>
                <c:pt idx="489">
                  <c:v>0.95942223069999999</c:v>
                </c:pt>
                <c:pt idx="490">
                  <c:v>0.89952176809999995</c:v>
                </c:pt>
                <c:pt idx="491">
                  <c:v>0.88050997259999997</c:v>
                </c:pt>
                <c:pt idx="492">
                  <c:v>0.92823100089999999</c:v>
                </c:pt>
                <c:pt idx="493">
                  <c:v>0.87762355800000003</c:v>
                </c:pt>
                <c:pt idx="494">
                  <c:v>0.91022086140000003</c:v>
                </c:pt>
                <c:pt idx="495">
                  <c:v>0.79188024999999995</c:v>
                </c:pt>
                <c:pt idx="496">
                  <c:v>0.80829286580000004</c:v>
                </c:pt>
                <c:pt idx="497">
                  <c:v>0.78484481569999998</c:v>
                </c:pt>
                <c:pt idx="498">
                  <c:v>0.84660917520000001</c:v>
                </c:pt>
                <c:pt idx="499">
                  <c:v>0.75607383250000004</c:v>
                </c:pt>
                <c:pt idx="500">
                  <c:v>0.77031058070000002</c:v>
                </c:pt>
                <c:pt idx="501">
                  <c:v>0.86865115169999996</c:v>
                </c:pt>
                <c:pt idx="502">
                  <c:v>0.7152340412</c:v>
                </c:pt>
                <c:pt idx="503">
                  <c:v>0.76864659790000001</c:v>
                </c:pt>
                <c:pt idx="504">
                  <c:v>0.68693143130000001</c:v>
                </c:pt>
                <c:pt idx="505">
                  <c:v>0.70227521660000003</c:v>
                </c:pt>
                <c:pt idx="506">
                  <c:v>0.73494976759999997</c:v>
                </c:pt>
                <c:pt idx="507">
                  <c:v>0.73207390309999998</c:v>
                </c:pt>
                <c:pt idx="508">
                  <c:v>0.7137451172</c:v>
                </c:pt>
                <c:pt idx="509">
                  <c:v>0.68732053039999996</c:v>
                </c:pt>
                <c:pt idx="510">
                  <c:v>0.61518782380000003</c:v>
                </c:pt>
                <c:pt idx="511">
                  <c:v>0.70438128710000003</c:v>
                </c:pt>
                <c:pt idx="512">
                  <c:v>0.64342832569999997</c:v>
                </c:pt>
                <c:pt idx="513">
                  <c:v>0.6656478643</c:v>
                </c:pt>
                <c:pt idx="514">
                  <c:v>0.63991630079999995</c:v>
                </c:pt>
                <c:pt idx="515">
                  <c:v>0.61964976790000004</c:v>
                </c:pt>
                <c:pt idx="516">
                  <c:v>0.58099788429999999</c:v>
                </c:pt>
                <c:pt idx="517">
                  <c:v>0.68476152420000003</c:v>
                </c:pt>
                <c:pt idx="518">
                  <c:v>0.57552862169999996</c:v>
                </c:pt>
                <c:pt idx="519">
                  <c:v>0.63950824740000001</c:v>
                </c:pt>
                <c:pt idx="520">
                  <c:v>0.60359799859999996</c:v>
                </c:pt>
                <c:pt idx="521">
                  <c:v>0.55541968350000004</c:v>
                </c:pt>
                <c:pt idx="522">
                  <c:v>0.59486538170000003</c:v>
                </c:pt>
                <c:pt idx="523">
                  <c:v>0.53670293089999999</c:v>
                </c:pt>
                <c:pt idx="524">
                  <c:v>0.55519044399999995</c:v>
                </c:pt>
                <c:pt idx="525">
                  <c:v>0.53740495440000002</c:v>
                </c:pt>
                <c:pt idx="526">
                  <c:v>0.460283041</c:v>
                </c:pt>
                <c:pt idx="527">
                  <c:v>0.55603677029999998</c:v>
                </c:pt>
                <c:pt idx="528">
                  <c:v>0.54136079550000005</c:v>
                </c:pt>
                <c:pt idx="529">
                  <c:v>0.53599286079999997</c:v>
                </c:pt>
                <c:pt idx="530">
                  <c:v>0.53875201939999995</c:v>
                </c:pt>
                <c:pt idx="531">
                  <c:v>0.48404368759999999</c:v>
                </c:pt>
                <c:pt idx="532">
                  <c:v>0.51454937460000005</c:v>
                </c:pt>
                <c:pt idx="533">
                  <c:v>0.49140763279999999</c:v>
                </c:pt>
                <c:pt idx="534">
                  <c:v>0.5367345214</c:v>
                </c:pt>
                <c:pt idx="535">
                  <c:v>0.46891549230000001</c:v>
                </c:pt>
                <c:pt idx="536">
                  <c:v>0.44105967880000002</c:v>
                </c:pt>
                <c:pt idx="537">
                  <c:v>0.50463682409999999</c:v>
                </c:pt>
                <c:pt idx="538">
                  <c:v>0.48882123830000002</c:v>
                </c:pt>
                <c:pt idx="539">
                  <c:v>0.41102963689999999</c:v>
                </c:pt>
                <c:pt idx="540">
                  <c:v>0.45682367680000002</c:v>
                </c:pt>
                <c:pt idx="541">
                  <c:v>0.44567492600000003</c:v>
                </c:pt>
                <c:pt idx="542">
                  <c:v>0.46156460049999998</c:v>
                </c:pt>
                <c:pt idx="543">
                  <c:v>0.44252741340000001</c:v>
                </c:pt>
                <c:pt idx="544">
                  <c:v>0.35975646970000003</c:v>
                </c:pt>
                <c:pt idx="545">
                  <c:v>0.39926463369999998</c:v>
                </c:pt>
                <c:pt idx="546">
                  <c:v>0.4526471198</c:v>
                </c:pt>
                <c:pt idx="547">
                  <c:v>0.39593791960000002</c:v>
                </c:pt>
                <c:pt idx="548">
                  <c:v>0.40555760260000001</c:v>
                </c:pt>
                <c:pt idx="549">
                  <c:v>0.37090250850000001</c:v>
                </c:pt>
                <c:pt idx="550">
                  <c:v>0.4062202573</c:v>
                </c:pt>
                <c:pt idx="551">
                  <c:v>0.3276673853</c:v>
                </c:pt>
                <c:pt idx="552">
                  <c:v>0.35870108010000001</c:v>
                </c:pt>
                <c:pt idx="553">
                  <c:v>0.34885573390000002</c:v>
                </c:pt>
                <c:pt idx="554">
                  <c:v>0.37132427099999998</c:v>
                </c:pt>
                <c:pt idx="555">
                  <c:v>0.3727134466</c:v>
                </c:pt>
                <c:pt idx="556">
                  <c:v>0.37055373190000002</c:v>
                </c:pt>
                <c:pt idx="557">
                  <c:v>0.36989459400000002</c:v>
                </c:pt>
                <c:pt idx="558">
                  <c:v>0.33519893880000001</c:v>
                </c:pt>
                <c:pt idx="559">
                  <c:v>0.31771355870000001</c:v>
                </c:pt>
                <c:pt idx="560">
                  <c:v>0.33160206679999998</c:v>
                </c:pt>
                <c:pt idx="561">
                  <c:v>0.3427344859</c:v>
                </c:pt>
                <c:pt idx="562">
                  <c:v>0.32214325669999999</c:v>
                </c:pt>
                <c:pt idx="563">
                  <c:v>0.30457317830000002</c:v>
                </c:pt>
                <c:pt idx="564">
                  <c:v>0.31792238350000002</c:v>
                </c:pt>
                <c:pt idx="565">
                  <c:v>0.31385305520000001</c:v>
                </c:pt>
                <c:pt idx="566">
                  <c:v>0.32931190729999998</c:v>
                </c:pt>
                <c:pt idx="567">
                  <c:v>0.30299776789999999</c:v>
                </c:pt>
                <c:pt idx="568">
                  <c:v>0.36034658549999998</c:v>
                </c:pt>
                <c:pt idx="569">
                  <c:v>0.31638565660000001</c:v>
                </c:pt>
                <c:pt idx="570">
                  <c:v>0.30510699749999998</c:v>
                </c:pt>
                <c:pt idx="571">
                  <c:v>0.2762681246</c:v>
                </c:pt>
                <c:pt idx="572">
                  <c:v>0.3583002985</c:v>
                </c:pt>
                <c:pt idx="573">
                  <c:v>0.27461126450000001</c:v>
                </c:pt>
                <c:pt idx="574">
                  <c:v>0.25977846980000002</c:v>
                </c:pt>
                <c:pt idx="575">
                  <c:v>0.27091461420000001</c:v>
                </c:pt>
                <c:pt idx="576">
                  <c:v>0.28937172890000001</c:v>
                </c:pt>
                <c:pt idx="577">
                  <c:v>0.2713043094</c:v>
                </c:pt>
                <c:pt idx="578">
                  <c:v>0.29241669180000002</c:v>
                </c:pt>
                <c:pt idx="579">
                  <c:v>0.26968243720000001</c:v>
                </c:pt>
                <c:pt idx="580">
                  <c:v>0.24929054079999999</c:v>
                </c:pt>
                <c:pt idx="581">
                  <c:v>0.20703381300000001</c:v>
                </c:pt>
                <c:pt idx="582">
                  <c:v>0.1983194053</c:v>
                </c:pt>
                <c:pt idx="583">
                  <c:v>0.2383868247</c:v>
                </c:pt>
                <c:pt idx="584">
                  <c:v>0.20531070230000001</c:v>
                </c:pt>
                <c:pt idx="585">
                  <c:v>0.22950448100000001</c:v>
                </c:pt>
                <c:pt idx="586">
                  <c:v>0.26974922420000003</c:v>
                </c:pt>
                <c:pt idx="587">
                  <c:v>0.2250055671</c:v>
                </c:pt>
                <c:pt idx="588">
                  <c:v>0.2666723728</c:v>
                </c:pt>
                <c:pt idx="589">
                  <c:v>0.1861418635</c:v>
                </c:pt>
                <c:pt idx="590">
                  <c:v>0.26987057920000002</c:v>
                </c:pt>
                <c:pt idx="591">
                  <c:v>0.2402097285</c:v>
                </c:pt>
                <c:pt idx="592">
                  <c:v>0.20449490849999999</c:v>
                </c:pt>
                <c:pt idx="593">
                  <c:v>0.2293204069</c:v>
                </c:pt>
                <c:pt idx="594">
                  <c:v>0.2028894275</c:v>
                </c:pt>
                <c:pt idx="595">
                  <c:v>0.23131766919999999</c:v>
                </c:pt>
                <c:pt idx="596">
                  <c:v>0.20400008559999999</c:v>
                </c:pt>
                <c:pt idx="597">
                  <c:v>0.2217102796</c:v>
                </c:pt>
                <c:pt idx="598">
                  <c:v>0.2327768207</c:v>
                </c:pt>
                <c:pt idx="599">
                  <c:v>0.22849039730000001</c:v>
                </c:pt>
                <c:pt idx="600">
                  <c:v>0.1856784672</c:v>
                </c:pt>
                <c:pt idx="601">
                  <c:v>0.18706883490000001</c:v>
                </c:pt>
                <c:pt idx="602">
                  <c:v>0.17212177810000001</c:v>
                </c:pt>
                <c:pt idx="603">
                  <c:v>0.1927864403</c:v>
                </c:pt>
                <c:pt idx="604">
                  <c:v>0.23923645909999999</c:v>
                </c:pt>
                <c:pt idx="605">
                  <c:v>0.20425929130000001</c:v>
                </c:pt>
                <c:pt idx="606">
                  <c:v>0.1578046978</c:v>
                </c:pt>
                <c:pt idx="607">
                  <c:v>0.187508285</c:v>
                </c:pt>
                <c:pt idx="608">
                  <c:v>0.21706365050000001</c:v>
                </c:pt>
                <c:pt idx="609">
                  <c:v>0.17420426010000001</c:v>
                </c:pt>
                <c:pt idx="610">
                  <c:v>0.13377057019999999</c:v>
                </c:pt>
              </c:numCache>
            </c:numRef>
          </c:yVal>
          <c:smooth val="1"/>
          <c:extLst>
            <c:ext xmlns:c16="http://schemas.microsoft.com/office/drawing/2014/chart" uri="{C3380CC4-5D6E-409C-BE32-E72D297353CC}">
              <c16:uniqueId val="{00000007-3FAF-4CBF-82DD-E60AB52489B3}"/>
            </c:ext>
          </c:extLst>
        </c:ser>
        <c:dLbls>
          <c:showLegendKey val="0"/>
          <c:showVal val="0"/>
          <c:showCatName val="0"/>
          <c:showSerName val="0"/>
          <c:showPercent val="0"/>
          <c:showBubbleSize val="0"/>
        </c:dLbls>
        <c:axId val="148439376"/>
        <c:axId val="148438816"/>
      </c:scatterChart>
      <c:valAx>
        <c:axId val="148437696"/>
        <c:scaling>
          <c:orientation val="minMax"/>
          <c:max val="600"/>
          <c:min val="310"/>
        </c:scaling>
        <c:delete val="0"/>
        <c:axPos val="b"/>
        <c:title>
          <c:tx>
            <c:rich>
              <a:bodyPr/>
              <a:lstStyle/>
              <a:p>
                <a:pPr>
                  <a:defRPr/>
                </a:pPr>
                <a:r>
                  <a:rPr lang="en-GB"/>
                  <a:t>Wavelength (nm)</a:t>
                </a:r>
              </a:p>
            </c:rich>
          </c:tx>
          <c:layout/>
          <c:overlay val="0"/>
        </c:title>
        <c:numFmt formatCode="General" sourceLinked="1"/>
        <c:majorTickMark val="out"/>
        <c:minorTickMark val="none"/>
        <c:tickLblPos val="nextTo"/>
        <c:crossAx val="148438256"/>
        <c:crosses val="autoZero"/>
        <c:crossBetween val="midCat"/>
      </c:valAx>
      <c:valAx>
        <c:axId val="148438256"/>
        <c:scaling>
          <c:orientation val="minMax"/>
          <c:max val="1.2"/>
          <c:min val="0"/>
        </c:scaling>
        <c:delete val="0"/>
        <c:axPos val="l"/>
        <c:title>
          <c:tx>
            <c:rich>
              <a:bodyPr rot="-5400000" vert="horz"/>
              <a:lstStyle/>
              <a:p>
                <a:pPr>
                  <a:defRPr/>
                </a:pPr>
                <a:r>
                  <a:rPr lang="en-GB"/>
                  <a:t>Absorbance (a.u.)</a:t>
                </a:r>
              </a:p>
            </c:rich>
          </c:tx>
          <c:layout/>
          <c:overlay val="0"/>
        </c:title>
        <c:numFmt formatCode="General" sourceLinked="1"/>
        <c:majorTickMark val="out"/>
        <c:minorTickMark val="none"/>
        <c:tickLblPos val="nextTo"/>
        <c:crossAx val="148437696"/>
        <c:crosses val="autoZero"/>
        <c:crossBetween val="midCat"/>
      </c:valAx>
      <c:valAx>
        <c:axId val="148438816"/>
        <c:scaling>
          <c:orientation val="minMax"/>
          <c:min val="0"/>
        </c:scaling>
        <c:delete val="0"/>
        <c:axPos val="r"/>
        <c:title>
          <c:tx>
            <c:rich>
              <a:bodyPr rot="-5400000" vert="horz"/>
              <a:lstStyle/>
              <a:p>
                <a:pPr>
                  <a:defRPr/>
                </a:pPr>
                <a:r>
                  <a:rPr lang="en-GB"/>
                  <a:t>Inensity (a.u)</a:t>
                </a:r>
              </a:p>
            </c:rich>
          </c:tx>
          <c:layout/>
          <c:overlay val="0"/>
        </c:title>
        <c:numFmt formatCode="General" sourceLinked="1"/>
        <c:majorTickMark val="out"/>
        <c:minorTickMark val="none"/>
        <c:tickLblPos val="nextTo"/>
        <c:crossAx val="148439376"/>
        <c:crosses val="max"/>
        <c:crossBetween val="midCat"/>
      </c:valAx>
      <c:valAx>
        <c:axId val="148439376"/>
        <c:scaling>
          <c:orientation val="minMax"/>
        </c:scaling>
        <c:delete val="1"/>
        <c:axPos val="b"/>
        <c:numFmt formatCode="General" sourceLinked="1"/>
        <c:majorTickMark val="out"/>
        <c:minorTickMark val="none"/>
        <c:tickLblPos val="nextTo"/>
        <c:crossAx val="148438816"/>
        <c:crosses val="autoZero"/>
        <c:crossBetween val="midCat"/>
      </c:valAx>
      <c:spPr>
        <a:noFill/>
        <a:ln w="25400">
          <a:noFill/>
        </a:ln>
      </c:spPr>
    </c:plotArea>
    <c:legend>
      <c:legendPos val="b"/>
      <c:layout>
        <c:manualLayout>
          <c:xMode val="edge"/>
          <c:yMode val="edge"/>
          <c:x val="0.63540198306781215"/>
          <c:y val="6.3296362324064839E-2"/>
          <c:w val="0.35301190348361622"/>
          <c:h val="0.3449876613445742"/>
        </c:manualLayout>
      </c:layout>
      <c:overlay val="0"/>
    </c:legend>
    <c:plotVisOnly val="1"/>
    <c:dispBlanksAs val="gap"/>
    <c:showDLblsOverMax val="0"/>
  </c:chart>
  <c:spPr>
    <a:ln>
      <a:noFill/>
    </a:ln>
  </c:spPr>
  <c:externalData r:id="rId1">
    <c:autoUpdate val="0"/>
  </c:externalData>
</c:chartSpace>
</file>

<file path=ppt/charts/chart3.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tx>
            <c:strRef>
              <c:f>AZD_MP_spectra!$I$3</c:f>
              <c:strCache>
                <c:ptCount val="1"/>
                <c:pt idx="0">
                  <c:v>Intensity (a.u.)</c:v>
                </c:pt>
              </c:strCache>
            </c:strRef>
          </c:tx>
          <c:spPr>
            <a:ln>
              <a:solidFill>
                <a:srgbClr val="C00000"/>
              </a:solidFill>
            </a:ln>
          </c:spPr>
          <c:marker>
            <c:symbol val="none"/>
          </c:marker>
          <c:xVal>
            <c:numRef>
              <c:f>AZD_MP_spectra!$H$4:$H$128</c:f>
              <c:numCache>
                <c:formatCode>General</c:formatCode>
                <c:ptCount val="125"/>
                <c:pt idx="0">
                  <c:v>680</c:v>
                </c:pt>
                <c:pt idx="1">
                  <c:v>685</c:v>
                </c:pt>
                <c:pt idx="2">
                  <c:v>690</c:v>
                </c:pt>
                <c:pt idx="3">
                  <c:v>695</c:v>
                </c:pt>
                <c:pt idx="4">
                  <c:v>700</c:v>
                </c:pt>
                <c:pt idx="5">
                  <c:v>705</c:v>
                </c:pt>
                <c:pt idx="6">
                  <c:v>710</c:v>
                </c:pt>
                <c:pt idx="7">
                  <c:v>715</c:v>
                </c:pt>
                <c:pt idx="8">
                  <c:v>720</c:v>
                </c:pt>
                <c:pt idx="9">
                  <c:v>725</c:v>
                </c:pt>
                <c:pt idx="10">
                  <c:v>730</c:v>
                </c:pt>
                <c:pt idx="11">
                  <c:v>735</c:v>
                </c:pt>
                <c:pt idx="12">
                  <c:v>740</c:v>
                </c:pt>
                <c:pt idx="13">
                  <c:v>745</c:v>
                </c:pt>
                <c:pt idx="14">
                  <c:v>750</c:v>
                </c:pt>
                <c:pt idx="15">
                  <c:v>755</c:v>
                </c:pt>
                <c:pt idx="16">
                  <c:v>760</c:v>
                </c:pt>
                <c:pt idx="17">
                  <c:v>765</c:v>
                </c:pt>
                <c:pt idx="18">
                  <c:v>770</c:v>
                </c:pt>
                <c:pt idx="19">
                  <c:v>775</c:v>
                </c:pt>
                <c:pt idx="20">
                  <c:v>780</c:v>
                </c:pt>
                <c:pt idx="21">
                  <c:v>785</c:v>
                </c:pt>
                <c:pt idx="22">
                  <c:v>790</c:v>
                </c:pt>
                <c:pt idx="23">
                  <c:v>795</c:v>
                </c:pt>
                <c:pt idx="24">
                  <c:v>800</c:v>
                </c:pt>
                <c:pt idx="25">
                  <c:v>805</c:v>
                </c:pt>
                <c:pt idx="26">
                  <c:v>810</c:v>
                </c:pt>
                <c:pt idx="27">
                  <c:v>815</c:v>
                </c:pt>
                <c:pt idx="28">
                  <c:v>820</c:v>
                </c:pt>
                <c:pt idx="29">
                  <c:v>825</c:v>
                </c:pt>
                <c:pt idx="30">
                  <c:v>830</c:v>
                </c:pt>
                <c:pt idx="31">
                  <c:v>835</c:v>
                </c:pt>
                <c:pt idx="32">
                  <c:v>840</c:v>
                </c:pt>
                <c:pt idx="33">
                  <c:v>845</c:v>
                </c:pt>
                <c:pt idx="34">
                  <c:v>850</c:v>
                </c:pt>
                <c:pt idx="35">
                  <c:v>855</c:v>
                </c:pt>
                <c:pt idx="36">
                  <c:v>860</c:v>
                </c:pt>
                <c:pt idx="37">
                  <c:v>865</c:v>
                </c:pt>
                <c:pt idx="38">
                  <c:v>870</c:v>
                </c:pt>
                <c:pt idx="39">
                  <c:v>875</c:v>
                </c:pt>
                <c:pt idx="40">
                  <c:v>880</c:v>
                </c:pt>
                <c:pt idx="41">
                  <c:v>885</c:v>
                </c:pt>
                <c:pt idx="42">
                  <c:v>890</c:v>
                </c:pt>
                <c:pt idx="43">
                  <c:v>895</c:v>
                </c:pt>
                <c:pt idx="44">
                  <c:v>900</c:v>
                </c:pt>
                <c:pt idx="45">
                  <c:v>905</c:v>
                </c:pt>
                <c:pt idx="46">
                  <c:v>910</c:v>
                </c:pt>
                <c:pt idx="47">
                  <c:v>915</c:v>
                </c:pt>
                <c:pt idx="48">
                  <c:v>920</c:v>
                </c:pt>
                <c:pt idx="49">
                  <c:v>925</c:v>
                </c:pt>
                <c:pt idx="50">
                  <c:v>930</c:v>
                </c:pt>
                <c:pt idx="51">
                  <c:v>935</c:v>
                </c:pt>
                <c:pt idx="52">
                  <c:v>940</c:v>
                </c:pt>
                <c:pt idx="53">
                  <c:v>945</c:v>
                </c:pt>
                <c:pt idx="54">
                  <c:v>950</c:v>
                </c:pt>
                <c:pt idx="55">
                  <c:v>955</c:v>
                </c:pt>
                <c:pt idx="56">
                  <c:v>960</c:v>
                </c:pt>
                <c:pt idx="57">
                  <c:v>965</c:v>
                </c:pt>
                <c:pt idx="58">
                  <c:v>970</c:v>
                </c:pt>
                <c:pt idx="59">
                  <c:v>975</c:v>
                </c:pt>
                <c:pt idx="60">
                  <c:v>980</c:v>
                </c:pt>
                <c:pt idx="61">
                  <c:v>985</c:v>
                </c:pt>
                <c:pt idx="62">
                  <c:v>990</c:v>
                </c:pt>
                <c:pt idx="63">
                  <c:v>995</c:v>
                </c:pt>
                <c:pt idx="64">
                  <c:v>1000</c:v>
                </c:pt>
                <c:pt idx="65">
                  <c:v>1005</c:v>
                </c:pt>
                <c:pt idx="66">
                  <c:v>1010</c:v>
                </c:pt>
                <c:pt idx="67">
                  <c:v>1015</c:v>
                </c:pt>
                <c:pt idx="68">
                  <c:v>1020</c:v>
                </c:pt>
                <c:pt idx="69">
                  <c:v>1025</c:v>
                </c:pt>
                <c:pt idx="70">
                  <c:v>1030</c:v>
                </c:pt>
                <c:pt idx="71">
                  <c:v>1035</c:v>
                </c:pt>
                <c:pt idx="72">
                  <c:v>1040</c:v>
                </c:pt>
                <c:pt idx="73">
                  <c:v>1045</c:v>
                </c:pt>
                <c:pt idx="74">
                  <c:v>1050</c:v>
                </c:pt>
                <c:pt idx="75">
                  <c:v>1055</c:v>
                </c:pt>
                <c:pt idx="76">
                  <c:v>1060</c:v>
                </c:pt>
                <c:pt idx="77">
                  <c:v>1065</c:v>
                </c:pt>
                <c:pt idx="78">
                  <c:v>1070</c:v>
                </c:pt>
                <c:pt idx="79">
                  <c:v>1075</c:v>
                </c:pt>
                <c:pt idx="80">
                  <c:v>1080</c:v>
                </c:pt>
                <c:pt idx="81">
                  <c:v>1085</c:v>
                </c:pt>
                <c:pt idx="82">
                  <c:v>1090</c:v>
                </c:pt>
                <c:pt idx="83">
                  <c:v>1095</c:v>
                </c:pt>
                <c:pt idx="84">
                  <c:v>1100</c:v>
                </c:pt>
                <c:pt idx="85">
                  <c:v>1105</c:v>
                </c:pt>
                <c:pt idx="86">
                  <c:v>1110</c:v>
                </c:pt>
                <c:pt idx="87">
                  <c:v>1115</c:v>
                </c:pt>
                <c:pt idx="88">
                  <c:v>1120</c:v>
                </c:pt>
                <c:pt idx="89">
                  <c:v>1125</c:v>
                </c:pt>
                <c:pt idx="90">
                  <c:v>1130</c:v>
                </c:pt>
                <c:pt idx="91">
                  <c:v>1135</c:v>
                </c:pt>
                <c:pt idx="92">
                  <c:v>1140</c:v>
                </c:pt>
                <c:pt idx="93">
                  <c:v>1145</c:v>
                </c:pt>
                <c:pt idx="94">
                  <c:v>1150</c:v>
                </c:pt>
                <c:pt idx="95">
                  <c:v>1155</c:v>
                </c:pt>
                <c:pt idx="96">
                  <c:v>1160</c:v>
                </c:pt>
                <c:pt idx="97">
                  <c:v>1165</c:v>
                </c:pt>
                <c:pt idx="98">
                  <c:v>1170</c:v>
                </c:pt>
                <c:pt idx="99">
                  <c:v>1175</c:v>
                </c:pt>
                <c:pt idx="100">
                  <c:v>1180</c:v>
                </c:pt>
                <c:pt idx="101">
                  <c:v>1185</c:v>
                </c:pt>
                <c:pt idx="102">
                  <c:v>1190</c:v>
                </c:pt>
                <c:pt idx="103">
                  <c:v>1195</c:v>
                </c:pt>
                <c:pt idx="104">
                  <c:v>1200</c:v>
                </c:pt>
                <c:pt idx="105">
                  <c:v>1205</c:v>
                </c:pt>
                <c:pt idx="106">
                  <c:v>1210</c:v>
                </c:pt>
                <c:pt idx="107">
                  <c:v>1215</c:v>
                </c:pt>
                <c:pt idx="108">
                  <c:v>1220</c:v>
                </c:pt>
                <c:pt idx="109">
                  <c:v>1225</c:v>
                </c:pt>
                <c:pt idx="110">
                  <c:v>1230</c:v>
                </c:pt>
                <c:pt idx="111">
                  <c:v>1235</c:v>
                </c:pt>
                <c:pt idx="112">
                  <c:v>1240</c:v>
                </c:pt>
                <c:pt idx="113">
                  <c:v>1245</c:v>
                </c:pt>
                <c:pt idx="114">
                  <c:v>1250</c:v>
                </c:pt>
                <c:pt idx="115">
                  <c:v>1255</c:v>
                </c:pt>
                <c:pt idx="116">
                  <c:v>1260</c:v>
                </c:pt>
                <c:pt idx="117">
                  <c:v>1265</c:v>
                </c:pt>
                <c:pt idx="118">
                  <c:v>1270</c:v>
                </c:pt>
                <c:pt idx="119">
                  <c:v>1275</c:v>
                </c:pt>
                <c:pt idx="120">
                  <c:v>1280</c:v>
                </c:pt>
                <c:pt idx="121">
                  <c:v>1285</c:v>
                </c:pt>
                <c:pt idx="122">
                  <c:v>1290</c:v>
                </c:pt>
                <c:pt idx="123">
                  <c:v>1295</c:v>
                </c:pt>
                <c:pt idx="124">
                  <c:v>1300</c:v>
                </c:pt>
              </c:numCache>
            </c:numRef>
          </c:xVal>
          <c:yVal>
            <c:numRef>
              <c:f>AZD_MP_spectra!$I$4:$I$128</c:f>
              <c:numCache>
                <c:formatCode>General</c:formatCode>
                <c:ptCount val="125"/>
                <c:pt idx="0">
                  <c:v>73.375699999999995</c:v>
                </c:pt>
                <c:pt idx="1">
                  <c:v>54.547400000000003</c:v>
                </c:pt>
                <c:pt idx="2">
                  <c:v>43.466500000000003</c:v>
                </c:pt>
                <c:pt idx="3">
                  <c:v>32.907899999999998</c:v>
                </c:pt>
                <c:pt idx="4">
                  <c:v>22.731400000000001</c:v>
                </c:pt>
                <c:pt idx="5">
                  <c:v>19.052499999999998</c:v>
                </c:pt>
                <c:pt idx="6">
                  <c:v>15.0823</c:v>
                </c:pt>
                <c:pt idx="7">
                  <c:v>14.454000000000001</c:v>
                </c:pt>
                <c:pt idx="8">
                  <c:v>13.885199999999999</c:v>
                </c:pt>
                <c:pt idx="9">
                  <c:v>12.039400000000001</c:v>
                </c:pt>
                <c:pt idx="10">
                  <c:v>12.8132</c:v>
                </c:pt>
                <c:pt idx="11">
                  <c:v>17.4649</c:v>
                </c:pt>
                <c:pt idx="12">
                  <c:v>22.8584</c:v>
                </c:pt>
                <c:pt idx="13">
                  <c:v>27.019600000000001</c:v>
                </c:pt>
                <c:pt idx="14">
                  <c:v>27.505500000000001</c:v>
                </c:pt>
                <c:pt idx="15">
                  <c:v>28.698599999999999</c:v>
                </c:pt>
                <c:pt idx="16">
                  <c:v>30.645800000000001</c:v>
                </c:pt>
                <c:pt idx="17">
                  <c:v>35.220100000000002</c:v>
                </c:pt>
                <c:pt idx="18">
                  <c:v>39.307099999999998</c:v>
                </c:pt>
                <c:pt idx="19">
                  <c:v>43.485599999999998</c:v>
                </c:pt>
                <c:pt idx="20">
                  <c:v>45.12</c:v>
                </c:pt>
                <c:pt idx="21">
                  <c:v>44.101100000000002</c:v>
                </c:pt>
                <c:pt idx="22">
                  <c:v>42.442300000000003</c:v>
                </c:pt>
                <c:pt idx="23">
                  <c:v>44.5779</c:v>
                </c:pt>
                <c:pt idx="24">
                  <c:v>42.899299999999997</c:v>
                </c:pt>
                <c:pt idx="25">
                  <c:v>44.398499999999999</c:v>
                </c:pt>
                <c:pt idx="26">
                  <c:v>42.381599999999999</c:v>
                </c:pt>
                <c:pt idx="27">
                  <c:v>41.8536</c:v>
                </c:pt>
                <c:pt idx="28">
                  <c:v>40.752899999999997</c:v>
                </c:pt>
                <c:pt idx="29">
                  <c:v>40.480400000000003</c:v>
                </c:pt>
                <c:pt idx="30">
                  <c:v>34.109000000000002</c:v>
                </c:pt>
                <c:pt idx="31">
                  <c:v>28.784300000000002</c:v>
                </c:pt>
                <c:pt idx="32">
                  <c:v>27.424299999999999</c:v>
                </c:pt>
                <c:pt idx="33">
                  <c:v>25.490400000000001</c:v>
                </c:pt>
                <c:pt idx="34">
                  <c:v>23.0639</c:v>
                </c:pt>
                <c:pt idx="35">
                  <c:v>19.632400000000001</c:v>
                </c:pt>
                <c:pt idx="36">
                  <c:v>16.6189</c:v>
                </c:pt>
                <c:pt idx="37">
                  <c:v>13.439500000000001</c:v>
                </c:pt>
                <c:pt idx="38">
                  <c:v>9.0366</c:v>
                </c:pt>
                <c:pt idx="39">
                  <c:v>6.1269</c:v>
                </c:pt>
                <c:pt idx="40">
                  <c:v>4.5815000000000001</c:v>
                </c:pt>
                <c:pt idx="41">
                  <c:v>3.5324</c:v>
                </c:pt>
                <c:pt idx="42">
                  <c:v>2.4432</c:v>
                </c:pt>
                <c:pt idx="43">
                  <c:v>1.7090000000000001</c:v>
                </c:pt>
                <c:pt idx="44">
                  <c:v>1.3354999999999999</c:v>
                </c:pt>
                <c:pt idx="45">
                  <c:v>1.0438000000000001</c:v>
                </c:pt>
                <c:pt idx="46">
                  <c:v>0.87070000000000003</c:v>
                </c:pt>
                <c:pt idx="47">
                  <c:v>0.75629999999999997</c:v>
                </c:pt>
                <c:pt idx="48">
                  <c:v>0.61750000000000005</c:v>
                </c:pt>
                <c:pt idx="49">
                  <c:v>0.52500000000000002</c:v>
                </c:pt>
                <c:pt idx="50">
                  <c:v>0.44819999999999999</c:v>
                </c:pt>
                <c:pt idx="51">
                  <c:v>0.36770000000000003</c:v>
                </c:pt>
                <c:pt idx="52">
                  <c:v>0.32400000000000001</c:v>
                </c:pt>
                <c:pt idx="53">
                  <c:v>0.29780000000000001</c:v>
                </c:pt>
                <c:pt idx="54">
                  <c:v>0.29799999999999999</c:v>
                </c:pt>
                <c:pt idx="55">
                  <c:v>0.32219999999999999</c:v>
                </c:pt>
                <c:pt idx="56">
                  <c:v>0.3488</c:v>
                </c:pt>
                <c:pt idx="57">
                  <c:v>0.35870000000000002</c:v>
                </c:pt>
                <c:pt idx="58">
                  <c:v>0.35580000000000001</c:v>
                </c:pt>
                <c:pt idx="59">
                  <c:v>0.32840000000000003</c:v>
                </c:pt>
                <c:pt idx="60">
                  <c:v>0.2389</c:v>
                </c:pt>
                <c:pt idx="61">
                  <c:v>0.2132</c:v>
                </c:pt>
                <c:pt idx="62">
                  <c:v>0.21460000000000001</c:v>
                </c:pt>
                <c:pt idx="63">
                  <c:v>0.1875</c:v>
                </c:pt>
                <c:pt idx="64">
                  <c:v>0.16850000000000001</c:v>
                </c:pt>
                <c:pt idx="65">
                  <c:v>0.15540000000000001</c:v>
                </c:pt>
                <c:pt idx="66">
                  <c:v>0.1211</c:v>
                </c:pt>
                <c:pt idx="67">
                  <c:v>9.0999999999999998E-2</c:v>
                </c:pt>
                <c:pt idx="68">
                  <c:v>7.6399999999999996E-2</c:v>
                </c:pt>
                <c:pt idx="69">
                  <c:v>6.2399999999999997E-2</c:v>
                </c:pt>
                <c:pt idx="70">
                  <c:v>6.2600000000000003E-2</c:v>
                </c:pt>
                <c:pt idx="71">
                  <c:v>6.7400000000000002E-2</c:v>
                </c:pt>
                <c:pt idx="72">
                  <c:v>6.9699999999999998E-2</c:v>
                </c:pt>
                <c:pt idx="73">
                  <c:v>8.43E-2</c:v>
                </c:pt>
                <c:pt idx="74">
                  <c:v>8.0199999999999994E-2</c:v>
                </c:pt>
                <c:pt idx="75">
                  <c:v>6.9800000000000001E-2</c:v>
                </c:pt>
                <c:pt idx="76">
                  <c:v>5.8099999999999999E-2</c:v>
                </c:pt>
                <c:pt idx="77">
                  <c:v>4.65E-2</c:v>
                </c:pt>
                <c:pt idx="78">
                  <c:v>3.2899999999999999E-2</c:v>
                </c:pt>
                <c:pt idx="79">
                  <c:v>2.7E-2</c:v>
                </c:pt>
                <c:pt idx="80">
                  <c:v>2.1600000000000001E-2</c:v>
                </c:pt>
                <c:pt idx="81">
                  <c:v>1.7899999999999999E-2</c:v>
                </c:pt>
                <c:pt idx="82">
                  <c:v>1.41E-2</c:v>
                </c:pt>
                <c:pt idx="83">
                  <c:v>1.0200000000000001E-2</c:v>
                </c:pt>
                <c:pt idx="84">
                  <c:v>6.8999999999999999E-3</c:v>
                </c:pt>
                <c:pt idx="85">
                  <c:v>4.4999999999999997E-3</c:v>
                </c:pt>
                <c:pt idx="86">
                  <c:v>3.8E-3</c:v>
                </c:pt>
                <c:pt idx="87">
                  <c:v>3.0000000000000001E-3</c:v>
                </c:pt>
                <c:pt idx="88">
                  <c:v>2.7000000000000001E-3</c:v>
                </c:pt>
                <c:pt idx="89">
                  <c:v>2.0999999999999999E-3</c:v>
                </c:pt>
                <c:pt idx="90">
                  <c:v>1.6999999999999999E-3</c:v>
                </c:pt>
                <c:pt idx="91">
                  <c:v>1.1000000000000001E-3</c:v>
                </c:pt>
                <c:pt idx="92">
                  <c:v>1.5E-3</c:v>
                </c:pt>
                <c:pt idx="93">
                  <c:v>1.4E-3</c:v>
                </c:pt>
                <c:pt idx="94">
                  <c:v>1.6999999999999999E-3</c:v>
                </c:pt>
                <c:pt idx="95">
                  <c:v>1.1000000000000001E-3</c:v>
                </c:pt>
                <c:pt idx="96">
                  <c:v>1.4E-3</c:v>
                </c:pt>
                <c:pt idx="97">
                  <c:v>1.2999999999999999E-3</c:v>
                </c:pt>
                <c:pt idx="98">
                  <c:v>1.6000000000000001E-3</c:v>
                </c:pt>
                <c:pt idx="99">
                  <c:v>1.1999999999999999E-3</c:v>
                </c:pt>
                <c:pt idx="100">
                  <c:v>1E-3</c:v>
                </c:pt>
                <c:pt idx="101">
                  <c:v>1.4E-3</c:v>
                </c:pt>
                <c:pt idx="102">
                  <c:v>1.2999999999999999E-3</c:v>
                </c:pt>
                <c:pt idx="103">
                  <c:v>1.4E-3</c:v>
                </c:pt>
                <c:pt idx="104">
                  <c:v>1.4E-3</c:v>
                </c:pt>
                <c:pt idx="105">
                  <c:v>1.1999999999999999E-3</c:v>
                </c:pt>
                <c:pt idx="106">
                  <c:v>1.1000000000000001E-3</c:v>
                </c:pt>
                <c:pt idx="107">
                  <c:v>1.4E-3</c:v>
                </c:pt>
                <c:pt idx="108">
                  <c:v>1.1999999999999999E-3</c:v>
                </c:pt>
                <c:pt idx="109">
                  <c:v>1.4E-3</c:v>
                </c:pt>
                <c:pt idx="110">
                  <c:v>1.4E-3</c:v>
                </c:pt>
                <c:pt idx="111">
                  <c:v>1.4E-3</c:v>
                </c:pt>
                <c:pt idx="112">
                  <c:v>1.2999999999999999E-3</c:v>
                </c:pt>
                <c:pt idx="113">
                  <c:v>6.9999999999999999E-4</c:v>
                </c:pt>
                <c:pt idx="114">
                  <c:v>0</c:v>
                </c:pt>
                <c:pt idx="115">
                  <c:v>0</c:v>
                </c:pt>
                <c:pt idx="116">
                  <c:v>0</c:v>
                </c:pt>
                <c:pt idx="117">
                  <c:v>0</c:v>
                </c:pt>
                <c:pt idx="118">
                  <c:v>0</c:v>
                </c:pt>
                <c:pt idx="119">
                  <c:v>0</c:v>
                </c:pt>
                <c:pt idx="120">
                  <c:v>0</c:v>
                </c:pt>
                <c:pt idx="121">
                  <c:v>0</c:v>
                </c:pt>
                <c:pt idx="122">
                  <c:v>0</c:v>
                </c:pt>
                <c:pt idx="123">
                  <c:v>0</c:v>
                </c:pt>
                <c:pt idx="124">
                  <c:v>0</c:v>
                </c:pt>
              </c:numCache>
            </c:numRef>
          </c:yVal>
          <c:smooth val="1"/>
          <c:extLst>
            <c:ext xmlns:c16="http://schemas.microsoft.com/office/drawing/2014/chart" uri="{C3380CC4-5D6E-409C-BE32-E72D297353CC}">
              <c16:uniqueId val="{00000000-11DF-42DB-B221-BE666921BFAD}"/>
            </c:ext>
          </c:extLst>
        </c:ser>
        <c:dLbls>
          <c:showLegendKey val="0"/>
          <c:showVal val="0"/>
          <c:showCatName val="0"/>
          <c:showSerName val="0"/>
          <c:showPercent val="0"/>
          <c:showBubbleSize val="0"/>
        </c:dLbls>
        <c:axId val="148441616"/>
        <c:axId val="148442176"/>
      </c:scatterChart>
      <c:valAx>
        <c:axId val="148441616"/>
        <c:scaling>
          <c:orientation val="minMax"/>
          <c:max val="1000"/>
          <c:min val="680"/>
        </c:scaling>
        <c:delete val="0"/>
        <c:axPos val="b"/>
        <c:title>
          <c:tx>
            <c:rich>
              <a:bodyPr/>
              <a:lstStyle/>
              <a:p>
                <a:pPr>
                  <a:defRPr/>
                </a:pPr>
                <a:r>
                  <a:rPr lang="en-GB"/>
                  <a:t>Wavelength</a:t>
                </a:r>
                <a:r>
                  <a:rPr lang="en-GB" baseline="0"/>
                  <a:t> (nm)</a:t>
                </a:r>
                <a:endParaRPr lang="en-GB"/>
              </a:p>
            </c:rich>
          </c:tx>
          <c:layout/>
          <c:overlay val="0"/>
        </c:title>
        <c:numFmt formatCode="General" sourceLinked="1"/>
        <c:majorTickMark val="out"/>
        <c:minorTickMark val="none"/>
        <c:tickLblPos val="nextTo"/>
        <c:crossAx val="148442176"/>
        <c:crosses val="autoZero"/>
        <c:crossBetween val="midCat"/>
      </c:valAx>
      <c:valAx>
        <c:axId val="148442176"/>
        <c:scaling>
          <c:orientation val="minMax"/>
          <c:min val="0"/>
        </c:scaling>
        <c:delete val="0"/>
        <c:axPos val="l"/>
        <c:title>
          <c:tx>
            <c:rich>
              <a:bodyPr rot="-5400000" vert="horz"/>
              <a:lstStyle/>
              <a:p>
                <a:pPr>
                  <a:defRPr/>
                </a:pPr>
                <a:r>
                  <a:rPr lang="en-GB"/>
                  <a:t>Mean intensity (a.u.)</a:t>
                </a:r>
              </a:p>
            </c:rich>
          </c:tx>
          <c:layout/>
          <c:overlay val="0"/>
        </c:title>
        <c:numFmt formatCode="General" sourceLinked="1"/>
        <c:majorTickMark val="out"/>
        <c:minorTickMark val="none"/>
        <c:tickLblPos val="nextTo"/>
        <c:crossAx val="148441616"/>
        <c:crosses val="autoZero"/>
        <c:crossBetween val="midCat"/>
      </c:valAx>
      <c:spPr>
        <a:noFill/>
        <a:ln w="25400">
          <a:noFill/>
        </a:ln>
      </c:spPr>
    </c:plotArea>
    <c:plotVisOnly val="1"/>
    <c:dispBlanksAs val="gap"/>
    <c:showDLblsOverMax val="0"/>
  </c:chart>
  <c:spPr>
    <a:ln>
      <a:noFill/>
    </a:ln>
  </c:spPr>
  <c:externalData r:id="rId1">
    <c:autoUpdate val="0"/>
  </c:externalData>
</c:chartSpace>
</file>

<file path=ppt/charts/chart4.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3107277835086471"/>
          <c:y val="7.8867108304795597E-2"/>
          <c:w val="0.58813929916080032"/>
          <c:h val="0.67569127114341287"/>
        </c:manualLayout>
      </c:layout>
      <c:barChart>
        <c:barDir val="col"/>
        <c:grouping val="clustered"/>
        <c:varyColors val="0"/>
        <c:ser>
          <c:idx val="1"/>
          <c:order val="0"/>
          <c:tx>
            <c:strRef>
              <c:f>Sheet1!$B$1</c:f>
              <c:strCache>
                <c:ptCount val="1"/>
                <c:pt idx="0">
                  <c:v>Count</c:v>
                </c:pt>
              </c:strCache>
            </c:strRef>
          </c:tx>
          <c:spPr>
            <a:solidFill>
              <a:schemeClr val="accent1">
                <a:alpha val="19000"/>
              </a:schemeClr>
            </a:solidFill>
            <a:ln>
              <a:noFill/>
            </a:ln>
            <a:effectLst/>
          </c:spPr>
          <c:invertIfNegative val="0"/>
          <c:dPt>
            <c:idx val="4"/>
            <c:invertIfNegative val="0"/>
            <c:bubble3D val="0"/>
            <c:spPr>
              <a:solidFill>
                <a:schemeClr val="accent5">
                  <a:lumMod val="50000"/>
                  <a:alpha val="19000"/>
                </a:schemeClr>
              </a:solidFill>
              <a:ln>
                <a:noFill/>
              </a:ln>
              <a:effectLst/>
            </c:spPr>
            <c:extLst>
              <c:ext xmlns:c16="http://schemas.microsoft.com/office/drawing/2014/chart" uri="{C3380CC4-5D6E-409C-BE32-E72D297353CC}">
                <c16:uniqueId val="{00000001-9D6E-4CE2-9D51-A45588F3C908}"/>
              </c:ext>
            </c:extLst>
          </c:dPt>
          <c:dPt>
            <c:idx val="5"/>
            <c:invertIfNegative val="0"/>
            <c:bubble3D val="0"/>
            <c:spPr>
              <a:solidFill>
                <a:schemeClr val="accent5">
                  <a:lumMod val="75000"/>
                  <a:alpha val="19000"/>
                </a:schemeClr>
              </a:solidFill>
              <a:ln>
                <a:noFill/>
              </a:ln>
              <a:effectLst/>
            </c:spPr>
            <c:extLst>
              <c:ext xmlns:c16="http://schemas.microsoft.com/office/drawing/2014/chart" uri="{C3380CC4-5D6E-409C-BE32-E72D297353CC}">
                <c16:uniqueId val="{00000003-9D6E-4CE2-9D51-A45588F3C908}"/>
              </c:ext>
            </c:extLst>
          </c:dPt>
          <c:dPt>
            <c:idx val="6"/>
            <c:invertIfNegative val="0"/>
            <c:bubble3D val="0"/>
            <c:spPr>
              <a:solidFill>
                <a:schemeClr val="accent5">
                  <a:lumMod val="75000"/>
                  <a:alpha val="19000"/>
                </a:schemeClr>
              </a:solidFill>
              <a:ln>
                <a:noFill/>
              </a:ln>
              <a:effectLst/>
            </c:spPr>
            <c:extLst>
              <c:ext xmlns:c16="http://schemas.microsoft.com/office/drawing/2014/chart" uri="{C3380CC4-5D6E-409C-BE32-E72D297353CC}">
                <c16:uniqueId val="{00000005-9D6E-4CE2-9D51-A45588F3C908}"/>
              </c:ext>
            </c:extLst>
          </c:dPt>
          <c:dPt>
            <c:idx val="9"/>
            <c:invertIfNegative val="0"/>
            <c:bubble3D val="0"/>
            <c:spPr>
              <a:solidFill>
                <a:srgbClr val="00B0F0">
                  <a:alpha val="19000"/>
                </a:srgbClr>
              </a:solidFill>
              <a:ln>
                <a:noFill/>
              </a:ln>
              <a:effectLst/>
            </c:spPr>
            <c:extLst>
              <c:ext xmlns:c16="http://schemas.microsoft.com/office/drawing/2014/chart" uri="{C3380CC4-5D6E-409C-BE32-E72D297353CC}">
                <c16:uniqueId val="{00000007-9D6E-4CE2-9D51-A45588F3C908}"/>
              </c:ext>
            </c:extLst>
          </c:dPt>
          <c:dPt>
            <c:idx val="10"/>
            <c:invertIfNegative val="0"/>
            <c:bubble3D val="0"/>
            <c:spPr>
              <a:solidFill>
                <a:srgbClr val="3AF42C">
                  <a:alpha val="19000"/>
                </a:srgbClr>
              </a:solidFill>
              <a:ln>
                <a:noFill/>
              </a:ln>
              <a:effectLst/>
            </c:spPr>
            <c:extLst>
              <c:ext xmlns:c16="http://schemas.microsoft.com/office/drawing/2014/chart" uri="{C3380CC4-5D6E-409C-BE32-E72D297353CC}">
                <c16:uniqueId val="{00000009-9D6E-4CE2-9D51-A45588F3C908}"/>
              </c:ext>
            </c:extLst>
          </c:dPt>
          <c:dPt>
            <c:idx val="11"/>
            <c:invertIfNegative val="0"/>
            <c:bubble3D val="0"/>
            <c:spPr>
              <a:solidFill>
                <a:srgbClr val="3AF42C">
                  <a:alpha val="18824"/>
                </a:srgbClr>
              </a:solidFill>
              <a:ln>
                <a:noFill/>
              </a:ln>
              <a:effectLst/>
            </c:spPr>
            <c:extLst>
              <c:ext xmlns:c16="http://schemas.microsoft.com/office/drawing/2014/chart" uri="{C3380CC4-5D6E-409C-BE32-E72D297353CC}">
                <c16:uniqueId val="{0000000B-9D6E-4CE2-9D51-A45588F3C908}"/>
              </c:ext>
            </c:extLst>
          </c:dPt>
          <c:dPt>
            <c:idx val="12"/>
            <c:invertIfNegative val="0"/>
            <c:bubble3D val="0"/>
            <c:spPr>
              <a:solidFill>
                <a:srgbClr val="FFFF00">
                  <a:alpha val="19000"/>
                </a:srgbClr>
              </a:solidFill>
              <a:ln>
                <a:noFill/>
              </a:ln>
              <a:effectLst/>
            </c:spPr>
            <c:extLst>
              <c:ext xmlns:c16="http://schemas.microsoft.com/office/drawing/2014/chart" uri="{C3380CC4-5D6E-409C-BE32-E72D297353CC}">
                <c16:uniqueId val="{0000000D-9D6E-4CE2-9D51-A45588F3C908}"/>
              </c:ext>
            </c:extLst>
          </c:dPt>
          <c:dPt>
            <c:idx val="13"/>
            <c:invertIfNegative val="0"/>
            <c:bubble3D val="0"/>
            <c:spPr>
              <a:solidFill>
                <a:srgbClr val="FFC000">
                  <a:alpha val="19000"/>
                </a:srgbClr>
              </a:solidFill>
              <a:ln>
                <a:noFill/>
              </a:ln>
              <a:effectLst/>
            </c:spPr>
            <c:extLst>
              <c:ext xmlns:c16="http://schemas.microsoft.com/office/drawing/2014/chart" uri="{C3380CC4-5D6E-409C-BE32-E72D297353CC}">
                <c16:uniqueId val="{0000000F-9D6E-4CE2-9D51-A45588F3C908}"/>
              </c:ext>
            </c:extLst>
          </c:dPt>
          <c:dPt>
            <c:idx val="14"/>
            <c:invertIfNegative val="0"/>
            <c:bubble3D val="0"/>
            <c:spPr>
              <a:solidFill>
                <a:srgbClr val="FF0000">
                  <a:alpha val="19000"/>
                </a:srgbClr>
              </a:solidFill>
              <a:ln>
                <a:noFill/>
              </a:ln>
              <a:effectLst/>
            </c:spPr>
            <c:extLst>
              <c:ext xmlns:c16="http://schemas.microsoft.com/office/drawing/2014/chart" uri="{C3380CC4-5D6E-409C-BE32-E72D297353CC}">
                <c16:uniqueId val="{00000011-9D6E-4CE2-9D51-A45588F3C908}"/>
              </c:ext>
            </c:extLst>
          </c:dPt>
          <c:dPt>
            <c:idx val="15"/>
            <c:invertIfNegative val="0"/>
            <c:bubble3D val="0"/>
            <c:spPr>
              <a:solidFill>
                <a:srgbClr val="FF0000">
                  <a:alpha val="19000"/>
                </a:srgbClr>
              </a:solidFill>
              <a:ln>
                <a:noFill/>
              </a:ln>
              <a:effectLst/>
            </c:spPr>
            <c:extLst>
              <c:ext xmlns:c16="http://schemas.microsoft.com/office/drawing/2014/chart" uri="{C3380CC4-5D6E-409C-BE32-E72D297353CC}">
                <c16:uniqueId val="{00000013-9D6E-4CE2-9D51-A45588F3C908}"/>
              </c:ext>
            </c:extLst>
          </c:dPt>
          <c:dPt>
            <c:idx val="16"/>
            <c:invertIfNegative val="0"/>
            <c:bubble3D val="0"/>
            <c:spPr>
              <a:solidFill>
                <a:srgbClr val="C00000">
                  <a:alpha val="19000"/>
                </a:srgbClr>
              </a:solidFill>
              <a:ln>
                <a:noFill/>
              </a:ln>
              <a:effectLst/>
            </c:spPr>
            <c:extLst>
              <c:ext xmlns:c16="http://schemas.microsoft.com/office/drawing/2014/chart" uri="{C3380CC4-5D6E-409C-BE32-E72D297353CC}">
                <c16:uniqueId val="{00000015-9D6E-4CE2-9D51-A45588F3C908}"/>
              </c:ext>
            </c:extLst>
          </c:dPt>
          <c:dPt>
            <c:idx val="17"/>
            <c:invertIfNegative val="0"/>
            <c:bubble3D val="0"/>
            <c:spPr>
              <a:solidFill>
                <a:schemeClr val="accent2">
                  <a:lumMod val="50000"/>
                  <a:alpha val="19000"/>
                </a:schemeClr>
              </a:solidFill>
              <a:ln>
                <a:noFill/>
              </a:ln>
              <a:effectLst/>
            </c:spPr>
            <c:extLst>
              <c:ext xmlns:c16="http://schemas.microsoft.com/office/drawing/2014/chart" uri="{C3380CC4-5D6E-409C-BE32-E72D297353CC}">
                <c16:uniqueId val="{00000017-9D6E-4CE2-9D51-A45588F3C908}"/>
              </c:ext>
            </c:extLst>
          </c:dPt>
          <c:dPt>
            <c:idx val="18"/>
            <c:invertIfNegative val="0"/>
            <c:bubble3D val="0"/>
            <c:spPr>
              <a:solidFill>
                <a:schemeClr val="accent2">
                  <a:lumMod val="50000"/>
                  <a:alpha val="19000"/>
                </a:schemeClr>
              </a:solidFill>
              <a:ln>
                <a:noFill/>
              </a:ln>
              <a:effectLst/>
            </c:spPr>
            <c:extLst>
              <c:ext xmlns:c16="http://schemas.microsoft.com/office/drawing/2014/chart" uri="{C3380CC4-5D6E-409C-BE32-E72D297353CC}">
                <c16:uniqueId val="{00000019-9D6E-4CE2-9D51-A45588F3C908}"/>
              </c:ext>
            </c:extLst>
          </c:dPt>
          <c:dPt>
            <c:idx val="19"/>
            <c:invertIfNegative val="0"/>
            <c:bubble3D val="0"/>
            <c:spPr>
              <a:solidFill>
                <a:schemeClr val="accent2">
                  <a:lumMod val="50000"/>
                  <a:alpha val="19000"/>
                </a:schemeClr>
              </a:solidFill>
              <a:ln>
                <a:noFill/>
              </a:ln>
              <a:effectLst/>
            </c:spPr>
            <c:extLst>
              <c:ext xmlns:c16="http://schemas.microsoft.com/office/drawing/2014/chart" uri="{C3380CC4-5D6E-409C-BE32-E72D297353CC}">
                <c16:uniqueId val="{0000001B-9D6E-4CE2-9D51-A45588F3C908}"/>
              </c:ext>
            </c:extLst>
          </c:dPt>
          <c:trendline>
            <c:name>Fit</c:name>
            <c:spPr>
              <a:ln w="19050" cap="rnd">
                <a:solidFill>
                  <a:schemeClr val="tx1"/>
                </a:solidFill>
                <a:prstDash val="sysDot"/>
              </a:ln>
              <a:effectLst/>
            </c:spPr>
            <c:trendlineType val="poly"/>
            <c:order val="4"/>
            <c:intercept val="0"/>
            <c:dispRSqr val="0"/>
            <c:dispEq val="0"/>
          </c:trendline>
          <c:cat>
            <c:numRef>
              <c:f>Sheet1!$A$2:$A$21</c:f>
              <c:numCache>
                <c:formatCode>General</c:formatCode>
                <c:ptCount val="20"/>
                <c:pt idx="0">
                  <c:v>-1</c:v>
                </c:pt>
                <c:pt idx="1">
                  <c:v>-0.9</c:v>
                </c:pt>
                <c:pt idx="2">
                  <c:v>-0.8</c:v>
                </c:pt>
                <c:pt idx="3">
                  <c:v>-0.7</c:v>
                </c:pt>
                <c:pt idx="4">
                  <c:v>-0.6</c:v>
                </c:pt>
                <c:pt idx="5">
                  <c:v>-0.5</c:v>
                </c:pt>
                <c:pt idx="6">
                  <c:v>-0.4</c:v>
                </c:pt>
                <c:pt idx="7">
                  <c:v>-0.3</c:v>
                </c:pt>
                <c:pt idx="8">
                  <c:v>-0.2</c:v>
                </c:pt>
                <c:pt idx="9">
                  <c:v>-0.1</c:v>
                </c:pt>
                <c:pt idx="10">
                  <c:v>0.1</c:v>
                </c:pt>
                <c:pt idx="11">
                  <c:v>0.2</c:v>
                </c:pt>
                <c:pt idx="12">
                  <c:v>0.3</c:v>
                </c:pt>
                <c:pt idx="13">
                  <c:v>0.4</c:v>
                </c:pt>
                <c:pt idx="14">
                  <c:v>0.5</c:v>
                </c:pt>
                <c:pt idx="15">
                  <c:v>0.6</c:v>
                </c:pt>
                <c:pt idx="16">
                  <c:v>0.7</c:v>
                </c:pt>
                <c:pt idx="17">
                  <c:v>0.8</c:v>
                </c:pt>
                <c:pt idx="18">
                  <c:v>0.9</c:v>
                </c:pt>
                <c:pt idx="19">
                  <c:v>1</c:v>
                </c:pt>
              </c:numCache>
            </c:numRef>
          </c:cat>
          <c:val>
            <c:numRef>
              <c:f>Sheet1!$B$2:$B$21</c:f>
              <c:numCache>
                <c:formatCode>General</c:formatCode>
                <c:ptCount val="20"/>
                <c:pt idx="0">
                  <c:v>2</c:v>
                </c:pt>
                <c:pt idx="1">
                  <c:v>4</c:v>
                </c:pt>
                <c:pt idx="2">
                  <c:v>31</c:v>
                </c:pt>
                <c:pt idx="3">
                  <c:v>117</c:v>
                </c:pt>
                <c:pt idx="4">
                  <c:v>63648</c:v>
                </c:pt>
                <c:pt idx="5">
                  <c:v>21949</c:v>
                </c:pt>
                <c:pt idx="6">
                  <c:v>31932</c:v>
                </c:pt>
                <c:pt idx="7">
                  <c:v>47227</c:v>
                </c:pt>
                <c:pt idx="8">
                  <c:v>69527</c:v>
                </c:pt>
                <c:pt idx="9">
                  <c:v>96636</c:v>
                </c:pt>
                <c:pt idx="10">
                  <c:v>93824</c:v>
                </c:pt>
                <c:pt idx="11">
                  <c:v>79146</c:v>
                </c:pt>
                <c:pt idx="12">
                  <c:v>73205</c:v>
                </c:pt>
                <c:pt idx="13">
                  <c:v>71300</c:v>
                </c:pt>
                <c:pt idx="14">
                  <c:v>69574</c:v>
                </c:pt>
                <c:pt idx="15">
                  <c:v>7139</c:v>
                </c:pt>
                <c:pt idx="16">
                  <c:v>1501</c:v>
                </c:pt>
                <c:pt idx="17">
                  <c:v>1039</c:v>
                </c:pt>
                <c:pt idx="18">
                  <c:v>646</c:v>
                </c:pt>
                <c:pt idx="19">
                  <c:v>670</c:v>
                </c:pt>
              </c:numCache>
            </c:numRef>
          </c:val>
          <c:extLst>
            <c:ext xmlns:c16="http://schemas.microsoft.com/office/drawing/2014/chart" uri="{C3380CC4-5D6E-409C-BE32-E72D297353CC}">
              <c16:uniqueId val="{0000001D-9D6E-4CE2-9D51-A45588F3C908}"/>
            </c:ext>
          </c:extLst>
        </c:ser>
        <c:dLbls>
          <c:showLegendKey val="0"/>
          <c:showVal val="0"/>
          <c:showCatName val="0"/>
          <c:showSerName val="0"/>
          <c:showPercent val="0"/>
          <c:showBubbleSize val="0"/>
        </c:dLbls>
        <c:gapWidth val="16"/>
        <c:overlap val="-27"/>
        <c:axId val="148808208"/>
        <c:axId val="148808768"/>
      </c:barChart>
      <c:catAx>
        <c:axId val="148808208"/>
        <c:scaling>
          <c:orientation val="minMax"/>
        </c:scaling>
        <c:delete val="0"/>
        <c:axPos val="b"/>
        <c:title>
          <c:tx>
            <c:rich>
              <a:bodyPr rot="0" vert="horz"/>
              <a:lstStyle/>
              <a:p>
                <a:pPr>
                  <a:defRPr/>
                </a:pPr>
                <a:r>
                  <a:rPr lang="en-GB"/>
                  <a:t>nMDP number</a:t>
                </a:r>
              </a:p>
            </c:rich>
          </c:tx>
          <c:layout>
            <c:manualLayout>
              <c:xMode val="edge"/>
              <c:yMode val="edge"/>
              <c:x val="0.41220354139638532"/>
              <c:y val="0.90598418524539592"/>
            </c:manualLayout>
          </c:layout>
          <c:overlay val="0"/>
          <c:spPr>
            <a:noFill/>
            <a:ln>
              <a:noFill/>
            </a:ln>
            <a:effectLst/>
          </c:spPr>
        </c:title>
        <c:numFmt formatCode="General" sourceLinked="1"/>
        <c:majorTickMark val="none"/>
        <c:minorTickMark val="none"/>
        <c:tickLblPos val="nextTo"/>
        <c:spPr>
          <a:noFill/>
          <a:ln w="9525" cap="flat" cmpd="sng" algn="ctr">
            <a:solidFill>
              <a:schemeClr val="tx1">
                <a:lumMod val="85000"/>
                <a:lumOff val="15000"/>
              </a:schemeClr>
            </a:solidFill>
            <a:round/>
          </a:ln>
          <a:effectLst/>
        </c:spPr>
        <c:txPr>
          <a:bodyPr rot="-60000000" vert="horz"/>
          <a:lstStyle/>
          <a:p>
            <a:pPr>
              <a:defRPr/>
            </a:pPr>
            <a:endParaRPr lang="en-US"/>
          </a:p>
        </c:txPr>
        <c:crossAx val="148808768"/>
        <c:crosses val="autoZero"/>
        <c:auto val="1"/>
        <c:lblAlgn val="ctr"/>
        <c:lblOffset val="100"/>
        <c:noMultiLvlLbl val="0"/>
      </c:catAx>
      <c:valAx>
        <c:axId val="148808768"/>
        <c:scaling>
          <c:orientation val="minMax"/>
          <c:max val="96636"/>
          <c:min val="0"/>
        </c:scaling>
        <c:delete val="0"/>
        <c:axPos val="l"/>
        <c:majorGridlines>
          <c:spPr>
            <a:ln w="9525" cap="flat" cmpd="sng" algn="ctr">
              <a:noFill/>
              <a:round/>
            </a:ln>
            <a:effectLst/>
          </c:spPr>
        </c:majorGridlines>
        <c:title>
          <c:tx>
            <c:rich>
              <a:bodyPr rot="-5400000" vert="horz"/>
              <a:lstStyle/>
              <a:p>
                <a:pPr>
                  <a:defRPr/>
                </a:pPr>
                <a:r>
                  <a:rPr lang="en-GB"/>
                  <a:t>Counts</a:t>
                </a:r>
              </a:p>
            </c:rich>
          </c:tx>
          <c:layout>
            <c:manualLayout>
              <c:xMode val="edge"/>
              <c:yMode val="edge"/>
              <c:x val="4.0763306921479212E-2"/>
              <c:y val="0.31027966229799475"/>
            </c:manualLayout>
          </c:layout>
          <c:overlay val="0"/>
          <c:spPr>
            <a:noFill/>
            <a:ln>
              <a:noFill/>
            </a:ln>
            <a:effectLst/>
          </c:spPr>
        </c:title>
        <c:numFmt formatCode="General" sourceLinked="1"/>
        <c:majorTickMark val="none"/>
        <c:minorTickMark val="none"/>
        <c:tickLblPos val="nextTo"/>
        <c:spPr>
          <a:noFill/>
          <a:ln>
            <a:solidFill>
              <a:schemeClr val="tx1">
                <a:lumMod val="85000"/>
                <a:lumOff val="15000"/>
              </a:schemeClr>
            </a:solidFill>
          </a:ln>
          <a:effectLst/>
        </c:spPr>
        <c:txPr>
          <a:bodyPr rot="-60000000" vert="horz"/>
          <a:lstStyle/>
          <a:p>
            <a:pPr>
              <a:defRPr/>
            </a:pPr>
            <a:endParaRPr lang="en-US"/>
          </a:p>
        </c:txPr>
        <c:crossAx val="148808208"/>
        <c:crosses val="autoZero"/>
        <c:crossBetween val="between"/>
      </c:valAx>
      <c:spPr>
        <a:noFill/>
        <a:ln>
          <a:noFill/>
        </a:ln>
        <a:effectLst/>
      </c:spPr>
    </c:plotArea>
    <c:plotVisOnly val="1"/>
    <c:dispBlanksAs val="gap"/>
    <c:showDLblsOverMax val="0"/>
  </c:chart>
  <c:spPr>
    <a:noFill/>
    <a:ln>
      <a:noFill/>
    </a:ln>
    <a:effectLst/>
  </c:spPr>
  <c:txPr>
    <a:bodyPr/>
    <a:lstStyle/>
    <a:p>
      <a:pPr>
        <a:defRPr sz="1050"/>
      </a:pPr>
      <a:endParaRPr lang="en-US"/>
    </a:p>
  </c:txPr>
  <c:externalData r:id="rId1">
    <c:autoUpdate val="0"/>
  </c:externalData>
</c:chartSpace>
</file>

<file path=ppt/charts/chart5.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scatterChart>
        <c:scatterStyle val="smoothMarker"/>
        <c:varyColors val="0"/>
        <c:ser>
          <c:idx val="0"/>
          <c:order val="0"/>
          <c:tx>
            <c:v>EGFP excitation</c:v>
          </c:tx>
          <c:spPr>
            <a:ln>
              <a:solidFill>
                <a:srgbClr val="0EE647"/>
              </a:solidFill>
            </a:ln>
          </c:spPr>
          <c:marker>
            <c:symbol val="none"/>
          </c:marker>
          <c:xVal>
            <c:numRef>
              <c:f>Sheet1!$A$3:$A$403</c:f>
              <c:numCache>
                <c:formatCode>0</c:formatCode>
                <c:ptCount val="401"/>
                <c:pt idx="0">
                  <c:v>300</c:v>
                </c:pt>
                <c:pt idx="1">
                  <c:v>301</c:v>
                </c:pt>
                <c:pt idx="2">
                  <c:v>302</c:v>
                </c:pt>
                <c:pt idx="3">
                  <c:v>303</c:v>
                </c:pt>
                <c:pt idx="4">
                  <c:v>304</c:v>
                </c:pt>
                <c:pt idx="5">
                  <c:v>305</c:v>
                </c:pt>
                <c:pt idx="6">
                  <c:v>306</c:v>
                </c:pt>
                <c:pt idx="7">
                  <c:v>307</c:v>
                </c:pt>
                <c:pt idx="8">
                  <c:v>308</c:v>
                </c:pt>
                <c:pt idx="9">
                  <c:v>309</c:v>
                </c:pt>
                <c:pt idx="10">
                  <c:v>310</c:v>
                </c:pt>
                <c:pt idx="11">
                  <c:v>311</c:v>
                </c:pt>
                <c:pt idx="12">
                  <c:v>312</c:v>
                </c:pt>
                <c:pt idx="13">
                  <c:v>313</c:v>
                </c:pt>
                <c:pt idx="14">
                  <c:v>314</c:v>
                </c:pt>
                <c:pt idx="15">
                  <c:v>315</c:v>
                </c:pt>
                <c:pt idx="16">
                  <c:v>316</c:v>
                </c:pt>
                <c:pt idx="17">
                  <c:v>317</c:v>
                </c:pt>
                <c:pt idx="18">
                  <c:v>318</c:v>
                </c:pt>
                <c:pt idx="19">
                  <c:v>319</c:v>
                </c:pt>
                <c:pt idx="20">
                  <c:v>320</c:v>
                </c:pt>
                <c:pt idx="21">
                  <c:v>321</c:v>
                </c:pt>
                <c:pt idx="22">
                  <c:v>322</c:v>
                </c:pt>
                <c:pt idx="23">
                  <c:v>323</c:v>
                </c:pt>
                <c:pt idx="24">
                  <c:v>324</c:v>
                </c:pt>
                <c:pt idx="25">
                  <c:v>325</c:v>
                </c:pt>
                <c:pt idx="26">
                  <c:v>326</c:v>
                </c:pt>
                <c:pt idx="27">
                  <c:v>327</c:v>
                </c:pt>
                <c:pt idx="28">
                  <c:v>328</c:v>
                </c:pt>
                <c:pt idx="29">
                  <c:v>329</c:v>
                </c:pt>
                <c:pt idx="30">
                  <c:v>330</c:v>
                </c:pt>
                <c:pt idx="31">
                  <c:v>331</c:v>
                </c:pt>
                <c:pt idx="32">
                  <c:v>332</c:v>
                </c:pt>
                <c:pt idx="33">
                  <c:v>333</c:v>
                </c:pt>
                <c:pt idx="34">
                  <c:v>334</c:v>
                </c:pt>
                <c:pt idx="35">
                  <c:v>335</c:v>
                </c:pt>
                <c:pt idx="36">
                  <c:v>336</c:v>
                </c:pt>
                <c:pt idx="37">
                  <c:v>337</c:v>
                </c:pt>
                <c:pt idx="38">
                  <c:v>338</c:v>
                </c:pt>
                <c:pt idx="39">
                  <c:v>339</c:v>
                </c:pt>
                <c:pt idx="40">
                  <c:v>340</c:v>
                </c:pt>
                <c:pt idx="41">
                  <c:v>341</c:v>
                </c:pt>
                <c:pt idx="42">
                  <c:v>342</c:v>
                </c:pt>
                <c:pt idx="43">
                  <c:v>343</c:v>
                </c:pt>
                <c:pt idx="44">
                  <c:v>344</c:v>
                </c:pt>
                <c:pt idx="45">
                  <c:v>345</c:v>
                </c:pt>
                <c:pt idx="46">
                  <c:v>346</c:v>
                </c:pt>
                <c:pt idx="47">
                  <c:v>347</c:v>
                </c:pt>
                <c:pt idx="48">
                  <c:v>348</c:v>
                </c:pt>
                <c:pt idx="49">
                  <c:v>349</c:v>
                </c:pt>
                <c:pt idx="50">
                  <c:v>350</c:v>
                </c:pt>
                <c:pt idx="51">
                  <c:v>351</c:v>
                </c:pt>
                <c:pt idx="52">
                  <c:v>352</c:v>
                </c:pt>
                <c:pt idx="53">
                  <c:v>353</c:v>
                </c:pt>
                <c:pt idx="54">
                  <c:v>354</c:v>
                </c:pt>
                <c:pt idx="55">
                  <c:v>355</c:v>
                </c:pt>
                <c:pt idx="56">
                  <c:v>356</c:v>
                </c:pt>
                <c:pt idx="57">
                  <c:v>357</c:v>
                </c:pt>
                <c:pt idx="58">
                  <c:v>358</c:v>
                </c:pt>
                <c:pt idx="59">
                  <c:v>359</c:v>
                </c:pt>
                <c:pt idx="60">
                  <c:v>360</c:v>
                </c:pt>
                <c:pt idx="61">
                  <c:v>361</c:v>
                </c:pt>
                <c:pt idx="62">
                  <c:v>362</c:v>
                </c:pt>
                <c:pt idx="63">
                  <c:v>363</c:v>
                </c:pt>
                <c:pt idx="64">
                  <c:v>364</c:v>
                </c:pt>
                <c:pt idx="65">
                  <c:v>365</c:v>
                </c:pt>
                <c:pt idx="66">
                  <c:v>366</c:v>
                </c:pt>
                <c:pt idx="67">
                  <c:v>367</c:v>
                </c:pt>
                <c:pt idx="68">
                  <c:v>368</c:v>
                </c:pt>
                <c:pt idx="69">
                  <c:v>369</c:v>
                </c:pt>
                <c:pt idx="70">
                  <c:v>370</c:v>
                </c:pt>
                <c:pt idx="71">
                  <c:v>371</c:v>
                </c:pt>
                <c:pt idx="72">
                  <c:v>372</c:v>
                </c:pt>
                <c:pt idx="73">
                  <c:v>373</c:v>
                </c:pt>
                <c:pt idx="74">
                  <c:v>374</c:v>
                </c:pt>
                <c:pt idx="75">
                  <c:v>375</c:v>
                </c:pt>
                <c:pt idx="76">
                  <c:v>376</c:v>
                </c:pt>
                <c:pt idx="77">
                  <c:v>377</c:v>
                </c:pt>
                <c:pt idx="78">
                  <c:v>378</c:v>
                </c:pt>
                <c:pt idx="79">
                  <c:v>379</c:v>
                </c:pt>
                <c:pt idx="80">
                  <c:v>380</c:v>
                </c:pt>
                <c:pt idx="81">
                  <c:v>381</c:v>
                </c:pt>
                <c:pt idx="82">
                  <c:v>382</c:v>
                </c:pt>
                <c:pt idx="83">
                  <c:v>383</c:v>
                </c:pt>
                <c:pt idx="84">
                  <c:v>384</c:v>
                </c:pt>
                <c:pt idx="85">
                  <c:v>385</c:v>
                </c:pt>
                <c:pt idx="86">
                  <c:v>386</c:v>
                </c:pt>
                <c:pt idx="87">
                  <c:v>387</c:v>
                </c:pt>
                <c:pt idx="88">
                  <c:v>388</c:v>
                </c:pt>
                <c:pt idx="89">
                  <c:v>389</c:v>
                </c:pt>
                <c:pt idx="90">
                  <c:v>390</c:v>
                </c:pt>
                <c:pt idx="91">
                  <c:v>391</c:v>
                </c:pt>
                <c:pt idx="92">
                  <c:v>392</c:v>
                </c:pt>
                <c:pt idx="93">
                  <c:v>393</c:v>
                </c:pt>
                <c:pt idx="94">
                  <c:v>394</c:v>
                </c:pt>
                <c:pt idx="95">
                  <c:v>395</c:v>
                </c:pt>
                <c:pt idx="96">
                  <c:v>396</c:v>
                </c:pt>
                <c:pt idx="97">
                  <c:v>397</c:v>
                </c:pt>
                <c:pt idx="98">
                  <c:v>398</c:v>
                </c:pt>
                <c:pt idx="99">
                  <c:v>399</c:v>
                </c:pt>
                <c:pt idx="100">
                  <c:v>400</c:v>
                </c:pt>
                <c:pt idx="101">
                  <c:v>401</c:v>
                </c:pt>
                <c:pt idx="102">
                  <c:v>402</c:v>
                </c:pt>
                <c:pt idx="103">
                  <c:v>403</c:v>
                </c:pt>
                <c:pt idx="104">
                  <c:v>404</c:v>
                </c:pt>
                <c:pt idx="105">
                  <c:v>405</c:v>
                </c:pt>
                <c:pt idx="106">
                  <c:v>406</c:v>
                </c:pt>
                <c:pt idx="107">
                  <c:v>407</c:v>
                </c:pt>
                <c:pt idx="108">
                  <c:v>408</c:v>
                </c:pt>
                <c:pt idx="109">
                  <c:v>409</c:v>
                </c:pt>
                <c:pt idx="110">
                  <c:v>410</c:v>
                </c:pt>
                <c:pt idx="111">
                  <c:v>411</c:v>
                </c:pt>
                <c:pt idx="112">
                  <c:v>412</c:v>
                </c:pt>
                <c:pt idx="113">
                  <c:v>413</c:v>
                </c:pt>
                <c:pt idx="114">
                  <c:v>414</c:v>
                </c:pt>
                <c:pt idx="115">
                  <c:v>415</c:v>
                </c:pt>
                <c:pt idx="116">
                  <c:v>416</c:v>
                </c:pt>
                <c:pt idx="117">
                  <c:v>417</c:v>
                </c:pt>
                <c:pt idx="118">
                  <c:v>418</c:v>
                </c:pt>
                <c:pt idx="119">
                  <c:v>419</c:v>
                </c:pt>
                <c:pt idx="120">
                  <c:v>420</c:v>
                </c:pt>
                <c:pt idx="121">
                  <c:v>421</c:v>
                </c:pt>
                <c:pt idx="122">
                  <c:v>422</c:v>
                </c:pt>
                <c:pt idx="123">
                  <c:v>423</c:v>
                </c:pt>
                <c:pt idx="124">
                  <c:v>424</c:v>
                </c:pt>
                <c:pt idx="125">
                  <c:v>425</c:v>
                </c:pt>
                <c:pt idx="126">
                  <c:v>426</c:v>
                </c:pt>
                <c:pt idx="127">
                  <c:v>427</c:v>
                </c:pt>
                <c:pt idx="128">
                  <c:v>428</c:v>
                </c:pt>
                <c:pt idx="129">
                  <c:v>429</c:v>
                </c:pt>
                <c:pt idx="130">
                  <c:v>430</c:v>
                </c:pt>
                <c:pt idx="131">
                  <c:v>431</c:v>
                </c:pt>
                <c:pt idx="132">
                  <c:v>432</c:v>
                </c:pt>
                <c:pt idx="133">
                  <c:v>433</c:v>
                </c:pt>
                <c:pt idx="134">
                  <c:v>434</c:v>
                </c:pt>
                <c:pt idx="135">
                  <c:v>435</c:v>
                </c:pt>
                <c:pt idx="136">
                  <c:v>436</c:v>
                </c:pt>
                <c:pt idx="137">
                  <c:v>437</c:v>
                </c:pt>
                <c:pt idx="138">
                  <c:v>438</c:v>
                </c:pt>
                <c:pt idx="139">
                  <c:v>439</c:v>
                </c:pt>
                <c:pt idx="140">
                  <c:v>440</c:v>
                </c:pt>
                <c:pt idx="141">
                  <c:v>441</c:v>
                </c:pt>
                <c:pt idx="142">
                  <c:v>442</c:v>
                </c:pt>
                <c:pt idx="143">
                  <c:v>443</c:v>
                </c:pt>
                <c:pt idx="144">
                  <c:v>444</c:v>
                </c:pt>
                <c:pt idx="145">
                  <c:v>445</c:v>
                </c:pt>
                <c:pt idx="146">
                  <c:v>446</c:v>
                </c:pt>
                <c:pt idx="147">
                  <c:v>447</c:v>
                </c:pt>
                <c:pt idx="148">
                  <c:v>448</c:v>
                </c:pt>
                <c:pt idx="149">
                  <c:v>449</c:v>
                </c:pt>
                <c:pt idx="150">
                  <c:v>450</c:v>
                </c:pt>
                <c:pt idx="151">
                  <c:v>451</c:v>
                </c:pt>
                <c:pt idx="152">
                  <c:v>452</c:v>
                </c:pt>
                <c:pt idx="153">
                  <c:v>453</c:v>
                </c:pt>
                <c:pt idx="154">
                  <c:v>454</c:v>
                </c:pt>
                <c:pt idx="155">
                  <c:v>455</c:v>
                </c:pt>
                <c:pt idx="156">
                  <c:v>456</c:v>
                </c:pt>
                <c:pt idx="157">
                  <c:v>457</c:v>
                </c:pt>
                <c:pt idx="158">
                  <c:v>458</c:v>
                </c:pt>
                <c:pt idx="159">
                  <c:v>459</c:v>
                </c:pt>
                <c:pt idx="160">
                  <c:v>460</c:v>
                </c:pt>
                <c:pt idx="161">
                  <c:v>461</c:v>
                </c:pt>
                <c:pt idx="162">
                  <c:v>462</c:v>
                </c:pt>
                <c:pt idx="163">
                  <c:v>463</c:v>
                </c:pt>
                <c:pt idx="164">
                  <c:v>464</c:v>
                </c:pt>
                <c:pt idx="165">
                  <c:v>465</c:v>
                </c:pt>
                <c:pt idx="166">
                  <c:v>466</c:v>
                </c:pt>
                <c:pt idx="167">
                  <c:v>467</c:v>
                </c:pt>
                <c:pt idx="168">
                  <c:v>468</c:v>
                </c:pt>
                <c:pt idx="169">
                  <c:v>469</c:v>
                </c:pt>
                <c:pt idx="170">
                  <c:v>470</c:v>
                </c:pt>
                <c:pt idx="171">
                  <c:v>471</c:v>
                </c:pt>
                <c:pt idx="172">
                  <c:v>472</c:v>
                </c:pt>
                <c:pt idx="173">
                  <c:v>473</c:v>
                </c:pt>
                <c:pt idx="174">
                  <c:v>474</c:v>
                </c:pt>
                <c:pt idx="175">
                  <c:v>475</c:v>
                </c:pt>
                <c:pt idx="176">
                  <c:v>476</c:v>
                </c:pt>
                <c:pt idx="177">
                  <c:v>477</c:v>
                </c:pt>
                <c:pt idx="178">
                  <c:v>478</c:v>
                </c:pt>
                <c:pt idx="179">
                  <c:v>479</c:v>
                </c:pt>
                <c:pt idx="180">
                  <c:v>480</c:v>
                </c:pt>
                <c:pt idx="181">
                  <c:v>481</c:v>
                </c:pt>
                <c:pt idx="182">
                  <c:v>482</c:v>
                </c:pt>
                <c:pt idx="183">
                  <c:v>483</c:v>
                </c:pt>
                <c:pt idx="184">
                  <c:v>484</c:v>
                </c:pt>
                <c:pt idx="185">
                  <c:v>485</c:v>
                </c:pt>
                <c:pt idx="186">
                  <c:v>486</c:v>
                </c:pt>
                <c:pt idx="187">
                  <c:v>487</c:v>
                </c:pt>
                <c:pt idx="188">
                  <c:v>488</c:v>
                </c:pt>
                <c:pt idx="189">
                  <c:v>489</c:v>
                </c:pt>
                <c:pt idx="190">
                  <c:v>490</c:v>
                </c:pt>
                <c:pt idx="191">
                  <c:v>491</c:v>
                </c:pt>
                <c:pt idx="192">
                  <c:v>492</c:v>
                </c:pt>
                <c:pt idx="193">
                  <c:v>493</c:v>
                </c:pt>
                <c:pt idx="194">
                  <c:v>494</c:v>
                </c:pt>
                <c:pt idx="195">
                  <c:v>495</c:v>
                </c:pt>
                <c:pt idx="196">
                  <c:v>496</c:v>
                </c:pt>
                <c:pt idx="197">
                  <c:v>497</c:v>
                </c:pt>
                <c:pt idx="198">
                  <c:v>498</c:v>
                </c:pt>
                <c:pt idx="199">
                  <c:v>499</c:v>
                </c:pt>
                <c:pt idx="200">
                  <c:v>500</c:v>
                </c:pt>
                <c:pt idx="201">
                  <c:v>501</c:v>
                </c:pt>
                <c:pt idx="202">
                  <c:v>502</c:v>
                </c:pt>
                <c:pt idx="203">
                  <c:v>503</c:v>
                </c:pt>
                <c:pt idx="204">
                  <c:v>504</c:v>
                </c:pt>
                <c:pt idx="205">
                  <c:v>505</c:v>
                </c:pt>
                <c:pt idx="206">
                  <c:v>506</c:v>
                </c:pt>
                <c:pt idx="207">
                  <c:v>507</c:v>
                </c:pt>
                <c:pt idx="208">
                  <c:v>508</c:v>
                </c:pt>
                <c:pt idx="209">
                  <c:v>509</c:v>
                </c:pt>
                <c:pt idx="210">
                  <c:v>510</c:v>
                </c:pt>
                <c:pt idx="211">
                  <c:v>511</c:v>
                </c:pt>
                <c:pt idx="212">
                  <c:v>512</c:v>
                </c:pt>
                <c:pt idx="213">
                  <c:v>513</c:v>
                </c:pt>
                <c:pt idx="214">
                  <c:v>514</c:v>
                </c:pt>
                <c:pt idx="215">
                  <c:v>515</c:v>
                </c:pt>
                <c:pt idx="216">
                  <c:v>516</c:v>
                </c:pt>
                <c:pt idx="217">
                  <c:v>517</c:v>
                </c:pt>
                <c:pt idx="218">
                  <c:v>518</c:v>
                </c:pt>
                <c:pt idx="219">
                  <c:v>519</c:v>
                </c:pt>
                <c:pt idx="220">
                  <c:v>520</c:v>
                </c:pt>
                <c:pt idx="221">
                  <c:v>521</c:v>
                </c:pt>
                <c:pt idx="222">
                  <c:v>522</c:v>
                </c:pt>
                <c:pt idx="223">
                  <c:v>523</c:v>
                </c:pt>
                <c:pt idx="224">
                  <c:v>524</c:v>
                </c:pt>
                <c:pt idx="225">
                  <c:v>525</c:v>
                </c:pt>
                <c:pt idx="226">
                  <c:v>526</c:v>
                </c:pt>
                <c:pt idx="227">
                  <c:v>527</c:v>
                </c:pt>
                <c:pt idx="228">
                  <c:v>528</c:v>
                </c:pt>
                <c:pt idx="229">
                  <c:v>529</c:v>
                </c:pt>
                <c:pt idx="230">
                  <c:v>530</c:v>
                </c:pt>
                <c:pt idx="231">
                  <c:v>531</c:v>
                </c:pt>
                <c:pt idx="232">
                  <c:v>532</c:v>
                </c:pt>
                <c:pt idx="233">
                  <c:v>533</c:v>
                </c:pt>
                <c:pt idx="234">
                  <c:v>534</c:v>
                </c:pt>
                <c:pt idx="235">
                  <c:v>535</c:v>
                </c:pt>
                <c:pt idx="236">
                  <c:v>536</c:v>
                </c:pt>
                <c:pt idx="237">
                  <c:v>537</c:v>
                </c:pt>
                <c:pt idx="238">
                  <c:v>538</c:v>
                </c:pt>
                <c:pt idx="239">
                  <c:v>539</c:v>
                </c:pt>
                <c:pt idx="240">
                  <c:v>540</c:v>
                </c:pt>
                <c:pt idx="241">
                  <c:v>541</c:v>
                </c:pt>
                <c:pt idx="242">
                  <c:v>542</c:v>
                </c:pt>
                <c:pt idx="243">
                  <c:v>543</c:v>
                </c:pt>
                <c:pt idx="244">
                  <c:v>544</c:v>
                </c:pt>
                <c:pt idx="245">
                  <c:v>545</c:v>
                </c:pt>
                <c:pt idx="246">
                  <c:v>546</c:v>
                </c:pt>
                <c:pt idx="247">
                  <c:v>547</c:v>
                </c:pt>
                <c:pt idx="248">
                  <c:v>548</c:v>
                </c:pt>
                <c:pt idx="249">
                  <c:v>549</c:v>
                </c:pt>
                <c:pt idx="250">
                  <c:v>550</c:v>
                </c:pt>
                <c:pt idx="251">
                  <c:v>551</c:v>
                </c:pt>
                <c:pt idx="252">
                  <c:v>552</c:v>
                </c:pt>
                <c:pt idx="253">
                  <c:v>553</c:v>
                </c:pt>
                <c:pt idx="254">
                  <c:v>554</c:v>
                </c:pt>
                <c:pt idx="255">
                  <c:v>555</c:v>
                </c:pt>
                <c:pt idx="256">
                  <c:v>556</c:v>
                </c:pt>
                <c:pt idx="257">
                  <c:v>557</c:v>
                </c:pt>
                <c:pt idx="258">
                  <c:v>558</c:v>
                </c:pt>
                <c:pt idx="259">
                  <c:v>559</c:v>
                </c:pt>
                <c:pt idx="260">
                  <c:v>560</c:v>
                </c:pt>
                <c:pt idx="261">
                  <c:v>561</c:v>
                </c:pt>
                <c:pt idx="262">
                  <c:v>562</c:v>
                </c:pt>
                <c:pt idx="263">
                  <c:v>563</c:v>
                </c:pt>
                <c:pt idx="264">
                  <c:v>564</c:v>
                </c:pt>
                <c:pt idx="265">
                  <c:v>565</c:v>
                </c:pt>
                <c:pt idx="266">
                  <c:v>566</c:v>
                </c:pt>
                <c:pt idx="267">
                  <c:v>567</c:v>
                </c:pt>
                <c:pt idx="268">
                  <c:v>568</c:v>
                </c:pt>
                <c:pt idx="269">
                  <c:v>569</c:v>
                </c:pt>
                <c:pt idx="270">
                  <c:v>570</c:v>
                </c:pt>
                <c:pt idx="271">
                  <c:v>571</c:v>
                </c:pt>
                <c:pt idx="272">
                  <c:v>572</c:v>
                </c:pt>
                <c:pt idx="273">
                  <c:v>573</c:v>
                </c:pt>
                <c:pt idx="274">
                  <c:v>574</c:v>
                </c:pt>
                <c:pt idx="275">
                  <c:v>575</c:v>
                </c:pt>
                <c:pt idx="276">
                  <c:v>576</c:v>
                </c:pt>
                <c:pt idx="277">
                  <c:v>577</c:v>
                </c:pt>
                <c:pt idx="278">
                  <c:v>578</c:v>
                </c:pt>
                <c:pt idx="279">
                  <c:v>579</c:v>
                </c:pt>
                <c:pt idx="280">
                  <c:v>580</c:v>
                </c:pt>
                <c:pt idx="281">
                  <c:v>581</c:v>
                </c:pt>
                <c:pt idx="282">
                  <c:v>582</c:v>
                </c:pt>
                <c:pt idx="283">
                  <c:v>583</c:v>
                </c:pt>
                <c:pt idx="284">
                  <c:v>584</c:v>
                </c:pt>
                <c:pt idx="285">
                  <c:v>585</c:v>
                </c:pt>
                <c:pt idx="286">
                  <c:v>586</c:v>
                </c:pt>
                <c:pt idx="287">
                  <c:v>587</c:v>
                </c:pt>
                <c:pt idx="288">
                  <c:v>588</c:v>
                </c:pt>
                <c:pt idx="289">
                  <c:v>589</c:v>
                </c:pt>
                <c:pt idx="290">
                  <c:v>590</c:v>
                </c:pt>
                <c:pt idx="291">
                  <c:v>591</c:v>
                </c:pt>
                <c:pt idx="292">
                  <c:v>592</c:v>
                </c:pt>
                <c:pt idx="293">
                  <c:v>593</c:v>
                </c:pt>
                <c:pt idx="294">
                  <c:v>594</c:v>
                </c:pt>
                <c:pt idx="295">
                  <c:v>595</c:v>
                </c:pt>
                <c:pt idx="296">
                  <c:v>596</c:v>
                </c:pt>
                <c:pt idx="297">
                  <c:v>597</c:v>
                </c:pt>
                <c:pt idx="298">
                  <c:v>598</c:v>
                </c:pt>
                <c:pt idx="299">
                  <c:v>599</c:v>
                </c:pt>
                <c:pt idx="300">
                  <c:v>600</c:v>
                </c:pt>
                <c:pt idx="301">
                  <c:v>601</c:v>
                </c:pt>
                <c:pt idx="302">
                  <c:v>602</c:v>
                </c:pt>
                <c:pt idx="303">
                  <c:v>603</c:v>
                </c:pt>
                <c:pt idx="304">
                  <c:v>604</c:v>
                </c:pt>
                <c:pt idx="305">
                  <c:v>605</c:v>
                </c:pt>
                <c:pt idx="306">
                  <c:v>606</c:v>
                </c:pt>
                <c:pt idx="307">
                  <c:v>607</c:v>
                </c:pt>
                <c:pt idx="308">
                  <c:v>608</c:v>
                </c:pt>
                <c:pt idx="309">
                  <c:v>609</c:v>
                </c:pt>
                <c:pt idx="310">
                  <c:v>610</c:v>
                </c:pt>
                <c:pt idx="311">
                  <c:v>611</c:v>
                </c:pt>
                <c:pt idx="312">
                  <c:v>612</c:v>
                </c:pt>
                <c:pt idx="313">
                  <c:v>613</c:v>
                </c:pt>
                <c:pt idx="314">
                  <c:v>614</c:v>
                </c:pt>
                <c:pt idx="315">
                  <c:v>615</c:v>
                </c:pt>
                <c:pt idx="316">
                  <c:v>616</c:v>
                </c:pt>
                <c:pt idx="317">
                  <c:v>617</c:v>
                </c:pt>
                <c:pt idx="318">
                  <c:v>618</c:v>
                </c:pt>
                <c:pt idx="319">
                  <c:v>619</c:v>
                </c:pt>
                <c:pt idx="320">
                  <c:v>620</c:v>
                </c:pt>
                <c:pt idx="321">
                  <c:v>621</c:v>
                </c:pt>
                <c:pt idx="322">
                  <c:v>622</c:v>
                </c:pt>
                <c:pt idx="323">
                  <c:v>623</c:v>
                </c:pt>
                <c:pt idx="324">
                  <c:v>624</c:v>
                </c:pt>
                <c:pt idx="325">
                  <c:v>625</c:v>
                </c:pt>
                <c:pt idx="326">
                  <c:v>626</c:v>
                </c:pt>
                <c:pt idx="327">
                  <c:v>627</c:v>
                </c:pt>
                <c:pt idx="328">
                  <c:v>628</c:v>
                </c:pt>
                <c:pt idx="329">
                  <c:v>629</c:v>
                </c:pt>
                <c:pt idx="330">
                  <c:v>630</c:v>
                </c:pt>
                <c:pt idx="331">
                  <c:v>631</c:v>
                </c:pt>
                <c:pt idx="332">
                  <c:v>632</c:v>
                </c:pt>
                <c:pt idx="333">
                  <c:v>633</c:v>
                </c:pt>
                <c:pt idx="334">
                  <c:v>634</c:v>
                </c:pt>
                <c:pt idx="335">
                  <c:v>635</c:v>
                </c:pt>
                <c:pt idx="336">
                  <c:v>636</c:v>
                </c:pt>
                <c:pt idx="337">
                  <c:v>637</c:v>
                </c:pt>
                <c:pt idx="338">
                  <c:v>638</c:v>
                </c:pt>
                <c:pt idx="339">
                  <c:v>639</c:v>
                </c:pt>
                <c:pt idx="340">
                  <c:v>640</c:v>
                </c:pt>
                <c:pt idx="341">
                  <c:v>641</c:v>
                </c:pt>
                <c:pt idx="342">
                  <c:v>642</c:v>
                </c:pt>
                <c:pt idx="343">
                  <c:v>643</c:v>
                </c:pt>
                <c:pt idx="344">
                  <c:v>644</c:v>
                </c:pt>
                <c:pt idx="345">
                  <c:v>645</c:v>
                </c:pt>
                <c:pt idx="346">
                  <c:v>646</c:v>
                </c:pt>
                <c:pt idx="347">
                  <c:v>647</c:v>
                </c:pt>
                <c:pt idx="348">
                  <c:v>648</c:v>
                </c:pt>
                <c:pt idx="349">
                  <c:v>649</c:v>
                </c:pt>
                <c:pt idx="350">
                  <c:v>650</c:v>
                </c:pt>
                <c:pt idx="351">
                  <c:v>651</c:v>
                </c:pt>
                <c:pt idx="352">
                  <c:v>652</c:v>
                </c:pt>
                <c:pt idx="353">
                  <c:v>653</c:v>
                </c:pt>
                <c:pt idx="354">
                  <c:v>654</c:v>
                </c:pt>
                <c:pt idx="355">
                  <c:v>655</c:v>
                </c:pt>
                <c:pt idx="356">
                  <c:v>656</c:v>
                </c:pt>
                <c:pt idx="357">
                  <c:v>657</c:v>
                </c:pt>
                <c:pt idx="358">
                  <c:v>658</c:v>
                </c:pt>
                <c:pt idx="359">
                  <c:v>659</c:v>
                </c:pt>
                <c:pt idx="360">
                  <c:v>660</c:v>
                </c:pt>
                <c:pt idx="361">
                  <c:v>661</c:v>
                </c:pt>
                <c:pt idx="362">
                  <c:v>662</c:v>
                </c:pt>
                <c:pt idx="363">
                  <c:v>663</c:v>
                </c:pt>
                <c:pt idx="364">
                  <c:v>664</c:v>
                </c:pt>
                <c:pt idx="365">
                  <c:v>665</c:v>
                </c:pt>
                <c:pt idx="366">
                  <c:v>666</c:v>
                </c:pt>
                <c:pt idx="367">
                  <c:v>667</c:v>
                </c:pt>
                <c:pt idx="368">
                  <c:v>668</c:v>
                </c:pt>
                <c:pt idx="369">
                  <c:v>669</c:v>
                </c:pt>
                <c:pt idx="370">
                  <c:v>670</c:v>
                </c:pt>
                <c:pt idx="371">
                  <c:v>671</c:v>
                </c:pt>
                <c:pt idx="372">
                  <c:v>672</c:v>
                </c:pt>
                <c:pt idx="373">
                  <c:v>673</c:v>
                </c:pt>
                <c:pt idx="374">
                  <c:v>674</c:v>
                </c:pt>
                <c:pt idx="375">
                  <c:v>675</c:v>
                </c:pt>
                <c:pt idx="376">
                  <c:v>676</c:v>
                </c:pt>
                <c:pt idx="377">
                  <c:v>677</c:v>
                </c:pt>
                <c:pt idx="378">
                  <c:v>678</c:v>
                </c:pt>
                <c:pt idx="379">
                  <c:v>679</c:v>
                </c:pt>
                <c:pt idx="380">
                  <c:v>680</c:v>
                </c:pt>
                <c:pt idx="381">
                  <c:v>681</c:v>
                </c:pt>
                <c:pt idx="382">
                  <c:v>682</c:v>
                </c:pt>
                <c:pt idx="383">
                  <c:v>683</c:v>
                </c:pt>
                <c:pt idx="384">
                  <c:v>684</c:v>
                </c:pt>
                <c:pt idx="385">
                  <c:v>685</c:v>
                </c:pt>
                <c:pt idx="386">
                  <c:v>686</c:v>
                </c:pt>
                <c:pt idx="387">
                  <c:v>687</c:v>
                </c:pt>
                <c:pt idx="388">
                  <c:v>688</c:v>
                </c:pt>
                <c:pt idx="389">
                  <c:v>689</c:v>
                </c:pt>
                <c:pt idx="390">
                  <c:v>690</c:v>
                </c:pt>
                <c:pt idx="391">
                  <c:v>691</c:v>
                </c:pt>
                <c:pt idx="392">
                  <c:v>692</c:v>
                </c:pt>
                <c:pt idx="393">
                  <c:v>693</c:v>
                </c:pt>
                <c:pt idx="394">
                  <c:v>694</c:v>
                </c:pt>
                <c:pt idx="395">
                  <c:v>695</c:v>
                </c:pt>
                <c:pt idx="396">
                  <c:v>696</c:v>
                </c:pt>
                <c:pt idx="397">
                  <c:v>697</c:v>
                </c:pt>
                <c:pt idx="398">
                  <c:v>698</c:v>
                </c:pt>
                <c:pt idx="399">
                  <c:v>699</c:v>
                </c:pt>
                <c:pt idx="400">
                  <c:v>700</c:v>
                </c:pt>
              </c:numCache>
            </c:numRef>
          </c:xVal>
          <c:yVal>
            <c:numRef>
              <c:f>Sheet1!$M$3:$M$403</c:f>
              <c:numCache>
                <c:formatCode>General</c:formatCode>
                <c:ptCount val="401"/>
                <c:pt idx="0">
                  <c:v>9.5972003831704858E-2</c:v>
                </c:pt>
                <c:pt idx="1">
                  <c:v>8.6985096442291465E-2</c:v>
                </c:pt>
                <c:pt idx="2">
                  <c:v>7.9836104215483039E-2</c:v>
                </c:pt>
                <c:pt idx="3">
                  <c:v>7.3640653067447173E-2</c:v>
                </c:pt>
                <c:pt idx="4">
                  <c:v>6.7231685756411502E-2</c:v>
                </c:pt>
                <c:pt idx="5">
                  <c:v>6.0961870044085653E-2</c:v>
                </c:pt>
                <c:pt idx="6">
                  <c:v>5.7652675944538836E-2</c:v>
                </c:pt>
                <c:pt idx="7">
                  <c:v>5.3863068621554766E-2</c:v>
                </c:pt>
                <c:pt idx="8">
                  <c:v>5.2590545347150755E-2</c:v>
                </c:pt>
                <c:pt idx="9">
                  <c:v>4.8798215150048938E-2</c:v>
                </c:pt>
                <c:pt idx="10">
                  <c:v>4.8458147076663613E-2</c:v>
                </c:pt>
                <c:pt idx="11">
                  <c:v>4.7159563000911849E-2</c:v>
                </c:pt>
                <c:pt idx="12">
                  <c:v>4.563417685382825E-2</c:v>
                </c:pt>
                <c:pt idx="13">
                  <c:v>4.433839595516096E-2</c:v>
                </c:pt>
                <c:pt idx="14">
                  <c:v>4.3674498545772843E-2</c:v>
                </c:pt>
                <c:pt idx="15">
                  <c:v>4.4409490142919783E-2</c:v>
                </c:pt>
                <c:pt idx="16">
                  <c:v>4.3964306485476945E-2</c:v>
                </c:pt>
                <c:pt idx="17">
                  <c:v>4.1764620500724416E-2</c:v>
                </c:pt>
                <c:pt idx="18">
                  <c:v>4.0986278156294326E-2</c:v>
                </c:pt>
                <c:pt idx="19">
                  <c:v>3.9660921526057387E-2</c:v>
                </c:pt>
                <c:pt idx="20">
                  <c:v>3.881349247005822E-2</c:v>
                </c:pt>
                <c:pt idx="21">
                  <c:v>3.7579804948804627E-2</c:v>
                </c:pt>
                <c:pt idx="22">
                  <c:v>3.5037674741949978E-2</c:v>
                </c:pt>
                <c:pt idx="23">
                  <c:v>3.437438689439342E-2</c:v>
                </c:pt>
                <c:pt idx="24">
                  <c:v>3.4511706202009274E-2</c:v>
                </c:pt>
                <c:pt idx="25">
                  <c:v>3.4392191461244379E-2</c:v>
                </c:pt>
                <c:pt idx="26">
                  <c:v>3.148506022679002E-2</c:v>
                </c:pt>
                <c:pt idx="27">
                  <c:v>3.2174131499292685E-2</c:v>
                </c:pt>
                <c:pt idx="28">
                  <c:v>3.1901321510768701E-2</c:v>
                </c:pt>
                <c:pt idx="29">
                  <c:v>2.9324025639328736E-2</c:v>
                </c:pt>
                <c:pt idx="30">
                  <c:v>3.0552528387190834E-2</c:v>
                </c:pt>
                <c:pt idx="31">
                  <c:v>3.0220984832323126E-2</c:v>
                </c:pt>
                <c:pt idx="32">
                  <c:v>2.9650278565112851E-2</c:v>
                </c:pt>
                <c:pt idx="33">
                  <c:v>3.1443045373638193E-2</c:v>
                </c:pt>
                <c:pt idx="34">
                  <c:v>3.1008326184298683E-2</c:v>
                </c:pt>
                <c:pt idx="35">
                  <c:v>3.0051925336209373E-2</c:v>
                </c:pt>
                <c:pt idx="36">
                  <c:v>3.1972386501011564E-2</c:v>
                </c:pt>
                <c:pt idx="37">
                  <c:v>3.2134346787682198E-2</c:v>
                </c:pt>
                <c:pt idx="38">
                  <c:v>3.2345669335429095E-2</c:v>
                </c:pt>
                <c:pt idx="39">
                  <c:v>3.3197704642495093E-2</c:v>
                </c:pt>
                <c:pt idx="40">
                  <c:v>3.4583888085418103E-2</c:v>
                </c:pt>
                <c:pt idx="41">
                  <c:v>3.4348709325139407E-2</c:v>
                </c:pt>
                <c:pt idx="42">
                  <c:v>3.5493184189093148E-2</c:v>
                </c:pt>
                <c:pt idx="43">
                  <c:v>3.6139766119416147E-2</c:v>
                </c:pt>
                <c:pt idx="44">
                  <c:v>3.7121320764676148E-2</c:v>
                </c:pt>
                <c:pt idx="45">
                  <c:v>3.9517455651440346E-2</c:v>
                </c:pt>
                <c:pt idx="46">
                  <c:v>4.1001188289126703E-2</c:v>
                </c:pt>
                <c:pt idx="47">
                  <c:v>4.26401214986473E-2</c:v>
                </c:pt>
                <c:pt idx="48">
                  <c:v>4.3567043319691315E-2</c:v>
                </c:pt>
                <c:pt idx="49">
                  <c:v>4.6400331919948079E-2</c:v>
                </c:pt>
                <c:pt idx="50">
                  <c:v>4.8712298402409981E-2</c:v>
                </c:pt>
                <c:pt idx="51">
                  <c:v>4.7835684175707362E-2</c:v>
                </c:pt>
                <c:pt idx="52">
                  <c:v>5.0929715960223568E-2</c:v>
                </c:pt>
                <c:pt idx="53">
                  <c:v>5.6749887732023906E-2</c:v>
                </c:pt>
                <c:pt idx="54">
                  <c:v>5.3682489803994239E-2</c:v>
                </c:pt>
                <c:pt idx="55">
                  <c:v>5.5420621985503932E-2</c:v>
                </c:pt>
                <c:pt idx="56">
                  <c:v>5.8755110422211022E-2</c:v>
                </c:pt>
                <c:pt idx="57">
                  <c:v>6.1378682475268329E-2</c:v>
                </c:pt>
                <c:pt idx="58">
                  <c:v>6.436393044874851E-2</c:v>
                </c:pt>
                <c:pt idx="59">
                  <c:v>6.5939361392934187E-2</c:v>
                </c:pt>
                <c:pt idx="60">
                  <c:v>6.823742147086076E-2</c:v>
                </c:pt>
                <c:pt idx="61">
                  <c:v>7.2042687186507401E-2</c:v>
                </c:pt>
                <c:pt idx="62">
                  <c:v>7.2706106442481447E-2</c:v>
                </c:pt>
                <c:pt idx="63">
                  <c:v>7.5329204006510886E-2</c:v>
                </c:pt>
                <c:pt idx="64">
                  <c:v>7.9547529978604384E-2</c:v>
                </c:pt>
                <c:pt idx="65">
                  <c:v>8.1114398075184377E-2</c:v>
                </c:pt>
                <c:pt idx="66">
                  <c:v>8.3888327165303866E-2</c:v>
                </c:pt>
                <c:pt idx="67">
                  <c:v>8.7274911671576735E-2</c:v>
                </c:pt>
                <c:pt idx="68">
                  <c:v>9.0652561032521922E-2</c:v>
                </c:pt>
                <c:pt idx="69">
                  <c:v>9.181653043122702E-2</c:v>
                </c:pt>
                <c:pt idx="70">
                  <c:v>9.5291510005565849E-2</c:v>
                </c:pt>
                <c:pt idx="71">
                  <c:v>9.8142358638578481E-2</c:v>
                </c:pt>
                <c:pt idx="72">
                  <c:v>9.9997545483974631E-2</c:v>
                </c:pt>
                <c:pt idx="73">
                  <c:v>0.10087738629093447</c:v>
                </c:pt>
                <c:pt idx="74">
                  <c:v>0.10751219209648827</c:v>
                </c:pt>
                <c:pt idx="75">
                  <c:v>0.11004509878845491</c:v>
                </c:pt>
                <c:pt idx="76">
                  <c:v>0.11205215375014035</c:v>
                </c:pt>
                <c:pt idx="77">
                  <c:v>0.11578223000308632</c:v>
                </c:pt>
                <c:pt idx="78">
                  <c:v>0.11715740149508824</c:v>
                </c:pt>
                <c:pt idx="79">
                  <c:v>0.12149304490871185</c:v>
                </c:pt>
                <c:pt idx="80">
                  <c:v>0.1247352145427163</c:v>
                </c:pt>
                <c:pt idx="81">
                  <c:v>0.1266422821210991</c:v>
                </c:pt>
                <c:pt idx="82">
                  <c:v>0.12939209949102864</c:v>
                </c:pt>
                <c:pt idx="83">
                  <c:v>0.13220180561036468</c:v>
                </c:pt>
                <c:pt idx="84">
                  <c:v>0.1347051183272131</c:v>
                </c:pt>
                <c:pt idx="85">
                  <c:v>0.13606568261550969</c:v>
                </c:pt>
                <c:pt idx="86">
                  <c:v>0.13906797596163886</c:v>
                </c:pt>
                <c:pt idx="87">
                  <c:v>0.1427031455909725</c:v>
                </c:pt>
                <c:pt idx="88">
                  <c:v>0.1439814978653014</c:v>
                </c:pt>
                <c:pt idx="89">
                  <c:v>0.14628014924191532</c:v>
                </c:pt>
                <c:pt idx="90">
                  <c:v>0.14771610737552429</c:v>
                </c:pt>
                <c:pt idx="91">
                  <c:v>0.1510655570505145</c:v>
                </c:pt>
                <c:pt idx="92">
                  <c:v>0.1538914982624425</c:v>
                </c:pt>
                <c:pt idx="93">
                  <c:v>0.15587651468433647</c:v>
                </c:pt>
                <c:pt idx="94">
                  <c:v>0.15797514747847552</c:v>
                </c:pt>
                <c:pt idx="95">
                  <c:v>0.16020672694848256</c:v>
                </c:pt>
                <c:pt idx="96">
                  <c:v>0.16192798165285785</c:v>
                </c:pt>
                <c:pt idx="97">
                  <c:v>0.16431759036572205</c:v>
                </c:pt>
                <c:pt idx="98">
                  <c:v>0.16486940803481762</c:v>
                </c:pt>
                <c:pt idx="99">
                  <c:v>0.16690783086768329</c:v>
                </c:pt>
                <c:pt idx="100">
                  <c:v>0.16810388351590103</c:v>
                </c:pt>
                <c:pt idx="101">
                  <c:v>0.16797501024623135</c:v>
                </c:pt>
                <c:pt idx="102">
                  <c:v>0.16974440079843861</c:v>
                </c:pt>
                <c:pt idx="103">
                  <c:v>0.16986121457302059</c:v>
                </c:pt>
                <c:pt idx="104">
                  <c:v>0.17078680416431949</c:v>
                </c:pt>
                <c:pt idx="105">
                  <c:v>0.17292095851920819</c:v>
                </c:pt>
                <c:pt idx="106">
                  <c:v>0.1729565822516681</c:v>
                </c:pt>
                <c:pt idx="107">
                  <c:v>0.17399003587346332</c:v>
                </c:pt>
                <c:pt idx="108">
                  <c:v>0.17605587730974287</c:v>
                </c:pt>
                <c:pt idx="109">
                  <c:v>0.17659973802867807</c:v>
                </c:pt>
                <c:pt idx="110">
                  <c:v>0.17733679916143288</c:v>
                </c:pt>
                <c:pt idx="111">
                  <c:v>0.17948114425281389</c:v>
                </c:pt>
                <c:pt idx="112">
                  <c:v>0.18157523648049917</c:v>
                </c:pt>
                <c:pt idx="113">
                  <c:v>0.18372292494220122</c:v>
                </c:pt>
                <c:pt idx="114">
                  <c:v>0.18551682872943204</c:v>
                </c:pt>
                <c:pt idx="115">
                  <c:v>0.18766380179320605</c:v>
                </c:pt>
                <c:pt idx="116">
                  <c:v>0.18986225407513313</c:v>
                </c:pt>
                <c:pt idx="117">
                  <c:v>0.19301315977937408</c:v>
                </c:pt>
                <c:pt idx="118">
                  <c:v>0.19643387151804206</c:v>
                </c:pt>
                <c:pt idx="119">
                  <c:v>0.19895744887861991</c:v>
                </c:pt>
                <c:pt idx="120">
                  <c:v>0.20258286583217897</c:v>
                </c:pt>
                <c:pt idx="121">
                  <c:v>0.20495845862042952</c:v>
                </c:pt>
                <c:pt idx="122">
                  <c:v>0.2076534387247444</c:v>
                </c:pt>
                <c:pt idx="123">
                  <c:v>0.21101067022358619</c:v>
                </c:pt>
                <c:pt idx="124">
                  <c:v>0.21446285929472581</c:v>
                </c:pt>
                <c:pt idx="125">
                  <c:v>0.21780366591712186</c:v>
                </c:pt>
                <c:pt idx="126">
                  <c:v>0.22154764849622058</c:v>
                </c:pt>
                <c:pt idx="127">
                  <c:v>0.22519569528825839</c:v>
                </c:pt>
                <c:pt idx="128">
                  <c:v>0.22966561394310889</c:v>
                </c:pt>
                <c:pt idx="129">
                  <c:v>0.23521164702385686</c:v>
                </c:pt>
                <c:pt idx="130">
                  <c:v>0.24055955967419781</c:v>
                </c:pt>
                <c:pt idx="131">
                  <c:v>0.24540421394563922</c:v>
                </c:pt>
                <c:pt idx="132">
                  <c:v>0.25157185214743494</c:v>
                </c:pt>
                <c:pt idx="133">
                  <c:v>0.2580381168597507</c:v>
                </c:pt>
                <c:pt idx="134">
                  <c:v>0.26586322299136911</c:v>
                </c:pt>
                <c:pt idx="135">
                  <c:v>0.27388665393600625</c:v>
                </c:pt>
                <c:pt idx="136">
                  <c:v>0.28291864585647275</c:v>
                </c:pt>
                <c:pt idx="137">
                  <c:v>0.29158733386965158</c:v>
                </c:pt>
                <c:pt idx="138">
                  <c:v>0.30156843592049354</c:v>
                </c:pt>
                <c:pt idx="139">
                  <c:v>0.3139062528998865</c:v>
                </c:pt>
                <c:pt idx="140">
                  <c:v>0.32456446886066226</c:v>
                </c:pt>
                <c:pt idx="141">
                  <c:v>0.33678744299577901</c:v>
                </c:pt>
                <c:pt idx="142">
                  <c:v>0.34939419026048107</c:v>
                </c:pt>
                <c:pt idx="143">
                  <c:v>0.36270695913144058</c:v>
                </c:pt>
                <c:pt idx="144">
                  <c:v>0.3763558468668059</c:v>
                </c:pt>
                <c:pt idx="145">
                  <c:v>0.39126166865655121</c:v>
                </c:pt>
                <c:pt idx="146">
                  <c:v>0.40693757669339936</c:v>
                </c:pt>
                <c:pt idx="147">
                  <c:v>0.42226656200110974</c:v>
                </c:pt>
                <c:pt idx="148">
                  <c:v>0.43901045226981222</c:v>
                </c:pt>
                <c:pt idx="149">
                  <c:v>0.4555481922033488</c:v>
                </c:pt>
                <c:pt idx="150">
                  <c:v>0.47311253835331807</c:v>
                </c:pt>
                <c:pt idx="151">
                  <c:v>0.48959000991095369</c:v>
                </c:pt>
                <c:pt idx="152">
                  <c:v>0.50775829531311834</c:v>
                </c:pt>
                <c:pt idx="153">
                  <c:v>0.52511535203288617</c:v>
                </c:pt>
                <c:pt idx="154">
                  <c:v>0.54286771568487013</c:v>
                </c:pt>
                <c:pt idx="155">
                  <c:v>0.56079148188463468</c:v>
                </c:pt>
                <c:pt idx="156">
                  <c:v>0.57826755708537436</c:v>
                </c:pt>
                <c:pt idx="157">
                  <c:v>0.59481128290159602</c:v>
                </c:pt>
                <c:pt idx="158">
                  <c:v>0.6116372538542314</c:v>
                </c:pt>
                <c:pt idx="159">
                  <c:v>0.62811860907340289</c:v>
                </c:pt>
                <c:pt idx="160">
                  <c:v>0.64355490348244548</c:v>
                </c:pt>
                <c:pt idx="161">
                  <c:v>0.65982415128936889</c:v>
                </c:pt>
                <c:pt idx="162">
                  <c:v>0.674203997269188</c:v>
                </c:pt>
                <c:pt idx="163">
                  <c:v>0.68850582160766238</c:v>
                </c:pt>
                <c:pt idx="164">
                  <c:v>0.70156758903576533</c:v>
                </c:pt>
                <c:pt idx="165">
                  <c:v>0.71483182791202304</c:v>
                </c:pt>
                <c:pt idx="166">
                  <c:v>0.72749577742153693</c:v>
                </c:pt>
                <c:pt idx="167">
                  <c:v>0.7394549608179799</c:v>
                </c:pt>
                <c:pt idx="168">
                  <c:v>0.75216796587748302</c:v>
                </c:pt>
                <c:pt idx="169">
                  <c:v>0.76448800039391629</c:v>
                </c:pt>
                <c:pt idx="170">
                  <c:v>0.77683957057906627</c:v>
                </c:pt>
                <c:pt idx="171">
                  <c:v>0.78864954291155498</c:v>
                </c:pt>
                <c:pt idx="172">
                  <c:v>0.8014735657447869</c:v>
                </c:pt>
                <c:pt idx="173">
                  <c:v>0.81404939029265111</c:v>
                </c:pt>
                <c:pt idx="174">
                  <c:v>0.82833655630237379</c:v>
                </c:pt>
                <c:pt idx="175">
                  <c:v>0.84160535018707794</c:v>
                </c:pt>
                <c:pt idx="176">
                  <c:v>0.85586045477684014</c:v>
                </c:pt>
                <c:pt idx="177">
                  <c:v>0.87027685898599083</c:v>
                </c:pt>
                <c:pt idx="178">
                  <c:v>0.8843265137850137</c:v>
                </c:pt>
                <c:pt idx="179">
                  <c:v>0.90007145023637725</c:v>
                </c:pt>
                <c:pt idx="180">
                  <c:v>0.91490330903545314</c:v>
                </c:pt>
                <c:pt idx="181">
                  <c:v>0.92877741465155939</c:v>
                </c:pt>
                <c:pt idx="182">
                  <c:v>0.94340341489467239</c:v>
                </c:pt>
                <c:pt idx="183">
                  <c:v>0.95660802793633681</c:v>
                </c:pt>
                <c:pt idx="184">
                  <c:v>0.96890575359101039</c:v>
                </c:pt>
                <c:pt idx="185">
                  <c:v>0.97903136531786716</c:v>
                </c:pt>
                <c:pt idx="186">
                  <c:v>0.98829815268813614</c:v>
                </c:pt>
                <c:pt idx="187">
                  <c:v>0.99370151573233123</c:v>
                </c:pt>
                <c:pt idx="188">
                  <c:v>0.99795919568409008</c:v>
                </c:pt>
                <c:pt idx="189">
                  <c:v>0.99976023877346043</c:v>
                </c:pt>
                <c:pt idx="190">
                  <c:v>0.99661448684229537</c:v>
                </c:pt>
                <c:pt idx="191">
                  <c:v>0.99060925776549447</c:v>
                </c:pt>
                <c:pt idx="192">
                  <c:v>0.97950136517865194</c:v>
                </c:pt>
                <c:pt idx="193">
                  <c:v>0.96379812611134208</c:v>
                </c:pt>
                <c:pt idx="194">
                  <c:v>0.94397427081384866</c:v>
                </c:pt>
                <c:pt idx="195">
                  <c:v>0.91918096165578167</c:v>
                </c:pt>
                <c:pt idx="196">
                  <c:v>0.89015198904064297</c:v>
                </c:pt>
                <c:pt idx="197">
                  <c:v>0.85587593063603895</c:v>
                </c:pt>
                <c:pt idx="198">
                  <c:v>0.81859521386691714</c:v>
                </c:pt>
                <c:pt idx="199">
                  <c:v>0.77727523141768906</c:v>
                </c:pt>
                <c:pt idx="200">
                  <c:v>0.73438809620589807</c:v>
                </c:pt>
                <c:pt idx="201">
                  <c:v>0.68711398425193215</c:v>
                </c:pt>
                <c:pt idx="202">
                  <c:v>0.63969527502940338</c:v>
                </c:pt>
                <c:pt idx="203">
                  <c:v>0.59035446041041517</c:v>
                </c:pt>
                <c:pt idx="204">
                  <c:v>0.54258220003475588</c:v>
                </c:pt>
                <c:pt idx="205">
                  <c:v>0.49280601635634808</c:v>
                </c:pt>
                <c:pt idx="206">
                  <c:v>0.44563293584182601</c:v>
                </c:pt>
                <c:pt idx="207">
                  <c:v>0.39935450758341123</c:v>
                </c:pt>
                <c:pt idx="208">
                  <c:v>0.35457767876531282</c:v>
                </c:pt>
                <c:pt idx="209">
                  <c:v>0.31340416242162544</c:v>
                </c:pt>
                <c:pt idx="210">
                  <c:v>0.27443607731081465</c:v>
                </c:pt>
                <c:pt idx="211">
                  <c:v>0.23734162580083698</c:v>
                </c:pt>
                <c:pt idx="212">
                  <c:v>0.20397248378478325</c:v>
                </c:pt>
                <c:pt idx="213">
                  <c:v>0.17441262986350636</c:v>
                </c:pt>
                <c:pt idx="214">
                  <c:v>0.14664229965136605</c:v>
                </c:pt>
                <c:pt idx="215">
                  <c:v>0.12261653608621757</c:v>
                </c:pt>
                <c:pt idx="216">
                  <c:v>0.10123128775546955</c:v>
                </c:pt>
                <c:pt idx="217">
                  <c:v>8.3586116630306018E-2</c:v>
                </c:pt>
                <c:pt idx="218">
                  <c:v>6.8375806585787471E-2</c:v>
                </c:pt>
                <c:pt idx="219">
                  <c:v>5.510507079193272E-2</c:v>
                </c:pt>
                <c:pt idx="220">
                  <c:v>4.5137842440489129E-2</c:v>
                </c:pt>
                <c:pt idx="221">
                  <c:v>3.5983445048816648E-2</c:v>
                </c:pt>
                <c:pt idx="222">
                  <c:v>3.0458651064196582E-2</c:v>
                </c:pt>
                <c:pt idx="223">
                  <c:v>2.5438464148565713E-2</c:v>
                </c:pt>
                <c:pt idx="224">
                  <c:v>2.093079014663363E-2</c:v>
                </c:pt>
                <c:pt idx="225">
                  <c:v>1.7565634645754568E-2</c:v>
                </c:pt>
                <c:pt idx="226">
                  <c:v>1.5498519364964014E-2</c:v>
                </c:pt>
                <c:pt idx="227">
                  <c:v>1.3566525202912096E-2</c:v>
                </c:pt>
                <c:pt idx="228">
                  <c:v>1.200723444371497E-2</c:v>
                </c:pt>
                <c:pt idx="229">
                  <c:v>1.0662605949956964E-2</c:v>
                </c:pt>
                <c:pt idx="230">
                  <c:v>9.0295428285165936E-3</c:v>
                </c:pt>
                <c:pt idx="231">
                  <c:v>8.055305476588729E-3</c:v>
                </c:pt>
                <c:pt idx="232">
                  <c:v>7.0911347521146525E-3</c:v>
                </c:pt>
                <c:pt idx="233">
                  <c:v>6.1498274638831559E-3</c:v>
                </c:pt>
                <c:pt idx="234">
                  <c:v>5.6566803983537882E-3</c:v>
                </c:pt>
                <c:pt idx="235">
                  <c:v>4.8829466074792076E-3</c:v>
                </c:pt>
                <c:pt idx="236">
                  <c:v>5.2092533644687586E-3</c:v>
                </c:pt>
                <c:pt idx="237">
                  <c:v>4.9160158277123884E-3</c:v>
                </c:pt>
                <c:pt idx="238">
                  <c:v>4.5935451951755295E-3</c:v>
                </c:pt>
                <c:pt idx="239">
                  <c:v>4.4578583265557931E-3</c:v>
                </c:pt>
                <c:pt idx="240">
                  <c:v>4.1688565851352062E-3</c:v>
                </c:pt>
                <c:pt idx="241">
                  <c:v>4.8032900326124336E-3</c:v>
                </c:pt>
                <c:pt idx="242">
                  <c:v>5.390657068682597E-3</c:v>
                </c:pt>
                <c:pt idx="243">
                  <c:v>5.0867908072201812E-3</c:v>
                </c:pt>
                <c:pt idx="244">
                  <c:v>5.2008301378167502E-3</c:v>
                </c:pt>
                <c:pt idx="245">
                  <c:v>5.0812779791614276E-3</c:v>
                </c:pt>
                <c:pt idx="246">
                  <c:v>4.3237742526354359E-3</c:v>
                </c:pt>
                <c:pt idx="247">
                  <c:v>5.5275653085863161E-3</c:v>
                </c:pt>
                <c:pt idx="248">
                  <c:v>5.4737902427236373E-3</c:v>
                </c:pt>
                <c:pt idx="249">
                  <c:v>5.8904963596760479E-3</c:v>
                </c:pt>
                <c:pt idx="250">
                  <c:v>5.6508066791999233E-3</c:v>
                </c:pt>
                <c:pt idx="251">
                  <c:v>4.793034062206979E-3</c:v>
                </c:pt>
                <c:pt idx="252">
                  <c:v>4.6356330440768213E-3</c:v>
                </c:pt>
                <c:pt idx="253">
                  <c:v>4.0705559423296718E-3</c:v>
                </c:pt>
                <c:pt idx="254">
                  <c:v>4.152591387748786E-3</c:v>
                </c:pt>
                <c:pt idx="255">
                  <c:v>4.0032613742903306E-3</c:v>
                </c:pt>
                <c:pt idx="256">
                  <c:v>4.1304629646781625E-3</c:v>
                </c:pt>
                <c:pt idx="257">
                  <c:v>3.7351041764978844E-3</c:v>
                </c:pt>
                <c:pt idx="258">
                  <c:v>4.3695207442836694E-3</c:v>
                </c:pt>
                <c:pt idx="259">
                  <c:v>3.3897491188195558E-3</c:v>
                </c:pt>
                <c:pt idx="260">
                  <c:v>5.1351817061316921E-3</c:v>
                </c:pt>
                <c:pt idx="261">
                  <c:v>4.0956910315349373E-3</c:v>
                </c:pt>
                <c:pt idx="262">
                  <c:v>3.3375859733496688E-3</c:v>
                </c:pt>
                <c:pt idx="263">
                  <c:v>3.5704595564305694E-3</c:v>
                </c:pt>
                <c:pt idx="264">
                  <c:v>3.3206745036441685E-3</c:v>
                </c:pt>
                <c:pt idx="265">
                  <c:v>4.173598357746092E-3</c:v>
                </c:pt>
                <c:pt idx="266">
                  <c:v>4.7323660213016783E-3</c:v>
                </c:pt>
                <c:pt idx="267">
                  <c:v>3.850695656840813E-3</c:v>
                </c:pt>
                <c:pt idx="268">
                  <c:v>3.4791570545929344E-3</c:v>
                </c:pt>
                <c:pt idx="269">
                  <c:v>3.1793844690674667E-3</c:v>
                </c:pt>
                <c:pt idx="270">
                  <c:v>3.9862347017684948E-3</c:v>
                </c:pt>
                <c:pt idx="271">
                  <c:v>3.8781174543453516E-3</c:v>
                </c:pt>
                <c:pt idx="272">
                  <c:v>4.4132802822646217E-3</c:v>
                </c:pt>
                <c:pt idx="273">
                  <c:v>3.8048241547542711E-3</c:v>
                </c:pt>
                <c:pt idx="274">
                  <c:v>3.8962637575452128E-3</c:v>
                </c:pt>
                <c:pt idx="275">
                  <c:v>4.3095457426716721E-3</c:v>
                </c:pt>
                <c:pt idx="276">
                  <c:v>4.5101410093994184E-3</c:v>
                </c:pt>
                <c:pt idx="277">
                  <c:v>5.0292152065212455E-3</c:v>
                </c:pt>
                <c:pt idx="278">
                  <c:v>4.0361941754987656E-3</c:v>
                </c:pt>
                <c:pt idx="279">
                  <c:v>4.4055788378028395E-3</c:v>
                </c:pt>
                <c:pt idx="280">
                  <c:v>3.5538492091333122E-3</c:v>
                </c:pt>
                <c:pt idx="281">
                  <c:v>4.0069318782831849E-3</c:v>
                </c:pt>
                <c:pt idx="282">
                  <c:v>3.8996276641056907E-3</c:v>
                </c:pt>
                <c:pt idx="283">
                  <c:v>3.510948785524542E-3</c:v>
                </c:pt>
                <c:pt idx="284">
                  <c:v>4.2806311055694759E-3</c:v>
                </c:pt>
                <c:pt idx="285">
                  <c:v>4.1429545438108261E-3</c:v>
                </c:pt>
                <c:pt idx="286">
                  <c:v>3.9020745158811019E-3</c:v>
                </c:pt>
                <c:pt idx="287">
                  <c:v>3.8125712237639829E-3</c:v>
                </c:pt>
                <c:pt idx="288">
                  <c:v>4.6037988826879575E-3</c:v>
                </c:pt>
                <c:pt idx="289">
                  <c:v>3.9395912291173103E-3</c:v>
                </c:pt>
                <c:pt idx="290">
                  <c:v>4.0927336406175012E-3</c:v>
                </c:pt>
                <c:pt idx="291">
                  <c:v>3.9160411398032058E-3</c:v>
                </c:pt>
                <c:pt idx="292">
                  <c:v>3.5487540740753894E-3</c:v>
                </c:pt>
                <c:pt idx="293">
                  <c:v>3.7951914161046298E-3</c:v>
                </c:pt>
                <c:pt idx="294">
                  <c:v>4.4997353889874884E-3</c:v>
                </c:pt>
                <c:pt idx="295">
                  <c:v>4.1207243781746826E-3</c:v>
                </c:pt>
                <c:pt idx="296">
                  <c:v>2.9711593878107212E-3</c:v>
                </c:pt>
                <c:pt idx="297">
                  <c:v>3.1489801864582837E-3</c:v>
                </c:pt>
                <c:pt idx="298">
                  <c:v>3.1987379994123698E-3</c:v>
                </c:pt>
                <c:pt idx="299">
                  <c:v>3.4285168613534429E-3</c:v>
                </c:pt>
                <c:pt idx="300">
                  <c:v>3.3367200161771009E-3</c:v>
                </c:pt>
                <c:pt idx="301">
                  <c:v>2.467332499962809E-3</c:v>
                </c:pt>
                <c:pt idx="302">
                  <c:v>2.8615931009829919E-3</c:v>
                </c:pt>
                <c:pt idx="303">
                  <c:v>2.7412495838286008E-3</c:v>
                </c:pt>
                <c:pt idx="304">
                  <c:v>3.0494225847118956E-3</c:v>
                </c:pt>
                <c:pt idx="305">
                  <c:v>2.8700443886033608E-3</c:v>
                </c:pt>
                <c:pt idx="306">
                  <c:v>3.7885147025557382E-3</c:v>
                </c:pt>
                <c:pt idx="307">
                  <c:v>3.7055973314702581E-3</c:v>
                </c:pt>
                <c:pt idx="308">
                  <c:v>4.1018088438818092E-3</c:v>
                </c:pt>
                <c:pt idx="309">
                  <c:v>3.5508429995772754E-3</c:v>
                </c:pt>
                <c:pt idx="310">
                  <c:v>4.4830048223879317E-3</c:v>
                </c:pt>
                <c:pt idx="311">
                  <c:v>3.1157250446736296E-3</c:v>
                </c:pt>
                <c:pt idx="312">
                  <c:v>3.9694630705283673E-3</c:v>
                </c:pt>
                <c:pt idx="313">
                  <c:v>3.5378504616150395E-3</c:v>
                </c:pt>
                <c:pt idx="314">
                  <c:v>4.2334615799015105E-3</c:v>
                </c:pt>
                <c:pt idx="315">
                  <c:v>3.8924915090272722E-3</c:v>
                </c:pt>
                <c:pt idx="316">
                  <c:v>3.5203235141517573E-3</c:v>
                </c:pt>
                <c:pt idx="317">
                  <c:v>3.5543077375056278E-3</c:v>
                </c:pt>
                <c:pt idx="318">
                  <c:v>3.8285749897277845E-3</c:v>
                </c:pt>
                <c:pt idx="319">
                  <c:v>4.7536937309107371E-3</c:v>
                </c:pt>
                <c:pt idx="320">
                  <c:v>3.839635324264081E-3</c:v>
                </c:pt>
                <c:pt idx="321">
                  <c:v>4.1480531022285065E-3</c:v>
                </c:pt>
                <c:pt idx="322">
                  <c:v>2.4598521061712005E-3</c:v>
                </c:pt>
                <c:pt idx="323">
                  <c:v>3.8442224284229616E-3</c:v>
                </c:pt>
                <c:pt idx="324">
                  <c:v>2.6095731233575069E-3</c:v>
                </c:pt>
                <c:pt idx="325">
                  <c:v>2.9611288026328442E-3</c:v>
                </c:pt>
                <c:pt idx="326">
                  <c:v>2.3729934486268799E-3</c:v>
                </c:pt>
                <c:pt idx="327">
                  <c:v>3.231384962818233E-3</c:v>
                </c:pt>
                <c:pt idx="328">
                  <c:v>3.4417623889330114E-3</c:v>
                </c:pt>
                <c:pt idx="329">
                  <c:v>3.601897922955575E-3</c:v>
                </c:pt>
                <c:pt idx="330">
                  <c:v>3.9084971013054956E-3</c:v>
                </c:pt>
                <c:pt idx="331">
                  <c:v>3.4889898569734246E-3</c:v>
                </c:pt>
                <c:pt idx="332">
                  <c:v>4.2668113902226508E-3</c:v>
                </c:pt>
                <c:pt idx="333">
                  <c:v>2.9692246741822347E-3</c:v>
                </c:pt>
                <c:pt idx="334">
                  <c:v>3.0446867437037496E-3</c:v>
                </c:pt>
                <c:pt idx="335">
                  <c:v>2.7651742498385886E-3</c:v>
                </c:pt>
                <c:pt idx="336">
                  <c:v>3.1517810845688582E-3</c:v>
                </c:pt>
                <c:pt idx="337">
                  <c:v>2.4342057919762203E-3</c:v>
                </c:pt>
                <c:pt idx="338">
                  <c:v>2.0107962702423723E-3</c:v>
                </c:pt>
                <c:pt idx="339">
                  <c:v>1.9471224744000747E-3</c:v>
                </c:pt>
                <c:pt idx="340">
                  <c:v>2.8460656562401586E-3</c:v>
                </c:pt>
                <c:pt idx="341">
                  <c:v>1.9242378239086493E-3</c:v>
                </c:pt>
                <c:pt idx="342">
                  <c:v>2.5200527222798601E-3</c:v>
                </c:pt>
                <c:pt idx="343">
                  <c:v>1.6721899003412592E-3</c:v>
                </c:pt>
                <c:pt idx="344">
                  <c:v>2.0790526083766274E-3</c:v>
                </c:pt>
                <c:pt idx="345">
                  <c:v>2.0766112316253495E-3</c:v>
                </c:pt>
                <c:pt idx="346">
                  <c:v>1.8022976690075733E-3</c:v>
                </c:pt>
                <c:pt idx="347">
                  <c:v>2.7697556516638145E-3</c:v>
                </c:pt>
                <c:pt idx="348">
                  <c:v>2.7845692994431025E-3</c:v>
                </c:pt>
                <c:pt idx="349">
                  <c:v>3.1569248109558621E-3</c:v>
                </c:pt>
                <c:pt idx="350">
                  <c:v>4.0893688208998129E-3</c:v>
                </c:pt>
                <c:pt idx="351">
                  <c:v>3.0731524347056478E-3</c:v>
                </c:pt>
                <c:pt idx="352">
                  <c:v>3.5766759172522894E-3</c:v>
                </c:pt>
                <c:pt idx="353">
                  <c:v>2.8696371871126287E-3</c:v>
                </c:pt>
                <c:pt idx="354">
                  <c:v>3.5692368154107714E-3</c:v>
                </c:pt>
                <c:pt idx="355">
                  <c:v>2.9194294472568555E-3</c:v>
                </c:pt>
                <c:pt idx="356">
                  <c:v>3.244271196348025E-3</c:v>
                </c:pt>
                <c:pt idx="357">
                  <c:v>3.0816055447213087E-3</c:v>
                </c:pt>
                <c:pt idx="358">
                  <c:v>3.0733559198366889E-3</c:v>
                </c:pt>
                <c:pt idx="359">
                  <c:v>3.8004920918770996E-3</c:v>
                </c:pt>
                <c:pt idx="360">
                  <c:v>2.6632692599084119E-3</c:v>
                </c:pt>
                <c:pt idx="361">
                  <c:v>2.6127285263414144E-3</c:v>
                </c:pt>
                <c:pt idx="362">
                  <c:v>2.9316488761472826E-3</c:v>
                </c:pt>
                <c:pt idx="363">
                  <c:v>3.0589957819841876E-3</c:v>
                </c:pt>
                <c:pt idx="364">
                  <c:v>3.0638333655578541E-3</c:v>
                </c:pt>
                <c:pt idx="365">
                  <c:v>2.9670862441940572E-3</c:v>
                </c:pt>
                <c:pt idx="366">
                  <c:v>2.4918600966369739E-3</c:v>
                </c:pt>
                <c:pt idx="367">
                  <c:v>1.7094051486372915E-3</c:v>
                </c:pt>
                <c:pt idx="368">
                  <c:v>2.2266716963888376E-3</c:v>
                </c:pt>
                <c:pt idx="369">
                  <c:v>2.3616979192814689E-3</c:v>
                </c:pt>
                <c:pt idx="370">
                  <c:v>3.147146758816713E-3</c:v>
                </c:pt>
                <c:pt idx="371">
                  <c:v>2.6030583776396102E-3</c:v>
                </c:pt>
                <c:pt idx="372">
                  <c:v>3.4021280053384314E-3</c:v>
                </c:pt>
                <c:pt idx="373">
                  <c:v>3.8431009733900789E-3</c:v>
                </c:pt>
                <c:pt idx="374">
                  <c:v>3.3268890401110321E-3</c:v>
                </c:pt>
                <c:pt idx="375">
                  <c:v>2.7955139745844582E-3</c:v>
                </c:pt>
                <c:pt idx="376">
                  <c:v>1.8461799364933727E-3</c:v>
                </c:pt>
                <c:pt idx="377">
                  <c:v>7.7697379904979164E-4</c:v>
                </c:pt>
                <c:pt idx="378">
                  <c:v>1.3589129532167856E-4</c:v>
                </c:pt>
                <c:pt idx="379">
                  <c:v>1.9349680619111308E-3</c:v>
                </c:pt>
                <c:pt idx="380">
                  <c:v>6.652013888708881E-4</c:v>
                </c:pt>
                <c:pt idx="381">
                  <c:v>1.2407243156175351E-3</c:v>
                </c:pt>
                <c:pt idx="382">
                  <c:v>1.7928161503677495E-4</c:v>
                </c:pt>
                <c:pt idx="383">
                  <c:v>4.4926482528151966E-4</c:v>
                </c:pt>
                <c:pt idx="384">
                  <c:v>7.5960516992396596E-4</c:v>
                </c:pt>
                <c:pt idx="385">
                  <c:v>1.0292138017092192E-3</c:v>
                </c:pt>
                <c:pt idx="386">
                  <c:v>1.3475411446750764E-3</c:v>
                </c:pt>
                <c:pt idx="387">
                  <c:v>1.1888960546821677E-3</c:v>
                </c:pt>
                <c:pt idx="388">
                  <c:v>1.5861741586224133E-3</c:v>
                </c:pt>
                <c:pt idx="389">
                  <c:v>3.0499920659963434E-4</c:v>
                </c:pt>
                <c:pt idx="390">
                  <c:v>1.4720590926087852E-3</c:v>
                </c:pt>
                <c:pt idx="391">
                  <c:v>1.1407009733204753E-4</c:v>
                </c:pt>
                <c:pt idx="392">
                  <c:v>1.0098080309336088E-3</c:v>
                </c:pt>
                <c:pt idx="393">
                  <c:v>9.9583821194104997E-4</c:v>
                </c:pt>
                <c:pt idx="394">
                  <c:v>0</c:v>
                </c:pt>
                <c:pt idx="395">
                  <c:v>8.2821829229736375E-4</c:v>
                </c:pt>
                <c:pt idx="396">
                  <c:v>1.8233995368104497E-3</c:v>
                </c:pt>
                <c:pt idx="397">
                  <c:v>1.9761107970185611E-3</c:v>
                </c:pt>
                <c:pt idx="398">
                  <c:v>2.026359531911162E-3</c:v>
                </c:pt>
                <c:pt idx="399">
                  <c:v>1.9122362535572888E-3</c:v>
                </c:pt>
                <c:pt idx="400">
                  <c:v>1.4719573496513516E-3</c:v>
                </c:pt>
              </c:numCache>
            </c:numRef>
          </c:yVal>
          <c:smooth val="1"/>
          <c:extLst>
            <c:ext xmlns:c16="http://schemas.microsoft.com/office/drawing/2014/chart" uri="{C3380CC4-5D6E-409C-BE32-E72D297353CC}">
              <c16:uniqueId val="{00000000-C379-4716-A601-4B261307531E}"/>
            </c:ext>
          </c:extLst>
        </c:ser>
        <c:ser>
          <c:idx val="1"/>
          <c:order val="1"/>
          <c:tx>
            <c:v>AZD2014 Emission</c:v>
          </c:tx>
          <c:spPr>
            <a:ln>
              <a:solidFill>
                <a:srgbClr val="0070C0"/>
              </a:solidFill>
            </a:ln>
          </c:spPr>
          <c:marker>
            <c:symbol val="none"/>
          </c:marker>
          <c:xVal>
            <c:numRef>
              <c:f>Sheet1!$D$3:$D$203</c:f>
              <c:numCache>
                <c:formatCode>General</c:formatCode>
                <c:ptCount val="201"/>
                <c:pt idx="0">
                  <c:v>400</c:v>
                </c:pt>
                <c:pt idx="1">
                  <c:v>401.05999759999997</c:v>
                </c:pt>
                <c:pt idx="2">
                  <c:v>401.9599915</c:v>
                </c:pt>
                <c:pt idx="3">
                  <c:v>403.02999879999999</c:v>
                </c:pt>
                <c:pt idx="4">
                  <c:v>403.92999270000001</c:v>
                </c:pt>
                <c:pt idx="5">
                  <c:v>405</c:v>
                </c:pt>
                <c:pt idx="6">
                  <c:v>406.05999759999997</c:v>
                </c:pt>
                <c:pt idx="7">
                  <c:v>406.9599915</c:v>
                </c:pt>
                <c:pt idx="8">
                  <c:v>408.02999879999999</c:v>
                </c:pt>
                <c:pt idx="9">
                  <c:v>408.92999270000001</c:v>
                </c:pt>
                <c:pt idx="10">
                  <c:v>410</c:v>
                </c:pt>
                <c:pt idx="11">
                  <c:v>411.05999759999997</c:v>
                </c:pt>
                <c:pt idx="12">
                  <c:v>411.9599915</c:v>
                </c:pt>
                <c:pt idx="13">
                  <c:v>413.02999879999999</c:v>
                </c:pt>
                <c:pt idx="14">
                  <c:v>413.92999270000001</c:v>
                </c:pt>
                <c:pt idx="15">
                  <c:v>415</c:v>
                </c:pt>
                <c:pt idx="16">
                  <c:v>416.05999759999997</c:v>
                </c:pt>
                <c:pt idx="17">
                  <c:v>416.9599915</c:v>
                </c:pt>
                <c:pt idx="18">
                  <c:v>418.02999879999999</c:v>
                </c:pt>
                <c:pt idx="19">
                  <c:v>418.92999270000001</c:v>
                </c:pt>
                <c:pt idx="20">
                  <c:v>420</c:v>
                </c:pt>
                <c:pt idx="21">
                  <c:v>421.05999759999997</c:v>
                </c:pt>
                <c:pt idx="22">
                  <c:v>421.9599915</c:v>
                </c:pt>
                <c:pt idx="23">
                  <c:v>423.02999879999999</c:v>
                </c:pt>
                <c:pt idx="24">
                  <c:v>423.92999270000001</c:v>
                </c:pt>
                <c:pt idx="25">
                  <c:v>425</c:v>
                </c:pt>
                <c:pt idx="26">
                  <c:v>426.05999759999997</c:v>
                </c:pt>
                <c:pt idx="27">
                  <c:v>426.9599915</c:v>
                </c:pt>
                <c:pt idx="28">
                  <c:v>428.02999879999999</c:v>
                </c:pt>
                <c:pt idx="29">
                  <c:v>428.92999270000001</c:v>
                </c:pt>
                <c:pt idx="30">
                  <c:v>430</c:v>
                </c:pt>
                <c:pt idx="31">
                  <c:v>431.05999759999997</c:v>
                </c:pt>
                <c:pt idx="32">
                  <c:v>431.9599915</c:v>
                </c:pt>
                <c:pt idx="33">
                  <c:v>433.02999879999999</c:v>
                </c:pt>
                <c:pt idx="34">
                  <c:v>433.92999270000001</c:v>
                </c:pt>
                <c:pt idx="35">
                  <c:v>435</c:v>
                </c:pt>
                <c:pt idx="36">
                  <c:v>436.05999759999997</c:v>
                </c:pt>
                <c:pt idx="37">
                  <c:v>436.9599915</c:v>
                </c:pt>
                <c:pt idx="38">
                  <c:v>438.02999879999999</c:v>
                </c:pt>
                <c:pt idx="39">
                  <c:v>438.92999270000001</c:v>
                </c:pt>
                <c:pt idx="40">
                  <c:v>440</c:v>
                </c:pt>
                <c:pt idx="41">
                  <c:v>441.05999759999997</c:v>
                </c:pt>
                <c:pt idx="42">
                  <c:v>441.9599915</c:v>
                </c:pt>
                <c:pt idx="43">
                  <c:v>443.02999879999999</c:v>
                </c:pt>
                <c:pt idx="44">
                  <c:v>443.92999270000001</c:v>
                </c:pt>
                <c:pt idx="45">
                  <c:v>445</c:v>
                </c:pt>
                <c:pt idx="46">
                  <c:v>446.05999759999997</c:v>
                </c:pt>
                <c:pt idx="47">
                  <c:v>446.9599915</c:v>
                </c:pt>
                <c:pt idx="48">
                  <c:v>448.02999879999999</c:v>
                </c:pt>
                <c:pt idx="49">
                  <c:v>448.92999270000001</c:v>
                </c:pt>
                <c:pt idx="50">
                  <c:v>450</c:v>
                </c:pt>
                <c:pt idx="51">
                  <c:v>451.0400085</c:v>
                </c:pt>
                <c:pt idx="52">
                  <c:v>451.94000240000003</c:v>
                </c:pt>
                <c:pt idx="53">
                  <c:v>452.98001099999999</c:v>
                </c:pt>
                <c:pt idx="54">
                  <c:v>454.01998900000001</c:v>
                </c:pt>
                <c:pt idx="55">
                  <c:v>455.07000729999999</c:v>
                </c:pt>
                <c:pt idx="56">
                  <c:v>455.97000120000001</c:v>
                </c:pt>
                <c:pt idx="57">
                  <c:v>457.01000979999998</c:v>
                </c:pt>
                <c:pt idx="58">
                  <c:v>458.0499878</c:v>
                </c:pt>
                <c:pt idx="59">
                  <c:v>458.9500122</c:v>
                </c:pt>
                <c:pt idx="60">
                  <c:v>460</c:v>
                </c:pt>
                <c:pt idx="61">
                  <c:v>461.05999759999997</c:v>
                </c:pt>
                <c:pt idx="62">
                  <c:v>461.9599915</c:v>
                </c:pt>
                <c:pt idx="63">
                  <c:v>463.02999879999999</c:v>
                </c:pt>
                <c:pt idx="64">
                  <c:v>463.92999270000001</c:v>
                </c:pt>
                <c:pt idx="65">
                  <c:v>465</c:v>
                </c:pt>
                <c:pt idx="66">
                  <c:v>466.05999759999997</c:v>
                </c:pt>
                <c:pt idx="67">
                  <c:v>466.9599915</c:v>
                </c:pt>
                <c:pt idx="68">
                  <c:v>468.02999879999999</c:v>
                </c:pt>
                <c:pt idx="69">
                  <c:v>468.92999270000001</c:v>
                </c:pt>
                <c:pt idx="70">
                  <c:v>470</c:v>
                </c:pt>
                <c:pt idx="71">
                  <c:v>471.0400085</c:v>
                </c:pt>
                <c:pt idx="72">
                  <c:v>471.94000240000003</c:v>
                </c:pt>
                <c:pt idx="73">
                  <c:v>472.98001099999999</c:v>
                </c:pt>
                <c:pt idx="74">
                  <c:v>474.01998900000001</c:v>
                </c:pt>
                <c:pt idx="75">
                  <c:v>475.07000729999999</c:v>
                </c:pt>
                <c:pt idx="76">
                  <c:v>475.97000120000001</c:v>
                </c:pt>
                <c:pt idx="77">
                  <c:v>477.01000979999998</c:v>
                </c:pt>
                <c:pt idx="78">
                  <c:v>478.0499878</c:v>
                </c:pt>
                <c:pt idx="79">
                  <c:v>478.9500122</c:v>
                </c:pt>
                <c:pt idx="80">
                  <c:v>480</c:v>
                </c:pt>
                <c:pt idx="81">
                  <c:v>481.0400085</c:v>
                </c:pt>
                <c:pt idx="82">
                  <c:v>481.94000240000003</c:v>
                </c:pt>
                <c:pt idx="83">
                  <c:v>482.98001099999999</c:v>
                </c:pt>
                <c:pt idx="84">
                  <c:v>484.01998900000001</c:v>
                </c:pt>
                <c:pt idx="85">
                  <c:v>485.07000729999999</c:v>
                </c:pt>
                <c:pt idx="86">
                  <c:v>485.97000120000001</c:v>
                </c:pt>
                <c:pt idx="87">
                  <c:v>487.01000979999998</c:v>
                </c:pt>
                <c:pt idx="88">
                  <c:v>488.0499878</c:v>
                </c:pt>
                <c:pt idx="89">
                  <c:v>488.9500122</c:v>
                </c:pt>
                <c:pt idx="90">
                  <c:v>490</c:v>
                </c:pt>
                <c:pt idx="91">
                  <c:v>491.0400085</c:v>
                </c:pt>
                <c:pt idx="92">
                  <c:v>491.94000240000003</c:v>
                </c:pt>
                <c:pt idx="93">
                  <c:v>492.98001099999999</c:v>
                </c:pt>
                <c:pt idx="94">
                  <c:v>494.01998900000001</c:v>
                </c:pt>
                <c:pt idx="95">
                  <c:v>495.07000729999999</c:v>
                </c:pt>
                <c:pt idx="96">
                  <c:v>495.97000120000001</c:v>
                </c:pt>
                <c:pt idx="97">
                  <c:v>497.01000979999998</c:v>
                </c:pt>
                <c:pt idx="98">
                  <c:v>498.0499878</c:v>
                </c:pt>
                <c:pt idx="99">
                  <c:v>498.9500122</c:v>
                </c:pt>
                <c:pt idx="100">
                  <c:v>500</c:v>
                </c:pt>
                <c:pt idx="101">
                  <c:v>501.0400085</c:v>
                </c:pt>
                <c:pt idx="102">
                  <c:v>501.94000240000003</c:v>
                </c:pt>
                <c:pt idx="103">
                  <c:v>502.98001099999999</c:v>
                </c:pt>
                <c:pt idx="104">
                  <c:v>504.01998900000001</c:v>
                </c:pt>
                <c:pt idx="105">
                  <c:v>505.07000729999999</c:v>
                </c:pt>
                <c:pt idx="106">
                  <c:v>505.97000120000001</c:v>
                </c:pt>
                <c:pt idx="107">
                  <c:v>507.01000979999998</c:v>
                </c:pt>
                <c:pt idx="108">
                  <c:v>508.0499878</c:v>
                </c:pt>
                <c:pt idx="109">
                  <c:v>508.9500122</c:v>
                </c:pt>
                <c:pt idx="110">
                  <c:v>510</c:v>
                </c:pt>
                <c:pt idx="111">
                  <c:v>511.0400085</c:v>
                </c:pt>
                <c:pt idx="112">
                  <c:v>511.94000240000003</c:v>
                </c:pt>
                <c:pt idx="113">
                  <c:v>512.97998050000001</c:v>
                </c:pt>
                <c:pt idx="114">
                  <c:v>514.02001949999999</c:v>
                </c:pt>
                <c:pt idx="115">
                  <c:v>515.07000730000004</c:v>
                </c:pt>
                <c:pt idx="116">
                  <c:v>515.96997069999998</c:v>
                </c:pt>
                <c:pt idx="117">
                  <c:v>517.01000980000003</c:v>
                </c:pt>
                <c:pt idx="118">
                  <c:v>518.04998780000005</c:v>
                </c:pt>
                <c:pt idx="119">
                  <c:v>518.95001219999995</c:v>
                </c:pt>
                <c:pt idx="120">
                  <c:v>520</c:v>
                </c:pt>
                <c:pt idx="121">
                  <c:v>521.03997800000002</c:v>
                </c:pt>
                <c:pt idx="122">
                  <c:v>521.94000240000003</c:v>
                </c:pt>
                <c:pt idx="123">
                  <c:v>522.97998050000001</c:v>
                </c:pt>
                <c:pt idx="124">
                  <c:v>524.02001949999999</c:v>
                </c:pt>
                <c:pt idx="125">
                  <c:v>525.07000730000004</c:v>
                </c:pt>
                <c:pt idx="126">
                  <c:v>525.96997069999998</c:v>
                </c:pt>
                <c:pt idx="127">
                  <c:v>527.01000980000003</c:v>
                </c:pt>
                <c:pt idx="128">
                  <c:v>528.04998780000005</c:v>
                </c:pt>
                <c:pt idx="129">
                  <c:v>528.95001219999995</c:v>
                </c:pt>
                <c:pt idx="130">
                  <c:v>530</c:v>
                </c:pt>
                <c:pt idx="131">
                  <c:v>531.02001949999999</c:v>
                </c:pt>
                <c:pt idx="132">
                  <c:v>532.04998780000005</c:v>
                </c:pt>
                <c:pt idx="133">
                  <c:v>532.94000240000003</c:v>
                </c:pt>
                <c:pt idx="134">
                  <c:v>533.96997069999998</c:v>
                </c:pt>
                <c:pt idx="135">
                  <c:v>535</c:v>
                </c:pt>
                <c:pt idx="136">
                  <c:v>536.02001949999999</c:v>
                </c:pt>
                <c:pt idx="137">
                  <c:v>537.04998780000005</c:v>
                </c:pt>
                <c:pt idx="138">
                  <c:v>537.94000240000003</c:v>
                </c:pt>
                <c:pt idx="139">
                  <c:v>538.96997069999998</c:v>
                </c:pt>
                <c:pt idx="140">
                  <c:v>540</c:v>
                </c:pt>
                <c:pt idx="141">
                  <c:v>541.02001949999999</c:v>
                </c:pt>
                <c:pt idx="142">
                  <c:v>542.04998780000005</c:v>
                </c:pt>
                <c:pt idx="143">
                  <c:v>542.94000240000003</c:v>
                </c:pt>
                <c:pt idx="144">
                  <c:v>543.96997069999998</c:v>
                </c:pt>
                <c:pt idx="145">
                  <c:v>545</c:v>
                </c:pt>
                <c:pt idx="146">
                  <c:v>546.02001949999999</c:v>
                </c:pt>
                <c:pt idx="147">
                  <c:v>547.04998780000005</c:v>
                </c:pt>
                <c:pt idx="148">
                  <c:v>547.94000240000003</c:v>
                </c:pt>
                <c:pt idx="149">
                  <c:v>548.96997069999998</c:v>
                </c:pt>
                <c:pt idx="150">
                  <c:v>550</c:v>
                </c:pt>
                <c:pt idx="151">
                  <c:v>551.03997800000002</c:v>
                </c:pt>
                <c:pt idx="152">
                  <c:v>551.94000240000003</c:v>
                </c:pt>
                <c:pt idx="153">
                  <c:v>552.97998050000001</c:v>
                </c:pt>
                <c:pt idx="154">
                  <c:v>554.02001949999999</c:v>
                </c:pt>
                <c:pt idx="155">
                  <c:v>555.07000730000004</c:v>
                </c:pt>
                <c:pt idx="156">
                  <c:v>555.96997069999998</c:v>
                </c:pt>
                <c:pt idx="157">
                  <c:v>557.01000980000003</c:v>
                </c:pt>
                <c:pt idx="158">
                  <c:v>558.04998780000005</c:v>
                </c:pt>
                <c:pt idx="159">
                  <c:v>558.95001219999995</c:v>
                </c:pt>
                <c:pt idx="160">
                  <c:v>560</c:v>
                </c:pt>
                <c:pt idx="161">
                  <c:v>561.01000980000003</c:v>
                </c:pt>
                <c:pt idx="162">
                  <c:v>562.02001949999999</c:v>
                </c:pt>
                <c:pt idx="163">
                  <c:v>563.03997800000002</c:v>
                </c:pt>
                <c:pt idx="164">
                  <c:v>564.04998780000005</c:v>
                </c:pt>
                <c:pt idx="165">
                  <c:v>565.07000730000004</c:v>
                </c:pt>
                <c:pt idx="166">
                  <c:v>565.94000240000003</c:v>
                </c:pt>
                <c:pt idx="167">
                  <c:v>566.95001219999995</c:v>
                </c:pt>
                <c:pt idx="168">
                  <c:v>567.96997069999998</c:v>
                </c:pt>
                <c:pt idx="169">
                  <c:v>568.97998050000001</c:v>
                </c:pt>
                <c:pt idx="170">
                  <c:v>570</c:v>
                </c:pt>
                <c:pt idx="171">
                  <c:v>571.02001949999999</c:v>
                </c:pt>
                <c:pt idx="172">
                  <c:v>572.04998780000005</c:v>
                </c:pt>
                <c:pt idx="173">
                  <c:v>572.94000240000003</c:v>
                </c:pt>
                <c:pt idx="174">
                  <c:v>573.96997069999998</c:v>
                </c:pt>
                <c:pt idx="175">
                  <c:v>575</c:v>
                </c:pt>
                <c:pt idx="176">
                  <c:v>576.02001949999999</c:v>
                </c:pt>
                <c:pt idx="177">
                  <c:v>577.04998780000005</c:v>
                </c:pt>
                <c:pt idx="178">
                  <c:v>577.94000240000003</c:v>
                </c:pt>
                <c:pt idx="179">
                  <c:v>578.96997069999998</c:v>
                </c:pt>
                <c:pt idx="180">
                  <c:v>580</c:v>
                </c:pt>
                <c:pt idx="181">
                  <c:v>581.02001949999999</c:v>
                </c:pt>
                <c:pt idx="182">
                  <c:v>582.04998780000005</c:v>
                </c:pt>
                <c:pt idx="183">
                  <c:v>582.94000240000003</c:v>
                </c:pt>
                <c:pt idx="184">
                  <c:v>583.96997069999998</c:v>
                </c:pt>
                <c:pt idx="185">
                  <c:v>585</c:v>
                </c:pt>
                <c:pt idx="186">
                  <c:v>586.02001949999999</c:v>
                </c:pt>
                <c:pt idx="187">
                  <c:v>587.04998780000005</c:v>
                </c:pt>
                <c:pt idx="188">
                  <c:v>587.94000240000003</c:v>
                </c:pt>
                <c:pt idx="189">
                  <c:v>588.96997069999998</c:v>
                </c:pt>
                <c:pt idx="190">
                  <c:v>590</c:v>
                </c:pt>
                <c:pt idx="191">
                  <c:v>591.01000980000003</c:v>
                </c:pt>
                <c:pt idx="192">
                  <c:v>592.02001949999999</c:v>
                </c:pt>
                <c:pt idx="193">
                  <c:v>593.03997800000002</c:v>
                </c:pt>
                <c:pt idx="194">
                  <c:v>594.04998780000005</c:v>
                </c:pt>
                <c:pt idx="195">
                  <c:v>595.07000730000004</c:v>
                </c:pt>
                <c:pt idx="196">
                  <c:v>595.94000240000003</c:v>
                </c:pt>
                <c:pt idx="197">
                  <c:v>596.95001219999995</c:v>
                </c:pt>
                <c:pt idx="198">
                  <c:v>597.96997069999998</c:v>
                </c:pt>
                <c:pt idx="199">
                  <c:v>598.97998050000001</c:v>
                </c:pt>
                <c:pt idx="200">
                  <c:v>600</c:v>
                </c:pt>
              </c:numCache>
            </c:numRef>
          </c:xVal>
          <c:yVal>
            <c:numRef>
              <c:f>Sheet1!$N$3:$N$203</c:f>
              <c:numCache>
                <c:formatCode>General</c:formatCode>
                <c:ptCount val="201"/>
                <c:pt idx="0">
                  <c:v>0</c:v>
                </c:pt>
                <c:pt idx="1">
                  <c:v>4.7037376770861191E-5</c:v>
                </c:pt>
                <c:pt idx="2">
                  <c:v>2.8783312901305895E-4</c:v>
                </c:pt>
                <c:pt idx="3">
                  <c:v>4.8807520730982456E-4</c:v>
                </c:pt>
                <c:pt idx="4">
                  <c:v>6.3849379292327734E-4</c:v>
                </c:pt>
                <c:pt idx="5">
                  <c:v>9.8427596030982857E-4</c:v>
                </c:pt>
                <c:pt idx="6">
                  <c:v>1.2085441675827437E-3</c:v>
                </c:pt>
                <c:pt idx="7">
                  <c:v>1.6231293534461513E-3</c:v>
                </c:pt>
                <c:pt idx="8">
                  <c:v>2.2267552494775779E-3</c:v>
                </c:pt>
                <c:pt idx="9">
                  <c:v>2.7781100900104252E-3</c:v>
                </c:pt>
                <c:pt idx="10">
                  <c:v>3.8242280640705842E-3</c:v>
                </c:pt>
                <c:pt idx="11">
                  <c:v>5.2771871037429951E-3</c:v>
                </c:pt>
                <c:pt idx="12">
                  <c:v>6.4919624240179098E-3</c:v>
                </c:pt>
                <c:pt idx="13">
                  <c:v>8.295760107757625E-3</c:v>
                </c:pt>
                <c:pt idx="14">
                  <c:v>1.0641061586829375E-2</c:v>
                </c:pt>
                <c:pt idx="15">
                  <c:v>1.325572384434748E-2</c:v>
                </c:pt>
                <c:pt idx="16">
                  <c:v>1.6739777048840002E-2</c:v>
                </c:pt>
                <c:pt idx="17">
                  <c:v>2.039831082201584E-2</c:v>
                </c:pt>
                <c:pt idx="18">
                  <c:v>2.4596304079463241E-2</c:v>
                </c:pt>
                <c:pt idx="19">
                  <c:v>3.0072026982620056E-2</c:v>
                </c:pt>
                <c:pt idx="20">
                  <c:v>3.7050856936913103E-2</c:v>
                </c:pt>
                <c:pt idx="21">
                  <c:v>4.4914985449522778E-2</c:v>
                </c:pt>
                <c:pt idx="22">
                  <c:v>5.2068503839059435E-2</c:v>
                </c:pt>
                <c:pt idx="23">
                  <c:v>6.1170764474737203E-2</c:v>
                </c:pt>
                <c:pt idx="24">
                  <c:v>7.2984583851727139E-2</c:v>
                </c:pt>
                <c:pt idx="25">
                  <c:v>8.7271665975008503E-2</c:v>
                </c:pt>
                <c:pt idx="26">
                  <c:v>0.10367675153788142</c:v>
                </c:pt>
                <c:pt idx="27">
                  <c:v>0.11723429984551152</c:v>
                </c:pt>
                <c:pt idx="28">
                  <c:v>0.13477006596210139</c:v>
                </c:pt>
                <c:pt idx="29">
                  <c:v>0.15350602955711093</c:v>
                </c:pt>
                <c:pt idx="30">
                  <c:v>0.1786111273270059</c:v>
                </c:pt>
                <c:pt idx="31">
                  <c:v>0.20687838898819463</c:v>
                </c:pt>
                <c:pt idx="32">
                  <c:v>0.22637859087300616</c:v>
                </c:pt>
                <c:pt idx="33">
                  <c:v>0.25533663276064467</c:v>
                </c:pt>
                <c:pt idx="34">
                  <c:v>0.28250419357054057</c:v>
                </c:pt>
                <c:pt idx="35">
                  <c:v>0.31403460626466601</c:v>
                </c:pt>
                <c:pt idx="36">
                  <c:v>0.34924705151588176</c:v>
                </c:pt>
                <c:pt idx="37">
                  <c:v>0.37762785513637787</c:v>
                </c:pt>
                <c:pt idx="38">
                  <c:v>0.41199249372490865</c:v>
                </c:pt>
                <c:pt idx="39">
                  <c:v>0.4455500996017896</c:v>
                </c:pt>
                <c:pt idx="40">
                  <c:v>0.47936545303878964</c:v>
                </c:pt>
                <c:pt idx="41">
                  <c:v>0.51471046373396889</c:v>
                </c:pt>
                <c:pt idx="42">
                  <c:v>0.54386085182747379</c:v>
                </c:pt>
                <c:pt idx="43">
                  <c:v>0.57852906713641372</c:v>
                </c:pt>
                <c:pt idx="44">
                  <c:v>0.60899163997311412</c:v>
                </c:pt>
                <c:pt idx="45">
                  <c:v>0.64405568905371458</c:v>
                </c:pt>
                <c:pt idx="46">
                  <c:v>0.67678258271514191</c:v>
                </c:pt>
                <c:pt idx="47">
                  <c:v>0.69741196841417552</c:v>
                </c:pt>
                <c:pt idx="48">
                  <c:v>0.73694313253861499</c:v>
                </c:pt>
                <c:pt idx="49">
                  <c:v>0.75182983539738013</c:v>
                </c:pt>
                <c:pt idx="50">
                  <c:v>0.77932448612952254</c:v>
                </c:pt>
                <c:pt idx="51">
                  <c:v>0.8044686120067408</c:v>
                </c:pt>
                <c:pt idx="52">
                  <c:v>0.82457112833746804</c:v>
                </c:pt>
                <c:pt idx="53">
                  <c:v>0.84832215332073102</c:v>
                </c:pt>
                <c:pt idx="54">
                  <c:v>0.86991960576169847</c:v>
                </c:pt>
                <c:pt idx="55">
                  <c:v>0.89674697301339801</c:v>
                </c:pt>
                <c:pt idx="56">
                  <c:v>0.90777750575781813</c:v>
                </c:pt>
                <c:pt idx="57">
                  <c:v>0.92019196009433013</c:v>
                </c:pt>
                <c:pt idx="58">
                  <c:v>0.94036012734123886</c:v>
                </c:pt>
                <c:pt idx="59">
                  <c:v>0.94996649646907105</c:v>
                </c:pt>
                <c:pt idx="60">
                  <c:v>0.96188268319594528</c:v>
                </c:pt>
                <c:pt idx="61">
                  <c:v>0.96923716992713438</c:v>
                </c:pt>
                <c:pt idx="62">
                  <c:v>0.97396329636065071</c:v>
                </c:pt>
                <c:pt idx="63">
                  <c:v>0.9859347574584586</c:v>
                </c:pt>
                <c:pt idx="64">
                  <c:v>0.98550686315236602</c:v>
                </c:pt>
                <c:pt idx="65">
                  <c:v>0.9868791445876095</c:v>
                </c:pt>
                <c:pt idx="66">
                  <c:v>0.99240378963877851</c:v>
                </c:pt>
                <c:pt idx="67">
                  <c:v>0.99790216115881081</c:v>
                </c:pt>
                <c:pt idx="68">
                  <c:v>0.995549773634678</c:v>
                </c:pt>
                <c:pt idx="69">
                  <c:v>0.99157846523651294</c:v>
                </c:pt>
                <c:pt idx="70">
                  <c:v>0.99165322865042582</c:v>
                </c:pt>
                <c:pt idx="71">
                  <c:v>0.98713642658940548</c:v>
                </c:pt>
                <c:pt idx="72">
                  <c:v>0.98218654205864753</c:v>
                </c:pt>
                <c:pt idx="73">
                  <c:v>0.97695283586821902</c:v>
                </c:pt>
                <c:pt idx="74">
                  <c:v>0.97556678569813837</c:v>
                </c:pt>
                <c:pt idx="75">
                  <c:v>0.96669055718107522</c:v>
                </c:pt>
                <c:pt idx="76">
                  <c:v>0.96705985129486094</c:v>
                </c:pt>
                <c:pt idx="77">
                  <c:v>0.94719452919227898</c:v>
                </c:pt>
                <c:pt idx="78">
                  <c:v>0.94152727497378985</c:v>
                </c:pt>
                <c:pt idx="79">
                  <c:v>0.92869297464890144</c:v>
                </c:pt>
                <c:pt idx="80">
                  <c:v>0.91622790196060366</c:v>
                </c:pt>
                <c:pt idx="81">
                  <c:v>0.90466411433186877</c:v>
                </c:pt>
                <c:pt idx="82">
                  <c:v>0.89877689328685562</c:v>
                </c:pt>
                <c:pt idx="83">
                  <c:v>0.88297666648100781</c:v>
                </c:pt>
                <c:pt idx="84">
                  <c:v>0.86940125037841032</c:v>
                </c:pt>
                <c:pt idx="85">
                  <c:v>0.8576304000185373</c:v>
                </c:pt>
                <c:pt idx="86">
                  <c:v>0.84297829746956343</c:v>
                </c:pt>
                <c:pt idx="87">
                  <c:v>0.83537397854158124</c:v>
                </c:pt>
                <c:pt idx="88">
                  <c:v>0.81526022102615481</c:v>
                </c:pt>
                <c:pt idx="89">
                  <c:v>0.79765004077337354</c:v>
                </c:pt>
                <c:pt idx="90">
                  <c:v>0.78440454161747486</c:v>
                </c:pt>
                <c:pt idx="91">
                  <c:v>0.7702770467954495</c:v>
                </c:pt>
                <c:pt idx="92">
                  <c:v>0.75975821779157116</c:v>
                </c:pt>
                <c:pt idx="93">
                  <c:v>0.74196425523032727</c:v>
                </c:pt>
                <c:pt idx="94">
                  <c:v>0.72534828218724745</c:v>
                </c:pt>
                <c:pt idx="95">
                  <c:v>0.71241793354039018</c:v>
                </c:pt>
                <c:pt idx="96">
                  <c:v>0.697649428769059</c:v>
                </c:pt>
                <c:pt idx="97">
                  <c:v>0.6834078599522081</c:v>
                </c:pt>
                <c:pt idx="98">
                  <c:v>0.66147064627277008</c:v>
                </c:pt>
                <c:pt idx="99">
                  <c:v>0.64900843373854344</c:v>
                </c:pt>
                <c:pt idx="100">
                  <c:v>0.64129376560925822</c:v>
                </c:pt>
                <c:pt idx="101">
                  <c:v>0.62361314535777856</c:v>
                </c:pt>
                <c:pt idx="102">
                  <c:v>0.60712927220033908</c:v>
                </c:pt>
                <c:pt idx="103">
                  <c:v>0.59115484136004137</c:v>
                </c:pt>
                <c:pt idx="104">
                  <c:v>0.57703911975823341</c:v>
                </c:pt>
                <c:pt idx="105">
                  <c:v>0.56353480875322126</c:v>
                </c:pt>
                <c:pt idx="106">
                  <c:v>0.55017450380845689</c:v>
                </c:pt>
                <c:pt idx="107">
                  <c:v>0.53528770123389902</c:v>
                </c:pt>
                <c:pt idx="108">
                  <c:v>0.52345166573412572</c:v>
                </c:pt>
                <c:pt idx="109">
                  <c:v>0.50856240208662495</c:v>
                </c:pt>
                <c:pt idx="110">
                  <c:v>0.4968627897787275</c:v>
                </c:pt>
                <c:pt idx="111">
                  <c:v>0.48269315746031588</c:v>
                </c:pt>
                <c:pt idx="112">
                  <c:v>0.47010200455985562</c:v>
                </c:pt>
                <c:pt idx="113">
                  <c:v>0.45806828495341362</c:v>
                </c:pt>
                <c:pt idx="114">
                  <c:v>0.44527628853585705</c:v>
                </c:pt>
                <c:pt idx="115">
                  <c:v>0.43363723869628867</c:v>
                </c:pt>
                <c:pt idx="116">
                  <c:v>0.42245621455084098</c:v>
                </c:pt>
                <c:pt idx="117">
                  <c:v>0.41017080029635516</c:v>
                </c:pt>
                <c:pt idx="118">
                  <c:v>0.40032966455676489</c:v>
                </c:pt>
                <c:pt idx="119">
                  <c:v>0.38939491411655447</c:v>
                </c:pt>
                <c:pt idx="120">
                  <c:v>0.37939670202834308</c:v>
                </c:pt>
                <c:pt idx="121">
                  <c:v>0.36524010675970742</c:v>
                </c:pt>
                <c:pt idx="122">
                  <c:v>0.35866667846538797</c:v>
                </c:pt>
                <c:pt idx="123">
                  <c:v>0.34858276114390019</c:v>
                </c:pt>
                <c:pt idx="124">
                  <c:v>0.340582575096681</c:v>
                </c:pt>
                <c:pt idx="125">
                  <c:v>0.32636252396704762</c:v>
                </c:pt>
                <c:pt idx="126">
                  <c:v>0.31897374862560335</c:v>
                </c:pt>
                <c:pt idx="127">
                  <c:v>0.30727836012610699</c:v>
                </c:pt>
                <c:pt idx="128">
                  <c:v>0.29924401842302256</c:v>
                </c:pt>
                <c:pt idx="129">
                  <c:v>0.29217132470726603</c:v>
                </c:pt>
                <c:pt idx="130">
                  <c:v>0.28450305112136559</c:v>
                </c:pt>
                <c:pt idx="131">
                  <c:v>0.2743647407421837</c:v>
                </c:pt>
                <c:pt idx="132">
                  <c:v>0.26567221149157871</c:v>
                </c:pt>
                <c:pt idx="133">
                  <c:v>0.25910575066117164</c:v>
                </c:pt>
                <c:pt idx="134">
                  <c:v>0.25087681778465121</c:v>
                </c:pt>
                <c:pt idx="135">
                  <c:v>0.24323899173488184</c:v>
                </c:pt>
                <c:pt idx="136">
                  <c:v>0.23658993527821923</c:v>
                </c:pt>
                <c:pt idx="137">
                  <c:v>0.22831791700589896</c:v>
                </c:pt>
                <c:pt idx="138">
                  <c:v>0.22445497896820549</c:v>
                </c:pt>
                <c:pt idx="139">
                  <c:v>0.21562180271732359</c:v>
                </c:pt>
                <c:pt idx="140">
                  <c:v>0.20799799474636219</c:v>
                </c:pt>
                <c:pt idx="141">
                  <c:v>0.2011441536557495</c:v>
                </c:pt>
                <c:pt idx="142">
                  <c:v>0.19531905805600147</c:v>
                </c:pt>
                <c:pt idx="143">
                  <c:v>0.19097391580550477</c:v>
                </c:pt>
                <c:pt idx="144">
                  <c:v>0.18434853885264596</c:v>
                </c:pt>
                <c:pt idx="145">
                  <c:v>0.17833989372359707</c:v>
                </c:pt>
                <c:pt idx="146">
                  <c:v>0.17188990159274239</c:v>
                </c:pt>
                <c:pt idx="147">
                  <c:v>0.16694575393493594</c:v>
                </c:pt>
                <c:pt idx="148">
                  <c:v>0.16256323003197229</c:v>
                </c:pt>
                <c:pt idx="149">
                  <c:v>0.15691288728495967</c:v>
                </c:pt>
                <c:pt idx="150">
                  <c:v>0.15218543065366874</c:v>
                </c:pt>
                <c:pt idx="151">
                  <c:v>0.14790953104950685</c:v>
                </c:pt>
                <c:pt idx="152">
                  <c:v>0.14371413195016722</c:v>
                </c:pt>
                <c:pt idx="153">
                  <c:v>0.13843087158796816</c:v>
                </c:pt>
                <c:pt idx="154">
                  <c:v>0.13367500445616801</c:v>
                </c:pt>
                <c:pt idx="155">
                  <c:v>0.12889845932040878</c:v>
                </c:pt>
                <c:pt idx="156">
                  <c:v>0.12596401131699836</c:v>
                </c:pt>
                <c:pt idx="157">
                  <c:v>0.12259160861035046</c:v>
                </c:pt>
                <c:pt idx="158">
                  <c:v>0.11760339441873308</c:v>
                </c:pt>
                <c:pt idx="159">
                  <c:v>0.11351535958566107</c:v>
                </c:pt>
                <c:pt idx="160">
                  <c:v>0.11033917761555932</c:v>
                </c:pt>
                <c:pt idx="161">
                  <c:v>0.10735374541783238</c:v>
                </c:pt>
                <c:pt idx="162">
                  <c:v>0.10403379015574664</c:v>
                </c:pt>
                <c:pt idx="163">
                  <c:v>9.9827607180320063E-2</c:v>
                </c:pt>
                <c:pt idx="164">
                  <c:v>9.7125456237157889E-2</c:v>
                </c:pt>
                <c:pt idx="165">
                  <c:v>9.3830144943098812E-2</c:v>
                </c:pt>
                <c:pt idx="166">
                  <c:v>9.1009114161622884E-2</c:v>
                </c:pt>
                <c:pt idx="167">
                  <c:v>8.7977703153631778E-2</c:v>
                </c:pt>
                <c:pt idx="168">
                  <c:v>8.4692194575852739E-2</c:v>
                </c:pt>
                <c:pt idx="169">
                  <c:v>8.2691582702749025E-2</c:v>
                </c:pt>
                <c:pt idx="170">
                  <c:v>7.9143753598605371E-2</c:v>
                </c:pt>
                <c:pt idx="171">
                  <c:v>7.656371681635489E-2</c:v>
                </c:pt>
                <c:pt idx="172">
                  <c:v>7.4615502529917055E-2</c:v>
                </c:pt>
                <c:pt idx="173">
                  <c:v>7.1307993956523763E-2</c:v>
                </c:pt>
                <c:pt idx="174">
                  <c:v>6.8713988920667879E-2</c:v>
                </c:pt>
                <c:pt idx="175">
                  <c:v>6.7192188929105418E-2</c:v>
                </c:pt>
                <c:pt idx="176">
                  <c:v>6.5571418016531394E-2</c:v>
                </c:pt>
                <c:pt idx="177">
                  <c:v>6.2772536902439627E-2</c:v>
                </c:pt>
                <c:pt idx="178">
                  <c:v>6.131339867453553E-2</c:v>
                </c:pt>
                <c:pt idx="179">
                  <c:v>5.8721247753036207E-2</c:v>
                </c:pt>
                <c:pt idx="180">
                  <c:v>5.6508434777658267E-2</c:v>
                </c:pt>
                <c:pt idx="181">
                  <c:v>5.5273038093084217E-2</c:v>
                </c:pt>
                <c:pt idx="182">
                  <c:v>5.3310094781482409E-2</c:v>
                </c:pt>
                <c:pt idx="183">
                  <c:v>5.1661175343037061E-2</c:v>
                </c:pt>
                <c:pt idx="184">
                  <c:v>5.0107722278656529E-2</c:v>
                </c:pt>
                <c:pt idx="185">
                  <c:v>4.83752468909351E-2</c:v>
                </c:pt>
                <c:pt idx="186">
                  <c:v>4.6712271884902942E-2</c:v>
                </c:pt>
                <c:pt idx="187">
                  <c:v>4.5158394794099284E-2</c:v>
                </c:pt>
                <c:pt idx="188">
                  <c:v>4.3875813664492974E-2</c:v>
                </c:pt>
                <c:pt idx="189">
                  <c:v>4.2321113444342237E-2</c:v>
                </c:pt>
                <c:pt idx="190">
                  <c:v>4.0913533043560289E-2</c:v>
                </c:pt>
                <c:pt idx="191">
                  <c:v>3.9336304846296216E-2</c:v>
                </c:pt>
                <c:pt idx="192">
                  <c:v>3.8113001518674139E-2</c:v>
                </c:pt>
                <c:pt idx="193">
                  <c:v>3.7180965427340104E-2</c:v>
                </c:pt>
                <c:pt idx="194">
                  <c:v>3.5460300705023283E-2</c:v>
                </c:pt>
                <c:pt idx="195">
                  <c:v>3.4127695758610514E-2</c:v>
                </c:pt>
                <c:pt idx="196">
                  <c:v>3.30124136009219E-2</c:v>
                </c:pt>
                <c:pt idx="197">
                  <c:v>3.1745561313492696E-2</c:v>
                </c:pt>
                <c:pt idx="198">
                  <c:v>3.0967007693739911E-2</c:v>
                </c:pt>
                <c:pt idx="199">
                  <c:v>3.0653490997989873E-2</c:v>
                </c:pt>
                <c:pt idx="200">
                  <c:v>2.8490219607306955E-2</c:v>
                </c:pt>
              </c:numCache>
            </c:numRef>
          </c:yVal>
          <c:smooth val="1"/>
          <c:extLst>
            <c:ext xmlns:c16="http://schemas.microsoft.com/office/drawing/2014/chart" uri="{C3380CC4-5D6E-409C-BE32-E72D297353CC}">
              <c16:uniqueId val="{00000001-C379-4716-A601-4B261307531E}"/>
            </c:ext>
          </c:extLst>
        </c:ser>
        <c:dLbls>
          <c:showLegendKey val="0"/>
          <c:showVal val="0"/>
          <c:showCatName val="0"/>
          <c:showSerName val="0"/>
          <c:showPercent val="0"/>
          <c:showBubbleSize val="0"/>
        </c:dLbls>
        <c:axId val="148811568"/>
        <c:axId val="148812128"/>
      </c:scatterChart>
      <c:valAx>
        <c:axId val="148811568"/>
        <c:scaling>
          <c:orientation val="minMax"/>
          <c:max val="600"/>
          <c:min val="300"/>
        </c:scaling>
        <c:delete val="0"/>
        <c:axPos val="b"/>
        <c:title>
          <c:tx>
            <c:rich>
              <a:bodyPr/>
              <a:lstStyle/>
              <a:p>
                <a:pPr>
                  <a:defRPr/>
                </a:pPr>
                <a:r>
                  <a:rPr lang="en-GB" dirty="0"/>
                  <a:t>Wavelength (nm)</a:t>
                </a:r>
              </a:p>
            </c:rich>
          </c:tx>
          <c:layout/>
          <c:overlay val="0"/>
        </c:title>
        <c:numFmt formatCode="0" sourceLinked="1"/>
        <c:majorTickMark val="out"/>
        <c:minorTickMark val="none"/>
        <c:tickLblPos val="nextTo"/>
        <c:crossAx val="148812128"/>
        <c:crosses val="autoZero"/>
        <c:crossBetween val="midCat"/>
        <c:majorUnit val="50"/>
      </c:valAx>
      <c:valAx>
        <c:axId val="148812128"/>
        <c:scaling>
          <c:orientation val="minMax"/>
          <c:max val="1"/>
        </c:scaling>
        <c:delete val="0"/>
        <c:axPos val="l"/>
        <c:title>
          <c:tx>
            <c:rich>
              <a:bodyPr rot="-5400000" vert="horz"/>
              <a:lstStyle/>
              <a:p>
                <a:pPr>
                  <a:defRPr/>
                </a:pPr>
                <a:r>
                  <a:rPr lang="en-GB" dirty="0"/>
                  <a:t>Normalised intensity  (a.u.)</a:t>
                </a:r>
              </a:p>
            </c:rich>
          </c:tx>
          <c:layout/>
          <c:overlay val="0"/>
        </c:title>
        <c:numFmt formatCode="General" sourceLinked="1"/>
        <c:majorTickMark val="out"/>
        <c:minorTickMark val="none"/>
        <c:tickLblPos val="nextTo"/>
        <c:crossAx val="148811568"/>
        <c:crosses val="autoZero"/>
        <c:crossBetween val="midCat"/>
      </c:valAx>
    </c:plotArea>
    <c:legend>
      <c:legendPos val="r"/>
      <c:layout>
        <c:manualLayout>
          <c:xMode val="edge"/>
          <c:yMode val="edge"/>
          <c:x val="0.49733472732135475"/>
          <c:y val="0.13555027753059654"/>
          <c:w val="0.32754066473777627"/>
          <c:h val="0.32253393838086813"/>
        </c:manualLayout>
      </c:layout>
      <c:overlay val="0"/>
      <c:txPr>
        <a:bodyPr/>
        <a:lstStyle/>
        <a:p>
          <a:pPr>
            <a:defRPr sz="1000"/>
          </a:pPr>
          <a:endParaRPr lang="en-US"/>
        </a:p>
      </c:txPr>
    </c:legend>
    <c:plotVisOnly val="1"/>
    <c:dispBlanksAs val="gap"/>
    <c:showDLblsOverMax val="0"/>
  </c:chart>
  <c:spPr>
    <a:ln>
      <a:noFill/>
    </a:ln>
  </c:spPr>
  <c:externalData r:id="rId1">
    <c:autoUpdate val="0"/>
  </c:externalData>
</c:chartSpace>
</file>

<file path=ppt/charts/chart6.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barChart>
        <c:barDir val="col"/>
        <c:grouping val="clustered"/>
        <c:varyColors val="0"/>
        <c:ser>
          <c:idx val="0"/>
          <c:order val="0"/>
          <c:invertIfNegative val="0"/>
          <c:dPt>
            <c:idx val="0"/>
            <c:invertIfNegative val="0"/>
            <c:bubble3D val="0"/>
            <c:spPr>
              <a:solidFill>
                <a:schemeClr val="tx1">
                  <a:lumMod val="50000"/>
                  <a:lumOff val="50000"/>
                </a:schemeClr>
              </a:solidFill>
            </c:spPr>
            <c:extLst>
              <c:ext xmlns:c16="http://schemas.microsoft.com/office/drawing/2014/chart" uri="{C3380CC4-5D6E-409C-BE32-E72D297353CC}">
                <c16:uniqueId val="{00000001-678D-4F4A-8C52-11616C6B6DD8}"/>
              </c:ext>
            </c:extLst>
          </c:dPt>
          <c:dPt>
            <c:idx val="1"/>
            <c:invertIfNegative val="0"/>
            <c:bubble3D val="0"/>
            <c:spPr>
              <a:solidFill>
                <a:schemeClr val="bg1">
                  <a:lumMod val="75000"/>
                </a:schemeClr>
              </a:solidFill>
            </c:spPr>
            <c:extLst>
              <c:ext xmlns:c16="http://schemas.microsoft.com/office/drawing/2014/chart" uri="{C3380CC4-5D6E-409C-BE32-E72D297353CC}">
                <c16:uniqueId val="{00000003-678D-4F4A-8C52-11616C6B6DD8}"/>
              </c:ext>
            </c:extLst>
          </c:dPt>
          <c:errBars>
            <c:errBarType val="both"/>
            <c:errValType val="cust"/>
            <c:noEndCap val="0"/>
            <c:plus>
              <c:numRef>
                <c:f>Sheet1!$F$2:$F$4</c:f>
                <c:numCache>
                  <c:formatCode>General</c:formatCode>
                  <c:ptCount val="3"/>
                  <c:pt idx="0">
                    <c:v>219.51862826547438</c:v>
                  </c:pt>
                  <c:pt idx="1">
                    <c:v>236.01903482558353</c:v>
                  </c:pt>
                  <c:pt idx="2">
                    <c:v>0</c:v>
                  </c:pt>
                </c:numCache>
              </c:numRef>
            </c:plus>
            <c:minus>
              <c:numRef>
                <c:f>Sheet1!$F$2:$F$4</c:f>
                <c:numCache>
                  <c:formatCode>General</c:formatCode>
                  <c:ptCount val="3"/>
                  <c:pt idx="0">
                    <c:v>219.51862826547438</c:v>
                  </c:pt>
                  <c:pt idx="1">
                    <c:v>236.01903482558353</c:v>
                  </c:pt>
                  <c:pt idx="2">
                    <c:v>0</c:v>
                  </c:pt>
                </c:numCache>
              </c:numRef>
            </c:minus>
          </c:errBars>
          <c:cat>
            <c:strRef>
              <c:f>Sheet1!$A$2:$A$4</c:f>
              <c:strCache>
                <c:ptCount val="3"/>
                <c:pt idx="0">
                  <c:v>AZD2014</c:v>
                </c:pt>
                <c:pt idx="1">
                  <c:v>AZD2014 + GFP (1:1)</c:v>
                </c:pt>
                <c:pt idx="2">
                  <c:v>GFP (control)</c:v>
                </c:pt>
              </c:strCache>
            </c:strRef>
          </c:cat>
          <c:val>
            <c:numRef>
              <c:f>Sheet1!$E$2:$E$4</c:f>
              <c:numCache>
                <c:formatCode>General</c:formatCode>
                <c:ptCount val="3"/>
                <c:pt idx="0">
                  <c:v>4019.6666666666665</c:v>
                </c:pt>
                <c:pt idx="1">
                  <c:v>2714.6</c:v>
                </c:pt>
                <c:pt idx="2">
                  <c:v>0</c:v>
                </c:pt>
              </c:numCache>
            </c:numRef>
          </c:val>
          <c:extLst>
            <c:ext xmlns:c16="http://schemas.microsoft.com/office/drawing/2014/chart" uri="{C3380CC4-5D6E-409C-BE32-E72D297353CC}">
              <c16:uniqueId val="{00000004-678D-4F4A-8C52-11616C6B6DD8}"/>
            </c:ext>
          </c:extLst>
        </c:ser>
        <c:dLbls>
          <c:showLegendKey val="0"/>
          <c:showVal val="0"/>
          <c:showCatName val="0"/>
          <c:showSerName val="0"/>
          <c:showPercent val="0"/>
          <c:showBubbleSize val="0"/>
        </c:dLbls>
        <c:gapWidth val="26"/>
        <c:axId val="148814368"/>
        <c:axId val="148814928"/>
      </c:barChart>
      <c:catAx>
        <c:axId val="148814368"/>
        <c:scaling>
          <c:orientation val="minMax"/>
        </c:scaling>
        <c:delete val="0"/>
        <c:axPos val="b"/>
        <c:numFmt formatCode="General" sourceLinked="0"/>
        <c:majorTickMark val="out"/>
        <c:minorTickMark val="none"/>
        <c:tickLblPos val="nextTo"/>
        <c:txPr>
          <a:bodyPr/>
          <a:lstStyle/>
          <a:p>
            <a:pPr>
              <a:defRPr sz="1100"/>
            </a:pPr>
            <a:endParaRPr lang="en-US"/>
          </a:p>
        </c:txPr>
        <c:crossAx val="148814928"/>
        <c:crosses val="autoZero"/>
        <c:auto val="1"/>
        <c:lblAlgn val="ctr"/>
        <c:lblOffset val="100"/>
        <c:noMultiLvlLbl val="0"/>
      </c:catAx>
      <c:valAx>
        <c:axId val="148814928"/>
        <c:scaling>
          <c:orientation val="minMax"/>
          <c:max val="4500"/>
          <c:min val="0"/>
        </c:scaling>
        <c:delete val="0"/>
        <c:axPos val="l"/>
        <c:title>
          <c:tx>
            <c:rich>
              <a:bodyPr rot="-5400000" vert="horz"/>
              <a:lstStyle/>
              <a:p>
                <a:pPr>
                  <a:defRPr sz="1100"/>
                </a:pPr>
                <a:r>
                  <a:rPr lang="en-GB" sz="1100"/>
                  <a:t>Lifetime (ps)</a:t>
                </a:r>
              </a:p>
            </c:rich>
          </c:tx>
          <c:layout/>
          <c:overlay val="0"/>
        </c:title>
        <c:numFmt formatCode="General" sourceLinked="1"/>
        <c:majorTickMark val="out"/>
        <c:minorTickMark val="none"/>
        <c:tickLblPos val="nextTo"/>
        <c:txPr>
          <a:bodyPr/>
          <a:lstStyle/>
          <a:p>
            <a:pPr>
              <a:defRPr sz="1100"/>
            </a:pPr>
            <a:endParaRPr lang="en-US"/>
          </a:p>
        </c:txPr>
        <c:crossAx val="148814368"/>
        <c:crosses val="autoZero"/>
        <c:crossBetween val="between"/>
        <c:majorUnit val="600"/>
      </c:valAx>
    </c:plotArea>
    <c:plotVisOnly val="1"/>
    <c:dispBlanksAs val="gap"/>
    <c:showDLblsOverMax val="0"/>
  </c:chart>
  <c:spPr>
    <a:ln>
      <a:noFill/>
    </a:ln>
  </c:spPr>
  <c:externalData r:id="rId1">
    <c:autoUpdate val="0"/>
  </c:externalData>
</c:chartSpace>
</file>

<file path=ppt/charts/chart7.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0"/>
    <c:plotArea>
      <c:layout>
        <c:manualLayout>
          <c:layoutTarget val="inner"/>
          <c:xMode val="edge"/>
          <c:yMode val="edge"/>
          <c:x val="0.19457801152402462"/>
          <c:y val="5.6045850420119302E-2"/>
          <c:w val="0.60086947102498767"/>
          <c:h val="0.39832095373580045"/>
        </c:manualLayout>
      </c:layout>
      <c:scatterChart>
        <c:scatterStyle val="smoothMarker"/>
        <c:varyColors val="0"/>
        <c:ser>
          <c:idx val="3"/>
          <c:order val="0"/>
          <c:tx>
            <c:strRef>
              <c:f>INK!$E$1</c:f>
              <c:strCache>
                <c:ptCount val="1"/>
                <c:pt idx="0">
                  <c:v>Quinine sulfate (200 µM) H2SO4 Abs</c:v>
                </c:pt>
              </c:strCache>
            </c:strRef>
          </c:tx>
          <c:marker>
            <c:symbol val="none"/>
          </c:marker>
          <c:xVal>
            <c:numRef>
              <c:f>INK!$E$3:$E$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INK!$F$3:$F$513</c:f>
              <c:numCache>
                <c:formatCode>General</c:formatCode>
                <c:ptCount val="511"/>
                <c:pt idx="0">
                  <c:v>3.8072810000000001</c:v>
                </c:pt>
                <c:pt idx="1">
                  <c:v>3.7487029999999999</c:v>
                </c:pt>
                <c:pt idx="2">
                  <c:v>3.8796390000000001</c:v>
                </c:pt>
                <c:pt idx="3">
                  <c:v>3.2689059999999999</c:v>
                </c:pt>
                <c:pt idx="4">
                  <c:v>3.4841609999999998</c:v>
                </c:pt>
                <c:pt idx="5">
                  <c:v>3.7718959999999999</c:v>
                </c:pt>
                <c:pt idx="6">
                  <c:v>3.6490019999999999</c:v>
                </c:pt>
                <c:pt idx="7">
                  <c:v>3.3213200000000001</c:v>
                </c:pt>
                <c:pt idx="8">
                  <c:v>3.3353120000000001</c:v>
                </c:pt>
                <c:pt idx="9">
                  <c:v>3.4586489999999999</c:v>
                </c:pt>
                <c:pt idx="10">
                  <c:v>3.295471</c:v>
                </c:pt>
                <c:pt idx="11">
                  <c:v>3.3747859999999998</c:v>
                </c:pt>
                <c:pt idx="12">
                  <c:v>3.1728969999999999</c:v>
                </c:pt>
                <c:pt idx="13">
                  <c:v>3.176453</c:v>
                </c:pt>
                <c:pt idx="14">
                  <c:v>3.1026150000000001</c:v>
                </c:pt>
                <c:pt idx="15">
                  <c:v>3.1504669999999999</c:v>
                </c:pt>
                <c:pt idx="16">
                  <c:v>3.2511290000000002</c:v>
                </c:pt>
                <c:pt idx="17">
                  <c:v>3.3808289999999999</c:v>
                </c:pt>
                <c:pt idx="18">
                  <c:v>3.2401279999999999</c:v>
                </c:pt>
                <c:pt idx="19">
                  <c:v>3.2020420000000001</c:v>
                </c:pt>
                <c:pt idx="20">
                  <c:v>3.134125</c:v>
                </c:pt>
                <c:pt idx="21">
                  <c:v>3.1278079999999999</c:v>
                </c:pt>
                <c:pt idx="22">
                  <c:v>3.0963590000000001</c:v>
                </c:pt>
                <c:pt idx="23">
                  <c:v>3.1302340000000002</c:v>
                </c:pt>
                <c:pt idx="24">
                  <c:v>3.1187290000000001</c:v>
                </c:pt>
                <c:pt idx="25">
                  <c:v>3.156876</c:v>
                </c:pt>
                <c:pt idx="26">
                  <c:v>3.0875089999999998</c:v>
                </c:pt>
                <c:pt idx="27">
                  <c:v>3.1176910000000002</c:v>
                </c:pt>
                <c:pt idx="28">
                  <c:v>3.1074830000000002</c:v>
                </c:pt>
                <c:pt idx="29">
                  <c:v>3.0135960000000002</c:v>
                </c:pt>
                <c:pt idx="30">
                  <c:v>2.988937</c:v>
                </c:pt>
                <c:pt idx="31">
                  <c:v>2.9153289999999998</c:v>
                </c:pt>
                <c:pt idx="32">
                  <c:v>2.8876949999999999</c:v>
                </c:pt>
                <c:pt idx="33">
                  <c:v>2.8015289999999999</c:v>
                </c:pt>
                <c:pt idx="34">
                  <c:v>2.7167509999999999</c:v>
                </c:pt>
                <c:pt idx="35">
                  <c:v>2.634277</c:v>
                </c:pt>
                <c:pt idx="36">
                  <c:v>2.5356290000000001</c:v>
                </c:pt>
                <c:pt idx="37">
                  <c:v>2.4366910000000002</c:v>
                </c:pt>
                <c:pt idx="38">
                  <c:v>2.3487849999999999</c:v>
                </c:pt>
                <c:pt idx="39">
                  <c:v>2.2752530000000002</c:v>
                </c:pt>
                <c:pt idx="40">
                  <c:v>2.2335970000000001</c:v>
                </c:pt>
                <c:pt idx="41">
                  <c:v>2.2210999999999999</c:v>
                </c:pt>
                <c:pt idx="42">
                  <c:v>2.2427519999999999</c:v>
                </c:pt>
                <c:pt idx="43">
                  <c:v>2.2932890000000001</c:v>
                </c:pt>
                <c:pt idx="44">
                  <c:v>2.3749690000000001</c:v>
                </c:pt>
                <c:pt idx="45">
                  <c:v>2.4633639999999999</c:v>
                </c:pt>
                <c:pt idx="46">
                  <c:v>2.5759430000000001</c:v>
                </c:pt>
                <c:pt idx="47">
                  <c:v>2.690582</c:v>
                </c:pt>
                <c:pt idx="48">
                  <c:v>2.7966609999999998</c:v>
                </c:pt>
                <c:pt idx="49">
                  <c:v>2.9064640000000002</c:v>
                </c:pt>
                <c:pt idx="50">
                  <c:v>2.9583279999999998</c:v>
                </c:pt>
                <c:pt idx="51">
                  <c:v>2.9703059999999999</c:v>
                </c:pt>
                <c:pt idx="52">
                  <c:v>2.9820859999999998</c:v>
                </c:pt>
                <c:pt idx="53">
                  <c:v>2.9998170000000002</c:v>
                </c:pt>
                <c:pt idx="54">
                  <c:v>3.0351560000000002</c:v>
                </c:pt>
                <c:pt idx="55">
                  <c:v>2.985001</c:v>
                </c:pt>
                <c:pt idx="56">
                  <c:v>2.9777979999999999</c:v>
                </c:pt>
                <c:pt idx="57">
                  <c:v>2.9538570000000002</c:v>
                </c:pt>
                <c:pt idx="58">
                  <c:v>2.9637910000000001</c:v>
                </c:pt>
                <c:pt idx="59">
                  <c:v>2.9507599999999998</c:v>
                </c:pt>
                <c:pt idx="60">
                  <c:v>2.9414060000000002</c:v>
                </c:pt>
                <c:pt idx="61">
                  <c:v>2.9442140000000001</c:v>
                </c:pt>
                <c:pt idx="62">
                  <c:v>2.9101870000000001</c:v>
                </c:pt>
                <c:pt idx="63">
                  <c:v>2.8871310000000001</c:v>
                </c:pt>
                <c:pt idx="64">
                  <c:v>2.9257659999999999</c:v>
                </c:pt>
                <c:pt idx="65">
                  <c:v>2.8807529999999999</c:v>
                </c:pt>
                <c:pt idx="66">
                  <c:v>2.8489230000000001</c:v>
                </c:pt>
                <c:pt idx="67">
                  <c:v>2.7453460000000001</c:v>
                </c:pt>
                <c:pt idx="68">
                  <c:v>2.5071110000000001</c:v>
                </c:pt>
                <c:pt idx="69">
                  <c:v>2.116028</c:v>
                </c:pt>
                <c:pt idx="70">
                  <c:v>1.670868</c:v>
                </c:pt>
                <c:pt idx="71">
                  <c:v>1.2799069999999999</c:v>
                </c:pt>
                <c:pt idx="72">
                  <c:v>0.95999100000000004</c:v>
                </c:pt>
                <c:pt idx="73">
                  <c:v>0.71281399999999995</c:v>
                </c:pt>
                <c:pt idx="74">
                  <c:v>0.531219</c:v>
                </c:pt>
                <c:pt idx="75">
                  <c:v>0.40833999999999998</c:v>
                </c:pt>
                <c:pt idx="76">
                  <c:v>0.32983400000000002</c:v>
                </c:pt>
                <c:pt idx="77">
                  <c:v>0.28112799999999999</c:v>
                </c:pt>
                <c:pt idx="78">
                  <c:v>0.25390600000000002</c:v>
                </c:pt>
                <c:pt idx="79">
                  <c:v>0.24032600000000001</c:v>
                </c:pt>
                <c:pt idx="80">
                  <c:v>0.23497000000000001</c:v>
                </c:pt>
                <c:pt idx="81">
                  <c:v>0.23443600000000001</c:v>
                </c:pt>
                <c:pt idx="82">
                  <c:v>0.23722799999999999</c:v>
                </c:pt>
                <c:pt idx="83">
                  <c:v>0.24191299999999999</c:v>
                </c:pt>
                <c:pt idx="84">
                  <c:v>0.248001</c:v>
                </c:pt>
                <c:pt idx="85">
                  <c:v>0.25495899999999999</c:v>
                </c:pt>
                <c:pt idx="86">
                  <c:v>0.26307700000000001</c:v>
                </c:pt>
                <c:pt idx="87">
                  <c:v>0.27171299999999998</c:v>
                </c:pt>
                <c:pt idx="88">
                  <c:v>0.28066999999999998</c:v>
                </c:pt>
                <c:pt idx="89">
                  <c:v>0.291016</c:v>
                </c:pt>
                <c:pt idx="90">
                  <c:v>0.30197099999999999</c:v>
                </c:pt>
                <c:pt idx="91">
                  <c:v>0.31365999999999999</c:v>
                </c:pt>
                <c:pt idx="92">
                  <c:v>0.325851</c:v>
                </c:pt>
                <c:pt idx="93">
                  <c:v>0.33931</c:v>
                </c:pt>
                <c:pt idx="94">
                  <c:v>0.35349999999999998</c:v>
                </c:pt>
                <c:pt idx="95">
                  <c:v>0.36724899999999999</c:v>
                </c:pt>
                <c:pt idx="96">
                  <c:v>0.381714</c:v>
                </c:pt>
                <c:pt idx="97">
                  <c:v>0.39704899999999999</c:v>
                </c:pt>
                <c:pt idx="98">
                  <c:v>0.41256700000000002</c:v>
                </c:pt>
                <c:pt idx="99">
                  <c:v>0.42895499999999998</c:v>
                </c:pt>
                <c:pt idx="100">
                  <c:v>0.44644200000000001</c:v>
                </c:pt>
                <c:pt idx="101">
                  <c:v>0.46464499999999997</c:v>
                </c:pt>
                <c:pt idx="102">
                  <c:v>0.483902</c:v>
                </c:pt>
                <c:pt idx="103">
                  <c:v>0.50373800000000002</c:v>
                </c:pt>
                <c:pt idx="104">
                  <c:v>0.525482</c:v>
                </c:pt>
                <c:pt idx="105">
                  <c:v>0.53082300000000004</c:v>
                </c:pt>
                <c:pt idx="106">
                  <c:v>0.53253200000000001</c:v>
                </c:pt>
                <c:pt idx="107">
                  <c:v>0.55822799999999995</c:v>
                </c:pt>
                <c:pt idx="108">
                  <c:v>0.57858299999999996</c:v>
                </c:pt>
                <c:pt idx="109">
                  <c:v>0.60143999999999997</c:v>
                </c:pt>
                <c:pt idx="110">
                  <c:v>0.62519800000000003</c:v>
                </c:pt>
                <c:pt idx="111">
                  <c:v>0.65055799999999997</c:v>
                </c:pt>
                <c:pt idx="112">
                  <c:v>0.66879299999999997</c:v>
                </c:pt>
                <c:pt idx="113">
                  <c:v>0.69113199999999997</c:v>
                </c:pt>
                <c:pt idx="114">
                  <c:v>0.71435499999999996</c:v>
                </c:pt>
                <c:pt idx="115">
                  <c:v>0.73574799999999996</c:v>
                </c:pt>
                <c:pt idx="116">
                  <c:v>0.79305999999999999</c:v>
                </c:pt>
                <c:pt idx="117">
                  <c:v>0.82313499999999995</c:v>
                </c:pt>
                <c:pt idx="118">
                  <c:v>0.84536699999999998</c:v>
                </c:pt>
                <c:pt idx="119">
                  <c:v>0.86714199999999997</c:v>
                </c:pt>
                <c:pt idx="120">
                  <c:v>0.88616899999999998</c:v>
                </c:pt>
                <c:pt idx="121">
                  <c:v>0.90388500000000005</c:v>
                </c:pt>
                <c:pt idx="122">
                  <c:v>0.92501800000000001</c:v>
                </c:pt>
                <c:pt idx="123">
                  <c:v>0.93377699999999997</c:v>
                </c:pt>
                <c:pt idx="124">
                  <c:v>0.94387799999999999</c:v>
                </c:pt>
                <c:pt idx="125">
                  <c:v>0.95286599999999999</c:v>
                </c:pt>
                <c:pt idx="126">
                  <c:v>0.95701599999999998</c:v>
                </c:pt>
                <c:pt idx="127">
                  <c:v>0.95700099999999999</c:v>
                </c:pt>
                <c:pt idx="128">
                  <c:v>0.95719900000000002</c:v>
                </c:pt>
                <c:pt idx="129">
                  <c:v>0.94900499999999999</c:v>
                </c:pt>
                <c:pt idx="130">
                  <c:v>0.94107099999999999</c:v>
                </c:pt>
                <c:pt idx="131">
                  <c:v>0.931091</c:v>
                </c:pt>
                <c:pt idx="132">
                  <c:v>0.921265</c:v>
                </c:pt>
                <c:pt idx="133">
                  <c:v>0.91468799999999995</c:v>
                </c:pt>
                <c:pt idx="134">
                  <c:v>0.90908800000000001</c:v>
                </c:pt>
                <c:pt idx="135">
                  <c:v>0.90493800000000002</c:v>
                </c:pt>
                <c:pt idx="136">
                  <c:v>0.90725699999999998</c:v>
                </c:pt>
                <c:pt idx="137">
                  <c:v>0.91180399999999995</c:v>
                </c:pt>
                <c:pt idx="138">
                  <c:v>0.92066999999999999</c:v>
                </c:pt>
                <c:pt idx="139">
                  <c:v>0.93042000000000002</c:v>
                </c:pt>
                <c:pt idx="140">
                  <c:v>0.94410700000000003</c:v>
                </c:pt>
                <c:pt idx="141">
                  <c:v>0.95869400000000005</c:v>
                </c:pt>
                <c:pt idx="142">
                  <c:v>0.97454799999999997</c:v>
                </c:pt>
                <c:pt idx="143">
                  <c:v>0.99345399999999995</c:v>
                </c:pt>
                <c:pt idx="144">
                  <c:v>1.0106200000000001</c:v>
                </c:pt>
                <c:pt idx="145">
                  <c:v>1.028351</c:v>
                </c:pt>
                <c:pt idx="146">
                  <c:v>1.049026</c:v>
                </c:pt>
                <c:pt idx="147">
                  <c:v>1.0658259999999999</c:v>
                </c:pt>
                <c:pt idx="148">
                  <c:v>1.085175</c:v>
                </c:pt>
                <c:pt idx="149">
                  <c:v>1.1020970000000001</c:v>
                </c:pt>
                <c:pt idx="150">
                  <c:v>1.1110530000000001</c:v>
                </c:pt>
                <c:pt idx="151">
                  <c:v>1.126312</c:v>
                </c:pt>
                <c:pt idx="152">
                  <c:v>1.1376500000000001</c:v>
                </c:pt>
                <c:pt idx="153">
                  <c:v>1.1451420000000001</c:v>
                </c:pt>
                <c:pt idx="154">
                  <c:v>1.1527860000000001</c:v>
                </c:pt>
                <c:pt idx="155">
                  <c:v>1.1579740000000001</c:v>
                </c:pt>
                <c:pt idx="156">
                  <c:v>1.1579740000000001</c:v>
                </c:pt>
                <c:pt idx="157">
                  <c:v>1.157913</c:v>
                </c:pt>
                <c:pt idx="158">
                  <c:v>1.155197</c:v>
                </c:pt>
                <c:pt idx="159">
                  <c:v>1.1519010000000001</c:v>
                </c:pt>
                <c:pt idx="160">
                  <c:v>1.1450499999999999</c:v>
                </c:pt>
                <c:pt idx="161">
                  <c:v>1.1358490000000001</c:v>
                </c:pt>
                <c:pt idx="162">
                  <c:v>1.12442</c:v>
                </c:pt>
                <c:pt idx="163">
                  <c:v>1.107834</c:v>
                </c:pt>
                <c:pt idx="164">
                  <c:v>1.091507</c:v>
                </c:pt>
                <c:pt idx="165">
                  <c:v>1.0690770000000001</c:v>
                </c:pt>
                <c:pt idx="166">
                  <c:v>1.049957</c:v>
                </c:pt>
                <c:pt idx="167">
                  <c:v>1.027039</c:v>
                </c:pt>
                <c:pt idx="168">
                  <c:v>0.99934400000000001</c:v>
                </c:pt>
                <c:pt idx="169">
                  <c:v>0.97270199999999996</c:v>
                </c:pt>
                <c:pt idx="170">
                  <c:v>0.94207799999999997</c:v>
                </c:pt>
                <c:pt idx="171">
                  <c:v>0.90966800000000003</c:v>
                </c:pt>
                <c:pt idx="172">
                  <c:v>0.87654100000000001</c:v>
                </c:pt>
                <c:pt idx="173">
                  <c:v>0.840866</c:v>
                </c:pt>
                <c:pt idx="174">
                  <c:v>0.80575600000000003</c:v>
                </c:pt>
                <c:pt idx="175">
                  <c:v>0.76773100000000005</c:v>
                </c:pt>
                <c:pt idx="176">
                  <c:v>0.72933999999999999</c:v>
                </c:pt>
                <c:pt idx="177">
                  <c:v>0.69032300000000002</c:v>
                </c:pt>
                <c:pt idx="178">
                  <c:v>0.65196200000000004</c:v>
                </c:pt>
                <c:pt idx="179">
                  <c:v>0.61465499999999995</c:v>
                </c:pt>
                <c:pt idx="180">
                  <c:v>0.57640100000000005</c:v>
                </c:pt>
                <c:pt idx="181">
                  <c:v>0.54010000000000002</c:v>
                </c:pt>
                <c:pt idx="182">
                  <c:v>0.50543199999999999</c:v>
                </c:pt>
                <c:pt idx="183">
                  <c:v>0.47178599999999998</c:v>
                </c:pt>
                <c:pt idx="184">
                  <c:v>0.44067400000000001</c:v>
                </c:pt>
                <c:pt idx="185">
                  <c:v>0.40931699999999999</c:v>
                </c:pt>
                <c:pt idx="186">
                  <c:v>0.38037100000000001</c:v>
                </c:pt>
                <c:pt idx="187">
                  <c:v>0.352325</c:v>
                </c:pt>
                <c:pt idx="188">
                  <c:v>0.32646199999999997</c:v>
                </c:pt>
                <c:pt idx="189">
                  <c:v>0.30253600000000003</c:v>
                </c:pt>
                <c:pt idx="190">
                  <c:v>0.280441</c:v>
                </c:pt>
                <c:pt idx="191">
                  <c:v>0.26060499999999998</c:v>
                </c:pt>
                <c:pt idx="192">
                  <c:v>0.241898</c:v>
                </c:pt>
                <c:pt idx="193">
                  <c:v>0.22514300000000001</c:v>
                </c:pt>
                <c:pt idx="194">
                  <c:v>0.20918300000000001</c:v>
                </c:pt>
                <c:pt idx="195">
                  <c:v>0.19483900000000001</c:v>
                </c:pt>
                <c:pt idx="196">
                  <c:v>0.18159500000000001</c:v>
                </c:pt>
                <c:pt idx="197">
                  <c:v>0.16992199999999999</c:v>
                </c:pt>
                <c:pt idx="198">
                  <c:v>0.159363</c:v>
                </c:pt>
                <c:pt idx="199">
                  <c:v>0.14961199999999999</c:v>
                </c:pt>
                <c:pt idx="200">
                  <c:v>0.14067099999999999</c:v>
                </c:pt>
                <c:pt idx="201">
                  <c:v>0.13308700000000001</c:v>
                </c:pt>
                <c:pt idx="202">
                  <c:v>0.12597700000000001</c:v>
                </c:pt>
                <c:pt idx="203">
                  <c:v>0.11956799999999999</c:v>
                </c:pt>
                <c:pt idx="204">
                  <c:v>0.113968</c:v>
                </c:pt>
                <c:pt idx="205">
                  <c:v>0.108917</c:v>
                </c:pt>
                <c:pt idx="206">
                  <c:v>0.104492</c:v>
                </c:pt>
                <c:pt idx="207">
                  <c:v>0.10058599999999999</c:v>
                </c:pt>
                <c:pt idx="208">
                  <c:v>9.7153000000000003E-2</c:v>
                </c:pt>
                <c:pt idx="209">
                  <c:v>9.3903E-2</c:v>
                </c:pt>
                <c:pt idx="210">
                  <c:v>9.1109999999999997E-2</c:v>
                </c:pt>
                <c:pt idx="211">
                  <c:v>8.8745000000000004E-2</c:v>
                </c:pt>
                <c:pt idx="212">
                  <c:v>8.6638999999999994E-2</c:v>
                </c:pt>
                <c:pt idx="213">
                  <c:v>8.4869E-2</c:v>
                </c:pt>
                <c:pt idx="214">
                  <c:v>8.3281999999999995E-2</c:v>
                </c:pt>
                <c:pt idx="215">
                  <c:v>8.1863000000000005E-2</c:v>
                </c:pt>
                <c:pt idx="216">
                  <c:v>8.0718999999999999E-2</c:v>
                </c:pt>
                <c:pt idx="217">
                  <c:v>7.9697000000000004E-2</c:v>
                </c:pt>
                <c:pt idx="218">
                  <c:v>7.8673999999999994E-2</c:v>
                </c:pt>
                <c:pt idx="219">
                  <c:v>7.7881000000000006E-2</c:v>
                </c:pt>
                <c:pt idx="220">
                  <c:v>7.7163999999999996E-2</c:v>
                </c:pt>
                <c:pt idx="221">
                  <c:v>7.6614000000000002E-2</c:v>
                </c:pt>
                <c:pt idx="222">
                  <c:v>7.6079999999999995E-2</c:v>
                </c:pt>
                <c:pt idx="223">
                  <c:v>7.5699000000000002E-2</c:v>
                </c:pt>
                <c:pt idx="224">
                  <c:v>7.5179999999999997E-2</c:v>
                </c:pt>
                <c:pt idx="225">
                  <c:v>7.4753E-2</c:v>
                </c:pt>
                <c:pt idx="226">
                  <c:v>7.4416999999999997E-2</c:v>
                </c:pt>
                <c:pt idx="227">
                  <c:v>7.4264999999999998E-2</c:v>
                </c:pt>
                <c:pt idx="228">
                  <c:v>7.3958999999999997E-2</c:v>
                </c:pt>
                <c:pt idx="229">
                  <c:v>7.3775999999999994E-2</c:v>
                </c:pt>
                <c:pt idx="230">
                  <c:v>7.3578000000000005E-2</c:v>
                </c:pt>
                <c:pt idx="231">
                  <c:v>7.3288000000000006E-2</c:v>
                </c:pt>
                <c:pt idx="232">
                  <c:v>7.3180999999999996E-2</c:v>
                </c:pt>
                <c:pt idx="233">
                  <c:v>7.3150999999999994E-2</c:v>
                </c:pt>
                <c:pt idx="234">
                  <c:v>7.2890999999999997E-2</c:v>
                </c:pt>
                <c:pt idx="235">
                  <c:v>7.2860999999999995E-2</c:v>
                </c:pt>
                <c:pt idx="236">
                  <c:v>7.2800000000000004E-2</c:v>
                </c:pt>
                <c:pt idx="237">
                  <c:v>7.2555999999999995E-2</c:v>
                </c:pt>
                <c:pt idx="238">
                  <c:v>7.2417999999999996E-2</c:v>
                </c:pt>
                <c:pt idx="239">
                  <c:v>7.2327000000000002E-2</c:v>
                </c:pt>
                <c:pt idx="240">
                  <c:v>7.2327000000000002E-2</c:v>
                </c:pt>
                <c:pt idx="241">
                  <c:v>7.2249999999999995E-2</c:v>
                </c:pt>
                <c:pt idx="242">
                  <c:v>7.2097999999999995E-2</c:v>
                </c:pt>
                <c:pt idx="243">
                  <c:v>7.2037000000000004E-2</c:v>
                </c:pt>
                <c:pt idx="244">
                  <c:v>7.2006000000000001E-2</c:v>
                </c:pt>
                <c:pt idx="245">
                  <c:v>7.1929999999999994E-2</c:v>
                </c:pt>
                <c:pt idx="246">
                  <c:v>7.1884000000000003E-2</c:v>
                </c:pt>
                <c:pt idx="247">
                  <c:v>7.1869000000000002E-2</c:v>
                </c:pt>
                <c:pt idx="248">
                  <c:v>7.1686E-2</c:v>
                </c:pt>
                <c:pt idx="249">
                  <c:v>7.1639999999999995E-2</c:v>
                </c:pt>
                <c:pt idx="250">
                  <c:v>7.1517999999999998E-2</c:v>
                </c:pt>
                <c:pt idx="251">
                  <c:v>7.1486999999999995E-2</c:v>
                </c:pt>
                <c:pt idx="252">
                  <c:v>7.1442000000000005E-2</c:v>
                </c:pt>
                <c:pt idx="253">
                  <c:v>7.1289000000000005E-2</c:v>
                </c:pt>
                <c:pt idx="254">
                  <c:v>7.1304000000000006E-2</c:v>
                </c:pt>
                <c:pt idx="255">
                  <c:v>7.1259000000000003E-2</c:v>
                </c:pt>
                <c:pt idx="256">
                  <c:v>7.1059999999999998E-2</c:v>
                </c:pt>
                <c:pt idx="257">
                  <c:v>7.1106000000000003E-2</c:v>
                </c:pt>
                <c:pt idx="258">
                  <c:v>7.1044999999999997E-2</c:v>
                </c:pt>
                <c:pt idx="259">
                  <c:v>7.0891999999999997E-2</c:v>
                </c:pt>
                <c:pt idx="260">
                  <c:v>7.0801000000000003E-2</c:v>
                </c:pt>
                <c:pt idx="261">
                  <c:v>7.0786000000000002E-2</c:v>
                </c:pt>
                <c:pt idx="262">
                  <c:v>7.0786000000000002E-2</c:v>
                </c:pt>
                <c:pt idx="263">
                  <c:v>7.0679000000000006E-2</c:v>
                </c:pt>
                <c:pt idx="264">
                  <c:v>7.0496000000000003E-2</c:v>
                </c:pt>
                <c:pt idx="265">
                  <c:v>7.0526000000000005E-2</c:v>
                </c:pt>
                <c:pt idx="266">
                  <c:v>7.0496000000000003E-2</c:v>
                </c:pt>
                <c:pt idx="267">
                  <c:v>7.0328000000000002E-2</c:v>
                </c:pt>
                <c:pt idx="268">
                  <c:v>7.0221000000000006E-2</c:v>
                </c:pt>
                <c:pt idx="269">
                  <c:v>7.0128999999999997E-2</c:v>
                </c:pt>
                <c:pt idx="270">
                  <c:v>7.0128999999999997E-2</c:v>
                </c:pt>
                <c:pt idx="271">
                  <c:v>7.016E-2</c:v>
                </c:pt>
                <c:pt idx="272">
                  <c:v>7.0068000000000005E-2</c:v>
                </c:pt>
                <c:pt idx="273">
                  <c:v>6.9961999999999996E-2</c:v>
                </c:pt>
                <c:pt idx="274">
                  <c:v>6.9976999999999998E-2</c:v>
                </c:pt>
                <c:pt idx="275">
                  <c:v>6.9870000000000002E-2</c:v>
                </c:pt>
                <c:pt idx="276">
                  <c:v>6.9748000000000004E-2</c:v>
                </c:pt>
                <c:pt idx="277">
                  <c:v>6.9763000000000006E-2</c:v>
                </c:pt>
                <c:pt idx="278">
                  <c:v>6.9640999999999995E-2</c:v>
                </c:pt>
                <c:pt idx="279">
                  <c:v>6.9611000000000006E-2</c:v>
                </c:pt>
                <c:pt idx="280">
                  <c:v>6.9503999999999996E-2</c:v>
                </c:pt>
                <c:pt idx="281">
                  <c:v>6.9458000000000006E-2</c:v>
                </c:pt>
                <c:pt idx="282">
                  <c:v>6.9365999999999997E-2</c:v>
                </c:pt>
                <c:pt idx="283">
                  <c:v>6.9244E-2</c:v>
                </c:pt>
                <c:pt idx="284">
                  <c:v>6.9167999999999993E-2</c:v>
                </c:pt>
                <c:pt idx="285">
                  <c:v>6.9045999999999996E-2</c:v>
                </c:pt>
                <c:pt idx="286">
                  <c:v>6.9015999999999994E-2</c:v>
                </c:pt>
                <c:pt idx="287">
                  <c:v>6.8877999999999995E-2</c:v>
                </c:pt>
                <c:pt idx="288">
                  <c:v>6.8770999999999999E-2</c:v>
                </c:pt>
                <c:pt idx="289">
                  <c:v>6.8740999999999997E-2</c:v>
                </c:pt>
                <c:pt idx="290">
                  <c:v>6.8634000000000001E-2</c:v>
                </c:pt>
                <c:pt idx="291">
                  <c:v>6.8634000000000001E-2</c:v>
                </c:pt>
                <c:pt idx="292">
                  <c:v>6.8497000000000002E-2</c:v>
                </c:pt>
                <c:pt idx="293">
                  <c:v>6.8527000000000005E-2</c:v>
                </c:pt>
                <c:pt idx="294">
                  <c:v>6.8375000000000005E-2</c:v>
                </c:pt>
                <c:pt idx="295">
                  <c:v>6.8207000000000004E-2</c:v>
                </c:pt>
                <c:pt idx="296">
                  <c:v>6.8145999999999998E-2</c:v>
                </c:pt>
                <c:pt idx="297">
                  <c:v>6.8145999999999998E-2</c:v>
                </c:pt>
                <c:pt idx="298">
                  <c:v>6.8069000000000005E-2</c:v>
                </c:pt>
                <c:pt idx="299">
                  <c:v>6.8007999999999999E-2</c:v>
                </c:pt>
                <c:pt idx="300">
                  <c:v>6.7946999999999994E-2</c:v>
                </c:pt>
                <c:pt idx="301">
                  <c:v>6.7946999999999994E-2</c:v>
                </c:pt>
                <c:pt idx="302">
                  <c:v>6.7886000000000002E-2</c:v>
                </c:pt>
                <c:pt idx="303">
                  <c:v>6.7886000000000002E-2</c:v>
                </c:pt>
                <c:pt idx="304">
                  <c:v>6.7824999999999996E-2</c:v>
                </c:pt>
                <c:pt idx="305">
                  <c:v>6.7734000000000003E-2</c:v>
                </c:pt>
                <c:pt idx="306">
                  <c:v>6.7687999999999998E-2</c:v>
                </c:pt>
                <c:pt idx="307">
                  <c:v>6.7702999999999999E-2</c:v>
                </c:pt>
                <c:pt idx="308">
                  <c:v>6.7672999999999997E-2</c:v>
                </c:pt>
                <c:pt idx="309">
                  <c:v>6.7641999999999994E-2</c:v>
                </c:pt>
                <c:pt idx="310">
                  <c:v>6.7534999999999998E-2</c:v>
                </c:pt>
                <c:pt idx="311">
                  <c:v>6.7398E-2</c:v>
                </c:pt>
                <c:pt idx="312">
                  <c:v>6.7322000000000007E-2</c:v>
                </c:pt>
                <c:pt idx="313">
                  <c:v>6.7291000000000004E-2</c:v>
                </c:pt>
                <c:pt idx="314">
                  <c:v>6.7276000000000002E-2</c:v>
                </c:pt>
                <c:pt idx="315">
                  <c:v>6.7229999999999998E-2</c:v>
                </c:pt>
                <c:pt idx="316">
                  <c:v>6.7123000000000002E-2</c:v>
                </c:pt>
                <c:pt idx="317">
                  <c:v>6.7016999999999993E-2</c:v>
                </c:pt>
                <c:pt idx="318">
                  <c:v>6.7046999999999995E-2</c:v>
                </c:pt>
                <c:pt idx="319">
                  <c:v>6.6956000000000002E-2</c:v>
                </c:pt>
                <c:pt idx="320">
                  <c:v>6.6924999999999998E-2</c:v>
                </c:pt>
                <c:pt idx="321">
                  <c:v>6.6894999999999996E-2</c:v>
                </c:pt>
                <c:pt idx="322">
                  <c:v>6.6803000000000001E-2</c:v>
                </c:pt>
                <c:pt idx="323">
                  <c:v>6.6726999999999995E-2</c:v>
                </c:pt>
                <c:pt idx="324">
                  <c:v>6.6619999999999999E-2</c:v>
                </c:pt>
                <c:pt idx="325">
                  <c:v>6.6604999999999998E-2</c:v>
                </c:pt>
                <c:pt idx="326">
                  <c:v>6.6513000000000003E-2</c:v>
                </c:pt>
                <c:pt idx="327">
                  <c:v>6.6544000000000006E-2</c:v>
                </c:pt>
                <c:pt idx="328">
                  <c:v>6.6483E-2</c:v>
                </c:pt>
                <c:pt idx="329">
                  <c:v>6.6298999999999997E-2</c:v>
                </c:pt>
                <c:pt idx="330">
                  <c:v>6.6268999999999995E-2</c:v>
                </c:pt>
                <c:pt idx="331">
                  <c:v>6.6238000000000005E-2</c:v>
                </c:pt>
                <c:pt idx="332">
                  <c:v>6.6161999999999999E-2</c:v>
                </c:pt>
                <c:pt idx="333">
                  <c:v>6.6146999999999997E-2</c:v>
                </c:pt>
                <c:pt idx="334">
                  <c:v>6.6071000000000005E-2</c:v>
                </c:pt>
                <c:pt idx="335">
                  <c:v>6.6055000000000003E-2</c:v>
                </c:pt>
                <c:pt idx="336">
                  <c:v>6.5887000000000001E-2</c:v>
                </c:pt>
                <c:pt idx="337">
                  <c:v>6.5825999999999996E-2</c:v>
                </c:pt>
                <c:pt idx="338">
                  <c:v>6.5795999999999993E-2</c:v>
                </c:pt>
                <c:pt idx="339">
                  <c:v>6.5795999999999993E-2</c:v>
                </c:pt>
                <c:pt idx="340">
                  <c:v>6.5720000000000001E-2</c:v>
                </c:pt>
                <c:pt idx="341">
                  <c:v>6.5658999999999995E-2</c:v>
                </c:pt>
                <c:pt idx="342">
                  <c:v>6.5505999999999995E-2</c:v>
                </c:pt>
                <c:pt idx="343">
                  <c:v>6.5490999999999994E-2</c:v>
                </c:pt>
                <c:pt idx="344">
                  <c:v>6.5460000000000004E-2</c:v>
                </c:pt>
                <c:pt idx="345">
                  <c:v>6.5398999999999999E-2</c:v>
                </c:pt>
                <c:pt idx="346">
                  <c:v>6.5262000000000001E-2</c:v>
                </c:pt>
                <c:pt idx="347">
                  <c:v>6.5078999999999998E-2</c:v>
                </c:pt>
                <c:pt idx="348">
                  <c:v>6.5109E-2</c:v>
                </c:pt>
                <c:pt idx="349">
                  <c:v>6.5047999999999995E-2</c:v>
                </c:pt>
                <c:pt idx="350">
                  <c:v>6.5018000000000006E-2</c:v>
                </c:pt>
                <c:pt idx="351">
                  <c:v>6.5002000000000004E-2</c:v>
                </c:pt>
                <c:pt idx="352">
                  <c:v>6.4895999999999995E-2</c:v>
                </c:pt>
                <c:pt idx="353">
                  <c:v>6.4895999999999995E-2</c:v>
                </c:pt>
                <c:pt idx="354">
                  <c:v>6.4865000000000006E-2</c:v>
                </c:pt>
                <c:pt idx="355">
                  <c:v>6.4835000000000004E-2</c:v>
                </c:pt>
                <c:pt idx="356">
                  <c:v>6.4773999999999998E-2</c:v>
                </c:pt>
                <c:pt idx="357">
                  <c:v>6.4727999999999994E-2</c:v>
                </c:pt>
                <c:pt idx="358">
                  <c:v>6.4605999999999997E-2</c:v>
                </c:pt>
                <c:pt idx="359">
                  <c:v>6.4484E-2</c:v>
                </c:pt>
                <c:pt idx="360">
                  <c:v>6.4514000000000002E-2</c:v>
                </c:pt>
                <c:pt idx="361">
                  <c:v>6.4499000000000001E-2</c:v>
                </c:pt>
                <c:pt idx="362">
                  <c:v>6.4484E-2</c:v>
                </c:pt>
                <c:pt idx="363">
                  <c:v>6.4422999999999994E-2</c:v>
                </c:pt>
                <c:pt idx="364">
                  <c:v>6.4346E-2</c:v>
                </c:pt>
                <c:pt idx="365">
                  <c:v>6.4315999999999998E-2</c:v>
                </c:pt>
                <c:pt idx="366">
                  <c:v>6.4209000000000002E-2</c:v>
                </c:pt>
                <c:pt idx="367">
                  <c:v>6.4147999999999997E-2</c:v>
                </c:pt>
                <c:pt idx="368">
                  <c:v>6.4072000000000004E-2</c:v>
                </c:pt>
                <c:pt idx="369">
                  <c:v>6.4041000000000001E-2</c:v>
                </c:pt>
                <c:pt idx="370">
                  <c:v>6.4041000000000001E-2</c:v>
                </c:pt>
                <c:pt idx="371">
                  <c:v>6.4026E-2</c:v>
                </c:pt>
                <c:pt idx="372">
                  <c:v>6.3934000000000005E-2</c:v>
                </c:pt>
                <c:pt idx="373">
                  <c:v>6.3889000000000001E-2</c:v>
                </c:pt>
                <c:pt idx="374">
                  <c:v>6.3919000000000004E-2</c:v>
                </c:pt>
                <c:pt idx="375">
                  <c:v>6.3872999999999999E-2</c:v>
                </c:pt>
                <c:pt idx="376">
                  <c:v>6.3811999999999994E-2</c:v>
                </c:pt>
                <c:pt idx="377">
                  <c:v>6.3736000000000001E-2</c:v>
                </c:pt>
                <c:pt idx="378">
                  <c:v>6.3689999999999997E-2</c:v>
                </c:pt>
                <c:pt idx="379">
                  <c:v>6.3659999999999994E-2</c:v>
                </c:pt>
                <c:pt idx="380">
                  <c:v>6.3568E-2</c:v>
                </c:pt>
                <c:pt idx="381">
                  <c:v>6.3552999999999998E-2</c:v>
                </c:pt>
                <c:pt idx="382">
                  <c:v>6.3506999999999994E-2</c:v>
                </c:pt>
                <c:pt idx="383">
                  <c:v>6.3477000000000006E-2</c:v>
                </c:pt>
                <c:pt idx="384">
                  <c:v>6.3461000000000004E-2</c:v>
                </c:pt>
                <c:pt idx="385">
                  <c:v>6.3416E-2</c:v>
                </c:pt>
                <c:pt idx="386">
                  <c:v>6.3416E-2</c:v>
                </c:pt>
                <c:pt idx="387">
                  <c:v>6.3369999999999996E-2</c:v>
                </c:pt>
                <c:pt idx="388">
                  <c:v>6.3431000000000001E-2</c:v>
                </c:pt>
                <c:pt idx="389">
                  <c:v>6.3353999999999994E-2</c:v>
                </c:pt>
                <c:pt idx="390">
                  <c:v>6.3293000000000002E-2</c:v>
                </c:pt>
                <c:pt idx="391">
                  <c:v>6.3216999999999995E-2</c:v>
                </c:pt>
                <c:pt idx="392">
                  <c:v>6.3156000000000004E-2</c:v>
                </c:pt>
                <c:pt idx="393">
                  <c:v>6.3171000000000005E-2</c:v>
                </c:pt>
                <c:pt idx="394">
                  <c:v>6.3186999999999993E-2</c:v>
                </c:pt>
                <c:pt idx="395">
                  <c:v>6.3109999999999999E-2</c:v>
                </c:pt>
                <c:pt idx="396">
                  <c:v>6.3019000000000006E-2</c:v>
                </c:pt>
                <c:pt idx="397">
                  <c:v>6.3019000000000006E-2</c:v>
                </c:pt>
                <c:pt idx="398">
                  <c:v>6.2988000000000002E-2</c:v>
                </c:pt>
                <c:pt idx="399">
                  <c:v>6.2896999999999995E-2</c:v>
                </c:pt>
                <c:pt idx="400">
                  <c:v>6.2958E-2</c:v>
                </c:pt>
                <c:pt idx="401">
                  <c:v>6.2911999999999996E-2</c:v>
                </c:pt>
                <c:pt idx="402">
                  <c:v>6.2866000000000005E-2</c:v>
                </c:pt>
                <c:pt idx="403">
                  <c:v>6.2851000000000004E-2</c:v>
                </c:pt>
                <c:pt idx="404">
                  <c:v>6.2836000000000003E-2</c:v>
                </c:pt>
                <c:pt idx="405">
                  <c:v>6.2851000000000004E-2</c:v>
                </c:pt>
                <c:pt idx="406">
                  <c:v>6.2866000000000005E-2</c:v>
                </c:pt>
                <c:pt idx="407">
                  <c:v>6.2714000000000006E-2</c:v>
                </c:pt>
                <c:pt idx="408">
                  <c:v>6.2789999999999999E-2</c:v>
                </c:pt>
                <c:pt idx="409">
                  <c:v>6.2789999999999999E-2</c:v>
                </c:pt>
                <c:pt idx="410">
                  <c:v>6.2805E-2</c:v>
                </c:pt>
                <c:pt idx="411">
                  <c:v>6.2866000000000005E-2</c:v>
                </c:pt>
                <c:pt idx="412">
                  <c:v>6.2866000000000005E-2</c:v>
                </c:pt>
                <c:pt idx="413">
                  <c:v>6.2774999999999997E-2</c:v>
                </c:pt>
                <c:pt idx="414">
                  <c:v>6.2836000000000003E-2</c:v>
                </c:pt>
                <c:pt idx="415">
                  <c:v>6.2805E-2</c:v>
                </c:pt>
                <c:pt idx="416">
                  <c:v>6.2728999999999993E-2</c:v>
                </c:pt>
                <c:pt idx="417">
                  <c:v>6.2743999999999994E-2</c:v>
                </c:pt>
                <c:pt idx="418">
                  <c:v>6.2698000000000004E-2</c:v>
                </c:pt>
                <c:pt idx="419">
                  <c:v>6.2636999999999998E-2</c:v>
                </c:pt>
                <c:pt idx="420">
                  <c:v>6.2653E-2</c:v>
                </c:pt>
                <c:pt idx="421">
                  <c:v>6.2591999999999995E-2</c:v>
                </c:pt>
                <c:pt idx="422">
                  <c:v>6.2561000000000005E-2</c:v>
                </c:pt>
                <c:pt idx="423">
                  <c:v>6.2531000000000003E-2</c:v>
                </c:pt>
                <c:pt idx="424">
                  <c:v>6.2484999999999999E-2</c:v>
                </c:pt>
                <c:pt idx="425">
                  <c:v>6.2392999999999997E-2</c:v>
                </c:pt>
                <c:pt idx="426">
                  <c:v>6.2331999999999999E-2</c:v>
                </c:pt>
                <c:pt idx="427">
                  <c:v>6.2378000000000003E-2</c:v>
                </c:pt>
                <c:pt idx="428">
                  <c:v>6.2302000000000003E-2</c:v>
                </c:pt>
                <c:pt idx="429">
                  <c:v>6.2225000000000003E-2</c:v>
                </c:pt>
                <c:pt idx="430">
                  <c:v>6.2302000000000003E-2</c:v>
                </c:pt>
                <c:pt idx="431">
                  <c:v>6.2255999999999999E-2</c:v>
                </c:pt>
                <c:pt idx="432">
                  <c:v>6.2210000000000001E-2</c:v>
                </c:pt>
                <c:pt idx="433">
                  <c:v>6.2225000000000003E-2</c:v>
                </c:pt>
                <c:pt idx="434">
                  <c:v>6.2195E-2</c:v>
                </c:pt>
                <c:pt idx="435">
                  <c:v>6.2042E-2</c:v>
                </c:pt>
                <c:pt idx="436">
                  <c:v>6.2102999999999998E-2</c:v>
                </c:pt>
                <c:pt idx="437">
                  <c:v>6.2087999999999997E-2</c:v>
                </c:pt>
                <c:pt idx="438">
                  <c:v>6.2073000000000003E-2</c:v>
                </c:pt>
                <c:pt idx="439">
                  <c:v>6.2119000000000001E-2</c:v>
                </c:pt>
                <c:pt idx="440">
                  <c:v>6.1966E-2</c:v>
                </c:pt>
                <c:pt idx="441">
                  <c:v>6.1920000000000003E-2</c:v>
                </c:pt>
                <c:pt idx="442">
                  <c:v>6.1890000000000001E-2</c:v>
                </c:pt>
                <c:pt idx="443">
                  <c:v>6.1890000000000001E-2</c:v>
                </c:pt>
                <c:pt idx="444">
                  <c:v>6.1873999999999998E-2</c:v>
                </c:pt>
                <c:pt idx="445">
                  <c:v>6.1782999999999998E-2</c:v>
                </c:pt>
                <c:pt idx="446">
                  <c:v>6.1615000000000003E-2</c:v>
                </c:pt>
                <c:pt idx="447">
                  <c:v>6.1539000000000003E-2</c:v>
                </c:pt>
                <c:pt idx="448">
                  <c:v>6.1492999999999999E-2</c:v>
                </c:pt>
                <c:pt idx="449">
                  <c:v>6.1400999999999997E-2</c:v>
                </c:pt>
                <c:pt idx="450">
                  <c:v>6.1295000000000002E-2</c:v>
                </c:pt>
                <c:pt idx="451">
                  <c:v>6.1279E-2</c:v>
                </c:pt>
                <c:pt idx="452">
                  <c:v>6.1263999999999999E-2</c:v>
                </c:pt>
                <c:pt idx="453">
                  <c:v>6.1203E-2</c:v>
                </c:pt>
                <c:pt idx="454">
                  <c:v>6.1295000000000002E-2</c:v>
                </c:pt>
                <c:pt idx="455">
                  <c:v>6.1324999999999998E-2</c:v>
                </c:pt>
                <c:pt idx="456">
                  <c:v>6.1324999999999998E-2</c:v>
                </c:pt>
                <c:pt idx="457">
                  <c:v>6.1371000000000002E-2</c:v>
                </c:pt>
                <c:pt idx="458">
                  <c:v>6.1447000000000002E-2</c:v>
                </c:pt>
                <c:pt idx="459">
                  <c:v>6.1416999999999999E-2</c:v>
                </c:pt>
                <c:pt idx="460">
                  <c:v>6.1447000000000002E-2</c:v>
                </c:pt>
                <c:pt idx="461">
                  <c:v>6.1447000000000002E-2</c:v>
                </c:pt>
                <c:pt idx="462">
                  <c:v>6.1400999999999997E-2</c:v>
                </c:pt>
                <c:pt idx="463">
                  <c:v>6.1371000000000002E-2</c:v>
                </c:pt>
                <c:pt idx="464">
                  <c:v>6.1432E-2</c:v>
                </c:pt>
                <c:pt idx="465">
                  <c:v>6.1400999999999997E-2</c:v>
                </c:pt>
                <c:pt idx="466">
                  <c:v>6.1310000000000003E-2</c:v>
                </c:pt>
                <c:pt idx="467">
                  <c:v>6.1218000000000002E-2</c:v>
                </c:pt>
                <c:pt idx="468">
                  <c:v>6.1263999999999999E-2</c:v>
                </c:pt>
                <c:pt idx="469">
                  <c:v>6.1324999999999998E-2</c:v>
                </c:pt>
                <c:pt idx="470">
                  <c:v>6.1233999999999997E-2</c:v>
                </c:pt>
                <c:pt idx="471">
                  <c:v>6.1233999999999997E-2</c:v>
                </c:pt>
                <c:pt idx="472">
                  <c:v>6.1203E-2</c:v>
                </c:pt>
                <c:pt idx="473">
                  <c:v>6.1203E-2</c:v>
                </c:pt>
                <c:pt idx="474">
                  <c:v>6.1233999999999997E-2</c:v>
                </c:pt>
                <c:pt idx="475">
                  <c:v>6.1171999999999997E-2</c:v>
                </c:pt>
                <c:pt idx="476">
                  <c:v>6.1127000000000001E-2</c:v>
                </c:pt>
                <c:pt idx="477">
                  <c:v>6.105E-2</c:v>
                </c:pt>
                <c:pt idx="478">
                  <c:v>6.0958999999999999E-2</c:v>
                </c:pt>
                <c:pt idx="479">
                  <c:v>6.0974E-2</c:v>
                </c:pt>
                <c:pt idx="480">
                  <c:v>6.0943999999999998E-2</c:v>
                </c:pt>
                <c:pt idx="481">
                  <c:v>6.0913000000000002E-2</c:v>
                </c:pt>
                <c:pt idx="482">
                  <c:v>6.0913000000000002E-2</c:v>
                </c:pt>
                <c:pt idx="483">
                  <c:v>6.0913000000000002E-2</c:v>
                </c:pt>
                <c:pt idx="484">
                  <c:v>6.0883E-2</c:v>
                </c:pt>
                <c:pt idx="485">
                  <c:v>6.0898000000000001E-2</c:v>
                </c:pt>
                <c:pt idx="486">
                  <c:v>6.0898000000000001E-2</c:v>
                </c:pt>
                <c:pt idx="487">
                  <c:v>6.0822000000000001E-2</c:v>
                </c:pt>
                <c:pt idx="488">
                  <c:v>6.0852000000000003E-2</c:v>
                </c:pt>
                <c:pt idx="489">
                  <c:v>6.0822000000000001E-2</c:v>
                </c:pt>
                <c:pt idx="490">
                  <c:v>6.0852000000000003E-2</c:v>
                </c:pt>
                <c:pt idx="491">
                  <c:v>6.0822000000000001E-2</c:v>
                </c:pt>
                <c:pt idx="492">
                  <c:v>6.0714999999999998E-2</c:v>
                </c:pt>
                <c:pt idx="493">
                  <c:v>6.0714999999999998E-2</c:v>
                </c:pt>
                <c:pt idx="494">
                  <c:v>6.0729999999999999E-2</c:v>
                </c:pt>
                <c:pt idx="495">
                  <c:v>6.0699000000000003E-2</c:v>
                </c:pt>
                <c:pt idx="496">
                  <c:v>6.0714999999999998E-2</c:v>
                </c:pt>
                <c:pt idx="497">
                  <c:v>6.0637999999999997E-2</c:v>
                </c:pt>
                <c:pt idx="498">
                  <c:v>6.0669000000000001E-2</c:v>
                </c:pt>
                <c:pt idx="499">
                  <c:v>6.0669000000000001E-2</c:v>
                </c:pt>
                <c:pt idx="500">
                  <c:v>6.0699000000000003E-2</c:v>
                </c:pt>
                <c:pt idx="501">
                  <c:v>6.0654E-2</c:v>
                </c:pt>
                <c:pt idx="502">
                  <c:v>6.0561999999999998E-2</c:v>
                </c:pt>
                <c:pt idx="503">
                  <c:v>6.0608000000000002E-2</c:v>
                </c:pt>
                <c:pt idx="504">
                  <c:v>6.0576999999999999E-2</c:v>
                </c:pt>
                <c:pt idx="505">
                  <c:v>6.0516E-2</c:v>
                </c:pt>
                <c:pt idx="506">
                  <c:v>6.0576999999999999E-2</c:v>
                </c:pt>
                <c:pt idx="507">
                  <c:v>6.0608000000000002E-2</c:v>
                </c:pt>
                <c:pt idx="508">
                  <c:v>6.0593000000000001E-2</c:v>
                </c:pt>
                <c:pt idx="509">
                  <c:v>6.0623000000000003E-2</c:v>
                </c:pt>
                <c:pt idx="510">
                  <c:v>6.0699000000000003E-2</c:v>
                </c:pt>
              </c:numCache>
            </c:numRef>
          </c:yVal>
          <c:smooth val="1"/>
          <c:extLst>
            <c:ext xmlns:c16="http://schemas.microsoft.com/office/drawing/2014/chart" uri="{C3380CC4-5D6E-409C-BE32-E72D297353CC}">
              <c16:uniqueId val="{00000000-23D1-4D6B-8D95-E81ABA7C315A}"/>
            </c:ext>
          </c:extLst>
        </c:ser>
        <c:ser>
          <c:idx val="2"/>
          <c:order val="2"/>
          <c:tx>
            <c:strRef>
              <c:f>INK!$A$1</c:f>
              <c:strCache>
                <c:ptCount val="1"/>
                <c:pt idx="0">
                  <c:v>INK128 (16 µM) DMSO Abs</c:v>
                </c:pt>
              </c:strCache>
            </c:strRef>
          </c:tx>
          <c:marker>
            <c:symbol val="none"/>
          </c:marker>
          <c:xVal>
            <c:numRef>
              <c:f>INK!$A$3:$A$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INK!$B$3:$B$513</c:f>
              <c:numCache>
                <c:formatCode>General</c:formatCode>
                <c:ptCount val="511"/>
                <c:pt idx="0">
                  <c:v>4</c:v>
                </c:pt>
                <c:pt idx="1">
                  <c:v>3.9269560000000001</c:v>
                </c:pt>
                <c:pt idx="2">
                  <c:v>3.891861</c:v>
                </c:pt>
                <c:pt idx="3">
                  <c:v>3.8192750000000002</c:v>
                </c:pt>
                <c:pt idx="4">
                  <c:v>3.887527</c:v>
                </c:pt>
                <c:pt idx="5">
                  <c:v>4</c:v>
                </c:pt>
                <c:pt idx="6">
                  <c:v>3.9804840000000001</c:v>
                </c:pt>
                <c:pt idx="7">
                  <c:v>4</c:v>
                </c:pt>
                <c:pt idx="8">
                  <c:v>3.9946440000000001</c:v>
                </c:pt>
                <c:pt idx="9">
                  <c:v>3.9861759999999999</c:v>
                </c:pt>
                <c:pt idx="10">
                  <c:v>4</c:v>
                </c:pt>
                <c:pt idx="11">
                  <c:v>4</c:v>
                </c:pt>
                <c:pt idx="12">
                  <c:v>4</c:v>
                </c:pt>
                <c:pt idx="13">
                  <c:v>3.961411</c:v>
                </c:pt>
                <c:pt idx="14">
                  <c:v>3.977509</c:v>
                </c:pt>
                <c:pt idx="15">
                  <c:v>3.9730989999999999</c:v>
                </c:pt>
                <c:pt idx="16">
                  <c:v>3.9880520000000002</c:v>
                </c:pt>
                <c:pt idx="17">
                  <c:v>3.9541629999999999</c:v>
                </c:pt>
                <c:pt idx="18">
                  <c:v>3.9865110000000001</c:v>
                </c:pt>
                <c:pt idx="19">
                  <c:v>3.9363860000000002</c:v>
                </c:pt>
                <c:pt idx="20">
                  <c:v>3.9827729999999999</c:v>
                </c:pt>
                <c:pt idx="21">
                  <c:v>3.959015</c:v>
                </c:pt>
                <c:pt idx="22">
                  <c:v>4</c:v>
                </c:pt>
                <c:pt idx="23">
                  <c:v>4</c:v>
                </c:pt>
                <c:pt idx="24">
                  <c:v>4</c:v>
                </c:pt>
                <c:pt idx="25">
                  <c:v>3.9904329999999999</c:v>
                </c:pt>
                <c:pt idx="26">
                  <c:v>3.990189</c:v>
                </c:pt>
                <c:pt idx="27">
                  <c:v>3.9872130000000001</c:v>
                </c:pt>
                <c:pt idx="28">
                  <c:v>3.9798740000000001</c:v>
                </c:pt>
                <c:pt idx="29">
                  <c:v>3.9809420000000002</c:v>
                </c:pt>
                <c:pt idx="30">
                  <c:v>3.991638</c:v>
                </c:pt>
                <c:pt idx="31">
                  <c:v>4</c:v>
                </c:pt>
                <c:pt idx="32">
                  <c:v>3.9923549999999999</c:v>
                </c:pt>
                <c:pt idx="33">
                  <c:v>4</c:v>
                </c:pt>
                <c:pt idx="34">
                  <c:v>3.9979550000000001</c:v>
                </c:pt>
                <c:pt idx="35">
                  <c:v>4</c:v>
                </c:pt>
                <c:pt idx="36">
                  <c:v>4</c:v>
                </c:pt>
                <c:pt idx="37">
                  <c:v>4</c:v>
                </c:pt>
                <c:pt idx="38">
                  <c:v>3.984604</c:v>
                </c:pt>
                <c:pt idx="39">
                  <c:v>4</c:v>
                </c:pt>
                <c:pt idx="40">
                  <c:v>4</c:v>
                </c:pt>
                <c:pt idx="41">
                  <c:v>3.9967039999999998</c:v>
                </c:pt>
                <c:pt idx="42">
                  <c:v>3.9967039999999998</c:v>
                </c:pt>
                <c:pt idx="43">
                  <c:v>4</c:v>
                </c:pt>
                <c:pt idx="44">
                  <c:v>4</c:v>
                </c:pt>
                <c:pt idx="45">
                  <c:v>4</c:v>
                </c:pt>
                <c:pt idx="46">
                  <c:v>3.9827270000000001</c:v>
                </c:pt>
                <c:pt idx="47">
                  <c:v>3.9958800000000001</c:v>
                </c:pt>
                <c:pt idx="48">
                  <c:v>4</c:v>
                </c:pt>
                <c:pt idx="49">
                  <c:v>4</c:v>
                </c:pt>
                <c:pt idx="50">
                  <c:v>4</c:v>
                </c:pt>
                <c:pt idx="51">
                  <c:v>3.9957889999999998</c:v>
                </c:pt>
                <c:pt idx="52">
                  <c:v>3.9976039999999999</c:v>
                </c:pt>
                <c:pt idx="53">
                  <c:v>3.987228</c:v>
                </c:pt>
                <c:pt idx="54">
                  <c:v>3.9996339999999999</c:v>
                </c:pt>
                <c:pt idx="55">
                  <c:v>3.9868320000000002</c:v>
                </c:pt>
                <c:pt idx="56">
                  <c:v>3.9992220000000001</c:v>
                </c:pt>
                <c:pt idx="57">
                  <c:v>4</c:v>
                </c:pt>
                <c:pt idx="58">
                  <c:v>4</c:v>
                </c:pt>
                <c:pt idx="59">
                  <c:v>3.998383</c:v>
                </c:pt>
                <c:pt idx="60">
                  <c:v>3.9957889999999998</c:v>
                </c:pt>
                <c:pt idx="61">
                  <c:v>4</c:v>
                </c:pt>
                <c:pt idx="62">
                  <c:v>3.991425</c:v>
                </c:pt>
                <c:pt idx="63">
                  <c:v>3.9628299999999999</c:v>
                </c:pt>
                <c:pt idx="64">
                  <c:v>3.9008479999999999</c:v>
                </c:pt>
                <c:pt idx="65">
                  <c:v>3.7206570000000001</c:v>
                </c:pt>
                <c:pt idx="66">
                  <c:v>3.5187379999999999</c:v>
                </c:pt>
                <c:pt idx="67">
                  <c:v>3.104492</c:v>
                </c:pt>
                <c:pt idx="68">
                  <c:v>2.6713710000000002</c:v>
                </c:pt>
                <c:pt idx="69">
                  <c:v>2.34375</c:v>
                </c:pt>
                <c:pt idx="70">
                  <c:v>2.0540769999999999</c:v>
                </c:pt>
                <c:pt idx="71">
                  <c:v>1.8215479999999999</c:v>
                </c:pt>
                <c:pt idx="72">
                  <c:v>1.6286320000000001</c:v>
                </c:pt>
                <c:pt idx="73">
                  <c:v>1.4610749999999999</c:v>
                </c:pt>
                <c:pt idx="74">
                  <c:v>1.3176730000000001</c:v>
                </c:pt>
                <c:pt idx="75">
                  <c:v>1.195587</c:v>
                </c:pt>
                <c:pt idx="76">
                  <c:v>1.091415</c:v>
                </c:pt>
                <c:pt idx="77">
                  <c:v>1.0000610000000001</c:v>
                </c:pt>
                <c:pt idx="78">
                  <c:v>0.919983</c:v>
                </c:pt>
                <c:pt idx="79">
                  <c:v>0.85263100000000003</c:v>
                </c:pt>
                <c:pt idx="80">
                  <c:v>0.79551700000000003</c:v>
                </c:pt>
                <c:pt idx="81">
                  <c:v>0.74557499999999999</c:v>
                </c:pt>
                <c:pt idx="82">
                  <c:v>0.70298799999999995</c:v>
                </c:pt>
                <c:pt idx="83">
                  <c:v>0.66810599999999998</c:v>
                </c:pt>
                <c:pt idx="84">
                  <c:v>0.634857</c:v>
                </c:pt>
                <c:pt idx="85">
                  <c:v>0.60795600000000005</c:v>
                </c:pt>
                <c:pt idx="86">
                  <c:v>0.58372500000000005</c:v>
                </c:pt>
                <c:pt idx="87">
                  <c:v>0.56262199999999996</c:v>
                </c:pt>
                <c:pt idx="88">
                  <c:v>0.54585300000000003</c:v>
                </c:pt>
                <c:pt idx="89">
                  <c:v>0.53161599999999998</c:v>
                </c:pt>
                <c:pt idx="90">
                  <c:v>0.52027900000000005</c:v>
                </c:pt>
                <c:pt idx="91">
                  <c:v>0.51171900000000003</c:v>
                </c:pt>
                <c:pt idx="92">
                  <c:v>0.50480700000000001</c:v>
                </c:pt>
                <c:pt idx="93">
                  <c:v>0.50048800000000004</c:v>
                </c:pt>
                <c:pt idx="94">
                  <c:v>0.497253</c:v>
                </c:pt>
                <c:pt idx="95">
                  <c:v>0.49494899999999997</c:v>
                </c:pt>
                <c:pt idx="96">
                  <c:v>0.49324000000000001</c:v>
                </c:pt>
                <c:pt idx="97">
                  <c:v>0.49197400000000002</c:v>
                </c:pt>
                <c:pt idx="98">
                  <c:v>0.489761</c:v>
                </c:pt>
                <c:pt idx="99">
                  <c:v>0.48767100000000002</c:v>
                </c:pt>
                <c:pt idx="100">
                  <c:v>0.48483300000000001</c:v>
                </c:pt>
                <c:pt idx="101">
                  <c:v>0.48171999999999998</c:v>
                </c:pt>
                <c:pt idx="102">
                  <c:v>0.47792099999999998</c:v>
                </c:pt>
                <c:pt idx="103">
                  <c:v>0.47410600000000003</c:v>
                </c:pt>
                <c:pt idx="104">
                  <c:v>0.469833</c:v>
                </c:pt>
                <c:pt idx="105">
                  <c:v>0.44866899999999998</c:v>
                </c:pt>
                <c:pt idx="106">
                  <c:v>0.42599500000000001</c:v>
                </c:pt>
                <c:pt idx="107">
                  <c:v>0.42207299999999998</c:v>
                </c:pt>
                <c:pt idx="108">
                  <c:v>0.41636699999999999</c:v>
                </c:pt>
                <c:pt idx="109">
                  <c:v>0.40770000000000001</c:v>
                </c:pt>
                <c:pt idx="110">
                  <c:v>0.401337</c:v>
                </c:pt>
                <c:pt idx="111">
                  <c:v>0.391403</c:v>
                </c:pt>
                <c:pt idx="112">
                  <c:v>0.38122600000000001</c:v>
                </c:pt>
                <c:pt idx="113">
                  <c:v>0.37127700000000002</c:v>
                </c:pt>
                <c:pt idx="114">
                  <c:v>0.36170999999999998</c:v>
                </c:pt>
                <c:pt idx="115">
                  <c:v>0.35049400000000003</c:v>
                </c:pt>
                <c:pt idx="116">
                  <c:v>0.35197400000000001</c:v>
                </c:pt>
                <c:pt idx="117">
                  <c:v>0.339279</c:v>
                </c:pt>
                <c:pt idx="118">
                  <c:v>0.32580599999999998</c:v>
                </c:pt>
                <c:pt idx="119">
                  <c:v>0.31109599999999998</c:v>
                </c:pt>
                <c:pt idx="120">
                  <c:v>0.29679899999999998</c:v>
                </c:pt>
                <c:pt idx="121">
                  <c:v>0.28210400000000002</c:v>
                </c:pt>
                <c:pt idx="122">
                  <c:v>0.268372</c:v>
                </c:pt>
                <c:pt idx="123">
                  <c:v>0.25286900000000001</c:v>
                </c:pt>
                <c:pt idx="124">
                  <c:v>0.238342</c:v>
                </c:pt>
                <c:pt idx="125">
                  <c:v>0.22525000000000001</c:v>
                </c:pt>
                <c:pt idx="126">
                  <c:v>0.210815</c:v>
                </c:pt>
                <c:pt idx="127">
                  <c:v>0.19683800000000001</c:v>
                </c:pt>
                <c:pt idx="128">
                  <c:v>0.18406700000000001</c:v>
                </c:pt>
                <c:pt idx="129">
                  <c:v>0.1716</c:v>
                </c:pt>
                <c:pt idx="130">
                  <c:v>0.15953100000000001</c:v>
                </c:pt>
                <c:pt idx="131">
                  <c:v>0.14846799999999999</c:v>
                </c:pt>
                <c:pt idx="132">
                  <c:v>0.138428</c:v>
                </c:pt>
                <c:pt idx="133">
                  <c:v>0.12936400000000001</c:v>
                </c:pt>
                <c:pt idx="134">
                  <c:v>0.121277</c:v>
                </c:pt>
                <c:pt idx="135">
                  <c:v>0.11405899999999999</c:v>
                </c:pt>
                <c:pt idx="136">
                  <c:v>0.107681</c:v>
                </c:pt>
                <c:pt idx="137">
                  <c:v>0.101685</c:v>
                </c:pt>
                <c:pt idx="138">
                  <c:v>9.6785999999999997E-2</c:v>
                </c:pt>
                <c:pt idx="139">
                  <c:v>9.1980000000000006E-2</c:v>
                </c:pt>
                <c:pt idx="140">
                  <c:v>8.7646000000000002E-2</c:v>
                </c:pt>
                <c:pt idx="141">
                  <c:v>8.2961999999999994E-2</c:v>
                </c:pt>
                <c:pt idx="142">
                  <c:v>7.9497999999999999E-2</c:v>
                </c:pt>
                <c:pt idx="143">
                  <c:v>7.7393000000000003E-2</c:v>
                </c:pt>
                <c:pt idx="144">
                  <c:v>7.4737999999999999E-2</c:v>
                </c:pt>
                <c:pt idx="145">
                  <c:v>7.2249999999999995E-2</c:v>
                </c:pt>
                <c:pt idx="146">
                  <c:v>6.9916000000000006E-2</c:v>
                </c:pt>
                <c:pt idx="147">
                  <c:v>6.8344000000000002E-2</c:v>
                </c:pt>
                <c:pt idx="148">
                  <c:v>6.6177E-2</c:v>
                </c:pt>
                <c:pt idx="149">
                  <c:v>6.4452999999999996E-2</c:v>
                </c:pt>
                <c:pt idx="150">
                  <c:v>6.2195E-2</c:v>
                </c:pt>
                <c:pt idx="151">
                  <c:v>6.1873999999999998E-2</c:v>
                </c:pt>
                <c:pt idx="152">
                  <c:v>6.1019999999999998E-2</c:v>
                </c:pt>
                <c:pt idx="153">
                  <c:v>5.9646999999999999E-2</c:v>
                </c:pt>
                <c:pt idx="154">
                  <c:v>5.8196999999999999E-2</c:v>
                </c:pt>
                <c:pt idx="155">
                  <c:v>5.7297000000000001E-2</c:v>
                </c:pt>
                <c:pt idx="156">
                  <c:v>5.6945999999999997E-2</c:v>
                </c:pt>
                <c:pt idx="157">
                  <c:v>5.6229000000000001E-2</c:v>
                </c:pt>
                <c:pt idx="158">
                  <c:v>5.5710000000000003E-2</c:v>
                </c:pt>
                <c:pt idx="159">
                  <c:v>5.4932000000000002E-2</c:v>
                </c:pt>
                <c:pt idx="160">
                  <c:v>5.4001E-2</c:v>
                </c:pt>
                <c:pt idx="161">
                  <c:v>5.3925000000000001E-2</c:v>
                </c:pt>
                <c:pt idx="162">
                  <c:v>5.3085E-2</c:v>
                </c:pt>
                <c:pt idx="163">
                  <c:v>5.2780000000000001E-2</c:v>
                </c:pt>
                <c:pt idx="164">
                  <c:v>5.1956000000000002E-2</c:v>
                </c:pt>
                <c:pt idx="165">
                  <c:v>5.1452999999999999E-2</c:v>
                </c:pt>
                <c:pt idx="166">
                  <c:v>5.0858E-2</c:v>
                </c:pt>
                <c:pt idx="167">
                  <c:v>5.0384999999999999E-2</c:v>
                </c:pt>
                <c:pt idx="168">
                  <c:v>4.9942E-2</c:v>
                </c:pt>
                <c:pt idx="169">
                  <c:v>4.9591000000000003E-2</c:v>
                </c:pt>
                <c:pt idx="170">
                  <c:v>4.9118000000000002E-2</c:v>
                </c:pt>
                <c:pt idx="171">
                  <c:v>4.8476999999999999E-2</c:v>
                </c:pt>
                <c:pt idx="172">
                  <c:v>4.8035000000000001E-2</c:v>
                </c:pt>
                <c:pt idx="173">
                  <c:v>4.7988999999999997E-2</c:v>
                </c:pt>
                <c:pt idx="174">
                  <c:v>4.7530999999999997E-2</c:v>
                </c:pt>
                <c:pt idx="175">
                  <c:v>4.6753000000000003E-2</c:v>
                </c:pt>
                <c:pt idx="176">
                  <c:v>4.6554999999999999E-2</c:v>
                </c:pt>
                <c:pt idx="177">
                  <c:v>4.6341E-2</c:v>
                </c:pt>
                <c:pt idx="178">
                  <c:v>4.5914000000000003E-2</c:v>
                </c:pt>
                <c:pt idx="179">
                  <c:v>4.5485999999999999E-2</c:v>
                </c:pt>
                <c:pt idx="180">
                  <c:v>4.5761000000000003E-2</c:v>
                </c:pt>
                <c:pt idx="181">
                  <c:v>4.5089999999999998E-2</c:v>
                </c:pt>
                <c:pt idx="182">
                  <c:v>4.4631999999999998E-2</c:v>
                </c:pt>
                <c:pt idx="183">
                  <c:v>4.4646999999999999E-2</c:v>
                </c:pt>
                <c:pt idx="184">
                  <c:v>4.4495E-2</c:v>
                </c:pt>
                <c:pt idx="185">
                  <c:v>4.4021999999999999E-2</c:v>
                </c:pt>
                <c:pt idx="186">
                  <c:v>4.3823000000000001E-2</c:v>
                </c:pt>
                <c:pt idx="187">
                  <c:v>4.3700999999999997E-2</c:v>
                </c:pt>
                <c:pt idx="188">
                  <c:v>4.3563999999999999E-2</c:v>
                </c:pt>
                <c:pt idx="189">
                  <c:v>4.3503E-2</c:v>
                </c:pt>
                <c:pt idx="190">
                  <c:v>4.3442000000000001E-2</c:v>
                </c:pt>
                <c:pt idx="191">
                  <c:v>4.3258999999999999E-2</c:v>
                </c:pt>
                <c:pt idx="192">
                  <c:v>4.3090999999999997E-2</c:v>
                </c:pt>
                <c:pt idx="193">
                  <c:v>4.2770000000000002E-2</c:v>
                </c:pt>
                <c:pt idx="194">
                  <c:v>4.2816E-2</c:v>
                </c:pt>
                <c:pt idx="195">
                  <c:v>4.2587E-2</c:v>
                </c:pt>
                <c:pt idx="196">
                  <c:v>4.2418999999999998E-2</c:v>
                </c:pt>
                <c:pt idx="197">
                  <c:v>4.2374000000000002E-2</c:v>
                </c:pt>
                <c:pt idx="198">
                  <c:v>4.2251999999999998E-2</c:v>
                </c:pt>
                <c:pt idx="199">
                  <c:v>4.1884999999999999E-2</c:v>
                </c:pt>
                <c:pt idx="200">
                  <c:v>4.1808999999999999E-2</c:v>
                </c:pt>
                <c:pt idx="201">
                  <c:v>4.1778999999999997E-2</c:v>
                </c:pt>
                <c:pt idx="202">
                  <c:v>4.1901000000000001E-2</c:v>
                </c:pt>
                <c:pt idx="203">
                  <c:v>4.1549999999999997E-2</c:v>
                </c:pt>
                <c:pt idx="204">
                  <c:v>4.1579999999999999E-2</c:v>
                </c:pt>
                <c:pt idx="205">
                  <c:v>4.1367000000000001E-2</c:v>
                </c:pt>
                <c:pt idx="206">
                  <c:v>4.1397000000000003E-2</c:v>
                </c:pt>
                <c:pt idx="207">
                  <c:v>4.1244999999999997E-2</c:v>
                </c:pt>
                <c:pt idx="208">
                  <c:v>4.1411999999999997E-2</c:v>
                </c:pt>
                <c:pt idx="209">
                  <c:v>4.1214000000000001E-2</c:v>
                </c:pt>
                <c:pt idx="210">
                  <c:v>4.1153000000000002E-2</c:v>
                </c:pt>
                <c:pt idx="211">
                  <c:v>4.1077000000000002E-2</c:v>
                </c:pt>
                <c:pt idx="212">
                  <c:v>4.0909000000000001E-2</c:v>
                </c:pt>
                <c:pt idx="213">
                  <c:v>4.0816999999999999E-2</c:v>
                </c:pt>
                <c:pt idx="214">
                  <c:v>4.0801999999999998E-2</c:v>
                </c:pt>
                <c:pt idx="215">
                  <c:v>4.0771000000000002E-2</c:v>
                </c:pt>
                <c:pt idx="216">
                  <c:v>4.0710000000000003E-2</c:v>
                </c:pt>
                <c:pt idx="217">
                  <c:v>4.0665E-2</c:v>
                </c:pt>
                <c:pt idx="218">
                  <c:v>4.0604000000000001E-2</c:v>
                </c:pt>
                <c:pt idx="219">
                  <c:v>4.0511999999999999E-2</c:v>
                </c:pt>
                <c:pt idx="220">
                  <c:v>4.0496999999999998E-2</c:v>
                </c:pt>
                <c:pt idx="221">
                  <c:v>4.0358999999999999E-2</c:v>
                </c:pt>
                <c:pt idx="222">
                  <c:v>4.0343999999999998E-2</c:v>
                </c:pt>
                <c:pt idx="223">
                  <c:v>4.0298E-2</c:v>
                </c:pt>
                <c:pt idx="224">
                  <c:v>4.0298E-2</c:v>
                </c:pt>
                <c:pt idx="225">
                  <c:v>4.0176000000000003E-2</c:v>
                </c:pt>
                <c:pt idx="226">
                  <c:v>4.0146000000000001E-2</c:v>
                </c:pt>
                <c:pt idx="227">
                  <c:v>4.0207E-2</c:v>
                </c:pt>
                <c:pt idx="228">
                  <c:v>4.0114999999999998E-2</c:v>
                </c:pt>
                <c:pt idx="229">
                  <c:v>4.0009000000000003E-2</c:v>
                </c:pt>
                <c:pt idx="230">
                  <c:v>3.9932000000000002E-2</c:v>
                </c:pt>
                <c:pt idx="231">
                  <c:v>3.9932000000000002E-2</c:v>
                </c:pt>
                <c:pt idx="232">
                  <c:v>3.9917000000000001E-2</c:v>
                </c:pt>
                <c:pt idx="233">
                  <c:v>3.9870999999999997E-2</c:v>
                </c:pt>
                <c:pt idx="234">
                  <c:v>3.9917000000000001E-2</c:v>
                </c:pt>
                <c:pt idx="235">
                  <c:v>3.9856000000000003E-2</c:v>
                </c:pt>
                <c:pt idx="236">
                  <c:v>3.9749E-2</c:v>
                </c:pt>
                <c:pt idx="237">
                  <c:v>3.9703000000000002E-2</c:v>
                </c:pt>
                <c:pt idx="238">
                  <c:v>3.9718999999999997E-2</c:v>
                </c:pt>
                <c:pt idx="239">
                  <c:v>3.9565999999999997E-2</c:v>
                </c:pt>
                <c:pt idx="240">
                  <c:v>3.9580999999999998E-2</c:v>
                </c:pt>
                <c:pt idx="241">
                  <c:v>3.9641999999999997E-2</c:v>
                </c:pt>
                <c:pt idx="242">
                  <c:v>3.9504999999999998E-2</c:v>
                </c:pt>
                <c:pt idx="243">
                  <c:v>3.9474000000000002E-2</c:v>
                </c:pt>
                <c:pt idx="244">
                  <c:v>3.9504999999999998E-2</c:v>
                </c:pt>
                <c:pt idx="245">
                  <c:v>3.9428999999999999E-2</c:v>
                </c:pt>
                <c:pt idx="246">
                  <c:v>3.952E-2</c:v>
                </c:pt>
                <c:pt idx="247">
                  <c:v>3.9489999999999997E-2</c:v>
                </c:pt>
                <c:pt idx="248">
                  <c:v>3.9351999999999998E-2</c:v>
                </c:pt>
                <c:pt idx="249">
                  <c:v>3.9260999999999997E-2</c:v>
                </c:pt>
                <c:pt idx="250">
                  <c:v>3.9246000000000003E-2</c:v>
                </c:pt>
                <c:pt idx="251">
                  <c:v>3.9246000000000003E-2</c:v>
                </c:pt>
                <c:pt idx="252">
                  <c:v>3.9184999999999998E-2</c:v>
                </c:pt>
                <c:pt idx="253">
                  <c:v>3.9246000000000003E-2</c:v>
                </c:pt>
                <c:pt idx="254">
                  <c:v>3.9154000000000001E-2</c:v>
                </c:pt>
                <c:pt idx="255">
                  <c:v>3.9169000000000002E-2</c:v>
                </c:pt>
                <c:pt idx="256">
                  <c:v>3.9139E-2</c:v>
                </c:pt>
                <c:pt idx="257">
                  <c:v>3.9107999999999997E-2</c:v>
                </c:pt>
                <c:pt idx="258">
                  <c:v>3.9078000000000002E-2</c:v>
                </c:pt>
                <c:pt idx="259">
                  <c:v>3.9031999999999997E-2</c:v>
                </c:pt>
                <c:pt idx="260">
                  <c:v>3.9031999999999997E-2</c:v>
                </c:pt>
                <c:pt idx="261">
                  <c:v>3.9046999999999998E-2</c:v>
                </c:pt>
                <c:pt idx="262">
                  <c:v>3.9093000000000003E-2</c:v>
                </c:pt>
                <c:pt idx="263">
                  <c:v>3.9001000000000001E-2</c:v>
                </c:pt>
                <c:pt idx="264">
                  <c:v>3.8894999999999999E-2</c:v>
                </c:pt>
                <c:pt idx="265">
                  <c:v>3.8925000000000001E-2</c:v>
                </c:pt>
                <c:pt idx="266">
                  <c:v>3.8940000000000002E-2</c:v>
                </c:pt>
                <c:pt idx="267">
                  <c:v>3.8940000000000002E-2</c:v>
                </c:pt>
                <c:pt idx="268">
                  <c:v>3.8925000000000001E-2</c:v>
                </c:pt>
                <c:pt idx="269">
                  <c:v>3.8802999999999997E-2</c:v>
                </c:pt>
                <c:pt idx="270">
                  <c:v>3.8788000000000003E-2</c:v>
                </c:pt>
                <c:pt idx="271">
                  <c:v>3.8817999999999998E-2</c:v>
                </c:pt>
                <c:pt idx="272">
                  <c:v>3.8788000000000003E-2</c:v>
                </c:pt>
                <c:pt idx="273">
                  <c:v>3.8712000000000003E-2</c:v>
                </c:pt>
                <c:pt idx="274">
                  <c:v>3.8726999999999998E-2</c:v>
                </c:pt>
                <c:pt idx="275">
                  <c:v>3.8605E-2</c:v>
                </c:pt>
                <c:pt idx="276">
                  <c:v>3.8573999999999997E-2</c:v>
                </c:pt>
                <c:pt idx="277">
                  <c:v>3.8665999999999999E-2</c:v>
                </c:pt>
                <c:pt idx="278">
                  <c:v>3.8573999999999997E-2</c:v>
                </c:pt>
                <c:pt idx="279">
                  <c:v>3.8605E-2</c:v>
                </c:pt>
                <c:pt idx="280">
                  <c:v>3.8588999999999998E-2</c:v>
                </c:pt>
                <c:pt idx="281">
                  <c:v>3.8544000000000002E-2</c:v>
                </c:pt>
                <c:pt idx="282">
                  <c:v>3.8573999999999997E-2</c:v>
                </c:pt>
                <c:pt idx="283">
                  <c:v>3.8528E-2</c:v>
                </c:pt>
                <c:pt idx="284">
                  <c:v>3.8452E-2</c:v>
                </c:pt>
                <c:pt idx="285">
                  <c:v>3.8421999999999998E-2</c:v>
                </c:pt>
                <c:pt idx="286">
                  <c:v>3.8391000000000002E-2</c:v>
                </c:pt>
                <c:pt idx="287">
                  <c:v>3.8421999999999998E-2</c:v>
                </c:pt>
                <c:pt idx="288">
                  <c:v>3.8376E-2</c:v>
                </c:pt>
                <c:pt idx="289">
                  <c:v>3.8436999999999999E-2</c:v>
                </c:pt>
                <c:pt idx="290">
                  <c:v>3.8391000000000002E-2</c:v>
                </c:pt>
                <c:pt idx="291">
                  <c:v>3.8360999999999999E-2</c:v>
                </c:pt>
                <c:pt idx="292">
                  <c:v>3.8406000000000003E-2</c:v>
                </c:pt>
                <c:pt idx="293">
                  <c:v>3.8497999999999998E-2</c:v>
                </c:pt>
                <c:pt idx="294">
                  <c:v>3.8467000000000001E-2</c:v>
                </c:pt>
                <c:pt idx="295">
                  <c:v>3.8467000000000001E-2</c:v>
                </c:pt>
                <c:pt idx="296">
                  <c:v>3.8452E-2</c:v>
                </c:pt>
                <c:pt idx="297">
                  <c:v>3.8467000000000001E-2</c:v>
                </c:pt>
                <c:pt idx="298">
                  <c:v>3.8421999999999998E-2</c:v>
                </c:pt>
                <c:pt idx="299">
                  <c:v>3.8421999999999998E-2</c:v>
                </c:pt>
                <c:pt idx="300">
                  <c:v>3.8406000000000003E-2</c:v>
                </c:pt>
                <c:pt idx="301">
                  <c:v>3.8406000000000003E-2</c:v>
                </c:pt>
                <c:pt idx="302">
                  <c:v>3.8315000000000002E-2</c:v>
                </c:pt>
                <c:pt idx="303">
                  <c:v>3.8344999999999997E-2</c:v>
                </c:pt>
                <c:pt idx="304">
                  <c:v>3.8315000000000002E-2</c:v>
                </c:pt>
                <c:pt idx="305">
                  <c:v>3.8239000000000002E-2</c:v>
                </c:pt>
                <c:pt idx="306">
                  <c:v>3.8177000000000003E-2</c:v>
                </c:pt>
                <c:pt idx="307">
                  <c:v>3.8192999999999998E-2</c:v>
                </c:pt>
                <c:pt idx="308">
                  <c:v>3.8268999999999997E-2</c:v>
                </c:pt>
                <c:pt idx="309">
                  <c:v>3.8192999999999998E-2</c:v>
                </c:pt>
                <c:pt idx="310">
                  <c:v>3.8147E-2</c:v>
                </c:pt>
                <c:pt idx="311">
                  <c:v>3.8086000000000002E-2</c:v>
                </c:pt>
                <c:pt idx="312">
                  <c:v>3.8054999999999999E-2</c:v>
                </c:pt>
                <c:pt idx="313">
                  <c:v>3.7918E-2</c:v>
                </c:pt>
                <c:pt idx="314">
                  <c:v>3.7948999999999997E-2</c:v>
                </c:pt>
                <c:pt idx="315">
                  <c:v>3.7948999999999997E-2</c:v>
                </c:pt>
                <c:pt idx="316">
                  <c:v>3.7872000000000003E-2</c:v>
                </c:pt>
                <c:pt idx="317">
                  <c:v>3.7842000000000001E-2</c:v>
                </c:pt>
                <c:pt idx="318">
                  <c:v>3.7933000000000001E-2</c:v>
                </c:pt>
                <c:pt idx="319">
                  <c:v>3.7872000000000003E-2</c:v>
                </c:pt>
                <c:pt idx="320">
                  <c:v>3.7887999999999998E-2</c:v>
                </c:pt>
                <c:pt idx="321">
                  <c:v>3.7963999999999998E-2</c:v>
                </c:pt>
                <c:pt idx="322">
                  <c:v>3.7978999999999999E-2</c:v>
                </c:pt>
                <c:pt idx="323">
                  <c:v>3.8039999999999997E-2</c:v>
                </c:pt>
                <c:pt idx="324">
                  <c:v>3.8025000000000003E-2</c:v>
                </c:pt>
                <c:pt idx="325">
                  <c:v>3.8115999999999997E-2</c:v>
                </c:pt>
                <c:pt idx="326">
                  <c:v>3.8115999999999997E-2</c:v>
                </c:pt>
                <c:pt idx="327">
                  <c:v>3.8177000000000003E-2</c:v>
                </c:pt>
                <c:pt idx="328">
                  <c:v>3.8223E-2</c:v>
                </c:pt>
                <c:pt idx="329">
                  <c:v>3.8192999999999998E-2</c:v>
                </c:pt>
                <c:pt idx="330">
                  <c:v>3.8192999999999998E-2</c:v>
                </c:pt>
                <c:pt idx="331">
                  <c:v>3.8239000000000002E-2</c:v>
                </c:pt>
                <c:pt idx="332">
                  <c:v>3.8223E-2</c:v>
                </c:pt>
                <c:pt idx="333">
                  <c:v>3.8223E-2</c:v>
                </c:pt>
                <c:pt idx="334">
                  <c:v>3.8162000000000001E-2</c:v>
                </c:pt>
                <c:pt idx="335">
                  <c:v>3.8147E-2</c:v>
                </c:pt>
                <c:pt idx="336">
                  <c:v>3.8039999999999997E-2</c:v>
                </c:pt>
                <c:pt idx="337">
                  <c:v>3.7978999999999999E-2</c:v>
                </c:pt>
                <c:pt idx="338">
                  <c:v>3.7963999999999998E-2</c:v>
                </c:pt>
                <c:pt idx="339">
                  <c:v>3.7887999999999998E-2</c:v>
                </c:pt>
                <c:pt idx="340">
                  <c:v>3.7810999999999997E-2</c:v>
                </c:pt>
                <c:pt idx="341">
                  <c:v>3.7810999999999997E-2</c:v>
                </c:pt>
                <c:pt idx="342">
                  <c:v>3.7567000000000003E-2</c:v>
                </c:pt>
                <c:pt idx="343">
                  <c:v>3.7490999999999997E-2</c:v>
                </c:pt>
                <c:pt idx="344">
                  <c:v>3.7414999999999997E-2</c:v>
                </c:pt>
                <c:pt idx="345">
                  <c:v>3.7308000000000001E-2</c:v>
                </c:pt>
                <c:pt idx="346">
                  <c:v>3.7170000000000002E-2</c:v>
                </c:pt>
                <c:pt idx="347">
                  <c:v>3.6986999999999999E-2</c:v>
                </c:pt>
                <c:pt idx="348">
                  <c:v>3.6926E-2</c:v>
                </c:pt>
                <c:pt idx="349">
                  <c:v>3.6910999999999999E-2</c:v>
                </c:pt>
                <c:pt idx="350">
                  <c:v>3.6865000000000002E-2</c:v>
                </c:pt>
                <c:pt idx="351">
                  <c:v>3.6835E-2</c:v>
                </c:pt>
                <c:pt idx="352">
                  <c:v>3.6697E-2</c:v>
                </c:pt>
                <c:pt idx="353">
                  <c:v>3.6651999999999997E-2</c:v>
                </c:pt>
                <c:pt idx="354">
                  <c:v>3.6606E-2</c:v>
                </c:pt>
                <c:pt idx="355">
                  <c:v>3.6681999999999999E-2</c:v>
                </c:pt>
                <c:pt idx="356">
                  <c:v>3.6651999999999997E-2</c:v>
                </c:pt>
                <c:pt idx="357">
                  <c:v>3.6713000000000003E-2</c:v>
                </c:pt>
                <c:pt idx="358">
                  <c:v>3.6575000000000003E-2</c:v>
                </c:pt>
                <c:pt idx="359">
                  <c:v>3.6498999999999997E-2</c:v>
                </c:pt>
                <c:pt idx="360">
                  <c:v>3.6452999999999999E-2</c:v>
                </c:pt>
                <c:pt idx="361">
                  <c:v>3.6484000000000003E-2</c:v>
                </c:pt>
                <c:pt idx="362">
                  <c:v>3.6469000000000001E-2</c:v>
                </c:pt>
                <c:pt idx="363">
                  <c:v>3.6407000000000002E-2</c:v>
                </c:pt>
                <c:pt idx="364">
                  <c:v>3.6377E-2</c:v>
                </c:pt>
                <c:pt idx="365">
                  <c:v>3.6361999999999998E-2</c:v>
                </c:pt>
                <c:pt idx="366">
                  <c:v>3.6269999999999997E-2</c:v>
                </c:pt>
                <c:pt idx="367">
                  <c:v>3.6255000000000003E-2</c:v>
                </c:pt>
                <c:pt idx="368">
                  <c:v>3.6208999999999998E-2</c:v>
                </c:pt>
                <c:pt idx="369">
                  <c:v>3.6223999999999999E-2</c:v>
                </c:pt>
                <c:pt idx="370">
                  <c:v>3.6193999999999997E-2</c:v>
                </c:pt>
                <c:pt idx="371">
                  <c:v>3.6179000000000003E-2</c:v>
                </c:pt>
                <c:pt idx="372">
                  <c:v>3.6179000000000003E-2</c:v>
                </c:pt>
                <c:pt idx="373">
                  <c:v>3.6117999999999997E-2</c:v>
                </c:pt>
                <c:pt idx="374">
                  <c:v>3.6148E-2</c:v>
                </c:pt>
                <c:pt idx="375">
                  <c:v>3.6132999999999998E-2</c:v>
                </c:pt>
                <c:pt idx="376">
                  <c:v>3.6179000000000003E-2</c:v>
                </c:pt>
                <c:pt idx="377">
                  <c:v>3.6072E-2</c:v>
                </c:pt>
                <c:pt idx="378">
                  <c:v>3.6117999999999997E-2</c:v>
                </c:pt>
                <c:pt idx="379">
                  <c:v>3.6132999999999998E-2</c:v>
                </c:pt>
                <c:pt idx="380">
                  <c:v>3.6072E-2</c:v>
                </c:pt>
                <c:pt idx="381">
                  <c:v>3.6072E-2</c:v>
                </c:pt>
                <c:pt idx="382">
                  <c:v>3.6056999999999999E-2</c:v>
                </c:pt>
                <c:pt idx="383">
                  <c:v>3.6117999999999997E-2</c:v>
                </c:pt>
                <c:pt idx="384">
                  <c:v>3.6148E-2</c:v>
                </c:pt>
                <c:pt idx="385">
                  <c:v>3.6193999999999997E-2</c:v>
                </c:pt>
                <c:pt idx="386">
                  <c:v>3.6208999999999998E-2</c:v>
                </c:pt>
                <c:pt idx="387">
                  <c:v>3.6148E-2</c:v>
                </c:pt>
                <c:pt idx="388">
                  <c:v>3.6117999999999997E-2</c:v>
                </c:pt>
                <c:pt idx="389">
                  <c:v>3.6208999999999998E-2</c:v>
                </c:pt>
                <c:pt idx="390">
                  <c:v>3.6301E-2</c:v>
                </c:pt>
                <c:pt idx="391">
                  <c:v>3.6223999999999999E-2</c:v>
                </c:pt>
                <c:pt idx="392">
                  <c:v>3.6240000000000001E-2</c:v>
                </c:pt>
                <c:pt idx="393">
                  <c:v>3.6269999999999997E-2</c:v>
                </c:pt>
                <c:pt idx="394">
                  <c:v>3.6331000000000002E-2</c:v>
                </c:pt>
                <c:pt idx="395">
                  <c:v>3.6346000000000003E-2</c:v>
                </c:pt>
                <c:pt idx="396">
                  <c:v>3.6316000000000001E-2</c:v>
                </c:pt>
                <c:pt idx="397">
                  <c:v>3.6346000000000003E-2</c:v>
                </c:pt>
                <c:pt idx="398">
                  <c:v>3.6407000000000002E-2</c:v>
                </c:pt>
                <c:pt idx="399">
                  <c:v>3.6407000000000002E-2</c:v>
                </c:pt>
                <c:pt idx="400">
                  <c:v>3.6452999999999999E-2</c:v>
                </c:pt>
                <c:pt idx="401">
                  <c:v>3.6452999999999999E-2</c:v>
                </c:pt>
                <c:pt idx="402">
                  <c:v>3.6545000000000001E-2</c:v>
                </c:pt>
                <c:pt idx="403">
                  <c:v>3.6560000000000002E-2</c:v>
                </c:pt>
                <c:pt idx="404">
                  <c:v>3.6560000000000002E-2</c:v>
                </c:pt>
                <c:pt idx="405">
                  <c:v>3.6606E-2</c:v>
                </c:pt>
                <c:pt idx="406">
                  <c:v>3.6621000000000001E-2</c:v>
                </c:pt>
                <c:pt idx="407">
                  <c:v>3.6621000000000001E-2</c:v>
                </c:pt>
                <c:pt idx="408">
                  <c:v>3.6697E-2</c:v>
                </c:pt>
                <c:pt idx="409">
                  <c:v>3.6713000000000003E-2</c:v>
                </c:pt>
                <c:pt idx="410">
                  <c:v>3.6742999999999998E-2</c:v>
                </c:pt>
                <c:pt idx="411">
                  <c:v>3.6713000000000003E-2</c:v>
                </c:pt>
                <c:pt idx="412">
                  <c:v>3.6757999999999999E-2</c:v>
                </c:pt>
                <c:pt idx="413">
                  <c:v>3.6804000000000003E-2</c:v>
                </c:pt>
                <c:pt idx="414">
                  <c:v>3.6910999999999999E-2</c:v>
                </c:pt>
                <c:pt idx="415">
                  <c:v>3.6850000000000001E-2</c:v>
                </c:pt>
                <c:pt idx="416">
                  <c:v>3.6818999999999998E-2</c:v>
                </c:pt>
                <c:pt idx="417">
                  <c:v>3.6850000000000001E-2</c:v>
                </c:pt>
                <c:pt idx="418">
                  <c:v>3.6850000000000001E-2</c:v>
                </c:pt>
                <c:pt idx="419">
                  <c:v>3.6804000000000003E-2</c:v>
                </c:pt>
                <c:pt idx="420">
                  <c:v>3.6895999999999998E-2</c:v>
                </c:pt>
                <c:pt idx="421">
                  <c:v>3.6804000000000003E-2</c:v>
                </c:pt>
                <c:pt idx="422">
                  <c:v>3.6835E-2</c:v>
                </c:pt>
                <c:pt idx="423">
                  <c:v>3.6835E-2</c:v>
                </c:pt>
                <c:pt idx="424">
                  <c:v>3.6804000000000003E-2</c:v>
                </c:pt>
                <c:pt idx="425">
                  <c:v>3.6818999999999998E-2</c:v>
                </c:pt>
                <c:pt idx="426">
                  <c:v>3.6789000000000002E-2</c:v>
                </c:pt>
                <c:pt idx="427">
                  <c:v>3.6804000000000003E-2</c:v>
                </c:pt>
                <c:pt idx="428">
                  <c:v>3.6865000000000002E-2</c:v>
                </c:pt>
                <c:pt idx="429">
                  <c:v>3.6880000000000003E-2</c:v>
                </c:pt>
                <c:pt idx="430">
                  <c:v>3.6865000000000002E-2</c:v>
                </c:pt>
                <c:pt idx="431">
                  <c:v>3.6956999999999997E-2</c:v>
                </c:pt>
                <c:pt idx="432">
                  <c:v>3.6956999999999997E-2</c:v>
                </c:pt>
                <c:pt idx="433">
                  <c:v>3.7047999999999998E-2</c:v>
                </c:pt>
                <c:pt idx="434">
                  <c:v>3.7047999999999998E-2</c:v>
                </c:pt>
                <c:pt idx="435">
                  <c:v>3.7047999999999998E-2</c:v>
                </c:pt>
                <c:pt idx="436">
                  <c:v>3.7139999999999999E-2</c:v>
                </c:pt>
                <c:pt idx="437">
                  <c:v>3.7047999999999998E-2</c:v>
                </c:pt>
                <c:pt idx="438">
                  <c:v>3.7018000000000002E-2</c:v>
                </c:pt>
                <c:pt idx="439">
                  <c:v>3.6971999999999998E-2</c:v>
                </c:pt>
                <c:pt idx="440">
                  <c:v>3.6880000000000003E-2</c:v>
                </c:pt>
                <c:pt idx="441">
                  <c:v>3.6757999999999999E-2</c:v>
                </c:pt>
                <c:pt idx="442">
                  <c:v>3.6666999999999998E-2</c:v>
                </c:pt>
                <c:pt idx="443">
                  <c:v>3.6713000000000003E-2</c:v>
                </c:pt>
                <c:pt idx="444">
                  <c:v>3.6713000000000003E-2</c:v>
                </c:pt>
                <c:pt idx="445">
                  <c:v>3.6621000000000001E-2</c:v>
                </c:pt>
                <c:pt idx="446">
                  <c:v>3.6484000000000003E-2</c:v>
                </c:pt>
                <c:pt idx="447">
                  <c:v>3.6392000000000001E-2</c:v>
                </c:pt>
                <c:pt idx="448">
                  <c:v>3.6269999999999997E-2</c:v>
                </c:pt>
                <c:pt idx="449">
                  <c:v>3.6255000000000003E-2</c:v>
                </c:pt>
                <c:pt idx="450">
                  <c:v>3.6132999999999998E-2</c:v>
                </c:pt>
                <c:pt idx="451">
                  <c:v>3.6087000000000001E-2</c:v>
                </c:pt>
                <c:pt idx="452">
                  <c:v>3.6072E-2</c:v>
                </c:pt>
                <c:pt idx="453">
                  <c:v>3.6011000000000001E-2</c:v>
                </c:pt>
                <c:pt idx="454">
                  <c:v>3.5964999999999997E-2</c:v>
                </c:pt>
                <c:pt idx="455">
                  <c:v>3.6026000000000002E-2</c:v>
                </c:pt>
                <c:pt idx="456">
                  <c:v>3.6026000000000002E-2</c:v>
                </c:pt>
                <c:pt idx="457">
                  <c:v>3.5950000000000003E-2</c:v>
                </c:pt>
                <c:pt idx="458">
                  <c:v>3.5950000000000003E-2</c:v>
                </c:pt>
                <c:pt idx="459">
                  <c:v>3.5964999999999997E-2</c:v>
                </c:pt>
                <c:pt idx="460">
                  <c:v>3.5934000000000001E-2</c:v>
                </c:pt>
                <c:pt idx="461">
                  <c:v>3.5888999999999997E-2</c:v>
                </c:pt>
                <c:pt idx="462">
                  <c:v>3.5827999999999999E-2</c:v>
                </c:pt>
                <c:pt idx="463">
                  <c:v>3.5782000000000001E-2</c:v>
                </c:pt>
                <c:pt idx="464">
                  <c:v>3.5645000000000003E-2</c:v>
                </c:pt>
                <c:pt idx="465">
                  <c:v>3.5598999999999999E-2</c:v>
                </c:pt>
                <c:pt idx="466">
                  <c:v>3.5506999999999997E-2</c:v>
                </c:pt>
                <c:pt idx="467">
                  <c:v>3.5477000000000002E-2</c:v>
                </c:pt>
                <c:pt idx="468">
                  <c:v>3.5416000000000003E-2</c:v>
                </c:pt>
                <c:pt idx="469">
                  <c:v>3.5400000000000001E-2</c:v>
                </c:pt>
                <c:pt idx="470">
                  <c:v>3.5293999999999999E-2</c:v>
                </c:pt>
                <c:pt idx="471">
                  <c:v>3.5248000000000002E-2</c:v>
                </c:pt>
                <c:pt idx="472">
                  <c:v>3.5248000000000002E-2</c:v>
                </c:pt>
                <c:pt idx="473">
                  <c:v>3.5172000000000002E-2</c:v>
                </c:pt>
                <c:pt idx="474">
                  <c:v>3.5110000000000002E-2</c:v>
                </c:pt>
                <c:pt idx="475">
                  <c:v>3.5064999999999999E-2</c:v>
                </c:pt>
                <c:pt idx="476">
                  <c:v>3.4987999999999998E-2</c:v>
                </c:pt>
                <c:pt idx="477">
                  <c:v>3.4958000000000003E-2</c:v>
                </c:pt>
                <c:pt idx="478">
                  <c:v>3.4882000000000003E-2</c:v>
                </c:pt>
                <c:pt idx="479">
                  <c:v>3.4866000000000001E-2</c:v>
                </c:pt>
                <c:pt idx="480">
                  <c:v>3.4851E-2</c:v>
                </c:pt>
                <c:pt idx="481">
                  <c:v>3.4820999999999998E-2</c:v>
                </c:pt>
                <c:pt idx="482">
                  <c:v>3.4790000000000001E-2</c:v>
                </c:pt>
                <c:pt idx="483">
                  <c:v>3.4714000000000002E-2</c:v>
                </c:pt>
                <c:pt idx="484">
                  <c:v>3.4729000000000003E-2</c:v>
                </c:pt>
                <c:pt idx="485">
                  <c:v>3.4775E-2</c:v>
                </c:pt>
                <c:pt idx="486">
                  <c:v>3.4743999999999997E-2</c:v>
                </c:pt>
                <c:pt idx="487">
                  <c:v>3.4714000000000002E-2</c:v>
                </c:pt>
                <c:pt idx="488">
                  <c:v>3.4759999999999999E-2</c:v>
                </c:pt>
                <c:pt idx="489">
                  <c:v>3.4775E-2</c:v>
                </c:pt>
                <c:pt idx="490">
                  <c:v>3.4743999999999997E-2</c:v>
                </c:pt>
                <c:pt idx="491">
                  <c:v>3.4743999999999997E-2</c:v>
                </c:pt>
                <c:pt idx="492">
                  <c:v>3.4667999999999997E-2</c:v>
                </c:pt>
                <c:pt idx="493">
                  <c:v>3.4682999999999999E-2</c:v>
                </c:pt>
                <c:pt idx="494">
                  <c:v>3.4714000000000002E-2</c:v>
                </c:pt>
                <c:pt idx="495">
                  <c:v>3.4759999999999999E-2</c:v>
                </c:pt>
                <c:pt idx="496">
                  <c:v>3.4729000000000003E-2</c:v>
                </c:pt>
                <c:pt idx="497">
                  <c:v>3.4667999999999997E-2</c:v>
                </c:pt>
                <c:pt idx="498">
                  <c:v>3.4759999999999999E-2</c:v>
                </c:pt>
                <c:pt idx="499">
                  <c:v>3.4775E-2</c:v>
                </c:pt>
                <c:pt idx="500">
                  <c:v>3.4851E-2</c:v>
                </c:pt>
                <c:pt idx="501">
                  <c:v>3.4851E-2</c:v>
                </c:pt>
                <c:pt idx="502">
                  <c:v>3.4743999999999997E-2</c:v>
                </c:pt>
                <c:pt idx="503">
                  <c:v>3.4743999999999997E-2</c:v>
                </c:pt>
                <c:pt idx="504">
                  <c:v>3.4698E-2</c:v>
                </c:pt>
                <c:pt idx="505">
                  <c:v>3.4637000000000001E-2</c:v>
                </c:pt>
                <c:pt idx="506">
                  <c:v>3.4698E-2</c:v>
                </c:pt>
                <c:pt idx="507">
                  <c:v>3.4729000000000003E-2</c:v>
                </c:pt>
                <c:pt idx="508">
                  <c:v>3.4759999999999999E-2</c:v>
                </c:pt>
                <c:pt idx="509">
                  <c:v>3.4729000000000003E-2</c:v>
                </c:pt>
                <c:pt idx="510">
                  <c:v>3.4759999999999999E-2</c:v>
                </c:pt>
              </c:numCache>
            </c:numRef>
          </c:yVal>
          <c:smooth val="1"/>
          <c:extLst>
            <c:ext xmlns:c16="http://schemas.microsoft.com/office/drawing/2014/chart" uri="{C3380CC4-5D6E-409C-BE32-E72D297353CC}">
              <c16:uniqueId val="{00000001-23D1-4D6B-8D95-E81ABA7C315A}"/>
            </c:ext>
          </c:extLst>
        </c:ser>
        <c:dLbls>
          <c:showLegendKey val="0"/>
          <c:showVal val="0"/>
          <c:showCatName val="0"/>
          <c:showSerName val="0"/>
          <c:showPercent val="0"/>
          <c:showBubbleSize val="0"/>
        </c:dLbls>
        <c:axId val="149725984"/>
        <c:axId val="149726544"/>
      </c:scatterChart>
      <c:scatterChart>
        <c:scatterStyle val="smoothMarker"/>
        <c:varyColors val="0"/>
        <c:ser>
          <c:idx val="1"/>
          <c:order val="1"/>
          <c:tx>
            <c:strRef>
              <c:f>INK!$M$1</c:f>
              <c:strCache>
                <c:ptCount val="1"/>
                <c:pt idx="0">
                  <c:v>Quinine sulfate (200 µM) H2SO4 Emission</c:v>
                </c:pt>
              </c:strCache>
            </c:strRef>
          </c:tx>
          <c:marker>
            <c:symbol val="none"/>
          </c:marker>
          <c:xVal>
            <c:numRef>
              <c:f>INK!$M$3:$M$293</c:f>
              <c:numCache>
                <c:formatCode>General</c:formatCode>
                <c:ptCount val="291"/>
                <c:pt idx="0">
                  <c:v>310</c:v>
                </c:pt>
                <c:pt idx="1">
                  <c:v>311.07000729999999</c:v>
                </c:pt>
                <c:pt idx="2">
                  <c:v>312</c:v>
                </c:pt>
                <c:pt idx="3">
                  <c:v>313.07000729999999</c:v>
                </c:pt>
                <c:pt idx="4">
                  <c:v>314</c:v>
                </c:pt>
                <c:pt idx="5">
                  <c:v>315.07000729999999</c:v>
                </c:pt>
                <c:pt idx="6">
                  <c:v>316</c:v>
                </c:pt>
                <c:pt idx="7">
                  <c:v>317.07000729999999</c:v>
                </c:pt>
                <c:pt idx="8">
                  <c:v>318</c:v>
                </c:pt>
                <c:pt idx="9">
                  <c:v>319.07000729999999</c:v>
                </c:pt>
                <c:pt idx="10">
                  <c:v>320</c:v>
                </c:pt>
                <c:pt idx="11">
                  <c:v>321.07000729999999</c:v>
                </c:pt>
                <c:pt idx="12">
                  <c:v>322</c:v>
                </c:pt>
                <c:pt idx="13">
                  <c:v>323.07000729999999</c:v>
                </c:pt>
                <c:pt idx="14">
                  <c:v>324</c:v>
                </c:pt>
                <c:pt idx="15">
                  <c:v>325.07000729999999</c:v>
                </c:pt>
                <c:pt idx="16">
                  <c:v>326</c:v>
                </c:pt>
                <c:pt idx="17">
                  <c:v>327.07000729999999</c:v>
                </c:pt>
                <c:pt idx="18">
                  <c:v>328</c:v>
                </c:pt>
                <c:pt idx="19">
                  <c:v>329.07000729999999</c:v>
                </c:pt>
                <c:pt idx="20">
                  <c:v>330</c:v>
                </c:pt>
                <c:pt idx="21">
                  <c:v>331.07000729999999</c:v>
                </c:pt>
                <c:pt idx="22">
                  <c:v>332</c:v>
                </c:pt>
                <c:pt idx="23">
                  <c:v>333.07000729999999</c:v>
                </c:pt>
                <c:pt idx="24">
                  <c:v>334</c:v>
                </c:pt>
                <c:pt idx="25">
                  <c:v>335.07000729999999</c:v>
                </c:pt>
                <c:pt idx="26">
                  <c:v>336</c:v>
                </c:pt>
                <c:pt idx="27">
                  <c:v>337.07000729999999</c:v>
                </c:pt>
                <c:pt idx="28">
                  <c:v>338</c:v>
                </c:pt>
                <c:pt idx="29">
                  <c:v>339.07000729999999</c:v>
                </c:pt>
                <c:pt idx="30">
                  <c:v>340</c:v>
                </c:pt>
                <c:pt idx="31">
                  <c:v>341.05999759999997</c:v>
                </c:pt>
                <c:pt idx="32">
                  <c:v>341.9599915</c:v>
                </c:pt>
                <c:pt idx="33">
                  <c:v>343.02999879999999</c:v>
                </c:pt>
                <c:pt idx="34">
                  <c:v>343.92999270000001</c:v>
                </c:pt>
                <c:pt idx="35">
                  <c:v>345</c:v>
                </c:pt>
                <c:pt idx="36">
                  <c:v>346.05999759999997</c:v>
                </c:pt>
                <c:pt idx="37">
                  <c:v>346.9599915</c:v>
                </c:pt>
                <c:pt idx="38">
                  <c:v>348.02999879999999</c:v>
                </c:pt>
                <c:pt idx="39">
                  <c:v>348.92999270000001</c:v>
                </c:pt>
                <c:pt idx="40">
                  <c:v>350</c:v>
                </c:pt>
                <c:pt idx="41">
                  <c:v>351.07000729999999</c:v>
                </c:pt>
                <c:pt idx="42">
                  <c:v>352</c:v>
                </c:pt>
                <c:pt idx="43">
                  <c:v>353.07000729999999</c:v>
                </c:pt>
                <c:pt idx="44">
                  <c:v>354</c:v>
                </c:pt>
                <c:pt idx="45">
                  <c:v>355.07000729999999</c:v>
                </c:pt>
                <c:pt idx="46">
                  <c:v>356</c:v>
                </c:pt>
                <c:pt idx="47">
                  <c:v>357.07000729999999</c:v>
                </c:pt>
                <c:pt idx="48">
                  <c:v>358</c:v>
                </c:pt>
                <c:pt idx="49">
                  <c:v>359.07000729999999</c:v>
                </c:pt>
                <c:pt idx="50">
                  <c:v>360</c:v>
                </c:pt>
                <c:pt idx="51">
                  <c:v>361.07000729999999</c:v>
                </c:pt>
                <c:pt idx="52">
                  <c:v>362</c:v>
                </c:pt>
                <c:pt idx="53">
                  <c:v>363.07000729999999</c:v>
                </c:pt>
                <c:pt idx="54">
                  <c:v>364</c:v>
                </c:pt>
                <c:pt idx="55">
                  <c:v>365.07000729999999</c:v>
                </c:pt>
                <c:pt idx="56">
                  <c:v>366</c:v>
                </c:pt>
                <c:pt idx="57">
                  <c:v>367.07000729999999</c:v>
                </c:pt>
                <c:pt idx="58">
                  <c:v>368</c:v>
                </c:pt>
                <c:pt idx="59">
                  <c:v>369.07000729999999</c:v>
                </c:pt>
                <c:pt idx="60">
                  <c:v>370</c:v>
                </c:pt>
                <c:pt idx="61">
                  <c:v>371.05999759999997</c:v>
                </c:pt>
                <c:pt idx="62">
                  <c:v>371.9599915</c:v>
                </c:pt>
                <c:pt idx="63">
                  <c:v>373.02999879999999</c:v>
                </c:pt>
                <c:pt idx="64">
                  <c:v>373.92999270000001</c:v>
                </c:pt>
                <c:pt idx="65">
                  <c:v>375</c:v>
                </c:pt>
                <c:pt idx="66">
                  <c:v>376.05999759999997</c:v>
                </c:pt>
                <c:pt idx="67">
                  <c:v>376.9599915</c:v>
                </c:pt>
                <c:pt idx="68">
                  <c:v>378.02999879999999</c:v>
                </c:pt>
                <c:pt idx="69">
                  <c:v>378.92999270000001</c:v>
                </c:pt>
                <c:pt idx="70">
                  <c:v>380</c:v>
                </c:pt>
                <c:pt idx="71">
                  <c:v>381.07000729999999</c:v>
                </c:pt>
                <c:pt idx="72">
                  <c:v>382</c:v>
                </c:pt>
                <c:pt idx="73">
                  <c:v>383.07000729999999</c:v>
                </c:pt>
                <c:pt idx="74">
                  <c:v>384</c:v>
                </c:pt>
                <c:pt idx="75">
                  <c:v>385.07000729999999</c:v>
                </c:pt>
                <c:pt idx="76">
                  <c:v>386</c:v>
                </c:pt>
                <c:pt idx="77">
                  <c:v>387.07000729999999</c:v>
                </c:pt>
                <c:pt idx="78">
                  <c:v>388</c:v>
                </c:pt>
                <c:pt idx="79">
                  <c:v>389.07000729999999</c:v>
                </c:pt>
                <c:pt idx="80">
                  <c:v>390</c:v>
                </c:pt>
                <c:pt idx="81">
                  <c:v>391.05999759999997</c:v>
                </c:pt>
                <c:pt idx="82">
                  <c:v>391.9599915</c:v>
                </c:pt>
                <c:pt idx="83">
                  <c:v>393.02999879999999</c:v>
                </c:pt>
                <c:pt idx="84">
                  <c:v>393.92999270000001</c:v>
                </c:pt>
                <c:pt idx="85">
                  <c:v>395</c:v>
                </c:pt>
                <c:pt idx="86">
                  <c:v>396.05999759999997</c:v>
                </c:pt>
                <c:pt idx="87">
                  <c:v>396.9599915</c:v>
                </c:pt>
                <c:pt idx="88">
                  <c:v>398.02999879999999</c:v>
                </c:pt>
                <c:pt idx="89">
                  <c:v>398.92999270000001</c:v>
                </c:pt>
                <c:pt idx="90">
                  <c:v>400</c:v>
                </c:pt>
                <c:pt idx="91">
                  <c:v>401.05999759999997</c:v>
                </c:pt>
                <c:pt idx="92">
                  <c:v>401.9599915</c:v>
                </c:pt>
                <c:pt idx="93">
                  <c:v>403.02999879999999</c:v>
                </c:pt>
                <c:pt idx="94">
                  <c:v>403.92999270000001</c:v>
                </c:pt>
                <c:pt idx="95">
                  <c:v>405</c:v>
                </c:pt>
                <c:pt idx="96">
                  <c:v>406.05999759999997</c:v>
                </c:pt>
                <c:pt idx="97">
                  <c:v>406.9599915</c:v>
                </c:pt>
                <c:pt idx="98">
                  <c:v>408.02999879999999</c:v>
                </c:pt>
                <c:pt idx="99">
                  <c:v>408.92999270000001</c:v>
                </c:pt>
                <c:pt idx="100">
                  <c:v>410</c:v>
                </c:pt>
                <c:pt idx="101">
                  <c:v>411.05999759999997</c:v>
                </c:pt>
                <c:pt idx="102">
                  <c:v>411.9599915</c:v>
                </c:pt>
                <c:pt idx="103">
                  <c:v>413.02999879999999</c:v>
                </c:pt>
                <c:pt idx="104">
                  <c:v>413.92999270000001</c:v>
                </c:pt>
                <c:pt idx="105">
                  <c:v>415</c:v>
                </c:pt>
                <c:pt idx="106">
                  <c:v>416.05999759999997</c:v>
                </c:pt>
                <c:pt idx="107">
                  <c:v>416.9599915</c:v>
                </c:pt>
                <c:pt idx="108">
                  <c:v>418.02999879999999</c:v>
                </c:pt>
                <c:pt idx="109">
                  <c:v>418.92999270000001</c:v>
                </c:pt>
                <c:pt idx="110">
                  <c:v>420</c:v>
                </c:pt>
                <c:pt idx="111">
                  <c:v>421.05999759999997</c:v>
                </c:pt>
                <c:pt idx="112">
                  <c:v>421.9599915</c:v>
                </c:pt>
                <c:pt idx="113">
                  <c:v>423.02999879999999</c:v>
                </c:pt>
                <c:pt idx="114">
                  <c:v>423.92999270000001</c:v>
                </c:pt>
                <c:pt idx="115">
                  <c:v>425</c:v>
                </c:pt>
                <c:pt idx="116">
                  <c:v>426.05999759999997</c:v>
                </c:pt>
                <c:pt idx="117">
                  <c:v>426.9599915</c:v>
                </c:pt>
                <c:pt idx="118">
                  <c:v>428.02999879999999</c:v>
                </c:pt>
                <c:pt idx="119">
                  <c:v>428.92999270000001</c:v>
                </c:pt>
                <c:pt idx="120">
                  <c:v>430</c:v>
                </c:pt>
                <c:pt idx="121">
                  <c:v>431.05999759999997</c:v>
                </c:pt>
                <c:pt idx="122">
                  <c:v>431.9599915</c:v>
                </c:pt>
                <c:pt idx="123">
                  <c:v>433.02999879999999</c:v>
                </c:pt>
                <c:pt idx="124">
                  <c:v>433.92999270000001</c:v>
                </c:pt>
                <c:pt idx="125">
                  <c:v>435</c:v>
                </c:pt>
                <c:pt idx="126">
                  <c:v>436.05999759999997</c:v>
                </c:pt>
                <c:pt idx="127">
                  <c:v>436.9599915</c:v>
                </c:pt>
                <c:pt idx="128">
                  <c:v>438.02999879999999</c:v>
                </c:pt>
                <c:pt idx="129">
                  <c:v>438.92999270000001</c:v>
                </c:pt>
                <c:pt idx="130">
                  <c:v>440</c:v>
                </c:pt>
                <c:pt idx="131">
                  <c:v>441.05999759999997</c:v>
                </c:pt>
                <c:pt idx="132">
                  <c:v>441.9599915</c:v>
                </c:pt>
                <c:pt idx="133">
                  <c:v>443.02999879999999</c:v>
                </c:pt>
                <c:pt idx="134">
                  <c:v>443.92999270000001</c:v>
                </c:pt>
                <c:pt idx="135">
                  <c:v>445</c:v>
                </c:pt>
                <c:pt idx="136">
                  <c:v>446.05999759999997</c:v>
                </c:pt>
                <c:pt idx="137">
                  <c:v>446.9599915</c:v>
                </c:pt>
                <c:pt idx="138">
                  <c:v>448.02999879999999</c:v>
                </c:pt>
                <c:pt idx="139">
                  <c:v>448.92999270000001</c:v>
                </c:pt>
                <c:pt idx="140">
                  <c:v>450</c:v>
                </c:pt>
                <c:pt idx="141">
                  <c:v>451.0400085</c:v>
                </c:pt>
                <c:pt idx="142">
                  <c:v>451.94000240000003</c:v>
                </c:pt>
                <c:pt idx="143">
                  <c:v>452.98001099999999</c:v>
                </c:pt>
                <c:pt idx="144">
                  <c:v>454.01998900000001</c:v>
                </c:pt>
                <c:pt idx="145">
                  <c:v>455.07000729999999</c:v>
                </c:pt>
                <c:pt idx="146">
                  <c:v>455.97000120000001</c:v>
                </c:pt>
                <c:pt idx="147">
                  <c:v>457.01000979999998</c:v>
                </c:pt>
                <c:pt idx="148">
                  <c:v>458.0499878</c:v>
                </c:pt>
                <c:pt idx="149">
                  <c:v>458.9500122</c:v>
                </c:pt>
                <c:pt idx="150">
                  <c:v>460</c:v>
                </c:pt>
                <c:pt idx="151">
                  <c:v>461.05999759999997</c:v>
                </c:pt>
                <c:pt idx="152">
                  <c:v>461.9599915</c:v>
                </c:pt>
                <c:pt idx="153">
                  <c:v>463.02999879999999</c:v>
                </c:pt>
                <c:pt idx="154">
                  <c:v>463.92999270000001</c:v>
                </c:pt>
                <c:pt idx="155">
                  <c:v>465</c:v>
                </c:pt>
                <c:pt idx="156">
                  <c:v>466.05999759999997</c:v>
                </c:pt>
                <c:pt idx="157">
                  <c:v>466.9599915</c:v>
                </c:pt>
                <c:pt idx="158">
                  <c:v>468.02999879999999</c:v>
                </c:pt>
                <c:pt idx="159">
                  <c:v>468.92999270000001</c:v>
                </c:pt>
                <c:pt idx="160">
                  <c:v>470</c:v>
                </c:pt>
                <c:pt idx="161">
                  <c:v>471.0400085</c:v>
                </c:pt>
                <c:pt idx="162">
                  <c:v>471.94000240000003</c:v>
                </c:pt>
                <c:pt idx="163">
                  <c:v>472.98001099999999</c:v>
                </c:pt>
                <c:pt idx="164">
                  <c:v>474.01998900000001</c:v>
                </c:pt>
                <c:pt idx="165">
                  <c:v>475.07000729999999</c:v>
                </c:pt>
                <c:pt idx="166">
                  <c:v>475.97000120000001</c:v>
                </c:pt>
                <c:pt idx="167">
                  <c:v>477.01000979999998</c:v>
                </c:pt>
                <c:pt idx="168">
                  <c:v>478.0499878</c:v>
                </c:pt>
                <c:pt idx="169">
                  <c:v>478.9500122</c:v>
                </c:pt>
                <c:pt idx="170">
                  <c:v>480</c:v>
                </c:pt>
                <c:pt idx="171">
                  <c:v>481.0400085</c:v>
                </c:pt>
                <c:pt idx="172">
                  <c:v>481.94000240000003</c:v>
                </c:pt>
                <c:pt idx="173">
                  <c:v>482.98001099999999</c:v>
                </c:pt>
                <c:pt idx="174">
                  <c:v>484.01998900000001</c:v>
                </c:pt>
                <c:pt idx="175">
                  <c:v>485.07000729999999</c:v>
                </c:pt>
                <c:pt idx="176">
                  <c:v>485.97000120000001</c:v>
                </c:pt>
                <c:pt idx="177">
                  <c:v>487.01000979999998</c:v>
                </c:pt>
                <c:pt idx="178">
                  <c:v>488.0499878</c:v>
                </c:pt>
                <c:pt idx="179">
                  <c:v>488.9500122</c:v>
                </c:pt>
                <c:pt idx="180">
                  <c:v>490</c:v>
                </c:pt>
                <c:pt idx="181">
                  <c:v>491.0400085</c:v>
                </c:pt>
                <c:pt idx="182">
                  <c:v>491.94000240000003</c:v>
                </c:pt>
                <c:pt idx="183">
                  <c:v>492.98001099999999</c:v>
                </c:pt>
                <c:pt idx="184">
                  <c:v>494.01998900000001</c:v>
                </c:pt>
                <c:pt idx="185">
                  <c:v>495.07000729999999</c:v>
                </c:pt>
                <c:pt idx="186">
                  <c:v>495.97000120000001</c:v>
                </c:pt>
                <c:pt idx="187">
                  <c:v>497.01000979999998</c:v>
                </c:pt>
                <c:pt idx="188">
                  <c:v>498.0499878</c:v>
                </c:pt>
                <c:pt idx="189">
                  <c:v>498.9500122</c:v>
                </c:pt>
                <c:pt idx="190">
                  <c:v>500</c:v>
                </c:pt>
                <c:pt idx="191">
                  <c:v>501.0400085</c:v>
                </c:pt>
                <c:pt idx="192">
                  <c:v>501.94000240000003</c:v>
                </c:pt>
                <c:pt idx="193">
                  <c:v>502.98001099999999</c:v>
                </c:pt>
                <c:pt idx="194">
                  <c:v>504.01998900000001</c:v>
                </c:pt>
                <c:pt idx="195">
                  <c:v>505.07000729999999</c:v>
                </c:pt>
                <c:pt idx="196">
                  <c:v>505.97000120000001</c:v>
                </c:pt>
                <c:pt idx="197">
                  <c:v>507.01000979999998</c:v>
                </c:pt>
                <c:pt idx="198">
                  <c:v>508.0499878</c:v>
                </c:pt>
                <c:pt idx="199">
                  <c:v>508.9500122</c:v>
                </c:pt>
                <c:pt idx="200">
                  <c:v>510</c:v>
                </c:pt>
                <c:pt idx="201">
                  <c:v>511.0400085</c:v>
                </c:pt>
                <c:pt idx="202">
                  <c:v>511.94000240000003</c:v>
                </c:pt>
                <c:pt idx="203">
                  <c:v>512.97998050000001</c:v>
                </c:pt>
                <c:pt idx="204">
                  <c:v>514.02001949999999</c:v>
                </c:pt>
                <c:pt idx="205">
                  <c:v>515.07000730000004</c:v>
                </c:pt>
                <c:pt idx="206">
                  <c:v>515.96997069999998</c:v>
                </c:pt>
                <c:pt idx="207">
                  <c:v>517.01000980000003</c:v>
                </c:pt>
                <c:pt idx="208">
                  <c:v>518.04998780000005</c:v>
                </c:pt>
                <c:pt idx="209">
                  <c:v>518.95001219999995</c:v>
                </c:pt>
                <c:pt idx="210">
                  <c:v>520</c:v>
                </c:pt>
                <c:pt idx="211">
                  <c:v>521.03997800000002</c:v>
                </c:pt>
                <c:pt idx="212">
                  <c:v>521.94000240000003</c:v>
                </c:pt>
                <c:pt idx="213">
                  <c:v>522.97998050000001</c:v>
                </c:pt>
                <c:pt idx="214">
                  <c:v>524.02001949999999</c:v>
                </c:pt>
                <c:pt idx="215">
                  <c:v>525.07000730000004</c:v>
                </c:pt>
                <c:pt idx="216">
                  <c:v>525.96997069999998</c:v>
                </c:pt>
                <c:pt idx="217">
                  <c:v>527.01000980000003</c:v>
                </c:pt>
                <c:pt idx="218">
                  <c:v>528.04998780000005</c:v>
                </c:pt>
                <c:pt idx="219">
                  <c:v>528.95001219999995</c:v>
                </c:pt>
                <c:pt idx="220">
                  <c:v>530</c:v>
                </c:pt>
                <c:pt idx="221">
                  <c:v>531.02001949999999</c:v>
                </c:pt>
                <c:pt idx="222">
                  <c:v>532.04998780000005</c:v>
                </c:pt>
                <c:pt idx="223">
                  <c:v>532.94000240000003</c:v>
                </c:pt>
                <c:pt idx="224">
                  <c:v>533.96997069999998</c:v>
                </c:pt>
                <c:pt idx="225">
                  <c:v>535</c:v>
                </c:pt>
                <c:pt idx="226">
                  <c:v>536.02001949999999</c:v>
                </c:pt>
                <c:pt idx="227">
                  <c:v>537.04998780000005</c:v>
                </c:pt>
                <c:pt idx="228">
                  <c:v>537.94000240000003</c:v>
                </c:pt>
                <c:pt idx="229">
                  <c:v>538.96997069999998</c:v>
                </c:pt>
                <c:pt idx="230">
                  <c:v>540</c:v>
                </c:pt>
                <c:pt idx="231">
                  <c:v>541.02001949999999</c:v>
                </c:pt>
                <c:pt idx="232">
                  <c:v>542.04998780000005</c:v>
                </c:pt>
                <c:pt idx="233">
                  <c:v>542.94000240000003</c:v>
                </c:pt>
                <c:pt idx="234">
                  <c:v>543.96997069999998</c:v>
                </c:pt>
                <c:pt idx="235">
                  <c:v>545</c:v>
                </c:pt>
                <c:pt idx="236">
                  <c:v>546.02001949999999</c:v>
                </c:pt>
                <c:pt idx="237">
                  <c:v>547.04998780000005</c:v>
                </c:pt>
                <c:pt idx="238">
                  <c:v>547.94000240000003</c:v>
                </c:pt>
                <c:pt idx="239">
                  <c:v>548.96997069999998</c:v>
                </c:pt>
                <c:pt idx="240">
                  <c:v>550</c:v>
                </c:pt>
                <c:pt idx="241">
                  <c:v>551.02001949999999</c:v>
                </c:pt>
                <c:pt idx="242">
                  <c:v>552.04998780000005</c:v>
                </c:pt>
                <c:pt idx="243">
                  <c:v>552.94000240000003</c:v>
                </c:pt>
                <c:pt idx="244">
                  <c:v>553.96997069999998</c:v>
                </c:pt>
                <c:pt idx="245">
                  <c:v>555</c:v>
                </c:pt>
                <c:pt idx="246">
                  <c:v>556.02001949999999</c:v>
                </c:pt>
                <c:pt idx="247">
                  <c:v>557.04998780000005</c:v>
                </c:pt>
                <c:pt idx="248">
                  <c:v>557.94000240000003</c:v>
                </c:pt>
                <c:pt idx="249">
                  <c:v>558.96997069999998</c:v>
                </c:pt>
                <c:pt idx="250">
                  <c:v>560</c:v>
                </c:pt>
                <c:pt idx="251">
                  <c:v>561.02001949999999</c:v>
                </c:pt>
                <c:pt idx="252">
                  <c:v>562.04998780000005</c:v>
                </c:pt>
                <c:pt idx="253">
                  <c:v>562.94000240000003</c:v>
                </c:pt>
                <c:pt idx="254">
                  <c:v>563.96997069999998</c:v>
                </c:pt>
                <c:pt idx="255">
                  <c:v>565</c:v>
                </c:pt>
                <c:pt idx="256">
                  <c:v>566.02001949999999</c:v>
                </c:pt>
                <c:pt idx="257">
                  <c:v>567.04998780000005</c:v>
                </c:pt>
                <c:pt idx="258">
                  <c:v>567.94000240000003</c:v>
                </c:pt>
                <c:pt idx="259">
                  <c:v>568.96997069999998</c:v>
                </c:pt>
                <c:pt idx="260">
                  <c:v>570</c:v>
                </c:pt>
                <c:pt idx="261">
                  <c:v>571.02001949999999</c:v>
                </c:pt>
                <c:pt idx="262">
                  <c:v>572.04998780000005</c:v>
                </c:pt>
                <c:pt idx="263">
                  <c:v>572.94000240000003</c:v>
                </c:pt>
                <c:pt idx="264">
                  <c:v>573.96997069999998</c:v>
                </c:pt>
                <c:pt idx="265">
                  <c:v>575</c:v>
                </c:pt>
                <c:pt idx="266">
                  <c:v>576.02001949999999</c:v>
                </c:pt>
                <c:pt idx="267">
                  <c:v>577.04998780000005</c:v>
                </c:pt>
                <c:pt idx="268">
                  <c:v>577.94000240000003</c:v>
                </c:pt>
                <c:pt idx="269">
                  <c:v>578.96997069999998</c:v>
                </c:pt>
                <c:pt idx="270">
                  <c:v>580</c:v>
                </c:pt>
                <c:pt idx="271">
                  <c:v>581.02001949999999</c:v>
                </c:pt>
                <c:pt idx="272">
                  <c:v>582.04998780000005</c:v>
                </c:pt>
                <c:pt idx="273">
                  <c:v>582.94000240000003</c:v>
                </c:pt>
                <c:pt idx="274">
                  <c:v>583.96997069999998</c:v>
                </c:pt>
                <c:pt idx="275">
                  <c:v>585</c:v>
                </c:pt>
                <c:pt idx="276">
                  <c:v>586.02001949999999</c:v>
                </c:pt>
                <c:pt idx="277">
                  <c:v>587.04998780000005</c:v>
                </c:pt>
                <c:pt idx="278">
                  <c:v>587.94000240000003</c:v>
                </c:pt>
                <c:pt idx="279">
                  <c:v>588.96997069999998</c:v>
                </c:pt>
                <c:pt idx="280">
                  <c:v>590</c:v>
                </c:pt>
                <c:pt idx="281">
                  <c:v>591.01000980000003</c:v>
                </c:pt>
                <c:pt idx="282">
                  <c:v>592.02001949999999</c:v>
                </c:pt>
                <c:pt idx="283">
                  <c:v>593.03997800000002</c:v>
                </c:pt>
                <c:pt idx="284">
                  <c:v>594.04998780000005</c:v>
                </c:pt>
                <c:pt idx="285">
                  <c:v>595.07000730000004</c:v>
                </c:pt>
                <c:pt idx="286">
                  <c:v>595.94000240000003</c:v>
                </c:pt>
                <c:pt idx="287">
                  <c:v>596.95001219999995</c:v>
                </c:pt>
                <c:pt idx="288">
                  <c:v>597.96997069999998</c:v>
                </c:pt>
                <c:pt idx="289">
                  <c:v>598.97998050000001</c:v>
                </c:pt>
                <c:pt idx="290">
                  <c:v>600</c:v>
                </c:pt>
              </c:numCache>
            </c:numRef>
          </c:xVal>
          <c:yVal>
            <c:numRef>
              <c:f>INK!$N$3:$N$293</c:f>
              <c:numCache>
                <c:formatCode>General</c:formatCode>
                <c:ptCount val="291"/>
                <c:pt idx="0">
                  <c:v>0.78091198210000001</c:v>
                </c:pt>
                <c:pt idx="1">
                  <c:v>0.92627096180000001</c:v>
                </c:pt>
                <c:pt idx="2">
                  <c:v>0.69544148449999998</c:v>
                </c:pt>
                <c:pt idx="3">
                  <c:v>0.85508996250000002</c:v>
                </c:pt>
                <c:pt idx="4">
                  <c:v>0.72769773010000005</c:v>
                </c:pt>
                <c:pt idx="5">
                  <c:v>0.99918550250000004</c:v>
                </c:pt>
                <c:pt idx="6">
                  <c:v>0.60759609940000003</c:v>
                </c:pt>
                <c:pt idx="7">
                  <c:v>0.80922961240000002</c:v>
                </c:pt>
                <c:pt idx="8">
                  <c:v>0.58623260259999999</c:v>
                </c:pt>
                <c:pt idx="9">
                  <c:v>0.65767842529999998</c:v>
                </c:pt>
                <c:pt idx="10">
                  <c:v>0.57660090919999996</c:v>
                </c:pt>
                <c:pt idx="11">
                  <c:v>0.54009097809999995</c:v>
                </c:pt>
                <c:pt idx="12">
                  <c:v>0.91752958299999998</c:v>
                </c:pt>
                <c:pt idx="13">
                  <c:v>0.67239183189999996</c:v>
                </c:pt>
                <c:pt idx="14">
                  <c:v>0.4413712025</c:v>
                </c:pt>
                <c:pt idx="15">
                  <c:v>0.61327266690000004</c:v>
                </c:pt>
                <c:pt idx="16">
                  <c:v>0.9220279455</c:v>
                </c:pt>
                <c:pt idx="17">
                  <c:v>0.5078535676</c:v>
                </c:pt>
                <c:pt idx="18">
                  <c:v>1.0257844920000001</c:v>
                </c:pt>
                <c:pt idx="19">
                  <c:v>0.73566377159999996</c:v>
                </c:pt>
                <c:pt idx="20">
                  <c:v>0.65081465240000003</c:v>
                </c:pt>
                <c:pt idx="21">
                  <c:v>0.65771251919999996</c:v>
                </c:pt>
                <c:pt idx="22">
                  <c:v>0.77424937490000001</c:v>
                </c:pt>
                <c:pt idx="23">
                  <c:v>0.62019497160000003</c:v>
                </c:pt>
                <c:pt idx="24">
                  <c:v>0.81267780069999995</c:v>
                </c:pt>
                <c:pt idx="25">
                  <c:v>0.75850737089999998</c:v>
                </c:pt>
                <c:pt idx="26">
                  <c:v>0.73006635900000005</c:v>
                </c:pt>
                <c:pt idx="27">
                  <c:v>0.99847954510000003</c:v>
                </c:pt>
                <c:pt idx="28">
                  <c:v>0.82040911910000003</c:v>
                </c:pt>
                <c:pt idx="29">
                  <c:v>0.64150899650000004</c:v>
                </c:pt>
                <c:pt idx="30">
                  <c:v>0.78727942709999998</c:v>
                </c:pt>
                <c:pt idx="31">
                  <c:v>0.80255901809999997</c:v>
                </c:pt>
                <c:pt idx="32">
                  <c:v>0.78396499159999999</c:v>
                </c:pt>
                <c:pt idx="33">
                  <c:v>0.77662360669999997</c:v>
                </c:pt>
                <c:pt idx="34">
                  <c:v>0.83959138389999999</c:v>
                </c:pt>
                <c:pt idx="35">
                  <c:v>0.84202492240000004</c:v>
                </c:pt>
                <c:pt idx="36">
                  <c:v>0.80497705939999997</c:v>
                </c:pt>
                <c:pt idx="37">
                  <c:v>0.71693015100000002</c:v>
                </c:pt>
                <c:pt idx="38">
                  <c:v>0.95110607150000004</c:v>
                </c:pt>
                <c:pt idx="39">
                  <c:v>0.60886645319999999</c:v>
                </c:pt>
                <c:pt idx="40">
                  <c:v>1.0296796560000001</c:v>
                </c:pt>
                <c:pt idx="41">
                  <c:v>1.161968946</c:v>
                </c:pt>
                <c:pt idx="42">
                  <c:v>1.072270989</c:v>
                </c:pt>
                <c:pt idx="43">
                  <c:v>0.89620524639999999</c:v>
                </c:pt>
                <c:pt idx="44">
                  <c:v>0.96737718579999998</c:v>
                </c:pt>
                <c:pt idx="45">
                  <c:v>0.80046492820000004</c:v>
                </c:pt>
                <c:pt idx="46">
                  <c:v>0.81356084350000002</c:v>
                </c:pt>
                <c:pt idx="47">
                  <c:v>0.94677287340000005</c:v>
                </c:pt>
                <c:pt idx="48">
                  <c:v>0.66890418529999995</c:v>
                </c:pt>
                <c:pt idx="49">
                  <c:v>0.80355769399999999</c:v>
                </c:pt>
                <c:pt idx="50">
                  <c:v>1.0333745480000001</c:v>
                </c:pt>
                <c:pt idx="51">
                  <c:v>0.92838048929999994</c:v>
                </c:pt>
                <c:pt idx="52">
                  <c:v>1.0254518989999999</c:v>
                </c:pt>
                <c:pt idx="53">
                  <c:v>1.05705893</c:v>
                </c:pt>
                <c:pt idx="54">
                  <c:v>1.0098433490000001</c:v>
                </c:pt>
                <c:pt idx="55">
                  <c:v>1.304100633</c:v>
                </c:pt>
                <c:pt idx="56">
                  <c:v>1.5423412320000001</c:v>
                </c:pt>
                <c:pt idx="57">
                  <c:v>1.2450506690000001</c:v>
                </c:pt>
                <c:pt idx="58">
                  <c:v>1.6910104749999999</c:v>
                </c:pt>
                <c:pt idx="59">
                  <c:v>1.6845060590000001</c:v>
                </c:pt>
                <c:pt idx="60">
                  <c:v>2.4354660510000001</c:v>
                </c:pt>
                <c:pt idx="61">
                  <c:v>1.7825526</c:v>
                </c:pt>
                <c:pt idx="62">
                  <c:v>2.7097470760000002</c:v>
                </c:pt>
                <c:pt idx="63">
                  <c:v>3.1919956209999998</c:v>
                </c:pt>
                <c:pt idx="64">
                  <c:v>3.1821336750000002</c:v>
                </c:pt>
                <c:pt idx="65">
                  <c:v>4.1711230280000002</c:v>
                </c:pt>
                <c:pt idx="66">
                  <c:v>5.2958450319999999</c:v>
                </c:pt>
                <c:pt idx="67">
                  <c:v>5.9746956830000002</c:v>
                </c:pt>
                <c:pt idx="68">
                  <c:v>7.632297039</c:v>
                </c:pt>
                <c:pt idx="69">
                  <c:v>8.4998226169999995</c:v>
                </c:pt>
                <c:pt idx="70">
                  <c:v>10.319787030000001</c:v>
                </c:pt>
                <c:pt idx="71">
                  <c:v>12.455829619999999</c:v>
                </c:pt>
                <c:pt idx="72">
                  <c:v>14.27226162</c:v>
                </c:pt>
                <c:pt idx="73">
                  <c:v>16.834377289999999</c:v>
                </c:pt>
                <c:pt idx="74">
                  <c:v>18.343814850000001</c:v>
                </c:pt>
                <c:pt idx="75">
                  <c:v>21.540216449999999</c:v>
                </c:pt>
                <c:pt idx="76">
                  <c:v>25.056680679999999</c:v>
                </c:pt>
                <c:pt idx="77">
                  <c:v>30.393531800000002</c:v>
                </c:pt>
                <c:pt idx="78">
                  <c:v>34.347270969999997</c:v>
                </c:pt>
                <c:pt idx="79">
                  <c:v>41.44914627</c:v>
                </c:pt>
                <c:pt idx="80">
                  <c:v>43.963661190000003</c:v>
                </c:pt>
                <c:pt idx="81">
                  <c:v>51.815483090000001</c:v>
                </c:pt>
                <c:pt idx="82">
                  <c:v>58.027427670000002</c:v>
                </c:pt>
                <c:pt idx="83">
                  <c:v>68.713867190000002</c:v>
                </c:pt>
                <c:pt idx="84">
                  <c:v>71.039184570000003</c:v>
                </c:pt>
                <c:pt idx="85">
                  <c:v>81.609130859999993</c:v>
                </c:pt>
                <c:pt idx="86">
                  <c:v>87.33955383</c:v>
                </c:pt>
                <c:pt idx="87">
                  <c:v>100.5113831</c:v>
                </c:pt>
                <c:pt idx="88">
                  <c:v>105.81535340000001</c:v>
                </c:pt>
                <c:pt idx="89">
                  <c:v>117.05219270000001</c:v>
                </c:pt>
                <c:pt idx="90">
                  <c:v>133.7800598</c:v>
                </c:pt>
                <c:pt idx="91">
                  <c:v>148.12155150000001</c:v>
                </c:pt>
                <c:pt idx="92">
                  <c:v>162.1100769</c:v>
                </c:pt>
                <c:pt idx="93">
                  <c:v>170.22073359999999</c:v>
                </c:pt>
                <c:pt idx="94">
                  <c:v>186.8171997</c:v>
                </c:pt>
                <c:pt idx="95">
                  <c:v>206.31306459999999</c:v>
                </c:pt>
                <c:pt idx="96">
                  <c:v>218.15290830000001</c:v>
                </c:pt>
                <c:pt idx="97">
                  <c:v>237.9366302</c:v>
                </c:pt>
                <c:pt idx="98">
                  <c:v>242.56445310000001</c:v>
                </c:pt>
                <c:pt idx="99">
                  <c:v>258.83288570000002</c:v>
                </c:pt>
                <c:pt idx="100">
                  <c:v>280.56738280000002</c:v>
                </c:pt>
                <c:pt idx="101">
                  <c:v>303.42416379999997</c:v>
                </c:pt>
                <c:pt idx="102">
                  <c:v>311.13861079999998</c:v>
                </c:pt>
                <c:pt idx="103">
                  <c:v>330.9688721</c:v>
                </c:pt>
                <c:pt idx="104">
                  <c:v>351.84039310000003</c:v>
                </c:pt>
                <c:pt idx="105">
                  <c:v>356.01321410000003</c:v>
                </c:pt>
                <c:pt idx="106">
                  <c:v>382.44461059999998</c:v>
                </c:pt>
                <c:pt idx="107">
                  <c:v>396.8282471</c:v>
                </c:pt>
                <c:pt idx="108">
                  <c:v>412.70916749999998</c:v>
                </c:pt>
                <c:pt idx="109">
                  <c:v>426.5358276</c:v>
                </c:pt>
                <c:pt idx="110">
                  <c:v>437.15716550000002</c:v>
                </c:pt>
                <c:pt idx="111">
                  <c:v>461.43572999999998</c:v>
                </c:pt>
                <c:pt idx="112">
                  <c:v>473.03753660000001</c:v>
                </c:pt>
                <c:pt idx="113">
                  <c:v>488.11025999999998</c:v>
                </c:pt>
                <c:pt idx="114">
                  <c:v>495.88201900000001</c:v>
                </c:pt>
                <c:pt idx="115">
                  <c:v>504.07565310000001</c:v>
                </c:pt>
                <c:pt idx="116">
                  <c:v>530.91870119999999</c:v>
                </c:pt>
                <c:pt idx="117">
                  <c:v>544.56500240000003</c:v>
                </c:pt>
                <c:pt idx="118">
                  <c:v>554.6384888</c:v>
                </c:pt>
                <c:pt idx="119">
                  <c:v>557.59271239999998</c:v>
                </c:pt>
                <c:pt idx="120">
                  <c:v>566.38452150000001</c:v>
                </c:pt>
                <c:pt idx="121">
                  <c:v>579.06280519999996</c:v>
                </c:pt>
                <c:pt idx="122">
                  <c:v>586.95648189999997</c:v>
                </c:pt>
                <c:pt idx="123">
                  <c:v>601.1427612</c:v>
                </c:pt>
                <c:pt idx="124">
                  <c:v>615.0234375</c:v>
                </c:pt>
                <c:pt idx="125">
                  <c:v>616.4102173</c:v>
                </c:pt>
                <c:pt idx="126">
                  <c:v>630.16485599999999</c:v>
                </c:pt>
                <c:pt idx="127">
                  <c:v>634.61303710000004</c:v>
                </c:pt>
                <c:pt idx="128">
                  <c:v>642.6055298</c:v>
                </c:pt>
                <c:pt idx="129">
                  <c:v>639.45989989999998</c:v>
                </c:pt>
                <c:pt idx="130">
                  <c:v>644.11853029999997</c:v>
                </c:pt>
                <c:pt idx="131">
                  <c:v>643.35308840000005</c:v>
                </c:pt>
                <c:pt idx="132">
                  <c:v>653.81481929999995</c:v>
                </c:pt>
                <c:pt idx="133">
                  <c:v>650.60882570000001</c:v>
                </c:pt>
                <c:pt idx="134">
                  <c:v>659.08911130000001</c:v>
                </c:pt>
                <c:pt idx="135">
                  <c:v>669.94970699999999</c:v>
                </c:pt>
                <c:pt idx="136">
                  <c:v>664.53857419999997</c:v>
                </c:pt>
                <c:pt idx="137">
                  <c:v>663.20953369999995</c:v>
                </c:pt>
                <c:pt idx="138">
                  <c:v>676.06323239999995</c:v>
                </c:pt>
                <c:pt idx="139">
                  <c:v>681.58886719999998</c:v>
                </c:pt>
                <c:pt idx="140">
                  <c:v>661.36737059999996</c:v>
                </c:pt>
                <c:pt idx="141">
                  <c:v>662.68188480000003</c:v>
                </c:pt>
                <c:pt idx="142">
                  <c:v>671.79010010000002</c:v>
                </c:pt>
                <c:pt idx="143">
                  <c:v>679.70849610000005</c:v>
                </c:pt>
                <c:pt idx="144">
                  <c:v>668.86108400000001</c:v>
                </c:pt>
                <c:pt idx="145">
                  <c:v>679.56011960000001</c:v>
                </c:pt>
                <c:pt idx="146">
                  <c:v>673.03753659999995</c:v>
                </c:pt>
                <c:pt idx="147">
                  <c:v>661.1818237</c:v>
                </c:pt>
                <c:pt idx="148">
                  <c:v>662.87921140000003</c:v>
                </c:pt>
                <c:pt idx="149">
                  <c:v>661.89837650000004</c:v>
                </c:pt>
                <c:pt idx="150">
                  <c:v>647.14819339999997</c:v>
                </c:pt>
                <c:pt idx="151">
                  <c:v>664.08062740000003</c:v>
                </c:pt>
                <c:pt idx="152">
                  <c:v>655.35546880000004</c:v>
                </c:pt>
                <c:pt idx="153">
                  <c:v>649.80120850000003</c:v>
                </c:pt>
                <c:pt idx="154">
                  <c:v>646.95764159999999</c:v>
                </c:pt>
                <c:pt idx="155">
                  <c:v>638.7186279</c:v>
                </c:pt>
                <c:pt idx="156">
                  <c:v>626.07135010000002</c:v>
                </c:pt>
                <c:pt idx="157">
                  <c:v>625.00933840000005</c:v>
                </c:pt>
                <c:pt idx="158">
                  <c:v>620.65466309999999</c:v>
                </c:pt>
                <c:pt idx="159">
                  <c:v>621.08721920000005</c:v>
                </c:pt>
                <c:pt idx="160">
                  <c:v>604.79626459999997</c:v>
                </c:pt>
                <c:pt idx="161">
                  <c:v>604.74975589999997</c:v>
                </c:pt>
                <c:pt idx="162">
                  <c:v>592.79223630000001</c:v>
                </c:pt>
                <c:pt idx="163">
                  <c:v>587.95135500000004</c:v>
                </c:pt>
                <c:pt idx="164">
                  <c:v>572.36822510000002</c:v>
                </c:pt>
                <c:pt idx="165">
                  <c:v>568.07464600000003</c:v>
                </c:pt>
                <c:pt idx="166">
                  <c:v>568.17687990000002</c:v>
                </c:pt>
                <c:pt idx="167">
                  <c:v>552.61236570000005</c:v>
                </c:pt>
                <c:pt idx="168">
                  <c:v>536.8826904</c:v>
                </c:pt>
                <c:pt idx="169">
                  <c:v>530.65759279999997</c:v>
                </c:pt>
                <c:pt idx="170">
                  <c:v>522.56109619999995</c:v>
                </c:pt>
                <c:pt idx="171">
                  <c:v>510.36257929999999</c:v>
                </c:pt>
                <c:pt idx="172">
                  <c:v>510.03460689999997</c:v>
                </c:pt>
                <c:pt idx="173">
                  <c:v>485.9931335</c:v>
                </c:pt>
                <c:pt idx="174">
                  <c:v>484.63912959999999</c:v>
                </c:pt>
                <c:pt idx="175">
                  <c:v>474.28665160000003</c:v>
                </c:pt>
                <c:pt idx="176">
                  <c:v>458.66595460000002</c:v>
                </c:pt>
                <c:pt idx="177">
                  <c:v>454.12445070000001</c:v>
                </c:pt>
                <c:pt idx="178">
                  <c:v>453.5197144</c:v>
                </c:pt>
                <c:pt idx="179">
                  <c:v>437.09158330000002</c:v>
                </c:pt>
                <c:pt idx="180">
                  <c:v>419.60140990000002</c:v>
                </c:pt>
                <c:pt idx="181">
                  <c:v>410.45791630000002</c:v>
                </c:pt>
                <c:pt idx="182">
                  <c:v>402.37756350000001</c:v>
                </c:pt>
                <c:pt idx="183">
                  <c:v>396.94192500000003</c:v>
                </c:pt>
                <c:pt idx="184">
                  <c:v>379.43814090000001</c:v>
                </c:pt>
                <c:pt idx="185">
                  <c:v>371.93463129999998</c:v>
                </c:pt>
                <c:pt idx="186">
                  <c:v>364.93548579999998</c:v>
                </c:pt>
                <c:pt idx="187">
                  <c:v>355.32022089999998</c:v>
                </c:pt>
                <c:pt idx="188">
                  <c:v>354.19332889999998</c:v>
                </c:pt>
                <c:pt idx="189">
                  <c:v>338.37725829999999</c:v>
                </c:pt>
                <c:pt idx="190">
                  <c:v>336.62649540000001</c:v>
                </c:pt>
                <c:pt idx="191">
                  <c:v>322.38226320000001</c:v>
                </c:pt>
                <c:pt idx="192">
                  <c:v>311.87783810000002</c:v>
                </c:pt>
                <c:pt idx="193">
                  <c:v>307.95089719999999</c:v>
                </c:pt>
                <c:pt idx="194">
                  <c:v>295.89697269999999</c:v>
                </c:pt>
                <c:pt idx="195">
                  <c:v>285.7920532</c:v>
                </c:pt>
                <c:pt idx="196">
                  <c:v>289.47116089999997</c:v>
                </c:pt>
                <c:pt idx="197">
                  <c:v>279.53042599999998</c:v>
                </c:pt>
                <c:pt idx="198">
                  <c:v>266.65072629999997</c:v>
                </c:pt>
                <c:pt idx="199">
                  <c:v>265.39733890000002</c:v>
                </c:pt>
                <c:pt idx="200">
                  <c:v>255.7288666</c:v>
                </c:pt>
                <c:pt idx="201">
                  <c:v>248.5062561</c:v>
                </c:pt>
                <c:pt idx="202">
                  <c:v>241.5475922</c:v>
                </c:pt>
                <c:pt idx="203">
                  <c:v>234.25724790000001</c:v>
                </c:pt>
                <c:pt idx="204">
                  <c:v>230.37890630000001</c:v>
                </c:pt>
                <c:pt idx="205">
                  <c:v>226.61877440000001</c:v>
                </c:pt>
                <c:pt idx="206">
                  <c:v>213.14585880000001</c:v>
                </c:pt>
                <c:pt idx="207">
                  <c:v>211.568634</c:v>
                </c:pt>
                <c:pt idx="208">
                  <c:v>200.45037840000001</c:v>
                </c:pt>
                <c:pt idx="209">
                  <c:v>201.7784576</c:v>
                </c:pt>
                <c:pt idx="210">
                  <c:v>191.62731930000001</c:v>
                </c:pt>
                <c:pt idx="211">
                  <c:v>185.49462890000001</c:v>
                </c:pt>
                <c:pt idx="212">
                  <c:v>183.77522279999999</c:v>
                </c:pt>
                <c:pt idx="213">
                  <c:v>176.5396576</c:v>
                </c:pt>
                <c:pt idx="214">
                  <c:v>175.06060790000001</c:v>
                </c:pt>
                <c:pt idx="215">
                  <c:v>162.4313507</c:v>
                </c:pt>
                <c:pt idx="216">
                  <c:v>159.93589779999999</c:v>
                </c:pt>
                <c:pt idx="217">
                  <c:v>153.41217040000001</c:v>
                </c:pt>
                <c:pt idx="218">
                  <c:v>152.913681</c:v>
                </c:pt>
                <c:pt idx="219">
                  <c:v>149.4410858</c:v>
                </c:pt>
                <c:pt idx="220">
                  <c:v>138.26713559999999</c:v>
                </c:pt>
                <c:pt idx="221">
                  <c:v>134.54368590000001</c:v>
                </c:pt>
                <c:pt idx="222">
                  <c:v>132.0306549</c:v>
                </c:pt>
                <c:pt idx="223">
                  <c:v>129.92349239999999</c:v>
                </c:pt>
                <c:pt idx="224">
                  <c:v>127.9116745</c:v>
                </c:pt>
                <c:pt idx="225">
                  <c:v>124.6372528</c:v>
                </c:pt>
                <c:pt idx="226">
                  <c:v>117.73496249999999</c:v>
                </c:pt>
                <c:pt idx="227">
                  <c:v>115.2923965</c:v>
                </c:pt>
                <c:pt idx="228">
                  <c:v>109.3977814</c:v>
                </c:pt>
                <c:pt idx="229">
                  <c:v>109.630394</c:v>
                </c:pt>
                <c:pt idx="230">
                  <c:v>103.79203029999999</c:v>
                </c:pt>
                <c:pt idx="231">
                  <c:v>103.1727219</c:v>
                </c:pt>
                <c:pt idx="232">
                  <c:v>98.361534120000002</c:v>
                </c:pt>
                <c:pt idx="233">
                  <c:v>96.537261959999995</c:v>
                </c:pt>
                <c:pt idx="234">
                  <c:v>91.722328189999999</c:v>
                </c:pt>
                <c:pt idx="235">
                  <c:v>88.110260010000005</c:v>
                </c:pt>
                <c:pt idx="236">
                  <c:v>89.283805849999993</c:v>
                </c:pt>
                <c:pt idx="237">
                  <c:v>85.377426150000005</c:v>
                </c:pt>
                <c:pt idx="238">
                  <c:v>83.457473750000005</c:v>
                </c:pt>
                <c:pt idx="239">
                  <c:v>81.180236820000005</c:v>
                </c:pt>
                <c:pt idx="240">
                  <c:v>79.448989870000005</c:v>
                </c:pt>
                <c:pt idx="241">
                  <c:v>77.287887569999995</c:v>
                </c:pt>
                <c:pt idx="242">
                  <c:v>73.700965879999998</c:v>
                </c:pt>
                <c:pt idx="243">
                  <c:v>70.642303470000002</c:v>
                </c:pt>
                <c:pt idx="244">
                  <c:v>66.586799619999994</c:v>
                </c:pt>
                <c:pt idx="245">
                  <c:v>65.153785709999994</c:v>
                </c:pt>
                <c:pt idx="246">
                  <c:v>64.86733246</c:v>
                </c:pt>
                <c:pt idx="247">
                  <c:v>62.175815579999998</c:v>
                </c:pt>
                <c:pt idx="248">
                  <c:v>63.004688260000002</c:v>
                </c:pt>
                <c:pt idx="249">
                  <c:v>59.437870029999999</c:v>
                </c:pt>
                <c:pt idx="250">
                  <c:v>53.930343630000003</c:v>
                </c:pt>
                <c:pt idx="251">
                  <c:v>54.842369079999997</c:v>
                </c:pt>
                <c:pt idx="252">
                  <c:v>53.368003850000001</c:v>
                </c:pt>
                <c:pt idx="253">
                  <c:v>51.564083099999998</c:v>
                </c:pt>
                <c:pt idx="254">
                  <c:v>51.07436371</c:v>
                </c:pt>
                <c:pt idx="255">
                  <c:v>50.693023680000003</c:v>
                </c:pt>
                <c:pt idx="256">
                  <c:v>46.868377690000003</c:v>
                </c:pt>
                <c:pt idx="257">
                  <c:v>44.058345789999997</c:v>
                </c:pt>
                <c:pt idx="258">
                  <c:v>42.753692630000003</c:v>
                </c:pt>
                <c:pt idx="259">
                  <c:v>42.514862059999999</c:v>
                </c:pt>
                <c:pt idx="260">
                  <c:v>39.493518829999999</c:v>
                </c:pt>
                <c:pt idx="261">
                  <c:v>39.29284286</c:v>
                </c:pt>
                <c:pt idx="262">
                  <c:v>37.449222560000003</c:v>
                </c:pt>
                <c:pt idx="263">
                  <c:v>39.036457059999996</c:v>
                </c:pt>
                <c:pt idx="264">
                  <c:v>35.382896420000002</c:v>
                </c:pt>
                <c:pt idx="265">
                  <c:v>34.097858430000002</c:v>
                </c:pt>
                <c:pt idx="266">
                  <c:v>33.770862579999999</c:v>
                </c:pt>
                <c:pt idx="267">
                  <c:v>32.387985229999998</c:v>
                </c:pt>
                <c:pt idx="268">
                  <c:v>32.548912049999998</c:v>
                </c:pt>
                <c:pt idx="269">
                  <c:v>31.076675420000001</c:v>
                </c:pt>
                <c:pt idx="270">
                  <c:v>28.141368870000001</c:v>
                </c:pt>
                <c:pt idx="271">
                  <c:v>28.477787020000001</c:v>
                </c:pt>
                <c:pt idx="272">
                  <c:v>28.046638489999999</c:v>
                </c:pt>
                <c:pt idx="273">
                  <c:v>25.472141270000002</c:v>
                </c:pt>
                <c:pt idx="274">
                  <c:v>27.620355610000001</c:v>
                </c:pt>
                <c:pt idx="275">
                  <c:v>25.755998609999999</c:v>
                </c:pt>
                <c:pt idx="276">
                  <c:v>24.190099719999999</c:v>
                </c:pt>
                <c:pt idx="277">
                  <c:v>22.273309709999999</c:v>
                </c:pt>
                <c:pt idx="278">
                  <c:v>24.1129055</c:v>
                </c:pt>
                <c:pt idx="279">
                  <c:v>22.07912636</c:v>
                </c:pt>
                <c:pt idx="280">
                  <c:v>20.349245069999998</c:v>
                </c:pt>
                <c:pt idx="281">
                  <c:v>21.273267749999999</c:v>
                </c:pt>
                <c:pt idx="282">
                  <c:v>19.85430908</c:v>
                </c:pt>
                <c:pt idx="283">
                  <c:v>19.862222670000001</c:v>
                </c:pt>
                <c:pt idx="284">
                  <c:v>17.40071678</c:v>
                </c:pt>
                <c:pt idx="285">
                  <c:v>17.5621376</c:v>
                </c:pt>
                <c:pt idx="286">
                  <c:v>21.563310619999999</c:v>
                </c:pt>
                <c:pt idx="287">
                  <c:v>31.05051422</c:v>
                </c:pt>
                <c:pt idx="288">
                  <c:v>54.618350980000002</c:v>
                </c:pt>
                <c:pt idx="289">
                  <c:v>100.66961670000001</c:v>
                </c:pt>
                <c:pt idx="290">
                  <c:v>161.21783450000001</c:v>
                </c:pt>
              </c:numCache>
            </c:numRef>
          </c:yVal>
          <c:smooth val="1"/>
          <c:extLst>
            <c:ext xmlns:c16="http://schemas.microsoft.com/office/drawing/2014/chart" uri="{C3380CC4-5D6E-409C-BE32-E72D297353CC}">
              <c16:uniqueId val="{00000002-23D1-4D6B-8D95-E81ABA7C315A}"/>
            </c:ext>
          </c:extLst>
        </c:ser>
        <c:ser>
          <c:idx val="0"/>
          <c:order val="3"/>
          <c:tx>
            <c:strRef>
              <c:f>INK!$I$1</c:f>
              <c:strCache>
                <c:ptCount val="1"/>
                <c:pt idx="0">
                  <c:v>INK128 (16 µM) DMSO Emission</c:v>
                </c:pt>
              </c:strCache>
            </c:strRef>
          </c:tx>
          <c:marker>
            <c:symbol val="none"/>
          </c:marker>
          <c:xVal>
            <c:numRef>
              <c:f>INK!$I$3:$I$293</c:f>
              <c:numCache>
                <c:formatCode>General</c:formatCode>
                <c:ptCount val="291"/>
                <c:pt idx="0">
                  <c:v>310</c:v>
                </c:pt>
                <c:pt idx="1">
                  <c:v>311.07000729999999</c:v>
                </c:pt>
                <c:pt idx="2">
                  <c:v>312</c:v>
                </c:pt>
                <c:pt idx="3">
                  <c:v>313.07000729999999</c:v>
                </c:pt>
                <c:pt idx="4">
                  <c:v>314</c:v>
                </c:pt>
                <c:pt idx="5">
                  <c:v>315.07000729999999</c:v>
                </c:pt>
                <c:pt idx="6">
                  <c:v>316</c:v>
                </c:pt>
                <c:pt idx="7">
                  <c:v>317.07000729999999</c:v>
                </c:pt>
                <c:pt idx="8">
                  <c:v>318</c:v>
                </c:pt>
                <c:pt idx="9">
                  <c:v>319.07000729999999</c:v>
                </c:pt>
                <c:pt idx="10">
                  <c:v>320</c:v>
                </c:pt>
                <c:pt idx="11">
                  <c:v>321.07000729999999</c:v>
                </c:pt>
                <c:pt idx="12">
                  <c:v>322</c:v>
                </c:pt>
                <c:pt idx="13">
                  <c:v>323.07000729999999</c:v>
                </c:pt>
                <c:pt idx="14">
                  <c:v>324</c:v>
                </c:pt>
                <c:pt idx="15">
                  <c:v>325.07000729999999</c:v>
                </c:pt>
                <c:pt idx="16">
                  <c:v>326</c:v>
                </c:pt>
                <c:pt idx="17">
                  <c:v>327.07000729999999</c:v>
                </c:pt>
                <c:pt idx="18">
                  <c:v>328</c:v>
                </c:pt>
                <c:pt idx="19">
                  <c:v>329.07000729999999</c:v>
                </c:pt>
                <c:pt idx="20">
                  <c:v>330</c:v>
                </c:pt>
                <c:pt idx="21">
                  <c:v>331.07000729999999</c:v>
                </c:pt>
                <c:pt idx="22">
                  <c:v>332</c:v>
                </c:pt>
                <c:pt idx="23">
                  <c:v>333.07000729999999</c:v>
                </c:pt>
                <c:pt idx="24">
                  <c:v>334</c:v>
                </c:pt>
                <c:pt idx="25">
                  <c:v>335.07000729999999</c:v>
                </c:pt>
                <c:pt idx="26">
                  <c:v>336</c:v>
                </c:pt>
                <c:pt idx="27">
                  <c:v>337.07000729999999</c:v>
                </c:pt>
                <c:pt idx="28">
                  <c:v>338</c:v>
                </c:pt>
                <c:pt idx="29">
                  <c:v>339.07000729999999</c:v>
                </c:pt>
                <c:pt idx="30">
                  <c:v>340</c:v>
                </c:pt>
                <c:pt idx="31">
                  <c:v>341.05999759999997</c:v>
                </c:pt>
                <c:pt idx="32">
                  <c:v>341.9599915</c:v>
                </c:pt>
                <c:pt idx="33">
                  <c:v>343.02999879999999</c:v>
                </c:pt>
                <c:pt idx="34">
                  <c:v>343.92999270000001</c:v>
                </c:pt>
                <c:pt idx="35">
                  <c:v>345</c:v>
                </c:pt>
                <c:pt idx="36">
                  <c:v>346.05999759999997</c:v>
                </c:pt>
                <c:pt idx="37">
                  <c:v>346.9599915</c:v>
                </c:pt>
                <c:pt idx="38">
                  <c:v>348.02999879999999</c:v>
                </c:pt>
                <c:pt idx="39">
                  <c:v>348.92999270000001</c:v>
                </c:pt>
                <c:pt idx="40">
                  <c:v>350</c:v>
                </c:pt>
                <c:pt idx="41">
                  <c:v>351.07000729999999</c:v>
                </c:pt>
                <c:pt idx="42">
                  <c:v>352</c:v>
                </c:pt>
                <c:pt idx="43">
                  <c:v>353.07000729999999</c:v>
                </c:pt>
                <c:pt idx="44">
                  <c:v>354</c:v>
                </c:pt>
                <c:pt idx="45">
                  <c:v>355.07000729999999</c:v>
                </c:pt>
                <c:pt idx="46">
                  <c:v>356</c:v>
                </c:pt>
                <c:pt idx="47">
                  <c:v>357.07000729999999</c:v>
                </c:pt>
                <c:pt idx="48">
                  <c:v>358</c:v>
                </c:pt>
                <c:pt idx="49">
                  <c:v>359.07000729999999</c:v>
                </c:pt>
                <c:pt idx="50">
                  <c:v>360</c:v>
                </c:pt>
                <c:pt idx="51">
                  <c:v>361.07000729999999</c:v>
                </c:pt>
                <c:pt idx="52">
                  <c:v>362</c:v>
                </c:pt>
                <c:pt idx="53">
                  <c:v>363.07000729999999</c:v>
                </c:pt>
                <c:pt idx="54">
                  <c:v>364</c:v>
                </c:pt>
                <c:pt idx="55">
                  <c:v>365.07000729999999</c:v>
                </c:pt>
                <c:pt idx="56">
                  <c:v>366</c:v>
                </c:pt>
                <c:pt idx="57">
                  <c:v>367.07000729999999</c:v>
                </c:pt>
                <c:pt idx="58">
                  <c:v>368</c:v>
                </c:pt>
                <c:pt idx="59">
                  <c:v>369.07000729999999</c:v>
                </c:pt>
                <c:pt idx="60">
                  <c:v>370</c:v>
                </c:pt>
                <c:pt idx="61">
                  <c:v>371.05999759999997</c:v>
                </c:pt>
                <c:pt idx="62">
                  <c:v>371.9599915</c:v>
                </c:pt>
                <c:pt idx="63">
                  <c:v>373.02999879999999</c:v>
                </c:pt>
                <c:pt idx="64">
                  <c:v>373.92999270000001</c:v>
                </c:pt>
                <c:pt idx="65">
                  <c:v>375</c:v>
                </c:pt>
                <c:pt idx="66">
                  <c:v>376.05999759999997</c:v>
                </c:pt>
                <c:pt idx="67">
                  <c:v>376.9599915</c:v>
                </c:pt>
                <c:pt idx="68">
                  <c:v>378.02999879999999</c:v>
                </c:pt>
                <c:pt idx="69">
                  <c:v>378.92999270000001</c:v>
                </c:pt>
                <c:pt idx="70">
                  <c:v>380</c:v>
                </c:pt>
                <c:pt idx="71">
                  <c:v>381.07000729999999</c:v>
                </c:pt>
                <c:pt idx="72">
                  <c:v>382</c:v>
                </c:pt>
                <c:pt idx="73">
                  <c:v>383.07000729999999</c:v>
                </c:pt>
                <c:pt idx="74">
                  <c:v>384</c:v>
                </c:pt>
                <c:pt idx="75">
                  <c:v>385.07000729999999</c:v>
                </c:pt>
                <c:pt idx="76">
                  <c:v>386</c:v>
                </c:pt>
                <c:pt idx="77">
                  <c:v>387.07000729999999</c:v>
                </c:pt>
                <c:pt idx="78">
                  <c:v>388</c:v>
                </c:pt>
                <c:pt idx="79">
                  <c:v>389.07000729999999</c:v>
                </c:pt>
                <c:pt idx="80">
                  <c:v>390</c:v>
                </c:pt>
                <c:pt idx="81">
                  <c:v>391.05999759999997</c:v>
                </c:pt>
                <c:pt idx="82">
                  <c:v>391.9599915</c:v>
                </c:pt>
                <c:pt idx="83">
                  <c:v>393.02999879999999</c:v>
                </c:pt>
                <c:pt idx="84">
                  <c:v>393.92999270000001</c:v>
                </c:pt>
                <c:pt idx="85">
                  <c:v>395</c:v>
                </c:pt>
                <c:pt idx="86">
                  <c:v>396.05999759999997</c:v>
                </c:pt>
                <c:pt idx="87">
                  <c:v>396.9599915</c:v>
                </c:pt>
                <c:pt idx="88">
                  <c:v>398.02999879999999</c:v>
                </c:pt>
                <c:pt idx="89">
                  <c:v>398.92999270000001</c:v>
                </c:pt>
                <c:pt idx="90">
                  <c:v>400</c:v>
                </c:pt>
                <c:pt idx="91">
                  <c:v>401.05999759999997</c:v>
                </c:pt>
                <c:pt idx="92">
                  <c:v>401.9599915</c:v>
                </c:pt>
                <c:pt idx="93">
                  <c:v>403.02999879999999</c:v>
                </c:pt>
                <c:pt idx="94">
                  <c:v>403.92999270000001</c:v>
                </c:pt>
                <c:pt idx="95">
                  <c:v>405</c:v>
                </c:pt>
                <c:pt idx="96">
                  <c:v>406.05999759999997</c:v>
                </c:pt>
                <c:pt idx="97">
                  <c:v>406.9599915</c:v>
                </c:pt>
                <c:pt idx="98">
                  <c:v>408.02999879999999</c:v>
                </c:pt>
                <c:pt idx="99">
                  <c:v>408.92999270000001</c:v>
                </c:pt>
                <c:pt idx="100">
                  <c:v>410</c:v>
                </c:pt>
                <c:pt idx="101">
                  <c:v>411.05999759999997</c:v>
                </c:pt>
                <c:pt idx="102">
                  <c:v>411.9599915</c:v>
                </c:pt>
                <c:pt idx="103">
                  <c:v>413.02999879999999</c:v>
                </c:pt>
                <c:pt idx="104">
                  <c:v>413.92999270000001</c:v>
                </c:pt>
                <c:pt idx="105">
                  <c:v>415</c:v>
                </c:pt>
                <c:pt idx="106">
                  <c:v>416.05999759999997</c:v>
                </c:pt>
                <c:pt idx="107">
                  <c:v>416.9599915</c:v>
                </c:pt>
                <c:pt idx="108">
                  <c:v>418.02999879999999</c:v>
                </c:pt>
                <c:pt idx="109">
                  <c:v>418.92999270000001</c:v>
                </c:pt>
                <c:pt idx="110">
                  <c:v>420</c:v>
                </c:pt>
                <c:pt idx="111">
                  <c:v>421.05999759999997</c:v>
                </c:pt>
                <c:pt idx="112">
                  <c:v>421.9599915</c:v>
                </c:pt>
                <c:pt idx="113">
                  <c:v>423.02999879999999</c:v>
                </c:pt>
                <c:pt idx="114">
                  <c:v>423.92999270000001</c:v>
                </c:pt>
                <c:pt idx="115">
                  <c:v>425</c:v>
                </c:pt>
                <c:pt idx="116">
                  <c:v>426.05999759999997</c:v>
                </c:pt>
                <c:pt idx="117">
                  <c:v>426.9599915</c:v>
                </c:pt>
                <c:pt idx="118">
                  <c:v>428.02999879999999</c:v>
                </c:pt>
                <c:pt idx="119">
                  <c:v>428.92999270000001</c:v>
                </c:pt>
                <c:pt idx="120">
                  <c:v>430</c:v>
                </c:pt>
                <c:pt idx="121">
                  <c:v>431.05999759999997</c:v>
                </c:pt>
                <c:pt idx="122">
                  <c:v>431.9599915</c:v>
                </c:pt>
                <c:pt idx="123">
                  <c:v>433.02999879999999</c:v>
                </c:pt>
                <c:pt idx="124">
                  <c:v>433.92999270000001</c:v>
                </c:pt>
                <c:pt idx="125">
                  <c:v>435</c:v>
                </c:pt>
                <c:pt idx="126">
                  <c:v>436.05999759999997</c:v>
                </c:pt>
                <c:pt idx="127">
                  <c:v>436.9599915</c:v>
                </c:pt>
                <c:pt idx="128">
                  <c:v>438.02999879999999</c:v>
                </c:pt>
                <c:pt idx="129">
                  <c:v>438.92999270000001</c:v>
                </c:pt>
                <c:pt idx="130">
                  <c:v>440</c:v>
                </c:pt>
                <c:pt idx="131">
                  <c:v>441.05999759999997</c:v>
                </c:pt>
                <c:pt idx="132">
                  <c:v>441.9599915</c:v>
                </c:pt>
                <c:pt idx="133">
                  <c:v>443.02999879999999</c:v>
                </c:pt>
                <c:pt idx="134">
                  <c:v>443.92999270000001</c:v>
                </c:pt>
                <c:pt idx="135">
                  <c:v>445</c:v>
                </c:pt>
                <c:pt idx="136">
                  <c:v>446.05999759999997</c:v>
                </c:pt>
                <c:pt idx="137">
                  <c:v>446.9599915</c:v>
                </c:pt>
                <c:pt idx="138">
                  <c:v>448.02999879999999</c:v>
                </c:pt>
                <c:pt idx="139">
                  <c:v>448.92999270000001</c:v>
                </c:pt>
                <c:pt idx="140">
                  <c:v>450</c:v>
                </c:pt>
                <c:pt idx="141">
                  <c:v>451.0400085</c:v>
                </c:pt>
                <c:pt idx="142">
                  <c:v>451.94000240000003</c:v>
                </c:pt>
                <c:pt idx="143">
                  <c:v>452.98001099999999</c:v>
                </c:pt>
                <c:pt idx="144">
                  <c:v>454.01998900000001</c:v>
                </c:pt>
                <c:pt idx="145">
                  <c:v>455.07000729999999</c:v>
                </c:pt>
                <c:pt idx="146">
                  <c:v>455.97000120000001</c:v>
                </c:pt>
                <c:pt idx="147">
                  <c:v>457.01000979999998</c:v>
                </c:pt>
                <c:pt idx="148">
                  <c:v>458.0499878</c:v>
                </c:pt>
                <c:pt idx="149">
                  <c:v>458.9500122</c:v>
                </c:pt>
                <c:pt idx="150">
                  <c:v>460</c:v>
                </c:pt>
                <c:pt idx="151">
                  <c:v>461.05999759999997</c:v>
                </c:pt>
                <c:pt idx="152">
                  <c:v>461.9599915</c:v>
                </c:pt>
                <c:pt idx="153">
                  <c:v>463.02999879999999</c:v>
                </c:pt>
                <c:pt idx="154">
                  <c:v>463.92999270000001</c:v>
                </c:pt>
                <c:pt idx="155">
                  <c:v>465</c:v>
                </c:pt>
                <c:pt idx="156">
                  <c:v>466.05999759999997</c:v>
                </c:pt>
                <c:pt idx="157">
                  <c:v>466.9599915</c:v>
                </c:pt>
                <c:pt idx="158">
                  <c:v>468.02999879999999</c:v>
                </c:pt>
                <c:pt idx="159">
                  <c:v>468.92999270000001</c:v>
                </c:pt>
                <c:pt idx="160">
                  <c:v>470</c:v>
                </c:pt>
                <c:pt idx="161">
                  <c:v>471.0400085</c:v>
                </c:pt>
                <c:pt idx="162">
                  <c:v>471.94000240000003</c:v>
                </c:pt>
                <c:pt idx="163">
                  <c:v>472.98001099999999</c:v>
                </c:pt>
                <c:pt idx="164">
                  <c:v>474.01998900000001</c:v>
                </c:pt>
                <c:pt idx="165">
                  <c:v>475.07000729999999</c:v>
                </c:pt>
                <c:pt idx="166">
                  <c:v>475.97000120000001</c:v>
                </c:pt>
                <c:pt idx="167">
                  <c:v>477.01000979999998</c:v>
                </c:pt>
                <c:pt idx="168">
                  <c:v>478.0499878</c:v>
                </c:pt>
                <c:pt idx="169">
                  <c:v>478.9500122</c:v>
                </c:pt>
                <c:pt idx="170">
                  <c:v>480</c:v>
                </c:pt>
                <c:pt idx="171">
                  <c:v>481.0400085</c:v>
                </c:pt>
                <c:pt idx="172">
                  <c:v>481.94000240000003</c:v>
                </c:pt>
                <c:pt idx="173">
                  <c:v>482.98001099999999</c:v>
                </c:pt>
                <c:pt idx="174">
                  <c:v>484.01998900000001</c:v>
                </c:pt>
                <c:pt idx="175">
                  <c:v>485.07000729999999</c:v>
                </c:pt>
                <c:pt idx="176">
                  <c:v>485.97000120000001</c:v>
                </c:pt>
                <c:pt idx="177">
                  <c:v>487.01000979999998</c:v>
                </c:pt>
                <c:pt idx="178">
                  <c:v>488.0499878</c:v>
                </c:pt>
                <c:pt idx="179">
                  <c:v>488.9500122</c:v>
                </c:pt>
                <c:pt idx="180">
                  <c:v>490</c:v>
                </c:pt>
                <c:pt idx="181">
                  <c:v>491.0400085</c:v>
                </c:pt>
                <c:pt idx="182">
                  <c:v>491.94000240000003</c:v>
                </c:pt>
                <c:pt idx="183">
                  <c:v>492.98001099999999</c:v>
                </c:pt>
                <c:pt idx="184">
                  <c:v>494.01998900000001</c:v>
                </c:pt>
                <c:pt idx="185">
                  <c:v>495.07000729999999</c:v>
                </c:pt>
                <c:pt idx="186">
                  <c:v>495.97000120000001</c:v>
                </c:pt>
                <c:pt idx="187">
                  <c:v>497.01000979999998</c:v>
                </c:pt>
                <c:pt idx="188">
                  <c:v>498.0499878</c:v>
                </c:pt>
                <c:pt idx="189">
                  <c:v>498.9500122</c:v>
                </c:pt>
                <c:pt idx="190">
                  <c:v>500</c:v>
                </c:pt>
                <c:pt idx="191">
                  <c:v>501.0400085</c:v>
                </c:pt>
                <c:pt idx="192">
                  <c:v>501.94000240000003</c:v>
                </c:pt>
                <c:pt idx="193">
                  <c:v>502.98001099999999</c:v>
                </c:pt>
                <c:pt idx="194">
                  <c:v>504.01998900000001</c:v>
                </c:pt>
                <c:pt idx="195">
                  <c:v>505.07000729999999</c:v>
                </c:pt>
                <c:pt idx="196">
                  <c:v>505.97000120000001</c:v>
                </c:pt>
                <c:pt idx="197">
                  <c:v>507.01000979999998</c:v>
                </c:pt>
                <c:pt idx="198">
                  <c:v>508.0499878</c:v>
                </c:pt>
                <c:pt idx="199">
                  <c:v>508.9500122</c:v>
                </c:pt>
                <c:pt idx="200">
                  <c:v>510</c:v>
                </c:pt>
                <c:pt idx="201">
                  <c:v>511.0400085</c:v>
                </c:pt>
                <c:pt idx="202">
                  <c:v>511.94000240000003</c:v>
                </c:pt>
                <c:pt idx="203">
                  <c:v>512.97998050000001</c:v>
                </c:pt>
                <c:pt idx="204">
                  <c:v>514.02001949999999</c:v>
                </c:pt>
                <c:pt idx="205">
                  <c:v>515.07000730000004</c:v>
                </c:pt>
                <c:pt idx="206">
                  <c:v>515.96997069999998</c:v>
                </c:pt>
                <c:pt idx="207">
                  <c:v>517.01000980000003</c:v>
                </c:pt>
                <c:pt idx="208">
                  <c:v>518.04998780000005</c:v>
                </c:pt>
                <c:pt idx="209">
                  <c:v>518.95001219999995</c:v>
                </c:pt>
                <c:pt idx="210">
                  <c:v>520</c:v>
                </c:pt>
                <c:pt idx="211">
                  <c:v>521.03997800000002</c:v>
                </c:pt>
                <c:pt idx="212">
                  <c:v>521.94000240000003</c:v>
                </c:pt>
                <c:pt idx="213">
                  <c:v>522.97998050000001</c:v>
                </c:pt>
                <c:pt idx="214">
                  <c:v>524.02001949999999</c:v>
                </c:pt>
                <c:pt idx="215">
                  <c:v>525.07000730000004</c:v>
                </c:pt>
                <c:pt idx="216">
                  <c:v>525.96997069999998</c:v>
                </c:pt>
                <c:pt idx="217">
                  <c:v>527.01000980000003</c:v>
                </c:pt>
                <c:pt idx="218">
                  <c:v>528.04998780000005</c:v>
                </c:pt>
                <c:pt idx="219">
                  <c:v>528.95001219999995</c:v>
                </c:pt>
                <c:pt idx="220">
                  <c:v>530</c:v>
                </c:pt>
                <c:pt idx="221">
                  <c:v>531.02001949999999</c:v>
                </c:pt>
                <c:pt idx="222">
                  <c:v>532.04998780000005</c:v>
                </c:pt>
                <c:pt idx="223">
                  <c:v>532.94000240000003</c:v>
                </c:pt>
                <c:pt idx="224">
                  <c:v>533.96997069999998</c:v>
                </c:pt>
                <c:pt idx="225">
                  <c:v>535</c:v>
                </c:pt>
                <c:pt idx="226">
                  <c:v>536.02001949999999</c:v>
                </c:pt>
                <c:pt idx="227">
                  <c:v>537.04998780000005</c:v>
                </c:pt>
                <c:pt idx="228">
                  <c:v>537.94000240000003</c:v>
                </c:pt>
                <c:pt idx="229">
                  <c:v>538.96997069999998</c:v>
                </c:pt>
                <c:pt idx="230">
                  <c:v>540</c:v>
                </c:pt>
                <c:pt idx="231">
                  <c:v>541.02001949999999</c:v>
                </c:pt>
                <c:pt idx="232">
                  <c:v>542.04998780000005</c:v>
                </c:pt>
                <c:pt idx="233">
                  <c:v>542.94000240000003</c:v>
                </c:pt>
                <c:pt idx="234">
                  <c:v>543.96997069999998</c:v>
                </c:pt>
                <c:pt idx="235">
                  <c:v>545</c:v>
                </c:pt>
                <c:pt idx="236">
                  <c:v>546.02001949999999</c:v>
                </c:pt>
                <c:pt idx="237">
                  <c:v>547.04998780000005</c:v>
                </c:pt>
                <c:pt idx="238">
                  <c:v>547.94000240000003</c:v>
                </c:pt>
                <c:pt idx="239">
                  <c:v>548.96997069999998</c:v>
                </c:pt>
                <c:pt idx="240">
                  <c:v>550</c:v>
                </c:pt>
                <c:pt idx="241">
                  <c:v>551.02001949999999</c:v>
                </c:pt>
                <c:pt idx="242">
                  <c:v>552.04998780000005</c:v>
                </c:pt>
                <c:pt idx="243">
                  <c:v>552.94000240000003</c:v>
                </c:pt>
                <c:pt idx="244">
                  <c:v>553.96997069999998</c:v>
                </c:pt>
                <c:pt idx="245">
                  <c:v>555</c:v>
                </c:pt>
                <c:pt idx="246">
                  <c:v>556.02001949999999</c:v>
                </c:pt>
                <c:pt idx="247">
                  <c:v>557.04998780000005</c:v>
                </c:pt>
                <c:pt idx="248">
                  <c:v>557.94000240000003</c:v>
                </c:pt>
                <c:pt idx="249">
                  <c:v>558.96997069999998</c:v>
                </c:pt>
                <c:pt idx="250">
                  <c:v>560</c:v>
                </c:pt>
                <c:pt idx="251">
                  <c:v>561.02001949999999</c:v>
                </c:pt>
                <c:pt idx="252">
                  <c:v>562.04998780000005</c:v>
                </c:pt>
                <c:pt idx="253">
                  <c:v>562.94000240000003</c:v>
                </c:pt>
                <c:pt idx="254">
                  <c:v>563.96997069999998</c:v>
                </c:pt>
                <c:pt idx="255">
                  <c:v>565</c:v>
                </c:pt>
                <c:pt idx="256">
                  <c:v>566.02001949999999</c:v>
                </c:pt>
                <c:pt idx="257">
                  <c:v>567.04998780000005</c:v>
                </c:pt>
                <c:pt idx="258">
                  <c:v>567.94000240000003</c:v>
                </c:pt>
                <c:pt idx="259">
                  <c:v>568.96997069999998</c:v>
                </c:pt>
                <c:pt idx="260">
                  <c:v>570</c:v>
                </c:pt>
                <c:pt idx="261">
                  <c:v>571.02001949999999</c:v>
                </c:pt>
                <c:pt idx="262">
                  <c:v>572.04998780000005</c:v>
                </c:pt>
                <c:pt idx="263">
                  <c:v>572.94000240000003</c:v>
                </c:pt>
                <c:pt idx="264">
                  <c:v>573.96997069999998</c:v>
                </c:pt>
                <c:pt idx="265">
                  <c:v>575</c:v>
                </c:pt>
                <c:pt idx="266">
                  <c:v>576.02001949999999</c:v>
                </c:pt>
                <c:pt idx="267">
                  <c:v>577.04998780000005</c:v>
                </c:pt>
                <c:pt idx="268">
                  <c:v>577.94000240000003</c:v>
                </c:pt>
                <c:pt idx="269">
                  <c:v>578.96997069999998</c:v>
                </c:pt>
                <c:pt idx="270">
                  <c:v>580</c:v>
                </c:pt>
                <c:pt idx="271">
                  <c:v>581.02001949999999</c:v>
                </c:pt>
                <c:pt idx="272">
                  <c:v>582.04998780000005</c:v>
                </c:pt>
                <c:pt idx="273">
                  <c:v>582.94000240000003</c:v>
                </c:pt>
                <c:pt idx="274">
                  <c:v>583.96997069999998</c:v>
                </c:pt>
                <c:pt idx="275">
                  <c:v>585</c:v>
                </c:pt>
                <c:pt idx="276">
                  <c:v>586.02001949999999</c:v>
                </c:pt>
                <c:pt idx="277">
                  <c:v>587.04998780000005</c:v>
                </c:pt>
                <c:pt idx="278">
                  <c:v>587.94000240000003</c:v>
                </c:pt>
                <c:pt idx="279">
                  <c:v>588.96997069999998</c:v>
                </c:pt>
                <c:pt idx="280">
                  <c:v>590</c:v>
                </c:pt>
                <c:pt idx="281">
                  <c:v>591.01000980000003</c:v>
                </c:pt>
                <c:pt idx="282">
                  <c:v>592.02001949999999</c:v>
                </c:pt>
                <c:pt idx="283">
                  <c:v>593.03997800000002</c:v>
                </c:pt>
                <c:pt idx="284">
                  <c:v>594.04998780000005</c:v>
                </c:pt>
                <c:pt idx="285">
                  <c:v>595.07000730000004</c:v>
                </c:pt>
                <c:pt idx="286">
                  <c:v>595.94000240000003</c:v>
                </c:pt>
                <c:pt idx="287">
                  <c:v>596.95001219999995</c:v>
                </c:pt>
                <c:pt idx="288">
                  <c:v>597.96997069999998</c:v>
                </c:pt>
                <c:pt idx="289">
                  <c:v>598.97998050000001</c:v>
                </c:pt>
                <c:pt idx="290">
                  <c:v>600</c:v>
                </c:pt>
              </c:numCache>
            </c:numRef>
          </c:xVal>
          <c:yVal>
            <c:numRef>
              <c:f>INK!$J$3:$J$293</c:f>
              <c:numCache>
                <c:formatCode>General</c:formatCode>
                <c:ptCount val="291"/>
                <c:pt idx="0">
                  <c:v>7.4927001000000004</c:v>
                </c:pt>
                <c:pt idx="1">
                  <c:v>7.7771492000000002</c:v>
                </c:pt>
                <c:pt idx="2">
                  <c:v>8.1750392909999992</c:v>
                </c:pt>
                <c:pt idx="3">
                  <c:v>8.7226142880000008</c:v>
                </c:pt>
                <c:pt idx="4">
                  <c:v>9.3689327240000004</c:v>
                </c:pt>
                <c:pt idx="5">
                  <c:v>9.8571214680000008</c:v>
                </c:pt>
                <c:pt idx="6">
                  <c:v>10.81852531</c:v>
                </c:pt>
                <c:pt idx="7">
                  <c:v>10.818571090000001</c:v>
                </c:pt>
                <c:pt idx="8">
                  <c:v>11.54191494</c:v>
                </c:pt>
                <c:pt idx="9">
                  <c:v>12.14728642</c:v>
                </c:pt>
                <c:pt idx="10">
                  <c:v>12.42483234</c:v>
                </c:pt>
                <c:pt idx="11">
                  <c:v>12.540785789999999</c:v>
                </c:pt>
                <c:pt idx="12">
                  <c:v>14.03181648</c:v>
                </c:pt>
                <c:pt idx="13">
                  <c:v>16.282489779999999</c:v>
                </c:pt>
                <c:pt idx="14">
                  <c:v>16.148748399999999</c:v>
                </c:pt>
                <c:pt idx="15">
                  <c:v>17.795698170000001</c:v>
                </c:pt>
                <c:pt idx="16">
                  <c:v>21.097595210000001</c:v>
                </c:pt>
                <c:pt idx="17">
                  <c:v>24.993177410000001</c:v>
                </c:pt>
                <c:pt idx="18">
                  <c:v>26.021301269999999</c:v>
                </c:pt>
                <c:pt idx="19">
                  <c:v>29.466133119999999</c:v>
                </c:pt>
                <c:pt idx="20">
                  <c:v>32.153171540000002</c:v>
                </c:pt>
                <c:pt idx="21">
                  <c:v>31.017412190000002</c:v>
                </c:pt>
                <c:pt idx="22">
                  <c:v>36.081157679999997</c:v>
                </c:pt>
                <c:pt idx="23">
                  <c:v>37.523601530000001</c:v>
                </c:pt>
                <c:pt idx="24">
                  <c:v>36.948108670000003</c:v>
                </c:pt>
                <c:pt idx="25">
                  <c:v>38.235500340000002</c:v>
                </c:pt>
                <c:pt idx="26">
                  <c:v>39.564128879999998</c:v>
                </c:pt>
                <c:pt idx="27">
                  <c:v>40.612407679999997</c:v>
                </c:pt>
                <c:pt idx="28">
                  <c:v>42.286155700000002</c:v>
                </c:pt>
                <c:pt idx="29">
                  <c:v>44.165298460000002</c:v>
                </c:pt>
                <c:pt idx="30">
                  <c:v>46.217437740000001</c:v>
                </c:pt>
                <c:pt idx="31">
                  <c:v>47.937343599999998</c:v>
                </c:pt>
                <c:pt idx="32">
                  <c:v>50.295127870000002</c:v>
                </c:pt>
                <c:pt idx="33">
                  <c:v>55.204681399999998</c:v>
                </c:pt>
                <c:pt idx="34">
                  <c:v>56.772872919999998</c:v>
                </c:pt>
                <c:pt idx="35">
                  <c:v>60.16770554</c:v>
                </c:pt>
                <c:pt idx="36">
                  <c:v>64.257606510000002</c:v>
                </c:pt>
                <c:pt idx="37">
                  <c:v>66.881378170000005</c:v>
                </c:pt>
                <c:pt idx="38">
                  <c:v>73.016677860000001</c:v>
                </c:pt>
                <c:pt idx="39">
                  <c:v>77.990577700000003</c:v>
                </c:pt>
                <c:pt idx="40">
                  <c:v>80.682884220000005</c:v>
                </c:pt>
                <c:pt idx="41">
                  <c:v>86.921943659999997</c:v>
                </c:pt>
                <c:pt idx="42">
                  <c:v>89.604309079999993</c:v>
                </c:pt>
                <c:pt idx="43">
                  <c:v>95.72641754</c:v>
                </c:pt>
                <c:pt idx="44">
                  <c:v>99.276168819999995</c:v>
                </c:pt>
                <c:pt idx="45">
                  <c:v>104.550972</c:v>
                </c:pt>
                <c:pt idx="46">
                  <c:v>110.2043686</c:v>
                </c:pt>
                <c:pt idx="47">
                  <c:v>118.2915649</c:v>
                </c:pt>
                <c:pt idx="48">
                  <c:v>117.0228195</c:v>
                </c:pt>
                <c:pt idx="49">
                  <c:v>124.9843979</c:v>
                </c:pt>
                <c:pt idx="50">
                  <c:v>129.6330566</c:v>
                </c:pt>
                <c:pt idx="51">
                  <c:v>137.48080440000001</c:v>
                </c:pt>
                <c:pt idx="52">
                  <c:v>141.807785</c:v>
                </c:pt>
                <c:pt idx="53">
                  <c:v>146.1663513</c:v>
                </c:pt>
                <c:pt idx="54">
                  <c:v>152.296402</c:v>
                </c:pt>
                <c:pt idx="55">
                  <c:v>154.87663269999999</c:v>
                </c:pt>
                <c:pt idx="56">
                  <c:v>164.13095089999999</c:v>
                </c:pt>
                <c:pt idx="57">
                  <c:v>165.80595400000001</c:v>
                </c:pt>
                <c:pt idx="58">
                  <c:v>176.90846250000001</c:v>
                </c:pt>
                <c:pt idx="59">
                  <c:v>179.57664489999999</c:v>
                </c:pt>
                <c:pt idx="60">
                  <c:v>181.1258698</c:v>
                </c:pt>
                <c:pt idx="61">
                  <c:v>189.91642759999999</c:v>
                </c:pt>
                <c:pt idx="62">
                  <c:v>191.31883239999999</c:v>
                </c:pt>
                <c:pt idx="63">
                  <c:v>196.71244809999999</c:v>
                </c:pt>
                <c:pt idx="64">
                  <c:v>199.09384159999999</c:v>
                </c:pt>
                <c:pt idx="65">
                  <c:v>203.0338898</c:v>
                </c:pt>
                <c:pt idx="66">
                  <c:v>211.73637389999999</c:v>
                </c:pt>
                <c:pt idx="67">
                  <c:v>217.28938289999999</c:v>
                </c:pt>
                <c:pt idx="68">
                  <c:v>217.3694611</c:v>
                </c:pt>
                <c:pt idx="69">
                  <c:v>225.74090580000001</c:v>
                </c:pt>
                <c:pt idx="70">
                  <c:v>231.69464110000001</c:v>
                </c:pt>
                <c:pt idx="71">
                  <c:v>226.83732599999999</c:v>
                </c:pt>
                <c:pt idx="72">
                  <c:v>226.78070070000001</c:v>
                </c:pt>
                <c:pt idx="73">
                  <c:v>224.4269257</c:v>
                </c:pt>
                <c:pt idx="74">
                  <c:v>232.64668270000001</c:v>
                </c:pt>
                <c:pt idx="75">
                  <c:v>233.25056459999999</c:v>
                </c:pt>
                <c:pt idx="76">
                  <c:v>238.96702579999999</c:v>
                </c:pt>
                <c:pt idx="77">
                  <c:v>239.4076843</c:v>
                </c:pt>
                <c:pt idx="78">
                  <c:v>242.3062286</c:v>
                </c:pt>
                <c:pt idx="79">
                  <c:v>240.71632389999999</c:v>
                </c:pt>
                <c:pt idx="80">
                  <c:v>242.47923280000001</c:v>
                </c:pt>
                <c:pt idx="81">
                  <c:v>247.0108032</c:v>
                </c:pt>
                <c:pt idx="82">
                  <c:v>250.17732240000001</c:v>
                </c:pt>
                <c:pt idx="83">
                  <c:v>248.66198729999999</c:v>
                </c:pt>
                <c:pt idx="84">
                  <c:v>250.96737669999999</c:v>
                </c:pt>
                <c:pt idx="85">
                  <c:v>251.87602229999999</c:v>
                </c:pt>
                <c:pt idx="86">
                  <c:v>244.972702</c:v>
                </c:pt>
                <c:pt idx="87">
                  <c:v>247.47084050000001</c:v>
                </c:pt>
                <c:pt idx="88">
                  <c:v>251.88023380000001</c:v>
                </c:pt>
                <c:pt idx="89">
                  <c:v>244.26013180000001</c:v>
                </c:pt>
                <c:pt idx="90">
                  <c:v>251.562027</c:v>
                </c:pt>
                <c:pt idx="91">
                  <c:v>250.56362920000001</c:v>
                </c:pt>
                <c:pt idx="92">
                  <c:v>246.86410520000001</c:v>
                </c:pt>
                <c:pt idx="93">
                  <c:v>240.57911680000001</c:v>
                </c:pt>
                <c:pt idx="94">
                  <c:v>245.17652889999999</c:v>
                </c:pt>
                <c:pt idx="95">
                  <c:v>247.83265689999999</c:v>
                </c:pt>
                <c:pt idx="96">
                  <c:v>241.44769289999999</c:v>
                </c:pt>
                <c:pt idx="97">
                  <c:v>235.7538605</c:v>
                </c:pt>
                <c:pt idx="98">
                  <c:v>239.24629210000001</c:v>
                </c:pt>
                <c:pt idx="99">
                  <c:v>234.13745119999999</c:v>
                </c:pt>
                <c:pt idx="100">
                  <c:v>235.42057800000001</c:v>
                </c:pt>
                <c:pt idx="101">
                  <c:v>230.87773129999999</c:v>
                </c:pt>
                <c:pt idx="102">
                  <c:v>223.13934330000001</c:v>
                </c:pt>
                <c:pt idx="103">
                  <c:v>225.92156979999999</c:v>
                </c:pt>
                <c:pt idx="104">
                  <c:v>219.24281310000001</c:v>
                </c:pt>
                <c:pt idx="105">
                  <c:v>218.20007319999999</c:v>
                </c:pt>
                <c:pt idx="106">
                  <c:v>214.14730829999999</c:v>
                </c:pt>
                <c:pt idx="107">
                  <c:v>220.5758362</c:v>
                </c:pt>
                <c:pt idx="108">
                  <c:v>211.01771550000001</c:v>
                </c:pt>
                <c:pt idx="109">
                  <c:v>211.60566710000001</c:v>
                </c:pt>
                <c:pt idx="110">
                  <c:v>199.66162109999999</c:v>
                </c:pt>
                <c:pt idx="111">
                  <c:v>199.26710510000001</c:v>
                </c:pt>
                <c:pt idx="112">
                  <c:v>200.10285949999999</c:v>
                </c:pt>
                <c:pt idx="113">
                  <c:v>200.5236664</c:v>
                </c:pt>
                <c:pt idx="114">
                  <c:v>188.5232239</c:v>
                </c:pt>
                <c:pt idx="115">
                  <c:v>183.80435180000001</c:v>
                </c:pt>
                <c:pt idx="116">
                  <c:v>182.02302549999999</c:v>
                </c:pt>
                <c:pt idx="117">
                  <c:v>177.2910004</c:v>
                </c:pt>
                <c:pt idx="118">
                  <c:v>174.11338810000001</c:v>
                </c:pt>
                <c:pt idx="119">
                  <c:v>171.7720947</c:v>
                </c:pt>
                <c:pt idx="120">
                  <c:v>168.21388239999999</c:v>
                </c:pt>
                <c:pt idx="121">
                  <c:v>161.43058780000001</c:v>
                </c:pt>
                <c:pt idx="122">
                  <c:v>163.48231509999999</c:v>
                </c:pt>
                <c:pt idx="123">
                  <c:v>160.3659973</c:v>
                </c:pt>
                <c:pt idx="124">
                  <c:v>158.2270508</c:v>
                </c:pt>
                <c:pt idx="125">
                  <c:v>148.48356630000001</c:v>
                </c:pt>
                <c:pt idx="126">
                  <c:v>149.3986511</c:v>
                </c:pt>
                <c:pt idx="127">
                  <c:v>145.9005737</c:v>
                </c:pt>
                <c:pt idx="128">
                  <c:v>142.0500183</c:v>
                </c:pt>
                <c:pt idx="129">
                  <c:v>138.58514400000001</c:v>
                </c:pt>
                <c:pt idx="130">
                  <c:v>136.8211823</c:v>
                </c:pt>
                <c:pt idx="131">
                  <c:v>136.96481320000001</c:v>
                </c:pt>
                <c:pt idx="132">
                  <c:v>131.78205869999999</c:v>
                </c:pt>
                <c:pt idx="133">
                  <c:v>128.02253719999999</c:v>
                </c:pt>
                <c:pt idx="134">
                  <c:v>126.09334560000001</c:v>
                </c:pt>
                <c:pt idx="135">
                  <c:v>121.23896790000001</c:v>
                </c:pt>
                <c:pt idx="136">
                  <c:v>117.82592769999999</c:v>
                </c:pt>
                <c:pt idx="137">
                  <c:v>115.69048309999999</c:v>
                </c:pt>
                <c:pt idx="138">
                  <c:v>114.45904539999999</c:v>
                </c:pt>
                <c:pt idx="139">
                  <c:v>114.76867679999999</c:v>
                </c:pt>
                <c:pt idx="140">
                  <c:v>110.28013609999999</c:v>
                </c:pt>
                <c:pt idx="141">
                  <c:v>104.38981630000001</c:v>
                </c:pt>
                <c:pt idx="142">
                  <c:v>106.9054565</c:v>
                </c:pt>
                <c:pt idx="143">
                  <c:v>102.4189377</c:v>
                </c:pt>
                <c:pt idx="144">
                  <c:v>100.32599639999999</c:v>
                </c:pt>
                <c:pt idx="145">
                  <c:v>96.948043819999995</c:v>
                </c:pt>
                <c:pt idx="146">
                  <c:v>96.584419249999996</c:v>
                </c:pt>
                <c:pt idx="147">
                  <c:v>94.517219539999999</c:v>
                </c:pt>
                <c:pt idx="148">
                  <c:v>92.308914180000002</c:v>
                </c:pt>
                <c:pt idx="149">
                  <c:v>89.131973270000003</c:v>
                </c:pt>
                <c:pt idx="150">
                  <c:v>86.034637450000005</c:v>
                </c:pt>
                <c:pt idx="151">
                  <c:v>84.371475219999994</c:v>
                </c:pt>
                <c:pt idx="152">
                  <c:v>83.006599429999994</c:v>
                </c:pt>
                <c:pt idx="153">
                  <c:v>83.087844849999996</c:v>
                </c:pt>
                <c:pt idx="154">
                  <c:v>82.002998349999999</c:v>
                </c:pt>
                <c:pt idx="155">
                  <c:v>79.031318659999997</c:v>
                </c:pt>
                <c:pt idx="156">
                  <c:v>74.758880619999999</c:v>
                </c:pt>
                <c:pt idx="157">
                  <c:v>73.726936339999995</c:v>
                </c:pt>
                <c:pt idx="158">
                  <c:v>73.919609070000007</c:v>
                </c:pt>
                <c:pt idx="159">
                  <c:v>71.454528809999999</c:v>
                </c:pt>
                <c:pt idx="160">
                  <c:v>71.488792419999996</c:v>
                </c:pt>
                <c:pt idx="161">
                  <c:v>65.390228269999994</c:v>
                </c:pt>
                <c:pt idx="162">
                  <c:v>64.712028500000002</c:v>
                </c:pt>
                <c:pt idx="163">
                  <c:v>64.830474850000002</c:v>
                </c:pt>
                <c:pt idx="164">
                  <c:v>60.188377379999999</c:v>
                </c:pt>
                <c:pt idx="165">
                  <c:v>58.498161320000001</c:v>
                </c:pt>
                <c:pt idx="166">
                  <c:v>58.688171390000001</c:v>
                </c:pt>
                <c:pt idx="167">
                  <c:v>57.064804080000002</c:v>
                </c:pt>
                <c:pt idx="168">
                  <c:v>55.899696349999999</c:v>
                </c:pt>
                <c:pt idx="169">
                  <c:v>54.226947780000003</c:v>
                </c:pt>
                <c:pt idx="170">
                  <c:v>50.343372340000002</c:v>
                </c:pt>
                <c:pt idx="171">
                  <c:v>50.45016098</c:v>
                </c:pt>
                <c:pt idx="172">
                  <c:v>48.983295439999999</c:v>
                </c:pt>
                <c:pt idx="173">
                  <c:v>47.838214870000002</c:v>
                </c:pt>
                <c:pt idx="174">
                  <c:v>45.044048310000001</c:v>
                </c:pt>
                <c:pt idx="175">
                  <c:v>43.632587430000001</c:v>
                </c:pt>
                <c:pt idx="176">
                  <c:v>41.017749790000003</c:v>
                </c:pt>
                <c:pt idx="177">
                  <c:v>40.688163760000002</c:v>
                </c:pt>
                <c:pt idx="178">
                  <c:v>40.697158809999998</c:v>
                </c:pt>
                <c:pt idx="179">
                  <c:v>39.677501679999999</c:v>
                </c:pt>
                <c:pt idx="180">
                  <c:v>38.08236694</c:v>
                </c:pt>
                <c:pt idx="181">
                  <c:v>37.344169620000002</c:v>
                </c:pt>
                <c:pt idx="182">
                  <c:v>36.125106809999998</c:v>
                </c:pt>
                <c:pt idx="183">
                  <c:v>34.066246030000002</c:v>
                </c:pt>
                <c:pt idx="184">
                  <c:v>31.73654556</c:v>
                </c:pt>
                <c:pt idx="185">
                  <c:v>33.339469909999998</c:v>
                </c:pt>
                <c:pt idx="186">
                  <c:v>31.746032710000001</c:v>
                </c:pt>
                <c:pt idx="187">
                  <c:v>29.95687294</c:v>
                </c:pt>
                <c:pt idx="188">
                  <c:v>30.045400619999999</c:v>
                </c:pt>
                <c:pt idx="189">
                  <c:v>29.028497699999999</c:v>
                </c:pt>
                <c:pt idx="190">
                  <c:v>28.690437320000001</c:v>
                </c:pt>
                <c:pt idx="191">
                  <c:v>25.380323409999999</c:v>
                </c:pt>
                <c:pt idx="192">
                  <c:v>26.519075390000001</c:v>
                </c:pt>
                <c:pt idx="193">
                  <c:v>24.198137280000001</c:v>
                </c:pt>
                <c:pt idx="194">
                  <c:v>25.27911568</c:v>
                </c:pt>
                <c:pt idx="195">
                  <c:v>23.575489040000001</c:v>
                </c:pt>
                <c:pt idx="196">
                  <c:v>24.234235760000001</c:v>
                </c:pt>
                <c:pt idx="197">
                  <c:v>22.039264679999999</c:v>
                </c:pt>
                <c:pt idx="198">
                  <c:v>21.381921770000002</c:v>
                </c:pt>
                <c:pt idx="199">
                  <c:v>21.390142440000002</c:v>
                </c:pt>
                <c:pt idx="200">
                  <c:v>19.747917180000002</c:v>
                </c:pt>
                <c:pt idx="201">
                  <c:v>20.130752560000001</c:v>
                </c:pt>
                <c:pt idx="202">
                  <c:v>20.25693893</c:v>
                </c:pt>
                <c:pt idx="203">
                  <c:v>19.629611969999999</c:v>
                </c:pt>
                <c:pt idx="204">
                  <c:v>18.357913969999998</c:v>
                </c:pt>
                <c:pt idx="205">
                  <c:v>18.05731201</c:v>
                </c:pt>
                <c:pt idx="206">
                  <c:v>17.379396440000001</c:v>
                </c:pt>
                <c:pt idx="207">
                  <c:v>17.00448608</c:v>
                </c:pt>
                <c:pt idx="208">
                  <c:v>16.6436882</c:v>
                </c:pt>
                <c:pt idx="209">
                  <c:v>16.705261230000001</c:v>
                </c:pt>
                <c:pt idx="210">
                  <c:v>16.332485200000001</c:v>
                </c:pt>
                <c:pt idx="211">
                  <c:v>17.411930080000001</c:v>
                </c:pt>
                <c:pt idx="212">
                  <c:v>16.00102425</c:v>
                </c:pt>
                <c:pt idx="213">
                  <c:v>16.546905519999999</c:v>
                </c:pt>
                <c:pt idx="214">
                  <c:v>16.80626869</c:v>
                </c:pt>
                <c:pt idx="215">
                  <c:v>17.947195050000001</c:v>
                </c:pt>
                <c:pt idx="216">
                  <c:v>16.78380585</c:v>
                </c:pt>
                <c:pt idx="217">
                  <c:v>17.641342160000001</c:v>
                </c:pt>
                <c:pt idx="218">
                  <c:v>18.208887099999998</c:v>
                </c:pt>
                <c:pt idx="219">
                  <c:v>18.087039950000001</c:v>
                </c:pt>
                <c:pt idx="220">
                  <c:v>17.468589779999999</c:v>
                </c:pt>
                <c:pt idx="221">
                  <c:v>20.112501139999999</c:v>
                </c:pt>
                <c:pt idx="222">
                  <c:v>20.098909379999998</c:v>
                </c:pt>
                <c:pt idx="223">
                  <c:v>19.610767360000001</c:v>
                </c:pt>
                <c:pt idx="224">
                  <c:v>20.593141559999999</c:v>
                </c:pt>
                <c:pt idx="225">
                  <c:v>20.53990555</c:v>
                </c:pt>
                <c:pt idx="226">
                  <c:v>19.754768370000001</c:v>
                </c:pt>
                <c:pt idx="227">
                  <c:v>18.89541054</c:v>
                </c:pt>
                <c:pt idx="228">
                  <c:v>18.64711952</c:v>
                </c:pt>
                <c:pt idx="229">
                  <c:v>18.624626159999998</c:v>
                </c:pt>
                <c:pt idx="230">
                  <c:v>18.508468629999999</c:v>
                </c:pt>
                <c:pt idx="231">
                  <c:v>16.402137759999999</c:v>
                </c:pt>
                <c:pt idx="232">
                  <c:v>18.283699039999998</c:v>
                </c:pt>
                <c:pt idx="233">
                  <c:v>15.520060539999999</c:v>
                </c:pt>
                <c:pt idx="234">
                  <c:v>15.93842888</c:v>
                </c:pt>
                <c:pt idx="235">
                  <c:v>15.771107669999999</c:v>
                </c:pt>
                <c:pt idx="236">
                  <c:v>15.31169128</c:v>
                </c:pt>
                <c:pt idx="237">
                  <c:v>13.37644386</c:v>
                </c:pt>
                <c:pt idx="238">
                  <c:v>13.836504939999999</c:v>
                </c:pt>
                <c:pt idx="239">
                  <c:v>13.24072552</c:v>
                </c:pt>
                <c:pt idx="240">
                  <c:v>12.734763149999999</c:v>
                </c:pt>
                <c:pt idx="241">
                  <c:v>11.66961193</c:v>
                </c:pt>
                <c:pt idx="242">
                  <c:v>11.088387490000001</c:v>
                </c:pt>
                <c:pt idx="243">
                  <c:v>10.84227085</c:v>
                </c:pt>
                <c:pt idx="244">
                  <c:v>9.8199844360000004</c:v>
                </c:pt>
                <c:pt idx="245">
                  <c:v>8.6152715680000007</c:v>
                </c:pt>
                <c:pt idx="246">
                  <c:v>8.8780841830000004</c:v>
                </c:pt>
                <c:pt idx="247">
                  <c:v>8.616512299</c:v>
                </c:pt>
                <c:pt idx="248">
                  <c:v>8.1050872799999993</c:v>
                </c:pt>
                <c:pt idx="249">
                  <c:v>8.1958560939999998</c:v>
                </c:pt>
                <c:pt idx="250">
                  <c:v>7.5619239809999996</c:v>
                </c:pt>
                <c:pt idx="251">
                  <c:v>8.1405315399999996</c:v>
                </c:pt>
                <c:pt idx="252">
                  <c:v>7.2960562710000003</c:v>
                </c:pt>
                <c:pt idx="253">
                  <c:v>7.7708139420000002</c:v>
                </c:pt>
                <c:pt idx="254">
                  <c:v>6.9397549630000004</c:v>
                </c:pt>
                <c:pt idx="255">
                  <c:v>7.5593490599999997</c:v>
                </c:pt>
                <c:pt idx="256">
                  <c:v>7.0382328029999996</c:v>
                </c:pt>
                <c:pt idx="257">
                  <c:v>7.0110387799999998</c:v>
                </c:pt>
                <c:pt idx="258">
                  <c:v>6.5295839310000003</c:v>
                </c:pt>
                <c:pt idx="259">
                  <c:v>7.2009463309999999</c:v>
                </c:pt>
                <c:pt idx="260">
                  <c:v>6.3586173060000002</c:v>
                </c:pt>
                <c:pt idx="261">
                  <c:v>6.3493733409999997</c:v>
                </c:pt>
                <c:pt idx="262">
                  <c:v>5.6836862559999997</c:v>
                </c:pt>
                <c:pt idx="263">
                  <c:v>6.2709469799999997</c:v>
                </c:pt>
                <c:pt idx="264">
                  <c:v>6.9303107260000001</c:v>
                </c:pt>
                <c:pt idx="265">
                  <c:v>6.064527988</c:v>
                </c:pt>
                <c:pt idx="266">
                  <c:v>6.3083691599999998</c:v>
                </c:pt>
                <c:pt idx="267">
                  <c:v>6.0621371269999997</c:v>
                </c:pt>
                <c:pt idx="268">
                  <c:v>6.8228883739999997</c:v>
                </c:pt>
                <c:pt idx="269">
                  <c:v>5.7544345860000004</c:v>
                </c:pt>
                <c:pt idx="270">
                  <c:v>6.9283819199999996</c:v>
                </c:pt>
                <c:pt idx="271">
                  <c:v>5.6870913510000003</c:v>
                </c:pt>
                <c:pt idx="272">
                  <c:v>5.4843587879999998</c:v>
                </c:pt>
                <c:pt idx="273">
                  <c:v>6.0177969930000001</c:v>
                </c:pt>
                <c:pt idx="274">
                  <c:v>5.5996708870000003</c:v>
                </c:pt>
                <c:pt idx="275">
                  <c:v>5.9929823879999997</c:v>
                </c:pt>
                <c:pt idx="276">
                  <c:v>4.7936997410000002</c:v>
                </c:pt>
                <c:pt idx="277">
                  <c:v>5.3732242579999996</c:v>
                </c:pt>
                <c:pt idx="278">
                  <c:v>5.0868783000000004</c:v>
                </c:pt>
                <c:pt idx="279">
                  <c:v>4.5793776509999997</c:v>
                </c:pt>
                <c:pt idx="280">
                  <c:v>4.9914607999999996</c:v>
                </c:pt>
                <c:pt idx="281">
                  <c:v>4.5840497019999997</c:v>
                </c:pt>
                <c:pt idx="282">
                  <c:v>4.0627064700000002</c:v>
                </c:pt>
                <c:pt idx="283">
                  <c:v>4.5123820300000004</c:v>
                </c:pt>
                <c:pt idx="284">
                  <c:v>4.6774230000000001</c:v>
                </c:pt>
                <c:pt idx="285">
                  <c:v>4.7786531449999998</c:v>
                </c:pt>
                <c:pt idx="286">
                  <c:v>8.1527996060000003</c:v>
                </c:pt>
                <c:pt idx="287">
                  <c:v>25.738153459999999</c:v>
                </c:pt>
                <c:pt idx="288">
                  <c:v>63.212490080000002</c:v>
                </c:pt>
                <c:pt idx="289">
                  <c:v>117.49848179999999</c:v>
                </c:pt>
                <c:pt idx="290">
                  <c:v>206.4611969</c:v>
                </c:pt>
              </c:numCache>
            </c:numRef>
          </c:yVal>
          <c:smooth val="1"/>
          <c:extLst>
            <c:ext xmlns:c16="http://schemas.microsoft.com/office/drawing/2014/chart" uri="{C3380CC4-5D6E-409C-BE32-E72D297353CC}">
              <c16:uniqueId val="{00000003-23D1-4D6B-8D95-E81ABA7C315A}"/>
            </c:ext>
          </c:extLst>
        </c:ser>
        <c:dLbls>
          <c:showLegendKey val="0"/>
          <c:showVal val="0"/>
          <c:showCatName val="0"/>
          <c:showSerName val="0"/>
          <c:showPercent val="0"/>
          <c:showBubbleSize val="0"/>
        </c:dLbls>
        <c:axId val="149727664"/>
        <c:axId val="149727104"/>
      </c:scatterChart>
      <c:valAx>
        <c:axId val="149725984"/>
        <c:scaling>
          <c:orientation val="minMax"/>
          <c:max val="595"/>
          <c:min val="280"/>
        </c:scaling>
        <c:delete val="0"/>
        <c:axPos val="b"/>
        <c:title>
          <c:tx>
            <c:rich>
              <a:bodyPr/>
              <a:lstStyle/>
              <a:p>
                <a:pPr>
                  <a:defRPr/>
                </a:pPr>
                <a:r>
                  <a:rPr lang="en-GB" dirty="0"/>
                  <a:t>Wavelength (nm)</a:t>
                </a:r>
              </a:p>
            </c:rich>
          </c:tx>
          <c:layout/>
          <c:overlay val="0"/>
        </c:title>
        <c:numFmt formatCode="General" sourceLinked="1"/>
        <c:majorTickMark val="out"/>
        <c:minorTickMark val="none"/>
        <c:tickLblPos val="nextTo"/>
        <c:crossAx val="149726544"/>
        <c:crosses val="autoZero"/>
        <c:crossBetween val="midCat"/>
      </c:valAx>
      <c:valAx>
        <c:axId val="149726544"/>
        <c:scaling>
          <c:orientation val="minMax"/>
          <c:max val="4.5"/>
          <c:min val="0"/>
        </c:scaling>
        <c:delete val="0"/>
        <c:axPos val="l"/>
        <c:title>
          <c:tx>
            <c:rich>
              <a:bodyPr rot="-5400000" vert="horz"/>
              <a:lstStyle/>
              <a:p>
                <a:pPr>
                  <a:defRPr/>
                </a:pPr>
                <a:r>
                  <a:rPr lang="en-GB"/>
                  <a:t>Absorbance (a.u)</a:t>
                </a:r>
              </a:p>
            </c:rich>
          </c:tx>
          <c:layout/>
          <c:overlay val="0"/>
        </c:title>
        <c:numFmt formatCode="General" sourceLinked="1"/>
        <c:majorTickMark val="out"/>
        <c:minorTickMark val="none"/>
        <c:tickLblPos val="nextTo"/>
        <c:crossAx val="149725984"/>
        <c:crosses val="autoZero"/>
        <c:crossBetween val="midCat"/>
      </c:valAx>
      <c:valAx>
        <c:axId val="149727104"/>
        <c:scaling>
          <c:orientation val="minMax"/>
        </c:scaling>
        <c:delete val="0"/>
        <c:axPos val="r"/>
        <c:title>
          <c:tx>
            <c:rich>
              <a:bodyPr rot="-5400000" vert="horz"/>
              <a:lstStyle/>
              <a:p>
                <a:pPr>
                  <a:defRPr/>
                </a:pPr>
                <a:r>
                  <a:rPr lang="en-GB"/>
                  <a:t>Intensiy (a.u)</a:t>
                </a:r>
              </a:p>
            </c:rich>
          </c:tx>
          <c:layout/>
          <c:overlay val="0"/>
        </c:title>
        <c:numFmt formatCode="General" sourceLinked="1"/>
        <c:majorTickMark val="out"/>
        <c:minorTickMark val="none"/>
        <c:tickLblPos val="nextTo"/>
        <c:crossAx val="149727664"/>
        <c:crosses val="max"/>
        <c:crossBetween val="midCat"/>
      </c:valAx>
      <c:valAx>
        <c:axId val="149727664"/>
        <c:scaling>
          <c:orientation val="minMax"/>
        </c:scaling>
        <c:delete val="1"/>
        <c:axPos val="b"/>
        <c:numFmt formatCode="General" sourceLinked="1"/>
        <c:majorTickMark val="out"/>
        <c:minorTickMark val="none"/>
        <c:tickLblPos val="nextTo"/>
        <c:crossAx val="149727104"/>
        <c:crosses val="autoZero"/>
        <c:crossBetween val="midCat"/>
      </c:valAx>
    </c:plotArea>
    <c:legend>
      <c:legendPos val="b"/>
      <c:layout/>
      <c:overlay val="0"/>
    </c:legend>
    <c:plotVisOnly val="1"/>
    <c:dispBlanksAs val="gap"/>
    <c:showDLblsOverMax val="0"/>
  </c:chart>
  <c:spPr>
    <a:ln>
      <a:noFill/>
    </a:ln>
  </c:spPr>
  <c:externalData r:id="rId1">
    <c:autoUpdate val="0"/>
  </c:externalData>
</c:chartSpace>
</file>

<file path=ppt/charts/chart8.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manualLayout>
          <c:layoutTarget val="inner"/>
          <c:xMode val="edge"/>
          <c:yMode val="edge"/>
          <c:x val="0.21444894565759803"/>
          <c:y val="6.5271451320223675E-2"/>
          <c:w val="0.73222890906290994"/>
          <c:h val="0.66278654223604783"/>
        </c:manualLayout>
      </c:layout>
      <c:scatterChart>
        <c:scatterStyle val="smoothMarker"/>
        <c:varyColors val="0"/>
        <c:ser>
          <c:idx val="0"/>
          <c:order val="0"/>
          <c:tx>
            <c:strRef>
              <c:f>Sheet1!$J$1</c:f>
              <c:strCache>
                <c:ptCount val="1"/>
                <c:pt idx="0">
                  <c:v>INK128 with DMSO</c:v>
                </c:pt>
              </c:strCache>
            </c:strRef>
          </c:tx>
          <c:spPr>
            <a:ln>
              <a:solidFill>
                <a:schemeClr val="tx1"/>
              </a:solidFill>
            </a:ln>
          </c:spPr>
          <c:marker>
            <c:symbol val="none"/>
          </c:marker>
          <c:xVal>
            <c:numRef>
              <c:f>Sheet1!$I$3:$I$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N$3:$N$513</c:f>
              <c:numCache>
                <c:formatCode>General</c:formatCode>
                <c:ptCount val="511"/>
                <c:pt idx="0">
                  <c:v>-0.10556000000000035</c:v>
                </c:pt>
                <c:pt idx="1">
                  <c:v>-4.0435000000000255E-2</c:v>
                </c:pt>
                <c:pt idx="2">
                  <c:v>0.31459099999999979</c:v>
                </c:pt>
                <c:pt idx="3">
                  <c:v>6.2607000000000051E-2</c:v>
                </c:pt>
                <c:pt idx="4">
                  <c:v>5.8090999999999858E-2</c:v>
                </c:pt>
                <c:pt idx="5">
                  <c:v>-0.10047899999999979</c:v>
                </c:pt>
                <c:pt idx="6">
                  <c:v>-0.1878650000000002</c:v>
                </c:pt>
                <c:pt idx="7">
                  <c:v>-0.15695100000000009</c:v>
                </c:pt>
                <c:pt idx="8">
                  <c:v>-2.2414999999999886E-2</c:v>
                </c:pt>
                <c:pt idx="9">
                  <c:v>-4.4234999999999837E-2</c:v>
                </c:pt>
                <c:pt idx="10">
                  <c:v>1.6327000000000168E-2</c:v>
                </c:pt>
                <c:pt idx="11">
                  <c:v>-2.8396000000000123E-2</c:v>
                </c:pt>
                <c:pt idx="12">
                  <c:v>-8.3952999999999972E-2</c:v>
                </c:pt>
                <c:pt idx="13">
                  <c:v>-4.3015000000000282E-2</c:v>
                </c:pt>
                <c:pt idx="14">
                  <c:v>-0.125335</c:v>
                </c:pt>
                <c:pt idx="15">
                  <c:v>-5.7448999999999896E-2</c:v>
                </c:pt>
                <c:pt idx="16">
                  <c:v>-2.5893999999999896E-2</c:v>
                </c:pt>
                <c:pt idx="17">
                  <c:v>-4.4005999999999802E-2</c:v>
                </c:pt>
                <c:pt idx="18">
                  <c:v>-2.0507999999999783E-2</c:v>
                </c:pt>
                <c:pt idx="19">
                  <c:v>-1.9835999999999999E-2</c:v>
                </c:pt>
                <c:pt idx="20">
                  <c:v>-6.2133000000000028E-2</c:v>
                </c:pt>
                <c:pt idx="21">
                  <c:v>-1.072600000000027E-2</c:v>
                </c:pt>
                <c:pt idx="22">
                  <c:v>-0.14976500000000018</c:v>
                </c:pt>
                <c:pt idx="23">
                  <c:v>-3.9153999999999724E-2</c:v>
                </c:pt>
                <c:pt idx="24">
                  <c:v>0.17399699999999971</c:v>
                </c:pt>
                <c:pt idx="25">
                  <c:v>3.1234999999999867E-2</c:v>
                </c:pt>
                <c:pt idx="26">
                  <c:v>-0.13952600000000029</c:v>
                </c:pt>
                <c:pt idx="27">
                  <c:v>-4.699699999999999E-2</c:v>
                </c:pt>
                <c:pt idx="28">
                  <c:v>-8.4808000000000022E-2</c:v>
                </c:pt>
                <c:pt idx="29">
                  <c:v>-3.8528000000000152E-2</c:v>
                </c:pt>
                <c:pt idx="30">
                  <c:v>-9.8556000000000116E-2</c:v>
                </c:pt>
                <c:pt idx="31">
                  <c:v>-4.2259999999998757E-3</c:v>
                </c:pt>
                <c:pt idx="32">
                  <c:v>3.6987999999999764E-2</c:v>
                </c:pt>
                <c:pt idx="33">
                  <c:v>-4.8080000000000379E-2</c:v>
                </c:pt>
                <c:pt idx="34">
                  <c:v>-3.0014000000000242E-2</c:v>
                </c:pt>
                <c:pt idx="35">
                  <c:v>4.7821999999999774E-2</c:v>
                </c:pt>
                <c:pt idx="36">
                  <c:v>2.3758999999999829E-2</c:v>
                </c:pt>
                <c:pt idx="37">
                  <c:v>3.5476999999999946E-2</c:v>
                </c:pt>
                <c:pt idx="38">
                  <c:v>-1.2343999999999945E-2</c:v>
                </c:pt>
                <c:pt idx="39">
                  <c:v>-3.4439000000000143E-2</c:v>
                </c:pt>
                <c:pt idx="40">
                  <c:v>-1.2939000000000069E-2</c:v>
                </c:pt>
                <c:pt idx="41">
                  <c:v>-6.2860000000000485E-3</c:v>
                </c:pt>
                <c:pt idx="42">
                  <c:v>1.6266000000000079E-2</c:v>
                </c:pt>
                <c:pt idx="43">
                  <c:v>3.7963999999999852E-2</c:v>
                </c:pt>
                <c:pt idx="44">
                  <c:v>3.0411000000000153E-2</c:v>
                </c:pt>
                <c:pt idx="45">
                  <c:v>-5.4160000000001221E-3</c:v>
                </c:pt>
                <c:pt idx="46">
                  <c:v>-3.2286999999999989E-2</c:v>
                </c:pt>
                <c:pt idx="47">
                  <c:v>-2.1895999999999728E-2</c:v>
                </c:pt>
                <c:pt idx="48">
                  <c:v>-5.0598000000000178E-2</c:v>
                </c:pt>
                <c:pt idx="49">
                  <c:v>4.9362999999999789E-2</c:v>
                </c:pt>
                <c:pt idx="50">
                  <c:v>-9.2769999999997924E-3</c:v>
                </c:pt>
                <c:pt idx="51">
                  <c:v>-4.8292999999999954E-2</c:v>
                </c:pt>
                <c:pt idx="52">
                  <c:v>7.3300000000005999E-4</c:v>
                </c:pt>
                <c:pt idx="53">
                  <c:v>-6.7153000000000046E-2</c:v>
                </c:pt>
                <c:pt idx="54">
                  <c:v>-2.8854000000000192E-2</c:v>
                </c:pt>
                <c:pt idx="55">
                  <c:v>-1.7273000000000129E-2</c:v>
                </c:pt>
                <c:pt idx="56">
                  <c:v>-1.5609000000000241E-2</c:v>
                </c:pt>
                <c:pt idx="57">
                  <c:v>4.6158000000000331E-2</c:v>
                </c:pt>
                <c:pt idx="58">
                  <c:v>8.6830000000001836E-3</c:v>
                </c:pt>
                <c:pt idx="59">
                  <c:v>1.3016000000000104E-2</c:v>
                </c:pt>
                <c:pt idx="60">
                  <c:v>-0.16210900000000031</c:v>
                </c:pt>
                <c:pt idx="61">
                  <c:v>8.2250000000001142E-3</c:v>
                </c:pt>
                <c:pt idx="62">
                  <c:v>7.7927000000000052E-2</c:v>
                </c:pt>
                <c:pt idx="63">
                  <c:v>-3.5309000000000069E-2</c:v>
                </c:pt>
                <c:pt idx="64">
                  <c:v>1.2670000000000944E-3</c:v>
                </c:pt>
                <c:pt idx="65">
                  <c:v>0.33378700000000022</c:v>
                </c:pt>
                <c:pt idx="66">
                  <c:v>0.3923799999999999</c:v>
                </c:pt>
                <c:pt idx="67">
                  <c:v>0.42266899999999968</c:v>
                </c:pt>
                <c:pt idx="68">
                  <c:v>0.39964299999999991</c:v>
                </c:pt>
                <c:pt idx="69">
                  <c:v>0.39343300000000009</c:v>
                </c:pt>
                <c:pt idx="70">
                  <c:v>0.38905299999999982</c:v>
                </c:pt>
                <c:pt idx="71">
                  <c:v>0.37793000000000004</c:v>
                </c:pt>
                <c:pt idx="72">
                  <c:v>0.36845500000000014</c:v>
                </c:pt>
                <c:pt idx="73">
                  <c:v>0.35806300000000008</c:v>
                </c:pt>
                <c:pt idx="74">
                  <c:v>0.34901499999999991</c:v>
                </c:pt>
                <c:pt idx="75">
                  <c:v>0.340057</c:v>
                </c:pt>
                <c:pt idx="76">
                  <c:v>0.32937600000000006</c:v>
                </c:pt>
                <c:pt idx="77">
                  <c:v>0.31909199999999999</c:v>
                </c:pt>
                <c:pt idx="78">
                  <c:v>0.30880800000000003</c:v>
                </c:pt>
                <c:pt idx="79">
                  <c:v>0.298097</c:v>
                </c:pt>
                <c:pt idx="80">
                  <c:v>0.28874299999999997</c:v>
                </c:pt>
                <c:pt idx="81">
                  <c:v>0.27922100000000005</c:v>
                </c:pt>
                <c:pt idx="82">
                  <c:v>0.270874</c:v>
                </c:pt>
                <c:pt idx="83">
                  <c:v>0.26362699999999994</c:v>
                </c:pt>
                <c:pt idx="84">
                  <c:v>0.25666800000000001</c:v>
                </c:pt>
                <c:pt idx="85">
                  <c:v>0.25097700000000001</c:v>
                </c:pt>
                <c:pt idx="86">
                  <c:v>0.24627700000000005</c:v>
                </c:pt>
                <c:pt idx="87">
                  <c:v>0.24238600000000002</c:v>
                </c:pt>
                <c:pt idx="88">
                  <c:v>0.24009699999999998</c:v>
                </c:pt>
                <c:pt idx="89">
                  <c:v>0.23924300000000001</c:v>
                </c:pt>
                <c:pt idx="90">
                  <c:v>0.24031100000000002</c:v>
                </c:pt>
                <c:pt idx="91">
                  <c:v>0.24220400000000006</c:v>
                </c:pt>
                <c:pt idx="92">
                  <c:v>0.24566700000000005</c:v>
                </c:pt>
                <c:pt idx="93">
                  <c:v>0.24987800000000002</c:v>
                </c:pt>
                <c:pt idx="94">
                  <c:v>0.25549300000000003</c:v>
                </c:pt>
                <c:pt idx="95">
                  <c:v>0.26133800000000001</c:v>
                </c:pt>
                <c:pt idx="96">
                  <c:v>0.26783799999999996</c:v>
                </c:pt>
                <c:pt idx="97">
                  <c:v>0.273789</c:v>
                </c:pt>
                <c:pt idx="98">
                  <c:v>0.27957199999999999</c:v>
                </c:pt>
                <c:pt idx="99">
                  <c:v>0.28424199999999999</c:v>
                </c:pt>
                <c:pt idx="100">
                  <c:v>0.28820799999999996</c:v>
                </c:pt>
                <c:pt idx="101">
                  <c:v>0.29168699999999997</c:v>
                </c:pt>
                <c:pt idx="102">
                  <c:v>0.29542499999999999</c:v>
                </c:pt>
                <c:pt idx="103">
                  <c:v>0.29943900000000001</c:v>
                </c:pt>
                <c:pt idx="104">
                  <c:v>0.30255199999999999</c:v>
                </c:pt>
                <c:pt idx="105">
                  <c:v>0.29103099999999998</c:v>
                </c:pt>
                <c:pt idx="106">
                  <c:v>0.27525399999999994</c:v>
                </c:pt>
                <c:pt idx="107">
                  <c:v>0.27062999999999998</c:v>
                </c:pt>
                <c:pt idx="108">
                  <c:v>0.26570199999999994</c:v>
                </c:pt>
                <c:pt idx="109">
                  <c:v>0.25660699999999997</c:v>
                </c:pt>
                <c:pt idx="110">
                  <c:v>0.24696399999999999</c:v>
                </c:pt>
                <c:pt idx="111">
                  <c:v>0.23812900000000001</c:v>
                </c:pt>
                <c:pt idx="112">
                  <c:v>0.23350500000000005</c:v>
                </c:pt>
                <c:pt idx="113">
                  <c:v>0.22424400000000003</c:v>
                </c:pt>
                <c:pt idx="114">
                  <c:v>0.216309</c:v>
                </c:pt>
                <c:pt idx="115">
                  <c:v>0.20846599999999998</c:v>
                </c:pt>
                <c:pt idx="116">
                  <c:v>0.20692500000000003</c:v>
                </c:pt>
                <c:pt idx="117">
                  <c:v>0.19825800000000002</c:v>
                </c:pt>
                <c:pt idx="118">
                  <c:v>0.18634100000000001</c:v>
                </c:pt>
                <c:pt idx="119">
                  <c:v>0.176423</c:v>
                </c:pt>
                <c:pt idx="120">
                  <c:v>0.16699300000000003</c:v>
                </c:pt>
                <c:pt idx="121">
                  <c:v>0.15525900000000001</c:v>
                </c:pt>
                <c:pt idx="122">
                  <c:v>0.14575199999999999</c:v>
                </c:pt>
                <c:pt idx="123">
                  <c:v>0.13395799999999999</c:v>
                </c:pt>
                <c:pt idx="124">
                  <c:v>0.12345999999999999</c:v>
                </c:pt>
                <c:pt idx="125">
                  <c:v>0.11190800000000001</c:v>
                </c:pt>
                <c:pt idx="126">
                  <c:v>0.10119700000000001</c:v>
                </c:pt>
                <c:pt idx="127">
                  <c:v>8.9904999999999985E-2</c:v>
                </c:pt>
                <c:pt idx="128">
                  <c:v>8.1252999999999992E-2</c:v>
                </c:pt>
                <c:pt idx="129">
                  <c:v>7.142699999999999E-2</c:v>
                </c:pt>
                <c:pt idx="130">
                  <c:v>6.2730000000000008E-2</c:v>
                </c:pt>
                <c:pt idx="131">
                  <c:v>5.4658000000000005E-2</c:v>
                </c:pt>
                <c:pt idx="132">
                  <c:v>4.7393999999999999E-2</c:v>
                </c:pt>
                <c:pt idx="133">
                  <c:v>4.0818E-2</c:v>
                </c:pt>
                <c:pt idx="134">
                  <c:v>3.5371000000000007E-2</c:v>
                </c:pt>
                <c:pt idx="135">
                  <c:v>2.9922999999999998E-2</c:v>
                </c:pt>
                <c:pt idx="136">
                  <c:v>2.4323000000000004E-2</c:v>
                </c:pt>
                <c:pt idx="137">
                  <c:v>2.1775000000000003E-2</c:v>
                </c:pt>
                <c:pt idx="138">
                  <c:v>1.8464000000000001E-2</c:v>
                </c:pt>
                <c:pt idx="139">
                  <c:v>1.5931000000000001E-2</c:v>
                </c:pt>
                <c:pt idx="140">
                  <c:v>1.3749000000000004E-2</c:v>
                </c:pt>
                <c:pt idx="141">
                  <c:v>1.2161999999999999E-2</c:v>
                </c:pt>
                <c:pt idx="142">
                  <c:v>1.0529E-2</c:v>
                </c:pt>
                <c:pt idx="143">
                  <c:v>9.11E-3</c:v>
                </c:pt>
                <c:pt idx="144">
                  <c:v>8.4229999999999999E-3</c:v>
                </c:pt>
                <c:pt idx="145">
                  <c:v>7.9959999999999996E-3</c:v>
                </c:pt>
                <c:pt idx="146">
                  <c:v>7.4779999999999985E-3</c:v>
                </c:pt>
                <c:pt idx="147">
                  <c:v>7.2030000000000011E-3</c:v>
                </c:pt>
                <c:pt idx="148">
                  <c:v>6.8970000000000004E-3</c:v>
                </c:pt>
                <c:pt idx="149">
                  <c:v>6.241E-3</c:v>
                </c:pt>
                <c:pt idx="150">
                  <c:v>5.7829999999999999E-3</c:v>
                </c:pt>
                <c:pt idx="151">
                  <c:v>4.8520000000000021E-3</c:v>
                </c:pt>
                <c:pt idx="152">
                  <c:v>4.4709999999999993E-3</c:v>
                </c:pt>
                <c:pt idx="153">
                  <c:v>3.3430000000000022E-3</c:v>
                </c:pt>
                <c:pt idx="154">
                  <c:v>3.311999999999999E-3</c:v>
                </c:pt>
                <c:pt idx="155">
                  <c:v>2.578999999999998E-3</c:v>
                </c:pt>
                <c:pt idx="156">
                  <c:v>2.1979999999999986E-3</c:v>
                </c:pt>
                <c:pt idx="157">
                  <c:v>1.8619999999999991E-3</c:v>
                </c:pt>
                <c:pt idx="158">
                  <c:v>1.5419999999999982E-3</c:v>
                </c:pt>
                <c:pt idx="159">
                  <c:v>8.6999999999999925E-4</c:v>
                </c:pt>
                <c:pt idx="160">
                  <c:v>1.3129999999999982E-3</c:v>
                </c:pt>
                <c:pt idx="161">
                  <c:v>1.236000000000001E-3</c:v>
                </c:pt>
                <c:pt idx="162">
                  <c:v>7.4800000000000214E-4</c:v>
                </c:pt>
                <c:pt idx="163">
                  <c:v>1.0830000000000006E-3</c:v>
                </c:pt>
                <c:pt idx="164">
                  <c:v>7.7900000000000191E-4</c:v>
                </c:pt>
                <c:pt idx="165">
                  <c:v>5.3399999999999975E-4</c:v>
                </c:pt>
                <c:pt idx="166">
                  <c:v>5.65000000000003E-4</c:v>
                </c:pt>
                <c:pt idx="167">
                  <c:v>2.5999999999999981E-4</c:v>
                </c:pt>
                <c:pt idx="168">
                  <c:v>3.5100000000000409E-4</c:v>
                </c:pt>
                <c:pt idx="169">
                  <c:v>1.9800000000000026E-4</c:v>
                </c:pt>
                <c:pt idx="170">
                  <c:v>1.2300000000000158E-4</c:v>
                </c:pt>
                <c:pt idx="171">
                  <c:v>1.9899999999999779E-4</c:v>
                </c:pt>
                <c:pt idx="172">
                  <c:v>1.6000000000002124E-5</c:v>
                </c:pt>
                <c:pt idx="173">
                  <c:v>1.2200000000000058E-4</c:v>
                </c:pt>
                <c:pt idx="174">
                  <c:v>-1.9800000000000026E-4</c:v>
                </c:pt>
                <c:pt idx="175">
                  <c:v>3.8200000000000039E-4</c:v>
                </c:pt>
                <c:pt idx="176">
                  <c:v>8.2400000000000181E-4</c:v>
                </c:pt>
                <c:pt idx="177">
                  <c:v>7.7899999999999844E-4</c:v>
                </c:pt>
                <c:pt idx="178">
                  <c:v>7.0300000000000223E-4</c:v>
                </c:pt>
                <c:pt idx="179">
                  <c:v>2.9099999999999959E-4</c:v>
                </c:pt>
                <c:pt idx="180">
                  <c:v>5.5000000000000188E-4</c:v>
                </c:pt>
                <c:pt idx="181">
                  <c:v>3.8200000000000039E-4</c:v>
                </c:pt>
                <c:pt idx="182">
                  <c:v>4.5900000000000107E-4</c:v>
                </c:pt>
                <c:pt idx="183">
                  <c:v>3.6699999999999927E-4</c:v>
                </c:pt>
                <c:pt idx="184">
                  <c:v>1.8399999999999667E-4</c:v>
                </c:pt>
                <c:pt idx="185">
                  <c:v>-1.3699999999999823E-4</c:v>
                </c:pt>
                <c:pt idx="186">
                  <c:v>-2.5900000000000228E-4</c:v>
                </c:pt>
                <c:pt idx="187">
                  <c:v>-2.1299999999999791E-4</c:v>
                </c:pt>
                <c:pt idx="188">
                  <c:v>-2.2900000000000004E-4</c:v>
                </c:pt>
                <c:pt idx="189">
                  <c:v>-4.720000000000002E-4</c:v>
                </c:pt>
                <c:pt idx="190">
                  <c:v>-1.9799999999999679E-4</c:v>
                </c:pt>
                <c:pt idx="191">
                  <c:v>-3.2000000000000084E-4</c:v>
                </c:pt>
                <c:pt idx="192">
                  <c:v>-6.4100000000000268E-4</c:v>
                </c:pt>
                <c:pt idx="193">
                  <c:v>-6.0899999999999843E-4</c:v>
                </c:pt>
                <c:pt idx="194">
                  <c:v>-5.9499999999999831E-4</c:v>
                </c:pt>
                <c:pt idx="195">
                  <c:v>-7.6199999999999879E-4</c:v>
                </c:pt>
                <c:pt idx="196">
                  <c:v>-8.0799999999999969E-4</c:v>
                </c:pt>
                <c:pt idx="197">
                  <c:v>-8.0799999999999969E-4</c:v>
                </c:pt>
                <c:pt idx="198">
                  <c:v>-6.0999999999999943E-4</c:v>
                </c:pt>
                <c:pt idx="199">
                  <c:v>-8.2299999999999734E-4</c:v>
                </c:pt>
                <c:pt idx="200">
                  <c:v>-6.8700000000000011E-4</c:v>
                </c:pt>
                <c:pt idx="201">
                  <c:v>-6.5600000000000033E-4</c:v>
                </c:pt>
                <c:pt idx="202">
                  <c:v>-7.1699999999999889E-4</c:v>
                </c:pt>
                <c:pt idx="203">
                  <c:v>-8.2300000000000081E-4</c:v>
                </c:pt>
                <c:pt idx="204">
                  <c:v>-9.4500000000000139E-4</c:v>
                </c:pt>
                <c:pt idx="205">
                  <c:v>-9.6100000000000005E-4</c:v>
                </c:pt>
                <c:pt idx="206">
                  <c:v>-9.9099999999999883E-4</c:v>
                </c:pt>
                <c:pt idx="207">
                  <c:v>-9.3100000000000127E-4</c:v>
                </c:pt>
                <c:pt idx="208">
                  <c:v>-7.9300000000000204E-4</c:v>
                </c:pt>
                <c:pt idx="209">
                  <c:v>-8.6899999999999825E-4</c:v>
                </c:pt>
                <c:pt idx="210">
                  <c:v>-7.6299999999999979E-4</c:v>
                </c:pt>
                <c:pt idx="211">
                  <c:v>-7.6199999999999879E-4</c:v>
                </c:pt>
                <c:pt idx="212">
                  <c:v>-7.4799999999999867E-4</c:v>
                </c:pt>
                <c:pt idx="213">
                  <c:v>-6.7099999999999799E-4</c:v>
                </c:pt>
                <c:pt idx="214">
                  <c:v>-6.0999999999999943E-4</c:v>
                </c:pt>
                <c:pt idx="215">
                  <c:v>-6.7099999999999799E-4</c:v>
                </c:pt>
                <c:pt idx="216">
                  <c:v>-6.7099999999999799E-4</c:v>
                </c:pt>
                <c:pt idx="217">
                  <c:v>-5.9499999999999831E-4</c:v>
                </c:pt>
                <c:pt idx="218">
                  <c:v>-3.4999999999999615E-4</c:v>
                </c:pt>
                <c:pt idx="219">
                  <c:v>-4.8800000000000232E-4</c:v>
                </c:pt>
                <c:pt idx="220">
                  <c:v>-5.0299999999999997E-4</c:v>
                </c:pt>
                <c:pt idx="221">
                  <c:v>-3.9700000000000152E-4</c:v>
                </c:pt>
                <c:pt idx="222">
                  <c:v>-4.119999999999957E-4</c:v>
                </c:pt>
                <c:pt idx="223">
                  <c:v>-3.6599999999999827E-4</c:v>
                </c:pt>
                <c:pt idx="224">
                  <c:v>-3.3500000000000196E-4</c:v>
                </c:pt>
                <c:pt idx="225">
                  <c:v>-4.5800000000000007E-4</c:v>
                </c:pt>
                <c:pt idx="226">
                  <c:v>-4.4199999999999795E-4</c:v>
                </c:pt>
                <c:pt idx="227">
                  <c:v>-4.720000000000002E-4</c:v>
                </c:pt>
                <c:pt idx="228">
                  <c:v>-3.8099999999999939E-4</c:v>
                </c:pt>
                <c:pt idx="229">
                  <c:v>-3.0499999999999972E-4</c:v>
                </c:pt>
                <c:pt idx="230">
                  <c:v>-3.6599999999999827E-4</c:v>
                </c:pt>
                <c:pt idx="231">
                  <c:v>-2.7399999999999994E-4</c:v>
                </c:pt>
                <c:pt idx="232">
                  <c:v>-2.7399999999999647E-4</c:v>
                </c:pt>
                <c:pt idx="233">
                  <c:v>-2.7399999999999647E-4</c:v>
                </c:pt>
                <c:pt idx="234">
                  <c:v>-2.4400000000000116E-4</c:v>
                </c:pt>
                <c:pt idx="235">
                  <c:v>-2.1399999999999891E-4</c:v>
                </c:pt>
                <c:pt idx="236">
                  <c:v>-9.1000000000000802E-5</c:v>
                </c:pt>
                <c:pt idx="237">
                  <c:v>-9.1000000000000802E-5</c:v>
                </c:pt>
                <c:pt idx="238">
                  <c:v>-9.1000000000000802E-5</c:v>
                </c:pt>
                <c:pt idx="239">
                  <c:v>-1.3699999999999823E-4</c:v>
                </c:pt>
                <c:pt idx="240">
                  <c:v>-1.5199999999999936E-4</c:v>
                </c:pt>
                <c:pt idx="241">
                  <c:v>-4.4999999999999901E-5</c:v>
                </c:pt>
                <c:pt idx="242">
                  <c:v>-9.1000000000000802E-5</c:v>
                </c:pt>
                <c:pt idx="243">
                  <c:v>-1.0600000000000193E-4</c:v>
                </c:pt>
                <c:pt idx="244">
                  <c:v>-1.0600000000000193E-4</c:v>
                </c:pt>
                <c:pt idx="245">
                  <c:v>-9.1000000000000802E-5</c:v>
                </c:pt>
                <c:pt idx="246">
                  <c:v>1.0000000000010001E-6</c:v>
                </c:pt>
                <c:pt idx="247">
                  <c:v>3.1000000000003247E-5</c:v>
                </c:pt>
                <c:pt idx="248">
                  <c:v>6.1999999999999555E-5</c:v>
                </c:pt>
                <c:pt idx="249">
                  <c:v>1.5999999999998654E-5</c:v>
                </c:pt>
                <c:pt idx="250">
                  <c:v>3.1000000000003247E-5</c:v>
                </c:pt>
                <c:pt idx="251">
                  <c:v>1.0700000000000293E-4</c:v>
                </c:pt>
                <c:pt idx="252">
                  <c:v>1.8300000000000261E-4</c:v>
                </c:pt>
                <c:pt idx="253">
                  <c:v>1.8400000000000361E-4</c:v>
                </c:pt>
                <c:pt idx="254">
                  <c:v>1.5300000000000036E-4</c:v>
                </c:pt>
                <c:pt idx="255">
                  <c:v>1.8400000000000014E-4</c:v>
                </c:pt>
                <c:pt idx="256">
                  <c:v>3.6600000000000174E-4</c:v>
                </c:pt>
                <c:pt idx="257">
                  <c:v>4.4299999999999895E-4</c:v>
                </c:pt>
                <c:pt idx="258">
                  <c:v>3.5199999999999815E-4</c:v>
                </c:pt>
                <c:pt idx="259">
                  <c:v>4.740000000000022E-4</c:v>
                </c:pt>
                <c:pt idx="260">
                  <c:v>5.3500000000000075E-4</c:v>
                </c:pt>
                <c:pt idx="261">
                  <c:v>6.2600000000000156E-4</c:v>
                </c:pt>
                <c:pt idx="262">
                  <c:v>7.1800000000000336E-4</c:v>
                </c:pt>
                <c:pt idx="263">
                  <c:v>6.5599999999999686E-4</c:v>
                </c:pt>
                <c:pt idx="264">
                  <c:v>7.1799999999999989E-4</c:v>
                </c:pt>
                <c:pt idx="265">
                  <c:v>9.1600000000000015E-4</c:v>
                </c:pt>
                <c:pt idx="266">
                  <c:v>9.9199999999999983E-4</c:v>
                </c:pt>
                <c:pt idx="267">
                  <c:v>9.6199999999999758E-4</c:v>
                </c:pt>
                <c:pt idx="268">
                  <c:v>1.0379999999999973E-3</c:v>
                </c:pt>
                <c:pt idx="269">
                  <c:v>1.0530000000000019E-3</c:v>
                </c:pt>
                <c:pt idx="270">
                  <c:v>9.9199999999999983E-4</c:v>
                </c:pt>
                <c:pt idx="271">
                  <c:v>1.0219999999999986E-3</c:v>
                </c:pt>
                <c:pt idx="272">
                  <c:v>1.0380000000000007E-3</c:v>
                </c:pt>
                <c:pt idx="273">
                  <c:v>1.0379999999999973E-3</c:v>
                </c:pt>
                <c:pt idx="274">
                  <c:v>1.0530000000000019E-3</c:v>
                </c:pt>
                <c:pt idx="275">
                  <c:v>1.0220000000000021E-3</c:v>
                </c:pt>
                <c:pt idx="276">
                  <c:v>1.0070000000000009E-3</c:v>
                </c:pt>
                <c:pt idx="277">
                  <c:v>1.1000000000000038E-3</c:v>
                </c:pt>
                <c:pt idx="278">
                  <c:v>1.1909999999999976E-3</c:v>
                </c:pt>
                <c:pt idx="279">
                  <c:v>1.2059999999999987E-3</c:v>
                </c:pt>
                <c:pt idx="280">
                  <c:v>1.2659999999999998E-3</c:v>
                </c:pt>
                <c:pt idx="281">
                  <c:v>1.2969999999999995E-3</c:v>
                </c:pt>
                <c:pt idx="282">
                  <c:v>1.297000000000003E-3</c:v>
                </c:pt>
                <c:pt idx="283">
                  <c:v>1.3430000000000039E-3</c:v>
                </c:pt>
                <c:pt idx="284">
                  <c:v>1.405E-3</c:v>
                </c:pt>
                <c:pt idx="285">
                  <c:v>1.5109999999999985E-3</c:v>
                </c:pt>
                <c:pt idx="286">
                  <c:v>1.6330000000000025E-3</c:v>
                </c:pt>
                <c:pt idx="287">
                  <c:v>1.8159999999999982E-3</c:v>
                </c:pt>
                <c:pt idx="288">
                  <c:v>1.969000000000002E-3</c:v>
                </c:pt>
                <c:pt idx="289">
                  <c:v>2.1060000000000002E-3</c:v>
                </c:pt>
                <c:pt idx="290">
                  <c:v>2.2290000000000018E-3</c:v>
                </c:pt>
                <c:pt idx="291">
                  <c:v>2.3500000000000014E-3</c:v>
                </c:pt>
                <c:pt idx="292">
                  <c:v>2.5179999999999994E-3</c:v>
                </c:pt>
                <c:pt idx="293">
                  <c:v>2.6709999999999998E-3</c:v>
                </c:pt>
                <c:pt idx="294">
                  <c:v>2.869E-3</c:v>
                </c:pt>
                <c:pt idx="295">
                  <c:v>2.9760000000000029E-3</c:v>
                </c:pt>
                <c:pt idx="296">
                  <c:v>3.0670000000000003E-3</c:v>
                </c:pt>
                <c:pt idx="297">
                  <c:v>3.1130000000000012E-3</c:v>
                </c:pt>
                <c:pt idx="298">
                  <c:v>3.2500000000000029E-3</c:v>
                </c:pt>
                <c:pt idx="299">
                  <c:v>3.2510000000000004E-3</c:v>
                </c:pt>
                <c:pt idx="300">
                  <c:v>3.2360000000000028E-3</c:v>
                </c:pt>
                <c:pt idx="301">
                  <c:v>3.1899999999999984E-3</c:v>
                </c:pt>
                <c:pt idx="302">
                  <c:v>3.0670000000000003E-3</c:v>
                </c:pt>
                <c:pt idx="303">
                  <c:v>3.0530000000000002E-3</c:v>
                </c:pt>
                <c:pt idx="304">
                  <c:v>3.0830000000000024E-3</c:v>
                </c:pt>
                <c:pt idx="305">
                  <c:v>2.9759999999999995E-3</c:v>
                </c:pt>
                <c:pt idx="306">
                  <c:v>2.7930000000000003E-3</c:v>
                </c:pt>
                <c:pt idx="307">
                  <c:v>2.7170000000000007E-3</c:v>
                </c:pt>
                <c:pt idx="308">
                  <c:v>2.6709999999999998E-3</c:v>
                </c:pt>
                <c:pt idx="309">
                  <c:v>2.5939999999999991E-3</c:v>
                </c:pt>
                <c:pt idx="310">
                  <c:v>2.5179999999999994E-3</c:v>
                </c:pt>
                <c:pt idx="311">
                  <c:v>2.4729999999999995E-3</c:v>
                </c:pt>
                <c:pt idx="312">
                  <c:v>2.4270000000000021E-3</c:v>
                </c:pt>
                <c:pt idx="313">
                  <c:v>2.4109999999999999E-3</c:v>
                </c:pt>
                <c:pt idx="314">
                  <c:v>2.3960000000000023E-3</c:v>
                </c:pt>
                <c:pt idx="315">
                  <c:v>2.3960000000000023E-3</c:v>
                </c:pt>
                <c:pt idx="316">
                  <c:v>2.4419999999999997E-3</c:v>
                </c:pt>
                <c:pt idx="317">
                  <c:v>2.4869999999999996E-3</c:v>
                </c:pt>
                <c:pt idx="318">
                  <c:v>2.6100000000000012E-3</c:v>
                </c:pt>
                <c:pt idx="319">
                  <c:v>2.7620000000000006E-3</c:v>
                </c:pt>
                <c:pt idx="320">
                  <c:v>2.9150000000000009E-3</c:v>
                </c:pt>
                <c:pt idx="321">
                  <c:v>3.0360000000000005E-3</c:v>
                </c:pt>
                <c:pt idx="322">
                  <c:v>3.2660000000000015E-3</c:v>
                </c:pt>
                <c:pt idx="323">
                  <c:v>3.4789999999999995E-3</c:v>
                </c:pt>
                <c:pt idx="324">
                  <c:v>3.6160000000000012E-3</c:v>
                </c:pt>
                <c:pt idx="325">
                  <c:v>3.8159999999999999E-3</c:v>
                </c:pt>
                <c:pt idx="326">
                  <c:v>4.0740000000000012E-3</c:v>
                </c:pt>
                <c:pt idx="327">
                  <c:v>4.3040000000000023E-3</c:v>
                </c:pt>
                <c:pt idx="328">
                  <c:v>4.4710000000000027E-3</c:v>
                </c:pt>
                <c:pt idx="329">
                  <c:v>4.608000000000001E-3</c:v>
                </c:pt>
                <c:pt idx="330">
                  <c:v>4.7299999999999981E-3</c:v>
                </c:pt>
                <c:pt idx="331">
                  <c:v>4.8990000000000006E-3</c:v>
                </c:pt>
                <c:pt idx="332">
                  <c:v>4.9750000000000003E-3</c:v>
                </c:pt>
                <c:pt idx="333">
                  <c:v>4.9440000000000005E-3</c:v>
                </c:pt>
                <c:pt idx="334">
                  <c:v>4.9900000000000014E-3</c:v>
                </c:pt>
                <c:pt idx="335">
                  <c:v>4.9289999999999994E-3</c:v>
                </c:pt>
                <c:pt idx="336">
                  <c:v>4.7620000000000023E-3</c:v>
                </c:pt>
                <c:pt idx="337">
                  <c:v>4.6229999999999986E-3</c:v>
                </c:pt>
                <c:pt idx="338">
                  <c:v>4.4869999999999979E-3</c:v>
                </c:pt>
                <c:pt idx="339">
                  <c:v>4.1659999999999996E-3</c:v>
                </c:pt>
                <c:pt idx="340">
                  <c:v>3.8459999999999987E-3</c:v>
                </c:pt>
                <c:pt idx="341">
                  <c:v>3.601E-3</c:v>
                </c:pt>
                <c:pt idx="342">
                  <c:v>3.311999999999999E-3</c:v>
                </c:pt>
                <c:pt idx="343">
                  <c:v>2.9460000000000007E-3</c:v>
                </c:pt>
                <c:pt idx="344">
                  <c:v>2.6549999999999976E-3</c:v>
                </c:pt>
                <c:pt idx="345">
                  <c:v>2.3350000000000003E-3</c:v>
                </c:pt>
                <c:pt idx="346">
                  <c:v>1.9389999999999998E-3</c:v>
                </c:pt>
                <c:pt idx="347">
                  <c:v>1.5879999999999991E-3</c:v>
                </c:pt>
                <c:pt idx="348">
                  <c:v>1.3279999999999993E-3</c:v>
                </c:pt>
                <c:pt idx="349">
                  <c:v>1.0529999999999984E-3</c:v>
                </c:pt>
                <c:pt idx="350">
                  <c:v>7.6299999999999979E-4</c:v>
                </c:pt>
                <c:pt idx="351">
                  <c:v>5.3500000000000075E-4</c:v>
                </c:pt>
                <c:pt idx="352">
                  <c:v>5.0399999999999751E-4</c:v>
                </c:pt>
                <c:pt idx="353">
                  <c:v>3.6699999999999927E-4</c:v>
                </c:pt>
                <c:pt idx="354">
                  <c:v>1.9800000000000026E-4</c:v>
                </c:pt>
                <c:pt idx="355">
                  <c:v>7.7000000000000679E-5</c:v>
                </c:pt>
                <c:pt idx="356">
                  <c:v>0</c:v>
                </c:pt>
                <c:pt idx="357">
                  <c:v>-3.0000000000002247E-5</c:v>
                </c:pt>
                <c:pt idx="358">
                  <c:v>-5.9999999999997555E-5</c:v>
                </c:pt>
                <c:pt idx="359">
                  <c:v>-1.0699999999999946E-4</c:v>
                </c:pt>
                <c:pt idx="360">
                  <c:v>-1.3699999999999823E-4</c:v>
                </c:pt>
                <c:pt idx="361">
                  <c:v>-1.3699999999999823E-4</c:v>
                </c:pt>
                <c:pt idx="362">
                  <c:v>-1.8299999999999914E-4</c:v>
                </c:pt>
                <c:pt idx="363">
                  <c:v>-2.1299999999999791E-4</c:v>
                </c:pt>
                <c:pt idx="364">
                  <c:v>-2.2900000000000004E-4</c:v>
                </c:pt>
                <c:pt idx="365">
                  <c:v>-3.2000000000000084E-4</c:v>
                </c:pt>
                <c:pt idx="366">
                  <c:v>-3.2000000000000084E-4</c:v>
                </c:pt>
                <c:pt idx="367">
                  <c:v>-2.8900000000000106E-4</c:v>
                </c:pt>
                <c:pt idx="368">
                  <c:v>-2.8899999999999759E-4</c:v>
                </c:pt>
                <c:pt idx="369">
                  <c:v>-3.4999999999999962E-4</c:v>
                </c:pt>
                <c:pt idx="370">
                  <c:v>-4.259999999999993E-4</c:v>
                </c:pt>
                <c:pt idx="371">
                  <c:v>-3.8099999999999939E-4</c:v>
                </c:pt>
                <c:pt idx="372">
                  <c:v>-3.6599999999999827E-4</c:v>
                </c:pt>
                <c:pt idx="373">
                  <c:v>-3.3499999999999849E-4</c:v>
                </c:pt>
                <c:pt idx="374">
                  <c:v>-2.5899999999999881E-4</c:v>
                </c:pt>
                <c:pt idx="375">
                  <c:v>-2.4399999999999769E-4</c:v>
                </c:pt>
                <c:pt idx="376">
                  <c:v>-2.5899999999999881E-4</c:v>
                </c:pt>
                <c:pt idx="377">
                  <c:v>-3.8099999999999939E-4</c:v>
                </c:pt>
                <c:pt idx="378">
                  <c:v>-3.8099999999999939E-4</c:v>
                </c:pt>
                <c:pt idx="379">
                  <c:v>-3.2000000000000084E-4</c:v>
                </c:pt>
                <c:pt idx="380">
                  <c:v>-3.8099999999999939E-4</c:v>
                </c:pt>
                <c:pt idx="381">
                  <c:v>-3.5100000000000062E-4</c:v>
                </c:pt>
                <c:pt idx="382">
                  <c:v>-2.8999999999999859E-4</c:v>
                </c:pt>
                <c:pt idx="383">
                  <c:v>-2.7399999999999994E-4</c:v>
                </c:pt>
                <c:pt idx="384">
                  <c:v>-2.9000000000000206E-4</c:v>
                </c:pt>
                <c:pt idx="385">
                  <c:v>-3.9600000000000052E-4</c:v>
                </c:pt>
                <c:pt idx="386">
                  <c:v>-3.5100000000000062E-4</c:v>
                </c:pt>
                <c:pt idx="387">
                  <c:v>-3.4999999999999962E-4</c:v>
                </c:pt>
                <c:pt idx="388">
                  <c:v>-3.0499999999999972E-4</c:v>
                </c:pt>
                <c:pt idx="389">
                  <c:v>-3.2000000000000084E-4</c:v>
                </c:pt>
                <c:pt idx="390">
                  <c:v>-3.0400000000000219E-4</c:v>
                </c:pt>
                <c:pt idx="391">
                  <c:v>-3.8099999999999939E-4</c:v>
                </c:pt>
                <c:pt idx="392">
                  <c:v>-3.6500000000000074E-4</c:v>
                </c:pt>
                <c:pt idx="393">
                  <c:v>-3.3499999999999849E-4</c:v>
                </c:pt>
                <c:pt idx="394">
                  <c:v>-4.2699999999999683E-4</c:v>
                </c:pt>
                <c:pt idx="395">
                  <c:v>-3.9600000000000052E-4</c:v>
                </c:pt>
                <c:pt idx="396">
                  <c:v>-3.9700000000000152E-4</c:v>
                </c:pt>
                <c:pt idx="397">
                  <c:v>-4.2699999999999683E-4</c:v>
                </c:pt>
                <c:pt idx="398">
                  <c:v>-3.8099999999999939E-4</c:v>
                </c:pt>
                <c:pt idx="399">
                  <c:v>-3.0399999999999872E-4</c:v>
                </c:pt>
                <c:pt idx="400">
                  <c:v>-3.6599999999999827E-4</c:v>
                </c:pt>
                <c:pt idx="401">
                  <c:v>-3.9700000000000152E-4</c:v>
                </c:pt>
                <c:pt idx="402">
                  <c:v>-3.0399999999999872E-4</c:v>
                </c:pt>
                <c:pt idx="403">
                  <c:v>-2.8999999999999859E-4</c:v>
                </c:pt>
                <c:pt idx="404">
                  <c:v>-2.9000000000000206E-4</c:v>
                </c:pt>
                <c:pt idx="405">
                  <c:v>-2.7500000000000094E-4</c:v>
                </c:pt>
                <c:pt idx="406">
                  <c:v>-2.2900000000000004E-4</c:v>
                </c:pt>
                <c:pt idx="407">
                  <c:v>-1.820000000000016E-4</c:v>
                </c:pt>
                <c:pt idx="408">
                  <c:v>-1.9799999999999679E-4</c:v>
                </c:pt>
                <c:pt idx="409">
                  <c:v>-2.1299999999999791E-4</c:v>
                </c:pt>
                <c:pt idx="410">
                  <c:v>-2.5900000000000228E-4</c:v>
                </c:pt>
                <c:pt idx="411">
                  <c:v>-2.4300000000000016E-4</c:v>
                </c:pt>
                <c:pt idx="412">
                  <c:v>-1.6800000000000148E-4</c:v>
                </c:pt>
                <c:pt idx="413">
                  <c:v>-2.2799999999999904E-4</c:v>
                </c:pt>
                <c:pt idx="414">
                  <c:v>-2.7399999999999994E-4</c:v>
                </c:pt>
                <c:pt idx="415">
                  <c:v>-2.1299999999999791E-4</c:v>
                </c:pt>
                <c:pt idx="416">
                  <c:v>-1.6700000000000048E-4</c:v>
                </c:pt>
                <c:pt idx="417">
                  <c:v>-1.820000000000016E-4</c:v>
                </c:pt>
                <c:pt idx="418">
                  <c:v>-2.5900000000000228E-4</c:v>
                </c:pt>
                <c:pt idx="419">
                  <c:v>-2.2799999999999904E-4</c:v>
                </c:pt>
                <c:pt idx="420">
                  <c:v>-1.8299999999999914E-4</c:v>
                </c:pt>
                <c:pt idx="421">
                  <c:v>-2.9999999999998778E-5</c:v>
                </c:pt>
                <c:pt idx="422">
                  <c:v>-2.9999999999998778E-5</c:v>
                </c:pt>
                <c:pt idx="423">
                  <c:v>-1.0700000000000293E-4</c:v>
                </c:pt>
                <c:pt idx="424">
                  <c:v>-1.0599999999999846E-4</c:v>
                </c:pt>
                <c:pt idx="425">
                  <c:v>-1.2099999999999958E-4</c:v>
                </c:pt>
                <c:pt idx="426">
                  <c:v>-9.1000000000000802E-5</c:v>
                </c:pt>
                <c:pt idx="427">
                  <c:v>-1.3699999999999823E-4</c:v>
                </c:pt>
                <c:pt idx="428">
                  <c:v>-1.2200000000000058E-4</c:v>
                </c:pt>
                <c:pt idx="429">
                  <c:v>-9.1000000000000802E-5</c:v>
                </c:pt>
                <c:pt idx="430">
                  <c:v>-1.6800000000000148E-4</c:v>
                </c:pt>
                <c:pt idx="431">
                  <c:v>-2.2799999999999904E-4</c:v>
                </c:pt>
                <c:pt idx="432">
                  <c:v>-1.2199999999999711E-4</c:v>
                </c:pt>
                <c:pt idx="433">
                  <c:v>-2.1399999999999891E-4</c:v>
                </c:pt>
                <c:pt idx="434">
                  <c:v>-2.5899999999999881E-4</c:v>
                </c:pt>
                <c:pt idx="435">
                  <c:v>-2.1300000000000138E-4</c:v>
                </c:pt>
                <c:pt idx="436">
                  <c:v>-2.7399999999999994E-4</c:v>
                </c:pt>
                <c:pt idx="437">
                  <c:v>-2.8900000000000106E-4</c:v>
                </c:pt>
                <c:pt idx="438">
                  <c:v>-2.4300000000000016E-4</c:v>
                </c:pt>
                <c:pt idx="439">
                  <c:v>-1.8299999999999914E-4</c:v>
                </c:pt>
                <c:pt idx="440">
                  <c:v>-1.6700000000000048E-4</c:v>
                </c:pt>
                <c:pt idx="441">
                  <c:v>-1.8299999999999914E-4</c:v>
                </c:pt>
                <c:pt idx="442">
                  <c:v>-1.9800000000000026E-4</c:v>
                </c:pt>
                <c:pt idx="443">
                  <c:v>-1.8299999999999914E-4</c:v>
                </c:pt>
                <c:pt idx="444">
                  <c:v>-1.5300000000000036E-4</c:v>
                </c:pt>
                <c:pt idx="445">
                  <c:v>-1.2199999999999711E-4</c:v>
                </c:pt>
                <c:pt idx="446">
                  <c:v>-1.3599999999999723E-4</c:v>
                </c:pt>
                <c:pt idx="447">
                  <c:v>-9.1000000000000802E-5</c:v>
                </c:pt>
                <c:pt idx="448">
                  <c:v>-7.5999999999999679E-5</c:v>
                </c:pt>
                <c:pt idx="449">
                  <c:v>-1.8300000000000261E-4</c:v>
                </c:pt>
                <c:pt idx="450">
                  <c:v>-1.8299999999999914E-4</c:v>
                </c:pt>
                <c:pt idx="451">
                  <c:v>-2.1299999999999791E-4</c:v>
                </c:pt>
                <c:pt idx="452">
                  <c:v>-1.9800000000000026E-4</c:v>
                </c:pt>
                <c:pt idx="453">
                  <c:v>-1.5199999999999936E-4</c:v>
                </c:pt>
                <c:pt idx="454">
                  <c:v>-1.9800000000000026E-4</c:v>
                </c:pt>
                <c:pt idx="455">
                  <c:v>-1.6700000000000048E-4</c:v>
                </c:pt>
                <c:pt idx="456">
                  <c:v>-1.0699999999999946E-4</c:v>
                </c:pt>
                <c:pt idx="457">
                  <c:v>-9.0999999999997333E-5</c:v>
                </c:pt>
                <c:pt idx="458">
                  <c:v>-1.5199999999999936E-4</c:v>
                </c:pt>
                <c:pt idx="459">
                  <c:v>-1.9800000000000026E-4</c:v>
                </c:pt>
                <c:pt idx="460">
                  <c:v>-1.3699999999999823E-4</c:v>
                </c:pt>
                <c:pt idx="461">
                  <c:v>-1.0600000000000193E-4</c:v>
                </c:pt>
                <c:pt idx="462">
                  <c:v>-1.3699999999999823E-4</c:v>
                </c:pt>
                <c:pt idx="463">
                  <c:v>-1.2099999999999958E-4</c:v>
                </c:pt>
                <c:pt idx="464">
                  <c:v>-1.0599999999999846E-4</c:v>
                </c:pt>
                <c:pt idx="465">
                  <c:v>-9.1000000000000802E-5</c:v>
                </c:pt>
                <c:pt idx="466">
                  <c:v>-4.4999999999999901E-5</c:v>
                </c:pt>
                <c:pt idx="467">
                  <c:v>-2.9999999999998778E-5</c:v>
                </c:pt>
                <c:pt idx="468">
                  <c:v>-1.0599999999999846E-4</c:v>
                </c:pt>
                <c:pt idx="469">
                  <c:v>-3.0000000000002247E-5</c:v>
                </c:pt>
                <c:pt idx="470">
                  <c:v>-9.1000000000000802E-5</c:v>
                </c:pt>
                <c:pt idx="471">
                  <c:v>-7.5999999999999679E-5</c:v>
                </c:pt>
                <c:pt idx="472">
                  <c:v>0</c:v>
                </c:pt>
                <c:pt idx="473">
                  <c:v>-2.9999999999998778E-5</c:v>
                </c:pt>
                <c:pt idx="474">
                  <c:v>-4.4999999999999901E-5</c:v>
                </c:pt>
                <c:pt idx="475">
                  <c:v>-1.5300000000000036E-4</c:v>
                </c:pt>
                <c:pt idx="476">
                  <c:v>-1.6700000000000048E-4</c:v>
                </c:pt>
                <c:pt idx="477">
                  <c:v>-5.9999999999997555E-5</c:v>
                </c:pt>
                <c:pt idx="478">
                  <c:v>-4.4999999999999901E-5</c:v>
                </c:pt>
                <c:pt idx="479">
                  <c:v>-1.0599999999999846E-4</c:v>
                </c:pt>
                <c:pt idx="480">
                  <c:v>-7.4999999999998679E-5</c:v>
                </c:pt>
                <c:pt idx="481">
                  <c:v>-4.4999999999999901E-5</c:v>
                </c:pt>
                <c:pt idx="482">
                  <c:v>-6.0999999999998555E-5</c:v>
                </c:pt>
                <c:pt idx="483">
                  <c:v>-5.9999999999997555E-5</c:v>
                </c:pt>
                <c:pt idx="484">
                  <c:v>-7.5999999999999679E-5</c:v>
                </c:pt>
                <c:pt idx="485">
                  <c:v>-7.4999999999998679E-5</c:v>
                </c:pt>
                <c:pt idx="486">
                  <c:v>-2.9999999999998778E-5</c:v>
                </c:pt>
                <c:pt idx="487">
                  <c:v>-1.0599999999999846E-4</c:v>
                </c:pt>
                <c:pt idx="488">
                  <c:v>-6.0000000000001025E-5</c:v>
                </c:pt>
                <c:pt idx="489">
                  <c:v>4.5999999999997432E-5</c:v>
                </c:pt>
                <c:pt idx="490">
                  <c:v>3.0999999999999778E-5</c:v>
                </c:pt>
                <c:pt idx="491">
                  <c:v>4.7000000000001901E-5</c:v>
                </c:pt>
                <c:pt idx="492">
                  <c:v>1.0800000000000046E-4</c:v>
                </c:pt>
                <c:pt idx="493">
                  <c:v>0</c:v>
                </c:pt>
                <c:pt idx="494">
                  <c:v>0</c:v>
                </c:pt>
                <c:pt idx="495">
                  <c:v>0</c:v>
                </c:pt>
                <c:pt idx="496">
                  <c:v>0</c:v>
                </c:pt>
                <c:pt idx="497">
                  <c:v>-1.4999999999997654E-5</c:v>
                </c:pt>
                <c:pt idx="498">
                  <c:v>0</c:v>
                </c:pt>
                <c:pt idx="499">
                  <c:v>7.7000000000000679E-5</c:v>
                </c:pt>
                <c:pt idx="500">
                  <c:v>7.5999999999999679E-5</c:v>
                </c:pt>
                <c:pt idx="501">
                  <c:v>1.0800000000000393E-4</c:v>
                </c:pt>
                <c:pt idx="502">
                  <c:v>1.0800000000000046E-4</c:v>
                </c:pt>
                <c:pt idx="503">
                  <c:v>9.2000000000001803E-5</c:v>
                </c:pt>
                <c:pt idx="504">
                  <c:v>3.1000000000003247E-5</c:v>
                </c:pt>
                <c:pt idx="505">
                  <c:v>4.6000000000000901E-5</c:v>
                </c:pt>
                <c:pt idx="506">
                  <c:v>3.0999999999999778E-5</c:v>
                </c:pt>
                <c:pt idx="507">
                  <c:v>-1.4999999999997654E-5</c:v>
                </c:pt>
                <c:pt idx="508">
                  <c:v>-4.4999999999999901E-5</c:v>
                </c:pt>
                <c:pt idx="509">
                  <c:v>1.0000000000010001E-6</c:v>
                </c:pt>
                <c:pt idx="510">
                  <c:v>-2.9999999999998778E-5</c:v>
                </c:pt>
              </c:numCache>
            </c:numRef>
          </c:yVal>
          <c:smooth val="1"/>
          <c:extLst>
            <c:ext xmlns:c16="http://schemas.microsoft.com/office/drawing/2014/chart" uri="{C3380CC4-5D6E-409C-BE32-E72D297353CC}">
              <c16:uniqueId val="{00000000-8A0C-4BAA-96FA-67C4F2B46522}"/>
            </c:ext>
          </c:extLst>
        </c:ser>
        <c:dLbls>
          <c:showLegendKey val="0"/>
          <c:showVal val="0"/>
          <c:showCatName val="0"/>
          <c:showSerName val="0"/>
          <c:showPercent val="0"/>
          <c:showBubbleSize val="0"/>
        </c:dLbls>
        <c:axId val="149729904"/>
        <c:axId val="150022288"/>
      </c:scatterChart>
      <c:valAx>
        <c:axId val="149729904"/>
        <c:scaling>
          <c:orientation val="minMax"/>
          <c:max val="700"/>
          <c:min val="265"/>
        </c:scaling>
        <c:delete val="0"/>
        <c:axPos val="b"/>
        <c:title>
          <c:tx>
            <c:rich>
              <a:bodyPr/>
              <a:lstStyle/>
              <a:p>
                <a:pPr>
                  <a:defRPr/>
                </a:pPr>
                <a:r>
                  <a:rPr lang="en-GB" dirty="0"/>
                  <a:t>Wavelength (nm)</a:t>
                </a:r>
              </a:p>
            </c:rich>
          </c:tx>
          <c:layout/>
          <c:overlay val="0"/>
        </c:title>
        <c:numFmt formatCode="General" sourceLinked="1"/>
        <c:majorTickMark val="out"/>
        <c:minorTickMark val="none"/>
        <c:tickLblPos val="nextTo"/>
        <c:crossAx val="150022288"/>
        <c:crosses val="autoZero"/>
        <c:crossBetween val="midCat"/>
      </c:valAx>
      <c:valAx>
        <c:axId val="150022288"/>
        <c:scaling>
          <c:orientation val="minMax"/>
          <c:max val="0.4"/>
          <c:min val="0"/>
        </c:scaling>
        <c:delete val="0"/>
        <c:axPos val="l"/>
        <c:title>
          <c:tx>
            <c:rich>
              <a:bodyPr rot="-5400000" vert="horz"/>
              <a:lstStyle/>
              <a:p>
                <a:pPr>
                  <a:defRPr/>
                </a:pPr>
                <a:r>
                  <a:rPr lang="en-GB"/>
                  <a:t>Absorbance (a.u.)</a:t>
                </a:r>
              </a:p>
            </c:rich>
          </c:tx>
          <c:layout/>
          <c:overlay val="0"/>
        </c:title>
        <c:numFmt formatCode="General" sourceLinked="1"/>
        <c:majorTickMark val="out"/>
        <c:minorTickMark val="none"/>
        <c:tickLblPos val="nextTo"/>
        <c:crossAx val="149729904"/>
        <c:crosses val="autoZero"/>
        <c:crossBetween val="midCat"/>
      </c:valAx>
    </c:plotArea>
    <c:plotVisOnly val="1"/>
    <c:dispBlanksAs val="gap"/>
    <c:showDLblsOverMax val="0"/>
  </c:chart>
  <c:externalData r:id="rId1">
    <c:autoUpdate val="0"/>
  </c:externalData>
</c:chartSpace>
</file>

<file path=ppt/charts/chart9.xml><?xml version="1.0" encoding="utf-8"?>
<c:chartSpace xmlns:c="http://schemas.openxmlformats.org/drawingml/2006/chart" xmlns:a="http://schemas.openxmlformats.org/drawingml/2006/main" xmlns:r="http://schemas.openxmlformats.org/officeDocument/2006/relationships" xmlns:c16r2="http://schemas.microsoft.com/office/drawing/2015/06/chart">
  <c:date1904 val="0"/>
  <c:lang val="en-US"/>
  <c:roundedCorners val="0"/>
  <mc:AlternateContent xmlns:mc="http://schemas.openxmlformats.org/markup-compatibility/2006">
    <mc:Choice xmlns:c14="http://schemas.microsoft.com/office/drawing/2007/8/2/chart" Requires="c14">
      <c14:style val="102"/>
    </mc:Choice>
    <mc:Fallback>
      <c:style val="2"/>
    </mc:Fallback>
  </mc:AlternateContent>
  <c:chart>
    <c:autoTitleDeleted val="1"/>
    <c:plotArea>
      <c:layout/>
      <c:scatterChart>
        <c:scatterStyle val="smoothMarker"/>
        <c:varyColors val="0"/>
        <c:ser>
          <c:idx val="0"/>
          <c:order val="0"/>
          <c:spPr>
            <a:ln>
              <a:solidFill>
                <a:schemeClr val="tx1"/>
              </a:solidFill>
            </a:ln>
          </c:spPr>
          <c:marker>
            <c:symbol val="none"/>
          </c:marker>
          <c:xVal>
            <c:numRef>
              <c:f>Sheet1!$R$3:$R$513</c:f>
              <c:numCache>
                <c:formatCode>General</c:formatCode>
                <c:ptCount val="511"/>
                <c:pt idx="0">
                  <c:v>190</c:v>
                </c:pt>
                <c:pt idx="1">
                  <c:v>191</c:v>
                </c:pt>
                <c:pt idx="2">
                  <c:v>192</c:v>
                </c:pt>
                <c:pt idx="3">
                  <c:v>193</c:v>
                </c:pt>
                <c:pt idx="4">
                  <c:v>194</c:v>
                </c:pt>
                <c:pt idx="5">
                  <c:v>195</c:v>
                </c:pt>
                <c:pt idx="6">
                  <c:v>196</c:v>
                </c:pt>
                <c:pt idx="7">
                  <c:v>197</c:v>
                </c:pt>
                <c:pt idx="8">
                  <c:v>198</c:v>
                </c:pt>
                <c:pt idx="9">
                  <c:v>199</c:v>
                </c:pt>
                <c:pt idx="10">
                  <c:v>200</c:v>
                </c:pt>
                <c:pt idx="11">
                  <c:v>201</c:v>
                </c:pt>
                <c:pt idx="12">
                  <c:v>202</c:v>
                </c:pt>
                <c:pt idx="13">
                  <c:v>203</c:v>
                </c:pt>
                <c:pt idx="14">
                  <c:v>204</c:v>
                </c:pt>
                <c:pt idx="15">
                  <c:v>205</c:v>
                </c:pt>
                <c:pt idx="16">
                  <c:v>206</c:v>
                </c:pt>
                <c:pt idx="17">
                  <c:v>207</c:v>
                </c:pt>
                <c:pt idx="18">
                  <c:v>208</c:v>
                </c:pt>
                <c:pt idx="19">
                  <c:v>209</c:v>
                </c:pt>
                <c:pt idx="20">
                  <c:v>210</c:v>
                </c:pt>
                <c:pt idx="21">
                  <c:v>211</c:v>
                </c:pt>
                <c:pt idx="22">
                  <c:v>212</c:v>
                </c:pt>
                <c:pt idx="23">
                  <c:v>213</c:v>
                </c:pt>
                <c:pt idx="24">
                  <c:v>214</c:v>
                </c:pt>
                <c:pt idx="25">
                  <c:v>215</c:v>
                </c:pt>
                <c:pt idx="26">
                  <c:v>216</c:v>
                </c:pt>
                <c:pt idx="27">
                  <c:v>217</c:v>
                </c:pt>
                <c:pt idx="28">
                  <c:v>218</c:v>
                </c:pt>
                <c:pt idx="29">
                  <c:v>219</c:v>
                </c:pt>
                <c:pt idx="30">
                  <c:v>220</c:v>
                </c:pt>
                <c:pt idx="31">
                  <c:v>221</c:v>
                </c:pt>
                <c:pt idx="32">
                  <c:v>222</c:v>
                </c:pt>
                <c:pt idx="33">
                  <c:v>223</c:v>
                </c:pt>
                <c:pt idx="34">
                  <c:v>224</c:v>
                </c:pt>
                <c:pt idx="35">
                  <c:v>225</c:v>
                </c:pt>
                <c:pt idx="36">
                  <c:v>226</c:v>
                </c:pt>
                <c:pt idx="37">
                  <c:v>227</c:v>
                </c:pt>
                <c:pt idx="38">
                  <c:v>228</c:v>
                </c:pt>
                <c:pt idx="39">
                  <c:v>229</c:v>
                </c:pt>
                <c:pt idx="40">
                  <c:v>230</c:v>
                </c:pt>
                <c:pt idx="41">
                  <c:v>231</c:v>
                </c:pt>
                <c:pt idx="42">
                  <c:v>232</c:v>
                </c:pt>
                <c:pt idx="43">
                  <c:v>233</c:v>
                </c:pt>
                <c:pt idx="44">
                  <c:v>234</c:v>
                </c:pt>
                <c:pt idx="45">
                  <c:v>235</c:v>
                </c:pt>
                <c:pt idx="46">
                  <c:v>236</c:v>
                </c:pt>
                <c:pt idx="47">
                  <c:v>237</c:v>
                </c:pt>
                <c:pt idx="48">
                  <c:v>238</c:v>
                </c:pt>
                <c:pt idx="49">
                  <c:v>239</c:v>
                </c:pt>
                <c:pt idx="50">
                  <c:v>240</c:v>
                </c:pt>
                <c:pt idx="51">
                  <c:v>241</c:v>
                </c:pt>
                <c:pt idx="52">
                  <c:v>242</c:v>
                </c:pt>
                <c:pt idx="53">
                  <c:v>243</c:v>
                </c:pt>
                <c:pt idx="54">
                  <c:v>244</c:v>
                </c:pt>
                <c:pt idx="55">
                  <c:v>245</c:v>
                </c:pt>
                <c:pt idx="56">
                  <c:v>246</c:v>
                </c:pt>
                <c:pt idx="57">
                  <c:v>247</c:v>
                </c:pt>
                <c:pt idx="58">
                  <c:v>248</c:v>
                </c:pt>
                <c:pt idx="59">
                  <c:v>249</c:v>
                </c:pt>
                <c:pt idx="60">
                  <c:v>250</c:v>
                </c:pt>
                <c:pt idx="61">
                  <c:v>251</c:v>
                </c:pt>
                <c:pt idx="62">
                  <c:v>252</c:v>
                </c:pt>
                <c:pt idx="63">
                  <c:v>253</c:v>
                </c:pt>
                <c:pt idx="64">
                  <c:v>254</c:v>
                </c:pt>
                <c:pt idx="65">
                  <c:v>255</c:v>
                </c:pt>
                <c:pt idx="66">
                  <c:v>256</c:v>
                </c:pt>
                <c:pt idx="67">
                  <c:v>257</c:v>
                </c:pt>
                <c:pt idx="68">
                  <c:v>258</c:v>
                </c:pt>
                <c:pt idx="69">
                  <c:v>259</c:v>
                </c:pt>
                <c:pt idx="70">
                  <c:v>260</c:v>
                </c:pt>
                <c:pt idx="71">
                  <c:v>261</c:v>
                </c:pt>
                <c:pt idx="72">
                  <c:v>262</c:v>
                </c:pt>
                <c:pt idx="73">
                  <c:v>263</c:v>
                </c:pt>
                <c:pt idx="74">
                  <c:v>264</c:v>
                </c:pt>
                <c:pt idx="75">
                  <c:v>265</c:v>
                </c:pt>
                <c:pt idx="76">
                  <c:v>266</c:v>
                </c:pt>
                <c:pt idx="77">
                  <c:v>267</c:v>
                </c:pt>
                <c:pt idx="78">
                  <c:v>268</c:v>
                </c:pt>
                <c:pt idx="79">
                  <c:v>269</c:v>
                </c:pt>
                <c:pt idx="80">
                  <c:v>270</c:v>
                </c:pt>
                <c:pt idx="81">
                  <c:v>271</c:v>
                </c:pt>
                <c:pt idx="82">
                  <c:v>272</c:v>
                </c:pt>
                <c:pt idx="83">
                  <c:v>273</c:v>
                </c:pt>
                <c:pt idx="84">
                  <c:v>274</c:v>
                </c:pt>
                <c:pt idx="85">
                  <c:v>275</c:v>
                </c:pt>
                <c:pt idx="86">
                  <c:v>276</c:v>
                </c:pt>
                <c:pt idx="87">
                  <c:v>277</c:v>
                </c:pt>
                <c:pt idx="88">
                  <c:v>278</c:v>
                </c:pt>
                <c:pt idx="89">
                  <c:v>279</c:v>
                </c:pt>
                <c:pt idx="90">
                  <c:v>280</c:v>
                </c:pt>
                <c:pt idx="91">
                  <c:v>281</c:v>
                </c:pt>
                <c:pt idx="92">
                  <c:v>282</c:v>
                </c:pt>
                <c:pt idx="93">
                  <c:v>283</c:v>
                </c:pt>
                <c:pt idx="94">
                  <c:v>284</c:v>
                </c:pt>
                <c:pt idx="95">
                  <c:v>285</c:v>
                </c:pt>
                <c:pt idx="96">
                  <c:v>286</c:v>
                </c:pt>
                <c:pt idx="97">
                  <c:v>287</c:v>
                </c:pt>
                <c:pt idx="98">
                  <c:v>288</c:v>
                </c:pt>
                <c:pt idx="99">
                  <c:v>289</c:v>
                </c:pt>
                <c:pt idx="100">
                  <c:v>290</c:v>
                </c:pt>
                <c:pt idx="101">
                  <c:v>291</c:v>
                </c:pt>
                <c:pt idx="102">
                  <c:v>292</c:v>
                </c:pt>
                <c:pt idx="103">
                  <c:v>293</c:v>
                </c:pt>
                <c:pt idx="104">
                  <c:v>294</c:v>
                </c:pt>
                <c:pt idx="105">
                  <c:v>295</c:v>
                </c:pt>
                <c:pt idx="106">
                  <c:v>296</c:v>
                </c:pt>
                <c:pt idx="107">
                  <c:v>297</c:v>
                </c:pt>
                <c:pt idx="108">
                  <c:v>298</c:v>
                </c:pt>
                <c:pt idx="109">
                  <c:v>299</c:v>
                </c:pt>
                <c:pt idx="110">
                  <c:v>300</c:v>
                </c:pt>
                <c:pt idx="111">
                  <c:v>301</c:v>
                </c:pt>
                <c:pt idx="112">
                  <c:v>302</c:v>
                </c:pt>
                <c:pt idx="113">
                  <c:v>303</c:v>
                </c:pt>
                <c:pt idx="114">
                  <c:v>304</c:v>
                </c:pt>
                <c:pt idx="115">
                  <c:v>305</c:v>
                </c:pt>
                <c:pt idx="116">
                  <c:v>306</c:v>
                </c:pt>
                <c:pt idx="117">
                  <c:v>307</c:v>
                </c:pt>
                <c:pt idx="118">
                  <c:v>308</c:v>
                </c:pt>
                <c:pt idx="119">
                  <c:v>309</c:v>
                </c:pt>
                <c:pt idx="120">
                  <c:v>310</c:v>
                </c:pt>
                <c:pt idx="121">
                  <c:v>311</c:v>
                </c:pt>
                <c:pt idx="122">
                  <c:v>312</c:v>
                </c:pt>
                <c:pt idx="123">
                  <c:v>313</c:v>
                </c:pt>
                <c:pt idx="124">
                  <c:v>314</c:v>
                </c:pt>
                <c:pt idx="125">
                  <c:v>315</c:v>
                </c:pt>
                <c:pt idx="126">
                  <c:v>316</c:v>
                </c:pt>
                <c:pt idx="127">
                  <c:v>317</c:v>
                </c:pt>
                <c:pt idx="128">
                  <c:v>318</c:v>
                </c:pt>
                <c:pt idx="129">
                  <c:v>319</c:v>
                </c:pt>
                <c:pt idx="130">
                  <c:v>320</c:v>
                </c:pt>
                <c:pt idx="131">
                  <c:v>321</c:v>
                </c:pt>
                <c:pt idx="132">
                  <c:v>322</c:v>
                </c:pt>
                <c:pt idx="133">
                  <c:v>323</c:v>
                </c:pt>
                <c:pt idx="134">
                  <c:v>324</c:v>
                </c:pt>
                <c:pt idx="135">
                  <c:v>325</c:v>
                </c:pt>
                <c:pt idx="136">
                  <c:v>326</c:v>
                </c:pt>
                <c:pt idx="137">
                  <c:v>327</c:v>
                </c:pt>
                <c:pt idx="138">
                  <c:v>328</c:v>
                </c:pt>
                <c:pt idx="139">
                  <c:v>329</c:v>
                </c:pt>
                <c:pt idx="140">
                  <c:v>330</c:v>
                </c:pt>
                <c:pt idx="141">
                  <c:v>331</c:v>
                </c:pt>
                <c:pt idx="142">
                  <c:v>332</c:v>
                </c:pt>
                <c:pt idx="143">
                  <c:v>333</c:v>
                </c:pt>
                <c:pt idx="144">
                  <c:v>334</c:v>
                </c:pt>
                <c:pt idx="145">
                  <c:v>335</c:v>
                </c:pt>
                <c:pt idx="146">
                  <c:v>336</c:v>
                </c:pt>
                <c:pt idx="147">
                  <c:v>337</c:v>
                </c:pt>
                <c:pt idx="148">
                  <c:v>338</c:v>
                </c:pt>
                <c:pt idx="149">
                  <c:v>339</c:v>
                </c:pt>
                <c:pt idx="150">
                  <c:v>340</c:v>
                </c:pt>
                <c:pt idx="151">
                  <c:v>341</c:v>
                </c:pt>
                <c:pt idx="152">
                  <c:v>342</c:v>
                </c:pt>
                <c:pt idx="153">
                  <c:v>343</c:v>
                </c:pt>
                <c:pt idx="154">
                  <c:v>344</c:v>
                </c:pt>
                <c:pt idx="155">
                  <c:v>345</c:v>
                </c:pt>
                <c:pt idx="156">
                  <c:v>346</c:v>
                </c:pt>
                <c:pt idx="157">
                  <c:v>347</c:v>
                </c:pt>
                <c:pt idx="158">
                  <c:v>348</c:v>
                </c:pt>
                <c:pt idx="159">
                  <c:v>349</c:v>
                </c:pt>
                <c:pt idx="160">
                  <c:v>350</c:v>
                </c:pt>
                <c:pt idx="161">
                  <c:v>351</c:v>
                </c:pt>
                <c:pt idx="162">
                  <c:v>352</c:v>
                </c:pt>
                <c:pt idx="163">
                  <c:v>353</c:v>
                </c:pt>
                <c:pt idx="164">
                  <c:v>354</c:v>
                </c:pt>
                <c:pt idx="165">
                  <c:v>355</c:v>
                </c:pt>
                <c:pt idx="166">
                  <c:v>356</c:v>
                </c:pt>
                <c:pt idx="167">
                  <c:v>357</c:v>
                </c:pt>
                <c:pt idx="168">
                  <c:v>358</c:v>
                </c:pt>
                <c:pt idx="169">
                  <c:v>359</c:v>
                </c:pt>
                <c:pt idx="170">
                  <c:v>360</c:v>
                </c:pt>
                <c:pt idx="171">
                  <c:v>361</c:v>
                </c:pt>
                <c:pt idx="172">
                  <c:v>362</c:v>
                </c:pt>
                <c:pt idx="173">
                  <c:v>363</c:v>
                </c:pt>
                <c:pt idx="174">
                  <c:v>364</c:v>
                </c:pt>
                <c:pt idx="175">
                  <c:v>365</c:v>
                </c:pt>
                <c:pt idx="176">
                  <c:v>366</c:v>
                </c:pt>
                <c:pt idx="177">
                  <c:v>367</c:v>
                </c:pt>
                <c:pt idx="178">
                  <c:v>368</c:v>
                </c:pt>
                <c:pt idx="179">
                  <c:v>369</c:v>
                </c:pt>
                <c:pt idx="180">
                  <c:v>370</c:v>
                </c:pt>
                <c:pt idx="181">
                  <c:v>371</c:v>
                </c:pt>
                <c:pt idx="182">
                  <c:v>372</c:v>
                </c:pt>
                <c:pt idx="183">
                  <c:v>373</c:v>
                </c:pt>
                <c:pt idx="184">
                  <c:v>374</c:v>
                </c:pt>
                <c:pt idx="185">
                  <c:v>375</c:v>
                </c:pt>
                <c:pt idx="186">
                  <c:v>376</c:v>
                </c:pt>
                <c:pt idx="187">
                  <c:v>377</c:v>
                </c:pt>
                <c:pt idx="188">
                  <c:v>378</c:v>
                </c:pt>
                <c:pt idx="189">
                  <c:v>379</c:v>
                </c:pt>
                <c:pt idx="190">
                  <c:v>380</c:v>
                </c:pt>
                <c:pt idx="191">
                  <c:v>381</c:v>
                </c:pt>
                <c:pt idx="192">
                  <c:v>382</c:v>
                </c:pt>
                <c:pt idx="193">
                  <c:v>383</c:v>
                </c:pt>
                <c:pt idx="194">
                  <c:v>384</c:v>
                </c:pt>
                <c:pt idx="195">
                  <c:v>385</c:v>
                </c:pt>
                <c:pt idx="196">
                  <c:v>386</c:v>
                </c:pt>
                <c:pt idx="197">
                  <c:v>387</c:v>
                </c:pt>
                <c:pt idx="198">
                  <c:v>388</c:v>
                </c:pt>
                <c:pt idx="199">
                  <c:v>389</c:v>
                </c:pt>
                <c:pt idx="200">
                  <c:v>390</c:v>
                </c:pt>
                <c:pt idx="201">
                  <c:v>391</c:v>
                </c:pt>
                <c:pt idx="202">
                  <c:v>392</c:v>
                </c:pt>
                <c:pt idx="203">
                  <c:v>393</c:v>
                </c:pt>
                <c:pt idx="204">
                  <c:v>394</c:v>
                </c:pt>
                <c:pt idx="205">
                  <c:v>395</c:v>
                </c:pt>
                <c:pt idx="206">
                  <c:v>396</c:v>
                </c:pt>
                <c:pt idx="207">
                  <c:v>397</c:v>
                </c:pt>
                <c:pt idx="208">
                  <c:v>398</c:v>
                </c:pt>
                <c:pt idx="209">
                  <c:v>399</c:v>
                </c:pt>
                <c:pt idx="210">
                  <c:v>400</c:v>
                </c:pt>
                <c:pt idx="211">
                  <c:v>401</c:v>
                </c:pt>
                <c:pt idx="212">
                  <c:v>402</c:v>
                </c:pt>
                <c:pt idx="213">
                  <c:v>403</c:v>
                </c:pt>
                <c:pt idx="214">
                  <c:v>404</c:v>
                </c:pt>
                <c:pt idx="215">
                  <c:v>405</c:v>
                </c:pt>
                <c:pt idx="216">
                  <c:v>406</c:v>
                </c:pt>
                <c:pt idx="217">
                  <c:v>407</c:v>
                </c:pt>
                <c:pt idx="218">
                  <c:v>408</c:v>
                </c:pt>
                <c:pt idx="219">
                  <c:v>409</c:v>
                </c:pt>
                <c:pt idx="220">
                  <c:v>410</c:v>
                </c:pt>
                <c:pt idx="221">
                  <c:v>411</c:v>
                </c:pt>
                <c:pt idx="222">
                  <c:v>412</c:v>
                </c:pt>
                <c:pt idx="223">
                  <c:v>413</c:v>
                </c:pt>
                <c:pt idx="224">
                  <c:v>414</c:v>
                </c:pt>
                <c:pt idx="225">
                  <c:v>415</c:v>
                </c:pt>
                <c:pt idx="226">
                  <c:v>416</c:v>
                </c:pt>
                <c:pt idx="227">
                  <c:v>417</c:v>
                </c:pt>
                <c:pt idx="228">
                  <c:v>418</c:v>
                </c:pt>
                <c:pt idx="229">
                  <c:v>419</c:v>
                </c:pt>
                <c:pt idx="230">
                  <c:v>420</c:v>
                </c:pt>
                <c:pt idx="231">
                  <c:v>421</c:v>
                </c:pt>
                <c:pt idx="232">
                  <c:v>422</c:v>
                </c:pt>
                <c:pt idx="233">
                  <c:v>423</c:v>
                </c:pt>
                <c:pt idx="234">
                  <c:v>424</c:v>
                </c:pt>
                <c:pt idx="235">
                  <c:v>425</c:v>
                </c:pt>
                <c:pt idx="236">
                  <c:v>426</c:v>
                </c:pt>
                <c:pt idx="237">
                  <c:v>427</c:v>
                </c:pt>
                <c:pt idx="238">
                  <c:v>428</c:v>
                </c:pt>
                <c:pt idx="239">
                  <c:v>429</c:v>
                </c:pt>
                <c:pt idx="240">
                  <c:v>430</c:v>
                </c:pt>
                <c:pt idx="241">
                  <c:v>431</c:v>
                </c:pt>
                <c:pt idx="242">
                  <c:v>432</c:v>
                </c:pt>
                <c:pt idx="243">
                  <c:v>433</c:v>
                </c:pt>
                <c:pt idx="244">
                  <c:v>434</c:v>
                </c:pt>
                <c:pt idx="245">
                  <c:v>435</c:v>
                </c:pt>
                <c:pt idx="246">
                  <c:v>436</c:v>
                </c:pt>
                <c:pt idx="247">
                  <c:v>437</c:v>
                </c:pt>
                <c:pt idx="248">
                  <c:v>438</c:v>
                </c:pt>
                <c:pt idx="249">
                  <c:v>439</c:v>
                </c:pt>
                <c:pt idx="250">
                  <c:v>440</c:v>
                </c:pt>
                <c:pt idx="251">
                  <c:v>441</c:v>
                </c:pt>
                <c:pt idx="252">
                  <c:v>442</c:v>
                </c:pt>
                <c:pt idx="253">
                  <c:v>443</c:v>
                </c:pt>
                <c:pt idx="254">
                  <c:v>444</c:v>
                </c:pt>
                <c:pt idx="255">
                  <c:v>445</c:v>
                </c:pt>
                <c:pt idx="256">
                  <c:v>446</c:v>
                </c:pt>
                <c:pt idx="257">
                  <c:v>447</c:v>
                </c:pt>
                <c:pt idx="258">
                  <c:v>448</c:v>
                </c:pt>
                <c:pt idx="259">
                  <c:v>449</c:v>
                </c:pt>
                <c:pt idx="260">
                  <c:v>450</c:v>
                </c:pt>
                <c:pt idx="261">
                  <c:v>451</c:v>
                </c:pt>
                <c:pt idx="262">
                  <c:v>452</c:v>
                </c:pt>
                <c:pt idx="263">
                  <c:v>453</c:v>
                </c:pt>
                <c:pt idx="264">
                  <c:v>454</c:v>
                </c:pt>
                <c:pt idx="265">
                  <c:v>455</c:v>
                </c:pt>
                <c:pt idx="266">
                  <c:v>456</c:v>
                </c:pt>
                <c:pt idx="267">
                  <c:v>457</c:v>
                </c:pt>
                <c:pt idx="268">
                  <c:v>458</c:v>
                </c:pt>
                <c:pt idx="269">
                  <c:v>459</c:v>
                </c:pt>
                <c:pt idx="270">
                  <c:v>460</c:v>
                </c:pt>
                <c:pt idx="271">
                  <c:v>461</c:v>
                </c:pt>
                <c:pt idx="272">
                  <c:v>462</c:v>
                </c:pt>
                <c:pt idx="273">
                  <c:v>463</c:v>
                </c:pt>
                <c:pt idx="274">
                  <c:v>464</c:v>
                </c:pt>
                <c:pt idx="275">
                  <c:v>465</c:v>
                </c:pt>
                <c:pt idx="276">
                  <c:v>466</c:v>
                </c:pt>
                <c:pt idx="277">
                  <c:v>467</c:v>
                </c:pt>
                <c:pt idx="278">
                  <c:v>468</c:v>
                </c:pt>
                <c:pt idx="279">
                  <c:v>469</c:v>
                </c:pt>
                <c:pt idx="280">
                  <c:v>470</c:v>
                </c:pt>
                <c:pt idx="281">
                  <c:v>471</c:v>
                </c:pt>
                <c:pt idx="282">
                  <c:v>472</c:v>
                </c:pt>
                <c:pt idx="283">
                  <c:v>473</c:v>
                </c:pt>
                <c:pt idx="284">
                  <c:v>474</c:v>
                </c:pt>
                <c:pt idx="285">
                  <c:v>475</c:v>
                </c:pt>
                <c:pt idx="286">
                  <c:v>476</c:v>
                </c:pt>
                <c:pt idx="287">
                  <c:v>477</c:v>
                </c:pt>
                <c:pt idx="288">
                  <c:v>478</c:v>
                </c:pt>
                <c:pt idx="289">
                  <c:v>479</c:v>
                </c:pt>
                <c:pt idx="290">
                  <c:v>480</c:v>
                </c:pt>
                <c:pt idx="291">
                  <c:v>481</c:v>
                </c:pt>
                <c:pt idx="292">
                  <c:v>482</c:v>
                </c:pt>
                <c:pt idx="293">
                  <c:v>483</c:v>
                </c:pt>
                <c:pt idx="294">
                  <c:v>484</c:v>
                </c:pt>
                <c:pt idx="295">
                  <c:v>485</c:v>
                </c:pt>
                <c:pt idx="296">
                  <c:v>486</c:v>
                </c:pt>
                <c:pt idx="297">
                  <c:v>487</c:v>
                </c:pt>
                <c:pt idx="298">
                  <c:v>488</c:v>
                </c:pt>
                <c:pt idx="299">
                  <c:v>489</c:v>
                </c:pt>
                <c:pt idx="300">
                  <c:v>490</c:v>
                </c:pt>
                <c:pt idx="301">
                  <c:v>491</c:v>
                </c:pt>
                <c:pt idx="302">
                  <c:v>492</c:v>
                </c:pt>
                <c:pt idx="303">
                  <c:v>493</c:v>
                </c:pt>
                <c:pt idx="304">
                  <c:v>494</c:v>
                </c:pt>
                <c:pt idx="305">
                  <c:v>495</c:v>
                </c:pt>
                <c:pt idx="306">
                  <c:v>496</c:v>
                </c:pt>
                <c:pt idx="307">
                  <c:v>497</c:v>
                </c:pt>
                <c:pt idx="308">
                  <c:v>498</c:v>
                </c:pt>
                <c:pt idx="309">
                  <c:v>499</c:v>
                </c:pt>
                <c:pt idx="310">
                  <c:v>500</c:v>
                </c:pt>
                <c:pt idx="311">
                  <c:v>501</c:v>
                </c:pt>
                <c:pt idx="312">
                  <c:v>502</c:v>
                </c:pt>
                <c:pt idx="313">
                  <c:v>503</c:v>
                </c:pt>
                <c:pt idx="314">
                  <c:v>504</c:v>
                </c:pt>
                <c:pt idx="315">
                  <c:v>505</c:v>
                </c:pt>
                <c:pt idx="316">
                  <c:v>506</c:v>
                </c:pt>
                <c:pt idx="317">
                  <c:v>507</c:v>
                </c:pt>
                <c:pt idx="318">
                  <c:v>508</c:v>
                </c:pt>
                <c:pt idx="319">
                  <c:v>509</c:v>
                </c:pt>
                <c:pt idx="320">
                  <c:v>510</c:v>
                </c:pt>
                <c:pt idx="321">
                  <c:v>511</c:v>
                </c:pt>
                <c:pt idx="322">
                  <c:v>512</c:v>
                </c:pt>
                <c:pt idx="323">
                  <c:v>513</c:v>
                </c:pt>
                <c:pt idx="324">
                  <c:v>514</c:v>
                </c:pt>
                <c:pt idx="325">
                  <c:v>515</c:v>
                </c:pt>
                <c:pt idx="326">
                  <c:v>516</c:v>
                </c:pt>
                <c:pt idx="327">
                  <c:v>517</c:v>
                </c:pt>
                <c:pt idx="328">
                  <c:v>518</c:v>
                </c:pt>
                <c:pt idx="329">
                  <c:v>519</c:v>
                </c:pt>
                <c:pt idx="330">
                  <c:v>520</c:v>
                </c:pt>
                <c:pt idx="331">
                  <c:v>521</c:v>
                </c:pt>
                <c:pt idx="332">
                  <c:v>522</c:v>
                </c:pt>
                <c:pt idx="333">
                  <c:v>523</c:v>
                </c:pt>
                <c:pt idx="334">
                  <c:v>524</c:v>
                </c:pt>
                <c:pt idx="335">
                  <c:v>525</c:v>
                </c:pt>
                <c:pt idx="336">
                  <c:v>526</c:v>
                </c:pt>
                <c:pt idx="337">
                  <c:v>527</c:v>
                </c:pt>
                <c:pt idx="338">
                  <c:v>528</c:v>
                </c:pt>
                <c:pt idx="339">
                  <c:v>529</c:v>
                </c:pt>
                <c:pt idx="340">
                  <c:v>530</c:v>
                </c:pt>
                <c:pt idx="341">
                  <c:v>531</c:v>
                </c:pt>
                <c:pt idx="342">
                  <c:v>532</c:v>
                </c:pt>
                <c:pt idx="343">
                  <c:v>533</c:v>
                </c:pt>
                <c:pt idx="344">
                  <c:v>534</c:v>
                </c:pt>
                <c:pt idx="345">
                  <c:v>535</c:v>
                </c:pt>
                <c:pt idx="346">
                  <c:v>536</c:v>
                </c:pt>
                <c:pt idx="347">
                  <c:v>537</c:v>
                </c:pt>
                <c:pt idx="348">
                  <c:v>538</c:v>
                </c:pt>
                <c:pt idx="349">
                  <c:v>539</c:v>
                </c:pt>
                <c:pt idx="350">
                  <c:v>540</c:v>
                </c:pt>
                <c:pt idx="351">
                  <c:v>541</c:v>
                </c:pt>
                <c:pt idx="352">
                  <c:v>542</c:v>
                </c:pt>
                <c:pt idx="353">
                  <c:v>543</c:v>
                </c:pt>
                <c:pt idx="354">
                  <c:v>544</c:v>
                </c:pt>
                <c:pt idx="355">
                  <c:v>545</c:v>
                </c:pt>
                <c:pt idx="356">
                  <c:v>546</c:v>
                </c:pt>
                <c:pt idx="357">
                  <c:v>547</c:v>
                </c:pt>
                <c:pt idx="358">
                  <c:v>548</c:v>
                </c:pt>
                <c:pt idx="359">
                  <c:v>549</c:v>
                </c:pt>
                <c:pt idx="360">
                  <c:v>550</c:v>
                </c:pt>
                <c:pt idx="361">
                  <c:v>551</c:v>
                </c:pt>
                <c:pt idx="362">
                  <c:v>552</c:v>
                </c:pt>
                <c:pt idx="363">
                  <c:v>553</c:v>
                </c:pt>
                <c:pt idx="364">
                  <c:v>554</c:v>
                </c:pt>
                <c:pt idx="365">
                  <c:v>555</c:v>
                </c:pt>
                <c:pt idx="366">
                  <c:v>556</c:v>
                </c:pt>
                <c:pt idx="367">
                  <c:v>557</c:v>
                </c:pt>
                <c:pt idx="368">
                  <c:v>558</c:v>
                </c:pt>
                <c:pt idx="369">
                  <c:v>559</c:v>
                </c:pt>
                <c:pt idx="370">
                  <c:v>560</c:v>
                </c:pt>
                <c:pt idx="371">
                  <c:v>561</c:v>
                </c:pt>
                <c:pt idx="372">
                  <c:v>562</c:v>
                </c:pt>
                <c:pt idx="373">
                  <c:v>563</c:v>
                </c:pt>
                <c:pt idx="374">
                  <c:v>564</c:v>
                </c:pt>
                <c:pt idx="375">
                  <c:v>565</c:v>
                </c:pt>
                <c:pt idx="376">
                  <c:v>566</c:v>
                </c:pt>
                <c:pt idx="377">
                  <c:v>567</c:v>
                </c:pt>
                <c:pt idx="378">
                  <c:v>568</c:v>
                </c:pt>
                <c:pt idx="379">
                  <c:v>569</c:v>
                </c:pt>
                <c:pt idx="380">
                  <c:v>570</c:v>
                </c:pt>
                <c:pt idx="381">
                  <c:v>571</c:v>
                </c:pt>
                <c:pt idx="382">
                  <c:v>572</c:v>
                </c:pt>
                <c:pt idx="383">
                  <c:v>573</c:v>
                </c:pt>
                <c:pt idx="384">
                  <c:v>574</c:v>
                </c:pt>
                <c:pt idx="385">
                  <c:v>575</c:v>
                </c:pt>
                <c:pt idx="386">
                  <c:v>576</c:v>
                </c:pt>
                <c:pt idx="387">
                  <c:v>577</c:v>
                </c:pt>
                <c:pt idx="388">
                  <c:v>578</c:v>
                </c:pt>
                <c:pt idx="389">
                  <c:v>579</c:v>
                </c:pt>
                <c:pt idx="390">
                  <c:v>580</c:v>
                </c:pt>
                <c:pt idx="391">
                  <c:v>581</c:v>
                </c:pt>
                <c:pt idx="392">
                  <c:v>582</c:v>
                </c:pt>
                <c:pt idx="393">
                  <c:v>583</c:v>
                </c:pt>
                <c:pt idx="394">
                  <c:v>584</c:v>
                </c:pt>
                <c:pt idx="395">
                  <c:v>585</c:v>
                </c:pt>
                <c:pt idx="396">
                  <c:v>586</c:v>
                </c:pt>
                <c:pt idx="397">
                  <c:v>587</c:v>
                </c:pt>
                <c:pt idx="398">
                  <c:v>588</c:v>
                </c:pt>
                <c:pt idx="399">
                  <c:v>589</c:v>
                </c:pt>
                <c:pt idx="400">
                  <c:v>590</c:v>
                </c:pt>
                <c:pt idx="401">
                  <c:v>591</c:v>
                </c:pt>
                <c:pt idx="402">
                  <c:v>592</c:v>
                </c:pt>
                <c:pt idx="403">
                  <c:v>593</c:v>
                </c:pt>
                <c:pt idx="404">
                  <c:v>594</c:v>
                </c:pt>
                <c:pt idx="405">
                  <c:v>595</c:v>
                </c:pt>
                <c:pt idx="406">
                  <c:v>596</c:v>
                </c:pt>
                <c:pt idx="407">
                  <c:v>597</c:v>
                </c:pt>
                <c:pt idx="408">
                  <c:v>598</c:v>
                </c:pt>
                <c:pt idx="409">
                  <c:v>599</c:v>
                </c:pt>
                <c:pt idx="410">
                  <c:v>600</c:v>
                </c:pt>
                <c:pt idx="411">
                  <c:v>601</c:v>
                </c:pt>
                <c:pt idx="412">
                  <c:v>602</c:v>
                </c:pt>
                <c:pt idx="413">
                  <c:v>603</c:v>
                </c:pt>
                <c:pt idx="414">
                  <c:v>604</c:v>
                </c:pt>
                <c:pt idx="415">
                  <c:v>605</c:v>
                </c:pt>
                <c:pt idx="416">
                  <c:v>606</c:v>
                </c:pt>
                <c:pt idx="417">
                  <c:v>607</c:v>
                </c:pt>
                <c:pt idx="418">
                  <c:v>608</c:v>
                </c:pt>
                <c:pt idx="419">
                  <c:v>609</c:v>
                </c:pt>
                <c:pt idx="420">
                  <c:v>610</c:v>
                </c:pt>
                <c:pt idx="421">
                  <c:v>611</c:v>
                </c:pt>
                <c:pt idx="422">
                  <c:v>612</c:v>
                </c:pt>
                <c:pt idx="423">
                  <c:v>613</c:v>
                </c:pt>
                <c:pt idx="424">
                  <c:v>614</c:v>
                </c:pt>
                <c:pt idx="425">
                  <c:v>615</c:v>
                </c:pt>
                <c:pt idx="426">
                  <c:v>616</c:v>
                </c:pt>
                <c:pt idx="427">
                  <c:v>617</c:v>
                </c:pt>
                <c:pt idx="428">
                  <c:v>618</c:v>
                </c:pt>
                <c:pt idx="429">
                  <c:v>619</c:v>
                </c:pt>
                <c:pt idx="430">
                  <c:v>620</c:v>
                </c:pt>
                <c:pt idx="431">
                  <c:v>621</c:v>
                </c:pt>
                <c:pt idx="432">
                  <c:v>622</c:v>
                </c:pt>
                <c:pt idx="433">
                  <c:v>623</c:v>
                </c:pt>
                <c:pt idx="434">
                  <c:v>624</c:v>
                </c:pt>
                <c:pt idx="435">
                  <c:v>625</c:v>
                </c:pt>
                <c:pt idx="436">
                  <c:v>626</c:v>
                </c:pt>
                <c:pt idx="437">
                  <c:v>627</c:v>
                </c:pt>
                <c:pt idx="438">
                  <c:v>628</c:v>
                </c:pt>
                <c:pt idx="439">
                  <c:v>629</c:v>
                </c:pt>
                <c:pt idx="440">
                  <c:v>630</c:v>
                </c:pt>
                <c:pt idx="441">
                  <c:v>631</c:v>
                </c:pt>
                <c:pt idx="442">
                  <c:v>632</c:v>
                </c:pt>
                <c:pt idx="443">
                  <c:v>633</c:v>
                </c:pt>
                <c:pt idx="444">
                  <c:v>634</c:v>
                </c:pt>
                <c:pt idx="445">
                  <c:v>635</c:v>
                </c:pt>
                <c:pt idx="446">
                  <c:v>636</c:v>
                </c:pt>
                <c:pt idx="447">
                  <c:v>637</c:v>
                </c:pt>
                <c:pt idx="448">
                  <c:v>638</c:v>
                </c:pt>
                <c:pt idx="449">
                  <c:v>639</c:v>
                </c:pt>
                <c:pt idx="450">
                  <c:v>640</c:v>
                </c:pt>
                <c:pt idx="451">
                  <c:v>641</c:v>
                </c:pt>
                <c:pt idx="452">
                  <c:v>642</c:v>
                </c:pt>
                <c:pt idx="453">
                  <c:v>643</c:v>
                </c:pt>
                <c:pt idx="454">
                  <c:v>644</c:v>
                </c:pt>
                <c:pt idx="455">
                  <c:v>645</c:v>
                </c:pt>
                <c:pt idx="456">
                  <c:v>646</c:v>
                </c:pt>
                <c:pt idx="457">
                  <c:v>647</c:v>
                </c:pt>
                <c:pt idx="458">
                  <c:v>648</c:v>
                </c:pt>
                <c:pt idx="459">
                  <c:v>649</c:v>
                </c:pt>
                <c:pt idx="460">
                  <c:v>650</c:v>
                </c:pt>
                <c:pt idx="461">
                  <c:v>651</c:v>
                </c:pt>
                <c:pt idx="462">
                  <c:v>652</c:v>
                </c:pt>
                <c:pt idx="463">
                  <c:v>653</c:v>
                </c:pt>
                <c:pt idx="464">
                  <c:v>654</c:v>
                </c:pt>
                <c:pt idx="465">
                  <c:v>655</c:v>
                </c:pt>
                <c:pt idx="466">
                  <c:v>656</c:v>
                </c:pt>
                <c:pt idx="467">
                  <c:v>657</c:v>
                </c:pt>
                <c:pt idx="468">
                  <c:v>658</c:v>
                </c:pt>
                <c:pt idx="469">
                  <c:v>659</c:v>
                </c:pt>
                <c:pt idx="470">
                  <c:v>660</c:v>
                </c:pt>
                <c:pt idx="471">
                  <c:v>661</c:v>
                </c:pt>
                <c:pt idx="472">
                  <c:v>662</c:v>
                </c:pt>
                <c:pt idx="473">
                  <c:v>663</c:v>
                </c:pt>
                <c:pt idx="474">
                  <c:v>664</c:v>
                </c:pt>
                <c:pt idx="475">
                  <c:v>665</c:v>
                </c:pt>
                <c:pt idx="476">
                  <c:v>666</c:v>
                </c:pt>
                <c:pt idx="477">
                  <c:v>667</c:v>
                </c:pt>
                <c:pt idx="478">
                  <c:v>668</c:v>
                </c:pt>
                <c:pt idx="479">
                  <c:v>669</c:v>
                </c:pt>
                <c:pt idx="480">
                  <c:v>670</c:v>
                </c:pt>
                <c:pt idx="481">
                  <c:v>671</c:v>
                </c:pt>
                <c:pt idx="482">
                  <c:v>672</c:v>
                </c:pt>
                <c:pt idx="483">
                  <c:v>673</c:v>
                </c:pt>
                <c:pt idx="484">
                  <c:v>674</c:v>
                </c:pt>
                <c:pt idx="485">
                  <c:v>675</c:v>
                </c:pt>
                <c:pt idx="486">
                  <c:v>676</c:v>
                </c:pt>
                <c:pt idx="487">
                  <c:v>677</c:v>
                </c:pt>
                <c:pt idx="488">
                  <c:v>678</c:v>
                </c:pt>
                <c:pt idx="489">
                  <c:v>679</c:v>
                </c:pt>
                <c:pt idx="490">
                  <c:v>680</c:v>
                </c:pt>
                <c:pt idx="491">
                  <c:v>681</c:v>
                </c:pt>
                <c:pt idx="492">
                  <c:v>682</c:v>
                </c:pt>
                <c:pt idx="493">
                  <c:v>683</c:v>
                </c:pt>
                <c:pt idx="494">
                  <c:v>684</c:v>
                </c:pt>
                <c:pt idx="495">
                  <c:v>685</c:v>
                </c:pt>
                <c:pt idx="496">
                  <c:v>686</c:v>
                </c:pt>
                <c:pt idx="497">
                  <c:v>687</c:v>
                </c:pt>
                <c:pt idx="498">
                  <c:v>688</c:v>
                </c:pt>
                <c:pt idx="499">
                  <c:v>689</c:v>
                </c:pt>
                <c:pt idx="500">
                  <c:v>690</c:v>
                </c:pt>
                <c:pt idx="501">
                  <c:v>691</c:v>
                </c:pt>
                <c:pt idx="502">
                  <c:v>692</c:v>
                </c:pt>
                <c:pt idx="503">
                  <c:v>693</c:v>
                </c:pt>
                <c:pt idx="504">
                  <c:v>694</c:v>
                </c:pt>
                <c:pt idx="505">
                  <c:v>695</c:v>
                </c:pt>
                <c:pt idx="506">
                  <c:v>696</c:v>
                </c:pt>
                <c:pt idx="507">
                  <c:v>697</c:v>
                </c:pt>
                <c:pt idx="508">
                  <c:v>698</c:v>
                </c:pt>
                <c:pt idx="509">
                  <c:v>699</c:v>
                </c:pt>
                <c:pt idx="510">
                  <c:v>700</c:v>
                </c:pt>
              </c:numCache>
            </c:numRef>
          </c:xVal>
          <c:yVal>
            <c:numRef>
              <c:f>Sheet1!$U$3:$U$513</c:f>
              <c:numCache>
                <c:formatCode>General</c:formatCode>
                <c:ptCount val="511"/>
                <c:pt idx="0">
                  <c:v>0.99404899999999985</c:v>
                </c:pt>
                <c:pt idx="1">
                  <c:v>0.10769699999999978</c:v>
                </c:pt>
                <c:pt idx="2">
                  <c:v>0.64430200000000004</c:v>
                </c:pt>
                <c:pt idx="3">
                  <c:v>0.31039399999999989</c:v>
                </c:pt>
                <c:pt idx="4">
                  <c:v>-0.12136800000000007</c:v>
                </c:pt>
                <c:pt idx="5">
                  <c:v>-0.42724599999999996</c:v>
                </c:pt>
                <c:pt idx="6">
                  <c:v>2.3039999999999311E-3</c:v>
                </c:pt>
                <c:pt idx="7">
                  <c:v>-0.14526400000000023</c:v>
                </c:pt>
                <c:pt idx="8">
                  <c:v>-0.29602100000000026</c:v>
                </c:pt>
                <c:pt idx="9">
                  <c:v>-0.18765299999999979</c:v>
                </c:pt>
                <c:pt idx="10">
                  <c:v>0.17587199999999986</c:v>
                </c:pt>
                <c:pt idx="11">
                  <c:v>4.1960000000001579E-3</c:v>
                </c:pt>
                <c:pt idx="12">
                  <c:v>6.5902999999999892E-2</c:v>
                </c:pt>
                <c:pt idx="13">
                  <c:v>0.11254799999999972</c:v>
                </c:pt>
                <c:pt idx="14">
                  <c:v>5.3496999999999975E-2</c:v>
                </c:pt>
                <c:pt idx="15">
                  <c:v>-2.9754999999999907E-2</c:v>
                </c:pt>
                <c:pt idx="16">
                  <c:v>3.7308000000000188E-2</c:v>
                </c:pt>
                <c:pt idx="17">
                  <c:v>-0.10765099999999987</c:v>
                </c:pt>
                <c:pt idx="18">
                  <c:v>-9.4833999999999793E-2</c:v>
                </c:pt>
                <c:pt idx="19">
                  <c:v>4.5104999999999798E-2</c:v>
                </c:pt>
                <c:pt idx="20">
                  <c:v>3.4789999999999946E-2</c:v>
                </c:pt>
                <c:pt idx="21">
                  <c:v>4.8217999999999719E-2</c:v>
                </c:pt>
                <c:pt idx="22">
                  <c:v>-0.10275300000000002</c:v>
                </c:pt>
                <c:pt idx="23">
                  <c:v>8.4198000000000064E-2</c:v>
                </c:pt>
                <c:pt idx="24">
                  <c:v>0.22827199999999986</c:v>
                </c:pt>
                <c:pt idx="25">
                  <c:v>-3.1000000000044881E-5</c:v>
                </c:pt>
                <c:pt idx="26">
                  <c:v>-2.7542000000000108E-2</c:v>
                </c:pt>
                <c:pt idx="27">
                  <c:v>3.0318999999999832E-2</c:v>
                </c:pt>
                <c:pt idx="28">
                  <c:v>6.8206999999999976E-2</c:v>
                </c:pt>
                <c:pt idx="29">
                  <c:v>-1.3397000000000034E-2</c:v>
                </c:pt>
                <c:pt idx="30">
                  <c:v>9.0178999999999856E-2</c:v>
                </c:pt>
                <c:pt idx="31">
                  <c:v>3.8208000000000311E-2</c:v>
                </c:pt>
                <c:pt idx="32">
                  <c:v>0.11904899999999981</c:v>
                </c:pt>
                <c:pt idx="33">
                  <c:v>7.0083999999999883E-2</c:v>
                </c:pt>
                <c:pt idx="34">
                  <c:v>5.9477999999999767E-2</c:v>
                </c:pt>
                <c:pt idx="35">
                  <c:v>5.5252000000000148E-2</c:v>
                </c:pt>
                <c:pt idx="36">
                  <c:v>2.5191999999999951E-2</c:v>
                </c:pt>
                <c:pt idx="37">
                  <c:v>5.1468000000000139E-2</c:v>
                </c:pt>
                <c:pt idx="38">
                  <c:v>-8.8485999999999773E-2</c:v>
                </c:pt>
                <c:pt idx="39">
                  <c:v>5.6656000000000109E-2</c:v>
                </c:pt>
                <c:pt idx="40">
                  <c:v>5.4931999999999828E-2</c:v>
                </c:pt>
                <c:pt idx="41">
                  <c:v>6.7138999999999907E-2</c:v>
                </c:pt>
                <c:pt idx="42">
                  <c:v>7.0098000000000063E-2</c:v>
                </c:pt>
                <c:pt idx="43">
                  <c:v>0.12977599999999995</c:v>
                </c:pt>
                <c:pt idx="44">
                  <c:v>0.10815400000000015</c:v>
                </c:pt>
                <c:pt idx="45">
                  <c:v>-7.8120000000000828E-3</c:v>
                </c:pt>
                <c:pt idx="46">
                  <c:v>-5.7980000000001225E-3</c:v>
                </c:pt>
                <c:pt idx="47">
                  <c:v>-5.7979999999996784E-3</c:v>
                </c:pt>
                <c:pt idx="48">
                  <c:v>6.7595999999999837E-2</c:v>
                </c:pt>
                <c:pt idx="49">
                  <c:v>0.11384599999999996</c:v>
                </c:pt>
                <c:pt idx="50">
                  <c:v>7.9315000000000094E-2</c:v>
                </c:pt>
                <c:pt idx="51">
                  <c:v>5.6625999999999913E-2</c:v>
                </c:pt>
                <c:pt idx="52">
                  <c:v>2.650500000000007E-2</c:v>
                </c:pt>
                <c:pt idx="53">
                  <c:v>5.8991000000000085E-2</c:v>
                </c:pt>
                <c:pt idx="54">
                  <c:v>2.262900000000008E-2</c:v>
                </c:pt>
                <c:pt idx="55">
                  <c:v>4.9148000000000039E-2</c:v>
                </c:pt>
                <c:pt idx="56">
                  <c:v>6.8313999999999833E-2</c:v>
                </c:pt>
                <c:pt idx="57">
                  <c:v>7.1532999999999916E-2</c:v>
                </c:pt>
                <c:pt idx="58">
                  <c:v>2.6916999999999927E-2</c:v>
                </c:pt>
                <c:pt idx="59">
                  <c:v>5.7520000000000487E-3</c:v>
                </c:pt>
                <c:pt idx="60">
                  <c:v>1.4500000000000207E-3</c:v>
                </c:pt>
                <c:pt idx="61">
                  <c:v>0.10815400000000015</c:v>
                </c:pt>
                <c:pt idx="62">
                  <c:v>0.19901999999999981</c:v>
                </c:pt>
                <c:pt idx="63">
                  <c:v>1.7485999999999738E-2</c:v>
                </c:pt>
                <c:pt idx="64">
                  <c:v>7.8505999999999812E-2</c:v>
                </c:pt>
                <c:pt idx="65">
                  <c:v>-7.8963999999999743E-2</c:v>
                </c:pt>
                <c:pt idx="66">
                  <c:v>-1.9958000000000073E-2</c:v>
                </c:pt>
                <c:pt idx="67">
                  <c:v>6.6970999999999961E-2</c:v>
                </c:pt>
                <c:pt idx="68">
                  <c:v>9.3002000000000098E-2</c:v>
                </c:pt>
                <c:pt idx="69">
                  <c:v>0.11772200000000017</c:v>
                </c:pt>
                <c:pt idx="70">
                  <c:v>0.13517699999999994</c:v>
                </c:pt>
                <c:pt idx="71">
                  <c:v>0.15385499999999991</c:v>
                </c:pt>
                <c:pt idx="72">
                  <c:v>0.17118900000000009</c:v>
                </c:pt>
                <c:pt idx="73">
                  <c:v>0.18820199999999992</c:v>
                </c:pt>
                <c:pt idx="74">
                  <c:v>0.20770299999999992</c:v>
                </c:pt>
                <c:pt idx="75">
                  <c:v>0.22958300000000004</c:v>
                </c:pt>
                <c:pt idx="76">
                  <c:v>0.25254799999999994</c:v>
                </c:pt>
                <c:pt idx="77">
                  <c:v>0.27529900000000002</c:v>
                </c:pt>
                <c:pt idx="78">
                  <c:v>0.29531800000000002</c:v>
                </c:pt>
                <c:pt idx="79">
                  <c:v>0.30888399999999999</c:v>
                </c:pt>
                <c:pt idx="80">
                  <c:v>0.31582699999999997</c:v>
                </c:pt>
                <c:pt idx="81">
                  <c:v>0.31785600000000003</c:v>
                </c:pt>
                <c:pt idx="82">
                  <c:v>0.31761099999999992</c:v>
                </c:pt>
                <c:pt idx="83">
                  <c:v>0.31889400000000001</c:v>
                </c:pt>
                <c:pt idx="84">
                  <c:v>0.32345599999999997</c:v>
                </c:pt>
                <c:pt idx="85">
                  <c:v>0.33416799999999991</c:v>
                </c:pt>
                <c:pt idx="86">
                  <c:v>0.35166899999999995</c:v>
                </c:pt>
                <c:pt idx="87">
                  <c:v>0.37356599999999995</c:v>
                </c:pt>
                <c:pt idx="88">
                  <c:v>0.39558399999999999</c:v>
                </c:pt>
                <c:pt idx="89">
                  <c:v>0.41424500000000003</c:v>
                </c:pt>
                <c:pt idx="90">
                  <c:v>0.42478899999999997</c:v>
                </c:pt>
                <c:pt idx="91">
                  <c:v>0.42503399999999997</c:v>
                </c:pt>
                <c:pt idx="92">
                  <c:v>0.41505500000000001</c:v>
                </c:pt>
                <c:pt idx="93">
                  <c:v>0.39740000000000003</c:v>
                </c:pt>
                <c:pt idx="94">
                  <c:v>0.37570100000000001</c:v>
                </c:pt>
                <c:pt idx="95">
                  <c:v>0.35427799999999998</c:v>
                </c:pt>
                <c:pt idx="96">
                  <c:v>0.33700599999999997</c:v>
                </c:pt>
                <c:pt idx="97">
                  <c:v>0.32464599999999999</c:v>
                </c:pt>
                <c:pt idx="98">
                  <c:v>0.31839000000000001</c:v>
                </c:pt>
                <c:pt idx="99">
                  <c:v>0.31828299999999998</c:v>
                </c:pt>
                <c:pt idx="100">
                  <c:v>0.32331799999999999</c:v>
                </c:pt>
                <c:pt idx="101">
                  <c:v>0.32949800000000001</c:v>
                </c:pt>
                <c:pt idx="102">
                  <c:v>0.33404499999999998</c:v>
                </c:pt>
                <c:pt idx="103">
                  <c:v>0.33262700000000001</c:v>
                </c:pt>
                <c:pt idx="104">
                  <c:v>0.32276899999999997</c:v>
                </c:pt>
                <c:pt idx="105">
                  <c:v>0.29145799999999999</c:v>
                </c:pt>
                <c:pt idx="106">
                  <c:v>0.25674400000000003</c:v>
                </c:pt>
                <c:pt idx="107">
                  <c:v>0.231964</c:v>
                </c:pt>
                <c:pt idx="108">
                  <c:v>0.20223999999999998</c:v>
                </c:pt>
                <c:pt idx="109">
                  <c:v>0.172623</c:v>
                </c:pt>
                <c:pt idx="110">
                  <c:v>0.14504999999999998</c:v>
                </c:pt>
                <c:pt idx="111">
                  <c:v>0.12149000000000001</c:v>
                </c:pt>
                <c:pt idx="112">
                  <c:v>0.10165299999999999</c:v>
                </c:pt>
                <c:pt idx="113">
                  <c:v>8.5953000000000002E-2</c:v>
                </c:pt>
                <c:pt idx="114">
                  <c:v>7.4508000000000005E-2</c:v>
                </c:pt>
                <c:pt idx="115">
                  <c:v>6.5155000000000005E-2</c:v>
                </c:pt>
                <c:pt idx="116">
                  <c:v>5.6014999999999995E-2</c:v>
                </c:pt>
                <c:pt idx="117">
                  <c:v>4.9850000000000005E-2</c:v>
                </c:pt>
                <c:pt idx="118">
                  <c:v>4.5593000000000002E-2</c:v>
                </c:pt>
                <c:pt idx="119">
                  <c:v>4.3457000000000003E-2</c:v>
                </c:pt>
                <c:pt idx="120">
                  <c:v>4.1870000000000004E-2</c:v>
                </c:pt>
                <c:pt idx="121">
                  <c:v>4.1015999999999997E-2</c:v>
                </c:pt>
                <c:pt idx="122">
                  <c:v>3.9108000000000004E-2</c:v>
                </c:pt>
                <c:pt idx="123">
                  <c:v>3.9673E-2</c:v>
                </c:pt>
                <c:pt idx="124">
                  <c:v>3.8894999999999999E-2</c:v>
                </c:pt>
                <c:pt idx="125">
                  <c:v>3.9230000000000001E-2</c:v>
                </c:pt>
                <c:pt idx="126">
                  <c:v>3.8315000000000002E-2</c:v>
                </c:pt>
                <c:pt idx="127">
                  <c:v>3.7277000000000005E-2</c:v>
                </c:pt>
                <c:pt idx="128">
                  <c:v>3.7109000000000003E-2</c:v>
                </c:pt>
                <c:pt idx="129">
                  <c:v>3.6544999999999994E-2</c:v>
                </c:pt>
                <c:pt idx="130">
                  <c:v>3.6208999999999998E-2</c:v>
                </c:pt>
                <c:pt idx="131">
                  <c:v>3.4591999999999998E-2</c:v>
                </c:pt>
                <c:pt idx="132">
                  <c:v>3.3951000000000002E-2</c:v>
                </c:pt>
                <c:pt idx="133">
                  <c:v>3.3890000000000003E-2</c:v>
                </c:pt>
                <c:pt idx="134">
                  <c:v>3.3843999999999999E-2</c:v>
                </c:pt>
                <c:pt idx="135">
                  <c:v>3.3767999999999999E-2</c:v>
                </c:pt>
                <c:pt idx="136">
                  <c:v>3.3049999999999996E-2</c:v>
                </c:pt>
                <c:pt idx="137">
                  <c:v>3.4195000000000003E-2</c:v>
                </c:pt>
                <c:pt idx="138">
                  <c:v>3.4317E-2</c:v>
                </c:pt>
                <c:pt idx="139">
                  <c:v>3.3570000000000003E-2</c:v>
                </c:pt>
                <c:pt idx="140">
                  <c:v>3.3554E-2</c:v>
                </c:pt>
                <c:pt idx="141">
                  <c:v>3.3615000000000006E-2</c:v>
                </c:pt>
                <c:pt idx="142">
                  <c:v>3.3538999999999999E-2</c:v>
                </c:pt>
                <c:pt idx="143">
                  <c:v>3.1585999999999996E-2</c:v>
                </c:pt>
                <c:pt idx="144">
                  <c:v>3.1310999999999999E-2</c:v>
                </c:pt>
                <c:pt idx="145">
                  <c:v>3.0365000000000003E-2</c:v>
                </c:pt>
                <c:pt idx="146">
                  <c:v>2.9526000000000004E-2</c:v>
                </c:pt>
                <c:pt idx="147">
                  <c:v>2.9052999999999999E-2</c:v>
                </c:pt>
                <c:pt idx="148">
                  <c:v>2.8045E-2</c:v>
                </c:pt>
                <c:pt idx="149">
                  <c:v>2.7434999999999998E-2</c:v>
                </c:pt>
                <c:pt idx="150">
                  <c:v>2.6488999999999999E-2</c:v>
                </c:pt>
                <c:pt idx="151">
                  <c:v>2.6015999999999997E-2</c:v>
                </c:pt>
                <c:pt idx="152">
                  <c:v>2.5328999999999997E-2</c:v>
                </c:pt>
                <c:pt idx="153">
                  <c:v>2.4642999999999998E-2</c:v>
                </c:pt>
                <c:pt idx="154">
                  <c:v>2.4474999999999997E-2</c:v>
                </c:pt>
                <c:pt idx="155">
                  <c:v>2.3605000000000001E-2</c:v>
                </c:pt>
                <c:pt idx="156">
                  <c:v>2.3254999999999998E-2</c:v>
                </c:pt>
                <c:pt idx="157">
                  <c:v>2.2614000000000002E-2</c:v>
                </c:pt>
                <c:pt idx="158">
                  <c:v>2.2415000000000004E-2</c:v>
                </c:pt>
                <c:pt idx="159">
                  <c:v>2.0843E-2</c:v>
                </c:pt>
                <c:pt idx="160">
                  <c:v>2.0492999999999997E-2</c:v>
                </c:pt>
                <c:pt idx="161">
                  <c:v>2.0415999999999997E-2</c:v>
                </c:pt>
                <c:pt idx="162">
                  <c:v>1.9333000000000003E-2</c:v>
                </c:pt>
                <c:pt idx="163">
                  <c:v>1.9470000000000001E-2</c:v>
                </c:pt>
                <c:pt idx="164">
                  <c:v>1.9118999999999997E-2</c:v>
                </c:pt>
                <c:pt idx="165">
                  <c:v>1.8508999999999998E-2</c:v>
                </c:pt>
                <c:pt idx="166">
                  <c:v>1.7975000000000005E-2</c:v>
                </c:pt>
                <c:pt idx="167">
                  <c:v>1.7684999999999992E-2</c:v>
                </c:pt>
                <c:pt idx="168">
                  <c:v>1.7471E-2</c:v>
                </c:pt>
                <c:pt idx="169">
                  <c:v>1.7149999999999999E-2</c:v>
                </c:pt>
                <c:pt idx="170">
                  <c:v>1.6998000000000006E-2</c:v>
                </c:pt>
                <c:pt idx="171">
                  <c:v>1.6785000000000008E-2</c:v>
                </c:pt>
                <c:pt idx="172">
                  <c:v>1.6205000000000011E-2</c:v>
                </c:pt>
                <c:pt idx="173">
                  <c:v>1.6081999999999999E-2</c:v>
                </c:pt>
                <c:pt idx="174">
                  <c:v>1.5167E-2</c:v>
                </c:pt>
                <c:pt idx="175">
                  <c:v>1.3794000000000001E-2</c:v>
                </c:pt>
                <c:pt idx="176">
                  <c:v>1.3366000000000003E-2</c:v>
                </c:pt>
                <c:pt idx="177">
                  <c:v>1.3504000000000002E-2</c:v>
                </c:pt>
                <c:pt idx="178">
                  <c:v>1.3489000000000001E-2</c:v>
                </c:pt>
                <c:pt idx="179">
                  <c:v>1.2786999999999993E-2</c:v>
                </c:pt>
                <c:pt idx="180">
                  <c:v>1.3016E-2</c:v>
                </c:pt>
                <c:pt idx="181">
                  <c:v>1.2603000000000003E-2</c:v>
                </c:pt>
                <c:pt idx="182">
                  <c:v>1.2116000000000002E-2</c:v>
                </c:pt>
                <c:pt idx="183">
                  <c:v>1.1963000000000001E-2</c:v>
                </c:pt>
                <c:pt idx="184">
                  <c:v>1.1612000000000004E-2</c:v>
                </c:pt>
                <c:pt idx="185">
                  <c:v>1.1444000000000003E-2</c:v>
                </c:pt>
                <c:pt idx="186">
                  <c:v>1.1261000000000007E-2</c:v>
                </c:pt>
                <c:pt idx="187">
                  <c:v>1.0864000000000006E-2</c:v>
                </c:pt>
                <c:pt idx="188">
                  <c:v>1.0696000000000004E-2</c:v>
                </c:pt>
                <c:pt idx="189">
                  <c:v>1.0483000000000006E-2</c:v>
                </c:pt>
                <c:pt idx="190">
                  <c:v>1.0329999999999999E-2</c:v>
                </c:pt>
                <c:pt idx="191">
                  <c:v>9.9640000000000006E-3</c:v>
                </c:pt>
                <c:pt idx="192">
                  <c:v>9.5819999999999933E-3</c:v>
                </c:pt>
                <c:pt idx="193">
                  <c:v>9.5980000000000093E-3</c:v>
                </c:pt>
                <c:pt idx="194">
                  <c:v>9.4140000000000057E-3</c:v>
                </c:pt>
                <c:pt idx="195">
                  <c:v>9.1860000000000067E-3</c:v>
                </c:pt>
                <c:pt idx="196">
                  <c:v>8.9110000000000023E-3</c:v>
                </c:pt>
                <c:pt idx="197">
                  <c:v>8.7129999999999985E-3</c:v>
                </c:pt>
                <c:pt idx="198">
                  <c:v>8.7119999999999975E-3</c:v>
                </c:pt>
                <c:pt idx="199">
                  <c:v>8.5299999999999959E-3</c:v>
                </c:pt>
                <c:pt idx="200">
                  <c:v>8.4070000000000047E-3</c:v>
                </c:pt>
                <c:pt idx="201">
                  <c:v>8.3309999999999912E-3</c:v>
                </c:pt>
                <c:pt idx="202">
                  <c:v>8.2389999999999963E-3</c:v>
                </c:pt>
                <c:pt idx="203">
                  <c:v>8.1940000000000068E-3</c:v>
                </c:pt>
                <c:pt idx="204">
                  <c:v>7.979999999999994E-3</c:v>
                </c:pt>
                <c:pt idx="205">
                  <c:v>7.8580000000000039E-3</c:v>
                </c:pt>
                <c:pt idx="206">
                  <c:v>7.7360000000000068E-3</c:v>
                </c:pt>
                <c:pt idx="207">
                  <c:v>7.7659999999999951E-3</c:v>
                </c:pt>
                <c:pt idx="208">
                  <c:v>7.9039999999999944E-3</c:v>
                </c:pt>
                <c:pt idx="209">
                  <c:v>7.6749999999999943E-3</c:v>
                </c:pt>
                <c:pt idx="210">
                  <c:v>7.6139999999999958E-3</c:v>
                </c:pt>
                <c:pt idx="211">
                  <c:v>7.6300000000000048E-3</c:v>
                </c:pt>
                <c:pt idx="212">
                  <c:v>7.5220000000000009E-3</c:v>
                </c:pt>
                <c:pt idx="213">
                  <c:v>7.538000000000003E-3</c:v>
                </c:pt>
                <c:pt idx="214">
                  <c:v>7.431000000000007E-3</c:v>
                </c:pt>
                <c:pt idx="215">
                  <c:v>7.4000000000000038E-3</c:v>
                </c:pt>
                <c:pt idx="216">
                  <c:v>7.2629999999999917E-3</c:v>
                </c:pt>
                <c:pt idx="217">
                  <c:v>7.2020000000000001E-3</c:v>
                </c:pt>
                <c:pt idx="218">
                  <c:v>7.079999999999996E-3</c:v>
                </c:pt>
                <c:pt idx="219">
                  <c:v>6.957999999999992E-3</c:v>
                </c:pt>
                <c:pt idx="220">
                  <c:v>6.9280000000000036E-3</c:v>
                </c:pt>
                <c:pt idx="221">
                  <c:v>6.8199999999999997E-3</c:v>
                </c:pt>
                <c:pt idx="222">
                  <c:v>6.8200000000000066E-3</c:v>
                </c:pt>
                <c:pt idx="223">
                  <c:v>6.7900000000000044E-3</c:v>
                </c:pt>
                <c:pt idx="224">
                  <c:v>6.9120000000000015E-3</c:v>
                </c:pt>
                <c:pt idx="225">
                  <c:v>6.744E-3</c:v>
                </c:pt>
                <c:pt idx="226">
                  <c:v>6.6680000000000073E-3</c:v>
                </c:pt>
                <c:pt idx="227">
                  <c:v>6.8360000000000087E-3</c:v>
                </c:pt>
                <c:pt idx="228">
                  <c:v>6.8819999999999992E-3</c:v>
                </c:pt>
                <c:pt idx="229">
                  <c:v>6.8510000000000099E-3</c:v>
                </c:pt>
                <c:pt idx="230">
                  <c:v>6.7289999999999989E-3</c:v>
                </c:pt>
                <c:pt idx="231">
                  <c:v>6.7139999999999977E-3</c:v>
                </c:pt>
                <c:pt idx="232">
                  <c:v>6.7140000000000047E-3</c:v>
                </c:pt>
                <c:pt idx="233">
                  <c:v>6.6230000000000039E-3</c:v>
                </c:pt>
                <c:pt idx="234">
                  <c:v>6.6829999999999945E-3</c:v>
                </c:pt>
                <c:pt idx="235">
                  <c:v>6.5909999999999996E-3</c:v>
                </c:pt>
                <c:pt idx="236">
                  <c:v>6.6229999999999969E-3</c:v>
                </c:pt>
                <c:pt idx="237">
                  <c:v>6.5609999999999974E-3</c:v>
                </c:pt>
                <c:pt idx="238">
                  <c:v>6.5769999999999995E-3</c:v>
                </c:pt>
                <c:pt idx="239">
                  <c:v>6.4699999999999966E-3</c:v>
                </c:pt>
                <c:pt idx="240">
                  <c:v>6.3939999999999969E-3</c:v>
                </c:pt>
                <c:pt idx="241">
                  <c:v>6.4239999999999992E-3</c:v>
                </c:pt>
                <c:pt idx="242">
                  <c:v>6.4400000000000013E-3</c:v>
                </c:pt>
                <c:pt idx="243">
                  <c:v>6.302000000000002E-3</c:v>
                </c:pt>
                <c:pt idx="244">
                  <c:v>6.2870000000000009E-3</c:v>
                </c:pt>
                <c:pt idx="245">
                  <c:v>6.2259999999999954E-3</c:v>
                </c:pt>
                <c:pt idx="246">
                  <c:v>6.1799999999999911E-3</c:v>
                </c:pt>
                <c:pt idx="247">
                  <c:v>6.1340000000000006E-3</c:v>
                </c:pt>
                <c:pt idx="248">
                  <c:v>6.1649999999999899E-3</c:v>
                </c:pt>
                <c:pt idx="249">
                  <c:v>6.1039999999999983E-3</c:v>
                </c:pt>
                <c:pt idx="250">
                  <c:v>6.0730000000000089E-3</c:v>
                </c:pt>
                <c:pt idx="251">
                  <c:v>5.9659999999999991E-3</c:v>
                </c:pt>
                <c:pt idx="252">
                  <c:v>5.9659999999999991E-3</c:v>
                </c:pt>
                <c:pt idx="253">
                  <c:v>5.8749999999999983E-3</c:v>
                </c:pt>
                <c:pt idx="254">
                  <c:v>5.844000000000002E-3</c:v>
                </c:pt>
                <c:pt idx="255">
                  <c:v>5.8139999999999997E-3</c:v>
                </c:pt>
                <c:pt idx="256">
                  <c:v>5.9050000000000075E-3</c:v>
                </c:pt>
                <c:pt idx="257">
                  <c:v>5.844000000000002E-3</c:v>
                </c:pt>
                <c:pt idx="258">
                  <c:v>5.6759999999999936E-3</c:v>
                </c:pt>
                <c:pt idx="259">
                  <c:v>5.7069999999999899E-3</c:v>
                </c:pt>
                <c:pt idx="260">
                  <c:v>5.6459999999999982E-3</c:v>
                </c:pt>
                <c:pt idx="261">
                  <c:v>5.5839999999999917E-3</c:v>
                </c:pt>
                <c:pt idx="262">
                  <c:v>5.5390000000000023E-3</c:v>
                </c:pt>
                <c:pt idx="263">
                  <c:v>5.4619999999999946E-3</c:v>
                </c:pt>
                <c:pt idx="264">
                  <c:v>5.5849999999999927E-3</c:v>
                </c:pt>
                <c:pt idx="265">
                  <c:v>5.614999999999995E-3</c:v>
                </c:pt>
                <c:pt idx="266">
                  <c:v>5.4929999999999979E-3</c:v>
                </c:pt>
                <c:pt idx="267">
                  <c:v>5.4629999999999956E-3</c:v>
                </c:pt>
                <c:pt idx="268">
                  <c:v>5.4469999999999935E-3</c:v>
                </c:pt>
                <c:pt idx="269">
                  <c:v>5.4769999999999958E-3</c:v>
                </c:pt>
                <c:pt idx="270">
                  <c:v>5.4170000000000051E-3</c:v>
                </c:pt>
                <c:pt idx="271">
                  <c:v>5.3249999999999964E-3</c:v>
                </c:pt>
                <c:pt idx="272">
                  <c:v>5.3399999999999975E-3</c:v>
                </c:pt>
                <c:pt idx="273">
                  <c:v>5.3710000000000008E-3</c:v>
                </c:pt>
                <c:pt idx="274">
                  <c:v>5.3249999999999964E-3</c:v>
                </c:pt>
                <c:pt idx="275">
                  <c:v>5.278999999999999E-3</c:v>
                </c:pt>
                <c:pt idx="276">
                  <c:v>5.2179999999999935E-3</c:v>
                </c:pt>
                <c:pt idx="277">
                  <c:v>5.2489999999999967E-3</c:v>
                </c:pt>
                <c:pt idx="278">
                  <c:v>5.2639999999999909E-3</c:v>
                </c:pt>
                <c:pt idx="279">
                  <c:v>5.1569999999999949E-3</c:v>
                </c:pt>
                <c:pt idx="280">
                  <c:v>5.1569999999999949E-3</c:v>
                </c:pt>
                <c:pt idx="281">
                  <c:v>5.1569999999999949E-3</c:v>
                </c:pt>
                <c:pt idx="282">
                  <c:v>5.0350000000000117E-3</c:v>
                </c:pt>
                <c:pt idx="283">
                  <c:v>5.0200000000000106E-3</c:v>
                </c:pt>
                <c:pt idx="284">
                  <c:v>4.9439999999999901E-3</c:v>
                </c:pt>
                <c:pt idx="285">
                  <c:v>4.8830000000000054E-3</c:v>
                </c:pt>
                <c:pt idx="286">
                  <c:v>5.0040000000000015E-3</c:v>
                </c:pt>
                <c:pt idx="287">
                  <c:v>4.9739999999999993E-3</c:v>
                </c:pt>
                <c:pt idx="288">
                  <c:v>4.7910000000000036E-3</c:v>
                </c:pt>
                <c:pt idx="289">
                  <c:v>4.7299999999999981E-3</c:v>
                </c:pt>
                <c:pt idx="290">
                  <c:v>4.7460000000000072E-3</c:v>
                </c:pt>
                <c:pt idx="291">
                  <c:v>4.6839999999999937E-3</c:v>
                </c:pt>
                <c:pt idx="292">
                  <c:v>4.6839999999999937E-3</c:v>
                </c:pt>
                <c:pt idx="293">
                  <c:v>4.7450000000000062E-3</c:v>
                </c:pt>
                <c:pt idx="294">
                  <c:v>4.8669999999999963E-3</c:v>
                </c:pt>
                <c:pt idx="295">
                  <c:v>4.6690000000000065E-3</c:v>
                </c:pt>
                <c:pt idx="296">
                  <c:v>4.837000000000008E-3</c:v>
                </c:pt>
                <c:pt idx="297">
                  <c:v>4.7599999999999934E-3</c:v>
                </c:pt>
                <c:pt idx="298">
                  <c:v>4.8059999999999908E-3</c:v>
                </c:pt>
                <c:pt idx="299">
                  <c:v>4.714999999999997E-3</c:v>
                </c:pt>
                <c:pt idx="300">
                  <c:v>4.6390000000000042E-3</c:v>
                </c:pt>
                <c:pt idx="301">
                  <c:v>4.5929999999999999E-3</c:v>
                </c:pt>
                <c:pt idx="302">
                  <c:v>4.4700000000000017E-3</c:v>
                </c:pt>
                <c:pt idx="303">
                  <c:v>4.3800000000000089E-3</c:v>
                </c:pt>
                <c:pt idx="304">
                  <c:v>4.4099999999999973E-3</c:v>
                </c:pt>
                <c:pt idx="305">
                  <c:v>4.2569999999999969E-3</c:v>
                </c:pt>
                <c:pt idx="306">
                  <c:v>4.2269999999999947E-3</c:v>
                </c:pt>
                <c:pt idx="307">
                  <c:v>4.1500000000000009E-3</c:v>
                </c:pt>
                <c:pt idx="308">
                  <c:v>4.1809999999999972E-3</c:v>
                </c:pt>
                <c:pt idx="309">
                  <c:v>4.0890000000000024E-3</c:v>
                </c:pt>
                <c:pt idx="310">
                  <c:v>4.1199999999999987E-3</c:v>
                </c:pt>
                <c:pt idx="311">
                  <c:v>4.043999999999992E-3</c:v>
                </c:pt>
                <c:pt idx="312">
                  <c:v>4.0280000000000038E-3</c:v>
                </c:pt>
                <c:pt idx="313">
                  <c:v>4.0280000000000038E-3</c:v>
                </c:pt>
                <c:pt idx="314">
                  <c:v>3.9670000000000052E-3</c:v>
                </c:pt>
                <c:pt idx="315">
                  <c:v>3.9670000000000052E-3</c:v>
                </c:pt>
                <c:pt idx="316">
                  <c:v>3.9980000000000016E-3</c:v>
                </c:pt>
                <c:pt idx="317">
                  <c:v>3.9819999999999994E-3</c:v>
                </c:pt>
                <c:pt idx="318">
                  <c:v>3.9980000000000085E-3</c:v>
                </c:pt>
                <c:pt idx="319">
                  <c:v>4.0279999999999969E-3</c:v>
                </c:pt>
                <c:pt idx="320">
                  <c:v>4.042999999999998E-3</c:v>
                </c:pt>
                <c:pt idx="321">
                  <c:v>3.9669999999999983E-3</c:v>
                </c:pt>
                <c:pt idx="322">
                  <c:v>3.9219999999999949E-3</c:v>
                </c:pt>
                <c:pt idx="323">
                  <c:v>3.9819999999999994E-3</c:v>
                </c:pt>
                <c:pt idx="324">
                  <c:v>3.9670000000000052E-3</c:v>
                </c:pt>
                <c:pt idx="325">
                  <c:v>4.0440000000000059E-3</c:v>
                </c:pt>
                <c:pt idx="326">
                  <c:v>3.9970000000000006E-3</c:v>
                </c:pt>
                <c:pt idx="327">
                  <c:v>3.9830000000000004E-3</c:v>
                </c:pt>
                <c:pt idx="328">
                  <c:v>3.8910000000000056E-3</c:v>
                </c:pt>
                <c:pt idx="329">
                  <c:v>3.8749999999999896E-3</c:v>
                </c:pt>
                <c:pt idx="330">
                  <c:v>3.9210000000000009E-3</c:v>
                </c:pt>
                <c:pt idx="331">
                  <c:v>3.8760000000000044E-3</c:v>
                </c:pt>
                <c:pt idx="332">
                  <c:v>3.8460000000000022E-3</c:v>
                </c:pt>
                <c:pt idx="333">
                  <c:v>3.7389999999999993E-3</c:v>
                </c:pt>
                <c:pt idx="334">
                  <c:v>3.8149999999999989E-3</c:v>
                </c:pt>
                <c:pt idx="335">
                  <c:v>3.7849999999999967E-3</c:v>
                </c:pt>
                <c:pt idx="336">
                  <c:v>3.708000000000003E-3</c:v>
                </c:pt>
                <c:pt idx="337">
                  <c:v>3.7379999999999983E-3</c:v>
                </c:pt>
                <c:pt idx="338">
                  <c:v>3.6930000000000018E-3</c:v>
                </c:pt>
                <c:pt idx="339">
                  <c:v>3.7079999999999891E-3</c:v>
                </c:pt>
                <c:pt idx="340">
                  <c:v>3.5099999999999992E-3</c:v>
                </c:pt>
                <c:pt idx="341">
                  <c:v>3.601E-3</c:v>
                </c:pt>
                <c:pt idx="342">
                  <c:v>3.5249999999999934E-3</c:v>
                </c:pt>
                <c:pt idx="343">
                  <c:v>3.494000000000004E-3</c:v>
                </c:pt>
                <c:pt idx="344">
                  <c:v>3.4640000000000018E-3</c:v>
                </c:pt>
                <c:pt idx="345">
                  <c:v>3.4019999999999953E-3</c:v>
                </c:pt>
                <c:pt idx="346">
                  <c:v>3.5099999999999923E-3</c:v>
                </c:pt>
                <c:pt idx="347">
                  <c:v>4.2579999999999979E-3</c:v>
                </c:pt>
                <c:pt idx="348">
                  <c:v>4.501000000000005E-3</c:v>
                </c:pt>
                <c:pt idx="349">
                  <c:v>4.3490000000000056E-3</c:v>
                </c:pt>
                <c:pt idx="350">
                  <c:v>4.1959999999999983E-3</c:v>
                </c:pt>
                <c:pt idx="351">
                  <c:v>4.1970000000000063E-3</c:v>
                </c:pt>
                <c:pt idx="352">
                  <c:v>4.2419999999999958E-3</c:v>
                </c:pt>
                <c:pt idx="353">
                  <c:v>4.271999999999998E-3</c:v>
                </c:pt>
                <c:pt idx="354">
                  <c:v>4.1800000000000032E-3</c:v>
                </c:pt>
                <c:pt idx="355">
                  <c:v>4.1659999999999961E-3</c:v>
                </c:pt>
                <c:pt idx="356">
                  <c:v>4.0130000000000027E-3</c:v>
                </c:pt>
                <c:pt idx="357">
                  <c:v>4.0279999999999969E-3</c:v>
                </c:pt>
                <c:pt idx="358">
                  <c:v>4.1049999999999975E-3</c:v>
                </c:pt>
                <c:pt idx="359">
                  <c:v>3.9970000000000006E-3</c:v>
                </c:pt>
                <c:pt idx="360">
                  <c:v>4.0130000000000027E-3</c:v>
                </c:pt>
                <c:pt idx="361">
                  <c:v>4.0290000000000048E-3</c:v>
                </c:pt>
                <c:pt idx="362">
                  <c:v>3.9219999999999949E-3</c:v>
                </c:pt>
                <c:pt idx="363">
                  <c:v>3.9370000000000099E-3</c:v>
                </c:pt>
                <c:pt idx="364">
                  <c:v>3.8300000000000001E-3</c:v>
                </c:pt>
                <c:pt idx="365">
                  <c:v>3.8600000000000023E-3</c:v>
                </c:pt>
                <c:pt idx="366">
                  <c:v>3.8610000000000033E-3</c:v>
                </c:pt>
                <c:pt idx="367">
                  <c:v>3.8449999999999943E-3</c:v>
                </c:pt>
                <c:pt idx="368">
                  <c:v>3.8149999999999989E-3</c:v>
                </c:pt>
                <c:pt idx="369">
                  <c:v>3.7230000000000041E-3</c:v>
                </c:pt>
                <c:pt idx="370">
                  <c:v>3.6929999999999949E-3</c:v>
                </c:pt>
                <c:pt idx="371">
                  <c:v>3.6930000000000018E-3</c:v>
                </c:pt>
                <c:pt idx="372">
                  <c:v>3.6620000000000055E-3</c:v>
                </c:pt>
                <c:pt idx="373">
                  <c:v>3.6469999999999975E-3</c:v>
                </c:pt>
                <c:pt idx="374">
                  <c:v>3.7230000000000041E-3</c:v>
                </c:pt>
                <c:pt idx="375">
                  <c:v>3.6160000000000012E-3</c:v>
                </c:pt>
                <c:pt idx="376">
                  <c:v>3.707000000000002E-3</c:v>
                </c:pt>
                <c:pt idx="377">
                  <c:v>3.5559999999999967E-3</c:v>
                </c:pt>
                <c:pt idx="378">
                  <c:v>3.5849999999999979E-3</c:v>
                </c:pt>
                <c:pt idx="379">
                  <c:v>3.5860000000000058E-3</c:v>
                </c:pt>
                <c:pt idx="380">
                  <c:v>3.4640000000000087E-3</c:v>
                </c:pt>
                <c:pt idx="381">
                  <c:v>3.4790000000000029E-3</c:v>
                </c:pt>
                <c:pt idx="382">
                  <c:v>3.5250000000000004E-3</c:v>
                </c:pt>
                <c:pt idx="383">
                  <c:v>3.4639999999999949E-3</c:v>
                </c:pt>
                <c:pt idx="384">
                  <c:v>3.5090000000000052E-3</c:v>
                </c:pt>
                <c:pt idx="385">
                  <c:v>3.3109999999999945E-3</c:v>
                </c:pt>
                <c:pt idx="386">
                  <c:v>3.4179999999999974E-3</c:v>
                </c:pt>
                <c:pt idx="387">
                  <c:v>3.3570000000000058E-3</c:v>
                </c:pt>
                <c:pt idx="388">
                  <c:v>3.3110000000000014E-3</c:v>
                </c:pt>
                <c:pt idx="389">
                  <c:v>3.3110000000000084E-3</c:v>
                </c:pt>
                <c:pt idx="390">
                  <c:v>3.3569999999999989E-3</c:v>
                </c:pt>
                <c:pt idx="391">
                  <c:v>3.1589999999999951E-3</c:v>
                </c:pt>
                <c:pt idx="392">
                  <c:v>3.143999999999994E-3</c:v>
                </c:pt>
                <c:pt idx="393">
                  <c:v>3.142999999999993E-3</c:v>
                </c:pt>
                <c:pt idx="394">
                  <c:v>3.0060000000000087E-3</c:v>
                </c:pt>
                <c:pt idx="395">
                  <c:v>3.036999999999998E-3</c:v>
                </c:pt>
                <c:pt idx="396">
                  <c:v>3.0059999999999948E-3</c:v>
                </c:pt>
                <c:pt idx="397">
                  <c:v>2.9450000000000032E-3</c:v>
                </c:pt>
                <c:pt idx="398">
                  <c:v>2.9449999999999962E-3</c:v>
                </c:pt>
                <c:pt idx="399">
                  <c:v>2.8999999999999998E-3</c:v>
                </c:pt>
                <c:pt idx="400">
                  <c:v>2.7920000000000028E-3</c:v>
                </c:pt>
                <c:pt idx="401">
                  <c:v>2.7620000000000006E-3</c:v>
                </c:pt>
                <c:pt idx="402">
                  <c:v>2.7310000000000043E-3</c:v>
                </c:pt>
                <c:pt idx="403">
                  <c:v>2.6850000000000068E-3</c:v>
                </c:pt>
                <c:pt idx="404">
                  <c:v>2.6090000000000002E-3</c:v>
                </c:pt>
                <c:pt idx="405">
                  <c:v>2.5629999999999958E-3</c:v>
                </c:pt>
                <c:pt idx="406">
                  <c:v>2.577999999999997E-3</c:v>
                </c:pt>
                <c:pt idx="407">
                  <c:v>2.5480000000000017E-3</c:v>
                </c:pt>
                <c:pt idx="408">
                  <c:v>2.5329999999999936E-3</c:v>
                </c:pt>
                <c:pt idx="409">
                  <c:v>2.5180000000000063E-3</c:v>
                </c:pt>
                <c:pt idx="410">
                  <c:v>2.4409999999999987E-3</c:v>
                </c:pt>
                <c:pt idx="411">
                  <c:v>2.3959999999999954E-3</c:v>
                </c:pt>
                <c:pt idx="412">
                  <c:v>2.3490000000000039E-3</c:v>
                </c:pt>
                <c:pt idx="413">
                  <c:v>2.3959999999999954E-3</c:v>
                </c:pt>
                <c:pt idx="414">
                  <c:v>2.364999999999999E-3</c:v>
                </c:pt>
                <c:pt idx="415">
                  <c:v>2.3350000000000037E-3</c:v>
                </c:pt>
                <c:pt idx="416">
                  <c:v>2.3350000000000037E-3</c:v>
                </c:pt>
                <c:pt idx="417">
                  <c:v>2.2130000000000066E-3</c:v>
                </c:pt>
                <c:pt idx="418">
                  <c:v>2.0909999999999956E-3</c:v>
                </c:pt>
                <c:pt idx="419">
                  <c:v>2.1209999999999979E-3</c:v>
                </c:pt>
                <c:pt idx="420">
                  <c:v>2.135999999999999E-3</c:v>
                </c:pt>
                <c:pt idx="421">
                  <c:v>2.1510000000000001E-3</c:v>
                </c:pt>
                <c:pt idx="422">
                  <c:v>2.1659999999999943E-3</c:v>
                </c:pt>
                <c:pt idx="423">
                  <c:v>2.1210000000000048E-3</c:v>
                </c:pt>
                <c:pt idx="424">
                  <c:v>2.029000000000003E-3</c:v>
                </c:pt>
                <c:pt idx="425">
                  <c:v>2.029000000000003E-3</c:v>
                </c:pt>
                <c:pt idx="426">
                  <c:v>2.0599999999999993E-3</c:v>
                </c:pt>
                <c:pt idx="427">
                  <c:v>1.9990000000000008E-3</c:v>
                </c:pt>
                <c:pt idx="428">
                  <c:v>1.9839999999999997E-3</c:v>
                </c:pt>
                <c:pt idx="429">
                  <c:v>2.0440000000000041E-3</c:v>
                </c:pt>
                <c:pt idx="430">
                  <c:v>1.9529999999999964E-3</c:v>
                </c:pt>
                <c:pt idx="431">
                  <c:v>1.907999999999993E-3</c:v>
                </c:pt>
                <c:pt idx="432">
                  <c:v>2.029000000000003E-3</c:v>
                </c:pt>
                <c:pt idx="433">
                  <c:v>1.9070000000000059E-3</c:v>
                </c:pt>
                <c:pt idx="434">
                  <c:v>1.7860000000000098E-3</c:v>
                </c:pt>
                <c:pt idx="435">
                  <c:v>1.799999999999996E-3</c:v>
                </c:pt>
                <c:pt idx="436">
                  <c:v>1.7399999999999985E-3</c:v>
                </c:pt>
                <c:pt idx="437">
                  <c:v>1.6480000000000036E-3</c:v>
                </c:pt>
                <c:pt idx="438">
                  <c:v>1.7399999999999916E-3</c:v>
                </c:pt>
                <c:pt idx="439">
                  <c:v>1.7700000000000007E-3</c:v>
                </c:pt>
                <c:pt idx="440">
                  <c:v>1.7090000000000022E-3</c:v>
                </c:pt>
                <c:pt idx="441">
                  <c:v>1.6479999999999967E-3</c:v>
                </c:pt>
                <c:pt idx="442">
                  <c:v>1.5870000000000051E-3</c:v>
                </c:pt>
                <c:pt idx="443">
                  <c:v>1.5560000000000018E-3</c:v>
                </c:pt>
                <c:pt idx="444">
                  <c:v>1.4800000000000021E-3</c:v>
                </c:pt>
                <c:pt idx="445">
                  <c:v>1.4339999999999908E-3</c:v>
                </c:pt>
                <c:pt idx="446">
                  <c:v>1.449999999999993E-3</c:v>
                </c:pt>
                <c:pt idx="447">
                  <c:v>1.4649999999999941E-3</c:v>
                </c:pt>
                <c:pt idx="448">
                  <c:v>1.3890000000000013E-3</c:v>
                </c:pt>
                <c:pt idx="449">
                  <c:v>1.3120000000000007E-3</c:v>
                </c:pt>
                <c:pt idx="450">
                  <c:v>1.3269999999999949E-3</c:v>
                </c:pt>
                <c:pt idx="451">
                  <c:v>1.2819999999999915E-3</c:v>
                </c:pt>
                <c:pt idx="452">
                  <c:v>1.4340000000000047E-3</c:v>
                </c:pt>
                <c:pt idx="453">
                  <c:v>1.5109999999999985E-3</c:v>
                </c:pt>
                <c:pt idx="454">
                  <c:v>1.3730000000000062E-3</c:v>
                </c:pt>
                <c:pt idx="455">
                  <c:v>1.3579999999999981E-3</c:v>
                </c:pt>
                <c:pt idx="456">
                  <c:v>1.3120000000000007E-3</c:v>
                </c:pt>
                <c:pt idx="457">
                  <c:v>1.2209999999999999E-3</c:v>
                </c:pt>
                <c:pt idx="458">
                  <c:v>1.0529999999999984E-3</c:v>
                </c:pt>
                <c:pt idx="459">
                  <c:v>8.6900000000000172E-4</c:v>
                </c:pt>
                <c:pt idx="460">
                  <c:v>7.470000000000046E-4</c:v>
                </c:pt>
                <c:pt idx="461">
                  <c:v>7.0200000000000123E-4</c:v>
                </c:pt>
                <c:pt idx="462">
                  <c:v>6.0999999999999943E-4</c:v>
                </c:pt>
                <c:pt idx="463">
                  <c:v>6.1099999999999349E-4</c:v>
                </c:pt>
                <c:pt idx="464">
                  <c:v>6.1000000000000637E-4</c:v>
                </c:pt>
                <c:pt idx="465">
                  <c:v>5.7900000000001006E-4</c:v>
                </c:pt>
                <c:pt idx="466">
                  <c:v>5.7999999999999718E-4</c:v>
                </c:pt>
                <c:pt idx="467">
                  <c:v>5.8000000000001106E-4</c:v>
                </c:pt>
                <c:pt idx="468">
                  <c:v>3.6599999999999827E-4</c:v>
                </c:pt>
                <c:pt idx="469">
                  <c:v>4.2699999999999683E-4</c:v>
                </c:pt>
                <c:pt idx="470">
                  <c:v>4.5800000000000007E-4</c:v>
                </c:pt>
                <c:pt idx="471">
                  <c:v>4.5800000000000007E-4</c:v>
                </c:pt>
                <c:pt idx="472">
                  <c:v>4.5800000000000007E-4</c:v>
                </c:pt>
                <c:pt idx="473">
                  <c:v>4.5699999999999907E-4</c:v>
                </c:pt>
                <c:pt idx="474">
                  <c:v>4.2800000000000477E-4</c:v>
                </c:pt>
                <c:pt idx="475">
                  <c:v>2.5900000000000228E-4</c:v>
                </c:pt>
                <c:pt idx="476">
                  <c:v>2.2900000000000698E-4</c:v>
                </c:pt>
                <c:pt idx="477">
                  <c:v>3.9700000000000152E-4</c:v>
                </c:pt>
                <c:pt idx="478">
                  <c:v>4.4299999999999895E-4</c:v>
                </c:pt>
                <c:pt idx="479">
                  <c:v>2.8999999999999859E-4</c:v>
                </c:pt>
                <c:pt idx="480">
                  <c:v>3.2100000000000184E-4</c:v>
                </c:pt>
                <c:pt idx="481">
                  <c:v>3.6600000000000521E-4</c:v>
                </c:pt>
                <c:pt idx="482">
                  <c:v>3.9699999999999458E-4</c:v>
                </c:pt>
                <c:pt idx="483">
                  <c:v>3.5100000000000409E-4</c:v>
                </c:pt>
                <c:pt idx="484">
                  <c:v>2.440000000000081E-4</c:v>
                </c:pt>
                <c:pt idx="485">
                  <c:v>2.6000000000000328E-4</c:v>
                </c:pt>
                <c:pt idx="486">
                  <c:v>2.8999999999999859E-4</c:v>
                </c:pt>
                <c:pt idx="487">
                  <c:v>1.8300000000000261E-4</c:v>
                </c:pt>
                <c:pt idx="488">
                  <c:v>1.8300000000000261E-4</c:v>
                </c:pt>
                <c:pt idx="489">
                  <c:v>2.4400000000000116E-4</c:v>
                </c:pt>
                <c:pt idx="490">
                  <c:v>2.5899999999999535E-4</c:v>
                </c:pt>
                <c:pt idx="491">
                  <c:v>1.8300000000000261E-4</c:v>
                </c:pt>
                <c:pt idx="492">
                  <c:v>1.5300000000000036E-4</c:v>
                </c:pt>
                <c:pt idx="493">
                  <c:v>1.5199999999999936E-4</c:v>
                </c:pt>
                <c:pt idx="494">
                  <c:v>9.0999999999993864E-5</c:v>
                </c:pt>
                <c:pt idx="495">
                  <c:v>-3.1000000000003247E-5</c:v>
                </c:pt>
                <c:pt idx="496">
                  <c:v>-4.5999999999990493E-5</c:v>
                </c:pt>
                <c:pt idx="497">
                  <c:v>0</c:v>
                </c:pt>
                <c:pt idx="498">
                  <c:v>1.5000000000001124E-5</c:v>
                </c:pt>
                <c:pt idx="499">
                  <c:v>-4.4999999999996432E-5</c:v>
                </c:pt>
                <c:pt idx="500">
                  <c:v>0</c:v>
                </c:pt>
                <c:pt idx="501">
                  <c:v>4.6000000000004371E-5</c:v>
                </c:pt>
                <c:pt idx="502">
                  <c:v>1.6000000000002124E-5</c:v>
                </c:pt>
                <c:pt idx="503">
                  <c:v>-1.379999999999923E-4</c:v>
                </c:pt>
                <c:pt idx="504">
                  <c:v>-1.9800000000000373E-4</c:v>
                </c:pt>
                <c:pt idx="505">
                  <c:v>-9.1999999999994864E-5</c:v>
                </c:pt>
                <c:pt idx="506">
                  <c:v>-1.8400000000000361E-4</c:v>
                </c:pt>
                <c:pt idx="507">
                  <c:v>-2.8999999999999859E-4</c:v>
                </c:pt>
                <c:pt idx="508">
                  <c:v>-3.199999999999939E-4</c:v>
                </c:pt>
                <c:pt idx="509">
                  <c:v>-2.7399999999999647E-4</c:v>
                </c:pt>
                <c:pt idx="510">
                  <c:v>-2.9000000000000553E-4</c:v>
                </c:pt>
              </c:numCache>
            </c:numRef>
          </c:yVal>
          <c:smooth val="1"/>
          <c:extLst>
            <c:ext xmlns:c16="http://schemas.microsoft.com/office/drawing/2014/chart" uri="{C3380CC4-5D6E-409C-BE32-E72D297353CC}">
              <c16:uniqueId val="{00000000-20FA-48F3-A040-BB2472BF71A2}"/>
            </c:ext>
          </c:extLst>
        </c:ser>
        <c:dLbls>
          <c:showLegendKey val="0"/>
          <c:showVal val="0"/>
          <c:showCatName val="0"/>
          <c:showSerName val="0"/>
          <c:showPercent val="0"/>
          <c:showBubbleSize val="0"/>
        </c:dLbls>
        <c:axId val="150024528"/>
        <c:axId val="150025088"/>
      </c:scatterChart>
      <c:valAx>
        <c:axId val="150024528"/>
        <c:scaling>
          <c:orientation val="minMax"/>
          <c:max val="700"/>
          <c:min val="265"/>
        </c:scaling>
        <c:delete val="0"/>
        <c:axPos val="b"/>
        <c:title>
          <c:tx>
            <c:rich>
              <a:bodyPr/>
              <a:lstStyle/>
              <a:p>
                <a:pPr>
                  <a:defRPr/>
                </a:pPr>
                <a:r>
                  <a:rPr lang="en-GB" dirty="0"/>
                  <a:t>Wavelength (nm)</a:t>
                </a:r>
              </a:p>
            </c:rich>
          </c:tx>
          <c:layout/>
          <c:overlay val="0"/>
        </c:title>
        <c:numFmt formatCode="General" sourceLinked="1"/>
        <c:majorTickMark val="out"/>
        <c:minorTickMark val="none"/>
        <c:tickLblPos val="nextTo"/>
        <c:crossAx val="150025088"/>
        <c:crosses val="autoZero"/>
        <c:crossBetween val="midCat"/>
      </c:valAx>
      <c:valAx>
        <c:axId val="150025088"/>
        <c:scaling>
          <c:orientation val="minMax"/>
          <c:max val="0.42000000000000004"/>
          <c:min val="0"/>
        </c:scaling>
        <c:delete val="0"/>
        <c:axPos val="l"/>
        <c:title>
          <c:tx>
            <c:rich>
              <a:bodyPr rot="-5400000" vert="horz"/>
              <a:lstStyle/>
              <a:p>
                <a:pPr>
                  <a:defRPr/>
                </a:pPr>
                <a:r>
                  <a:rPr lang="en-GB"/>
                  <a:t>Absorbance (a.u.)</a:t>
                </a:r>
              </a:p>
            </c:rich>
          </c:tx>
          <c:layout/>
          <c:overlay val="0"/>
        </c:title>
        <c:numFmt formatCode="General" sourceLinked="1"/>
        <c:majorTickMark val="out"/>
        <c:minorTickMark val="none"/>
        <c:tickLblPos val="nextTo"/>
        <c:crossAx val="150024528"/>
        <c:crosses val="autoZero"/>
        <c:crossBetween val="midCat"/>
      </c:valAx>
    </c:plotArea>
    <c:plotVisOnly val="1"/>
    <c:dispBlanksAs val="gap"/>
    <c:showDLblsOverMax val="0"/>
  </c:chart>
  <c:externalData r:id="rId1">
    <c:autoUpdate val="0"/>
  </c:externalData>
</c:chartSpace>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3F2634FB-5E52-4198-AD78-A607A9FCB5DC}" type="datetimeFigureOut">
              <a:rPr lang="en-GB" smtClean="0"/>
              <a:t>26/05/2020</a:t>
            </a:fld>
            <a:endParaRPr lang="en-GB"/>
          </a:p>
        </p:txBody>
      </p:sp>
      <p:sp>
        <p:nvSpPr>
          <p:cNvPr id="4" name="Slide Image Placeholder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2173E2C9-C3F2-45F3-9086-58EE1D0F7D37}" type="slidenum">
              <a:rPr lang="en-GB" smtClean="0"/>
              <a:t>‹#›</a:t>
            </a:fld>
            <a:endParaRPr lang="en-GB"/>
          </a:p>
        </p:txBody>
      </p:sp>
    </p:spTree>
    <p:extLst>
      <p:ext uri="{BB962C8B-B14F-4D97-AF65-F5344CB8AC3E}">
        <p14:creationId xmlns:p14="http://schemas.microsoft.com/office/powerpoint/2010/main" val="3654296276"/>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en-US"/>
              <a:t>Click to edit Master title style</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212611640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22248789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35180498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11387609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en-US"/>
              <a:t>Click to edit Master title style</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Edit Master text styles</a:t>
            </a:r>
          </a:p>
        </p:txBody>
      </p:sp>
      <p:sp>
        <p:nvSpPr>
          <p:cNvPr id="4" name="Date Placeholder 3"/>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5" name="Footer Placeholder 4"/>
          <p:cNvSpPr>
            <a:spLocks noGrp="1"/>
          </p:cNvSpPr>
          <p:nvPr>
            <p:ph type="ftr" sz="quarter" idx="11"/>
          </p:nvPr>
        </p:nvSpPr>
        <p:spPr/>
        <p:txBody>
          <a:bodyPr/>
          <a:lstStyle/>
          <a:p>
            <a:endParaRPr lang="en-GB" dirty="0"/>
          </a:p>
        </p:txBody>
      </p:sp>
      <p:sp>
        <p:nvSpPr>
          <p:cNvPr id="6" name="Slide Number Placeholder 5"/>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3547240538"/>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318759429"/>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4" name="Content Placeholder 3"/>
          <p:cNvSpPr>
            <a:spLocks noGrp="1"/>
          </p:cNvSpPr>
          <p:nvPr>
            <p:ph sz="half" idx="2"/>
          </p:nvPr>
        </p:nvSpPr>
        <p:spPr>
          <a:xfrm>
            <a:off x="629842" y="2505075"/>
            <a:ext cx="3868340"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Edit Master text styles</a:t>
            </a:r>
          </a:p>
        </p:txBody>
      </p:sp>
      <p:sp>
        <p:nvSpPr>
          <p:cNvPr id="6" name="Content Placeholder 5"/>
          <p:cNvSpPr>
            <a:spLocks noGrp="1"/>
          </p:cNvSpPr>
          <p:nvPr>
            <p:ph sz="quarter" idx="4"/>
          </p:nvPr>
        </p:nvSpPr>
        <p:spPr>
          <a:xfrm>
            <a:off x="4629150" y="2505075"/>
            <a:ext cx="3887391" cy="3684588"/>
          </a:xfrm>
        </p:spPr>
        <p:txBody>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8" name="Footer Placeholder 7"/>
          <p:cNvSpPr>
            <a:spLocks noGrp="1"/>
          </p:cNvSpPr>
          <p:nvPr>
            <p:ph type="ftr" sz="quarter" idx="11"/>
          </p:nvPr>
        </p:nvSpPr>
        <p:spPr/>
        <p:txBody>
          <a:bodyPr/>
          <a:lstStyle/>
          <a:p>
            <a:endParaRPr lang="en-GB" dirty="0"/>
          </a:p>
        </p:txBody>
      </p:sp>
      <p:sp>
        <p:nvSpPr>
          <p:cNvPr id="9" name="Slide Number Placeholder 8"/>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4285472443"/>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4" name="Footer Placeholder 3"/>
          <p:cNvSpPr>
            <a:spLocks noGrp="1"/>
          </p:cNvSpPr>
          <p:nvPr>
            <p:ph type="ftr" sz="quarter" idx="11"/>
          </p:nvPr>
        </p:nvSpPr>
        <p:spPr/>
        <p:txBody>
          <a:bodyPr/>
          <a:lstStyle/>
          <a:p>
            <a:endParaRPr lang="en-GB" dirty="0"/>
          </a:p>
        </p:txBody>
      </p:sp>
      <p:sp>
        <p:nvSpPr>
          <p:cNvPr id="5" name="Slide Number Placeholder 4"/>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1829393870"/>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3" name="Footer Placeholder 2"/>
          <p:cNvSpPr>
            <a:spLocks noGrp="1"/>
          </p:cNvSpPr>
          <p:nvPr>
            <p:ph type="ftr" sz="quarter" idx="11"/>
          </p:nvPr>
        </p:nvSpPr>
        <p:spPr/>
        <p:txBody>
          <a:bodyPr/>
          <a:lstStyle/>
          <a:p>
            <a:endParaRPr lang="en-GB" dirty="0"/>
          </a:p>
        </p:txBody>
      </p:sp>
      <p:sp>
        <p:nvSpPr>
          <p:cNvPr id="4" name="Slide Number Placeholder 3"/>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4149942397"/>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3123052496"/>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987426"/>
            <a:ext cx="4629150" cy="4873625"/>
          </a:xfrm>
        </p:spPr>
        <p:txBody>
          <a:bodyPr anchor="t"/>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r>
              <a:rPr lang="en-US" dirty="0"/>
              <a:t>Click icon to add picture</a:t>
            </a:r>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Edit Master text styles</a:t>
            </a:r>
          </a:p>
        </p:txBody>
      </p:sp>
      <p:sp>
        <p:nvSpPr>
          <p:cNvPr id="5" name="Date Placeholder 4"/>
          <p:cNvSpPr>
            <a:spLocks noGrp="1"/>
          </p:cNvSpPr>
          <p:nvPr>
            <p:ph type="dt" sz="half" idx="10"/>
          </p:nvPr>
        </p:nvSpPr>
        <p:spPr/>
        <p:txBody>
          <a:bodyPr/>
          <a:lstStyle/>
          <a:p>
            <a:fld id="{BA50AE67-1A90-4B19-9C4C-310DC804CD33}" type="datetimeFigureOut">
              <a:rPr lang="en-GB" smtClean="0"/>
              <a:t>26/05/2020</a:t>
            </a:fld>
            <a:endParaRPr lang="en-GB" dirty="0"/>
          </a:p>
        </p:txBody>
      </p:sp>
      <p:sp>
        <p:nvSpPr>
          <p:cNvPr id="6" name="Footer Placeholder 5"/>
          <p:cNvSpPr>
            <a:spLocks noGrp="1"/>
          </p:cNvSpPr>
          <p:nvPr>
            <p:ph type="ftr" sz="quarter" idx="11"/>
          </p:nvPr>
        </p:nvSpPr>
        <p:spPr/>
        <p:txBody>
          <a:bodyPr/>
          <a:lstStyle/>
          <a:p>
            <a:endParaRPr lang="en-GB" dirty="0"/>
          </a:p>
        </p:txBody>
      </p:sp>
      <p:sp>
        <p:nvSpPr>
          <p:cNvPr id="7" name="Slide Number Placeholder 6"/>
          <p:cNvSpPr>
            <a:spLocks noGrp="1"/>
          </p:cNvSpPr>
          <p:nvPr>
            <p:ph type="sldNum" sz="quarter" idx="12"/>
          </p:nvPr>
        </p:nvSpPr>
        <p:spPr/>
        <p:txBody>
          <a:bodyPr/>
          <a:lstStyle/>
          <a:p>
            <a:fld id="{C54B57B2-D994-41E1-BB98-5C979DB9B7A8}" type="slidenum">
              <a:rPr lang="en-GB" smtClean="0"/>
              <a:t>‹#›</a:t>
            </a:fld>
            <a:endParaRPr lang="en-GB" dirty="0"/>
          </a:p>
        </p:txBody>
      </p:sp>
    </p:spTree>
    <p:extLst>
      <p:ext uri="{BB962C8B-B14F-4D97-AF65-F5344CB8AC3E}">
        <p14:creationId xmlns:p14="http://schemas.microsoft.com/office/powerpoint/2010/main" val="1197296518"/>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en-US"/>
              <a:t>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A50AE67-1A90-4B19-9C4C-310DC804CD33}" type="datetimeFigureOut">
              <a:rPr lang="en-GB" smtClean="0"/>
              <a:t>26/05/2020</a:t>
            </a:fld>
            <a:endParaRPr lang="en-GB" dirty="0"/>
          </a:p>
        </p:txBody>
      </p:sp>
      <p:sp>
        <p:nvSpPr>
          <p:cNvPr id="5" name="Footer Placeholder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GB" dirty="0"/>
          </a:p>
        </p:txBody>
      </p:sp>
      <p:sp>
        <p:nvSpPr>
          <p:cNvPr id="6" name="Slide Number Placeholder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C54B57B2-D994-41E1-BB98-5C979DB9B7A8}" type="slidenum">
              <a:rPr lang="en-GB" smtClean="0"/>
              <a:t>‹#›</a:t>
            </a:fld>
            <a:endParaRPr lang="en-GB" dirty="0"/>
          </a:p>
        </p:txBody>
      </p:sp>
    </p:spTree>
    <p:extLst>
      <p:ext uri="{BB962C8B-B14F-4D97-AF65-F5344CB8AC3E}">
        <p14:creationId xmlns:p14="http://schemas.microsoft.com/office/powerpoint/2010/main" val="3662535260"/>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2" Type="http://schemas.openxmlformats.org/officeDocument/2006/relationships/image" Target="../media/image1.jpeg"/><Relationship Id="rId1" Type="http://schemas.openxmlformats.org/officeDocument/2006/relationships/slideLayout" Target="../slideLayouts/slideLayout2.xml"/><Relationship Id="rId4" Type="http://schemas.openxmlformats.org/officeDocument/2006/relationships/image" Target="../media/image3.jpeg"/></Relationships>
</file>

<file path=ppt/slides/_rels/slide2.xml.rels><?xml version="1.0" encoding="UTF-8" standalone="yes"?>
<Relationships xmlns="http://schemas.openxmlformats.org/package/2006/relationships"><Relationship Id="rId3" Type="http://schemas.openxmlformats.org/officeDocument/2006/relationships/chart" Target="../charts/chart2.xml"/><Relationship Id="rId2" Type="http://schemas.openxmlformats.org/officeDocument/2006/relationships/chart" Target="../charts/chart1.xml"/><Relationship Id="rId1" Type="http://schemas.openxmlformats.org/officeDocument/2006/relationships/slideLayout" Target="../slideLayouts/slideLayout2.xml"/><Relationship Id="rId4" Type="http://schemas.openxmlformats.org/officeDocument/2006/relationships/chart" Target="../charts/chart3.xml"/></Relationships>
</file>

<file path=ppt/slides/_rels/slide3.xml.rels><?xml version="1.0" encoding="UTF-8" standalone="yes"?>
<Relationships xmlns="http://schemas.openxmlformats.org/package/2006/relationships"><Relationship Id="rId8" Type="http://schemas.microsoft.com/office/2007/relationships/hdphoto" Target="../media/hdphoto3.wdp"/><Relationship Id="rId13" Type="http://schemas.microsoft.com/office/2007/relationships/hdphoto" Target="../media/hdphoto5.wdp"/><Relationship Id="rId18" Type="http://schemas.openxmlformats.org/officeDocument/2006/relationships/chart" Target="../charts/chart4.xml"/><Relationship Id="rId3" Type="http://schemas.microsoft.com/office/2007/relationships/hdphoto" Target="../media/hdphoto1.wdp"/><Relationship Id="rId21" Type="http://schemas.openxmlformats.org/officeDocument/2006/relationships/image" Target="../media/image15.png"/><Relationship Id="rId7" Type="http://schemas.openxmlformats.org/officeDocument/2006/relationships/image" Target="../media/image7.png"/><Relationship Id="rId12" Type="http://schemas.openxmlformats.org/officeDocument/2006/relationships/image" Target="../media/image10.png"/><Relationship Id="rId17" Type="http://schemas.openxmlformats.org/officeDocument/2006/relationships/image" Target="../media/image13.png"/><Relationship Id="rId2" Type="http://schemas.openxmlformats.org/officeDocument/2006/relationships/image" Target="../media/image4.png"/><Relationship Id="rId16" Type="http://schemas.openxmlformats.org/officeDocument/2006/relationships/image" Target="../media/image12.png"/><Relationship Id="rId20" Type="http://schemas.microsoft.com/office/2007/relationships/hdphoto" Target="../media/hdphoto7.wdp"/><Relationship Id="rId1" Type="http://schemas.openxmlformats.org/officeDocument/2006/relationships/slideLayout" Target="../slideLayouts/slideLayout2.xml"/><Relationship Id="rId6" Type="http://schemas.openxmlformats.org/officeDocument/2006/relationships/image" Target="../media/image6.png"/><Relationship Id="rId11" Type="http://schemas.microsoft.com/office/2007/relationships/hdphoto" Target="../media/hdphoto4.wdp"/><Relationship Id="rId5" Type="http://schemas.microsoft.com/office/2007/relationships/hdphoto" Target="../media/hdphoto2.wdp"/><Relationship Id="rId15" Type="http://schemas.microsoft.com/office/2007/relationships/hdphoto" Target="../media/hdphoto6.wdp"/><Relationship Id="rId10" Type="http://schemas.openxmlformats.org/officeDocument/2006/relationships/image" Target="../media/image9.png"/><Relationship Id="rId19" Type="http://schemas.openxmlformats.org/officeDocument/2006/relationships/image" Target="../media/image14.png"/><Relationship Id="rId4" Type="http://schemas.openxmlformats.org/officeDocument/2006/relationships/image" Target="../media/image5.png"/><Relationship Id="rId9" Type="http://schemas.openxmlformats.org/officeDocument/2006/relationships/image" Target="../media/image8.png"/><Relationship Id="rId14" Type="http://schemas.openxmlformats.org/officeDocument/2006/relationships/image" Target="../media/image11.png"/></Relationships>
</file>

<file path=ppt/slides/_rels/slide4.xml.rels><?xml version="1.0" encoding="UTF-8" standalone="yes"?>
<Relationships xmlns="http://schemas.openxmlformats.org/package/2006/relationships"><Relationship Id="rId8" Type="http://schemas.openxmlformats.org/officeDocument/2006/relationships/image" Target="../media/image20.png"/><Relationship Id="rId13" Type="http://schemas.openxmlformats.org/officeDocument/2006/relationships/image" Target="../media/image25.png"/><Relationship Id="rId18" Type="http://schemas.openxmlformats.org/officeDocument/2006/relationships/image" Target="../media/image30.png"/><Relationship Id="rId26" Type="http://schemas.openxmlformats.org/officeDocument/2006/relationships/image" Target="../media/image38.png"/><Relationship Id="rId3" Type="http://schemas.openxmlformats.org/officeDocument/2006/relationships/chart" Target="../charts/chart6.xml"/><Relationship Id="rId21" Type="http://schemas.openxmlformats.org/officeDocument/2006/relationships/image" Target="../media/image33.png"/><Relationship Id="rId7" Type="http://schemas.openxmlformats.org/officeDocument/2006/relationships/image" Target="../media/image19.png"/><Relationship Id="rId12" Type="http://schemas.openxmlformats.org/officeDocument/2006/relationships/image" Target="../media/image24.png"/><Relationship Id="rId17" Type="http://schemas.openxmlformats.org/officeDocument/2006/relationships/image" Target="../media/image29.png"/><Relationship Id="rId25" Type="http://schemas.openxmlformats.org/officeDocument/2006/relationships/image" Target="../media/image37.tiff"/><Relationship Id="rId2" Type="http://schemas.openxmlformats.org/officeDocument/2006/relationships/chart" Target="../charts/chart5.xml"/><Relationship Id="rId16" Type="http://schemas.openxmlformats.org/officeDocument/2006/relationships/image" Target="../media/image28.png"/><Relationship Id="rId20" Type="http://schemas.openxmlformats.org/officeDocument/2006/relationships/image" Target="../media/image32.png"/><Relationship Id="rId1" Type="http://schemas.openxmlformats.org/officeDocument/2006/relationships/slideLayout" Target="../slideLayouts/slideLayout1.xml"/><Relationship Id="rId6" Type="http://schemas.openxmlformats.org/officeDocument/2006/relationships/image" Target="../media/image18.png"/><Relationship Id="rId11" Type="http://schemas.openxmlformats.org/officeDocument/2006/relationships/image" Target="../media/image23.png"/><Relationship Id="rId24" Type="http://schemas.openxmlformats.org/officeDocument/2006/relationships/image" Target="../media/image36.png"/><Relationship Id="rId5" Type="http://schemas.openxmlformats.org/officeDocument/2006/relationships/image" Target="../media/image17.png"/><Relationship Id="rId15" Type="http://schemas.openxmlformats.org/officeDocument/2006/relationships/image" Target="../media/image27.png"/><Relationship Id="rId23" Type="http://schemas.openxmlformats.org/officeDocument/2006/relationships/image" Target="../media/image35.png"/><Relationship Id="rId10" Type="http://schemas.openxmlformats.org/officeDocument/2006/relationships/image" Target="../media/image22.png"/><Relationship Id="rId19" Type="http://schemas.openxmlformats.org/officeDocument/2006/relationships/image" Target="../media/image31.png"/><Relationship Id="rId4" Type="http://schemas.openxmlformats.org/officeDocument/2006/relationships/image" Target="../media/image16.png"/><Relationship Id="rId9" Type="http://schemas.openxmlformats.org/officeDocument/2006/relationships/image" Target="../media/image21.png"/><Relationship Id="rId14" Type="http://schemas.openxmlformats.org/officeDocument/2006/relationships/image" Target="../media/image26.png"/><Relationship Id="rId22" Type="http://schemas.openxmlformats.org/officeDocument/2006/relationships/image" Target="../media/image34.png"/><Relationship Id="rId27" Type="http://schemas.openxmlformats.org/officeDocument/2006/relationships/image" Target="../media/image39.png"/></Relationships>
</file>

<file path=ppt/slides/_rels/slide5.xml.rels><?xml version="1.0" encoding="UTF-8" standalone="yes"?>
<Relationships xmlns="http://schemas.openxmlformats.org/package/2006/relationships"><Relationship Id="rId8" Type="http://schemas.openxmlformats.org/officeDocument/2006/relationships/image" Target="../media/image43.png"/><Relationship Id="rId13" Type="http://schemas.microsoft.com/office/2007/relationships/hdphoto" Target="../media/hdphoto13.wdp"/><Relationship Id="rId18" Type="http://schemas.openxmlformats.org/officeDocument/2006/relationships/image" Target="../media/image48.png"/><Relationship Id="rId26" Type="http://schemas.openxmlformats.org/officeDocument/2006/relationships/image" Target="../media/image52.png"/><Relationship Id="rId39" Type="http://schemas.microsoft.com/office/2007/relationships/hdphoto" Target="../media/hdphoto23.wdp"/><Relationship Id="rId3" Type="http://schemas.microsoft.com/office/2007/relationships/hdphoto" Target="../media/hdphoto8.wdp"/><Relationship Id="rId21" Type="http://schemas.microsoft.com/office/2007/relationships/hdphoto" Target="../media/hdphoto17.wdp"/><Relationship Id="rId34" Type="http://schemas.openxmlformats.org/officeDocument/2006/relationships/image" Target="../media/image59.png"/><Relationship Id="rId7" Type="http://schemas.microsoft.com/office/2007/relationships/hdphoto" Target="../media/hdphoto10.wdp"/><Relationship Id="rId12" Type="http://schemas.openxmlformats.org/officeDocument/2006/relationships/image" Target="../media/image45.png"/><Relationship Id="rId17" Type="http://schemas.microsoft.com/office/2007/relationships/hdphoto" Target="../media/hdphoto15.wdp"/><Relationship Id="rId25" Type="http://schemas.microsoft.com/office/2007/relationships/hdphoto" Target="../media/hdphoto19.wdp"/><Relationship Id="rId33" Type="http://schemas.openxmlformats.org/officeDocument/2006/relationships/image" Target="../media/image58.png"/><Relationship Id="rId38" Type="http://schemas.openxmlformats.org/officeDocument/2006/relationships/image" Target="../media/image61.png"/><Relationship Id="rId2" Type="http://schemas.openxmlformats.org/officeDocument/2006/relationships/image" Target="../media/image40.png"/><Relationship Id="rId16" Type="http://schemas.openxmlformats.org/officeDocument/2006/relationships/image" Target="../media/image47.png"/><Relationship Id="rId20" Type="http://schemas.openxmlformats.org/officeDocument/2006/relationships/image" Target="../media/image49.png"/><Relationship Id="rId29" Type="http://schemas.openxmlformats.org/officeDocument/2006/relationships/image" Target="../media/image54.png"/><Relationship Id="rId41" Type="http://schemas.microsoft.com/office/2007/relationships/hdphoto" Target="../media/hdphoto24.wdp"/><Relationship Id="rId1" Type="http://schemas.openxmlformats.org/officeDocument/2006/relationships/slideLayout" Target="../slideLayouts/slideLayout2.xml"/><Relationship Id="rId6" Type="http://schemas.openxmlformats.org/officeDocument/2006/relationships/image" Target="../media/image42.png"/><Relationship Id="rId11" Type="http://schemas.microsoft.com/office/2007/relationships/hdphoto" Target="../media/hdphoto12.wdp"/><Relationship Id="rId24" Type="http://schemas.openxmlformats.org/officeDocument/2006/relationships/image" Target="../media/image51.png"/><Relationship Id="rId32" Type="http://schemas.openxmlformats.org/officeDocument/2006/relationships/image" Target="../media/image57.png"/><Relationship Id="rId37" Type="http://schemas.microsoft.com/office/2007/relationships/hdphoto" Target="../media/hdphoto22.wdp"/><Relationship Id="rId40" Type="http://schemas.openxmlformats.org/officeDocument/2006/relationships/image" Target="../media/image62.png"/><Relationship Id="rId5" Type="http://schemas.microsoft.com/office/2007/relationships/hdphoto" Target="../media/hdphoto9.wdp"/><Relationship Id="rId15" Type="http://schemas.microsoft.com/office/2007/relationships/hdphoto" Target="../media/hdphoto14.wdp"/><Relationship Id="rId23" Type="http://schemas.microsoft.com/office/2007/relationships/hdphoto" Target="../media/hdphoto18.wdp"/><Relationship Id="rId28" Type="http://schemas.openxmlformats.org/officeDocument/2006/relationships/image" Target="../media/image53.png"/><Relationship Id="rId36" Type="http://schemas.openxmlformats.org/officeDocument/2006/relationships/image" Target="../media/image60.png"/><Relationship Id="rId10" Type="http://schemas.openxmlformats.org/officeDocument/2006/relationships/image" Target="../media/image44.png"/><Relationship Id="rId19" Type="http://schemas.microsoft.com/office/2007/relationships/hdphoto" Target="../media/hdphoto16.wdp"/><Relationship Id="rId31" Type="http://schemas.openxmlformats.org/officeDocument/2006/relationships/image" Target="../media/image56.png"/><Relationship Id="rId4" Type="http://schemas.openxmlformats.org/officeDocument/2006/relationships/image" Target="../media/image41.png"/><Relationship Id="rId9" Type="http://schemas.microsoft.com/office/2007/relationships/hdphoto" Target="../media/hdphoto11.wdp"/><Relationship Id="rId14" Type="http://schemas.openxmlformats.org/officeDocument/2006/relationships/image" Target="../media/image46.png"/><Relationship Id="rId22" Type="http://schemas.openxmlformats.org/officeDocument/2006/relationships/image" Target="../media/image50.png"/><Relationship Id="rId27" Type="http://schemas.microsoft.com/office/2007/relationships/hdphoto" Target="../media/hdphoto20.wdp"/><Relationship Id="rId30" Type="http://schemas.openxmlformats.org/officeDocument/2006/relationships/image" Target="../media/image55.png"/><Relationship Id="rId35" Type="http://schemas.microsoft.com/office/2007/relationships/hdphoto" Target="../media/hdphoto21.wdp"/></Relationships>
</file>

<file path=ppt/slides/_rels/slide6.xml.rels><?xml version="1.0" encoding="UTF-8" standalone="yes"?>
<Relationships xmlns="http://schemas.openxmlformats.org/package/2006/relationships"><Relationship Id="rId8" Type="http://schemas.openxmlformats.org/officeDocument/2006/relationships/chart" Target="../charts/chart11.xml"/><Relationship Id="rId3" Type="http://schemas.openxmlformats.org/officeDocument/2006/relationships/chart" Target="../charts/chart8.xml"/><Relationship Id="rId7" Type="http://schemas.openxmlformats.org/officeDocument/2006/relationships/chart" Target="../charts/chart10.xml"/><Relationship Id="rId2" Type="http://schemas.openxmlformats.org/officeDocument/2006/relationships/chart" Target="../charts/chart7.xml"/><Relationship Id="rId1" Type="http://schemas.openxmlformats.org/officeDocument/2006/relationships/slideLayout" Target="../slideLayouts/slideLayout2.xml"/><Relationship Id="rId6" Type="http://schemas.openxmlformats.org/officeDocument/2006/relationships/image" Target="../media/image64.png"/><Relationship Id="rId11" Type="http://schemas.openxmlformats.org/officeDocument/2006/relationships/chart" Target="../charts/chart14.xml"/><Relationship Id="rId5" Type="http://schemas.openxmlformats.org/officeDocument/2006/relationships/image" Target="../media/image63.png"/><Relationship Id="rId10" Type="http://schemas.openxmlformats.org/officeDocument/2006/relationships/chart" Target="../charts/chart13.xml"/><Relationship Id="rId4" Type="http://schemas.openxmlformats.org/officeDocument/2006/relationships/chart" Target="../charts/chart9.xml"/><Relationship Id="rId9" Type="http://schemas.openxmlformats.org/officeDocument/2006/relationships/chart" Target="../charts/chart12.xml"/></Relationships>
</file>

<file path=ppt/slides/_rels/slide7.xml.rels><?xml version="1.0" encoding="UTF-8" standalone="yes"?>
<Relationships xmlns="http://schemas.openxmlformats.org/package/2006/relationships"><Relationship Id="rId3" Type="http://schemas.openxmlformats.org/officeDocument/2006/relationships/image" Target="../media/image66.png"/><Relationship Id="rId2" Type="http://schemas.openxmlformats.org/officeDocument/2006/relationships/image" Target="../media/image65.png"/><Relationship Id="rId1" Type="http://schemas.openxmlformats.org/officeDocument/2006/relationships/slideLayout" Target="../slideLayouts/slideLayout2.xml"/><Relationship Id="rId5" Type="http://schemas.openxmlformats.org/officeDocument/2006/relationships/image" Target="../media/image68.tiff"/><Relationship Id="rId4" Type="http://schemas.openxmlformats.org/officeDocument/2006/relationships/image" Target="../media/image67.tiff"/></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167" name="Group 166"/>
          <p:cNvGrpSpPr/>
          <p:nvPr/>
        </p:nvGrpSpPr>
        <p:grpSpPr>
          <a:xfrm>
            <a:off x="565718" y="4025863"/>
            <a:ext cx="2873096" cy="2412170"/>
            <a:chOff x="817608" y="304800"/>
            <a:chExt cx="2873096" cy="2412170"/>
          </a:xfrm>
        </p:grpSpPr>
        <p:sp>
          <p:nvSpPr>
            <p:cNvPr id="32" name="Rettangolo 5"/>
            <p:cNvSpPr/>
            <p:nvPr/>
          </p:nvSpPr>
          <p:spPr>
            <a:xfrm>
              <a:off x="862749" y="1917204"/>
              <a:ext cx="2784502" cy="535806"/>
            </a:xfrm>
            <a:prstGeom prst="rect">
              <a:avLst/>
            </a:prstGeom>
            <a:solidFill>
              <a:schemeClr val="accent1">
                <a:alpha val="2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54" name="Rectangle 53"/>
            <p:cNvSpPr/>
            <p:nvPr/>
          </p:nvSpPr>
          <p:spPr>
            <a:xfrm>
              <a:off x="2060505" y="2197870"/>
              <a:ext cx="376294" cy="255140"/>
            </a:xfrm>
            <a:prstGeom prst="rect">
              <a:avLst/>
            </a:prstGeom>
            <a:solidFill>
              <a:schemeClr val="bg1">
                <a:lumMod val="65000"/>
                <a:alpha val="5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9" name="Flowchart: Delay 23"/>
            <p:cNvSpPr/>
            <p:nvPr/>
          </p:nvSpPr>
          <p:spPr>
            <a:xfrm rot="5400000">
              <a:off x="2065937" y="1910188"/>
              <a:ext cx="387693" cy="550880"/>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5336"/>
                <a:gd name="connsiteY0" fmla="*/ 0 h 444051"/>
                <a:gd name="connsiteX1" fmla="*/ 177174 w 355336"/>
                <a:gd name="connsiteY1" fmla="*/ 0 h 444051"/>
                <a:gd name="connsiteX2" fmla="*/ 354348 w 355336"/>
                <a:gd name="connsiteY2" fmla="*/ 222026 h 444051"/>
                <a:gd name="connsiteX3" fmla="*/ 108117 w 355336"/>
                <a:gd name="connsiteY3" fmla="*/ 405952 h 444051"/>
                <a:gd name="connsiteX4" fmla="*/ 0 w 355336"/>
                <a:gd name="connsiteY4" fmla="*/ 444051 h 444051"/>
                <a:gd name="connsiteX5" fmla="*/ 0 w 355336"/>
                <a:gd name="connsiteY5" fmla="*/ 0 h 444051"/>
                <a:gd name="connsiteX0" fmla="*/ 0 w 354367"/>
                <a:gd name="connsiteY0" fmla="*/ 0 h 444051"/>
                <a:gd name="connsiteX1" fmla="*/ 96214 w 354367"/>
                <a:gd name="connsiteY1" fmla="*/ 52388 h 444051"/>
                <a:gd name="connsiteX2" fmla="*/ 354348 w 354367"/>
                <a:gd name="connsiteY2" fmla="*/ 222026 h 444051"/>
                <a:gd name="connsiteX3" fmla="*/ 108117 w 354367"/>
                <a:gd name="connsiteY3" fmla="*/ 405952 h 444051"/>
                <a:gd name="connsiteX4" fmla="*/ 0 w 354367"/>
                <a:gd name="connsiteY4" fmla="*/ 444051 h 444051"/>
                <a:gd name="connsiteX5" fmla="*/ 0 w 354367"/>
                <a:gd name="connsiteY5" fmla="*/ 0 h 444051"/>
                <a:gd name="connsiteX0" fmla="*/ 0 w 354367"/>
                <a:gd name="connsiteY0" fmla="*/ 0 h 444051"/>
                <a:gd name="connsiteX1" fmla="*/ 96214 w 354367"/>
                <a:gd name="connsiteY1" fmla="*/ 52388 h 444051"/>
                <a:gd name="connsiteX2" fmla="*/ 354348 w 354367"/>
                <a:gd name="connsiteY2" fmla="*/ 222026 h 444051"/>
                <a:gd name="connsiteX3" fmla="*/ 108117 w 354367"/>
                <a:gd name="connsiteY3" fmla="*/ 405952 h 444051"/>
                <a:gd name="connsiteX4" fmla="*/ 0 w 354367"/>
                <a:gd name="connsiteY4" fmla="*/ 444051 h 444051"/>
                <a:gd name="connsiteX5" fmla="*/ 0 w 354367"/>
                <a:gd name="connsiteY5" fmla="*/ 0 h 444051"/>
                <a:gd name="connsiteX0" fmla="*/ 0 w 354367"/>
                <a:gd name="connsiteY0" fmla="*/ 0 h 444051"/>
                <a:gd name="connsiteX1" fmla="*/ 96214 w 354367"/>
                <a:gd name="connsiteY1" fmla="*/ 52388 h 444051"/>
                <a:gd name="connsiteX2" fmla="*/ 354348 w 354367"/>
                <a:gd name="connsiteY2" fmla="*/ 222026 h 444051"/>
                <a:gd name="connsiteX3" fmla="*/ 108117 w 354367"/>
                <a:gd name="connsiteY3" fmla="*/ 405952 h 444051"/>
                <a:gd name="connsiteX4" fmla="*/ 0 w 354367"/>
                <a:gd name="connsiteY4" fmla="*/ 444051 h 444051"/>
                <a:gd name="connsiteX5" fmla="*/ 0 w 354367"/>
                <a:gd name="connsiteY5" fmla="*/ 0 h 444051"/>
                <a:gd name="connsiteX0" fmla="*/ 0 w 354370"/>
                <a:gd name="connsiteY0" fmla="*/ 0 h 444051"/>
                <a:gd name="connsiteX1" fmla="*/ 96214 w 354370"/>
                <a:gd name="connsiteY1" fmla="*/ 52388 h 444051"/>
                <a:gd name="connsiteX2" fmla="*/ 354348 w 354370"/>
                <a:gd name="connsiteY2" fmla="*/ 222026 h 444051"/>
                <a:gd name="connsiteX3" fmla="*/ 108117 w 354370"/>
                <a:gd name="connsiteY3" fmla="*/ 405952 h 444051"/>
                <a:gd name="connsiteX4" fmla="*/ 0 w 354370"/>
                <a:gd name="connsiteY4" fmla="*/ 444051 h 444051"/>
                <a:gd name="connsiteX5" fmla="*/ 0 w 354370"/>
                <a:gd name="connsiteY5" fmla="*/ 0 h 444051"/>
                <a:gd name="connsiteX0" fmla="*/ 0 w 355194"/>
                <a:gd name="connsiteY0" fmla="*/ 0 h 446480"/>
                <a:gd name="connsiteX1" fmla="*/ 96214 w 355194"/>
                <a:gd name="connsiteY1" fmla="*/ 52388 h 446480"/>
                <a:gd name="connsiteX2" fmla="*/ 354348 w 355194"/>
                <a:gd name="connsiteY2" fmla="*/ 222026 h 446480"/>
                <a:gd name="connsiteX3" fmla="*/ 10489 w 355194"/>
                <a:gd name="connsiteY3" fmla="*/ 446480 h 446480"/>
                <a:gd name="connsiteX4" fmla="*/ 0 w 355194"/>
                <a:gd name="connsiteY4" fmla="*/ 444051 h 446480"/>
                <a:gd name="connsiteX5" fmla="*/ 0 w 355194"/>
                <a:gd name="connsiteY5" fmla="*/ 0 h 446480"/>
                <a:gd name="connsiteX0" fmla="*/ 0 w 354356"/>
                <a:gd name="connsiteY0" fmla="*/ 0 h 446480"/>
                <a:gd name="connsiteX1" fmla="*/ 964 w 354356"/>
                <a:gd name="connsiteY1" fmla="*/ 11858 h 446480"/>
                <a:gd name="connsiteX2" fmla="*/ 354348 w 354356"/>
                <a:gd name="connsiteY2" fmla="*/ 222026 h 446480"/>
                <a:gd name="connsiteX3" fmla="*/ 10489 w 354356"/>
                <a:gd name="connsiteY3" fmla="*/ 446480 h 446480"/>
                <a:gd name="connsiteX4" fmla="*/ 0 w 354356"/>
                <a:gd name="connsiteY4" fmla="*/ 444051 h 446480"/>
                <a:gd name="connsiteX5" fmla="*/ 0 w 354356"/>
                <a:gd name="connsiteY5" fmla="*/ 0 h 446480"/>
                <a:gd name="connsiteX0" fmla="*/ 0 w 354356"/>
                <a:gd name="connsiteY0" fmla="*/ 0 h 446480"/>
                <a:gd name="connsiteX1" fmla="*/ 964 w 354356"/>
                <a:gd name="connsiteY1" fmla="*/ 11858 h 446480"/>
                <a:gd name="connsiteX2" fmla="*/ 354348 w 354356"/>
                <a:gd name="connsiteY2" fmla="*/ 222026 h 446480"/>
                <a:gd name="connsiteX3" fmla="*/ 10489 w 354356"/>
                <a:gd name="connsiteY3" fmla="*/ 446480 h 446480"/>
                <a:gd name="connsiteX4" fmla="*/ 0 w 354356"/>
                <a:gd name="connsiteY4" fmla="*/ 444051 h 446480"/>
                <a:gd name="connsiteX5" fmla="*/ 0 w 354356"/>
                <a:gd name="connsiteY5" fmla="*/ 0 h 446480"/>
                <a:gd name="connsiteX0" fmla="*/ 0 w 354356"/>
                <a:gd name="connsiteY0" fmla="*/ 0 h 446480"/>
                <a:gd name="connsiteX1" fmla="*/ 964 w 354356"/>
                <a:gd name="connsiteY1" fmla="*/ 11858 h 446480"/>
                <a:gd name="connsiteX2" fmla="*/ 354348 w 354356"/>
                <a:gd name="connsiteY2" fmla="*/ 229746 h 446480"/>
                <a:gd name="connsiteX3" fmla="*/ 10489 w 354356"/>
                <a:gd name="connsiteY3" fmla="*/ 446480 h 446480"/>
                <a:gd name="connsiteX4" fmla="*/ 0 w 354356"/>
                <a:gd name="connsiteY4" fmla="*/ 444051 h 446480"/>
                <a:gd name="connsiteX5" fmla="*/ 0 w 354356"/>
                <a:gd name="connsiteY5" fmla="*/ 0 h 446480"/>
                <a:gd name="connsiteX0" fmla="*/ 0 w 387693"/>
                <a:gd name="connsiteY0" fmla="*/ 0 h 446480"/>
                <a:gd name="connsiteX1" fmla="*/ 34301 w 387693"/>
                <a:gd name="connsiteY1" fmla="*/ 11858 h 446480"/>
                <a:gd name="connsiteX2" fmla="*/ 387685 w 387693"/>
                <a:gd name="connsiteY2" fmla="*/ 229746 h 446480"/>
                <a:gd name="connsiteX3" fmla="*/ 43826 w 387693"/>
                <a:gd name="connsiteY3" fmla="*/ 446480 h 446480"/>
                <a:gd name="connsiteX4" fmla="*/ 33337 w 387693"/>
                <a:gd name="connsiteY4" fmla="*/ 444051 h 446480"/>
                <a:gd name="connsiteX5" fmla="*/ 0 w 387693"/>
                <a:gd name="connsiteY5" fmla="*/ 0 h 4464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87693" h="446480">
                  <a:moveTo>
                    <a:pt x="0" y="0"/>
                  </a:moveTo>
                  <a:cubicBezTo>
                    <a:pt x="321" y="3953"/>
                    <a:pt x="33980" y="7905"/>
                    <a:pt x="34301" y="11858"/>
                  </a:cubicBezTo>
                  <a:cubicBezTo>
                    <a:pt x="129769" y="63018"/>
                    <a:pt x="386098" y="157309"/>
                    <a:pt x="387685" y="229746"/>
                  </a:cubicBezTo>
                  <a:cubicBezTo>
                    <a:pt x="389273" y="302183"/>
                    <a:pt x="160726" y="386949"/>
                    <a:pt x="43826" y="446480"/>
                  </a:cubicBezTo>
                  <a:lnTo>
                    <a:pt x="33337" y="444051"/>
                  </a:lnTo>
                  <a:cubicBezTo>
                    <a:pt x="76199" y="281746"/>
                    <a:pt x="90491" y="219455"/>
                    <a:pt x="0" y="0"/>
                  </a:cubicBezTo>
                  <a:close/>
                </a:path>
              </a:pathLst>
            </a:custGeom>
            <a:solidFill>
              <a:srgbClr val="D0DCF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nvGrpSpPr>
            <p:cNvPr id="33" name="Group 32"/>
            <p:cNvGrpSpPr/>
            <p:nvPr/>
          </p:nvGrpSpPr>
          <p:grpSpPr>
            <a:xfrm>
              <a:off x="1232121" y="304800"/>
              <a:ext cx="2045759" cy="1744128"/>
              <a:chOff x="3014133" y="990600"/>
              <a:chExt cx="2045759" cy="1744128"/>
            </a:xfrm>
            <a:solidFill>
              <a:schemeClr val="bg2">
                <a:lumMod val="75000"/>
              </a:schemeClr>
            </a:solidFill>
          </p:grpSpPr>
          <p:sp>
            <p:nvSpPr>
              <p:cNvPr id="34" name="Rectangle 33"/>
              <p:cNvSpPr/>
              <p:nvPr/>
            </p:nvSpPr>
            <p:spPr>
              <a:xfrm>
                <a:off x="3014133" y="990600"/>
                <a:ext cx="2040467" cy="129540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5" name="Trapezoid 34"/>
              <p:cNvSpPr/>
              <p:nvPr/>
            </p:nvSpPr>
            <p:spPr>
              <a:xfrm flipV="1">
                <a:off x="3014134" y="2285995"/>
                <a:ext cx="2045758" cy="448733"/>
              </a:xfrm>
              <a:prstGeom prst="trapezoid">
                <a:avLst>
                  <a:gd name="adj" fmla="val 117453"/>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36" name="Cloud 35"/>
            <p:cNvSpPr/>
            <p:nvPr/>
          </p:nvSpPr>
          <p:spPr>
            <a:xfrm>
              <a:off x="2170126" y="2216857"/>
              <a:ext cx="169748" cy="143606"/>
            </a:xfrm>
            <a:prstGeom prst="cloud">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nvGrpSpPr>
            <p:cNvPr id="37" name="Group 36"/>
            <p:cNvGrpSpPr/>
            <p:nvPr/>
          </p:nvGrpSpPr>
          <p:grpSpPr>
            <a:xfrm>
              <a:off x="1626350" y="2244209"/>
              <a:ext cx="1257301" cy="48141"/>
              <a:chOff x="3220715" y="1939925"/>
              <a:chExt cx="1554485" cy="117475"/>
            </a:xfrm>
          </p:grpSpPr>
          <p:sp>
            <p:nvSpPr>
              <p:cNvPr id="38" name="Isosceles Triangle 37"/>
              <p:cNvSpPr/>
              <p:nvPr/>
            </p:nvSpPr>
            <p:spPr>
              <a:xfrm rot="16200000">
                <a:off x="426720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39" name="Isosceles Triangle 38"/>
              <p:cNvSpPr/>
              <p:nvPr/>
            </p:nvSpPr>
            <p:spPr>
              <a:xfrm rot="5400000" flipH="1">
                <a:off x="361124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60" name="Rectangle 59"/>
            <p:cNvSpPr/>
            <p:nvPr/>
          </p:nvSpPr>
          <p:spPr>
            <a:xfrm>
              <a:off x="1687728" y="2248970"/>
              <a:ext cx="36000" cy="468000"/>
            </a:xfrm>
            <a:prstGeom prst="rect">
              <a:avLst/>
            </a:prstGeom>
            <a:gradFill>
              <a:gsLst>
                <a:gs pos="0">
                  <a:srgbClr val="4472C4"/>
                </a:gs>
                <a:gs pos="100000">
                  <a:schemeClr val="bg1"/>
                </a:gs>
                <a:gs pos="84000">
                  <a:schemeClr val="accent1">
                    <a:tint val="44500"/>
                    <a:satMod val="160000"/>
                  </a:schemeClr>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62" name="Rectangle 61"/>
            <p:cNvSpPr/>
            <p:nvPr/>
          </p:nvSpPr>
          <p:spPr>
            <a:xfrm>
              <a:off x="2784887" y="2248970"/>
              <a:ext cx="36000" cy="468000"/>
            </a:xfrm>
            <a:prstGeom prst="rect">
              <a:avLst/>
            </a:prstGeom>
            <a:gradFill>
              <a:gsLst>
                <a:gs pos="0">
                  <a:srgbClr val="4472C4"/>
                </a:gs>
                <a:gs pos="100000">
                  <a:schemeClr val="bg1"/>
                </a:gs>
                <a:gs pos="84000">
                  <a:schemeClr val="accent1">
                    <a:tint val="44500"/>
                    <a:satMod val="160000"/>
                  </a:schemeClr>
                </a:gs>
              </a:gsLst>
              <a:lin ang="5400000" scaled="0"/>
            </a:gra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40" name="Group 39"/>
            <p:cNvGrpSpPr/>
            <p:nvPr/>
          </p:nvGrpSpPr>
          <p:grpSpPr>
            <a:xfrm>
              <a:off x="1119938" y="1048457"/>
              <a:ext cx="2270125" cy="1316918"/>
              <a:chOff x="2898775" y="1734257"/>
              <a:chExt cx="2270125" cy="1316918"/>
            </a:xfrm>
          </p:grpSpPr>
          <p:grpSp>
            <p:nvGrpSpPr>
              <p:cNvPr id="41" name="Group 40"/>
              <p:cNvGrpSpPr/>
              <p:nvPr/>
            </p:nvGrpSpPr>
            <p:grpSpPr>
              <a:xfrm>
                <a:off x="2898775" y="1734257"/>
                <a:ext cx="666750" cy="1316918"/>
                <a:chOff x="2898775" y="1734257"/>
                <a:chExt cx="666750" cy="1316918"/>
              </a:xfrm>
              <a:solidFill>
                <a:schemeClr val="tx1">
                  <a:lumMod val="65000"/>
                  <a:lumOff val="35000"/>
                </a:schemeClr>
              </a:solidFill>
            </p:grpSpPr>
            <p:sp>
              <p:nvSpPr>
                <p:cNvPr id="47" name="Rectangle 46"/>
                <p:cNvSpPr/>
                <p:nvPr/>
              </p:nvSpPr>
              <p:spPr>
                <a:xfrm>
                  <a:off x="2898775" y="1734257"/>
                  <a:ext cx="115358" cy="113665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8" name="Trapezoid 47"/>
                <p:cNvSpPr/>
                <p:nvPr/>
              </p:nvSpPr>
              <p:spPr>
                <a:xfrm flipV="1">
                  <a:off x="2898775" y="2870907"/>
                  <a:ext cx="666750" cy="180268"/>
                </a:xfrm>
                <a:prstGeom prst="trapezoid">
                  <a:avLst>
                    <a:gd name="adj" fmla="val 94556"/>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9" name="Trapezoid 48"/>
                <p:cNvSpPr/>
                <p:nvPr/>
              </p:nvSpPr>
              <p:spPr>
                <a:xfrm>
                  <a:off x="2898775" y="2774950"/>
                  <a:ext cx="666750" cy="95957"/>
                </a:xfrm>
                <a:prstGeom prst="trapezoid">
                  <a:avLst>
                    <a:gd name="adj" fmla="val 94556"/>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42" name="Group 41"/>
              <p:cNvGrpSpPr/>
              <p:nvPr/>
            </p:nvGrpSpPr>
            <p:grpSpPr>
              <a:xfrm flipH="1">
                <a:off x="4502150" y="1734257"/>
                <a:ext cx="666750" cy="1316918"/>
                <a:chOff x="2898775" y="1734257"/>
                <a:chExt cx="666750" cy="1316918"/>
              </a:xfrm>
              <a:solidFill>
                <a:schemeClr val="tx1">
                  <a:lumMod val="65000"/>
                  <a:lumOff val="35000"/>
                </a:schemeClr>
              </a:solidFill>
            </p:grpSpPr>
            <p:sp>
              <p:nvSpPr>
                <p:cNvPr id="44" name="Rectangle 43"/>
                <p:cNvSpPr/>
                <p:nvPr/>
              </p:nvSpPr>
              <p:spPr>
                <a:xfrm>
                  <a:off x="2898775" y="1734257"/>
                  <a:ext cx="115358" cy="1136650"/>
                </a:xfrm>
                <a:prstGeom prst="rect">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5" name="Trapezoid 44"/>
                <p:cNvSpPr/>
                <p:nvPr/>
              </p:nvSpPr>
              <p:spPr>
                <a:xfrm flipV="1">
                  <a:off x="2898775" y="2870907"/>
                  <a:ext cx="666750" cy="180268"/>
                </a:xfrm>
                <a:prstGeom prst="trapezoid">
                  <a:avLst>
                    <a:gd name="adj" fmla="val 94556"/>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Trapezoid 45"/>
                <p:cNvSpPr/>
                <p:nvPr/>
              </p:nvSpPr>
              <p:spPr>
                <a:xfrm>
                  <a:off x="2898775" y="2774950"/>
                  <a:ext cx="666750" cy="95957"/>
                </a:xfrm>
                <a:prstGeom prst="trapezoid">
                  <a:avLst>
                    <a:gd name="adj" fmla="val 94556"/>
                  </a:avLst>
                </a:prstGeom>
                <a:grp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43" name="Rectangle 42"/>
              <p:cNvSpPr/>
              <p:nvPr/>
            </p:nvSpPr>
            <p:spPr>
              <a:xfrm flipV="1">
                <a:off x="3014134" y="1734257"/>
                <a:ext cx="2045758" cy="551738"/>
              </a:xfrm>
              <a:prstGeom prst="rect">
                <a:avLst/>
              </a:prstGeom>
              <a:solidFill>
                <a:schemeClr val="tx1">
                  <a:lumMod val="65000"/>
                  <a:lumOff val="3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nvGrpSpPr>
            <p:cNvPr id="57" name="Group 56"/>
            <p:cNvGrpSpPr/>
            <p:nvPr/>
          </p:nvGrpSpPr>
          <p:grpSpPr>
            <a:xfrm>
              <a:off x="817608" y="1852962"/>
              <a:ext cx="2873096" cy="635000"/>
              <a:chOff x="2678171" y="5148610"/>
              <a:chExt cx="2873096" cy="635000"/>
            </a:xfrm>
          </p:grpSpPr>
          <p:sp>
            <p:nvSpPr>
              <p:cNvPr id="50" name="Rectangle 49"/>
              <p:cNvSpPr/>
              <p:nvPr/>
            </p:nvSpPr>
            <p:spPr>
              <a:xfrm>
                <a:off x="2678171" y="5148610"/>
                <a:ext cx="52286" cy="635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1" name="Rectangle 50"/>
              <p:cNvSpPr/>
              <p:nvPr/>
            </p:nvSpPr>
            <p:spPr>
              <a:xfrm>
                <a:off x="5498981" y="5148610"/>
                <a:ext cx="52286" cy="635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52" name="Rectangle 51"/>
              <p:cNvSpPr/>
              <p:nvPr/>
            </p:nvSpPr>
            <p:spPr>
              <a:xfrm>
                <a:off x="2678171" y="5729610"/>
                <a:ext cx="2846954" cy="54000"/>
              </a:xfrm>
              <a:prstGeom prst="rect">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65" name="Rectangle 64"/>
          <p:cNvSpPr/>
          <p:nvPr/>
        </p:nvSpPr>
        <p:spPr>
          <a:xfrm>
            <a:off x="3847492" y="475548"/>
            <a:ext cx="1627412" cy="1603234"/>
          </a:xfrm>
          <a:prstGeom prst="rect">
            <a:avLst/>
          </a:prstGeom>
          <a:no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cxnSp>
        <p:nvCxnSpPr>
          <p:cNvPr id="66" name="Straight Connector 65"/>
          <p:cNvCxnSpPr/>
          <p:nvPr/>
        </p:nvCxnSpPr>
        <p:spPr>
          <a:xfrm flipH="1">
            <a:off x="4473650" y="1790589"/>
            <a:ext cx="21747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67" name="TextBox 66"/>
          <p:cNvSpPr txBox="1"/>
          <p:nvPr/>
        </p:nvSpPr>
        <p:spPr>
          <a:xfrm>
            <a:off x="4101710" y="1695491"/>
            <a:ext cx="636742" cy="346249"/>
          </a:xfrm>
          <a:prstGeom prst="rect">
            <a:avLst/>
          </a:prstGeom>
          <a:noFill/>
        </p:spPr>
        <p:txBody>
          <a:bodyPr wrap="square" rtlCol="0">
            <a:spAutoFit/>
          </a:bodyPr>
          <a:lstStyle/>
          <a:p>
            <a:r>
              <a:rPr lang="en-GB" sz="825" dirty="0"/>
              <a:t>1.5% Agarose</a:t>
            </a:r>
          </a:p>
        </p:txBody>
      </p:sp>
      <p:sp>
        <p:nvSpPr>
          <p:cNvPr id="68" name="Isosceles Triangle 67"/>
          <p:cNvSpPr/>
          <p:nvPr/>
        </p:nvSpPr>
        <p:spPr>
          <a:xfrm rot="12808862">
            <a:off x="2254454" y="1079921"/>
            <a:ext cx="100023" cy="394487"/>
          </a:xfrm>
          <a:prstGeom prst="triangle">
            <a:avLst/>
          </a:prstGeom>
          <a:solidFill>
            <a:schemeClr val="accent1">
              <a:lumMod val="40000"/>
              <a:lumOff val="6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69" name="Can 68"/>
          <p:cNvSpPr/>
          <p:nvPr/>
        </p:nvSpPr>
        <p:spPr>
          <a:xfrm rot="1962248">
            <a:off x="2501893" y="553307"/>
            <a:ext cx="133519" cy="643316"/>
          </a:xfrm>
          <a:prstGeom prst="can">
            <a:avLst/>
          </a:prstGeom>
          <a:solidFill>
            <a:schemeClr val="accent4">
              <a:lumMod val="75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70" name="Can 69"/>
          <p:cNvSpPr/>
          <p:nvPr/>
        </p:nvSpPr>
        <p:spPr>
          <a:xfrm rot="1962248">
            <a:off x="2562030" y="400353"/>
            <a:ext cx="258194" cy="643316"/>
          </a:xfrm>
          <a:prstGeom prst="can">
            <a:avLst/>
          </a:prstGeom>
          <a:solidFill>
            <a:schemeClr val="accent4">
              <a:lumMod val="50000"/>
            </a:schemeClr>
          </a:solidFill>
          <a:ln>
            <a:solidFill>
              <a:schemeClr val="accent3">
                <a:lumMod val="50000"/>
              </a:schemeClr>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71" name="TextBox 70"/>
          <p:cNvSpPr txBox="1"/>
          <p:nvPr/>
        </p:nvSpPr>
        <p:spPr>
          <a:xfrm>
            <a:off x="2408703" y="60601"/>
            <a:ext cx="1460656" cy="300082"/>
          </a:xfrm>
          <a:prstGeom prst="rect">
            <a:avLst/>
          </a:prstGeom>
          <a:noFill/>
        </p:spPr>
        <p:txBody>
          <a:bodyPr wrap="none" rtlCol="0">
            <a:spAutoFit/>
          </a:bodyPr>
          <a:lstStyle/>
          <a:p>
            <a:r>
              <a:rPr lang="en-GB" sz="1350" dirty="0"/>
              <a:t>Seed HEK293 cells</a:t>
            </a:r>
          </a:p>
        </p:txBody>
      </p:sp>
      <p:sp>
        <p:nvSpPr>
          <p:cNvPr id="72" name="Flowchart: Delay 71"/>
          <p:cNvSpPr/>
          <p:nvPr/>
        </p:nvSpPr>
        <p:spPr>
          <a:xfrm rot="5400000">
            <a:off x="4323878" y="1159211"/>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75" name="Flowchart: Delay 23"/>
          <p:cNvSpPr/>
          <p:nvPr/>
        </p:nvSpPr>
        <p:spPr>
          <a:xfrm rot="5400000">
            <a:off x="4679368" y="1533056"/>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76" name="Cloud 75"/>
          <p:cNvSpPr/>
          <p:nvPr/>
        </p:nvSpPr>
        <p:spPr>
          <a:xfrm>
            <a:off x="4722031" y="1405244"/>
            <a:ext cx="269024" cy="227593"/>
          </a:xfrm>
          <a:prstGeom prst="cloud">
            <a:avLst/>
          </a:prstGeom>
          <a:solidFill>
            <a:schemeClr val="tx1"/>
          </a:solidFill>
          <a:ln>
            <a:solidFill>
              <a:schemeClr val="bg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cxnSp>
        <p:nvCxnSpPr>
          <p:cNvPr id="77" name="Straight Connector 76"/>
          <p:cNvCxnSpPr/>
          <p:nvPr/>
        </p:nvCxnSpPr>
        <p:spPr>
          <a:xfrm flipH="1">
            <a:off x="4558617" y="1519041"/>
            <a:ext cx="217473" cy="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78" name="TextBox 77"/>
          <p:cNvSpPr txBox="1"/>
          <p:nvPr/>
        </p:nvSpPr>
        <p:spPr>
          <a:xfrm>
            <a:off x="4029838" y="1403351"/>
            <a:ext cx="636742" cy="219291"/>
          </a:xfrm>
          <a:prstGeom prst="rect">
            <a:avLst/>
          </a:prstGeom>
          <a:noFill/>
        </p:spPr>
        <p:txBody>
          <a:bodyPr wrap="square" rtlCol="0">
            <a:spAutoFit/>
          </a:bodyPr>
          <a:lstStyle/>
          <a:p>
            <a:r>
              <a:rPr lang="en-GB" sz="825" dirty="0"/>
              <a:t>Spheroid</a:t>
            </a:r>
          </a:p>
        </p:txBody>
      </p:sp>
      <p:cxnSp>
        <p:nvCxnSpPr>
          <p:cNvPr id="79" name="Straight Connector 78"/>
          <p:cNvCxnSpPr>
            <a:endCxn id="64" idx="0"/>
          </p:cNvCxnSpPr>
          <p:nvPr/>
        </p:nvCxnSpPr>
        <p:spPr>
          <a:xfrm flipH="1">
            <a:off x="3091581" y="475548"/>
            <a:ext cx="755911" cy="899227"/>
          </a:xfrm>
          <a:prstGeom prst="line">
            <a:avLst/>
          </a:prstGeom>
          <a:no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cxnSp>
      <p:cxnSp>
        <p:nvCxnSpPr>
          <p:cNvPr id="80" name="Straight Connector 79"/>
          <p:cNvCxnSpPr>
            <a:endCxn id="64" idx="2"/>
          </p:cNvCxnSpPr>
          <p:nvPr/>
        </p:nvCxnSpPr>
        <p:spPr>
          <a:xfrm flipH="1" flipV="1">
            <a:off x="3091581" y="1708095"/>
            <a:ext cx="755911" cy="370689"/>
          </a:xfrm>
          <a:prstGeom prst="line">
            <a:avLst/>
          </a:prstGeom>
          <a:no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cxnSp>
      <p:sp>
        <p:nvSpPr>
          <p:cNvPr id="81" name="TextBox 80"/>
          <p:cNvSpPr txBox="1"/>
          <p:nvPr/>
        </p:nvSpPr>
        <p:spPr>
          <a:xfrm>
            <a:off x="4130509" y="568228"/>
            <a:ext cx="1131785" cy="300082"/>
          </a:xfrm>
          <a:prstGeom prst="rect">
            <a:avLst/>
          </a:prstGeom>
          <a:noFill/>
        </p:spPr>
        <p:txBody>
          <a:bodyPr wrap="none" rtlCol="0">
            <a:spAutoFit/>
          </a:bodyPr>
          <a:lstStyle/>
          <a:p>
            <a:r>
              <a:rPr lang="en-GB" sz="1350" dirty="0"/>
              <a:t>3-4 days later</a:t>
            </a:r>
          </a:p>
        </p:txBody>
      </p:sp>
      <p:grpSp>
        <p:nvGrpSpPr>
          <p:cNvPr id="168" name="Group 167"/>
          <p:cNvGrpSpPr/>
          <p:nvPr/>
        </p:nvGrpSpPr>
        <p:grpSpPr>
          <a:xfrm>
            <a:off x="565718" y="2113494"/>
            <a:ext cx="5974851" cy="1850284"/>
            <a:chOff x="107504" y="4120839"/>
            <a:chExt cx="8952211" cy="2772309"/>
          </a:xfrm>
        </p:grpSpPr>
        <p:grpSp>
          <p:nvGrpSpPr>
            <p:cNvPr id="82" name="Gruppo 27"/>
            <p:cNvGrpSpPr/>
            <p:nvPr/>
          </p:nvGrpSpPr>
          <p:grpSpPr>
            <a:xfrm>
              <a:off x="2940848" y="4294116"/>
              <a:ext cx="3141507" cy="2487646"/>
              <a:chOff x="925286" y="27354906"/>
              <a:chExt cx="4648094" cy="3680658"/>
            </a:xfrm>
          </p:grpSpPr>
          <p:pic>
            <p:nvPicPr>
              <p:cNvPr id="83" name="Immagine 28"/>
              <p:cNvPicPr>
                <a:picLocks noChangeAspect="1"/>
              </p:cNvPicPr>
              <p:nvPr/>
            </p:nvPicPr>
            <p:blipFill rotWithShape="1">
              <a:blip r:embed="rId2" cstate="print">
                <a:extLst>
                  <a:ext uri="{28A0092B-C50C-407E-A947-70E740481C1C}">
                    <a14:useLocalDpi xmlns:a14="http://schemas.microsoft.com/office/drawing/2010/main" val="0"/>
                  </a:ext>
                </a:extLst>
              </a:blip>
              <a:srcRect l="22097" t="15937" r="22530" b="6112"/>
              <a:stretch/>
            </p:blipFill>
            <p:spPr>
              <a:xfrm>
                <a:off x="925286" y="27354906"/>
                <a:ext cx="4648094" cy="3680658"/>
              </a:xfrm>
              <a:prstGeom prst="rect">
                <a:avLst/>
              </a:prstGeom>
            </p:spPr>
          </p:pic>
          <p:sp>
            <p:nvSpPr>
              <p:cNvPr id="84" name="Ovale 31"/>
              <p:cNvSpPr/>
              <p:nvPr/>
            </p:nvSpPr>
            <p:spPr bwMode="auto">
              <a:xfrm>
                <a:off x="3127178" y="28822581"/>
                <a:ext cx="321704" cy="311219"/>
              </a:xfrm>
              <a:prstGeom prst="ellipse">
                <a:avLst/>
              </a:prstGeom>
              <a:noFill/>
              <a:ln w="12700">
                <a:solidFill>
                  <a:schemeClr val="bg1"/>
                </a:solidFill>
                <a:round/>
                <a:headEnd/>
                <a:tailEnd/>
              </a:ln>
              <a:extLst/>
            </p:spPr>
            <p:txBody>
              <a:bodyPr wrap="none" lIns="71716" tIns="35858" rIns="71716" bIns="35858" rtlCol="0" anchor="ctr"/>
              <a:lstStyle/>
              <a:p>
                <a:pPr algn="ctr" defTabSz="717550"/>
                <a:endParaRPr lang="it-IT" b="0"/>
              </a:p>
            </p:txBody>
          </p:sp>
        </p:grpSp>
        <p:pic>
          <p:nvPicPr>
            <p:cNvPr id="85" name="Immagine 5"/>
            <p:cNvPicPr>
              <a:picLocks noChangeAspect="1"/>
            </p:cNvPicPr>
            <p:nvPr/>
          </p:nvPicPr>
          <p:blipFill rotWithShape="1">
            <a:blip r:embed="rId3"/>
            <a:srcRect l="5117" r="5235"/>
            <a:stretch/>
          </p:blipFill>
          <p:spPr>
            <a:xfrm>
              <a:off x="6251403" y="4294116"/>
              <a:ext cx="2808312" cy="2487646"/>
            </a:xfrm>
            <a:prstGeom prst="rect">
              <a:avLst/>
            </a:prstGeom>
          </p:spPr>
        </p:pic>
        <p:pic>
          <p:nvPicPr>
            <p:cNvPr id="86" name="Immagine 33"/>
            <p:cNvPicPr>
              <a:picLocks noChangeAspect="1"/>
            </p:cNvPicPr>
            <p:nvPr/>
          </p:nvPicPr>
          <p:blipFill rotWithShape="1">
            <a:blip r:embed="rId4" cstate="print">
              <a:extLst>
                <a:ext uri="{28A0092B-C50C-407E-A947-70E740481C1C}">
                  <a14:useLocalDpi xmlns:a14="http://schemas.microsoft.com/office/drawing/2010/main" val="0"/>
                </a:ext>
              </a:extLst>
            </a:blip>
            <a:srcRect l="16221" t="-7209" r="23761" b="-3818"/>
            <a:stretch/>
          </p:blipFill>
          <p:spPr>
            <a:xfrm>
              <a:off x="107504" y="4120839"/>
              <a:ext cx="2664296" cy="2772309"/>
            </a:xfrm>
            <a:prstGeom prst="rect">
              <a:avLst/>
            </a:prstGeom>
          </p:spPr>
        </p:pic>
      </p:grpSp>
      <p:grpSp>
        <p:nvGrpSpPr>
          <p:cNvPr id="165" name="Group 164"/>
          <p:cNvGrpSpPr/>
          <p:nvPr/>
        </p:nvGrpSpPr>
        <p:grpSpPr>
          <a:xfrm>
            <a:off x="5435443" y="6961846"/>
            <a:ext cx="3142661" cy="700273"/>
            <a:chOff x="661475" y="3192924"/>
            <a:chExt cx="4884868" cy="1088485"/>
          </a:xfrm>
        </p:grpSpPr>
        <p:grpSp>
          <p:nvGrpSpPr>
            <p:cNvPr id="132" name="Group 131"/>
            <p:cNvGrpSpPr/>
            <p:nvPr/>
          </p:nvGrpSpPr>
          <p:grpSpPr>
            <a:xfrm>
              <a:off x="1078966" y="3514066"/>
              <a:ext cx="3880631" cy="592804"/>
              <a:chOff x="1078966" y="3192924"/>
              <a:chExt cx="3880631" cy="592804"/>
            </a:xfrm>
          </p:grpSpPr>
          <p:sp>
            <p:nvSpPr>
              <p:cNvPr id="133" name="Parallelogram 132"/>
              <p:cNvSpPr/>
              <p:nvPr/>
            </p:nvSpPr>
            <p:spPr>
              <a:xfrm rot="120000">
                <a:off x="1083810" y="3208018"/>
                <a:ext cx="2303868" cy="502548"/>
              </a:xfrm>
              <a:prstGeom prst="parallelogram">
                <a:avLst>
                  <a:gd name="adj" fmla="val 151505"/>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4" name="Parallelogram 133"/>
              <p:cNvSpPr/>
              <p:nvPr/>
            </p:nvSpPr>
            <p:spPr>
              <a:xfrm rot="-120000">
                <a:off x="2610198" y="3233787"/>
                <a:ext cx="2349399" cy="445675"/>
              </a:xfrm>
              <a:prstGeom prst="parallelogram">
                <a:avLst>
                  <a:gd name="adj" fmla="val 177699"/>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35" name="Group 134"/>
              <p:cNvGrpSpPr/>
              <p:nvPr/>
            </p:nvGrpSpPr>
            <p:grpSpPr>
              <a:xfrm>
                <a:off x="1849444" y="3194328"/>
                <a:ext cx="3081238" cy="117978"/>
                <a:chOff x="3220715" y="1939925"/>
                <a:chExt cx="1554485" cy="117475"/>
              </a:xfrm>
              <a:solidFill>
                <a:srgbClr val="9CB6E0"/>
              </a:solidFill>
            </p:grpSpPr>
            <p:sp>
              <p:nvSpPr>
                <p:cNvPr id="141" name="Isosceles Triangle 140"/>
                <p:cNvSpPr/>
                <p:nvPr/>
              </p:nvSpPr>
              <p:spPr>
                <a:xfrm rot="16200000">
                  <a:off x="426720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2" name="Isosceles Triangle 141"/>
                <p:cNvSpPr/>
                <p:nvPr/>
              </p:nvSpPr>
              <p:spPr>
                <a:xfrm rot="5400000" flipH="1">
                  <a:off x="361124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36" name="Parallelogram 135"/>
              <p:cNvSpPr/>
              <p:nvPr/>
            </p:nvSpPr>
            <p:spPr>
              <a:xfrm rot="5400000" flipV="1">
                <a:off x="4260505" y="3092624"/>
                <a:ext cx="591399" cy="792000"/>
              </a:xfrm>
              <a:prstGeom prst="parallelogram">
                <a:avLst>
                  <a:gd name="adj" fmla="val 80181"/>
                </a:avLst>
              </a:prstGeom>
              <a:solidFill>
                <a:srgbClr val="6A9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7" name="Parallelogram 136"/>
              <p:cNvSpPr/>
              <p:nvPr/>
            </p:nvSpPr>
            <p:spPr>
              <a:xfrm rot="5400000" flipV="1">
                <a:off x="1168507" y="3104789"/>
                <a:ext cx="591399" cy="770479"/>
              </a:xfrm>
              <a:prstGeom prst="parallelogram">
                <a:avLst>
                  <a:gd name="adj" fmla="val 80181"/>
                </a:avLst>
              </a:prstGeom>
              <a:solidFill>
                <a:srgbClr val="9CB6E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38" name="Group 137"/>
              <p:cNvGrpSpPr/>
              <p:nvPr/>
            </p:nvGrpSpPr>
            <p:grpSpPr>
              <a:xfrm>
                <a:off x="1078966" y="3666345"/>
                <a:ext cx="3081238" cy="117978"/>
                <a:chOff x="3220715" y="1939925"/>
                <a:chExt cx="1554485" cy="117475"/>
              </a:xfrm>
            </p:grpSpPr>
            <p:sp>
              <p:nvSpPr>
                <p:cNvPr id="139" name="Isosceles Triangle 138"/>
                <p:cNvSpPr/>
                <p:nvPr/>
              </p:nvSpPr>
              <p:spPr>
                <a:xfrm rot="16200000">
                  <a:off x="426720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40" name="Isosceles Triangle 139"/>
                <p:cNvSpPr/>
                <p:nvPr/>
              </p:nvSpPr>
              <p:spPr>
                <a:xfrm rot="5400000" flipH="1">
                  <a:off x="361124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145" name="Rectangle 144"/>
            <p:cNvSpPr/>
            <p:nvPr/>
          </p:nvSpPr>
          <p:spPr>
            <a:xfrm>
              <a:off x="928047" y="3472877"/>
              <a:ext cx="4618296" cy="808532"/>
            </a:xfrm>
            <a:prstGeom prst="rect">
              <a:avLst/>
            </a:prstGeom>
            <a:solidFill>
              <a:schemeClr val="bg1">
                <a:alpha val="7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21" name="Group 120"/>
            <p:cNvGrpSpPr/>
            <p:nvPr/>
          </p:nvGrpSpPr>
          <p:grpSpPr>
            <a:xfrm>
              <a:off x="1078966" y="3353495"/>
              <a:ext cx="3880631" cy="592804"/>
              <a:chOff x="1078966" y="3192924"/>
              <a:chExt cx="3880631" cy="592804"/>
            </a:xfrm>
          </p:grpSpPr>
          <p:sp>
            <p:nvSpPr>
              <p:cNvPr id="122" name="Parallelogram 121"/>
              <p:cNvSpPr/>
              <p:nvPr/>
            </p:nvSpPr>
            <p:spPr>
              <a:xfrm rot="120000">
                <a:off x="1083810" y="3208018"/>
                <a:ext cx="2303868" cy="502548"/>
              </a:xfrm>
              <a:prstGeom prst="parallelogram">
                <a:avLst>
                  <a:gd name="adj" fmla="val 151505"/>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3" name="Parallelogram 122"/>
              <p:cNvSpPr/>
              <p:nvPr/>
            </p:nvSpPr>
            <p:spPr>
              <a:xfrm rot="-120000">
                <a:off x="2610198" y="3233787"/>
                <a:ext cx="2349399" cy="445675"/>
              </a:xfrm>
              <a:prstGeom prst="parallelogram">
                <a:avLst>
                  <a:gd name="adj" fmla="val 177699"/>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24" name="Group 123"/>
              <p:cNvGrpSpPr/>
              <p:nvPr/>
            </p:nvGrpSpPr>
            <p:grpSpPr>
              <a:xfrm>
                <a:off x="1849444" y="3194328"/>
                <a:ext cx="3081238" cy="117978"/>
                <a:chOff x="3220715" y="1939925"/>
                <a:chExt cx="1554485" cy="117475"/>
              </a:xfrm>
              <a:solidFill>
                <a:srgbClr val="9CB6E0"/>
              </a:solidFill>
            </p:grpSpPr>
            <p:sp>
              <p:nvSpPr>
                <p:cNvPr id="130" name="Isosceles Triangle 129"/>
                <p:cNvSpPr/>
                <p:nvPr/>
              </p:nvSpPr>
              <p:spPr>
                <a:xfrm rot="16200000">
                  <a:off x="426720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31" name="Isosceles Triangle 130"/>
                <p:cNvSpPr/>
                <p:nvPr/>
              </p:nvSpPr>
              <p:spPr>
                <a:xfrm rot="5400000" flipH="1">
                  <a:off x="361124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25" name="Parallelogram 124"/>
              <p:cNvSpPr/>
              <p:nvPr/>
            </p:nvSpPr>
            <p:spPr>
              <a:xfrm rot="5400000" flipV="1">
                <a:off x="4260505" y="3092624"/>
                <a:ext cx="591399" cy="792000"/>
              </a:xfrm>
              <a:prstGeom prst="parallelogram">
                <a:avLst>
                  <a:gd name="adj" fmla="val 80181"/>
                </a:avLst>
              </a:prstGeom>
              <a:solidFill>
                <a:srgbClr val="6A9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6" name="Parallelogram 125"/>
              <p:cNvSpPr/>
              <p:nvPr/>
            </p:nvSpPr>
            <p:spPr>
              <a:xfrm rot="5400000" flipV="1">
                <a:off x="1168507" y="3104789"/>
                <a:ext cx="591399" cy="770479"/>
              </a:xfrm>
              <a:prstGeom prst="parallelogram">
                <a:avLst>
                  <a:gd name="adj" fmla="val 80181"/>
                </a:avLst>
              </a:prstGeom>
              <a:solidFill>
                <a:srgbClr val="9CB6E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27" name="Group 126"/>
              <p:cNvGrpSpPr/>
              <p:nvPr/>
            </p:nvGrpSpPr>
            <p:grpSpPr>
              <a:xfrm>
                <a:off x="1078966" y="3666345"/>
                <a:ext cx="3081238" cy="117978"/>
                <a:chOff x="3220715" y="1939925"/>
                <a:chExt cx="1554485" cy="117475"/>
              </a:xfrm>
            </p:grpSpPr>
            <p:sp>
              <p:nvSpPr>
                <p:cNvPr id="128" name="Isosceles Triangle 127"/>
                <p:cNvSpPr/>
                <p:nvPr/>
              </p:nvSpPr>
              <p:spPr>
                <a:xfrm rot="16200000">
                  <a:off x="426720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29" name="Isosceles Triangle 128"/>
                <p:cNvSpPr/>
                <p:nvPr/>
              </p:nvSpPr>
              <p:spPr>
                <a:xfrm rot="5400000" flipH="1">
                  <a:off x="361124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144" name="Rectangle 143"/>
            <p:cNvSpPr/>
            <p:nvPr/>
          </p:nvSpPr>
          <p:spPr>
            <a:xfrm>
              <a:off x="661475" y="3354900"/>
              <a:ext cx="4618296" cy="808532"/>
            </a:xfrm>
            <a:prstGeom prst="rect">
              <a:avLst/>
            </a:prstGeom>
            <a:solidFill>
              <a:schemeClr val="bg1">
                <a:alpha val="58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120" name="Group 119"/>
            <p:cNvGrpSpPr/>
            <p:nvPr/>
          </p:nvGrpSpPr>
          <p:grpSpPr>
            <a:xfrm>
              <a:off x="1078966" y="3192924"/>
              <a:ext cx="3880631" cy="592804"/>
              <a:chOff x="1078966" y="3192924"/>
              <a:chExt cx="3880631" cy="592804"/>
            </a:xfrm>
          </p:grpSpPr>
          <p:sp>
            <p:nvSpPr>
              <p:cNvPr id="116" name="Parallelogram 115"/>
              <p:cNvSpPr/>
              <p:nvPr/>
            </p:nvSpPr>
            <p:spPr>
              <a:xfrm rot="120000">
                <a:off x="1083810" y="3208018"/>
                <a:ext cx="2303868" cy="502548"/>
              </a:xfrm>
              <a:prstGeom prst="parallelogram">
                <a:avLst>
                  <a:gd name="adj" fmla="val 151505"/>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7" name="Parallelogram 116"/>
              <p:cNvSpPr/>
              <p:nvPr/>
            </p:nvSpPr>
            <p:spPr>
              <a:xfrm rot="-120000">
                <a:off x="2610198" y="3233787"/>
                <a:ext cx="2349399" cy="445675"/>
              </a:xfrm>
              <a:prstGeom prst="parallelogram">
                <a:avLst>
                  <a:gd name="adj" fmla="val 177699"/>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96" name="Group 95"/>
              <p:cNvGrpSpPr/>
              <p:nvPr/>
            </p:nvGrpSpPr>
            <p:grpSpPr>
              <a:xfrm>
                <a:off x="1849444" y="3194328"/>
                <a:ext cx="3081238" cy="117978"/>
                <a:chOff x="3220715" y="1939925"/>
                <a:chExt cx="1554485" cy="117475"/>
              </a:xfrm>
              <a:solidFill>
                <a:srgbClr val="9CB6E0"/>
              </a:solidFill>
            </p:grpSpPr>
            <p:sp>
              <p:nvSpPr>
                <p:cNvPr id="97" name="Isosceles Triangle 96"/>
                <p:cNvSpPr/>
                <p:nvPr/>
              </p:nvSpPr>
              <p:spPr>
                <a:xfrm rot="16200000">
                  <a:off x="426720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8" name="Isosceles Triangle 97"/>
                <p:cNvSpPr/>
                <p:nvPr/>
              </p:nvSpPr>
              <p:spPr>
                <a:xfrm rot="5400000" flipH="1">
                  <a:off x="361124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118" name="Parallelogram 117"/>
              <p:cNvSpPr/>
              <p:nvPr/>
            </p:nvSpPr>
            <p:spPr>
              <a:xfrm rot="5400000" flipV="1">
                <a:off x="4260505" y="3092624"/>
                <a:ext cx="591399" cy="792000"/>
              </a:xfrm>
              <a:prstGeom prst="parallelogram">
                <a:avLst>
                  <a:gd name="adj" fmla="val 80181"/>
                </a:avLst>
              </a:prstGeom>
              <a:solidFill>
                <a:srgbClr val="6A9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119" name="Parallelogram 118"/>
              <p:cNvSpPr/>
              <p:nvPr/>
            </p:nvSpPr>
            <p:spPr>
              <a:xfrm rot="5400000" flipV="1">
                <a:off x="1168507" y="3104789"/>
                <a:ext cx="591399" cy="770479"/>
              </a:xfrm>
              <a:prstGeom prst="parallelogram">
                <a:avLst>
                  <a:gd name="adj" fmla="val 80181"/>
                </a:avLst>
              </a:prstGeom>
              <a:solidFill>
                <a:srgbClr val="9CB6E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93" name="Group 92"/>
              <p:cNvGrpSpPr/>
              <p:nvPr/>
            </p:nvGrpSpPr>
            <p:grpSpPr>
              <a:xfrm>
                <a:off x="1078966" y="3666345"/>
                <a:ext cx="3081238" cy="117978"/>
                <a:chOff x="3220715" y="1939925"/>
                <a:chExt cx="1554485" cy="117475"/>
              </a:xfrm>
            </p:grpSpPr>
            <p:sp>
              <p:nvSpPr>
                <p:cNvPr id="94" name="Isosceles Triangle 93"/>
                <p:cNvSpPr/>
                <p:nvPr/>
              </p:nvSpPr>
              <p:spPr>
                <a:xfrm rot="16200000">
                  <a:off x="426720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95" name="Isosceles Triangle 94"/>
                <p:cNvSpPr/>
                <p:nvPr/>
              </p:nvSpPr>
              <p:spPr>
                <a:xfrm rot="5400000" flipH="1">
                  <a:off x="361124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sp>
          <p:nvSpPr>
            <p:cNvPr id="161" name="Cloud 160"/>
            <p:cNvSpPr/>
            <p:nvPr/>
          </p:nvSpPr>
          <p:spPr>
            <a:xfrm>
              <a:off x="2395145" y="3312307"/>
              <a:ext cx="874549" cy="746434"/>
            </a:xfrm>
            <a:prstGeom prst="cloud">
              <a:avLst/>
            </a:pr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162" name="Cloud 161"/>
            <p:cNvSpPr/>
            <p:nvPr/>
          </p:nvSpPr>
          <p:spPr>
            <a:xfrm>
              <a:off x="2394416" y="3314743"/>
              <a:ext cx="873759" cy="461079"/>
            </a:xfrm>
            <a:custGeom>
              <a:avLst/>
              <a:gdLst>
                <a:gd name="connsiteX0" fmla="*/ 3900 w 43200"/>
                <a:gd name="connsiteY0" fmla="*/ 14370 h 43200"/>
                <a:gd name="connsiteX1" fmla="*/ 5623 w 43200"/>
                <a:gd name="connsiteY1" fmla="*/ 6907 h 43200"/>
                <a:gd name="connsiteX2" fmla="*/ 14005 w 43200"/>
                <a:gd name="connsiteY2" fmla="*/ 5202 h 43200"/>
                <a:gd name="connsiteX3" fmla="*/ 22456 w 43200"/>
                <a:gd name="connsiteY3" fmla="*/ 3432 h 43200"/>
                <a:gd name="connsiteX4" fmla="*/ 25749 w 43200"/>
                <a:gd name="connsiteY4" fmla="*/ 200 h 43200"/>
                <a:gd name="connsiteX5" fmla="*/ 29833 w 43200"/>
                <a:gd name="connsiteY5" fmla="*/ 2481 h 43200"/>
                <a:gd name="connsiteX6" fmla="*/ 35463 w 43200"/>
                <a:gd name="connsiteY6" fmla="*/ 690 h 43200"/>
                <a:gd name="connsiteX7" fmla="*/ 38318 w 43200"/>
                <a:gd name="connsiteY7" fmla="*/ 5576 h 43200"/>
                <a:gd name="connsiteX8" fmla="*/ 41982 w 43200"/>
                <a:gd name="connsiteY8" fmla="*/ 10318 h 43200"/>
                <a:gd name="connsiteX9" fmla="*/ 41818 w 43200"/>
                <a:gd name="connsiteY9" fmla="*/ 15460 h 43200"/>
                <a:gd name="connsiteX10" fmla="*/ 43016 w 43200"/>
                <a:gd name="connsiteY10" fmla="*/ 23322 h 43200"/>
                <a:gd name="connsiteX11" fmla="*/ 37404 w 43200"/>
                <a:gd name="connsiteY11" fmla="*/ 30204 h 43200"/>
                <a:gd name="connsiteX12" fmla="*/ 35395 w 43200"/>
                <a:gd name="connsiteY12" fmla="*/ 36101 h 43200"/>
                <a:gd name="connsiteX13" fmla="*/ 28555 w 43200"/>
                <a:gd name="connsiteY13" fmla="*/ 36815 h 43200"/>
                <a:gd name="connsiteX14" fmla="*/ 23667 w 43200"/>
                <a:gd name="connsiteY14" fmla="*/ 43106 h 43200"/>
                <a:gd name="connsiteX15" fmla="*/ 16480 w 43200"/>
                <a:gd name="connsiteY15" fmla="*/ 39266 h 43200"/>
                <a:gd name="connsiteX16" fmla="*/ 5804 w 43200"/>
                <a:gd name="connsiteY16" fmla="*/ 35472 h 43200"/>
                <a:gd name="connsiteX17" fmla="*/ 1110 w 43200"/>
                <a:gd name="connsiteY17" fmla="*/ 31250 h 43200"/>
                <a:gd name="connsiteX18" fmla="*/ 2113 w 43200"/>
                <a:gd name="connsiteY18" fmla="*/ 25551 h 43200"/>
                <a:gd name="connsiteX19" fmla="*/ -5 w 43200"/>
                <a:gd name="connsiteY19" fmla="*/ 19704 h 43200"/>
                <a:gd name="connsiteX20" fmla="*/ 3863 w 43200"/>
                <a:gd name="connsiteY20" fmla="*/ 14507 h 43200"/>
                <a:gd name="connsiteX21" fmla="*/ 3900 w 43200"/>
                <a:gd name="connsiteY21" fmla="*/ 14370 h 43200"/>
                <a:gd name="connsiteX0" fmla="*/ 4693 w 43200"/>
                <a:gd name="connsiteY0" fmla="*/ 26177 h 43200"/>
                <a:gd name="connsiteX1" fmla="*/ 2160 w 43200"/>
                <a:gd name="connsiteY1" fmla="*/ 25380 h 43200"/>
                <a:gd name="connsiteX2" fmla="*/ 6928 w 43200"/>
                <a:gd name="connsiteY2" fmla="*/ 34899 h 43200"/>
                <a:gd name="connsiteX3" fmla="*/ 5820 w 43200"/>
                <a:gd name="connsiteY3" fmla="*/ 35280 h 43200"/>
                <a:gd name="connsiteX4" fmla="*/ 16478 w 43200"/>
                <a:gd name="connsiteY4" fmla="*/ 39090 h 43200"/>
                <a:gd name="connsiteX5" fmla="*/ 15810 w 43200"/>
                <a:gd name="connsiteY5" fmla="*/ 37350 h 43200"/>
                <a:gd name="connsiteX6" fmla="*/ 28827 w 43200"/>
                <a:gd name="connsiteY6" fmla="*/ 34751 h 43200"/>
                <a:gd name="connsiteX7" fmla="*/ 28560 w 43200"/>
                <a:gd name="connsiteY7" fmla="*/ 36660 h 43200"/>
                <a:gd name="connsiteX8" fmla="*/ 34129 w 43200"/>
                <a:gd name="connsiteY8" fmla="*/ 22954 h 43200"/>
                <a:gd name="connsiteX9" fmla="*/ 37380 w 43200"/>
                <a:gd name="connsiteY9" fmla="*/ 30090 h 43200"/>
                <a:gd name="connsiteX10" fmla="*/ 41798 w 43200"/>
                <a:gd name="connsiteY10" fmla="*/ 15354 h 43200"/>
                <a:gd name="connsiteX11" fmla="*/ 40350 w 43200"/>
                <a:gd name="connsiteY11" fmla="*/ 18030 h 43200"/>
                <a:gd name="connsiteX12" fmla="*/ 38324 w 43200"/>
                <a:gd name="connsiteY12" fmla="*/ 5426 h 43200"/>
                <a:gd name="connsiteX13" fmla="*/ 38400 w 43200"/>
                <a:gd name="connsiteY13" fmla="*/ 6690 h 43200"/>
                <a:gd name="connsiteX14" fmla="*/ 29078 w 43200"/>
                <a:gd name="connsiteY14" fmla="*/ 3952 h 43200"/>
                <a:gd name="connsiteX15" fmla="*/ 29820 w 43200"/>
                <a:gd name="connsiteY15" fmla="*/ 2340 h 43200"/>
                <a:gd name="connsiteX16" fmla="*/ 22141 w 43200"/>
                <a:gd name="connsiteY16" fmla="*/ 4720 h 43200"/>
                <a:gd name="connsiteX17" fmla="*/ 22500 w 43200"/>
                <a:gd name="connsiteY17" fmla="*/ 3330 h 43200"/>
                <a:gd name="connsiteX18" fmla="*/ 14000 w 43200"/>
                <a:gd name="connsiteY18" fmla="*/ 5192 h 43200"/>
                <a:gd name="connsiteX19" fmla="*/ 15300 w 43200"/>
                <a:gd name="connsiteY19" fmla="*/ 6540 h 43200"/>
                <a:gd name="connsiteX20" fmla="*/ 4127 w 43200"/>
                <a:gd name="connsiteY20" fmla="*/ 15789 h 43200"/>
                <a:gd name="connsiteX21" fmla="*/ 3900 w 43200"/>
                <a:gd name="connsiteY21" fmla="*/ 14370 h 43200"/>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16514 w 43256"/>
                <a:gd name="connsiteY2" fmla="*/ 38949 h 43219"/>
                <a:gd name="connsiteX3" fmla="*/ 15846 w 43256"/>
                <a:gd name="connsiteY3" fmla="*/ 37209 h 43219"/>
                <a:gd name="connsiteX4" fmla="*/ 28863 w 43256"/>
                <a:gd name="connsiteY4" fmla="*/ 34610 h 43219"/>
                <a:gd name="connsiteX5" fmla="*/ 28596 w 43256"/>
                <a:gd name="connsiteY5" fmla="*/ 36519 h 43219"/>
                <a:gd name="connsiteX6" fmla="*/ 34165 w 43256"/>
                <a:gd name="connsiteY6" fmla="*/ 22813 h 43219"/>
                <a:gd name="connsiteX7" fmla="*/ 37416 w 43256"/>
                <a:gd name="connsiteY7" fmla="*/ 29949 h 43219"/>
                <a:gd name="connsiteX8" fmla="*/ 41834 w 43256"/>
                <a:gd name="connsiteY8" fmla="*/ 15213 h 43219"/>
                <a:gd name="connsiteX9" fmla="*/ 40386 w 43256"/>
                <a:gd name="connsiteY9" fmla="*/ 17889 h 43219"/>
                <a:gd name="connsiteX10" fmla="*/ 38360 w 43256"/>
                <a:gd name="connsiteY10" fmla="*/ 5285 h 43219"/>
                <a:gd name="connsiteX11" fmla="*/ 38436 w 43256"/>
                <a:gd name="connsiteY11" fmla="*/ 6549 h 43219"/>
                <a:gd name="connsiteX12" fmla="*/ 29114 w 43256"/>
                <a:gd name="connsiteY12" fmla="*/ 3811 h 43219"/>
                <a:gd name="connsiteX13" fmla="*/ 29856 w 43256"/>
                <a:gd name="connsiteY13" fmla="*/ 2199 h 43219"/>
                <a:gd name="connsiteX14" fmla="*/ 22177 w 43256"/>
                <a:gd name="connsiteY14" fmla="*/ 4579 h 43219"/>
                <a:gd name="connsiteX15" fmla="*/ 22536 w 43256"/>
                <a:gd name="connsiteY15" fmla="*/ 3189 h 43219"/>
                <a:gd name="connsiteX16" fmla="*/ 14036 w 43256"/>
                <a:gd name="connsiteY16" fmla="*/ 5051 h 43219"/>
                <a:gd name="connsiteX17" fmla="*/ 15336 w 43256"/>
                <a:gd name="connsiteY17" fmla="*/ 6399 h 43219"/>
                <a:gd name="connsiteX18" fmla="*/ 4163 w 43256"/>
                <a:gd name="connsiteY18" fmla="*/ 15648 h 43219"/>
                <a:gd name="connsiteX19" fmla="*/ 3936 w 43256"/>
                <a:gd name="connsiteY19"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28863 w 43256"/>
                <a:gd name="connsiteY2" fmla="*/ 34610 h 43219"/>
                <a:gd name="connsiteX3" fmla="*/ 28596 w 43256"/>
                <a:gd name="connsiteY3" fmla="*/ 36519 h 43219"/>
                <a:gd name="connsiteX4" fmla="*/ 34165 w 43256"/>
                <a:gd name="connsiteY4" fmla="*/ 22813 h 43219"/>
                <a:gd name="connsiteX5" fmla="*/ 37416 w 43256"/>
                <a:gd name="connsiteY5" fmla="*/ 29949 h 43219"/>
                <a:gd name="connsiteX6" fmla="*/ 41834 w 43256"/>
                <a:gd name="connsiteY6" fmla="*/ 15213 h 43219"/>
                <a:gd name="connsiteX7" fmla="*/ 40386 w 43256"/>
                <a:gd name="connsiteY7" fmla="*/ 17889 h 43219"/>
                <a:gd name="connsiteX8" fmla="*/ 38360 w 43256"/>
                <a:gd name="connsiteY8" fmla="*/ 5285 h 43219"/>
                <a:gd name="connsiteX9" fmla="*/ 38436 w 43256"/>
                <a:gd name="connsiteY9" fmla="*/ 6549 h 43219"/>
                <a:gd name="connsiteX10" fmla="*/ 29114 w 43256"/>
                <a:gd name="connsiteY10" fmla="*/ 3811 h 43219"/>
                <a:gd name="connsiteX11" fmla="*/ 29856 w 43256"/>
                <a:gd name="connsiteY11" fmla="*/ 2199 h 43219"/>
                <a:gd name="connsiteX12" fmla="*/ 22177 w 43256"/>
                <a:gd name="connsiteY12" fmla="*/ 4579 h 43219"/>
                <a:gd name="connsiteX13" fmla="*/ 22536 w 43256"/>
                <a:gd name="connsiteY13" fmla="*/ 3189 h 43219"/>
                <a:gd name="connsiteX14" fmla="*/ 14036 w 43256"/>
                <a:gd name="connsiteY14" fmla="*/ 5051 h 43219"/>
                <a:gd name="connsiteX15" fmla="*/ 15336 w 43256"/>
                <a:gd name="connsiteY15" fmla="*/ 6399 h 43219"/>
                <a:gd name="connsiteX16" fmla="*/ 4163 w 43256"/>
                <a:gd name="connsiteY16" fmla="*/ 15648 h 43219"/>
                <a:gd name="connsiteX17" fmla="*/ 3936 w 43256"/>
                <a:gd name="connsiteY17"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34165 w 43256"/>
                <a:gd name="connsiteY2" fmla="*/ 22813 h 43219"/>
                <a:gd name="connsiteX3" fmla="*/ 37416 w 43256"/>
                <a:gd name="connsiteY3" fmla="*/ 29949 h 43219"/>
                <a:gd name="connsiteX4" fmla="*/ 41834 w 43256"/>
                <a:gd name="connsiteY4" fmla="*/ 15213 h 43219"/>
                <a:gd name="connsiteX5" fmla="*/ 40386 w 43256"/>
                <a:gd name="connsiteY5" fmla="*/ 17889 h 43219"/>
                <a:gd name="connsiteX6" fmla="*/ 38360 w 43256"/>
                <a:gd name="connsiteY6" fmla="*/ 5285 h 43219"/>
                <a:gd name="connsiteX7" fmla="*/ 38436 w 43256"/>
                <a:gd name="connsiteY7" fmla="*/ 6549 h 43219"/>
                <a:gd name="connsiteX8" fmla="*/ 29114 w 43256"/>
                <a:gd name="connsiteY8" fmla="*/ 3811 h 43219"/>
                <a:gd name="connsiteX9" fmla="*/ 29856 w 43256"/>
                <a:gd name="connsiteY9" fmla="*/ 2199 h 43219"/>
                <a:gd name="connsiteX10" fmla="*/ 22177 w 43256"/>
                <a:gd name="connsiteY10" fmla="*/ 4579 h 43219"/>
                <a:gd name="connsiteX11" fmla="*/ 22536 w 43256"/>
                <a:gd name="connsiteY11" fmla="*/ 3189 h 43219"/>
                <a:gd name="connsiteX12" fmla="*/ 14036 w 43256"/>
                <a:gd name="connsiteY12" fmla="*/ 5051 h 43219"/>
                <a:gd name="connsiteX13" fmla="*/ 15336 w 43256"/>
                <a:gd name="connsiteY13" fmla="*/ 6399 h 43219"/>
                <a:gd name="connsiteX14" fmla="*/ 4163 w 43256"/>
                <a:gd name="connsiteY14" fmla="*/ 15648 h 43219"/>
                <a:gd name="connsiteX15" fmla="*/ 3936 w 43256"/>
                <a:gd name="connsiteY15"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41834 w 43256"/>
                <a:gd name="connsiteY2" fmla="*/ 15213 h 43219"/>
                <a:gd name="connsiteX3" fmla="*/ 40386 w 43256"/>
                <a:gd name="connsiteY3" fmla="*/ 17889 h 43219"/>
                <a:gd name="connsiteX4" fmla="*/ 38360 w 43256"/>
                <a:gd name="connsiteY4" fmla="*/ 5285 h 43219"/>
                <a:gd name="connsiteX5" fmla="*/ 38436 w 43256"/>
                <a:gd name="connsiteY5" fmla="*/ 6549 h 43219"/>
                <a:gd name="connsiteX6" fmla="*/ 29114 w 43256"/>
                <a:gd name="connsiteY6" fmla="*/ 3811 h 43219"/>
                <a:gd name="connsiteX7" fmla="*/ 29856 w 43256"/>
                <a:gd name="connsiteY7" fmla="*/ 2199 h 43219"/>
                <a:gd name="connsiteX8" fmla="*/ 22177 w 43256"/>
                <a:gd name="connsiteY8" fmla="*/ 4579 h 43219"/>
                <a:gd name="connsiteX9" fmla="*/ 22536 w 43256"/>
                <a:gd name="connsiteY9" fmla="*/ 3189 h 43219"/>
                <a:gd name="connsiteX10" fmla="*/ 14036 w 43256"/>
                <a:gd name="connsiteY10" fmla="*/ 5051 h 43219"/>
                <a:gd name="connsiteX11" fmla="*/ 15336 w 43256"/>
                <a:gd name="connsiteY11" fmla="*/ 6399 h 43219"/>
                <a:gd name="connsiteX12" fmla="*/ 4163 w 43256"/>
                <a:gd name="connsiteY12" fmla="*/ 15648 h 43219"/>
                <a:gd name="connsiteX13" fmla="*/ 3936 w 43256"/>
                <a:gd name="connsiteY13" fmla="*/ 14229 h 43219"/>
                <a:gd name="connsiteX0" fmla="*/ 3936 w 43503"/>
                <a:gd name="connsiteY0" fmla="*/ 14229 h 43219"/>
                <a:gd name="connsiteX1" fmla="*/ 5659 w 43503"/>
                <a:gd name="connsiteY1" fmla="*/ 6766 h 43219"/>
                <a:gd name="connsiteX2" fmla="*/ 14041 w 43503"/>
                <a:gd name="connsiteY2" fmla="*/ 5061 h 43219"/>
                <a:gd name="connsiteX3" fmla="*/ 22492 w 43503"/>
                <a:gd name="connsiteY3" fmla="*/ 3291 h 43219"/>
                <a:gd name="connsiteX4" fmla="*/ 25785 w 43503"/>
                <a:gd name="connsiteY4" fmla="*/ 59 h 43219"/>
                <a:gd name="connsiteX5" fmla="*/ 29869 w 43503"/>
                <a:gd name="connsiteY5" fmla="*/ 2340 h 43219"/>
                <a:gd name="connsiteX6" fmla="*/ 35499 w 43503"/>
                <a:gd name="connsiteY6" fmla="*/ 549 h 43219"/>
                <a:gd name="connsiteX7" fmla="*/ 38354 w 43503"/>
                <a:gd name="connsiteY7" fmla="*/ 5435 h 43219"/>
                <a:gd name="connsiteX8" fmla="*/ 42018 w 43503"/>
                <a:gd name="connsiteY8" fmla="*/ 10177 h 43219"/>
                <a:gd name="connsiteX9" fmla="*/ 41854 w 43503"/>
                <a:gd name="connsiteY9" fmla="*/ 15319 h 43219"/>
                <a:gd name="connsiteX10" fmla="*/ 43052 w 43503"/>
                <a:gd name="connsiteY10" fmla="*/ 23181 h 43219"/>
                <a:gd name="connsiteX11" fmla="*/ 35431 w 43503"/>
                <a:gd name="connsiteY11" fmla="*/ 35960 h 43219"/>
                <a:gd name="connsiteX12" fmla="*/ 28591 w 43503"/>
                <a:gd name="connsiteY12" fmla="*/ 36674 h 43219"/>
                <a:gd name="connsiteX13" fmla="*/ 23703 w 43503"/>
                <a:gd name="connsiteY13" fmla="*/ 42965 h 43219"/>
                <a:gd name="connsiteX14" fmla="*/ 16516 w 43503"/>
                <a:gd name="connsiteY14" fmla="*/ 39125 h 43219"/>
                <a:gd name="connsiteX15" fmla="*/ 5840 w 43503"/>
                <a:gd name="connsiteY15" fmla="*/ 35331 h 43219"/>
                <a:gd name="connsiteX16" fmla="*/ 1146 w 43503"/>
                <a:gd name="connsiteY16" fmla="*/ 31109 h 43219"/>
                <a:gd name="connsiteX17" fmla="*/ 2149 w 43503"/>
                <a:gd name="connsiteY17" fmla="*/ 25410 h 43219"/>
                <a:gd name="connsiteX18" fmla="*/ 31 w 43503"/>
                <a:gd name="connsiteY18" fmla="*/ 19563 h 43219"/>
                <a:gd name="connsiteX19" fmla="*/ 3899 w 43503"/>
                <a:gd name="connsiteY19" fmla="*/ 14366 h 43219"/>
                <a:gd name="connsiteX20" fmla="*/ 3936 w 43503"/>
                <a:gd name="connsiteY20" fmla="*/ 14229 h 43219"/>
                <a:gd name="connsiteX0" fmla="*/ 4729 w 43503"/>
                <a:gd name="connsiteY0" fmla="*/ 26036 h 43219"/>
                <a:gd name="connsiteX1" fmla="*/ 2196 w 43503"/>
                <a:gd name="connsiteY1" fmla="*/ 25239 h 43219"/>
                <a:gd name="connsiteX2" fmla="*/ 41834 w 43503"/>
                <a:gd name="connsiteY2" fmla="*/ 15213 h 43219"/>
                <a:gd name="connsiteX3" fmla="*/ 40386 w 43503"/>
                <a:gd name="connsiteY3" fmla="*/ 17889 h 43219"/>
                <a:gd name="connsiteX4" fmla="*/ 38360 w 43503"/>
                <a:gd name="connsiteY4" fmla="*/ 5285 h 43219"/>
                <a:gd name="connsiteX5" fmla="*/ 38436 w 43503"/>
                <a:gd name="connsiteY5" fmla="*/ 6549 h 43219"/>
                <a:gd name="connsiteX6" fmla="*/ 29114 w 43503"/>
                <a:gd name="connsiteY6" fmla="*/ 3811 h 43219"/>
                <a:gd name="connsiteX7" fmla="*/ 29856 w 43503"/>
                <a:gd name="connsiteY7" fmla="*/ 2199 h 43219"/>
                <a:gd name="connsiteX8" fmla="*/ 22177 w 43503"/>
                <a:gd name="connsiteY8" fmla="*/ 4579 h 43219"/>
                <a:gd name="connsiteX9" fmla="*/ 22536 w 43503"/>
                <a:gd name="connsiteY9" fmla="*/ 3189 h 43219"/>
                <a:gd name="connsiteX10" fmla="*/ 14036 w 43503"/>
                <a:gd name="connsiteY10" fmla="*/ 5051 h 43219"/>
                <a:gd name="connsiteX11" fmla="*/ 15336 w 43503"/>
                <a:gd name="connsiteY11" fmla="*/ 6399 h 43219"/>
                <a:gd name="connsiteX12" fmla="*/ 4163 w 43503"/>
                <a:gd name="connsiteY12" fmla="*/ 15648 h 43219"/>
                <a:gd name="connsiteX13" fmla="*/ 3936 w 43503"/>
                <a:gd name="connsiteY13" fmla="*/ 14229 h 43219"/>
                <a:gd name="connsiteX0" fmla="*/ 3936 w 44007"/>
                <a:gd name="connsiteY0" fmla="*/ 14229 h 43219"/>
                <a:gd name="connsiteX1" fmla="*/ 5659 w 44007"/>
                <a:gd name="connsiteY1" fmla="*/ 6766 h 43219"/>
                <a:gd name="connsiteX2" fmla="*/ 14041 w 44007"/>
                <a:gd name="connsiteY2" fmla="*/ 5061 h 43219"/>
                <a:gd name="connsiteX3" fmla="*/ 22492 w 44007"/>
                <a:gd name="connsiteY3" fmla="*/ 3291 h 43219"/>
                <a:gd name="connsiteX4" fmla="*/ 25785 w 44007"/>
                <a:gd name="connsiteY4" fmla="*/ 59 h 43219"/>
                <a:gd name="connsiteX5" fmla="*/ 29869 w 44007"/>
                <a:gd name="connsiteY5" fmla="*/ 2340 h 43219"/>
                <a:gd name="connsiteX6" fmla="*/ 35499 w 44007"/>
                <a:gd name="connsiteY6" fmla="*/ 549 h 43219"/>
                <a:gd name="connsiteX7" fmla="*/ 38354 w 44007"/>
                <a:gd name="connsiteY7" fmla="*/ 5435 h 43219"/>
                <a:gd name="connsiteX8" fmla="*/ 42018 w 44007"/>
                <a:gd name="connsiteY8" fmla="*/ 10177 h 43219"/>
                <a:gd name="connsiteX9" fmla="*/ 41854 w 44007"/>
                <a:gd name="connsiteY9" fmla="*/ 15319 h 43219"/>
                <a:gd name="connsiteX10" fmla="*/ 43052 w 44007"/>
                <a:gd name="connsiteY10" fmla="*/ 23181 h 43219"/>
                <a:gd name="connsiteX11" fmla="*/ 28591 w 44007"/>
                <a:gd name="connsiteY11" fmla="*/ 36674 h 43219"/>
                <a:gd name="connsiteX12" fmla="*/ 23703 w 44007"/>
                <a:gd name="connsiteY12" fmla="*/ 42965 h 43219"/>
                <a:gd name="connsiteX13" fmla="*/ 16516 w 44007"/>
                <a:gd name="connsiteY13" fmla="*/ 39125 h 43219"/>
                <a:gd name="connsiteX14" fmla="*/ 5840 w 44007"/>
                <a:gd name="connsiteY14" fmla="*/ 35331 h 43219"/>
                <a:gd name="connsiteX15" fmla="*/ 1146 w 44007"/>
                <a:gd name="connsiteY15" fmla="*/ 31109 h 43219"/>
                <a:gd name="connsiteX16" fmla="*/ 2149 w 44007"/>
                <a:gd name="connsiteY16" fmla="*/ 25410 h 43219"/>
                <a:gd name="connsiteX17" fmla="*/ 31 w 44007"/>
                <a:gd name="connsiteY17" fmla="*/ 19563 h 43219"/>
                <a:gd name="connsiteX18" fmla="*/ 3899 w 44007"/>
                <a:gd name="connsiteY18" fmla="*/ 14366 h 43219"/>
                <a:gd name="connsiteX19" fmla="*/ 3936 w 44007"/>
                <a:gd name="connsiteY19" fmla="*/ 14229 h 43219"/>
                <a:gd name="connsiteX0" fmla="*/ 4729 w 44007"/>
                <a:gd name="connsiteY0" fmla="*/ 26036 h 43219"/>
                <a:gd name="connsiteX1" fmla="*/ 2196 w 44007"/>
                <a:gd name="connsiteY1" fmla="*/ 25239 h 43219"/>
                <a:gd name="connsiteX2" fmla="*/ 41834 w 44007"/>
                <a:gd name="connsiteY2" fmla="*/ 15213 h 43219"/>
                <a:gd name="connsiteX3" fmla="*/ 40386 w 44007"/>
                <a:gd name="connsiteY3" fmla="*/ 17889 h 43219"/>
                <a:gd name="connsiteX4" fmla="*/ 38360 w 44007"/>
                <a:gd name="connsiteY4" fmla="*/ 5285 h 43219"/>
                <a:gd name="connsiteX5" fmla="*/ 38436 w 44007"/>
                <a:gd name="connsiteY5" fmla="*/ 6549 h 43219"/>
                <a:gd name="connsiteX6" fmla="*/ 29114 w 44007"/>
                <a:gd name="connsiteY6" fmla="*/ 3811 h 43219"/>
                <a:gd name="connsiteX7" fmla="*/ 29856 w 44007"/>
                <a:gd name="connsiteY7" fmla="*/ 2199 h 43219"/>
                <a:gd name="connsiteX8" fmla="*/ 22177 w 44007"/>
                <a:gd name="connsiteY8" fmla="*/ 4579 h 43219"/>
                <a:gd name="connsiteX9" fmla="*/ 22536 w 44007"/>
                <a:gd name="connsiteY9" fmla="*/ 3189 h 43219"/>
                <a:gd name="connsiteX10" fmla="*/ 14036 w 44007"/>
                <a:gd name="connsiteY10" fmla="*/ 5051 h 43219"/>
                <a:gd name="connsiteX11" fmla="*/ 15336 w 44007"/>
                <a:gd name="connsiteY11" fmla="*/ 6399 h 43219"/>
                <a:gd name="connsiteX12" fmla="*/ 4163 w 44007"/>
                <a:gd name="connsiteY12" fmla="*/ 15648 h 43219"/>
                <a:gd name="connsiteX13" fmla="*/ 3936 w 44007"/>
                <a:gd name="connsiteY13" fmla="*/ 14229 h 43219"/>
                <a:gd name="connsiteX0" fmla="*/ 3936 w 44368"/>
                <a:gd name="connsiteY0" fmla="*/ 14229 h 43937"/>
                <a:gd name="connsiteX1" fmla="*/ 5659 w 44368"/>
                <a:gd name="connsiteY1" fmla="*/ 6766 h 43937"/>
                <a:gd name="connsiteX2" fmla="*/ 14041 w 44368"/>
                <a:gd name="connsiteY2" fmla="*/ 5061 h 43937"/>
                <a:gd name="connsiteX3" fmla="*/ 22492 w 44368"/>
                <a:gd name="connsiteY3" fmla="*/ 3291 h 43937"/>
                <a:gd name="connsiteX4" fmla="*/ 25785 w 44368"/>
                <a:gd name="connsiteY4" fmla="*/ 59 h 43937"/>
                <a:gd name="connsiteX5" fmla="*/ 29869 w 44368"/>
                <a:gd name="connsiteY5" fmla="*/ 2340 h 43937"/>
                <a:gd name="connsiteX6" fmla="*/ 35499 w 44368"/>
                <a:gd name="connsiteY6" fmla="*/ 549 h 43937"/>
                <a:gd name="connsiteX7" fmla="*/ 38354 w 44368"/>
                <a:gd name="connsiteY7" fmla="*/ 5435 h 43937"/>
                <a:gd name="connsiteX8" fmla="*/ 42018 w 44368"/>
                <a:gd name="connsiteY8" fmla="*/ 10177 h 43937"/>
                <a:gd name="connsiteX9" fmla="*/ 41854 w 44368"/>
                <a:gd name="connsiteY9" fmla="*/ 15319 h 43937"/>
                <a:gd name="connsiteX10" fmla="*/ 43052 w 44368"/>
                <a:gd name="connsiteY10" fmla="*/ 23181 h 43937"/>
                <a:gd name="connsiteX11" fmla="*/ 23703 w 44368"/>
                <a:gd name="connsiteY11" fmla="*/ 42965 h 43937"/>
                <a:gd name="connsiteX12" fmla="*/ 16516 w 44368"/>
                <a:gd name="connsiteY12" fmla="*/ 39125 h 43937"/>
                <a:gd name="connsiteX13" fmla="*/ 5840 w 44368"/>
                <a:gd name="connsiteY13" fmla="*/ 35331 h 43937"/>
                <a:gd name="connsiteX14" fmla="*/ 1146 w 44368"/>
                <a:gd name="connsiteY14" fmla="*/ 31109 h 43937"/>
                <a:gd name="connsiteX15" fmla="*/ 2149 w 44368"/>
                <a:gd name="connsiteY15" fmla="*/ 25410 h 43937"/>
                <a:gd name="connsiteX16" fmla="*/ 31 w 44368"/>
                <a:gd name="connsiteY16" fmla="*/ 19563 h 43937"/>
                <a:gd name="connsiteX17" fmla="*/ 3899 w 44368"/>
                <a:gd name="connsiteY17" fmla="*/ 14366 h 43937"/>
                <a:gd name="connsiteX18" fmla="*/ 3936 w 44368"/>
                <a:gd name="connsiteY18" fmla="*/ 14229 h 43937"/>
                <a:gd name="connsiteX0" fmla="*/ 4729 w 44368"/>
                <a:gd name="connsiteY0" fmla="*/ 26036 h 43937"/>
                <a:gd name="connsiteX1" fmla="*/ 2196 w 44368"/>
                <a:gd name="connsiteY1" fmla="*/ 25239 h 43937"/>
                <a:gd name="connsiteX2" fmla="*/ 41834 w 44368"/>
                <a:gd name="connsiteY2" fmla="*/ 15213 h 43937"/>
                <a:gd name="connsiteX3" fmla="*/ 40386 w 44368"/>
                <a:gd name="connsiteY3" fmla="*/ 17889 h 43937"/>
                <a:gd name="connsiteX4" fmla="*/ 38360 w 44368"/>
                <a:gd name="connsiteY4" fmla="*/ 5285 h 43937"/>
                <a:gd name="connsiteX5" fmla="*/ 38436 w 44368"/>
                <a:gd name="connsiteY5" fmla="*/ 6549 h 43937"/>
                <a:gd name="connsiteX6" fmla="*/ 29114 w 44368"/>
                <a:gd name="connsiteY6" fmla="*/ 3811 h 43937"/>
                <a:gd name="connsiteX7" fmla="*/ 29856 w 44368"/>
                <a:gd name="connsiteY7" fmla="*/ 2199 h 43937"/>
                <a:gd name="connsiteX8" fmla="*/ 22177 w 44368"/>
                <a:gd name="connsiteY8" fmla="*/ 4579 h 43937"/>
                <a:gd name="connsiteX9" fmla="*/ 22536 w 44368"/>
                <a:gd name="connsiteY9" fmla="*/ 3189 h 43937"/>
                <a:gd name="connsiteX10" fmla="*/ 14036 w 44368"/>
                <a:gd name="connsiteY10" fmla="*/ 5051 h 43937"/>
                <a:gd name="connsiteX11" fmla="*/ 15336 w 44368"/>
                <a:gd name="connsiteY11" fmla="*/ 6399 h 43937"/>
                <a:gd name="connsiteX12" fmla="*/ 4163 w 44368"/>
                <a:gd name="connsiteY12" fmla="*/ 15648 h 43937"/>
                <a:gd name="connsiteX13" fmla="*/ 3936 w 44368"/>
                <a:gd name="connsiteY13" fmla="*/ 14229 h 43937"/>
                <a:gd name="connsiteX0" fmla="*/ 3936 w 44368"/>
                <a:gd name="connsiteY0" fmla="*/ 14229 h 43937"/>
                <a:gd name="connsiteX1" fmla="*/ 5659 w 44368"/>
                <a:gd name="connsiteY1" fmla="*/ 6766 h 43937"/>
                <a:gd name="connsiteX2" fmla="*/ 14041 w 44368"/>
                <a:gd name="connsiteY2" fmla="*/ 5061 h 43937"/>
                <a:gd name="connsiteX3" fmla="*/ 22492 w 44368"/>
                <a:gd name="connsiteY3" fmla="*/ 3291 h 43937"/>
                <a:gd name="connsiteX4" fmla="*/ 25785 w 44368"/>
                <a:gd name="connsiteY4" fmla="*/ 59 h 43937"/>
                <a:gd name="connsiteX5" fmla="*/ 29869 w 44368"/>
                <a:gd name="connsiteY5" fmla="*/ 2340 h 43937"/>
                <a:gd name="connsiteX6" fmla="*/ 35499 w 44368"/>
                <a:gd name="connsiteY6" fmla="*/ 549 h 43937"/>
                <a:gd name="connsiteX7" fmla="*/ 38354 w 44368"/>
                <a:gd name="connsiteY7" fmla="*/ 5435 h 43937"/>
                <a:gd name="connsiteX8" fmla="*/ 42018 w 44368"/>
                <a:gd name="connsiteY8" fmla="*/ 10177 h 43937"/>
                <a:gd name="connsiteX9" fmla="*/ 41854 w 44368"/>
                <a:gd name="connsiteY9" fmla="*/ 15319 h 43937"/>
                <a:gd name="connsiteX10" fmla="*/ 43052 w 44368"/>
                <a:gd name="connsiteY10" fmla="*/ 23181 h 43937"/>
                <a:gd name="connsiteX11" fmla="*/ 23703 w 44368"/>
                <a:gd name="connsiteY11" fmla="*/ 42965 h 43937"/>
                <a:gd name="connsiteX12" fmla="*/ 16516 w 44368"/>
                <a:gd name="connsiteY12" fmla="*/ 39125 h 43937"/>
                <a:gd name="connsiteX13" fmla="*/ 5840 w 44368"/>
                <a:gd name="connsiteY13" fmla="*/ 35331 h 43937"/>
                <a:gd name="connsiteX14" fmla="*/ 1146 w 44368"/>
                <a:gd name="connsiteY14" fmla="*/ 31109 h 43937"/>
                <a:gd name="connsiteX15" fmla="*/ 2149 w 44368"/>
                <a:gd name="connsiteY15" fmla="*/ 25410 h 43937"/>
                <a:gd name="connsiteX16" fmla="*/ 31 w 44368"/>
                <a:gd name="connsiteY16" fmla="*/ 19563 h 43937"/>
                <a:gd name="connsiteX17" fmla="*/ 3899 w 44368"/>
                <a:gd name="connsiteY17" fmla="*/ 14366 h 43937"/>
                <a:gd name="connsiteX18" fmla="*/ 3936 w 44368"/>
                <a:gd name="connsiteY18" fmla="*/ 14229 h 43937"/>
                <a:gd name="connsiteX0" fmla="*/ 41834 w 44368"/>
                <a:gd name="connsiteY0" fmla="*/ 15213 h 43937"/>
                <a:gd name="connsiteX1" fmla="*/ 40386 w 44368"/>
                <a:gd name="connsiteY1" fmla="*/ 17889 h 43937"/>
                <a:gd name="connsiteX2" fmla="*/ 38360 w 44368"/>
                <a:gd name="connsiteY2" fmla="*/ 5285 h 43937"/>
                <a:gd name="connsiteX3" fmla="*/ 38436 w 44368"/>
                <a:gd name="connsiteY3" fmla="*/ 6549 h 43937"/>
                <a:gd name="connsiteX4" fmla="*/ 29114 w 44368"/>
                <a:gd name="connsiteY4" fmla="*/ 3811 h 43937"/>
                <a:gd name="connsiteX5" fmla="*/ 29856 w 44368"/>
                <a:gd name="connsiteY5" fmla="*/ 2199 h 43937"/>
                <a:gd name="connsiteX6" fmla="*/ 22177 w 44368"/>
                <a:gd name="connsiteY6" fmla="*/ 4579 h 43937"/>
                <a:gd name="connsiteX7" fmla="*/ 22536 w 44368"/>
                <a:gd name="connsiteY7" fmla="*/ 3189 h 43937"/>
                <a:gd name="connsiteX8" fmla="*/ 14036 w 44368"/>
                <a:gd name="connsiteY8" fmla="*/ 5051 h 43937"/>
                <a:gd name="connsiteX9" fmla="*/ 15336 w 44368"/>
                <a:gd name="connsiteY9" fmla="*/ 6399 h 43937"/>
                <a:gd name="connsiteX10" fmla="*/ 4163 w 44368"/>
                <a:gd name="connsiteY10" fmla="*/ 15648 h 43937"/>
                <a:gd name="connsiteX11" fmla="*/ 3936 w 44368"/>
                <a:gd name="connsiteY11" fmla="*/ 14229 h 43937"/>
                <a:gd name="connsiteX0" fmla="*/ 3936 w 44368"/>
                <a:gd name="connsiteY0" fmla="*/ 14229 h 43937"/>
                <a:gd name="connsiteX1" fmla="*/ 5659 w 44368"/>
                <a:gd name="connsiteY1" fmla="*/ 6766 h 43937"/>
                <a:gd name="connsiteX2" fmla="*/ 14041 w 44368"/>
                <a:gd name="connsiteY2" fmla="*/ 5061 h 43937"/>
                <a:gd name="connsiteX3" fmla="*/ 22492 w 44368"/>
                <a:gd name="connsiteY3" fmla="*/ 3291 h 43937"/>
                <a:gd name="connsiteX4" fmla="*/ 25785 w 44368"/>
                <a:gd name="connsiteY4" fmla="*/ 59 h 43937"/>
                <a:gd name="connsiteX5" fmla="*/ 29869 w 44368"/>
                <a:gd name="connsiteY5" fmla="*/ 2340 h 43937"/>
                <a:gd name="connsiteX6" fmla="*/ 35499 w 44368"/>
                <a:gd name="connsiteY6" fmla="*/ 549 h 43937"/>
                <a:gd name="connsiteX7" fmla="*/ 38354 w 44368"/>
                <a:gd name="connsiteY7" fmla="*/ 5435 h 43937"/>
                <a:gd name="connsiteX8" fmla="*/ 42018 w 44368"/>
                <a:gd name="connsiteY8" fmla="*/ 10177 h 43937"/>
                <a:gd name="connsiteX9" fmla="*/ 41854 w 44368"/>
                <a:gd name="connsiteY9" fmla="*/ 15319 h 43937"/>
                <a:gd name="connsiteX10" fmla="*/ 43052 w 44368"/>
                <a:gd name="connsiteY10" fmla="*/ 23181 h 43937"/>
                <a:gd name="connsiteX11" fmla="*/ 23703 w 44368"/>
                <a:gd name="connsiteY11" fmla="*/ 42965 h 43937"/>
                <a:gd name="connsiteX12" fmla="*/ 16516 w 44368"/>
                <a:gd name="connsiteY12" fmla="*/ 39125 h 43937"/>
                <a:gd name="connsiteX13" fmla="*/ 5840 w 44368"/>
                <a:gd name="connsiteY13" fmla="*/ 35331 h 43937"/>
                <a:gd name="connsiteX14" fmla="*/ 2149 w 44368"/>
                <a:gd name="connsiteY14" fmla="*/ 25410 h 43937"/>
                <a:gd name="connsiteX15" fmla="*/ 31 w 44368"/>
                <a:gd name="connsiteY15" fmla="*/ 19563 h 43937"/>
                <a:gd name="connsiteX16" fmla="*/ 3899 w 44368"/>
                <a:gd name="connsiteY16" fmla="*/ 14366 h 43937"/>
                <a:gd name="connsiteX17" fmla="*/ 3936 w 44368"/>
                <a:gd name="connsiteY17" fmla="*/ 14229 h 43937"/>
                <a:gd name="connsiteX0" fmla="*/ 41834 w 44368"/>
                <a:gd name="connsiteY0" fmla="*/ 15213 h 43937"/>
                <a:gd name="connsiteX1" fmla="*/ 40386 w 44368"/>
                <a:gd name="connsiteY1" fmla="*/ 17889 h 43937"/>
                <a:gd name="connsiteX2" fmla="*/ 38360 w 44368"/>
                <a:gd name="connsiteY2" fmla="*/ 5285 h 43937"/>
                <a:gd name="connsiteX3" fmla="*/ 38436 w 44368"/>
                <a:gd name="connsiteY3" fmla="*/ 6549 h 43937"/>
                <a:gd name="connsiteX4" fmla="*/ 29114 w 44368"/>
                <a:gd name="connsiteY4" fmla="*/ 3811 h 43937"/>
                <a:gd name="connsiteX5" fmla="*/ 29856 w 44368"/>
                <a:gd name="connsiteY5" fmla="*/ 2199 h 43937"/>
                <a:gd name="connsiteX6" fmla="*/ 22177 w 44368"/>
                <a:gd name="connsiteY6" fmla="*/ 4579 h 43937"/>
                <a:gd name="connsiteX7" fmla="*/ 22536 w 44368"/>
                <a:gd name="connsiteY7" fmla="*/ 3189 h 43937"/>
                <a:gd name="connsiteX8" fmla="*/ 14036 w 44368"/>
                <a:gd name="connsiteY8" fmla="*/ 5051 h 43937"/>
                <a:gd name="connsiteX9" fmla="*/ 15336 w 44368"/>
                <a:gd name="connsiteY9" fmla="*/ 6399 h 43937"/>
                <a:gd name="connsiteX10" fmla="*/ 4163 w 44368"/>
                <a:gd name="connsiteY10" fmla="*/ 15648 h 43937"/>
                <a:gd name="connsiteX11" fmla="*/ 3936 w 44368"/>
                <a:gd name="connsiteY11" fmla="*/ 14229 h 43937"/>
                <a:gd name="connsiteX0" fmla="*/ 3936 w 44368"/>
                <a:gd name="connsiteY0" fmla="*/ 14229 h 43937"/>
                <a:gd name="connsiteX1" fmla="*/ 5659 w 44368"/>
                <a:gd name="connsiteY1" fmla="*/ 6766 h 43937"/>
                <a:gd name="connsiteX2" fmla="*/ 14041 w 44368"/>
                <a:gd name="connsiteY2" fmla="*/ 5061 h 43937"/>
                <a:gd name="connsiteX3" fmla="*/ 22492 w 44368"/>
                <a:gd name="connsiteY3" fmla="*/ 3291 h 43937"/>
                <a:gd name="connsiteX4" fmla="*/ 25785 w 44368"/>
                <a:gd name="connsiteY4" fmla="*/ 59 h 43937"/>
                <a:gd name="connsiteX5" fmla="*/ 29869 w 44368"/>
                <a:gd name="connsiteY5" fmla="*/ 2340 h 43937"/>
                <a:gd name="connsiteX6" fmla="*/ 35499 w 44368"/>
                <a:gd name="connsiteY6" fmla="*/ 549 h 43937"/>
                <a:gd name="connsiteX7" fmla="*/ 38354 w 44368"/>
                <a:gd name="connsiteY7" fmla="*/ 5435 h 43937"/>
                <a:gd name="connsiteX8" fmla="*/ 42018 w 44368"/>
                <a:gd name="connsiteY8" fmla="*/ 10177 h 43937"/>
                <a:gd name="connsiteX9" fmla="*/ 41854 w 44368"/>
                <a:gd name="connsiteY9" fmla="*/ 15319 h 43937"/>
                <a:gd name="connsiteX10" fmla="*/ 43052 w 44368"/>
                <a:gd name="connsiteY10" fmla="*/ 23181 h 43937"/>
                <a:gd name="connsiteX11" fmla="*/ 23703 w 44368"/>
                <a:gd name="connsiteY11" fmla="*/ 42965 h 43937"/>
                <a:gd name="connsiteX12" fmla="*/ 16516 w 44368"/>
                <a:gd name="connsiteY12" fmla="*/ 39125 h 43937"/>
                <a:gd name="connsiteX13" fmla="*/ 2149 w 44368"/>
                <a:gd name="connsiteY13" fmla="*/ 25410 h 43937"/>
                <a:gd name="connsiteX14" fmla="*/ 31 w 44368"/>
                <a:gd name="connsiteY14" fmla="*/ 19563 h 43937"/>
                <a:gd name="connsiteX15" fmla="*/ 3899 w 44368"/>
                <a:gd name="connsiteY15" fmla="*/ 14366 h 43937"/>
                <a:gd name="connsiteX16" fmla="*/ 3936 w 44368"/>
                <a:gd name="connsiteY16" fmla="*/ 14229 h 43937"/>
                <a:gd name="connsiteX0" fmla="*/ 41834 w 44368"/>
                <a:gd name="connsiteY0" fmla="*/ 15213 h 43937"/>
                <a:gd name="connsiteX1" fmla="*/ 40386 w 44368"/>
                <a:gd name="connsiteY1" fmla="*/ 17889 h 43937"/>
                <a:gd name="connsiteX2" fmla="*/ 38360 w 44368"/>
                <a:gd name="connsiteY2" fmla="*/ 5285 h 43937"/>
                <a:gd name="connsiteX3" fmla="*/ 38436 w 44368"/>
                <a:gd name="connsiteY3" fmla="*/ 6549 h 43937"/>
                <a:gd name="connsiteX4" fmla="*/ 29114 w 44368"/>
                <a:gd name="connsiteY4" fmla="*/ 3811 h 43937"/>
                <a:gd name="connsiteX5" fmla="*/ 29856 w 44368"/>
                <a:gd name="connsiteY5" fmla="*/ 2199 h 43937"/>
                <a:gd name="connsiteX6" fmla="*/ 22177 w 44368"/>
                <a:gd name="connsiteY6" fmla="*/ 4579 h 43937"/>
                <a:gd name="connsiteX7" fmla="*/ 22536 w 44368"/>
                <a:gd name="connsiteY7" fmla="*/ 3189 h 43937"/>
                <a:gd name="connsiteX8" fmla="*/ 14036 w 44368"/>
                <a:gd name="connsiteY8" fmla="*/ 5051 h 43937"/>
                <a:gd name="connsiteX9" fmla="*/ 15336 w 44368"/>
                <a:gd name="connsiteY9" fmla="*/ 6399 h 43937"/>
                <a:gd name="connsiteX10" fmla="*/ 4163 w 44368"/>
                <a:gd name="connsiteY10" fmla="*/ 15648 h 43937"/>
                <a:gd name="connsiteX11" fmla="*/ 3936 w 44368"/>
                <a:gd name="connsiteY11" fmla="*/ 14229 h 43937"/>
                <a:gd name="connsiteX0" fmla="*/ 3936 w 44368"/>
                <a:gd name="connsiteY0" fmla="*/ 14229 h 42972"/>
                <a:gd name="connsiteX1" fmla="*/ 5659 w 44368"/>
                <a:gd name="connsiteY1" fmla="*/ 6766 h 42972"/>
                <a:gd name="connsiteX2" fmla="*/ 14041 w 44368"/>
                <a:gd name="connsiteY2" fmla="*/ 5061 h 42972"/>
                <a:gd name="connsiteX3" fmla="*/ 22492 w 44368"/>
                <a:gd name="connsiteY3" fmla="*/ 3291 h 42972"/>
                <a:gd name="connsiteX4" fmla="*/ 25785 w 44368"/>
                <a:gd name="connsiteY4" fmla="*/ 59 h 42972"/>
                <a:gd name="connsiteX5" fmla="*/ 29869 w 44368"/>
                <a:gd name="connsiteY5" fmla="*/ 2340 h 42972"/>
                <a:gd name="connsiteX6" fmla="*/ 35499 w 44368"/>
                <a:gd name="connsiteY6" fmla="*/ 549 h 42972"/>
                <a:gd name="connsiteX7" fmla="*/ 38354 w 44368"/>
                <a:gd name="connsiteY7" fmla="*/ 5435 h 42972"/>
                <a:gd name="connsiteX8" fmla="*/ 42018 w 44368"/>
                <a:gd name="connsiteY8" fmla="*/ 10177 h 42972"/>
                <a:gd name="connsiteX9" fmla="*/ 41854 w 44368"/>
                <a:gd name="connsiteY9" fmla="*/ 15319 h 42972"/>
                <a:gd name="connsiteX10" fmla="*/ 43052 w 44368"/>
                <a:gd name="connsiteY10" fmla="*/ 23181 h 42972"/>
                <a:gd name="connsiteX11" fmla="*/ 23703 w 44368"/>
                <a:gd name="connsiteY11" fmla="*/ 42965 h 42972"/>
                <a:gd name="connsiteX12" fmla="*/ 2149 w 44368"/>
                <a:gd name="connsiteY12" fmla="*/ 25410 h 42972"/>
                <a:gd name="connsiteX13" fmla="*/ 31 w 44368"/>
                <a:gd name="connsiteY13" fmla="*/ 19563 h 42972"/>
                <a:gd name="connsiteX14" fmla="*/ 3899 w 44368"/>
                <a:gd name="connsiteY14" fmla="*/ 14366 h 42972"/>
                <a:gd name="connsiteX15" fmla="*/ 3936 w 44368"/>
                <a:gd name="connsiteY15" fmla="*/ 14229 h 42972"/>
                <a:gd name="connsiteX0" fmla="*/ 41834 w 44368"/>
                <a:gd name="connsiteY0" fmla="*/ 15213 h 42972"/>
                <a:gd name="connsiteX1" fmla="*/ 40386 w 44368"/>
                <a:gd name="connsiteY1" fmla="*/ 17889 h 42972"/>
                <a:gd name="connsiteX2" fmla="*/ 38360 w 44368"/>
                <a:gd name="connsiteY2" fmla="*/ 5285 h 42972"/>
                <a:gd name="connsiteX3" fmla="*/ 38436 w 44368"/>
                <a:gd name="connsiteY3" fmla="*/ 6549 h 42972"/>
                <a:gd name="connsiteX4" fmla="*/ 29114 w 44368"/>
                <a:gd name="connsiteY4" fmla="*/ 3811 h 42972"/>
                <a:gd name="connsiteX5" fmla="*/ 29856 w 44368"/>
                <a:gd name="connsiteY5" fmla="*/ 2199 h 42972"/>
                <a:gd name="connsiteX6" fmla="*/ 22177 w 44368"/>
                <a:gd name="connsiteY6" fmla="*/ 4579 h 42972"/>
                <a:gd name="connsiteX7" fmla="*/ 22536 w 44368"/>
                <a:gd name="connsiteY7" fmla="*/ 3189 h 42972"/>
                <a:gd name="connsiteX8" fmla="*/ 14036 w 44368"/>
                <a:gd name="connsiteY8" fmla="*/ 5051 h 42972"/>
                <a:gd name="connsiteX9" fmla="*/ 15336 w 44368"/>
                <a:gd name="connsiteY9" fmla="*/ 6399 h 42972"/>
                <a:gd name="connsiteX10" fmla="*/ 4163 w 44368"/>
                <a:gd name="connsiteY10" fmla="*/ 15648 h 42972"/>
                <a:gd name="connsiteX11" fmla="*/ 3936 w 44368"/>
                <a:gd name="connsiteY11" fmla="*/ 14229 h 42972"/>
                <a:gd name="connsiteX0" fmla="*/ 3936 w 45964"/>
                <a:gd name="connsiteY0" fmla="*/ 14229 h 25572"/>
                <a:gd name="connsiteX1" fmla="*/ 5659 w 45964"/>
                <a:gd name="connsiteY1" fmla="*/ 6766 h 25572"/>
                <a:gd name="connsiteX2" fmla="*/ 14041 w 45964"/>
                <a:gd name="connsiteY2" fmla="*/ 5061 h 25572"/>
                <a:gd name="connsiteX3" fmla="*/ 22492 w 45964"/>
                <a:gd name="connsiteY3" fmla="*/ 3291 h 25572"/>
                <a:gd name="connsiteX4" fmla="*/ 25785 w 45964"/>
                <a:gd name="connsiteY4" fmla="*/ 59 h 25572"/>
                <a:gd name="connsiteX5" fmla="*/ 29869 w 45964"/>
                <a:gd name="connsiteY5" fmla="*/ 2340 h 25572"/>
                <a:gd name="connsiteX6" fmla="*/ 35499 w 45964"/>
                <a:gd name="connsiteY6" fmla="*/ 549 h 25572"/>
                <a:gd name="connsiteX7" fmla="*/ 38354 w 45964"/>
                <a:gd name="connsiteY7" fmla="*/ 5435 h 25572"/>
                <a:gd name="connsiteX8" fmla="*/ 42018 w 45964"/>
                <a:gd name="connsiteY8" fmla="*/ 10177 h 25572"/>
                <a:gd name="connsiteX9" fmla="*/ 41854 w 45964"/>
                <a:gd name="connsiteY9" fmla="*/ 15319 h 25572"/>
                <a:gd name="connsiteX10" fmla="*/ 43052 w 45964"/>
                <a:gd name="connsiteY10" fmla="*/ 23181 h 25572"/>
                <a:gd name="connsiteX11" fmla="*/ 2149 w 45964"/>
                <a:gd name="connsiteY11" fmla="*/ 25410 h 25572"/>
                <a:gd name="connsiteX12" fmla="*/ 31 w 45964"/>
                <a:gd name="connsiteY12" fmla="*/ 19563 h 25572"/>
                <a:gd name="connsiteX13" fmla="*/ 3899 w 45964"/>
                <a:gd name="connsiteY13" fmla="*/ 14366 h 25572"/>
                <a:gd name="connsiteX14" fmla="*/ 3936 w 45964"/>
                <a:gd name="connsiteY14" fmla="*/ 14229 h 25572"/>
                <a:gd name="connsiteX0" fmla="*/ 41834 w 45964"/>
                <a:gd name="connsiteY0" fmla="*/ 15213 h 25572"/>
                <a:gd name="connsiteX1" fmla="*/ 40386 w 45964"/>
                <a:gd name="connsiteY1" fmla="*/ 17889 h 25572"/>
                <a:gd name="connsiteX2" fmla="*/ 38360 w 45964"/>
                <a:gd name="connsiteY2" fmla="*/ 5285 h 25572"/>
                <a:gd name="connsiteX3" fmla="*/ 38436 w 45964"/>
                <a:gd name="connsiteY3" fmla="*/ 6549 h 25572"/>
                <a:gd name="connsiteX4" fmla="*/ 29114 w 45964"/>
                <a:gd name="connsiteY4" fmla="*/ 3811 h 25572"/>
                <a:gd name="connsiteX5" fmla="*/ 29856 w 45964"/>
                <a:gd name="connsiteY5" fmla="*/ 2199 h 25572"/>
                <a:gd name="connsiteX6" fmla="*/ 22177 w 45964"/>
                <a:gd name="connsiteY6" fmla="*/ 4579 h 25572"/>
                <a:gd name="connsiteX7" fmla="*/ 22536 w 45964"/>
                <a:gd name="connsiteY7" fmla="*/ 3189 h 25572"/>
                <a:gd name="connsiteX8" fmla="*/ 14036 w 45964"/>
                <a:gd name="connsiteY8" fmla="*/ 5051 h 25572"/>
                <a:gd name="connsiteX9" fmla="*/ 15336 w 45964"/>
                <a:gd name="connsiteY9" fmla="*/ 6399 h 25572"/>
                <a:gd name="connsiteX10" fmla="*/ 4163 w 45964"/>
                <a:gd name="connsiteY10" fmla="*/ 15648 h 25572"/>
                <a:gd name="connsiteX11" fmla="*/ 3936 w 45964"/>
                <a:gd name="connsiteY11" fmla="*/ 14229 h 25572"/>
                <a:gd name="connsiteX0" fmla="*/ 3936 w 43296"/>
                <a:gd name="connsiteY0" fmla="*/ 14229 h 25762"/>
                <a:gd name="connsiteX1" fmla="*/ 5659 w 43296"/>
                <a:gd name="connsiteY1" fmla="*/ 6766 h 25762"/>
                <a:gd name="connsiteX2" fmla="*/ 14041 w 43296"/>
                <a:gd name="connsiteY2" fmla="*/ 5061 h 25762"/>
                <a:gd name="connsiteX3" fmla="*/ 22492 w 43296"/>
                <a:gd name="connsiteY3" fmla="*/ 3291 h 25762"/>
                <a:gd name="connsiteX4" fmla="*/ 25785 w 43296"/>
                <a:gd name="connsiteY4" fmla="*/ 59 h 25762"/>
                <a:gd name="connsiteX5" fmla="*/ 29869 w 43296"/>
                <a:gd name="connsiteY5" fmla="*/ 2340 h 25762"/>
                <a:gd name="connsiteX6" fmla="*/ 35499 w 43296"/>
                <a:gd name="connsiteY6" fmla="*/ 549 h 25762"/>
                <a:gd name="connsiteX7" fmla="*/ 38354 w 43296"/>
                <a:gd name="connsiteY7" fmla="*/ 5435 h 25762"/>
                <a:gd name="connsiteX8" fmla="*/ 42018 w 43296"/>
                <a:gd name="connsiteY8" fmla="*/ 10177 h 25762"/>
                <a:gd name="connsiteX9" fmla="*/ 41854 w 43296"/>
                <a:gd name="connsiteY9" fmla="*/ 15319 h 25762"/>
                <a:gd name="connsiteX10" fmla="*/ 38817 w 43296"/>
                <a:gd name="connsiteY10" fmla="*/ 24284 h 25762"/>
                <a:gd name="connsiteX11" fmla="*/ 2149 w 43296"/>
                <a:gd name="connsiteY11" fmla="*/ 25410 h 25762"/>
                <a:gd name="connsiteX12" fmla="*/ 31 w 43296"/>
                <a:gd name="connsiteY12" fmla="*/ 19563 h 25762"/>
                <a:gd name="connsiteX13" fmla="*/ 3899 w 43296"/>
                <a:gd name="connsiteY13" fmla="*/ 14366 h 25762"/>
                <a:gd name="connsiteX14" fmla="*/ 3936 w 43296"/>
                <a:gd name="connsiteY14" fmla="*/ 14229 h 25762"/>
                <a:gd name="connsiteX0" fmla="*/ 41834 w 43296"/>
                <a:gd name="connsiteY0" fmla="*/ 15213 h 25762"/>
                <a:gd name="connsiteX1" fmla="*/ 40386 w 43296"/>
                <a:gd name="connsiteY1" fmla="*/ 17889 h 25762"/>
                <a:gd name="connsiteX2" fmla="*/ 38360 w 43296"/>
                <a:gd name="connsiteY2" fmla="*/ 5285 h 25762"/>
                <a:gd name="connsiteX3" fmla="*/ 38436 w 43296"/>
                <a:gd name="connsiteY3" fmla="*/ 6549 h 25762"/>
                <a:gd name="connsiteX4" fmla="*/ 29114 w 43296"/>
                <a:gd name="connsiteY4" fmla="*/ 3811 h 25762"/>
                <a:gd name="connsiteX5" fmla="*/ 29856 w 43296"/>
                <a:gd name="connsiteY5" fmla="*/ 2199 h 25762"/>
                <a:gd name="connsiteX6" fmla="*/ 22177 w 43296"/>
                <a:gd name="connsiteY6" fmla="*/ 4579 h 25762"/>
                <a:gd name="connsiteX7" fmla="*/ 22536 w 43296"/>
                <a:gd name="connsiteY7" fmla="*/ 3189 h 25762"/>
                <a:gd name="connsiteX8" fmla="*/ 14036 w 43296"/>
                <a:gd name="connsiteY8" fmla="*/ 5051 h 25762"/>
                <a:gd name="connsiteX9" fmla="*/ 15336 w 43296"/>
                <a:gd name="connsiteY9" fmla="*/ 6399 h 25762"/>
                <a:gd name="connsiteX10" fmla="*/ 4163 w 43296"/>
                <a:gd name="connsiteY10" fmla="*/ 15648 h 25762"/>
                <a:gd name="connsiteX11" fmla="*/ 3936 w 43296"/>
                <a:gd name="connsiteY11" fmla="*/ 14229 h 25762"/>
                <a:gd name="connsiteX0" fmla="*/ 3936 w 42466"/>
                <a:gd name="connsiteY0" fmla="*/ 14229 h 26685"/>
                <a:gd name="connsiteX1" fmla="*/ 5659 w 42466"/>
                <a:gd name="connsiteY1" fmla="*/ 6766 h 26685"/>
                <a:gd name="connsiteX2" fmla="*/ 14041 w 42466"/>
                <a:gd name="connsiteY2" fmla="*/ 5061 h 26685"/>
                <a:gd name="connsiteX3" fmla="*/ 22492 w 42466"/>
                <a:gd name="connsiteY3" fmla="*/ 3291 h 26685"/>
                <a:gd name="connsiteX4" fmla="*/ 25785 w 42466"/>
                <a:gd name="connsiteY4" fmla="*/ 59 h 26685"/>
                <a:gd name="connsiteX5" fmla="*/ 29869 w 42466"/>
                <a:gd name="connsiteY5" fmla="*/ 2340 h 26685"/>
                <a:gd name="connsiteX6" fmla="*/ 35499 w 42466"/>
                <a:gd name="connsiteY6" fmla="*/ 549 h 26685"/>
                <a:gd name="connsiteX7" fmla="*/ 38354 w 42466"/>
                <a:gd name="connsiteY7" fmla="*/ 5435 h 26685"/>
                <a:gd name="connsiteX8" fmla="*/ 42018 w 42466"/>
                <a:gd name="connsiteY8" fmla="*/ 10177 h 26685"/>
                <a:gd name="connsiteX9" fmla="*/ 41854 w 42466"/>
                <a:gd name="connsiteY9" fmla="*/ 15319 h 26685"/>
                <a:gd name="connsiteX10" fmla="*/ 38817 w 42466"/>
                <a:gd name="connsiteY10" fmla="*/ 24284 h 26685"/>
                <a:gd name="connsiteX11" fmla="*/ 19268 w 42466"/>
                <a:gd name="connsiteY11" fmla="*/ 26642 h 26685"/>
                <a:gd name="connsiteX12" fmla="*/ 2149 w 42466"/>
                <a:gd name="connsiteY12" fmla="*/ 25410 h 26685"/>
                <a:gd name="connsiteX13" fmla="*/ 31 w 42466"/>
                <a:gd name="connsiteY13" fmla="*/ 19563 h 26685"/>
                <a:gd name="connsiteX14" fmla="*/ 3899 w 42466"/>
                <a:gd name="connsiteY14" fmla="*/ 14366 h 26685"/>
                <a:gd name="connsiteX15" fmla="*/ 3936 w 42466"/>
                <a:gd name="connsiteY15" fmla="*/ 14229 h 26685"/>
                <a:gd name="connsiteX0" fmla="*/ 41834 w 42466"/>
                <a:gd name="connsiteY0" fmla="*/ 15213 h 26685"/>
                <a:gd name="connsiteX1" fmla="*/ 40386 w 42466"/>
                <a:gd name="connsiteY1" fmla="*/ 17889 h 26685"/>
                <a:gd name="connsiteX2" fmla="*/ 38360 w 42466"/>
                <a:gd name="connsiteY2" fmla="*/ 5285 h 26685"/>
                <a:gd name="connsiteX3" fmla="*/ 38436 w 42466"/>
                <a:gd name="connsiteY3" fmla="*/ 6549 h 26685"/>
                <a:gd name="connsiteX4" fmla="*/ 29114 w 42466"/>
                <a:gd name="connsiteY4" fmla="*/ 3811 h 26685"/>
                <a:gd name="connsiteX5" fmla="*/ 29856 w 42466"/>
                <a:gd name="connsiteY5" fmla="*/ 2199 h 26685"/>
                <a:gd name="connsiteX6" fmla="*/ 22177 w 42466"/>
                <a:gd name="connsiteY6" fmla="*/ 4579 h 26685"/>
                <a:gd name="connsiteX7" fmla="*/ 22536 w 42466"/>
                <a:gd name="connsiteY7" fmla="*/ 3189 h 26685"/>
                <a:gd name="connsiteX8" fmla="*/ 14036 w 42466"/>
                <a:gd name="connsiteY8" fmla="*/ 5051 h 26685"/>
                <a:gd name="connsiteX9" fmla="*/ 15336 w 42466"/>
                <a:gd name="connsiteY9" fmla="*/ 6399 h 26685"/>
                <a:gd name="connsiteX10" fmla="*/ 4163 w 42466"/>
                <a:gd name="connsiteY10" fmla="*/ 15648 h 26685"/>
                <a:gd name="connsiteX11" fmla="*/ 3936 w 42466"/>
                <a:gd name="connsiteY11" fmla="*/ 14229 h 26685"/>
                <a:gd name="connsiteX0" fmla="*/ 3936 w 43161"/>
                <a:gd name="connsiteY0" fmla="*/ 14229 h 26685"/>
                <a:gd name="connsiteX1" fmla="*/ 5659 w 43161"/>
                <a:gd name="connsiteY1" fmla="*/ 6766 h 26685"/>
                <a:gd name="connsiteX2" fmla="*/ 14041 w 43161"/>
                <a:gd name="connsiteY2" fmla="*/ 5061 h 26685"/>
                <a:gd name="connsiteX3" fmla="*/ 22492 w 43161"/>
                <a:gd name="connsiteY3" fmla="*/ 3291 h 26685"/>
                <a:gd name="connsiteX4" fmla="*/ 25785 w 43161"/>
                <a:gd name="connsiteY4" fmla="*/ 59 h 26685"/>
                <a:gd name="connsiteX5" fmla="*/ 29869 w 43161"/>
                <a:gd name="connsiteY5" fmla="*/ 2340 h 26685"/>
                <a:gd name="connsiteX6" fmla="*/ 35499 w 43161"/>
                <a:gd name="connsiteY6" fmla="*/ 549 h 26685"/>
                <a:gd name="connsiteX7" fmla="*/ 38354 w 43161"/>
                <a:gd name="connsiteY7" fmla="*/ 5435 h 26685"/>
                <a:gd name="connsiteX8" fmla="*/ 42018 w 43161"/>
                <a:gd name="connsiteY8" fmla="*/ 10177 h 26685"/>
                <a:gd name="connsiteX9" fmla="*/ 41854 w 43161"/>
                <a:gd name="connsiteY9" fmla="*/ 15319 h 26685"/>
                <a:gd name="connsiteX10" fmla="*/ 40699 w 43161"/>
                <a:gd name="connsiteY10" fmla="*/ 23916 h 26685"/>
                <a:gd name="connsiteX11" fmla="*/ 19268 w 43161"/>
                <a:gd name="connsiteY11" fmla="*/ 26642 h 26685"/>
                <a:gd name="connsiteX12" fmla="*/ 2149 w 43161"/>
                <a:gd name="connsiteY12" fmla="*/ 25410 h 26685"/>
                <a:gd name="connsiteX13" fmla="*/ 31 w 43161"/>
                <a:gd name="connsiteY13" fmla="*/ 19563 h 26685"/>
                <a:gd name="connsiteX14" fmla="*/ 3899 w 43161"/>
                <a:gd name="connsiteY14" fmla="*/ 14366 h 26685"/>
                <a:gd name="connsiteX15" fmla="*/ 3936 w 43161"/>
                <a:gd name="connsiteY15" fmla="*/ 14229 h 26685"/>
                <a:gd name="connsiteX0" fmla="*/ 41834 w 43161"/>
                <a:gd name="connsiteY0" fmla="*/ 15213 h 26685"/>
                <a:gd name="connsiteX1" fmla="*/ 40386 w 43161"/>
                <a:gd name="connsiteY1" fmla="*/ 17889 h 26685"/>
                <a:gd name="connsiteX2" fmla="*/ 38360 w 43161"/>
                <a:gd name="connsiteY2" fmla="*/ 5285 h 26685"/>
                <a:gd name="connsiteX3" fmla="*/ 38436 w 43161"/>
                <a:gd name="connsiteY3" fmla="*/ 6549 h 26685"/>
                <a:gd name="connsiteX4" fmla="*/ 29114 w 43161"/>
                <a:gd name="connsiteY4" fmla="*/ 3811 h 26685"/>
                <a:gd name="connsiteX5" fmla="*/ 29856 w 43161"/>
                <a:gd name="connsiteY5" fmla="*/ 2199 h 26685"/>
                <a:gd name="connsiteX6" fmla="*/ 22177 w 43161"/>
                <a:gd name="connsiteY6" fmla="*/ 4579 h 26685"/>
                <a:gd name="connsiteX7" fmla="*/ 22536 w 43161"/>
                <a:gd name="connsiteY7" fmla="*/ 3189 h 26685"/>
                <a:gd name="connsiteX8" fmla="*/ 14036 w 43161"/>
                <a:gd name="connsiteY8" fmla="*/ 5051 h 26685"/>
                <a:gd name="connsiteX9" fmla="*/ 15336 w 43161"/>
                <a:gd name="connsiteY9" fmla="*/ 6399 h 26685"/>
                <a:gd name="connsiteX10" fmla="*/ 4163 w 43161"/>
                <a:gd name="connsiteY10" fmla="*/ 15648 h 26685"/>
                <a:gd name="connsiteX11" fmla="*/ 3936 w 43161"/>
                <a:gd name="connsiteY11" fmla="*/ 14229 h 2668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Lst>
              <a:rect l="l" t="t" r="r" b="b"/>
              <a:pathLst>
                <a:path w="43161" h="26685">
                  <a:moveTo>
                    <a:pt x="3936" y="14229"/>
                  </a:moveTo>
                  <a:cubicBezTo>
                    <a:pt x="3665" y="11516"/>
                    <a:pt x="4297" y="8780"/>
                    <a:pt x="5659" y="6766"/>
                  </a:cubicBezTo>
                  <a:cubicBezTo>
                    <a:pt x="7811" y="3585"/>
                    <a:pt x="11300" y="2876"/>
                    <a:pt x="14041" y="5061"/>
                  </a:cubicBezTo>
                  <a:cubicBezTo>
                    <a:pt x="15714" y="768"/>
                    <a:pt x="19950" y="-119"/>
                    <a:pt x="22492" y="3291"/>
                  </a:cubicBezTo>
                  <a:cubicBezTo>
                    <a:pt x="23133" y="1542"/>
                    <a:pt x="24364" y="333"/>
                    <a:pt x="25785" y="59"/>
                  </a:cubicBezTo>
                  <a:cubicBezTo>
                    <a:pt x="27349" y="-243"/>
                    <a:pt x="28911" y="629"/>
                    <a:pt x="29869" y="2340"/>
                  </a:cubicBezTo>
                  <a:cubicBezTo>
                    <a:pt x="31251" y="126"/>
                    <a:pt x="33537" y="-601"/>
                    <a:pt x="35499" y="549"/>
                  </a:cubicBezTo>
                  <a:cubicBezTo>
                    <a:pt x="36994" y="1425"/>
                    <a:pt x="38066" y="3259"/>
                    <a:pt x="38354" y="5435"/>
                  </a:cubicBezTo>
                  <a:cubicBezTo>
                    <a:pt x="40082" y="6077"/>
                    <a:pt x="41458" y="7857"/>
                    <a:pt x="42018" y="10177"/>
                  </a:cubicBezTo>
                  <a:cubicBezTo>
                    <a:pt x="42425" y="11861"/>
                    <a:pt x="42367" y="13690"/>
                    <a:pt x="41854" y="15319"/>
                  </a:cubicBezTo>
                  <a:cubicBezTo>
                    <a:pt x="43115" y="17553"/>
                    <a:pt x="44463" y="22029"/>
                    <a:pt x="40699" y="23916"/>
                  </a:cubicBezTo>
                  <a:cubicBezTo>
                    <a:pt x="36935" y="25803"/>
                    <a:pt x="25379" y="26454"/>
                    <a:pt x="19268" y="26642"/>
                  </a:cubicBezTo>
                  <a:cubicBezTo>
                    <a:pt x="13157" y="26830"/>
                    <a:pt x="5355" y="26406"/>
                    <a:pt x="2149" y="25410"/>
                  </a:cubicBezTo>
                  <a:cubicBezTo>
                    <a:pt x="655" y="24213"/>
                    <a:pt x="-177" y="21916"/>
                    <a:pt x="31" y="19563"/>
                  </a:cubicBezTo>
                  <a:cubicBezTo>
                    <a:pt x="275" y="16808"/>
                    <a:pt x="1881" y="14650"/>
                    <a:pt x="3899" y="14366"/>
                  </a:cubicBezTo>
                  <a:cubicBezTo>
                    <a:pt x="3911" y="14320"/>
                    <a:pt x="3924" y="14275"/>
                    <a:pt x="3936" y="14229"/>
                  </a:cubicBezTo>
                  <a:close/>
                </a:path>
                <a:path w="43161" h="26685" fill="none" extrusionOk="0">
                  <a:moveTo>
                    <a:pt x="41834" y="15213"/>
                  </a:moveTo>
                  <a:cubicBezTo>
                    <a:pt x="41509" y="16245"/>
                    <a:pt x="41014" y="17161"/>
                    <a:pt x="40386" y="17889"/>
                  </a:cubicBezTo>
                  <a:moveTo>
                    <a:pt x="38360" y="5285"/>
                  </a:moveTo>
                  <a:cubicBezTo>
                    <a:pt x="38415" y="5702"/>
                    <a:pt x="38441" y="6125"/>
                    <a:pt x="38436" y="6549"/>
                  </a:cubicBezTo>
                  <a:moveTo>
                    <a:pt x="29114" y="3811"/>
                  </a:moveTo>
                  <a:cubicBezTo>
                    <a:pt x="29303" y="3228"/>
                    <a:pt x="29552" y="2685"/>
                    <a:pt x="29856" y="2199"/>
                  </a:cubicBezTo>
                  <a:moveTo>
                    <a:pt x="22177" y="4579"/>
                  </a:moveTo>
                  <a:cubicBezTo>
                    <a:pt x="22254" y="4097"/>
                    <a:pt x="22375" y="3630"/>
                    <a:pt x="22536" y="3189"/>
                  </a:cubicBezTo>
                  <a:moveTo>
                    <a:pt x="14036" y="5051"/>
                  </a:moveTo>
                  <a:cubicBezTo>
                    <a:pt x="14508" y="5427"/>
                    <a:pt x="14944" y="5880"/>
                    <a:pt x="15336" y="6399"/>
                  </a:cubicBezTo>
                  <a:moveTo>
                    <a:pt x="4163" y="15648"/>
                  </a:moveTo>
                  <a:cubicBezTo>
                    <a:pt x="4060" y="15184"/>
                    <a:pt x="3984" y="14710"/>
                    <a:pt x="3936" y="14229"/>
                  </a:cubicBezTo>
                </a:path>
              </a:pathLst>
            </a:cu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163" name="Cloud 162"/>
            <p:cNvSpPr/>
            <p:nvPr/>
          </p:nvSpPr>
          <p:spPr>
            <a:xfrm>
              <a:off x="2472842" y="3314741"/>
              <a:ext cx="776790" cy="270375"/>
            </a:xfrm>
            <a:custGeom>
              <a:avLst/>
              <a:gdLst>
                <a:gd name="connsiteX0" fmla="*/ 3900 w 43200"/>
                <a:gd name="connsiteY0" fmla="*/ 14370 h 43200"/>
                <a:gd name="connsiteX1" fmla="*/ 5623 w 43200"/>
                <a:gd name="connsiteY1" fmla="*/ 6907 h 43200"/>
                <a:gd name="connsiteX2" fmla="*/ 14005 w 43200"/>
                <a:gd name="connsiteY2" fmla="*/ 5202 h 43200"/>
                <a:gd name="connsiteX3" fmla="*/ 22456 w 43200"/>
                <a:gd name="connsiteY3" fmla="*/ 3432 h 43200"/>
                <a:gd name="connsiteX4" fmla="*/ 25749 w 43200"/>
                <a:gd name="connsiteY4" fmla="*/ 200 h 43200"/>
                <a:gd name="connsiteX5" fmla="*/ 29833 w 43200"/>
                <a:gd name="connsiteY5" fmla="*/ 2481 h 43200"/>
                <a:gd name="connsiteX6" fmla="*/ 35463 w 43200"/>
                <a:gd name="connsiteY6" fmla="*/ 690 h 43200"/>
                <a:gd name="connsiteX7" fmla="*/ 38318 w 43200"/>
                <a:gd name="connsiteY7" fmla="*/ 5576 h 43200"/>
                <a:gd name="connsiteX8" fmla="*/ 41982 w 43200"/>
                <a:gd name="connsiteY8" fmla="*/ 10318 h 43200"/>
                <a:gd name="connsiteX9" fmla="*/ 41818 w 43200"/>
                <a:gd name="connsiteY9" fmla="*/ 15460 h 43200"/>
                <a:gd name="connsiteX10" fmla="*/ 43016 w 43200"/>
                <a:gd name="connsiteY10" fmla="*/ 23322 h 43200"/>
                <a:gd name="connsiteX11" fmla="*/ 37404 w 43200"/>
                <a:gd name="connsiteY11" fmla="*/ 30204 h 43200"/>
                <a:gd name="connsiteX12" fmla="*/ 35395 w 43200"/>
                <a:gd name="connsiteY12" fmla="*/ 36101 h 43200"/>
                <a:gd name="connsiteX13" fmla="*/ 28555 w 43200"/>
                <a:gd name="connsiteY13" fmla="*/ 36815 h 43200"/>
                <a:gd name="connsiteX14" fmla="*/ 23667 w 43200"/>
                <a:gd name="connsiteY14" fmla="*/ 43106 h 43200"/>
                <a:gd name="connsiteX15" fmla="*/ 16480 w 43200"/>
                <a:gd name="connsiteY15" fmla="*/ 39266 h 43200"/>
                <a:gd name="connsiteX16" fmla="*/ 5804 w 43200"/>
                <a:gd name="connsiteY16" fmla="*/ 35472 h 43200"/>
                <a:gd name="connsiteX17" fmla="*/ 1110 w 43200"/>
                <a:gd name="connsiteY17" fmla="*/ 31250 h 43200"/>
                <a:gd name="connsiteX18" fmla="*/ 2113 w 43200"/>
                <a:gd name="connsiteY18" fmla="*/ 25551 h 43200"/>
                <a:gd name="connsiteX19" fmla="*/ -5 w 43200"/>
                <a:gd name="connsiteY19" fmla="*/ 19704 h 43200"/>
                <a:gd name="connsiteX20" fmla="*/ 3863 w 43200"/>
                <a:gd name="connsiteY20" fmla="*/ 14507 h 43200"/>
                <a:gd name="connsiteX21" fmla="*/ 3900 w 43200"/>
                <a:gd name="connsiteY21" fmla="*/ 14370 h 43200"/>
                <a:gd name="connsiteX0" fmla="*/ 4693 w 43200"/>
                <a:gd name="connsiteY0" fmla="*/ 26177 h 43200"/>
                <a:gd name="connsiteX1" fmla="*/ 2160 w 43200"/>
                <a:gd name="connsiteY1" fmla="*/ 25380 h 43200"/>
                <a:gd name="connsiteX2" fmla="*/ 6928 w 43200"/>
                <a:gd name="connsiteY2" fmla="*/ 34899 h 43200"/>
                <a:gd name="connsiteX3" fmla="*/ 5820 w 43200"/>
                <a:gd name="connsiteY3" fmla="*/ 35280 h 43200"/>
                <a:gd name="connsiteX4" fmla="*/ 16478 w 43200"/>
                <a:gd name="connsiteY4" fmla="*/ 39090 h 43200"/>
                <a:gd name="connsiteX5" fmla="*/ 15810 w 43200"/>
                <a:gd name="connsiteY5" fmla="*/ 37350 h 43200"/>
                <a:gd name="connsiteX6" fmla="*/ 28827 w 43200"/>
                <a:gd name="connsiteY6" fmla="*/ 34751 h 43200"/>
                <a:gd name="connsiteX7" fmla="*/ 28560 w 43200"/>
                <a:gd name="connsiteY7" fmla="*/ 36660 h 43200"/>
                <a:gd name="connsiteX8" fmla="*/ 34129 w 43200"/>
                <a:gd name="connsiteY8" fmla="*/ 22954 h 43200"/>
                <a:gd name="connsiteX9" fmla="*/ 37380 w 43200"/>
                <a:gd name="connsiteY9" fmla="*/ 30090 h 43200"/>
                <a:gd name="connsiteX10" fmla="*/ 41798 w 43200"/>
                <a:gd name="connsiteY10" fmla="*/ 15354 h 43200"/>
                <a:gd name="connsiteX11" fmla="*/ 40350 w 43200"/>
                <a:gd name="connsiteY11" fmla="*/ 18030 h 43200"/>
                <a:gd name="connsiteX12" fmla="*/ 38324 w 43200"/>
                <a:gd name="connsiteY12" fmla="*/ 5426 h 43200"/>
                <a:gd name="connsiteX13" fmla="*/ 38400 w 43200"/>
                <a:gd name="connsiteY13" fmla="*/ 6690 h 43200"/>
                <a:gd name="connsiteX14" fmla="*/ 29078 w 43200"/>
                <a:gd name="connsiteY14" fmla="*/ 3952 h 43200"/>
                <a:gd name="connsiteX15" fmla="*/ 29820 w 43200"/>
                <a:gd name="connsiteY15" fmla="*/ 2340 h 43200"/>
                <a:gd name="connsiteX16" fmla="*/ 22141 w 43200"/>
                <a:gd name="connsiteY16" fmla="*/ 4720 h 43200"/>
                <a:gd name="connsiteX17" fmla="*/ 22500 w 43200"/>
                <a:gd name="connsiteY17" fmla="*/ 3330 h 43200"/>
                <a:gd name="connsiteX18" fmla="*/ 14000 w 43200"/>
                <a:gd name="connsiteY18" fmla="*/ 5192 h 43200"/>
                <a:gd name="connsiteX19" fmla="*/ 15300 w 43200"/>
                <a:gd name="connsiteY19" fmla="*/ 6540 h 43200"/>
                <a:gd name="connsiteX20" fmla="*/ 4127 w 43200"/>
                <a:gd name="connsiteY20" fmla="*/ 15789 h 43200"/>
                <a:gd name="connsiteX21" fmla="*/ 3900 w 43200"/>
                <a:gd name="connsiteY21" fmla="*/ 14370 h 43200"/>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16514 w 43256"/>
                <a:gd name="connsiteY2" fmla="*/ 38949 h 43219"/>
                <a:gd name="connsiteX3" fmla="*/ 15846 w 43256"/>
                <a:gd name="connsiteY3" fmla="*/ 37209 h 43219"/>
                <a:gd name="connsiteX4" fmla="*/ 28863 w 43256"/>
                <a:gd name="connsiteY4" fmla="*/ 34610 h 43219"/>
                <a:gd name="connsiteX5" fmla="*/ 28596 w 43256"/>
                <a:gd name="connsiteY5" fmla="*/ 36519 h 43219"/>
                <a:gd name="connsiteX6" fmla="*/ 34165 w 43256"/>
                <a:gd name="connsiteY6" fmla="*/ 22813 h 43219"/>
                <a:gd name="connsiteX7" fmla="*/ 37416 w 43256"/>
                <a:gd name="connsiteY7" fmla="*/ 29949 h 43219"/>
                <a:gd name="connsiteX8" fmla="*/ 41834 w 43256"/>
                <a:gd name="connsiteY8" fmla="*/ 15213 h 43219"/>
                <a:gd name="connsiteX9" fmla="*/ 40386 w 43256"/>
                <a:gd name="connsiteY9" fmla="*/ 17889 h 43219"/>
                <a:gd name="connsiteX10" fmla="*/ 38360 w 43256"/>
                <a:gd name="connsiteY10" fmla="*/ 5285 h 43219"/>
                <a:gd name="connsiteX11" fmla="*/ 38436 w 43256"/>
                <a:gd name="connsiteY11" fmla="*/ 6549 h 43219"/>
                <a:gd name="connsiteX12" fmla="*/ 29114 w 43256"/>
                <a:gd name="connsiteY12" fmla="*/ 3811 h 43219"/>
                <a:gd name="connsiteX13" fmla="*/ 29856 w 43256"/>
                <a:gd name="connsiteY13" fmla="*/ 2199 h 43219"/>
                <a:gd name="connsiteX14" fmla="*/ 22177 w 43256"/>
                <a:gd name="connsiteY14" fmla="*/ 4579 h 43219"/>
                <a:gd name="connsiteX15" fmla="*/ 22536 w 43256"/>
                <a:gd name="connsiteY15" fmla="*/ 3189 h 43219"/>
                <a:gd name="connsiteX16" fmla="*/ 14036 w 43256"/>
                <a:gd name="connsiteY16" fmla="*/ 5051 h 43219"/>
                <a:gd name="connsiteX17" fmla="*/ 15336 w 43256"/>
                <a:gd name="connsiteY17" fmla="*/ 6399 h 43219"/>
                <a:gd name="connsiteX18" fmla="*/ 4163 w 43256"/>
                <a:gd name="connsiteY18" fmla="*/ 15648 h 43219"/>
                <a:gd name="connsiteX19" fmla="*/ 3936 w 43256"/>
                <a:gd name="connsiteY19"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16514 w 43256"/>
                <a:gd name="connsiteY0" fmla="*/ 38949 h 43219"/>
                <a:gd name="connsiteX1" fmla="*/ 15846 w 43256"/>
                <a:gd name="connsiteY1" fmla="*/ 37209 h 43219"/>
                <a:gd name="connsiteX2" fmla="*/ 28863 w 43256"/>
                <a:gd name="connsiteY2" fmla="*/ 34610 h 43219"/>
                <a:gd name="connsiteX3" fmla="*/ 28596 w 43256"/>
                <a:gd name="connsiteY3" fmla="*/ 36519 h 43219"/>
                <a:gd name="connsiteX4" fmla="*/ 34165 w 43256"/>
                <a:gd name="connsiteY4" fmla="*/ 22813 h 43219"/>
                <a:gd name="connsiteX5" fmla="*/ 37416 w 43256"/>
                <a:gd name="connsiteY5" fmla="*/ 29949 h 43219"/>
                <a:gd name="connsiteX6" fmla="*/ 41834 w 43256"/>
                <a:gd name="connsiteY6" fmla="*/ 15213 h 43219"/>
                <a:gd name="connsiteX7" fmla="*/ 40386 w 43256"/>
                <a:gd name="connsiteY7" fmla="*/ 17889 h 43219"/>
                <a:gd name="connsiteX8" fmla="*/ 38360 w 43256"/>
                <a:gd name="connsiteY8" fmla="*/ 5285 h 43219"/>
                <a:gd name="connsiteX9" fmla="*/ 38436 w 43256"/>
                <a:gd name="connsiteY9" fmla="*/ 6549 h 43219"/>
                <a:gd name="connsiteX10" fmla="*/ 29114 w 43256"/>
                <a:gd name="connsiteY10" fmla="*/ 3811 h 43219"/>
                <a:gd name="connsiteX11" fmla="*/ 29856 w 43256"/>
                <a:gd name="connsiteY11" fmla="*/ 2199 h 43219"/>
                <a:gd name="connsiteX12" fmla="*/ 22177 w 43256"/>
                <a:gd name="connsiteY12" fmla="*/ 4579 h 43219"/>
                <a:gd name="connsiteX13" fmla="*/ 22536 w 43256"/>
                <a:gd name="connsiteY13" fmla="*/ 3189 h 43219"/>
                <a:gd name="connsiteX14" fmla="*/ 14036 w 43256"/>
                <a:gd name="connsiteY14" fmla="*/ 5051 h 43219"/>
                <a:gd name="connsiteX15" fmla="*/ 15336 w 43256"/>
                <a:gd name="connsiteY15" fmla="*/ 6399 h 43219"/>
                <a:gd name="connsiteX16" fmla="*/ 4163 w 43256"/>
                <a:gd name="connsiteY16" fmla="*/ 15648 h 43219"/>
                <a:gd name="connsiteX17" fmla="*/ 3936 w 43256"/>
                <a:gd name="connsiteY17" fmla="*/ 14229 h 43219"/>
                <a:gd name="connsiteX0" fmla="*/ 4061 w 43381"/>
                <a:gd name="connsiteY0" fmla="*/ 14229 h 43219"/>
                <a:gd name="connsiteX1" fmla="*/ 5784 w 43381"/>
                <a:gd name="connsiteY1" fmla="*/ 6766 h 43219"/>
                <a:gd name="connsiteX2" fmla="*/ 14166 w 43381"/>
                <a:gd name="connsiteY2" fmla="*/ 5061 h 43219"/>
                <a:gd name="connsiteX3" fmla="*/ 22617 w 43381"/>
                <a:gd name="connsiteY3" fmla="*/ 3291 h 43219"/>
                <a:gd name="connsiteX4" fmla="*/ 25910 w 43381"/>
                <a:gd name="connsiteY4" fmla="*/ 59 h 43219"/>
                <a:gd name="connsiteX5" fmla="*/ 29994 w 43381"/>
                <a:gd name="connsiteY5" fmla="*/ 2340 h 43219"/>
                <a:gd name="connsiteX6" fmla="*/ 35624 w 43381"/>
                <a:gd name="connsiteY6" fmla="*/ 549 h 43219"/>
                <a:gd name="connsiteX7" fmla="*/ 38479 w 43381"/>
                <a:gd name="connsiteY7" fmla="*/ 5435 h 43219"/>
                <a:gd name="connsiteX8" fmla="*/ 42143 w 43381"/>
                <a:gd name="connsiteY8" fmla="*/ 10177 h 43219"/>
                <a:gd name="connsiteX9" fmla="*/ 41979 w 43381"/>
                <a:gd name="connsiteY9" fmla="*/ 15319 h 43219"/>
                <a:gd name="connsiteX10" fmla="*/ 43177 w 43381"/>
                <a:gd name="connsiteY10" fmla="*/ 23181 h 43219"/>
                <a:gd name="connsiteX11" fmla="*/ 37565 w 43381"/>
                <a:gd name="connsiteY11" fmla="*/ 30063 h 43219"/>
                <a:gd name="connsiteX12" fmla="*/ 35556 w 43381"/>
                <a:gd name="connsiteY12" fmla="*/ 35960 h 43219"/>
                <a:gd name="connsiteX13" fmla="*/ 28716 w 43381"/>
                <a:gd name="connsiteY13" fmla="*/ 36674 h 43219"/>
                <a:gd name="connsiteX14" fmla="*/ 23828 w 43381"/>
                <a:gd name="connsiteY14" fmla="*/ 42965 h 43219"/>
                <a:gd name="connsiteX15" fmla="*/ 16641 w 43381"/>
                <a:gd name="connsiteY15" fmla="*/ 39125 h 43219"/>
                <a:gd name="connsiteX16" fmla="*/ 5965 w 43381"/>
                <a:gd name="connsiteY16" fmla="*/ 35331 h 43219"/>
                <a:gd name="connsiteX17" fmla="*/ 1271 w 43381"/>
                <a:gd name="connsiteY17" fmla="*/ 31109 h 43219"/>
                <a:gd name="connsiteX18" fmla="*/ 156 w 43381"/>
                <a:gd name="connsiteY18" fmla="*/ 19563 h 43219"/>
                <a:gd name="connsiteX19" fmla="*/ 4024 w 43381"/>
                <a:gd name="connsiteY19" fmla="*/ 14366 h 43219"/>
                <a:gd name="connsiteX20" fmla="*/ 4061 w 43381"/>
                <a:gd name="connsiteY20" fmla="*/ 14229 h 43219"/>
                <a:gd name="connsiteX0" fmla="*/ 16639 w 43381"/>
                <a:gd name="connsiteY0" fmla="*/ 38949 h 43219"/>
                <a:gd name="connsiteX1" fmla="*/ 15971 w 43381"/>
                <a:gd name="connsiteY1" fmla="*/ 37209 h 43219"/>
                <a:gd name="connsiteX2" fmla="*/ 28988 w 43381"/>
                <a:gd name="connsiteY2" fmla="*/ 34610 h 43219"/>
                <a:gd name="connsiteX3" fmla="*/ 28721 w 43381"/>
                <a:gd name="connsiteY3" fmla="*/ 36519 h 43219"/>
                <a:gd name="connsiteX4" fmla="*/ 34290 w 43381"/>
                <a:gd name="connsiteY4" fmla="*/ 22813 h 43219"/>
                <a:gd name="connsiteX5" fmla="*/ 37541 w 43381"/>
                <a:gd name="connsiteY5" fmla="*/ 29949 h 43219"/>
                <a:gd name="connsiteX6" fmla="*/ 41959 w 43381"/>
                <a:gd name="connsiteY6" fmla="*/ 15213 h 43219"/>
                <a:gd name="connsiteX7" fmla="*/ 40511 w 43381"/>
                <a:gd name="connsiteY7" fmla="*/ 17889 h 43219"/>
                <a:gd name="connsiteX8" fmla="*/ 38485 w 43381"/>
                <a:gd name="connsiteY8" fmla="*/ 5285 h 43219"/>
                <a:gd name="connsiteX9" fmla="*/ 38561 w 43381"/>
                <a:gd name="connsiteY9" fmla="*/ 6549 h 43219"/>
                <a:gd name="connsiteX10" fmla="*/ 29239 w 43381"/>
                <a:gd name="connsiteY10" fmla="*/ 3811 h 43219"/>
                <a:gd name="connsiteX11" fmla="*/ 29981 w 43381"/>
                <a:gd name="connsiteY11" fmla="*/ 2199 h 43219"/>
                <a:gd name="connsiteX12" fmla="*/ 22302 w 43381"/>
                <a:gd name="connsiteY12" fmla="*/ 4579 h 43219"/>
                <a:gd name="connsiteX13" fmla="*/ 22661 w 43381"/>
                <a:gd name="connsiteY13" fmla="*/ 3189 h 43219"/>
                <a:gd name="connsiteX14" fmla="*/ 14161 w 43381"/>
                <a:gd name="connsiteY14" fmla="*/ 5051 h 43219"/>
                <a:gd name="connsiteX15" fmla="*/ 15461 w 43381"/>
                <a:gd name="connsiteY15" fmla="*/ 6399 h 43219"/>
                <a:gd name="connsiteX16" fmla="*/ 4288 w 43381"/>
                <a:gd name="connsiteY16" fmla="*/ 15648 h 43219"/>
                <a:gd name="connsiteX17" fmla="*/ 4061 w 43381"/>
                <a:gd name="connsiteY17" fmla="*/ 14229 h 43219"/>
                <a:gd name="connsiteX0" fmla="*/ 4061 w 43381"/>
                <a:gd name="connsiteY0" fmla="*/ 14229 h 40633"/>
                <a:gd name="connsiteX1" fmla="*/ 5784 w 43381"/>
                <a:gd name="connsiteY1" fmla="*/ 6766 h 40633"/>
                <a:gd name="connsiteX2" fmla="*/ 14166 w 43381"/>
                <a:gd name="connsiteY2" fmla="*/ 5061 h 40633"/>
                <a:gd name="connsiteX3" fmla="*/ 22617 w 43381"/>
                <a:gd name="connsiteY3" fmla="*/ 3291 h 40633"/>
                <a:gd name="connsiteX4" fmla="*/ 25910 w 43381"/>
                <a:gd name="connsiteY4" fmla="*/ 59 h 40633"/>
                <a:gd name="connsiteX5" fmla="*/ 29994 w 43381"/>
                <a:gd name="connsiteY5" fmla="*/ 2340 h 40633"/>
                <a:gd name="connsiteX6" fmla="*/ 35624 w 43381"/>
                <a:gd name="connsiteY6" fmla="*/ 549 h 40633"/>
                <a:gd name="connsiteX7" fmla="*/ 38479 w 43381"/>
                <a:gd name="connsiteY7" fmla="*/ 5435 h 40633"/>
                <a:gd name="connsiteX8" fmla="*/ 42143 w 43381"/>
                <a:gd name="connsiteY8" fmla="*/ 10177 h 40633"/>
                <a:gd name="connsiteX9" fmla="*/ 41979 w 43381"/>
                <a:gd name="connsiteY9" fmla="*/ 15319 h 40633"/>
                <a:gd name="connsiteX10" fmla="*/ 43177 w 43381"/>
                <a:gd name="connsiteY10" fmla="*/ 23181 h 40633"/>
                <a:gd name="connsiteX11" fmla="*/ 37565 w 43381"/>
                <a:gd name="connsiteY11" fmla="*/ 30063 h 40633"/>
                <a:gd name="connsiteX12" fmla="*/ 35556 w 43381"/>
                <a:gd name="connsiteY12" fmla="*/ 35960 h 40633"/>
                <a:gd name="connsiteX13" fmla="*/ 28716 w 43381"/>
                <a:gd name="connsiteY13" fmla="*/ 36674 h 40633"/>
                <a:gd name="connsiteX14" fmla="*/ 16641 w 43381"/>
                <a:gd name="connsiteY14" fmla="*/ 39125 h 40633"/>
                <a:gd name="connsiteX15" fmla="*/ 5965 w 43381"/>
                <a:gd name="connsiteY15" fmla="*/ 35331 h 40633"/>
                <a:gd name="connsiteX16" fmla="*/ 1271 w 43381"/>
                <a:gd name="connsiteY16" fmla="*/ 31109 h 40633"/>
                <a:gd name="connsiteX17" fmla="*/ 156 w 43381"/>
                <a:gd name="connsiteY17" fmla="*/ 19563 h 40633"/>
                <a:gd name="connsiteX18" fmla="*/ 4024 w 43381"/>
                <a:gd name="connsiteY18" fmla="*/ 14366 h 40633"/>
                <a:gd name="connsiteX19" fmla="*/ 4061 w 43381"/>
                <a:gd name="connsiteY19" fmla="*/ 14229 h 40633"/>
                <a:gd name="connsiteX0" fmla="*/ 16639 w 43381"/>
                <a:gd name="connsiteY0" fmla="*/ 38949 h 40633"/>
                <a:gd name="connsiteX1" fmla="*/ 15971 w 43381"/>
                <a:gd name="connsiteY1" fmla="*/ 37209 h 40633"/>
                <a:gd name="connsiteX2" fmla="*/ 28988 w 43381"/>
                <a:gd name="connsiteY2" fmla="*/ 34610 h 40633"/>
                <a:gd name="connsiteX3" fmla="*/ 28721 w 43381"/>
                <a:gd name="connsiteY3" fmla="*/ 36519 h 40633"/>
                <a:gd name="connsiteX4" fmla="*/ 34290 w 43381"/>
                <a:gd name="connsiteY4" fmla="*/ 22813 h 40633"/>
                <a:gd name="connsiteX5" fmla="*/ 37541 w 43381"/>
                <a:gd name="connsiteY5" fmla="*/ 29949 h 40633"/>
                <a:gd name="connsiteX6" fmla="*/ 41959 w 43381"/>
                <a:gd name="connsiteY6" fmla="*/ 15213 h 40633"/>
                <a:gd name="connsiteX7" fmla="*/ 40511 w 43381"/>
                <a:gd name="connsiteY7" fmla="*/ 17889 h 40633"/>
                <a:gd name="connsiteX8" fmla="*/ 38485 w 43381"/>
                <a:gd name="connsiteY8" fmla="*/ 5285 h 40633"/>
                <a:gd name="connsiteX9" fmla="*/ 38561 w 43381"/>
                <a:gd name="connsiteY9" fmla="*/ 6549 h 40633"/>
                <a:gd name="connsiteX10" fmla="*/ 29239 w 43381"/>
                <a:gd name="connsiteY10" fmla="*/ 3811 h 40633"/>
                <a:gd name="connsiteX11" fmla="*/ 29981 w 43381"/>
                <a:gd name="connsiteY11" fmla="*/ 2199 h 40633"/>
                <a:gd name="connsiteX12" fmla="*/ 22302 w 43381"/>
                <a:gd name="connsiteY12" fmla="*/ 4579 h 40633"/>
                <a:gd name="connsiteX13" fmla="*/ 22661 w 43381"/>
                <a:gd name="connsiteY13" fmla="*/ 3189 h 40633"/>
                <a:gd name="connsiteX14" fmla="*/ 14161 w 43381"/>
                <a:gd name="connsiteY14" fmla="*/ 5051 h 40633"/>
                <a:gd name="connsiteX15" fmla="*/ 15461 w 43381"/>
                <a:gd name="connsiteY15" fmla="*/ 6399 h 40633"/>
                <a:gd name="connsiteX16" fmla="*/ 4288 w 43381"/>
                <a:gd name="connsiteY16" fmla="*/ 15648 h 40633"/>
                <a:gd name="connsiteX17" fmla="*/ 4061 w 43381"/>
                <a:gd name="connsiteY17" fmla="*/ 14229 h 40633"/>
                <a:gd name="connsiteX0" fmla="*/ 4061 w 43381"/>
                <a:gd name="connsiteY0" fmla="*/ 14229 h 40633"/>
                <a:gd name="connsiteX1" fmla="*/ 5784 w 43381"/>
                <a:gd name="connsiteY1" fmla="*/ 6766 h 40633"/>
                <a:gd name="connsiteX2" fmla="*/ 14166 w 43381"/>
                <a:gd name="connsiteY2" fmla="*/ 5061 h 40633"/>
                <a:gd name="connsiteX3" fmla="*/ 22617 w 43381"/>
                <a:gd name="connsiteY3" fmla="*/ 3291 h 40633"/>
                <a:gd name="connsiteX4" fmla="*/ 25910 w 43381"/>
                <a:gd name="connsiteY4" fmla="*/ 59 h 40633"/>
                <a:gd name="connsiteX5" fmla="*/ 29994 w 43381"/>
                <a:gd name="connsiteY5" fmla="*/ 2340 h 40633"/>
                <a:gd name="connsiteX6" fmla="*/ 35624 w 43381"/>
                <a:gd name="connsiteY6" fmla="*/ 549 h 40633"/>
                <a:gd name="connsiteX7" fmla="*/ 38479 w 43381"/>
                <a:gd name="connsiteY7" fmla="*/ 5435 h 40633"/>
                <a:gd name="connsiteX8" fmla="*/ 42143 w 43381"/>
                <a:gd name="connsiteY8" fmla="*/ 10177 h 40633"/>
                <a:gd name="connsiteX9" fmla="*/ 41979 w 43381"/>
                <a:gd name="connsiteY9" fmla="*/ 15319 h 40633"/>
                <a:gd name="connsiteX10" fmla="*/ 43177 w 43381"/>
                <a:gd name="connsiteY10" fmla="*/ 23181 h 40633"/>
                <a:gd name="connsiteX11" fmla="*/ 37565 w 43381"/>
                <a:gd name="connsiteY11" fmla="*/ 30063 h 40633"/>
                <a:gd name="connsiteX12" fmla="*/ 35556 w 43381"/>
                <a:gd name="connsiteY12" fmla="*/ 35960 h 40633"/>
                <a:gd name="connsiteX13" fmla="*/ 28716 w 43381"/>
                <a:gd name="connsiteY13" fmla="*/ 36674 h 40633"/>
                <a:gd name="connsiteX14" fmla="*/ 16641 w 43381"/>
                <a:gd name="connsiteY14" fmla="*/ 39125 h 40633"/>
                <a:gd name="connsiteX15" fmla="*/ 5965 w 43381"/>
                <a:gd name="connsiteY15" fmla="*/ 35331 h 40633"/>
                <a:gd name="connsiteX16" fmla="*/ 1271 w 43381"/>
                <a:gd name="connsiteY16" fmla="*/ 31109 h 40633"/>
                <a:gd name="connsiteX17" fmla="*/ 156 w 43381"/>
                <a:gd name="connsiteY17" fmla="*/ 19563 h 40633"/>
                <a:gd name="connsiteX18" fmla="*/ 4024 w 43381"/>
                <a:gd name="connsiteY18" fmla="*/ 14366 h 40633"/>
                <a:gd name="connsiteX19" fmla="*/ 4061 w 43381"/>
                <a:gd name="connsiteY19" fmla="*/ 14229 h 40633"/>
                <a:gd name="connsiteX0" fmla="*/ 28988 w 43381"/>
                <a:gd name="connsiteY0" fmla="*/ 34610 h 40633"/>
                <a:gd name="connsiteX1" fmla="*/ 28721 w 43381"/>
                <a:gd name="connsiteY1" fmla="*/ 36519 h 40633"/>
                <a:gd name="connsiteX2" fmla="*/ 34290 w 43381"/>
                <a:gd name="connsiteY2" fmla="*/ 22813 h 40633"/>
                <a:gd name="connsiteX3" fmla="*/ 37541 w 43381"/>
                <a:gd name="connsiteY3" fmla="*/ 29949 h 40633"/>
                <a:gd name="connsiteX4" fmla="*/ 41959 w 43381"/>
                <a:gd name="connsiteY4" fmla="*/ 15213 h 40633"/>
                <a:gd name="connsiteX5" fmla="*/ 40511 w 43381"/>
                <a:gd name="connsiteY5" fmla="*/ 17889 h 40633"/>
                <a:gd name="connsiteX6" fmla="*/ 38485 w 43381"/>
                <a:gd name="connsiteY6" fmla="*/ 5285 h 40633"/>
                <a:gd name="connsiteX7" fmla="*/ 38561 w 43381"/>
                <a:gd name="connsiteY7" fmla="*/ 6549 h 40633"/>
                <a:gd name="connsiteX8" fmla="*/ 29239 w 43381"/>
                <a:gd name="connsiteY8" fmla="*/ 3811 h 40633"/>
                <a:gd name="connsiteX9" fmla="*/ 29981 w 43381"/>
                <a:gd name="connsiteY9" fmla="*/ 2199 h 40633"/>
                <a:gd name="connsiteX10" fmla="*/ 22302 w 43381"/>
                <a:gd name="connsiteY10" fmla="*/ 4579 h 40633"/>
                <a:gd name="connsiteX11" fmla="*/ 22661 w 43381"/>
                <a:gd name="connsiteY11" fmla="*/ 3189 h 40633"/>
                <a:gd name="connsiteX12" fmla="*/ 14161 w 43381"/>
                <a:gd name="connsiteY12" fmla="*/ 5051 h 40633"/>
                <a:gd name="connsiteX13" fmla="*/ 15461 w 43381"/>
                <a:gd name="connsiteY13" fmla="*/ 6399 h 40633"/>
                <a:gd name="connsiteX14" fmla="*/ 4288 w 43381"/>
                <a:gd name="connsiteY14" fmla="*/ 15648 h 40633"/>
                <a:gd name="connsiteX15" fmla="*/ 4061 w 43381"/>
                <a:gd name="connsiteY15" fmla="*/ 14229 h 40633"/>
                <a:gd name="connsiteX0" fmla="*/ 4550 w 43870"/>
                <a:gd name="connsiteY0" fmla="*/ 14229 h 39141"/>
                <a:gd name="connsiteX1" fmla="*/ 6273 w 43870"/>
                <a:gd name="connsiteY1" fmla="*/ 6766 h 39141"/>
                <a:gd name="connsiteX2" fmla="*/ 14655 w 43870"/>
                <a:gd name="connsiteY2" fmla="*/ 5061 h 39141"/>
                <a:gd name="connsiteX3" fmla="*/ 23106 w 43870"/>
                <a:gd name="connsiteY3" fmla="*/ 3291 h 39141"/>
                <a:gd name="connsiteX4" fmla="*/ 26399 w 43870"/>
                <a:gd name="connsiteY4" fmla="*/ 59 h 39141"/>
                <a:gd name="connsiteX5" fmla="*/ 30483 w 43870"/>
                <a:gd name="connsiteY5" fmla="*/ 2340 h 39141"/>
                <a:gd name="connsiteX6" fmla="*/ 36113 w 43870"/>
                <a:gd name="connsiteY6" fmla="*/ 549 h 39141"/>
                <a:gd name="connsiteX7" fmla="*/ 38968 w 43870"/>
                <a:gd name="connsiteY7" fmla="*/ 5435 h 39141"/>
                <a:gd name="connsiteX8" fmla="*/ 42632 w 43870"/>
                <a:gd name="connsiteY8" fmla="*/ 10177 h 39141"/>
                <a:gd name="connsiteX9" fmla="*/ 42468 w 43870"/>
                <a:gd name="connsiteY9" fmla="*/ 15319 h 39141"/>
                <a:gd name="connsiteX10" fmla="*/ 43666 w 43870"/>
                <a:gd name="connsiteY10" fmla="*/ 23181 h 39141"/>
                <a:gd name="connsiteX11" fmla="*/ 38054 w 43870"/>
                <a:gd name="connsiteY11" fmla="*/ 30063 h 39141"/>
                <a:gd name="connsiteX12" fmla="*/ 36045 w 43870"/>
                <a:gd name="connsiteY12" fmla="*/ 35960 h 39141"/>
                <a:gd name="connsiteX13" fmla="*/ 29205 w 43870"/>
                <a:gd name="connsiteY13" fmla="*/ 36674 h 39141"/>
                <a:gd name="connsiteX14" fmla="*/ 17130 w 43870"/>
                <a:gd name="connsiteY14" fmla="*/ 39125 h 39141"/>
                <a:gd name="connsiteX15" fmla="*/ 1760 w 43870"/>
                <a:gd name="connsiteY15" fmla="*/ 31109 h 39141"/>
                <a:gd name="connsiteX16" fmla="*/ 645 w 43870"/>
                <a:gd name="connsiteY16" fmla="*/ 19563 h 39141"/>
                <a:gd name="connsiteX17" fmla="*/ 4513 w 43870"/>
                <a:gd name="connsiteY17" fmla="*/ 14366 h 39141"/>
                <a:gd name="connsiteX18" fmla="*/ 4550 w 43870"/>
                <a:gd name="connsiteY18" fmla="*/ 14229 h 39141"/>
                <a:gd name="connsiteX0" fmla="*/ 29477 w 43870"/>
                <a:gd name="connsiteY0" fmla="*/ 34610 h 39141"/>
                <a:gd name="connsiteX1" fmla="*/ 29210 w 43870"/>
                <a:gd name="connsiteY1" fmla="*/ 36519 h 39141"/>
                <a:gd name="connsiteX2" fmla="*/ 34779 w 43870"/>
                <a:gd name="connsiteY2" fmla="*/ 22813 h 39141"/>
                <a:gd name="connsiteX3" fmla="*/ 38030 w 43870"/>
                <a:gd name="connsiteY3" fmla="*/ 29949 h 39141"/>
                <a:gd name="connsiteX4" fmla="*/ 42448 w 43870"/>
                <a:gd name="connsiteY4" fmla="*/ 15213 h 39141"/>
                <a:gd name="connsiteX5" fmla="*/ 41000 w 43870"/>
                <a:gd name="connsiteY5" fmla="*/ 17889 h 39141"/>
                <a:gd name="connsiteX6" fmla="*/ 38974 w 43870"/>
                <a:gd name="connsiteY6" fmla="*/ 5285 h 39141"/>
                <a:gd name="connsiteX7" fmla="*/ 39050 w 43870"/>
                <a:gd name="connsiteY7" fmla="*/ 6549 h 39141"/>
                <a:gd name="connsiteX8" fmla="*/ 29728 w 43870"/>
                <a:gd name="connsiteY8" fmla="*/ 3811 h 39141"/>
                <a:gd name="connsiteX9" fmla="*/ 30470 w 43870"/>
                <a:gd name="connsiteY9" fmla="*/ 2199 h 39141"/>
                <a:gd name="connsiteX10" fmla="*/ 22791 w 43870"/>
                <a:gd name="connsiteY10" fmla="*/ 4579 h 39141"/>
                <a:gd name="connsiteX11" fmla="*/ 23150 w 43870"/>
                <a:gd name="connsiteY11" fmla="*/ 3189 h 39141"/>
                <a:gd name="connsiteX12" fmla="*/ 14650 w 43870"/>
                <a:gd name="connsiteY12" fmla="*/ 5051 h 39141"/>
                <a:gd name="connsiteX13" fmla="*/ 15950 w 43870"/>
                <a:gd name="connsiteY13" fmla="*/ 6399 h 39141"/>
                <a:gd name="connsiteX14" fmla="*/ 4777 w 43870"/>
                <a:gd name="connsiteY14" fmla="*/ 15648 h 39141"/>
                <a:gd name="connsiteX15" fmla="*/ 4550 w 43870"/>
                <a:gd name="connsiteY15" fmla="*/ 14229 h 39141"/>
                <a:gd name="connsiteX0" fmla="*/ 3905 w 43225"/>
                <a:gd name="connsiteY0" fmla="*/ 14229 h 39141"/>
                <a:gd name="connsiteX1" fmla="*/ 5628 w 43225"/>
                <a:gd name="connsiteY1" fmla="*/ 6766 h 39141"/>
                <a:gd name="connsiteX2" fmla="*/ 14010 w 43225"/>
                <a:gd name="connsiteY2" fmla="*/ 5061 h 39141"/>
                <a:gd name="connsiteX3" fmla="*/ 22461 w 43225"/>
                <a:gd name="connsiteY3" fmla="*/ 3291 h 39141"/>
                <a:gd name="connsiteX4" fmla="*/ 25754 w 43225"/>
                <a:gd name="connsiteY4" fmla="*/ 59 h 39141"/>
                <a:gd name="connsiteX5" fmla="*/ 29838 w 43225"/>
                <a:gd name="connsiteY5" fmla="*/ 2340 h 39141"/>
                <a:gd name="connsiteX6" fmla="*/ 35468 w 43225"/>
                <a:gd name="connsiteY6" fmla="*/ 549 h 39141"/>
                <a:gd name="connsiteX7" fmla="*/ 38323 w 43225"/>
                <a:gd name="connsiteY7" fmla="*/ 5435 h 39141"/>
                <a:gd name="connsiteX8" fmla="*/ 41987 w 43225"/>
                <a:gd name="connsiteY8" fmla="*/ 10177 h 39141"/>
                <a:gd name="connsiteX9" fmla="*/ 41823 w 43225"/>
                <a:gd name="connsiteY9" fmla="*/ 15319 h 39141"/>
                <a:gd name="connsiteX10" fmla="*/ 43021 w 43225"/>
                <a:gd name="connsiteY10" fmla="*/ 23181 h 39141"/>
                <a:gd name="connsiteX11" fmla="*/ 37409 w 43225"/>
                <a:gd name="connsiteY11" fmla="*/ 30063 h 39141"/>
                <a:gd name="connsiteX12" fmla="*/ 35400 w 43225"/>
                <a:gd name="connsiteY12" fmla="*/ 35960 h 39141"/>
                <a:gd name="connsiteX13" fmla="*/ 28560 w 43225"/>
                <a:gd name="connsiteY13" fmla="*/ 36674 h 39141"/>
                <a:gd name="connsiteX14" fmla="*/ 16485 w 43225"/>
                <a:gd name="connsiteY14" fmla="*/ 39125 h 39141"/>
                <a:gd name="connsiteX15" fmla="*/ 0 w 43225"/>
                <a:gd name="connsiteY15" fmla="*/ 19563 h 39141"/>
                <a:gd name="connsiteX16" fmla="*/ 3868 w 43225"/>
                <a:gd name="connsiteY16" fmla="*/ 14366 h 39141"/>
                <a:gd name="connsiteX17" fmla="*/ 3905 w 43225"/>
                <a:gd name="connsiteY17" fmla="*/ 14229 h 39141"/>
                <a:gd name="connsiteX0" fmla="*/ 28832 w 43225"/>
                <a:gd name="connsiteY0" fmla="*/ 34610 h 39141"/>
                <a:gd name="connsiteX1" fmla="*/ 28565 w 43225"/>
                <a:gd name="connsiteY1" fmla="*/ 36519 h 39141"/>
                <a:gd name="connsiteX2" fmla="*/ 34134 w 43225"/>
                <a:gd name="connsiteY2" fmla="*/ 22813 h 39141"/>
                <a:gd name="connsiteX3" fmla="*/ 37385 w 43225"/>
                <a:gd name="connsiteY3" fmla="*/ 29949 h 39141"/>
                <a:gd name="connsiteX4" fmla="*/ 41803 w 43225"/>
                <a:gd name="connsiteY4" fmla="*/ 15213 h 39141"/>
                <a:gd name="connsiteX5" fmla="*/ 40355 w 43225"/>
                <a:gd name="connsiteY5" fmla="*/ 17889 h 39141"/>
                <a:gd name="connsiteX6" fmla="*/ 38329 w 43225"/>
                <a:gd name="connsiteY6" fmla="*/ 5285 h 39141"/>
                <a:gd name="connsiteX7" fmla="*/ 38405 w 43225"/>
                <a:gd name="connsiteY7" fmla="*/ 6549 h 39141"/>
                <a:gd name="connsiteX8" fmla="*/ 29083 w 43225"/>
                <a:gd name="connsiteY8" fmla="*/ 3811 h 39141"/>
                <a:gd name="connsiteX9" fmla="*/ 29825 w 43225"/>
                <a:gd name="connsiteY9" fmla="*/ 2199 h 39141"/>
                <a:gd name="connsiteX10" fmla="*/ 22146 w 43225"/>
                <a:gd name="connsiteY10" fmla="*/ 4579 h 39141"/>
                <a:gd name="connsiteX11" fmla="*/ 22505 w 43225"/>
                <a:gd name="connsiteY11" fmla="*/ 3189 h 39141"/>
                <a:gd name="connsiteX12" fmla="*/ 14005 w 43225"/>
                <a:gd name="connsiteY12" fmla="*/ 5051 h 39141"/>
                <a:gd name="connsiteX13" fmla="*/ 15305 w 43225"/>
                <a:gd name="connsiteY13" fmla="*/ 6399 h 39141"/>
                <a:gd name="connsiteX14" fmla="*/ 4132 w 43225"/>
                <a:gd name="connsiteY14" fmla="*/ 15648 h 39141"/>
                <a:gd name="connsiteX15" fmla="*/ 3905 w 43225"/>
                <a:gd name="connsiteY15" fmla="*/ 14229 h 39141"/>
                <a:gd name="connsiteX0" fmla="*/ 3905 w 43225"/>
                <a:gd name="connsiteY0" fmla="*/ 14229 h 39141"/>
                <a:gd name="connsiteX1" fmla="*/ 5628 w 43225"/>
                <a:gd name="connsiteY1" fmla="*/ 6766 h 39141"/>
                <a:gd name="connsiteX2" fmla="*/ 14010 w 43225"/>
                <a:gd name="connsiteY2" fmla="*/ 5061 h 39141"/>
                <a:gd name="connsiteX3" fmla="*/ 22461 w 43225"/>
                <a:gd name="connsiteY3" fmla="*/ 3291 h 39141"/>
                <a:gd name="connsiteX4" fmla="*/ 25754 w 43225"/>
                <a:gd name="connsiteY4" fmla="*/ 59 h 39141"/>
                <a:gd name="connsiteX5" fmla="*/ 29838 w 43225"/>
                <a:gd name="connsiteY5" fmla="*/ 2340 h 39141"/>
                <a:gd name="connsiteX6" fmla="*/ 35468 w 43225"/>
                <a:gd name="connsiteY6" fmla="*/ 549 h 39141"/>
                <a:gd name="connsiteX7" fmla="*/ 38323 w 43225"/>
                <a:gd name="connsiteY7" fmla="*/ 5435 h 39141"/>
                <a:gd name="connsiteX8" fmla="*/ 41987 w 43225"/>
                <a:gd name="connsiteY8" fmla="*/ 10177 h 39141"/>
                <a:gd name="connsiteX9" fmla="*/ 41823 w 43225"/>
                <a:gd name="connsiteY9" fmla="*/ 15319 h 39141"/>
                <a:gd name="connsiteX10" fmla="*/ 43021 w 43225"/>
                <a:gd name="connsiteY10" fmla="*/ 23181 h 39141"/>
                <a:gd name="connsiteX11" fmla="*/ 37409 w 43225"/>
                <a:gd name="connsiteY11" fmla="*/ 30063 h 39141"/>
                <a:gd name="connsiteX12" fmla="*/ 35400 w 43225"/>
                <a:gd name="connsiteY12" fmla="*/ 35960 h 39141"/>
                <a:gd name="connsiteX13" fmla="*/ 28560 w 43225"/>
                <a:gd name="connsiteY13" fmla="*/ 36674 h 39141"/>
                <a:gd name="connsiteX14" fmla="*/ 16485 w 43225"/>
                <a:gd name="connsiteY14" fmla="*/ 39125 h 39141"/>
                <a:gd name="connsiteX15" fmla="*/ 0 w 43225"/>
                <a:gd name="connsiteY15" fmla="*/ 19563 h 39141"/>
                <a:gd name="connsiteX16" fmla="*/ 3868 w 43225"/>
                <a:gd name="connsiteY16" fmla="*/ 14366 h 39141"/>
                <a:gd name="connsiteX17" fmla="*/ 3905 w 43225"/>
                <a:gd name="connsiteY17" fmla="*/ 14229 h 39141"/>
                <a:gd name="connsiteX0" fmla="*/ 28832 w 43225"/>
                <a:gd name="connsiteY0" fmla="*/ 34610 h 39141"/>
                <a:gd name="connsiteX1" fmla="*/ 28565 w 43225"/>
                <a:gd name="connsiteY1" fmla="*/ 36519 h 39141"/>
                <a:gd name="connsiteX2" fmla="*/ 41803 w 43225"/>
                <a:gd name="connsiteY2" fmla="*/ 15213 h 39141"/>
                <a:gd name="connsiteX3" fmla="*/ 40355 w 43225"/>
                <a:gd name="connsiteY3" fmla="*/ 17889 h 39141"/>
                <a:gd name="connsiteX4" fmla="*/ 38329 w 43225"/>
                <a:gd name="connsiteY4" fmla="*/ 5285 h 39141"/>
                <a:gd name="connsiteX5" fmla="*/ 38405 w 43225"/>
                <a:gd name="connsiteY5" fmla="*/ 6549 h 39141"/>
                <a:gd name="connsiteX6" fmla="*/ 29083 w 43225"/>
                <a:gd name="connsiteY6" fmla="*/ 3811 h 39141"/>
                <a:gd name="connsiteX7" fmla="*/ 29825 w 43225"/>
                <a:gd name="connsiteY7" fmla="*/ 2199 h 39141"/>
                <a:gd name="connsiteX8" fmla="*/ 22146 w 43225"/>
                <a:gd name="connsiteY8" fmla="*/ 4579 h 39141"/>
                <a:gd name="connsiteX9" fmla="*/ 22505 w 43225"/>
                <a:gd name="connsiteY9" fmla="*/ 3189 h 39141"/>
                <a:gd name="connsiteX10" fmla="*/ 14005 w 43225"/>
                <a:gd name="connsiteY10" fmla="*/ 5051 h 39141"/>
                <a:gd name="connsiteX11" fmla="*/ 15305 w 43225"/>
                <a:gd name="connsiteY11" fmla="*/ 6399 h 39141"/>
                <a:gd name="connsiteX12" fmla="*/ 4132 w 43225"/>
                <a:gd name="connsiteY12" fmla="*/ 15648 h 39141"/>
                <a:gd name="connsiteX13" fmla="*/ 3905 w 43225"/>
                <a:gd name="connsiteY13" fmla="*/ 14229 h 39141"/>
                <a:gd name="connsiteX0" fmla="*/ 3905 w 43225"/>
                <a:gd name="connsiteY0" fmla="*/ 14229 h 37867"/>
                <a:gd name="connsiteX1" fmla="*/ 5628 w 43225"/>
                <a:gd name="connsiteY1" fmla="*/ 6766 h 37867"/>
                <a:gd name="connsiteX2" fmla="*/ 14010 w 43225"/>
                <a:gd name="connsiteY2" fmla="*/ 5061 h 37867"/>
                <a:gd name="connsiteX3" fmla="*/ 22461 w 43225"/>
                <a:gd name="connsiteY3" fmla="*/ 3291 h 37867"/>
                <a:gd name="connsiteX4" fmla="*/ 25754 w 43225"/>
                <a:gd name="connsiteY4" fmla="*/ 59 h 37867"/>
                <a:gd name="connsiteX5" fmla="*/ 29838 w 43225"/>
                <a:gd name="connsiteY5" fmla="*/ 2340 h 37867"/>
                <a:gd name="connsiteX6" fmla="*/ 35468 w 43225"/>
                <a:gd name="connsiteY6" fmla="*/ 549 h 37867"/>
                <a:gd name="connsiteX7" fmla="*/ 38323 w 43225"/>
                <a:gd name="connsiteY7" fmla="*/ 5435 h 37867"/>
                <a:gd name="connsiteX8" fmla="*/ 41987 w 43225"/>
                <a:gd name="connsiteY8" fmla="*/ 10177 h 37867"/>
                <a:gd name="connsiteX9" fmla="*/ 41823 w 43225"/>
                <a:gd name="connsiteY9" fmla="*/ 15319 h 37867"/>
                <a:gd name="connsiteX10" fmla="*/ 43021 w 43225"/>
                <a:gd name="connsiteY10" fmla="*/ 23181 h 37867"/>
                <a:gd name="connsiteX11" fmla="*/ 37409 w 43225"/>
                <a:gd name="connsiteY11" fmla="*/ 30063 h 37867"/>
                <a:gd name="connsiteX12" fmla="*/ 35400 w 43225"/>
                <a:gd name="connsiteY12" fmla="*/ 35960 h 37867"/>
                <a:gd name="connsiteX13" fmla="*/ 28560 w 43225"/>
                <a:gd name="connsiteY13" fmla="*/ 36674 h 37867"/>
                <a:gd name="connsiteX14" fmla="*/ 0 w 43225"/>
                <a:gd name="connsiteY14" fmla="*/ 19563 h 37867"/>
                <a:gd name="connsiteX15" fmla="*/ 3868 w 43225"/>
                <a:gd name="connsiteY15" fmla="*/ 14366 h 37867"/>
                <a:gd name="connsiteX16" fmla="*/ 3905 w 43225"/>
                <a:gd name="connsiteY16" fmla="*/ 14229 h 37867"/>
                <a:gd name="connsiteX0" fmla="*/ 28832 w 43225"/>
                <a:gd name="connsiteY0" fmla="*/ 34610 h 37867"/>
                <a:gd name="connsiteX1" fmla="*/ 28565 w 43225"/>
                <a:gd name="connsiteY1" fmla="*/ 36519 h 37867"/>
                <a:gd name="connsiteX2" fmla="*/ 41803 w 43225"/>
                <a:gd name="connsiteY2" fmla="*/ 15213 h 37867"/>
                <a:gd name="connsiteX3" fmla="*/ 40355 w 43225"/>
                <a:gd name="connsiteY3" fmla="*/ 17889 h 37867"/>
                <a:gd name="connsiteX4" fmla="*/ 38329 w 43225"/>
                <a:gd name="connsiteY4" fmla="*/ 5285 h 37867"/>
                <a:gd name="connsiteX5" fmla="*/ 38405 w 43225"/>
                <a:gd name="connsiteY5" fmla="*/ 6549 h 37867"/>
                <a:gd name="connsiteX6" fmla="*/ 29083 w 43225"/>
                <a:gd name="connsiteY6" fmla="*/ 3811 h 37867"/>
                <a:gd name="connsiteX7" fmla="*/ 29825 w 43225"/>
                <a:gd name="connsiteY7" fmla="*/ 2199 h 37867"/>
                <a:gd name="connsiteX8" fmla="*/ 22146 w 43225"/>
                <a:gd name="connsiteY8" fmla="*/ 4579 h 37867"/>
                <a:gd name="connsiteX9" fmla="*/ 22505 w 43225"/>
                <a:gd name="connsiteY9" fmla="*/ 3189 h 37867"/>
                <a:gd name="connsiteX10" fmla="*/ 14005 w 43225"/>
                <a:gd name="connsiteY10" fmla="*/ 5051 h 37867"/>
                <a:gd name="connsiteX11" fmla="*/ 15305 w 43225"/>
                <a:gd name="connsiteY11" fmla="*/ 6399 h 37867"/>
                <a:gd name="connsiteX12" fmla="*/ 4132 w 43225"/>
                <a:gd name="connsiteY12" fmla="*/ 15648 h 37867"/>
                <a:gd name="connsiteX13" fmla="*/ 3905 w 43225"/>
                <a:gd name="connsiteY13" fmla="*/ 14229 h 37867"/>
                <a:gd name="connsiteX0" fmla="*/ 3905 w 43225"/>
                <a:gd name="connsiteY0" fmla="*/ 14229 h 37867"/>
                <a:gd name="connsiteX1" fmla="*/ 5628 w 43225"/>
                <a:gd name="connsiteY1" fmla="*/ 6766 h 37867"/>
                <a:gd name="connsiteX2" fmla="*/ 14010 w 43225"/>
                <a:gd name="connsiteY2" fmla="*/ 5061 h 37867"/>
                <a:gd name="connsiteX3" fmla="*/ 22461 w 43225"/>
                <a:gd name="connsiteY3" fmla="*/ 3291 h 37867"/>
                <a:gd name="connsiteX4" fmla="*/ 25754 w 43225"/>
                <a:gd name="connsiteY4" fmla="*/ 59 h 37867"/>
                <a:gd name="connsiteX5" fmla="*/ 29838 w 43225"/>
                <a:gd name="connsiteY5" fmla="*/ 2340 h 37867"/>
                <a:gd name="connsiteX6" fmla="*/ 35468 w 43225"/>
                <a:gd name="connsiteY6" fmla="*/ 549 h 37867"/>
                <a:gd name="connsiteX7" fmla="*/ 38323 w 43225"/>
                <a:gd name="connsiteY7" fmla="*/ 5435 h 37867"/>
                <a:gd name="connsiteX8" fmla="*/ 41987 w 43225"/>
                <a:gd name="connsiteY8" fmla="*/ 10177 h 37867"/>
                <a:gd name="connsiteX9" fmla="*/ 41823 w 43225"/>
                <a:gd name="connsiteY9" fmla="*/ 15319 h 37867"/>
                <a:gd name="connsiteX10" fmla="*/ 43021 w 43225"/>
                <a:gd name="connsiteY10" fmla="*/ 23181 h 37867"/>
                <a:gd name="connsiteX11" fmla="*/ 37409 w 43225"/>
                <a:gd name="connsiteY11" fmla="*/ 30063 h 37867"/>
                <a:gd name="connsiteX12" fmla="*/ 35400 w 43225"/>
                <a:gd name="connsiteY12" fmla="*/ 35960 h 37867"/>
                <a:gd name="connsiteX13" fmla="*/ 28560 w 43225"/>
                <a:gd name="connsiteY13" fmla="*/ 36674 h 37867"/>
                <a:gd name="connsiteX14" fmla="*/ 0 w 43225"/>
                <a:gd name="connsiteY14" fmla="*/ 19563 h 37867"/>
                <a:gd name="connsiteX15" fmla="*/ 3868 w 43225"/>
                <a:gd name="connsiteY15" fmla="*/ 14366 h 37867"/>
                <a:gd name="connsiteX16" fmla="*/ 3905 w 43225"/>
                <a:gd name="connsiteY16" fmla="*/ 14229 h 37867"/>
                <a:gd name="connsiteX0" fmla="*/ 41803 w 43225"/>
                <a:gd name="connsiteY0" fmla="*/ 15213 h 37867"/>
                <a:gd name="connsiteX1" fmla="*/ 40355 w 43225"/>
                <a:gd name="connsiteY1" fmla="*/ 17889 h 37867"/>
                <a:gd name="connsiteX2" fmla="*/ 38329 w 43225"/>
                <a:gd name="connsiteY2" fmla="*/ 5285 h 37867"/>
                <a:gd name="connsiteX3" fmla="*/ 38405 w 43225"/>
                <a:gd name="connsiteY3" fmla="*/ 6549 h 37867"/>
                <a:gd name="connsiteX4" fmla="*/ 29083 w 43225"/>
                <a:gd name="connsiteY4" fmla="*/ 3811 h 37867"/>
                <a:gd name="connsiteX5" fmla="*/ 29825 w 43225"/>
                <a:gd name="connsiteY5" fmla="*/ 2199 h 37867"/>
                <a:gd name="connsiteX6" fmla="*/ 22146 w 43225"/>
                <a:gd name="connsiteY6" fmla="*/ 4579 h 37867"/>
                <a:gd name="connsiteX7" fmla="*/ 22505 w 43225"/>
                <a:gd name="connsiteY7" fmla="*/ 3189 h 37867"/>
                <a:gd name="connsiteX8" fmla="*/ 14005 w 43225"/>
                <a:gd name="connsiteY8" fmla="*/ 5051 h 37867"/>
                <a:gd name="connsiteX9" fmla="*/ 15305 w 43225"/>
                <a:gd name="connsiteY9" fmla="*/ 6399 h 37867"/>
                <a:gd name="connsiteX10" fmla="*/ 4132 w 43225"/>
                <a:gd name="connsiteY10" fmla="*/ 15648 h 37867"/>
                <a:gd name="connsiteX11" fmla="*/ 3905 w 43225"/>
                <a:gd name="connsiteY11" fmla="*/ 14229 h 37867"/>
                <a:gd name="connsiteX0" fmla="*/ 3905 w 43225"/>
                <a:gd name="connsiteY0" fmla="*/ 14229 h 36304"/>
                <a:gd name="connsiteX1" fmla="*/ 5628 w 43225"/>
                <a:gd name="connsiteY1" fmla="*/ 6766 h 36304"/>
                <a:gd name="connsiteX2" fmla="*/ 14010 w 43225"/>
                <a:gd name="connsiteY2" fmla="*/ 5061 h 36304"/>
                <a:gd name="connsiteX3" fmla="*/ 22461 w 43225"/>
                <a:gd name="connsiteY3" fmla="*/ 3291 h 36304"/>
                <a:gd name="connsiteX4" fmla="*/ 25754 w 43225"/>
                <a:gd name="connsiteY4" fmla="*/ 59 h 36304"/>
                <a:gd name="connsiteX5" fmla="*/ 29838 w 43225"/>
                <a:gd name="connsiteY5" fmla="*/ 2340 h 36304"/>
                <a:gd name="connsiteX6" fmla="*/ 35468 w 43225"/>
                <a:gd name="connsiteY6" fmla="*/ 549 h 36304"/>
                <a:gd name="connsiteX7" fmla="*/ 38323 w 43225"/>
                <a:gd name="connsiteY7" fmla="*/ 5435 h 36304"/>
                <a:gd name="connsiteX8" fmla="*/ 41987 w 43225"/>
                <a:gd name="connsiteY8" fmla="*/ 10177 h 36304"/>
                <a:gd name="connsiteX9" fmla="*/ 41823 w 43225"/>
                <a:gd name="connsiteY9" fmla="*/ 15319 h 36304"/>
                <a:gd name="connsiteX10" fmla="*/ 43021 w 43225"/>
                <a:gd name="connsiteY10" fmla="*/ 23181 h 36304"/>
                <a:gd name="connsiteX11" fmla="*/ 37409 w 43225"/>
                <a:gd name="connsiteY11" fmla="*/ 30063 h 36304"/>
                <a:gd name="connsiteX12" fmla="*/ 35400 w 43225"/>
                <a:gd name="connsiteY12" fmla="*/ 35960 h 36304"/>
                <a:gd name="connsiteX13" fmla="*/ 0 w 43225"/>
                <a:gd name="connsiteY13" fmla="*/ 19563 h 36304"/>
                <a:gd name="connsiteX14" fmla="*/ 3868 w 43225"/>
                <a:gd name="connsiteY14" fmla="*/ 14366 h 36304"/>
                <a:gd name="connsiteX15" fmla="*/ 3905 w 43225"/>
                <a:gd name="connsiteY15" fmla="*/ 14229 h 36304"/>
                <a:gd name="connsiteX0" fmla="*/ 41803 w 43225"/>
                <a:gd name="connsiteY0" fmla="*/ 15213 h 36304"/>
                <a:gd name="connsiteX1" fmla="*/ 40355 w 43225"/>
                <a:gd name="connsiteY1" fmla="*/ 17889 h 36304"/>
                <a:gd name="connsiteX2" fmla="*/ 38329 w 43225"/>
                <a:gd name="connsiteY2" fmla="*/ 5285 h 36304"/>
                <a:gd name="connsiteX3" fmla="*/ 38405 w 43225"/>
                <a:gd name="connsiteY3" fmla="*/ 6549 h 36304"/>
                <a:gd name="connsiteX4" fmla="*/ 29083 w 43225"/>
                <a:gd name="connsiteY4" fmla="*/ 3811 h 36304"/>
                <a:gd name="connsiteX5" fmla="*/ 29825 w 43225"/>
                <a:gd name="connsiteY5" fmla="*/ 2199 h 36304"/>
                <a:gd name="connsiteX6" fmla="*/ 22146 w 43225"/>
                <a:gd name="connsiteY6" fmla="*/ 4579 h 36304"/>
                <a:gd name="connsiteX7" fmla="*/ 22505 w 43225"/>
                <a:gd name="connsiteY7" fmla="*/ 3189 h 36304"/>
                <a:gd name="connsiteX8" fmla="*/ 14005 w 43225"/>
                <a:gd name="connsiteY8" fmla="*/ 5051 h 36304"/>
                <a:gd name="connsiteX9" fmla="*/ 15305 w 43225"/>
                <a:gd name="connsiteY9" fmla="*/ 6399 h 36304"/>
                <a:gd name="connsiteX10" fmla="*/ 4132 w 43225"/>
                <a:gd name="connsiteY10" fmla="*/ 15648 h 36304"/>
                <a:gd name="connsiteX11" fmla="*/ 3905 w 43225"/>
                <a:gd name="connsiteY11" fmla="*/ 14229 h 36304"/>
                <a:gd name="connsiteX0" fmla="*/ 3905 w 43225"/>
                <a:gd name="connsiteY0" fmla="*/ 14229 h 30063"/>
                <a:gd name="connsiteX1" fmla="*/ 5628 w 43225"/>
                <a:gd name="connsiteY1" fmla="*/ 6766 h 30063"/>
                <a:gd name="connsiteX2" fmla="*/ 14010 w 43225"/>
                <a:gd name="connsiteY2" fmla="*/ 5061 h 30063"/>
                <a:gd name="connsiteX3" fmla="*/ 22461 w 43225"/>
                <a:gd name="connsiteY3" fmla="*/ 3291 h 30063"/>
                <a:gd name="connsiteX4" fmla="*/ 25754 w 43225"/>
                <a:gd name="connsiteY4" fmla="*/ 59 h 30063"/>
                <a:gd name="connsiteX5" fmla="*/ 29838 w 43225"/>
                <a:gd name="connsiteY5" fmla="*/ 2340 h 30063"/>
                <a:gd name="connsiteX6" fmla="*/ 35468 w 43225"/>
                <a:gd name="connsiteY6" fmla="*/ 549 h 30063"/>
                <a:gd name="connsiteX7" fmla="*/ 38323 w 43225"/>
                <a:gd name="connsiteY7" fmla="*/ 5435 h 30063"/>
                <a:gd name="connsiteX8" fmla="*/ 41987 w 43225"/>
                <a:gd name="connsiteY8" fmla="*/ 10177 h 30063"/>
                <a:gd name="connsiteX9" fmla="*/ 41823 w 43225"/>
                <a:gd name="connsiteY9" fmla="*/ 15319 h 30063"/>
                <a:gd name="connsiteX10" fmla="*/ 43021 w 43225"/>
                <a:gd name="connsiteY10" fmla="*/ 23181 h 30063"/>
                <a:gd name="connsiteX11" fmla="*/ 37409 w 43225"/>
                <a:gd name="connsiteY11" fmla="*/ 30063 h 30063"/>
                <a:gd name="connsiteX12" fmla="*/ 0 w 43225"/>
                <a:gd name="connsiteY12" fmla="*/ 19563 h 30063"/>
                <a:gd name="connsiteX13" fmla="*/ 3868 w 43225"/>
                <a:gd name="connsiteY13" fmla="*/ 14366 h 30063"/>
                <a:gd name="connsiteX14" fmla="*/ 3905 w 43225"/>
                <a:gd name="connsiteY14" fmla="*/ 14229 h 30063"/>
                <a:gd name="connsiteX0" fmla="*/ 41803 w 43225"/>
                <a:gd name="connsiteY0" fmla="*/ 15213 h 30063"/>
                <a:gd name="connsiteX1" fmla="*/ 40355 w 43225"/>
                <a:gd name="connsiteY1" fmla="*/ 17889 h 30063"/>
                <a:gd name="connsiteX2" fmla="*/ 38329 w 43225"/>
                <a:gd name="connsiteY2" fmla="*/ 5285 h 30063"/>
                <a:gd name="connsiteX3" fmla="*/ 38405 w 43225"/>
                <a:gd name="connsiteY3" fmla="*/ 6549 h 30063"/>
                <a:gd name="connsiteX4" fmla="*/ 29083 w 43225"/>
                <a:gd name="connsiteY4" fmla="*/ 3811 h 30063"/>
                <a:gd name="connsiteX5" fmla="*/ 29825 w 43225"/>
                <a:gd name="connsiteY5" fmla="*/ 2199 h 30063"/>
                <a:gd name="connsiteX6" fmla="*/ 22146 w 43225"/>
                <a:gd name="connsiteY6" fmla="*/ 4579 h 30063"/>
                <a:gd name="connsiteX7" fmla="*/ 22505 w 43225"/>
                <a:gd name="connsiteY7" fmla="*/ 3189 h 30063"/>
                <a:gd name="connsiteX8" fmla="*/ 14005 w 43225"/>
                <a:gd name="connsiteY8" fmla="*/ 5051 h 30063"/>
                <a:gd name="connsiteX9" fmla="*/ 15305 w 43225"/>
                <a:gd name="connsiteY9" fmla="*/ 6399 h 30063"/>
                <a:gd name="connsiteX10" fmla="*/ 4132 w 43225"/>
                <a:gd name="connsiteY10" fmla="*/ 15648 h 30063"/>
                <a:gd name="connsiteX11" fmla="*/ 3905 w 43225"/>
                <a:gd name="connsiteY11" fmla="*/ 14229 h 30063"/>
                <a:gd name="connsiteX0" fmla="*/ 3905 w 46089"/>
                <a:gd name="connsiteY0" fmla="*/ 14229 h 23291"/>
                <a:gd name="connsiteX1" fmla="*/ 5628 w 46089"/>
                <a:gd name="connsiteY1" fmla="*/ 6766 h 23291"/>
                <a:gd name="connsiteX2" fmla="*/ 14010 w 46089"/>
                <a:gd name="connsiteY2" fmla="*/ 5061 h 23291"/>
                <a:gd name="connsiteX3" fmla="*/ 22461 w 46089"/>
                <a:gd name="connsiteY3" fmla="*/ 3291 h 23291"/>
                <a:gd name="connsiteX4" fmla="*/ 25754 w 46089"/>
                <a:gd name="connsiteY4" fmla="*/ 59 h 23291"/>
                <a:gd name="connsiteX5" fmla="*/ 29838 w 46089"/>
                <a:gd name="connsiteY5" fmla="*/ 2340 h 23291"/>
                <a:gd name="connsiteX6" fmla="*/ 35468 w 46089"/>
                <a:gd name="connsiteY6" fmla="*/ 549 h 23291"/>
                <a:gd name="connsiteX7" fmla="*/ 38323 w 46089"/>
                <a:gd name="connsiteY7" fmla="*/ 5435 h 23291"/>
                <a:gd name="connsiteX8" fmla="*/ 41987 w 46089"/>
                <a:gd name="connsiteY8" fmla="*/ 10177 h 23291"/>
                <a:gd name="connsiteX9" fmla="*/ 41823 w 46089"/>
                <a:gd name="connsiteY9" fmla="*/ 15319 h 23291"/>
                <a:gd name="connsiteX10" fmla="*/ 43021 w 46089"/>
                <a:gd name="connsiteY10" fmla="*/ 23181 h 23291"/>
                <a:gd name="connsiteX11" fmla="*/ 0 w 46089"/>
                <a:gd name="connsiteY11" fmla="*/ 19563 h 23291"/>
                <a:gd name="connsiteX12" fmla="*/ 3868 w 46089"/>
                <a:gd name="connsiteY12" fmla="*/ 14366 h 23291"/>
                <a:gd name="connsiteX13" fmla="*/ 3905 w 46089"/>
                <a:gd name="connsiteY13" fmla="*/ 14229 h 23291"/>
                <a:gd name="connsiteX0" fmla="*/ 41803 w 46089"/>
                <a:gd name="connsiteY0" fmla="*/ 15213 h 23291"/>
                <a:gd name="connsiteX1" fmla="*/ 40355 w 46089"/>
                <a:gd name="connsiteY1" fmla="*/ 17889 h 23291"/>
                <a:gd name="connsiteX2" fmla="*/ 38329 w 46089"/>
                <a:gd name="connsiteY2" fmla="*/ 5285 h 23291"/>
                <a:gd name="connsiteX3" fmla="*/ 38405 w 46089"/>
                <a:gd name="connsiteY3" fmla="*/ 6549 h 23291"/>
                <a:gd name="connsiteX4" fmla="*/ 29083 w 46089"/>
                <a:gd name="connsiteY4" fmla="*/ 3811 h 23291"/>
                <a:gd name="connsiteX5" fmla="*/ 29825 w 46089"/>
                <a:gd name="connsiteY5" fmla="*/ 2199 h 23291"/>
                <a:gd name="connsiteX6" fmla="*/ 22146 w 46089"/>
                <a:gd name="connsiteY6" fmla="*/ 4579 h 23291"/>
                <a:gd name="connsiteX7" fmla="*/ 22505 w 46089"/>
                <a:gd name="connsiteY7" fmla="*/ 3189 h 23291"/>
                <a:gd name="connsiteX8" fmla="*/ 14005 w 46089"/>
                <a:gd name="connsiteY8" fmla="*/ 5051 h 23291"/>
                <a:gd name="connsiteX9" fmla="*/ 15305 w 46089"/>
                <a:gd name="connsiteY9" fmla="*/ 6399 h 23291"/>
                <a:gd name="connsiteX10" fmla="*/ 4132 w 46089"/>
                <a:gd name="connsiteY10" fmla="*/ 15648 h 23291"/>
                <a:gd name="connsiteX11" fmla="*/ 3905 w 46089"/>
                <a:gd name="connsiteY11" fmla="*/ 14229 h 23291"/>
                <a:gd name="connsiteX0" fmla="*/ 3905 w 42255"/>
                <a:gd name="connsiteY0" fmla="*/ 14229 h 19569"/>
                <a:gd name="connsiteX1" fmla="*/ 5628 w 42255"/>
                <a:gd name="connsiteY1" fmla="*/ 6766 h 19569"/>
                <a:gd name="connsiteX2" fmla="*/ 14010 w 42255"/>
                <a:gd name="connsiteY2" fmla="*/ 5061 h 19569"/>
                <a:gd name="connsiteX3" fmla="*/ 22461 w 42255"/>
                <a:gd name="connsiteY3" fmla="*/ 3291 h 19569"/>
                <a:gd name="connsiteX4" fmla="*/ 25754 w 42255"/>
                <a:gd name="connsiteY4" fmla="*/ 59 h 19569"/>
                <a:gd name="connsiteX5" fmla="*/ 29838 w 42255"/>
                <a:gd name="connsiteY5" fmla="*/ 2340 h 19569"/>
                <a:gd name="connsiteX6" fmla="*/ 35468 w 42255"/>
                <a:gd name="connsiteY6" fmla="*/ 549 h 19569"/>
                <a:gd name="connsiteX7" fmla="*/ 38323 w 42255"/>
                <a:gd name="connsiteY7" fmla="*/ 5435 h 19569"/>
                <a:gd name="connsiteX8" fmla="*/ 41987 w 42255"/>
                <a:gd name="connsiteY8" fmla="*/ 10177 h 19569"/>
                <a:gd name="connsiteX9" fmla="*/ 41823 w 42255"/>
                <a:gd name="connsiteY9" fmla="*/ 15319 h 19569"/>
                <a:gd name="connsiteX10" fmla="*/ 0 w 42255"/>
                <a:gd name="connsiteY10" fmla="*/ 19563 h 19569"/>
                <a:gd name="connsiteX11" fmla="*/ 3868 w 42255"/>
                <a:gd name="connsiteY11" fmla="*/ 14366 h 19569"/>
                <a:gd name="connsiteX12" fmla="*/ 3905 w 42255"/>
                <a:gd name="connsiteY12" fmla="*/ 14229 h 19569"/>
                <a:gd name="connsiteX0" fmla="*/ 41803 w 42255"/>
                <a:gd name="connsiteY0" fmla="*/ 15213 h 19569"/>
                <a:gd name="connsiteX1" fmla="*/ 40355 w 42255"/>
                <a:gd name="connsiteY1" fmla="*/ 17889 h 19569"/>
                <a:gd name="connsiteX2" fmla="*/ 38329 w 42255"/>
                <a:gd name="connsiteY2" fmla="*/ 5285 h 19569"/>
                <a:gd name="connsiteX3" fmla="*/ 38405 w 42255"/>
                <a:gd name="connsiteY3" fmla="*/ 6549 h 19569"/>
                <a:gd name="connsiteX4" fmla="*/ 29083 w 42255"/>
                <a:gd name="connsiteY4" fmla="*/ 3811 h 19569"/>
                <a:gd name="connsiteX5" fmla="*/ 29825 w 42255"/>
                <a:gd name="connsiteY5" fmla="*/ 2199 h 19569"/>
                <a:gd name="connsiteX6" fmla="*/ 22146 w 42255"/>
                <a:gd name="connsiteY6" fmla="*/ 4579 h 19569"/>
                <a:gd name="connsiteX7" fmla="*/ 22505 w 42255"/>
                <a:gd name="connsiteY7" fmla="*/ 3189 h 19569"/>
                <a:gd name="connsiteX8" fmla="*/ 14005 w 42255"/>
                <a:gd name="connsiteY8" fmla="*/ 5051 h 19569"/>
                <a:gd name="connsiteX9" fmla="*/ 15305 w 42255"/>
                <a:gd name="connsiteY9" fmla="*/ 6399 h 19569"/>
                <a:gd name="connsiteX10" fmla="*/ 4132 w 42255"/>
                <a:gd name="connsiteY10" fmla="*/ 15648 h 19569"/>
                <a:gd name="connsiteX11" fmla="*/ 3905 w 42255"/>
                <a:gd name="connsiteY11" fmla="*/ 14229 h 19569"/>
                <a:gd name="connsiteX0" fmla="*/ 62 w 38412"/>
                <a:gd name="connsiteY0" fmla="*/ 14229 h 17889"/>
                <a:gd name="connsiteX1" fmla="*/ 1785 w 38412"/>
                <a:gd name="connsiteY1" fmla="*/ 6766 h 17889"/>
                <a:gd name="connsiteX2" fmla="*/ 10167 w 38412"/>
                <a:gd name="connsiteY2" fmla="*/ 5061 h 17889"/>
                <a:gd name="connsiteX3" fmla="*/ 18618 w 38412"/>
                <a:gd name="connsiteY3" fmla="*/ 3291 h 17889"/>
                <a:gd name="connsiteX4" fmla="*/ 21911 w 38412"/>
                <a:gd name="connsiteY4" fmla="*/ 59 h 17889"/>
                <a:gd name="connsiteX5" fmla="*/ 25995 w 38412"/>
                <a:gd name="connsiteY5" fmla="*/ 2340 h 17889"/>
                <a:gd name="connsiteX6" fmla="*/ 31625 w 38412"/>
                <a:gd name="connsiteY6" fmla="*/ 549 h 17889"/>
                <a:gd name="connsiteX7" fmla="*/ 34480 w 38412"/>
                <a:gd name="connsiteY7" fmla="*/ 5435 h 17889"/>
                <a:gd name="connsiteX8" fmla="*/ 38144 w 38412"/>
                <a:gd name="connsiteY8" fmla="*/ 10177 h 17889"/>
                <a:gd name="connsiteX9" fmla="*/ 37980 w 38412"/>
                <a:gd name="connsiteY9" fmla="*/ 15319 h 17889"/>
                <a:gd name="connsiteX10" fmla="*/ 25 w 38412"/>
                <a:gd name="connsiteY10" fmla="*/ 14366 h 17889"/>
                <a:gd name="connsiteX11" fmla="*/ 62 w 38412"/>
                <a:gd name="connsiteY11" fmla="*/ 14229 h 17889"/>
                <a:gd name="connsiteX0" fmla="*/ 37960 w 38412"/>
                <a:gd name="connsiteY0" fmla="*/ 15213 h 17889"/>
                <a:gd name="connsiteX1" fmla="*/ 36512 w 38412"/>
                <a:gd name="connsiteY1" fmla="*/ 17889 h 17889"/>
                <a:gd name="connsiteX2" fmla="*/ 34486 w 38412"/>
                <a:gd name="connsiteY2" fmla="*/ 5285 h 17889"/>
                <a:gd name="connsiteX3" fmla="*/ 34562 w 38412"/>
                <a:gd name="connsiteY3" fmla="*/ 6549 h 17889"/>
                <a:gd name="connsiteX4" fmla="*/ 25240 w 38412"/>
                <a:gd name="connsiteY4" fmla="*/ 3811 h 17889"/>
                <a:gd name="connsiteX5" fmla="*/ 25982 w 38412"/>
                <a:gd name="connsiteY5" fmla="*/ 2199 h 17889"/>
                <a:gd name="connsiteX6" fmla="*/ 18303 w 38412"/>
                <a:gd name="connsiteY6" fmla="*/ 4579 h 17889"/>
                <a:gd name="connsiteX7" fmla="*/ 18662 w 38412"/>
                <a:gd name="connsiteY7" fmla="*/ 3189 h 17889"/>
                <a:gd name="connsiteX8" fmla="*/ 10162 w 38412"/>
                <a:gd name="connsiteY8" fmla="*/ 5051 h 17889"/>
                <a:gd name="connsiteX9" fmla="*/ 11462 w 38412"/>
                <a:gd name="connsiteY9" fmla="*/ 6399 h 17889"/>
                <a:gd name="connsiteX10" fmla="*/ 289 w 38412"/>
                <a:gd name="connsiteY10" fmla="*/ 15648 h 17889"/>
                <a:gd name="connsiteX11" fmla="*/ 62 w 38412"/>
                <a:gd name="connsiteY11" fmla="*/ 14229 h 17889"/>
                <a:gd name="connsiteX0" fmla="*/ 62 w 38412"/>
                <a:gd name="connsiteY0" fmla="*/ 14229 h 15648"/>
                <a:gd name="connsiteX1" fmla="*/ 1785 w 38412"/>
                <a:gd name="connsiteY1" fmla="*/ 6766 h 15648"/>
                <a:gd name="connsiteX2" fmla="*/ 10167 w 38412"/>
                <a:gd name="connsiteY2" fmla="*/ 5061 h 15648"/>
                <a:gd name="connsiteX3" fmla="*/ 18618 w 38412"/>
                <a:gd name="connsiteY3" fmla="*/ 3291 h 15648"/>
                <a:gd name="connsiteX4" fmla="*/ 21911 w 38412"/>
                <a:gd name="connsiteY4" fmla="*/ 59 h 15648"/>
                <a:gd name="connsiteX5" fmla="*/ 25995 w 38412"/>
                <a:gd name="connsiteY5" fmla="*/ 2340 h 15648"/>
                <a:gd name="connsiteX6" fmla="*/ 31625 w 38412"/>
                <a:gd name="connsiteY6" fmla="*/ 549 h 15648"/>
                <a:gd name="connsiteX7" fmla="*/ 34480 w 38412"/>
                <a:gd name="connsiteY7" fmla="*/ 5435 h 15648"/>
                <a:gd name="connsiteX8" fmla="*/ 38144 w 38412"/>
                <a:gd name="connsiteY8" fmla="*/ 10177 h 15648"/>
                <a:gd name="connsiteX9" fmla="*/ 37980 w 38412"/>
                <a:gd name="connsiteY9" fmla="*/ 15319 h 15648"/>
                <a:gd name="connsiteX10" fmla="*/ 25 w 38412"/>
                <a:gd name="connsiteY10" fmla="*/ 14366 h 15648"/>
                <a:gd name="connsiteX11" fmla="*/ 62 w 38412"/>
                <a:gd name="connsiteY11" fmla="*/ 14229 h 15648"/>
                <a:gd name="connsiteX0" fmla="*/ 34486 w 38412"/>
                <a:gd name="connsiteY0" fmla="*/ 5285 h 15648"/>
                <a:gd name="connsiteX1" fmla="*/ 34562 w 38412"/>
                <a:gd name="connsiteY1" fmla="*/ 6549 h 15648"/>
                <a:gd name="connsiteX2" fmla="*/ 25240 w 38412"/>
                <a:gd name="connsiteY2" fmla="*/ 3811 h 15648"/>
                <a:gd name="connsiteX3" fmla="*/ 25982 w 38412"/>
                <a:gd name="connsiteY3" fmla="*/ 2199 h 15648"/>
                <a:gd name="connsiteX4" fmla="*/ 18303 w 38412"/>
                <a:gd name="connsiteY4" fmla="*/ 4579 h 15648"/>
                <a:gd name="connsiteX5" fmla="*/ 18662 w 38412"/>
                <a:gd name="connsiteY5" fmla="*/ 3189 h 15648"/>
                <a:gd name="connsiteX6" fmla="*/ 10162 w 38412"/>
                <a:gd name="connsiteY6" fmla="*/ 5051 h 15648"/>
                <a:gd name="connsiteX7" fmla="*/ 11462 w 38412"/>
                <a:gd name="connsiteY7" fmla="*/ 6399 h 15648"/>
                <a:gd name="connsiteX8" fmla="*/ 289 w 38412"/>
                <a:gd name="connsiteY8" fmla="*/ 15648 h 15648"/>
                <a:gd name="connsiteX9" fmla="*/ 62 w 38412"/>
                <a:gd name="connsiteY9" fmla="*/ 14229 h 15648"/>
                <a:gd name="connsiteX0" fmla="*/ 62 w 38371"/>
                <a:gd name="connsiteY0" fmla="*/ 14229 h 15648"/>
                <a:gd name="connsiteX1" fmla="*/ 1785 w 38371"/>
                <a:gd name="connsiteY1" fmla="*/ 6766 h 15648"/>
                <a:gd name="connsiteX2" fmla="*/ 10167 w 38371"/>
                <a:gd name="connsiteY2" fmla="*/ 5061 h 15648"/>
                <a:gd name="connsiteX3" fmla="*/ 18618 w 38371"/>
                <a:gd name="connsiteY3" fmla="*/ 3291 h 15648"/>
                <a:gd name="connsiteX4" fmla="*/ 21911 w 38371"/>
                <a:gd name="connsiteY4" fmla="*/ 59 h 15648"/>
                <a:gd name="connsiteX5" fmla="*/ 25995 w 38371"/>
                <a:gd name="connsiteY5" fmla="*/ 2340 h 15648"/>
                <a:gd name="connsiteX6" fmla="*/ 31625 w 38371"/>
                <a:gd name="connsiteY6" fmla="*/ 549 h 15648"/>
                <a:gd name="connsiteX7" fmla="*/ 34480 w 38371"/>
                <a:gd name="connsiteY7" fmla="*/ 5435 h 15648"/>
                <a:gd name="connsiteX8" fmla="*/ 38144 w 38371"/>
                <a:gd name="connsiteY8" fmla="*/ 10177 h 15648"/>
                <a:gd name="connsiteX9" fmla="*/ 37666 w 38371"/>
                <a:gd name="connsiteY9" fmla="*/ 13114 h 15648"/>
                <a:gd name="connsiteX10" fmla="*/ 25 w 38371"/>
                <a:gd name="connsiteY10" fmla="*/ 14366 h 15648"/>
                <a:gd name="connsiteX11" fmla="*/ 62 w 38371"/>
                <a:gd name="connsiteY11" fmla="*/ 14229 h 15648"/>
                <a:gd name="connsiteX0" fmla="*/ 34486 w 38371"/>
                <a:gd name="connsiteY0" fmla="*/ 5285 h 15648"/>
                <a:gd name="connsiteX1" fmla="*/ 34562 w 38371"/>
                <a:gd name="connsiteY1" fmla="*/ 6549 h 15648"/>
                <a:gd name="connsiteX2" fmla="*/ 25240 w 38371"/>
                <a:gd name="connsiteY2" fmla="*/ 3811 h 15648"/>
                <a:gd name="connsiteX3" fmla="*/ 25982 w 38371"/>
                <a:gd name="connsiteY3" fmla="*/ 2199 h 15648"/>
                <a:gd name="connsiteX4" fmla="*/ 18303 w 38371"/>
                <a:gd name="connsiteY4" fmla="*/ 4579 h 15648"/>
                <a:gd name="connsiteX5" fmla="*/ 18662 w 38371"/>
                <a:gd name="connsiteY5" fmla="*/ 3189 h 15648"/>
                <a:gd name="connsiteX6" fmla="*/ 10162 w 38371"/>
                <a:gd name="connsiteY6" fmla="*/ 5051 h 15648"/>
                <a:gd name="connsiteX7" fmla="*/ 11462 w 38371"/>
                <a:gd name="connsiteY7" fmla="*/ 6399 h 15648"/>
                <a:gd name="connsiteX8" fmla="*/ 289 w 38371"/>
                <a:gd name="connsiteY8" fmla="*/ 15648 h 15648"/>
                <a:gd name="connsiteX9" fmla="*/ 62 w 38371"/>
                <a:gd name="connsiteY9" fmla="*/ 14229 h 15648"/>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38371" h="15648">
                  <a:moveTo>
                    <a:pt x="62" y="14229"/>
                  </a:moveTo>
                  <a:cubicBezTo>
                    <a:pt x="-209" y="11516"/>
                    <a:pt x="423" y="8780"/>
                    <a:pt x="1785" y="6766"/>
                  </a:cubicBezTo>
                  <a:cubicBezTo>
                    <a:pt x="3937" y="3585"/>
                    <a:pt x="7426" y="2876"/>
                    <a:pt x="10167" y="5061"/>
                  </a:cubicBezTo>
                  <a:cubicBezTo>
                    <a:pt x="11840" y="768"/>
                    <a:pt x="16076" y="-119"/>
                    <a:pt x="18618" y="3291"/>
                  </a:cubicBezTo>
                  <a:cubicBezTo>
                    <a:pt x="19259" y="1542"/>
                    <a:pt x="20490" y="333"/>
                    <a:pt x="21911" y="59"/>
                  </a:cubicBezTo>
                  <a:cubicBezTo>
                    <a:pt x="23475" y="-243"/>
                    <a:pt x="25037" y="629"/>
                    <a:pt x="25995" y="2340"/>
                  </a:cubicBezTo>
                  <a:cubicBezTo>
                    <a:pt x="27377" y="126"/>
                    <a:pt x="29663" y="-601"/>
                    <a:pt x="31625" y="549"/>
                  </a:cubicBezTo>
                  <a:cubicBezTo>
                    <a:pt x="33120" y="1425"/>
                    <a:pt x="34192" y="3259"/>
                    <a:pt x="34480" y="5435"/>
                  </a:cubicBezTo>
                  <a:cubicBezTo>
                    <a:pt x="36208" y="6077"/>
                    <a:pt x="37613" y="8897"/>
                    <a:pt x="38144" y="10177"/>
                  </a:cubicBezTo>
                  <a:cubicBezTo>
                    <a:pt x="38675" y="11457"/>
                    <a:pt x="38179" y="11485"/>
                    <a:pt x="37666" y="13114"/>
                  </a:cubicBezTo>
                  <a:cubicBezTo>
                    <a:pt x="31313" y="13812"/>
                    <a:pt x="6345" y="14548"/>
                    <a:pt x="25" y="14366"/>
                  </a:cubicBezTo>
                  <a:cubicBezTo>
                    <a:pt x="37" y="14320"/>
                    <a:pt x="50" y="14275"/>
                    <a:pt x="62" y="14229"/>
                  </a:cubicBezTo>
                  <a:close/>
                </a:path>
                <a:path w="38371" h="15648" fill="none" extrusionOk="0">
                  <a:moveTo>
                    <a:pt x="34486" y="5285"/>
                  </a:moveTo>
                  <a:cubicBezTo>
                    <a:pt x="34541" y="5702"/>
                    <a:pt x="34567" y="6125"/>
                    <a:pt x="34562" y="6549"/>
                  </a:cubicBezTo>
                  <a:moveTo>
                    <a:pt x="25240" y="3811"/>
                  </a:moveTo>
                  <a:cubicBezTo>
                    <a:pt x="25429" y="3228"/>
                    <a:pt x="25678" y="2685"/>
                    <a:pt x="25982" y="2199"/>
                  </a:cubicBezTo>
                  <a:moveTo>
                    <a:pt x="18303" y="4579"/>
                  </a:moveTo>
                  <a:cubicBezTo>
                    <a:pt x="18380" y="4097"/>
                    <a:pt x="18501" y="3630"/>
                    <a:pt x="18662" y="3189"/>
                  </a:cubicBezTo>
                  <a:moveTo>
                    <a:pt x="10162" y="5051"/>
                  </a:moveTo>
                  <a:cubicBezTo>
                    <a:pt x="10634" y="5427"/>
                    <a:pt x="11070" y="5880"/>
                    <a:pt x="11462" y="6399"/>
                  </a:cubicBezTo>
                  <a:moveTo>
                    <a:pt x="289" y="15648"/>
                  </a:moveTo>
                  <a:cubicBezTo>
                    <a:pt x="186" y="15184"/>
                    <a:pt x="110" y="14710"/>
                    <a:pt x="62" y="14229"/>
                  </a:cubicBezTo>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164" name="Cloud 163"/>
            <p:cNvSpPr/>
            <p:nvPr/>
          </p:nvSpPr>
          <p:spPr>
            <a:xfrm>
              <a:off x="2394416" y="3314743"/>
              <a:ext cx="875683" cy="622114"/>
            </a:xfrm>
            <a:custGeom>
              <a:avLst/>
              <a:gdLst>
                <a:gd name="connsiteX0" fmla="*/ 3900 w 43200"/>
                <a:gd name="connsiteY0" fmla="*/ 14370 h 43200"/>
                <a:gd name="connsiteX1" fmla="*/ 5623 w 43200"/>
                <a:gd name="connsiteY1" fmla="*/ 6907 h 43200"/>
                <a:gd name="connsiteX2" fmla="*/ 14005 w 43200"/>
                <a:gd name="connsiteY2" fmla="*/ 5202 h 43200"/>
                <a:gd name="connsiteX3" fmla="*/ 22456 w 43200"/>
                <a:gd name="connsiteY3" fmla="*/ 3432 h 43200"/>
                <a:gd name="connsiteX4" fmla="*/ 25749 w 43200"/>
                <a:gd name="connsiteY4" fmla="*/ 200 h 43200"/>
                <a:gd name="connsiteX5" fmla="*/ 29833 w 43200"/>
                <a:gd name="connsiteY5" fmla="*/ 2481 h 43200"/>
                <a:gd name="connsiteX6" fmla="*/ 35463 w 43200"/>
                <a:gd name="connsiteY6" fmla="*/ 690 h 43200"/>
                <a:gd name="connsiteX7" fmla="*/ 38318 w 43200"/>
                <a:gd name="connsiteY7" fmla="*/ 5576 h 43200"/>
                <a:gd name="connsiteX8" fmla="*/ 41982 w 43200"/>
                <a:gd name="connsiteY8" fmla="*/ 10318 h 43200"/>
                <a:gd name="connsiteX9" fmla="*/ 41818 w 43200"/>
                <a:gd name="connsiteY9" fmla="*/ 15460 h 43200"/>
                <a:gd name="connsiteX10" fmla="*/ 43016 w 43200"/>
                <a:gd name="connsiteY10" fmla="*/ 23322 h 43200"/>
                <a:gd name="connsiteX11" fmla="*/ 37404 w 43200"/>
                <a:gd name="connsiteY11" fmla="*/ 30204 h 43200"/>
                <a:gd name="connsiteX12" fmla="*/ 35395 w 43200"/>
                <a:gd name="connsiteY12" fmla="*/ 36101 h 43200"/>
                <a:gd name="connsiteX13" fmla="*/ 28555 w 43200"/>
                <a:gd name="connsiteY13" fmla="*/ 36815 h 43200"/>
                <a:gd name="connsiteX14" fmla="*/ 23667 w 43200"/>
                <a:gd name="connsiteY14" fmla="*/ 43106 h 43200"/>
                <a:gd name="connsiteX15" fmla="*/ 16480 w 43200"/>
                <a:gd name="connsiteY15" fmla="*/ 39266 h 43200"/>
                <a:gd name="connsiteX16" fmla="*/ 5804 w 43200"/>
                <a:gd name="connsiteY16" fmla="*/ 35472 h 43200"/>
                <a:gd name="connsiteX17" fmla="*/ 1110 w 43200"/>
                <a:gd name="connsiteY17" fmla="*/ 31250 h 43200"/>
                <a:gd name="connsiteX18" fmla="*/ 2113 w 43200"/>
                <a:gd name="connsiteY18" fmla="*/ 25551 h 43200"/>
                <a:gd name="connsiteX19" fmla="*/ -5 w 43200"/>
                <a:gd name="connsiteY19" fmla="*/ 19704 h 43200"/>
                <a:gd name="connsiteX20" fmla="*/ 3863 w 43200"/>
                <a:gd name="connsiteY20" fmla="*/ 14507 h 43200"/>
                <a:gd name="connsiteX21" fmla="*/ 3900 w 43200"/>
                <a:gd name="connsiteY21" fmla="*/ 14370 h 43200"/>
                <a:gd name="connsiteX0" fmla="*/ 4693 w 43200"/>
                <a:gd name="connsiteY0" fmla="*/ 26177 h 43200"/>
                <a:gd name="connsiteX1" fmla="*/ 2160 w 43200"/>
                <a:gd name="connsiteY1" fmla="*/ 25380 h 43200"/>
                <a:gd name="connsiteX2" fmla="*/ 6928 w 43200"/>
                <a:gd name="connsiteY2" fmla="*/ 34899 h 43200"/>
                <a:gd name="connsiteX3" fmla="*/ 5820 w 43200"/>
                <a:gd name="connsiteY3" fmla="*/ 35280 h 43200"/>
                <a:gd name="connsiteX4" fmla="*/ 16478 w 43200"/>
                <a:gd name="connsiteY4" fmla="*/ 39090 h 43200"/>
                <a:gd name="connsiteX5" fmla="*/ 15810 w 43200"/>
                <a:gd name="connsiteY5" fmla="*/ 37350 h 43200"/>
                <a:gd name="connsiteX6" fmla="*/ 28827 w 43200"/>
                <a:gd name="connsiteY6" fmla="*/ 34751 h 43200"/>
                <a:gd name="connsiteX7" fmla="*/ 28560 w 43200"/>
                <a:gd name="connsiteY7" fmla="*/ 36660 h 43200"/>
                <a:gd name="connsiteX8" fmla="*/ 34129 w 43200"/>
                <a:gd name="connsiteY8" fmla="*/ 22954 h 43200"/>
                <a:gd name="connsiteX9" fmla="*/ 37380 w 43200"/>
                <a:gd name="connsiteY9" fmla="*/ 30090 h 43200"/>
                <a:gd name="connsiteX10" fmla="*/ 41798 w 43200"/>
                <a:gd name="connsiteY10" fmla="*/ 15354 h 43200"/>
                <a:gd name="connsiteX11" fmla="*/ 40350 w 43200"/>
                <a:gd name="connsiteY11" fmla="*/ 18030 h 43200"/>
                <a:gd name="connsiteX12" fmla="*/ 38324 w 43200"/>
                <a:gd name="connsiteY12" fmla="*/ 5426 h 43200"/>
                <a:gd name="connsiteX13" fmla="*/ 38400 w 43200"/>
                <a:gd name="connsiteY13" fmla="*/ 6690 h 43200"/>
                <a:gd name="connsiteX14" fmla="*/ 29078 w 43200"/>
                <a:gd name="connsiteY14" fmla="*/ 3952 h 43200"/>
                <a:gd name="connsiteX15" fmla="*/ 29820 w 43200"/>
                <a:gd name="connsiteY15" fmla="*/ 2340 h 43200"/>
                <a:gd name="connsiteX16" fmla="*/ 22141 w 43200"/>
                <a:gd name="connsiteY16" fmla="*/ 4720 h 43200"/>
                <a:gd name="connsiteX17" fmla="*/ 22500 w 43200"/>
                <a:gd name="connsiteY17" fmla="*/ 3330 h 43200"/>
                <a:gd name="connsiteX18" fmla="*/ 14000 w 43200"/>
                <a:gd name="connsiteY18" fmla="*/ 5192 h 43200"/>
                <a:gd name="connsiteX19" fmla="*/ 15300 w 43200"/>
                <a:gd name="connsiteY19" fmla="*/ 6540 h 43200"/>
                <a:gd name="connsiteX20" fmla="*/ 4127 w 43200"/>
                <a:gd name="connsiteY20" fmla="*/ 15789 h 43200"/>
                <a:gd name="connsiteX21" fmla="*/ 3900 w 43200"/>
                <a:gd name="connsiteY21" fmla="*/ 14370 h 43200"/>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6964 w 43256"/>
                <a:gd name="connsiteY2" fmla="*/ 34758 h 43219"/>
                <a:gd name="connsiteX3" fmla="*/ 5856 w 43256"/>
                <a:gd name="connsiteY3" fmla="*/ 35139 h 43219"/>
                <a:gd name="connsiteX4" fmla="*/ 28863 w 43256"/>
                <a:gd name="connsiteY4" fmla="*/ 34610 h 43219"/>
                <a:gd name="connsiteX5" fmla="*/ 28596 w 43256"/>
                <a:gd name="connsiteY5" fmla="*/ 36519 h 43219"/>
                <a:gd name="connsiteX6" fmla="*/ 34165 w 43256"/>
                <a:gd name="connsiteY6" fmla="*/ 22813 h 43219"/>
                <a:gd name="connsiteX7" fmla="*/ 37416 w 43256"/>
                <a:gd name="connsiteY7" fmla="*/ 29949 h 43219"/>
                <a:gd name="connsiteX8" fmla="*/ 41834 w 43256"/>
                <a:gd name="connsiteY8" fmla="*/ 15213 h 43219"/>
                <a:gd name="connsiteX9" fmla="*/ 40386 w 43256"/>
                <a:gd name="connsiteY9" fmla="*/ 17889 h 43219"/>
                <a:gd name="connsiteX10" fmla="*/ 38360 w 43256"/>
                <a:gd name="connsiteY10" fmla="*/ 5285 h 43219"/>
                <a:gd name="connsiteX11" fmla="*/ 38436 w 43256"/>
                <a:gd name="connsiteY11" fmla="*/ 6549 h 43219"/>
                <a:gd name="connsiteX12" fmla="*/ 29114 w 43256"/>
                <a:gd name="connsiteY12" fmla="*/ 3811 h 43219"/>
                <a:gd name="connsiteX13" fmla="*/ 29856 w 43256"/>
                <a:gd name="connsiteY13" fmla="*/ 2199 h 43219"/>
                <a:gd name="connsiteX14" fmla="*/ 22177 w 43256"/>
                <a:gd name="connsiteY14" fmla="*/ 4579 h 43219"/>
                <a:gd name="connsiteX15" fmla="*/ 22536 w 43256"/>
                <a:gd name="connsiteY15" fmla="*/ 3189 h 43219"/>
                <a:gd name="connsiteX16" fmla="*/ 14036 w 43256"/>
                <a:gd name="connsiteY16" fmla="*/ 5051 h 43219"/>
                <a:gd name="connsiteX17" fmla="*/ 15336 w 43256"/>
                <a:gd name="connsiteY17" fmla="*/ 6399 h 43219"/>
                <a:gd name="connsiteX18" fmla="*/ 4163 w 43256"/>
                <a:gd name="connsiteY18" fmla="*/ 15648 h 43219"/>
                <a:gd name="connsiteX19" fmla="*/ 3936 w 43256"/>
                <a:gd name="connsiteY19"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6964 w 43256"/>
                <a:gd name="connsiteY2" fmla="*/ 34758 h 43219"/>
                <a:gd name="connsiteX3" fmla="*/ 5856 w 43256"/>
                <a:gd name="connsiteY3" fmla="*/ 35139 h 43219"/>
                <a:gd name="connsiteX4" fmla="*/ 34165 w 43256"/>
                <a:gd name="connsiteY4" fmla="*/ 22813 h 43219"/>
                <a:gd name="connsiteX5" fmla="*/ 37416 w 43256"/>
                <a:gd name="connsiteY5" fmla="*/ 29949 h 43219"/>
                <a:gd name="connsiteX6" fmla="*/ 41834 w 43256"/>
                <a:gd name="connsiteY6" fmla="*/ 15213 h 43219"/>
                <a:gd name="connsiteX7" fmla="*/ 40386 w 43256"/>
                <a:gd name="connsiteY7" fmla="*/ 17889 h 43219"/>
                <a:gd name="connsiteX8" fmla="*/ 38360 w 43256"/>
                <a:gd name="connsiteY8" fmla="*/ 5285 h 43219"/>
                <a:gd name="connsiteX9" fmla="*/ 38436 w 43256"/>
                <a:gd name="connsiteY9" fmla="*/ 6549 h 43219"/>
                <a:gd name="connsiteX10" fmla="*/ 29114 w 43256"/>
                <a:gd name="connsiteY10" fmla="*/ 3811 h 43219"/>
                <a:gd name="connsiteX11" fmla="*/ 29856 w 43256"/>
                <a:gd name="connsiteY11" fmla="*/ 2199 h 43219"/>
                <a:gd name="connsiteX12" fmla="*/ 22177 w 43256"/>
                <a:gd name="connsiteY12" fmla="*/ 4579 h 43219"/>
                <a:gd name="connsiteX13" fmla="*/ 22536 w 43256"/>
                <a:gd name="connsiteY13" fmla="*/ 3189 h 43219"/>
                <a:gd name="connsiteX14" fmla="*/ 14036 w 43256"/>
                <a:gd name="connsiteY14" fmla="*/ 5051 h 43219"/>
                <a:gd name="connsiteX15" fmla="*/ 15336 w 43256"/>
                <a:gd name="connsiteY15" fmla="*/ 6399 h 43219"/>
                <a:gd name="connsiteX16" fmla="*/ 4163 w 43256"/>
                <a:gd name="connsiteY16" fmla="*/ 15648 h 43219"/>
                <a:gd name="connsiteX17" fmla="*/ 3936 w 43256"/>
                <a:gd name="connsiteY17" fmla="*/ 14229 h 43219"/>
                <a:gd name="connsiteX0" fmla="*/ 3936 w 43256"/>
                <a:gd name="connsiteY0" fmla="*/ 14229 h 43087"/>
                <a:gd name="connsiteX1" fmla="*/ 5659 w 43256"/>
                <a:gd name="connsiteY1" fmla="*/ 6766 h 43087"/>
                <a:gd name="connsiteX2" fmla="*/ 14041 w 43256"/>
                <a:gd name="connsiteY2" fmla="*/ 5061 h 43087"/>
                <a:gd name="connsiteX3" fmla="*/ 22492 w 43256"/>
                <a:gd name="connsiteY3" fmla="*/ 3291 h 43087"/>
                <a:gd name="connsiteX4" fmla="*/ 25785 w 43256"/>
                <a:gd name="connsiteY4" fmla="*/ 59 h 43087"/>
                <a:gd name="connsiteX5" fmla="*/ 29869 w 43256"/>
                <a:gd name="connsiteY5" fmla="*/ 2340 h 43087"/>
                <a:gd name="connsiteX6" fmla="*/ 35499 w 43256"/>
                <a:gd name="connsiteY6" fmla="*/ 549 h 43087"/>
                <a:gd name="connsiteX7" fmla="*/ 38354 w 43256"/>
                <a:gd name="connsiteY7" fmla="*/ 5435 h 43087"/>
                <a:gd name="connsiteX8" fmla="*/ 42018 w 43256"/>
                <a:gd name="connsiteY8" fmla="*/ 10177 h 43087"/>
                <a:gd name="connsiteX9" fmla="*/ 41854 w 43256"/>
                <a:gd name="connsiteY9" fmla="*/ 15319 h 43087"/>
                <a:gd name="connsiteX10" fmla="*/ 43052 w 43256"/>
                <a:gd name="connsiteY10" fmla="*/ 23181 h 43087"/>
                <a:gd name="connsiteX11" fmla="*/ 37440 w 43256"/>
                <a:gd name="connsiteY11" fmla="*/ 30063 h 43087"/>
                <a:gd name="connsiteX12" fmla="*/ 35431 w 43256"/>
                <a:gd name="connsiteY12" fmla="*/ 35960 h 43087"/>
                <a:gd name="connsiteX13" fmla="*/ 23703 w 43256"/>
                <a:gd name="connsiteY13" fmla="*/ 42965 h 43087"/>
                <a:gd name="connsiteX14" fmla="*/ 16516 w 43256"/>
                <a:gd name="connsiteY14" fmla="*/ 39125 h 43087"/>
                <a:gd name="connsiteX15" fmla="*/ 5840 w 43256"/>
                <a:gd name="connsiteY15" fmla="*/ 35331 h 43087"/>
                <a:gd name="connsiteX16" fmla="*/ 1146 w 43256"/>
                <a:gd name="connsiteY16" fmla="*/ 31109 h 43087"/>
                <a:gd name="connsiteX17" fmla="*/ 2149 w 43256"/>
                <a:gd name="connsiteY17" fmla="*/ 25410 h 43087"/>
                <a:gd name="connsiteX18" fmla="*/ 31 w 43256"/>
                <a:gd name="connsiteY18" fmla="*/ 19563 h 43087"/>
                <a:gd name="connsiteX19" fmla="*/ 3899 w 43256"/>
                <a:gd name="connsiteY19" fmla="*/ 14366 h 43087"/>
                <a:gd name="connsiteX20" fmla="*/ 3936 w 43256"/>
                <a:gd name="connsiteY20" fmla="*/ 14229 h 43087"/>
                <a:gd name="connsiteX0" fmla="*/ 4729 w 43256"/>
                <a:gd name="connsiteY0" fmla="*/ 26036 h 43087"/>
                <a:gd name="connsiteX1" fmla="*/ 2196 w 43256"/>
                <a:gd name="connsiteY1" fmla="*/ 25239 h 43087"/>
                <a:gd name="connsiteX2" fmla="*/ 6964 w 43256"/>
                <a:gd name="connsiteY2" fmla="*/ 34758 h 43087"/>
                <a:gd name="connsiteX3" fmla="*/ 5856 w 43256"/>
                <a:gd name="connsiteY3" fmla="*/ 35139 h 43087"/>
                <a:gd name="connsiteX4" fmla="*/ 34165 w 43256"/>
                <a:gd name="connsiteY4" fmla="*/ 22813 h 43087"/>
                <a:gd name="connsiteX5" fmla="*/ 37416 w 43256"/>
                <a:gd name="connsiteY5" fmla="*/ 29949 h 43087"/>
                <a:gd name="connsiteX6" fmla="*/ 41834 w 43256"/>
                <a:gd name="connsiteY6" fmla="*/ 15213 h 43087"/>
                <a:gd name="connsiteX7" fmla="*/ 40386 w 43256"/>
                <a:gd name="connsiteY7" fmla="*/ 17889 h 43087"/>
                <a:gd name="connsiteX8" fmla="*/ 38360 w 43256"/>
                <a:gd name="connsiteY8" fmla="*/ 5285 h 43087"/>
                <a:gd name="connsiteX9" fmla="*/ 38436 w 43256"/>
                <a:gd name="connsiteY9" fmla="*/ 6549 h 43087"/>
                <a:gd name="connsiteX10" fmla="*/ 29114 w 43256"/>
                <a:gd name="connsiteY10" fmla="*/ 3811 h 43087"/>
                <a:gd name="connsiteX11" fmla="*/ 29856 w 43256"/>
                <a:gd name="connsiteY11" fmla="*/ 2199 h 43087"/>
                <a:gd name="connsiteX12" fmla="*/ 22177 w 43256"/>
                <a:gd name="connsiteY12" fmla="*/ 4579 h 43087"/>
                <a:gd name="connsiteX13" fmla="*/ 22536 w 43256"/>
                <a:gd name="connsiteY13" fmla="*/ 3189 h 43087"/>
                <a:gd name="connsiteX14" fmla="*/ 14036 w 43256"/>
                <a:gd name="connsiteY14" fmla="*/ 5051 h 43087"/>
                <a:gd name="connsiteX15" fmla="*/ 15336 w 43256"/>
                <a:gd name="connsiteY15" fmla="*/ 6399 h 43087"/>
                <a:gd name="connsiteX16" fmla="*/ 4163 w 43256"/>
                <a:gd name="connsiteY16" fmla="*/ 15648 h 43087"/>
                <a:gd name="connsiteX17" fmla="*/ 3936 w 43256"/>
                <a:gd name="connsiteY17" fmla="*/ 14229 h 43087"/>
                <a:gd name="connsiteX0" fmla="*/ 3936 w 43256"/>
                <a:gd name="connsiteY0" fmla="*/ 14229 h 40633"/>
                <a:gd name="connsiteX1" fmla="*/ 5659 w 43256"/>
                <a:gd name="connsiteY1" fmla="*/ 6766 h 40633"/>
                <a:gd name="connsiteX2" fmla="*/ 14041 w 43256"/>
                <a:gd name="connsiteY2" fmla="*/ 5061 h 40633"/>
                <a:gd name="connsiteX3" fmla="*/ 22492 w 43256"/>
                <a:gd name="connsiteY3" fmla="*/ 3291 h 40633"/>
                <a:gd name="connsiteX4" fmla="*/ 25785 w 43256"/>
                <a:gd name="connsiteY4" fmla="*/ 59 h 40633"/>
                <a:gd name="connsiteX5" fmla="*/ 29869 w 43256"/>
                <a:gd name="connsiteY5" fmla="*/ 2340 h 40633"/>
                <a:gd name="connsiteX6" fmla="*/ 35499 w 43256"/>
                <a:gd name="connsiteY6" fmla="*/ 549 h 40633"/>
                <a:gd name="connsiteX7" fmla="*/ 38354 w 43256"/>
                <a:gd name="connsiteY7" fmla="*/ 5435 h 40633"/>
                <a:gd name="connsiteX8" fmla="*/ 42018 w 43256"/>
                <a:gd name="connsiteY8" fmla="*/ 10177 h 40633"/>
                <a:gd name="connsiteX9" fmla="*/ 41854 w 43256"/>
                <a:gd name="connsiteY9" fmla="*/ 15319 h 40633"/>
                <a:gd name="connsiteX10" fmla="*/ 43052 w 43256"/>
                <a:gd name="connsiteY10" fmla="*/ 23181 h 40633"/>
                <a:gd name="connsiteX11" fmla="*/ 37440 w 43256"/>
                <a:gd name="connsiteY11" fmla="*/ 30063 h 40633"/>
                <a:gd name="connsiteX12" fmla="*/ 35431 w 43256"/>
                <a:gd name="connsiteY12" fmla="*/ 35960 h 40633"/>
                <a:gd name="connsiteX13" fmla="*/ 16516 w 43256"/>
                <a:gd name="connsiteY13" fmla="*/ 39125 h 40633"/>
                <a:gd name="connsiteX14" fmla="*/ 5840 w 43256"/>
                <a:gd name="connsiteY14" fmla="*/ 35331 h 40633"/>
                <a:gd name="connsiteX15" fmla="*/ 1146 w 43256"/>
                <a:gd name="connsiteY15" fmla="*/ 31109 h 40633"/>
                <a:gd name="connsiteX16" fmla="*/ 2149 w 43256"/>
                <a:gd name="connsiteY16" fmla="*/ 25410 h 40633"/>
                <a:gd name="connsiteX17" fmla="*/ 31 w 43256"/>
                <a:gd name="connsiteY17" fmla="*/ 19563 h 40633"/>
                <a:gd name="connsiteX18" fmla="*/ 3899 w 43256"/>
                <a:gd name="connsiteY18" fmla="*/ 14366 h 40633"/>
                <a:gd name="connsiteX19" fmla="*/ 3936 w 43256"/>
                <a:gd name="connsiteY19" fmla="*/ 14229 h 40633"/>
                <a:gd name="connsiteX0" fmla="*/ 4729 w 43256"/>
                <a:gd name="connsiteY0" fmla="*/ 26036 h 40633"/>
                <a:gd name="connsiteX1" fmla="*/ 2196 w 43256"/>
                <a:gd name="connsiteY1" fmla="*/ 25239 h 40633"/>
                <a:gd name="connsiteX2" fmla="*/ 6964 w 43256"/>
                <a:gd name="connsiteY2" fmla="*/ 34758 h 40633"/>
                <a:gd name="connsiteX3" fmla="*/ 5856 w 43256"/>
                <a:gd name="connsiteY3" fmla="*/ 35139 h 40633"/>
                <a:gd name="connsiteX4" fmla="*/ 34165 w 43256"/>
                <a:gd name="connsiteY4" fmla="*/ 22813 h 40633"/>
                <a:gd name="connsiteX5" fmla="*/ 37416 w 43256"/>
                <a:gd name="connsiteY5" fmla="*/ 29949 h 40633"/>
                <a:gd name="connsiteX6" fmla="*/ 41834 w 43256"/>
                <a:gd name="connsiteY6" fmla="*/ 15213 h 40633"/>
                <a:gd name="connsiteX7" fmla="*/ 40386 w 43256"/>
                <a:gd name="connsiteY7" fmla="*/ 17889 h 40633"/>
                <a:gd name="connsiteX8" fmla="*/ 38360 w 43256"/>
                <a:gd name="connsiteY8" fmla="*/ 5285 h 40633"/>
                <a:gd name="connsiteX9" fmla="*/ 38436 w 43256"/>
                <a:gd name="connsiteY9" fmla="*/ 6549 h 40633"/>
                <a:gd name="connsiteX10" fmla="*/ 29114 w 43256"/>
                <a:gd name="connsiteY10" fmla="*/ 3811 h 40633"/>
                <a:gd name="connsiteX11" fmla="*/ 29856 w 43256"/>
                <a:gd name="connsiteY11" fmla="*/ 2199 h 40633"/>
                <a:gd name="connsiteX12" fmla="*/ 22177 w 43256"/>
                <a:gd name="connsiteY12" fmla="*/ 4579 h 40633"/>
                <a:gd name="connsiteX13" fmla="*/ 22536 w 43256"/>
                <a:gd name="connsiteY13" fmla="*/ 3189 h 40633"/>
                <a:gd name="connsiteX14" fmla="*/ 14036 w 43256"/>
                <a:gd name="connsiteY14" fmla="*/ 5051 h 40633"/>
                <a:gd name="connsiteX15" fmla="*/ 15336 w 43256"/>
                <a:gd name="connsiteY15" fmla="*/ 6399 h 40633"/>
                <a:gd name="connsiteX16" fmla="*/ 4163 w 43256"/>
                <a:gd name="connsiteY16" fmla="*/ 15648 h 40633"/>
                <a:gd name="connsiteX17" fmla="*/ 3936 w 43256"/>
                <a:gd name="connsiteY17" fmla="*/ 14229 h 40633"/>
                <a:gd name="connsiteX0" fmla="*/ 3936 w 43256"/>
                <a:gd name="connsiteY0" fmla="*/ 14229 h 36366"/>
                <a:gd name="connsiteX1" fmla="*/ 5659 w 43256"/>
                <a:gd name="connsiteY1" fmla="*/ 6766 h 36366"/>
                <a:gd name="connsiteX2" fmla="*/ 14041 w 43256"/>
                <a:gd name="connsiteY2" fmla="*/ 5061 h 36366"/>
                <a:gd name="connsiteX3" fmla="*/ 22492 w 43256"/>
                <a:gd name="connsiteY3" fmla="*/ 3291 h 36366"/>
                <a:gd name="connsiteX4" fmla="*/ 25785 w 43256"/>
                <a:gd name="connsiteY4" fmla="*/ 59 h 36366"/>
                <a:gd name="connsiteX5" fmla="*/ 29869 w 43256"/>
                <a:gd name="connsiteY5" fmla="*/ 2340 h 36366"/>
                <a:gd name="connsiteX6" fmla="*/ 35499 w 43256"/>
                <a:gd name="connsiteY6" fmla="*/ 549 h 36366"/>
                <a:gd name="connsiteX7" fmla="*/ 38354 w 43256"/>
                <a:gd name="connsiteY7" fmla="*/ 5435 h 36366"/>
                <a:gd name="connsiteX8" fmla="*/ 42018 w 43256"/>
                <a:gd name="connsiteY8" fmla="*/ 10177 h 36366"/>
                <a:gd name="connsiteX9" fmla="*/ 41854 w 43256"/>
                <a:gd name="connsiteY9" fmla="*/ 15319 h 36366"/>
                <a:gd name="connsiteX10" fmla="*/ 43052 w 43256"/>
                <a:gd name="connsiteY10" fmla="*/ 23181 h 36366"/>
                <a:gd name="connsiteX11" fmla="*/ 37440 w 43256"/>
                <a:gd name="connsiteY11" fmla="*/ 30063 h 36366"/>
                <a:gd name="connsiteX12" fmla="*/ 35431 w 43256"/>
                <a:gd name="connsiteY12" fmla="*/ 35960 h 36366"/>
                <a:gd name="connsiteX13" fmla="*/ 5840 w 43256"/>
                <a:gd name="connsiteY13" fmla="*/ 35331 h 36366"/>
                <a:gd name="connsiteX14" fmla="*/ 1146 w 43256"/>
                <a:gd name="connsiteY14" fmla="*/ 31109 h 36366"/>
                <a:gd name="connsiteX15" fmla="*/ 2149 w 43256"/>
                <a:gd name="connsiteY15" fmla="*/ 25410 h 36366"/>
                <a:gd name="connsiteX16" fmla="*/ 31 w 43256"/>
                <a:gd name="connsiteY16" fmla="*/ 19563 h 36366"/>
                <a:gd name="connsiteX17" fmla="*/ 3899 w 43256"/>
                <a:gd name="connsiteY17" fmla="*/ 14366 h 36366"/>
                <a:gd name="connsiteX18" fmla="*/ 3936 w 43256"/>
                <a:gd name="connsiteY18" fmla="*/ 14229 h 36366"/>
                <a:gd name="connsiteX0" fmla="*/ 4729 w 43256"/>
                <a:gd name="connsiteY0" fmla="*/ 26036 h 36366"/>
                <a:gd name="connsiteX1" fmla="*/ 2196 w 43256"/>
                <a:gd name="connsiteY1" fmla="*/ 25239 h 36366"/>
                <a:gd name="connsiteX2" fmla="*/ 6964 w 43256"/>
                <a:gd name="connsiteY2" fmla="*/ 34758 h 36366"/>
                <a:gd name="connsiteX3" fmla="*/ 5856 w 43256"/>
                <a:gd name="connsiteY3" fmla="*/ 35139 h 36366"/>
                <a:gd name="connsiteX4" fmla="*/ 34165 w 43256"/>
                <a:gd name="connsiteY4" fmla="*/ 22813 h 36366"/>
                <a:gd name="connsiteX5" fmla="*/ 37416 w 43256"/>
                <a:gd name="connsiteY5" fmla="*/ 29949 h 36366"/>
                <a:gd name="connsiteX6" fmla="*/ 41834 w 43256"/>
                <a:gd name="connsiteY6" fmla="*/ 15213 h 36366"/>
                <a:gd name="connsiteX7" fmla="*/ 40386 w 43256"/>
                <a:gd name="connsiteY7" fmla="*/ 17889 h 36366"/>
                <a:gd name="connsiteX8" fmla="*/ 38360 w 43256"/>
                <a:gd name="connsiteY8" fmla="*/ 5285 h 36366"/>
                <a:gd name="connsiteX9" fmla="*/ 38436 w 43256"/>
                <a:gd name="connsiteY9" fmla="*/ 6549 h 36366"/>
                <a:gd name="connsiteX10" fmla="*/ 29114 w 43256"/>
                <a:gd name="connsiteY10" fmla="*/ 3811 h 36366"/>
                <a:gd name="connsiteX11" fmla="*/ 29856 w 43256"/>
                <a:gd name="connsiteY11" fmla="*/ 2199 h 36366"/>
                <a:gd name="connsiteX12" fmla="*/ 22177 w 43256"/>
                <a:gd name="connsiteY12" fmla="*/ 4579 h 36366"/>
                <a:gd name="connsiteX13" fmla="*/ 22536 w 43256"/>
                <a:gd name="connsiteY13" fmla="*/ 3189 h 36366"/>
                <a:gd name="connsiteX14" fmla="*/ 14036 w 43256"/>
                <a:gd name="connsiteY14" fmla="*/ 5051 h 36366"/>
                <a:gd name="connsiteX15" fmla="*/ 15336 w 43256"/>
                <a:gd name="connsiteY15" fmla="*/ 6399 h 36366"/>
                <a:gd name="connsiteX16" fmla="*/ 4163 w 43256"/>
                <a:gd name="connsiteY16" fmla="*/ 15648 h 36366"/>
                <a:gd name="connsiteX17" fmla="*/ 3936 w 43256"/>
                <a:gd name="connsiteY17" fmla="*/ 14229 h 36366"/>
                <a:gd name="connsiteX0" fmla="*/ 3936 w 43256"/>
                <a:gd name="connsiteY0" fmla="*/ 14229 h 36005"/>
                <a:gd name="connsiteX1" fmla="*/ 5659 w 43256"/>
                <a:gd name="connsiteY1" fmla="*/ 6766 h 36005"/>
                <a:gd name="connsiteX2" fmla="*/ 14041 w 43256"/>
                <a:gd name="connsiteY2" fmla="*/ 5061 h 36005"/>
                <a:gd name="connsiteX3" fmla="*/ 22492 w 43256"/>
                <a:gd name="connsiteY3" fmla="*/ 3291 h 36005"/>
                <a:gd name="connsiteX4" fmla="*/ 25785 w 43256"/>
                <a:gd name="connsiteY4" fmla="*/ 59 h 36005"/>
                <a:gd name="connsiteX5" fmla="*/ 29869 w 43256"/>
                <a:gd name="connsiteY5" fmla="*/ 2340 h 36005"/>
                <a:gd name="connsiteX6" fmla="*/ 35499 w 43256"/>
                <a:gd name="connsiteY6" fmla="*/ 549 h 36005"/>
                <a:gd name="connsiteX7" fmla="*/ 38354 w 43256"/>
                <a:gd name="connsiteY7" fmla="*/ 5435 h 36005"/>
                <a:gd name="connsiteX8" fmla="*/ 42018 w 43256"/>
                <a:gd name="connsiteY8" fmla="*/ 10177 h 36005"/>
                <a:gd name="connsiteX9" fmla="*/ 41854 w 43256"/>
                <a:gd name="connsiteY9" fmla="*/ 15319 h 36005"/>
                <a:gd name="connsiteX10" fmla="*/ 43052 w 43256"/>
                <a:gd name="connsiteY10" fmla="*/ 23181 h 36005"/>
                <a:gd name="connsiteX11" fmla="*/ 37440 w 43256"/>
                <a:gd name="connsiteY11" fmla="*/ 30063 h 36005"/>
                <a:gd name="connsiteX12" fmla="*/ 31824 w 43256"/>
                <a:gd name="connsiteY12" fmla="*/ 35409 h 36005"/>
                <a:gd name="connsiteX13" fmla="*/ 5840 w 43256"/>
                <a:gd name="connsiteY13" fmla="*/ 35331 h 36005"/>
                <a:gd name="connsiteX14" fmla="*/ 1146 w 43256"/>
                <a:gd name="connsiteY14" fmla="*/ 31109 h 36005"/>
                <a:gd name="connsiteX15" fmla="*/ 2149 w 43256"/>
                <a:gd name="connsiteY15" fmla="*/ 25410 h 36005"/>
                <a:gd name="connsiteX16" fmla="*/ 31 w 43256"/>
                <a:gd name="connsiteY16" fmla="*/ 19563 h 36005"/>
                <a:gd name="connsiteX17" fmla="*/ 3899 w 43256"/>
                <a:gd name="connsiteY17" fmla="*/ 14366 h 36005"/>
                <a:gd name="connsiteX18" fmla="*/ 3936 w 43256"/>
                <a:gd name="connsiteY18" fmla="*/ 14229 h 36005"/>
                <a:gd name="connsiteX0" fmla="*/ 4729 w 43256"/>
                <a:gd name="connsiteY0" fmla="*/ 26036 h 36005"/>
                <a:gd name="connsiteX1" fmla="*/ 2196 w 43256"/>
                <a:gd name="connsiteY1" fmla="*/ 25239 h 36005"/>
                <a:gd name="connsiteX2" fmla="*/ 6964 w 43256"/>
                <a:gd name="connsiteY2" fmla="*/ 34758 h 36005"/>
                <a:gd name="connsiteX3" fmla="*/ 5856 w 43256"/>
                <a:gd name="connsiteY3" fmla="*/ 35139 h 36005"/>
                <a:gd name="connsiteX4" fmla="*/ 34165 w 43256"/>
                <a:gd name="connsiteY4" fmla="*/ 22813 h 36005"/>
                <a:gd name="connsiteX5" fmla="*/ 37416 w 43256"/>
                <a:gd name="connsiteY5" fmla="*/ 29949 h 36005"/>
                <a:gd name="connsiteX6" fmla="*/ 41834 w 43256"/>
                <a:gd name="connsiteY6" fmla="*/ 15213 h 36005"/>
                <a:gd name="connsiteX7" fmla="*/ 40386 w 43256"/>
                <a:gd name="connsiteY7" fmla="*/ 17889 h 36005"/>
                <a:gd name="connsiteX8" fmla="*/ 38360 w 43256"/>
                <a:gd name="connsiteY8" fmla="*/ 5285 h 36005"/>
                <a:gd name="connsiteX9" fmla="*/ 38436 w 43256"/>
                <a:gd name="connsiteY9" fmla="*/ 6549 h 36005"/>
                <a:gd name="connsiteX10" fmla="*/ 29114 w 43256"/>
                <a:gd name="connsiteY10" fmla="*/ 3811 h 36005"/>
                <a:gd name="connsiteX11" fmla="*/ 29856 w 43256"/>
                <a:gd name="connsiteY11" fmla="*/ 2199 h 36005"/>
                <a:gd name="connsiteX12" fmla="*/ 22177 w 43256"/>
                <a:gd name="connsiteY12" fmla="*/ 4579 h 36005"/>
                <a:gd name="connsiteX13" fmla="*/ 22536 w 43256"/>
                <a:gd name="connsiteY13" fmla="*/ 3189 h 36005"/>
                <a:gd name="connsiteX14" fmla="*/ 14036 w 43256"/>
                <a:gd name="connsiteY14" fmla="*/ 5051 h 36005"/>
                <a:gd name="connsiteX15" fmla="*/ 15336 w 43256"/>
                <a:gd name="connsiteY15" fmla="*/ 6399 h 36005"/>
                <a:gd name="connsiteX16" fmla="*/ 4163 w 43256"/>
                <a:gd name="connsiteY16" fmla="*/ 15648 h 36005"/>
                <a:gd name="connsiteX17" fmla="*/ 3936 w 43256"/>
                <a:gd name="connsiteY17" fmla="*/ 14229 h 36005"/>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 ang="0">
                  <a:pos x="connsiteX10" y="connsiteY10"/>
                </a:cxn>
                <a:cxn ang="0">
                  <a:pos x="connsiteX11" y="connsiteY11"/>
                </a:cxn>
                <a:cxn ang="0">
                  <a:pos x="connsiteX12" y="connsiteY12"/>
                </a:cxn>
                <a:cxn ang="0">
                  <a:pos x="connsiteX13" y="connsiteY13"/>
                </a:cxn>
                <a:cxn ang="0">
                  <a:pos x="connsiteX14" y="connsiteY14"/>
                </a:cxn>
                <a:cxn ang="0">
                  <a:pos x="connsiteX15" y="connsiteY15"/>
                </a:cxn>
                <a:cxn ang="0">
                  <a:pos x="connsiteX16" y="connsiteY16"/>
                </a:cxn>
                <a:cxn ang="0">
                  <a:pos x="connsiteX17" y="connsiteY17"/>
                </a:cxn>
              </a:cxnLst>
              <a:rect l="l" t="t" r="r" b="b"/>
              <a:pathLst>
                <a:path w="43256" h="36005">
                  <a:moveTo>
                    <a:pt x="3936" y="14229"/>
                  </a:moveTo>
                  <a:cubicBezTo>
                    <a:pt x="3665" y="11516"/>
                    <a:pt x="4297" y="8780"/>
                    <a:pt x="5659" y="6766"/>
                  </a:cubicBezTo>
                  <a:cubicBezTo>
                    <a:pt x="7811" y="3585"/>
                    <a:pt x="11300" y="2876"/>
                    <a:pt x="14041" y="5061"/>
                  </a:cubicBezTo>
                  <a:cubicBezTo>
                    <a:pt x="15714" y="768"/>
                    <a:pt x="19950" y="-119"/>
                    <a:pt x="22492" y="3291"/>
                  </a:cubicBezTo>
                  <a:cubicBezTo>
                    <a:pt x="23133" y="1542"/>
                    <a:pt x="24364" y="333"/>
                    <a:pt x="25785" y="59"/>
                  </a:cubicBezTo>
                  <a:cubicBezTo>
                    <a:pt x="27349" y="-243"/>
                    <a:pt x="28911" y="629"/>
                    <a:pt x="29869" y="2340"/>
                  </a:cubicBezTo>
                  <a:cubicBezTo>
                    <a:pt x="31251" y="126"/>
                    <a:pt x="33537" y="-601"/>
                    <a:pt x="35499" y="549"/>
                  </a:cubicBezTo>
                  <a:cubicBezTo>
                    <a:pt x="36994" y="1425"/>
                    <a:pt x="38066" y="3259"/>
                    <a:pt x="38354" y="5435"/>
                  </a:cubicBezTo>
                  <a:cubicBezTo>
                    <a:pt x="40082" y="6077"/>
                    <a:pt x="41458" y="7857"/>
                    <a:pt x="42018" y="10177"/>
                  </a:cubicBezTo>
                  <a:cubicBezTo>
                    <a:pt x="42425" y="11861"/>
                    <a:pt x="42367" y="13690"/>
                    <a:pt x="41854" y="15319"/>
                  </a:cubicBezTo>
                  <a:cubicBezTo>
                    <a:pt x="43115" y="17553"/>
                    <a:pt x="43556" y="20449"/>
                    <a:pt x="43052" y="23181"/>
                  </a:cubicBezTo>
                  <a:cubicBezTo>
                    <a:pt x="42382" y="26813"/>
                    <a:pt x="40164" y="29533"/>
                    <a:pt x="37440" y="30063"/>
                  </a:cubicBezTo>
                  <a:cubicBezTo>
                    <a:pt x="37427" y="32330"/>
                    <a:pt x="37091" y="34531"/>
                    <a:pt x="31824" y="35409"/>
                  </a:cubicBezTo>
                  <a:cubicBezTo>
                    <a:pt x="26557" y="36287"/>
                    <a:pt x="11554" y="36140"/>
                    <a:pt x="5840" y="35331"/>
                  </a:cubicBezTo>
                  <a:cubicBezTo>
                    <a:pt x="3726" y="35668"/>
                    <a:pt x="1741" y="33883"/>
                    <a:pt x="1146" y="31109"/>
                  </a:cubicBezTo>
                  <a:cubicBezTo>
                    <a:pt x="715" y="29102"/>
                    <a:pt x="1096" y="26936"/>
                    <a:pt x="2149" y="25410"/>
                  </a:cubicBezTo>
                  <a:cubicBezTo>
                    <a:pt x="655" y="24213"/>
                    <a:pt x="-177" y="21916"/>
                    <a:pt x="31" y="19563"/>
                  </a:cubicBezTo>
                  <a:cubicBezTo>
                    <a:pt x="275" y="16808"/>
                    <a:pt x="1881" y="14650"/>
                    <a:pt x="3899" y="14366"/>
                  </a:cubicBezTo>
                  <a:cubicBezTo>
                    <a:pt x="3911" y="14320"/>
                    <a:pt x="3924" y="14275"/>
                    <a:pt x="3936" y="14229"/>
                  </a:cubicBezTo>
                  <a:close/>
                </a:path>
                <a:path w="43256" h="36005" fill="none" extrusionOk="0">
                  <a:moveTo>
                    <a:pt x="4729" y="26036"/>
                  </a:moveTo>
                  <a:cubicBezTo>
                    <a:pt x="3845" y="26130"/>
                    <a:pt x="2961" y="25852"/>
                    <a:pt x="2196" y="25239"/>
                  </a:cubicBezTo>
                  <a:moveTo>
                    <a:pt x="6964" y="34758"/>
                  </a:moveTo>
                  <a:cubicBezTo>
                    <a:pt x="6609" y="34951"/>
                    <a:pt x="6236" y="35079"/>
                    <a:pt x="5856" y="35139"/>
                  </a:cubicBezTo>
                  <a:moveTo>
                    <a:pt x="34165" y="22813"/>
                  </a:moveTo>
                  <a:cubicBezTo>
                    <a:pt x="36169" y="24141"/>
                    <a:pt x="37434" y="26917"/>
                    <a:pt x="37416" y="29949"/>
                  </a:cubicBezTo>
                  <a:moveTo>
                    <a:pt x="41834" y="15213"/>
                  </a:moveTo>
                  <a:cubicBezTo>
                    <a:pt x="41509" y="16245"/>
                    <a:pt x="41014" y="17161"/>
                    <a:pt x="40386" y="17889"/>
                  </a:cubicBezTo>
                  <a:moveTo>
                    <a:pt x="38360" y="5285"/>
                  </a:moveTo>
                  <a:cubicBezTo>
                    <a:pt x="38415" y="5702"/>
                    <a:pt x="38441" y="6125"/>
                    <a:pt x="38436" y="6549"/>
                  </a:cubicBezTo>
                  <a:moveTo>
                    <a:pt x="29114" y="3811"/>
                  </a:moveTo>
                  <a:cubicBezTo>
                    <a:pt x="29303" y="3228"/>
                    <a:pt x="29552" y="2685"/>
                    <a:pt x="29856" y="2199"/>
                  </a:cubicBezTo>
                  <a:moveTo>
                    <a:pt x="22177" y="4579"/>
                  </a:moveTo>
                  <a:cubicBezTo>
                    <a:pt x="22254" y="4097"/>
                    <a:pt x="22375" y="3630"/>
                    <a:pt x="22536" y="3189"/>
                  </a:cubicBezTo>
                  <a:moveTo>
                    <a:pt x="14036" y="5051"/>
                  </a:moveTo>
                  <a:cubicBezTo>
                    <a:pt x="14508" y="5427"/>
                    <a:pt x="14944" y="5880"/>
                    <a:pt x="15336" y="6399"/>
                  </a:cubicBezTo>
                  <a:moveTo>
                    <a:pt x="4163" y="15648"/>
                  </a:moveTo>
                  <a:cubicBezTo>
                    <a:pt x="4060" y="15184"/>
                    <a:pt x="3984" y="14710"/>
                    <a:pt x="3936" y="14229"/>
                  </a:cubicBezTo>
                </a:path>
              </a:pathLst>
            </a:custGeom>
            <a:solidFill>
              <a:schemeClr val="tx1">
                <a:alpha val="15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sp>
        <p:nvSpPr>
          <p:cNvPr id="169" name="TextBox 168"/>
          <p:cNvSpPr txBox="1"/>
          <p:nvPr/>
        </p:nvSpPr>
        <p:spPr>
          <a:xfrm>
            <a:off x="1924037" y="1726238"/>
            <a:ext cx="1420976" cy="219291"/>
          </a:xfrm>
          <a:prstGeom prst="rect">
            <a:avLst/>
          </a:prstGeom>
          <a:noFill/>
        </p:spPr>
        <p:txBody>
          <a:bodyPr wrap="square" rtlCol="0">
            <a:spAutoFit/>
          </a:bodyPr>
          <a:lstStyle/>
          <a:p>
            <a:r>
              <a:rPr lang="en-GB" sz="825" dirty="0"/>
              <a:t>U-bottom 96 Well Plate</a:t>
            </a:r>
          </a:p>
        </p:txBody>
      </p:sp>
      <p:sp>
        <p:nvSpPr>
          <p:cNvPr id="170" name="TextBox 18">
            <a:extLst>
              <a:ext uri="{FF2B5EF4-FFF2-40B4-BE49-F238E27FC236}">
                <a16:creationId xmlns:a16="http://schemas.microsoft.com/office/drawing/2014/main" id="{B1150B2B-08BC-48DF-A5E6-29F896C69744}"/>
              </a:ext>
            </a:extLst>
          </p:cNvPr>
          <p:cNvSpPr txBox="1"/>
          <p:nvPr/>
        </p:nvSpPr>
        <p:spPr>
          <a:xfrm>
            <a:off x="561975" y="8422"/>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171" name="TextBox 18">
            <a:extLst>
              <a:ext uri="{FF2B5EF4-FFF2-40B4-BE49-F238E27FC236}">
                <a16:creationId xmlns:a16="http://schemas.microsoft.com/office/drawing/2014/main" id="{B1150B2B-08BC-48DF-A5E6-29F896C69744}"/>
              </a:ext>
            </a:extLst>
          </p:cNvPr>
          <p:cNvSpPr txBox="1"/>
          <p:nvPr/>
        </p:nvSpPr>
        <p:spPr>
          <a:xfrm>
            <a:off x="561975" y="2229142"/>
            <a:ext cx="303348" cy="32553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172" name="TextBox 18">
            <a:extLst>
              <a:ext uri="{FF2B5EF4-FFF2-40B4-BE49-F238E27FC236}">
                <a16:creationId xmlns:a16="http://schemas.microsoft.com/office/drawing/2014/main" id="{B1150B2B-08BC-48DF-A5E6-29F896C69744}"/>
              </a:ext>
            </a:extLst>
          </p:cNvPr>
          <p:cNvSpPr txBox="1"/>
          <p:nvPr/>
        </p:nvSpPr>
        <p:spPr>
          <a:xfrm>
            <a:off x="2453539" y="2229142"/>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173" name="TextBox 18">
            <a:extLst>
              <a:ext uri="{FF2B5EF4-FFF2-40B4-BE49-F238E27FC236}">
                <a16:creationId xmlns:a16="http://schemas.microsoft.com/office/drawing/2014/main" id="{B1150B2B-08BC-48DF-A5E6-29F896C69744}"/>
              </a:ext>
            </a:extLst>
          </p:cNvPr>
          <p:cNvSpPr txBox="1"/>
          <p:nvPr/>
        </p:nvSpPr>
        <p:spPr>
          <a:xfrm>
            <a:off x="4666256" y="2229142"/>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
            </a:r>
            <a:endParaRPr lang="en-GB" sz="1200" dirty="0">
              <a:effectLst/>
              <a:latin typeface="Times New Roman" panose="02020603050405020304" pitchFamily="18" charset="0"/>
              <a:ea typeface="Times New Roman" panose="02020603050405020304" pitchFamily="18" charset="0"/>
            </a:endParaRPr>
          </a:p>
        </p:txBody>
      </p:sp>
      <p:sp>
        <p:nvSpPr>
          <p:cNvPr id="174" name="TextBox 18">
            <a:extLst>
              <a:ext uri="{FF2B5EF4-FFF2-40B4-BE49-F238E27FC236}">
                <a16:creationId xmlns:a16="http://schemas.microsoft.com/office/drawing/2014/main" id="{B1150B2B-08BC-48DF-A5E6-29F896C69744}"/>
              </a:ext>
            </a:extLst>
          </p:cNvPr>
          <p:cNvSpPr txBox="1"/>
          <p:nvPr/>
        </p:nvSpPr>
        <p:spPr>
          <a:xfrm>
            <a:off x="561975" y="3991250"/>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a:t>
            </a:r>
            <a:endParaRPr lang="en-GB" sz="1200" dirty="0">
              <a:effectLst/>
              <a:latin typeface="Times New Roman" panose="02020603050405020304" pitchFamily="18" charset="0"/>
              <a:ea typeface="Times New Roman" panose="02020603050405020304" pitchFamily="18" charset="0"/>
            </a:endParaRPr>
          </a:p>
        </p:txBody>
      </p:sp>
      <p:sp>
        <p:nvSpPr>
          <p:cNvPr id="175" name="TextBox 18">
            <a:extLst>
              <a:ext uri="{FF2B5EF4-FFF2-40B4-BE49-F238E27FC236}">
                <a16:creationId xmlns:a16="http://schemas.microsoft.com/office/drawing/2014/main" id="{B1150B2B-08BC-48DF-A5E6-29F896C69744}"/>
              </a:ext>
            </a:extLst>
          </p:cNvPr>
          <p:cNvSpPr txBox="1"/>
          <p:nvPr/>
        </p:nvSpPr>
        <p:spPr>
          <a:xfrm>
            <a:off x="3762160" y="3991250"/>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a:t>
            </a:r>
            <a:endParaRPr lang="en-GB" sz="1200" dirty="0">
              <a:effectLst/>
              <a:latin typeface="Times New Roman" panose="02020603050405020304" pitchFamily="18" charset="0"/>
              <a:ea typeface="Times New Roman" panose="02020603050405020304" pitchFamily="18" charset="0"/>
            </a:endParaRPr>
          </a:p>
        </p:txBody>
      </p:sp>
      <p:sp>
        <p:nvSpPr>
          <p:cNvPr id="176" name="TextBox 175">
            <a:extLst>
              <a:ext uri="{FF2B5EF4-FFF2-40B4-BE49-F238E27FC236}">
                <a16:creationId xmlns:a16="http://schemas.microsoft.com/office/drawing/2014/main" id="{4D177E4C-F856-4F45-8640-4EEB05E629D8}"/>
              </a:ext>
            </a:extLst>
          </p:cNvPr>
          <p:cNvSpPr txBox="1"/>
          <p:nvPr/>
        </p:nvSpPr>
        <p:spPr>
          <a:xfrm>
            <a:off x="6810038" y="37169"/>
            <a:ext cx="2333961" cy="3477875"/>
          </a:xfrm>
          <a:prstGeom prst="rect">
            <a:avLst/>
          </a:prstGeom>
          <a:noFill/>
        </p:spPr>
        <p:txBody>
          <a:bodyPr wrap="square" rtlCol="0">
            <a:spAutoFit/>
          </a:bodyPr>
          <a:lstStyle/>
          <a:p>
            <a:pPr algn="just"/>
            <a:r>
              <a:rPr lang="en-GB" sz="1000" b="1" i="1" dirty="0">
                <a:latin typeface="Arial" panose="020B0604020202020204" pitchFamily="34" charset="0"/>
                <a:cs typeface="Arial" panose="020B0604020202020204" pitchFamily="34" charset="0"/>
              </a:rPr>
              <a:t>Supplementary Figure </a:t>
            </a:r>
            <a:r>
              <a:rPr lang="en-GB" sz="1000" b="1" i="1" dirty="0" smtClean="0">
                <a:latin typeface="Arial" panose="020B0604020202020204" pitchFamily="34" charset="0"/>
                <a:cs typeface="Arial" panose="020B0604020202020204" pitchFamily="34" charset="0"/>
              </a:rPr>
              <a:t>S.1: </a:t>
            </a:r>
            <a:r>
              <a:rPr lang="en-GB" sz="1000" i="1" dirty="0" smtClean="0">
                <a:latin typeface="Arial" panose="020B0604020202020204" pitchFamily="34" charset="0"/>
                <a:cs typeface="Arial" panose="020B0604020202020204" pitchFamily="34" charset="0"/>
              </a:rPr>
              <a:t>Spheroids seeding</a:t>
            </a:r>
            <a:r>
              <a:rPr lang="en-GB" sz="1000" i="1" dirty="0">
                <a:latin typeface="Arial" panose="020B0604020202020204" pitchFamily="34" charset="0"/>
                <a:cs typeface="Arial" panose="020B0604020202020204" pitchFamily="34" charset="0"/>
              </a:rPr>
              <a:t>, mounting and imaging procedure. A) HEK293 cells were seeded into a 96-well round (U-well) bottom plate pre-cast with 100 µl of 1.5% agarose </a:t>
            </a:r>
            <a:r>
              <a:rPr lang="en-GB" sz="1000" i="1" dirty="0" smtClean="0">
                <a:latin typeface="Arial" panose="020B0604020202020204" pitchFamily="34" charset="0"/>
                <a:cs typeface="Arial" panose="020B0604020202020204" pitchFamily="34" charset="0"/>
              </a:rPr>
              <a:t>at </a:t>
            </a:r>
            <a:r>
              <a:rPr lang="en-GB" sz="1000" i="1" dirty="0">
                <a:latin typeface="Arial" panose="020B0604020202020204" pitchFamily="34" charset="0"/>
                <a:cs typeface="Arial" panose="020B0604020202020204" pitchFamily="34" charset="0"/>
              </a:rPr>
              <a:t>a cell density of 10,000 cells per well with a final volume of </a:t>
            </a:r>
            <a:r>
              <a:rPr lang="en-GB" sz="1000" i="1" dirty="0" smtClean="0">
                <a:latin typeface="Arial" panose="020B0604020202020204" pitchFamily="34" charset="0"/>
                <a:cs typeface="Arial" panose="020B0604020202020204" pitchFamily="34" charset="0"/>
              </a:rPr>
              <a:t>200 </a:t>
            </a:r>
            <a:r>
              <a:rPr lang="en-GB" sz="1000" i="1" dirty="0">
                <a:latin typeface="Arial" panose="020B0604020202020204" pitchFamily="34" charset="0"/>
                <a:cs typeface="Arial" panose="020B0604020202020204" pitchFamily="34" charset="0"/>
              </a:rPr>
              <a:t>µl in complete growth media. B) 3D printed comb used to create wells in agar  to hold the spheroids during the imaging experiment. C) The spheroids were then transferred to the wells. The white circle shows a single spheroid in a well. D) Zoomed view of the circled spheroid in panel C). E) Leica light sheet fluorescence microscope principle, with the light sheet created in between two mirrors, where the spheroid is placed. F) The spheroid is moved through the light sheet and is optically sectioned.</a:t>
            </a:r>
          </a:p>
        </p:txBody>
      </p:sp>
      <p:sp>
        <p:nvSpPr>
          <p:cNvPr id="177" name="TextBox 176"/>
          <p:cNvSpPr txBox="1"/>
          <p:nvPr/>
        </p:nvSpPr>
        <p:spPr>
          <a:xfrm>
            <a:off x="1535012" y="6438032"/>
            <a:ext cx="602287" cy="220443"/>
          </a:xfrm>
          <a:prstGeom prst="rect">
            <a:avLst/>
          </a:prstGeom>
          <a:noFill/>
        </p:spPr>
        <p:txBody>
          <a:bodyPr wrap="square" rtlCol="0">
            <a:spAutoFit/>
          </a:bodyPr>
          <a:lstStyle/>
          <a:p>
            <a:r>
              <a:rPr lang="en-GB" sz="825" dirty="0"/>
              <a:t>Spheroid</a:t>
            </a:r>
          </a:p>
        </p:txBody>
      </p:sp>
      <p:cxnSp>
        <p:nvCxnSpPr>
          <p:cNvPr id="178" name="Straight Connector 177"/>
          <p:cNvCxnSpPr>
            <a:stCxn id="36" idx="1"/>
          </p:cNvCxnSpPr>
          <p:nvPr/>
        </p:nvCxnSpPr>
        <p:spPr>
          <a:xfrm flipH="1">
            <a:off x="1788814" y="6081373"/>
            <a:ext cx="214296" cy="356660"/>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0" name="TextBox 179"/>
          <p:cNvSpPr txBox="1"/>
          <p:nvPr/>
        </p:nvSpPr>
        <p:spPr>
          <a:xfrm>
            <a:off x="543520" y="6321215"/>
            <a:ext cx="879771" cy="219291"/>
          </a:xfrm>
          <a:prstGeom prst="rect">
            <a:avLst/>
          </a:prstGeom>
          <a:noFill/>
        </p:spPr>
        <p:txBody>
          <a:bodyPr wrap="square" rtlCol="0">
            <a:spAutoFit/>
          </a:bodyPr>
          <a:lstStyle/>
          <a:p>
            <a:r>
              <a:rPr lang="en-GB" sz="825" dirty="0"/>
              <a:t>Light sheet</a:t>
            </a:r>
          </a:p>
        </p:txBody>
      </p:sp>
      <p:cxnSp>
        <p:nvCxnSpPr>
          <p:cNvPr id="181" name="Straight Connector 180"/>
          <p:cNvCxnSpPr>
            <a:stCxn id="39" idx="5"/>
          </p:cNvCxnSpPr>
          <p:nvPr/>
        </p:nvCxnSpPr>
        <p:spPr>
          <a:xfrm flipH="1">
            <a:off x="1146775" y="5977307"/>
            <a:ext cx="591059" cy="343908"/>
          </a:xfrm>
          <a:prstGeom prst="line">
            <a:avLst/>
          </a:prstGeom>
          <a:ln>
            <a:solidFill>
              <a:schemeClr val="tx1"/>
            </a:solidFill>
          </a:ln>
        </p:spPr>
        <p:style>
          <a:lnRef idx="1">
            <a:schemeClr val="accent1"/>
          </a:lnRef>
          <a:fillRef idx="0">
            <a:schemeClr val="accent1"/>
          </a:fillRef>
          <a:effectRef idx="0">
            <a:schemeClr val="accent1"/>
          </a:effectRef>
          <a:fontRef idx="minor">
            <a:schemeClr val="tx1"/>
          </a:fontRef>
        </p:style>
      </p:cxnSp>
      <p:sp>
        <p:nvSpPr>
          <p:cNvPr id="184" name="TextBox 183"/>
          <p:cNvSpPr txBox="1"/>
          <p:nvPr/>
        </p:nvSpPr>
        <p:spPr>
          <a:xfrm>
            <a:off x="1313796" y="4957656"/>
            <a:ext cx="1376269" cy="307777"/>
          </a:xfrm>
          <a:prstGeom prst="rect">
            <a:avLst/>
          </a:prstGeom>
          <a:noFill/>
        </p:spPr>
        <p:txBody>
          <a:bodyPr wrap="square" rtlCol="0">
            <a:spAutoFit/>
          </a:bodyPr>
          <a:lstStyle/>
          <a:p>
            <a:r>
              <a:rPr lang="en-GB" sz="1400" b="1" dirty="0">
                <a:solidFill>
                  <a:schemeClr val="bg1"/>
                </a:solidFill>
              </a:rPr>
              <a:t>Mirror Device</a:t>
            </a:r>
          </a:p>
        </p:txBody>
      </p:sp>
      <p:sp>
        <p:nvSpPr>
          <p:cNvPr id="185" name="TextBox 184"/>
          <p:cNvSpPr txBox="1"/>
          <p:nvPr/>
        </p:nvSpPr>
        <p:spPr>
          <a:xfrm>
            <a:off x="983406" y="4316782"/>
            <a:ext cx="2037291" cy="307777"/>
          </a:xfrm>
          <a:prstGeom prst="rect">
            <a:avLst/>
          </a:prstGeom>
          <a:noFill/>
        </p:spPr>
        <p:txBody>
          <a:bodyPr wrap="square" rtlCol="0">
            <a:spAutoFit/>
          </a:bodyPr>
          <a:lstStyle/>
          <a:p>
            <a:r>
              <a:rPr lang="en-GB" sz="1400" b="1" dirty="0">
                <a:solidFill>
                  <a:schemeClr val="bg1"/>
                </a:solidFill>
              </a:rPr>
              <a:t>10X Detection Objective</a:t>
            </a:r>
          </a:p>
        </p:txBody>
      </p:sp>
      <p:grpSp>
        <p:nvGrpSpPr>
          <p:cNvPr id="231" name="Group 230"/>
          <p:cNvGrpSpPr/>
          <p:nvPr/>
        </p:nvGrpSpPr>
        <p:grpSpPr>
          <a:xfrm>
            <a:off x="4065508" y="5065598"/>
            <a:ext cx="2496589" cy="381378"/>
            <a:chOff x="1078966" y="3192924"/>
            <a:chExt cx="3880631" cy="592804"/>
          </a:xfrm>
        </p:grpSpPr>
        <p:sp>
          <p:nvSpPr>
            <p:cNvPr id="270" name="Isosceles Triangle 269"/>
            <p:cNvSpPr/>
            <p:nvPr/>
          </p:nvSpPr>
          <p:spPr>
            <a:xfrm rot="5400000" flipH="1">
              <a:off x="2680964" y="2683951"/>
              <a:ext cx="117978" cy="1781019"/>
            </a:xfrm>
            <a:prstGeom prst="triangle">
              <a:avLst/>
            </a:prstGeom>
            <a:solidFill>
              <a:srgbClr val="9CB6E0"/>
            </a:soli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60" name="Isosceles Triangle 259"/>
            <p:cNvSpPr/>
            <p:nvPr/>
          </p:nvSpPr>
          <p:spPr>
            <a:xfrm rot="5400000" flipH="1">
              <a:off x="2680964" y="2523379"/>
              <a:ext cx="117978" cy="1781019"/>
            </a:xfrm>
            <a:prstGeom prst="triangle">
              <a:avLst/>
            </a:prstGeom>
            <a:solidFill>
              <a:srgbClr val="9CB6E0"/>
            </a:solid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36" name="Group 235"/>
            <p:cNvGrpSpPr/>
            <p:nvPr/>
          </p:nvGrpSpPr>
          <p:grpSpPr>
            <a:xfrm>
              <a:off x="1078966" y="3192924"/>
              <a:ext cx="3880631" cy="592804"/>
              <a:chOff x="1078966" y="3192924"/>
              <a:chExt cx="3880631" cy="592804"/>
            </a:xfrm>
          </p:grpSpPr>
          <p:sp>
            <p:nvSpPr>
              <p:cNvPr id="241" name="Parallelogram 240"/>
              <p:cNvSpPr/>
              <p:nvPr/>
            </p:nvSpPr>
            <p:spPr>
              <a:xfrm rot="120000">
                <a:off x="1083810" y="3208018"/>
                <a:ext cx="2303868" cy="502548"/>
              </a:xfrm>
              <a:prstGeom prst="parallelogram">
                <a:avLst>
                  <a:gd name="adj" fmla="val 151505"/>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2" name="Parallelogram 241"/>
              <p:cNvSpPr/>
              <p:nvPr/>
            </p:nvSpPr>
            <p:spPr>
              <a:xfrm rot="-120000">
                <a:off x="2610198" y="3233787"/>
                <a:ext cx="2349399" cy="445675"/>
              </a:xfrm>
              <a:prstGeom prst="parallelogram">
                <a:avLst>
                  <a:gd name="adj" fmla="val 177699"/>
                </a:avLst>
              </a:prstGeom>
              <a:solidFill>
                <a:schemeClr val="accent1">
                  <a:lumMod val="60000"/>
                  <a:lumOff val="4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43" name="Group 242"/>
              <p:cNvGrpSpPr/>
              <p:nvPr/>
            </p:nvGrpSpPr>
            <p:grpSpPr>
              <a:xfrm>
                <a:off x="1849444" y="3194328"/>
                <a:ext cx="3081238" cy="117978"/>
                <a:chOff x="3220715" y="1939925"/>
                <a:chExt cx="1554485" cy="117475"/>
              </a:xfrm>
              <a:solidFill>
                <a:srgbClr val="9CB6E0"/>
              </a:solidFill>
            </p:grpSpPr>
            <p:sp>
              <p:nvSpPr>
                <p:cNvPr id="249" name="Isosceles Triangle 248"/>
                <p:cNvSpPr/>
                <p:nvPr/>
              </p:nvSpPr>
              <p:spPr>
                <a:xfrm rot="16200000">
                  <a:off x="426720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50" name="Isosceles Triangle 249"/>
                <p:cNvSpPr/>
                <p:nvPr/>
              </p:nvSpPr>
              <p:spPr>
                <a:xfrm rot="5400000" flipH="1">
                  <a:off x="3611240" y="1549400"/>
                  <a:ext cx="117475" cy="898525"/>
                </a:xfrm>
                <a:prstGeom prst="triangle">
                  <a:avLst/>
                </a:prstGeom>
                <a:grpFill/>
                <a:ln w="3175">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sp>
            <p:nvSpPr>
              <p:cNvPr id="244" name="Parallelogram 243"/>
              <p:cNvSpPr/>
              <p:nvPr/>
            </p:nvSpPr>
            <p:spPr>
              <a:xfrm rot="5400000" flipV="1">
                <a:off x="4260505" y="3092624"/>
                <a:ext cx="591399" cy="792000"/>
              </a:xfrm>
              <a:prstGeom prst="parallelogram">
                <a:avLst>
                  <a:gd name="adj" fmla="val 80181"/>
                </a:avLst>
              </a:prstGeom>
              <a:solidFill>
                <a:srgbClr val="6A91D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5" name="Parallelogram 244"/>
              <p:cNvSpPr/>
              <p:nvPr/>
            </p:nvSpPr>
            <p:spPr>
              <a:xfrm rot="5400000" flipV="1">
                <a:off x="1168507" y="3104789"/>
                <a:ext cx="591399" cy="770479"/>
              </a:xfrm>
              <a:prstGeom prst="parallelogram">
                <a:avLst>
                  <a:gd name="adj" fmla="val 80181"/>
                </a:avLst>
              </a:prstGeom>
              <a:solidFill>
                <a:srgbClr val="9CB6E0"/>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nvGrpSpPr>
              <p:cNvPr id="246" name="Group 245"/>
              <p:cNvGrpSpPr/>
              <p:nvPr/>
            </p:nvGrpSpPr>
            <p:grpSpPr>
              <a:xfrm>
                <a:off x="1078966" y="3666345"/>
                <a:ext cx="3081238" cy="117978"/>
                <a:chOff x="3220715" y="1939925"/>
                <a:chExt cx="1554485" cy="117475"/>
              </a:xfrm>
            </p:grpSpPr>
            <p:sp>
              <p:nvSpPr>
                <p:cNvPr id="247" name="Isosceles Triangle 246"/>
                <p:cNvSpPr/>
                <p:nvPr/>
              </p:nvSpPr>
              <p:spPr>
                <a:xfrm rot="16200000">
                  <a:off x="426720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248" name="Isosceles Triangle 247"/>
                <p:cNvSpPr/>
                <p:nvPr/>
              </p:nvSpPr>
              <p:spPr>
                <a:xfrm rot="5400000" flipH="1">
                  <a:off x="3611240" y="1549400"/>
                  <a:ext cx="117475" cy="898525"/>
                </a:xfrm>
                <a:prstGeom prst="triangle">
                  <a:avLst/>
                </a:prstGeom>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grpSp>
        </p:grpSp>
      </p:grpSp>
      <p:sp>
        <p:nvSpPr>
          <p:cNvPr id="271" name="Cloud 270"/>
          <p:cNvSpPr/>
          <p:nvPr/>
        </p:nvSpPr>
        <p:spPr>
          <a:xfrm>
            <a:off x="5008072" y="4765990"/>
            <a:ext cx="541868" cy="458418"/>
          </a:xfrm>
          <a:prstGeom prst="cloud">
            <a:avLst/>
          </a:prstGeom>
          <a:solidFill>
            <a:schemeClr val="tx1">
              <a:alpha val="1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72" name="Cloud 271"/>
          <p:cNvSpPr/>
          <p:nvPr/>
        </p:nvSpPr>
        <p:spPr>
          <a:xfrm>
            <a:off x="5008072" y="4856830"/>
            <a:ext cx="541868" cy="458418"/>
          </a:xfrm>
          <a:prstGeom prst="cloud">
            <a:avLst/>
          </a:prstGeom>
          <a:solidFill>
            <a:schemeClr val="tx1">
              <a:alpha val="2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73" name="Cloud 272"/>
          <p:cNvSpPr/>
          <p:nvPr/>
        </p:nvSpPr>
        <p:spPr>
          <a:xfrm>
            <a:off x="5008072" y="4947670"/>
            <a:ext cx="541868" cy="458418"/>
          </a:xfrm>
          <a:prstGeom prst="cloud">
            <a:avLst/>
          </a:prstGeom>
          <a:solidFill>
            <a:schemeClr val="tx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74" name="Cloud 273"/>
          <p:cNvSpPr/>
          <p:nvPr/>
        </p:nvSpPr>
        <p:spPr>
          <a:xfrm>
            <a:off x="5008072" y="5038510"/>
            <a:ext cx="541868" cy="458418"/>
          </a:xfrm>
          <a:prstGeom prst="cloud">
            <a:avLst/>
          </a:prstGeom>
          <a:solidFill>
            <a:schemeClr val="tx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317" name="Cloud 316"/>
          <p:cNvSpPr/>
          <p:nvPr/>
        </p:nvSpPr>
        <p:spPr>
          <a:xfrm>
            <a:off x="5053038" y="5130845"/>
            <a:ext cx="481811" cy="174635"/>
          </a:xfrm>
          <a:custGeom>
            <a:avLst/>
            <a:gdLst>
              <a:gd name="connsiteX0" fmla="*/ 3900 w 43200"/>
              <a:gd name="connsiteY0" fmla="*/ 14370 h 43200"/>
              <a:gd name="connsiteX1" fmla="*/ 5623 w 43200"/>
              <a:gd name="connsiteY1" fmla="*/ 6907 h 43200"/>
              <a:gd name="connsiteX2" fmla="*/ 14005 w 43200"/>
              <a:gd name="connsiteY2" fmla="*/ 5202 h 43200"/>
              <a:gd name="connsiteX3" fmla="*/ 22456 w 43200"/>
              <a:gd name="connsiteY3" fmla="*/ 3432 h 43200"/>
              <a:gd name="connsiteX4" fmla="*/ 25749 w 43200"/>
              <a:gd name="connsiteY4" fmla="*/ 200 h 43200"/>
              <a:gd name="connsiteX5" fmla="*/ 29833 w 43200"/>
              <a:gd name="connsiteY5" fmla="*/ 2481 h 43200"/>
              <a:gd name="connsiteX6" fmla="*/ 35463 w 43200"/>
              <a:gd name="connsiteY6" fmla="*/ 690 h 43200"/>
              <a:gd name="connsiteX7" fmla="*/ 38318 w 43200"/>
              <a:gd name="connsiteY7" fmla="*/ 5576 h 43200"/>
              <a:gd name="connsiteX8" fmla="*/ 41982 w 43200"/>
              <a:gd name="connsiteY8" fmla="*/ 10318 h 43200"/>
              <a:gd name="connsiteX9" fmla="*/ 41818 w 43200"/>
              <a:gd name="connsiteY9" fmla="*/ 15460 h 43200"/>
              <a:gd name="connsiteX10" fmla="*/ 43016 w 43200"/>
              <a:gd name="connsiteY10" fmla="*/ 23322 h 43200"/>
              <a:gd name="connsiteX11" fmla="*/ 37404 w 43200"/>
              <a:gd name="connsiteY11" fmla="*/ 30204 h 43200"/>
              <a:gd name="connsiteX12" fmla="*/ 35395 w 43200"/>
              <a:gd name="connsiteY12" fmla="*/ 36101 h 43200"/>
              <a:gd name="connsiteX13" fmla="*/ 28555 w 43200"/>
              <a:gd name="connsiteY13" fmla="*/ 36815 h 43200"/>
              <a:gd name="connsiteX14" fmla="*/ 23667 w 43200"/>
              <a:gd name="connsiteY14" fmla="*/ 43106 h 43200"/>
              <a:gd name="connsiteX15" fmla="*/ 16480 w 43200"/>
              <a:gd name="connsiteY15" fmla="*/ 39266 h 43200"/>
              <a:gd name="connsiteX16" fmla="*/ 5804 w 43200"/>
              <a:gd name="connsiteY16" fmla="*/ 35472 h 43200"/>
              <a:gd name="connsiteX17" fmla="*/ 1110 w 43200"/>
              <a:gd name="connsiteY17" fmla="*/ 31250 h 43200"/>
              <a:gd name="connsiteX18" fmla="*/ 2113 w 43200"/>
              <a:gd name="connsiteY18" fmla="*/ 25551 h 43200"/>
              <a:gd name="connsiteX19" fmla="*/ -5 w 43200"/>
              <a:gd name="connsiteY19" fmla="*/ 19704 h 43200"/>
              <a:gd name="connsiteX20" fmla="*/ 3863 w 43200"/>
              <a:gd name="connsiteY20" fmla="*/ 14507 h 43200"/>
              <a:gd name="connsiteX21" fmla="*/ 3900 w 43200"/>
              <a:gd name="connsiteY21" fmla="*/ 14370 h 43200"/>
              <a:gd name="connsiteX0" fmla="*/ 4693 w 43200"/>
              <a:gd name="connsiteY0" fmla="*/ 26177 h 43200"/>
              <a:gd name="connsiteX1" fmla="*/ 2160 w 43200"/>
              <a:gd name="connsiteY1" fmla="*/ 25380 h 43200"/>
              <a:gd name="connsiteX2" fmla="*/ 6928 w 43200"/>
              <a:gd name="connsiteY2" fmla="*/ 34899 h 43200"/>
              <a:gd name="connsiteX3" fmla="*/ 5820 w 43200"/>
              <a:gd name="connsiteY3" fmla="*/ 35280 h 43200"/>
              <a:gd name="connsiteX4" fmla="*/ 16478 w 43200"/>
              <a:gd name="connsiteY4" fmla="*/ 39090 h 43200"/>
              <a:gd name="connsiteX5" fmla="*/ 15810 w 43200"/>
              <a:gd name="connsiteY5" fmla="*/ 37350 h 43200"/>
              <a:gd name="connsiteX6" fmla="*/ 28827 w 43200"/>
              <a:gd name="connsiteY6" fmla="*/ 34751 h 43200"/>
              <a:gd name="connsiteX7" fmla="*/ 28560 w 43200"/>
              <a:gd name="connsiteY7" fmla="*/ 36660 h 43200"/>
              <a:gd name="connsiteX8" fmla="*/ 34129 w 43200"/>
              <a:gd name="connsiteY8" fmla="*/ 22954 h 43200"/>
              <a:gd name="connsiteX9" fmla="*/ 37380 w 43200"/>
              <a:gd name="connsiteY9" fmla="*/ 30090 h 43200"/>
              <a:gd name="connsiteX10" fmla="*/ 41798 w 43200"/>
              <a:gd name="connsiteY10" fmla="*/ 15354 h 43200"/>
              <a:gd name="connsiteX11" fmla="*/ 40350 w 43200"/>
              <a:gd name="connsiteY11" fmla="*/ 18030 h 43200"/>
              <a:gd name="connsiteX12" fmla="*/ 38324 w 43200"/>
              <a:gd name="connsiteY12" fmla="*/ 5426 h 43200"/>
              <a:gd name="connsiteX13" fmla="*/ 38400 w 43200"/>
              <a:gd name="connsiteY13" fmla="*/ 6690 h 43200"/>
              <a:gd name="connsiteX14" fmla="*/ 29078 w 43200"/>
              <a:gd name="connsiteY14" fmla="*/ 3952 h 43200"/>
              <a:gd name="connsiteX15" fmla="*/ 29820 w 43200"/>
              <a:gd name="connsiteY15" fmla="*/ 2340 h 43200"/>
              <a:gd name="connsiteX16" fmla="*/ 22141 w 43200"/>
              <a:gd name="connsiteY16" fmla="*/ 4720 h 43200"/>
              <a:gd name="connsiteX17" fmla="*/ 22500 w 43200"/>
              <a:gd name="connsiteY17" fmla="*/ 3330 h 43200"/>
              <a:gd name="connsiteX18" fmla="*/ 14000 w 43200"/>
              <a:gd name="connsiteY18" fmla="*/ 5192 h 43200"/>
              <a:gd name="connsiteX19" fmla="*/ 15300 w 43200"/>
              <a:gd name="connsiteY19" fmla="*/ 6540 h 43200"/>
              <a:gd name="connsiteX20" fmla="*/ 4127 w 43200"/>
              <a:gd name="connsiteY20" fmla="*/ 15789 h 43200"/>
              <a:gd name="connsiteX21" fmla="*/ 3900 w 43200"/>
              <a:gd name="connsiteY21" fmla="*/ 14370 h 43200"/>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6964 w 43256"/>
              <a:gd name="connsiteY0" fmla="*/ 34758 h 43219"/>
              <a:gd name="connsiteX1" fmla="*/ 5856 w 43256"/>
              <a:gd name="connsiteY1" fmla="*/ 35139 h 43219"/>
              <a:gd name="connsiteX2" fmla="*/ 16514 w 43256"/>
              <a:gd name="connsiteY2" fmla="*/ 38949 h 43219"/>
              <a:gd name="connsiteX3" fmla="*/ 15846 w 43256"/>
              <a:gd name="connsiteY3" fmla="*/ 37209 h 43219"/>
              <a:gd name="connsiteX4" fmla="*/ 28863 w 43256"/>
              <a:gd name="connsiteY4" fmla="*/ 34610 h 43219"/>
              <a:gd name="connsiteX5" fmla="*/ 28596 w 43256"/>
              <a:gd name="connsiteY5" fmla="*/ 36519 h 43219"/>
              <a:gd name="connsiteX6" fmla="*/ 34165 w 43256"/>
              <a:gd name="connsiteY6" fmla="*/ 22813 h 43219"/>
              <a:gd name="connsiteX7" fmla="*/ 37416 w 43256"/>
              <a:gd name="connsiteY7" fmla="*/ 29949 h 43219"/>
              <a:gd name="connsiteX8" fmla="*/ 41834 w 43256"/>
              <a:gd name="connsiteY8" fmla="*/ 15213 h 43219"/>
              <a:gd name="connsiteX9" fmla="*/ 40386 w 43256"/>
              <a:gd name="connsiteY9" fmla="*/ 17889 h 43219"/>
              <a:gd name="connsiteX10" fmla="*/ 38360 w 43256"/>
              <a:gd name="connsiteY10" fmla="*/ 5285 h 43219"/>
              <a:gd name="connsiteX11" fmla="*/ 38436 w 43256"/>
              <a:gd name="connsiteY11" fmla="*/ 6549 h 43219"/>
              <a:gd name="connsiteX12" fmla="*/ 29114 w 43256"/>
              <a:gd name="connsiteY12" fmla="*/ 3811 h 43219"/>
              <a:gd name="connsiteX13" fmla="*/ 29856 w 43256"/>
              <a:gd name="connsiteY13" fmla="*/ 2199 h 43219"/>
              <a:gd name="connsiteX14" fmla="*/ 22177 w 43256"/>
              <a:gd name="connsiteY14" fmla="*/ 4579 h 43219"/>
              <a:gd name="connsiteX15" fmla="*/ 22536 w 43256"/>
              <a:gd name="connsiteY15" fmla="*/ 3189 h 43219"/>
              <a:gd name="connsiteX16" fmla="*/ 14036 w 43256"/>
              <a:gd name="connsiteY16" fmla="*/ 5051 h 43219"/>
              <a:gd name="connsiteX17" fmla="*/ 15336 w 43256"/>
              <a:gd name="connsiteY17" fmla="*/ 6399 h 43219"/>
              <a:gd name="connsiteX18" fmla="*/ 4163 w 43256"/>
              <a:gd name="connsiteY18" fmla="*/ 15648 h 43219"/>
              <a:gd name="connsiteX19" fmla="*/ 3936 w 43256"/>
              <a:gd name="connsiteY19" fmla="*/ 14229 h 43219"/>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6964 w 43256"/>
              <a:gd name="connsiteY0" fmla="*/ 34758 h 43219"/>
              <a:gd name="connsiteX1" fmla="*/ 5856 w 43256"/>
              <a:gd name="connsiteY1" fmla="*/ 35139 h 43219"/>
              <a:gd name="connsiteX2" fmla="*/ 16514 w 43256"/>
              <a:gd name="connsiteY2" fmla="*/ 38949 h 43219"/>
              <a:gd name="connsiteX3" fmla="*/ 15846 w 43256"/>
              <a:gd name="connsiteY3" fmla="*/ 37209 h 43219"/>
              <a:gd name="connsiteX4" fmla="*/ 28863 w 43256"/>
              <a:gd name="connsiteY4" fmla="*/ 34610 h 43219"/>
              <a:gd name="connsiteX5" fmla="*/ 28596 w 43256"/>
              <a:gd name="connsiteY5" fmla="*/ 36519 h 43219"/>
              <a:gd name="connsiteX6" fmla="*/ 41834 w 43256"/>
              <a:gd name="connsiteY6" fmla="*/ 15213 h 43219"/>
              <a:gd name="connsiteX7" fmla="*/ 40386 w 43256"/>
              <a:gd name="connsiteY7" fmla="*/ 17889 h 43219"/>
              <a:gd name="connsiteX8" fmla="*/ 38360 w 43256"/>
              <a:gd name="connsiteY8" fmla="*/ 5285 h 43219"/>
              <a:gd name="connsiteX9" fmla="*/ 38436 w 43256"/>
              <a:gd name="connsiteY9" fmla="*/ 6549 h 43219"/>
              <a:gd name="connsiteX10" fmla="*/ 29114 w 43256"/>
              <a:gd name="connsiteY10" fmla="*/ 3811 h 43219"/>
              <a:gd name="connsiteX11" fmla="*/ 29856 w 43256"/>
              <a:gd name="connsiteY11" fmla="*/ 2199 h 43219"/>
              <a:gd name="connsiteX12" fmla="*/ 22177 w 43256"/>
              <a:gd name="connsiteY12" fmla="*/ 4579 h 43219"/>
              <a:gd name="connsiteX13" fmla="*/ 22536 w 43256"/>
              <a:gd name="connsiteY13" fmla="*/ 3189 h 43219"/>
              <a:gd name="connsiteX14" fmla="*/ 14036 w 43256"/>
              <a:gd name="connsiteY14" fmla="*/ 5051 h 43219"/>
              <a:gd name="connsiteX15" fmla="*/ 15336 w 43256"/>
              <a:gd name="connsiteY15" fmla="*/ 6399 h 43219"/>
              <a:gd name="connsiteX16" fmla="*/ 4163 w 43256"/>
              <a:gd name="connsiteY16" fmla="*/ 15648 h 43219"/>
              <a:gd name="connsiteX17" fmla="*/ 3936 w 43256"/>
              <a:gd name="connsiteY17" fmla="*/ 14229 h 43219"/>
              <a:gd name="connsiteX0" fmla="*/ 3936 w 42286"/>
              <a:gd name="connsiteY0" fmla="*/ 14229 h 43219"/>
              <a:gd name="connsiteX1" fmla="*/ 5659 w 42286"/>
              <a:gd name="connsiteY1" fmla="*/ 6766 h 43219"/>
              <a:gd name="connsiteX2" fmla="*/ 14041 w 42286"/>
              <a:gd name="connsiteY2" fmla="*/ 5061 h 43219"/>
              <a:gd name="connsiteX3" fmla="*/ 22492 w 42286"/>
              <a:gd name="connsiteY3" fmla="*/ 3291 h 43219"/>
              <a:gd name="connsiteX4" fmla="*/ 25785 w 42286"/>
              <a:gd name="connsiteY4" fmla="*/ 59 h 43219"/>
              <a:gd name="connsiteX5" fmla="*/ 29869 w 42286"/>
              <a:gd name="connsiteY5" fmla="*/ 2340 h 43219"/>
              <a:gd name="connsiteX6" fmla="*/ 35499 w 42286"/>
              <a:gd name="connsiteY6" fmla="*/ 549 h 43219"/>
              <a:gd name="connsiteX7" fmla="*/ 38354 w 42286"/>
              <a:gd name="connsiteY7" fmla="*/ 5435 h 43219"/>
              <a:gd name="connsiteX8" fmla="*/ 42018 w 42286"/>
              <a:gd name="connsiteY8" fmla="*/ 10177 h 43219"/>
              <a:gd name="connsiteX9" fmla="*/ 41854 w 42286"/>
              <a:gd name="connsiteY9" fmla="*/ 15319 h 43219"/>
              <a:gd name="connsiteX10" fmla="*/ 37440 w 42286"/>
              <a:gd name="connsiteY10" fmla="*/ 30063 h 43219"/>
              <a:gd name="connsiteX11" fmla="*/ 35431 w 42286"/>
              <a:gd name="connsiteY11" fmla="*/ 35960 h 43219"/>
              <a:gd name="connsiteX12" fmla="*/ 28591 w 42286"/>
              <a:gd name="connsiteY12" fmla="*/ 36674 h 43219"/>
              <a:gd name="connsiteX13" fmla="*/ 23703 w 42286"/>
              <a:gd name="connsiteY13" fmla="*/ 42965 h 43219"/>
              <a:gd name="connsiteX14" fmla="*/ 16516 w 42286"/>
              <a:gd name="connsiteY14" fmla="*/ 39125 h 43219"/>
              <a:gd name="connsiteX15" fmla="*/ 5840 w 42286"/>
              <a:gd name="connsiteY15" fmla="*/ 35331 h 43219"/>
              <a:gd name="connsiteX16" fmla="*/ 1146 w 42286"/>
              <a:gd name="connsiteY16" fmla="*/ 31109 h 43219"/>
              <a:gd name="connsiteX17" fmla="*/ 2149 w 42286"/>
              <a:gd name="connsiteY17" fmla="*/ 25410 h 43219"/>
              <a:gd name="connsiteX18" fmla="*/ 31 w 42286"/>
              <a:gd name="connsiteY18" fmla="*/ 19563 h 43219"/>
              <a:gd name="connsiteX19" fmla="*/ 3899 w 42286"/>
              <a:gd name="connsiteY19" fmla="*/ 14366 h 43219"/>
              <a:gd name="connsiteX20" fmla="*/ 3936 w 42286"/>
              <a:gd name="connsiteY20" fmla="*/ 14229 h 43219"/>
              <a:gd name="connsiteX0" fmla="*/ 6964 w 42286"/>
              <a:gd name="connsiteY0" fmla="*/ 34758 h 43219"/>
              <a:gd name="connsiteX1" fmla="*/ 5856 w 42286"/>
              <a:gd name="connsiteY1" fmla="*/ 35139 h 43219"/>
              <a:gd name="connsiteX2" fmla="*/ 16514 w 42286"/>
              <a:gd name="connsiteY2" fmla="*/ 38949 h 43219"/>
              <a:gd name="connsiteX3" fmla="*/ 15846 w 42286"/>
              <a:gd name="connsiteY3" fmla="*/ 37209 h 43219"/>
              <a:gd name="connsiteX4" fmla="*/ 28863 w 42286"/>
              <a:gd name="connsiteY4" fmla="*/ 34610 h 43219"/>
              <a:gd name="connsiteX5" fmla="*/ 28596 w 42286"/>
              <a:gd name="connsiteY5" fmla="*/ 36519 h 43219"/>
              <a:gd name="connsiteX6" fmla="*/ 41834 w 42286"/>
              <a:gd name="connsiteY6" fmla="*/ 15213 h 43219"/>
              <a:gd name="connsiteX7" fmla="*/ 40386 w 42286"/>
              <a:gd name="connsiteY7" fmla="*/ 17889 h 43219"/>
              <a:gd name="connsiteX8" fmla="*/ 38360 w 42286"/>
              <a:gd name="connsiteY8" fmla="*/ 5285 h 43219"/>
              <a:gd name="connsiteX9" fmla="*/ 38436 w 42286"/>
              <a:gd name="connsiteY9" fmla="*/ 6549 h 43219"/>
              <a:gd name="connsiteX10" fmla="*/ 29114 w 42286"/>
              <a:gd name="connsiteY10" fmla="*/ 3811 h 43219"/>
              <a:gd name="connsiteX11" fmla="*/ 29856 w 42286"/>
              <a:gd name="connsiteY11" fmla="*/ 2199 h 43219"/>
              <a:gd name="connsiteX12" fmla="*/ 22177 w 42286"/>
              <a:gd name="connsiteY12" fmla="*/ 4579 h 43219"/>
              <a:gd name="connsiteX13" fmla="*/ 22536 w 42286"/>
              <a:gd name="connsiteY13" fmla="*/ 3189 h 43219"/>
              <a:gd name="connsiteX14" fmla="*/ 14036 w 42286"/>
              <a:gd name="connsiteY14" fmla="*/ 5051 h 43219"/>
              <a:gd name="connsiteX15" fmla="*/ 15336 w 42286"/>
              <a:gd name="connsiteY15" fmla="*/ 6399 h 43219"/>
              <a:gd name="connsiteX16" fmla="*/ 4163 w 42286"/>
              <a:gd name="connsiteY16" fmla="*/ 15648 h 43219"/>
              <a:gd name="connsiteX17" fmla="*/ 3936 w 42286"/>
              <a:gd name="connsiteY17" fmla="*/ 14229 h 43219"/>
              <a:gd name="connsiteX0" fmla="*/ 3936 w 42286"/>
              <a:gd name="connsiteY0" fmla="*/ 14229 h 43219"/>
              <a:gd name="connsiteX1" fmla="*/ 5659 w 42286"/>
              <a:gd name="connsiteY1" fmla="*/ 6766 h 43219"/>
              <a:gd name="connsiteX2" fmla="*/ 14041 w 42286"/>
              <a:gd name="connsiteY2" fmla="*/ 5061 h 43219"/>
              <a:gd name="connsiteX3" fmla="*/ 22492 w 42286"/>
              <a:gd name="connsiteY3" fmla="*/ 3291 h 43219"/>
              <a:gd name="connsiteX4" fmla="*/ 25785 w 42286"/>
              <a:gd name="connsiteY4" fmla="*/ 59 h 43219"/>
              <a:gd name="connsiteX5" fmla="*/ 29869 w 42286"/>
              <a:gd name="connsiteY5" fmla="*/ 2340 h 43219"/>
              <a:gd name="connsiteX6" fmla="*/ 35499 w 42286"/>
              <a:gd name="connsiteY6" fmla="*/ 549 h 43219"/>
              <a:gd name="connsiteX7" fmla="*/ 38354 w 42286"/>
              <a:gd name="connsiteY7" fmla="*/ 5435 h 43219"/>
              <a:gd name="connsiteX8" fmla="*/ 42018 w 42286"/>
              <a:gd name="connsiteY8" fmla="*/ 10177 h 43219"/>
              <a:gd name="connsiteX9" fmla="*/ 41854 w 42286"/>
              <a:gd name="connsiteY9" fmla="*/ 15319 h 43219"/>
              <a:gd name="connsiteX10" fmla="*/ 37440 w 42286"/>
              <a:gd name="connsiteY10" fmla="*/ 30063 h 43219"/>
              <a:gd name="connsiteX11" fmla="*/ 35431 w 42286"/>
              <a:gd name="connsiteY11" fmla="*/ 35960 h 43219"/>
              <a:gd name="connsiteX12" fmla="*/ 28591 w 42286"/>
              <a:gd name="connsiteY12" fmla="*/ 36674 h 43219"/>
              <a:gd name="connsiteX13" fmla="*/ 23703 w 42286"/>
              <a:gd name="connsiteY13" fmla="*/ 42965 h 43219"/>
              <a:gd name="connsiteX14" fmla="*/ 16516 w 42286"/>
              <a:gd name="connsiteY14" fmla="*/ 39125 h 43219"/>
              <a:gd name="connsiteX15" fmla="*/ 5840 w 42286"/>
              <a:gd name="connsiteY15" fmla="*/ 35331 h 43219"/>
              <a:gd name="connsiteX16" fmla="*/ 1146 w 42286"/>
              <a:gd name="connsiteY16" fmla="*/ 31109 h 43219"/>
              <a:gd name="connsiteX17" fmla="*/ 2149 w 42286"/>
              <a:gd name="connsiteY17" fmla="*/ 25410 h 43219"/>
              <a:gd name="connsiteX18" fmla="*/ 31 w 42286"/>
              <a:gd name="connsiteY18" fmla="*/ 19563 h 43219"/>
              <a:gd name="connsiteX19" fmla="*/ 3899 w 42286"/>
              <a:gd name="connsiteY19" fmla="*/ 14366 h 43219"/>
              <a:gd name="connsiteX20" fmla="*/ 3936 w 42286"/>
              <a:gd name="connsiteY20" fmla="*/ 14229 h 43219"/>
              <a:gd name="connsiteX0" fmla="*/ 6964 w 42286"/>
              <a:gd name="connsiteY0" fmla="*/ 34758 h 43219"/>
              <a:gd name="connsiteX1" fmla="*/ 5856 w 42286"/>
              <a:gd name="connsiteY1" fmla="*/ 35139 h 43219"/>
              <a:gd name="connsiteX2" fmla="*/ 16514 w 42286"/>
              <a:gd name="connsiteY2" fmla="*/ 38949 h 43219"/>
              <a:gd name="connsiteX3" fmla="*/ 15846 w 42286"/>
              <a:gd name="connsiteY3" fmla="*/ 37209 h 43219"/>
              <a:gd name="connsiteX4" fmla="*/ 28863 w 42286"/>
              <a:gd name="connsiteY4" fmla="*/ 34610 h 43219"/>
              <a:gd name="connsiteX5" fmla="*/ 28596 w 42286"/>
              <a:gd name="connsiteY5" fmla="*/ 36519 h 43219"/>
              <a:gd name="connsiteX6" fmla="*/ 38360 w 42286"/>
              <a:gd name="connsiteY6" fmla="*/ 5285 h 43219"/>
              <a:gd name="connsiteX7" fmla="*/ 38436 w 42286"/>
              <a:gd name="connsiteY7" fmla="*/ 6549 h 43219"/>
              <a:gd name="connsiteX8" fmla="*/ 29114 w 42286"/>
              <a:gd name="connsiteY8" fmla="*/ 3811 h 43219"/>
              <a:gd name="connsiteX9" fmla="*/ 29856 w 42286"/>
              <a:gd name="connsiteY9" fmla="*/ 2199 h 43219"/>
              <a:gd name="connsiteX10" fmla="*/ 22177 w 42286"/>
              <a:gd name="connsiteY10" fmla="*/ 4579 h 43219"/>
              <a:gd name="connsiteX11" fmla="*/ 22536 w 42286"/>
              <a:gd name="connsiteY11" fmla="*/ 3189 h 43219"/>
              <a:gd name="connsiteX12" fmla="*/ 14036 w 42286"/>
              <a:gd name="connsiteY12" fmla="*/ 5051 h 43219"/>
              <a:gd name="connsiteX13" fmla="*/ 15336 w 42286"/>
              <a:gd name="connsiteY13" fmla="*/ 6399 h 43219"/>
              <a:gd name="connsiteX14" fmla="*/ 4163 w 42286"/>
              <a:gd name="connsiteY14" fmla="*/ 15648 h 43219"/>
              <a:gd name="connsiteX15" fmla="*/ 3936 w 42286"/>
              <a:gd name="connsiteY15" fmla="*/ 14229 h 43219"/>
              <a:gd name="connsiteX0" fmla="*/ 4061 w 42411"/>
              <a:gd name="connsiteY0" fmla="*/ 14229 h 43219"/>
              <a:gd name="connsiteX1" fmla="*/ 5784 w 42411"/>
              <a:gd name="connsiteY1" fmla="*/ 6766 h 43219"/>
              <a:gd name="connsiteX2" fmla="*/ 14166 w 42411"/>
              <a:gd name="connsiteY2" fmla="*/ 5061 h 43219"/>
              <a:gd name="connsiteX3" fmla="*/ 22617 w 42411"/>
              <a:gd name="connsiteY3" fmla="*/ 3291 h 43219"/>
              <a:gd name="connsiteX4" fmla="*/ 25910 w 42411"/>
              <a:gd name="connsiteY4" fmla="*/ 59 h 43219"/>
              <a:gd name="connsiteX5" fmla="*/ 29994 w 42411"/>
              <a:gd name="connsiteY5" fmla="*/ 2340 h 43219"/>
              <a:gd name="connsiteX6" fmla="*/ 35624 w 42411"/>
              <a:gd name="connsiteY6" fmla="*/ 549 h 43219"/>
              <a:gd name="connsiteX7" fmla="*/ 38479 w 42411"/>
              <a:gd name="connsiteY7" fmla="*/ 5435 h 43219"/>
              <a:gd name="connsiteX8" fmla="*/ 42143 w 42411"/>
              <a:gd name="connsiteY8" fmla="*/ 10177 h 43219"/>
              <a:gd name="connsiteX9" fmla="*/ 41979 w 42411"/>
              <a:gd name="connsiteY9" fmla="*/ 15319 h 43219"/>
              <a:gd name="connsiteX10" fmla="*/ 37565 w 42411"/>
              <a:gd name="connsiteY10" fmla="*/ 30063 h 43219"/>
              <a:gd name="connsiteX11" fmla="*/ 35556 w 42411"/>
              <a:gd name="connsiteY11" fmla="*/ 35960 h 43219"/>
              <a:gd name="connsiteX12" fmla="*/ 28716 w 42411"/>
              <a:gd name="connsiteY12" fmla="*/ 36674 h 43219"/>
              <a:gd name="connsiteX13" fmla="*/ 23828 w 42411"/>
              <a:gd name="connsiteY13" fmla="*/ 42965 h 43219"/>
              <a:gd name="connsiteX14" fmla="*/ 16641 w 42411"/>
              <a:gd name="connsiteY14" fmla="*/ 39125 h 43219"/>
              <a:gd name="connsiteX15" fmla="*/ 5965 w 42411"/>
              <a:gd name="connsiteY15" fmla="*/ 35331 h 43219"/>
              <a:gd name="connsiteX16" fmla="*/ 1271 w 42411"/>
              <a:gd name="connsiteY16" fmla="*/ 31109 h 43219"/>
              <a:gd name="connsiteX17" fmla="*/ 156 w 42411"/>
              <a:gd name="connsiteY17" fmla="*/ 19563 h 43219"/>
              <a:gd name="connsiteX18" fmla="*/ 4024 w 42411"/>
              <a:gd name="connsiteY18" fmla="*/ 14366 h 43219"/>
              <a:gd name="connsiteX19" fmla="*/ 4061 w 42411"/>
              <a:gd name="connsiteY19" fmla="*/ 14229 h 43219"/>
              <a:gd name="connsiteX0" fmla="*/ 7089 w 42411"/>
              <a:gd name="connsiteY0" fmla="*/ 34758 h 43219"/>
              <a:gd name="connsiteX1" fmla="*/ 5981 w 42411"/>
              <a:gd name="connsiteY1" fmla="*/ 35139 h 43219"/>
              <a:gd name="connsiteX2" fmla="*/ 16639 w 42411"/>
              <a:gd name="connsiteY2" fmla="*/ 38949 h 43219"/>
              <a:gd name="connsiteX3" fmla="*/ 15971 w 42411"/>
              <a:gd name="connsiteY3" fmla="*/ 37209 h 43219"/>
              <a:gd name="connsiteX4" fmla="*/ 28988 w 42411"/>
              <a:gd name="connsiteY4" fmla="*/ 34610 h 43219"/>
              <a:gd name="connsiteX5" fmla="*/ 28721 w 42411"/>
              <a:gd name="connsiteY5" fmla="*/ 36519 h 43219"/>
              <a:gd name="connsiteX6" fmla="*/ 38485 w 42411"/>
              <a:gd name="connsiteY6" fmla="*/ 5285 h 43219"/>
              <a:gd name="connsiteX7" fmla="*/ 38561 w 42411"/>
              <a:gd name="connsiteY7" fmla="*/ 6549 h 43219"/>
              <a:gd name="connsiteX8" fmla="*/ 29239 w 42411"/>
              <a:gd name="connsiteY8" fmla="*/ 3811 h 43219"/>
              <a:gd name="connsiteX9" fmla="*/ 29981 w 42411"/>
              <a:gd name="connsiteY9" fmla="*/ 2199 h 43219"/>
              <a:gd name="connsiteX10" fmla="*/ 22302 w 42411"/>
              <a:gd name="connsiteY10" fmla="*/ 4579 h 43219"/>
              <a:gd name="connsiteX11" fmla="*/ 22661 w 42411"/>
              <a:gd name="connsiteY11" fmla="*/ 3189 h 43219"/>
              <a:gd name="connsiteX12" fmla="*/ 14161 w 42411"/>
              <a:gd name="connsiteY12" fmla="*/ 5051 h 43219"/>
              <a:gd name="connsiteX13" fmla="*/ 15461 w 42411"/>
              <a:gd name="connsiteY13" fmla="*/ 6399 h 43219"/>
              <a:gd name="connsiteX14" fmla="*/ 4288 w 42411"/>
              <a:gd name="connsiteY14" fmla="*/ 15648 h 43219"/>
              <a:gd name="connsiteX15" fmla="*/ 4061 w 42411"/>
              <a:gd name="connsiteY15"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37409 w 42255"/>
              <a:gd name="connsiteY10" fmla="*/ 30063 h 43219"/>
              <a:gd name="connsiteX11" fmla="*/ 35400 w 42255"/>
              <a:gd name="connsiteY11" fmla="*/ 35960 h 43219"/>
              <a:gd name="connsiteX12" fmla="*/ 28560 w 42255"/>
              <a:gd name="connsiteY12" fmla="*/ 36674 h 43219"/>
              <a:gd name="connsiteX13" fmla="*/ 23672 w 42255"/>
              <a:gd name="connsiteY13" fmla="*/ 42965 h 43219"/>
              <a:gd name="connsiteX14" fmla="*/ 16485 w 42255"/>
              <a:gd name="connsiteY14" fmla="*/ 39125 h 43219"/>
              <a:gd name="connsiteX15" fmla="*/ 5809 w 42255"/>
              <a:gd name="connsiteY15" fmla="*/ 35331 h 43219"/>
              <a:gd name="connsiteX16" fmla="*/ 0 w 42255"/>
              <a:gd name="connsiteY16" fmla="*/ 19563 h 43219"/>
              <a:gd name="connsiteX17" fmla="*/ 3868 w 42255"/>
              <a:gd name="connsiteY17" fmla="*/ 14366 h 43219"/>
              <a:gd name="connsiteX18" fmla="*/ 3905 w 42255"/>
              <a:gd name="connsiteY18" fmla="*/ 14229 h 43219"/>
              <a:gd name="connsiteX0" fmla="*/ 6933 w 42255"/>
              <a:gd name="connsiteY0" fmla="*/ 34758 h 43219"/>
              <a:gd name="connsiteX1" fmla="*/ 5825 w 42255"/>
              <a:gd name="connsiteY1" fmla="*/ 35139 h 43219"/>
              <a:gd name="connsiteX2" fmla="*/ 16483 w 42255"/>
              <a:gd name="connsiteY2" fmla="*/ 38949 h 43219"/>
              <a:gd name="connsiteX3" fmla="*/ 15815 w 42255"/>
              <a:gd name="connsiteY3" fmla="*/ 37209 h 43219"/>
              <a:gd name="connsiteX4" fmla="*/ 28832 w 42255"/>
              <a:gd name="connsiteY4" fmla="*/ 34610 h 43219"/>
              <a:gd name="connsiteX5" fmla="*/ 28565 w 42255"/>
              <a:gd name="connsiteY5" fmla="*/ 36519 h 43219"/>
              <a:gd name="connsiteX6" fmla="*/ 38329 w 42255"/>
              <a:gd name="connsiteY6" fmla="*/ 5285 h 43219"/>
              <a:gd name="connsiteX7" fmla="*/ 38405 w 42255"/>
              <a:gd name="connsiteY7" fmla="*/ 6549 h 43219"/>
              <a:gd name="connsiteX8" fmla="*/ 29083 w 42255"/>
              <a:gd name="connsiteY8" fmla="*/ 3811 h 43219"/>
              <a:gd name="connsiteX9" fmla="*/ 29825 w 42255"/>
              <a:gd name="connsiteY9" fmla="*/ 2199 h 43219"/>
              <a:gd name="connsiteX10" fmla="*/ 22146 w 42255"/>
              <a:gd name="connsiteY10" fmla="*/ 4579 h 43219"/>
              <a:gd name="connsiteX11" fmla="*/ 22505 w 42255"/>
              <a:gd name="connsiteY11" fmla="*/ 3189 h 43219"/>
              <a:gd name="connsiteX12" fmla="*/ 14005 w 42255"/>
              <a:gd name="connsiteY12" fmla="*/ 5051 h 43219"/>
              <a:gd name="connsiteX13" fmla="*/ 15305 w 42255"/>
              <a:gd name="connsiteY13" fmla="*/ 6399 h 43219"/>
              <a:gd name="connsiteX14" fmla="*/ 4132 w 42255"/>
              <a:gd name="connsiteY14" fmla="*/ 15648 h 43219"/>
              <a:gd name="connsiteX15" fmla="*/ 3905 w 42255"/>
              <a:gd name="connsiteY15"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37409 w 42255"/>
              <a:gd name="connsiteY10" fmla="*/ 30063 h 43219"/>
              <a:gd name="connsiteX11" fmla="*/ 35400 w 42255"/>
              <a:gd name="connsiteY11" fmla="*/ 35960 h 43219"/>
              <a:gd name="connsiteX12" fmla="*/ 28560 w 42255"/>
              <a:gd name="connsiteY12" fmla="*/ 36674 h 43219"/>
              <a:gd name="connsiteX13" fmla="*/ 23672 w 42255"/>
              <a:gd name="connsiteY13" fmla="*/ 42965 h 43219"/>
              <a:gd name="connsiteX14" fmla="*/ 16485 w 42255"/>
              <a:gd name="connsiteY14" fmla="*/ 39125 h 43219"/>
              <a:gd name="connsiteX15" fmla="*/ 5809 w 42255"/>
              <a:gd name="connsiteY15" fmla="*/ 35331 h 43219"/>
              <a:gd name="connsiteX16" fmla="*/ 0 w 42255"/>
              <a:gd name="connsiteY16" fmla="*/ 19563 h 43219"/>
              <a:gd name="connsiteX17" fmla="*/ 3868 w 42255"/>
              <a:gd name="connsiteY17" fmla="*/ 14366 h 43219"/>
              <a:gd name="connsiteX18" fmla="*/ 3905 w 42255"/>
              <a:gd name="connsiteY18" fmla="*/ 14229 h 43219"/>
              <a:gd name="connsiteX0" fmla="*/ 16483 w 42255"/>
              <a:gd name="connsiteY0" fmla="*/ 38949 h 43219"/>
              <a:gd name="connsiteX1" fmla="*/ 15815 w 42255"/>
              <a:gd name="connsiteY1" fmla="*/ 37209 h 43219"/>
              <a:gd name="connsiteX2" fmla="*/ 28832 w 42255"/>
              <a:gd name="connsiteY2" fmla="*/ 34610 h 43219"/>
              <a:gd name="connsiteX3" fmla="*/ 28565 w 42255"/>
              <a:gd name="connsiteY3" fmla="*/ 36519 h 43219"/>
              <a:gd name="connsiteX4" fmla="*/ 38329 w 42255"/>
              <a:gd name="connsiteY4" fmla="*/ 5285 h 43219"/>
              <a:gd name="connsiteX5" fmla="*/ 38405 w 42255"/>
              <a:gd name="connsiteY5" fmla="*/ 6549 h 43219"/>
              <a:gd name="connsiteX6" fmla="*/ 29083 w 42255"/>
              <a:gd name="connsiteY6" fmla="*/ 3811 h 43219"/>
              <a:gd name="connsiteX7" fmla="*/ 29825 w 42255"/>
              <a:gd name="connsiteY7" fmla="*/ 2199 h 43219"/>
              <a:gd name="connsiteX8" fmla="*/ 22146 w 42255"/>
              <a:gd name="connsiteY8" fmla="*/ 4579 h 43219"/>
              <a:gd name="connsiteX9" fmla="*/ 22505 w 42255"/>
              <a:gd name="connsiteY9" fmla="*/ 3189 h 43219"/>
              <a:gd name="connsiteX10" fmla="*/ 14005 w 42255"/>
              <a:gd name="connsiteY10" fmla="*/ 5051 h 43219"/>
              <a:gd name="connsiteX11" fmla="*/ 15305 w 42255"/>
              <a:gd name="connsiteY11" fmla="*/ 6399 h 43219"/>
              <a:gd name="connsiteX12" fmla="*/ 4132 w 42255"/>
              <a:gd name="connsiteY12" fmla="*/ 15648 h 43219"/>
              <a:gd name="connsiteX13" fmla="*/ 3905 w 42255"/>
              <a:gd name="connsiteY13"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37409 w 42255"/>
              <a:gd name="connsiteY10" fmla="*/ 30063 h 43219"/>
              <a:gd name="connsiteX11" fmla="*/ 35400 w 42255"/>
              <a:gd name="connsiteY11" fmla="*/ 35960 h 43219"/>
              <a:gd name="connsiteX12" fmla="*/ 28560 w 42255"/>
              <a:gd name="connsiteY12" fmla="*/ 36674 h 43219"/>
              <a:gd name="connsiteX13" fmla="*/ 23672 w 42255"/>
              <a:gd name="connsiteY13" fmla="*/ 42965 h 43219"/>
              <a:gd name="connsiteX14" fmla="*/ 16485 w 42255"/>
              <a:gd name="connsiteY14" fmla="*/ 39125 h 43219"/>
              <a:gd name="connsiteX15" fmla="*/ 5809 w 42255"/>
              <a:gd name="connsiteY15" fmla="*/ 35331 h 43219"/>
              <a:gd name="connsiteX16" fmla="*/ 0 w 42255"/>
              <a:gd name="connsiteY16" fmla="*/ 19563 h 43219"/>
              <a:gd name="connsiteX17" fmla="*/ 3868 w 42255"/>
              <a:gd name="connsiteY17" fmla="*/ 14366 h 43219"/>
              <a:gd name="connsiteX18" fmla="*/ 3905 w 42255"/>
              <a:gd name="connsiteY18" fmla="*/ 14229 h 43219"/>
              <a:gd name="connsiteX0" fmla="*/ 28832 w 42255"/>
              <a:gd name="connsiteY0" fmla="*/ 34610 h 43219"/>
              <a:gd name="connsiteX1" fmla="*/ 28565 w 42255"/>
              <a:gd name="connsiteY1" fmla="*/ 36519 h 43219"/>
              <a:gd name="connsiteX2" fmla="*/ 38329 w 42255"/>
              <a:gd name="connsiteY2" fmla="*/ 5285 h 43219"/>
              <a:gd name="connsiteX3" fmla="*/ 38405 w 42255"/>
              <a:gd name="connsiteY3" fmla="*/ 6549 h 43219"/>
              <a:gd name="connsiteX4" fmla="*/ 29083 w 42255"/>
              <a:gd name="connsiteY4" fmla="*/ 3811 h 43219"/>
              <a:gd name="connsiteX5" fmla="*/ 29825 w 42255"/>
              <a:gd name="connsiteY5" fmla="*/ 2199 h 43219"/>
              <a:gd name="connsiteX6" fmla="*/ 22146 w 42255"/>
              <a:gd name="connsiteY6" fmla="*/ 4579 h 43219"/>
              <a:gd name="connsiteX7" fmla="*/ 22505 w 42255"/>
              <a:gd name="connsiteY7" fmla="*/ 3189 h 43219"/>
              <a:gd name="connsiteX8" fmla="*/ 14005 w 42255"/>
              <a:gd name="connsiteY8" fmla="*/ 5051 h 43219"/>
              <a:gd name="connsiteX9" fmla="*/ 15305 w 42255"/>
              <a:gd name="connsiteY9" fmla="*/ 6399 h 43219"/>
              <a:gd name="connsiteX10" fmla="*/ 4132 w 42255"/>
              <a:gd name="connsiteY10" fmla="*/ 15648 h 43219"/>
              <a:gd name="connsiteX11" fmla="*/ 3905 w 42255"/>
              <a:gd name="connsiteY11"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37409 w 42255"/>
              <a:gd name="connsiteY10" fmla="*/ 30063 h 43219"/>
              <a:gd name="connsiteX11" fmla="*/ 35400 w 42255"/>
              <a:gd name="connsiteY11" fmla="*/ 35960 h 43219"/>
              <a:gd name="connsiteX12" fmla="*/ 28560 w 42255"/>
              <a:gd name="connsiteY12" fmla="*/ 36674 h 43219"/>
              <a:gd name="connsiteX13" fmla="*/ 23672 w 42255"/>
              <a:gd name="connsiteY13" fmla="*/ 42965 h 43219"/>
              <a:gd name="connsiteX14" fmla="*/ 16485 w 42255"/>
              <a:gd name="connsiteY14" fmla="*/ 39125 h 43219"/>
              <a:gd name="connsiteX15" fmla="*/ 5809 w 42255"/>
              <a:gd name="connsiteY15" fmla="*/ 35331 h 43219"/>
              <a:gd name="connsiteX16" fmla="*/ 0 w 42255"/>
              <a:gd name="connsiteY16" fmla="*/ 19563 h 43219"/>
              <a:gd name="connsiteX17" fmla="*/ 3868 w 42255"/>
              <a:gd name="connsiteY17" fmla="*/ 14366 h 43219"/>
              <a:gd name="connsiteX18" fmla="*/ 3905 w 42255"/>
              <a:gd name="connsiteY18" fmla="*/ 14229 h 43219"/>
              <a:gd name="connsiteX0" fmla="*/ 38329 w 42255"/>
              <a:gd name="connsiteY0" fmla="*/ 5285 h 43219"/>
              <a:gd name="connsiteX1" fmla="*/ 38405 w 42255"/>
              <a:gd name="connsiteY1" fmla="*/ 6549 h 43219"/>
              <a:gd name="connsiteX2" fmla="*/ 29083 w 42255"/>
              <a:gd name="connsiteY2" fmla="*/ 3811 h 43219"/>
              <a:gd name="connsiteX3" fmla="*/ 29825 w 42255"/>
              <a:gd name="connsiteY3" fmla="*/ 2199 h 43219"/>
              <a:gd name="connsiteX4" fmla="*/ 22146 w 42255"/>
              <a:gd name="connsiteY4" fmla="*/ 4579 h 43219"/>
              <a:gd name="connsiteX5" fmla="*/ 22505 w 42255"/>
              <a:gd name="connsiteY5" fmla="*/ 3189 h 43219"/>
              <a:gd name="connsiteX6" fmla="*/ 14005 w 42255"/>
              <a:gd name="connsiteY6" fmla="*/ 5051 h 43219"/>
              <a:gd name="connsiteX7" fmla="*/ 15305 w 42255"/>
              <a:gd name="connsiteY7" fmla="*/ 6399 h 43219"/>
              <a:gd name="connsiteX8" fmla="*/ 4132 w 42255"/>
              <a:gd name="connsiteY8" fmla="*/ 15648 h 43219"/>
              <a:gd name="connsiteX9" fmla="*/ 3905 w 42255"/>
              <a:gd name="connsiteY9"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35400 w 42255"/>
              <a:gd name="connsiteY10" fmla="*/ 35960 h 43219"/>
              <a:gd name="connsiteX11" fmla="*/ 28560 w 42255"/>
              <a:gd name="connsiteY11" fmla="*/ 36674 h 43219"/>
              <a:gd name="connsiteX12" fmla="*/ 23672 w 42255"/>
              <a:gd name="connsiteY12" fmla="*/ 42965 h 43219"/>
              <a:gd name="connsiteX13" fmla="*/ 16485 w 42255"/>
              <a:gd name="connsiteY13" fmla="*/ 39125 h 43219"/>
              <a:gd name="connsiteX14" fmla="*/ 5809 w 42255"/>
              <a:gd name="connsiteY14" fmla="*/ 35331 h 43219"/>
              <a:gd name="connsiteX15" fmla="*/ 0 w 42255"/>
              <a:gd name="connsiteY15" fmla="*/ 19563 h 43219"/>
              <a:gd name="connsiteX16" fmla="*/ 3868 w 42255"/>
              <a:gd name="connsiteY16" fmla="*/ 14366 h 43219"/>
              <a:gd name="connsiteX17" fmla="*/ 3905 w 42255"/>
              <a:gd name="connsiteY17" fmla="*/ 14229 h 43219"/>
              <a:gd name="connsiteX0" fmla="*/ 38329 w 42255"/>
              <a:gd name="connsiteY0" fmla="*/ 5285 h 43219"/>
              <a:gd name="connsiteX1" fmla="*/ 38405 w 42255"/>
              <a:gd name="connsiteY1" fmla="*/ 6549 h 43219"/>
              <a:gd name="connsiteX2" fmla="*/ 29083 w 42255"/>
              <a:gd name="connsiteY2" fmla="*/ 3811 h 43219"/>
              <a:gd name="connsiteX3" fmla="*/ 29825 w 42255"/>
              <a:gd name="connsiteY3" fmla="*/ 2199 h 43219"/>
              <a:gd name="connsiteX4" fmla="*/ 22146 w 42255"/>
              <a:gd name="connsiteY4" fmla="*/ 4579 h 43219"/>
              <a:gd name="connsiteX5" fmla="*/ 22505 w 42255"/>
              <a:gd name="connsiteY5" fmla="*/ 3189 h 43219"/>
              <a:gd name="connsiteX6" fmla="*/ 14005 w 42255"/>
              <a:gd name="connsiteY6" fmla="*/ 5051 h 43219"/>
              <a:gd name="connsiteX7" fmla="*/ 15305 w 42255"/>
              <a:gd name="connsiteY7" fmla="*/ 6399 h 43219"/>
              <a:gd name="connsiteX8" fmla="*/ 4132 w 42255"/>
              <a:gd name="connsiteY8" fmla="*/ 15648 h 43219"/>
              <a:gd name="connsiteX9" fmla="*/ 3905 w 42255"/>
              <a:gd name="connsiteY9" fmla="*/ 14229 h 43219"/>
              <a:gd name="connsiteX0" fmla="*/ 3905 w 42255"/>
              <a:gd name="connsiteY0" fmla="*/ 14229 h 43219"/>
              <a:gd name="connsiteX1" fmla="*/ 5628 w 42255"/>
              <a:gd name="connsiteY1" fmla="*/ 6766 h 43219"/>
              <a:gd name="connsiteX2" fmla="*/ 14010 w 42255"/>
              <a:gd name="connsiteY2" fmla="*/ 5061 h 43219"/>
              <a:gd name="connsiteX3" fmla="*/ 22461 w 42255"/>
              <a:gd name="connsiteY3" fmla="*/ 3291 h 43219"/>
              <a:gd name="connsiteX4" fmla="*/ 25754 w 42255"/>
              <a:gd name="connsiteY4" fmla="*/ 59 h 43219"/>
              <a:gd name="connsiteX5" fmla="*/ 29838 w 42255"/>
              <a:gd name="connsiteY5" fmla="*/ 2340 h 43219"/>
              <a:gd name="connsiteX6" fmla="*/ 35468 w 42255"/>
              <a:gd name="connsiteY6" fmla="*/ 549 h 43219"/>
              <a:gd name="connsiteX7" fmla="*/ 38323 w 42255"/>
              <a:gd name="connsiteY7" fmla="*/ 5435 h 43219"/>
              <a:gd name="connsiteX8" fmla="*/ 41987 w 42255"/>
              <a:gd name="connsiteY8" fmla="*/ 10177 h 43219"/>
              <a:gd name="connsiteX9" fmla="*/ 41823 w 42255"/>
              <a:gd name="connsiteY9" fmla="*/ 15319 h 43219"/>
              <a:gd name="connsiteX10" fmla="*/ 28560 w 42255"/>
              <a:gd name="connsiteY10" fmla="*/ 36674 h 43219"/>
              <a:gd name="connsiteX11" fmla="*/ 23672 w 42255"/>
              <a:gd name="connsiteY11" fmla="*/ 42965 h 43219"/>
              <a:gd name="connsiteX12" fmla="*/ 16485 w 42255"/>
              <a:gd name="connsiteY12" fmla="*/ 39125 h 43219"/>
              <a:gd name="connsiteX13" fmla="*/ 5809 w 42255"/>
              <a:gd name="connsiteY13" fmla="*/ 35331 h 43219"/>
              <a:gd name="connsiteX14" fmla="*/ 0 w 42255"/>
              <a:gd name="connsiteY14" fmla="*/ 19563 h 43219"/>
              <a:gd name="connsiteX15" fmla="*/ 3868 w 42255"/>
              <a:gd name="connsiteY15" fmla="*/ 14366 h 43219"/>
              <a:gd name="connsiteX16" fmla="*/ 3905 w 42255"/>
              <a:gd name="connsiteY16" fmla="*/ 14229 h 43219"/>
              <a:gd name="connsiteX0" fmla="*/ 38329 w 42255"/>
              <a:gd name="connsiteY0" fmla="*/ 5285 h 43219"/>
              <a:gd name="connsiteX1" fmla="*/ 38405 w 42255"/>
              <a:gd name="connsiteY1" fmla="*/ 6549 h 43219"/>
              <a:gd name="connsiteX2" fmla="*/ 29083 w 42255"/>
              <a:gd name="connsiteY2" fmla="*/ 3811 h 43219"/>
              <a:gd name="connsiteX3" fmla="*/ 29825 w 42255"/>
              <a:gd name="connsiteY3" fmla="*/ 2199 h 43219"/>
              <a:gd name="connsiteX4" fmla="*/ 22146 w 42255"/>
              <a:gd name="connsiteY4" fmla="*/ 4579 h 43219"/>
              <a:gd name="connsiteX5" fmla="*/ 22505 w 42255"/>
              <a:gd name="connsiteY5" fmla="*/ 3189 h 43219"/>
              <a:gd name="connsiteX6" fmla="*/ 14005 w 42255"/>
              <a:gd name="connsiteY6" fmla="*/ 5051 h 43219"/>
              <a:gd name="connsiteX7" fmla="*/ 15305 w 42255"/>
              <a:gd name="connsiteY7" fmla="*/ 6399 h 43219"/>
              <a:gd name="connsiteX8" fmla="*/ 4132 w 42255"/>
              <a:gd name="connsiteY8" fmla="*/ 15648 h 43219"/>
              <a:gd name="connsiteX9" fmla="*/ 3905 w 42255"/>
              <a:gd name="connsiteY9" fmla="*/ 14229 h 43219"/>
              <a:gd name="connsiteX0" fmla="*/ 3905 w 42255"/>
              <a:gd name="connsiteY0" fmla="*/ 14229 h 44501"/>
              <a:gd name="connsiteX1" fmla="*/ 5628 w 42255"/>
              <a:gd name="connsiteY1" fmla="*/ 6766 h 44501"/>
              <a:gd name="connsiteX2" fmla="*/ 14010 w 42255"/>
              <a:gd name="connsiteY2" fmla="*/ 5061 h 44501"/>
              <a:gd name="connsiteX3" fmla="*/ 22461 w 42255"/>
              <a:gd name="connsiteY3" fmla="*/ 3291 h 44501"/>
              <a:gd name="connsiteX4" fmla="*/ 25754 w 42255"/>
              <a:gd name="connsiteY4" fmla="*/ 59 h 44501"/>
              <a:gd name="connsiteX5" fmla="*/ 29838 w 42255"/>
              <a:gd name="connsiteY5" fmla="*/ 2340 h 44501"/>
              <a:gd name="connsiteX6" fmla="*/ 35468 w 42255"/>
              <a:gd name="connsiteY6" fmla="*/ 549 h 44501"/>
              <a:gd name="connsiteX7" fmla="*/ 38323 w 42255"/>
              <a:gd name="connsiteY7" fmla="*/ 5435 h 44501"/>
              <a:gd name="connsiteX8" fmla="*/ 41987 w 42255"/>
              <a:gd name="connsiteY8" fmla="*/ 10177 h 44501"/>
              <a:gd name="connsiteX9" fmla="*/ 41823 w 42255"/>
              <a:gd name="connsiteY9" fmla="*/ 15319 h 44501"/>
              <a:gd name="connsiteX10" fmla="*/ 23672 w 42255"/>
              <a:gd name="connsiteY10" fmla="*/ 42965 h 44501"/>
              <a:gd name="connsiteX11" fmla="*/ 16485 w 42255"/>
              <a:gd name="connsiteY11" fmla="*/ 39125 h 44501"/>
              <a:gd name="connsiteX12" fmla="*/ 5809 w 42255"/>
              <a:gd name="connsiteY12" fmla="*/ 35331 h 44501"/>
              <a:gd name="connsiteX13" fmla="*/ 0 w 42255"/>
              <a:gd name="connsiteY13" fmla="*/ 19563 h 44501"/>
              <a:gd name="connsiteX14" fmla="*/ 3868 w 42255"/>
              <a:gd name="connsiteY14" fmla="*/ 14366 h 44501"/>
              <a:gd name="connsiteX15" fmla="*/ 3905 w 42255"/>
              <a:gd name="connsiteY15" fmla="*/ 14229 h 44501"/>
              <a:gd name="connsiteX0" fmla="*/ 38329 w 42255"/>
              <a:gd name="connsiteY0" fmla="*/ 5285 h 44501"/>
              <a:gd name="connsiteX1" fmla="*/ 38405 w 42255"/>
              <a:gd name="connsiteY1" fmla="*/ 6549 h 44501"/>
              <a:gd name="connsiteX2" fmla="*/ 29083 w 42255"/>
              <a:gd name="connsiteY2" fmla="*/ 3811 h 44501"/>
              <a:gd name="connsiteX3" fmla="*/ 29825 w 42255"/>
              <a:gd name="connsiteY3" fmla="*/ 2199 h 44501"/>
              <a:gd name="connsiteX4" fmla="*/ 22146 w 42255"/>
              <a:gd name="connsiteY4" fmla="*/ 4579 h 44501"/>
              <a:gd name="connsiteX5" fmla="*/ 22505 w 42255"/>
              <a:gd name="connsiteY5" fmla="*/ 3189 h 44501"/>
              <a:gd name="connsiteX6" fmla="*/ 14005 w 42255"/>
              <a:gd name="connsiteY6" fmla="*/ 5051 h 44501"/>
              <a:gd name="connsiteX7" fmla="*/ 15305 w 42255"/>
              <a:gd name="connsiteY7" fmla="*/ 6399 h 44501"/>
              <a:gd name="connsiteX8" fmla="*/ 4132 w 42255"/>
              <a:gd name="connsiteY8" fmla="*/ 15648 h 44501"/>
              <a:gd name="connsiteX9" fmla="*/ 3905 w 42255"/>
              <a:gd name="connsiteY9" fmla="*/ 14229 h 44501"/>
              <a:gd name="connsiteX0" fmla="*/ 3905 w 42255"/>
              <a:gd name="connsiteY0" fmla="*/ 14229 h 40633"/>
              <a:gd name="connsiteX1" fmla="*/ 5628 w 42255"/>
              <a:gd name="connsiteY1" fmla="*/ 6766 h 40633"/>
              <a:gd name="connsiteX2" fmla="*/ 14010 w 42255"/>
              <a:gd name="connsiteY2" fmla="*/ 5061 h 40633"/>
              <a:gd name="connsiteX3" fmla="*/ 22461 w 42255"/>
              <a:gd name="connsiteY3" fmla="*/ 3291 h 40633"/>
              <a:gd name="connsiteX4" fmla="*/ 25754 w 42255"/>
              <a:gd name="connsiteY4" fmla="*/ 59 h 40633"/>
              <a:gd name="connsiteX5" fmla="*/ 29838 w 42255"/>
              <a:gd name="connsiteY5" fmla="*/ 2340 h 40633"/>
              <a:gd name="connsiteX6" fmla="*/ 35468 w 42255"/>
              <a:gd name="connsiteY6" fmla="*/ 549 h 40633"/>
              <a:gd name="connsiteX7" fmla="*/ 38323 w 42255"/>
              <a:gd name="connsiteY7" fmla="*/ 5435 h 40633"/>
              <a:gd name="connsiteX8" fmla="*/ 41987 w 42255"/>
              <a:gd name="connsiteY8" fmla="*/ 10177 h 40633"/>
              <a:gd name="connsiteX9" fmla="*/ 41823 w 42255"/>
              <a:gd name="connsiteY9" fmla="*/ 15319 h 40633"/>
              <a:gd name="connsiteX10" fmla="*/ 16485 w 42255"/>
              <a:gd name="connsiteY10" fmla="*/ 39125 h 40633"/>
              <a:gd name="connsiteX11" fmla="*/ 5809 w 42255"/>
              <a:gd name="connsiteY11" fmla="*/ 35331 h 40633"/>
              <a:gd name="connsiteX12" fmla="*/ 0 w 42255"/>
              <a:gd name="connsiteY12" fmla="*/ 19563 h 40633"/>
              <a:gd name="connsiteX13" fmla="*/ 3868 w 42255"/>
              <a:gd name="connsiteY13" fmla="*/ 14366 h 40633"/>
              <a:gd name="connsiteX14" fmla="*/ 3905 w 42255"/>
              <a:gd name="connsiteY14" fmla="*/ 14229 h 40633"/>
              <a:gd name="connsiteX0" fmla="*/ 38329 w 42255"/>
              <a:gd name="connsiteY0" fmla="*/ 5285 h 40633"/>
              <a:gd name="connsiteX1" fmla="*/ 38405 w 42255"/>
              <a:gd name="connsiteY1" fmla="*/ 6549 h 40633"/>
              <a:gd name="connsiteX2" fmla="*/ 29083 w 42255"/>
              <a:gd name="connsiteY2" fmla="*/ 3811 h 40633"/>
              <a:gd name="connsiteX3" fmla="*/ 29825 w 42255"/>
              <a:gd name="connsiteY3" fmla="*/ 2199 h 40633"/>
              <a:gd name="connsiteX4" fmla="*/ 22146 w 42255"/>
              <a:gd name="connsiteY4" fmla="*/ 4579 h 40633"/>
              <a:gd name="connsiteX5" fmla="*/ 22505 w 42255"/>
              <a:gd name="connsiteY5" fmla="*/ 3189 h 40633"/>
              <a:gd name="connsiteX6" fmla="*/ 14005 w 42255"/>
              <a:gd name="connsiteY6" fmla="*/ 5051 h 40633"/>
              <a:gd name="connsiteX7" fmla="*/ 15305 w 42255"/>
              <a:gd name="connsiteY7" fmla="*/ 6399 h 40633"/>
              <a:gd name="connsiteX8" fmla="*/ 4132 w 42255"/>
              <a:gd name="connsiteY8" fmla="*/ 15648 h 40633"/>
              <a:gd name="connsiteX9" fmla="*/ 3905 w 42255"/>
              <a:gd name="connsiteY9" fmla="*/ 14229 h 40633"/>
              <a:gd name="connsiteX0" fmla="*/ 3905 w 42255"/>
              <a:gd name="connsiteY0" fmla="*/ 14229 h 35331"/>
              <a:gd name="connsiteX1" fmla="*/ 5628 w 42255"/>
              <a:gd name="connsiteY1" fmla="*/ 6766 h 35331"/>
              <a:gd name="connsiteX2" fmla="*/ 14010 w 42255"/>
              <a:gd name="connsiteY2" fmla="*/ 5061 h 35331"/>
              <a:gd name="connsiteX3" fmla="*/ 22461 w 42255"/>
              <a:gd name="connsiteY3" fmla="*/ 3291 h 35331"/>
              <a:gd name="connsiteX4" fmla="*/ 25754 w 42255"/>
              <a:gd name="connsiteY4" fmla="*/ 59 h 35331"/>
              <a:gd name="connsiteX5" fmla="*/ 29838 w 42255"/>
              <a:gd name="connsiteY5" fmla="*/ 2340 h 35331"/>
              <a:gd name="connsiteX6" fmla="*/ 35468 w 42255"/>
              <a:gd name="connsiteY6" fmla="*/ 549 h 35331"/>
              <a:gd name="connsiteX7" fmla="*/ 38323 w 42255"/>
              <a:gd name="connsiteY7" fmla="*/ 5435 h 35331"/>
              <a:gd name="connsiteX8" fmla="*/ 41987 w 42255"/>
              <a:gd name="connsiteY8" fmla="*/ 10177 h 35331"/>
              <a:gd name="connsiteX9" fmla="*/ 41823 w 42255"/>
              <a:gd name="connsiteY9" fmla="*/ 15319 h 35331"/>
              <a:gd name="connsiteX10" fmla="*/ 5809 w 42255"/>
              <a:gd name="connsiteY10" fmla="*/ 35331 h 35331"/>
              <a:gd name="connsiteX11" fmla="*/ 0 w 42255"/>
              <a:gd name="connsiteY11" fmla="*/ 19563 h 35331"/>
              <a:gd name="connsiteX12" fmla="*/ 3868 w 42255"/>
              <a:gd name="connsiteY12" fmla="*/ 14366 h 35331"/>
              <a:gd name="connsiteX13" fmla="*/ 3905 w 42255"/>
              <a:gd name="connsiteY13" fmla="*/ 14229 h 35331"/>
              <a:gd name="connsiteX0" fmla="*/ 38329 w 42255"/>
              <a:gd name="connsiteY0" fmla="*/ 5285 h 35331"/>
              <a:gd name="connsiteX1" fmla="*/ 38405 w 42255"/>
              <a:gd name="connsiteY1" fmla="*/ 6549 h 35331"/>
              <a:gd name="connsiteX2" fmla="*/ 29083 w 42255"/>
              <a:gd name="connsiteY2" fmla="*/ 3811 h 35331"/>
              <a:gd name="connsiteX3" fmla="*/ 29825 w 42255"/>
              <a:gd name="connsiteY3" fmla="*/ 2199 h 35331"/>
              <a:gd name="connsiteX4" fmla="*/ 22146 w 42255"/>
              <a:gd name="connsiteY4" fmla="*/ 4579 h 35331"/>
              <a:gd name="connsiteX5" fmla="*/ 22505 w 42255"/>
              <a:gd name="connsiteY5" fmla="*/ 3189 h 35331"/>
              <a:gd name="connsiteX6" fmla="*/ 14005 w 42255"/>
              <a:gd name="connsiteY6" fmla="*/ 5051 h 35331"/>
              <a:gd name="connsiteX7" fmla="*/ 15305 w 42255"/>
              <a:gd name="connsiteY7" fmla="*/ 6399 h 35331"/>
              <a:gd name="connsiteX8" fmla="*/ 4132 w 42255"/>
              <a:gd name="connsiteY8" fmla="*/ 15648 h 35331"/>
              <a:gd name="connsiteX9" fmla="*/ 3905 w 42255"/>
              <a:gd name="connsiteY9" fmla="*/ 14229 h 35331"/>
              <a:gd name="connsiteX0" fmla="*/ 3905 w 42255"/>
              <a:gd name="connsiteY0" fmla="*/ 14229 h 19569"/>
              <a:gd name="connsiteX1" fmla="*/ 5628 w 42255"/>
              <a:gd name="connsiteY1" fmla="*/ 6766 h 19569"/>
              <a:gd name="connsiteX2" fmla="*/ 14010 w 42255"/>
              <a:gd name="connsiteY2" fmla="*/ 5061 h 19569"/>
              <a:gd name="connsiteX3" fmla="*/ 22461 w 42255"/>
              <a:gd name="connsiteY3" fmla="*/ 3291 h 19569"/>
              <a:gd name="connsiteX4" fmla="*/ 25754 w 42255"/>
              <a:gd name="connsiteY4" fmla="*/ 59 h 19569"/>
              <a:gd name="connsiteX5" fmla="*/ 29838 w 42255"/>
              <a:gd name="connsiteY5" fmla="*/ 2340 h 19569"/>
              <a:gd name="connsiteX6" fmla="*/ 35468 w 42255"/>
              <a:gd name="connsiteY6" fmla="*/ 549 h 19569"/>
              <a:gd name="connsiteX7" fmla="*/ 38323 w 42255"/>
              <a:gd name="connsiteY7" fmla="*/ 5435 h 19569"/>
              <a:gd name="connsiteX8" fmla="*/ 41987 w 42255"/>
              <a:gd name="connsiteY8" fmla="*/ 10177 h 19569"/>
              <a:gd name="connsiteX9" fmla="*/ 41823 w 42255"/>
              <a:gd name="connsiteY9" fmla="*/ 15319 h 19569"/>
              <a:gd name="connsiteX10" fmla="*/ 0 w 42255"/>
              <a:gd name="connsiteY10" fmla="*/ 19563 h 19569"/>
              <a:gd name="connsiteX11" fmla="*/ 3868 w 42255"/>
              <a:gd name="connsiteY11" fmla="*/ 14366 h 19569"/>
              <a:gd name="connsiteX12" fmla="*/ 3905 w 42255"/>
              <a:gd name="connsiteY12" fmla="*/ 14229 h 19569"/>
              <a:gd name="connsiteX0" fmla="*/ 38329 w 42255"/>
              <a:gd name="connsiteY0" fmla="*/ 5285 h 19569"/>
              <a:gd name="connsiteX1" fmla="*/ 38405 w 42255"/>
              <a:gd name="connsiteY1" fmla="*/ 6549 h 19569"/>
              <a:gd name="connsiteX2" fmla="*/ 29083 w 42255"/>
              <a:gd name="connsiteY2" fmla="*/ 3811 h 19569"/>
              <a:gd name="connsiteX3" fmla="*/ 29825 w 42255"/>
              <a:gd name="connsiteY3" fmla="*/ 2199 h 19569"/>
              <a:gd name="connsiteX4" fmla="*/ 22146 w 42255"/>
              <a:gd name="connsiteY4" fmla="*/ 4579 h 19569"/>
              <a:gd name="connsiteX5" fmla="*/ 22505 w 42255"/>
              <a:gd name="connsiteY5" fmla="*/ 3189 h 19569"/>
              <a:gd name="connsiteX6" fmla="*/ 14005 w 42255"/>
              <a:gd name="connsiteY6" fmla="*/ 5051 h 19569"/>
              <a:gd name="connsiteX7" fmla="*/ 15305 w 42255"/>
              <a:gd name="connsiteY7" fmla="*/ 6399 h 19569"/>
              <a:gd name="connsiteX8" fmla="*/ 4132 w 42255"/>
              <a:gd name="connsiteY8" fmla="*/ 15648 h 19569"/>
              <a:gd name="connsiteX9" fmla="*/ 3905 w 42255"/>
              <a:gd name="connsiteY9" fmla="*/ 14229 h 19569"/>
              <a:gd name="connsiteX0" fmla="*/ 62 w 38412"/>
              <a:gd name="connsiteY0" fmla="*/ 14229 h 15648"/>
              <a:gd name="connsiteX1" fmla="*/ 1785 w 38412"/>
              <a:gd name="connsiteY1" fmla="*/ 6766 h 15648"/>
              <a:gd name="connsiteX2" fmla="*/ 10167 w 38412"/>
              <a:gd name="connsiteY2" fmla="*/ 5061 h 15648"/>
              <a:gd name="connsiteX3" fmla="*/ 18618 w 38412"/>
              <a:gd name="connsiteY3" fmla="*/ 3291 h 15648"/>
              <a:gd name="connsiteX4" fmla="*/ 21911 w 38412"/>
              <a:gd name="connsiteY4" fmla="*/ 59 h 15648"/>
              <a:gd name="connsiteX5" fmla="*/ 25995 w 38412"/>
              <a:gd name="connsiteY5" fmla="*/ 2340 h 15648"/>
              <a:gd name="connsiteX6" fmla="*/ 31625 w 38412"/>
              <a:gd name="connsiteY6" fmla="*/ 549 h 15648"/>
              <a:gd name="connsiteX7" fmla="*/ 34480 w 38412"/>
              <a:gd name="connsiteY7" fmla="*/ 5435 h 15648"/>
              <a:gd name="connsiteX8" fmla="*/ 38144 w 38412"/>
              <a:gd name="connsiteY8" fmla="*/ 10177 h 15648"/>
              <a:gd name="connsiteX9" fmla="*/ 37980 w 38412"/>
              <a:gd name="connsiteY9" fmla="*/ 15319 h 15648"/>
              <a:gd name="connsiteX10" fmla="*/ 25 w 38412"/>
              <a:gd name="connsiteY10" fmla="*/ 14366 h 15648"/>
              <a:gd name="connsiteX11" fmla="*/ 62 w 38412"/>
              <a:gd name="connsiteY11" fmla="*/ 14229 h 15648"/>
              <a:gd name="connsiteX0" fmla="*/ 34486 w 38412"/>
              <a:gd name="connsiteY0" fmla="*/ 5285 h 15648"/>
              <a:gd name="connsiteX1" fmla="*/ 34562 w 38412"/>
              <a:gd name="connsiteY1" fmla="*/ 6549 h 15648"/>
              <a:gd name="connsiteX2" fmla="*/ 25240 w 38412"/>
              <a:gd name="connsiteY2" fmla="*/ 3811 h 15648"/>
              <a:gd name="connsiteX3" fmla="*/ 25982 w 38412"/>
              <a:gd name="connsiteY3" fmla="*/ 2199 h 15648"/>
              <a:gd name="connsiteX4" fmla="*/ 18303 w 38412"/>
              <a:gd name="connsiteY4" fmla="*/ 4579 h 15648"/>
              <a:gd name="connsiteX5" fmla="*/ 18662 w 38412"/>
              <a:gd name="connsiteY5" fmla="*/ 3189 h 15648"/>
              <a:gd name="connsiteX6" fmla="*/ 10162 w 38412"/>
              <a:gd name="connsiteY6" fmla="*/ 5051 h 15648"/>
              <a:gd name="connsiteX7" fmla="*/ 11462 w 38412"/>
              <a:gd name="connsiteY7" fmla="*/ 6399 h 15648"/>
              <a:gd name="connsiteX8" fmla="*/ 289 w 38412"/>
              <a:gd name="connsiteY8" fmla="*/ 15648 h 15648"/>
              <a:gd name="connsiteX9" fmla="*/ 62 w 38412"/>
              <a:gd name="connsiteY9" fmla="*/ 14229 h 15648"/>
              <a:gd name="connsiteX0" fmla="*/ 62 w 38412"/>
              <a:gd name="connsiteY0" fmla="*/ 14229 h 16457"/>
              <a:gd name="connsiteX1" fmla="*/ 1785 w 38412"/>
              <a:gd name="connsiteY1" fmla="*/ 6766 h 16457"/>
              <a:gd name="connsiteX2" fmla="*/ 10167 w 38412"/>
              <a:gd name="connsiteY2" fmla="*/ 5061 h 16457"/>
              <a:gd name="connsiteX3" fmla="*/ 18618 w 38412"/>
              <a:gd name="connsiteY3" fmla="*/ 3291 h 16457"/>
              <a:gd name="connsiteX4" fmla="*/ 21911 w 38412"/>
              <a:gd name="connsiteY4" fmla="*/ 59 h 16457"/>
              <a:gd name="connsiteX5" fmla="*/ 25995 w 38412"/>
              <a:gd name="connsiteY5" fmla="*/ 2340 h 16457"/>
              <a:gd name="connsiteX6" fmla="*/ 31625 w 38412"/>
              <a:gd name="connsiteY6" fmla="*/ 549 h 16457"/>
              <a:gd name="connsiteX7" fmla="*/ 34480 w 38412"/>
              <a:gd name="connsiteY7" fmla="*/ 5435 h 16457"/>
              <a:gd name="connsiteX8" fmla="*/ 38144 w 38412"/>
              <a:gd name="connsiteY8" fmla="*/ 10177 h 16457"/>
              <a:gd name="connsiteX9" fmla="*/ 37980 w 38412"/>
              <a:gd name="connsiteY9" fmla="*/ 15319 h 16457"/>
              <a:gd name="connsiteX10" fmla="*/ 17419 w 38412"/>
              <a:gd name="connsiteY10" fmla="*/ 16429 h 16457"/>
              <a:gd name="connsiteX11" fmla="*/ 25 w 38412"/>
              <a:gd name="connsiteY11" fmla="*/ 14366 h 16457"/>
              <a:gd name="connsiteX12" fmla="*/ 62 w 38412"/>
              <a:gd name="connsiteY12" fmla="*/ 14229 h 16457"/>
              <a:gd name="connsiteX0" fmla="*/ 34486 w 38412"/>
              <a:gd name="connsiteY0" fmla="*/ 5285 h 16457"/>
              <a:gd name="connsiteX1" fmla="*/ 34562 w 38412"/>
              <a:gd name="connsiteY1" fmla="*/ 6549 h 16457"/>
              <a:gd name="connsiteX2" fmla="*/ 25240 w 38412"/>
              <a:gd name="connsiteY2" fmla="*/ 3811 h 16457"/>
              <a:gd name="connsiteX3" fmla="*/ 25982 w 38412"/>
              <a:gd name="connsiteY3" fmla="*/ 2199 h 16457"/>
              <a:gd name="connsiteX4" fmla="*/ 18303 w 38412"/>
              <a:gd name="connsiteY4" fmla="*/ 4579 h 16457"/>
              <a:gd name="connsiteX5" fmla="*/ 18662 w 38412"/>
              <a:gd name="connsiteY5" fmla="*/ 3189 h 16457"/>
              <a:gd name="connsiteX6" fmla="*/ 10162 w 38412"/>
              <a:gd name="connsiteY6" fmla="*/ 5051 h 16457"/>
              <a:gd name="connsiteX7" fmla="*/ 11462 w 38412"/>
              <a:gd name="connsiteY7" fmla="*/ 6399 h 16457"/>
              <a:gd name="connsiteX8" fmla="*/ 289 w 38412"/>
              <a:gd name="connsiteY8" fmla="*/ 15648 h 16457"/>
              <a:gd name="connsiteX9" fmla="*/ 62 w 38412"/>
              <a:gd name="connsiteY9" fmla="*/ 14229 h 16457"/>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 ang="0">
                <a:pos x="connsiteX8" y="connsiteY8"/>
              </a:cxn>
              <a:cxn ang="0">
                <a:pos x="connsiteX9" y="connsiteY9"/>
              </a:cxn>
            </a:cxnLst>
            <a:rect l="l" t="t" r="r" b="b"/>
            <a:pathLst>
              <a:path w="38412" h="16457">
                <a:moveTo>
                  <a:pt x="62" y="14229"/>
                </a:moveTo>
                <a:cubicBezTo>
                  <a:pt x="-209" y="11516"/>
                  <a:pt x="423" y="8780"/>
                  <a:pt x="1785" y="6766"/>
                </a:cubicBezTo>
                <a:cubicBezTo>
                  <a:pt x="3937" y="3585"/>
                  <a:pt x="7426" y="2876"/>
                  <a:pt x="10167" y="5061"/>
                </a:cubicBezTo>
                <a:cubicBezTo>
                  <a:pt x="11840" y="768"/>
                  <a:pt x="16076" y="-119"/>
                  <a:pt x="18618" y="3291"/>
                </a:cubicBezTo>
                <a:cubicBezTo>
                  <a:pt x="19259" y="1542"/>
                  <a:pt x="20490" y="333"/>
                  <a:pt x="21911" y="59"/>
                </a:cubicBezTo>
                <a:cubicBezTo>
                  <a:pt x="23475" y="-243"/>
                  <a:pt x="25037" y="629"/>
                  <a:pt x="25995" y="2340"/>
                </a:cubicBezTo>
                <a:cubicBezTo>
                  <a:pt x="27377" y="126"/>
                  <a:pt x="29663" y="-601"/>
                  <a:pt x="31625" y="549"/>
                </a:cubicBezTo>
                <a:cubicBezTo>
                  <a:pt x="33120" y="1425"/>
                  <a:pt x="34192" y="3259"/>
                  <a:pt x="34480" y="5435"/>
                </a:cubicBezTo>
                <a:cubicBezTo>
                  <a:pt x="36208" y="6077"/>
                  <a:pt x="37584" y="7857"/>
                  <a:pt x="38144" y="10177"/>
                </a:cubicBezTo>
                <a:cubicBezTo>
                  <a:pt x="38551" y="11861"/>
                  <a:pt x="38493" y="13690"/>
                  <a:pt x="37980" y="15319"/>
                </a:cubicBezTo>
                <a:cubicBezTo>
                  <a:pt x="34695" y="16062"/>
                  <a:pt x="23745" y="16588"/>
                  <a:pt x="17419" y="16429"/>
                </a:cubicBezTo>
                <a:cubicBezTo>
                  <a:pt x="11093" y="16270"/>
                  <a:pt x="3086" y="14433"/>
                  <a:pt x="25" y="14366"/>
                </a:cubicBezTo>
                <a:cubicBezTo>
                  <a:pt x="37" y="14320"/>
                  <a:pt x="50" y="14275"/>
                  <a:pt x="62" y="14229"/>
                </a:cubicBezTo>
                <a:close/>
              </a:path>
              <a:path w="38412" h="16457" fill="none" extrusionOk="0">
                <a:moveTo>
                  <a:pt x="34486" y="5285"/>
                </a:moveTo>
                <a:cubicBezTo>
                  <a:pt x="34541" y="5702"/>
                  <a:pt x="34567" y="6125"/>
                  <a:pt x="34562" y="6549"/>
                </a:cubicBezTo>
                <a:moveTo>
                  <a:pt x="25240" y="3811"/>
                </a:moveTo>
                <a:cubicBezTo>
                  <a:pt x="25429" y="3228"/>
                  <a:pt x="25678" y="2685"/>
                  <a:pt x="25982" y="2199"/>
                </a:cubicBezTo>
                <a:moveTo>
                  <a:pt x="18303" y="4579"/>
                </a:moveTo>
                <a:cubicBezTo>
                  <a:pt x="18380" y="4097"/>
                  <a:pt x="18501" y="3630"/>
                  <a:pt x="18662" y="3189"/>
                </a:cubicBezTo>
                <a:moveTo>
                  <a:pt x="10162" y="5051"/>
                </a:moveTo>
                <a:cubicBezTo>
                  <a:pt x="10634" y="5427"/>
                  <a:pt x="11070" y="5880"/>
                  <a:pt x="11462" y="6399"/>
                </a:cubicBezTo>
                <a:moveTo>
                  <a:pt x="289" y="15648"/>
                </a:moveTo>
                <a:cubicBezTo>
                  <a:pt x="186" y="15184"/>
                  <a:pt x="110" y="14710"/>
                  <a:pt x="62" y="14229"/>
                </a:cubicBezTo>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319" name="Cloud 318"/>
          <p:cNvSpPr/>
          <p:nvPr/>
        </p:nvSpPr>
        <p:spPr>
          <a:xfrm>
            <a:off x="5019798" y="5398671"/>
            <a:ext cx="510685" cy="190795"/>
          </a:xfrm>
          <a:custGeom>
            <a:avLst/>
            <a:gdLst>
              <a:gd name="connsiteX0" fmla="*/ 3900 w 43200"/>
              <a:gd name="connsiteY0" fmla="*/ 14370 h 43200"/>
              <a:gd name="connsiteX1" fmla="*/ 5623 w 43200"/>
              <a:gd name="connsiteY1" fmla="*/ 6907 h 43200"/>
              <a:gd name="connsiteX2" fmla="*/ 14005 w 43200"/>
              <a:gd name="connsiteY2" fmla="*/ 5202 h 43200"/>
              <a:gd name="connsiteX3" fmla="*/ 22456 w 43200"/>
              <a:gd name="connsiteY3" fmla="*/ 3432 h 43200"/>
              <a:gd name="connsiteX4" fmla="*/ 25749 w 43200"/>
              <a:gd name="connsiteY4" fmla="*/ 200 h 43200"/>
              <a:gd name="connsiteX5" fmla="*/ 29833 w 43200"/>
              <a:gd name="connsiteY5" fmla="*/ 2481 h 43200"/>
              <a:gd name="connsiteX6" fmla="*/ 35463 w 43200"/>
              <a:gd name="connsiteY6" fmla="*/ 690 h 43200"/>
              <a:gd name="connsiteX7" fmla="*/ 38318 w 43200"/>
              <a:gd name="connsiteY7" fmla="*/ 5576 h 43200"/>
              <a:gd name="connsiteX8" fmla="*/ 41982 w 43200"/>
              <a:gd name="connsiteY8" fmla="*/ 10318 h 43200"/>
              <a:gd name="connsiteX9" fmla="*/ 41818 w 43200"/>
              <a:gd name="connsiteY9" fmla="*/ 15460 h 43200"/>
              <a:gd name="connsiteX10" fmla="*/ 43016 w 43200"/>
              <a:gd name="connsiteY10" fmla="*/ 23322 h 43200"/>
              <a:gd name="connsiteX11" fmla="*/ 37404 w 43200"/>
              <a:gd name="connsiteY11" fmla="*/ 30204 h 43200"/>
              <a:gd name="connsiteX12" fmla="*/ 35395 w 43200"/>
              <a:gd name="connsiteY12" fmla="*/ 36101 h 43200"/>
              <a:gd name="connsiteX13" fmla="*/ 28555 w 43200"/>
              <a:gd name="connsiteY13" fmla="*/ 36815 h 43200"/>
              <a:gd name="connsiteX14" fmla="*/ 23667 w 43200"/>
              <a:gd name="connsiteY14" fmla="*/ 43106 h 43200"/>
              <a:gd name="connsiteX15" fmla="*/ 16480 w 43200"/>
              <a:gd name="connsiteY15" fmla="*/ 39266 h 43200"/>
              <a:gd name="connsiteX16" fmla="*/ 5804 w 43200"/>
              <a:gd name="connsiteY16" fmla="*/ 35472 h 43200"/>
              <a:gd name="connsiteX17" fmla="*/ 1110 w 43200"/>
              <a:gd name="connsiteY17" fmla="*/ 31250 h 43200"/>
              <a:gd name="connsiteX18" fmla="*/ 2113 w 43200"/>
              <a:gd name="connsiteY18" fmla="*/ 25551 h 43200"/>
              <a:gd name="connsiteX19" fmla="*/ -5 w 43200"/>
              <a:gd name="connsiteY19" fmla="*/ 19704 h 43200"/>
              <a:gd name="connsiteX20" fmla="*/ 3863 w 43200"/>
              <a:gd name="connsiteY20" fmla="*/ 14507 h 43200"/>
              <a:gd name="connsiteX21" fmla="*/ 3900 w 43200"/>
              <a:gd name="connsiteY21" fmla="*/ 14370 h 43200"/>
              <a:gd name="connsiteX0" fmla="*/ 4693 w 43200"/>
              <a:gd name="connsiteY0" fmla="*/ 26177 h 43200"/>
              <a:gd name="connsiteX1" fmla="*/ 2160 w 43200"/>
              <a:gd name="connsiteY1" fmla="*/ 25380 h 43200"/>
              <a:gd name="connsiteX2" fmla="*/ 6928 w 43200"/>
              <a:gd name="connsiteY2" fmla="*/ 34899 h 43200"/>
              <a:gd name="connsiteX3" fmla="*/ 5820 w 43200"/>
              <a:gd name="connsiteY3" fmla="*/ 35280 h 43200"/>
              <a:gd name="connsiteX4" fmla="*/ 16478 w 43200"/>
              <a:gd name="connsiteY4" fmla="*/ 39090 h 43200"/>
              <a:gd name="connsiteX5" fmla="*/ 15810 w 43200"/>
              <a:gd name="connsiteY5" fmla="*/ 37350 h 43200"/>
              <a:gd name="connsiteX6" fmla="*/ 28827 w 43200"/>
              <a:gd name="connsiteY6" fmla="*/ 34751 h 43200"/>
              <a:gd name="connsiteX7" fmla="*/ 28560 w 43200"/>
              <a:gd name="connsiteY7" fmla="*/ 36660 h 43200"/>
              <a:gd name="connsiteX8" fmla="*/ 34129 w 43200"/>
              <a:gd name="connsiteY8" fmla="*/ 22954 h 43200"/>
              <a:gd name="connsiteX9" fmla="*/ 37380 w 43200"/>
              <a:gd name="connsiteY9" fmla="*/ 30090 h 43200"/>
              <a:gd name="connsiteX10" fmla="*/ 41798 w 43200"/>
              <a:gd name="connsiteY10" fmla="*/ 15354 h 43200"/>
              <a:gd name="connsiteX11" fmla="*/ 40350 w 43200"/>
              <a:gd name="connsiteY11" fmla="*/ 18030 h 43200"/>
              <a:gd name="connsiteX12" fmla="*/ 38324 w 43200"/>
              <a:gd name="connsiteY12" fmla="*/ 5426 h 43200"/>
              <a:gd name="connsiteX13" fmla="*/ 38400 w 43200"/>
              <a:gd name="connsiteY13" fmla="*/ 6690 h 43200"/>
              <a:gd name="connsiteX14" fmla="*/ 29078 w 43200"/>
              <a:gd name="connsiteY14" fmla="*/ 3952 h 43200"/>
              <a:gd name="connsiteX15" fmla="*/ 29820 w 43200"/>
              <a:gd name="connsiteY15" fmla="*/ 2340 h 43200"/>
              <a:gd name="connsiteX16" fmla="*/ 22141 w 43200"/>
              <a:gd name="connsiteY16" fmla="*/ 4720 h 43200"/>
              <a:gd name="connsiteX17" fmla="*/ 22500 w 43200"/>
              <a:gd name="connsiteY17" fmla="*/ 3330 h 43200"/>
              <a:gd name="connsiteX18" fmla="*/ 14000 w 43200"/>
              <a:gd name="connsiteY18" fmla="*/ 5192 h 43200"/>
              <a:gd name="connsiteX19" fmla="*/ 15300 w 43200"/>
              <a:gd name="connsiteY19" fmla="*/ 6540 h 43200"/>
              <a:gd name="connsiteX20" fmla="*/ 4127 w 43200"/>
              <a:gd name="connsiteY20" fmla="*/ 15789 h 43200"/>
              <a:gd name="connsiteX21" fmla="*/ 3900 w 43200"/>
              <a:gd name="connsiteY21" fmla="*/ 14370 h 43200"/>
              <a:gd name="connsiteX0" fmla="*/ 3936 w 43256"/>
              <a:gd name="connsiteY0" fmla="*/ 14229 h 43219"/>
              <a:gd name="connsiteX1" fmla="*/ 5659 w 43256"/>
              <a:gd name="connsiteY1" fmla="*/ 6766 h 43219"/>
              <a:gd name="connsiteX2" fmla="*/ 14041 w 43256"/>
              <a:gd name="connsiteY2" fmla="*/ 5061 h 43219"/>
              <a:gd name="connsiteX3" fmla="*/ 22492 w 43256"/>
              <a:gd name="connsiteY3" fmla="*/ 3291 h 43219"/>
              <a:gd name="connsiteX4" fmla="*/ 25785 w 43256"/>
              <a:gd name="connsiteY4" fmla="*/ 59 h 43219"/>
              <a:gd name="connsiteX5" fmla="*/ 29869 w 43256"/>
              <a:gd name="connsiteY5" fmla="*/ 2340 h 43219"/>
              <a:gd name="connsiteX6" fmla="*/ 35499 w 43256"/>
              <a:gd name="connsiteY6" fmla="*/ 549 h 43219"/>
              <a:gd name="connsiteX7" fmla="*/ 38354 w 43256"/>
              <a:gd name="connsiteY7" fmla="*/ 5435 h 43219"/>
              <a:gd name="connsiteX8" fmla="*/ 42018 w 43256"/>
              <a:gd name="connsiteY8" fmla="*/ 10177 h 43219"/>
              <a:gd name="connsiteX9" fmla="*/ 41854 w 43256"/>
              <a:gd name="connsiteY9" fmla="*/ 15319 h 43219"/>
              <a:gd name="connsiteX10" fmla="*/ 43052 w 43256"/>
              <a:gd name="connsiteY10" fmla="*/ 23181 h 43219"/>
              <a:gd name="connsiteX11" fmla="*/ 37440 w 43256"/>
              <a:gd name="connsiteY11" fmla="*/ 30063 h 43219"/>
              <a:gd name="connsiteX12" fmla="*/ 35431 w 43256"/>
              <a:gd name="connsiteY12" fmla="*/ 35960 h 43219"/>
              <a:gd name="connsiteX13" fmla="*/ 28591 w 43256"/>
              <a:gd name="connsiteY13" fmla="*/ 36674 h 43219"/>
              <a:gd name="connsiteX14" fmla="*/ 23703 w 43256"/>
              <a:gd name="connsiteY14" fmla="*/ 42965 h 43219"/>
              <a:gd name="connsiteX15" fmla="*/ 16516 w 43256"/>
              <a:gd name="connsiteY15" fmla="*/ 39125 h 43219"/>
              <a:gd name="connsiteX16" fmla="*/ 5840 w 43256"/>
              <a:gd name="connsiteY16" fmla="*/ 35331 h 43219"/>
              <a:gd name="connsiteX17" fmla="*/ 1146 w 43256"/>
              <a:gd name="connsiteY17" fmla="*/ 31109 h 43219"/>
              <a:gd name="connsiteX18" fmla="*/ 2149 w 43256"/>
              <a:gd name="connsiteY18" fmla="*/ 25410 h 43219"/>
              <a:gd name="connsiteX19" fmla="*/ 31 w 43256"/>
              <a:gd name="connsiteY19" fmla="*/ 19563 h 43219"/>
              <a:gd name="connsiteX20" fmla="*/ 3899 w 43256"/>
              <a:gd name="connsiteY20" fmla="*/ 14366 h 43219"/>
              <a:gd name="connsiteX21" fmla="*/ 3936 w 43256"/>
              <a:gd name="connsiteY21" fmla="*/ 14229 h 43219"/>
              <a:gd name="connsiteX0" fmla="*/ 4729 w 43256"/>
              <a:gd name="connsiteY0" fmla="*/ 26036 h 43219"/>
              <a:gd name="connsiteX1" fmla="*/ 2196 w 43256"/>
              <a:gd name="connsiteY1" fmla="*/ 25239 h 43219"/>
              <a:gd name="connsiteX2" fmla="*/ 6964 w 43256"/>
              <a:gd name="connsiteY2" fmla="*/ 34758 h 43219"/>
              <a:gd name="connsiteX3" fmla="*/ 5856 w 43256"/>
              <a:gd name="connsiteY3" fmla="*/ 35139 h 43219"/>
              <a:gd name="connsiteX4" fmla="*/ 16514 w 43256"/>
              <a:gd name="connsiteY4" fmla="*/ 38949 h 43219"/>
              <a:gd name="connsiteX5" fmla="*/ 15846 w 43256"/>
              <a:gd name="connsiteY5" fmla="*/ 37209 h 43219"/>
              <a:gd name="connsiteX6" fmla="*/ 28863 w 43256"/>
              <a:gd name="connsiteY6" fmla="*/ 34610 h 43219"/>
              <a:gd name="connsiteX7" fmla="*/ 28596 w 43256"/>
              <a:gd name="connsiteY7" fmla="*/ 36519 h 43219"/>
              <a:gd name="connsiteX8" fmla="*/ 34165 w 43256"/>
              <a:gd name="connsiteY8" fmla="*/ 22813 h 43219"/>
              <a:gd name="connsiteX9" fmla="*/ 37416 w 43256"/>
              <a:gd name="connsiteY9" fmla="*/ 29949 h 43219"/>
              <a:gd name="connsiteX10" fmla="*/ 41834 w 43256"/>
              <a:gd name="connsiteY10" fmla="*/ 15213 h 43219"/>
              <a:gd name="connsiteX11" fmla="*/ 40386 w 43256"/>
              <a:gd name="connsiteY11" fmla="*/ 17889 h 43219"/>
              <a:gd name="connsiteX12" fmla="*/ 38360 w 43256"/>
              <a:gd name="connsiteY12" fmla="*/ 5285 h 43219"/>
              <a:gd name="connsiteX13" fmla="*/ 38436 w 43256"/>
              <a:gd name="connsiteY13" fmla="*/ 6549 h 43219"/>
              <a:gd name="connsiteX14" fmla="*/ 29114 w 43256"/>
              <a:gd name="connsiteY14" fmla="*/ 3811 h 43219"/>
              <a:gd name="connsiteX15" fmla="*/ 29856 w 43256"/>
              <a:gd name="connsiteY15" fmla="*/ 2199 h 43219"/>
              <a:gd name="connsiteX16" fmla="*/ 14036 w 43256"/>
              <a:gd name="connsiteY16" fmla="*/ 5051 h 43219"/>
              <a:gd name="connsiteX17" fmla="*/ 15336 w 43256"/>
              <a:gd name="connsiteY17" fmla="*/ 6399 h 43219"/>
              <a:gd name="connsiteX18" fmla="*/ 4163 w 43256"/>
              <a:gd name="connsiteY18" fmla="*/ 15648 h 43219"/>
              <a:gd name="connsiteX19" fmla="*/ 3936 w 43256"/>
              <a:gd name="connsiteY19" fmla="*/ 14229 h 43219"/>
              <a:gd name="connsiteX0" fmla="*/ 3936 w 43256"/>
              <a:gd name="connsiteY0" fmla="*/ 14277 h 43267"/>
              <a:gd name="connsiteX1" fmla="*/ 5659 w 43256"/>
              <a:gd name="connsiteY1" fmla="*/ 6814 h 43267"/>
              <a:gd name="connsiteX2" fmla="*/ 14041 w 43256"/>
              <a:gd name="connsiteY2" fmla="*/ 5109 h 43267"/>
              <a:gd name="connsiteX3" fmla="*/ 25785 w 43256"/>
              <a:gd name="connsiteY3" fmla="*/ 107 h 43267"/>
              <a:gd name="connsiteX4" fmla="*/ 29869 w 43256"/>
              <a:gd name="connsiteY4" fmla="*/ 2388 h 43267"/>
              <a:gd name="connsiteX5" fmla="*/ 35499 w 43256"/>
              <a:gd name="connsiteY5" fmla="*/ 597 h 43267"/>
              <a:gd name="connsiteX6" fmla="*/ 38354 w 43256"/>
              <a:gd name="connsiteY6" fmla="*/ 5483 h 43267"/>
              <a:gd name="connsiteX7" fmla="*/ 42018 w 43256"/>
              <a:gd name="connsiteY7" fmla="*/ 10225 h 43267"/>
              <a:gd name="connsiteX8" fmla="*/ 41854 w 43256"/>
              <a:gd name="connsiteY8" fmla="*/ 15367 h 43267"/>
              <a:gd name="connsiteX9" fmla="*/ 43052 w 43256"/>
              <a:gd name="connsiteY9" fmla="*/ 23229 h 43267"/>
              <a:gd name="connsiteX10" fmla="*/ 37440 w 43256"/>
              <a:gd name="connsiteY10" fmla="*/ 30111 h 43267"/>
              <a:gd name="connsiteX11" fmla="*/ 35431 w 43256"/>
              <a:gd name="connsiteY11" fmla="*/ 36008 h 43267"/>
              <a:gd name="connsiteX12" fmla="*/ 28591 w 43256"/>
              <a:gd name="connsiteY12" fmla="*/ 36722 h 43267"/>
              <a:gd name="connsiteX13" fmla="*/ 23703 w 43256"/>
              <a:gd name="connsiteY13" fmla="*/ 43013 h 43267"/>
              <a:gd name="connsiteX14" fmla="*/ 16516 w 43256"/>
              <a:gd name="connsiteY14" fmla="*/ 39173 h 43267"/>
              <a:gd name="connsiteX15" fmla="*/ 5840 w 43256"/>
              <a:gd name="connsiteY15" fmla="*/ 35379 h 43267"/>
              <a:gd name="connsiteX16" fmla="*/ 1146 w 43256"/>
              <a:gd name="connsiteY16" fmla="*/ 31157 h 43267"/>
              <a:gd name="connsiteX17" fmla="*/ 2149 w 43256"/>
              <a:gd name="connsiteY17" fmla="*/ 25458 h 43267"/>
              <a:gd name="connsiteX18" fmla="*/ 31 w 43256"/>
              <a:gd name="connsiteY18" fmla="*/ 19611 h 43267"/>
              <a:gd name="connsiteX19" fmla="*/ 3899 w 43256"/>
              <a:gd name="connsiteY19" fmla="*/ 14414 h 43267"/>
              <a:gd name="connsiteX20" fmla="*/ 3936 w 43256"/>
              <a:gd name="connsiteY20" fmla="*/ 14277 h 43267"/>
              <a:gd name="connsiteX0" fmla="*/ 4729 w 43256"/>
              <a:gd name="connsiteY0" fmla="*/ 26084 h 43267"/>
              <a:gd name="connsiteX1" fmla="*/ 2196 w 43256"/>
              <a:gd name="connsiteY1" fmla="*/ 25287 h 43267"/>
              <a:gd name="connsiteX2" fmla="*/ 6964 w 43256"/>
              <a:gd name="connsiteY2" fmla="*/ 34806 h 43267"/>
              <a:gd name="connsiteX3" fmla="*/ 5856 w 43256"/>
              <a:gd name="connsiteY3" fmla="*/ 35187 h 43267"/>
              <a:gd name="connsiteX4" fmla="*/ 16514 w 43256"/>
              <a:gd name="connsiteY4" fmla="*/ 38997 h 43267"/>
              <a:gd name="connsiteX5" fmla="*/ 15846 w 43256"/>
              <a:gd name="connsiteY5" fmla="*/ 37257 h 43267"/>
              <a:gd name="connsiteX6" fmla="*/ 28863 w 43256"/>
              <a:gd name="connsiteY6" fmla="*/ 34658 h 43267"/>
              <a:gd name="connsiteX7" fmla="*/ 28596 w 43256"/>
              <a:gd name="connsiteY7" fmla="*/ 36567 h 43267"/>
              <a:gd name="connsiteX8" fmla="*/ 34165 w 43256"/>
              <a:gd name="connsiteY8" fmla="*/ 22861 h 43267"/>
              <a:gd name="connsiteX9" fmla="*/ 37416 w 43256"/>
              <a:gd name="connsiteY9" fmla="*/ 29997 h 43267"/>
              <a:gd name="connsiteX10" fmla="*/ 41834 w 43256"/>
              <a:gd name="connsiteY10" fmla="*/ 15261 h 43267"/>
              <a:gd name="connsiteX11" fmla="*/ 40386 w 43256"/>
              <a:gd name="connsiteY11" fmla="*/ 17937 h 43267"/>
              <a:gd name="connsiteX12" fmla="*/ 38360 w 43256"/>
              <a:gd name="connsiteY12" fmla="*/ 5333 h 43267"/>
              <a:gd name="connsiteX13" fmla="*/ 38436 w 43256"/>
              <a:gd name="connsiteY13" fmla="*/ 6597 h 43267"/>
              <a:gd name="connsiteX14" fmla="*/ 29114 w 43256"/>
              <a:gd name="connsiteY14" fmla="*/ 3859 h 43267"/>
              <a:gd name="connsiteX15" fmla="*/ 29856 w 43256"/>
              <a:gd name="connsiteY15" fmla="*/ 2247 h 43267"/>
              <a:gd name="connsiteX16" fmla="*/ 14036 w 43256"/>
              <a:gd name="connsiteY16" fmla="*/ 5099 h 43267"/>
              <a:gd name="connsiteX17" fmla="*/ 15336 w 43256"/>
              <a:gd name="connsiteY17" fmla="*/ 6447 h 43267"/>
              <a:gd name="connsiteX18" fmla="*/ 4163 w 43256"/>
              <a:gd name="connsiteY18" fmla="*/ 15696 h 43267"/>
              <a:gd name="connsiteX19" fmla="*/ 3936 w 43256"/>
              <a:gd name="connsiteY19" fmla="*/ 14277 h 43267"/>
              <a:gd name="connsiteX0" fmla="*/ 3936 w 43256"/>
              <a:gd name="connsiteY0" fmla="*/ 14221 h 43211"/>
              <a:gd name="connsiteX1" fmla="*/ 5659 w 43256"/>
              <a:gd name="connsiteY1" fmla="*/ 6758 h 43211"/>
              <a:gd name="connsiteX2" fmla="*/ 14041 w 43256"/>
              <a:gd name="connsiteY2" fmla="*/ 5053 h 43211"/>
              <a:gd name="connsiteX3" fmla="*/ 29869 w 43256"/>
              <a:gd name="connsiteY3" fmla="*/ 2332 h 43211"/>
              <a:gd name="connsiteX4" fmla="*/ 35499 w 43256"/>
              <a:gd name="connsiteY4" fmla="*/ 541 h 43211"/>
              <a:gd name="connsiteX5" fmla="*/ 38354 w 43256"/>
              <a:gd name="connsiteY5" fmla="*/ 5427 h 43211"/>
              <a:gd name="connsiteX6" fmla="*/ 42018 w 43256"/>
              <a:gd name="connsiteY6" fmla="*/ 10169 h 43211"/>
              <a:gd name="connsiteX7" fmla="*/ 41854 w 43256"/>
              <a:gd name="connsiteY7" fmla="*/ 15311 h 43211"/>
              <a:gd name="connsiteX8" fmla="*/ 43052 w 43256"/>
              <a:gd name="connsiteY8" fmla="*/ 23173 h 43211"/>
              <a:gd name="connsiteX9" fmla="*/ 37440 w 43256"/>
              <a:gd name="connsiteY9" fmla="*/ 30055 h 43211"/>
              <a:gd name="connsiteX10" fmla="*/ 35431 w 43256"/>
              <a:gd name="connsiteY10" fmla="*/ 35952 h 43211"/>
              <a:gd name="connsiteX11" fmla="*/ 28591 w 43256"/>
              <a:gd name="connsiteY11" fmla="*/ 36666 h 43211"/>
              <a:gd name="connsiteX12" fmla="*/ 23703 w 43256"/>
              <a:gd name="connsiteY12" fmla="*/ 42957 h 43211"/>
              <a:gd name="connsiteX13" fmla="*/ 16516 w 43256"/>
              <a:gd name="connsiteY13" fmla="*/ 39117 h 43211"/>
              <a:gd name="connsiteX14" fmla="*/ 5840 w 43256"/>
              <a:gd name="connsiteY14" fmla="*/ 35323 h 43211"/>
              <a:gd name="connsiteX15" fmla="*/ 1146 w 43256"/>
              <a:gd name="connsiteY15" fmla="*/ 31101 h 43211"/>
              <a:gd name="connsiteX16" fmla="*/ 2149 w 43256"/>
              <a:gd name="connsiteY16" fmla="*/ 25402 h 43211"/>
              <a:gd name="connsiteX17" fmla="*/ 31 w 43256"/>
              <a:gd name="connsiteY17" fmla="*/ 19555 h 43211"/>
              <a:gd name="connsiteX18" fmla="*/ 3899 w 43256"/>
              <a:gd name="connsiteY18" fmla="*/ 14358 h 43211"/>
              <a:gd name="connsiteX19" fmla="*/ 3936 w 43256"/>
              <a:gd name="connsiteY19" fmla="*/ 14221 h 43211"/>
              <a:gd name="connsiteX0" fmla="*/ 4729 w 43256"/>
              <a:gd name="connsiteY0" fmla="*/ 26028 h 43211"/>
              <a:gd name="connsiteX1" fmla="*/ 2196 w 43256"/>
              <a:gd name="connsiteY1" fmla="*/ 25231 h 43211"/>
              <a:gd name="connsiteX2" fmla="*/ 6964 w 43256"/>
              <a:gd name="connsiteY2" fmla="*/ 34750 h 43211"/>
              <a:gd name="connsiteX3" fmla="*/ 5856 w 43256"/>
              <a:gd name="connsiteY3" fmla="*/ 35131 h 43211"/>
              <a:gd name="connsiteX4" fmla="*/ 16514 w 43256"/>
              <a:gd name="connsiteY4" fmla="*/ 38941 h 43211"/>
              <a:gd name="connsiteX5" fmla="*/ 15846 w 43256"/>
              <a:gd name="connsiteY5" fmla="*/ 37201 h 43211"/>
              <a:gd name="connsiteX6" fmla="*/ 28863 w 43256"/>
              <a:gd name="connsiteY6" fmla="*/ 34602 h 43211"/>
              <a:gd name="connsiteX7" fmla="*/ 28596 w 43256"/>
              <a:gd name="connsiteY7" fmla="*/ 36511 h 43211"/>
              <a:gd name="connsiteX8" fmla="*/ 34165 w 43256"/>
              <a:gd name="connsiteY8" fmla="*/ 22805 h 43211"/>
              <a:gd name="connsiteX9" fmla="*/ 37416 w 43256"/>
              <a:gd name="connsiteY9" fmla="*/ 29941 h 43211"/>
              <a:gd name="connsiteX10" fmla="*/ 41834 w 43256"/>
              <a:gd name="connsiteY10" fmla="*/ 15205 h 43211"/>
              <a:gd name="connsiteX11" fmla="*/ 40386 w 43256"/>
              <a:gd name="connsiteY11" fmla="*/ 17881 h 43211"/>
              <a:gd name="connsiteX12" fmla="*/ 38360 w 43256"/>
              <a:gd name="connsiteY12" fmla="*/ 5277 h 43211"/>
              <a:gd name="connsiteX13" fmla="*/ 38436 w 43256"/>
              <a:gd name="connsiteY13" fmla="*/ 6541 h 43211"/>
              <a:gd name="connsiteX14" fmla="*/ 29114 w 43256"/>
              <a:gd name="connsiteY14" fmla="*/ 3803 h 43211"/>
              <a:gd name="connsiteX15" fmla="*/ 29856 w 43256"/>
              <a:gd name="connsiteY15" fmla="*/ 2191 h 43211"/>
              <a:gd name="connsiteX16" fmla="*/ 14036 w 43256"/>
              <a:gd name="connsiteY16" fmla="*/ 5043 h 43211"/>
              <a:gd name="connsiteX17" fmla="*/ 15336 w 43256"/>
              <a:gd name="connsiteY17" fmla="*/ 6391 h 43211"/>
              <a:gd name="connsiteX18" fmla="*/ 4163 w 43256"/>
              <a:gd name="connsiteY18" fmla="*/ 15640 h 43211"/>
              <a:gd name="connsiteX19" fmla="*/ 3936 w 43256"/>
              <a:gd name="connsiteY19" fmla="*/ 14221 h 43211"/>
              <a:gd name="connsiteX0" fmla="*/ 3936 w 43256"/>
              <a:gd name="connsiteY0" fmla="*/ 14221 h 43211"/>
              <a:gd name="connsiteX1" fmla="*/ 5659 w 43256"/>
              <a:gd name="connsiteY1" fmla="*/ 6758 h 43211"/>
              <a:gd name="connsiteX2" fmla="*/ 14041 w 43256"/>
              <a:gd name="connsiteY2" fmla="*/ 5053 h 43211"/>
              <a:gd name="connsiteX3" fmla="*/ 29869 w 43256"/>
              <a:gd name="connsiteY3" fmla="*/ 2332 h 43211"/>
              <a:gd name="connsiteX4" fmla="*/ 35499 w 43256"/>
              <a:gd name="connsiteY4" fmla="*/ 541 h 43211"/>
              <a:gd name="connsiteX5" fmla="*/ 38354 w 43256"/>
              <a:gd name="connsiteY5" fmla="*/ 5427 h 43211"/>
              <a:gd name="connsiteX6" fmla="*/ 42018 w 43256"/>
              <a:gd name="connsiteY6" fmla="*/ 10169 h 43211"/>
              <a:gd name="connsiteX7" fmla="*/ 41854 w 43256"/>
              <a:gd name="connsiteY7" fmla="*/ 15311 h 43211"/>
              <a:gd name="connsiteX8" fmla="*/ 43052 w 43256"/>
              <a:gd name="connsiteY8" fmla="*/ 23173 h 43211"/>
              <a:gd name="connsiteX9" fmla="*/ 37440 w 43256"/>
              <a:gd name="connsiteY9" fmla="*/ 30055 h 43211"/>
              <a:gd name="connsiteX10" fmla="*/ 35431 w 43256"/>
              <a:gd name="connsiteY10" fmla="*/ 35952 h 43211"/>
              <a:gd name="connsiteX11" fmla="*/ 28591 w 43256"/>
              <a:gd name="connsiteY11" fmla="*/ 36666 h 43211"/>
              <a:gd name="connsiteX12" fmla="*/ 23703 w 43256"/>
              <a:gd name="connsiteY12" fmla="*/ 42957 h 43211"/>
              <a:gd name="connsiteX13" fmla="*/ 16516 w 43256"/>
              <a:gd name="connsiteY13" fmla="*/ 39117 h 43211"/>
              <a:gd name="connsiteX14" fmla="*/ 5840 w 43256"/>
              <a:gd name="connsiteY14" fmla="*/ 35323 h 43211"/>
              <a:gd name="connsiteX15" fmla="*/ 1146 w 43256"/>
              <a:gd name="connsiteY15" fmla="*/ 31101 h 43211"/>
              <a:gd name="connsiteX16" fmla="*/ 2149 w 43256"/>
              <a:gd name="connsiteY16" fmla="*/ 25402 h 43211"/>
              <a:gd name="connsiteX17" fmla="*/ 31 w 43256"/>
              <a:gd name="connsiteY17" fmla="*/ 19555 h 43211"/>
              <a:gd name="connsiteX18" fmla="*/ 3899 w 43256"/>
              <a:gd name="connsiteY18" fmla="*/ 14358 h 43211"/>
              <a:gd name="connsiteX19" fmla="*/ 3936 w 43256"/>
              <a:gd name="connsiteY19" fmla="*/ 14221 h 43211"/>
              <a:gd name="connsiteX0" fmla="*/ 4729 w 43256"/>
              <a:gd name="connsiteY0" fmla="*/ 26028 h 43211"/>
              <a:gd name="connsiteX1" fmla="*/ 2196 w 43256"/>
              <a:gd name="connsiteY1" fmla="*/ 25231 h 43211"/>
              <a:gd name="connsiteX2" fmla="*/ 6964 w 43256"/>
              <a:gd name="connsiteY2" fmla="*/ 34750 h 43211"/>
              <a:gd name="connsiteX3" fmla="*/ 5856 w 43256"/>
              <a:gd name="connsiteY3" fmla="*/ 35131 h 43211"/>
              <a:gd name="connsiteX4" fmla="*/ 16514 w 43256"/>
              <a:gd name="connsiteY4" fmla="*/ 38941 h 43211"/>
              <a:gd name="connsiteX5" fmla="*/ 15846 w 43256"/>
              <a:gd name="connsiteY5" fmla="*/ 37201 h 43211"/>
              <a:gd name="connsiteX6" fmla="*/ 28863 w 43256"/>
              <a:gd name="connsiteY6" fmla="*/ 34602 h 43211"/>
              <a:gd name="connsiteX7" fmla="*/ 28596 w 43256"/>
              <a:gd name="connsiteY7" fmla="*/ 36511 h 43211"/>
              <a:gd name="connsiteX8" fmla="*/ 34165 w 43256"/>
              <a:gd name="connsiteY8" fmla="*/ 22805 h 43211"/>
              <a:gd name="connsiteX9" fmla="*/ 37416 w 43256"/>
              <a:gd name="connsiteY9" fmla="*/ 29941 h 43211"/>
              <a:gd name="connsiteX10" fmla="*/ 41834 w 43256"/>
              <a:gd name="connsiteY10" fmla="*/ 15205 h 43211"/>
              <a:gd name="connsiteX11" fmla="*/ 40386 w 43256"/>
              <a:gd name="connsiteY11" fmla="*/ 17881 h 43211"/>
              <a:gd name="connsiteX12" fmla="*/ 38360 w 43256"/>
              <a:gd name="connsiteY12" fmla="*/ 5277 h 43211"/>
              <a:gd name="connsiteX13" fmla="*/ 38436 w 43256"/>
              <a:gd name="connsiteY13" fmla="*/ 6541 h 43211"/>
              <a:gd name="connsiteX14" fmla="*/ 14036 w 43256"/>
              <a:gd name="connsiteY14" fmla="*/ 5043 h 43211"/>
              <a:gd name="connsiteX15" fmla="*/ 15336 w 43256"/>
              <a:gd name="connsiteY15" fmla="*/ 6391 h 43211"/>
              <a:gd name="connsiteX16" fmla="*/ 4163 w 43256"/>
              <a:gd name="connsiteY16" fmla="*/ 15640 h 43211"/>
              <a:gd name="connsiteX17" fmla="*/ 3936 w 43256"/>
              <a:gd name="connsiteY17" fmla="*/ 14221 h 43211"/>
              <a:gd name="connsiteX0" fmla="*/ 35499 w 43256"/>
              <a:gd name="connsiteY0" fmla="*/ 0 h 42670"/>
              <a:gd name="connsiteX1" fmla="*/ 38354 w 43256"/>
              <a:gd name="connsiteY1" fmla="*/ 4886 h 42670"/>
              <a:gd name="connsiteX2" fmla="*/ 42018 w 43256"/>
              <a:gd name="connsiteY2" fmla="*/ 9628 h 42670"/>
              <a:gd name="connsiteX3" fmla="*/ 41854 w 43256"/>
              <a:gd name="connsiteY3" fmla="*/ 14770 h 42670"/>
              <a:gd name="connsiteX4" fmla="*/ 43052 w 43256"/>
              <a:gd name="connsiteY4" fmla="*/ 22632 h 42670"/>
              <a:gd name="connsiteX5" fmla="*/ 37440 w 43256"/>
              <a:gd name="connsiteY5" fmla="*/ 29514 h 42670"/>
              <a:gd name="connsiteX6" fmla="*/ 35431 w 43256"/>
              <a:gd name="connsiteY6" fmla="*/ 35411 h 42670"/>
              <a:gd name="connsiteX7" fmla="*/ 28591 w 43256"/>
              <a:gd name="connsiteY7" fmla="*/ 36125 h 42670"/>
              <a:gd name="connsiteX8" fmla="*/ 23703 w 43256"/>
              <a:gd name="connsiteY8" fmla="*/ 42416 h 42670"/>
              <a:gd name="connsiteX9" fmla="*/ 16516 w 43256"/>
              <a:gd name="connsiteY9" fmla="*/ 38576 h 42670"/>
              <a:gd name="connsiteX10" fmla="*/ 5840 w 43256"/>
              <a:gd name="connsiteY10" fmla="*/ 34782 h 42670"/>
              <a:gd name="connsiteX11" fmla="*/ 1146 w 43256"/>
              <a:gd name="connsiteY11" fmla="*/ 30560 h 42670"/>
              <a:gd name="connsiteX12" fmla="*/ 2149 w 43256"/>
              <a:gd name="connsiteY12" fmla="*/ 24861 h 42670"/>
              <a:gd name="connsiteX13" fmla="*/ 31 w 43256"/>
              <a:gd name="connsiteY13" fmla="*/ 19014 h 42670"/>
              <a:gd name="connsiteX14" fmla="*/ 3899 w 43256"/>
              <a:gd name="connsiteY14" fmla="*/ 13817 h 42670"/>
              <a:gd name="connsiteX15" fmla="*/ 3936 w 43256"/>
              <a:gd name="connsiteY15" fmla="*/ 13680 h 42670"/>
              <a:gd name="connsiteX16" fmla="*/ 5659 w 43256"/>
              <a:gd name="connsiteY16" fmla="*/ 6217 h 42670"/>
              <a:gd name="connsiteX17" fmla="*/ 14041 w 43256"/>
              <a:gd name="connsiteY17" fmla="*/ 4512 h 42670"/>
              <a:gd name="connsiteX18" fmla="*/ 37159 w 43256"/>
              <a:gd name="connsiteY18" fmla="*/ 10408 h 42670"/>
              <a:gd name="connsiteX0" fmla="*/ 4729 w 43256"/>
              <a:gd name="connsiteY0" fmla="*/ 25487 h 42670"/>
              <a:gd name="connsiteX1" fmla="*/ 2196 w 43256"/>
              <a:gd name="connsiteY1" fmla="*/ 24690 h 42670"/>
              <a:gd name="connsiteX2" fmla="*/ 6964 w 43256"/>
              <a:gd name="connsiteY2" fmla="*/ 34209 h 42670"/>
              <a:gd name="connsiteX3" fmla="*/ 5856 w 43256"/>
              <a:gd name="connsiteY3" fmla="*/ 34590 h 42670"/>
              <a:gd name="connsiteX4" fmla="*/ 16514 w 43256"/>
              <a:gd name="connsiteY4" fmla="*/ 38400 h 42670"/>
              <a:gd name="connsiteX5" fmla="*/ 15846 w 43256"/>
              <a:gd name="connsiteY5" fmla="*/ 36660 h 42670"/>
              <a:gd name="connsiteX6" fmla="*/ 28863 w 43256"/>
              <a:gd name="connsiteY6" fmla="*/ 34061 h 42670"/>
              <a:gd name="connsiteX7" fmla="*/ 28596 w 43256"/>
              <a:gd name="connsiteY7" fmla="*/ 35970 h 42670"/>
              <a:gd name="connsiteX8" fmla="*/ 34165 w 43256"/>
              <a:gd name="connsiteY8" fmla="*/ 22264 h 42670"/>
              <a:gd name="connsiteX9" fmla="*/ 37416 w 43256"/>
              <a:gd name="connsiteY9" fmla="*/ 29400 h 42670"/>
              <a:gd name="connsiteX10" fmla="*/ 41834 w 43256"/>
              <a:gd name="connsiteY10" fmla="*/ 14664 h 42670"/>
              <a:gd name="connsiteX11" fmla="*/ 40386 w 43256"/>
              <a:gd name="connsiteY11" fmla="*/ 17340 h 42670"/>
              <a:gd name="connsiteX12" fmla="*/ 38360 w 43256"/>
              <a:gd name="connsiteY12" fmla="*/ 4736 h 42670"/>
              <a:gd name="connsiteX13" fmla="*/ 38436 w 43256"/>
              <a:gd name="connsiteY13" fmla="*/ 6000 h 42670"/>
              <a:gd name="connsiteX14" fmla="*/ 14036 w 43256"/>
              <a:gd name="connsiteY14" fmla="*/ 4502 h 42670"/>
              <a:gd name="connsiteX15" fmla="*/ 15336 w 43256"/>
              <a:gd name="connsiteY15" fmla="*/ 5850 h 42670"/>
              <a:gd name="connsiteX16" fmla="*/ 4163 w 43256"/>
              <a:gd name="connsiteY16" fmla="*/ 15099 h 42670"/>
              <a:gd name="connsiteX17" fmla="*/ 3936 w 43256"/>
              <a:gd name="connsiteY17" fmla="*/ 13680 h 42670"/>
              <a:gd name="connsiteX0" fmla="*/ 38354 w 43256"/>
              <a:gd name="connsiteY0" fmla="*/ 1635 h 39419"/>
              <a:gd name="connsiteX1" fmla="*/ 42018 w 43256"/>
              <a:gd name="connsiteY1" fmla="*/ 6377 h 39419"/>
              <a:gd name="connsiteX2" fmla="*/ 41854 w 43256"/>
              <a:gd name="connsiteY2" fmla="*/ 11519 h 39419"/>
              <a:gd name="connsiteX3" fmla="*/ 43052 w 43256"/>
              <a:gd name="connsiteY3" fmla="*/ 19381 h 39419"/>
              <a:gd name="connsiteX4" fmla="*/ 37440 w 43256"/>
              <a:gd name="connsiteY4" fmla="*/ 26263 h 39419"/>
              <a:gd name="connsiteX5" fmla="*/ 35431 w 43256"/>
              <a:gd name="connsiteY5" fmla="*/ 32160 h 39419"/>
              <a:gd name="connsiteX6" fmla="*/ 28591 w 43256"/>
              <a:gd name="connsiteY6" fmla="*/ 32874 h 39419"/>
              <a:gd name="connsiteX7" fmla="*/ 23703 w 43256"/>
              <a:gd name="connsiteY7" fmla="*/ 39165 h 39419"/>
              <a:gd name="connsiteX8" fmla="*/ 16516 w 43256"/>
              <a:gd name="connsiteY8" fmla="*/ 35325 h 39419"/>
              <a:gd name="connsiteX9" fmla="*/ 5840 w 43256"/>
              <a:gd name="connsiteY9" fmla="*/ 31531 h 39419"/>
              <a:gd name="connsiteX10" fmla="*/ 1146 w 43256"/>
              <a:gd name="connsiteY10" fmla="*/ 27309 h 39419"/>
              <a:gd name="connsiteX11" fmla="*/ 2149 w 43256"/>
              <a:gd name="connsiteY11" fmla="*/ 21610 h 39419"/>
              <a:gd name="connsiteX12" fmla="*/ 31 w 43256"/>
              <a:gd name="connsiteY12" fmla="*/ 15763 h 39419"/>
              <a:gd name="connsiteX13" fmla="*/ 3899 w 43256"/>
              <a:gd name="connsiteY13" fmla="*/ 10566 h 39419"/>
              <a:gd name="connsiteX14" fmla="*/ 3936 w 43256"/>
              <a:gd name="connsiteY14" fmla="*/ 10429 h 39419"/>
              <a:gd name="connsiteX15" fmla="*/ 5659 w 43256"/>
              <a:gd name="connsiteY15" fmla="*/ 2966 h 39419"/>
              <a:gd name="connsiteX16" fmla="*/ 14041 w 43256"/>
              <a:gd name="connsiteY16" fmla="*/ 1261 h 39419"/>
              <a:gd name="connsiteX17" fmla="*/ 37159 w 43256"/>
              <a:gd name="connsiteY17" fmla="*/ 7157 h 39419"/>
              <a:gd name="connsiteX0" fmla="*/ 4729 w 43256"/>
              <a:gd name="connsiteY0" fmla="*/ 22236 h 39419"/>
              <a:gd name="connsiteX1" fmla="*/ 2196 w 43256"/>
              <a:gd name="connsiteY1" fmla="*/ 21439 h 39419"/>
              <a:gd name="connsiteX2" fmla="*/ 6964 w 43256"/>
              <a:gd name="connsiteY2" fmla="*/ 30958 h 39419"/>
              <a:gd name="connsiteX3" fmla="*/ 5856 w 43256"/>
              <a:gd name="connsiteY3" fmla="*/ 31339 h 39419"/>
              <a:gd name="connsiteX4" fmla="*/ 16514 w 43256"/>
              <a:gd name="connsiteY4" fmla="*/ 35149 h 39419"/>
              <a:gd name="connsiteX5" fmla="*/ 15846 w 43256"/>
              <a:gd name="connsiteY5" fmla="*/ 33409 h 39419"/>
              <a:gd name="connsiteX6" fmla="*/ 28863 w 43256"/>
              <a:gd name="connsiteY6" fmla="*/ 30810 h 39419"/>
              <a:gd name="connsiteX7" fmla="*/ 28596 w 43256"/>
              <a:gd name="connsiteY7" fmla="*/ 32719 h 39419"/>
              <a:gd name="connsiteX8" fmla="*/ 34165 w 43256"/>
              <a:gd name="connsiteY8" fmla="*/ 19013 h 39419"/>
              <a:gd name="connsiteX9" fmla="*/ 37416 w 43256"/>
              <a:gd name="connsiteY9" fmla="*/ 26149 h 39419"/>
              <a:gd name="connsiteX10" fmla="*/ 41834 w 43256"/>
              <a:gd name="connsiteY10" fmla="*/ 11413 h 39419"/>
              <a:gd name="connsiteX11" fmla="*/ 40386 w 43256"/>
              <a:gd name="connsiteY11" fmla="*/ 14089 h 39419"/>
              <a:gd name="connsiteX12" fmla="*/ 38360 w 43256"/>
              <a:gd name="connsiteY12" fmla="*/ 1485 h 39419"/>
              <a:gd name="connsiteX13" fmla="*/ 38436 w 43256"/>
              <a:gd name="connsiteY13" fmla="*/ 2749 h 39419"/>
              <a:gd name="connsiteX14" fmla="*/ 14036 w 43256"/>
              <a:gd name="connsiteY14" fmla="*/ 1251 h 39419"/>
              <a:gd name="connsiteX15" fmla="*/ 15336 w 43256"/>
              <a:gd name="connsiteY15" fmla="*/ 2599 h 39419"/>
              <a:gd name="connsiteX16" fmla="*/ 4163 w 43256"/>
              <a:gd name="connsiteY16" fmla="*/ 11848 h 39419"/>
              <a:gd name="connsiteX17" fmla="*/ 3936 w 43256"/>
              <a:gd name="connsiteY17" fmla="*/ 10429 h 39419"/>
              <a:gd name="connsiteX0" fmla="*/ 38354 w 43256"/>
              <a:gd name="connsiteY0" fmla="*/ 1635 h 39419"/>
              <a:gd name="connsiteX1" fmla="*/ 42018 w 43256"/>
              <a:gd name="connsiteY1" fmla="*/ 6377 h 39419"/>
              <a:gd name="connsiteX2" fmla="*/ 41854 w 43256"/>
              <a:gd name="connsiteY2" fmla="*/ 11519 h 39419"/>
              <a:gd name="connsiteX3" fmla="*/ 43052 w 43256"/>
              <a:gd name="connsiteY3" fmla="*/ 19381 h 39419"/>
              <a:gd name="connsiteX4" fmla="*/ 37440 w 43256"/>
              <a:gd name="connsiteY4" fmla="*/ 26263 h 39419"/>
              <a:gd name="connsiteX5" fmla="*/ 35431 w 43256"/>
              <a:gd name="connsiteY5" fmla="*/ 32160 h 39419"/>
              <a:gd name="connsiteX6" fmla="*/ 28591 w 43256"/>
              <a:gd name="connsiteY6" fmla="*/ 32874 h 39419"/>
              <a:gd name="connsiteX7" fmla="*/ 23703 w 43256"/>
              <a:gd name="connsiteY7" fmla="*/ 39165 h 39419"/>
              <a:gd name="connsiteX8" fmla="*/ 16516 w 43256"/>
              <a:gd name="connsiteY8" fmla="*/ 35325 h 39419"/>
              <a:gd name="connsiteX9" fmla="*/ 5840 w 43256"/>
              <a:gd name="connsiteY9" fmla="*/ 31531 h 39419"/>
              <a:gd name="connsiteX10" fmla="*/ 1146 w 43256"/>
              <a:gd name="connsiteY10" fmla="*/ 27309 h 39419"/>
              <a:gd name="connsiteX11" fmla="*/ 2149 w 43256"/>
              <a:gd name="connsiteY11" fmla="*/ 21610 h 39419"/>
              <a:gd name="connsiteX12" fmla="*/ 31 w 43256"/>
              <a:gd name="connsiteY12" fmla="*/ 15763 h 39419"/>
              <a:gd name="connsiteX13" fmla="*/ 3899 w 43256"/>
              <a:gd name="connsiteY13" fmla="*/ 10566 h 39419"/>
              <a:gd name="connsiteX14" fmla="*/ 3936 w 43256"/>
              <a:gd name="connsiteY14" fmla="*/ 10429 h 39419"/>
              <a:gd name="connsiteX15" fmla="*/ 5659 w 43256"/>
              <a:gd name="connsiteY15" fmla="*/ 2966 h 39419"/>
              <a:gd name="connsiteX16" fmla="*/ 14041 w 43256"/>
              <a:gd name="connsiteY16" fmla="*/ 1261 h 39419"/>
              <a:gd name="connsiteX17" fmla="*/ 37159 w 43256"/>
              <a:gd name="connsiteY17" fmla="*/ 7157 h 39419"/>
              <a:gd name="connsiteX0" fmla="*/ 4729 w 43256"/>
              <a:gd name="connsiteY0" fmla="*/ 22236 h 39419"/>
              <a:gd name="connsiteX1" fmla="*/ 2196 w 43256"/>
              <a:gd name="connsiteY1" fmla="*/ 21439 h 39419"/>
              <a:gd name="connsiteX2" fmla="*/ 6964 w 43256"/>
              <a:gd name="connsiteY2" fmla="*/ 30958 h 39419"/>
              <a:gd name="connsiteX3" fmla="*/ 5856 w 43256"/>
              <a:gd name="connsiteY3" fmla="*/ 31339 h 39419"/>
              <a:gd name="connsiteX4" fmla="*/ 16514 w 43256"/>
              <a:gd name="connsiteY4" fmla="*/ 35149 h 39419"/>
              <a:gd name="connsiteX5" fmla="*/ 15846 w 43256"/>
              <a:gd name="connsiteY5" fmla="*/ 33409 h 39419"/>
              <a:gd name="connsiteX6" fmla="*/ 28863 w 43256"/>
              <a:gd name="connsiteY6" fmla="*/ 30810 h 39419"/>
              <a:gd name="connsiteX7" fmla="*/ 28596 w 43256"/>
              <a:gd name="connsiteY7" fmla="*/ 32719 h 39419"/>
              <a:gd name="connsiteX8" fmla="*/ 34165 w 43256"/>
              <a:gd name="connsiteY8" fmla="*/ 19013 h 39419"/>
              <a:gd name="connsiteX9" fmla="*/ 37416 w 43256"/>
              <a:gd name="connsiteY9" fmla="*/ 26149 h 39419"/>
              <a:gd name="connsiteX10" fmla="*/ 38360 w 43256"/>
              <a:gd name="connsiteY10" fmla="*/ 1485 h 39419"/>
              <a:gd name="connsiteX11" fmla="*/ 38436 w 43256"/>
              <a:gd name="connsiteY11" fmla="*/ 2749 h 39419"/>
              <a:gd name="connsiteX12" fmla="*/ 14036 w 43256"/>
              <a:gd name="connsiteY12" fmla="*/ 1251 h 39419"/>
              <a:gd name="connsiteX13" fmla="*/ 15336 w 43256"/>
              <a:gd name="connsiteY13" fmla="*/ 2599 h 39419"/>
              <a:gd name="connsiteX14" fmla="*/ 4163 w 43256"/>
              <a:gd name="connsiteY14" fmla="*/ 11848 h 39419"/>
              <a:gd name="connsiteX15" fmla="*/ 3936 w 43256"/>
              <a:gd name="connsiteY15" fmla="*/ 10429 h 39419"/>
              <a:gd name="connsiteX0" fmla="*/ 38354 w 43322"/>
              <a:gd name="connsiteY0" fmla="*/ 1635 h 39419"/>
              <a:gd name="connsiteX1" fmla="*/ 42018 w 43322"/>
              <a:gd name="connsiteY1" fmla="*/ 6377 h 39419"/>
              <a:gd name="connsiteX2" fmla="*/ 43052 w 43322"/>
              <a:gd name="connsiteY2" fmla="*/ 19381 h 39419"/>
              <a:gd name="connsiteX3" fmla="*/ 37440 w 43322"/>
              <a:gd name="connsiteY3" fmla="*/ 26263 h 39419"/>
              <a:gd name="connsiteX4" fmla="*/ 35431 w 43322"/>
              <a:gd name="connsiteY4" fmla="*/ 32160 h 39419"/>
              <a:gd name="connsiteX5" fmla="*/ 28591 w 43322"/>
              <a:gd name="connsiteY5" fmla="*/ 32874 h 39419"/>
              <a:gd name="connsiteX6" fmla="*/ 23703 w 43322"/>
              <a:gd name="connsiteY6" fmla="*/ 39165 h 39419"/>
              <a:gd name="connsiteX7" fmla="*/ 16516 w 43322"/>
              <a:gd name="connsiteY7" fmla="*/ 35325 h 39419"/>
              <a:gd name="connsiteX8" fmla="*/ 5840 w 43322"/>
              <a:gd name="connsiteY8" fmla="*/ 31531 h 39419"/>
              <a:gd name="connsiteX9" fmla="*/ 1146 w 43322"/>
              <a:gd name="connsiteY9" fmla="*/ 27309 h 39419"/>
              <a:gd name="connsiteX10" fmla="*/ 2149 w 43322"/>
              <a:gd name="connsiteY10" fmla="*/ 21610 h 39419"/>
              <a:gd name="connsiteX11" fmla="*/ 31 w 43322"/>
              <a:gd name="connsiteY11" fmla="*/ 15763 h 39419"/>
              <a:gd name="connsiteX12" fmla="*/ 3899 w 43322"/>
              <a:gd name="connsiteY12" fmla="*/ 10566 h 39419"/>
              <a:gd name="connsiteX13" fmla="*/ 3936 w 43322"/>
              <a:gd name="connsiteY13" fmla="*/ 10429 h 39419"/>
              <a:gd name="connsiteX14" fmla="*/ 5659 w 43322"/>
              <a:gd name="connsiteY14" fmla="*/ 2966 h 39419"/>
              <a:gd name="connsiteX15" fmla="*/ 14041 w 43322"/>
              <a:gd name="connsiteY15" fmla="*/ 1261 h 39419"/>
              <a:gd name="connsiteX16" fmla="*/ 37159 w 43322"/>
              <a:gd name="connsiteY16" fmla="*/ 7157 h 39419"/>
              <a:gd name="connsiteX0" fmla="*/ 4729 w 43322"/>
              <a:gd name="connsiteY0" fmla="*/ 22236 h 39419"/>
              <a:gd name="connsiteX1" fmla="*/ 2196 w 43322"/>
              <a:gd name="connsiteY1" fmla="*/ 21439 h 39419"/>
              <a:gd name="connsiteX2" fmla="*/ 6964 w 43322"/>
              <a:gd name="connsiteY2" fmla="*/ 30958 h 39419"/>
              <a:gd name="connsiteX3" fmla="*/ 5856 w 43322"/>
              <a:gd name="connsiteY3" fmla="*/ 31339 h 39419"/>
              <a:gd name="connsiteX4" fmla="*/ 16514 w 43322"/>
              <a:gd name="connsiteY4" fmla="*/ 35149 h 39419"/>
              <a:gd name="connsiteX5" fmla="*/ 15846 w 43322"/>
              <a:gd name="connsiteY5" fmla="*/ 33409 h 39419"/>
              <a:gd name="connsiteX6" fmla="*/ 28863 w 43322"/>
              <a:gd name="connsiteY6" fmla="*/ 30810 h 39419"/>
              <a:gd name="connsiteX7" fmla="*/ 28596 w 43322"/>
              <a:gd name="connsiteY7" fmla="*/ 32719 h 39419"/>
              <a:gd name="connsiteX8" fmla="*/ 34165 w 43322"/>
              <a:gd name="connsiteY8" fmla="*/ 19013 h 39419"/>
              <a:gd name="connsiteX9" fmla="*/ 37416 w 43322"/>
              <a:gd name="connsiteY9" fmla="*/ 26149 h 39419"/>
              <a:gd name="connsiteX10" fmla="*/ 38360 w 43322"/>
              <a:gd name="connsiteY10" fmla="*/ 1485 h 39419"/>
              <a:gd name="connsiteX11" fmla="*/ 38436 w 43322"/>
              <a:gd name="connsiteY11" fmla="*/ 2749 h 39419"/>
              <a:gd name="connsiteX12" fmla="*/ 14036 w 43322"/>
              <a:gd name="connsiteY12" fmla="*/ 1251 h 39419"/>
              <a:gd name="connsiteX13" fmla="*/ 15336 w 43322"/>
              <a:gd name="connsiteY13" fmla="*/ 2599 h 39419"/>
              <a:gd name="connsiteX14" fmla="*/ 4163 w 43322"/>
              <a:gd name="connsiteY14" fmla="*/ 11848 h 39419"/>
              <a:gd name="connsiteX15" fmla="*/ 3936 w 43322"/>
              <a:gd name="connsiteY15" fmla="*/ 10429 h 39419"/>
              <a:gd name="connsiteX0" fmla="*/ 38354 w 42025"/>
              <a:gd name="connsiteY0" fmla="*/ 1635 h 39419"/>
              <a:gd name="connsiteX1" fmla="*/ 42018 w 42025"/>
              <a:gd name="connsiteY1" fmla="*/ 6377 h 39419"/>
              <a:gd name="connsiteX2" fmla="*/ 37440 w 42025"/>
              <a:gd name="connsiteY2" fmla="*/ 26263 h 39419"/>
              <a:gd name="connsiteX3" fmla="*/ 35431 w 42025"/>
              <a:gd name="connsiteY3" fmla="*/ 32160 h 39419"/>
              <a:gd name="connsiteX4" fmla="*/ 28591 w 42025"/>
              <a:gd name="connsiteY4" fmla="*/ 32874 h 39419"/>
              <a:gd name="connsiteX5" fmla="*/ 23703 w 42025"/>
              <a:gd name="connsiteY5" fmla="*/ 39165 h 39419"/>
              <a:gd name="connsiteX6" fmla="*/ 16516 w 42025"/>
              <a:gd name="connsiteY6" fmla="*/ 35325 h 39419"/>
              <a:gd name="connsiteX7" fmla="*/ 5840 w 42025"/>
              <a:gd name="connsiteY7" fmla="*/ 31531 h 39419"/>
              <a:gd name="connsiteX8" fmla="*/ 1146 w 42025"/>
              <a:gd name="connsiteY8" fmla="*/ 27309 h 39419"/>
              <a:gd name="connsiteX9" fmla="*/ 2149 w 42025"/>
              <a:gd name="connsiteY9" fmla="*/ 21610 h 39419"/>
              <a:gd name="connsiteX10" fmla="*/ 31 w 42025"/>
              <a:gd name="connsiteY10" fmla="*/ 15763 h 39419"/>
              <a:gd name="connsiteX11" fmla="*/ 3899 w 42025"/>
              <a:gd name="connsiteY11" fmla="*/ 10566 h 39419"/>
              <a:gd name="connsiteX12" fmla="*/ 3936 w 42025"/>
              <a:gd name="connsiteY12" fmla="*/ 10429 h 39419"/>
              <a:gd name="connsiteX13" fmla="*/ 5659 w 42025"/>
              <a:gd name="connsiteY13" fmla="*/ 2966 h 39419"/>
              <a:gd name="connsiteX14" fmla="*/ 14041 w 42025"/>
              <a:gd name="connsiteY14" fmla="*/ 1261 h 39419"/>
              <a:gd name="connsiteX15" fmla="*/ 37159 w 42025"/>
              <a:gd name="connsiteY15" fmla="*/ 7157 h 39419"/>
              <a:gd name="connsiteX0" fmla="*/ 4729 w 42025"/>
              <a:gd name="connsiteY0" fmla="*/ 22236 h 39419"/>
              <a:gd name="connsiteX1" fmla="*/ 2196 w 42025"/>
              <a:gd name="connsiteY1" fmla="*/ 21439 h 39419"/>
              <a:gd name="connsiteX2" fmla="*/ 6964 w 42025"/>
              <a:gd name="connsiteY2" fmla="*/ 30958 h 39419"/>
              <a:gd name="connsiteX3" fmla="*/ 5856 w 42025"/>
              <a:gd name="connsiteY3" fmla="*/ 31339 h 39419"/>
              <a:gd name="connsiteX4" fmla="*/ 16514 w 42025"/>
              <a:gd name="connsiteY4" fmla="*/ 35149 h 39419"/>
              <a:gd name="connsiteX5" fmla="*/ 15846 w 42025"/>
              <a:gd name="connsiteY5" fmla="*/ 33409 h 39419"/>
              <a:gd name="connsiteX6" fmla="*/ 28863 w 42025"/>
              <a:gd name="connsiteY6" fmla="*/ 30810 h 39419"/>
              <a:gd name="connsiteX7" fmla="*/ 28596 w 42025"/>
              <a:gd name="connsiteY7" fmla="*/ 32719 h 39419"/>
              <a:gd name="connsiteX8" fmla="*/ 34165 w 42025"/>
              <a:gd name="connsiteY8" fmla="*/ 19013 h 39419"/>
              <a:gd name="connsiteX9" fmla="*/ 37416 w 42025"/>
              <a:gd name="connsiteY9" fmla="*/ 26149 h 39419"/>
              <a:gd name="connsiteX10" fmla="*/ 38360 w 42025"/>
              <a:gd name="connsiteY10" fmla="*/ 1485 h 39419"/>
              <a:gd name="connsiteX11" fmla="*/ 38436 w 42025"/>
              <a:gd name="connsiteY11" fmla="*/ 2749 h 39419"/>
              <a:gd name="connsiteX12" fmla="*/ 14036 w 42025"/>
              <a:gd name="connsiteY12" fmla="*/ 1251 h 39419"/>
              <a:gd name="connsiteX13" fmla="*/ 15336 w 42025"/>
              <a:gd name="connsiteY13" fmla="*/ 2599 h 39419"/>
              <a:gd name="connsiteX14" fmla="*/ 4163 w 42025"/>
              <a:gd name="connsiteY14" fmla="*/ 11848 h 39419"/>
              <a:gd name="connsiteX15" fmla="*/ 3936 w 42025"/>
              <a:gd name="connsiteY15" fmla="*/ 10429 h 39419"/>
              <a:gd name="connsiteX0" fmla="*/ 38354 w 42025"/>
              <a:gd name="connsiteY0" fmla="*/ 1635 h 39419"/>
              <a:gd name="connsiteX1" fmla="*/ 42018 w 42025"/>
              <a:gd name="connsiteY1" fmla="*/ 6377 h 39419"/>
              <a:gd name="connsiteX2" fmla="*/ 37440 w 42025"/>
              <a:gd name="connsiteY2" fmla="*/ 26263 h 39419"/>
              <a:gd name="connsiteX3" fmla="*/ 35431 w 42025"/>
              <a:gd name="connsiteY3" fmla="*/ 32160 h 39419"/>
              <a:gd name="connsiteX4" fmla="*/ 28591 w 42025"/>
              <a:gd name="connsiteY4" fmla="*/ 32874 h 39419"/>
              <a:gd name="connsiteX5" fmla="*/ 23703 w 42025"/>
              <a:gd name="connsiteY5" fmla="*/ 39165 h 39419"/>
              <a:gd name="connsiteX6" fmla="*/ 16516 w 42025"/>
              <a:gd name="connsiteY6" fmla="*/ 35325 h 39419"/>
              <a:gd name="connsiteX7" fmla="*/ 5840 w 42025"/>
              <a:gd name="connsiteY7" fmla="*/ 31531 h 39419"/>
              <a:gd name="connsiteX8" fmla="*/ 1146 w 42025"/>
              <a:gd name="connsiteY8" fmla="*/ 27309 h 39419"/>
              <a:gd name="connsiteX9" fmla="*/ 2149 w 42025"/>
              <a:gd name="connsiteY9" fmla="*/ 21610 h 39419"/>
              <a:gd name="connsiteX10" fmla="*/ 31 w 42025"/>
              <a:gd name="connsiteY10" fmla="*/ 15763 h 39419"/>
              <a:gd name="connsiteX11" fmla="*/ 3899 w 42025"/>
              <a:gd name="connsiteY11" fmla="*/ 10566 h 39419"/>
              <a:gd name="connsiteX12" fmla="*/ 3936 w 42025"/>
              <a:gd name="connsiteY12" fmla="*/ 10429 h 39419"/>
              <a:gd name="connsiteX13" fmla="*/ 5659 w 42025"/>
              <a:gd name="connsiteY13" fmla="*/ 2966 h 39419"/>
              <a:gd name="connsiteX14" fmla="*/ 14041 w 42025"/>
              <a:gd name="connsiteY14" fmla="*/ 1261 h 39419"/>
              <a:gd name="connsiteX15" fmla="*/ 37159 w 42025"/>
              <a:gd name="connsiteY15" fmla="*/ 7157 h 39419"/>
              <a:gd name="connsiteX0" fmla="*/ 4729 w 42025"/>
              <a:gd name="connsiteY0" fmla="*/ 22236 h 39419"/>
              <a:gd name="connsiteX1" fmla="*/ 2196 w 42025"/>
              <a:gd name="connsiteY1" fmla="*/ 21439 h 39419"/>
              <a:gd name="connsiteX2" fmla="*/ 6964 w 42025"/>
              <a:gd name="connsiteY2" fmla="*/ 30958 h 39419"/>
              <a:gd name="connsiteX3" fmla="*/ 5856 w 42025"/>
              <a:gd name="connsiteY3" fmla="*/ 31339 h 39419"/>
              <a:gd name="connsiteX4" fmla="*/ 16514 w 42025"/>
              <a:gd name="connsiteY4" fmla="*/ 35149 h 39419"/>
              <a:gd name="connsiteX5" fmla="*/ 15846 w 42025"/>
              <a:gd name="connsiteY5" fmla="*/ 33409 h 39419"/>
              <a:gd name="connsiteX6" fmla="*/ 28863 w 42025"/>
              <a:gd name="connsiteY6" fmla="*/ 30810 h 39419"/>
              <a:gd name="connsiteX7" fmla="*/ 28596 w 42025"/>
              <a:gd name="connsiteY7" fmla="*/ 32719 h 39419"/>
              <a:gd name="connsiteX8" fmla="*/ 38360 w 42025"/>
              <a:gd name="connsiteY8" fmla="*/ 1485 h 39419"/>
              <a:gd name="connsiteX9" fmla="*/ 38436 w 42025"/>
              <a:gd name="connsiteY9" fmla="*/ 2749 h 39419"/>
              <a:gd name="connsiteX10" fmla="*/ 14036 w 42025"/>
              <a:gd name="connsiteY10" fmla="*/ 1251 h 39419"/>
              <a:gd name="connsiteX11" fmla="*/ 15336 w 42025"/>
              <a:gd name="connsiteY11" fmla="*/ 2599 h 39419"/>
              <a:gd name="connsiteX12" fmla="*/ 4163 w 42025"/>
              <a:gd name="connsiteY12" fmla="*/ 11848 h 39419"/>
              <a:gd name="connsiteX13" fmla="*/ 3936 w 42025"/>
              <a:gd name="connsiteY13" fmla="*/ 10429 h 39419"/>
              <a:gd name="connsiteX0" fmla="*/ 38354 w 38436"/>
              <a:gd name="connsiteY0" fmla="*/ 1635 h 39419"/>
              <a:gd name="connsiteX1" fmla="*/ 37440 w 38436"/>
              <a:gd name="connsiteY1" fmla="*/ 26263 h 39419"/>
              <a:gd name="connsiteX2" fmla="*/ 35431 w 38436"/>
              <a:gd name="connsiteY2" fmla="*/ 32160 h 39419"/>
              <a:gd name="connsiteX3" fmla="*/ 28591 w 38436"/>
              <a:gd name="connsiteY3" fmla="*/ 32874 h 39419"/>
              <a:gd name="connsiteX4" fmla="*/ 23703 w 38436"/>
              <a:gd name="connsiteY4" fmla="*/ 39165 h 39419"/>
              <a:gd name="connsiteX5" fmla="*/ 16516 w 38436"/>
              <a:gd name="connsiteY5" fmla="*/ 35325 h 39419"/>
              <a:gd name="connsiteX6" fmla="*/ 5840 w 38436"/>
              <a:gd name="connsiteY6" fmla="*/ 31531 h 39419"/>
              <a:gd name="connsiteX7" fmla="*/ 1146 w 38436"/>
              <a:gd name="connsiteY7" fmla="*/ 27309 h 39419"/>
              <a:gd name="connsiteX8" fmla="*/ 2149 w 38436"/>
              <a:gd name="connsiteY8" fmla="*/ 21610 h 39419"/>
              <a:gd name="connsiteX9" fmla="*/ 31 w 38436"/>
              <a:gd name="connsiteY9" fmla="*/ 15763 h 39419"/>
              <a:gd name="connsiteX10" fmla="*/ 3899 w 38436"/>
              <a:gd name="connsiteY10" fmla="*/ 10566 h 39419"/>
              <a:gd name="connsiteX11" fmla="*/ 3936 w 38436"/>
              <a:gd name="connsiteY11" fmla="*/ 10429 h 39419"/>
              <a:gd name="connsiteX12" fmla="*/ 5659 w 38436"/>
              <a:gd name="connsiteY12" fmla="*/ 2966 h 39419"/>
              <a:gd name="connsiteX13" fmla="*/ 14041 w 38436"/>
              <a:gd name="connsiteY13" fmla="*/ 1261 h 39419"/>
              <a:gd name="connsiteX14" fmla="*/ 37159 w 38436"/>
              <a:gd name="connsiteY14" fmla="*/ 7157 h 39419"/>
              <a:gd name="connsiteX0" fmla="*/ 4729 w 38436"/>
              <a:gd name="connsiteY0" fmla="*/ 22236 h 39419"/>
              <a:gd name="connsiteX1" fmla="*/ 2196 w 38436"/>
              <a:gd name="connsiteY1" fmla="*/ 21439 h 39419"/>
              <a:gd name="connsiteX2" fmla="*/ 6964 w 38436"/>
              <a:gd name="connsiteY2" fmla="*/ 30958 h 39419"/>
              <a:gd name="connsiteX3" fmla="*/ 5856 w 38436"/>
              <a:gd name="connsiteY3" fmla="*/ 31339 h 39419"/>
              <a:gd name="connsiteX4" fmla="*/ 16514 w 38436"/>
              <a:gd name="connsiteY4" fmla="*/ 35149 h 39419"/>
              <a:gd name="connsiteX5" fmla="*/ 15846 w 38436"/>
              <a:gd name="connsiteY5" fmla="*/ 33409 h 39419"/>
              <a:gd name="connsiteX6" fmla="*/ 28863 w 38436"/>
              <a:gd name="connsiteY6" fmla="*/ 30810 h 39419"/>
              <a:gd name="connsiteX7" fmla="*/ 28596 w 38436"/>
              <a:gd name="connsiteY7" fmla="*/ 32719 h 39419"/>
              <a:gd name="connsiteX8" fmla="*/ 38360 w 38436"/>
              <a:gd name="connsiteY8" fmla="*/ 1485 h 39419"/>
              <a:gd name="connsiteX9" fmla="*/ 38436 w 38436"/>
              <a:gd name="connsiteY9" fmla="*/ 2749 h 39419"/>
              <a:gd name="connsiteX10" fmla="*/ 14036 w 38436"/>
              <a:gd name="connsiteY10" fmla="*/ 1251 h 39419"/>
              <a:gd name="connsiteX11" fmla="*/ 15336 w 38436"/>
              <a:gd name="connsiteY11" fmla="*/ 2599 h 39419"/>
              <a:gd name="connsiteX12" fmla="*/ 4163 w 38436"/>
              <a:gd name="connsiteY12" fmla="*/ 11848 h 39419"/>
              <a:gd name="connsiteX13" fmla="*/ 3936 w 38436"/>
              <a:gd name="connsiteY13" fmla="*/ 10429 h 39419"/>
              <a:gd name="connsiteX0" fmla="*/ 38354 w 38436"/>
              <a:gd name="connsiteY0" fmla="*/ 1635 h 39419"/>
              <a:gd name="connsiteX1" fmla="*/ 37440 w 38436"/>
              <a:gd name="connsiteY1" fmla="*/ 26263 h 39419"/>
              <a:gd name="connsiteX2" fmla="*/ 35431 w 38436"/>
              <a:gd name="connsiteY2" fmla="*/ 32160 h 39419"/>
              <a:gd name="connsiteX3" fmla="*/ 28591 w 38436"/>
              <a:gd name="connsiteY3" fmla="*/ 32874 h 39419"/>
              <a:gd name="connsiteX4" fmla="*/ 23703 w 38436"/>
              <a:gd name="connsiteY4" fmla="*/ 39165 h 39419"/>
              <a:gd name="connsiteX5" fmla="*/ 16516 w 38436"/>
              <a:gd name="connsiteY5" fmla="*/ 35325 h 39419"/>
              <a:gd name="connsiteX6" fmla="*/ 5840 w 38436"/>
              <a:gd name="connsiteY6" fmla="*/ 31531 h 39419"/>
              <a:gd name="connsiteX7" fmla="*/ 1146 w 38436"/>
              <a:gd name="connsiteY7" fmla="*/ 27309 h 39419"/>
              <a:gd name="connsiteX8" fmla="*/ 2149 w 38436"/>
              <a:gd name="connsiteY8" fmla="*/ 21610 h 39419"/>
              <a:gd name="connsiteX9" fmla="*/ 31 w 38436"/>
              <a:gd name="connsiteY9" fmla="*/ 15763 h 39419"/>
              <a:gd name="connsiteX10" fmla="*/ 3899 w 38436"/>
              <a:gd name="connsiteY10" fmla="*/ 10566 h 39419"/>
              <a:gd name="connsiteX11" fmla="*/ 3936 w 38436"/>
              <a:gd name="connsiteY11" fmla="*/ 10429 h 39419"/>
              <a:gd name="connsiteX12" fmla="*/ 5659 w 38436"/>
              <a:gd name="connsiteY12" fmla="*/ 2966 h 39419"/>
              <a:gd name="connsiteX13" fmla="*/ 14041 w 38436"/>
              <a:gd name="connsiteY13" fmla="*/ 1261 h 39419"/>
              <a:gd name="connsiteX0" fmla="*/ 4729 w 38436"/>
              <a:gd name="connsiteY0" fmla="*/ 22236 h 39419"/>
              <a:gd name="connsiteX1" fmla="*/ 2196 w 38436"/>
              <a:gd name="connsiteY1" fmla="*/ 21439 h 39419"/>
              <a:gd name="connsiteX2" fmla="*/ 6964 w 38436"/>
              <a:gd name="connsiteY2" fmla="*/ 30958 h 39419"/>
              <a:gd name="connsiteX3" fmla="*/ 5856 w 38436"/>
              <a:gd name="connsiteY3" fmla="*/ 31339 h 39419"/>
              <a:gd name="connsiteX4" fmla="*/ 16514 w 38436"/>
              <a:gd name="connsiteY4" fmla="*/ 35149 h 39419"/>
              <a:gd name="connsiteX5" fmla="*/ 15846 w 38436"/>
              <a:gd name="connsiteY5" fmla="*/ 33409 h 39419"/>
              <a:gd name="connsiteX6" fmla="*/ 28863 w 38436"/>
              <a:gd name="connsiteY6" fmla="*/ 30810 h 39419"/>
              <a:gd name="connsiteX7" fmla="*/ 28596 w 38436"/>
              <a:gd name="connsiteY7" fmla="*/ 32719 h 39419"/>
              <a:gd name="connsiteX8" fmla="*/ 38360 w 38436"/>
              <a:gd name="connsiteY8" fmla="*/ 1485 h 39419"/>
              <a:gd name="connsiteX9" fmla="*/ 38436 w 38436"/>
              <a:gd name="connsiteY9" fmla="*/ 2749 h 39419"/>
              <a:gd name="connsiteX10" fmla="*/ 14036 w 38436"/>
              <a:gd name="connsiteY10" fmla="*/ 1251 h 39419"/>
              <a:gd name="connsiteX11" fmla="*/ 15336 w 38436"/>
              <a:gd name="connsiteY11" fmla="*/ 2599 h 39419"/>
              <a:gd name="connsiteX12" fmla="*/ 4163 w 38436"/>
              <a:gd name="connsiteY12" fmla="*/ 11848 h 39419"/>
              <a:gd name="connsiteX13" fmla="*/ 3936 w 38436"/>
              <a:gd name="connsiteY13" fmla="*/ 10429 h 39419"/>
              <a:gd name="connsiteX0" fmla="*/ 38354 w 38354"/>
              <a:gd name="connsiteY0" fmla="*/ 1635 h 39419"/>
              <a:gd name="connsiteX1" fmla="*/ 37440 w 38354"/>
              <a:gd name="connsiteY1" fmla="*/ 26263 h 39419"/>
              <a:gd name="connsiteX2" fmla="*/ 35431 w 38354"/>
              <a:gd name="connsiteY2" fmla="*/ 32160 h 39419"/>
              <a:gd name="connsiteX3" fmla="*/ 28591 w 38354"/>
              <a:gd name="connsiteY3" fmla="*/ 32874 h 39419"/>
              <a:gd name="connsiteX4" fmla="*/ 23703 w 38354"/>
              <a:gd name="connsiteY4" fmla="*/ 39165 h 39419"/>
              <a:gd name="connsiteX5" fmla="*/ 16516 w 38354"/>
              <a:gd name="connsiteY5" fmla="*/ 35325 h 39419"/>
              <a:gd name="connsiteX6" fmla="*/ 5840 w 38354"/>
              <a:gd name="connsiteY6" fmla="*/ 31531 h 39419"/>
              <a:gd name="connsiteX7" fmla="*/ 1146 w 38354"/>
              <a:gd name="connsiteY7" fmla="*/ 27309 h 39419"/>
              <a:gd name="connsiteX8" fmla="*/ 2149 w 38354"/>
              <a:gd name="connsiteY8" fmla="*/ 21610 h 39419"/>
              <a:gd name="connsiteX9" fmla="*/ 31 w 38354"/>
              <a:gd name="connsiteY9" fmla="*/ 15763 h 39419"/>
              <a:gd name="connsiteX10" fmla="*/ 3899 w 38354"/>
              <a:gd name="connsiteY10" fmla="*/ 10566 h 39419"/>
              <a:gd name="connsiteX11" fmla="*/ 3936 w 38354"/>
              <a:gd name="connsiteY11" fmla="*/ 10429 h 39419"/>
              <a:gd name="connsiteX12" fmla="*/ 5659 w 38354"/>
              <a:gd name="connsiteY12" fmla="*/ 2966 h 39419"/>
              <a:gd name="connsiteX13" fmla="*/ 14041 w 38354"/>
              <a:gd name="connsiteY13" fmla="*/ 1261 h 39419"/>
              <a:gd name="connsiteX0" fmla="*/ 4729 w 38354"/>
              <a:gd name="connsiteY0" fmla="*/ 22236 h 39419"/>
              <a:gd name="connsiteX1" fmla="*/ 2196 w 38354"/>
              <a:gd name="connsiteY1" fmla="*/ 21439 h 39419"/>
              <a:gd name="connsiteX2" fmla="*/ 6964 w 38354"/>
              <a:gd name="connsiteY2" fmla="*/ 30958 h 39419"/>
              <a:gd name="connsiteX3" fmla="*/ 5856 w 38354"/>
              <a:gd name="connsiteY3" fmla="*/ 31339 h 39419"/>
              <a:gd name="connsiteX4" fmla="*/ 16514 w 38354"/>
              <a:gd name="connsiteY4" fmla="*/ 35149 h 39419"/>
              <a:gd name="connsiteX5" fmla="*/ 15846 w 38354"/>
              <a:gd name="connsiteY5" fmla="*/ 33409 h 39419"/>
              <a:gd name="connsiteX6" fmla="*/ 28863 w 38354"/>
              <a:gd name="connsiteY6" fmla="*/ 30810 h 39419"/>
              <a:gd name="connsiteX7" fmla="*/ 28596 w 38354"/>
              <a:gd name="connsiteY7" fmla="*/ 32719 h 39419"/>
              <a:gd name="connsiteX8" fmla="*/ 14036 w 38354"/>
              <a:gd name="connsiteY8" fmla="*/ 1251 h 39419"/>
              <a:gd name="connsiteX9" fmla="*/ 15336 w 38354"/>
              <a:gd name="connsiteY9" fmla="*/ 2599 h 39419"/>
              <a:gd name="connsiteX10" fmla="*/ 4163 w 38354"/>
              <a:gd name="connsiteY10" fmla="*/ 11848 h 39419"/>
              <a:gd name="connsiteX11" fmla="*/ 3936 w 38354"/>
              <a:gd name="connsiteY11" fmla="*/ 10429 h 39419"/>
              <a:gd name="connsiteX0" fmla="*/ 37440 w 37440"/>
              <a:gd name="connsiteY0" fmla="*/ 26263 h 39419"/>
              <a:gd name="connsiteX1" fmla="*/ 35431 w 37440"/>
              <a:gd name="connsiteY1" fmla="*/ 32160 h 39419"/>
              <a:gd name="connsiteX2" fmla="*/ 28591 w 37440"/>
              <a:gd name="connsiteY2" fmla="*/ 32874 h 39419"/>
              <a:gd name="connsiteX3" fmla="*/ 23703 w 37440"/>
              <a:gd name="connsiteY3" fmla="*/ 39165 h 39419"/>
              <a:gd name="connsiteX4" fmla="*/ 16516 w 37440"/>
              <a:gd name="connsiteY4" fmla="*/ 35325 h 39419"/>
              <a:gd name="connsiteX5" fmla="*/ 5840 w 37440"/>
              <a:gd name="connsiteY5" fmla="*/ 31531 h 39419"/>
              <a:gd name="connsiteX6" fmla="*/ 1146 w 37440"/>
              <a:gd name="connsiteY6" fmla="*/ 27309 h 39419"/>
              <a:gd name="connsiteX7" fmla="*/ 2149 w 37440"/>
              <a:gd name="connsiteY7" fmla="*/ 21610 h 39419"/>
              <a:gd name="connsiteX8" fmla="*/ 31 w 37440"/>
              <a:gd name="connsiteY8" fmla="*/ 15763 h 39419"/>
              <a:gd name="connsiteX9" fmla="*/ 3899 w 37440"/>
              <a:gd name="connsiteY9" fmla="*/ 10566 h 39419"/>
              <a:gd name="connsiteX10" fmla="*/ 3936 w 37440"/>
              <a:gd name="connsiteY10" fmla="*/ 10429 h 39419"/>
              <a:gd name="connsiteX11" fmla="*/ 5659 w 37440"/>
              <a:gd name="connsiteY11" fmla="*/ 2966 h 39419"/>
              <a:gd name="connsiteX12" fmla="*/ 14041 w 37440"/>
              <a:gd name="connsiteY12" fmla="*/ 1261 h 39419"/>
              <a:gd name="connsiteX0" fmla="*/ 4729 w 37440"/>
              <a:gd name="connsiteY0" fmla="*/ 22236 h 39419"/>
              <a:gd name="connsiteX1" fmla="*/ 2196 w 37440"/>
              <a:gd name="connsiteY1" fmla="*/ 21439 h 39419"/>
              <a:gd name="connsiteX2" fmla="*/ 6964 w 37440"/>
              <a:gd name="connsiteY2" fmla="*/ 30958 h 39419"/>
              <a:gd name="connsiteX3" fmla="*/ 5856 w 37440"/>
              <a:gd name="connsiteY3" fmla="*/ 31339 h 39419"/>
              <a:gd name="connsiteX4" fmla="*/ 16514 w 37440"/>
              <a:gd name="connsiteY4" fmla="*/ 35149 h 39419"/>
              <a:gd name="connsiteX5" fmla="*/ 15846 w 37440"/>
              <a:gd name="connsiteY5" fmla="*/ 33409 h 39419"/>
              <a:gd name="connsiteX6" fmla="*/ 28863 w 37440"/>
              <a:gd name="connsiteY6" fmla="*/ 30810 h 39419"/>
              <a:gd name="connsiteX7" fmla="*/ 28596 w 37440"/>
              <a:gd name="connsiteY7" fmla="*/ 32719 h 39419"/>
              <a:gd name="connsiteX8" fmla="*/ 14036 w 37440"/>
              <a:gd name="connsiteY8" fmla="*/ 1251 h 39419"/>
              <a:gd name="connsiteX9" fmla="*/ 15336 w 37440"/>
              <a:gd name="connsiteY9" fmla="*/ 2599 h 39419"/>
              <a:gd name="connsiteX10" fmla="*/ 4163 w 37440"/>
              <a:gd name="connsiteY10" fmla="*/ 11848 h 39419"/>
              <a:gd name="connsiteX11" fmla="*/ 3936 w 37440"/>
              <a:gd name="connsiteY11" fmla="*/ 10429 h 39419"/>
              <a:gd name="connsiteX0" fmla="*/ 37440 w 37440"/>
              <a:gd name="connsiteY0" fmla="*/ 26263 h 39419"/>
              <a:gd name="connsiteX1" fmla="*/ 35431 w 37440"/>
              <a:gd name="connsiteY1" fmla="*/ 32160 h 39419"/>
              <a:gd name="connsiteX2" fmla="*/ 28591 w 37440"/>
              <a:gd name="connsiteY2" fmla="*/ 32874 h 39419"/>
              <a:gd name="connsiteX3" fmla="*/ 23703 w 37440"/>
              <a:gd name="connsiteY3" fmla="*/ 39165 h 39419"/>
              <a:gd name="connsiteX4" fmla="*/ 16516 w 37440"/>
              <a:gd name="connsiteY4" fmla="*/ 35325 h 39419"/>
              <a:gd name="connsiteX5" fmla="*/ 5840 w 37440"/>
              <a:gd name="connsiteY5" fmla="*/ 31531 h 39419"/>
              <a:gd name="connsiteX6" fmla="*/ 1146 w 37440"/>
              <a:gd name="connsiteY6" fmla="*/ 27309 h 39419"/>
              <a:gd name="connsiteX7" fmla="*/ 2149 w 37440"/>
              <a:gd name="connsiteY7" fmla="*/ 21610 h 39419"/>
              <a:gd name="connsiteX8" fmla="*/ 31 w 37440"/>
              <a:gd name="connsiteY8" fmla="*/ 15763 h 39419"/>
              <a:gd name="connsiteX9" fmla="*/ 3899 w 37440"/>
              <a:gd name="connsiteY9" fmla="*/ 10566 h 39419"/>
              <a:gd name="connsiteX10" fmla="*/ 3936 w 37440"/>
              <a:gd name="connsiteY10" fmla="*/ 10429 h 39419"/>
              <a:gd name="connsiteX11" fmla="*/ 5659 w 37440"/>
              <a:gd name="connsiteY11" fmla="*/ 2966 h 39419"/>
              <a:gd name="connsiteX12" fmla="*/ 14041 w 37440"/>
              <a:gd name="connsiteY12" fmla="*/ 1261 h 39419"/>
              <a:gd name="connsiteX0" fmla="*/ 4729 w 37440"/>
              <a:gd name="connsiteY0" fmla="*/ 22236 h 39419"/>
              <a:gd name="connsiteX1" fmla="*/ 2196 w 37440"/>
              <a:gd name="connsiteY1" fmla="*/ 21439 h 39419"/>
              <a:gd name="connsiteX2" fmla="*/ 6964 w 37440"/>
              <a:gd name="connsiteY2" fmla="*/ 30958 h 39419"/>
              <a:gd name="connsiteX3" fmla="*/ 5856 w 37440"/>
              <a:gd name="connsiteY3" fmla="*/ 31339 h 39419"/>
              <a:gd name="connsiteX4" fmla="*/ 16514 w 37440"/>
              <a:gd name="connsiteY4" fmla="*/ 35149 h 39419"/>
              <a:gd name="connsiteX5" fmla="*/ 15846 w 37440"/>
              <a:gd name="connsiteY5" fmla="*/ 33409 h 39419"/>
              <a:gd name="connsiteX6" fmla="*/ 28863 w 37440"/>
              <a:gd name="connsiteY6" fmla="*/ 30810 h 39419"/>
              <a:gd name="connsiteX7" fmla="*/ 28596 w 37440"/>
              <a:gd name="connsiteY7" fmla="*/ 32719 h 39419"/>
              <a:gd name="connsiteX8" fmla="*/ 4163 w 37440"/>
              <a:gd name="connsiteY8" fmla="*/ 11848 h 39419"/>
              <a:gd name="connsiteX9" fmla="*/ 3936 w 37440"/>
              <a:gd name="connsiteY9" fmla="*/ 10429 h 39419"/>
              <a:gd name="connsiteX0" fmla="*/ 37440 w 37440"/>
              <a:gd name="connsiteY0" fmla="*/ 23297 h 36453"/>
              <a:gd name="connsiteX1" fmla="*/ 35431 w 37440"/>
              <a:gd name="connsiteY1" fmla="*/ 29194 h 36453"/>
              <a:gd name="connsiteX2" fmla="*/ 28591 w 37440"/>
              <a:gd name="connsiteY2" fmla="*/ 29908 h 36453"/>
              <a:gd name="connsiteX3" fmla="*/ 23703 w 37440"/>
              <a:gd name="connsiteY3" fmla="*/ 36199 h 36453"/>
              <a:gd name="connsiteX4" fmla="*/ 16516 w 37440"/>
              <a:gd name="connsiteY4" fmla="*/ 32359 h 36453"/>
              <a:gd name="connsiteX5" fmla="*/ 5840 w 37440"/>
              <a:gd name="connsiteY5" fmla="*/ 28565 h 36453"/>
              <a:gd name="connsiteX6" fmla="*/ 1146 w 37440"/>
              <a:gd name="connsiteY6" fmla="*/ 24343 h 36453"/>
              <a:gd name="connsiteX7" fmla="*/ 2149 w 37440"/>
              <a:gd name="connsiteY7" fmla="*/ 18644 h 36453"/>
              <a:gd name="connsiteX8" fmla="*/ 31 w 37440"/>
              <a:gd name="connsiteY8" fmla="*/ 12797 h 36453"/>
              <a:gd name="connsiteX9" fmla="*/ 3899 w 37440"/>
              <a:gd name="connsiteY9" fmla="*/ 7600 h 36453"/>
              <a:gd name="connsiteX10" fmla="*/ 3936 w 37440"/>
              <a:gd name="connsiteY10" fmla="*/ 7463 h 36453"/>
              <a:gd name="connsiteX11" fmla="*/ 5659 w 37440"/>
              <a:gd name="connsiteY11" fmla="*/ 0 h 36453"/>
              <a:gd name="connsiteX0" fmla="*/ 4729 w 37440"/>
              <a:gd name="connsiteY0" fmla="*/ 19270 h 36453"/>
              <a:gd name="connsiteX1" fmla="*/ 2196 w 37440"/>
              <a:gd name="connsiteY1" fmla="*/ 18473 h 36453"/>
              <a:gd name="connsiteX2" fmla="*/ 6964 w 37440"/>
              <a:gd name="connsiteY2" fmla="*/ 27992 h 36453"/>
              <a:gd name="connsiteX3" fmla="*/ 5856 w 37440"/>
              <a:gd name="connsiteY3" fmla="*/ 28373 h 36453"/>
              <a:gd name="connsiteX4" fmla="*/ 16514 w 37440"/>
              <a:gd name="connsiteY4" fmla="*/ 32183 h 36453"/>
              <a:gd name="connsiteX5" fmla="*/ 15846 w 37440"/>
              <a:gd name="connsiteY5" fmla="*/ 30443 h 36453"/>
              <a:gd name="connsiteX6" fmla="*/ 28863 w 37440"/>
              <a:gd name="connsiteY6" fmla="*/ 27844 h 36453"/>
              <a:gd name="connsiteX7" fmla="*/ 28596 w 37440"/>
              <a:gd name="connsiteY7" fmla="*/ 29753 h 36453"/>
              <a:gd name="connsiteX8" fmla="*/ 4163 w 37440"/>
              <a:gd name="connsiteY8" fmla="*/ 8882 h 36453"/>
              <a:gd name="connsiteX9" fmla="*/ 3936 w 37440"/>
              <a:gd name="connsiteY9" fmla="*/ 7463 h 36453"/>
              <a:gd name="connsiteX0" fmla="*/ 37440 w 37440"/>
              <a:gd name="connsiteY0" fmla="*/ 15834 h 28990"/>
              <a:gd name="connsiteX1" fmla="*/ 35431 w 37440"/>
              <a:gd name="connsiteY1" fmla="*/ 21731 h 28990"/>
              <a:gd name="connsiteX2" fmla="*/ 28591 w 37440"/>
              <a:gd name="connsiteY2" fmla="*/ 22445 h 28990"/>
              <a:gd name="connsiteX3" fmla="*/ 23703 w 37440"/>
              <a:gd name="connsiteY3" fmla="*/ 28736 h 28990"/>
              <a:gd name="connsiteX4" fmla="*/ 16516 w 37440"/>
              <a:gd name="connsiteY4" fmla="*/ 24896 h 28990"/>
              <a:gd name="connsiteX5" fmla="*/ 5840 w 37440"/>
              <a:gd name="connsiteY5" fmla="*/ 21102 h 28990"/>
              <a:gd name="connsiteX6" fmla="*/ 1146 w 37440"/>
              <a:gd name="connsiteY6" fmla="*/ 16880 h 28990"/>
              <a:gd name="connsiteX7" fmla="*/ 2149 w 37440"/>
              <a:gd name="connsiteY7" fmla="*/ 11181 h 28990"/>
              <a:gd name="connsiteX8" fmla="*/ 31 w 37440"/>
              <a:gd name="connsiteY8" fmla="*/ 5334 h 28990"/>
              <a:gd name="connsiteX9" fmla="*/ 3899 w 37440"/>
              <a:gd name="connsiteY9" fmla="*/ 137 h 28990"/>
              <a:gd name="connsiteX10" fmla="*/ 3936 w 37440"/>
              <a:gd name="connsiteY10" fmla="*/ 0 h 28990"/>
              <a:gd name="connsiteX0" fmla="*/ 4729 w 37440"/>
              <a:gd name="connsiteY0" fmla="*/ 11807 h 28990"/>
              <a:gd name="connsiteX1" fmla="*/ 2196 w 37440"/>
              <a:gd name="connsiteY1" fmla="*/ 11010 h 28990"/>
              <a:gd name="connsiteX2" fmla="*/ 6964 w 37440"/>
              <a:gd name="connsiteY2" fmla="*/ 20529 h 28990"/>
              <a:gd name="connsiteX3" fmla="*/ 5856 w 37440"/>
              <a:gd name="connsiteY3" fmla="*/ 20910 h 28990"/>
              <a:gd name="connsiteX4" fmla="*/ 16514 w 37440"/>
              <a:gd name="connsiteY4" fmla="*/ 24720 h 28990"/>
              <a:gd name="connsiteX5" fmla="*/ 15846 w 37440"/>
              <a:gd name="connsiteY5" fmla="*/ 22980 h 28990"/>
              <a:gd name="connsiteX6" fmla="*/ 28863 w 37440"/>
              <a:gd name="connsiteY6" fmla="*/ 20381 h 28990"/>
              <a:gd name="connsiteX7" fmla="*/ 28596 w 37440"/>
              <a:gd name="connsiteY7" fmla="*/ 22290 h 28990"/>
              <a:gd name="connsiteX8" fmla="*/ 4163 w 37440"/>
              <a:gd name="connsiteY8" fmla="*/ 1419 h 28990"/>
              <a:gd name="connsiteX9" fmla="*/ 3936 w 37440"/>
              <a:gd name="connsiteY9" fmla="*/ 0 h 28990"/>
              <a:gd name="connsiteX0" fmla="*/ 37440 w 37440"/>
              <a:gd name="connsiteY0" fmla="*/ 15834 h 28990"/>
              <a:gd name="connsiteX1" fmla="*/ 35431 w 37440"/>
              <a:gd name="connsiteY1" fmla="*/ 21731 h 28990"/>
              <a:gd name="connsiteX2" fmla="*/ 28591 w 37440"/>
              <a:gd name="connsiteY2" fmla="*/ 22445 h 28990"/>
              <a:gd name="connsiteX3" fmla="*/ 23703 w 37440"/>
              <a:gd name="connsiteY3" fmla="*/ 28736 h 28990"/>
              <a:gd name="connsiteX4" fmla="*/ 16516 w 37440"/>
              <a:gd name="connsiteY4" fmla="*/ 24896 h 28990"/>
              <a:gd name="connsiteX5" fmla="*/ 5840 w 37440"/>
              <a:gd name="connsiteY5" fmla="*/ 21102 h 28990"/>
              <a:gd name="connsiteX6" fmla="*/ 1146 w 37440"/>
              <a:gd name="connsiteY6" fmla="*/ 16880 h 28990"/>
              <a:gd name="connsiteX7" fmla="*/ 2149 w 37440"/>
              <a:gd name="connsiteY7" fmla="*/ 11181 h 28990"/>
              <a:gd name="connsiteX8" fmla="*/ 31 w 37440"/>
              <a:gd name="connsiteY8" fmla="*/ 5334 h 28990"/>
              <a:gd name="connsiteX9" fmla="*/ 3899 w 37440"/>
              <a:gd name="connsiteY9" fmla="*/ 137 h 28990"/>
              <a:gd name="connsiteX10" fmla="*/ 3936 w 37440"/>
              <a:gd name="connsiteY10" fmla="*/ 0 h 28990"/>
              <a:gd name="connsiteX0" fmla="*/ 4729 w 37440"/>
              <a:gd name="connsiteY0" fmla="*/ 11807 h 28990"/>
              <a:gd name="connsiteX1" fmla="*/ 2196 w 37440"/>
              <a:gd name="connsiteY1" fmla="*/ 11010 h 28990"/>
              <a:gd name="connsiteX2" fmla="*/ 6964 w 37440"/>
              <a:gd name="connsiteY2" fmla="*/ 20529 h 28990"/>
              <a:gd name="connsiteX3" fmla="*/ 5856 w 37440"/>
              <a:gd name="connsiteY3" fmla="*/ 20910 h 28990"/>
              <a:gd name="connsiteX4" fmla="*/ 16514 w 37440"/>
              <a:gd name="connsiteY4" fmla="*/ 24720 h 28990"/>
              <a:gd name="connsiteX5" fmla="*/ 15846 w 37440"/>
              <a:gd name="connsiteY5" fmla="*/ 22980 h 28990"/>
              <a:gd name="connsiteX6" fmla="*/ 28863 w 37440"/>
              <a:gd name="connsiteY6" fmla="*/ 20381 h 28990"/>
              <a:gd name="connsiteX7" fmla="*/ 28596 w 37440"/>
              <a:gd name="connsiteY7" fmla="*/ 22290 h 28990"/>
              <a:gd name="connsiteX0" fmla="*/ 37440 w 37440"/>
              <a:gd name="connsiteY0" fmla="*/ 15697 h 28853"/>
              <a:gd name="connsiteX1" fmla="*/ 35431 w 37440"/>
              <a:gd name="connsiteY1" fmla="*/ 21594 h 28853"/>
              <a:gd name="connsiteX2" fmla="*/ 28591 w 37440"/>
              <a:gd name="connsiteY2" fmla="*/ 22308 h 28853"/>
              <a:gd name="connsiteX3" fmla="*/ 23703 w 37440"/>
              <a:gd name="connsiteY3" fmla="*/ 28599 h 28853"/>
              <a:gd name="connsiteX4" fmla="*/ 16516 w 37440"/>
              <a:gd name="connsiteY4" fmla="*/ 24759 h 28853"/>
              <a:gd name="connsiteX5" fmla="*/ 5840 w 37440"/>
              <a:gd name="connsiteY5" fmla="*/ 20965 h 28853"/>
              <a:gd name="connsiteX6" fmla="*/ 1146 w 37440"/>
              <a:gd name="connsiteY6" fmla="*/ 16743 h 28853"/>
              <a:gd name="connsiteX7" fmla="*/ 2149 w 37440"/>
              <a:gd name="connsiteY7" fmla="*/ 11044 h 28853"/>
              <a:gd name="connsiteX8" fmla="*/ 31 w 37440"/>
              <a:gd name="connsiteY8" fmla="*/ 5197 h 28853"/>
              <a:gd name="connsiteX9" fmla="*/ 3899 w 37440"/>
              <a:gd name="connsiteY9" fmla="*/ 0 h 28853"/>
              <a:gd name="connsiteX0" fmla="*/ 4729 w 37440"/>
              <a:gd name="connsiteY0" fmla="*/ 11670 h 28853"/>
              <a:gd name="connsiteX1" fmla="*/ 2196 w 37440"/>
              <a:gd name="connsiteY1" fmla="*/ 10873 h 28853"/>
              <a:gd name="connsiteX2" fmla="*/ 6964 w 37440"/>
              <a:gd name="connsiteY2" fmla="*/ 20392 h 28853"/>
              <a:gd name="connsiteX3" fmla="*/ 5856 w 37440"/>
              <a:gd name="connsiteY3" fmla="*/ 20773 h 28853"/>
              <a:gd name="connsiteX4" fmla="*/ 16514 w 37440"/>
              <a:gd name="connsiteY4" fmla="*/ 24583 h 28853"/>
              <a:gd name="connsiteX5" fmla="*/ 15846 w 37440"/>
              <a:gd name="connsiteY5" fmla="*/ 22843 h 28853"/>
              <a:gd name="connsiteX6" fmla="*/ 28863 w 37440"/>
              <a:gd name="connsiteY6" fmla="*/ 20244 h 28853"/>
              <a:gd name="connsiteX7" fmla="*/ 28596 w 37440"/>
              <a:gd name="connsiteY7" fmla="*/ 22153 h 28853"/>
              <a:gd name="connsiteX0" fmla="*/ 37440 w 37440"/>
              <a:gd name="connsiteY0" fmla="*/ 10500 h 23656"/>
              <a:gd name="connsiteX1" fmla="*/ 35431 w 37440"/>
              <a:gd name="connsiteY1" fmla="*/ 16397 h 23656"/>
              <a:gd name="connsiteX2" fmla="*/ 28591 w 37440"/>
              <a:gd name="connsiteY2" fmla="*/ 17111 h 23656"/>
              <a:gd name="connsiteX3" fmla="*/ 23703 w 37440"/>
              <a:gd name="connsiteY3" fmla="*/ 23402 h 23656"/>
              <a:gd name="connsiteX4" fmla="*/ 16516 w 37440"/>
              <a:gd name="connsiteY4" fmla="*/ 19562 h 23656"/>
              <a:gd name="connsiteX5" fmla="*/ 5840 w 37440"/>
              <a:gd name="connsiteY5" fmla="*/ 15768 h 23656"/>
              <a:gd name="connsiteX6" fmla="*/ 1146 w 37440"/>
              <a:gd name="connsiteY6" fmla="*/ 11546 h 23656"/>
              <a:gd name="connsiteX7" fmla="*/ 2149 w 37440"/>
              <a:gd name="connsiteY7" fmla="*/ 5847 h 23656"/>
              <a:gd name="connsiteX8" fmla="*/ 31 w 37440"/>
              <a:gd name="connsiteY8" fmla="*/ 0 h 23656"/>
              <a:gd name="connsiteX0" fmla="*/ 4729 w 37440"/>
              <a:gd name="connsiteY0" fmla="*/ 6473 h 23656"/>
              <a:gd name="connsiteX1" fmla="*/ 2196 w 37440"/>
              <a:gd name="connsiteY1" fmla="*/ 5676 h 23656"/>
              <a:gd name="connsiteX2" fmla="*/ 6964 w 37440"/>
              <a:gd name="connsiteY2" fmla="*/ 15195 h 23656"/>
              <a:gd name="connsiteX3" fmla="*/ 5856 w 37440"/>
              <a:gd name="connsiteY3" fmla="*/ 15576 h 23656"/>
              <a:gd name="connsiteX4" fmla="*/ 16514 w 37440"/>
              <a:gd name="connsiteY4" fmla="*/ 19386 h 23656"/>
              <a:gd name="connsiteX5" fmla="*/ 15846 w 37440"/>
              <a:gd name="connsiteY5" fmla="*/ 17646 h 23656"/>
              <a:gd name="connsiteX6" fmla="*/ 28863 w 37440"/>
              <a:gd name="connsiteY6" fmla="*/ 15047 h 23656"/>
              <a:gd name="connsiteX7" fmla="*/ 28596 w 37440"/>
              <a:gd name="connsiteY7" fmla="*/ 16956 h 23656"/>
              <a:gd name="connsiteX0" fmla="*/ 36469 w 36469"/>
              <a:gd name="connsiteY0" fmla="*/ 4824 h 17980"/>
              <a:gd name="connsiteX1" fmla="*/ 34460 w 36469"/>
              <a:gd name="connsiteY1" fmla="*/ 10721 h 17980"/>
              <a:gd name="connsiteX2" fmla="*/ 27620 w 36469"/>
              <a:gd name="connsiteY2" fmla="*/ 11435 h 17980"/>
              <a:gd name="connsiteX3" fmla="*/ 22732 w 36469"/>
              <a:gd name="connsiteY3" fmla="*/ 17726 h 17980"/>
              <a:gd name="connsiteX4" fmla="*/ 15545 w 36469"/>
              <a:gd name="connsiteY4" fmla="*/ 13886 h 17980"/>
              <a:gd name="connsiteX5" fmla="*/ 4869 w 36469"/>
              <a:gd name="connsiteY5" fmla="*/ 10092 h 17980"/>
              <a:gd name="connsiteX6" fmla="*/ 175 w 36469"/>
              <a:gd name="connsiteY6" fmla="*/ 5870 h 17980"/>
              <a:gd name="connsiteX7" fmla="*/ 1178 w 36469"/>
              <a:gd name="connsiteY7" fmla="*/ 171 h 17980"/>
              <a:gd name="connsiteX0" fmla="*/ 3758 w 36469"/>
              <a:gd name="connsiteY0" fmla="*/ 797 h 17980"/>
              <a:gd name="connsiteX1" fmla="*/ 1225 w 36469"/>
              <a:gd name="connsiteY1" fmla="*/ 0 h 17980"/>
              <a:gd name="connsiteX2" fmla="*/ 5993 w 36469"/>
              <a:gd name="connsiteY2" fmla="*/ 9519 h 17980"/>
              <a:gd name="connsiteX3" fmla="*/ 4885 w 36469"/>
              <a:gd name="connsiteY3" fmla="*/ 9900 h 17980"/>
              <a:gd name="connsiteX4" fmla="*/ 15543 w 36469"/>
              <a:gd name="connsiteY4" fmla="*/ 13710 h 17980"/>
              <a:gd name="connsiteX5" fmla="*/ 14875 w 36469"/>
              <a:gd name="connsiteY5" fmla="*/ 11970 h 17980"/>
              <a:gd name="connsiteX6" fmla="*/ 27892 w 36469"/>
              <a:gd name="connsiteY6" fmla="*/ 9371 h 17980"/>
              <a:gd name="connsiteX7" fmla="*/ 27625 w 36469"/>
              <a:gd name="connsiteY7" fmla="*/ 11280 h 17980"/>
              <a:gd name="connsiteX0" fmla="*/ 36469 w 40714"/>
              <a:gd name="connsiteY0" fmla="*/ 4824 h 17980"/>
              <a:gd name="connsiteX1" fmla="*/ 34460 w 40714"/>
              <a:gd name="connsiteY1" fmla="*/ 10721 h 17980"/>
              <a:gd name="connsiteX2" fmla="*/ 27620 w 40714"/>
              <a:gd name="connsiteY2" fmla="*/ 11435 h 17980"/>
              <a:gd name="connsiteX3" fmla="*/ 22732 w 40714"/>
              <a:gd name="connsiteY3" fmla="*/ 17726 h 17980"/>
              <a:gd name="connsiteX4" fmla="*/ 15545 w 40714"/>
              <a:gd name="connsiteY4" fmla="*/ 13886 h 17980"/>
              <a:gd name="connsiteX5" fmla="*/ 4869 w 40714"/>
              <a:gd name="connsiteY5" fmla="*/ 10092 h 17980"/>
              <a:gd name="connsiteX6" fmla="*/ 175 w 40714"/>
              <a:gd name="connsiteY6" fmla="*/ 5870 h 17980"/>
              <a:gd name="connsiteX7" fmla="*/ 1178 w 40714"/>
              <a:gd name="connsiteY7" fmla="*/ 171 h 17980"/>
              <a:gd name="connsiteX0" fmla="*/ 40714 w 40714"/>
              <a:gd name="connsiteY0" fmla="*/ 2891 h 17980"/>
              <a:gd name="connsiteX1" fmla="*/ 1225 w 40714"/>
              <a:gd name="connsiteY1" fmla="*/ 0 h 17980"/>
              <a:gd name="connsiteX2" fmla="*/ 5993 w 40714"/>
              <a:gd name="connsiteY2" fmla="*/ 9519 h 17980"/>
              <a:gd name="connsiteX3" fmla="*/ 4885 w 40714"/>
              <a:gd name="connsiteY3" fmla="*/ 9900 h 17980"/>
              <a:gd name="connsiteX4" fmla="*/ 15543 w 40714"/>
              <a:gd name="connsiteY4" fmla="*/ 13710 h 17980"/>
              <a:gd name="connsiteX5" fmla="*/ 14875 w 40714"/>
              <a:gd name="connsiteY5" fmla="*/ 11970 h 17980"/>
              <a:gd name="connsiteX6" fmla="*/ 27892 w 40714"/>
              <a:gd name="connsiteY6" fmla="*/ 9371 h 17980"/>
              <a:gd name="connsiteX7" fmla="*/ 27625 w 40714"/>
              <a:gd name="connsiteY7" fmla="*/ 11280 h 17980"/>
              <a:gd name="connsiteX0" fmla="*/ 36722 w 40714"/>
              <a:gd name="connsiteY0" fmla="*/ 3029 h 17980"/>
              <a:gd name="connsiteX1" fmla="*/ 34460 w 40714"/>
              <a:gd name="connsiteY1" fmla="*/ 10721 h 17980"/>
              <a:gd name="connsiteX2" fmla="*/ 27620 w 40714"/>
              <a:gd name="connsiteY2" fmla="*/ 11435 h 17980"/>
              <a:gd name="connsiteX3" fmla="*/ 22732 w 40714"/>
              <a:gd name="connsiteY3" fmla="*/ 17726 h 17980"/>
              <a:gd name="connsiteX4" fmla="*/ 15545 w 40714"/>
              <a:gd name="connsiteY4" fmla="*/ 13886 h 17980"/>
              <a:gd name="connsiteX5" fmla="*/ 4869 w 40714"/>
              <a:gd name="connsiteY5" fmla="*/ 10092 h 17980"/>
              <a:gd name="connsiteX6" fmla="*/ 175 w 40714"/>
              <a:gd name="connsiteY6" fmla="*/ 5870 h 17980"/>
              <a:gd name="connsiteX7" fmla="*/ 1178 w 40714"/>
              <a:gd name="connsiteY7" fmla="*/ 171 h 17980"/>
              <a:gd name="connsiteX0" fmla="*/ 40714 w 40714"/>
              <a:gd name="connsiteY0" fmla="*/ 2891 h 17980"/>
              <a:gd name="connsiteX1" fmla="*/ 1225 w 40714"/>
              <a:gd name="connsiteY1" fmla="*/ 0 h 17980"/>
              <a:gd name="connsiteX2" fmla="*/ 5993 w 40714"/>
              <a:gd name="connsiteY2" fmla="*/ 9519 h 17980"/>
              <a:gd name="connsiteX3" fmla="*/ 4885 w 40714"/>
              <a:gd name="connsiteY3" fmla="*/ 9900 h 17980"/>
              <a:gd name="connsiteX4" fmla="*/ 15543 w 40714"/>
              <a:gd name="connsiteY4" fmla="*/ 13710 h 17980"/>
              <a:gd name="connsiteX5" fmla="*/ 14875 w 40714"/>
              <a:gd name="connsiteY5" fmla="*/ 11970 h 17980"/>
              <a:gd name="connsiteX6" fmla="*/ 27892 w 40714"/>
              <a:gd name="connsiteY6" fmla="*/ 9371 h 17980"/>
              <a:gd name="connsiteX7" fmla="*/ 27625 w 40714"/>
              <a:gd name="connsiteY7" fmla="*/ 11280 h 17980"/>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 ang="0">
                <a:pos x="connsiteX6" y="connsiteY6"/>
              </a:cxn>
              <a:cxn ang="0">
                <a:pos x="connsiteX7" y="connsiteY7"/>
              </a:cxn>
            </a:cxnLst>
            <a:rect l="l" t="t" r="r" b="b"/>
            <a:pathLst>
              <a:path w="40714" h="17980">
                <a:moveTo>
                  <a:pt x="36722" y="3029"/>
                </a:moveTo>
                <a:cubicBezTo>
                  <a:pt x="36709" y="5296"/>
                  <a:pt x="35977" y="9320"/>
                  <a:pt x="34460" y="10721"/>
                </a:cubicBezTo>
                <a:cubicBezTo>
                  <a:pt x="32943" y="12122"/>
                  <a:pt x="29769" y="13259"/>
                  <a:pt x="27620" y="11435"/>
                </a:cubicBezTo>
                <a:cubicBezTo>
                  <a:pt x="26925" y="14568"/>
                  <a:pt x="25064" y="16963"/>
                  <a:pt x="22732" y="17726"/>
                </a:cubicBezTo>
                <a:cubicBezTo>
                  <a:pt x="19984" y="18625"/>
                  <a:pt x="17116" y="17093"/>
                  <a:pt x="15545" y="13886"/>
                </a:cubicBezTo>
                <a:cubicBezTo>
                  <a:pt x="11837" y="16930"/>
                  <a:pt x="7021" y="15219"/>
                  <a:pt x="4869" y="10092"/>
                </a:cubicBezTo>
                <a:cubicBezTo>
                  <a:pt x="2755" y="10429"/>
                  <a:pt x="770" y="8644"/>
                  <a:pt x="175" y="5870"/>
                </a:cubicBezTo>
                <a:cubicBezTo>
                  <a:pt x="-256" y="3863"/>
                  <a:pt x="125" y="1697"/>
                  <a:pt x="1178" y="171"/>
                </a:cubicBezTo>
              </a:path>
              <a:path w="40714" h="17980" fill="none" extrusionOk="0">
                <a:moveTo>
                  <a:pt x="40714" y="2891"/>
                </a:moveTo>
                <a:cubicBezTo>
                  <a:pt x="39830" y="2985"/>
                  <a:pt x="1990" y="613"/>
                  <a:pt x="1225" y="0"/>
                </a:cubicBezTo>
                <a:moveTo>
                  <a:pt x="5993" y="9519"/>
                </a:moveTo>
                <a:cubicBezTo>
                  <a:pt x="5638" y="9712"/>
                  <a:pt x="5265" y="9840"/>
                  <a:pt x="4885" y="9900"/>
                </a:cubicBezTo>
                <a:moveTo>
                  <a:pt x="15543" y="13710"/>
                </a:moveTo>
                <a:cubicBezTo>
                  <a:pt x="15276" y="13164"/>
                  <a:pt x="15052" y="12581"/>
                  <a:pt x="14875" y="11970"/>
                </a:cubicBezTo>
                <a:moveTo>
                  <a:pt x="27892" y="9371"/>
                </a:moveTo>
                <a:cubicBezTo>
                  <a:pt x="27853" y="10018"/>
                  <a:pt x="27763" y="10658"/>
                  <a:pt x="27625" y="11280"/>
                </a:cubicBezTo>
              </a:path>
            </a:pathLst>
          </a:custGeom>
          <a:solidFill>
            <a:schemeClr val="tx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320" name="Cloud 319"/>
          <p:cNvSpPr/>
          <p:nvPr/>
        </p:nvSpPr>
        <p:spPr>
          <a:xfrm>
            <a:off x="5008072" y="5130845"/>
            <a:ext cx="541868" cy="458418"/>
          </a:xfrm>
          <a:prstGeom prst="cloud">
            <a:avLst/>
          </a:prstGeom>
          <a:solidFill>
            <a:schemeClr val="tx1">
              <a:alpha val="3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cxnSp>
        <p:nvCxnSpPr>
          <p:cNvPr id="323" name="Straight Arrow Connector 322"/>
          <p:cNvCxnSpPr/>
          <p:nvPr/>
        </p:nvCxnSpPr>
        <p:spPr>
          <a:xfrm flipV="1">
            <a:off x="5806358" y="4765990"/>
            <a:ext cx="0" cy="808035"/>
          </a:xfrm>
          <a:prstGeom prst="straightConnector1">
            <a:avLst/>
          </a:prstGeom>
          <a:ln>
            <a:solidFill>
              <a:schemeClr val="tx1"/>
            </a:solidFill>
            <a:tailEnd type="arrow"/>
          </a:ln>
        </p:spPr>
        <p:style>
          <a:lnRef idx="1">
            <a:schemeClr val="accent1"/>
          </a:lnRef>
          <a:fillRef idx="0">
            <a:schemeClr val="accent1"/>
          </a:fillRef>
          <a:effectRef idx="0">
            <a:schemeClr val="accent1"/>
          </a:effectRef>
          <a:fontRef idx="minor">
            <a:schemeClr val="tx1"/>
          </a:fontRef>
        </p:style>
      </p:cxnSp>
      <p:grpSp>
        <p:nvGrpSpPr>
          <p:cNvPr id="5" name="Gruppo 4"/>
          <p:cNvGrpSpPr/>
          <p:nvPr/>
        </p:nvGrpSpPr>
        <p:grpSpPr>
          <a:xfrm>
            <a:off x="1542316" y="1411207"/>
            <a:ext cx="2000250" cy="265067"/>
            <a:chOff x="1534798" y="2566985"/>
            <a:chExt cx="2000250" cy="265067"/>
          </a:xfrm>
        </p:grpSpPr>
        <p:grpSp>
          <p:nvGrpSpPr>
            <p:cNvPr id="205" name="Gruppo 204"/>
            <p:cNvGrpSpPr/>
            <p:nvPr/>
          </p:nvGrpSpPr>
          <p:grpSpPr>
            <a:xfrm>
              <a:off x="1662124" y="2652052"/>
              <a:ext cx="1777077" cy="180000"/>
              <a:chOff x="4057976" y="5834808"/>
              <a:chExt cx="1777077" cy="180000"/>
            </a:xfrm>
          </p:grpSpPr>
          <p:grpSp>
            <p:nvGrpSpPr>
              <p:cNvPr id="206" name="Gruppo 205"/>
              <p:cNvGrpSpPr>
                <a:grpSpLocks noChangeAspect="1"/>
              </p:cNvGrpSpPr>
              <p:nvPr/>
            </p:nvGrpSpPr>
            <p:grpSpPr>
              <a:xfrm>
                <a:off x="4057976" y="5834808"/>
                <a:ext cx="100677" cy="180000"/>
                <a:chOff x="7586169" y="3682425"/>
                <a:chExt cx="595853" cy="1065330"/>
              </a:xfrm>
            </p:grpSpPr>
            <p:sp>
              <p:nvSpPr>
                <p:cNvPr id="252"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53"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07" name="Gruppo 206"/>
              <p:cNvGrpSpPr>
                <a:grpSpLocks noChangeAspect="1"/>
              </p:cNvGrpSpPr>
              <p:nvPr/>
            </p:nvGrpSpPr>
            <p:grpSpPr>
              <a:xfrm>
                <a:off x="4210376" y="5834808"/>
                <a:ext cx="100677" cy="180000"/>
                <a:chOff x="7586169" y="3682425"/>
                <a:chExt cx="595853" cy="1065330"/>
              </a:xfrm>
            </p:grpSpPr>
            <p:sp>
              <p:nvSpPr>
                <p:cNvPr id="240"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51"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08" name="Gruppo 207"/>
              <p:cNvGrpSpPr>
                <a:grpSpLocks noChangeAspect="1"/>
              </p:cNvGrpSpPr>
              <p:nvPr/>
            </p:nvGrpSpPr>
            <p:grpSpPr>
              <a:xfrm>
                <a:off x="4362776" y="5834808"/>
                <a:ext cx="100677" cy="180000"/>
                <a:chOff x="7586169" y="3682425"/>
                <a:chExt cx="595853" cy="1065330"/>
              </a:xfrm>
            </p:grpSpPr>
            <p:sp>
              <p:nvSpPr>
                <p:cNvPr id="238"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39"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09" name="Gruppo 208"/>
              <p:cNvGrpSpPr>
                <a:grpSpLocks noChangeAspect="1"/>
              </p:cNvGrpSpPr>
              <p:nvPr/>
            </p:nvGrpSpPr>
            <p:grpSpPr>
              <a:xfrm>
                <a:off x="4515176" y="5834808"/>
                <a:ext cx="100677" cy="180000"/>
                <a:chOff x="7586169" y="3682425"/>
                <a:chExt cx="595853" cy="1065330"/>
              </a:xfrm>
            </p:grpSpPr>
            <p:sp>
              <p:nvSpPr>
                <p:cNvPr id="235"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37"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0" name="Gruppo 209"/>
              <p:cNvGrpSpPr>
                <a:grpSpLocks noChangeAspect="1"/>
              </p:cNvGrpSpPr>
              <p:nvPr/>
            </p:nvGrpSpPr>
            <p:grpSpPr>
              <a:xfrm>
                <a:off x="4667576" y="5834808"/>
                <a:ext cx="100677" cy="180000"/>
                <a:chOff x="7586169" y="3682425"/>
                <a:chExt cx="595853" cy="1065330"/>
              </a:xfrm>
            </p:grpSpPr>
            <p:sp>
              <p:nvSpPr>
                <p:cNvPr id="233"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34"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1" name="Gruppo 210"/>
              <p:cNvGrpSpPr>
                <a:grpSpLocks noChangeAspect="1"/>
              </p:cNvGrpSpPr>
              <p:nvPr/>
            </p:nvGrpSpPr>
            <p:grpSpPr>
              <a:xfrm>
                <a:off x="4819976" y="5834808"/>
                <a:ext cx="100677" cy="180000"/>
                <a:chOff x="7586169" y="3682425"/>
                <a:chExt cx="595853" cy="1065330"/>
              </a:xfrm>
            </p:grpSpPr>
            <p:sp>
              <p:nvSpPr>
                <p:cNvPr id="230"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32"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2" name="Gruppo 211"/>
              <p:cNvGrpSpPr>
                <a:grpSpLocks noChangeAspect="1"/>
              </p:cNvGrpSpPr>
              <p:nvPr/>
            </p:nvGrpSpPr>
            <p:grpSpPr>
              <a:xfrm>
                <a:off x="4972376" y="5834808"/>
                <a:ext cx="100677" cy="180000"/>
                <a:chOff x="7586169" y="3682425"/>
                <a:chExt cx="595853" cy="1065330"/>
              </a:xfrm>
            </p:grpSpPr>
            <p:sp>
              <p:nvSpPr>
                <p:cNvPr id="228"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29"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3" name="Gruppo 212"/>
              <p:cNvGrpSpPr>
                <a:grpSpLocks noChangeAspect="1"/>
              </p:cNvGrpSpPr>
              <p:nvPr/>
            </p:nvGrpSpPr>
            <p:grpSpPr>
              <a:xfrm>
                <a:off x="5124776" y="5834808"/>
                <a:ext cx="100677" cy="180000"/>
                <a:chOff x="7586169" y="3682425"/>
                <a:chExt cx="595853" cy="1065330"/>
              </a:xfrm>
            </p:grpSpPr>
            <p:sp>
              <p:nvSpPr>
                <p:cNvPr id="226"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27"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4" name="Gruppo 213"/>
              <p:cNvGrpSpPr>
                <a:grpSpLocks noChangeAspect="1"/>
              </p:cNvGrpSpPr>
              <p:nvPr/>
            </p:nvGrpSpPr>
            <p:grpSpPr>
              <a:xfrm>
                <a:off x="5277176" y="5834808"/>
                <a:ext cx="100677" cy="180000"/>
                <a:chOff x="7586169" y="3682425"/>
                <a:chExt cx="595853" cy="1065330"/>
              </a:xfrm>
            </p:grpSpPr>
            <p:sp>
              <p:nvSpPr>
                <p:cNvPr id="224"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25"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5" name="Gruppo 214"/>
              <p:cNvGrpSpPr>
                <a:grpSpLocks noChangeAspect="1"/>
              </p:cNvGrpSpPr>
              <p:nvPr/>
            </p:nvGrpSpPr>
            <p:grpSpPr>
              <a:xfrm>
                <a:off x="5429576" y="5834808"/>
                <a:ext cx="100677" cy="180000"/>
                <a:chOff x="7586169" y="3682425"/>
                <a:chExt cx="595853" cy="1065330"/>
              </a:xfrm>
            </p:grpSpPr>
            <p:sp>
              <p:nvSpPr>
                <p:cNvPr id="222"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23"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6" name="Gruppo 215"/>
              <p:cNvGrpSpPr>
                <a:grpSpLocks noChangeAspect="1"/>
              </p:cNvGrpSpPr>
              <p:nvPr/>
            </p:nvGrpSpPr>
            <p:grpSpPr>
              <a:xfrm>
                <a:off x="5581976" y="5834808"/>
                <a:ext cx="100677" cy="180000"/>
                <a:chOff x="7586169" y="3682425"/>
                <a:chExt cx="595853" cy="1065330"/>
              </a:xfrm>
            </p:grpSpPr>
            <p:sp>
              <p:nvSpPr>
                <p:cNvPr id="220"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21"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nvGrpSpPr>
              <p:cNvPr id="217" name="Gruppo 216"/>
              <p:cNvGrpSpPr>
                <a:grpSpLocks noChangeAspect="1"/>
              </p:cNvGrpSpPr>
              <p:nvPr/>
            </p:nvGrpSpPr>
            <p:grpSpPr>
              <a:xfrm>
                <a:off x="5734376" y="5834808"/>
                <a:ext cx="100677" cy="180000"/>
                <a:chOff x="7586169" y="3682425"/>
                <a:chExt cx="595853" cy="1065330"/>
              </a:xfrm>
            </p:grpSpPr>
            <p:sp>
              <p:nvSpPr>
                <p:cNvPr id="218" name="Flowchart: Delay 71"/>
                <p:cNvSpPr/>
                <p:nvPr/>
              </p:nvSpPr>
              <p:spPr>
                <a:xfrm rot="5400000">
                  <a:off x="7351431" y="3917163"/>
                  <a:ext cx="1065330" cy="595853"/>
                </a:xfrm>
                <a:prstGeom prst="flowChartDelay">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
              <p:nvSpPr>
                <p:cNvPr id="219" name="Flowchart: Delay 23"/>
                <p:cNvSpPr/>
                <p:nvPr/>
              </p:nvSpPr>
              <p:spPr>
                <a:xfrm rot="5400000">
                  <a:off x="7706921" y="4291008"/>
                  <a:ext cx="354348" cy="444052"/>
                </a:xfrm>
                <a:custGeom>
                  <a:avLst/>
                  <a:gdLst>
                    <a:gd name="connsiteX0" fmla="*/ 0 w 354348"/>
                    <a:gd name="connsiteY0" fmla="*/ 0 h 444051"/>
                    <a:gd name="connsiteX1" fmla="*/ 177174 w 354348"/>
                    <a:gd name="connsiteY1" fmla="*/ 0 h 444051"/>
                    <a:gd name="connsiteX2" fmla="*/ 354348 w 354348"/>
                    <a:gd name="connsiteY2" fmla="*/ 222026 h 444051"/>
                    <a:gd name="connsiteX3" fmla="*/ 177174 w 354348"/>
                    <a:gd name="connsiteY3" fmla="*/ 444052 h 444051"/>
                    <a:gd name="connsiteX4" fmla="*/ 0 w 354348"/>
                    <a:gd name="connsiteY4" fmla="*/ 444051 h 444051"/>
                    <a:gd name="connsiteX5" fmla="*/ 0 w 354348"/>
                    <a:gd name="connsiteY5" fmla="*/ 0 h 444051"/>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 name="connsiteX0" fmla="*/ 0 w 354348"/>
                    <a:gd name="connsiteY0" fmla="*/ 0 h 444052"/>
                    <a:gd name="connsiteX1" fmla="*/ 177174 w 354348"/>
                    <a:gd name="connsiteY1" fmla="*/ 0 h 444052"/>
                    <a:gd name="connsiteX2" fmla="*/ 354348 w 354348"/>
                    <a:gd name="connsiteY2" fmla="*/ 222026 h 444052"/>
                    <a:gd name="connsiteX3" fmla="*/ 177174 w 354348"/>
                    <a:gd name="connsiteY3" fmla="*/ 444052 h 444052"/>
                    <a:gd name="connsiteX4" fmla="*/ 0 w 354348"/>
                    <a:gd name="connsiteY4" fmla="*/ 444051 h 444052"/>
                    <a:gd name="connsiteX5" fmla="*/ 0 w 354348"/>
                    <a:gd name="connsiteY5" fmla="*/ 0 h 444052"/>
                  </a:gdLst>
                  <a:ahLst/>
                  <a:cxnLst>
                    <a:cxn ang="0">
                      <a:pos x="connsiteX0" y="connsiteY0"/>
                    </a:cxn>
                    <a:cxn ang="0">
                      <a:pos x="connsiteX1" y="connsiteY1"/>
                    </a:cxn>
                    <a:cxn ang="0">
                      <a:pos x="connsiteX2" y="connsiteY2"/>
                    </a:cxn>
                    <a:cxn ang="0">
                      <a:pos x="connsiteX3" y="connsiteY3"/>
                    </a:cxn>
                    <a:cxn ang="0">
                      <a:pos x="connsiteX4" y="connsiteY4"/>
                    </a:cxn>
                    <a:cxn ang="0">
                      <a:pos x="connsiteX5" y="connsiteY5"/>
                    </a:cxn>
                  </a:cxnLst>
                  <a:rect l="l" t="t" r="r" b="b"/>
                  <a:pathLst>
                    <a:path w="354348" h="444052">
                      <a:moveTo>
                        <a:pt x="0" y="0"/>
                      </a:moveTo>
                      <a:lnTo>
                        <a:pt x="177174" y="0"/>
                      </a:lnTo>
                      <a:cubicBezTo>
                        <a:pt x="275024" y="0"/>
                        <a:pt x="354348" y="99404"/>
                        <a:pt x="354348" y="222026"/>
                      </a:cubicBezTo>
                      <a:cubicBezTo>
                        <a:pt x="354348" y="344648"/>
                        <a:pt x="275024" y="444052"/>
                        <a:pt x="177174" y="444052"/>
                      </a:cubicBezTo>
                      <a:lnTo>
                        <a:pt x="0" y="444051"/>
                      </a:lnTo>
                      <a:cubicBezTo>
                        <a:pt x="42862" y="281746"/>
                        <a:pt x="90491" y="219455"/>
                        <a:pt x="0" y="0"/>
                      </a:cubicBezTo>
                      <a:close/>
                    </a:path>
                  </a:pathLst>
                </a:custGeom>
                <a:solidFill>
                  <a:schemeClr val="bg2">
                    <a:lumMod val="90000"/>
                  </a:schemeClr>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grpSp>
        </p:grpSp>
        <p:sp>
          <p:nvSpPr>
            <p:cNvPr id="254" name="Rettangolo 253"/>
            <p:cNvSpPr/>
            <p:nvPr/>
          </p:nvSpPr>
          <p:spPr>
            <a:xfrm>
              <a:off x="1534798" y="2566985"/>
              <a:ext cx="2000250" cy="85066"/>
            </a:xfrm>
            <a:prstGeom prst="rect">
              <a:avLst/>
            </a:prstGeom>
            <a:solidFill>
              <a:schemeClr val="bg1">
                <a:lumMod val="95000"/>
              </a:schemeClr>
            </a:soli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350"/>
            </a:p>
          </p:txBody>
        </p:sp>
      </p:grpSp>
      <p:sp>
        <p:nvSpPr>
          <p:cNvPr id="64" name="Rectangle 63"/>
          <p:cNvSpPr/>
          <p:nvPr/>
        </p:nvSpPr>
        <p:spPr>
          <a:xfrm>
            <a:off x="3002344" y="1374775"/>
            <a:ext cx="178473" cy="333320"/>
          </a:xfrm>
          <a:prstGeom prst="rect">
            <a:avLst/>
          </a:prstGeom>
          <a:noFill/>
          <a:ln>
            <a:solidFill>
              <a:schemeClr val="tx1"/>
            </a:solidFill>
            <a:prstDash val="sysDot"/>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sz="1350"/>
          </a:p>
        </p:txBody>
      </p:sp>
    </p:spTree>
    <p:extLst>
      <p:ext uri="{BB962C8B-B14F-4D97-AF65-F5344CB8AC3E}">
        <p14:creationId xmlns:p14="http://schemas.microsoft.com/office/powerpoint/2010/main" val="3660733876"/>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6" name="Group 5">
            <a:extLst>
              <a:ext uri="{FF2B5EF4-FFF2-40B4-BE49-F238E27FC236}">
                <a16:creationId xmlns:a16="http://schemas.microsoft.com/office/drawing/2014/main" id="{9A53B83D-8D86-4687-9D19-A25F87B1CBB3}"/>
              </a:ext>
            </a:extLst>
          </p:cNvPr>
          <p:cNvGrpSpPr/>
          <p:nvPr/>
        </p:nvGrpSpPr>
        <p:grpSpPr>
          <a:xfrm>
            <a:off x="0" y="0"/>
            <a:ext cx="4207911" cy="2866882"/>
            <a:chOff x="0" y="0"/>
            <a:chExt cx="3452945" cy="2403946"/>
          </a:xfrm>
        </p:grpSpPr>
        <p:grpSp>
          <p:nvGrpSpPr>
            <p:cNvPr id="7" name="Group 6">
              <a:extLst>
                <a:ext uri="{FF2B5EF4-FFF2-40B4-BE49-F238E27FC236}">
                  <a16:creationId xmlns:a16="http://schemas.microsoft.com/office/drawing/2014/main" id="{E95308F4-D4B3-4690-B178-206194786794}"/>
                </a:ext>
              </a:extLst>
            </p:cNvPr>
            <p:cNvGrpSpPr/>
            <p:nvPr/>
          </p:nvGrpSpPr>
          <p:grpSpPr>
            <a:xfrm>
              <a:off x="0" y="0"/>
              <a:ext cx="3452945" cy="2403946"/>
              <a:chOff x="0" y="0"/>
              <a:chExt cx="3452945" cy="2403946"/>
            </a:xfrm>
          </p:grpSpPr>
          <p:graphicFrame>
            <p:nvGraphicFramePr>
              <p:cNvPr id="11" name="Chart 10">
                <a:extLst>
                  <a:ext uri="{FF2B5EF4-FFF2-40B4-BE49-F238E27FC236}">
                    <a16:creationId xmlns:a16="http://schemas.microsoft.com/office/drawing/2014/main" id="{5BF680BB-7C56-4C66-A876-75E2D04C9360}"/>
                  </a:ext>
                </a:extLst>
              </p:cNvPr>
              <p:cNvGraphicFramePr>
                <a:graphicFrameLocks/>
              </p:cNvGraphicFramePr>
              <p:nvPr/>
            </p:nvGraphicFramePr>
            <p:xfrm>
              <a:off x="0" y="96242"/>
              <a:ext cx="3452945" cy="2307704"/>
            </p:xfrm>
            <a:graphic>
              <a:graphicData uri="http://schemas.openxmlformats.org/drawingml/2006/chart">
                <c:chart xmlns:c="http://schemas.openxmlformats.org/drawingml/2006/chart" xmlns:r="http://schemas.openxmlformats.org/officeDocument/2006/relationships" r:id="rId2"/>
              </a:graphicData>
            </a:graphic>
          </p:graphicFrame>
          <p:sp>
            <p:nvSpPr>
              <p:cNvPr id="12" name="TextBox 4">
                <a:extLst>
                  <a:ext uri="{FF2B5EF4-FFF2-40B4-BE49-F238E27FC236}">
                    <a16:creationId xmlns:a16="http://schemas.microsoft.com/office/drawing/2014/main" id="{18EF94F3-2E47-4528-89AD-4C051A5BDE59}"/>
                  </a:ext>
                </a:extLst>
              </p:cNvPr>
              <p:cNvSpPr txBox="1"/>
              <p:nvPr/>
            </p:nvSpPr>
            <p:spPr>
              <a:xfrm>
                <a:off x="1295987" y="1076814"/>
                <a:ext cx="537210" cy="262255"/>
              </a:xfrm>
              <a:prstGeom prst="rect">
                <a:avLst/>
              </a:prstGeom>
              <a:noFill/>
            </p:spPr>
            <p:txBody>
              <a:bodyPr wrap="square" rtlCol="0">
                <a:noAutofit/>
              </a:bodyPr>
              <a:lstStyle/>
              <a:p>
                <a:pPr>
                  <a:spcAft>
                    <a:spcPts val="0"/>
                  </a:spcAft>
                </a:pPr>
                <a:r>
                  <a:rPr lang="en-GB" sz="11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1616</a:t>
                </a:r>
                <a:endParaRPr lang="en-GB" sz="1200">
                  <a:effectLst/>
                  <a:latin typeface="Times New Roman" panose="02020603050405020304" pitchFamily="18" charset="0"/>
                  <a:ea typeface="Times New Roman" panose="02020603050405020304" pitchFamily="18" charset="0"/>
                </a:endParaRPr>
              </a:p>
            </p:txBody>
          </p:sp>
          <p:sp>
            <p:nvSpPr>
              <p:cNvPr id="13" name="Rectangle 12">
                <a:extLst>
                  <a:ext uri="{FF2B5EF4-FFF2-40B4-BE49-F238E27FC236}">
                    <a16:creationId xmlns:a16="http://schemas.microsoft.com/office/drawing/2014/main" id="{61493DE6-8DE0-4C94-A144-5A724B56BC61}"/>
                  </a:ext>
                </a:extLst>
              </p:cNvPr>
              <p:cNvSpPr/>
              <p:nvPr/>
            </p:nvSpPr>
            <p:spPr>
              <a:xfrm>
                <a:off x="719993" y="17834"/>
                <a:ext cx="537210" cy="262255"/>
              </a:xfrm>
              <a:prstGeom prst="rect">
                <a:avLst/>
              </a:prstGeom>
            </p:spPr>
            <p:txBody>
              <a:bodyPr wrap="square">
                <a:noAutofit/>
              </a:bodyPr>
              <a:lstStyle/>
              <a:p>
                <a:pPr>
                  <a:spcAft>
                    <a:spcPts val="0"/>
                  </a:spcAft>
                </a:pPr>
                <a:r>
                  <a:rPr lang="en-GB" sz="11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6790</a:t>
                </a:r>
                <a:endParaRPr lang="en-GB" sz="1200">
                  <a:effectLst/>
                  <a:latin typeface="Times New Roman" panose="02020603050405020304" pitchFamily="18" charset="0"/>
                  <a:ea typeface="Times New Roman" panose="02020603050405020304" pitchFamily="18" charset="0"/>
                </a:endParaRPr>
              </a:p>
            </p:txBody>
          </p:sp>
          <p:sp>
            <p:nvSpPr>
              <p:cNvPr id="14" name="TextBox 12">
                <a:extLst>
                  <a:ext uri="{FF2B5EF4-FFF2-40B4-BE49-F238E27FC236}">
                    <a16:creationId xmlns:a16="http://schemas.microsoft.com/office/drawing/2014/main" id="{FA161866-9757-45AF-9DA4-92A516C6499A}"/>
                  </a:ext>
                </a:extLst>
              </p:cNvPr>
              <p:cNvSpPr txBox="1"/>
              <p:nvPr/>
            </p:nvSpPr>
            <p:spPr>
              <a:xfrm>
                <a:off x="14946" y="0"/>
                <a:ext cx="274434" cy="276999"/>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grpSp>
        <p:sp>
          <p:nvSpPr>
            <p:cNvPr id="8" name="TextBox 25">
              <a:extLst>
                <a:ext uri="{FF2B5EF4-FFF2-40B4-BE49-F238E27FC236}">
                  <a16:creationId xmlns:a16="http://schemas.microsoft.com/office/drawing/2014/main" id="{1625F149-CFA8-4786-A060-3D372942AF52}"/>
                </a:ext>
              </a:extLst>
            </p:cNvPr>
            <p:cNvSpPr txBox="1"/>
            <p:nvPr/>
          </p:nvSpPr>
          <p:spPr>
            <a:xfrm>
              <a:off x="1385693" y="96242"/>
              <a:ext cx="1183005" cy="277495"/>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1 µM AZD2014</a:t>
              </a:r>
              <a:endParaRPr lang="en-GB" sz="1200" dirty="0">
                <a:effectLst/>
                <a:latin typeface="Times New Roman" panose="02020603050405020304" pitchFamily="18" charset="0"/>
                <a:ea typeface="Times New Roman" panose="02020603050405020304" pitchFamily="18" charset="0"/>
              </a:endParaRPr>
            </a:p>
          </p:txBody>
        </p:sp>
      </p:grpSp>
      <p:graphicFrame>
        <p:nvGraphicFramePr>
          <p:cNvPr id="21" name="Chart 20">
            <a:extLst>
              <a:ext uri="{FF2B5EF4-FFF2-40B4-BE49-F238E27FC236}">
                <a16:creationId xmlns:a16="http://schemas.microsoft.com/office/drawing/2014/main" id="{EFA9E28A-CCCA-45BA-964D-DBC5624FBDE0}"/>
              </a:ext>
            </a:extLst>
          </p:cNvPr>
          <p:cNvGraphicFramePr/>
          <p:nvPr>
            <p:extLst>
              <p:ext uri="{D42A27DB-BD31-4B8C-83A1-F6EECF244321}">
                <p14:modId xmlns:p14="http://schemas.microsoft.com/office/powerpoint/2010/main" val="1904641030"/>
              </p:ext>
            </p:extLst>
          </p:nvPr>
        </p:nvGraphicFramePr>
        <p:xfrm>
          <a:off x="155122" y="2568453"/>
          <a:ext cx="7672960" cy="6116955"/>
        </p:xfrm>
        <a:graphic>
          <a:graphicData uri="http://schemas.openxmlformats.org/drawingml/2006/chart">
            <c:chart xmlns:c="http://schemas.openxmlformats.org/drawingml/2006/chart" xmlns:r="http://schemas.openxmlformats.org/officeDocument/2006/relationships" r:id="rId3"/>
          </a:graphicData>
        </a:graphic>
      </p:graphicFrame>
      <p:sp>
        <p:nvSpPr>
          <p:cNvPr id="22" name="TextBox 12">
            <a:extLst>
              <a:ext uri="{FF2B5EF4-FFF2-40B4-BE49-F238E27FC236}">
                <a16:creationId xmlns:a16="http://schemas.microsoft.com/office/drawing/2014/main" id="{B10C249C-96D9-49C3-BFCD-06C1C250EED8}"/>
              </a:ext>
            </a:extLst>
          </p:cNvPr>
          <p:cNvSpPr txBox="1"/>
          <p:nvPr/>
        </p:nvSpPr>
        <p:spPr>
          <a:xfrm>
            <a:off x="18214" y="2568453"/>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graphicFrame>
        <p:nvGraphicFramePr>
          <p:cNvPr id="23" name="Chart 22">
            <a:extLst>
              <a:ext uri="{FF2B5EF4-FFF2-40B4-BE49-F238E27FC236}">
                <a16:creationId xmlns:a16="http://schemas.microsoft.com/office/drawing/2014/main" id="{F144084D-0732-4AFE-B1B4-F9318BE75C4B}"/>
              </a:ext>
            </a:extLst>
          </p:cNvPr>
          <p:cNvGraphicFramePr/>
          <p:nvPr>
            <p:extLst>
              <p:ext uri="{D42A27DB-BD31-4B8C-83A1-F6EECF244321}">
                <p14:modId xmlns:p14="http://schemas.microsoft.com/office/powerpoint/2010/main" val="2937107624"/>
              </p:ext>
            </p:extLst>
          </p:nvPr>
        </p:nvGraphicFramePr>
        <p:xfrm>
          <a:off x="4054568" y="114776"/>
          <a:ext cx="4031469" cy="2743200"/>
        </p:xfrm>
        <a:graphic>
          <a:graphicData uri="http://schemas.openxmlformats.org/drawingml/2006/chart">
            <c:chart xmlns:c="http://schemas.openxmlformats.org/drawingml/2006/chart" xmlns:r="http://schemas.openxmlformats.org/officeDocument/2006/relationships" r:id="rId4"/>
          </a:graphicData>
        </a:graphic>
      </p:graphicFrame>
      <p:sp>
        <p:nvSpPr>
          <p:cNvPr id="24" name="TextBox 12">
            <a:extLst>
              <a:ext uri="{FF2B5EF4-FFF2-40B4-BE49-F238E27FC236}">
                <a16:creationId xmlns:a16="http://schemas.microsoft.com/office/drawing/2014/main" id="{B34FD160-1027-4E09-A82B-C171DF8F16B6}"/>
              </a:ext>
            </a:extLst>
          </p:cNvPr>
          <p:cNvSpPr txBox="1"/>
          <p:nvPr/>
        </p:nvSpPr>
        <p:spPr>
          <a:xfrm>
            <a:off x="3887349" y="-296"/>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25" name="TextBox 25">
            <a:extLst>
              <a:ext uri="{FF2B5EF4-FFF2-40B4-BE49-F238E27FC236}">
                <a16:creationId xmlns:a16="http://schemas.microsoft.com/office/drawing/2014/main" id="{0CBC138B-A3AC-4D89-83AF-612F0F1E9022}"/>
              </a:ext>
            </a:extLst>
          </p:cNvPr>
          <p:cNvSpPr txBox="1"/>
          <p:nvPr/>
        </p:nvSpPr>
        <p:spPr>
          <a:xfrm>
            <a:off x="5485595" y="164875"/>
            <a:ext cx="1441662" cy="330933"/>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 µM AZD2014</a:t>
            </a:r>
            <a:endParaRPr lang="en-GB" sz="1200" dirty="0">
              <a:effectLst/>
              <a:latin typeface="Times New Roman" panose="02020603050405020304" pitchFamily="18" charset="0"/>
              <a:ea typeface="Times New Roman" panose="02020603050405020304" pitchFamily="18" charset="0"/>
            </a:endParaRPr>
          </a:p>
        </p:txBody>
      </p:sp>
      <p:sp>
        <p:nvSpPr>
          <p:cNvPr id="15" name="Rectangle 14">
            <a:extLst>
              <a:ext uri="{FF2B5EF4-FFF2-40B4-BE49-F238E27FC236}">
                <a16:creationId xmlns:a16="http://schemas.microsoft.com/office/drawing/2014/main" id="{84FD7459-53BA-4E89-89D1-586A595094B0}"/>
              </a:ext>
            </a:extLst>
          </p:cNvPr>
          <p:cNvSpPr/>
          <p:nvPr/>
        </p:nvSpPr>
        <p:spPr>
          <a:xfrm>
            <a:off x="0" y="5842337"/>
            <a:ext cx="9144000" cy="1015663"/>
          </a:xfrm>
          <a:prstGeom prst="rect">
            <a:avLst/>
          </a:prstGeom>
        </p:spPr>
        <p:txBody>
          <a:bodyPr wrap="square">
            <a:spAutoFit/>
          </a:bodyPr>
          <a:lstStyle/>
          <a:p>
            <a:pPr algn="just">
              <a:spcAft>
                <a:spcPts val="1000"/>
              </a:spcAft>
            </a:pPr>
            <a:r>
              <a:rPr lang="en-GB" sz="1000" b="1" i="1" dirty="0">
                <a:latin typeface="Arial" panose="020B0604020202020204" pitchFamily="34" charset="0"/>
                <a:ea typeface="Calibri" panose="020F0502020204030204" pitchFamily="34" charset="0"/>
                <a:cs typeface="Times New Roman" panose="02020603050405020304" pitchFamily="18" charset="0"/>
              </a:rPr>
              <a:t>Supplementary Figure </a:t>
            </a:r>
            <a:r>
              <a:rPr lang="en-GB" sz="1000" b="1" i="1" dirty="0" smtClean="0">
                <a:latin typeface="Arial" panose="020B0604020202020204" pitchFamily="34" charset="0"/>
                <a:ea typeface="Calibri" panose="020F0502020204030204" pitchFamily="34" charset="0"/>
                <a:cs typeface="Times New Roman" panose="02020603050405020304" pitchFamily="18" charset="0"/>
              </a:rPr>
              <a:t>S.2: </a:t>
            </a:r>
            <a:r>
              <a:rPr lang="en-GB" sz="1000" b="1" i="1" dirty="0">
                <a:latin typeface="Arial" panose="020B0604020202020204" pitchFamily="34" charset="0"/>
                <a:ea typeface="Calibri" panose="020F0502020204030204" pitchFamily="34" charset="0"/>
                <a:cs typeface="Times New Roman" panose="02020603050405020304" pitchFamily="18" charset="0"/>
              </a:rPr>
              <a:t>Photophysical characterisation of AZD2014. </a:t>
            </a:r>
            <a:r>
              <a:rPr lang="en-GB" sz="1000" i="1" dirty="0">
                <a:latin typeface="Arial" panose="020B0604020202020204" pitchFamily="34" charset="0"/>
                <a:ea typeface="Calibri" panose="020F0502020204030204" pitchFamily="34" charset="0"/>
                <a:cs typeface="Times New Roman" panose="02020603050405020304" pitchFamily="18" charset="0"/>
              </a:rPr>
              <a:t>A) </a:t>
            </a:r>
            <a:r>
              <a:rPr lang="en-GB" sz="1000" i="1" dirty="0">
                <a:solidFill>
                  <a:srgbClr val="000000"/>
                </a:solidFill>
                <a:latin typeface="Arial" panose="020B0604020202020204" pitchFamily="34" charset="0"/>
              </a:rPr>
              <a:t>Molar extinction coefficients (</a:t>
            </a:r>
            <a:r>
              <a:rPr lang="el-GR" sz="1000" i="1" dirty="0">
                <a:solidFill>
                  <a:srgbClr val="000000"/>
                </a:solidFill>
                <a:latin typeface="Arial" panose="020B0604020202020204" pitchFamily="34" charset="0"/>
              </a:rPr>
              <a:t>ε) </a:t>
            </a:r>
            <a:r>
              <a:rPr lang="en-GB" sz="1000" i="1" dirty="0">
                <a:solidFill>
                  <a:srgbClr val="000000"/>
                </a:solidFill>
                <a:latin typeface="Arial" panose="020B0604020202020204" pitchFamily="34" charset="0"/>
              </a:rPr>
              <a:t>of AZD2014 </a:t>
            </a:r>
            <a:r>
              <a:rPr lang="en-GB" sz="1000" i="1" dirty="0">
                <a:latin typeface="Arial" panose="020B0604020202020204" pitchFamily="34" charset="0"/>
                <a:ea typeface="Calibri" panose="020F0502020204030204" pitchFamily="34" charset="0"/>
                <a:cs typeface="Times New Roman" panose="02020603050405020304" pitchFamily="18" charset="0"/>
              </a:rPr>
              <a:t>(11 </a:t>
            </a:r>
            <a:r>
              <a:rPr lang="en-GB" sz="1000" i="1" dirty="0" err="1">
                <a:latin typeface="Arial" panose="020B0604020202020204" pitchFamily="34" charset="0"/>
                <a:ea typeface="Calibri" panose="020F0502020204030204" pitchFamily="34" charset="0"/>
                <a:cs typeface="Times New Roman" panose="02020603050405020304" pitchFamily="18" charset="0"/>
              </a:rPr>
              <a:t>μM</a:t>
            </a:r>
            <a:r>
              <a:rPr lang="en-GB" sz="1000" i="1" dirty="0">
                <a:latin typeface="Arial" panose="020B0604020202020204" pitchFamily="34" charset="0"/>
                <a:ea typeface="Calibri" panose="020F0502020204030204" pitchFamily="34" charset="0"/>
                <a:cs typeface="Times New Roman" panose="02020603050405020304" pitchFamily="18" charset="0"/>
              </a:rPr>
              <a:t>) in DMSO </a:t>
            </a:r>
            <a:r>
              <a:rPr lang="en-GB" sz="1000" i="1" dirty="0" smtClean="0">
                <a:latin typeface="Arial" panose="020B0604020202020204" pitchFamily="34" charset="0"/>
                <a:ea typeface="Calibri" panose="020F0502020204030204" pitchFamily="34" charset="0"/>
                <a:cs typeface="Times New Roman" panose="02020603050405020304" pitchFamily="18" charset="0"/>
              </a:rPr>
              <a:t>solvent </a:t>
            </a:r>
            <a:r>
              <a:rPr lang="en-GB" sz="1000" i="1" dirty="0">
                <a:latin typeface="Arial" panose="020B0604020202020204" pitchFamily="34" charset="0"/>
                <a:ea typeface="Calibri" panose="020F0502020204030204" pitchFamily="34" charset="0"/>
                <a:cs typeface="Times New Roman" panose="02020603050405020304" pitchFamily="18" charset="0"/>
              </a:rPr>
              <a:t>using UV-VIS spectrum and Beer-lambert Law. B) Two-photon excitation spectrum of AZD2014. Lambda scan of 7 </a:t>
            </a:r>
            <a:r>
              <a:rPr lang="el-GR" sz="1000" i="1" dirty="0">
                <a:latin typeface="Arial" panose="020B0604020202020204" pitchFamily="34" charset="0"/>
                <a:ea typeface="Calibri" panose="020F0502020204030204" pitchFamily="34" charset="0"/>
                <a:cs typeface="Times New Roman" panose="02020603050405020304" pitchFamily="18" charset="0"/>
              </a:rPr>
              <a:t>μ</a:t>
            </a:r>
            <a:r>
              <a:rPr lang="en-GB" sz="1000" i="1" dirty="0">
                <a:latin typeface="Arial" panose="020B0604020202020204" pitchFamily="34" charset="0"/>
                <a:ea typeface="Calibri" panose="020F0502020204030204" pitchFamily="34" charset="0"/>
                <a:cs typeface="Times New Roman" panose="02020603050405020304" pitchFamily="18" charset="0"/>
              </a:rPr>
              <a:t>M AZD2014 in DMSO. Data taken from confocal multiphoton images and intensities quantified, spectrum plotted in red. C) </a:t>
            </a:r>
            <a:r>
              <a:rPr lang="en-GB" sz="1000" i="1" dirty="0">
                <a:latin typeface="Arial" panose="020B0604020202020204" pitchFamily="34" charset="0"/>
                <a:cs typeface="Arial" panose="020B0604020202020204" pitchFamily="34" charset="0"/>
              </a:rPr>
              <a:t>Quantum yield absorbance and fluorescence spectra of AZD2014 and standards. UV-VIS spectra of AZD2014 in DMSO and PBS, coumarin-1 in ethanol, quinine sulphate in sulphuric acid (H2SO4) with fluorescence emissions of the same solutions. All settings were kept constant for each experiment. AZD2014 and standards were excited at 393 nm. Absorbance values at 393 nm and integrated fluorescent intensities were used for quantum yield calculations. </a:t>
            </a:r>
            <a:r>
              <a:rPr lang="en-GB" sz="1000" i="1" dirty="0" smtClean="0">
                <a:latin typeface="Arial" panose="020B0604020202020204" pitchFamily="34" charset="0"/>
                <a:cs typeface="Arial" panose="020B0604020202020204" pitchFamily="34" charset="0"/>
              </a:rPr>
              <a:t>(n&gt;2).</a:t>
            </a:r>
            <a:endParaRPr lang="en-GB" sz="1000" i="1" dirty="0">
              <a:latin typeface="Arial" panose="020B0604020202020204" pitchFamily="34" charset="0"/>
              <a:ea typeface="Calibri" panose="020F0502020204030204" pitchFamily="34" charset="0"/>
              <a:cs typeface="Arial" panose="020B0604020202020204" pitchFamily="34" charset="0"/>
            </a:endParaRPr>
          </a:p>
        </p:txBody>
      </p:sp>
      <p:sp>
        <p:nvSpPr>
          <p:cNvPr id="2" name="Rettangolo 1"/>
          <p:cNvSpPr/>
          <p:nvPr/>
        </p:nvSpPr>
        <p:spPr>
          <a:xfrm>
            <a:off x="5416559" y="2928937"/>
            <a:ext cx="2538413" cy="2319337"/>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sp>
        <p:nvSpPr>
          <p:cNvPr id="16" name="Rettangolo 15"/>
          <p:cNvSpPr/>
          <p:nvPr/>
        </p:nvSpPr>
        <p:spPr>
          <a:xfrm>
            <a:off x="5331820" y="2870211"/>
            <a:ext cx="2588054" cy="2246769"/>
          </a:xfrm>
          <a:prstGeom prst="rect">
            <a:avLst/>
          </a:prstGeom>
        </p:spPr>
        <p:txBody>
          <a:bodyPr wrap="square">
            <a:spAutoFit/>
          </a:bodyPr>
          <a:lstStyle/>
          <a:p>
            <a:pPr>
              <a:lnSpc>
                <a:spcPts val="2100"/>
              </a:lnSpc>
            </a:pPr>
            <a:r>
              <a:rPr lang="it-IT" sz="1000" dirty="0" err="1"/>
              <a:t>Quinine</a:t>
            </a:r>
            <a:r>
              <a:rPr lang="it-IT" sz="1000" dirty="0"/>
              <a:t> </a:t>
            </a:r>
            <a:r>
              <a:rPr lang="it-IT" sz="1000" dirty="0" err="1" smtClean="0"/>
              <a:t>sulphate</a:t>
            </a:r>
            <a:r>
              <a:rPr lang="it-IT" sz="1000" dirty="0" smtClean="0"/>
              <a:t> </a:t>
            </a:r>
            <a:r>
              <a:rPr lang="it-IT" sz="1000" dirty="0"/>
              <a:t>(</a:t>
            </a:r>
            <a:r>
              <a:rPr lang="it-IT" sz="1000" dirty="0" smtClean="0"/>
              <a:t>200 µM</a:t>
            </a:r>
            <a:r>
              <a:rPr lang="it-IT" sz="1000" dirty="0"/>
              <a:t>) H</a:t>
            </a:r>
            <a:r>
              <a:rPr lang="it-IT" sz="1000" baseline="-25000" dirty="0"/>
              <a:t>2</a:t>
            </a:r>
            <a:r>
              <a:rPr lang="it-IT" sz="1000" dirty="0"/>
              <a:t>SO</a:t>
            </a:r>
            <a:r>
              <a:rPr lang="it-IT" sz="1000" baseline="-25000" dirty="0"/>
              <a:t>4</a:t>
            </a:r>
            <a:r>
              <a:rPr lang="it-IT" sz="1000" dirty="0"/>
              <a:t> </a:t>
            </a:r>
            <a:r>
              <a:rPr lang="it-IT" sz="1000" dirty="0" err="1" smtClean="0"/>
              <a:t>Absorption</a:t>
            </a:r>
            <a:endParaRPr lang="it-IT" sz="1000" dirty="0" smtClean="0"/>
          </a:p>
          <a:p>
            <a:pPr>
              <a:lnSpc>
                <a:spcPts val="2100"/>
              </a:lnSpc>
            </a:pPr>
            <a:r>
              <a:rPr lang="it-IT" sz="1000" dirty="0" smtClean="0"/>
              <a:t>Coumarin1 (5 µM</a:t>
            </a:r>
            <a:r>
              <a:rPr lang="it-IT" sz="1000" dirty="0"/>
              <a:t>) </a:t>
            </a:r>
            <a:r>
              <a:rPr lang="it-IT" sz="1000" dirty="0" err="1" smtClean="0"/>
              <a:t>Ethanol</a:t>
            </a:r>
            <a:r>
              <a:rPr lang="it-IT" sz="1000" dirty="0" smtClean="0"/>
              <a:t> </a:t>
            </a:r>
            <a:r>
              <a:rPr lang="it-IT" sz="1000" dirty="0" err="1" smtClean="0"/>
              <a:t>Absorption</a:t>
            </a:r>
            <a:endParaRPr lang="it-IT" sz="1000" dirty="0"/>
          </a:p>
          <a:p>
            <a:pPr>
              <a:lnSpc>
                <a:spcPts val="2100"/>
              </a:lnSpc>
            </a:pPr>
            <a:r>
              <a:rPr lang="it-IT" sz="1000" dirty="0" smtClean="0"/>
              <a:t>AZD2014 (11 </a:t>
            </a:r>
            <a:r>
              <a:rPr lang="it-IT" sz="1000" dirty="0"/>
              <a:t>µM) DMSO </a:t>
            </a:r>
            <a:r>
              <a:rPr lang="it-IT" sz="1000" dirty="0" err="1"/>
              <a:t>Absorption</a:t>
            </a:r>
            <a:endParaRPr lang="it-IT" sz="1000" dirty="0"/>
          </a:p>
          <a:p>
            <a:pPr>
              <a:lnSpc>
                <a:spcPts val="2100"/>
              </a:lnSpc>
            </a:pPr>
            <a:r>
              <a:rPr lang="it-IT" sz="1000" dirty="0"/>
              <a:t>AZD2014 (11 µM) </a:t>
            </a:r>
            <a:r>
              <a:rPr lang="it-IT" sz="1000" dirty="0" smtClean="0"/>
              <a:t>PBS </a:t>
            </a:r>
            <a:r>
              <a:rPr lang="it-IT" sz="1000" dirty="0" err="1"/>
              <a:t>Absorption</a:t>
            </a:r>
            <a:endParaRPr lang="it-IT" sz="1000" dirty="0"/>
          </a:p>
          <a:p>
            <a:pPr>
              <a:lnSpc>
                <a:spcPts val="2100"/>
              </a:lnSpc>
            </a:pPr>
            <a:r>
              <a:rPr lang="it-IT" sz="1000" dirty="0" err="1"/>
              <a:t>Quinine</a:t>
            </a:r>
            <a:r>
              <a:rPr lang="it-IT" sz="1000" dirty="0"/>
              <a:t> </a:t>
            </a:r>
            <a:r>
              <a:rPr lang="it-IT" sz="1000" dirty="0" err="1" smtClean="0"/>
              <a:t>sulphate</a:t>
            </a:r>
            <a:r>
              <a:rPr lang="it-IT" sz="1000" dirty="0" smtClean="0"/>
              <a:t> </a:t>
            </a:r>
            <a:r>
              <a:rPr lang="it-IT" sz="1000" dirty="0"/>
              <a:t>(200 µM) H</a:t>
            </a:r>
            <a:r>
              <a:rPr lang="it-IT" sz="1000" baseline="-25000" dirty="0"/>
              <a:t>2</a:t>
            </a:r>
            <a:r>
              <a:rPr lang="it-IT" sz="1000" dirty="0"/>
              <a:t>SO</a:t>
            </a:r>
            <a:r>
              <a:rPr lang="it-IT" sz="1000" baseline="-25000" dirty="0"/>
              <a:t>4</a:t>
            </a:r>
            <a:r>
              <a:rPr lang="it-IT" sz="1000" dirty="0"/>
              <a:t> </a:t>
            </a:r>
            <a:r>
              <a:rPr lang="it-IT" sz="1000" dirty="0" err="1" smtClean="0"/>
              <a:t>Emission</a:t>
            </a:r>
            <a:endParaRPr lang="it-IT" sz="1000" dirty="0"/>
          </a:p>
          <a:p>
            <a:pPr>
              <a:lnSpc>
                <a:spcPts val="2100"/>
              </a:lnSpc>
            </a:pPr>
            <a:r>
              <a:rPr lang="it-IT" sz="1000" dirty="0"/>
              <a:t>Coumarin1 (5 µM) </a:t>
            </a:r>
            <a:r>
              <a:rPr lang="it-IT" sz="1000" dirty="0" err="1"/>
              <a:t>Ethanol</a:t>
            </a:r>
            <a:r>
              <a:rPr lang="it-IT" sz="1000" dirty="0"/>
              <a:t> </a:t>
            </a:r>
            <a:r>
              <a:rPr lang="it-IT" sz="1000" dirty="0" err="1"/>
              <a:t>Emission</a:t>
            </a:r>
            <a:endParaRPr lang="it-IT" sz="1000" dirty="0"/>
          </a:p>
          <a:p>
            <a:pPr>
              <a:lnSpc>
                <a:spcPts val="2100"/>
              </a:lnSpc>
            </a:pPr>
            <a:r>
              <a:rPr lang="it-IT" sz="1000" dirty="0"/>
              <a:t>AZD2014 (11 µM) DMSO </a:t>
            </a:r>
            <a:r>
              <a:rPr lang="it-IT" sz="1000" dirty="0" err="1"/>
              <a:t>Emission</a:t>
            </a:r>
            <a:endParaRPr lang="it-IT" sz="1000" dirty="0"/>
          </a:p>
          <a:p>
            <a:pPr>
              <a:lnSpc>
                <a:spcPts val="2100"/>
              </a:lnSpc>
            </a:pPr>
            <a:r>
              <a:rPr lang="it-IT" sz="1000" dirty="0"/>
              <a:t>AZD2014 (11 µM) PBS </a:t>
            </a:r>
            <a:r>
              <a:rPr lang="it-IT" sz="1000" dirty="0" err="1"/>
              <a:t>Emission</a:t>
            </a:r>
            <a:endParaRPr lang="it-IT" sz="1000" dirty="0"/>
          </a:p>
        </p:txBody>
      </p:sp>
    </p:spTree>
    <p:extLst>
      <p:ext uri="{BB962C8B-B14F-4D97-AF65-F5344CB8AC3E}">
        <p14:creationId xmlns:p14="http://schemas.microsoft.com/office/powerpoint/2010/main" val="3494171061"/>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5" name="Picture 7">
            <a:extLst>
              <a:ext uri="{FF2B5EF4-FFF2-40B4-BE49-F238E27FC236}">
                <a16:creationId xmlns:a16="http://schemas.microsoft.com/office/drawing/2014/main" id="{FE5CFCA6-76F7-4CD6-9D92-EC6E2EBCB60F}"/>
              </a:ext>
            </a:extLst>
          </p:cNvPr>
          <p:cNvPicPr>
            <a:picLocks noChangeAspect="1" noChangeArrowheads="1"/>
          </p:cNvPicPr>
          <p:nvPr/>
        </p:nvPicPr>
        <p:blipFill rotWithShape="1">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rcRect l="42377" t="34937" r="28186" b="39711"/>
          <a:stretch/>
        </p:blipFill>
        <p:spPr bwMode="auto">
          <a:xfrm>
            <a:off x="7526775" y="62773"/>
            <a:ext cx="1266629" cy="134393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grpSp>
        <p:nvGrpSpPr>
          <p:cNvPr id="18" name="Group 17">
            <a:extLst>
              <a:ext uri="{FF2B5EF4-FFF2-40B4-BE49-F238E27FC236}">
                <a16:creationId xmlns:a16="http://schemas.microsoft.com/office/drawing/2014/main" id="{2C765E60-0A7F-4E7C-96DF-4A4FACBF4106}"/>
              </a:ext>
            </a:extLst>
          </p:cNvPr>
          <p:cNvGrpSpPr/>
          <p:nvPr/>
        </p:nvGrpSpPr>
        <p:grpSpPr>
          <a:xfrm>
            <a:off x="338840" y="55930"/>
            <a:ext cx="7119667" cy="4221575"/>
            <a:chOff x="312652" y="508013"/>
            <a:chExt cx="9174596" cy="5603269"/>
          </a:xfrm>
        </p:grpSpPr>
        <p:grpSp>
          <p:nvGrpSpPr>
            <p:cNvPr id="4" name="Group 3">
              <a:extLst>
                <a:ext uri="{FF2B5EF4-FFF2-40B4-BE49-F238E27FC236}">
                  <a16:creationId xmlns:a16="http://schemas.microsoft.com/office/drawing/2014/main" id="{0F7F07A8-9FCC-40F2-B640-B0394C7B3B75}"/>
                </a:ext>
              </a:extLst>
            </p:cNvPr>
            <p:cNvGrpSpPr/>
            <p:nvPr/>
          </p:nvGrpSpPr>
          <p:grpSpPr>
            <a:xfrm>
              <a:off x="312653" y="508013"/>
              <a:ext cx="9174595" cy="2736306"/>
              <a:chOff x="279019" y="260647"/>
              <a:chExt cx="10141384" cy="3064109"/>
            </a:xfrm>
          </p:grpSpPr>
          <p:pic>
            <p:nvPicPr>
              <p:cNvPr id="5" name="Picture 2">
                <a:extLst>
                  <a:ext uri="{FF2B5EF4-FFF2-40B4-BE49-F238E27FC236}">
                    <a16:creationId xmlns:a16="http://schemas.microsoft.com/office/drawing/2014/main" id="{B93A86F4-7F8E-4EF2-9979-B2D8DE6387FB}"/>
                  </a:ext>
                </a:extLst>
              </p:cNvPr>
              <p:cNvPicPr>
                <a:picLocks noChangeAspect="1" noChangeArrowheads="1"/>
              </p:cNvPicPr>
              <p:nvPr/>
            </p:nvPicPr>
            <p:blipFill>
              <a:blip r:embed="rId4" cstate="print">
                <a:extLst>
                  <a:ext uri="{BEBA8EAE-BF5A-486C-A8C5-ECC9F3942E4B}">
                    <a14:imgProps xmlns:a14="http://schemas.microsoft.com/office/drawing/2010/main">
                      <a14:imgLayer r:embed="rId5">
                        <a14:imgEffect>
                          <a14:brightnessContrast bright="20000"/>
                        </a14:imgEffect>
                      </a14:imgLayer>
                    </a14:imgProps>
                  </a:ext>
                  <a:ext uri="{28A0092B-C50C-407E-A947-70E740481C1C}">
                    <a14:useLocalDpi xmlns:a14="http://schemas.microsoft.com/office/drawing/2010/main" val="0"/>
                  </a:ext>
                </a:extLst>
              </a:blip>
              <a:srcRect/>
              <a:stretch>
                <a:fillRect/>
              </a:stretch>
            </p:blipFill>
            <p:spPr bwMode="auto">
              <a:xfrm>
                <a:off x="3794636" y="270818"/>
                <a:ext cx="3047951" cy="3053938"/>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 name="Picture 3">
                <a:extLst>
                  <a:ext uri="{FF2B5EF4-FFF2-40B4-BE49-F238E27FC236}">
                    <a16:creationId xmlns:a16="http://schemas.microsoft.com/office/drawing/2014/main" id="{1F5B8893-AC28-42F6-84A3-FFA1D8FCF81B}"/>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279019" y="260647"/>
                <a:ext cx="3053937" cy="305393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 name="Rectangle 6">
                <a:extLst>
                  <a:ext uri="{FF2B5EF4-FFF2-40B4-BE49-F238E27FC236}">
                    <a16:creationId xmlns:a16="http://schemas.microsoft.com/office/drawing/2014/main" id="{6404AEB4-DA74-4D20-8177-CDE01A423CDF}"/>
                  </a:ext>
                </a:extLst>
              </p:cNvPr>
              <p:cNvSpPr/>
              <p:nvPr/>
            </p:nvSpPr>
            <p:spPr>
              <a:xfrm>
                <a:off x="4930351" y="270818"/>
                <a:ext cx="1912236" cy="411704"/>
              </a:xfrm>
              <a:prstGeom prst="rect">
                <a:avLst/>
              </a:prstGeom>
            </p:spPr>
            <p:txBody>
              <a:bodyPr wrap="square">
                <a:spAutoFit/>
              </a:bodyPr>
              <a:lstStyle/>
              <a:p>
                <a:pPr algn="r"/>
                <a:r>
                  <a:rPr lang="en-GB" sz="1200" dirty="0">
                    <a:solidFill>
                      <a:schemeClr val="bg1"/>
                    </a:solidFill>
                  </a:rPr>
                  <a:t>ER-Tracker™ Red</a:t>
                </a:r>
              </a:p>
            </p:txBody>
          </p:sp>
          <p:sp>
            <p:nvSpPr>
              <p:cNvPr id="8" name="Rectangle 7">
                <a:extLst>
                  <a:ext uri="{FF2B5EF4-FFF2-40B4-BE49-F238E27FC236}">
                    <a16:creationId xmlns:a16="http://schemas.microsoft.com/office/drawing/2014/main" id="{6696668A-4101-4E1C-A246-8FF0BD4C00C3}"/>
                  </a:ext>
                </a:extLst>
              </p:cNvPr>
              <p:cNvSpPr/>
              <p:nvPr/>
            </p:nvSpPr>
            <p:spPr>
              <a:xfrm>
                <a:off x="2171084" y="260647"/>
                <a:ext cx="1161873" cy="411704"/>
              </a:xfrm>
              <a:prstGeom prst="rect">
                <a:avLst/>
              </a:prstGeom>
            </p:spPr>
            <p:txBody>
              <a:bodyPr wrap="square">
                <a:spAutoFit/>
              </a:bodyPr>
              <a:lstStyle/>
              <a:p>
                <a:pPr algn="r"/>
                <a:r>
                  <a:rPr lang="en-GB" sz="1200" dirty="0">
                    <a:solidFill>
                      <a:schemeClr val="bg1"/>
                    </a:solidFill>
                  </a:rPr>
                  <a:t>AZD2014</a:t>
                </a:r>
              </a:p>
            </p:txBody>
          </p:sp>
          <p:pic>
            <p:nvPicPr>
              <p:cNvPr id="9" name="Picture 7">
                <a:extLst>
                  <a:ext uri="{FF2B5EF4-FFF2-40B4-BE49-F238E27FC236}">
                    <a16:creationId xmlns:a16="http://schemas.microsoft.com/office/drawing/2014/main" id="{9FF35396-F1B5-4603-ACD7-3D18758CE1E6}"/>
                  </a:ext>
                </a:extLst>
              </p:cNvPr>
              <p:cNvPicPr>
                <a:picLocks noChangeAspect="1" noChangeArrowheads="1"/>
              </p:cNvPicPr>
              <p:nvPr/>
            </p:nvPicPr>
            <p:blipFill>
              <a:blip r:embed="rId7" cstate="print">
                <a:extLst>
                  <a:ext uri="{BEBA8EAE-BF5A-486C-A8C5-ECC9F3942E4B}">
                    <a14:imgProps xmlns:a14="http://schemas.microsoft.com/office/drawing/2010/main">
                      <a14:imgLayer r:embed="rId8">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7367682" y="260647"/>
                <a:ext cx="3052721" cy="304376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0" name="Rectangle 9">
                <a:extLst>
                  <a:ext uri="{FF2B5EF4-FFF2-40B4-BE49-F238E27FC236}">
                    <a16:creationId xmlns:a16="http://schemas.microsoft.com/office/drawing/2014/main" id="{82305D20-2036-4FD0-9342-A565A7FC9019}"/>
                  </a:ext>
                </a:extLst>
              </p:cNvPr>
              <p:cNvSpPr/>
              <p:nvPr/>
            </p:nvSpPr>
            <p:spPr>
              <a:xfrm>
                <a:off x="8939260" y="268857"/>
                <a:ext cx="1481143" cy="276999"/>
              </a:xfrm>
              <a:prstGeom prst="rect">
                <a:avLst/>
              </a:prstGeom>
            </p:spPr>
            <p:txBody>
              <a:bodyPr wrap="square">
                <a:spAutoFit/>
              </a:bodyPr>
              <a:lstStyle/>
              <a:p>
                <a:pPr algn="r"/>
                <a:r>
                  <a:rPr lang="en-GB" sz="1200" dirty="0">
                    <a:solidFill>
                      <a:schemeClr val="bg1"/>
                    </a:solidFill>
                  </a:rPr>
                  <a:t>Merge</a:t>
                </a:r>
              </a:p>
            </p:txBody>
          </p:sp>
        </p:grpSp>
        <p:grpSp>
          <p:nvGrpSpPr>
            <p:cNvPr id="11" name="Group 10">
              <a:extLst>
                <a:ext uri="{FF2B5EF4-FFF2-40B4-BE49-F238E27FC236}">
                  <a16:creationId xmlns:a16="http://schemas.microsoft.com/office/drawing/2014/main" id="{29342C16-20A1-49EC-9B6A-F9486BD523C7}"/>
                </a:ext>
              </a:extLst>
            </p:cNvPr>
            <p:cNvGrpSpPr/>
            <p:nvPr/>
          </p:nvGrpSpPr>
          <p:grpSpPr>
            <a:xfrm>
              <a:off x="312652" y="3332017"/>
              <a:ext cx="9174596" cy="2779265"/>
              <a:chOff x="481166" y="412064"/>
              <a:chExt cx="9174596" cy="2779265"/>
            </a:xfrm>
          </p:grpSpPr>
          <p:pic>
            <p:nvPicPr>
              <p:cNvPr id="12" name="Picture 2">
                <a:extLst>
                  <a:ext uri="{FF2B5EF4-FFF2-40B4-BE49-F238E27FC236}">
                    <a16:creationId xmlns:a16="http://schemas.microsoft.com/office/drawing/2014/main" id="{87E175CE-F561-4B19-B67A-AE961697E339}"/>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81166" y="412065"/>
                <a:ext cx="2762803" cy="276821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 name="Picture 3">
                <a:extLst>
                  <a:ext uri="{FF2B5EF4-FFF2-40B4-BE49-F238E27FC236}">
                    <a16:creationId xmlns:a16="http://schemas.microsoft.com/office/drawing/2014/main" id="{5AF12734-CEB6-4431-AFC6-15172FB097FE}"/>
                  </a:ext>
                </a:extLst>
              </p:cNvPr>
              <p:cNvPicPr>
                <a:picLocks noChangeAspect="1" noChangeArrowheads="1"/>
              </p:cNvPicPr>
              <p:nvPr/>
            </p:nvPicPr>
            <p:blipFill>
              <a:blip r:embed="rId10" cstate="print">
                <a:extLst>
                  <a:ext uri="{BEBA8EAE-BF5A-486C-A8C5-ECC9F3942E4B}">
                    <a14:imgProps xmlns:a14="http://schemas.microsoft.com/office/drawing/2010/main">
                      <a14:imgLayer r:embed="rId11">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3641467" y="415718"/>
                <a:ext cx="2772901" cy="27756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4" name="Rectangle 13">
                <a:extLst>
                  <a:ext uri="{FF2B5EF4-FFF2-40B4-BE49-F238E27FC236}">
                    <a16:creationId xmlns:a16="http://schemas.microsoft.com/office/drawing/2014/main" id="{922B144F-7DCB-42AD-87F7-5283DC43272D}"/>
                  </a:ext>
                </a:extLst>
              </p:cNvPr>
              <p:cNvSpPr/>
              <p:nvPr/>
            </p:nvSpPr>
            <p:spPr>
              <a:xfrm>
                <a:off x="4768993" y="412064"/>
                <a:ext cx="1331968" cy="276999"/>
              </a:xfrm>
              <a:prstGeom prst="rect">
                <a:avLst/>
              </a:prstGeom>
            </p:spPr>
            <p:txBody>
              <a:bodyPr wrap="none">
                <a:spAutoFit/>
              </a:bodyPr>
              <a:lstStyle/>
              <a:p>
                <a:r>
                  <a:rPr lang="en-GB" sz="1200" dirty="0" err="1">
                    <a:solidFill>
                      <a:schemeClr val="bg1"/>
                    </a:solidFill>
                  </a:rPr>
                  <a:t>Lyso</a:t>
                </a:r>
                <a:r>
                  <a:rPr lang="en-GB" sz="1200" dirty="0">
                    <a:solidFill>
                      <a:schemeClr val="bg1"/>
                    </a:solidFill>
                  </a:rPr>
                  <a:t>-Tracker™ Red</a:t>
                </a:r>
              </a:p>
            </p:txBody>
          </p:sp>
          <p:sp>
            <p:nvSpPr>
              <p:cNvPr id="15" name="Rectangle 14">
                <a:extLst>
                  <a:ext uri="{FF2B5EF4-FFF2-40B4-BE49-F238E27FC236}">
                    <a16:creationId xmlns:a16="http://schemas.microsoft.com/office/drawing/2014/main" id="{12D34597-6865-4053-BC16-6BC1A0C73DEB}"/>
                  </a:ext>
                </a:extLst>
              </p:cNvPr>
              <p:cNvSpPr/>
              <p:nvPr/>
            </p:nvSpPr>
            <p:spPr>
              <a:xfrm>
                <a:off x="2273560" y="412066"/>
                <a:ext cx="755335" cy="276999"/>
              </a:xfrm>
              <a:prstGeom prst="rect">
                <a:avLst/>
              </a:prstGeom>
            </p:spPr>
            <p:txBody>
              <a:bodyPr wrap="none">
                <a:spAutoFit/>
              </a:bodyPr>
              <a:lstStyle/>
              <a:p>
                <a:r>
                  <a:rPr lang="en-GB" sz="1200" dirty="0">
                    <a:solidFill>
                      <a:schemeClr val="bg1"/>
                    </a:solidFill>
                  </a:rPr>
                  <a:t>AZD2014</a:t>
                </a:r>
              </a:p>
            </p:txBody>
          </p:sp>
          <p:pic>
            <p:nvPicPr>
              <p:cNvPr id="16" name="Picture 4">
                <a:extLst>
                  <a:ext uri="{FF2B5EF4-FFF2-40B4-BE49-F238E27FC236}">
                    <a16:creationId xmlns:a16="http://schemas.microsoft.com/office/drawing/2014/main" id="{9E681A8F-853E-49BE-AB0A-1309ADE49E2B}"/>
                  </a:ext>
                </a:extLst>
              </p:cNvPr>
              <p:cNvPicPr>
                <a:picLocks noChangeAspect="1" noChangeArrowheads="1"/>
              </p:cNvPicPr>
              <p:nvPr/>
            </p:nvPicPr>
            <p:blipFill>
              <a:blip r:embed="rId12" cstate="print">
                <a:extLst>
                  <a:ext uri="{BEBA8EAE-BF5A-486C-A8C5-ECC9F3942E4B}">
                    <a14:imgProps xmlns:a14="http://schemas.microsoft.com/office/drawing/2010/main">
                      <a14:imgLayer r:embed="rId13">
                        <a14:imgEffect>
                          <a14:brightnessContrast bright="20000" contrast="40000"/>
                        </a14:imgEffect>
                      </a14:imgLayer>
                    </a14:imgProps>
                  </a:ext>
                  <a:ext uri="{28A0092B-C50C-407E-A947-70E740481C1C}">
                    <a14:useLocalDpi xmlns:a14="http://schemas.microsoft.com/office/drawing/2010/main" val="0"/>
                  </a:ext>
                </a:extLst>
              </a:blip>
              <a:srcRect/>
              <a:stretch>
                <a:fillRect/>
              </a:stretch>
            </p:blipFill>
            <p:spPr bwMode="auto">
              <a:xfrm>
                <a:off x="6882108" y="423119"/>
                <a:ext cx="2773654" cy="276821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17" name="Rectangle 16">
                <a:extLst>
                  <a:ext uri="{FF2B5EF4-FFF2-40B4-BE49-F238E27FC236}">
                    <a16:creationId xmlns:a16="http://schemas.microsoft.com/office/drawing/2014/main" id="{306A216D-835A-4A67-9534-8310FCBFA888}"/>
                  </a:ext>
                </a:extLst>
              </p:cNvPr>
              <p:cNvSpPr/>
              <p:nvPr/>
            </p:nvSpPr>
            <p:spPr>
              <a:xfrm>
                <a:off x="8985789" y="477103"/>
                <a:ext cx="591637" cy="277000"/>
              </a:xfrm>
              <a:prstGeom prst="rect">
                <a:avLst/>
              </a:prstGeom>
            </p:spPr>
            <p:txBody>
              <a:bodyPr wrap="none">
                <a:spAutoFit/>
              </a:bodyPr>
              <a:lstStyle/>
              <a:p>
                <a:r>
                  <a:rPr lang="en-GB" sz="1200" dirty="0">
                    <a:solidFill>
                      <a:schemeClr val="bg1"/>
                    </a:solidFill>
                  </a:rPr>
                  <a:t>Merge</a:t>
                </a:r>
              </a:p>
            </p:txBody>
          </p:sp>
        </p:grpSp>
      </p:grpSp>
      <p:sp>
        <p:nvSpPr>
          <p:cNvPr id="19" name="TextBox 12">
            <a:extLst>
              <a:ext uri="{FF2B5EF4-FFF2-40B4-BE49-F238E27FC236}">
                <a16:creationId xmlns:a16="http://schemas.microsoft.com/office/drawing/2014/main" id="{AF018B52-386E-43AF-904D-36160C8181E6}"/>
              </a:ext>
            </a:extLst>
          </p:cNvPr>
          <p:cNvSpPr txBox="1"/>
          <p:nvPr/>
        </p:nvSpPr>
        <p:spPr>
          <a:xfrm>
            <a:off x="9563" y="62773"/>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20" name="TextBox 12">
            <a:extLst>
              <a:ext uri="{FF2B5EF4-FFF2-40B4-BE49-F238E27FC236}">
                <a16:creationId xmlns:a16="http://schemas.microsoft.com/office/drawing/2014/main" id="{89415982-4D64-495B-B510-6D4C5A6918CA}"/>
              </a:ext>
            </a:extLst>
          </p:cNvPr>
          <p:cNvSpPr txBox="1"/>
          <p:nvPr/>
        </p:nvSpPr>
        <p:spPr>
          <a:xfrm>
            <a:off x="2496895" y="55930"/>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21" name="TextBox 12">
            <a:extLst>
              <a:ext uri="{FF2B5EF4-FFF2-40B4-BE49-F238E27FC236}">
                <a16:creationId xmlns:a16="http://schemas.microsoft.com/office/drawing/2014/main" id="{2D316FA7-2FE8-4AC2-A61C-8FFF80A1452A}"/>
              </a:ext>
            </a:extLst>
          </p:cNvPr>
          <p:cNvSpPr txBox="1"/>
          <p:nvPr/>
        </p:nvSpPr>
        <p:spPr>
          <a:xfrm>
            <a:off x="4977701" y="55930"/>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22" name="TextBox 12">
            <a:extLst>
              <a:ext uri="{FF2B5EF4-FFF2-40B4-BE49-F238E27FC236}">
                <a16:creationId xmlns:a16="http://schemas.microsoft.com/office/drawing/2014/main" id="{44EC4A55-6901-4225-BB0D-7FA733E9F823}"/>
              </a:ext>
            </a:extLst>
          </p:cNvPr>
          <p:cNvSpPr txBox="1"/>
          <p:nvPr/>
        </p:nvSpPr>
        <p:spPr>
          <a:xfrm>
            <a:off x="4403" y="2171749"/>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
            </a:r>
            <a:endParaRPr lang="en-GB" sz="1200" dirty="0">
              <a:effectLst/>
              <a:latin typeface="Times New Roman" panose="02020603050405020304" pitchFamily="18" charset="0"/>
              <a:ea typeface="Times New Roman" panose="02020603050405020304" pitchFamily="18" charset="0"/>
            </a:endParaRPr>
          </a:p>
        </p:txBody>
      </p:sp>
      <p:sp>
        <p:nvSpPr>
          <p:cNvPr id="23" name="TextBox 12">
            <a:extLst>
              <a:ext uri="{FF2B5EF4-FFF2-40B4-BE49-F238E27FC236}">
                <a16:creationId xmlns:a16="http://schemas.microsoft.com/office/drawing/2014/main" id="{2AED7BCE-EC19-40B5-85FC-8BE80A961B27}"/>
              </a:ext>
            </a:extLst>
          </p:cNvPr>
          <p:cNvSpPr txBox="1"/>
          <p:nvPr/>
        </p:nvSpPr>
        <p:spPr>
          <a:xfrm>
            <a:off x="2511684" y="2171748"/>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a:t>
            </a:r>
            <a:endParaRPr lang="en-GB" sz="1200" dirty="0">
              <a:effectLst/>
              <a:latin typeface="Times New Roman" panose="02020603050405020304" pitchFamily="18" charset="0"/>
              <a:ea typeface="Times New Roman" panose="02020603050405020304" pitchFamily="18" charset="0"/>
            </a:endParaRPr>
          </a:p>
        </p:txBody>
      </p:sp>
      <p:sp>
        <p:nvSpPr>
          <p:cNvPr id="24" name="TextBox 12">
            <a:extLst>
              <a:ext uri="{FF2B5EF4-FFF2-40B4-BE49-F238E27FC236}">
                <a16:creationId xmlns:a16="http://schemas.microsoft.com/office/drawing/2014/main" id="{EBF80807-6D1C-4525-A6F9-02D55B2FC73F}"/>
              </a:ext>
            </a:extLst>
          </p:cNvPr>
          <p:cNvSpPr txBox="1"/>
          <p:nvPr/>
        </p:nvSpPr>
        <p:spPr>
          <a:xfrm>
            <a:off x="5018965" y="2171748"/>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a:t>
            </a:r>
            <a:endParaRPr lang="en-GB" sz="1200" dirty="0">
              <a:effectLst/>
              <a:latin typeface="Times New Roman" panose="02020603050405020304" pitchFamily="18" charset="0"/>
              <a:ea typeface="Times New Roman" panose="02020603050405020304" pitchFamily="18" charset="0"/>
            </a:endParaRPr>
          </a:p>
        </p:txBody>
      </p:sp>
      <p:sp>
        <p:nvSpPr>
          <p:cNvPr id="26" name="Rectangle 25">
            <a:extLst>
              <a:ext uri="{FF2B5EF4-FFF2-40B4-BE49-F238E27FC236}">
                <a16:creationId xmlns:a16="http://schemas.microsoft.com/office/drawing/2014/main" id="{6943FB98-C2AE-43D6-8CE4-BD3315F64F2B}"/>
              </a:ext>
            </a:extLst>
          </p:cNvPr>
          <p:cNvSpPr/>
          <p:nvPr/>
        </p:nvSpPr>
        <p:spPr>
          <a:xfrm>
            <a:off x="7782980" y="55930"/>
            <a:ext cx="1039823" cy="276999"/>
          </a:xfrm>
          <a:prstGeom prst="rect">
            <a:avLst/>
          </a:prstGeom>
        </p:spPr>
        <p:txBody>
          <a:bodyPr wrap="square">
            <a:spAutoFit/>
          </a:bodyPr>
          <a:lstStyle/>
          <a:p>
            <a:pPr algn="r"/>
            <a:r>
              <a:rPr lang="en-GB" sz="1200" dirty="0">
                <a:solidFill>
                  <a:schemeClr val="bg1"/>
                </a:solidFill>
              </a:rPr>
              <a:t>Zoom</a:t>
            </a:r>
          </a:p>
        </p:txBody>
      </p:sp>
      <p:pic>
        <p:nvPicPr>
          <p:cNvPr id="27" name="Picture 4">
            <a:extLst>
              <a:ext uri="{FF2B5EF4-FFF2-40B4-BE49-F238E27FC236}">
                <a16:creationId xmlns:a16="http://schemas.microsoft.com/office/drawing/2014/main" id="{33847E10-62BE-417D-8F6E-DB10DC66D039}"/>
              </a:ext>
            </a:extLst>
          </p:cNvPr>
          <p:cNvPicPr>
            <a:picLocks noChangeAspect="1" noChangeArrowheads="1"/>
          </p:cNvPicPr>
          <p:nvPr/>
        </p:nvPicPr>
        <p:blipFill rotWithShape="1">
          <a:blip r:embed="rId14" cstate="print">
            <a:extLst>
              <a:ext uri="{BEBA8EAE-BF5A-486C-A8C5-ECC9F3942E4B}">
                <a14:imgProps xmlns:a14="http://schemas.microsoft.com/office/drawing/2010/main">
                  <a14:imgLayer r:embed="rId15">
                    <a14:imgEffect>
                      <a14:brightnessContrast bright="20000" contrast="40000"/>
                    </a14:imgEffect>
                  </a14:imgLayer>
                </a14:imgProps>
              </a:ext>
              <a:ext uri="{28A0092B-C50C-407E-A947-70E740481C1C}">
                <a14:useLocalDpi xmlns:a14="http://schemas.microsoft.com/office/drawing/2010/main" val="0"/>
              </a:ext>
            </a:extLst>
          </a:blip>
          <a:srcRect l="51988" t="46206" r="15289" b="17357"/>
          <a:stretch/>
        </p:blipFill>
        <p:spPr bwMode="auto">
          <a:xfrm>
            <a:off x="7516652" y="2191900"/>
            <a:ext cx="1276751" cy="133240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8" name="Rectangle 27">
            <a:extLst>
              <a:ext uri="{FF2B5EF4-FFF2-40B4-BE49-F238E27FC236}">
                <a16:creationId xmlns:a16="http://schemas.microsoft.com/office/drawing/2014/main" id="{FF04B5ED-6BF6-4E37-A54F-3B6620B1B972}"/>
              </a:ext>
            </a:extLst>
          </p:cNvPr>
          <p:cNvSpPr/>
          <p:nvPr/>
        </p:nvSpPr>
        <p:spPr>
          <a:xfrm>
            <a:off x="7711740" y="2171748"/>
            <a:ext cx="1039823" cy="276999"/>
          </a:xfrm>
          <a:prstGeom prst="rect">
            <a:avLst/>
          </a:prstGeom>
        </p:spPr>
        <p:txBody>
          <a:bodyPr wrap="square">
            <a:spAutoFit/>
          </a:bodyPr>
          <a:lstStyle/>
          <a:p>
            <a:pPr algn="r"/>
            <a:r>
              <a:rPr lang="en-GB" sz="1200" dirty="0">
                <a:solidFill>
                  <a:schemeClr val="bg1"/>
                </a:solidFill>
              </a:rPr>
              <a:t>Zoom</a:t>
            </a:r>
          </a:p>
        </p:txBody>
      </p:sp>
      <p:sp>
        <p:nvSpPr>
          <p:cNvPr id="29" name="TextBox 12">
            <a:extLst>
              <a:ext uri="{FF2B5EF4-FFF2-40B4-BE49-F238E27FC236}">
                <a16:creationId xmlns:a16="http://schemas.microsoft.com/office/drawing/2014/main" id="{C1E5246D-E550-46BA-BF59-CC3B5EB41F89}"/>
              </a:ext>
            </a:extLst>
          </p:cNvPr>
          <p:cNvSpPr txBox="1"/>
          <p:nvPr/>
        </p:nvSpPr>
        <p:spPr>
          <a:xfrm>
            <a:off x="0" y="4335602"/>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G</a:t>
            </a:r>
            <a:endParaRPr lang="en-GB" sz="1200" dirty="0">
              <a:effectLst/>
              <a:latin typeface="Times New Roman" panose="02020603050405020304" pitchFamily="18" charset="0"/>
              <a:ea typeface="Times New Roman" panose="02020603050405020304" pitchFamily="18" charset="0"/>
            </a:endParaRPr>
          </a:p>
        </p:txBody>
      </p:sp>
      <p:grpSp>
        <p:nvGrpSpPr>
          <p:cNvPr id="30" name="Group 29">
            <a:extLst>
              <a:ext uri="{FF2B5EF4-FFF2-40B4-BE49-F238E27FC236}">
                <a16:creationId xmlns:a16="http://schemas.microsoft.com/office/drawing/2014/main" id="{4E982D43-0A59-4433-8262-92147442E62A}"/>
              </a:ext>
            </a:extLst>
          </p:cNvPr>
          <p:cNvGrpSpPr/>
          <p:nvPr/>
        </p:nvGrpSpPr>
        <p:grpSpPr>
          <a:xfrm>
            <a:off x="1859368" y="4370176"/>
            <a:ext cx="2241909" cy="2353353"/>
            <a:chOff x="2584300" y="679870"/>
            <a:chExt cx="3156057" cy="3130457"/>
          </a:xfrm>
        </p:grpSpPr>
        <p:pic>
          <p:nvPicPr>
            <p:cNvPr id="31" name="Picture 30">
              <a:extLst>
                <a:ext uri="{FF2B5EF4-FFF2-40B4-BE49-F238E27FC236}">
                  <a16:creationId xmlns:a16="http://schemas.microsoft.com/office/drawing/2014/main" id="{C1169AB2-0129-4500-BB9A-83E3337A4901}"/>
                </a:ext>
              </a:extLst>
            </p:cNvPr>
            <p:cNvPicPr>
              <a:picLocks noChangeAspect="1"/>
            </p:cNvPicPr>
            <p:nvPr/>
          </p:nvPicPr>
          <p:blipFill>
            <a:blip r:embed="rId16"/>
            <a:stretch>
              <a:fillRect/>
            </a:stretch>
          </p:blipFill>
          <p:spPr>
            <a:xfrm>
              <a:off x="2584300" y="679870"/>
              <a:ext cx="2831883" cy="3063364"/>
            </a:xfrm>
            <a:prstGeom prst="rect">
              <a:avLst/>
            </a:prstGeom>
          </p:spPr>
        </p:pic>
        <p:pic>
          <p:nvPicPr>
            <p:cNvPr id="32" name="Picture 31">
              <a:extLst>
                <a:ext uri="{FF2B5EF4-FFF2-40B4-BE49-F238E27FC236}">
                  <a16:creationId xmlns:a16="http://schemas.microsoft.com/office/drawing/2014/main" id="{9BC5469E-CA43-4546-9574-F48DCDF0B815}"/>
                </a:ext>
              </a:extLst>
            </p:cNvPr>
            <p:cNvPicPr>
              <a:picLocks noChangeAspect="1"/>
            </p:cNvPicPr>
            <p:nvPr/>
          </p:nvPicPr>
          <p:blipFill>
            <a:blip r:embed="rId17"/>
            <a:stretch>
              <a:fillRect/>
            </a:stretch>
          </p:blipFill>
          <p:spPr>
            <a:xfrm rot="16200000">
              <a:off x="4006372" y="2123266"/>
              <a:ext cx="3061324" cy="178606"/>
            </a:xfrm>
            <a:prstGeom prst="rect">
              <a:avLst/>
            </a:prstGeom>
          </p:spPr>
        </p:pic>
        <p:sp>
          <p:nvSpPr>
            <p:cNvPr id="33" name="TextBox 32">
              <a:extLst>
                <a:ext uri="{FF2B5EF4-FFF2-40B4-BE49-F238E27FC236}">
                  <a16:creationId xmlns:a16="http://schemas.microsoft.com/office/drawing/2014/main" id="{E582DA8E-048B-4978-91E9-C850E5BEBF80}"/>
                </a:ext>
              </a:extLst>
            </p:cNvPr>
            <p:cNvSpPr txBox="1"/>
            <p:nvPr/>
          </p:nvSpPr>
          <p:spPr>
            <a:xfrm>
              <a:off x="5333710" y="690072"/>
              <a:ext cx="406647" cy="3120255"/>
            </a:xfrm>
            <a:prstGeom prst="rect">
              <a:avLst/>
            </a:prstGeom>
            <a:noFill/>
          </p:spPr>
          <p:txBody>
            <a:bodyPr wrap="none" rtlCol="0">
              <a:spAutoFit/>
            </a:bodyPr>
            <a:lstStyle/>
            <a:p>
              <a:r>
                <a:rPr lang="en-GB" sz="1000" dirty="0">
                  <a:solidFill>
                    <a:schemeClr val="bg1"/>
                  </a:solidFill>
                </a:rPr>
                <a:t>1</a:t>
              </a: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r>
                <a:rPr lang="en-GB" sz="1000" dirty="0">
                  <a:solidFill>
                    <a:schemeClr val="bg1"/>
                  </a:solidFill>
                </a:rPr>
                <a:t>0</a:t>
              </a: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endParaRPr lang="en-GB" sz="1000" dirty="0">
                <a:solidFill>
                  <a:schemeClr val="bg1"/>
                </a:solidFill>
              </a:endParaRPr>
            </a:p>
            <a:p>
              <a:r>
                <a:rPr lang="en-GB" sz="1000" dirty="0">
                  <a:solidFill>
                    <a:schemeClr val="bg1"/>
                  </a:solidFill>
                </a:rPr>
                <a:t>-1</a:t>
              </a:r>
            </a:p>
          </p:txBody>
        </p:sp>
        <p:sp>
          <p:nvSpPr>
            <p:cNvPr id="34" name="TextBox 33">
              <a:extLst>
                <a:ext uri="{FF2B5EF4-FFF2-40B4-BE49-F238E27FC236}">
                  <a16:creationId xmlns:a16="http://schemas.microsoft.com/office/drawing/2014/main" id="{38AF3C99-3CAF-4CA0-8AD1-3BCE48AA39F1}"/>
                </a:ext>
              </a:extLst>
            </p:cNvPr>
            <p:cNvSpPr txBox="1"/>
            <p:nvPr/>
          </p:nvSpPr>
          <p:spPr>
            <a:xfrm rot="16200000">
              <a:off x="5112440" y="1508391"/>
              <a:ext cx="855065" cy="400768"/>
            </a:xfrm>
            <a:prstGeom prst="rect">
              <a:avLst/>
            </a:prstGeom>
            <a:noFill/>
          </p:spPr>
          <p:txBody>
            <a:bodyPr wrap="none" rtlCol="0">
              <a:spAutoFit/>
            </a:bodyPr>
            <a:lstStyle/>
            <a:p>
              <a:r>
                <a:rPr lang="en-GB" sz="1050" dirty="0"/>
                <a:t>nMDP</a:t>
              </a:r>
              <a:endParaRPr lang="en-GB" dirty="0"/>
            </a:p>
          </p:txBody>
        </p:sp>
      </p:grpSp>
      <p:graphicFrame>
        <p:nvGraphicFramePr>
          <p:cNvPr id="35" name="Chart 34">
            <a:extLst>
              <a:ext uri="{FF2B5EF4-FFF2-40B4-BE49-F238E27FC236}">
                <a16:creationId xmlns:a16="http://schemas.microsoft.com/office/drawing/2014/main" id="{5F398F48-BD63-4BAF-BC73-C0D66EEE71F3}"/>
              </a:ext>
            </a:extLst>
          </p:cNvPr>
          <p:cNvGraphicFramePr>
            <a:graphicFrameLocks/>
          </p:cNvGraphicFramePr>
          <p:nvPr>
            <p:extLst>
              <p:ext uri="{D42A27DB-BD31-4B8C-83A1-F6EECF244321}">
                <p14:modId xmlns:p14="http://schemas.microsoft.com/office/powerpoint/2010/main" val="1358561264"/>
              </p:ext>
            </p:extLst>
          </p:nvPr>
        </p:nvGraphicFramePr>
        <p:xfrm>
          <a:off x="4014702" y="4466621"/>
          <a:ext cx="2525557" cy="2171390"/>
        </p:xfrm>
        <a:graphic>
          <a:graphicData uri="http://schemas.openxmlformats.org/drawingml/2006/chart">
            <c:chart xmlns:c="http://schemas.openxmlformats.org/drawingml/2006/chart" xmlns:r="http://schemas.openxmlformats.org/officeDocument/2006/relationships" r:id="rId18"/>
          </a:graphicData>
        </a:graphic>
      </p:graphicFrame>
      <p:grpSp>
        <p:nvGrpSpPr>
          <p:cNvPr id="36" name="Group 35">
            <a:extLst>
              <a:ext uri="{FF2B5EF4-FFF2-40B4-BE49-F238E27FC236}">
                <a16:creationId xmlns:a16="http://schemas.microsoft.com/office/drawing/2014/main" id="{D8A70610-3243-477C-941C-9230C9915C9B}"/>
              </a:ext>
            </a:extLst>
          </p:cNvPr>
          <p:cNvGrpSpPr/>
          <p:nvPr/>
        </p:nvGrpSpPr>
        <p:grpSpPr>
          <a:xfrm>
            <a:off x="357217" y="5506983"/>
            <a:ext cx="1254977" cy="1147904"/>
            <a:chOff x="617426" y="514875"/>
            <a:chExt cx="2203938" cy="1917416"/>
          </a:xfrm>
        </p:grpSpPr>
        <p:pic>
          <p:nvPicPr>
            <p:cNvPr id="37" name="Picture 13">
              <a:extLst>
                <a:ext uri="{FF2B5EF4-FFF2-40B4-BE49-F238E27FC236}">
                  <a16:creationId xmlns:a16="http://schemas.microsoft.com/office/drawing/2014/main" id="{76809FEE-662A-4617-8353-CE255A564E47}"/>
                </a:ext>
              </a:extLst>
            </p:cNvPr>
            <p:cNvPicPr>
              <a:picLocks noChangeAspect="1" noChangeArrowheads="1"/>
            </p:cNvPicPr>
            <p:nvPr/>
          </p:nvPicPr>
          <p:blipFill>
            <a:blip r:embed="rId19" cstate="print">
              <a:extLst>
                <a:ext uri="{BEBA8EAE-BF5A-486C-A8C5-ECC9F3942E4B}">
                  <a14:imgProps xmlns:a14="http://schemas.microsoft.com/office/drawing/2010/main">
                    <a14:imgLayer r:embed="rId20">
                      <a14:imgEffect>
                        <a14:brightnessContrast bright="20000" contrast="20000"/>
                      </a14:imgEffect>
                    </a14:imgLayer>
                  </a14:imgProps>
                </a:ext>
                <a:ext uri="{28A0092B-C50C-407E-A947-70E740481C1C}">
                  <a14:useLocalDpi xmlns:a14="http://schemas.microsoft.com/office/drawing/2010/main" val="0"/>
                </a:ext>
              </a:extLst>
            </a:blip>
            <a:srcRect/>
            <a:stretch>
              <a:fillRect/>
            </a:stretch>
          </p:blipFill>
          <p:spPr bwMode="auto">
            <a:xfrm>
              <a:off x="627368" y="514875"/>
              <a:ext cx="1899299" cy="19174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8" name="TextBox 37">
              <a:extLst>
                <a:ext uri="{FF2B5EF4-FFF2-40B4-BE49-F238E27FC236}">
                  <a16:creationId xmlns:a16="http://schemas.microsoft.com/office/drawing/2014/main" id="{AC2A230D-2A48-4134-8DD5-EEDB21FA1CE0}"/>
                </a:ext>
              </a:extLst>
            </p:cNvPr>
            <p:cNvSpPr txBox="1"/>
            <p:nvPr/>
          </p:nvSpPr>
          <p:spPr>
            <a:xfrm>
              <a:off x="617426" y="526877"/>
              <a:ext cx="2203938" cy="462689"/>
            </a:xfrm>
            <a:prstGeom prst="rect">
              <a:avLst/>
            </a:prstGeom>
            <a:noFill/>
          </p:spPr>
          <p:txBody>
            <a:bodyPr wrap="square" rtlCol="0">
              <a:spAutoFit/>
            </a:bodyPr>
            <a:lstStyle/>
            <a:p>
              <a:r>
                <a:rPr lang="en-GB" sz="1200" dirty="0" err="1">
                  <a:solidFill>
                    <a:schemeClr val="bg1"/>
                  </a:solidFill>
                </a:rPr>
                <a:t>mDsRed</a:t>
              </a:r>
              <a:r>
                <a:rPr lang="en-GB" sz="1200" dirty="0">
                  <a:solidFill>
                    <a:schemeClr val="bg1"/>
                  </a:solidFill>
                </a:rPr>
                <a:t>-Rheb</a:t>
              </a:r>
              <a:endParaRPr lang="en-GB" sz="1400" dirty="0">
                <a:solidFill>
                  <a:schemeClr val="bg1"/>
                </a:solidFill>
              </a:endParaRPr>
            </a:p>
          </p:txBody>
        </p:sp>
      </p:grpSp>
      <p:grpSp>
        <p:nvGrpSpPr>
          <p:cNvPr id="39" name="Group 38">
            <a:extLst>
              <a:ext uri="{FF2B5EF4-FFF2-40B4-BE49-F238E27FC236}">
                <a16:creationId xmlns:a16="http://schemas.microsoft.com/office/drawing/2014/main" id="{DB70F202-DD1F-479B-A52F-93D107F76FFF}"/>
              </a:ext>
            </a:extLst>
          </p:cNvPr>
          <p:cNvGrpSpPr/>
          <p:nvPr/>
        </p:nvGrpSpPr>
        <p:grpSpPr>
          <a:xfrm>
            <a:off x="334808" y="4317165"/>
            <a:ext cx="1109578" cy="1147903"/>
            <a:chOff x="382252" y="483483"/>
            <a:chExt cx="2049765" cy="2012299"/>
          </a:xfrm>
        </p:grpSpPr>
        <p:pic>
          <p:nvPicPr>
            <p:cNvPr id="40" name="Picture 12">
              <a:extLst>
                <a:ext uri="{FF2B5EF4-FFF2-40B4-BE49-F238E27FC236}">
                  <a16:creationId xmlns:a16="http://schemas.microsoft.com/office/drawing/2014/main" id="{27535750-2DF1-493B-BC74-BD8E97C6950D}"/>
                </a:ext>
              </a:extLst>
            </p:cNvPr>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423649" y="483483"/>
              <a:ext cx="2008368" cy="201229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1" name="TextBox 40">
              <a:extLst>
                <a:ext uri="{FF2B5EF4-FFF2-40B4-BE49-F238E27FC236}">
                  <a16:creationId xmlns:a16="http://schemas.microsoft.com/office/drawing/2014/main" id="{E1C7252B-FC3C-4D35-B3A2-FAE14E119BCD}"/>
                </a:ext>
              </a:extLst>
            </p:cNvPr>
            <p:cNvSpPr txBox="1"/>
            <p:nvPr/>
          </p:nvSpPr>
          <p:spPr>
            <a:xfrm>
              <a:off x="382405" y="2014003"/>
              <a:ext cx="752129" cy="307776"/>
            </a:xfrm>
            <a:prstGeom prst="rect">
              <a:avLst/>
            </a:prstGeom>
            <a:noFill/>
          </p:spPr>
          <p:txBody>
            <a:bodyPr wrap="none" rtlCol="0">
              <a:spAutoFit/>
            </a:bodyPr>
            <a:lstStyle/>
            <a:p>
              <a:r>
                <a:rPr lang="en-GB" sz="1400" dirty="0">
                  <a:solidFill>
                    <a:schemeClr val="bg1"/>
                  </a:solidFill>
                </a:rPr>
                <a:t>HEK293</a:t>
              </a:r>
              <a:endParaRPr lang="en-GB" dirty="0">
                <a:solidFill>
                  <a:schemeClr val="bg1"/>
                </a:solidFill>
              </a:endParaRPr>
            </a:p>
          </p:txBody>
        </p:sp>
        <p:sp>
          <p:nvSpPr>
            <p:cNvPr id="42" name="TextBox 41">
              <a:extLst>
                <a:ext uri="{FF2B5EF4-FFF2-40B4-BE49-F238E27FC236}">
                  <a16:creationId xmlns:a16="http://schemas.microsoft.com/office/drawing/2014/main" id="{D9EEDAC2-2D68-4809-A2CB-FF2D9BE8356A}"/>
                </a:ext>
              </a:extLst>
            </p:cNvPr>
            <p:cNvSpPr txBox="1"/>
            <p:nvPr/>
          </p:nvSpPr>
          <p:spPr>
            <a:xfrm>
              <a:off x="382252" y="499201"/>
              <a:ext cx="1719027" cy="539540"/>
            </a:xfrm>
            <a:prstGeom prst="rect">
              <a:avLst/>
            </a:prstGeom>
            <a:noFill/>
          </p:spPr>
          <p:txBody>
            <a:bodyPr wrap="square" rtlCol="0">
              <a:spAutoFit/>
            </a:bodyPr>
            <a:lstStyle/>
            <a:p>
              <a:r>
                <a:rPr lang="en-GB" sz="1400" dirty="0">
                  <a:solidFill>
                    <a:schemeClr val="bg1"/>
                  </a:solidFill>
                </a:rPr>
                <a:t>AZD2014</a:t>
              </a:r>
              <a:endParaRPr lang="en-GB" dirty="0">
                <a:solidFill>
                  <a:schemeClr val="bg1"/>
                </a:solidFill>
              </a:endParaRPr>
            </a:p>
          </p:txBody>
        </p:sp>
      </p:grpSp>
      <p:sp>
        <p:nvSpPr>
          <p:cNvPr id="43" name="TextBox 12">
            <a:extLst>
              <a:ext uri="{FF2B5EF4-FFF2-40B4-BE49-F238E27FC236}">
                <a16:creationId xmlns:a16="http://schemas.microsoft.com/office/drawing/2014/main" id="{63BF28D7-81DE-49F0-9759-04DA75BF7D96}"/>
              </a:ext>
            </a:extLst>
          </p:cNvPr>
          <p:cNvSpPr txBox="1"/>
          <p:nvPr/>
        </p:nvSpPr>
        <p:spPr>
          <a:xfrm>
            <a:off x="1539720" y="4301450"/>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H</a:t>
            </a:r>
            <a:endParaRPr lang="en-GB" sz="1200" dirty="0">
              <a:effectLst/>
              <a:latin typeface="Times New Roman" panose="02020603050405020304" pitchFamily="18" charset="0"/>
              <a:ea typeface="Times New Roman" panose="02020603050405020304" pitchFamily="18" charset="0"/>
            </a:endParaRPr>
          </a:p>
        </p:txBody>
      </p:sp>
      <p:sp>
        <p:nvSpPr>
          <p:cNvPr id="44" name="TextBox 12">
            <a:extLst>
              <a:ext uri="{FF2B5EF4-FFF2-40B4-BE49-F238E27FC236}">
                <a16:creationId xmlns:a16="http://schemas.microsoft.com/office/drawing/2014/main" id="{CC26B337-F96B-4A7E-8ECD-19A465DE986C}"/>
              </a:ext>
            </a:extLst>
          </p:cNvPr>
          <p:cNvSpPr txBox="1"/>
          <p:nvPr/>
        </p:nvSpPr>
        <p:spPr>
          <a:xfrm>
            <a:off x="4183094" y="4342236"/>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I</a:t>
            </a:r>
            <a:endParaRPr lang="en-GB" sz="1200" dirty="0">
              <a:effectLst/>
              <a:latin typeface="Times New Roman" panose="02020603050405020304" pitchFamily="18" charset="0"/>
              <a:ea typeface="Times New Roman" panose="02020603050405020304" pitchFamily="18" charset="0"/>
            </a:endParaRPr>
          </a:p>
        </p:txBody>
      </p:sp>
      <p:sp>
        <p:nvSpPr>
          <p:cNvPr id="45" name="Rectangle 44">
            <a:extLst>
              <a:ext uri="{FF2B5EF4-FFF2-40B4-BE49-F238E27FC236}">
                <a16:creationId xmlns:a16="http://schemas.microsoft.com/office/drawing/2014/main" id="{422BA039-FAD4-44B7-8634-BBCA21B32852}"/>
              </a:ext>
            </a:extLst>
          </p:cNvPr>
          <p:cNvSpPr/>
          <p:nvPr/>
        </p:nvSpPr>
        <p:spPr>
          <a:xfrm>
            <a:off x="6265975" y="780509"/>
            <a:ext cx="576239" cy="555309"/>
          </a:xfrm>
          <a:prstGeom prst="rect">
            <a:avLst/>
          </a:pr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6" name="Rectangle 45">
            <a:extLst>
              <a:ext uri="{FF2B5EF4-FFF2-40B4-BE49-F238E27FC236}">
                <a16:creationId xmlns:a16="http://schemas.microsoft.com/office/drawing/2014/main" id="{74CC451A-865F-4A37-B5F6-2D93D9F942C4}"/>
              </a:ext>
            </a:extLst>
          </p:cNvPr>
          <p:cNvSpPr/>
          <p:nvPr/>
        </p:nvSpPr>
        <p:spPr>
          <a:xfrm>
            <a:off x="6382302" y="3180116"/>
            <a:ext cx="692386" cy="712922"/>
          </a:xfrm>
          <a:prstGeom prst="rect">
            <a:avLst/>
          </a:prstGeom>
          <a:noFill/>
          <a:ln>
            <a:solidFill>
              <a:srgbClr val="FFFF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a:p>
        </p:txBody>
      </p:sp>
      <p:sp>
        <p:nvSpPr>
          <p:cNvPr id="47" name="Rectangle 46">
            <a:extLst>
              <a:ext uri="{FF2B5EF4-FFF2-40B4-BE49-F238E27FC236}">
                <a16:creationId xmlns:a16="http://schemas.microsoft.com/office/drawing/2014/main" id="{E3204F22-334A-4A9F-84C1-48878D382DE6}"/>
              </a:ext>
            </a:extLst>
          </p:cNvPr>
          <p:cNvSpPr/>
          <p:nvPr/>
        </p:nvSpPr>
        <p:spPr>
          <a:xfrm>
            <a:off x="7526775" y="1442973"/>
            <a:ext cx="1266629" cy="129341"/>
          </a:xfrm>
          <a:prstGeom prst="rect">
            <a:avLst/>
          </a:prstGeom>
          <a:gradFill flip="none" rotWithShape="1">
            <a:gsLst>
              <a:gs pos="19000">
                <a:schemeClr val="bg1">
                  <a:lumMod val="95000"/>
                </a:schemeClr>
              </a:gs>
              <a:gs pos="49000">
                <a:srgbClr val="1DDCDB"/>
              </a:gs>
              <a:gs pos="100000">
                <a:srgbClr val="FF0000"/>
              </a:gs>
            </a:gsLst>
            <a:lin ang="0" scaled="1"/>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50" name="TextBox 49">
            <a:extLst>
              <a:ext uri="{FF2B5EF4-FFF2-40B4-BE49-F238E27FC236}">
                <a16:creationId xmlns:a16="http://schemas.microsoft.com/office/drawing/2014/main" id="{456B23D0-3AC8-4D59-9973-C8BE9407A5B7}"/>
              </a:ext>
            </a:extLst>
          </p:cNvPr>
          <p:cNvSpPr txBox="1"/>
          <p:nvPr/>
        </p:nvSpPr>
        <p:spPr>
          <a:xfrm>
            <a:off x="7458507" y="1603905"/>
            <a:ext cx="575799" cy="369332"/>
          </a:xfrm>
          <a:prstGeom prst="rect">
            <a:avLst/>
          </a:prstGeom>
          <a:noFill/>
        </p:spPr>
        <p:txBody>
          <a:bodyPr wrap="none" rtlCol="0">
            <a:spAutoFit/>
          </a:bodyPr>
          <a:lstStyle/>
          <a:p>
            <a:r>
              <a:rPr lang="en-GB" sz="900" dirty="0"/>
              <a:t>Strong</a:t>
            </a:r>
          </a:p>
          <a:p>
            <a:r>
              <a:rPr lang="en-GB" sz="900" dirty="0"/>
              <a:t>co-local.</a:t>
            </a:r>
          </a:p>
        </p:txBody>
      </p:sp>
      <p:sp>
        <p:nvSpPr>
          <p:cNvPr id="51" name="TextBox 50">
            <a:extLst>
              <a:ext uri="{FF2B5EF4-FFF2-40B4-BE49-F238E27FC236}">
                <a16:creationId xmlns:a16="http://schemas.microsoft.com/office/drawing/2014/main" id="{DF9A6705-3E9F-4106-9077-B653C61AC4A5}"/>
              </a:ext>
            </a:extLst>
          </p:cNvPr>
          <p:cNvSpPr txBox="1"/>
          <p:nvPr/>
        </p:nvSpPr>
        <p:spPr>
          <a:xfrm>
            <a:off x="8374028" y="1603905"/>
            <a:ext cx="575799" cy="369332"/>
          </a:xfrm>
          <a:prstGeom prst="rect">
            <a:avLst/>
          </a:prstGeom>
          <a:noFill/>
        </p:spPr>
        <p:txBody>
          <a:bodyPr wrap="none" rtlCol="0">
            <a:spAutoFit/>
          </a:bodyPr>
          <a:lstStyle/>
          <a:p>
            <a:r>
              <a:rPr lang="en-GB" sz="900" dirty="0"/>
              <a:t>Poor</a:t>
            </a:r>
          </a:p>
          <a:p>
            <a:r>
              <a:rPr lang="en-GB" sz="900" dirty="0"/>
              <a:t>co-local.</a:t>
            </a:r>
          </a:p>
        </p:txBody>
      </p:sp>
      <p:sp>
        <p:nvSpPr>
          <p:cNvPr id="52" name="Rectangle 51">
            <a:extLst>
              <a:ext uri="{FF2B5EF4-FFF2-40B4-BE49-F238E27FC236}">
                <a16:creationId xmlns:a16="http://schemas.microsoft.com/office/drawing/2014/main" id="{285A9F0A-8D58-4D22-BFDF-68201FAB4335}"/>
              </a:ext>
            </a:extLst>
          </p:cNvPr>
          <p:cNvSpPr/>
          <p:nvPr/>
        </p:nvSpPr>
        <p:spPr>
          <a:xfrm>
            <a:off x="7526775" y="3547723"/>
            <a:ext cx="1260000" cy="129341"/>
          </a:xfrm>
          <a:prstGeom prst="rect">
            <a:avLst/>
          </a:prstGeom>
          <a:gradFill flip="none" rotWithShape="1">
            <a:gsLst>
              <a:gs pos="19000">
                <a:schemeClr val="bg1">
                  <a:lumMod val="95000"/>
                </a:schemeClr>
              </a:gs>
              <a:gs pos="49000">
                <a:srgbClr val="1DDCDB"/>
              </a:gs>
              <a:gs pos="100000">
                <a:srgbClr val="FF0000"/>
              </a:gs>
            </a:gsLst>
            <a:lin ang="0" scaled="1"/>
            <a:tileRect/>
          </a:gradFill>
          <a:ln>
            <a:solidFill>
              <a:schemeClr val="tx1"/>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en-GB" dirty="0"/>
          </a:p>
        </p:txBody>
      </p:sp>
      <p:sp>
        <p:nvSpPr>
          <p:cNvPr id="53" name="TextBox 52">
            <a:extLst>
              <a:ext uri="{FF2B5EF4-FFF2-40B4-BE49-F238E27FC236}">
                <a16:creationId xmlns:a16="http://schemas.microsoft.com/office/drawing/2014/main" id="{57213526-E04B-4B26-8232-37CA496DC042}"/>
              </a:ext>
            </a:extLst>
          </p:cNvPr>
          <p:cNvSpPr txBox="1"/>
          <p:nvPr/>
        </p:nvSpPr>
        <p:spPr>
          <a:xfrm>
            <a:off x="7458507" y="3708655"/>
            <a:ext cx="575799" cy="369332"/>
          </a:xfrm>
          <a:prstGeom prst="rect">
            <a:avLst/>
          </a:prstGeom>
          <a:noFill/>
        </p:spPr>
        <p:txBody>
          <a:bodyPr wrap="none" rtlCol="0">
            <a:spAutoFit/>
          </a:bodyPr>
          <a:lstStyle/>
          <a:p>
            <a:r>
              <a:rPr lang="en-GB" sz="900" dirty="0"/>
              <a:t>Strong</a:t>
            </a:r>
          </a:p>
          <a:p>
            <a:r>
              <a:rPr lang="en-GB" sz="900" dirty="0"/>
              <a:t>co-local.</a:t>
            </a:r>
          </a:p>
        </p:txBody>
      </p:sp>
      <p:sp>
        <p:nvSpPr>
          <p:cNvPr id="54" name="TextBox 53">
            <a:extLst>
              <a:ext uri="{FF2B5EF4-FFF2-40B4-BE49-F238E27FC236}">
                <a16:creationId xmlns:a16="http://schemas.microsoft.com/office/drawing/2014/main" id="{5F7A7F53-FC41-4D2A-8A81-0F08EF4A4B77}"/>
              </a:ext>
            </a:extLst>
          </p:cNvPr>
          <p:cNvSpPr txBox="1"/>
          <p:nvPr/>
        </p:nvSpPr>
        <p:spPr>
          <a:xfrm>
            <a:off x="8374028" y="3708655"/>
            <a:ext cx="575799" cy="369332"/>
          </a:xfrm>
          <a:prstGeom prst="rect">
            <a:avLst/>
          </a:prstGeom>
          <a:noFill/>
        </p:spPr>
        <p:txBody>
          <a:bodyPr wrap="none" rtlCol="0">
            <a:spAutoFit/>
          </a:bodyPr>
          <a:lstStyle/>
          <a:p>
            <a:r>
              <a:rPr lang="en-GB" sz="900" dirty="0"/>
              <a:t>Poor</a:t>
            </a:r>
          </a:p>
          <a:p>
            <a:r>
              <a:rPr lang="en-GB" sz="900" dirty="0"/>
              <a:t>co-local.</a:t>
            </a:r>
          </a:p>
        </p:txBody>
      </p:sp>
      <p:cxnSp>
        <p:nvCxnSpPr>
          <p:cNvPr id="57" name="Straight Connector 56">
            <a:extLst>
              <a:ext uri="{FF2B5EF4-FFF2-40B4-BE49-F238E27FC236}">
                <a16:creationId xmlns:a16="http://schemas.microsoft.com/office/drawing/2014/main" id="{1510D0E0-35B3-4024-AB43-312CFAC98DF4}"/>
              </a:ext>
            </a:extLst>
          </p:cNvPr>
          <p:cNvCxnSpPr/>
          <p:nvPr/>
        </p:nvCxnSpPr>
        <p:spPr>
          <a:xfrm flipH="1">
            <a:off x="6842214" y="55930"/>
            <a:ext cx="674438" cy="724579"/>
          </a:xfrm>
          <a:prstGeom prst="line">
            <a:avLst/>
          </a:prstGeom>
          <a:ln>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58" name="Straight Connector 57">
            <a:extLst>
              <a:ext uri="{FF2B5EF4-FFF2-40B4-BE49-F238E27FC236}">
                <a16:creationId xmlns:a16="http://schemas.microsoft.com/office/drawing/2014/main" id="{5EC88514-BBF1-468F-8F19-1197ECE5682F}"/>
              </a:ext>
            </a:extLst>
          </p:cNvPr>
          <p:cNvCxnSpPr>
            <a:cxnSpLocks/>
          </p:cNvCxnSpPr>
          <p:nvPr/>
        </p:nvCxnSpPr>
        <p:spPr>
          <a:xfrm flipH="1" flipV="1">
            <a:off x="6842214" y="1335818"/>
            <a:ext cx="674438" cy="70890"/>
          </a:xfrm>
          <a:prstGeom prst="line">
            <a:avLst/>
          </a:prstGeom>
          <a:ln>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61" name="Straight Connector 60">
            <a:extLst>
              <a:ext uri="{FF2B5EF4-FFF2-40B4-BE49-F238E27FC236}">
                <a16:creationId xmlns:a16="http://schemas.microsoft.com/office/drawing/2014/main" id="{2BAFD3BC-33A1-43CF-8A88-FF973D5B7A2F}"/>
              </a:ext>
            </a:extLst>
          </p:cNvPr>
          <p:cNvCxnSpPr>
            <a:cxnSpLocks/>
          </p:cNvCxnSpPr>
          <p:nvPr/>
        </p:nvCxnSpPr>
        <p:spPr>
          <a:xfrm flipH="1">
            <a:off x="7060498" y="2209155"/>
            <a:ext cx="456154" cy="1008426"/>
          </a:xfrm>
          <a:prstGeom prst="line">
            <a:avLst/>
          </a:prstGeom>
          <a:ln>
            <a:solidFill>
              <a:srgbClr val="FFFF00"/>
            </a:solidFill>
          </a:ln>
        </p:spPr>
        <p:style>
          <a:lnRef idx="1">
            <a:schemeClr val="accent1"/>
          </a:lnRef>
          <a:fillRef idx="0">
            <a:schemeClr val="accent1"/>
          </a:fillRef>
          <a:effectRef idx="0">
            <a:schemeClr val="accent1"/>
          </a:effectRef>
          <a:fontRef idx="minor">
            <a:schemeClr val="tx1"/>
          </a:fontRef>
        </p:style>
      </p:cxnSp>
      <p:cxnSp>
        <p:nvCxnSpPr>
          <p:cNvPr id="63" name="Straight Connector 62">
            <a:extLst>
              <a:ext uri="{FF2B5EF4-FFF2-40B4-BE49-F238E27FC236}">
                <a16:creationId xmlns:a16="http://schemas.microsoft.com/office/drawing/2014/main" id="{45F81E40-D8A3-4453-915E-E03EBEF8A4F4}"/>
              </a:ext>
            </a:extLst>
          </p:cNvPr>
          <p:cNvCxnSpPr>
            <a:cxnSpLocks/>
          </p:cNvCxnSpPr>
          <p:nvPr/>
        </p:nvCxnSpPr>
        <p:spPr>
          <a:xfrm flipH="1">
            <a:off x="7074688" y="3509137"/>
            <a:ext cx="441964" cy="393124"/>
          </a:xfrm>
          <a:prstGeom prst="line">
            <a:avLst/>
          </a:prstGeom>
          <a:ln>
            <a:solidFill>
              <a:srgbClr val="FFFF00"/>
            </a:solidFill>
          </a:ln>
        </p:spPr>
        <p:style>
          <a:lnRef idx="1">
            <a:schemeClr val="accent1"/>
          </a:lnRef>
          <a:fillRef idx="0">
            <a:schemeClr val="accent1"/>
          </a:fillRef>
          <a:effectRef idx="0">
            <a:schemeClr val="accent1"/>
          </a:effectRef>
          <a:fontRef idx="minor">
            <a:schemeClr val="tx1"/>
          </a:fontRef>
        </p:style>
      </p:cxnSp>
      <p:sp>
        <p:nvSpPr>
          <p:cNvPr id="56" name="Rectangle 55">
            <a:extLst>
              <a:ext uri="{FF2B5EF4-FFF2-40B4-BE49-F238E27FC236}">
                <a16:creationId xmlns:a16="http://schemas.microsoft.com/office/drawing/2014/main" id="{52A603B8-284A-4D23-9983-990DE6D574DF}"/>
              </a:ext>
            </a:extLst>
          </p:cNvPr>
          <p:cNvSpPr/>
          <p:nvPr/>
        </p:nvSpPr>
        <p:spPr>
          <a:xfrm>
            <a:off x="6299836" y="4327005"/>
            <a:ext cx="2844164" cy="2400657"/>
          </a:xfrm>
          <a:prstGeom prst="rect">
            <a:avLst/>
          </a:prstGeom>
        </p:spPr>
        <p:txBody>
          <a:bodyPr wrap="square">
            <a:spAutoFit/>
          </a:bodyPr>
          <a:lstStyle/>
          <a:p>
            <a:pPr algn="just">
              <a:spcAft>
                <a:spcPts val="1000"/>
              </a:spcAft>
            </a:pPr>
            <a:r>
              <a:rPr lang="en-GB" sz="1000" b="1" i="1" dirty="0">
                <a:latin typeface="Arial" panose="020B0604020202020204" pitchFamily="34" charset="0"/>
                <a:ea typeface="Calibri" panose="020F0502020204030204" pitchFamily="34" charset="0"/>
                <a:cs typeface="Times New Roman" panose="02020603050405020304" pitchFamily="18" charset="0"/>
              </a:rPr>
              <a:t>Supplementary Figure </a:t>
            </a:r>
            <a:r>
              <a:rPr lang="en-GB" sz="1000" b="1" i="1" dirty="0" smtClean="0">
                <a:latin typeface="Arial" panose="020B0604020202020204" pitchFamily="34" charset="0"/>
                <a:ea typeface="Calibri" panose="020F0502020204030204" pitchFamily="34" charset="0"/>
                <a:cs typeface="Times New Roman" panose="02020603050405020304" pitchFamily="18" charset="0"/>
              </a:rPr>
              <a:t>S.3: </a:t>
            </a:r>
            <a:r>
              <a:rPr lang="en-GB" sz="1000" b="1" i="1" dirty="0">
                <a:latin typeface="Arial" panose="020B0604020202020204" pitchFamily="34" charset="0"/>
                <a:ea typeface="Calibri" panose="020F0502020204030204" pitchFamily="34" charset="0"/>
                <a:cs typeface="Times New Roman" panose="02020603050405020304" pitchFamily="18" charset="0"/>
              </a:rPr>
              <a:t>Co-localisation of AZD2014 with mTORC1 and </a:t>
            </a:r>
            <a:r>
              <a:rPr lang="en-GB" sz="1000" b="1" i="1" dirty="0" smtClean="0">
                <a:latin typeface="Arial" panose="020B0604020202020204" pitchFamily="34" charset="0"/>
                <a:ea typeface="Calibri" panose="020F0502020204030204" pitchFamily="34" charset="0"/>
                <a:cs typeface="Times New Roman" panose="02020603050405020304" pitchFamily="18" charset="0"/>
              </a:rPr>
              <a:t>ER in HEK293 cells. </a:t>
            </a:r>
            <a:r>
              <a:rPr lang="en-GB" sz="1000" i="1" dirty="0">
                <a:latin typeface="Arial" panose="020B0604020202020204" pitchFamily="34" charset="0"/>
                <a:ea typeface="Calibri" panose="020F0502020204030204" pitchFamily="34" charset="0"/>
                <a:cs typeface="Times New Roman" panose="02020603050405020304" pitchFamily="18" charset="0"/>
              </a:rPr>
              <a:t>Confocal images of A) AZD2014 (7 µM) and B) ER tracker with C) </a:t>
            </a:r>
            <a:r>
              <a:rPr lang="en-GB" sz="1000" i="1" dirty="0" smtClean="0">
                <a:latin typeface="Arial" panose="020B0604020202020204" pitchFamily="34" charset="0"/>
                <a:ea typeface="Calibri" panose="020F0502020204030204" pitchFamily="34" charset="0"/>
                <a:cs typeface="Times New Roman" panose="02020603050405020304" pitchFamily="18" charset="0"/>
              </a:rPr>
              <a:t>co-localisation merge. D) </a:t>
            </a:r>
            <a:r>
              <a:rPr lang="en-GB" sz="1000" i="1" dirty="0">
                <a:latin typeface="Arial" panose="020B0604020202020204" pitchFamily="34" charset="0"/>
                <a:ea typeface="Calibri" panose="020F0502020204030204" pitchFamily="34" charset="0"/>
                <a:cs typeface="Times New Roman" panose="02020603050405020304" pitchFamily="18" charset="0"/>
              </a:rPr>
              <a:t>AZD2014 (7 µM) and </a:t>
            </a:r>
            <a:r>
              <a:rPr lang="en-GB" sz="1000" i="1" dirty="0" smtClean="0">
                <a:latin typeface="Arial" panose="020B0604020202020204" pitchFamily="34" charset="0"/>
                <a:ea typeface="Calibri" panose="020F0502020204030204" pitchFamily="34" charset="0"/>
                <a:cs typeface="Times New Roman" panose="02020603050405020304" pitchFamily="18" charset="0"/>
              </a:rPr>
              <a:t>E) </a:t>
            </a:r>
            <a:r>
              <a:rPr lang="en-GB" sz="1000" i="1" dirty="0" err="1" smtClean="0">
                <a:latin typeface="Arial" panose="020B0604020202020204" pitchFamily="34" charset="0"/>
                <a:ea typeface="Calibri" panose="020F0502020204030204" pitchFamily="34" charset="0"/>
                <a:cs typeface="Times New Roman" panose="02020603050405020304" pitchFamily="18" charset="0"/>
              </a:rPr>
              <a:t>Lyso</a:t>
            </a:r>
            <a:r>
              <a:rPr lang="en-GB" sz="1000" i="1" dirty="0" err="1">
                <a:latin typeface="Arial" panose="020B0604020202020204" pitchFamily="34" charset="0"/>
                <a:ea typeface="Calibri" panose="020F0502020204030204" pitchFamily="34" charset="0"/>
                <a:cs typeface="Times New Roman" panose="02020603050405020304" pitchFamily="18" charset="0"/>
              </a:rPr>
              <a:t>T</a:t>
            </a:r>
            <a:r>
              <a:rPr lang="en-GB" sz="1000" i="1" dirty="0" err="1" smtClean="0">
                <a:latin typeface="Arial" panose="020B0604020202020204" pitchFamily="34" charset="0"/>
                <a:ea typeface="Calibri" panose="020F0502020204030204" pitchFamily="34" charset="0"/>
                <a:cs typeface="Times New Roman" panose="02020603050405020304" pitchFamily="18" charset="0"/>
              </a:rPr>
              <a:t>racker</a:t>
            </a:r>
            <a:r>
              <a:rPr lang="en-GB" sz="1000" i="1" dirty="0" smtClean="0">
                <a:latin typeface="Arial" panose="020B0604020202020204" pitchFamily="34" charset="0"/>
                <a:ea typeface="Calibri" panose="020F0502020204030204" pitchFamily="34" charset="0"/>
                <a:cs typeface="Times New Roman" panose="02020603050405020304" pitchFamily="18" charset="0"/>
              </a:rPr>
              <a:t> </a:t>
            </a:r>
            <a:r>
              <a:rPr lang="en-GB" sz="1000" i="1" dirty="0">
                <a:latin typeface="Arial" panose="020B0604020202020204" pitchFamily="34" charset="0"/>
                <a:ea typeface="Calibri" panose="020F0502020204030204" pitchFamily="34" charset="0"/>
                <a:cs typeface="Times New Roman" panose="02020603050405020304" pitchFamily="18" charset="0"/>
              </a:rPr>
              <a:t>with </a:t>
            </a:r>
            <a:r>
              <a:rPr lang="en-GB" sz="1000" i="1" dirty="0" smtClean="0">
                <a:latin typeface="Arial" panose="020B0604020202020204" pitchFamily="34" charset="0"/>
                <a:ea typeface="Calibri" panose="020F0502020204030204" pitchFamily="34" charset="0"/>
                <a:cs typeface="Times New Roman" panose="02020603050405020304" pitchFamily="18" charset="0"/>
              </a:rPr>
              <a:t>F) co-localisation merge. G</a:t>
            </a:r>
            <a:r>
              <a:rPr lang="en-GB" sz="1000" i="1" dirty="0">
                <a:latin typeface="Arial" panose="020B0604020202020204" pitchFamily="34" charset="0"/>
                <a:ea typeface="Calibri" panose="020F0502020204030204" pitchFamily="34" charset="0"/>
                <a:cs typeface="Times New Roman" panose="02020603050405020304" pitchFamily="18" charset="0"/>
              </a:rPr>
              <a:t>) AZD2014 (7 µM) and </a:t>
            </a:r>
            <a:r>
              <a:rPr lang="en-GB" sz="1000" i="1" dirty="0" err="1" smtClean="0">
                <a:latin typeface="Arial" panose="020B0604020202020204" pitchFamily="34" charset="0"/>
                <a:ea typeface="Calibri" panose="020F0502020204030204" pitchFamily="34" charset="0"/>
                <a:cs typeface="Times New Roman" panose="02020603050405020304" pitchFamily="18" charset="0"/>
              </a:rPr>
              <a:t>mDsRed-Rheb</a:t>
            </a:r>
            <a:r>
              <a:rPr lang="en-GB" sz="1000" i="1" dirty="0" smtClean="0">
                <a:latin typeface="Arial" panose="020B0604020202020204" pitchFamily="34" charset="0"/>
                <a:ea typeface="Calibri" panose="020F0502020204030204" pitchFamily="34" charset="0"/>
                <a:cs typeface="Times New Roman" panose="02020603050405020304" pitchFamily="18" charset="0"/>
              </a:rPr>
              <a:t>. </a:t>
            </a:r>
            <a:r>
              <a:rPr lang="en-GB" sz="1000" i="1" dirty="0">
                <a:latin typeface="Arial" panose="020B0604020202020204" pitchFamily="34" charset="0"/>
                <a:ea typeface="Calibri" panose="020F0502020204030204" pitchFamily="34" charset="0"/>
                <a:cs typeface="Times New Roman" panose="02020603050405020304" pitchFamily="18" charset="0"/>
              </a:rPr>
              <a:t>H) Co-localisation </a:t>
            </a:r>
            <a:r>
              <a:rPr lang="en-GB" sz="1000" i="1" dirty="0">
                <a:latin typeface="Arial" panose="020B0604020202020204" pitchFamily="34" charset="0"/>
                <a:ea typeface="Calibri" panose="020F0502020204030204" pitchFamily="34" charset="0"/>
                <a:cs typeface="Arial" panose="020B0604020202020204" pitchFamily="34" charset="0"/>
              </a:rPr>
              <a:t>c</a:t>
            </a:r>
            <a:r>
              <a:rPr lang="en-GB" sz="1000" i="1" dirty="0">
                <a:latin typeface="Arial" panose="020B0604020202020204" pitchFamily="34" charset="0"/>
                <a:cs typeface="Arial" panose="020B0604020202020204" pitchFamily="34" charset="0"/>
              </a:rPr>
              <a:t>olour map. Distribution of </a:t>
            </a:r>
            <a:r>
              <a:rPr lang="en-GB" sz="1000" i="1" dirty="0" err="1">
                <a:latin typeface="Arial" panose="020B0604020202020204" pitchFamily="34" charset="0"/>
                <a:cs typeface="Arial" panose="020B0604020202020204" pitchFamily="34" charset="0"/>
              </a:rPr>
              <a:t>nMDP</a:t>
            </a:r>
            <a:r>
              <a:rPr lang="en-GB" sz="1000" i="1" dirty="0">
                <a:latin typeface="Arial" panose="020B0604020202020204" pitchFamily="34" charset="0"/>
                <a:cs typeface="Arial" panose="020B0604020202020204" pitchFamily="34" charset="0"/>
              </a:rPr>
              <a:t> (normalized mean deviation product) values (ranging from -1 to 1) is visualised with a colour scale. Negative indexes are represented by cold colours (exclusion). Indexes above 0 are represented by hot colours (co-localisation). I) Respected histogram with a normal distribution (dotted)</a:t>
            </a:r>
            <a:endParaRPr lang="en-GB" sz="1000" i="1"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3119676290"/>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7" name="Chart 6">
            <a:extLst>
              <a:ext uri="{FF2B5EF4-FFF2-40B4-BE49-F238E27FC236}">
                <a16:creationId xmlns:a16="http://schemas.microsoft.com/office/drawing/2014/main" id="{80F99DAD-C54B-4598-A4A3-041CACBABA75}"/>
              </a:ext>
            </a:extLst>
          </p:cNvPr>
          <p:cNvGraphicFramePr>
            <a:graphicFrameLocks/>
          </p:cNvGraphicFramePr>
          <p:nvPr>
            <p:extLst>
              <p:ext uri="{D42A27DB-BD31-4B8C-83A1-F6EECF244321}">
                <p14:modId xmlns:p14="http://schemas.microsoft.com/office/powerpoint/2010/main" val="1732773061"/>
              </p:ext>
            </p:extLst>
          </p:nvPr>
        </p:nvGraphicFramePr>
        <p:xfrm>
          <a:off x="149087" y="21631"/>
          <a:ext cx="4112900" cy="2302629"/>
        </p:xfrm>
        <a:graphic>
          <a:graphicData uri="http://schemas.openxmlformats.org/drawingml/2006/chart">
            <c:chart xmlns:c="http://schemas.openxmlformats.org/drawingml/2006/chart" xmlns:r="http://schemas.openxmlformats.org/officeDocument/2006/relationships" r:id="rId2"/>
          </a:graphicData>
        </a:graphic>
      </p:graphicFrame>
      <p:graphicFrame>
        <p:nvGraphicFramePr>
          <p:cNvPr id="8" name="Chart 7">
            <a:extLst>
              <a:ext uri="{FF2B5EF4-FFF2-40B4-BE49-F238E27FC236}">
                <a16:creationId xmlns:a16="http://schemas.microsoft.com/office/drawing/2014/main" id="{9CFF6734-2B1F-46B5-AF69-F5862790B65F}"/>
              </a:ext>
            </a:extLst>
          </p:cNvPr>
          <p:cNvGraphicFramePr>
            <a:graphicFrameLocks/>
          </p:cNvGraphicFramePr>
          <p:nvPr>
            <p:extLst/>
          </p:nvPr>
        </p:nvGraphicFramePr>
        <p:xfrm>
          <a:off x="4733" y="2337469"/>
          <a:ext cx="2948351" cy="2199172"/>
        </p:xfrm>
        <a:graphic>
          <a:graphicData uri="http://schemas.openxmlformats.org/drawingml/2006/chart">
            <c:chart xmlns:c="http://schemas.openxmlformats.org/drawingml/2006/chart" xmlns:r="http://schemas.openxmlformats.org/officeDocument/2006/relationships" r:id="rId3"/>
          </a:graphicData>
        </a:graphic>
      </p:graphicFrame>
      <p:sp>
        <p:nvSpPr>
          <p:cNvPr id="9" name="TextBox 18">
            <a:extLst>
              <a:ext uri="{FF2B5EF4-FFF2-40B4-BE49-F238E27FC236}">
                <a16:creationId xmlns:a16="http://schemas.microsoft.com/office/drawing/2014/main" id="{B1150B2B-08BC-48DF-A5E6-29F896C69744}"/>
              </a:ext>
            </a:extLst>
          </p:cNvPr>
          <p:cNvSpPr txBox="1"/>
          <p:nvPr/>
        </p:nvSpPr>
        <p:spPr>
          <a:xfrm>
            <a:off x="0" y="8422"/>
            <a:ext cx="303348"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10" name="TextBox 20">
            <a:extLst>
              <a:ext uri="{FF2B5EF4-FFF2-40B4-BE49-F238E27FC236}">
                <a16:creationId xmlns:a16="http://schemas.microsoft.com/office/drawing/2014/main" id="{7C43CBEE-7F30-442C-9082-15FAF6A46F70}"/>
              </a:ext>
            </a:extLst>
          </p:cNvPr>
          <p:cNvSpPr txBox="1"/>
          <p:nvPr/>
        </p:nvSpPr>
        <p:spPr>
          <a:xfrm>
            <a:off x="2172" y="2331738"/>
            <a:ext cx="301176" cy="32553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6" name="TextBox 8">
            <a:extLst>
              <a:ext uri="{FF2B5EF4-FFF2-40B4-BE49-F238E27FC236}">
                <a16:creationId xmlns:a16="http://schemas.microsoft.com/office/drawing/2014/main" id="{9488E729-B7CB-46E5-A5BA-9C870CC2D19A}"/>
              </a:ext>
            </a:extLst>
          </p:cNvPr>
          <p:cNvSpPr txBox="1"/>
          <p:nvPr/>
        </p:nvSpPr>
        <p:spPr>
          <a:xfrm>
            <a:off x="2543724" y="326334"/>
            <a:ext cx="976635" cy="470235"/>
          </a:xfrm>
          <a:prstGeom prst="rect">
            <a:avLst/>
          </a:prstGeom>
          <a:solidFill>
            <a:schemeClr val="bg1"/>
          </a:solidFill>
        </p:spPr>
        <p:txBody>
          <a:bodyPr wrap="square" lIns="0" tIns="108000" bIns="0" rtlCol="0">
            <a:noAutofit/>
          </a:bodyPr>
          <a:lstStyle/>
          <a:p>
            <a:pPr>
              <a:spcAft>
                <a:spcPts val="0"/>
              </a:spcAft>
            </a:pPr>
            <a:r>
              <a:rPr lang="en-GB" sz="10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GFP </a:t>
            </a:r>
            <a:r>
              <a:rPr lang="en-GB" sz="1000" kern="1200" dirty="0" smtClean="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bsorption</a:t>
            </a:r>
            <a:endParaRPr lang="en-GB" sz="1200" dirty="0">
              <a:effectLst/>
              <a:latin typeface="Times New Roman" panose="02020603050405020304" pitchFamily="18" charset="0"/>
              <a:ea typeface="Times New Roman" panose="02020603050405020304" pitchFamily="18" charset="0"/>
            </a:endParaRPr>
          </a:p>
        </p:txBody>
      </p:sp>
      <p:grpSp>
        <p:nvGrpSpPr>
          <p:cNvPr id="11" name="Group 10">
            <a:extLst>
              <a:ext uri="{FF2B5EF4-FFF2-40B4-BE49-F238E27FC236}">
                <a16:creationId xmlns:a16="http://schemas.microsoft.com/office/drawing/2014/main" id="{2BAF9743-9BB8-46D6-B598-3849638D472E}"/>
              </a:ext>
            </a:extLst>
          </p:cNvPr>
          <p:cNvGrpSpPr/>
          <p:nvPr/>
        </p:nvGrpSpPr>
        <p:grpSpPr>
          <a:xfrm>
            <a:off x="3484563" y="27708"/>
            <a:ext cx="3983501" cy="5936217"/>
            <a:chOff x="-137278" y="0"/>
            <a:chExt cx="6977318" cy="10595924"/>
          </a:xfrm>
        </p:grpSpPr>
        <p:pic>
          <p:nvPicPr>
            <p:cNvPr id="12" name="Picture 11">
              <a:extLst>
                <a:ext uri="{FF2B5EF4-FFF2-40B4-BE49-F238E27FC236}">
                  <a16:creationId xmlns:a16="http://schemas.microsoft.com/office/drawing/2014/main" id="{104E5C9F-A2AF-4FB6-ABD7-A093676CDEAA}"/>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539606" y="9542013"/>
              <a:ext cx="1045773" cy="105391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3" name="Picture 12">
              <a:extLst>
                <a:ext uri="{FF2B5EF4-FFF2-40B4-BE49-F238E27FC236}">
                  <a16:creationId xmlns:a16="http://schemas.microsoft.com/office/drawing/2014/main" id="{EF557308-89EA-4F49-AB95-09C4EE3ACEE1}"/>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338935" y="8657728"/>
              <a:ext cx="1101542" cy="1105845"/>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4" name="Picture 13">
              <a:extLst>
                <a:ext uri="{FF2B5EF4-FFF2-40B4-BE49-F238E27FC236}">
                  <a16:creationId xmlns:a16="http://schemas.microsoft.com/office/drawing/2014/main" id="{46E9B458-C6F3-489E-8E26-A570308B1E6B}"/>
                </a:ext>
              </a:extLst>
            </p:cNvPr>
            <p:cNvPicPr>
              <a:picLocks noChangeAspect="1" noChangeArrowheads="1"/>
            </p:cNvPicPr>
            <p:nvPr/>
          </p:nvPicPr>
          <p:blipFill>
            <a:blip r:embed="rId6" cstate="print">
              <a:extLst>
                <a:ext uri="{28A0092B-C50C-407E-A947-70E740481C1C}">
                  <a14:useLocalDpi xmlns:a14="http://schemas.microsoft.com/office/drawing/2010/main" val="0"/>
                </a:ext>
              </a:extLst>
            </a:blip>
            <a:srcRect/>
            <a:stretch>
              <a:fillRect/>
            </a:stretch>
          </p:blipFill>
          <p:spPr bwMode="auto">
            <a:xfrm>
              <a:off x="1539606" y="7375956"/>
              <a:ext cx="1030817" cy="103883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5" name="Picture 14">
              <a:extLst>
                <a:ext uri="{FF2B5EF4-FFF2-40B4-BE49-F238E27FC236}">
                  <a16:creationId xmlns:a16="http://schemas.microsoft.com/office/drawing/2014/main" id="{A44BCBF9-751C-4C60-9949-F02EE23E7476}"/>
                </a:ext>
              </a:extLst>
            </p:cNvPr>
            <p:cNvPicPr>
              <a:picLocks noChangeAspect="1" noChangeArrowheads="1"/>
            </p:cNvPicPr>
            <p:nvPr/>
          </p:nvPicPr>
          <p:blipFill>
            <a:blip r:embed="rId7" cstate="print">
              <a:extLst>
                <a:ext uri="{28A0092B-C50C-407E-A947-70E740481C1C}">
                  <a14:useLocalDpi xmlns:a14="http://schemas.microsoft.com/office/drawing/2010/main" val="0"/>
                </a:ext>
              </a:extLst>
            </a:blip>
            <a:srcRect/>
            <a:stretch>
              <a:fillRect/>
            </a:stretch>
          </p:blipFill>
          <p:spPr bwMode="auto">
            <a:xfrm>
              <a:off x="364366" y="6464503"/>
              <a:ext cx="1076146" cy="109302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6" name="Picture 15">
              <a:extLst>
                <a:ext uri="{FF2B5EF4-FFF2-40B4-BE49-F238E27FC236}">
                  <a16:creationId xmlns:a16="http://schemas.microsoft.com/office/drawing/2014/main" id="{4F85361C-D69C-402B-966D-A1DE8CBB182E}"/>
                </a:ext>
              </a:extLst>
            </p:cNvPr>
            <p:cNvPicPr>
              <a:picLocks noChangeAspect="1" noChangeArrowheads="1"/>
            </p:cNvPicPr>
            <p:nvPr/>
          </p:nvPicPr>
          <p:blipFill>
            <a:blip r:embed="rId8" cstate="print">
              <a:extLst>
                <a:ext uri="{28A0092B-C50C-407E-A947-70E740481C1C}">
                  <a14:useLocalDpi xmlns:a14="http://schemas.microsoft.com/office/drawing/2010/main" val="0"/>
                </a:ext>
              </a:extLst>
            </a:blip>
            <a:srcRect/>
            <a:stretch>
              <a:fillRect/>
            </a:stretch>
          </p:blipFill>
          <p:spPr bwMode="auto">
            <a:xfrm>
              <a:off x="1494841" y="5300417"/>
              <a:ext cx="969768" cy="97355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7" name="Picture 16">
              <a:extLst>
                <a:ext uri="{FF2B5EF4-FFF2-40B4-BE49-F238E27FC236}">
                  <a16:creationId xmlns:a16="http://schemas.microsoft.com/office/drawing/2014/main" id="{97A75E5C-EA44-4962-91F5-BB222A42599C}"/>
                </a:ext>
              </a:extLst>
            </p:cNvPr>
            <p:cNvPicPr>
              <a:picLocks noChangeAspect="1" noChangeArrowheads="1"/>
            </p:cNvPicPr>
            <p:nvPr/>
          </p:nvPicPr>
          <p:blipFill>
            <a:blip r:embed="rId9" cstate="print">
              <a:extLst>
                <a:ext uri="{28A0092B-C50C-407E-A947-70E740481C1C}">
                  <a14:useLocalDpi xmlns:a14="http://schemas.microsoft.com/office/drawing/2010/main" val="0"/>
                </a:ext>
              </a:extLst>
            </a:blip>
            <a:srcRect/>
            <a:stretch>
              <a:fillRect/>
            </a:stretch>
          </p:blipFill>
          <p:spPr bwMode="auto">
            <a:xfrm>
              <a:off x="430255" y="4326861"/>
              <a:ext cx="1013613" cy="100966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8" name="Picture 17">
              <a:extLst>
                <a:ext uri="{FF2B5EF4-FFF2-40B4-BE49-F238E27FC236}">
                  <a16:creationId xmlns:a16="http://schemas.microsoft.com/office/drawing/2014/main" id="{EF1EB56C-4599-4ACD-8EC2-48AB0C647F9A}"/>
                </a:ext>
              </a:extLst>
            </p:cNvPr>
            <p:cNvPicPr>
              <a:picLocks noChangeAspect="1" noChangeArrowheads="1"/>
            </p:cNvPicPr>
            <p:nvPr/>
          </p:nvPicPr>
          <p:blipFill>
            <a:blip r:embed="rId10" cstate="print">
              <a:extLst>
                <a:ext uri="{28A0092B-C50C-407E-A947-70E740481C1C}">
                  <a14:useLocalDpi xmlns:a14="http://schemas.microsoft.com/office/drawing/2010/main" val="0"/>
                </a:ext>
              </a:extLst>
            </a:blip>
            <a:srcRect/>
            <a:stretch>
              <a:fillRect/>
            </a:stretch>
          </p:blipFill>
          <p:spPr bwMode="auto">
            <a:xfrm>
              <a:off x="2722778" y="4326861"/>
              <a:ext cx="1941725" cy="190511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19" name="Picture 18">
              <a:extLst>
                <a:ext uri="{FF2B5EF4-FFF2-40B4-BE49-F238E27FC236}">
                  <a16:creationId xmlns:a16="http://schemas.microsoft.com/office/drawing/2014/main" id="{EEBF3B2D-5ACA-4E41-89CA-BFDC5D13F027}"/>
                </a:ext>
              </a:extLst>
            </p:cNvPr>
            <p:cNvPicPr>
              <a:picLocks noChangeAspect="1" noChangeArrowheads="1"/>
            </p:cNvPicPr>
            <p:nvPr/>
          </p:nvPicPr>
          <p:blipFill>
            <a:blip r:embed="rId11">
              <a:extLst>
                <a:ext uri="{28A0092B-C50C-407E-A947-70E740481C1C}">
                  <a14:useLocalDpi xmlns:a14="http://schemas.microsoft.com/office/drawing/2010/main" val="0"/>
                </a:ext>
              </a:extLst>
            </a:blip>
            <a:srcRect/>
            <a:stretch>
              <a:fillRect/>
            </a:stretch>
          </p:blipFill>
          <p:spPr bwMode="auto">
            <a:xfrm>
              <a:off x="482986" y="33776"/>
              <a:ext cx="1957349" cy="194973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0" name="TextBox 4">
              <a:extLst>
                <a:ext uri="{FF2B5EF4-FFF2-40B4-BE49-F238E27FC236}">
                  <a16:creationId xmlns:a16="http://schemas.microsoft.com/office/drawing/2014/main" id="{3EA789DD-4EFF-4EA1-94FD-1D8F76D98593}"/>
                </a:ext>
              </a:extLst>
            </p:cNvPr>
            <p:cNvSpPr txBox="1"/>
            <p:nvPr/>
          </p:nvSpPr>
          <p:spPr>
            <a:xfrm>
              <a:off x="190760" y="33775"/>
              <a:ext cx="274434" cy="276999"/>
            </a:xfrm>
            <a:prstGeom prst="rect">
              <a:avLst/>
            </a:prstGeom>
            <a:noFill/>
          </p:spPr>
          <p:txBody>
            <a:bodyPr wrap="square" rtlCol="0">
              <a:noAutofit/>
            </a:bodyPr>
            <a:lstStyle/>
            <a:p>
              <a:pPr>
                <a:spcAft>
                  <a:spcPts val="0"/>
                </a:spcAft>
              </a:pPr>
              <a:r>
                <a:rPr lang="en-GB" sz="10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a:t>
              </a:r>
              <a:endParaRPr lang="en-GB" sz="1000" dirty="0">
                <a:effectLst/>
                <a:latin typeface="Times New Roman" panose="02020603050405020304" pitchFamily="18" charset="0"/>
                <a:ea typeface="Times New Roman" panose="02020603050405020304" pitchFamily="18" charset="0"/>
              </a:endParaRPr>
            </a:p>
          </p:txBody>
        </p:sp>
        <p:sp>
          <p:nvSpPr>
            <p:cNvPr id="21" name="TextBox 5">
              <a:extLst>
                <a:ext uri="{FF2B5EF4-FFF2-40B4-BE49-F238E27FC236}">
                  <a16:creationId xmlns:a16="http://schemas.microsoft.com/office/drawing/2014/main" id="{D0275484-E66B-4A0C-864C-BE5564FFDF41}"/>
                </a:ext>
              </a:extLst>
            </p:cNvPr>
            <p:cNvSpPr txBox="1"/>
            <p:nvPr/>
          </p:nvSpPr>
          <p:spPr>
            <a:xfrm>
              <a:off x="471880" y="1626734"/>
              <a:ext cx="1067534" cy="356593"/>
            </a:xfrm>
            <a:prstGeom prst="rect">
              <a:avLst/>
            </a:prstGeom>
            <a:noFill/>
          </p:spPr>
          <p:txBody>
            <a:bodyPr wrap="square" rtlCol="0">
              <a:noAutofit/>
            </a:bodyPr>
            <a:lstStyle/>
            <a:p>
              <a:pPr>
                <a:spcAft>
                  <a:spcPts val="0"/>
                </a:spcAft>
              </a:pPr>
              <a:r>
                <a:rPr lang="en-GB" sz="1000" b="1"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HEK293</a:t>
              </a:r>
              <a:endParaRPr lang="en-GB" sz="1000">
                <a:effectLst/>
                <a:latin typeface="Times New Roman" panose="02020603050405020304" pitchFamily="18" charset="0"/>
                <a:ea typeface="Times New Roman" panose="02020603050405020304" pitchFamily="18" charset="0"/>
              </a:endParaRPr>
            </a:p>
          </p:txBody>
        </p:sp>
        <p:sp>
          <p:nvSpPr>
            <p:cNvPr id="22" name="TextBox 7">
              <a:extLst>
                <a:ext uri="{FF2B5EF4-FFF2-40B4-BE49-F238E27FC236}">
                  <a16:creationId xmlns:a16="http://schemas.microsoft.com/office/drawing/2014/main" id="{77022819-E272-4F94-8E79-4F296B061C18}"/>
                </a:ext>
              </a:extLst>
            </p:cNvPr>
            <p:cNvSpPr txBox="1"/>
            <p:nvPr/>
          </p:nvSpPr>
          <p:spPr>
            <a:xfrm>
              <a:off x="482935" y="33771"/>
              <a:ext cx="1433980" cy="356593"/>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AZD2014</a:t>
              </a:r>
              <a:endParaRPr lang="en-GB" sz="1000" dirty="0">
                <a:effectLst/>
                <a:latin typeface="Times New Roman" panose="02020603050405020304" pitchFamily="18" charset="0"/>
                <a:ea typeface="Times New Roman" panose="02020603050405020304" pitchFamily="18" charset="0"/>
              </a:endParaRPr>
            </a:p>
          </p:txBody>
        </p:sp>
        <p:pic>
          <p:nvPicPr>
            <p:cNvPr id="23" name="Picture 22">
              <a:extLst>
                <a:ext uri="{FF2B5EF4-FFF2-40B4-BE49-F238E27FC236}">
                  <a16:creationId xmlns:a16="http://schemas.microsoft.com/office/drawing/2014/main" id="{D4A92830-BF5A-45AF-AE7A-142D91185611}"/>
                </a:ext>
              </a:extLst>
            </p:cNvPr>
            <p:cNvPicPr>
              <a:picLocks noChangeAspect="1" noChangeArrowheads="1"/>
            </p:cNvPicPr>
            <p:nvPr/>
          </p:nvPicPr>
          <p:blipFill>
            <a:blip r:embed="rId12" cstate="print">
              <a:extLst>
                <a:ext uri="{28A0092B-C50C-407E-A947-70E740481C1C}">
                  <a14:useLocalDpi xmlns:a14="http://schemas.microsoft.com/office/drawing/2010/main" val="0"/>
                </a:ext>
              </a:extLst>
            </a:blip>
            <a:srcRect/>
            <a:stretch>
              <a:fillRect/>
            </a:stretch>
          </p:blipFill>
          <p:spPr bwMode="auto">
            <a:xfrm>
              <a:off x="2714769" y="16887"/>
              <a:ext cx="1949734" cy="1949734"/>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4" name="Picture 23">
              <a:extLst>
                <a:ext uri="{FF2B5EF4-FFF2-40B4-BE49-F238E27FC236}">
                  <a16:creationId xmlns:a16="http://schemas.microsoft.com/office/drawing/2014/main" id="{1D95B719-1223-4AF6-842A-9F6D3102EB01}"/>
                </a:ext>
              </a:extLst>
            </p:cNvPr>
            <p:cNvPicPr>
              <a:picLocks noChangeAspect="1" noChangeArrowheads="1"/>
            </p:cNvPicPr>
            <p:nvPr/>
          </p:nvPicPr>
          <p:blipFill>
            <a:blip r:embed="rId13">
              <a:extLst>
                <a:ext uri="{28A0092B-C50C-407E-A947-70E740481C1C}">
                  <a14:useLocalDpi xmlns:a14="http://schemas.microsoft.com/office/drawing/2010/main" val="0"/>
                </a:ext>
              </a:extLst>
            </a:blip>
            <a:srcRect/>
            <a:stretch>
              <a:fillRect/>
            </a:stretch>
          </p:blipFill>
          <p:spPr bwMode="auto">
            <a:xfrm>
              <a:off x="4917561" y="0"/>
              <a:ext cx="1922478" cy="1983509"/>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5" name="TextBox 11">
              <a:extLst>
                <a:ext uri="{FF2B5EF4-FFF2-40B4-BE49-F238E27FC236}">
                  <a16:creationId xmlns:a16="http://schemas.microsoft.com/office/drawing/2014/main" id="{BE8AC639-D7B1-4DE4-B80B-E682DCA48762}"/>
                </a:ext>
              </a:extLst>
            </p:cNvPr>
            <p:cNvSpPr txBox="1"/>
            <p:nvPr/>
          </p:nvSpPr>
          <p:spPr>
            <a:xfrm>
              <a:off x="2449763" y="27543"/>
              <a:ext cx="266065" cy="304431"/>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2</a:t>
              </a:r>
              <a:endParaRPr lang="en-GB" sz="1000" dirty="0">
                <a:effectLst/>
                <a:latin typeface="Times New Roman" panose="02020603050405020304" pitchFamily="18" charset="0"/>
                <a:ea typeface="Times New Roman" panose="02020603050405020304" pitchFamily="18" charset="0"/>
              </a:endParaRPr>
            </a:p>
          </p:txBody>
        </p:sp>
        <p:sp>
          <p:nvSpPr>
            <p:cNvPr id="26" name="TextBox 12">
              <a:extLst>
                <a:ext uri="{FF2B5EF4-FFF2-40B4-BE49-F238E27FC236}">
                  <a16:creationId xmlns:a16="http://schemas.microsoft.com/office/drawing/2014/main" id="{5616DE52-FE95-48E1-ADF4-1DA69FC5ED00}"/>
                </a:ext>
              </a:extLst>
            </p:cNvPr>
            <p:cNvSpPr txBox="1"/>
            <p:nvPr/>
          </p:nvSpPr>
          <p:spPr>
            <a:xfrm>
              <a:off x="4664006" y="33771"/>
              <a:ext cx="264160" cy="325120"/>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3</a:t>
              </a:r>
              <a:endParaRPr lang="en-GB" sz="1000" dirty="0">
                <a:effectLst/>
                <a:latin typeface="Times New Roman" panose="02020603050405020304" pitchFamily="18" charset="0"/>
                <a:ea typeface="Times New Roman" panose="02020603050405020304" pitchFamily="18" charset="0"/>
              </a:endParaRPr>
            </a:p>
          </p:txBody>
        </p:sp>
        <p:pic>
          <p:nvPicPr>
            <p:cNvPr id="27" name="Picture 26">
              <a:extLst>
                <a:ext uri="{FF2B5EF4-FFF2-40B4-BE49-F238E27FC236}">
                  <a16:creationId xmlns:a16="http://schemas.microsoft.com/office/drawing/2014/main" id="{DFE90B69-A36B-4B4D-9B5B-58782ADC90BC}"/>
                </a:ext>
              </a:extLst>
            </p:cNvPr>
            <p:cNvPicPr>
              <a:picLocks noChangeAspect="1" noChangeArrowheads="1"/>
            </p:cNvPicPr>
            <p:nvPr/>
          </p:nvPicPr>
          <p:blipFill>
            <a:blip r:embed="rId14" cstate="print">
              <a:extLst>
                <a:ext uri="{28A0092B-C50C-407E-A947-70E740481C1C}">
                  <a14:useLocalDpi xmlns:a14="http://schemas.microsoft.com/office/drawing/2010/main" val="0"/>
                </a:ext>
              </a:extLst>
            </a:blip>
            <a:srcRect/>
            <a:stretch>
              <a:fillRect/>
            </a:stretch>
          </p:blipFill>
          <p:spPr bwMode="auto">
            <a:xfrm>
              <a:off x="2714770" y="2200903"/>
              <a:ext cx="1949734" cy="195596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28" name="Picture 27">
              <a:extLst>
                <a:ext uri="{FF2B5EF4-FFF2-40B4-BE49-F238E27FC236}">
                  <a16:creationId xmlns:a16="http://schemas.microsoft.com/office/drawing/2014/main" id="{D80EDFC2-B82F-4EC0-817C-F2E3B27A70DE}"/>
                </a:ext>
              </a:extLst>
            </p:cNvPr>
            <p:cNvPicPr>
              <a:picLocks noChangeAspect="1" noChangeArrowheads="1"/>
            </p:cNvPicPr>
            <p:nvPr/>
          </p:nvPicPr>
          <p:blipFill>
            <a:blip r:embed="rId15">
              <a:extLst>
                <a:ext uri="{28A0092B-C50C-407E-A947-70E740481C1C}">
                  <a14:useLocalDpi xmlns:a14="http://schemas.microsoft.com/office/drawing/2010/main" val="0"/>
                </a:ext>
              </a:extLst>
            </a:blip>
            <a:srcRect/>
            <a:stretch>
              <a:fillRect/>
            </a:stretch>
          </p:blipFill>
          <p:spPr bwMode="auto">
            <a:xfrm>
              <a:off x="4917562" y="2206198"/>
              <a:ext cx="1922478" cy="197333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29" name="TextBox 28">
              <a:extLst>
                <a:ext uri="{FF2B5EF4-FFF2-40B4-BE49-F238E27FC236}">
                  <a16:creationId xmlns:a16="http://schemas.microsoft.com/office/drawing/2014/main" id="{0DF56913-8A2A-4F70-8768-4111F5874068}"/>
                </a:ext>
              </a:extLst>
            </p:cNvPr>
            <p:cNvSpPr txBox="1"/>
            <p:nvPr/>
          </p:nvSpPr>
          <p:spPr>
            <a:xfrm>
              <a:off x="2722668" y="2206089"/>
              <a:ext cx="1244478" cy="297973"/>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1000" dirty="0">
                <a:effectLst/>
                <a:latin typeface="Times New Roman" panose="02020603050405020304" pitchFamily="18" charset="0"/>
                <a:ea typeface="Times New Roman" panose="02020603050405020304" pitchFamily="18" charset="0"/>
              </a:endParaRPr>
            </a:p>
          </p:txBody>
        </p:sp>
        <p:pic>
          <p:nvPicPr>
            <p:cNvPr id="30" name="Picture 29">
              <a:extLst>
                <a:ext uri="{FF2B5EF4-FFF2-40B4-BE49-F238E27FC236}">
                  <a16:creationId xmlns:a16="http://schemas.microsoft.com/office/drawing/2014/main" id="{412F6DED-30BC-4437-90D2-26CA5644CA29}"/>
                </a:ext>
              </a:extLst>
            </p:cNvPr>
            <p:cNvPicPr>
              <a:picLocks noChangeAspect="1" noChangeArrowheads="1"/>
            </p:cNvPicPr>
            <p:nvPr/>
          </p:nvPicPr>
          <p:blipFill>
            <a:blip r:embed="rId16" cstate="print">
              <a:extLst>
                <a:ext uri="{28A0092B-C50C-407E-A947-70E740481C1C}">
                  <a14:useLocalDpi xmlns:a14="http://schemas.microsoft.com/office/drawing/2010/main" val="0"/>
                </a:ext>
              </a:extLst>
            </a:blip>
            <a:srcRect/>
            <a:stretch>
              <a:fillRect/>
            </a:stretch>
          </p:blipFill>
          <p:spPr bwMode="auto">
            <a:xfrm>
              <a:off x="482986" y="2200903"/>
              <a:ext cx="981786" cy="977981"/>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31" name="Picture 30">
              <a:extLst>
                <a:ext uri="{FF2B5EF4-FFF2-40B4-BE49-F238E27FC236}">
                  <a16:creationId xmlns:a16="http://schemas.microsoft.com/office/drawing/2014/main" id="{C2C9BF2D-5CE1-46CD-9B5E-60A18E557EE0}"/>
                </a:ext>
              </a:extLst>
            </p:cNvPr>
            <p:cNvPicPr>
              <a:picLocks noChangeAspect="1" noChangeArrowheads="1"/>
            </p:cNvPicPr>
            <p:nvPr/>
          </p:nvPicPr>
          <p:blipFill>
            <a:blip r:embed="rId17" cstate="print">
              <a:extLst>
                <a:ext uri="{28A0092B-C50C-407E-A947-70E740481C1C}">
                  <a14:useLocalDpi xmlns:a14="http://schemas.microsoft.com/office/drawing/2010/main" val="0"/>
                </a:ext>
              </a:extLst>
            </a:blip>
            <a:srcRect/>
            <a:stretch>
              <a:fillRect/>
            </a:stretch>
          </p:blipFill>
          <p:spPr bwMode="auto">
            <a:xfrm>
              <a:off x="1464772" y="3178884"/>
              <a:ext cx="964000" cy="96400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32" name="TextBox 31">
              <a:extLst>
                <a:ext uri="{FF2B5EF4-FFF2-40B4-BE49-F238E27FC236}">
                  <a16:creationId xmlns:a16="http://schemas.microsoft.com/office/drawing/2014/main" id="{FEFAB85A-6BD5-41AF-9E44-C1E735D50F16}"/>
                </a:ext>
              </a:extLst>
            </p:cNvPr>
            <p:cNvSpPr txBox="1"/>
            <p:nvPr/>
          </p:nvSpPr>
          <p:spPr>
            <a:xfrm>
              <a:off x="156079" y="2099740"/>
              <a:ext cx="279243" cy="317677"/>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4</a:t>
              </a:r>
              <a:endParaRPr lang="en-GB" sz="1000" dirty="0">
                <a:effectLst/>
                <a:latin typeface="Times New Roman" panose="02020603050405020304" pitchFamily="18" charset="0"/>
                <a:ea typeface="Times New Roman" panose="02020603050405020304" pitchFamily="18" charset="0"/>
              </a:endParaRPr>
            </a:p>
          </p:txBody>
        </p:sp>
        <p:sp>
          <p:nvSpPr>
            <p:cNvPr id="33" name="TextBox 32">
              <a:extLst>
                <a:ext uri="{FF2B5EF4-FFF2-40B4-BE49-F238E27FC236}">
                  <a16:creationId xmlns:a16="http://schemas.microsoft.com/office/drawing/2014/main" id="{3180B134-8A02-4FC5-B047-06A83EE4317F}"/>
                </a:ext>
              </a:extLst>
            </p:cNvPr>
            <p:cNvSpPr txBox="1"/>
            <p:nvPr/>
          </p:nvSpPr>
          <p:spPr>
            <a:xfrm>
              <a:off x="2457139" y="2194563"/>
              <a:ext cx="260008" cy="326650"/>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5</a:t>
              </a:r>
              <a:endParaRPr lang="en-GB" sz="1000" dirty="0">
                <a:effectLst/>
                <a:latin typeface="Times New Roman" panose="02020603050405020304" pitchFamily="18" charset="0"/>
                <a:ea typeface="Times New Roman" panose="02020603050405020304" pitchFamily="18" charset="0"/>
              </a:endParaRPr>
            </a:p>
          </p:txBody>
        </p:sp>
        <p:sp>
          <p:nvSpPr>
            <p:cNvPr id="34" name="TextBox 33">
              <a:extLst>
                <a:ext uri="{FF2B5EF4-FFF2-40B4-BE49-F238E27FC236}">
                  <a16:creationId xmlns:a16="http://schemas.microsoft.com/office/drawing/2014/main" id="{9D322013-DEE7-4842-8674-257D3D014162}"/>
                </a:ext>
              </a:extLst>
            </p:cNvPr>
            <p:cNvSpPr txBox="1"/>
            <p:nvPr/>
          </p:nvSpPr>
          <p:spPr>
            <a:xfrm>
              <a:off x="4673934" y="2208463"/>
              <a:ext cx="255199" cy="366583"/>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6</a:t>
              </a:r>
              <a:endParaRPr lang="en-GB" sz="1000" dirty="0">
                <a:effectLst/>
                <a:latin typeface="Times New Roman" panose="02020603050405020304" pitchFamily="18" charset="0"/>
                <a:ea typeface="Times New Roman" panose="02020603050405020304" pitchFamily="18" charset="0"/>
              </a:endParaRPr>
            </a:p>
          </p:txBody>
        </p:sp>
        <p:sp>
          <p:nvSpPr>
            <p:cNvPr id="35" name="TextBox 34">
              <a:extLst>
                <a:ext uri="{FF2B5EF4-FFF2-40B4-BE49-F238E27FC236}">
                  <a16:creationId xmlns:a16="http://schemas.microsoft.com/office/drawing/2014/main" id="{E11164A1-AE2B-4CF0-B6CB-9D333B0D7842}"/>
                </a:ext>
              </a:extLst>
            </p:cNvPr>
            <p:cNvSpPr txBox="1"/>
            <p:nvPr/>
          </p:nvSpPr>
          <p:spPr>
            <a:xfrm>
              <a:off x="2704505" y="16888"/>
              <a:ext cx="1048621" cy="350945"/>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1000" dirty="0">
                <a:effectLst/>
                <a:latin typeface="Times New Roman" panose="02020603050405020304" pitchFamily="18" charset="0"/>
                <a:ea typeface="Times New Roman" panose="02020603050405020304" pitchFamily="18" charset="0"/>
              </a:endParaRPr>
            </a:p>
          </p:txBody>
        </p:sp>
        <p:sp>
          <p:nvSpPr>
            <p:cNvPr id="36" name="TextBox 35">
              <a:extLst>
                <a:ext uri="{FF2B5EF4-FFF2-40B4-BE49-F238E27FC236}">
                  <a16:creationId xmlns:a16="http://schemas.microsoft.com/office/drawing/2014/main" id="{5BD64AEB-E3E7-4E82-A1CE-5A3E8C491B9B}"/>
                </a:ext>
              </a:extLst>
            </p:cNvPr>
            <p:cNvSpPr txBox="1"/>
            <p:nvPr/>
          </p:nvSpPr>
          <p:spPr>
            <a:xfrm>
              <a:off x="471920" y="2194497"/>
              <a:ext cx="850900" cy="573853"/>
            </a:xfrm>
            <a:prstGeom prst="rect">
              <a:avLst/>
            </a:prstGeom>
            <a:noFill/>
          </p:spPr>
          <p:txBody>
            <a:bodyPr wrap="square" rtlCol="0">
              <a:noAutofit/>
            </a:bodyPr>
            <a:lstStyle/>
            <a:p>
              <a:pPr>
                <a:spcAft>
                  <a:spcPts val="0"/>
                </a:spcAft>
              </a:pPr>
              <a:r>
                <a:rPr lang="en-GB" sz="10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EGFP-S6K1</a:t>
              </a:r>
              <a:endParaRPr lang="en-GB" sz="1000">
                <a:effectLst/>
                <a:latin typeface="Times New Roman" panose="02020603050405020304" pitchFamily="18" charset="0"/>
                <a:ea typeface="Times New Roman" panose="02020603050405020304" pitchFamily="18" charset="0"/>
              </a:endParaRPr>
            </a:p>
          </p:txBody>
        </p:sp>
        <p:sp>
          <p:nvSpPr>
            <p:cNvPr id="37" name="TextBox 36">
              <a:extLst>
                <a:ext uri="{FF2B5EF4-FFF2-40B4-BE49-F238E27FC236}">
                  <a16:creationId xmlns:a16="http://schemas.microsoft.com/office/drawing/2014/main" id="{8FAEF5AD-BACA-4B31-884A-E47BD93D6F89}"/>
                </a:ext>
              </a:extLst>
            </p:cNvPr>
            <p:cNvSpPr txBox="1"/>
            <p:nvPr/>
          </p:nvSpPr>
          <p:spPr>
            <a:xfrm>
              <a:off x="1391417" y="3155471"/>
              <a:ext cx="1176614" cy="274193"/>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AZD2014</a:t>
              </a:r>
              <a:endParaRPr lang="en-GB" sz="1000" dirty="0">
                <a:effectLst/>
                <a:latin typeface="Times New Roman" panose="02020603050405020304" pitchFamily="18" charset="0"/>
                <a:ea typeface="Times New Roman" panose="02020603050405020304" pitchFamily="18" charset="0"/>
              </a:endParaRPr>
            </a:p>
          </p:txBody>
        </p:sp>
        <p:sp>
          <p:nvSpPr>
            <p:cNvPr id="39" name="TextBox 33">
              <a:extLst>
                <a:ext uri="{FF2B5EF4-FFF2-40B4-BE49-F238E27FC236}">
                  <a16:creationId xmlns:a16="http://schemas.microsoft.com/office/drawing/2014/main" id="{FC458926-819E-412F-BA9F-55EF434E8119}"/>
                </a:ext>
              </a:extLst>
            </p:cNvPr>
            <p:cNvSpPr txBox="1"/>
            <p:nvPr/>
          </p:nvSpPr>
          <p:spPr>
            <a:xfrm>
              <a:off x="2445918" y="4257453"/>
              <a:ext cx="282450" cy="331872"/>
            </a:xfrm>
            <a:prstGeom prst="rect">
              <a:avLst/>
            </a:prstGeom>
            <a:noFill/>
          </p:spPr>
          <p:txBody>
            <a:bodyPr wrap="square" rtlCol="0">
              <a:noAutofit/>
            </a:bodyPr>
            <a:lstStyle/>
            <a:p>
              <a:pPr>
                <a:spcAft>
                  <a:spcPts val="0"/>
                </a:spcAft>
              </a:pPr>
              <a:r>
                <a:rPr lang="en-GB" sz="10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8</a:t>
              </a:r>
              <a:endParaRPr lang="en-GB" sz="1000" dirty="0">
                <a:effectLst/>
                <a:latin typeface="Times New Roman" panose="02020603050405020304" pitchFamily="18" charset="0"/>
                <a:ea typeface="Times New Roman" panose="02020603050405020304" pitchFamily="18" charset="0"/>
              </a:endParaRPr>
            </a:p>
          </p:txBody>
        </p:sp>
        <p:sp>
          <p:nvSpPr>
            <p:cNvPr id="40" name="TextBox 36">
              <a:extLst>
                <a:ext uri="{FF2B5EF4-FFF2-40B4-BE49-F238E27FC236}">
                  <a16:creationId xmlns:a16="http://schemas.microsoft.com/office/drawing/2014/main" id="{96F87995-EEC4-49A7-B184-4EA310FA4D60}"/>
                </a:ext>
              </a:extLst>
            </p:cNvPr>
            <p:cNvSpPr txBox="1"/>
            <p:nvPr/>
          </p:nvSpPr>
          <p:spPr>
            <a:xfrm>
              <a:off x="4705995" y="4307709"/>
              <a:ext cx="223137" cy="352402"/>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9</a:t>
              </a:r>
              <a:endParaRPr lang="en-GB" sz="1000" dirty="0">
                <a:effectLst/>
                <a:latin typeface="Times New Roman" panose="02020603050405020304" pitchFamily="18" charset="0"/>
                <a:ea typeface="Times New Roman" panose="02020603050405020304" pitchFamily="18" charset="0"/>
              </a:endParaRPr>
            </a:p>
          </p:txBody>
        </p:sp>
        <p:sp>
          <p:nvSpPr>
            <p:cNvPr id="41" name="TextBox 39">
              <a:extLst>
                <a:ext uri="{FF2B5EF4-FFF2-40B4-BE49-F238E27FC236}">
                  <a16:creationId xmlns:a16="http://schemas.microsoft.com/office/drawing/2014/main" id="{66AF56D2-F5F5-432E-8C39-527E1D6D3286}"/>
                </a:ext>
              </a:extLst>
            </p:cNvPr>
            <p:cNvSpPr txBox="1"/>
            <p:nvPr/>
          </p:nvSpPr>
          <p:spPr>
            <a:xfrm>
              <a:off x="347422" y="4280690"/>
              <a:ext cx="866140" cy="642313"/>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EGFP-</a:t>
              </a:r>
              <a:r>
                <a:rPr lang="en-GB" sz="1000" kern="1200" dirty="0" err="1">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Rheb</a:t>
              </a:r>
              <a:endParaRPr lang="en-GB" sz="1000" dirty="0">
                <a:effectLst/>
                <a:latin typeface="Times New Roman" panose="02020603050405020304" pitchFamily="18" charset="0"/>
                <a:ea typeface="Times New Roman" panose="02020603050405020304" pitchFamily="18" charset="0"/>
              </a:endParaRPr>
            </a:p>
          </p:txBody>
        </p:sp>
        <p:sp>
          <p:nvSpPr>
            <p:cNvPr id="42" name="TextBox 40">
              <a:extLst>
                <a:ext uri="{FF2B5EF4-FFF2-40B4-BE49-F238E27FC236}">
                  <a16:creationId xmlns:a16="http://schemas.microsoft.com/office/drawing/2014/main" id="{28E90B55-AB12-435C-B2C3-17D285E5EF03}"/>
                </a:ext>
              </a:extLst>
            </p:cNvPr>
            <p:cNvSpPr txBox="1"/>
            <p:nvPr/>
          </p:nvSpPr>
          <p:spPr>
            <a:xfrm>
              <a:off x="1406181" y="5298529"/>
              <a:ext cx="1176614" cy="591615"/>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AZD2014</a:t>
              </a:r>
              <a:endParaRPr lang="en-GB" sz="1000" dirty="0">
                <a:effectLst/>
                <a:latin typeface="Times New Roman" panose="02020603050405020304" pitchFamily="18" charset="0"/>
                <a:ea typeface="Times New Roman" panose="02020603050405020304" pitchFamily="18" charset="0"/>
              </a:endParaRPr>
            </a:p>
          </p:txBody>
        </p:sp>
        <p:sp>
          <p:nvSpPr>
            <p:cNvPr id="43" name="TextBox 41">
              <a:extLst>
                <a:ext uri="{FF2B5EF4-FFF2-40B4-BE49-F238E27FC236}">
                  <a16:creationId xmlns:a16="http://schemas.microsoft.com/office/drawing/2014/main" id="{5D2A01B1-8AD0-43EF-BC5B-D1A31359080D}"/>
                </a:ext>
              </a:extLst>
            </p:cNvPr>
            <p:cNvSpPr txBox="1"/>
            <p:nvPr/>
          </p:nvSpPr>
          <p:spPr>
            <a:xfrm>
              <a:off x="2734275" y="4314671"/>
              <a:ext cx="807521" cy="313440"/>
            </a:xfrm>
            <a:prstGeom prst="rect">
              <a:avLst/>
            </a:prstGeom>
            <a:noFill/>
          </p:spPr>
          <p:txBody>
            <a:bodyPr wrap="square" rtlCol="0">
              <a:noAutofit/>
            </a:bodyPr>
            <a:lstStyle/>
            <a:p>
              <a:pPr>
                <a:spcAft>
                  <a:spcPts val="0"/>
                </a:spcAft>
              </a:pPr>
              <a:r>
                <a:rPr lang="en-GB" sz="10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1000">
                <a:effectLst/>
                <a:latin typeface="Times New Roman" panose="02020603050405020304" pitchFamily="18" charset="0"/>
                <a:ea typeface="Times New Roman" panose="02020603050405020304" pitchFamily="18" charset="0"/>
              </a:endParaRPr>
            </a:p>
          </p:txBody>
        </p:sp>
        <p:pic>
          <p:nvPicPr>
            <p:cNvPr id="44" name="Picture 43">
              <a:extLst>
                <a:ext uri="{FF2B5EF4-FFF2-40B4-BE49-F238E27FC236}">
                  <a16:creationId xmlns:a16="http://schemas.microsoft.com/office/drawing/2014/main" id="{5ED915FC-0F2D-49A4-A2E7-262E7C42EECD}"/>
                </a:ext>
              </a:extLst>
            </p:cNvPr>
            <p:cNvPicPr>
              <a:picLocks noChangeAspect="1" noChangeArrowheads="1"/>
            </p:cNvPicPr>
            <p:nvPr/>
          </p:nvPicPr>
          <p:blipFill rotWithShape="1">
            <a:blip r:embed="rId18">
              <a:extLst>
                <a:ext uri="{28A0092B-C50C-407E-A947-70E740481C1C}">
                  <a14:useLocalDpi xmlns:a14="http://schemas.microsoft.com/office/drawing/2010/main" val="0"/>
                </a:ext>
              </a:extLst>
            </a:blip>
            <a:srcRect/>
            <a:stretch/>
          </p:blipFill>
          <p:spPr bwMode="auto">
            <a:xfrm>
              <a:off x="4929319" y="4326861"/>
              <a:ext cx="1905000" cy="1947112"/>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5" name="Picture 44">
              <a:extLst>
                <a:ext uri="{FF2B5EF4-FFF2-40B4-BE49-F238E27FC236}">
                  <a16:creationId xmlns:a16="http://schemas.microsoft.com/office/drawing/2014/main" id="{A558B805-E8ED-468A-8F29-4236416254E5}"/>
                </a:ext>
              </a:extLst>
            </p:cNvPr>
            <p:cNvPicPr>
              <a:picLocks noChangeAspect="1" noChangeArrowheads="1"/>
            </p:cNvPicPr>
            <p:nvPr/>
          </p:nvPicPr>
          <p:blipFill>
            <a:blip r:embed="rId19" cstate="print">
              <a:extLst>
                <a:ext uri="{28A0092B-C50C-407E-A947-70E740481C1C}">
                  <a14:useLocalDpi xmlns:a14="http://schemas.microsoft.com/office/drawing/2010/main" val="0"/>
                </a:ext>
              </a:extLst>
            </a:blip>
            <a:srcRect/>
            <a:stretch>
              <a:fillRect/>
            </a:stretch>
          </p:blipFill>
          <p:spPr bwMode="auto">
            <a:xfrm>
              <a:off x="2710825" y="6464503"/>
              <a:ext cx="1930118" cy="195029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46" name="Picture 45">
              <a:extLst>
                <a:ext uri="{FF2B5EF4-FFF2-40B4-BE49-F238E27FC236}">
                  <a16:creationId xmlns:a16="http://schemas.microsoft.com/office/drawing/2014/main" id="{5A19B929-CC75-42B7-95B4-5AC6713DBD18}"/>
                </a:ext>
              </a:extLst>
            </p:cNvPr>
            <p:cNvPicPr>
              <a:picLocks noChangeAspect="1" noChangeArrowheads="1"/>
            </p:cNvPicPr>
            <p:nvPr/>
          </p:nvPicPr>
          <p:blipFill>
            <a:blip r:embed="rId20">
              <a:extLst>
                <a:ext uri="{28A0092B-C50C-407E-A947-70E740481C1C}">
                  <a14:useLocalDpi xmlns:a14="http://schemas.microsoft.com/office/drawing/2010/main" val="0"/>
                </a:ext>
              </a:extLst>
            </a:blip>
            <a:srcRect/>
            <a:stretch>
              <a:fillRect/>
            </a:stretch>
          </p:blipFill>
          <p:spPr bwMode="auto">
            <a:xfrm>
              <a:off x="4893487" y="6464502"/>
              <a:ext cx="1933575" cy="1950293"/>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47" name="TextBox 51">
              <a:extLst>
                <a:ext uri="{FF2B5EF4-FFF2-40B4-BE49-F238E27FC236}">
                  <a16:creationId xmlns:a16="http://schemas.microsoft.com/office/drawing/2014/main" id="{0CAA7F7D-3D3F-4788-B2F7-BF53F4D9195E}"/>
                </a:ext>
              </a:extLst>
            </p:cNvPr>
            <p:cNvSpPr txBox="1"/>
            <p:nvPr/>
          </p:nvSpPr>
          <p:spPr>
            <a:xfrm>
              <a:off x="-97087" y="6409113"/>
              <a:ext cx="761886" cy="384825"/>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0</a:t>
              </a:r>
              <a:endParaRPr lang="en-GB" sz="1000" dirty="0">
                <a:effectLst/>
                <a:latin typeface="Times New Roman" panose="02020603050405020304" pitchFamily="18" charset="0"/>
                <a:ea typeface="Times New Roman" panose="02020603050405020304" pitchFamily="18" charset="0"/>
              </a:endParaRPr>
            </a:p>
          </p:txBody>
        </p:sp>
        <p:sp>
          <p:nvSpPr>
            <p:cNvPr id="48" name="TextBox 52">
              <a:extLst>
                <a:ext uri="{FF2B5EF4-FFF2-40B4-BE49-F238E27FC236}">
                  <a16:creationId xmlns:a16="http://schemas.microsoft.com/office/drawing/2014/main" id="{4A71ECCE-4C1F-4A6B-BFD3-FAD04C32BC1B}"/>
                </a:ext>
              </a:extLst>
            </p:cNvPr>
            <p:cNvSpPr txBox="1"/>
            <p:nvPr/>
          </p:nvSpPr>
          <p:spPr>
            <a:xfrm>
              <a:off x="2285043" y="6427583"/>
              <a:ext cx="633612" cy="322073"/>
            </a:xfrm>
            <a:prstGeom prst="rect">
              <a:avLst/>
            </a:prstGeom>
            <a:noFill/>
          </p:spPr>
          <p:txBody>
            <a:bodyPr wrap="square" rtlCol="0">
              <a:noAutofit/>
            </a:bodyPr>
            <a:lstStyle/>
            <a:p>
              <a:pPr>
                <a:spcAft>
                  <a:spcPts val="0"/>
                </a:spcAft>
              </a:pPr>
              <a:r>
                <a:rPr lang="en-GB" sz="10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1</a:t>
              </a:r>
              <a:endParaRPr lang="en-GB" sz="1000" dirty="0">
                <a:effectLst/>
                <a:latin typeface="Times New Roman" panose="02020603050405020304" pitchFamily="18" charset="0"/>
                <a:ea typeface="Times New Roman" panose="02020603050405020304" pitchFamily="18" charset="0"/>
              </a:endParaRPr>
            </a:p>
          </p:txBody>
        </p:sp>
        <p:sp>
          <p:nvSpPr>
            <p:cNvPr id="49" name="TextBox 54">
              <a:extLst>
                <a:ext uri="{FF2B5EF4-FFF2-40B4-BE49-F238E27FC236}">
                  <a16:creationId xmlns:a16="http://schemas.microsoft.com/office/drawing/2014/main" id="{3EDDD312-AC9A-43BE-A987-A5305CD70A38}"/>
                </a:ext>
              </a:extLst>
            </p:cNvPr>
            <p:cNvSpPr txBox="1"/>
            <p:nvPr/>
          </p:nvSpPr>
          <p:spPr>
            <a:xfrm>
              <a:off x="4582716" y="6430343"/>
              <a:ext cx="795535" cy="466709"/>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2</a:t>
              </a:r>
              <a:endParaRPr lang="en-GB" sz="1000" dirty="0">
                <a:effectLst/>
                <a:latin typeface="Times New Roman" panose="02020603050405020304" pitchFamily="18" charset="0"/>
                <a:ea typeface="Times New Roman" panose="02020603050405020304" pitchFamily="18" charset="0"/>
              </a:endParaRPr>
            </a:p>
          </p:txBody>
        </p:sp>
        <p:sp>
          <p:nvSpPr>
            <p:cNvPr id="50" name="TextBox 55">
              <a:extLst>
                <a:ext uri="{FF2B5EF4-FFF2-40B4-BE49-F238E27FC236}">
                  <a16:creationId xmlns:a16="http://schemas.microsoft.com/office/drawing/2014/main" id="{4AC3106B-EED0-4B3C-858C-1A72A74AB091}"/>
                </a:ext>
              </a:extLst>
            </p:cNvPr>
            <p:cNvSpPr txBox="1"/>
            <p:nvPr/>
          </p:nvSpPr>
          <p:spPr>
            <a:xfrm>
              <a:off x="338934" y="6457773"/>
              <a:ext cx="932815" cy="583770"/>
            </a:xfrm>
            <a:prstGeom prst="rect">
              <a:avLst/>
            </a:prstGeom>
            <a:noFill/>
          </p:spPr>
          <p:txBody>
            <a:bodyPr wrap="square" rtlCol="0">
              <a:noAutofit/>
            </a:bodyPr>
            <a:lstStyle/>
            <a:p>
              <a:pPr>
                <a:spcAft>
                  <a:spcPts val="0"/>
                </a:spcAft>
              </a:pPr>
              <a:r>
                <a:rPr lang="en-GB" sz="10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EGFP-raptor</a:t>
              </a:r>
              <a:endParaRPr lang="en-GB" sz="1000">
                <a:effectLst/>
                <a:latin typeface="Times New Roman" panose="02020603050405020304" pitchFamily="18" charset="0"/>
                <a:ea typeface="Times New Roman" panose="02020603050405020304" pitchFamily="18" charset="0"/>
              </a:endParaRPr>
            </a:p>
          </p:txBody>
        </p:sp>
        <p:sp>
          <p:nvSpPr>
            <p:cNvPr id="51" name="TextBox 56">
              <a:extLst>
                <a:ext uri="{FF2B5EF4-FFF2-40B4-BE49-F238E27FC236}">
                  <a16:creationId xmlns:a16="http://schemas.microsoft.com/office/drawing/2014/main" id="{EEBB764C-C99D-42D4-A23A-648AB4AE5491}"/>
                </a:ext>
              </a:extLst>
            </p:cNvPr>
            <p:cNvSpPr txBox="1"/>
            <p:nvPr/>
          </p:nvSpPr>
          <p:spPr>
            <a:xfrm>
              <a:off x="1494841" y="7375008"/>
              <a:ext cx="1188987" cy="560560"/>
            </a:xfrm>
            <a:prstGeom prst="rect">
              <a:avLst/>
            </a:prstGeom>
            <a:noFill/>
          </p:spPr>
          <p:txBody>
            <a:bodyPr wrap="square" rtlCol="0">
              <a:noAutofit/>
            </a:bodyPr>
            <a:lstStyle/>
            <a:p>
              <a:pPr>
                <a:spcAft>
                  <a:spcPts val="0"/>
                </a:spcAft>
              </a:pPr>
              <a:r>
                <a:rPr lang="en-GB" sz="10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AZD2014</a:t>
              </a:r>
              <a:endParaRPr lang="en-GB" sz="1000">
                <a:effectLst/>
                <a:latin typeface="Times New Roman" panose="02020603050405020304" pitchFamily="18" charset="0"/>
                <a:ea typeface="Times New Roman" panose="02020603050405020304" pitchFamily="18" charset="0"/>
              </a:endParaRPr>
            </a:p>
          </p:txBody>
        </p:sp>
        <p:sp>
          <p:nvSpPr>
            <p:cNvPr id="52" name="TextBox 57">
              <a:extLst>
                <a:ext uri="{FF2B5EF4-FFF2-40B4-BE49-F238E27FC236}">
                  <a16:creationId xmlns:a16="http://schemas.microsoft.com/office/drawing/2014/main" id="{E0E98C17-DA59-4AA2-8B3C-F127AAA84005}"/>
                </a:ext>
              </a:extLst>
            </p:cNvPr>
            <p:cNvSpPr txBox="1"/>
            <p:nvPr/>
          </p:nvSpPr>
          <p:spPr>
            <a:xfrm>
              <a:off x="2710607" y="6457964"/>
              <a:ext cx="1052579" cy="291693"/>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1000" dirty="0">
                <a:effectLst/>
                <a:latin typeface="Times New Roman" panose="02020603050405020304" pitchFamily="18" charset="0"/>
                <a:ea typeface="Times New Roman" panose="02020603050405020304" pitchFamily="18" charset="0"/>
              </a:endParaRPr>
            </a:p>
          </p:txBody>
        </p:sp>
        <p:pic>
          <p:nvPicPr>
            <p:cNvPr id="53" name="Picture 52">
              <a:extLst>
                <a:ext uri="{FF2B5EF4-FFF2-40B4-BE49-F238E27FC236}">
                  <a16:creationId xmlns:a16="http://schemas.microsoft.com/office/drawing/2014/main" id="{40174674-172E-4998-90FA-A689F48F0A2F}"/>
                </a:ext>
              </a:extLst>
            </p:cNvPr>
            <p:cNvPicPr>
              <a:picLocks noChangeAspect="1" noChangeArrowheads="1"/>
            </p:cNvPicPr>
            <p:nvPr/>
          </p:nvPicPr>
          <p:blipFill>
            <a:blip r:embed="rId21" cstate="print">
              <a:extLst>
                <a:ext uri="{28A0092B-C50C-407E-A947-70E740481C1C}">
                  <a14:useLocalDpi xmlns:a14="http://schemas.microsoft.com/office/drawing/2010/main" val="0"/>
                </a:ext>
              </a:extLst>
            </a:blip>
            <a:srcRect/>
            <a:stretch>
              <a:fillRect/>
            </a:stretch>
          </p:blipFill>
          <p:spPr bwMode="auto">
            <a:xfrm>
              <a:off x="2704613" y="8651708"/>
              <a:ext cx="1911485" cy="1944216"/>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54" name="Picture 53">
              <a:extLst>
                <a:ext uri="{FF2B5EF4-FFF2-40B4-BE49-F238E27FC236}">
                  <a16:creationId xmlns:a16="http://schemas.microsoft.com/office/drawing/2014/main" id="{F3669F6B-2633-451D-81A5-4B5B047863B8}"/>
                </a:ext>
              </a:extLst>
            </p:cNvPr>
            <p:cNvPicPr>
              <a:picLocks noChangeAspect="1" noChangeArrowheads="1"/>
            </p:cNvPicPr>
            <p:nvPr/>
          </p:nvPicPr>
          <p:blipFill>
            <a:blip r:embed="rId22">
              <a:extLst>
                <a:ext uri="{28A0092B-C50C-407E-A947-70E740481C1C}">
                  <a14:useLocalDpi xmlns:a14="http://schemas.microsoft.com/office/drawing/2010/main" val="0"/>
                </a:ext>
              </a:extLst>
            </a:blip>
            <a:srcRect/>
            <a:stretch>
              <a:fillRect/>
            </a:stretch>
          </p:blipFill>
          <p:spPr bwMode="auto">
            <a:xfrm>
              <a:off x="4893486" y="8655867"/>
              <a:ext cx="1933575" cy="1940057"/>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55" name="TextBox 62">
              <a:extLst>
                <a:ext uri="{FF2B5EF4-FFF2-40B4-BE49-F238E27FC236}">
                  <a16:creationId xmlns:a16="http://schemas.microsoft.com/office/drawing/2014/main" id="{0B619F65-ABF3-4BA4-80E0-BEBB8CB51BEB}"/>
                </a:ext>
              </a:extLst>
            </p:cNvPr>
            <p:cNvSpPr txBox="1"/>
            <p:nvPr/>
          </p:nvSpPr>
          <p:spPr>
            <a:xfrm>
              <a:off x="-137278" y="8511527"/>
              <a:ext cx="622548" cy="303065"/>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3</a:t>
              </a:r>
              <a:endParaRPr lang="en-GB" sz="1000" dirty="0">
                <a:effectLst/>
                <a:latin typeface="Times New Roman" panose="02020603050405020304" pitchFamily="18" charset="0"/>
                <a:ea typeface="Times New Roman" panose="02020603050405020304" pitchFamily="18" charset="0"/>
              </a:endParaRPr>
            </a:p>
          </p:txBody>
        </p:sp>
        <p:sp>
          <p:nvSpPr>
            <p:cNvPr id="56" name="TextBox 63">
              <a:extLst>
                <a:ext uri="{FF2B5EF4-FFF2-40B4-BE49-F238E27FC236}">
                  <a16:creationId xmlns:a16="http://schemas.microsoft.com/office/drawing/2014/main" id="{4A45628F-FEC6-427C-BDA8-8A4F692778A2}"/>
                </a:ext>
              </a:extLst>
            </p:cNvPr>
            <p:cNvSpPr txBox="1"/>
            <p:nvPr/>
          </p:nvSpPr>
          <p:spPr>
            <a:xfrm>
              <a:off x="2249115" y="8556324"/>
              <a:ext cx="633611" cy="303065"/>
            </a:xfrm>
            <a:prstGeom prst="rect">
              <a:avLst/>
            </a:prstGeom>
            <a:noFill/>
          </p:spPr>
          <p:txBody>
            <a:bodyPr wrap="square" rtlCol="0">
              <a:noAutofit/>
            </a:bodyPr>
            <a:lstStyle/>
            <a:p>
              <a:pPr>
                <a:spcAft>
                  <a:spcPts val="0"/>
                </a:spcAft>
              </a:pPr>
              <a:r>
                <a:rPr lang="en-GB" sz="10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14</a:t>
              </a:r>
              <a:endParaRPr lang="en-GB" sz="1000" dirty="0">
                <a:effectLst/>
                <a:latin typeface="Times New Roman" panose="02020603050405020304" pitchFamily="18" charset="0"/>
                <a:ea typeface="Times New Roman" panose="02020603050405020304" pitchFamily="18" charset="0"/>
              </a:endParaRPr>
            </a:p>
          </p:txBody>
        </p:sp>
        <p:sp>
          <p:nvSpPr>
            <p:cNvPr id="57" name="TextBox 64">
              <a:extLst>
                <a:ext uri="{FF2B5EF4-FFF2-40B4-BE49-F238E27FC236}">
                  <a16:creationId xmlns:a16="http://schemas.microsoft.com/office/drawing/2014/main" id="{664BCF77-98A3-46DA-8DB8-A8232CFC285F}"/>
                </a:ext>
              </a:extLst>
            </p:cNvPr>
            <p:cNvSpPr txBox="1"/>
            <p:nvPr/>
          </p:nvSpPr>
          <p:spPr>
            <a:xfrm>
              <a:off x="4553773" y="8580041"/>
              <a:ext cx="633611" cy="325120"/>
            </a:xfrm>
            <a:prstGeom prst="rect">
              <a:avLst/>
            </a:prstGeom>
            <a:noFill/>
          </p:spPr>
          <p:txBody>
            <a:bodyPr wrap="square" rtlCol="0">
              <a:noAutofit/>
            </a:bodyPr>
            <a:lstStyle/>
            <a:p>
              <a:pPr>
                <a:spcAft>
                  <a:spcPts val="0"/>
                </a:spcAft>
              </a:pPr>
              <a:r>
                <a:rPr lang="en-GB" sz="10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5</a:t>
              </a:r>
              <a:endParaRPr lang="en-GB" sz="1000" dirty="0">
                <a:effectLst/>
                <a:latin typeface="Times New Roman" panose="02020603050405020304" pitchFamily="18" charset="0"/>
                <a:ea typeface="Times New Roman" panose="02020603050405020304" pitchFamily="18" charset="0"/>
              </a:endParaRPr>
            </a:p>
          </p:txBody>
        </p:sp>
        <p:sp>
          <p:nvSpPr>
            <p:cNvPr id="58" name="TextBox 65">
              <a:extLst>
                <a:ext uri="{FF2B5EF4-FFF2-40B4-BE49-F238E27FC236}">
                  <a16:creationId xmlns:a16="http://schemas.microsoft.com/office/drawing/2014/main" id="{C0C5D7D6-3775-4685-8ECE-C713A89F57ED}"/>
                </a:ext>
              </a:extLst>
            </p:cNvPr>
            <p:cNvSpPr txBox="1"/>
            <p:nvPr/>
          </p:nvSpPr>
          <p:spPr>
            <a:xfrm>
              <a:off x="318462" y="8676406"/>
              <a:ext cx="922656" cy="515129"/>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EGFP-mTOR</a:t>
              </a:r>
              <a:endParaRPr lang="en-GB" sz="1000" dirty="0">
                <a:effectLst/>
                <a:latin typeface="Times New Roman" panose="02020603050405020304" pitchFamily="18" charset="0"/>
                <a:ea typeface="Times New Roman" panose="02020603050405020304" pitchFamily="18" charset="0"/>
              </a:endParaRPr>
            </a:p>
          </p:txBody>
        </p:sp>
        <p:sp>
          <p:nvSpPr>
            <p:cNvPr id="59" name="TextBox 66">
              <a:extLst>
                <a:ext uri="{FF2B5EF4-FFF2-40B4-BE49-F238E27FC236}">
                  <a16:creationId xmlns:a16="http://schemas.microsoft.com/office/drawing/2014/main" id="{CFED2966-83FE-4595-A637-2F7B8113684D}"/>
                </a:ext>
              </a:extLst>
            </p:cNvPr>
            <p:cNvSpPr txBox="1"/>
            <p:nvPr/>
          </p:nvSpPr>
          <p:spPr>
            <a:xfrm>
              <a:off x="1456288" y="9529627"/>
              <a:ext cx="1293891" cy="612472"/>
            </a:xfrm>
            <a:prstGeom prst="rect">
              <a:avLst/>
            </a:prstGeom>
            <a:noFill/>
          </p:spPr>
          <p:txBody>
            <a:bodyPr wrap="square" rtlCol="0">
              <a:noAutofit/>
            </a:bodyPr>
            <a:lstStyle/>
            <a:p>
              <a:pPr>
                <a:spcAft>
                  <a:spcPts val="0"/>
                </a:spcAft>
              </a:pPr>
              <a:r>
                <a:rPr lang="en-GB" sz="1000" kern="1200" dirty="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AZD2014</a:t>
              </a:r>
              <a:endParaRPr lang="en-GB" sz="1000" dirty="0">
                <a:effectLst/>
                <a:latin typeface="Times New Roman" panose="02020603050405020304" pitchFamily="18" charset="0"/>
                <a:ea typeface="Times New Roman" panose="02020603050405020304" pitchFamily="18" charset="0"/>
              </a:endParaRPr>
            </a:p>
          </p:txBody>
        </p:sp>
        <p:sp>
          <p:nvSpPr>
            <p:cNvPr id="60" name="TextBox 67">
              <a:extLst>
                <a:ext uri="{FF2B5EF4-FFF2-40B4-BE49-F238E27FC236}">
                  <a16:creationId xmlns:a16="http://schemas.microsoft.com/office/drawing/2014/main" id="{BCDEB1CD-04F5-4E2E-8615-8B0541178FD5}"/>
                </a:ext>
              </a:extLst>
            </p:cNvPr>
            <p:cNvSpPr txBox="1"/>
            <p:nvPr/>
          </p:nvSpPr>
          <p:spPr>
            <a:xfrm>
              <a:off x="2737261" y="8655443"/>
              <a:ext cx="1409565" cy="345476"/>
            </a:xfrm>
            <a:prstGeom prst="rect">
              <a:avLst/>
            </a:prstGeom>
            <a:noFill/>
          </p:spPr>
          <p:txBody>
            <a:bodyPr wrap="square" rtlCol="0">
              <a:noAutofit/>
            </a:bodyPr>
            <a:lstStyle/>
            <a:p>
              <a:pPr>
                <a:spcAft>
                  <a:spcPts val="0"/>
                </a:spcAft>
              </a:pPr>
              <a:r>
                <a:rPr lang="en-GB" sz="10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1000">
                <a:effectLst/>
                <a:latin typeface="Times New Roman" panose="02020603050405020304" pitchFamily="18" charset="0"/>
                <a:ea typeface="Times New Roman" panose="02020603050405020304" pitchFamily="18" charset="0"/>
              </a:endParaRPr>
            </a:p>
          </p:txBody>
        </p:sp>
      </p:grpSp>
      <p:grpSp>
        <p:nvGrpSpPr>
          <p:cNvPr id="79" name="Group 78">
            <a:extLst>
              <a:ext uri="{FF2B5EF4-FFF2-40B4-BE49-F238E27FC236}">
                <a16:creationId xmlns:a16="http://schemas.microsoft.com/office/drawing/2014/main" id="{155CB176-2ABB-4E95-AD88-9D7D51E0B879}"/>
              </a:ext>
            </a:extLst>
          </p:cNvPr>
          <p:cNvGrpSpPr/>
          <p:nvPr/>
        </p:nvGrpSpPr>
        <p:grpSpPr>
          <a:xfrm>
            <a:off x="505870" y="4686108"/>
            <a:ext cx="2167387" cy="2137341"/>
            <a:chOff x="477620" y="4720659"/>
            <a:chExt cx="2412947" cy="2506208"/>
          </a:xfrm>
        </p:grpSpPr>
        <p:grpSp>
          <p:nvGrpSpPr>
            <p:cNvPr id="66" name="Group 65">
              <a:extLst>
                <a:ext uri="{FF2B5EF4-FFF2-40B4-BE49-F238E27FC236}">
                  <a16:creationId xmlns:a16="http://schemas.microsoft.com/office/drawing/2014/main" id="{DC75F51B-177D-4100-A9A7-8A3815EA0150}"/>
                </a:ext>
              </a:extLst>
            </p:cNvPr>
            <p:cNvGrpSpPr/>
            <p:nvPr/>
          </p:nvGrpSpPr>
          <p:grpSpPr>
            <a:xfrm>
              <a:off x="766856" y="4720659"/>
              <a:ext cx="2123711" cy="1243244"/>
              <a:chOff x="0" y="0"/>
              <a:chExt cx="5412440" cy="2999728"/>
            </a:xfrm>
          </p:grpSpPr>
          <p:pic>
            <p:nvPicPr>
              <p:cNvPr id="67" name="Picture 66">
                <a:extLst>
                  <a:ext uri="{FF2B5EF4-FFF2-40B4-BE49-F238E27FC236}">
                    <a16:creationId xmlns:a16="http://schemas.microsoft.com/office/drawing/2014/main" id="{2535BAF2-BE41-456A-B5D1-ADB08FE4E4D1}"/>
                  </a:ext>
                </a:extLst>
              </p:cNvPr>
              <p:cNvPicPr>
                <a:picLocks noChangeAspect="1" noChangeArrowheads="1"/>
              </p:cNvPicPr>
              <p:nvPr/>
            </p:nvPicPr>
            <p:blipFill>
              <a:blip r:embed="rId23" cstate="print">
                <a:extLst>
                  <a:ext uri="{28A0092B-C50C-407E-A947-70E740481C1C}">
                    <a14:useLocalDpi xmlns:a14="http://schemas.microsoft.com/office/drawing/2010/main" val="0"/>
                  </a:ext>
                </a:extLst>
              </a:blip>
              <a:srcRect/>
              <a:stretch>
                <a:fillRect/>
              </a:stretch>
            </p:blipFill>
            <p:spPr bwMode="auto">
              <a:xfrm>
                <a:off x="0" y="0"/>
                <a:ext cx="2447925" cy="2457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68" name="Picture 67">
                <a:extLst>
                  <a:ext uri="{FF2B5EF4-FFF2-40B4-BE49-F238E27FC236}">
                    <a16:creationId xmlns:a16="http://schemas.microsoft.com/office/drawing/2014/main" id="{38C3D72C-1713-4AC0-8540-C8FA14179DA4}"/>
                  </a:ext>
                </a:extLst>
              </p:cNvPr>
              <p:cNvPicPr>
                <a:picLocks noChangeAspect="1" noChangeArrowheads="1"/>
              </p:cNvPicPr>
              <p:nvPr/>
            </p:nvPicPr>
            <p:blipFill>
              <a:blip r:embed="rId24" cstate="print">
                <a:extLst>
                  <a:ext uri="{28A0092B-C50C-407E-A947-70E740481C1C}">
                    <a14:useLocalDpi xmlns:a14="http://schemas.microsoft.com/office/drawing/2010/main" val="0"/>
                  </a:ext>
                </a:extLst>
              </a:blip>
              <a:srcRect/>
              <a:stretch>
                <a:fillRect/>
              </a:stretch>
            </p:blipFill>
            <p:spPr bwMode="auto">
              <a:xfrm>
                <a:off x="2618556" y="1"/>
                <a:ext cx="2449599" cy="2457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69" name="TextBox 9">
                <a:extLst>
                  <a:ext uri="{FF2B5EF4-FFF2-40B4-BE49-F238E27FC236}">
                    <a16:creationId xmlns:a16="http://schemas.microsoft.com/office/drawing/2014/main" id="{89B0823D-B02E-408E-92E5-AEBBE5E1972A}"/>
                  </a:ext>
                </a:extLst>
              </p:cNvPr>
              <p:cNvSpPr txBox="1"/>
              <p:nvPr/>
            </p:nvSpPr>
            <p:spPr>
              <a:xfrm>
                <a:off x="2618275" y="0"/>
                <a:ext cx="1181489" cy="631219"/>
              </a:xfrm>
              <a:prstGeom prst="rect">
                <a:avLst/>
              </a:prstGeom>
              <a:noFill/>
            </p:spPr>
            <p:txBody>
              <a:bodyPr wrap="none" rtlCol="0">
                <a:spAutoFit/>
              </a:bodyPr>
              <a:lstStyle/>
              <a:p>
                <a:pPr>
                  <a:spcAft>
                    <a:spcPts val="0"/>
                  </a:spcAft>
                </a:pPr>
                <a:r>
                  <a:rPr lang="en-GB" sz="105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800">
                  <a:effectLst/>
                  <a:latin typeface="Times New Roman" panose="02020603050405020304" pitchFamily="18" charset="0"/>
                  <a:ea typeface="Times New Roman" panose="02020603050405020304" pitchFamily="18" charset="0"/>
                </a:endParaRPr>
              </a:p>
            </p:txBody>
          </p:sp>
          <p:pic>
            <p:nvPicPr>
              <p:cNvPr id="70" name="Picture 69" descr="C:\Users\vwq83165\Desktop\noname_color_legend.tiff">
                <a:extLst>
                  <a:ext uri="{FF2B5EF4-FFF2-40B4-BE49-F238E27FC236}">
                    <a16:creationId xmlns:a16="http://schemas.microsoft.com/office/drawing/2014/main" id="{366403FC-99B3-4608-8D5B-4F618E3FF59E}"/>
                  </a:ext>
                </a:extLst>
              </p:cNvPr>
              <p:cNvPicPr>
                <a:picLocks noChangeAspect="1" noChangeArrowheads="1"/>
              </p:cNvPicPr>
              <p:nvPr/>
            </p:nvPicPr>
            <p:blipFill rotWithShape="1">
              <a:blip r:embed="rId25">
                <a:extLst>
                  <a:ext uri="{28A0092B-C50C-407E-A947-70E740481C1C}">
                    <a14:useLocalDpi xmlns:a14="http://schemas.microsoft.com/office/drawing/2010/main" val="0"/>
                  </a:ext>
                </a:extLst>
              </a:blip>
              <a:srcRect r="19698"/>
              <a:stretch/>
            </p:blipFill>
            <p:spPr bwMode="auto">
              <a:xfrm>
                <a:off x="2618556" y="2457451"/>
                <a:ext cx="2449599" cy="119159"/>
              </a:xfrm>
              <a:prstGeom prst="rect">
                <a:avLst/>
              </a:prstGeom>
              <a:noFill/>
              <a:extLst>
                <a:ext uri="{909E8E84-426E-40DD-AFC4-6F175D3DCCD1}">
                  <a14:hiddenFill xmlns:a14="http://schemas.microsoft.com/office/drawing/2010/main">
                    <a:solidFill>
                      <a:srgbClr val="FFFFFF"/>
                    </a:solidFill>
                  </a14:hiddenFill>
                </a:ext>
              </a:extLst>
            </p:spPr>
          </p:pic>
          <p:sp>
            <p:nvSpPr>
              <p:cNvPr id="71" name="TextBox 11">
                <a:extLst>
                  <a:ext uri="{FF2B5EF4-FFF2-40B4-BE49-F238E27FC236}">
                    <a16:creationId xmlns:a16="http://schemas.microsoft.com/office/drawing/2014/main" id="{045172EE-EA07-4949-BA46-BF8BF9889A82}"/>
                  </a:ext>
                </a:extLst>
              </p:cNvPr>
              <p:cNvSpPr txBox="1"/>
              <p:nvPr/>
            </p:nvSpPr>
            <p:spPr>
              <a:xfrm>
                <a:off x="2384359" y="2517031"/>
                <a:ext cx="3028081" cy="482697"/>
              </a:xfrm>
              <a:prstGeom prst="rect">
                <a:avLst/>
              </a:prstGeom>
              <a:noFill/>
            </p:spPr>
            <p:txBody>
              <a:bodyPr wrap="none" rtlCol="0">
                <a:spAutoFit/>
              </a:bodyPr>
              <a:lstStyle/>
              <a:p>
                <a:pPr>
                  <a:spcAft>
                    <a:spcPts val="0"/>
                  </a:spcAft>
                </a:pPr>
                <a:r>
                  <a:rPr lang="en-GB" sz="7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500                         4700 </a:t>
                </a:r>
                <a:r>
                  <a:rPr lang="en-GB" sz="700"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s</a:t>
                </a:r>
                <a:endParaRPr lang="en-GB" sz="500" dirty="0">
                  <a:effectLst/>
                  <a:latin typeface="Times New Roman" panose="02020603050405020304" pitchFamily="18" charset="0"/>
                  <a:ea typeface="Times New Roman" panose="02020603050405020304" pitchFamily="18" charset="0"/>
                </a:endParaRPr>
              </a:p>
            </p:txBody>
          </p:sp>
        </p:grpSp>
        <p:grpSp>
          <p:nvGrpSpPr>
            <p:cNvPr id="72" name="Group 71">
              <a:extLst>
                <a:ext uri="{FF2B5EF4-FFF2-40B4-BE49-F238E27FC236}">
                  <a16:creationId xmlns:a16="http://schemas.microsoft.com/office/drawing/2014/main" id="{EC9314BE-5BD7-492B-849B-ACB93A10B978}"/>
                </a:ext>
              </a:extLst>
            </p:cNvPr>
            <p:cNvGrpSpPr/>
            <p:nvPr/>
          </p:nvGrpSpPr>
          <p:grpSpPr>
            <a:xfrm>
              <a:off x="477620" y="5939320"/>
              <a:ext cx="2361421" cy="1287547"/>
              <a:chOff x="-809704" y="0"/>
              <a:chExt cx="6198745" cy="3010056"/>
            </a:xfrm>
          </p:grpSpPr>
          <p:pic>
            <p:nvPicPr>
              <p:cNvPr id="73" name="Picture 72">
                <a:extLst>
                  <a:ext uri="{FF2B5EF4-FFF2-40B4-BE49-F238E27FC236}">
                    <a16:creationId xmlns:a16="http://schemas.microsoft.com/office/drawing/2014/main" id="{0931DD70-7A32-4F0A-89D2-91EB30FC3903}"/>
                  </a:ext>
                </a:extLst>
              </p:cNvPr>
              <p:cNvPicPr>
                <a:picLocks noChangeAspect="1" noChangeArrowheads="1"/>
              </p:cNvPicPr>
              <p:nvPr/>
            </p:nvPicPr>
            <p:blipFill>
              <a:blip r:embed="rId26" cstate="print">
                <a:extLst>
                  <a:ext uri="{28A0092B-C50C-407E-A947-70E740481C1C}">
                    <a14:useLocalDpi xmlns:a14="http://schemas.microsoft.com/office/drawing/2010/main" val="0"/>
                  </a:ext>
                </a:extLst>
              </a:blip>
              <a:srcRect/>
              <a:stretch>
                <a:fillRect/>
              </a:stretch>
            </p:blipFill>
            <p:spPr bwMode="auto">
              <a:xfrm>
                <a:off x="7962" y="0"/>
                <a:ext cx="2409825" cy="2457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pic>
            <p:nvPicPr>
              <p:cNvPr id="74" name="Picture 73">
                <a:extLst>
                  <a:ext uri="{FF2B5EF4-FFF2-40B4-BE49-F238E27FC236}">
                    <a16:creationId xmlns:a16="http://schemas.microsoft.com/office/drawing/2014/main" id="{F7E8194F-335C-4A63-999F-6BA4F52A1213}"/>
                  </a:ext>
                </a:extLst>
              </p:cNvPr>
              <p:cNvPicPr>
                <a:picLocks noChangeAspect="1" noChangeArrowheads="1"/>
              </p:cNvPicPr>
              <p:nvPr/>
            </p:nvPicPr>
            <p:blipFill>
              <a:blip r:embed="rId27" cstate="print">
                <a:extLst>
                  <a:ext uri="{28A0092B-C50C-407E-A947-70E740481C1C}">
                    <a14:useLocalDpi xmlns:a14="http://schemas.microsoft.com/office/drawing/2010/main" val="0"/>
                  </a:ext>
                </a:extLst>
              </a:blip>
              <a:srcRect/>
              <a:stretch>
                <a:fillRect/>
              </a:stretch>
            </p:blipFill>
            <p:spPr bwMode="auto">
              <a:xfrm>
                <a:off x="2589614" y="0"/>
                <a:ext cx="2580072" cy="2457450"/>
              </a:xfrm>
              <a:prstGeom prst="rect">
                <a:avLst/>
              </a:prstGeom>
              <a:noFill/>
              <a:ln>
                <a:noFill/>
              </a:ln>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Lst>
            </p:spPr>
          </p:pic>
          <p:sp>
            <p:nvSpPr>
              <p:cNvPr id="75" name="TextBox 5">
                <a:extLst>
                  <a:ext uri="{FF2B5EF4-FFF2-40B4-BE49-F238E27FC236}">
                    <a16:creationId xmlns:a16="http://schemas.microsoft.com/office/drawing/2014/main" id="{9BACD242-2D28-4D11-85AE-E134A080239D}"/>
                  </a:ext>
                </a:extLst>
              </p:cNvPr>
              <p:cNvSpPr txBox="1"/>
              <p:nvPr/>
            </p:nvSpPr>
            <p:spPr>
              <a:xfrm>
                <a:off x="2613743" y="42254"/>
                <a:ext cx="1216921" cy="611598"/>
              </a:xfrm>
              <a:prstGeom prst="rect">
                <a:avLst/>
              </a:prstGeom>
              <a:noFill/>
            </p:spPr>
            <p:txBody>
              <a:bodyPr wrap="none" rtlCol="0">
                <a:spAutoFit/>
              </a:bodyPr>
              <a:lstStyle/>
              <a:p>
                <a:pPr>
                  <a:spcAft>
                    <a:spcPts val="0"/>
                  </a:spcAft>
                </a:pPr>
                <a:r>
                  <a:rPr lang="en-GB" sz="11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FLIM</a:t>
                </a:r>
                <a:endParaRPr lang="en-GB" sz="900">
                  <a:effectLst/>
                  <a:latin typeface="Times New Roman" panose="02020603050405020304" pitchFamily="18" charset="0"/>
                  <a:ea typeface="Times New Roman" panose="02020603050405020304" pitchFamily="18" charset="0"/>
                </a:endParaRPr>
              </a:p>
            </p:txBody>
          </p:sp>
          <p:pic>
            <p:nvPicPr>
              <p:cNvPr id="76" name="Picture 75" descr="C:\Users\vwq83165\Desktop\noname_color_legend.tiff">
                <a:extLst>
                  <a:ext uri="{FF2B5EF4-FFF2-40B4-BE49-F238E27FC236}">
                    <a16:creationId xmlns:a16="http://schemas.microsoft.com/office/drawing/2014/main" id="{2896B481-6B2C-4984-B4AE-E955B8BCB7F6}"/>
                  </a:ext>
                </a:extLst>
              </p:cNvPr>
              <p:cNvPicPr>
                <a:picLocks noChangeAspect="1" noChangeArrowheads="1"/>
              </p:cNvPicPr>
              <p:nvPr/>
            </p:nvPicPr>
            <p:blipFill rotWithShape="1">
              <a:blip r:embed="rId25">
                <a:extLst>
                  <a:ext uri="{28A0092B-C50C-407E-A947-70E740481C1C}">
                    <a14:useLocalDpi xmlns:a14="http://schemas.microsoft.com/office/drawing/2010/main" val="0"/>
                  </a:ext>
                </a:extLst>
              </a:blip>
              <a:srcRect r="19698"/>
              <a:stretch/>
            </p:blipFill>
            <p:spPr bwMode="auto">
              <a:xfrm>
                <a:off x="2613744" y="2457449"/>
                <a:ext cx="2555944" cy="124332"/>
              </a:xfrm>
              <a:prstGeom prst="rect">
                <a:avLst/>
              </a:prstGeom>
              <a:noFill/>
              <a:extLst>
                <a:ext uri="{909E8E84-426E-40DD-AFC4-6F175D3DCCD1}">
                  <a14:hiddenFill xmlns:a14="http://schemas.microsoft.com/office/drawing/2010/main">
                    <a:solidFill>
                      <a:srgbClr val="FFFFFF"/>
                    </a:solidFill>
                  </a14:hiddenFill>
                </a:ext>
              </a:extLst>
            </p:spPr>
          </p:pic>
          <p:sp>
            <p:nvSpPr>
              <p:cNvPr id="77" name="TextBox 12">
                <a:extLst>
                  <a:ext uri="{FF2B5EF4-FFF2-40B4-BE49-F238E27FC236}">
                    <a16:creationId xmlns:a16="http://schemas.microsoft.com/office/drawing/2014/main" id="{F0BE7EBC-5825-44E2-873E-50F4BF4F3A1D}"/>
                  </a:ext>
                </a:extLst>
              </p:cNvPr>
              <p:cNvSpPr txBox="1"/>
              <p:nvPr/>
            </p:nvSpPr>
            <p:spPr>
              <a:xfrm>
                <a:off x="2337478" y="2578340"/>
                <a:ext cx="3051563" cy="431716"/>
              </a:xfrm>
              <a:prstGeom prst="rect">
                <a:avLst/>
              </a:prstGeom>
              <a:noFill/>
            </p:spPr>
            <p:txBody>
              <a:bodyPr wrap="none" rtlCol="0">
                <a:spAutoFit/>
              </a:bodyPr>
              <a:lstStyle/>
              <a:p>
                <a:pPr>
                  <a:spcAft>
                    <a:spcPts val="0"/>
                  </a:spcAft>
                </a:pPr>
                <a:r>
                  <a:rPr lang="en-GB" sz="6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3500                                 4700 </a:t>
                </a:r>
                <a:r>
                  <a:rPr lang="en-GB" sz="600" kern="1200" dirty="0" err="1">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ps</a:t>
                </a:r>
                <a:endParaRPr lang="en-GB" sz="400" dirty="0">
                  <a:effectLst/>
                  <a:latin typeface="Times New Roman" panose="02020603050405020304" pitchFamily="18" charset="0"/>
                  <a:ea typeface="Times New Roman" panose="02020603050405020304" pitchFamily="18" charset="0"/>
                </a:endParaRPr>
              </a:p>
            </p:txBody>
          </p:sp>
          <p:sp>
            <p:nvSpPr>
              <p:cNvPr id="78" name="TextBox 2">
                <a:extLst>
                  <a:ext uri="{FF2B5EF4-FFF2-40B4-BE49-F238E27FC236}">
                    <a16:creationId xmlns:a16="http://schemas.microsoft.com/office/drawing/2014/main" id="{7D263FB6-103F-49BD-9E69-F9BB8F06FA40}"/>
                  </a:ext>
                </a:extLst>
              </p:cNvPr>
              <p:cNvSpPr txBox="1"/>
              <p:nvPr/>
            </p:nvSpPr>
            <p:spPr>
              <a:xfrm rot="16200000">
                <a:off x="-1530847" y="812473"/>
                <a:ext cx="2206817" cy="764532"/>
              </a:xfrm>
              <a:prstGeom prst="rect">
                <a:avLst/>
              </a:prstGeom>
              <a:noFill/>
            </p:spPr>
            <p:txBody>
              <a:bodyPr wrap="none" rtlCol="0">
                <a:spAutoFit/>
              </a:bodyPr>
              <a:lstStyle/>
              <a:p>
                <a:pPr>
                  <a:spcAft>
                    <a:spcPts val="0"/>
                  </a:spcAft>
                </a:pPr>
                <a:r>
                  <a:rPr lang="en-GB" sz="1100" kern="1200" dirty="0">
                    <a:effectLst/>
                    <a:latin typeface="Calibri" panose="020F0502020204030204" pitchFamily="34" charset="0"/>
                    <a:ea typeface="Times New Roman" panose="02020603050405020304" pitchFamily="18" charset="0"/>
                    <a:cs typeface="Times New Roman" panose="02020603050405020304" pitchFamily="18" charset="0"/>
                  </a:rPr>
                  <a:t>EGFP-S6K1</a:t>
                </a:r>
                <a:endParaRPr lang="en-GB" sz="900" dirty="0">
                  <a:effectLst/>
                  <a:latin typeface="Times New Roman" panose="02020603050405020304" pitchFamily="18" charset="0"/>
                  <a:ea typeface="Times New Roman" panose="02020603050405020304" pitchFamily="18" charset="0"/>
                </a:endParaRPr>
              </a:p>
            </p:txBody>
          </p:sp>
        </p:grpSp>
      </p:grpSp>
      <p:sp>
        <p:nvSpPr>
          <p:cNvPr id="80" name="TextBox 20">
            <a:extLst>
              <a:ext uri="{FF2B5EF4-FFF2-40B4-BE49-F238E27FC236}">
                <a16:creationId xmlns:a16="http://schemas.microsoft.com/office/drawing/2014/main" id="{839A10E1-AF10-4836-AE8A-EA08A53FFEB6}"/>
              </a:ext>
            </a:extLst>
          </p:cNvPr>
          <p:cNvSpPr txBox="1"/>
          <p:nvPr/>
        </p:nvSpPr>
        <p:spPr>
          <a:xfrm>
            <a:off x="0" y="4655054"/>
            <a:ext cx="301176" cy="32553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81" name="TextBox 20">
            <a:extLst>
              <a:ext uri="{FF2B5EF4-FFF2-40B4-BE49-F238E27FC236}">
                <a16:creationId xmlns:a16="http://schemas.microsoft.com/office/drawing/2014/main" id="{DC5AA761-05B6-4748-9CE0-FCAC33D5B57F}"/>
              </a:ext>
            </a:extLst>
          </p:cNvPr>
          <p:cNvSpPr txBox="1"/>
          <p:nvPr/>
        </p:nvSpPr>
        <p:spPr>
          <a:xfrm>
            <a:off x="6626" y="5643148"/>
            <a:ext cx="301176" cy="32553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D</a:t>
            </a:r>
            <a:endParaRPr lang="en-GB" sz="1200" dirty="0">
              <a:effectLst/>
              <a:latin typeface="Times New Roman" panose="02020603050405020304" pitchFamily="18" charset="0"/>
              <a:ea typeface="Times New Roman" panose="02020603050405020304" pitchFamily="18" charset="0"/>
            </a:endParaRPr>
          </a:p>
        </p:txBody>
      </p:sp>
      <p:sp>
        <p:nvSpPr>
          <p:cNvPr id="82" name="TextBox 2">
            <a:extLst>
              <a:ext uri="{FF2B5EF4-FFF2-40B4-BE49-F238E27FC236}">
                <a16:creationId xmlns:a16="http://schemas.microsoft.com/office/drawing/2014/main" id="{9747A834-E484-46A7-8CC9-AD1EBE2EF9D6}"/>
              </a:ext>
            </a:extLst>
          </p:cNvPr>
          <p:cNvSpPr txBox="1"/>
          <p:nvPr/>
        </p:nvSpPr>
        <p:spPr>
          <a:xfrm rot="16200000">
            <a:off x="99686" y="5014209"/>
            <a:ext cx="1072730" cy="261610"/>
          </a:xfrm>
          <a:prstGeom prst="rect">
            <a:avLst/>
          </a:prstGeom>
          <a:noFill/>
        </p:spPr>
        <p:txBody>
          <a:bodyPr wrap="none" rtlCol="0">
            <a:spAutoFit/>
          </a:bodyPr>
          <a:lstStyle/>
          <a:p>
            <a:pPr>
              <a:spcAft>
                <a:spcPts val="0"/>
              </a:spcAft>
            </a:pPr>
            <a:r>
              <a:rPr lang="en-GB" sz="1100" kern="1200" dirty="0">
                <a:effectLst/>
                <a:latin typeface="Calibri" panose="020F0502020204030204" pitchFamily="34" charset="0"/>
                <a:ea typeface="Times New Roman" panose="02020603050405020304" pitchFamily="18" charset="0"/>
                <a:cs typeface="Times New Roman" panose="02020603050405020304" pitchFamily="18" charset="0"/>
              </a:rPr>
              <a:t>No transfection</a:t>
            </a:r>
            <a:endParaRPr lang="en-GB" sz="900" dirty="0">
              <a:effectLst/>
              <a:latin typeface="Times New Roman" panose="02020603050405020304" pitchFamily="18" charset="0"/>
              <a:ea typeface="Times New Roman" panose="02020603050405020304" pitchFamily="18" charset="0"/>
            </a:endParaRPr>
          </a:p>
        </p:txBody>
      </p:sp>
      <p:sp>
        <p:nvSpPr>
          <p:cNvPr id="83" name="TextBox 20">
            <a:extLst>
              <a:ext uri="{FF2B5EF4-FFF2-40B4-BE49-F238E27FC236}">
                <a16:creationId xmlns:a16="http://schemas.microsoft.com/office/drawing/2014/main" id="{D1B42194-2152-4F85-8682-4483711C7ED6}"/>
              </a:ext>
            </a:extLst>
          </p:cNvPr>
          <p:cNvSpPr txBox="1"/>
          <p:nvPr/>
        </p:nvSpPr>
        <p:spPr>
          <a:xfrm>
            <a:off x="3522279" y="19488"/>
            <a:ext cx="301176" cy="32553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E</a:t>
            </a:r>
            <a:endParaRPr lang="en-GB" sz="1200" dirty="0">
              <a:effectLst/>
              <a:latin typeface="Times New Roman" panose="02020603050405020304" pitchFamily="18" charset="0"/>
              <a:ea typeface="Times New Roman" panose="02020603050405020304" pitchFamily="18" charset="0"/>
            </a:endParaRPr>
          </a:p>
        </p:txBody>
      </p:sp>
      <p:sp>
        <p:nvSpPr>
          <p:cNvPr id="84" name="TextBox 33">
            <a:extLst>
              <a:ext uri="{FF2B5EF4-FFF2-40B4-BE49-F238E27FC236}">
                <a16:creationId xmlns:a16="http://schemas.microsoft.com/office/drawing/2014/main" id="{EF259BD2-C876-4EEA-9862-8FD53E0DA34E}"/>
              </a:ext>
            </a:extLst>
          </p:cNvPr>
          <p:cNvSpPr txBox="1"/>
          <p:nvPr/>
        </p:nvSpPr>
        <p:spPr>
          <a:xfrm>
            <a:off x="3609661" y="2395384"/>
            <a:ext cx="161257" cy="185927"/>
          </a:xfrm>
          <a:prstGeom prst="rect">
            <a:avLst/>
          </a:prstGeom>
          <a:noFill/>
        </p:spPr>
        <p:txBody>
          <a:bodyPr wrap="square" rtlCol="0">
            <a:noAutofit/>
          </a:bodyPr>
          <a:lstStyle/>
          <a:p>
            <a:pPr>
              <a:spcAft>
                <a:spcPts val="0"/>
              </a:spcAft>
            </a:pPr>
            <a:r>
              <a:rPr lang="en-GB" sz="10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7</a:t>
            </a:r>
            <a:endParaRPr lang="en-GB" sz="1000" dirty="0">
              <a:effectLst/>
              <a:latin typeface="Times New Roman" panose="02020603050405020304" pitchFamily="18" charset="0"/>
              <a:ea typeface="Times New Roman" panose="02020603050405020304" pitchFamily="18" charset="0"/>
            </a:endParaRPr>
          </a:p>
        </p:txBody>
      </p:sp>
      <p:sp>
        <p:nvSpPr>
          <p:cNvPr id="85" name="TextBox 84">
            <a:extLst>
              <a:ext uri="{FF2B5EF4-FFF2-40B4-BE49-F238E27FC236}">
                <a16:creationId xmlns:a16="http://schemas.microsoft.com/office/drawing/2014/main" id="{4D177E4C-F856-4F45-8640-4EEB05E629D8}"/>
              </a:ext>
            </a:extLst>
          </p:cNvPr>
          <p:cNvSpPr txBox="1"/>
          <p:nvPr/>
        </p:nvSpPr>
        <p:spPr>
          <a:xfrm>
            <a:off x="7523246" y="37169"/>
            <a:ext cx="1479175" cy="5632311"/>
          </a:xfrm>
          <a:prstGeom prst="rect">
            <a:avLst/>
          </a:prstGeom>
          <a:noFill/>
        </p:spPr>
        <p:txBody>
          <a:bodyPr wrap="square" rtlCol="0">
            <a:spAutoFit/>
          </a:bodyPr>
          <a:lstStyle/>
          <a:p>
            <a:pPr algn="just"/>
            <a:r>
              <a:rPr lang="en-GB" sz="1000" b="1" i="1" dirty="0">
                <a:latin typeface="Arial" panose="020B0604020202020204" pitchFamily="34" charset="0"/>
                <a:cs typeface="Arial" panose="020B0604020202020204" pitchFamily="34" charset="0"/>
              </a:rPr>
              <a:t>Supplementary Figure </a:t>
            </a:r>
            <a:r>
              <a:rPr lang="en-GB" sz="1000" b="1" i="1" dirty="0" smtClean="0">
                <a:latin typeface="Arial" panose="020B0604020202020204" pitchFamily="34" charset="0"/>
                <a:cs typeface="Arial" panose="020B0604020202020204" pitchFamily="34" charset="0"/>
              </a:rPr>
              <a:t>S.4: </a:t>
            </a:r>
            <a:r>
              <a:rPr lang="en-GB" sz="1000" i="1" dirty="0">
                <a:latin typeface="Arial" panose="020B0604020202020204" pitchFamily="34" charset="0"/>
                <a:cs typeface="Arial" panose="020B0604020202020204" pitchFamily="34" charset="0"/>
              </a:rPr>
              <a:t>AZD2014 interactions with EGFP tagged mTORC1. A) Spectral overlap between EGFP absorption and AZD2014 emission by normalisation to the maximum peaks of each spectra. B) Bar chart showing lifetimes (</a:t>
            </a:r>
            <a:r>
              <a:rPr lang="en-GB" sz="1000" i="1" dirty="0" err="1">
                <a:latin typeface="Arial" panose="020B0604020202020204" pitchFamily="34" charset="0"/>
                <a:cs typeface="Arial" panose="020B0604020202020204" pitchFamily="34" charset="0"/>
              </a:rPr>
              <a:t>ps</a:t>
            </a:r>
            <a:r>
              <a:rPr lang="en-GB" sz="1000" i="1" dirty="0">
                <a:latin typeface="Arial" panose="020B0604020202020204" pitchFamily="34" charset="0"/>
                <a:cs typeface="Arial" panose="020B0604020202020204" pitchFamily="34" charset="0"/>
              </a:rPr>
              <a:t>) of AZD2014, GFP and both mixed (1:1) in ethyl glycerol solutions using 600 nm multiphoton excitation. C) FLIM of HEK293 cells with no transfection or treatment. D) FLIM of HEK293 cells with EGFP-S6K1 only expression. E) 1</a:t>
            </a:r>
            <a:r>
              <a:rPr lang="en-GB" sz="1000" i="1" dirty="0" smtClean="0">
                <a:latin typeface="Arial" panose="020B0604020202020204" pitchFamily="34" charset="0"/>
                <a:cs typeface="Arial" panose="020B0604020202020204" pitchFamily="34" charset="0"/>
              </a:rPr>
              <a:t>, 4, 7</a:t>
            </a:r>
            <a:r>
              <a:rPr lang="en-GB" sz="1000" i="1" dirty="0">
                <a:latin typeface="Arial" panose="020B0604020202020204" pitchFamily="34" charset="0"/>
                <a:cs typeface="Arial" panose="020B0604020202020204" pitchFamily="34" charset="0"/>
              </a:rPr>
              <a:t>, </a:t>
            </a:r>
            <a:r>
              <a:rPr lang="en-GB" sz="1000" i="1" dirty="0" smtClean="0">
                <a:latin typeface="Arial" panose="020B0604020202020204" pitchFamily="34" charset="0"/>
                <a:cs typeface="Arial" panose="020B0604020202020204" pitchFamily="34" charset="0"/>
              </a:rPr>
              <a:t>10 and 13 </a:t>
            </a:r>
            <a:r>
              <a:rPr lang="en-GB" sz="1000" i="1" dirty="0">
                <a:latin typeface="Arial" panose="020B0604020202020204" pitchFamily="34" charset="0"/>
                <a:cs typeface="Arial" panose="020B0604020202020204" pitchFamily="34" charset="0"/>
              </a:rPr>
              <a:t>show confocal images at 405 nm and 488 nm excitations. 2, 5</a:t>
            </a:r>
            <a:r>
              <a:rPr lang="en-GB" sz="1000" i="1" dirty="0" smtClean="0">
                <a:latin typeface="Arial" panose="020B0604020202020204" pitchFamily="34" charset="0"/>
                <a:cs typeface="Arial" panose="020B0604020202020204" pitchFamily="34" charset="0"/>
              </a:rPr>
              <a:t>, 8</a:t>
            </a:r>
            <a:r>
              <a:rPr lang="en-GB" sz="1000" i="1" dirty="0">
                <a:latin typeface="Arial" panose="020B0604020202020204" pitchFamily="34" charset="0"/>
                <a:cs typeface="Arial" panose="020B0604020202020204" pitchFamily="34" charset="0"/>
              </a:rPr>
              <a:t>, </a:t>
            </a:r>
            <a:r>
              <a:rPr lang="en-GB" sz="1000" i="1" dirty="0" smtClean="0">
                <a:latin typeface="Arial" panose="020B0604020202020204" pitchFamily="34" charset="0"/>
                <a:cs typeface="Arial" panose="020B0604020202020204" pitchFamily="34" charset="0"/>
              </a:rPr>
              <a:t>11 and 14 </a:t>
            </a:r>
            <a:r>
              <a:rPr lang="en-GB" sz="1000" i="1" dirty="0">
                <a:latin typeface="Arial" panose="020B0604020202020204" pitchFamily="34" charset="0"/>
                <a:cs typeface="Arial" panose="020B0604020202020204" pitchFamily="34" charset="0"/>
              </a:rPr>
              <a:t>show FLIM at 600 nm excitation with respective lifetime distribution histograms shown in 3</a:t>
            </a:r>
            <a:r>
              <a:rPr lang="en-GB" sz="1000" i="1" dirty="0" smtClean="0">
                <a:latin typeface="Arial" panose="020B0604020202020204" pitchFamily="34" charset="0"/>
                <a:cs typeface="Arial" panose="020B0604020202020204" pitchFamily="34" charset="0"/>
              </a:rPr>
              <a:t>, 6, 9,12</a:t>
            </a:r>
            <a:r>
              <a:rPr lang="en-GB" sz="1000" i="1" dirty="0" smtClean="0">
                <a:latin typeface="Arial" panose="020B0604020202020204" pitchFamily="34" charset="0"/>
                <a:cs typeface="Arial" panose="020B0604020202020204" pitchFamily="34" charset="0"/>
              </a:rPr>
              <a:t>, and 15. Error </a:t>
            </a:r>
            <a:r>
              <a:rPr lang="en-GB" sz="1000" i="1" dirty="0">
                <a:latin typeface="Arial" panose="020B0604020202020204" pitchFamily="34" charset="0"/>
                <a:cs typeface="Arial" panose="020B0604020202020204" pitchFamily="34" charset="0"/>
              </a:rPr>
              <a:t>bars show standard </a:t>
            </a:r>
            <a:r>
              <a:rPr lang="en-GB" sz="1000" i="1" dirty="0" smtClean="0">
                <a:latin typeface="Arial" panose="020B0604020202020204" pitchFamily="34" charset="0"/>
                <a:cs typeface="Arial" panose="020B0604020202020204" pitchFamily="34" charset="0"/>
              </a:rPr>
              <a:t>deviation</a:t>
            </a:r>
            <a:r>
              <a:rPr lang="en-GB" sz="1000" i="1" dirty="0">
                <a:latin typeface="Arial" panose="020B0604020202020204" pitchFamily="34" charset="0"/>
                <a:cs typeface="Arial" panose="020B0604020202020204" pitchFamily="34" charset="0"/>
              </a:rPr>
              <a:t> </a:t>
            </a:r>
            <a:r>
              <a:rPr lang="en-GB" sz="1000" i="1" dirty="0" smtClean="0">
                <a:latin typeface="Arial" panose="020B0604020202020204" pitchFamily="34" charset="0"/>
                <a:cs typeface="Arial" panose="020B0604020202020204" pitchFamily="34" charset="0"/>
              </a:rPr>
              <a:t>(n&gt;3).</a:t>
            </a:r>
            <a:endParaRPr lang="en-GB" sz="1000" b="1" i="1" dirty="0">
              <a:latin typeface="Arial" panose="020B0604020202020204" pitchFamily="34" charset="0"/>
              <a:cs typeface="Arial" panose="020B0604020202020204" pitchFamily="34" charset="0"/>
            </a:endParaRPr>
          </a:p>
        </p:txBody>
      </p:sp>
    </p:spTree>
    <p:extLst>
      <p:ext uri="{BB962C8B-B14F-4D97-AF65-F5344CB8AC3E}">
        <p14:creationId xmlns:p14="http://schemas.microsoft.com/office/powerpoint/2010/main" val="3005278998"/>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Rectangle 2">
            <a:extLst>
              <a:ext uri="{FF2B5EF4-FFF2-40B4-BE49-F238E27FC236}">
                <a16:creationId xmlns:a16="http://schemas.microsoft.com/office/drawing/2014/main" id="{71BE4030-2DFE-44D3-A9B0-F75B034BFDE4}"/>
              </a:ext>
            </a:extLst>
          </p:cNvPr>
          <p:cNvSpPr/>
          <p:nvPr/>
        </p:nvSpPr>
        <p:spPr>
          <a:xfrm>
            <a:off x="269532" y="5747512"/>
            <a:ext cx="8546265" cy="861774"/>
          </a:xfrm>
          <a:prstGeom prst="rect">
            <a:avLst/>
          </a:prstGeom>
        </p:spPr>
        <p:txBody>
          <a:bodyPr wrap="square">
            <a:spAutoFit/>
          </a:bodyPr>
          <a:lstStyle/>
          <a:p>
            <a:pPr algn="just">
              <a:spcAft>
                <a:spcPts val="1000"/>
              </a:spcAft>
            </a:pPr>
            <a:r>
              <a:rPr lang="en-GB" sz="1000" b="1" i="1" dirty="0"/>
              <a:t>Supplementary Figure </a:t>
            </a:r>
            <a:r>
              <a:rPr lang="en-GB" sz="1000" b="1" i="1" dirty="0" smtClean="0"/>
              <a:t>S.5: </a:t>
            </a:r>
            <a:r>
              <a:rPr lang="en-GB" sz="1000" b="1" i="1" dirty="0"/>
              <a:t>PDT effect in </a:t>
            </a:r>
            <a:r>
              <a:rPr lang="en-GB" sz="1000" b="1" i="1" dirty="0" smtClean="0"/>
              <a:t>cell </a:t>
            </a:r>
            <a:r>
              <a:rPr lang="en-GB" sz="1000" b="1" i="1" dirty="0"/>
              <a:t>lines using one-photon and two-photon excitation. </a:t>
            </a:r>
            <a:r>
              <a:rPr lang="en-GB" sz="1000" i="1" dirty="0"/>
              <a:t>A) Compilation of confocal overlay channel (561 nm and transmitted light) images over time and laser power showing cell death (as indicated by red fluorescence staining of PI) in CHO cells following treatment of AZD2014 (3.5 µM) and then 405 nm (CW) irradiation of FOV shown in cyan blue box </a:t>
            </a:r>
            <a:r>
              <a:rPr lang="pl-PL" sz="1000" i="1" dirty="0"/>
              <a:t>405 nm</a:t>
            </a:r>
            <a:r>
              <a:rPr lang="en-GB" sz="1000" i="1" dirty="0"/>
              <a:t>. B) Treatment and irradiation of HEK293 cells with AZD2014 (7 µM) over time and laser powers. C) Treatment and irradiation of HEK293 cells with AZD2014 (7 µM) over time using </a:t>
            </a:r>
            <a:r>
              <a:rPr lang="pt-BR" sz="1000" i="1" dirty="0"/>
              <a:t>800 nm excitation (8.4 mW, 120 fs, 80 MHz), which at scan </a:t>
            </a:r>
            <a:r>
              <a:rPr lang="pt-BR" sz="1000" i="1" dirty="0" smtClean="0"/>
              <a:t>times </a:t>
            </a:r>
            <a:r>
              <a:rPr lang="pt-BR" sz="1000" i="1" dirty="0"/>
              <a:t>used delivers 2.7 nW per pixel. Controls of cells without AZD2014 treatment but with irradiation are also </a:t>
            </a:r>
            <a:r>
              <a:rPr lang="pt-BR" sz="1000" i="1" dirty="0" smtClean="0"/>
              <a:t>shown (n&gt;3).</a:t>
            </a:r>
            <a:endParaRPr lang="pl-PL" sz="1000" i="1" dirty="0">
              <a:latin typeface="Arial" panose="020B0604020202020204" pitchFamily="34" charset="0"/>
              <a:ea typeface="Calibri" panose="020F0502020204030204" pitchFamily="34" charset="0"/>
              <a:cs typeface="Times New Roman" panose="02020603050405020304" pitchFamily="18" charset="0"/>
            </a:endParaRPr>
          </a:p>
        </p:txBody>
      </p:sp>
      <p:pic>
        <p:nvPicPr>
          <p:cNvPr id="65" name="Immagine 137">
            <a:extLst>
              <a:ext uri="{FF2B5EF4-FFF2-40B4-BE49-F238E27FC236}">
                <a16:creationId xmlns:a16="http://schemas.microsoft.com/office/drawing/2014/main" id="{97BCFB19-6103-414A-A445-E765C990692C}"/>
              </a:ext>
            </a:extLst>
          </p:cNvPr>
          <p:cNvPicPr>
            <a:picLocks noChangeAspect="1"/>
          </p:cNvPicPr>
          <p:nvPr/>
        </p:nvPicPr>
        <p:blipFill>
          <a:blip r:embed="rId2" cstate="print">
            <a:extLst>
              <a:ext uri="{BEBA8EAE-BF5A-486C-A8C5-ECC9F3942E4B}">
                <a14:imgProps xmlns:a14="http://schemas.microsoft.com/office/drawing/2010/main">
                  <a14:imgLayer r:embed="rId3">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7253289" y="3950061"/>
            <a:ext cx="1408721" cy="1408721"/>
          </a:xfrm>
          <a:prstGeom prst="rect">
            <a:avLst/>
          </a:prstGeom>
        </p:spPr>
      </p:pic>
      <p:pic>
        <p:nvPicPr>
          <p:cNvPr id="67" name="Immagine 138">
            <a:extLst>
              <a:ext uri="{FF2B5EF4-FFF2-40B4-BE49-F238E27FC236}">
                <a16:creationId xmlns:a16="http://schemas.microsoft.com/office/drawing/2014/main" id="{767B9ABE-0875-43A6-8DC7-C4734A68671C}"/>
              </a:ext>
            </a:extLst>
          </p:cNvPr>
          <p:cNvPicPr>
            <a:picLocks noChangeAspect="1"/>
          </p:cNvPicPr>
          <p:nvPr/>
        </p:nvPicPr>
        <p:blipFill>
          <a:blip r:embed="rId4" cstate="print">
            <a:extLst>
              <a:ext uri="{BEBA8EAE-BF5A-486C-A8C5-ECC9F3942E4B}">
                <a14:imgProps xmlns:a14="http://schemas.microsoft.com/office/drawing/2010/main">
                  <a14:imgLayer r:embed="rId5">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1440070" y="3950061"/>
            <a:ext cx="1408721" cy="1408721"/>
          </a:xfrm>
          <a:prstGeom prst="rect">
            <a:avLst/>
          </a:prstGeom>
        </p:spPr>
      </p:pic>
      <p:pic>
        <p:nvPicPr>
          <p:cNvPr id="73" name="Immagine 139">
            <a:extLst>
              <a:ext uri="{FF2B5EF4-FFF2-40B4-BE49-F238E27FC236}">
                <a16:creationId xmlns:a16="http://schemas.microsoft.com/office/drawing/2014/main" id="{FD5A1126-C922-4D64-BEC5-251A04087EF4}"/>
              </a:ext>
            </a:extLst>
          </p:cNvPr>
          <p:cNvPicPr>
            <a:picLocks noChangeAspect="1"/>
          </p:cNvPicPr>
          <p:nvPr/>
        </p:nvPicPr>
        <p:blipFill>
          <a:blip r:embed="rId6" cstate="print">
            <a:extLst>
              <a:ext uri="{BEBA8EAE-BF5A-486C-A8C5-ECC9F3942E4B}">
                <a14:imgProps xmlns:a14="http://schemas.microsoft.com/office/drawing/2010/main">
                  <a14:imgLayer r:embed="rId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2884521" y="3950061"/>
            <a:ext cx="1408721" cy="1408721"/>
          </a:xfrm>
          <a:prstGeom prst="rect">
            <a:avLst/>
          </a:prstGeom>
        </p:spPr>
      </p:pic>
      <p:pic>
        <p:nvPicPr>
          <p:cNvPr id="74" name="Immagine 140">
            <a:extLst>
              <a:ext uri="{FF2B5EF4-FFF2-40B4-BE49-F238E27FC236}">
                <a16:creationId xmlns:a16="http://schemas.microsoft.com/office/drawing/2014/main" id="{E758C419-9027-4BE9-B331-78143D2867CA}"/>
              </a:ext>
            </a:extLst>
          </p:cNvPr>
          <p:cNvPicPr>
            <a:picLocks noChangeAspect="1"/>
          </p:cNvPicPr>
          <p:nvPr/>
        </p:nvPicPr>
        <p:blipFill>
          <a:blip r:embed="rId8" cstate="print">
            <a:extLst>
              <a:ext uri="{BEBA8EAE-BF5A-486C-A8C5-ECC9F3942E4B}">
                <a14:imgProps xmlns:a14="http://schemas.microsoft.com/office/drawing/2010/main">
                  <a14:imgLayer r:embed="rId9">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4328973" y="3950061"/>
            <a:ext cx="1408721" cy="1408721"/>
          </a:xfrm>
          <a:prstGeom prst="rect">
            <a:avLst/>
          </a:prstGeom>
        </p:spPr>
      </p:pic>
      <p:pic>
        <p:nvPicPr>
          <p:cNvPr id="75" name="Immagine 141">
            <a:extLst>
              <a:ext uri="{FF2B5EF4-FFF2-40B4-BE49-F238E27FC236}">
                <a16:creationId xmlns:a16="http://schemas.microsoft.com/office/drawing/2014/main" id="{8EA8ED9D-26EA-4C92-960E-0BFA28F23776}"/>
              </a:ext>
            </a:extLst>
          </p:cNvPr>
          <p:cNvPicPr>
            <a:picLocks noChangeAspect="1"/>
          </p:cNvPicPr>
          <p:nvPr/>
        </p:nvPicPr>
        <p:blipFill>
          <a:blip r:embed="rId10" cstate="print">
            <a:extLst>
              <a:ext uri="{BEBA8EAE-BF5A-486C-A8C5-ECC9F3942E4B}">
                <a14:imgProps xmlns:a14="http://schemas.microsoft.com/office/drawing/2010/main">
                  <a14:imgLayer r:embed="rId11">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5773425" y="3950061"/>
            <a:ext cx="1408721" cy="1408721"/>
          </a:xfrm>
          <a:prstGeom prst="rect">
            <a:avLst/>
          </a:prstGeom>
        </p:spPr>
      </p:pic>
      <p:sp>
        <p:nvSpPr>
          <p:cNvPr id="77" name="CasellaDiTesto 144">
            <a:extLst>
              <a:ext uri="{FF2B5EF4-FFF2-40B4-BE49-F238E27FC236}">
                <a16:creationId xmlns:a16="http://schemas.microsoft.com/office/drawing/2014/main" id="{FEBECDD0-F093-44FD-9055-DA5EFCFF05BE}"/>
              </a:ext>
            </a:extLst>
          </p:cNvPr>
          <p:cNvSpPr txBox="1"/>
          <p:nvPr/>
        </p:nvSpPr>
        <p:spPr>
          <a:xfrm>
            <a:off x="1855682" y="3626431"/>
            <a:ext cx="537327" cy="276999"/>
          </a:xfrm>
          <a:prstGeom prst="rect">
            <a:avLst/>
          </a:prstGeom>
          <a:noFill/>
        </p:spPr>
        <p:txBody>
          <a:bodyPr wrap="none" rtlCol="0">
            <a:spAutoFit/>
          </a:bodyPr>
          <a:lstStyle/>
          <a:p>
            <a:r>
              <a:rPr lang="it-IT" sz="1200" dirty="0"/>
              <a:t>1 </a:t>
            </a:r>
            <a:r>
              <a:rPr lang="it-IT" sz="1200" dirty="0" err="1"/>
              <a:t>min</a:t>
            </a:r>
            <a:endParaRPr lang="it-IT" sz="1200" dirty="0"/>
          </a:p>
        </p:txBody>
      </p:sp>
      <p:sp>
        <p:nvSpPr>
          <p:cNvPr id="78" name="CasellaDiTesto 145">
            <a:extLst>
              <a:ext uri="{FF2B5EF4-FFF2-40B4-BE49-F238E27FC236}">
                <a16:creationId xmlns:a16="http://schemas.microsoft.com/office/drawing/2014/main" id="{D82517D1-B187-4D62-B8A4-2921B62C2710}"/>
              </a:ext>
            </a:extLst>
          </p:cNvPr>
          <p:cNvSpPr txBox="1"/>
          <p:nvPr/>
        </p:nvSpPr>
        <p:spPr>
          <a:xfrm>
            <a:off x="3262681" y="3626431"/>
            <a:ext cx="495649" cy="276999"/>
          </a:xfrm>
          <a:prstGeom prst="rect">
            <a:avLst/>
          </a:prstGeom>
          <a:noFill/>
        </p:spPr>
        <p:txBody>
          <a:bodyPr wrap="none" rtlCol="0">
            <a:spAutoFit/>
          </a:bodyPr>
          <a:lstStyle/>
          <a:p>
            <a:r>
              <a:rPr lang="it-IT" sz="1200" dirty="0"/>
              <a:t>1.5 </a:t>
            </a:r>
            <a:r>
              <a:rPr lang="it-IT" sz="1200" dirty="0" smtClean="0"/>
              <a:t>h</a:t>
            </a:r>
            <a:endParaRPr lang="it-IT" sz="1200" dirty="0"/>
          </a:p>
        </p:txBody>
      </p:sp>
      <p:sp>
        <p:nvSpPr>
          <p:cNvPr id="79" name="CasellaDiTesto 146">
            <a:extLst>
              <a:ext uri="{FF2B5EF4-FFF2-40B4-BE49-F238E27FC236}">
                <a16:creationId xmlns:a16="http://schemas.microsoft.com/office/drawing/2014/main" id="{44C5511F-FA04-4B2F-BA60-1CFFB1E24D0B}"/>
              </a:ext>
            </a:extLst>
          </p:cNvPr>
          <p:cNvSpPr txBox="1"/>
          <p:nvPr/>
        </p:nvSpPr>
        <p:spPr>
          <a:xfrm>
            <a:off x="4646739" y="3626431"/>
            <a:ext cx="457176" cy="276999"/>
          </a:xfrm>
          <a:prstGeom prst="rect">
            <a:avLst/>
          </a:prstGeom>
          <a:noFill/>
        </p:spPr>
        <p:txBody>
          <a:bodyPr wrap="none" rtlCol="0">
            <a:spAutoFit/>
          </a:bodyPr>
          <a:lstStyle/>
          <a:p>
            <a:r>
              <a:rPr lang="it-IT" sz="1200" dirty="0"/>
              <a:t>15 </a:t>
            </a:r>
            <a:r>
              <a:rPr lang="it-IT" sz="1200" dirty="0" smtClean="0"/>
              <a:t>h</a:t>
            </a:r>
            <a:endParaRPr lang="it-IT" sz="1200" dirty="0"/>
          </a:p>
        </p:txBody>
      </p:sp>
      <p:sp>
        <p:nvSpPr>
          <p:cNvPr id="80" name="CasellaDiTesto 147">
            <a:extLst>
              <a:ext uri="{FF2B5EF4-FFF2-40B4-BE49-F238E27FC236}">
                <a16:creationId xmlns:a16="http://schemas.microsoft.com/office/drawing/2014/main" id="{363E026F-CF2C-42DF-85EF-374EB2A6DE67}"/>
              </a:ext>
            </a:extLst>
          </p:cNvPr>
          <p:cNvSpPr txBox="1"/>
          <p:nvPr/>
        </p:nvSpPr>
        <p:spPr>
          <a:xfrm>
            <a:off x="6174856" y="3626431"/>
            <a:ext cx="457176" cy="276999"/>
          </a:xfrm>
          <a:prstGeom prst="rect">
            <a:avLst/>
          </a:prstGeom>
          <a:noFill/>
        </p:spPr>
        <p:txBody>
          <a:bodyPr wrap="none" rtlCol="0">
            <a:spAutoFit/>
          </a:bodyPr>
          <a:lstStyle/>
          <a:p>
            <a:r>
              <a:rPr lang="it-IT" sz="1200" dirty="0"/>
              <a:t>24 </a:t>
            </a:r>
            <a:r>
              <a:rPr lang="it-IT" sz="1200" dirty="0" smtClean="0"/>
              <a:t>h</a:t>
            </a:r>
            <a:endParaRPr lang="it-IT" sz="1200" dirty="0"/>
          </a:p>
        </p:txBody>
      </p:sp>
      <p:grpSp>
        <p:nvGrpSpPr>
          <p:cNvPr id="81" name="Gruppo 150">
            <a:extLst>
              <a:ext uri="{FF2B5EF4-FFF2-40B4-BE49-F238E27FC236}">
                <a16:creationId xmlns:a16="http://schemas.microsoft.com/office/drawing/2014/main" id="{4B95B34B-D0AE-478B-B43B-29288F9A8CC4}"/>
              </a:ext>
            </a:extLst>
          </p:cNvPr>
          <p:cNvGrpSpPr/>
          <p:nvPr/>
        </p:nvGrpSpPr>
        <p:grpSpPr>
          <a:xfrm>
            <a:off x="1892524" y="4428603"/>
            <a:ext cx="4837166" cy="481715"/>
            <a:chOff x="2216142" y="1099230"/>
            <a:chExt cx="4837166" cy="481715"/>
          </a:xfrm>
        </p:grpSpPr>
        <p:sp>
          <p:nvSpPr>
            <p:cNvPr id="82" name="Rettangolo 151">
              <a:extLst>
                <a:ext uri="{FF2B5EF4-FFF2-40B4-BE49-F238E27FC236}">
                  <a16:creationId xmlns:a16="http://schemas.microsoft.com/office/drawing/2014/main" id="{DCE52EC9-A616-4CAE-8AEA-D861A949E4B3}"/>
                </a:ext>
              </a:extLst>
            </p:cNvPr>
            <p:cNvSpPr/>
            <p:nvPr/>
          </p:nvSpPr>
          <p:spPr>
            <a:xfrm>
              <a:off x="6549498" y="1099230"/>
              <a:ext cx="503810" cy="48171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83" name="Rettangolo 152">
              <a:extLst>
                <a:ext uri="{FF2B5EF4-FFF2-40B4-BE49-F238E27FC236}">
                  <a16:creationId xmlns:a16="http://schemas.microsoft.com/office/drawing/2014/main" id="{1D61CCF3-4A8B-4F56-9221-57F016C4FAEC}"/>
                </a:ext>
              </a:extLst>
            </p:cNvPr>
            <p:cNvSpPr/>
            <p:nvPr/>
          </p:nvSpPr>
          <p:spPr>
            <a:xfrm>
              <a:off x="5105046" y="1099230"/>
              <a:ext cx="503810" cy="48171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84" name="Rettangolo 153">
              <a:extLst>
                <a:ext uri="{FF2B5EF4-FFF2-40B4-BE49-F238E27FC236}">
                  <a16:creationId xmlns:a16="http://schemas.microsoft.com/office/drawing/2014/main" id="{14D3BD82-AB85-4068-822D-991990453A3E}"/>
                </a:ext>
              </a:extLst>
            </p:cNvPr>
            <p:cNvSpPr/>
            <p:nvPr/>
          </p:nvSpPr>
          <p:spPr>
            <a:xfrm>
              <a:off x="3660594" y="1099230"/>
              <a:ext cx="503810" cy="48171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85" name="Rettangolo 154">
              <a:extLst>
                <a:ext uri="{FF2B5EF4-FFF2-40B4-BE49-F238E27FC236}">
                  <a16:creationId xmlns:a16="http://schemas.microsoft.com/office/drawing/2014/main" id="{44D16784-7FAC-4EFC-84FC-13E29F7A7B9F}"/>
                </a:ext>
              </a:extLst>
            </p:cNvPr>
            <p:cNvSpPr/>
            <p:nvPr/>
          </p:nvSpPr>
          <p:spPr>
            <a:xfrm>
              <a:off x="2216142" y="1099230"/>
              <a:ext cx="503810" cy="48171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sp>
        <p:nvSpPr>
          <p:cNvPr id="86" name="Rettangolo 155">
            <a:extLst>
              <a:ext uri="{FF2B5EF4-FFF2-40B4-BE49-F238E27FC236}">
                <a16:creationId xmlns:a16="http://schemas.microsoft.com/office/drawing/2014/main" id="{1E19E62B-50E8-461D-99E0-16489A4D5749}"/>
              </a:ext>
            </a:extLst>
          </p:cNvPr>
          <p:cNvSpPr/>
          <p:nvPr/>
        </p:nvSpPr>
        <p:spPr>
          <a:xfrm>
            <a:off x="7705743" y="4423567"/>
            <a:ext cx="503810" cy="481715"/>
          </a:xfrm>
          <a:prstGeom prst="rect">
            <a:avLst/>
          </a:prstGeom>
          <a:noFill/>
          <a:ln>
            <a:solidFill>
              <a:srgbClr val="FF0000"/>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87" name="CasellaDiTesto 156">
            <a:extLst>
              <a:ext uri="{FF2B5EF4-FFF2-40B4-BE49-F238E27FC236}">
                <a16:creationId xmlns:a16="http://schemas.microsoft.com/office/drawing/2014/main" id="{A5A5B0E2-D403-4F17-99EE-1C6259908351}"/>
              </a:ext>
            </a:extLst>
          </p:cNvPr>
          <p:cNvSpPr txBox="1"/>
          <p:nvPr/>
        </p:nvSpPr>
        <p:spPr>
          <a:xfrm>
            <a:off x="7446937" y="3648525"/>
            <a:ext cx="991875" cy="276999"/>
          </a:xfrm>
          <a:prstGeom prst="rect">
            <a:avLst/>
          </a:prstGeom>
          <a:noFill/>
        </p:spPr>
        <p:txBody>
          <a:bodyPr wrap="none" rtlCol="0">
            <a:spAutoFit/>
          </a:bodyPr>
          <a:lstStyle/>
          <a:p>
            <a:r>
              <a:rPr lang="it-IT" sz="1200" dirty="0"/>
              <a:t>Control 2.5 h</a:t>
            </a:r>
          </a:p>
        </p:txBody>
      </p:sp>
      <p:sp>
        <p:nvSpPr>
          <p:cNvPr id="88" name="Rettangolo arrotondato 25">
            <a:extLst>
              <a:ext uri="{FF2B5EF4-FFF2-40B4-BE49-F238E27FC236}">
                <a16:creationId xmlns:a16="http://schemas.microsoft.com/office/drawing/2014/main" id="{8C178FB4-BC79-424A-AC94-A3EC700D93CB}"/>
              </a:ext>
            </a:extLst>
          </p:cNvPr>
          <p:cNvSpPr/>
          <p:nvPr/>
        </p:nvSpPr>
        <p:spPr bwMode="auto">
          <a:xfrm>
            <a:off x="4542665" y="-99279"/>
            <a:ext cx="1458650" cy="802370"/>
          </a:xfrm>
          <a:prstGeom prst="roundRect">
            <a:avLst>
              <a:gd name="adj" fmla="val 9284"/>
            </a:avLst>
          </a:prstGeom>
          <a:noFill/>
          <a:ln w="9525" cap="flat" cmpd="sng" algn="ctr">
            <a:noFill/>
            <a:prstDash val="solid"/>
            <a:round/>
            <a:headEnd type="none" w="med" len="med"/>
            <a:tailEnd type="none" w="med" len="med"/>
          </a:ln>
          <a:effectLst/>
        </p:spPr>
        <p:txBody>
          <a:bodyPr rtlCol="0" anchor="ctr"/>
          <a:lstStyle/>
          <a:p>
            <a:pPr algn="ctr"/>
            <a:endParaRPr lang="it-IT" sz="1200"/>
          </a:p>
        </p:txBody>
      </p:sp>
      <p:sp>
        <p:nvSpPr>
          <p:cNvPr id="89" name="Rettangolo arrotondato 27">
            <a:extLst>
              <a:ext uri="{FF2B5EF4-FFF2-40B4-BE49-F238E27FC236}">
                <a16:creationId xmlns:a16="http://schemas.microsoft.com/office/drawing/2014/main" id="{47A269E9-3989-47D2-AFAD-AC1ED9E726B4}"/>
              </a:ext>
            </a:extLst>
          </p:cNvPr>
          <p:cNvSpPr/>
          <p:nvPr/>
        </p:nvSpPr>
        <p:spPr bwMode="auto">
          <a:xfrm>
            <a:off x="119315" y="-93757"/>
            <a:ext cx="1458650" cy="802370"/>
          </a:xfrm>
          <a:prstGeom prst="roundRect">
            <a:avLst>
              <a:gd name="adj" fmla="val 9284"/>
            </a:avLst>
          </a:prstGeom>
          <a:noFill/>
          <a:ln w="9525" cap="flat" cmpd="sng" algn="ctr">
            <a:noFill/>
            <a:prstDash val="solid"/>
            <a:round/>
            <a:headEnd type="none" w="med" len="med"/>
            <a:tailEnd type="none" w="med" len="med"/>
          </a:ln>
          <a:effectLst/>
        </p:spPr>
        <p:txBody>
          <a:bodyPr rtlCol="0" anchor="ctr"/>
          <a:lstStyle/>
          <a:p>
            <a:pPr algn="ctr"/>
            <a:endParaRPr lang="it-IT" sz="1200"/>
          </a:p>
        </p:txBody>
      </p:sp>
      <p:pic>
        <p:nvPicPr>
          <p:cNvPr id="91" name="Immagine 30">
            <a:extLst>
              <a:ext uri="{FF2B5EF4-FFF2-40B4-BE49-F238E27FC236}">
                <a16:creationId xmlns:a16="http://schemas.microsoft.com/office/drawing/2014/main" id="{CB2255BD-EB8B-4C99-8690-563FCCC31D4E}"/>
              </a:ext>
            </a:extLst>
          </p:cNvPr>
          <p:cNvPicPr>
            <a:picLocks noChangeAspect="1"/>
          </p:cNvPicPr>
          <p:nvPr/>
        </p:nvPicPr>
        <p:blipFill>
          <a:blip r:embed="rId12" cstate="print">
            <a:extLst>
              <a:ext uri="{BEBA8EAE-BF5A-486C-A8C5-ECC9F3942E4B}">
                <a14:imgProps xmlns:a14="http://schemas.microsoft.com/office/drawing/2010/main">
                  <a14:imgLayer r:embed="rId13">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1423400" y="2302619"/>
            <a:ext cx="949390" cy="949389"/>
          </a:xfrm>
          <a:prstGeom prst="rect">
            <a:avLst/>
          </a:prstGeom>
        </p:spPr>
      </p:pic>
      <p:pic>
        <p:nvPicPr>
          <p:cNvPr id="92" name="Immagine 32">
            <a:extLst>
              <a:ext uri="{FF2B5EF4-FFF2-40B4-BE49-F238E27FC236}">
                <a16:creationId xmlns:a16="http://schemas.microsoft.com/office/drawing/2014/main" id="{6FB7431F-BC11-4C0B-87BE-C56CDA061B89}"/>
              </a:ext>
            </a:extLst>
          </p:cNvPr>
          <p:cNvPicPr>
            <a:picLocks noChangeAspect="1"/>
          </p:cNvPicPr>
          <p:nvPr/>
        </p:nvPicPr>
        <p:blipFill>
          <a:blip r:embed="rId14" cstate="print">
            <a:extLst>
              <a:ext uri="{BEBA8EAE-BF5A-486C-A8C5-ECC9F3942E4B}">
                <a14:imgProps xmlns:a14="http://schemas.microsoft.com/office/drawing/2010/main">
                  <a14:imgLayer r:embed="rId15">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396870" y="2302619"/>
            <a:ext cx="949390" cy="949389"/>
          </a:xfrm>
          <a:prstGeom prst="rect">
            <a:avLst/>
          </a:prstGeom>
        </p:spPr>
      </p:pic>
      <p:pic>
        <p:nvPicPr>
          <p:cNvPr id="93" name="Immagine 33">
            <a:extLst>
              <a:ext uri="{FF2B5EF4-FFF2-40B4-BE49-F238E27FC236}">
                <a16:creationId xmlns:a16="http://schemas.microsoft.com/office/drawing/2014/main" id="{509D9116-B23D-43F3-9D6A-20F076F4E0EE}"/>
              </a:ext>
            </a:extLst>
          </p:cNvPr>
          <p:cNvPicPr>
            <a:picLocks noChangeAspect="1"/>
          </p:cNvPicPr>
          <p:nvPr/>
        </p:nvPicPr>
        <p:blipFill>
          <a:blip r:embed="rId16" cstate="print">
            <a:extLst>
              <a:ext uri="{BEBA8EAE-BF5A-486C-A8C5-ECC9F3942E4B}">
                <a14:imgProps xmlns:a14="http://schemas.microsoft.com/office/drawing/2010/main">
                  <a14:imgLayer r:embed="rId17">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1423400" y="1307976"/>
            <a:ext cx="949390" cy="949389"/>
          </a:xfrm>
          <a:prstGeom prst="rect">
            <a:avLst/>
          </a:prstGeom>
        </p:spPr>
      </p:pic>
      <p:pic>
        <p:nvPicPr>
          <p:cNvPr id="94" name="Immagine 34">
            <a:extLst>
              <a:ext uri="{FF2B5EF4-FFF2-40B4-BE49-F238E27FC236}">
                <a16:creationId xmlns:a16="http://schemas.microsoft.com/office/drawing/2014/main" id="{6EA1CBC5-2DFD-4199-B0E0-564C7880A6B9}"/>
              </a:ext>
            </a:extLst>
          </p:cNvPr>
          <p:cNvPicPr>
            <a:picLocks noChangeAspect="1"/>
          </p:cNvPicPr>
          <p:nvPr/>
        </p:nvPicPr>
        <p:blipFill>
          <a:blip r:embed="rId18" cstate="print">
            <a:extLst>
              <a:ext uri="{BEBA8EAE-BF5A-486C-A8C5-ECC9F3942E4B}">
                <a14:imgProps xmlns:a14="http://schemas.microsoft.com/office/drawing/2010/main">
                  <a14:imgLayer r:embed="rId19">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396870" y="1307976"/>
            <a:ext cx="949390" cy="949389"/>
          </a:xfrm>
          <a:prstGeom prst="rect">
            <a:avLst/>
          </a:prstGeom>
        </p:spPr>
      </p:pic>
      <p:pic>
        <p:nvPicPr>
          <p:cNvPr id="95" name="Immagine 35">
            <a:extLst>
              <a:ext uri="{FF2B5EF4-FFF2-40B4-BE49-F238E27FC236}">
                <a16:creationId xmlns:a16="http://schemas.microsoft.com/office/drawing/2014/main" id="{4EB955E2-158E-4B01-A96C-853B3166A1AF}"/>
              </a:ext>
            </a:extLst>
          </p:cNvPr>
          <p:cNvPicPr>
            <a:picLocks noChangeAspect="1"/>
          </p:cNvPicPr>
          <p:nvPr/>
        </p:nvPicPr>
        <p:blipFill>
          <a:blip r:embed="rId20" cstate="print">
            <a:extLst>
              <a:ext uri="{BEBA8EAE-BF5A-486C-A8C5-ECC9F3942E4B}">
                <a14:imgProps xmlns:a14="http://schemas.microsoft.com/office/drawing/2010/main">
                  <a14:imgLayer r:embed="rId21">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1423400" y="314160"/>
            <a:ext cx="949390" cy="949389"/>
          </a:xfrm>
          <a:prstGeom prst="rect">
            <a:avLst/>
          </a:prstGeom>
        </p:spPr>
      </p:pic>
      <p:pic>
        <p:nvPicPr>
          <p:cNvPr id="96" name="Immagine 36">
            <a:extLst>
              <a:ext uri="{FF2B5EF4-FFF2-40B4-BE49-F238E27FC236}">
                <a16:creationId xmlns:a16="http://schemas.microsoft.com/office/drawing/2014/main" id="{84744A40-AB27-4737-AE34-AFEAC98D3394}"/>
              </a:ext>
            </a:extLst>
          </p:cNvPr>
          <p:cNvPicPr>
            <a:picLocks noChangeAspect="1"/>
          </p:cNvPicPr>
          <p:nvPr/>
        </p:nvPicPr>
        <p:blipFill>
          <a:blip r:embed="rId22" cstate="print">
            <a:extLst>
              <a:ext uri="{BEBA8EAE-BF5A-486C-A8C5-ECC9F3942E4B}">
                <a14:imgProps xmlns:a14="http://schemas.microsoft.com/office/drawing/2010/main">
                  <a14:imgLayer r:embed="rId23">
                    <a14:imgEffect>
                      <a14:brightnessContrast bright="20000" contrast="40000"/>
                    </a14:imgEffect>
                  </a14:imgLayer>
                </a14:imgProps>
              </a:ext>
              <a:ext uri="{28A0092B-C50C-407E-A947-70E740481C1C}">
                <a14:useLocalDpi xmlns:a14="http://schemas.microsoft.com/office/drawing/2010/main" val="0"/>
              </a:ext>
            </a:extLst>
          </a:blip>
          <a:stretch>
            <a:fillRect/>
          </a:stretch>
        </p:blipFill>
        <p:spPr>
          <a:xfrm>
            <a:off x="2396870" y="314160"/>
            <a:ext cx="949390" cy="949389"/>
          </a:xfrm>
          <a:prstGeom prst="rect">
            <a:avLst/>
          </a:prstGeom>
        </p:spPr>
      </p:pic>
      <p:sp>
        <p:nvSpPr>
          <p:cNvPr id="97" name="CasellaDiTesto 37">
            <a:extLst>
              <a:ext uri="{FF2B5EF4-FFF2-40B4-BE49-F238E27FC236}">
                <a16:creationId xmlns:a16="http://schemas.microsoft.com/office/drawing/2014/main" id="{96ED3D92-F30E-45BF-9CD9-D1DF5FF9BA95}"/>
              </a:ext>
            </a:extLst>
          </p:cNvPr>
          <p:cNvSpPr txBox="1"/>
          <p:nvPr/>
        </p:nvSpPr>
        <p:spPr>
          <a:xfrm>
            <a:off x="572515" y="664401"/>
            <a:ext cx="593432" cy="276999"/>
          </a:xfrm>
          <a:prstGeom prst="rect">
            <a:avLst/>
          </a:prstGeom>
          <a:noFill/>
        </p:spPr>
        <p:txBody>
          <a:bodyPr wrap="none" rtlCol="0">
            <a:spAutoFit/>
          </a:bodyPr>
          <a:lstStyle/>
          <a:p>
            <a:r>
              <a:rPr lang="it-IT" sz="1200" dirty="0"/>
              <a:t>75 </a:t>
            </a:r>
            <a:r>
              <a:rPr lang="it-IT" sz="1200" dirty="0" err="1"/>
              <a:t>uW</a:t>
            </a:r>
            <a:endParaRPr lang="it-IT" sz="1200" dirty="0"/>
          </a:p>
        </p:txBody>
      </p:sp>
      <p:sp>
        <p:nvSpPr>
          <p:cNvPr id="98" name="CasellaDiTesto 38">
            <a:extLst>
              <a:ext uri="{FF2B5EF4-FFF2-40B4-BE49-F238E27FC236}">
                <a16:creationId xmlns:a16="http://schemas.microsoft.com/office/drawing/2014/main" id="{6130B6C0-0D16-404F-A393-788EB37441E3}"/>
              </a:ext>
            </a:extLst>
          </p:cNvPr>
          <p:cNvSpPr txBox="1"/>
          <p:nvPr/>
        </p:nvSpPr>
        <p:spPr>
          <a:xfrm>
            <a:off x="455497" y="1658217"/>
            <a:ext cx="671979" cy="276999"/>
          </a:xfrm>
          <a:prstGeom prst="rect">
            <a:avLst/>
          </a:prstGeom>
          <a:noFill/>
        </p:spPr>
        <p:txBody>
          <a:bodyPr wrap="none" rtlCol="0">
            <a:spAutoFit/>
          </a:bodyPr>
          <a:lstStyle/>
          <a:p>
            <a:r>
              <a:rPr lang="it-IT" sz="1200" dirty="0"/>
              <a:t>120 </a:t>
            </a:r>
            <a:r>
              <a:rPr lang="it-IT" sz="1200" dirty="0" err="1"/>
              <a:t>uW</a:t>
            </a:r>
            <a:endParaRPr lang="it-IT" sz="1200" dirty="0"/>
          </a:p>
        </p:txBody>
      </p:sp>
      <p:sp>
        <p:nvSpPr>
          <p:cNvPr id="99" name="CasellaDiTesto 39">
            <a:extLst>
              <a:ext uri="{FF2B5EF4-FFF2-40B4-BE49-F238E27FC236}">
                <a16:creationId xmlns:a16="http://schemas.microsoft.com/office/drawing/2014/main" id="{27CC0B83-50DB-4F88-84D9-EF3C1D9B7208}"/>
              </a:ext>
            </a:extLst>
          </p:cNvPr>
          <p:cNvSpPr txBox="1"/>
          <p:nvPr/>
        </p:nvSpPr>
        <p:spPr>
          <a:xfrm>
            <a:off x="455497" y="2652033"/>
            <a:ext cx="671979" cy="276999"/>
          </a:xfrm>
          <a:prstGeom prst="rect">
            <a:avLst/>
          </a:prstGeom>
          <a:noFill/>
        </p:spPr>
        <p:txBody>
          <a:bodyPr wrap="none" rtlCol="0">
            <a:spAutoFit/>
          </a:bodyPr>
          <a:lstStyle/>
          <a:p>
            <a:r>
              <a:rPr lang="it-IT" sz="1200" dirty="0"/>
              <a:t>185 </a:t>
            </a:r>
            <a:r>
              <a:rPr lang="it-IT" sz="1200" dirty="0" err="1"/>
              <a:t>uW</a:t>
            </a:r>
            <a:endParaRPr lang="it-IT" sz="1200" dirty="0"/>
          </a:p>
        </p:txBody>
      </p:sp>
      <p:sp>
        <p:nvSpPr>
          <p:cNvPr id="100" name="CasellaDiTesto 40">
            <a:extLst>
              <a:ext uri="{FF2B5EF4-FFF2-40B4-BE49-F238E27FC236}">
                <a16:creationId xmlns:a16="http://schemas.microsoft.com/office/drawing/2014/main" id="{C1A78E0B-7D14-496F-9C47-67A2BE400663}"/>
              </a:ext>
            </a:extLst>
          </p:cNvPr>
          <p:cNvSpPr txBox="1"/>
          <p:nvPr/>
        </p:nvSpPr>
        <p:spPr>
          <a:xfrm>
            <a:off x="1566094" y="20826"/>
            <a:ext cx="495649" cy="276999"/>
          </a:xfrm>
          <a:prstGeom prst="rect">
            <a:avLst/>
          </a:prstGeom>
          <a:noFill/>
        </p:spPr>
        <p:txBody>
          <a:bodyPr wrap="none" rtlCol="0">
            <a:spAutoFit/>
          </a:bodyPr>
          <a:lstStyle/>
          <a:p>
            <a:r>
              <a:rPr lang="it-IT" sz="1200" dirty="0"/>
              <a:t>1.5 h</a:t>
            </a:r>
          </a:p>
        </p:txBody>
      </p:sp>
      <p:sp>
        <p:nvSpPr>
          <p:cNvPr id="101" name="CasellaDiTesto 41">
            <a:extLst>
              <a:ext uri="{FF2B5EF4-FFF2-40B4-BE49-F238E27FC236}">
                <a16:creationId xmlns:a16="http://schemas.microsoft.com/office/drawing/2014/main" id="{14D7F3EF-563A-4F2A-A594-683559044149}"/>
              </a:ext>
            </a:extLst>
          </p:cNvPr>
          <p:cNvSpPr txBox="1"/>
          <p:nvPr/>
        </p:nvSpPr>
        <p:spPr>
          <a:xfrm>
            <a:off x="2643381" y="20826"/>
            <a:ext cx="378630" cy="276999"/>
          </a:xfrm>
          <a:prstGeom prst="rect">
            <a:avLst/>
          </a:prstGeom>
          <a:noFill/>
        </p:spPr>
        <p:txBody>
          <a:bodyPr wrap="none" rtlCol="0">
            <a:spAutoFit/>
          </a:bodyPr>
          <a:lstStyle/>
          <a:p>
            <a:r>
              <a:rPr lang="it-IT" sz="1200" dirty="0"/>
              <a:t>5 h</a:t>
            </a:r>
          </a:p>
        </p:txBody>
      </p:sp>
      <p:grpSp>
        <p:nvGrpSpPr>
          <p:cNvPr id="103" name="Gruppo 43">
            <a:extLst>
              <a:ext uri="{FF2B5EF4-FFF2-40B4-BE49-F238E27FC236}">
                <a16:creationId xmlns:a16="http://schemas.microsoft.com/office/drawing/2014/main" id="{9D3DE68A-AA1F-4B77-9291-3FC1DF08ECD2}"/>
              </a:ext>
            </a:extLst>
          </p:cNvPr>
          <p:cNvGrpSpPr/>
          <p:nvPr/>
        </p:nvGrpSpPr>
        <p:grpSpPr>
          <a:xfrm>
            <a:off x="1728326" y="636667"/>
            <a:ext cx="1313006" cy="324646"/>
            <a:chOff x="3660594" y="1099230"/>
            <a:chExt cx="1948262" cy="481715"/>
          </a:xfrm>
        </p:grpSpPr>
        <p:sp>
          <p:nvSpPr>
            <p:cNvPr id="118" name="Rettangolo 58">
              <a:extLst>
                <a:ext uri="{FF2B5EF4-FFF2-40B4-BE49-F238E27FC236}">
                  <a16:creationId xmlns:a16="http://schemas.microsoft.com/office/drawing/2014/main" id="{B16A7391-22F5-4DB8-8B57-ADE886C453F0}"/>
                </a:ext>
              </a:extLst>
            </p:cNvPr>
            <p:cNvSpPr/>
            <p:nvPr/>
          </p:nvSpPr>
          <p:spPr>
            <a:xfrm>
              <a:off x="5105046" y="1099230"/>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19" name="Rettangolo 59">
              <a:extLst>
                <a:ext uri="{FF2B5EF4-FFF2-40B4-BE49-F238E27FC236}">
                  <a16:creationId xmlns:a16="http://schemas.microsoft.com/office/drawing/2014/main" id="{ADD8A706-3B00-4FE0-BAB4-4B4F7BE2DED4}"/>
                </a:ext>
              </a:extLst>
            </p:cNvPr>
            <p:cNvSpPr/>
            <p:nvPr/>
          </p:nvSpPr>
          <p:spPr>
            <a:xfrm>
              <a:off x="3660594" y="1099230"/>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grpSp>
        <p:nvGrpSpPr>
          <p:cNvPr id="104" name="Gruppo 44">
            <a:extLst>
              <a:ext uri="{FF2B5EF4-FFF2-40B4-BE49-F238E27FC236}">
                <a16:creationId xmlns:a16="http://schemas.microsoft.com/office/drawing/2014/main" id="{8A68C5CA-E3FA-4CC6-A2EB-CAE9E91D0900}"/>
              </a:ext>
            </a:extLst>
          </p:cNvPr>
          <p:cNvGrpSpPr/>
          <p:nvPr/>
        </p:nvGrpSpPr>
        <p:grpSpPr>
          <a:xfrm>
            <a:off x="1728326" y="2617511"/>
            <a:ext cx="1313006" cy="324646"/>
            <a:chOff x="3660594" y="5508049"/>
            <a:chExt cx="1948262" cy="481715"/>
          </a:xfrm>
        </p:grpSpPr>
        <p:sp>
          <p:nvSpPr>
            <p:cNvPr id="116" name="Rettangolo 56">
              <a:extLst>
                <a:ext uri="{FF2B5EF4-FFF2-40B4-BE49-F238E27FC236}">
                  <a16:creationId xmlns:a16="http://schemas.microsoft.com/office/drawing/2014/main" id="{9C66C91F-DEFB-4EBE-8C5A-EB2CB7AAD441}"/>
                </a:ext>
              </a:extLst>
            </p:cNvPr>
            <p:cNvSpPr/>
            <p:nvPr/>
          </p:nvSpPr>
          <p:spPr>
            <a:xfrm>
              <a:off x="5105046" y="5508049"/>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17" name="Rettangolo 57">
              <a:extLst>
                <a:ext uri="{FF2B5EF4-FFF2-40B4-BE49-F238E27FC236}">
                  <a16:creationId xmlns:a16="http://schemas.microsoft.com/office/drawing/2014/main" id="{0A4E835C-38F9-4E00-8A45-97AD61C4ADB6}"/>
                </a:ext>
              </a:extLst>
            </p:cNvPr>
            <p:cNvSpPr/>
            <p:nvPr/>
          </p:nvSpPr>
          <p:spPr>
            <a:xfrm>
              <a:off x="3660594" y="5508049"/>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grpSp>
        <p:nvGrpSpPr>
          <p:cNvPr id="105" name="Gruppo 45">
            <a:extLst>
              <a:ext uri="{FF2B5EF4-FFF2-40B4-BE49-F238E27FC236}">
                <a16:creationId xmlns:a16="http://schemas.microsoft.com/office/drawing/2014/main" id="{0EADD3D2-3484-4AD2-91A5-F69B2E89CC3B}"/>
              </a:ext>
            </a:extLst>
          </p:cNvPr>
          <p:cNvGrpSpPr/>
          <p:nvPr/>
        </p:nvGrpSpPr>
        <p:grpSpPr>
          <a:xfrm>
            <a:off x="1728326" y="1627089"/>
            <a:ext cx="1313006" cy="324646"/>
            <a:chOff x="3660594" y="5508049"/>
            <a:chExt cx="1948262" cy="481715"/>
          </a:xfrm>
        </p:grpSpPr>
        <p:sp>
          <p:nvSpPr>
            <p:cNvPr id="114" name="Rettangolo 54">
              <a:extLst>
                <a:ext uri="{FF2B5EF4-FFF2-40B4-BE49-F238E27FC236}">
                  <a16:creationId xmlns:a16="http://schemas.microsoft.com/office/drawing/2014/main" id="{047D2F8D-E725-4A9C-AC8F-495D097B2DA8}"/>
                </a:ext>
              </a:extLst>
            </p:cNvPr>
            <p:cNvSpPr/>
            <p:nvPr/>
          </p:nvSpPr>
          <p:spPr>
            <a:xfrm>
              <a:off x="5105046" y="5508049"/>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15" name="Rettangolo 55">
              <a:extLst>
                <a:ext uri="{FF2B5EF4-FFF2-40B4-BE49-F238E27FC236}">
                  <a16:creationId xmlns:a16="http://schemas.microsoft.com/office/drawing/2014/main" id="{B5FF95B2-B484-41F8-89C7-223E321276DE}"/>
                </a:ext>
              </a:extLst>
            </p:cNvPr>
            <p:cNvSpPr/>
            <p:nvPr/>
          </p:nvSpPr>
          <p:spPr>
            <a:xfrm>
              <a:off x="3660594" y="5508049"/>
              <a:ext cx="503810" cy="481715"/>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pic>
        <p:nvPicPr>
          <p:cNvPr id="107" name="Immagine 47">
            <a:extLst>
              <a:ext uri="{FF2B5EF4-FFF2-40B4-BE49-F238E27FC236}">
                <a16:creationId xmlns:a16="http://schemas.microsoft.com/office/drawing/2014/main" id="{8D534FBE-D9EC-401D-AD89-E4CE058ADC2E}"/>
              </a:ext>
            </a:extLst>
          </p:cNvPr>
          <p:cNvPicPr>
            <a:picLocks noChangeAspect="1"/>
          </p:cNvPicPr>
          <p:nvPr/>
        </p:nvPicPr>
        <p:blipFill>
          <a:blip r:embed="rId24" cstate="print">
            <a:extLst>
              <a:ext uri="{BEBA8EAE-BF5A-486C-A8C5-ECC9F3942E4B}">
                <a14:imgProps xmlns:a14="http://schemas.microsoft.com/office/drawing/2010/main">
                  <a14:imgLayer r:embed="rId25">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3377252" y="2303809"/>
            <a:ext cx="949389" cy="949389"/>
          </a:xfrm>
          <a:prstGeom prst="rect">
            <a:avLst/>
          </a:prstGeom>
        </p:spPr>
      </p:pic>
      <p:pic>
        <p:nvPicPr>
          <p:cNvPr id="108" name="Immagine 48">
            <a:extLst>
              <a:ext uri="{FF2B5EF4-FFF2-40B4-BE49-F238E27FC236}">
                <a16:creationId xmlns:a16="http://schemas.microsoft.com/office/drawing/2014/main" id="{10B10981-BFE6-4A69-9ADD-0503BC1C40D9}"/>
              </a:ext>
            </a:extLst>
          </p:cNvPr>
          <p:cNvPicPr>
            <a:picLocks noChangeAspect="1"/>
          </p:cNvPicPr>
          <p:nvPr/>
        </p:nvPicPr>
        <p:blipFill>
          <a:blip r:embed="rId26" cstate="print">
            <a:extLst>
              <a:ext uri="{BEBA8EAE-BF5A-486C-A8C5-ECC9F3942E4B}">
                <a14:imgProps xmlns:a14="http://schemas.microsoft.com/office/drawing/2010/main">
                  <a14:imgLayer r:embed="rId27">
                    <a14:imgEffect>
                      <a14:brightnessContrast contrast="20000"/>
                    </a14:imgEffect>
                  </a14:imgLayer>
                </a14:imgProps>
              </a:ext>
              <a:ext uri="{28A0092B-C50C-407E-A947-70E740481C1C}">
                <a14:useLocalDpi xmlns:a14="http://schemas.microsoft.com/office/drawing/2010/main" val="0"/>
              </a:ext>
            </a:extLst>
          </a:blip>
          <a:stretch>
            <a:fillRect/>
          </a:stretch>
        </p:blipFill>
        <p:spPr>
          <a:xfrm>
            <a:off x="3377252" y="1306219"/>
            <a:ext cx="949389" cy="949389"/>
          </a:xfrm>
          <a:prstGeom prst="rect">
            <a:avLst/>
          </a:prstGeom>
        </p:spPr>
      </p:pic>
      <p:pic>
        <p:nvPicPr>
          <p:cNvPr id="109" name="Immagine 49">
            <a:extLst>
              <a:ext uri="{FF2B5EF4-FFF2-40B4-BE49-F238E27FC236}">
                <a16:creationId xmlns:a16="http://schemas.microsoft.com/office/drawing/2014/main" id="{BDFB1F69-1059-4855-B3DD-8C4B837FEBF4}"/>
              </a:ext>
            </a:extLst>
          </p:cNvPr>
          <p:cNvPicPr>
            <a:picLocks noChangeAspect="1"/>
          </p:cNvPicPr>
          <p:nvPr/>
        </p:nvPicPr>
        <p:blipFill>
          <a:blip r:embed="rId28" cstate="print">
            <a:extLst>
              <a:ext uri="{28A0092B-C50C-407E-A947-70E740481C1C}">
                <a14:useLocalDpi xmlns:a14="http://schemas.microsoft.com/office/drawing/2010/main" val="0"/>
              </a:ext>
            </a:extLst>
          </a:blip>
          <a:stretch>
            <a:fillRect/>
          </a:stretch>
        </p:blipFill>
        <p:spPr>
          <a:xfrm>
            <a:off x="3377252" y="312403"/>
            <a:ext cx="949389" cy="949389"/>
          </a:xfrm>
          <a:prstGeom prst="rect">
            <a:avLst/>
          </a:prstGeom>
        </p:spPr>
      </p:pic>
      <p:sp>
        <p:nvSpPr>
          <p:cNvPr id="110" name="CasellaDiTesto 50">
            <a:extLst>
              <a:ext uri="{FF2B5EF4-FFF2-40B4-BE49-F238E27FC236}">
                <a16:creationId xmlns:a16="http://schemas.microsoft.com/office/drawing/2014/main" id="{CC479B37-C76F-43F4-82D1-52238839939C}"/>
              </a:ext>
            </a:extLst>
          </p:cNvPr>
          <p:cNvSpPr txBox="1"/>
          <p:nvPr/>
        </p:nvSpPr>
        <p:spPr>
          <a:xfrm>
            <a:off x="3393313" y="30430"/>
            <a:ext cx="953402" cy="276999"/>
          </a:xfrm>
          <a:prstGeom prst="rect">
            <a:avLst/>
          </a:prstGeom>
          <a:noFill/>
        </p:spPr>
        <p:txBody>
          <a:bodyPr wrap="none" rtlCol="0">
            <a:spAutoFit/>
          </a:bodyPr>
          <a:lstStyle/>
          <a:p>
            <a:r>
              <a:rPr lang="it-IT" sz="1200" dirty="0"/>
              <a:t>Control 24 h</a:t>
            </a:r>
          </a:p>
        </p:txBody>
      </p:sp>
      <p:sp>
        <p:nvSpPr>
          <p:cNvPr id="111" name="Rettangolo 51">
            <a:extLst>
              <a:ext uri="{FF2B5EF4-FFF2-40B4-BE49-F238E27FC236}">
                <a16:creationId xmlns:a16="http://schemas.microsoft.com/office/drawing/2014/main" id="{B6F71AAF-E825-49E1-A19E-A0C56C4CF5D6}"/>
              </a:ext>
            </a:extLst>
          </p:cNvPr>
          <p:cNvSpPr/>
          <p:nvPr/>
        </p:nvSpPr>
        <p:spPr>
          <a:xfrm>
            <a:off x="3682179" y="639006"/>
            <a:ext cx="339536" cy="324646"/>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12" name="Rettangolo 52">
            <a:extLst>
              <a:ext uri="{FF2B5EF4-FFF2-40B4-BE49-F238E27FC236}">
                <a16:creationId xmlns:a16="http://schemas.microsoft.com/office/drawing/2014/main" id="{65E13A89-8064-4C17-8B5B-5B62BD22A9C7}"/>
              </a:ext>
            </a:extLst>
          </p:cNvPr>
          <p:cNvSpPr/>
          <p:nvPr/>
        </p:nvSpPr>
        <p:spPr>
          <a:xfrm>
            <a:off x="3682179" y="2619850"/>
            <a:ext cx="339536" cy="324646"/>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13" name="Rettangolo 53">
            <a:extLst>
              <a:ext uri="{FF2B5EF4-FFF2-40B4-BE49-F238E27FC236}">
                <a16:creationId xmlns:a16="http://schemas.microsoft.com/office/drawing/2014/main" id="{8F216A73-4738-4FA2-B989-93F8F098D14F}"/>
              </a:ext>
            </a:extLst>
          </p:cNvPr>
          <p:cNvSpPr/>
          <p:nvPr/>
        </p:nvSpPr>
        <p:spPr>
          <a:xfrm>
            <a:off x="3682179" y="1629428"/>
            <a:ext cx="339536" cy="324646"/>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pic>
        <p:nvPicPr>
          <p:cNvPr id="121" name="Immagine 61">
            <a:extLst>
              <a:ext uri="{FF2B5EF4-FFF2-40B4-BE49-F238E27FC236}">
                <a16:creationId xmlns:a16="http://schemas.microsoft.com/office/drawing/2014/main" id="{78431C2A-7430-45E0-8E17-0C32C9C60745}"/>
              </a:ext>
            </a:extLst>
          </p:cNvPr>
          <p:cNvPicPr>
            <a:picLocks noChangeAspect="1"/>
          </p:cNvPicPr>
          <p:nvPr/>
        </p:nvPicPr>
        <p:blipFill>
          <a:blip r:embed="rId29" cstate="print">
            <a:extLst>
              <a:ext uri="{28A0092B-C50C-407E-A947-70E740481C1C}">
                <a14:useLocalDpi xmlns:a14="http://schemas.microsoft.com/office/drawing/2010/main" val="0"/>
              </a:ext>
            </a:extLst>
          </a:blip>
          <a:stretch>
            <a:fillRect/>
          </a:stretch>
        </p:blipFill>
        <p:spPr>
          <a:xfrm>
            <a:off x="5791008" y="2302619"/>
            <a:ext cx="949389" cy="949389"/>
          </a:xfrm>
          <a:prstGeom prst="rect">
            <a:avLst/>
          </a:prstGeom>
        </p:spPr>
      </p:pic>
      <p:pic>
        <p:nvPicPr>
          <p:cNvPr id="122" name="Immagine 62">
            <a:extLst>
              <a:ext uri="{FF2B5EF4-FFF2-40B4-BE49-F238E27FC236}">
                <a16:creationId xmlns:a16="http://schemas.microsoft.com/office/drawing/2014/main" id="{70616077-84C1-4EDF-BF70-9C7E6A174366}"/>
              </a:ext>
            </a:extLst>
          </p:cNvPr>
          <p:cNvPicPr>
            <a:picLocks noChangeAspect="1"/>
          </p:cNvPicPr>
          <p:nvPr/>
        </p:nvPicPr>
        <p:blipFill>
          <a:blip r:embed="rId30" cstate="print">
            <a:extLst>
              <a:ext uri="{28A0092B-C50C-407E-A947-70E740481C1C}">
                <a14:useLocalDpi xmlns:a14="http://schemas.microsoft.com/office/drawing/2010/main" val="0"/>
              </a:ext>
            </a:extLst>
          </a:blip>
          <a:stretch>
            <a:fillRect/>
          </a:stretch>
        </p:blipFill>
        <p:spPr>
          <a:xfrm>
            <a:off x="6764478" y="2302619"/>
            <a:ext cx="949389" cy="949389"/>
          </a:xfrm>
          <a:prstGeom prst="rect">
            <a:avLst/>
          </a:prstGeom>
        </p:spPr>
      </p:pic>
      <p:pic>
        <p:nvPicPr>
          <p:cNvPr id="123" name="Immagine 63">
            <a:extLst>
              <a:ext uri="{FF2B5EF4-FFF2-40B4-BE49-F238E27FC236}">
                <a16:creationId xmlns:a16="http://schemas.microsoft.com/office/drawing/2014/main" id="{97F75E92-7411-4FFA-97BC-5B2CBE7D4256}"/>
              </a:ext>
            </a:extLst>
          </p:cNvPr>
          <p:cNvPicPr>
            <a:picLocks noChangeAspect="1"/>
          </p:cNvPicPr>
          <p:nvPr/>
        </p:nvPicPr>
        <p:blipFill>
          <a:blip r:embed="rId31" cstate="print">
            <a:extLst>
              <a:ext uri="{28A0092B-C50C-407E-A947-70E740481C1C}">
                <a14:useLocalDpi xmlns:a14="http://schemas.microsoft.com/office/drawing/2010/main" val="0"/>
              </a:ext>
            </a:extLst>
          </a:blip>
          <a:stretch>
            <a:fillRect/>
          </a:stretch>
        </p:blipFill>
        <p:spPr>
          <a:xfrm>
            <a:off x="5791008" y="1307976"/>
            <a:ext cx="949389" cy="949389"/>
          </a:xfrm>
          <a:prstGeom prst="rect">
            <a:avLst/>
          </a:prstGeom>
        </p:spPr>
      </p:pic>
      <p:pic>
        <p:nvPicPr>
          <p:cNvPr id="124" name="Immagine 64">
            <a:extLst>
              <a:ext uri="{FF2B5EF4-FFF2-40B4-BE49-F238E27FC236}">
                <a16:creationId xmlns:a16="http://schemas.microsoft.com/office/drawing/2014/main" id="{4F02AEFB-DCA8-4100-9C7C-DC3A7D289F29}"/>
              </a:ext>
            </a:extLst>
          </p:cNvPr>
          <p:cNvPicPr>
            <a:picLocks noChangeAspect="1"/>
          </p:cNvPicPr>
          <p:nvPr/>
        </p:nvPicPr>
        <p:blipFill>
          <a:blip r:embed="rId32" cstate="print">
            <a:extLst>
              <a:ext uri="{28A0092B-C50C-407E-A947-70E740481C1C}">
                <a14:useLocalDpi xmlns:a14="http://schemas.microsoft.com/office/drawing/2010/main" val="0"/>
              </a:ext>
            </a:extLst>
          </a:blip>
          <a:stretch>
            <a:fillRect/>
          </a:stretch>
        </p:blipFill>
        <p:spPr>
          <a:xfrm>
            <a:off x="6764478" y="1307976"/>
            <a:ext cx="949389" cy="949389"/>
          </a:xfrm>
          <a:prstGeom prst="rect">
            <a:avLst/>
          </a:prstGeom>
        </p:spPr>
      </p:pic>
      <p:pic>
        <p:nvPicPr>
          <p:cNvPr id="125" name="Immagine 65">
            <a:extLst>
              <a:ext uri="{FF2B5EF4-FFF2-40B4-BE49-F238E27FC236}">
                <a16:creationId xmlns:a16="http://schemas.microsoft.com/office/drawing/2014/main" id="{CAA2D292-CB73-447A-B96C-1610CBB2DFD5}"/>
              </a:ext>
            </a:extLst>
          </p:cNvPr>
          <p:cNvPicPr>
            <a:picLocks noChangeAspect="1"/>
          </p:cNvPicPr>
          <p:nvPr/>
        </p:nvPicPr>
        <p:blipFill>
          <a:blip r:embed="rId33" cstate="print">
            <a:extLst>
              <a:ext uri="{28A0092B-C50C-407E-A947-70E740481C1C}">
                <a14:useLocalDpi xmlns:a14="http://schemas.microsoft.com/office/drawing/2010/main" val="0"/>
              </a:ext>
            </a:extLst>
          </a:blip>
          <a:stretch>
            <a:fillRect/>
          </a:stretch>
        </p:blipFill>
        <p:spPr>
          <a:xfrm>
            <a:off x="5791008" y="314159"/>
            <a:ext cx="949389" cy="949389"/>
          </a:xfrm>
          <a:prstGeom prst="rect">
            <a:avLst/>
          </a:prstGeom>
        </p:spPr>
      </p:pic>
      <p:pic>
        <p:nvPicPr>
          <p:cNvPr id="126" name="Immagine 66">
            <a:extLst>
              <a:ext uri="{FF2B5EF4-FFF2-40B4-BE49-F238E27FC236}">
                <a16:creationId xmlns:a16="http://schemas.microsoft.com/office/drawing/2014/main" id="{00A3F5E2-BF66-42E1-94E3-030447FDC0B0}"/>
              </a:ext>
            </a:extLst>
          </p:cNvPr>
          <p:cNvPicPr>
            <a:picLocks noChangeAspect="1"/>
          </p:cNvPicPr>
          <p:nvPr/>
        </p:nvPicPr>
        <p:blipFill>
          <a:blip r:embed="rId34" cstate="print">
            <a:extLst>
              <a:ext uri="{BEBA8EAE-BF5A-486C-A8C5-ECC9F3942E4B}">
                <a14:imgProps xmlns:a14="http://schemas.microsoft.com/office/drawing/2010/main">
                  <a14:imgLayer r:embed="rId35">
                    <a14:imgEffect>
                      <a14:brightnessContrast contrast="40000"/>
                    </a14:imgEffect>
                  </a14:imgLayer>
                </a14:imgProps>
              </a:ext>
              <a:ext uri="{28A0092B-C50C-407E-A947-70E740481C1C}">
                <a14:useLocalDpi xmlns:a14="http://schemas.microsoft.com/office/drawing/2010/main" val="0"/>
              </a:ext>
            </a:extLst>
          </a:blip>
          <a:stretch>
            <a:fillRect/>
          </a:stretch>
        </p:blipFill>
        <p:spPr>
          <a:xfrm>
            <a:off x="6764478" y="314159"/>
            <a:ext cx="949389" cy="949389"/>
          </a:xfrm>
          <a:prstGeom prst="rect">
            <a:avLst/>
          </a:prstGeom>
        </p:spPr>
      </p:pic>
      <p:sp>
        <p:nvSpPr>
          <p:cNvPr id="127" name="CasellaDiTesto 67">
            <a:extLst>
              <a:ext uri="{FF2B5EF4-FFF2-40B4-BE49-F238E27FC236}">
                <a16:creationId xmlns:a16="http://schemas.microsoft.com/office/drawing/2014/main" id="{5B2E9ACF-B968-4826-A96B-C78BACB10157}"/>
              </a:ext>
            </a:extLst>
          </p:cNvPr>
          <p:cNvSpPr txBox="1"/>
          <p:nvPr/>
        </p:nvSpPr>
        <p:spPr>
          <a:xfrm>
            <a:off x="4947715" y="664400"/>
            <a:ext cx="593432" cy="276999"/>
          </a:xfrm>
          <a:prstGeom prst="rect">
            <a:avLst/>
          </a:prstGeom>
          <a:noFill/>
        </p:spPr>
        <p:txBody>
          <a:bodyPr wrap="none" rtlCol="0">
            <a:spAutoFit/>
          </a:bodyPr>
          <a:lstStyle/>
          <a:p>
            <a:r>
              <a:rPr lang="it-IT" sz="1200" dirty="0"/>
              <a:t>75 </a:t>
            </a:r>
            <a:r>
              <a:rPr lang="it-IT" sz="1200" dirty="0" err="1"/>
              <a:t>uW</a:t>
            </a:r>
            <a:endParaRPr lang="it-IT" sz="1200" dirty="0"/>
          </a:p>
        </p:txBody>
      </p:sp>
      <p:sp>
        <p:nvSpPr>
          <p:cNvPr id="128" name="CasellaDiTesto 68">
            <a:extLst>
              <a:ext uri="{FF2B5EF4-FFF2-40B4-BE49-F238E27FC236}">
                <a16:creationId xmlns:a16="http://schemas.microsoft.com/office/drawing/2014/main" id="{54DF4022-D2CC-46F5-91FF-BAA2A4F65367}"/>
              </a:ext>
            </a:extLst>
          </p:cNvPr>
          <p:cNvSpPr txBox="1"/>
          <p:nvPr/>
        </p:nvSpPr>
        <p:spPr>
          <a:xfrm>
            <a:off x="4830697" y="1658217"/>
            <a:ext cx="671979" cy="276999"/>
          </a:xfrm>
          <a:prstGeom prst="rect">
            <a:avLst/>
          </a:prstGeom>
          <a:noFill/>
        </p:spPr>
        <p:txBody>
          <a:bodyPr wrap="none" rtlCol="0">
            <a:spAutoFit/>
          </a:bodyPr>
          <a:lstStyle/>
          <a:p>
            <a:r>
              <a:rPr lang="it-IT" sz="1200" dirty="0"/>
              <a:t>120 </a:t>
            </a:r>
            <a:r>
              <a:rPr lang="it-IT" sz="1200" dirty="0" err="1"/>
              <a:t>uW</a:t>
            </a:r>
            <a:endParaRPr lang="it-IT" sz="1200" dirty="0"/>
          </a:p>
        </p:txBody>
      </p:sp>
      <p:sp>
        <p:nvSpPr>
          <p:cNvPr id="129" name="CasellaDiTesto 69">
            <a:extLst>
              <a:ext uri="{FF2B5EF4-FFF2-40B4-BE49-F238E27FC236}">
                <a16:creationId xmlns:a16="http://schemas.microsoft.com/office/drawing/2014/main" id="{83B2C1BF-3801-4373-B2DA-F0756BAE3EB9}"/>
              </a:ext>
            </a:extLst>
          </p:cNvPr>
          <p:cNvSpPr txBox="1"/>
          <p:nvPr/>
        </p:nvSpPr>
        <p:spPr>
          <a:xfrm>
            <a:off x="4830697" y="2652033"/>
            <a:ext cx="671979" cy="276999"/>
          </a:xfrm>
          <a:prstGeom prst="rect">
            <a:avLst/>
          </a:prstGeom>
          <a:noFill/>
        </p:spPr>
        <p:txBody>
          <a:bodyPr wrap="none" rtlCol="0">
            <a:spAutoFit/>
          </a:bodyPr>
          <a:lstStyle/>
          <a:p>
            <a:r>
              <a:rPr lang="it-IT" sz="1200" dirty="0"/>
              <a:t>185 </a:t>
            </a:r>
            <a:r>
              <a:rPr lang="it-IT" sz="1200" dirty="0" err="1"/>
              <a:t>uW</a:t>
            </a:r>
            <a:endParaRPr lang="it-IT" sz="1200" dirty="0"/>
          </a:p>
        </p:txBody>
      </p:sp>
      <p:sp>
        <p:nvSpPr>
          <p:cNvPr id="130" name="CasellaDiTesto 70">
            <a:extLst>
              <a:ext uri="{FF2B5EF4-FFF2-40B4-BE49-F238E27FC236}">
                <a16:creationId xmlns:a16="http://schemas.microsoft.com/office/drawing/2014/main" id="{73763312-EF9E-440E-A600-36C47F9F26EB}"/>
              </a:ext>
            </a:extLst>
          </p:cNvPr>
          <p:cNvSpPr txBox="1"/>
          <p:nvPr/>
        </p:nvSpPr>
        <p:spPr>
          <a:xfrm>
            <a:off x="5933703" y="20826"/>
            <a:ext cx="495649" cy="276999"/>
          </a:xfrm>
          <a:prstGeom prst="rect">
            <a:avLst/>
          </a:prstGeom>
          <a:noFill/>
        </p:spPr>
        <p:txBody>
          <a:bodyPr wrap="none" rtlCol="0">
            <a:spAutoFit/>
          </a:bodyPr>
          <a:lstStyle/>
          <a:p>
            <a:r>
              <a:rPr lang="it-IT" sz="1200" dirty="0"/>
              <a:t>1.5 h</a:t>
            </a:r>
          </a:p>
        </p:txBody>
      </p:sp>
      <p:sp>
        <p:nvSpPr>
          <p:cNvPr id="131" name="CasellaDiTesto 71">
            <a:extLst>
              <a:ext uri="{FF2B5EF4-FFF2-40B4-BE49-F238E27FC236}">
                <a16:creationId xmlns:a16="http://schemas.microsoft.com/office/drawing/2014/main" id="{032B8762-E8DE-492A-ABE4-FFAF985D733E}"/>
              </a:ext>
            </a:extLst>
          </p:cNvPr>
          <p:cNvSpPr txBox="1"/>
          <p:nvPr/>
        </p:nvSpPr>
        <p:spPr>
          <a:xfrm>
            <a:off x="7018581" y="20826"/>
            <a:ext cx="378630" cy="276999"/>
          </a:xfrm>
          <a:prstGeom prst="rect">
            <a:avLst/>
          </a:prstGeom>
          <a:noFill/>
        </p:spPr>
        <p:txBody>
          <a:bodyPr wrap="none" rtlCol="0">
            <a:spAutoFit/>
          </a:bodyPr>
          <a:lstStyle/>
          <a:p>
            <a:r>
              <a:rPr lang="it-IT" sz="1200" dirty="0"/>
              <a:t>5 h</a:t>
            </a:r>
          </a:p>
        </p:txBody>
      </p:sp>
      <p:pic>
        <p:nvPicPr>
          <p:cNvPr id="146" name="Immagine 87">
            <a:extLst>
              <a:ext uri="{FF2B5EF4-FFF2-40B4-BE49-F238E27FC236}">
                <a16:creationId xmlns:a16="http://schemas.microsoft.com/office/drawing/2014/main" id="{96210DD4-2723-47CC-88E2-0E655F2DC3E9}"/>
              </a:ext>
            </a:extLst>
          </p:cNvPr>
          <p:cNvPicPr>
            <a:picLocks noChangeAspect="1"/>
          </p:cNvPicPr>
          <p:nvPr/>
        </p:nvPicPr>
        <p:blipFill>
          <a:blip r:embed="rId36" cstate="print">
            <a:extLst>
              <a:ext uri="{BEBA8EAE-BF5A-486C-A8C5-ECC9F3942E4B}">
                <a14:imgProps xmlns:a14="http://schemas.microsoft.com/office/drawing/2010/main">
                  <a14:imgLayer r:embed="rId37">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7744860" y="2303809"/>
            <a:ext cx="949389" cy="949389"/>
          </a:xfrm>
          <a:prstGeom prst="rect">
            <a:avLst/>
          </a:prstGeom>
        </p:spPr>
      </p:pic>
      <p:pic>
        <p:nvPicPr>
          <p:cNvPr id="147" name="Immagine 88">
            <a:extLst>
              <a:ext uri="{FF2B5EF4-FFF2-40B4-BE49-F238E27FC236}">
                <a16:creationId xmlns:a16="http://schemas.microsoft.com/office/drawing/2014/main" id="{EF3B57ED-3FDB-4104-AAB3-5BC909099ED0}"/>
              </a:ext>
            </a:extLst>
          </p:cNvPr>
          <p:cNvPicPr>
            <a:picLocks noChangeAspect="1"/>
          </p:cNvPicPr>
          <p:nvPr/>
        </p:nvPicPr>
        <p:blipFill>
          <a:blip r:embed="rId38" cstate="print">
            <a:extLst>
              <a:ext uri="{BEBA8EAE-BF5A-486C-A8C5-ECC9F3942E4B}">
                <a14:imgProps xmlns:a14="http://schemas.microsoft.com/office/drawing/2010/main">
                  <a14:imgLayer r:embed="rId39">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7744860" y="1306218"/>
            <a:ext cx="949389" cy="949389"/>
          </a:xfrm>
          <a:prstGeom prst="rect">
            <a:avLst/>
          </a:prstGeom>
        </p:spPr>
      </p:pic>
      <p:pic>
        <p:nvPicPr>
          <p:cNvPr id="148" name="Immagine 89">
            <a:extLst>
              <a:ext uri="{FF2B5EF4-FFF2-40B4-BE49-F238E27FC236}">
                <a16:creationId xmlns:a16="http://schemas.microsoft.com/office/drawing/2014/main" id="{B63D4B0A-912A-4924-9771-C2E7179C1A2F}"/>
              </a:ext>
            </a:extLst>
          </p:cNvPr>
          <p:cNvPicPr>
            <a:picLocks noChangeAspect="1"/>
          </p:cNvPicPr>
          <p:nvPr/>
        </p:nvPicPr>
        <p:blipFill>
          <a:blip r:embed="rId40" cstate="print">
            <a:extLst>
              <a:ext uri="{BEBA8EAE-BF5A-486C-A8C5-ECC9F3942E4B}">
                <a14:imgProps xmlns:a14="http://schemas.microsoft.com/office/drawing/2010/main">
                  <a14:imgLayer r:embed="rId41">
                    <a14:imgEffect>
                      <a14:brightnessContrast bright="40000" contrast="40000"/>
                    </a14:imgEffect>
                  </a14:imgLayer>
                </a14:imgProps>
              </a:ext>
              <a:ext uri="{28A0092B-C50C-407E-A947-70E740481C1C}">
                <a14:useLocalDpi xmlns:a14="http://schemas.microsoft.com/office/drawing/2010/main" val="0"/>
              </a:ext>
            </a:extLst>
          </a:blip>
          <a:stretch>
            <a:fillRect/>
          </a:stretch>
        </p:blipFill>
        <p:spPr>
          <a:xfrm>
            <a:off x="7744860" y="312402"/>
            <a:ext cx="949389" cy="949389"/>
          </a:xfrm>
          <a:prstGeom prst="rect">
            <a:avLst/>
          </a:prstGeom>
        </p:spPr>
      </p:pic>
      <p:sp>
        <p:nvSpPr>
          <p:cNvPr id="149" name="CasellaDiTesto 90">
            <a:extLst>
              <a:ext uri="{FF2B5EF4-FFF2-40B4-BE49-F238E27FC236}">
                <a16:creationId xmlns:a16="http://schemas.microsoft.com/office/drawing/2014/main" id="{E5CEC4DA-3DB4-4537-B219-01E18A3B9DBA}"/>
              </a:ext>
            </a:extLst>
          </p:cNvPr>
          <p:cNvSpPr txBox="1"/>
          <p:nvPr/>
        </p:nvSpPr>
        <p:spPr>
          <a:xfrm>
            <a:off x="7768512" y="11447"/>
            <a:ext cx="953403" cy="276999"/>
          </a:xfrm>
          <a:prstGeom prst="rect">
            <a:avLst/>
          </a:prstGeom>
          <a:noFill/>
        </p:spPr>
        <p:txBody>
          <a:bodyPr wrap="none" rtlCol="0">
            <a:spAutoFit/>
          </a:bodyPr>
          <a:lstStyle/>
          <a:p>
            <a:r>
              <a:rPr lang="it-IT" sz="1200" dirty="0"/>
              <a:t>Control 24 h</a:t>
            </a:r>
          </a:p>
        </p:txBody>
      </p:sp>
      <p:grpSp>
        <p:nvGrpSpPr>
          <p:cNvPr id="134" name="Gruppo 74">
            <a:extLst>
              <a:ext uri="{FF2B5EF4-FFF2-40B4-BE49-F238E27FC236}">
                <a16:creationId xmlns:a16="http://schemas.microsoft.com/office/drawing/2014/main" id="{A430147C-C2F9-4525-855B-9AA0AB61CC2C}"/>
              </a:ext>
            </a:extLst>
          </p:cNvPr>
          <p:cNvGrpSpPr/>
          <p:nvPr/>
        </p:nvGrpSpPr>
        <p:grpSpPr>
          <a:xfrm>
            <a:off x="5985124" y="2527181"/>
            <a:ext cx="2509619" cy="533818"/>
            <a:chOff x="7812360" y="5589240"/>
            <a:chExt cx="3723817" cy="792088"/>
          </a:xfrm>
        </p:grpSpPr>
        <p:sp>
          <p:nvSpPr>
            <p:cNvPr id="143" name="Rettangolo 84">
              <a:extLst>
                <a:ext uri="{FF2B5EF4-FFF2-40B4-BE49-F238E27FC236}">
                  <a16:creationId xmlns:a16="http://schemas.microsoft.com/office/drawing/2014/main" id="{77228B0C-CAA1-433F-B78E-526337A45BF4}"/>
                </a:ext>
              </a:extLst>
            </p:cNvPr>
            <p:cNvSpPr/>
            <p:nvPr/>
          </p:nvSpPr>
          <p:spPr>
            <a:xfrm>
              <a:off x="7812360"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44" name="Rettangolo 85">
              <a:extLst>
                <a:ext uri="{FF2B5EF4-FFF2-40B4-BE49-F238E27FC236}">
                  <a16:creationId xmlns:a16="http://schemas.microsoft.com/office/drawing/2014/main" id="{E47206ED-BF3F-44A1-8198-09BF522CEDAB}"/>
                </a:ext>
              </a:extLst>
            </p:cNvPr>
            <p:cNvSpPr/>
            <p:nvPr/>
          </p:nvSpPr>
          <p:spPr>
            <a:xfrm>
              <a:off x="9278224"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45" name="Rettangolo 86">
              <a:extLst>
                <a:ext uri="{FF2B5EF4-FFF2-40B4-BE49-F238E27FC236}">
                  <a16:creationId xmlns:a16="http://schemas.microsoft.com/office/drawing/2014/main" id="{7269C62C-AAA8-4139-AC8E-D57A54B59EB7}"/>
                </a:ext>
              </a:extLst>
            </p:cNvPr>
            <p:cNvSpPr/>
            <p:nvPr/>
          </p:nvSpPr>
          <p:spPr>
            <a:xfrm>
              <a:off x="10744089"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grpSp>
        <p:nvGrpSpPr>
          <p:cNvPr id="135" name="Gruppo 75">
            <a:extLst>
              <a:ext uri="{FF2B5EF4-FFF2-40B4-BE49-F238E27FC236}">
                <a16:creationId xmlns:a16="http://schemas.microsoft.com/office/drawing/2014/main" id="{E60626EE-2A63-4F01-A8F1-1F71851CB726}"/>
              </a:ext>
            </a:extLst>
          </p:cNvPr>
          <p:cNvGrpSpPr/>
          <p:nvPr/>
        </p:nvGrpSpPr>
        <p:grpSpPr>
          <a:xfrm>
            <a:off x="5985124" y="539792"/>
            <a:ext cx="2509619" cy="533818"/>
            <a:chOff x="7812360" y="5589240"/>
            <a:chExt cx="3723817" cy="792088"/>
          </a:xfrm>
        </p:grpSpPr>
        <p:sp>
          <p:nvSpPr>
            <p:cNvPr id="140" name="Rettangolo 80">
              <a:extLst>
                <a:ext uri="{FF2B5EF4-FFF2-40B4-BE49-F238E27FC236}">
                  <a16:creationId xmlns:a16="http://schemas.microsoft.com/office/drawing/2014/main" id="{478E1B22-2C04-4EDF-8854-050249E9D304}"/>
                </a:ext>
              </a:extLst>
            </p:cNvPr>
            <p:cNvSpPr/>
            <p:nvPr/>
          </p:nvSpPr>
          <p:spPr>
            <a:xfrm>
              <a:off x="7812360"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41" name="Rettangolo 81">
              <a:extLst>
                <a:ext uri="{FF2B5EF4-FFF2-40B4-BE49-F238E27FC236}">
                  <a16:creationId xmlns:a16="http://schemas.microsoft.com/office/drawing/2014/main" id="{87616562-E263-44AE-983E-065CE26E9F5F}"/>
                </a:ext>
              </a:extLst>
            </p:cNvPr>
            <p:cNvSpPr/>
            <p:nvPr/>
          </p:nvSpPr>
          <p:spPr>
            <a:xfrm>
              <a:off x="9278224"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42" name="Rettangolo 82">
              <a:extLst>
                <a:ext uri="{FF2B5EF4-FFF2-40B4-BE49-F238E27FC236}">
                  <a16:creationId xmlns:a16="http://schemas.microsoft.com/office/drawing/2014/main" id="{AE493DA2-CA52-4697-9B7E-0B7EE2F1E90C}"/>
                </a:ext>
              </a:extLst>
            </p:cNvPr>
            <p:cNvSpPr/>
            <p:nvPr/>
          </p:nvSpPr>
          <p:spPr>
            <a:xfrm>
              <a:off x="10744089"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grpSp>
        <p:nvGrpSpPr>
          <p:cNvPr id="136" name="Gruppo 76">
            <a:extLst>
              <a:ext uri="{FF2B5EF4-FFF2-40B4-BE49-F238E27FC236}">
                <a16:creationId xmlns:a16="http://schemas.microsoft.com/office/drawing/2014/main" id="{CDAA6BE0-CD89-45B1-9A13-FB14D450FA26}"/>
              </a:ext>
            </a:extLst>
          </p:cNvPr>
          <p:cNvGrpSpPr/>
          <p:nvPr/>
        </p:nvGrpSpPr>
        <p:grpSpPr>
          <a:xfrm>
            <a:off x="5985124" y="1533487"/>
            <a:ext cx="2509619" cy="533818"/>
            <a:chOff x="7812360" y="5589240"/>
            <a:chExt cx="3723817" cy="792088"/>
          </a:xfrm>
        </p:grpSpPr>
        <p:sp>
          <p:nvSpPr>
            <p:cNvPr id="137" name="Rettangolo 77">
              <a:extLst>
                <a:ext uri="{FF2B5EF4-FFF2-40B4-BE49-F238E27FC236}">
                  <a16:creationId xmlns:a16="http://schemas.microsoft.com/office/drawing/2014/main" id="{6C8E2F29-DEEE-49AF-8732-88CCBBABA5A6}"/>
                </a:ext>
              </a:extLst>
            </p:cNvPr>
            <p:cNvSpPr/>
            <p:nvPr/>
          </p:nvSpPr>
          <p:spPr>
            <a:xfrm>
              <a:off x="7812360"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38" name="Rettangolo 78">
              <a:extLst>
                <a:ext uri="{FF2B5EF4-FFF2-40B4-BE49-F238E27FC236}">
                  <a16:creationId xmlns:a16="http://schemas.microsoft.com/office/drawing/2014/main" id="{166620A1-D6FC-45B3-84B7-2B3DACC1F2D0}"/>
                </a:ext>
              </a:extLst>
            </p:cNvPr>
            <p:cNvSpPr/>
            <p:nvPr/>
          </p:nvSpPr>
          <p:spPr>
            <a:xfrm>
              <a:off x="9278224"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sp>
          <p:nvSpPr>
            <p:cNvPr id="139" name="Rettangolo 79">
              <a:extLst>
                <a:ext uri="{FF2B5EF4-FFF2-40B4-BE49-F238E27FC236}">
                  <a16:creationId xmlns:a16="http://schemas.microsoft.com/office/drawing/2014/main" id="{C7BA6E78-AD33-4348-8D54-E1A5AAC759AB}"/>
                </a:ext>
              </a:extLst>
            </p:cNvPr>
            <p:cNvSpPr/>
            <p:nvPr/>
          </p:nvSpPr>
          <p:spPr>
            <a:xfrm>
              <a:off x="10744089" y="5589240"/>
              <a:ext cx="792088" cy="792088"/>
            </a:xfrm>
            <a:prstGeom prst="rect">
              <a:avLst/>
            </a:prstGeom>
            <a:noFill/>
            <a:ln>
              <a:solidFill>
                <a:schemeClr val="accent5"/>
              </a:solid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sz="1200"/>
            </a:p>
          </p:txBody>
        </p:sp>
      </p:grpSp>
      <p:sp>
        <p:nvSpPr>
          <p:cNvPr id="150" name="CasellaDiTesto 91">
            <a:extLst>
              <a:ext uri="{FF2B5EF4-FFF2-40B4-BE49-F238E27FC236}">
                <a16:creationId xmlns:a16="http://schemas.microsoft.com/office/drawing/2014/main" id="{B55CB916-924B-4869-847D-68B222EF916B}"/>
              </a:ext>
            </a:extLst>
          </p:cNvPr>
          <p:cNvSpPr txBox="1"/>
          <p:nvPr/>
        </p:nvSpPr>
        <p:spPr>
          <a:xfrm>
            <a:off x="1662071" y="3295338"/>
            <a:ext cx="2444900" cy="307777"/>
          </a:xfrm>
          <a:prstGeom prst="rect">
            <a:avLst/>
          </a:prstGeom>
          <a:noFill/>
        </p:spPr>
        <p:txBody>
          <a:bodyPr wrap="none" rtlCol="0">
            <a:spAutoFit/>
          </a:bodyPr>
          <a:lstStyle/>
          <a:p>
            <a:r>
              <a:rPr lang="it-IT" sz="1400" b="1" dirty="0"/>
              <a:t>CHO cells + AZD2014 [3.6 </a:t>
            </a:r>
            <a:r>
              <a:rPr lang="it-IT" sz="1400" b="1" dirty="0" smtClean="0"/>
              <a:t>µM]</a:t>
            </a:r>
            <a:endParaRPr lang="it-IT" sz="1400" b="1" dirty="0"/>
          </a:p>
        </p:txBody>
      </p:sp>
      <p:sp>
        <p:nvSpPr>
          <p:cNvPr id="151" name="CasellaDiTesto 92">
            <a:extLst>
              <a:ext uri="{FF2B5EF4-FFF2-40B4-BE49-F238E27FC236}">
                <a16:creationId xmlns:a16="http://schemas.microsoft.com/office/drawing/2014/main" id="{0098E222-5D22-4F43-B2D7-BE6014C040AB}"/>
              </a:ext>
            </a:extLst>
          </p:cNvPr>
          <p:cNvSpPr txBox="1"/>
          <p:nvPr/>
        </p:nvSpPr>
        <p:spPr>
          <a:xfrm>
            <a:off x="6083466" y="3274284"/>
            <a:ext cx="2571538" cy="307777"/>
          </a:xfrm>
          <a:prstGeom prst="rect">
            <a:avLst/>
          </a:prstGeom>
          <a:noFill/>
        </p:spPr>
        <p:txBody>
          <a:bodyPr wrap="none" rtlCol="0">
            <a:spAutoFit/>
          </a:bodyPr>
          <a:lstStyle/>
          <a:p>
            <a:r>
              <a:rPr lang="it-IT" sz="1400" b="1" dirty="0"/>
              <a:t>HEK293 cells + AZD2014 [7 </a:t>
            </a:r>
            <a:r>
              <a:rPr lang="it-IT" sz="1400" b="1" dirty="0" smtClean="0"/>
              <a:t>µM]</a:t>
            </a:r>
            <a:endParaRPr lang="it-IT" sz="1400" b="1" dirty="0"/>
          </a:p>
        </p:txBody>
      </p:sp>
      <p:sp>
        <p:nvSpPr>
          <p:cNvPr id="152" name="TextBox 12">
            <a:extLst>
              <a:ext uri="{FF2B5EF4-FFF2-40B4-BE49-F238E27FC236}">
                <a16:creationId xmlns:a16="http://schemas.microsoft.com/office/drawing/2014/main" id="{90A89567-1A17-4394-8BDA-9A963DAE47BD}"/>
              </a:ext>
            </a:extLst>
          </p:cNvPr>
          <p:cNvSpPr txBox="1"/>
          <p:nvPr/>
        </p:nvSpPr>
        <p:spPr>
          <a:xfrm>
            <a:off x="181289" y="30430"/>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sp>
        <p:nvSpPr>
          <p:cNvPr id="153" name="TextBox 12">
            <a:extLst>
              <a:ext uri="{FF2B5EF4-FFF2-40B4-BE49-F238E27FC236}">
                <a16:creationId xmlns:a16="http://schemas.microsoft.com/office/drawing/2014/main" id="{C3C94626-E2E0-49EC-9640-5804B373A197}"/>
              </a:ext>
            </a:extLst>
          </p:cNvPr>
          <p:cNvSpPr txBox="1"/>
          <p:nvPr/>
        </p:nvSpPr>
        <p:spPr>
          <a:xfrm>
            <a:off x="4584798" y="20826"/>
            <a:ext cx="334437" cy="33034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154" name="CasellaDiTesto 39">
            <a:extLst>
              <a:ext uri="{FF2B5EF4-FFF2-40B4-BE49-F238E27FC236}">
                <a16:creationId xmlns:a16="http://schemas.microsoft.com/office/drawing/2014/main" id="{EB89A1DA-4767-436F-916A-CCC83B7D4F39}"/>
              </a:ext>
            </a:extLst>
          </p:cNvPr>
          <p:cNvSpPr txBox="1"/>
          <p:nvPr/>
        </p:nvSpPr>
        <p:spPr>
          <a:xfrm>
            <a:off x="658328" y="4515921"/>
            <a:ext cx="675185" cy="276999"/>
          </a:xfrm>
          <a:prstGeom prst="rect">
            <a:avLst/>
          </a:prstGeom>
          <a:noFill/>
        </p:spPr>
        <p:txBody>
          <a:bodyPr wrap="none" rtlCol="0">
            <a:spAutoFit/>
          </a:bodyPr>
          <a:lstStyle/>
          <a:p>
            <a:r>
              <a:rPr lang="it-IT" sz="1200" dirty="0"/>
              <a:t>8.4 mW</a:t>
            </a:r>
          </a:p>
        </p:txBody>
      </p:sp>
      <p:sp>
        <p:nvSpPr>
          <p:cNvPr id="155" name="TextBox 12">
            <a:extLst>
              <a:ext uri="{FF2B5EF4-FFF2-40B4-BE49-F238E27FC236}">
                <a16:creationId xmlns:a16="http://schemas.microsoft.com/office/drawing/2014/main" id="{D99A6D67-2378-4D55-B7AA-E43CA023BC02}"/>
              </a:ext>
            </a:extLst>
          </p:cNvPr>
          <p:cNvSpPr txBox="1"/>
          <p:nvPr/>
        </p:nvSpPr>
        <p:spPr>
          <a:xfrm>
            <a:off x="178173" y="3950061"/>
            <a:ext cx="334437" cy="33034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156" name="CasellaDiTesto 91">
            <a:extLst>
              <a:ext uri="{FF2B5EF4-FFF2-40B4-BE49-F238E27FC236}">
                <a16:creationId xmlns:a16="http://schemas.microsoft.com/office/drawing/2014/main" id="{90E575C9-998D-4E2B-93D8-FE1F900785ED}"/>
              </a:ext>
            </a:extLst>
          </p:cNvPr>
          <p:cNvSpPr txBox="1"/>
          <p:nvPr/>
        </p:nvSpPr>
        <p:spPr>
          <a:xfrm>
            <a:off x="4199254" y="5353935"/>
            <a:ext cx="2287806" cy="523220"/>
          </a:xfrm>
          <a:prstGeom prst="rect">
            <a:avLst/>
          </a:prstGeom>
          <a:noFill/>
        </p:spPr>
        <p:txBody>
          <a:bodyPr wrap="none" rtlCol="0">
            <a:spAutoFit/>
          </a:bodyPr>
          <a:lstStyle/>
          <a:p>
            <a:r>
              <a:rPr lang="it-IT" sz="1400" b="1" dirty="0"/>
              <a:t>CHO </a:t>
            </a:r>
            <a:r>
              <a:rPr lang="it-IT" sz="1400" b="1" dirty="0" err="1" smtClean="0"/>
              <a:t>cells</a:t>
            </a:r>
            <a:r>
              <a:rPr lang="it-IT" sz="1400" b="1" dirty="0" smtClean="0"/>
              <a:t> + </a:t>
            </a:r>
            <a:r>
              <a:rPr lang="it-IT" sz="1400" b="1" dirty="0"/>
              <a:t>AZD2014 [7 </a:t>
            </a:r>
            <a:r>
              <a:rPr lang="it-IT" sz="1400" b="1" dirty="0" smtClean="0"/>
              <a:t>µM]</a:t>
            </a:r>
            <a:endParaRPr lang="it-IT" sz="1400" b="1" dirty="0"/>
          </a:p>
          <a:p>
            <a:endParaRPr lang="it-IT" sz="1400" b="1" dirty="0"/>
          </a:p>
        </p:txBody>
      </p:sp>
    </p:spTree>
    <p:extLst>
      <p:ext uri="{BB962C8B-B14F-4D97-AF65-F5344CB8AC3E}">
        <p14:creationId xmlns:p14="http://schemas.microsoft.com/office/powerpoint/2010/main" val="1927322376"/>
      </p:ext>
    </p:extLst>
  </p:cSld>
  <p:clrMapOvr>
    <a:masterClrMapping/>
  </p:clrMapOvr>
  <p:timing>
    <p:tnLst>
      <p:par>
        <p:cTn id="1" dur="indefinite" restart="never" nodeType="tmRoot">
          <p:childTnLst>
            <p:seq concurrent="1" nextAc="seek">
              <p:cTn id="2" dur="indefinite" nodeType="mainSeq">
                <p:childTnLst>
                  <p:par>
                    <p:cTn id="3" fill="hold">
                      <p:stCondLst>
                        <p:cond delay="indefinite"/>
                      </p:stCondLst>
                      <p:childTnLst>
                        <p:par>
                          <p:cTn id="4" fill="hold">
                            <p:stCondLst>
                              <p:cond delay="0"/>
                            </p:stCondLst>
                            <p:childTnLst>
                              <p:par>
                                <p:cTn id="5" presetID="10" presetClass="entr" presetSubtype="0" fill="hold" nodeType="clickEffect">
                                  <p:stCondLst>
                                    <p:cond delay="0"/>
                                  </p:stCondLst>
                                  <p:childTnLst>
                                    <p:set>
                                      <p:cBhvr>
                                        <p:cTn id="6" dur="1" fill="hold">
                                          <p:stCondLst>
                                            <p:cond delay="0"/>
                                          </p:stCondLst>
                                        </p:cTn>
                                        <p:tgtEl>
                                          <p:spTgt spid="65"/>
                                        </p:tgtEl>
                                        <p:attrNameLst>
                                          <p:attrName>style.visibility</p:attrName>
                                        </p:attrNameLst>
                                      </p:cBhvr>
                                      <p:to>
                                        <p:strVal val="visible"/>
                                      </p:to>
                                    </p:set>
                                    <p:animEffect transition="in" filter="fade">
                                      <p:cBhvr>
                                        <p:cTn id="7" dur="250"/>
                                        <p:tgtEl>
                                          <p:spTgt spid="65"/>
                                        </p:tgtEl>
                                      </p:cBhvr>
                                    </p:animEffect>
                                  </p:childTnLst>
                                </p:cTn>
                              </p:par>
                              <p:par>
                                <p:cTn id="8" presetID="10" presetClass="entr" presetSubtype="0" fill="hold" nodeType="withEffect">
                                  <p:stCondLst>
                                    <p:cond delay="0"/>
                                  </p:stCondLst>
                                  <p:childTnLst>
                                    <p:set>
                                      <p:cBhvr>
                                        <p:cTn id="9" dur="1" fill="hold">
                                          <p:stCondLst>
                                            <p:cond delay="0"/>
                                          </p:stCondLst>
                                        </p:cTn>
                                        <p:tgtEl>
                                          <p:spTgt spid="67"/>
                                        </p:tgtEl>
                                        <p:attrNameLst>
                                          <p:attrName>style.visibility</p:attrName>
                                        </p:attrNameLst>
                                      </p:cBhvr>
                                      <p:to>
                                        <p:strVal val="visible"/>
                                      </p:to>
                                    </p:set>
                                    <p:animEffect transition="in" filter="fade">
                                      <p:cBhvr>
                                        <p:cTn id="10" dur="250"/>
                                        <p:tgtEl>
                                          <p:spTgt spid="67"/>
                                        </p:tgtEl>
                                      </p:cBhvr>
                                    </p:animEffect>
                                  </p:childTnLst>
                                </p:cTn>
                              </p:par>
                              <p:par>
                                <p:cTn id="11" presetID="10" presetClass="entr" presetSubtype="0" fill="hold" nodeType="withEffect">
                                  <p:stCondLst>
                                    <p:cond delay="0"/>
                                  </p:stCondLst>
                                  <p:childTnLst>
                                    <p:set>
                                      <p:cBhvr>
                                        <p:cTn id="12" dur="1" fill="hold">
                                          <p:stCondLst>
                                            <p:cond delay="0"/>
                                          </p:stCondLst>
                                        </p:cTn>
                                        <p:tgtEl>
                                          <p:spTgt spid="73"/>
                                        </p:tgtEl>
                                        <p:attrNameLst>
                                          <p:attrName>style.visibility</p:attrName>
                                        </p:attrNameLst>
                                      </p:cBhvr>
                                      <p:to>
                                        <p:strVal val="visible"/>
                                      </p:to>
                                    </p:set>
                                    <p:animEffect transition="in" filter="fade">
                                      <p:cBhvr>
                                        <p:cTn id="13" dur="250"/>
                                        <p:tgtEl>
                                          <p:spTgt spid="73"/>
                                        </p:tgtEl>
                                      </p:cBhvr>
                                    </p:animEffect>
                                  </p:childTnLst>
                                </p:cTn>
                              </p:par>
                              <p:par>
                                <p:cTn id="14" presetID="10" presetClass="entr" presetSubtype="0" fill="hold" nodeType="withEffect">
                                  <p:stCondLst>
                                    <p:cond delay="0"/>
                                  </p:stCondLst>
                                  <p:childTnLst>
                                    <p:set>
                                      <p:cBhvr>
                                        <p:cTn id="15" dur="1" fill="hold">
                                          <p:stCondLst>
                                            <p:cond delay="0"/>
                                          </p:stCondLst>
                                        </p:cTn>
                                        <p:tgtEl>
                                          <p:spTgt spid="74"/>
                                        </p:tgtEl>
                                        <p:attrNameLst>
                                          <p:attrName>style.visibility</p:attrName>
                                        </p:attrNameLst>
                                      </p:cBhvr>
                                      <p:to>
                                        <p:strVal val="visible"/>
                                      </p:to>
                                    </p:set>
                                    <p:animEffect transition="in" filter="fade">
                                      <p:cBhvr>
                                        <p:cTn id="16" dur="250"/>
                                        <p:tgtEl>
                                          <p:spTgt spid="74"/>
                                        </p:tgtEl>
                                      </p:cBhvr>
                                    </p:animEffect>
                                  </p:childTnLst>
                                </p:cTn>
                              </p:par>
                              <p:par>
                                <p:cTn id="17" presetID="10" presetClass="entr" presetSubtype="0" fill="hold" nodeType="withEffect">
                                  <p:stCondLst>
                                    <p:cond delay="0"/>
                                  </p:stCondLst>
                                  <p:childTnLst>
                                    <p:set>
                                      <p:cBhvr>
                                        <p:cTn id="18" dur="1" fill="hold">
                                          <p:stCondLst>
                                            <p:cond delay="0"/>
                                          </p:stCondLst>
                                        </p:cTn>
                                        <p:tgtEl>
                                          <p:spTgt spid="75"/>
                                        </p:tgtEl>
                                        <p:attrNameLst>
                                          <p:attrName>style.visibility</p:attrName>
                                        </p:attrNameLst>
                                      </p:cBhvr>
                                      <p:to>
                                        <p:strVal val="visible"/>
                                      </p:to>
                                    </p:set>
                                    <p:animEffect transition="in" filter="fade">
                                      <p:cBhvr>
                                        <p:cTn id="19" dur="250"/>
                                        <p:tgtEl>
                                          <p:spTgt spid="75"/>
                                        </p:tgtEl>
                                      </p:cBhvr>
                                    </p:animEffect>
                                  </p:childTnLst>
                                </p:cTn>
                              </p:par>
                              <p:par>
                                <p:cTn id="20" presetID="10" presetClass="entr" presetSubtype="0" fill="hold" grpId="0" nodeType="withEffect">
                                  <p:stCondLst>
                                    <p:cond delay="0"/>
                                  </p:stCondLst>
                                  <p:childTnLst>
                                    <p:set>
                                      <p:cBhvr>
                                        <p:cTn id="21" dur="1" fill="hold">
                                          <p:stCondLst>
                                            <p:cond delay="0"/>
                                          </p:stCondLst>
                                        </p:cTn>
                                        <p:tgtEl>
                                          <p:spTgt spid="77"/>
                                        </p:tgtEl>
                                        <p:attrNameLst>
                                          <p:attrName>style.visibility</p:attrName>
                                        </p:attrNameLst>
                                      </p:cBhvr>
                                      <p:to>
                                        <p:strVal val="visible"/>
                                      </p:to>
                                    </p:set>
                                    <p:animEffect transition="in" filter="fade">
                                      <p:cBhvr>
                                        <p:cTn id="22" dur="250"/>
                                        <p:tgtEl>
                                          <p:spTgt spid="77"/>
                                        </p:tgtEl>
                                      </p:cBhvr>
                                    </p:animEffect>
                                  </p:childTnLst>
                                </p:cTn>
                              </p:par>
                              <p:par>
                                <p:cTn id="23" presetID="10" presetClass="entr" presetSubtype="0" fill="hold" grpId="0" nodeType="withEffect">
                                  <p:stCondLst>
                                    <p:cond delay="0"/>
                                  </p:stCondLst>
                                  <p:childTnLst>
                                    <p:set>
                                      <p:cBhvr>
                                        <p:cTn id="24" dur="1" fill="hold">
                                          <p:stCondLst>
                                            <p:cond delay="0"/>
                                          </p:stCondLst>
                                        </p:cTn>
                                        <p:tgtEl>
                                          <p:spTgt spid="78"/>
                                        </p:tgtEl>
                                        <p:attrNameLst>
                                          <p:attrName>style.visibility</p:attrName>
                                        </p:attrNameLst>
                                      </p:cBhvr>
                                      <p:to>
                                        <p:strVal val="visible"/>
                                      </p:to>
                                    </p:set>
                                    <p:animEffect transition="in" filter="fade">
                                      <p:cBhvr>
                                        <p:cTn id="25" dur="250"/>
                                        <p:tgtEl>
                                          <p:spTgt spid="78"/>
                                        </p:tgtEl>
                                      </p:cBhvr>
                                    </p:animEffect>
                                  </p:childTnLst>
                                </p:cTn>
                              </p:par>
                              <p:par>
                                <p:cTn id="26" presetID="10" presetClass="entr" presetSubtype="0" fill="hold" grpId="0" nodeType="withEffect">
                                  <p:stCondLst>
                                    <p:cond delay="0"/>
                                  </p:stCondLst>
                                  <p:childTnLst>
                                    <p:set>
                                      <p:cBhvr>
                                        <p:cTn id="27" dur="1" fill="hold">
                                          <p:stCondLst>
                                            <p:cond delay="0"/>
                                          </p:stCondLst>
                                        </p:cTn>
                                        <p:tgtEl>
                                          <p:spTgt spid="79"/>
                                        </p:tgtEl>
                                        <p:attrNameLst>
                                          <p:attrName>style.visibility</p:attrName>
                                        </p:attrNameLst>
                                      </p:cBhvr>
                                      <p:to>
                                        <p:strVal val="visible"/>
                                      </p:to>
                                    </p:set>
                                    <p:animEffect transition="in" filter="fade">
                                      <p:cBhvr>
                                        <p:cTn id="28" dur="250"/>
                                        <p:tgtEl>
                                          <p:spTgt spid="79"/>
                                        </p:tgtEl>
                                      </p:cBhvr>
                                    </p:animEffect>
                                  </p:childTnLst>
                                </p:cTn>
                              </p:par>
                              <p:par>
                                <p:cTn id="29" presetID="10" presetClass="entr" presetSubtype="0" fill="hold" grpId="0" nodeType="withEffect">
                                  <p:stCondLst>
                                    <p:cond delay="0"/>
                                  </p:stCondLst>
                                  <p:childTnLst>
                                    <p:set>
                                      <p:cBhvr>
                                        <p:cTn id="30" dur="1" fill="hold">
                                          <p:stCondLst>
                                            <p:cond delay="0"/>
                                          </p:stCondLst>
                                        </p:cTn>
                                        <p:tgtEl>
                                          <p:spTgt spid="80"/>
                                        </p:tgtEl>
                                        <p:attrNameLst>
                                          <p:attrName>style.visibility</p:attrName>
                                        </p:attrNameLst>
                                      </p:cBhvr>
                                      <p:to>
                                        <p:strVal val="visible"/>
                                      </p:to>
                                    </p:set>
                                    <p:animEffect transition="in" filter="fade">
                                      <p:cBhvr>
                                        <p:cTn id="31" dur="250"/>
                                        <p:tgtEl>
                                          <p:spTgt spid="80"/>
                                        </p:tgtEl>
                                      </p:cBhvr>
                                    </p:animEffect>
                                  </p:childTnLst>
                                </p:cTn>
                              </p:par>
                              <p:par>
                                <p:cTn id="32" presetID="10" presetClass="entr" presetSubtype="0" fill="hold" nodeType="withEffect">
                                  <p:stCondLst>
                                    <p:cond delay="0"/>
                                  </p:stCondLst>
                                  <p:childTnLst>
                                    <p:set>
                                      <p:cBhvr>
                                        <p:cTn id="33" dur="1" fill="hold">
                                          <p:stCondLst>
                                            <p:cond delay="0"/>
                                          </p:stCondLst>
                                        </p:cTn>
                                        <p:tgtEl>
                                          <p:spTgt spid="81"/>
                                        </p:tgtEl>
                                        <p:attrNameLst>
                                          <p:attrName>style.visibility</p:attrName>
                                        </p:attrNameLst>
                                      </p:cBhvr>
                                      <p:to>
                                        <p:strVal val="visible"/>
                                      </p:to>
                                    </p:set>
                                    <p:animEffect transition="in" filter="fade">
                                      <p:cBhvr>
                                        <p:cTn id="34" dur="250"/>
                                        <p:tgtEl>
                                          <p:spTgt spid="81"/>
                                        </p:tgtEl>
                                      </p:cBhvr>
                                    </p:animEffect>
                                  </p:childTnLst>
                                </p:cTn>
                              </p:par>
                              <p:par>
                                <p:cTn id="35" presetID="10" presetClass="entr" presetSubtype="0" fill="hold" grpId="0" nodeType="withEffect">
                                  <p:stCondLst>
                                    <p:cond delay="0"/>
                                  </p:stCondLst>
                                  <p:childTnLst>
                                    <p:set>
                                      <p:cBhvr>
                                        <p:cTn id="36" dur="1" fill="hold">
                                          <p:stCondLst>
                                            <p:cond delay="0"/>
                                          </p:stCondLst>
                                        </p:cTn>
                                        <p:tgtEl>
                                          <p:spTgt spid="86"/>
                                        </p:tgtEl>
                                        <p:attrNameLst>
                                          <p:attrName>style.visibility</p:attrName>
                                        </p:attrNameLst>
                                      </p:cBhvr>
                                      <p:to>
                                        <p:strVal val="visible"/>
                                      </p:to>
                                    </p:set>
                                    <p:animEffect transition="in" filter="fade">
                                      <p:cBhvr>
                                        <p:cTn id="37" dur="250"/>
                                        <p:tgtEl>
                                          <p:spTgt spid="86"/>
                                        </p:tgtEl>
                                      </p:cBhvr>
                                    </p:animEffect>
                                  </p:childTnLst>
                                </p:cTn>
                              </p:par>
                              <p:par>
                                <p:cTn id="38" presetID="10" presetClass="entr" presetSubtype="0" fill="hold" grpId="0" nodeType="withEffect">
                                  <p:stCondLst>
                                    <p:cond delay="0"/>
                                  </p:stCondLst>
                                  <p:childTnLst>
                                    <p:set>
                                      <p:cBhvr>
                                        <p:cTn id="39" dur="1" fill="hold">
                                          <p:stCondLst>
                                            <p:cond delay="0"/>
                                          </p:stCondLst>
                                        </p:cTn>
                                        <p:tgtEl>
                                          <p:spTgt spid="87"/>
                                        </p:tgtEl>
                                        <p:attrNameLst>
                                          <p:attrName>style.visibility</p:attrName>
                                        </p:attrNameLst>
                                      </p:cBhvr>
                                      <p:to>
                                        <p:strVal val="visible"/>
                                      </p:to>
                                    </p:set>
                                    <p:animEffect transition="in" filter="fade">
                                      <p:cBhvr>
                                        <p:cTn id="40" dur="250"/>
                                        <p:tgtEl>
                                          <p:spTgt spid="87"/>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77" grpId="0"/>
      <p:bldP spid="78" grpId="0"/>
      <p:bldP spid="79" grpId="0"/>
      <p:bldP spid="80" grpId="0"/>
      <p:bldP spid="86" grpId="0" animBg="1"/>
      <p:bldP spid="87" grpId="0"/>
    </p:bldLst>
  </p:timing>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aphicFrame>
        <p:nvGraphicFramePr>
          <p:cNvPr id="40" name="Chart 39">
            <a:extLst>
              <a:ext uri="{FF2B5EF4-FFF2-40B4-BE49-F238E27FC236}">
                <a16:creationId xmlns:a16="http://schemas.microsoft.com/office/drawing/2014/main" id="{1BCAA9BC-E0B6-4879-9ACE-A4C3357A4676}"/>
              </a:ext>
            </a:extLst>
          </p:cNvPr>
          <p:cNvGraphicFramePr/>
          <p:nvPr>
            <p:extLst>
              <p:ext uri="{D42A27DB-BD31-4B8C-83A1-F6EECF244321}">
                <p14:modId xmlns:p14="http://schemas.microsoft.com/office/powerpoint/2010/main" val="3418268202"/>
              </p:ext>
            </p:extLst>
          </p:nvPr>
        </p:nvGraphicFramePr>
        <p:xfrm>
          <a:off x="3672000" y="4364800"/>
          <a:ext cx="3756185" cy="2515833"/>
        </p:xfrm>
        <a:graphic>
          <a:graphicData uri="http://schemas.openxmlformats.org/drawingml/2006/chart">
            <c:chart xmlns:c="http://schemas.openxmlformats.org/drawingml/2006/chart" xmlns:r="http://schemas.openxmlformats.org/officeDocument/2006/relationships" r:id="rId2"/>
          </a:graphicData>
        </a:graphic>
      </p:graphicFrame>
      <p:sp>
        <p:nvSpPr>
          <p:cNvPr id="23" name="Rettangolo 22"/>
          <p:cNvSpPr/>
          <p:nvPr/>
        </p:nvSpPr>
        <p:spPr>
          <a:xfrm>
            <a:off x="4629150" y="5919788"/>
            <a:ext cx="2309813" cy="936625"/>
          </a:xfrm>
          <a:prstGeom prst="rect">
            <a:avLst/>
          </a:prstGeom>
          <a:solidFill>
            <a:schemeClr val="bg1"/>
          </a:solidFill>
          <a:ln>
            <a:noFill/>
          </a:ln>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it-IT"/>
          </a:p>
        </p:txBody>
      </p:sp>
      <p:graphicFrame>
        <p:nvGraphicFramePr>
          <p:cNvPr id="5" name="Chart 4">
            <a:extLst>
              <a:ext uri="{FF2B5EF4-FFF2-40B4-BE49-F238E27FC236}">
                <a16:creationId xmlns:a16="http://schemas.microsoft.com/office/drawing/2014/main" id="{6C2F215D-B916-44BB-9BBB-ACECD730B85E}"/>
              </a:ext>
            </a:extLst>
          </p:cNvPr>
          <p:cNvGraphicFramePr>
            <a:graphicFrameLocks/>
          </p:cNvGraphicFramePr>
          <p:nvPr>
            <p:extLst>
              <p:ext uri="{D42A27DB-BD31-4B8C-83A1-F6EECF244321}">
                <p14:modId xmlns:p14="http://schemas.microsoft.com/office/powerpoint/2010/main" val="835402324"/>
              </p:ext>
            </p:extLst>
          </p:nvPr>
        </p:nvGraphicFramePr>
        <p:xfrm>
          <a:off x="3636000" y="144014"/>
          <a:ext cx="3600000" cy="2160240"/>
        </p:xfrm>
        <a:graphic>
          <a:graphicData uri="http://schemas.openxmlformats.org/drawingml/2006/chart">
            <c:chart xmlns:c="http://schemas.openxmlformats.org/drawingml/2006/chart" xmlns:r="http://schemas.openxmlformats.org/officeDocument/2006/relationships" r:id="rId3"/>
          </a:graphicData>
        </a:graphic>
      </p:graphicFrame>
      <p:graphicFrame>
        <p:nvGraphicFramePr>
          <p:cNvPr id="6" name="Chart 5">
            <a:extLst>
              <a:ext uri="{FF2B5EF4-FFF2-40B4-BE49-F238E27FC236}">
                <a16:creationId xmlns:a16="http://schemas.microsoft.com/office/drawing/2014/main" id="{45931219-C9D6-4270-A298-050CE08ABCF2}"/>
              </a:ext>
            </a:extLst>
          </p:cNvPr>
          <p:cNvGraphicFramePr>
            <a:graphicFrameLocks/>
          </p:cNvGraphicFramePr>
          <p:nvPr>
            <p:extLst>
              <p:ext uri="{D42A27DB-BD31-4B8C-83A1-F6EECF244321}">
                <p14:modId xmlns:p14="http://schemas.microsoft.com/office/powerpoint/2010/main" val="1364515518"/>
              </p:ext>
            </p:extLst>
          </p:nvPr>
        </p:nvGraphicFramePr>
        <p:xfrm>
          <a:off x="136799" y="144014"/>
          <a:ext cx="3600000" cy="2160240"/>
        </p:xfrm>
        <a:graphic>
          <a:graphicData uri="http://schemas.openxmlformats.org/drawingml/2006/chart">
            <c:chart xmlns:c="http://schemas.openxmlformats.org/drawingml/2006/chart" xmlns:r="http://schemas.openxmlformats.org/officeDocument/2006/relationships" r:id="rId4"/>
          </a:graphicData>
        </a:graphic>
      </p:graphicFrame>
      <p:grpSp>
        <p:nvGrpSpPr>
          <p:cNvPr id="7" name="Group 6">
            <a:extLst>
              <a:ext uri="{FF2B5EF4-FFF2-40B4-BE49-F238E27FC236}">
                <a16:creationId xmlns:a16="http://schemas.microsoft.com/office/drawing/2014/main" id="{D398814A-CC7A-43FA-AE1F-15FDA5A5F32F}"/>
              </a:ext>
            </a:extLst>
          </p:cNvPr>
          <p:cNvGrpSpPr/>
          <p:nvPr/>
        </p:nvGrpSpPr>
        <p:grpSpPr>
          <a:xfrm>
            <a:off x="5924175" y="381126"/>
            <a:ext cx="937560" cy="1317891"/>
            <a:chOff x="4444905" y="1924452"/>
            <a:chExt cx="1838860" cy="2610099"/>
          </a:xfrm>
        </p:grpSpPr>
        <p:sp>
          <p:nvSpPr>
            <p:cNvPr id="17" name="TextBox 12">
              <a:extLst>
                <a:ext uri="{FF2B5EF4-FFF2-40B4-BE49-F238E27FC236}">
                  <a16:creationId xmlns:a16="http://schemas.microsoft.com/office/drawing/2014/main" id="{E204940F-0F53-4AEA-B7E2-F8320592EC6A}"/>
                </a:ext>
              </a:extLst>
            </p:cNvPr>
            <p:cNvSpPr txBox="1"/>
            <p:nvPr/>
          </p:nvSpPr>
          <p:spPr>
            <a:xfrm>
              <a:off x="4663157" y="3890126"/>
              <a:ext cx="1620608" cy="644425"/>
            </a:xfrm>
            <a:prstGeom prst="rect">
              <a:avLst/>
            </a:prstGeom>
            <a:noFill/>
          </p:spPr>
          <p:txBody>
            <a:bodyPr wrap="square" rtlCol="0">
              <a:noAutofit/>
            </a:bodyPr>
            <a:lstStyle/>
            <a:p>
              <a:pPr>
                <a:spcAft>
                  <a:spcPts val="0"/>
                </a:spcAft>
              </a:pPr>
              <a:r>
                <a:rPr lang="en-GB" sz="1200" kern="1200" dirty="0">
                  <a:solidFill>
                    <a:srgbClr val="000000"/>
                  </a:solidFill>
                  <a:effectLst/>
                  <a:latin typeface="Calibri"/>
                  <a:ea typeface="Times New Roman"/>
                </a:rPr>
                <a:t>INK128</a:t>
              </a:r>
              <a:endParaRPr lang="en-GB" sz="1200" dirty="0">
                <a:effectLst/>
                <a:latin typeface="Times New Roman"/>
                <a:ea typeface="Times New Roman"/>
              </a:endParaRPr>
            </a:p>
          </p:txBody>
        </p:sp>
        <p:pic>
          <p:nvPicPr>
            <p:cNvPr id="18" name="Picture 17" descr="N:\AbdullahAhmed\Public\Year 4 PhD 2017\Thesis\Introduction\Figures and files\INK128.png">
              <a:extLst>
                <a:ext uri="{FF2B5EF4-FFF2-40B4-BE49-F238E27FC236}">
                  <a16:creationId xmlns:a16="http://schemas.microsoft.com/office/drawing/2014/main" id="{6235F4A4-AC9A-4A21-83C3-6E1DD533D2CB}"/>
                </a:ext>
              </a:extLst>
            </p:cNvPr>
            <p:cNvPicPr>
              <a:picLocks noChangeAspect="1" noChangeArrowheads="1"/>
            </p:cNvPicPr>
            <p:nvPr/>
          </p:nvPicPr>
          <p:blipFill>
            <a:blip r:embed="rId5" cstate="print">
              <a:extLst>
                <a:ext uri="{28A0092B-C50C-407E-A947-70E740481C1C}">
                  <a14:useLocalDpi xmlns:a14="http://schemas.microsoft.com/office/drawing/2010/main" val="0"/>
                </a:ext>
              </a:extLst>
            </a:blip>
            <a:srcRect/>
            <a:stretch>
              <a:fillRect/>
            </a:stretch>
          </p:blipFill>
          <p:spPr bwMode="auto">
            <a:xfrm>
              <a:off x="4444905" y="1924452"/>
              <a:ext cx="1361452" cy="2088232"/>
            </a:xfrm>
            <a:prstGeom prst="rect">
              <a:avLst/>
            </a:prstGeom>
            <a:noFill/>
            <a:extLst>
              <a:ext uri="{909E8E84-426E-40DD-AFC4-6F175D3DCCD1}">
                <a14:hiddenFill xmlns:a14="http://schemas.microsoft.com/office/drawing/2010/main">
                  <a:solidFill>
                    <a:srgbClr val="FFFFFF"/>
                  </a:solidFill>
                </a14:hiddenFill>
              </a:ext>
            </a:extLst>
          </p:spPr>
        </p:pic>
      </p:grpSp>
      <p:grpSp>
        <p:nvGrpSpPr>
          <p:cNvPr id="8" name="Group 7">
            <a:extLst>
              <a:ext uri="{FF2B5EF4-FFF2-40B4-BE49-F238E27FC236}">
                <a16:creationId xmlns:a16="http://schemas.microsoft.com/office/drawing/2014/main" id="{EE5E4121-EC5D-4891-989E-1074FCDC09FF}"/>
              </a:ext>
            </a:extLst>
          </p:cNvPr>
          <p:cNvGrpSpPr/>
          <p:nvPr/>
        </p:nvGrpSpPr>
        <p:grpSpPr>
          <a:xfrm>
            <a:off x="2252140" y="366364"/>
            <a:ext cx="1147558" cy="1296190"/>
            <a:chOff x="4283968" y="2946248"/>
            <a:chExt cx="2812999" cy="2804159"/>
          </a:xfrm>
        </p:grpSpPr>
        <p:pic>
          <p:nvPicPr>
            <p:cNvPr id="15" name="Picture 14">
              <a:extLst>
                <a:ext uri="{FF2B5EF4-FFF2-40B4-BE49-F238E27FC236}">
                  <a16:creationId xmlns:a16="http://schemas.microsoft.com/office/drawing/2014/main" id="{A83F7127-C45B-4D87-8742-EEE47BC353A5}"/>
                </a:ext>
              </a:extLst>
            </p:cNvPr>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a:off x="4283968" y="2946248"/>
              <a:ext cx="2615672" cy="2242515"/>
            </a:xfrm>
            <a:prstGeom prst="rect">
              <a:avLst/>
            </a:prstGeom>
          </p:spPr>
        </p:pic>
        <p:sp>
          <p:nvSpPr>
            <p:cNvPr id="16" name="TextBox 10">
              <a:extLst>
                <a:ext uri="{FF2B5EF4-FFF2-40B4-BE49-F238E27FC236}">
                  <a16:creationId xmlns:a16="http://schemas.microsoft.com/office/drawing/2014/main" id="{D9E4C6DE-B1A4-4258-85CD-805CB71B30F9}"/>
                </a:ext>
              </a:extLst>
            </p:cNvPr>
            <p:cNvSpPr txBox="1"/>
            <p:nvPr/>
          </p:nvSpPr>
          <p:spPr>
            <a:xfrm>
              <a:off x="4337502" y="5188762"/>
              <a:ext cx="2759465" cy="561645"/>
            </a:xfrm>
            <a:prstGeom prst="rect">
              <a:avLst/>
            </a:prstGeom>
            <a:noFill/>
          </p:spPr>
          <p:txBody>
            <a:bodyPr wrap="square" rtlCol="0">
              <a:noAutofit/>
            </a:bodyPr>
            <a:lstStyle/>
            <a:p>
              <a:pPr algn="ctr">
                <a:spcAft>
                  <a:spcPts val="0"/>
                </a:spcAft>
              </a:pPr>
              <a:r>
                <a:rPr lang="en-GB" sz="1200" kern="1200" dirty="0">
                  <a:solidFill>
                    <a:srgbClr val="000000"/>
                  </a:solidFill>
                  <a:effectLst/>
                  <a:latin typeface="Calibri"/>
                  <a:ea typeface="Times New Roman"/>
                </a:rPr>
                <a:t>Rapamycin</a:t>
              </a:r>
              <a:endParaRPr lang="en-GB" sz="1200" dirty="0">
                <a:effectLst/>
                <a:latin typeface="Times New Roman"/>
                <a:ea typeface="Times New Roman"/>
              </a:endParaRPr>
            </a:p>
          </p:txBody>
        </p:sp>
      </p:grpSp>
      <p:sp>
        <p:nvSpPr>
          <p:cNvPr id="9" name="TextBox 8">
            <a:extLst>
              <a:ext uri="{FF2B5EF4-FFF2-40B4-BE49-F238E27FC236}">
                <a16:creationId xmlns:a16="http://schemas.microsoft.com/office/drawing/2014/main" id="{737DDB3B-FA26-4832-96F9-9EFDADF80FC3}"/>
              </a:ext>
            </a:extLst>
          </p:cNvPr>
          <p:cNvSpPr txBox="1"/>
          <p:nvPr/>
        </p:nvSpPr>
        <p:spPr>
          <a:xfrm>
            <a:off x="3600000" y="3804"/>
            <a:ext cx="274434" cy="276999"/>
          </a:xfrm>
          <a:prstGeom prst="rect">
            <a:avLst/>
          </a:prstGeom>
          <a:noFill/>
        </p:spPr>
        <p:txBody>
          <a:bodyPr wrap="none" rtlCol="0">
            <a:spAutoFit/>
          </a:bodyPr>
          <a:lstStyle/>
          <a:p>
            <a:r>
              <a:rPr lang="en-GB" sz="1200" dirty="0"/>
              <a:t>B</a:t>
            </a:r>
          </a:p>
        </p:txBody>
      </p:sp>
      <p:sp>
        <p:nvSpPr>
          <p:cNvPr id="10" name="TextBox 9">
            <a:extLst>
              <a:ext uri="{FF2B5EF4-FFF2-40B4-BE49-F238E27FC236}">
                <a16:creationId xmlns:a16="http://schemas.microsoft.com/office/drawing/2014/main" id="{E177BD67-55E9-4F03-AA76-52C7D0A4DAA3}"/>
              </a:ext>
            </a:extLst>
          </p:cNvPr>
          <p:cNvSpPr txBox="1"/>
          <p:nvPr/>
        </p:nvSpPr>
        <p:spPr>
          <a:xfrm>
            <a:off x="0" y="0"/>
            <a:ext cx="274434" cy="276999"/>
          </a:xfrm>
          <a:prstGeom prst="rect">
            <a:avLst/>
          </a:prstGeom>
          <a:noFill/>
        </p:spPr>
        <p:txBody>
          <a:bodyPr wrap="none" rtlCol="0">
            <a:spAutoFit/>
          </a:bodyPr>
          <a:lstStyle/>
          <a:p>
            <a:r>
              <a:rPr lang="en-GB" sz="1200" dirty="0"/>
              <a:t>A</a:t>
            </a:r>
          </a:p>
        </p:txBody>
      </p:sp>
      <p:graphicFrame>
        <p:nvGraphicFramePr>
          <p:cNvPr id="11" name="Chart 10">
            <a:extLst>
              <a:ext uri="{FF2B5EF4-FFF2-40B4-BE49-F238E27FC236}">
                <a16:creationId xmlns:a16="http://schemas.microsoft.com/office/drawing/2014/main" id="{741716F0-AA44-4C60-960F-D4E8DB32B374}"/>
              </a:ext>
            </a:extLst>
          </p:cNvPr>
          <p:cNvGraphicFramePr>
            <a:graphicFrameLocks/>
          </p:cNvGraphicFramePr>
          <p:nvPr>
            <p:extLst>
              <p:ext uri="{D42A27DB-BD31-4B8C-83A1-F6EECF244321}">
                <p14:modId xmlns:p14="http://schemas.microsoft.com/office/powerpoint/2010/main" val="1696401148"/>
              </p:ext>
            </p:extLst>
          </p:nvPr>
        </p:nvGraphicFramePr>
        <p:xfrm>
          <a:off x="4749222" y="313198"/>
          <a:ext cx="1174953" cy="1190246"/>
        </p:xfrm>
        <a:graphic>
          <a:graphicData uri="http://schemas.openxmlformats.org/drawingml/2006/chart">
            <c:chart xmlns:c="http://schemas.openxmlformats.org/drawingml/2006/chart" xmlns:r="http://schemas.openxmlformats.org/officeDocument/2006/relationships" r:id="rId7"/>
          </a:graphicData>
        </a:graphic>
      </p:graphicFrame>
      <p:graphicFrame>
        <p:nvGraphicFramePr>
          <p:cNvPr id="12" name="Chart 11">
            <a:extLst>
              <a:ext uri="{FF2B5EF4-FFF2-40B4-BE49-F238E27FC236}">
                <a16:creationId xmlns:a16="http://schemas.microsoft.com/office/drawing/2014/main" id="{CB177A2A-BA1B-49FB-A9A8-CDC26FFCA974}"/>
              </a:ext>
            </a:extLst>
          </p:cNvPr>
          <p:cNvGraphicFramePr>
            <a:graphicFrameLocks/>
          </p:cNvGraphicFramePr>
          <p:nvPr>
            <p:extLst>
              <p:ext uri="{D42A27DB-BD31-4B8C-83A1-F6EECF244321}">
                <p14:modId xmlns:p14="http://schemas.microsoft.com/office/powerpoint/2010/main" val="3552286236"/>
              </p:ext>
            </p:extLst>
          </p:nvPr>
        </p:nvGraphicFramePr>
        <p:xfrm>
          <a:off x="1150724" y="288029"/>
          <a:ext cx="1123255" cy="1296112"/>
        </p:xfrm>
        <a:graphic>
          <a:graphicData uri="http://schemas.openxmlformats.org/drawingml/2006/chart">
            <c:chart xmlns:c="http://schemas.openxmlformats.org/drawingml/2006/chart" xmlns:r="http://schemas.openxmlformats.org/officeDocument/2006/relationships" r:id="rId8"/>
          </a:graphicData>
        </a:graphic>
      </p:graphicFrame>
      <p:sp>
        <p:nvSpPr>
          <p:cNvPr id="13" name="TextBox 12">
            <a:extLst>
              <a:ext uri="{FF2B5EF4-FFF2-40B4-BE49-F238E27FC236}">
                <a16:creationId xmlns:a16="http://schemas.microsoft.com/office/drawing/2014/main" id="{CDB38845-0170-4EC0-B938-63827D3C4BC5}"/>
              </a:ext>
            </a:extLst>
          </p:cNvPr>
          <p:cNvSpPr txBox="1"/>
          <p:nvPr/>
        </p:nvSpPr>
        <p:spPr>
          <a:xfrm>
            <a:off x="5096324" y="314829"/>
            <a:ext cx="619080" cy="261610"/>
          </a:xfrm>
          <a:prstGeom prst="rect">
            <a:avLst/>
          </a:prstGeom>
          <a:noFill/>
        </p:spPr>
        <p:txBody>
          <a:bodyPr wrap="none" rtlCol="0">
            <a:spAutoFit/>
          </a:bodyPr>
          <a:lstStyle/>
          <a:p>
            <a:r>
              <a:rPr lang="en-GB" sz="1100" dirty="0"/>
              <a:t>293 nm</a:t>
            </a:r>
          </a:p>
        </p:txBody>
      </p:sp>
      <p:sp>
        <p:nvSpPr>
          <p:cNvPr id="14" name="TextBox 13">
            <a:extLst>
              <a:ext uri="{FF2B5EF4-FFF2-40B4-BE49-F238E27FC236}">
                <a16:creationId xmlns:a16="http://schemas.microsoft.com/office/drawing/2014/main" id="{134B7E9D-1B01-4698-964B-46E1E7489836}"/>
              </a:ext>
            </a:extLst>
          </p:cNvPr>
          <p:cNvSpPr txBox="1"/>
          <p:nvPr/>
        </p:nvSpPr>
        <p:spPr>
          <a:xfrm>
            <a:off x="1520201" y="235559"/>
            <a:ext cx="619080" cy="261610"/>
          </a:xfrm>
          <a:prstGeom prst="rect">
            <a:avLst/>
          </a:prstGeom>
          <a:noFill/>
        </p:spPr>
        <p:txBody>
          <a:bodyPr wrap="none" rtlCol="0">
            <a:spAutoFit/>
          </a:bodyPr>
          <a:lstStyle/>
          <a:p>
            <a:r>
              <a:rPr lang="en-GB" sz="1100" dirty="0"/>
              <a:t>279 nm</a:t>
            </a:r>
          </a:p>
        </p:txBody>
      </p:sp>
      <p:graphicFrame>
        <p:nvGraphicFramePr>
          <p:cNvPr id="20" name="Chart 19">
            <a:extLst>
              <a:ext uri="{FF2B5EF4-FFF2-40B4-BE49-F238E27FC236}">
                <a16:creationId xmlns:a16="http://schemas.microsoft.com/office/drawing/2014/main" id="{ABFD3657-0F8B-471F-87F4-B781EB78AF1B}"/>
              </a:ext>
            </a:extLst>
          </p:cNvPr>
          <p:cNvGraphicFramePr>
            <a:graphicFrameLocks/>
          </p:cNvGraphicFramePr>
          <p:nvPr>
            <p:extLst>
              <p:ext uri="{D42A27DB-BD31-4B8C-83A1-F6EECF244321}">
                <p14:modId xmlns:p14="http://schemas.microsoft.com/office/powerpoint/2010/main" val="366169360"/>
              </p:ext>
            </p:extLst>
          </p:nvPr>
        </p:nvGraphicFramePr>
        <p:xfrm>
          <a:off x="3618000" y="2061702"/>
          <a:ext cx="3600000" cy="2345689"/>
        </p:xfrm>
        <a:graphic>
          <a:graphicData uri="http://schemas.openxmlformats.org/drawingml/2006/chart">
            <c:chart xmlns:c="http://schemas.openxmlformats.org/drawingml/2006/chart" xmlns:r="http://schemas.openxmlformats.org/officeDocument/2006/relationships" r:id="rId9"/>
          </a:graphicData>
        </a:graphic>
      </p:graphicFrame>
      <p:grpSp>
        <p:nvGrpSpPr>
          <p:cNvPr id="21" name="Group 20">
            <a:extLst>
              <a:ext uri="{FF2B5EF4-FFF2-40B4-BE49-F238E27FC236}">
                <a16:creationId xmlns:a16="http://schemas.microsoft.com/office/drawing/2014/main" id="{CF7C603E-78E2-4778-893E-707EB5616C0A}"/>
              </a:ext>
            </a:extLst>
          </p:cNvPr>
          <p:cNvGrpSpPr/>
          <p:nvPr/>
        </p:nvGrpSpPr>
        <p:grpSpPr>
          <a:xfrm>
            <a:off x="0" y="2010170"/>
            <a:ext cx="7037064" cy="2354630"/>
            <a:chOff x="-80062" y="2222639"/>
            <a:chExt cx="6753666" cy="2453428"/>
          </a:xfrm>
        </p:grpSpPr>
        <p:grpSp>
          <p:nvGrpSpPr>
            <p:cNvPr id="22" name="Group 21">
              <a:extLst>
                <a:ext uri="{FF2B5EF4-FFF2-40B4-BE49-F238E27FC236}">
                  <a16:creationId xmlns:a16="http://schemas.microsoft.com/office/drawing/2014/main" id="{9B38FD1A-477C-4CE6-9D85-E217D58CC7C5}"/>
                </a:ext>
              </a:extLst>
            </p:cNvPr>
            <p:cNvGrpSpPr/>
            <p:nvPr/>
          </p:nvGrpSpPr>
          <p:grpSpPr>
            <a:xfrm>
              <a:off x="-80062" y="2222639"/>
              <a:ext cx="4891083" cy="2453428"/>
              <a:chOff x="-80062" y="2222639"/>
              <a:chExt cx="4891083" cy="2453428"/>
            </a:xfrm>
          </p:grpSpPr>
          <p:sp>
            <p:nvSpPr>
              <p:cNvPr id="30" name="TextBox 18">
                <a:extLst>
                  <a:ext uri="{FF2B5EF4-FFF2-40B4-BE49-F238E27FC236}">
                    <a16:creationId xmlns:a16="http://schemas.microsoft.com/office/drawing/2014/main" id="{25580136-5F84-4873-9B3B-B58B00B41339}"/>
                  </a:ext>
                </a:extLst>
              </p:cNvPr>
              <p:cNvSpPr txBox="1"/>
              <p:nvPr/>
            </p:nvSpPr>
            <p:spPr>
              <a:xfrm>
                <a:off x="-80062" y="2222639"/>
                <a:ext cx="266065" cy="277495"/>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31" name="TextBox 21">
                <a:extLst>
                  <a:ext uri="{FF2B5EF4-FFF2-40B4-BE49-F238E27FC236}">
                    <a16:creationId xmlns:a16="http://schemas.microsoft.com/office/drawing/2014/main" id="{9D3BEDC7-30C0-440C-AD32-EDA74B976A1D}"/>
                  </a:ext>
                </a:extLst>
              </p:cNvPr>
              <p:cNvSpPr txBox="1"/>
              <p:nvPr/>
            </p:nvSpPr>
            <p:spPr>
              <a:xfrm>
                <a:off x="3374958" y="2251567"/>
                <a:ext cx="264160" cy="277495"/>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
                </a:r>
                <a:endParaRPr lang="en-GB" sz="1200" dirty="0">
                  <a:effectLst/>
                  <a:latin typeface="Times New Roman" panose="02020603050405020304" pitchFamily="18" charset="0"/>
                  <a:ea typeface="Times New Roman" panose="02020603050405020304" pitchFamily="18" charset="0"/>
                </a:endParaRPr>
              </a:p>
            </p:txBody>
          </p:sp>
          <p:graphicFrame>
            <p:nvGraphicFramePr>
              <p:cNvPr id="32" name="Chart 31">
                <a:extLst>
                  <a:ext uri="{FF2B5EF4-FFF2-40B4-BE49-F238E27FC236}">
                    <a16:creationId xmlns:a16="http://schemas.microsoft.com/office/drawing/2014/main" id="{B239179D-AB56-4874-89AF-ED9F2021DEF9}"/>
                  </a:ext>
                </a:extLst>
              </p:cNvPr>
              <p:cNvGraphicFramePr>
                <a:graphicFrameLocks/>
              </p:cNvGraphicFramePr>
              <p:nvPr>
                <p:extLst>
                  <p:ext uri="{D42A27DB-BD31-4B8C-83A1-F6EECF244321}">
                    <p14:modId xmlns:p14="http://schemas.microsoft.com/office/powerpoint/2010/main" val="105973830"/>
                  </p:ext>
                </p:extLst>
              </p:nvPr>
            </p:nvGraphicFramePr>
            <p:xfrm>
              <a:off x="-45512" y="2471204"/>
              <a:ext cx="3456384" cy="2204863"/>
            </p:xfrm>
            <a:graphic>
              <a:graphicData uri="http://schemas.openxmlformats.org/drawingml/2006/chart">
                <c:chart xmlns:c="http://schemas.openxmlformats.org/drawingml/2006/chart" xmlns:r="http://schemas.openxmlformats.org/officeDocument/2006/relationships" r:id="rId10"/>
              </a:graphicData>
            </a:graphic>
          </p:graphicFrame>
          <p:sp>
            <p:nvSpPr>
              <p:cNvPr id="33" name="Rectangle 32">
                <a:extLst>
                  <a:ext uri="{FF2B5EF4-FFF2-40B4-BE49-F238E27FC236}">
                    <a16:creationId xmlns:a16="http://schemas.microsoft.com/office/drawing/2014/main" id="{8A3AD2D3-8F96-486F-A48C-78E4E1703CBF}"/>
                  </a:ext>
                </a:extLst>
              </p:cNvPr>
              <p:cNvSpPr/>
              <p:nvPr/>
            </p:nvSpPr>
            <p:spPr>
              <a:xfrm>
                <a:off x="705793" y="2390314"/>
                <a:ext cx="569595" cy="277495"/>
              </a:xfrm>
              <a:prstGeom prst="rect">
                <a:avLst/>
              </a:prstGeom>
            </p:spPr>
            <p:txBody>
              <a:bodyPr wrap="square">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41425</a:t>
                </a:r>
                <a:endParaRPr lang="en-GB" sz="1200" dirty="0">
                  <a:effectLst/>
                  <a:latin typeface="Times New Roman" panose="02020603050405020304" pitchFamily="18" charset="0"/>
                  <a:ea typeface="Times New Roman" panose="02020603050405020304" pitchFamily="18" charset="0"/>
                </a:endParaRPr>
              </a:p>
            </p:txBody>
          </p:sp>
          <p:sp>
            <p:nvSpPr>
              <p:cNvPr id="34" name="Rectangle 33">
                <a:extLst>
                  <a:ext uri="{FF2B5EF4-FFF2-40B4-BE49-F238E27FC236}">
                    <a16:creationId xmlns:a16="http://schemas.microsoft.com/office/drawing/2014/main" id="{124BF566-B258-4550-A4AA-FC90B83D3DB5}"/>
                  </a:ext>
                </a:extLst>
              </p:cNvPr>
              <p:cNvSpPr/>
              <p:nvPr/>
            </p:nvSpPr>
            <p:spPr>
              <a:xfrm>
                <a:off x="4241426" y="2529062"/>
                <a:ext cx="569595" cy="277495"/>
              </a:xfrm>
              <a:prstGeom prst="rect">
                <a:avLst/>
              </a:prstGeom>
            </p:spPr>
            <p:txBody>
              <a:bodyPr wrap="square">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6215</a:t>
                </a:r>
                <a:endParaRPr lang="en-GB" sz="1200" dirty="0">
                  <a:effectLst/>
                  <a:latin typeface="Times New Roman" panose="02020603050405020304" pitchFamily="18" charset="0"/>
                  <a:ea typeface="Times New Roman" panose="02020603050405020304" pitchFamily="18" charset="0"/>
                </a:endParaRPr>
              </a:p>
            </p:txBody>
          </p:sp>
        </p:grpSp>
        <p:sp>
          <p:nvSpPr>
            <p:cNvPr id="24" name="TextBox 27">
              <a:extLst>
                <a:ext uri="{FF2B5EF4-FFF2-40B4-BE49-F238E27FC236}">
                  <a16:creationId xmlns:a16="http://schemas.microsoft.com/office/drawing/2014/main" id="{4FAF76C3-60A7-4187-B0BA-174C3CA6E1CC}"/>
                </a:ext>
              </a:extLst>
            </p:cNvPr>
            <p:cNvSpPr txBox="1"/>
            <p:nvPr/>
          </p:nvSpPr>
          <p:spPr>
            <a:xfrm>
              <a:off x="5605534" y="3110745"/>
              <a:ext cx="1068070" cy="277495"/>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6 µM INK128</a:t>
              </a:r>
              <a:endParaRPr lang="en-GB" sz="1200" dirty="0">
                <a:effectLst/>
                <a:latin typeface="Times New Roman" panose="02020603050405020304" pitchFamily="18" charset="0"/>
                <a:ea typeface="Times New Roman" panose="02020603050405020304" pitchFamily="18" charset="0"/>
              </a:endParaRPr>
            </a:p>
          </p:txBody>
        </p:sp>
        <p:sp>
          <p:nvSpPr>
            <p:cNvPr id="25" name="TextBox 28">
              <a:extLst>
                <a:ext uri="{FF2B5EF4-FFF2-40B4-BE49-F238E27FC236}">
                  <a16:creationId xmlns:a16="http://schemas.microsoft.com/office/drawing/2014/main" id="{954E0801-A250-4B80-82D8-15948EAF3C5B}"/>
                </a:ext>
              </a:extLst>
            </p:cNvPr>
            <p:cNvSpPr txBox="1"/>
            <p:nvPr/>
          </p:nvSpPr>
          <p:spPr>
            <a:xfrm>
              <a:off x="1471149" y="3366895"/>
              <a:ext cx="1262380" cy="277495"/>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10 µM rapamycin</a:t>
              </a:r>
              <a:endParaRPr lang="en-GB" sz="1200" dirty="0">
                <a:effectLst/>
                <a:latin typeface="Times New Roman" panose="02020603050405020304" pitchFamily="18" charset="0"/>
                <a:ea typeface="Times New Roman" panose="02020603050405020304" pitchFamily="18" charset="0"/>
              </a:endParaRPr>
            </a:p>
          </p:txBody>
        </p:sp>
      </p:grpSp>
      <p:grpSp>
        <p:nvGrpSpPr>
          <p:cNvPr id="35" name="Group 34">
            <a:extLst>
              <a:ext uri="{FF2B5EF4-FFF2-40B4-BE49-F238E27FC236}">
                <a16:creationId xmlns:a16="http://schemas.microsoft.com/office/drawing/2014/main" id="{3502AFA9-D4A9-40CC-A04B-EAB71817E412}"/>
              </a:ext>
            </a:extLst>
          </p:cNvPr>
          <p:cNvGrpSpPr/>
          <p:nvPr/>
        </p:nvGrpSpPr>
        <p:grpSpPr>
          <a:xfrm>
            <a:off x="0" y="4134411"/>
            <a:ext cx="3943707" cy="2190668"/>
            <a:chOff x="1132928" y="-549538"/>
            <a:chExt cx="5739751" cy="2758217"/>
          </a:xfrm>
        </p:grpSpPr>
        <p:graphicFrame>
          <p:nvGraphicFramePr>
            <p:cNvPr id="36" name="Chart 35">
              <a:extLst>
                <a:ext uri="{FF2B5EF4-FFF2-40B4-BE49-F238E27FC236}">
                  <a16:creationId xmlns:a16="http://schemas.microsoft.com/office/drawing/2014/main" id="{E90FF7A6-0F22-494F-90FE-225E4A8CE45B}"/>
                </a:ext>
              </a:extLst>
            </p:cNvPr>
            <p:cNvGraphicFramePr>
              <a:graphicFrameLocks/>
            </p:cNvGraphicFramePr>
            <p:nvPr>
              <p:extLst>
                <p:ext uri="{D42A27DB-BD31-4B8C-83A1-F6EECF244321}">
                  <p14:modId xmlns:p14="http://schemas.microsoft.com/office/powerpoint/2010/main" val="4270426079"/>
                </p:ext>
              </p:extLst>
            </p:nvPr>
          </p:nvGraphicFramePr>
          <p:xfrm>
            <a:off x="1421101" y="-455617"/>
            <a:ext cx="5451578" cy="2664296"/>
          </p:xfrm>
          <a:graphic>
            <a:graphicData uri="http://schemas.openxmlformats.org/drawingml/2006/chart">
              <c:chart xmlns:c="http://schemas.openxmlformats.org/drawingml/2006/chart" xmlns:r="http://schemas.openxmlformats.org/officeDocument/2006/relationships" r:id="rId11"/>
            </a:graphicData>
          </a:graphic>
        </p:graphicFrame>
        <p:sp>
          <p:nvSpPr>
            <p:cNvPr id="37" name="TextBox 4">
              <a:extLst>
                <a:ext uri="{FF2B5EF4-FFF2-40B4-BE49-F238E27FC236}">
                  <a16:creationId xmlns:a16="http://schemas.microsoft.com/office/drawing/2014/main" id="{FE54D671-8AE1-45B7-9803-A4E11220E7CE}"/>
                </a:ext>
              </a:extLst>
            </p:cNvPr>
            <p:cNvSpPr txBox="1"/>
            <p:nvPr/>
          </p:nvSpPr>
          <p:spPr>
            <a:xfrm>
              <a:off x="1132928" y="-549538"/>
              <a:ext cx="274434" cy="276999"/>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E</a:t>
              </a:r>
              <a:endParaRPr lang="en-GB" sz="1200" dirty="0">
                <a:effectLst/>
                <a:latin typeface="Times New Roman" panose="02020603050405020304" pitchFamily="18" charset="0"/>
                <a:ea typeface="Times New Roman" panose="02020603050405020304" pitchFamily="18" charset="0"/>
              </a:endParaRPr>
            </a:p>
          </p:txBody>
        </p:sp>
      </p:grpSp>
      <p:sp>
        <p:nvSpPr>
          <p:cNvPr id="41" name="TextBox 4">
            <a:extLst>
              <a:ext uri="{FF2B5EF4-FFF2-40B4-BE49-F238E27FC236}">
                <a16:creationId xmlns:a16="http://schemas.microsoft.com/office/drawing/2014/main" id="{EDAEFC54-C50D-4C21-ACEB-3A7B66097DF3}"/>
              </a:ext>
            </a:extLst>
          </p:cNvPr>
          <p:cNvSpPr txBox="1"/>
          <p:nvPr/>
        </p:nvSpPr>
        <p:spPr>
          <a:xfrm>
            <a:off x="3600000" y="4140287"/>
            <a:ext cx="188560" cy="220002"/>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F</a:t>
            </a:r>
            <a:endParaRPr lang="en-GB" sz="1200" dirty="0">
              <a:effectLst/>
              <a:latin typeface="Times New Roman" panose="02020603050405020304" pitchFamily="18" charset="0"/>
              <a:ea typeface="Times New Roman" panose="02020603050405020304" pitchFamily="18" charset="0"/>
            </a:endParaRPr>
          </a:p>
        </p:txBody>
      </p:sp>
      <p:sp>
        <p:nvSpPr>
          <p:cNvPr id="38" name="Rectangle 37">
            <a:extLst>
              <a:ext uri="{FF2B5EF4-FFF2-40B4-BE49-F238E27FC236}">
                <a16:creationId xmlns:a16="http://schemas.microsoft.com/office/drawing/2014/main" id="{0B475872-1808-45F1-BDD4-26D39E88939F}"/>
              </a:ext>
            </a:extLst>
          </p:cNvPr>
          <p:cNvSpPr/>
          <p:nvPr/>
        </p:nvSpPr>
        <p:spPr>
          <a:xfrm>
            <a:off x="7126713" y="243207"/>
            <a:ext cx="2046795" cy="4555093"/>
          </a:xfrm>
          <a:prstGeom prst="rect">
            <a:avLst/>
          </a:prstGeom>
        </p:spPr>
        <p:txBody>
          <a:bodyPr wrap="square">
            <a:spAutoFit/>
          </a:bodyPr>
          <a:lstStyle/>
          <a:p>
            <a:pPr algn="just">
              <a:spcAft>
                <a:spcPts val="1000"/>
              </a:spcAft>
            </a:pPr>
            <a:r>
              <a:rPr lang="en-GB" sz="1000" b="1" i="1" dirty="0">
                <a:latin typeface="Arial" panose="020B0604020202020204" pitchFamily="34" charset="0"/>
                <a:ea typeface="Calibri" panose="020F0502020204030204" pitchFamily="34" charset="0"/>
                <a:cs typeface="Times New Roman" panose="02020603050405020304" pitchFamily="18" charset="0"/>
              </a:rPr>
              <a:t>Supplementary Figure S.6: Fluorescence characterisation of rapamycin and INK128. </a:t>
            </a:r>
            <a:r>
              <a:rPr lang="en-GB" sz="1000" dirty="0">
                <a:solidFill>
                  <a:srgbClr val="000000"/>
                </a:solidFill>
                <a:latin typeface="Arial" panose="020B0604020202020204" pitchFamily="34" charset="0"/>
              </a:rPr>
              <a:t>UV-Vis spectra of A) rapamycin </a:t>
            </a:r>
            <a:r>
              <a:rPr lang="en-GB" sz="1000" i="1" dirty="0">
                <a:latin typeface="Arial" panose="020B0604020202020204" pitchFamily="34" charset="0"/>
                <a:ea typeface="Calibri" panose="020F0502020204030204" pitchFamily="34" charset="0"/>
                <a:cs typeface="Times New Roman" panose="02020603050405020304" pitchFamily="18" charset="0"/>
              </a:rPr>
              <a:t>(10 </a:t>
            </a:r>
            <a:r>
              <a:rPr lang="en-GB" sz="1000" i="1" dirty="0" err="1">
                <a:latin typeface="Arial" panose="020B0604020202020204" pitchFamily="34" charset="0"/>
                <a:ea typeface="Calibri" panose="020F0502020204030204" pitchFamily="34" charset="0"/>
                <a:cs typeface="Times New Roman" panose="02020603050405020304" pitchFamily="18" charset="0"/>
              </a:rPr>
              <a:t>μM</a:t>
            </a:r>
            <a:r>
              <a:rPr lang="en-GB" sz="1000" i="1" dirty="0">
                <a:latin typeface="Arial" panose="020B0604020202020204" pitchFamily="34" charset="0"/>
                <a:ea typeface="Calibri" panose="020F0502020204030204" pitchFamily="34" charset="0"/>
                <a:cs typeface="Times New Roman" panose="02020603050405020304" pitchFamily="18" charset="0"/>
              </a:rPr>
              <a:t>) and B) INK128 (16 µM) in DMSO solvent.</a:t>
            </a:r>
            <a:r>
              <a:rPr lang="en-GB" sz="1000" dirty="0">
                <a:solidFill>
                  <a:srgbClr val="000000"/>
                </a:solidFill>
                <a:latin typeface="Arial" panose="020B0604020202020204" pitchFamily="34" charset="0"/>
              </a:rPr>
              <a:t> Molar extinction coefficients (</a:t>
            </a:r>
            <a:r>
              <a:rPr lang="el-GR" sz="1000" dirty="0">
                <a:solidFill>
                  <a:srgbClr val="000000"/>
                </a:solidFill>
                <a:latin typeface="Arial" panose="020B0604020202020204" pitchFamily="34" charset="0"/>
              </a:rPr>
              <a:t>ε) </a:t>
            </a:r>
            <a:r>
              <a:rPr lang="en-GB" sz="1000" dirty="0">
                <a:solidFill>
                  <a:srgbClr val="000000"/>
                </a:solidFill>
                <a:latin typeface="Arial" panose="020B0604020202020204" pitchFamily="34" charset="0"/>
              </a:rPr>
              <a:t>of C) rapamycin </a:t>
            </a:r>
            <a:r>
              <a:rPr lang="en-GB" sz="1000" i="1" dirty="0">
                <a:latin typeface="Arial" panose="020B0604020202020204" pitchFamily="34" charset="0"/>
                <a:ea typeface="Calibri" panose="020F0502020204030204" pitchFamily="34" charset="0"/>
                <a:cs typeface="Times New Roman" panose="02020603050405020304" pitchFamily="18" charset="0"/>
              </a:rPr>
              <a:t>(10 </a:t>
            </a:r>
            <a:r>
              <a:rPr lang="en-GB" sz="1000" i="1" dirty="0" err="1">
                <a:latin typeface="Arial" panose="020B0604020202020204" pitchFamily="34" charset="0"/>
                <a:ea typeface="Calibri" panose="020F0502020204030204" pitchFamily="34" charset="0"/>
                <a:cs typeface="Times New Roman" panose="02020603050405020304" pitchFamily="18" charset="0"/>
              </a:rPr>
              <a:t>μM</a:t>
            </a:r>
            <a:r>
              <a:rPr lang="en-GB" sz="1000" i="1" dirty="0">
                <a:latin typeface="Arial" panose="020B0604020202020204" pitchFamily="34" charset="0"/>
                <a:ea typeface="Calibri" panose="020F0502020204030204" pitchFamily="34" charset="0"/>
                <a:cs typeface="Times New Roman" panose="02020603050405020304" pitchFamily="18" charset="0"/>
              </a:rPr>
              <a:t>) and D) INK128 (16 µM) in DMSO solvent. using UV-VIS spectrum and Beer-lambert Law. E) </a:t>
            </a:r>
            <a:r>
              <a:rPr lang="en-GB" sz="1000" i="1" dirty="0">
                <a:latin typeface="Arial" panose="020B0604020202020204" pitchFamily="34" charset="0"/>
                <a:cs typeface="Arial" panose="020B0604020202020204" pitchFamily="34" charset="0"/>
              </a:rPr>
              <a:t>Fluorescence spectrum of INK128 (7 </a:t>
            </a:r>
            <a:r>
              <a:rPr lang="en-GB" sz="1000" i="1" dirty="0" err="1">
                <a:latin typeface="Arial" panose="020B0604020202020204" pitchFamily="34" charset="0"/>
                <a:cs typeface="Arial" panose="020B0604020202020204" pitchFamily="34" charset="0"/>
              </a:rPr>
              <a:t>μM</a:t>
            </a:r>
            <a:r>
              <a:rPr lang="en-GB" sz="1000" i="1" dirty="0">
                <a:latin typeface="Arial" panose="020B0604020202020204" pitchFamily="34" charset="0"/>
                <a:cs typeface="Arial" panose="020B0604020202020204" pitchFamily="34" charset="0"/>
              </a:rPr>
              <a:t>) in DMSO showing excitation profile in dark blue and emission profile in lighter blue. F) Quantum yield absorbance and fluorescence spectra of INK128 and standard. UV-VIS spectra of INK128 in DMSO and quinine sulphate in sulphuric acid (H</a:t>
            </a:r>
            <a:r>
              <a:rPr lang="en-GB" sz="1000" i="1" baseline="-25000" dirty="0">
                <a:latin typeface="Arial" panose="020B0604020202020204" pitchFamily="34" charset="0"/>
                <a:cs typeface="Arial" panose="020B0604020202020204" pitchFamily="34" charset="0"/>
              </a:rPr>
              <a:t>2</a:t>
            </a:r>
            <a:r>
              <a:rPr lang="en-GB" sz="1000" i="1" dirty="0">
                <a:latin typeface="Arial" panose="020B0604020202020204" pitchFamily="34" charset="0"/>
                <a:cs typeface="Arial" panose="020B0604020202020204" pitchFamily="34" charset="0"/>
              </a:rPr>
              <a:t>SO</a:t>
            </a:r>
            <a:r>
              <a:rPr lang="en-GB" sz="1000" i="1" baseline="-25000" dirty="0">
                <a:latin typeface="Arial" panose="020B0604020202020204" pitchFamily="34" charset="0"/>
                <a:cs typeface="Arial" panose="020B0604020202020204" pitchFamily="34" charset="0"/>
              </a:rPr>
              <a:t>4</a:t>
            </a:r>
            <a:r>
              <a:rPr lang="en-GB" sz="1000" i="1" dirty="0">
                <a:latin typeface="Arial" panose="020B0604020202020204" pitchFamily="34" charset="0"/>
                <a:cs typeface="Arial" panose="020B0604020202020204" pitchFamily="34" charset="0"/>
              </a:rPr>
              <a:t>) with fluorescence emissions of the same solutions. All settings were kept constant for each experiment. INK128 and standards were excited at 300 nm. Absorbance values at 300 nm and integrated fluorescent intensities were used for quantum yield calculations. </a:t>
            </a:r>
            <a:endParaRPr lang="en-GB" sz="1000" i="1" dirty="0">
              <a:latin typeface="Arial" panose="020B0604020202020204" pitchFamily="34" charset="0"/>
              <a:ea typeface="Calibri" panose="020F0502020204030204" pitchFamily="34" charset="0"/>
              <a:cs typeface="Arial" panose="020B0604020202020204" pitchFamily="34" charset="0"/>
            </a:endParaRPr>
          </a:p>
        </p:txBody>
      </p:sp>
      <p:sp>
        <p:nvSpPr>
          <p:cNvPr id="19" name="Rettangolo 18"/>
          <p:cNvSpPr/>
          <p:nvPr/>
        </p:nvSpPr>
        <p:spPr>
          <a:xfrm>
            <a:off x="4538659" y="5841678"/>
            <a:ext cx="2588054" cy="1015663"/>
          </a:xfrm>
          <a:prstGeom prst="rect">
            <a:avLst/>
          </a:prstGeom>
        </p:spPr>
        <p:txBody>
          <a:bodyPr wrap="square">
            <a:spAutoFit/>
          </a:bodyPr>
          <a:lstStyle/>
          <a:p>
            <a:pPr>
              <a:lnSpc>
                <a:spcPct val="150000"/>
              </a:lnSpc>
            </a:pPr>
            <a:r>
              <a:rPr lang="it-IT" sz="1000" dirty="0" err="1"/>
              <a:t>Quinine</a:t>
            </a:r>
            <a:r>
              <a:rPr lang="it-IT" sz="1000" dirty="0"/>
              <a:t> </a:t>
            </a:r>
            <a:r>
              <a:rPr lang="it-IT" sz="1000" dirty="0" err="1"/>
              <a:t>sulfate</a:t>
            </a:r>
            <a:r>
              <a:rPr lang="it-IT" sz="1000" dirty="0"/>
              <a:t> (</a:t>
            </a:r>
            <a:r>
              <a:rPr lang="it-IT" sz="1000" dirty="0" smtClean="0"/>
              <a:t>200 µM</a:t>
            </a:r>
            <a:r>
              <a:rPr lang="it-IT" sz="1000" dirty="0"/>
              <a:t>) H</a:t>
            </a:r>
            <a:r>
              <a:rPr lang="it-IT" sz="1000" baseline="-25000" dirty="0"/>
              <a:t>2</a:t>
            </a:r>
            <a:r>
              <a:rPr lang="it-IT" sz="1000" dirty="0"/>
              <a:t>SO</a:t>
            </a:r>
            <a:r>
              <a:rPr lang="it-IT" sz="1000" baseline="-25000" dirty="0"/>
              <a:t>4</a:t>
            </a:r>
            <a:r>
              <a:rPr lang="it-IT" sz="1000" dirty="0"/>
              <a:t> </a:t>
            </a:r>
            <a:r>
              <a:rPr lang="it-IT" sz="1000" dirty="0" err="1" smtClean="0"/>
              <a:t>Absorption</a:t>
            </a:r>
            <a:endParaRPr lang="it-IT" sz="1000" dirty="0"/>
          </a:p>
          <a:p>
            <a:pPr>
              <a:lnSpc>
                <a:spcPct val="150000"/>
              </a:lnSpc>
            </a:pPr>
            <a:r>
              <a:rPr lang="it-IT" sz="1000" dirty="0"/>
              <a:t>INK128 (</a:t>
            </a:r>
            <a:r>
              <a:rPr lang="it-IT" sz="1000" dirty="0" smtClean="0"/>
              <a:t>16 µM</a:t>
            </a:r>
            <a:r>
              <a:rPr lang="it-IT" sz="1000" dirty="0"/>
              <a:t>) DMSO </a:t>
            </a:r>
            <a:r>
              <a:rPr lang="it-IT" sz="1000" dirty="0" err="1" smtClean="0"/>
              <a:t>Absorption</a:t>
            </a:r>
            <a:endParaRPr lang="it-IT" sz="1000" dirty="0"/>
          </a:p>
          <a:p>
            <a:pPr>
              <a:lnSpc>
                <a:spcPct val="150000"/>
              </a:lnSpc>
            </a:pPr>
            <a:r>
              <a:rPr lang="it-IT" sz="1000" dirty="0" err="1"/>
              <a:t>Quinine</a:t>
            </a:r>
            <a:r>
              <a:rPr lang="it-IT" sz="1000" dirty="0"/>
              <a:t> </a:t>
            </a:r>
            <a:r>
              <a:rPr lang="it-IT" sz="1000" dirty="0" err="1"/>
              <a:t>sulfate</a:t>
            </a:r>
            <a:r>
              <a:rPr lang="it-IT" sz="1000" dirty="0"/>
              <a:t> (</a:t>
            </a:r>
            <a:r>
              <a:rPr lang="it-IT" sz="1000" dirty="0" smtClean="0"/>
              <a:t>200 µM</a:t>
            </a:r>
            <a:r>
              <a:rPr lang="it-IT" sz="1000" dirty="0"/>
              <a:t>) H</a:t>
            </a:r>
            <a:r>
              <a:rPr lang="it-IT" sz="1000" baseline="-25000" dirty="0"/>
              <a:t>2</a:t>
            </a:r>
            <a:r>
              <a:rPr lang="it-IT" sz="1000" dirty="0"/>
              <a:t>SO</a:t>
            </a:r>
            <a:r>
              <a:rPr lang="it-IT" sz="1000" baseline="-25000" dirty="0"/>
              <a:t>4</a:t>
            </a:r>
            <a:r>
              <a:rPr lang="it-IT" sz="1000" dirty="0"/>
              <a:t> </a:t>
            </a:r>
            <a:r>
              <a:rPr lang="it-IT" sz="1000" dirty="0" err="1" smtClean="0"/>
              <a:t>Emission</a:t>
            </a:r>
            <a:endParaRPr lang="it-IT" sz="1000" dirty="0"/>
          </a:p>
          <a:p>
            <a:pPr>
              <a:lnSpc>
                <a:spcPct val="150000"/>
              </a:lnSpc>
            </a:pPr>
            <a:r>
              <a:rPr lang="it-IT" sz="1000" dirty="0"/>
              <a:t>INK128 (</a:t>
            </a:r>
            <a:r>
              <a:rPr lang="it-IT" sz="1000" dirty="0" smtClean="0"/>
              <a:t>16 µM</a:t>
            </a:r>
            <a:r>
              <a:rPr lang="it-IT" sz="1000" dirty="0"/>
              <a:t>) DMSO </a:t>
            </a:r>
            <a:r>
              <a:rPr lang="it-IT" sz="1000" dirty="0" err="1" smtClean="0"/>
              <a:t>Emission</a:t>
            </a:r>
            <a:endParaRPr lang="it-IT" sz="1000" dirty="0"/>
          </a:p>
        </p:txBody>
      </p:sp>
    </p:spTree>
    <p:extLst>
      <p:ext uri="{BB962C8B-B14F-4D97-AF65-F5344CB8AC3E}">
        <p14:creationId xmlns:p14="http://schemas.microsoft.com/office/powerpoint/2010/main" val="164504399"/>
      </p:ext>
    </p:extLst>
  </p:cSld>
  <p:clrMapOvr>
    <a:masterClrMapping/>
  </p:clrMapOvr>
  <p:timing>
    <p:tnLst>
      <p:par>
        <p:cTn id="1" dur="indefinite" restart="never" nodeType="tmRoot"/>
      </p:par>
    </p:tnLst>
  </p:timing>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4" name="Picture 1"/>
          <p:cNvPicPr/>
          <p:nvPr/>
        </p:nvPicPr>
        <p:blipFill rotWithShape="1">
          <a:blip r:embed="rId2"/>
          <a:srcRect l="42918" t="22885" r="38641" b="46174"/>
          <a:stretch/>
        </p:blipFill>
        <p:spPr bwMode="auto">
          <a:xfrm>
            <a:off x="1963500" y="201716"/>
            <a:ext cx="1994323" cy="1989969"/>
          </a:xfrm>
          <a:prstGeom prst="rect">
            <a:avLst/>
          </a:prstGeom>
          <a:ln>
            <a:noFill/>
          </a:ln>
          <a:extLst>
            <a:ext uri="{53640926-AAD7-44D8-BBD7-CCE9431645EC}">
              <a14:shadowObscured xmlns:a14="http://schemas.microsoft.com/office/drawing/2010/main"/>
            </a:ext>
          </a:extLst>
        </p:spPr>
      </p:pic>
      <p:pic>
        <p:nvPicPr>
          <p:cNvPr id="5" name="Picture 4" descr="N:\AbdullahAhmed\Public\Year 4 PhD 2017\MMfit.png">
            <a:extLst>
              <a:ext uri="{FF2B5EF4-FFF2-40B4-BE49-F238E27FC236}">
                <a16:creationId xmlns:a16="http://schemas.microsoft.com/office/drawing/2014/main" id="{092FD110-9A65-4045-B688-925B239642FB}"/>
              </a:ext>
            </a:extLst>
          </p:cNvPr>
          <p:cNvPicPr>
            <a:picLocks noChangeAspect="1" noChangeArrowheads="1"/>
          </p:cNvPicPr>
          <p:nvPr/>
        </p:nvPicPr>
        <p:blipFill rotWithShape="1">
          <a:blip r:embed="rId3" cstate="hqprint">
            <a:extLst>
              <a:ext uri="{28A0092B-C50C-407E-A947-70E740481C1C}">
                <a14:useLocalDpi xmlns:a14="http://schemas.microsoft.com/office/drawing/2010/main" val="0"/>
              </a:ext>
            </a:extLst>
          </a:blip>
          <a:srcRect l="10364" t="2352" r="24737" b="15512"/>
          <a:stretch/>
        </p:blipFill>
        <p:spPr bwMode="auto">
          <a:xfrm>
            <a:off x="4001504" y="326972"/>
            <a:ext cx="2159288" cy="2100063"/>
          </a:xfrm>
          <a:prstGeom prst="rect">
            <a:avLst/>
          </a:prstGeom>
          <a:noFill/>
          <a:extLst>
            <a:ext uri="{909E8E84-426E-40DD-AFC4-6F175D3DCCD1}">
              <a14:hiddenFill xmlns:a14="http://schemas.microsoft.com/office/drawing/2010/main">
                <a:solidFill>
                  <a:srgbClr val="FFFFFF"/>
                </a:solidFill>
              </a14:hiddenFill>
            </a:ext>
          </a:extLst>
        </p:spPr>
      </p:pic>
      <p:pic>
        <p:nvPicPr>
          <p:cNvPr id="6" name="Picture 5" descr="M:\Octopus\FLIM data Stan 1_5_13\Abdullah\April 2018\20_04_18\INK128 70um\TIF\Montage.tif">
            <a:extLst>
              <a:ext uri="{FF2B5EF4-FFF2-40B4-BE49-F238E27FC236}">
                <a16:creationId xmlns:a16="http://schemas.microsoft.com/office/drawing/2014/main" id="{CCC5000E-476D-48B3-800C-EC5D739339BC}"/>
              </a:ext>
            </a:extLst>
          </p:cNvPr>
          <p:cNvPicPr>
            <a:picLocks noChangeAspect="1" noChangeArrowheads="1"/>
          </p:cNvPicPr>
          <p:nvPr/>
        </p:nvPicPr>
        <p:blipFill>
          <a:blip r:embed="rId4" cstate="print">
            <a:extLst>
              <a:ext uri="{28A0092B-C50C-407E-A947-70E740481C1C}">
                <a14:useLocalDpi xmlns:a14="http://schemas.microsoft.com/office/drawing/2010/main" val="0"/>
              </a:ext>
            </a:extLst>
          </a:blip>
          <a:srcRect/>
          <a:stretch>
            <a:fillRect/>
          </a:stretch>
        </p:blipFill>
        <p:spPr bwMode="auto">
          <a:xfrm>
            <a:off x="1949370" y="2549121"/>
            <a:ext cx="4169435" cy="1650884"/>
          </a:xfrm>
          <a:prstGeom prst="rect">
            <a:avLst/>
          </a:prstGeom>
          <a:noFill/>
          <a:extLst>
            <a:ext uri="{909E8E84-426E-40DD-AFC4-6F175D3DCCD1}">
              <a14:hiddenFill xmlns:a14="http://schemas.microsoft.com/office/drawing/2010/main">
                <a:solidFill>
                  <a:srgbClr val="FFFFFF"/>
                </a:solidFill>
              </a14:hiddenFill>
            </a:ext>
          </a:extLst>
        </p:spPr>
      </p:pic>
      <p:sp>
        <p:nvSpPr>
          <p:cNvPr id="7" name="TextBox 38">
            <a:extLst>
              <a:ext uri="{FF2B5EF4-FFF2-40B4-BE49-F238E27FC236}">
                <a16:creationId xmlns:a16="http://schemas.microsoft.com/office/drawing/2014/main" id="{BE0E0003-BC6B-40CA-A756-07DFF30C5B74}"/>
              </a:ext>
            </a:extLst>
          </p:cNvPr>
          <p:cNvSpPr txBox="1"/>
          <p:nvPr/>
        </p:nvSpPr>
        <p:spPr>
          <a:xfrm>
            <a:off x="1972309" y="2549083"/>
            <a:ext cx="635195"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0 min</a:t>
            </a:r>
            <a:endParaRPr lang="en-GB" sz="1200">
              <a:effectLst/>
              <a:latin typeface="Times New Roman" panose="02020603050405020304" pitchFamily="18" charset="0"/>
              <a:ea typeface="Times New Roman" panose="02020603050405020304" pitchFamily="18" charset="0"/>
            </a:endParaRPr>
          </a:p>
        </p:txBody>
      </p:sp>
      <p:sp>
        <p:nvSpPr>
          <p:cNvPr id="8" name="TextBox 39">
            <a:extLst>
              <a:ext uri="{FF2B5EF4-FFF2-40B4-BE49-F238E27FC236}">
                <a16:creationId xmlns:a16="http://schemas.microsoft.com/office/drawing/2014/main" id="{50A74537-A8AE-41E3-BECB-4BF1EF0130B4}"/>
              </a:ext>
            </a:extLst>
          </p:cNvPr>
          <p:cNvSpPr txBox="1"/>
          <p:nvPr/>
        </p:nvSpPr>
        <p:spPr>
          <a:xfrm>
            <a:off x="2840481" y="2549044"/>
            <a:ext cx="626511"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1 min</a:t>
            </a:r>
            <a:endParaRPr lang="en-GB" sz="1200">
              <a:effectLst/>
              <a:latin typeface="Times New Roman" panose="02020603050405020304" pitchFamily="18" charset="0"/>
              <a:ea typeface="Times New Roman" panose="02020603050405020304" pitchFamily="18" charset="0"/>
            </a:endParaRPr>
          </a:p>
        </p:txBody>
      </p:sp>
      <p:sp>
        <p:nvSpPr>
          <p:cNvPr id="9" name="TextBox 40">
            <a:extLst>
              <a:ext uri="{FF2B5EF4-FFF2-40B4-BE49-F238E27FC236}">
                <a16:creationId xmlns:a16="http://schemas.microsoft.com/office/drawing/2014/main" id="{AD567756-A96D-45DA-8E3C-B22E38A520C2}"/>
              </a:ext>
            </a:extLst>
          </p:cNvPr>
          <p:cNvSpPr txBox="1"/>
          <p:nvPr/>
        </p:nvSpPr>
        <p:spPr>
          <a:xfrm>
            <a:off x="3726978" y="2550888"/>
            <a:ext cx="694656"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2 min</a:t>
            </a:r>
            <a:endParaRPr lang="en-GB" sz="1200">
              <a:effectLst/>
              <a:latin typeface="Times New Roman" panose="02020603050405020304" pitchFamily="18" charset="0"/>
              <a:ea typeface="Times New Roman" panose="02020603050405020304" pitchFamily="18" charset="0"/>
            </a:endParaRPr>
          </a:p>
        </p:txBody>
      </p:sp>
      <p:sp>
        <p:nvSpPr>
          <p:cNvPr id="10" name="TextBox 41">
            <a:extLst>
              <a:ext uri="{FF2B5EF4-FFF2-40B4-BE49-F238E27FC236}">
                <a16:creationId xmlns:a16="http://schemas.microsoft.com/office/drawing/2014/main" id="{4CA3A093-D2AC-4BCD-A325-98179320F3B3}"/>
              </a:ext>
            </a:extLst>
          </p:cNvPr>
          <p:cNvSpPr txBox="1"/>
          <p:nvPr/>
        </p:nvSpPr>
        <p:spPr>
          <a:xfrm>
            <a:off x="4482166" y="2550850"/>
            <a:ext cx="645450"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3 min</a:t>
            </a:r>
            <a:endParaRPr lang="en-GB" sz="1200">
              <a:effectLst/>
              <a:latin typeface="Times New Roman" panose="02020603050405020304" pitchFamily="18" charset="0"/>
              <a:ea typeface="Times New Roman" panose="02020603050405020304" pitchFamily="18" charset="0"/>
            </a:endParaRPr>
          </a:p>
        </p:txBody>
      </p:sp>
      <p:sp>
        <p:nvSpPr>
          <p:cNvPr id="11" name="TextBox 42">
            <a:extLst>
              <a:ext uri="{FF2B5EF4-FFF2-40B4-BE49-F238E27FC236}">
                <a16:creationId xmlns:a16="http://schemas.microsoft.com/office/drawing/2014/main" id="{4645EEEA-D36C-4CA8-92A5-4816D1F10489}"/>
              </a:ext>
            </a:extLst>
          </p:cNvPr>
          <p:cNvSpPr txBox="1"/>
          <p:nvPr/>
        </p:nvSpPr>
        <p:spPr>
          <a:xfrm>
            <a:off x="5188862" y="2550850"/>
            <a:ext cx="658787"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4 min</a:t>
            </a:r>
            <a:endParaRPr lang="en-GB" sz="1200">
              <a:effectLst/>
              <a:latin typeface="Times New Roman" panose="02020603050405020304" pitchFamily="18" charset="0"/>
              <a:ea typeface="Times New Roman" panose="02020603050405020304" pitchFamily="18" charset="0"/>
            </a:endParaRPr>
          </a:p>
        </p:txBody>
      </p:sp>
      <p:sp>
        <p:nvSpPr>
          <p:cNvPr id="12" name="TextBox 43">
            <a:extLst>
              <a:ext uri="{FF2B5EF4-FFF2-40B4-BE49-F238E27FC236}">
                <a16:creationId xmlns:a16="http://schemas.microsoft.com/office/drawing/2014/main" id="{6754527D-9186-4B82-85D9-FECB42A99133}"/>
              </a:ext>
            </a:extLst>
          </p:cNvPr>
          <p:cNvSpPr txBox="1"/>
          <p:nvPr/>
        </p:nvSpPr>
        <p:spPr>
          <a:xfrm>
            <a:off x="1949369" y="3356632"/>
            <a:ext cx="658134"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5 min</a:t>
            </a:r>
            <a:endParaRPr lang="en-GB" sz="1200">
              <a:effectLst/>
              <a:latin typeface="Times New Roman" panose="02020603050405020304" pitchFamily="18" charset="0"/>
              <a:ea typeface="Times New Roman" panose="02020603050405020304" pitchFamily="18" charset="0"/>
            </a:endParaRPr>
          </a:p>
        </p:txBody>
      </p:sp>
      <p:sp>
        <p:nvSpPr>
          <p:cNvPr id="13" name="TextBox 44">
            <a:extLst>
              <a:ext uri="{FF2B5EF4-FFF2-40B4-BE49-F238E27FC236}">
                <a16:creationId xmlns:a16="http://schemas.microsoft.com/office/drawing/2014/main" id="{E36D0DDE-7387-4A6A-971F-CB4C14F0CA00}"/>
              </a:ext>
            </a:extLst>
          </p:cNvPr>
          <p:cNvSpPr txBox="1"/>
          <p:nvPr/>
        </p:nvSpPr>
        <p:spPr>
          <a:xfrm>
            <a:off x="2803316" y="3362458"/>
            <a:ext cx="596224"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6 min</a:t>
            </a:r>
            <a:endParaRPr lang="en-GB" sz="1200">
              <a:effectLst/>
              <a:latin typeface="Times New Roman" panose="02020603050405020304" pitchFamily="18" charset="0"/>
              <a:ea typeface="Times New Roman" panose="02020603050405020304" pitchFamily="18" charset="0"/>
            </a:endParaRPr>
          </a:p>
        </p:txBody>
      </p:sp>
      <p:sp>
        <p:nvSpPr>
          <p:cNvPr id="14" name="TextBox 45">
            <a:extLst>
              <a:ext uri="{FF2B5EF4-FFF2-40B4-BE49-F238E27FC236}">
                <a16:creationId xmlns:a16="http://schemas.microsoft.com/office/drawing/2014/main" id="{F680D839-F781-4A9B-900A-0654888AF939}"/>
              </a:ext>
            </a:extLst>
          </p:cNvPr>
          <p:cNvSpPr txBox="1"/>
          <p:nvPr/>
        </p:nvSpPr>
        <p:spPr>
          <a:xfrm>
            <a:off x="3550301" y="3368285"/>
            <a:ext cx="713276"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7min</a:t>
            </a:r>
            <a:endParaRPr lang="en-GB" sz="1200">
              <a:effectLst/>
              <a:latin typeface="Times New Roman" panose="02020603050405020304" pitchFamily="18" charset="0"/>
              <a:ea typeface="Times New Roman" panose="02020603050405020304" pitchFamily="18" charset="0"/>
            </a:endParaRPr>
          </a:p>
        </p:txBody>
      </p:sp>
      <p:sp>
        <p:nvSpPr>
          <p:cNvPr id="15" name="TextBox 46">
            <a:extLst>
              <a:ext uri="{FF2B5EF4-FFF2-40B4-BE49-F238E27FC236}">
                <a16:creationId xmlns:a16="http://schemas.microsoft.com/office/drawing/2014/main" id="{924B8E1D-0946-4CEE-87C1-1327CC4648A2}"/>
              </a:ext>
            </a:extLst>
          </p:cNvPr>
          <p:cNvSpPr txBox="1"/>
          <p:nvPr/>
        </p:nvSpPr>
        <p:spPr>
          <a:xfrm>
            <a:off x="4421634" y="3370712"/>
            <a:ext cx="767227"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8 min</a:t>
            </a:r>
            <a:endParaRPr lang="en-GB" sz="1200">
              <a:effectLst/>
              <a:latin typeface="Times New Roman" panose="02020603050405020304" pitchFamily="18" charset="0"/>
              <a:ea typeface="Times New Roman" panose="02020603050405020304" pitchFamily="18" charset="0"/>
            </a:endParaRPr>
          </a:p>
        </p:txBody>
      </p:sp>
      <p:sp>
        <p:nvSpPr>
          <p:cNvPr id="16" name="TextBox 47">
            <a:extLst>
              <a:ext uri="{FF2B5EF4-FFF2-40B4-BE49-F238E27FC236}">
                <a16:creationId xmlns:a16="http://schemas.microsoft.com/office/drawing/2014/main" id="{9A02053F-49EB-4DCC-80A6-922563703371}"/>
              </a:ext>
            </a:extLst>
          </p:cNvPr>
          <p:cNvSpPr txBox="1"/>
          <p:nvPr/>
        </p:nvSpPr>
        <p:spPr>
          <a:xfrm>
            <a:off x="5295839" y="3368232"/>
            <a:ext cx="641814"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9 min</a:t>
            </a:r>
            <a:endParaRPr lang="en-GB" sz="1200">
              <a:effectLst/>
              <a:latin typeface="Times New Roman" panose="02020603050405020304" pitchFamily="18" charset="0"/>
              <a:ea typeface="Times New Roman" panose="02020603050405020304" pitchFamily="18" charset="0"/>
            </a:endParaRPr>
          </a:p>
        </p:txBody>
      </p:sp>
      <p:sp>
        <p:nvSpPr>
          <p:cNvPr id="17" name="TextBox 48">
            <a:extLst>
              <a:ext uri="{FF2B5EF4-FFF2-40B4-BE49-F238E27FC236}">
                <a16:creationId xmlns:a16="http://schemas.microsoft.com/office/drawing/2014/main" id="{D05F777D-9BD2-4767-B680-D9629B2BADA2}"/>
              </a:ext>
            </a:extLst>
          </p:cNvPr>
          <p:cNvSpPr txBox="1"/>
          <p:nvPr/>
        </p:nvSpPr>
        <p:spPr>
          <a:xfrm rot="16200000">
            <a:off x="1059352" y="3180260"/>
            <a:ext cx="1452111" cy="258456"/>
          </a:xfrm>
          <a:prstGeom prst="rect">
            <a:avLst/>
          </a:prstGeom>
          <a:noFill/>
        </p:spPr>
        <p:txBody>
          <a:bodyPr wrap="square" rtlCol="0">
            <a:noAutofit/>
          </a:bodyPr>
          <a:lstStyle/>
          <a:p>
            <a:pPr algn="ctr">
              <a:spcAft>
                <a:spcPts val="0"/>
              </a:spcAft>
            </a:pPr>
            <a:r>
              <a:rPr lang="en-GB" sz="11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 INK128 (70 µM)</a:t>
            </a:r>
            <a:endParaRPr lang="en-GB" sz="1200">
              <a:effectLst/>
              <a:latin typeface="Times New Roman" panose="02020603050405020304" pitchFamily="18" charset="0"/>
              <a:ea typeface="Times New Roman" panose="02020603050405020304" pitchFamily="18" charset="0"/>
            </a:endParaRPr>
          </a:p>
        </p:txBody>
      </p:sp>
      <p:pic>
        <p:nvPicPr>
          <p:cNvPr id="18" name="Picture 17" descr="M:\Octopus\FLIM data Stan 1_5_13\Abdullah\April 2018\20_04_18\HEK293 only\TIF\Montage.tif">
            <a:extLst>
              <a:ext uri="{FF2B5EF4-FFF2-40B4-BE49-F238E27FC236}">
                <a16:creationId xmlns:a16="http://schemas.microsoft.com/office/drawing/2014/main" id="{42E0E10C-4688-4E4F-A565-5185BE59497F}"/>
              </a:ext>
            </a:extLst>
          </p:cNvPr>
          <p:cNvPicPr>
            <a:picLocks noChangeAspect="1" noChangeArrowheads="1"/>
          </p:cNvPicPr>
          <p:nvPr/>
        </p:nvPicPr>
        <p:blipFill>
          <a:blip r:embed="rId5">
            <a:extLst>
              <a:ext uri="{28A0092B-C50C-407E-A947-70E740481C1C}">
                <a14:useLocalDpi xmlns:a14="http://schemas.microsoft.com/office/drawing/2010/main" val="0"/>
              </a:ext>
            </a:extLst>
          </a:blip>
          <a:srcRect/>
          <a:stretch>
            <a:fillRect/>
          </a:stretch>
        </p:blipFill>
        <p:spPr bwMode="auto">
          <a:xfrm>
            <a:off x="1949375" y="4511111"/>
            <a:ext cx="4198092" cy="1655238"/>
          </a:xfrm>
          <a:prstGeom prst="rect">
            <a:avLst/>
          </a:prstGeom>
          <a:noFill/>
          <a:extLst>
            <a:ext uri="{909E8E84-426E-40DD-AFC4-6F175D3DCCD1}">
              <a14:hiddenFill xmlns:a14="http://schemas.microsoft.com/office/drawing/2010/main">
                <a:solidFill>
                  <a:srgbClr val="FFFFFF"/>
                </a:solidFill>
              </a14:hiddenFill>
            </a:ext>
          </a:extLst>
        </p:spPr>
      </p:pic>
      <p:sp>
        <p:nvSpPr>
          <p:cNvPr id="19" name="TextBox 50">
            <a:extLst>
              <a:ext uri="{FF2B5EF4-FFF2-40B4-BE49-F238E27FC236}">
                <a16:creationId xmlns:a16="http://schemas.microsoft.com/office/drawing/2014/main" id="{D8646D1A-D664-4217-908D-541F2687A97C}"/>
              </a:ext>
            </a:extLst>
          </p:cNvPr>
          <p:cNvSpPr txBox="1"/>
          <p:nvPr/>
        </p:nvSpPr>
        <p:spPr>
          <a:xfrm>
            <a:off x="1949370" y="4510219"/>
            <a:ext cx="684574"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0 min</a:t>
            </a:r>
            <a:endParaRPr lang="en-GB" sz="1200">
              <a:effectLst/>
              <a:latin typeface="Times New Roman" panose="02020603050405020304" pitchFamily="18" charset="0"/>
              <a:ea typeface="Times New Roman" panose="02020603050405020304" pitchFamily="18" charset="0"/>
            </a:endParaRPr>
          </a:p>
        </p:txBody>
      </p:sp>
      <p:sp>
        <p:nvSpPr>
          <p:cNvPr id="20" name="TextBox 51">
            <a:extLst>
              <a:ext uri="{FF2B5EF4-FFF2-40B4-BE49-F238E27FC236}">
                <a16:creationId xmlns:a16="http://schemas.microsoft.com/office/drawing/2014/main" id="{EE536852-06AE-427B-B2E1-1DAED563A99E}"/>
              </a:ext>
            </a:extLst>
          </p:cNvPr>
          <p:cNvSpPr txBox="1"/>
          <p:nvPr/>
        </p:nvSpPr>
        <p:spPr>
          <a:xfrm>
            <a:off x="2766773" y="4508231"/>
            <a:ext cx="663675"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1 min</a:t>
            </a:r>
            <a:endParaRPr lang="en-GB" sz="1200">
              <a:effectLst/>
              <a:latin typeface="Times New Roman" panose="02020603050405020304" pitchFamily="18" charset="0"/>
              <a:ea typeface="Times New Roman" panose="02020603050405020304" pitchFamily="18" charset="0"/>
            </a:endParaRPr>
          </a:p>
        </p:txBody>
      </p:sp>
      <p:sp>
        <p:nvSpPr>
          <p:cNvPr id="21" name="TextBox 52">
            <a:extLst>
              <a:ext uri="{FF2B5EF4-FFF2-40B4-BE49-F238E27FC236}">
                <a16:creationId xmlns:a16="http://schemas.microsoft.com/office/drawing/2014/main" id="{A50D169A-560C-48DB-9B81-997F4BFC4109}"/>
              </a:ext>
            </a:extLst>
          </p:cNvPr>
          <p:cNvSpPr txBox="1"/>
          <p:nvPr/>
        </p:nvSpPr>
        <p:spPr>
          <a:xfrm>
            <a:off x="3646365" y="4516421"/>
            <a:ext cx="651813"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2 min</a:t>
            </a:r>
            <a:endParaRPr lang="en-GB" sz="1200">
              <a:effectLst/>
              <a:latin typeface="Times New Roman" panose="02020603050405020304" pitchFamily="18" charset="0"/>
              <a:ea typeface="Times New Roman" panose="02020603050405020304" pitchFamily="18" charset="0"/>
            </a:endParaRPr>
          </a:p>
        </p:txBody>
      </p:sp>
      <p:sp>
        <p:nvSpPr>
          <p:cNvPr id="22" name="TextBox 53">
            <a:extLst>
              <a:ext uri="{FF2B5EF4-FFF2-40B4-BE49-F238E27FC236}">
                <a16:creationId xmlns:a16="http://schemas.microsoft.com/office/drawing/2014/main" id="{D960627D-CA13-4D77-90EF-37A9D0D19BE9}"/>
              </a:ext>
            </a:extLst>
          </p:cNvPr>
          <p:cNvSpPr txBox="1"/>
          <p:nvPr/>
        </p:nvSpPr>
        <p:spPr>
          <a:xfrm>
            <a:off x="4542612" y="4508232"/>
            <a:ext cx="587855"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3 min</a:t>
            </a:r>
            <a:endParaRPr lang="en-GB" sz="1200">
              <a:effectLst/>
              <a:latin typeface="Times New Roman" panose="02020603050405020304" pitchFamily="18" charset="0"/>
              <a:ea typeface="Times New Roman" panose="02020603050405020304" pitchFamily="18" charset="0"/>
            </a:endParaRPr>
          </a:p>
        </p:txBody>
      </p:sp>
      <p:sp>
        <p:nvSpPr>
          <p:cNvPr id="23" name="TextBox 54">
            <a:extLst>
              <a:ext uri="{FF2B5EF4-FFF2-40B4-BE49-F238E27FC236}">
                <a16:creationId xmlns:a16="http://schemas.microsoft.com/office/drawing/2014/main" id="{220230DA-D05D-4845-8C81-090FE7A69E37}"/>
              </a:ext>
            </a:extLst>
          </p:cNvPr>
          <p:cNvSpPr txBox="1"/>
          <p:nvPr/>
        </p:nvSpPr>
        <p:spPr>
          <a:xfrm>
            <a:off x="5350440" y="4510219"/>
            <a:ext cx="671418"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4 min</a:t>
            </a:r>
            <a:endParaRPr lang="en-GB" sz="1200">
              <a:effectLst/>
              <a:latin typeface="Times New Roman" panose="02020603050405020304" pitchFamily="18" charset="0"/>
              <a:ea typeface="Times New Roman" panose="02020603050405020304" pitchFamily="18" charset="0"/>
            </a:endParaRPr>
          </a:p>
        </p:txBody>
      </p:sp>
      <p:sp>
        <p:nvSpPr>
          <p:cNvPr id="24" name="TextBox 55">
            <a:extLst>
              <a:ext uri="{FF2B5EF4-FFF2-40B4-BE49-F238E27FC236}">
                <a16:creationId xmlns:a16="http://schemas.microsoft.com/office/drawing/2014/main" id="{3F5EBB1A-ACB5-4AB8-A8B5-C89EBA453F88}"/>
              </a:ext>
            </a:extLst>
          </p:cNvPr>
          <p:cNvSpPr txBox="1"/>
          <p:nvPr/>
        </p:nvSpPr>
        <p:spPr>
          <a:xfrm>
            <a:off x="1964232" y="5359874"/>
            <a:ext cx="586131"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5 min</a:t>
            </a:r>
            <a:endParaRPr lang="en-GB" sz="1200">
              <a:effectLst/>
              <a:latin typeface="Times New Roman" panose="02020603050405020304" pitchFamily="18" charset="0"/>
              <a:ea typeface="Times New Roman" panose="02020603050405020304" pitchFamily="18" charset="0"/>
            </a:endParaRPr>
          </a:p>
        </p:txBody>
      </p:sp>
      <p:sp>
        <p:nvSpPr>
          <p:cNvPr id="25" name="TextBox 56">
            <a:extLst>
              <a:ext uri="{FF2B5EF4-FFF2-40B4-BE49-F238E27FC236}">
                <a16:creationId xmlns:a16="http://schemas.microsoft.com/office/drawing/2014/main" id="{B552C8CF-6362-4B1F-AD79-E1266456B0AB}"/>
              </a:ext>
            </a:extLst>
          </p:cNvPr>
          <p:cNvSpPr txBox="1"/>
          <p:nvPr/>
        </p:nvSpPr>
        <p:spPr>
          <a:xfrm>
            <a:off x="2766774" y="5359885"/>
            <a:ext cx="663674"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6 min</a:t>
            </a:r>
            <a:endParaRPr lang="en-GB" sz="1200">
              <a:effectLst/>
              <a:latin typeface="Times New Roman" panose="02020603050405020304" pitchFamily="18" charset="0"/>
              <a:ea typeface="Times New Roman" panose="02020603050405020304" pitchFamily="18" charset="0"/>
            </a:endParaRPr>
          </a:p>
        </p:txBody>
      </p:sp>
      <p:sp>
        <p:nvSpPr>
          <p:cNvPr id="26" name="TextBox 57">
            <a:extLst>
              <a:ext uri="{FF2B5EF4-FFF2-40B4-BE49-F238E27FC236}">
                <a16:creationId xmlns:a16="http://schemas.microsoft.com/office/drawing/2014/main" id="{9995E7CD-CD74-4187-842A-25F744DBA252}"/>
              </a:ext>
            </a:extLst>
          </p:cNvPr>
          <p:cNvSpPr txBox="1"/>
          <p:nvPr/>
        </p:nvSpPr>
        <p:spPr>
          <a:xfrm>
            <a:off x="3670896" y="5351489"/>
            <a:ext cx="789851"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7min</a:t>
            </a:r>
            <a:endParaRPr lang="en-GB" sz="1200">
              <a:effectLst/>
              <a:latin typeface="Times New Roman" panose="02020603050405020304" pitchFamily="18" charset="0"/>
              <a:ea typeface="Times New Roman" panose="02020603050405020304" pitchFamily="18" charset="0"/>
            </a:endParaRPr>
          </a:p>
        </p:txBody>
      </p:sp>
      <p:sp>
        <p:nvSpPr>
          <p:cNvPr id="27" name="TextBox 58">
            <a:extLst>
              <a:ext uri="{FF2B5EF4-FFF2-40B4-BE49-F238E27FC236}">
                <a16:creationId xmlns:a16="http://schemas.microsoft.com/office/drawing/2014/main" id="{FB7132AD-9649-442C-817C-8DB6DE5A00F3}"/>
              </a:ext>
            </a:extLst>
          </p:cNvPr>
          <p:cNvSpPr txBox="1"/>
          <p:nvPr/>
        </p:nvSpPr>
        <p:spPr>
          <a:xfrm>
            <a:off x="4545671" y="5351471"/>
            <a:ext cx="690005"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8 min</a:t>
            </a:r>
            <a:endParaRPr lang="en-GB" sz="1200">
              <a:effectLst/>
              <a:latin typeface="Times New Roman" panose="02020603050405020304" pitchFamily="18" charset="0"/>
              <a:ea typeface="Times New Roman" panose="02020603050405020304" pitchFamily="18" charset="0"/>
            </a:endParaRPr>
          </a:p>
        </p:txBody>
      </p:sp>
      <p:sp>
        <p:nvSpPr>
          <p:cNvPr id="28" name="TextBox 59">
            <a:extLst>
              <a:ext uri="{FF2B5EF4-FFF2-40B4-BE49-F238E27FC236}">
                <a16:creationId xmlns:a16="http://schemas.microsoft.com/office/drawing/2014/main" id="{E2DB1151-9B72-44BB-982C-FD2C5EEF8B0D}"/>
              </a:ext>
            </a:extLst>
          </p:cNvPr>
          <p:cNvSpPr txBox="1"/>
          <p:nvPr/>
        </p:nvSpPr>
        <p:spPr>
          <a:xfrm>
            <a:off x="5395274" y="5351471"/>
            <a:ext cx="586410" cy="197684"/>
          </a:xfrm>
          <a:prstGeom prst="rect">
            <a:avLst/>
          </a:prstGeom>
          <a:noFill/>
        </p:spPr>
        <p:txBody>
          <a:bodyPr wrap="square" rtlCol="0">
            <a:noAutofit/>
          </a:bodyPr>
          <a:lstStyle/>
          <a:p>
            <a:pPr>
              <a:spcAft>
                <a:spcPts val="0"/>
              </a:spcAft>
            </a:pPr>
            <a:r>
              <a:rPr lang="en-GB" sz="700" kern="1200">
                <a:solidFill>
                  <a:srgbClr val="FFFFFF"/>
                </a:solidFill>
                <a:effectLst/>
                <a:latin typeface="Calibri" panose="020F0502020204030204" pitchFamily="34" charset="0"/>
                <a:ea typeface="Times New Roman" panose="02020603050405020304" pitchFamily="18" charset="0"/>
                <a:cs typeface="Times New Roman" panose="02020603050405020304" pitchFamily="18" charset="0"/>
              </a:rPr>
              <a:t>9 min</a:t>
            </a:r>
            <a:endParaRPr lang="en-GB" sz="1200">
              <a:effectLst/>
              <a:latin typeface="Times New Roman" panose="02020603050405020304" pitchFamily="18" charset="0"/>
              <a:ea typeface="Times New Roman" panose="02020603050405020304" pitchFamily="18" charset="0"/>
            </a:endParaRPr>
          </a:p>
        </p:txBody>
      </p:sp>
      <p:sp>
        <p:nvSpPr>
          <p:cNvPr id="29" name="TextBox 60">
            <a:extLst>
              <a:ext uri="{FF2B5EF4-FFF2-40B4-BE49-F238E27FC236}">
                <a16:creationId xmlns:a16="http://schemas.microsoft.com/office/drawing/2014/main" id="{798DEC88-44BF-4850-A586-916F26E789AB}"/>
              </a:ext>
            </a:extLst>
          </p:cNvPr>
          <p:cNvSpPr txBox="1"/>
          <p:nvPr/>
        </p:nvSpPr>
        <p:spPr>
          <a:xfrm rot="16200000">
            <a:off x="1382344" y="5159837"/>
            <a:ext cx="702171" cy="258456"/>
          </a:xfrm>
          <a:prstGeom prst="rect">
            <a:avLst/>
          </a:prstGeom>
          <a:noFill/>
        </p:spPr>
        <p:txBody>
          <a:bodyPr wrap="square" rtlCol="0">
            <a:noAutofit/>
          </a:bodyPr>
          <a:lstStyle/>
          <a:p>
            <a:pPr>
              <a:spcAft>
                <a:spcPts val="0"/>
              </a:spcAft>
            </a:pPr>
            <a:r>
              <a:rPr lang="en-GB" sz="1100" kern="120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ontrol </a:t>
            </a:r>
            <a:endParaRPr lang="en-GB" sz="1200">
              <a:effectLst/>
              <a:latin typeface="Times New Roman" panose="02020603050405020304" pitchFamily="18" charset="0"/>
              <a:ea typeface="Times New Roman" panose="02020603050405020304" pitchFamily="18" charset="0"/>
            </a:endParaRPr>
          </a:p>
        </p:txBody>
      </p:sp>
      <p:sp>
        <p:nvSpPr>
          <p:cNvPr id="31" name="TextBox 62">
            <a:extLst>
              <a:ext uri="{FF2B5EF4-FFF2-40B4-BE49-F238E27FC236}">
                <a16:creationId xmlns:a16="http://schemas.microsoft.com/office/drawing/2014/main" id="{9D2F89A6-129C-441A-AEB4-95182B7F5C4E}"/>
              </a:ext>
            </a:extLst>
          </p:cNvPr>
          <p:cNvSpPr txBox="1"/>
          <p:nvPr/>
        </p:nvSpPr>
        <p:spPr>
          <a:xfrm>
            <a:off x="1521268" y="4430691"/>
            <a:ext cx="264139" cy="273757"/>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D</a:t>
            </a:r>
            <a:endParaRPr lang="en-GB" sz="1200" dirty="0">
              <a:effectLst/>
              <a:latin typeface="Times New Roman" panose="02020603050405020304" pitchFamily="18" charset="0"/>
              <a:ea typeface="Times New Roman" panose="02020603050405020304" pitchFamily="18" charset="0"/>
            </a:endParaRPr>
          </a:p>
        </p:txBody>
      </p:sp>
      <p:sp>
        <p:nvSpPr>
          <p:cNvPr id="32" name="TextBox 63">
            <a:extLst>
              <a:ext uri="{FF2B5EF4-FFF2-40B4-BE49-F238E27FC236}">
                <a16:creationId xmlns:a16="http://schemas.microsoft.com/office/drawing/2014/main" id="{C81E2CFA-A7AA-4895-B868-16AAA3E0FC24}"/>
              </a:ext>
            </a:extLst>
          </p:cNvPr>
          <p:cNvSpPr txBox="1"/>
          <p:nvPr/>
        </p:nvSpPr>
        <p:spPr>
          <a:xfrm>
            <a:off x="1526012" y="2505989"/>
            <a:ext cx="260333" cy="274247"/>
          </a:xfrm>
          <a:prstGeom prst="rect">
            <a:avLst/>
          </a:prstGeom>
          <a:noFill/>
        </p:spPr>
        <p:txBody>
          <a:bodyPr wrap="square" rtlCol="0">
            <a:noAutofit/>
          </a:bodyPr>
          <a:lstStyle/>
          <a:p>
            <a:pPr>
              <a:spcAft>
                <a:spcPts val="0"/>
              </a:spcAft>
            </a:pPr>
            <a:r>
              <a:rPr lang="en-GB" sz="1200" kern="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C</a:t>
            </a:r>
            <a:endParaRPr lang="en-GB" sz="1200" dirty="0">
              <a:effectLst/>
              <a:latin typeface="Times New Roman" panose="02020603050405020304" pitchFamily="18" charset="0"/>
              <a:ea typeface="Times New Roman" panose="02020603050405020304" pitchFamily="18" charset="0"/>
            </a:endParaRPr>
          </a:p>
        </p:txBody>
      </p:sp>
      <p:sp>
        <p:nvSpPr>
          <p:cNvPr id="35" name="TextBox 8">
            <a:extLst>
              <a:ext uri="{FF2B5EF4-FFF2-40B4-BE49-F238E27FC236}">
                <a16:creationId xmlns:a16="http://schemas.microsoft.com/office/drawing/2014/main" id="{22AB78BD-C1E3-4D4C-92BE-EF587A5DC676}"/>
              </a:ext>
            </a:extLst>
          </p:cNvPr>
          <p:cNvSpPr txBox="1"/>
          <p:nvPr/>
        </p:nvSpPr>
        <p:spPr>
          <a:xfrm>
            <a:off x="2539128" y="205781"/>
            <a:ext cx="1707094" cy="304135"/>
          </a:xfrm>
          <a:prstGeom prst="rect">
            <a:avLst/>
          </a:prstGeom>
          <a:noFill/>
        </p:spPr>
        <p:txBody>
          <a:bodyPr wrap="square" rtlCol="0">
            <a:noAutofit/>
          </a:bodyPr>
          <a:lstStyle/>
          <a:p>
            <a:pPr algn="ctr">
              <a:spcAft>
                <a:spcPts val="0"/>
              </a:spcAft>
            </a:pPr>
            <a:r>
              <a:rPr lang="en-GB" sz="1100" kern="1200" dirty="0">
                <a:solidFill>
                  <a:schemeClr val="bg1"/>
                </a:solidFill>
                <a:effectLst/>
                <a:latin typeface="Calibri" panose="020F0502020204030204" pitchFamily="34" charset="0"/>
                <a:ea typeface="Times New Roman" panose="02020603050405020304" pitchFamily="18" charset="0"/>
                <a:cs typeface="Times New Roman" panose="02020603050405020304" pitchFamily="18" charset="0"/>
              </a:rPr>
              <a:t>+ INK128 (70 µM)</a:t>
            </a:r>
            <a:endParaRPr lang="en-GB" sz="1200" dirty="0">
              <a:solidFill>
                <a:schemeClr val="bg1"/>
              </a:solidFill>
              <a:effectLst/>
              <a:latin typeface="Times New Roman" panose="02020603050405020304" pitchFamily="18" charset="0"/>
              <a:ea typeface="Times New Roman" panose="02020603050405020304" pitchFamily="18" charset="0"/>
            </a:endParaRPr>
          </a:p>
        </p:txBody>
      </p:sp>
      <p:sp>
        <p:nvSpPr>
          <p:cNvPr id="38" name="TextBox 19">
            <a:extLst>
              <a:ext uri="{FF2B5EF4-FFF2-40B4-BE49-F238E27FC236}">
                <a16:creationId xmlns:a16="http://schemas.microsoft.com/office/drawing/2014/main" id="{321EF678-1E68-4B40-BD78-1FE3AA679829}"/>
              </a:ext>
            </a:extLst>
          </p:cNvPr>
          <p:cNvSpPr txBox="1"/>
          <p:nvPr/>
        </p:nvSpPr>
        <p:spPr>
          <a:xfrm>
            <a:off x="1510205" y="190386"/>
            <a:ext cx="275202" cy="273782"/>
          </a:xfrm>
          <a:prstGeom prst="rect">
            <a:avLst/>
          </a:prstGeom>
          <a:noFill/>
        </p:spPr>
        <p:txBody>
          <a:bodyPr wrap="square" rtlCol="0">
            <a:noAutofit/>
          </a:bodyPr>
          <a:lstStyle/>
          <a:p>
            <a:pPr>
              <a:spcAft>
                <a:spcPts val="0"/>
              </a:spcAft>
            </a:pPr>
            <a:r>
              <a:rPr lang="en-GB" sz="1200" dirty="0">
                <a:solidFill>
                  <a:srgbClr val="000000"/>
                </a:solidFill>
                <a:latin typeface="Calibri" panose="020F0502020204030204" pitchFamily="34" charset="0"/>
                <a:ea typeface="Times New Roman" panose="02020603050405020304" pitchFamily="18" charset="0"/>
                <a:cs typeface="Times New Roman" panose="02020603050405020304" pitchFamily="18" charset="0"/>
              </a:rPr>
              <a:t>A</a:t>
            </a:r>
            <a:endParaRPr lang="en-GB" sz="1200" dirty="0">
              <a:effectLst/>
              <a:latin typeface="Times New Roman" panose="02020603050405020304" pitchFamily="18" charset="0"/>
              <a:ea typeface="Times New Roman" panose="02020603050405020304" pitchFamily="18" charset="0"/>
            </a:endParaRPr>
          </a:p>
        </p:txBody>
      </p:sp>
      <p:cxnSp>
        <p:nvCxnSpPr>
          <p:cNvPr id="39" name="Straight Connector 38">
            <a:extLst>
              <a:ext uri="{FF2B5EF4-FFF2-40B4-BE49-F238E27FC236}">
                <a16:creationId xmlns:a16="http://schemas.microsoft.com/office/drawing/2014/main" id="{534F0480-F9A6-4670-8576-3EDEC4311CB3}"/>
              </a:ext>
            </a:extLst>
          </p:cNvPr>
          <p:cNvCxnSpPr/>
          <p:nvPr/>
        </p:nvCxnSpPr>
        <p:spPr>
          <a:xfrm>
            <a:off x="5811105" y="6096879"/>
            <a:ext cx="180008"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0" name="Straight Connector 39">
            <a:extLst>
              <a:ext uri="{FF2B5EF4-FFF2-40B4-BE49-F238E27FC236}">
                <a16:creationId xmlns:a16="http://schemas.microsoft.com/office/drawing/2014/main" id="{34F62C15-C56A-4D26-96CF-9497B17E6827}"/>
              </a:ext>
            </a:extLst>
          </p:cNvPr>
          <p:cNvCxnSpPr/>
          <p:nvPr/>
        </p:nvCxnSpPr>
        <p:spPr>
          <a:xfrm>
            <a:off x="5877261" y="4120868"/>
            <a:ext cx="180008" cy="0"/>
          </a:xfrm>
          <a:prstGeom prst="line">
            <a:avLst/>
          </a:prstGeom>
          <a:ln>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1" name="Straight Connector 40">
            <a:extLst>
              <a:ext uri="{FF2B5EF4-FFF2-40B4-BE49-F238E27FC236}">
                <a16:creationId xmlns:a16="http://schemas.microsoft.com/office/drawing/2014/main" id="{39B7977E-301E-43D9-90B1-3A5AFBF24A35}"/>
              </a:ext>
            </a:extLst>
          </p:cNvPr>
          <p:cNvCxnSpPr/>
          <p:nvPr/>
        </p:nvCxnSpPr>
        <p:spPr>
          <a:xfrm>
            <a:off x="3646369" y="4273503"/>
            <a:ext cx="32397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42" name="Straight Connector 41">
            <a:extLst>
              <a:ext uri="{FF2B5EF4-FFF2-40B4-BE49-F238E27FC236}">
                <a16:creationId xmlns:a16="http://schemas.microsoft.com/office/drawing/2014/main" id="{2C65E89A-64FF-496F-852A-69686A87F980}"/>
              </a:ext>
            </a:extLst>
          </p:cNvPr>
          <p:cNvCxnSpPr/>
          <p:nvPr/>
        </p:nvCxnSpPr>
        <p:spPr>
          <a:xfrm>
            <a:off x="5756493" y="4266938"/>
            <a:ext cx="323979" cy="0"/>
          </a:xfrm>
          <a:prstGeom prst="line">
            <a:avLst/>
          </a:prstGeom>
          <a:ln w="19050">
            <a:solidFill>
              <a:schemeClr val="bg1"/>
            </a:solidFill>
          </a:ln>
        </p:spPr>
        <p:style>
          <a:lnRef idx="1">
            <a:schemeClr val="accent1"/>
          </a:lnRef>
          <a:fillRef idx="0">
            <a:schemeClr val="accent1"/>
          </a:fillRef>
          <a:effectRef idx="0">
            <a:schemeClr val="accent1"/>
          </a:effectRef>
          <a:fontRef idx="minor">
            <a:schemeClr val="tx1"/>
          </a:fontRef>
        </p:style>
      </p:cxnSp>
      <p:sp>
        <p:nvSpPr>
          <p:cNvPr id="43" name="TextBox 19">
            <a:extLst>
              <a:ext uri="{FF2B5EF4-FFF2-40B4-BE49-F238E27FC236}">
                <a16:creationId xmlns:a16="http://schemas.microsoft.com/office/drawing/2014/main" id="{C56E38DC-9E7E-4B85-B9C9-05CB893C0595}"/>
              </a:ext>
            </a:extLst>
          </p:cNvPr>
          <p:cNvSpPr txBox="1"/>
          <p:nvPr/>
        </p:nvSpPr>
        <p:spPr>
          <a:xfrm>
            <a:off x="3988375" y="176328"/>
            <a:ext cx="275202" cy="273782"/>
          </a:xfrm>
          <a:prstGeom prst="rect">
            <a:avLst/>
          </a:prstGeom>
          <a:noFill/>
        </p:spPr>
        <p:txBody>
          <a:bodyPr wrap="square" rtlCol="0">
            <a:noAutofit/>
          </a:bodyPr>
          <a:lstStyle/>
          <a:p>
            <a:pPr>
              <a:spcAft>
                <a:spcPts val="0"/>
              </a:spcAft>
            </a:pPr>
            <a:r>
              <a:rPr lang="en-GB" sz="1200" dirty="0">
                <a:solidFill>
                  <a:srgbClr val="000000"/>
                </a:solidFill>
                <a:effectLst/>
                <a:latin typeface="Calibri" panose="020F0502020204030204" pitchFamily="34" charset="0"/>
                <a:ea typeface="Times New Roman" panose="02020603050405020304" pitchFamily="18" charset="0"/>
                <a:cs typeface="Times New Roman" panose="02020603050405020304" pitchFamily="18" charset="0"/>
              </a:rPr>
              <a:t>B</a:t>
            </a:r>
            <a:endParaRPr lang="en-GB" sz="1200" dirty="0">
              <a:effectLst/>
              <a:latin typeface="Times New Roman" panose="02020603050405020304" pitchFamily="18" charset="0"/>
              <a:ea typeface="Times New Roman" panose="02020603050405020304" pitchFamily="18" charset="0"/>
            </a:endParaRPr>
          </a:p>
        </p:txBody>
      </p:sp>
      <p:sp>
        <p:nvSpPr>
          <p:cNvPr id="37" name="Rectangle 36">
            <a:extLst>
              <a:ext uri="{FF2B5EF4-FFF2-40B4-BE49-F238E27FC236}">
                <a16:creationId xmlns:a16="http://schemas.microsoft.com/office/drawing/2014/main" id="{BF0C420A-60D2-471D-BBD7-2D2D77F09EDA}"/>
              </a:ext>
            </a:extLst>
          </p:cNvPr>
          <p:cNvSpPr/>
          <p:nvPr/>
        </p:nvSpPr>
        <p:spPr>
          <a:xfrm>
            <a:off x="6245821" y="114279"/>
            <a:ext cx="1851739" cy="4093428"/>
          </a:xfrm>
          <a:prstGeom prst="rect">
            <a:avLst/>
          </a:prstGeom>
        </p:spPr>
        <p:txBody>
          <a:bodyPr wrap="square">
            <a:spAutoFit/>
          </a:bodyPr>
          <a:lstStyle/>
          <a:p>
            <a:pPr algn="just">
              <a:spcAft>
                <a:spcPts val="1000"/>
              </a:spcAft>
            </a:pPr>
            <a:r>
              <a:rPr lang="en-GB" sz="1000" b="1" i="1" dirty="0">
                <a:latin typeface="Arial" panose="020B0604020202020204" pitchFamily="34" charset="0"/>
                <a:ea typeface="Calibri" panose="020F0502020204030204" pitchFamily="34" charset="0"/>
                <a:cs typeface="Times New Roman" panose="02020603050405020304" pitchFamily="18" charset="0"/>
              </a:rPr>
              <a:t>Supplementary Figure S.7: </a:t>
            </a:r>
            <a:r>
              <a:rPr lang="en-GB" sz="1000" b="1" i="1" dirty="0">
                <a:latin typeface="Arial" panose="020B0604020202020204" pitchFamily="34" charset="0"/>
                <a:cs typeface="Arial" panose="020B0604020202020204" pitchFamily="34" charset="0"/>
              </a:rPr>
              <a:t>Imaging the uptake of INK128 in live HEK293 cells. </a:t>
            </a:r>
            <a:r>
              <a:rPr lang="en-GB" sz="1000" i="1" dirty="0">
                <a:latin typeface="Arial" panose="020B0604020202020204" pitchFamily="34" charset="0"/>
                <a:cs typeface="Arial" panose="020B0604020202020204" pitchFamily="34" charset="0"/>
              </a:rPr>
              <a:t>A) Two-photon confocal image of INK128 in live HEK293 cells. Data representative of one of three independent repeats where error bars show standard deviation. Scale bar </a:t>
            </a:r>
            <a:r>
              <a:rPr lang="en-GB" sz="1000" i="1" dirty="0" smtClean="0">
                <a:latin typeface="Arial" panose="020B0604020202020204" pitchFamily="34" charset="0"/>
                <a:cs typeface="Arial" panose="020B0604020202020204" pitchFamily="34" charset="0"/>
              </a:rPr>
              <a:t>10 </a:t>
            </a:r>
            <a:r>
              <a:rPr lang="en-GB" sz="1000" i="1" dirty="0" err="1">
                <a:latin typeface="Arial" panose="020B0604020202020204" pitchFamily="34" charset="0"/>
                <a:cs typeface="Arial" panose="020B0604020202020204" pitchFamily="34" charset="0"/>
              </a:rPr>
              <a:t>μm</a:t>
            </a:r>
            <a:r>
              <a:rPr lang="en-GB" sz="1000" i="1" dirty="0">
                <a:latin typeface="Arial" panose="020B0604020202020204" pitchFamily="34" charset="0"/>
                <a:cs typeface="Arial" panose="020B0604020202020204" pitchFamily="34" charset="0"/>
              </a:rPr>
              <a:t>. B) Uptake curve of INK128 (70 </a:t>
            </a:r>
            <a:r>
              <a:rPr lang="en-GB" sz="1000" i="1" dirty="0" err="1">
                <a:latin typeface="Arial" panose="020B0604020202020204" pitchFamily="34" charset="0"/>
                <a:cs typeface="Arial" panose="020B0604020202020204" pitchFamily="34" charset="0"/>
              </a:rPr>
              <a:t>μM</a:t>
            </a:r>
            <a:r>
              <a:rPr lang="en-GB" sz="1000" i="1" dirty="0">
                <a:latin typeface="Arial" panose="020B0604020202020204" pitchFamily="34" charset="0"/>
                <a:cs typeface="Arial" panose="020B0604020202020204" pitchFamily="34" charset="0"/>
              </a:rPr>
              <a:t>) in HEK293 cells over time by extracting average intensity from multiphoton confocal images with a Michaelis–Menten (MM) fitting. </a:t>
            </a:r>
            <a:r>
              <a:rPr lang="en-GB" sz="1000" i="1" dirty="0" smtClean="0">
                <a:latin typeface="Arial" panose="020B0604020202020204" pitchFamily="34" charset="0"/>
                <a:cs typeface="Arial" panose="020B0604020202020204" pitchFamily="34" charset="0"/>
              </a:rPr>
              <a:t>C</a:t>
            </a:r>
            <a:r>
              <a:rPr lang="en-GB" sz="1000" i="1" dirty="0">
                <a:latin typeface="Arial" panose="020B0604020202020204" pitchFamily="34" charset="0"/>
                <a:cs typeface="Arial" panose="020B0604020202020204" pitchFamily="34" charset="0"/>
              </a:rPr>
              <a:t>) Series of multiphoton images of </a:t>
            </a:r>
            <a:r>
              <a:rPr lang="en-GB" sz="1000" i="1" dirty="0" smtClean="0">
                <a:latin typeface="Arial" panose="020B0604020202020204" pitchFamily="34" charset="0"/>
                <a:cs typeface="Arial" panose="020B0604020202020204" pitchFamily="34" charset="0"/>
              </a:rPr>
              <a:t>HEK293 cells </a:t>
            </a:r>
            <a:r>
              <a:rPr lang="en-GB" sz="1000" i="1" dirty="0">
                <a:latin typeface="Arial" panose="020B0604020202020204" pitchFamily="34" charset="0"/>
                <a:cs typeface="Arial" panose="020B0604020202020204" pitchFamily="34" charset="0"/>
              </a:rPr>
              <a:t>administered with INK128 (70 </a:t>
            </a:r>
            <a:r>
              <a:rPr lang="en-GB" sz="1000" i="1" dirty="0" err="1">
                <a:latin typeface="Arial" panose="020B0604020202020204" pitchFamily="34" charset="0"/>
                <a:cs typeface="Arial" panose="020B0604020202020204" pitchFamily="34" charset="0"/>
              </a:rPr>
              <a:t>μM</a:t>
            </a:r>
            <a:r>
              <a:rPr lang="en-GB" sz="1000" i="1" dirty="0">
                <a:latin typeface="Arial" panose="020B0604020202020204" pitchFamily="34" charset="0"/>
                <a:cs typeface="Arial" panose="020B0604020202020204" pitchFamily="34" charset="0"/>
              </a:rPr>
              <a:t>) illuminated with 600 nm over time. D) Series of multiphoton images of </a:t>
            </a:r>
            <a:r>
              <a:rPr lang="en-GB" sz="1000" i="1" dirty="0" smtClean="0">
                <a:latin typeface="Arial" panose="020B0604020202020204" pitchFamily="34" charset="0"/>
                <a:cs typeface="Arial" panose="020B0604020202020204" pitchFamily="34" charset="0"/>
              </a:rPr>
              <a:t>HEK293 cells </a:t>
            </a:r>
            <a:r>
              <a:rPr lang="en-GB" sz="1000" i="1" dirty="0">
                <a:latin typeface="Arial" panose="020B0604020202020204" pitchFamily="34" charset="0"/>
                <a:cs typeface="Arial" panose="020B0604020202020204" pitchFamily="34" charset="0"/>
              </a:rPr>
              <a:t>without treatment illuminated with 600 nm over time. Scale bar = 50 </a:t>
            </a:r>
            <a:r>
              <a:rPr lang="en-GB" sz="1000" i="1" dirty="0" err="1" smtClean="0">
                <a:latin typeface="Arial" panose="020B0604020202020204" pitchFamily="34" charset="0"/>
                <a:cs typeface="Arial" panose="020B0604020202020204" pitchFamily="34" charset="0"/>
              </a:rPr>
              <a:t>μm</a:t>
            </a:r>
            <a:r>
              <a:rPr lang="en-GB" sz="1000" i="1" dirty="0" smtClean="0">
                <a:latin typeface="Arial" panose="020B0604020202020204" pitchFamily="34" charset="0"/>
                <a:cs typeface="Arial" panose="020B0604020202020204" pitchFamily="34" charset="0"/>
              </a:rPr>
              <a:t>, n&gt;3.</a:t>
            </a:r>
            <a:endParaRPr lang="en-GB" sz="1000" i="1" dirty="0">
              <a:latin typeface="Arial" panose="020B0604020202020204" pitchFamily="34" charset="0"/>
              <a:ea typeface="Calibri" panose="020F0502020204030204" pitchFamily="34" charset="0"/>
              <a:cs typeface="Arial" panose="020B0604020202020204" pitchFamily="34" charset="0"/>
            </a:endParaRPr>
          </a:p>
        </p:txBody>
      </p:sp>
    </p:spTree>
    <p:extLst>
      <p:ext uri="{BB962C8B-B14F-4D97-AF65-F5344CB8AC3E}">
        <p14:creationId xmlns:p14="http://schemas.microsoft.com/office/powerpoint/2010/main" val="4229821768"/>
      </p:ext>
    </p:extLst>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8351</TotalTime>
  <Words>1474</Words>
  <Application>Microsoft Office PowerPoint</Application>
  <PresentationFormat>On-screen Show (4:3)</PresentationFormat>
  <Paragraphs>215</Paragraphs>
  <Slides>7</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7</vt:i4>
      </vt:variant>
    </vt:vector>
  </HeadingPairs>
  <TitlesOfParts>
    <vt:vector size="12" baseType="lpstr">
      <vt:lpstr>Arial</vt:lpstr>
      <vt:lpstr>Calibri</vt:lpstr>
      <vt:lpstr>Calibri Light</vt:lpstr>
      <vt:lpstr>Times New Roman</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Abdullah Ahmed</dc:creator>
  <cp:lastModifiedBy>Parker, Tony (STFC,RAL,CLF)</cp:lastModifiedBy>
  <cp:revision>121</cp:revision>
  <dcterms:created xsi:type="dcterms:W3CDTF">2018-12-29T13:54:57Z</dcterms:created>
  <dcterms:modified xsi:type="dcterms:W3CDTF">2020-05-26T12:51:07Z</dcterms:modified>
</cp:coreProperties>
</file>